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3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300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C0C000"/>
    <a:srgbClr val="FFFFA0"/>
    <a:srgbClr val="FFC080"/>
    <a:srgbClr val="FFFF00"/>
    <a:srgbClr val="FF6000"/>
    <a:srgbClr val="0000FF"/>
    <a:srgbClr val="EB0000"/>
    <a:srgbClr val="00CC00"/>
    <a:srgbClr val="FF8838"/>
    <a:srgbClr val="FF7214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8934" autoAdjust="0"/>
    <p:restoredTop sz="92752" autoAdjust="0"/>
  </p:normalViewPr>
  <p:slideViewPr>
    <p:cSldViewPr snapToGrid="0">
      <p:cViewPr varScale="1">
        <p:scale>
          <a:sx n="103" d="100"/>
          <a:sy n="103" d="100"/>
        </p:scale>
        <p:origin x="1176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User\Desktop\Gaelle\Calcium%20analysis%20Gaelle.xlsx" TargetMode="Externa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User\Desktop\Gaelle\Calcium%20analysis%20Gaelle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User\Desktop\Gaelle\Calcium%20analysis%20Gaelle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7"/>
    </mc:Choice>
    <mc:Fallback>
      <c:style val="7"/>
    </mc:Fallback>
  </mc:AlternateContent>
  <c:chart>
    <c:autoTitleDeleted val="1"/>
    <c:plotArea>
      <c:layout/>
      <c:scatterChart>
        <c:scatterStyle val="smoothMarker"/>
        <c:varyColors val="0"/>
        <c:ser>
          <c:idx val="23"/>
          <c:order val="0"/>
          <c:tx>
            <c:strRef>
              <c:f>'Sheet2 control'!$DB$91</c:f>
              <c:strCache>
                <c:ptCount val="1"/>
                <c:pt idx="0">
                  <c:v>   Object[28]</c:v>
                </c:pt>
              </c:strCache>
            </c:strRef>
          </c:tx>
          <c:spPr>
            <a:ln w="3175">
              <a:solidFill>
                <a:srgbClr val="00588A"/>
              </a:solidFill>
            </a:ln>
          </c:spPr>
          <c:marker>
            <c:symbol val="none"/>
          </c:marker>
          <c:xVal>
            <c:numRef>
              <c:f>'Sheet2 control'!$BZ$92:$BZ$3961</c:f>
              <c:numCache>
                <c:formatCode>General</c:formatCode>
                <c:ptCount val="3870"/>
                <c:pt idx="0">
                  <c:v>0.18</c:v>
                </c:pt>
                <c:pt idx="1">
                  <c:v>0.44</c:v>
                </c:pt>
                <c:pt idx="2">
                  <c:v>0.73</c:v>
                </c:pt>
                <c:pt idx="3">
                  <c:v>1.01</c:v>
                </c:pt>
                <c:pt idx="4">
                  <c:v>1.29</c:v>
                </c:pt>
                <c:pt idx="5">
                  <c:v>1.57</c:v>
                </c:pt>
                <c:pt idx="6">
                  <c:v>1.85</c:v>
                </c:pt>
                <c:pt idx="7">
                  <c:v>2.13</c:v>
                </c:pt>
                <c:pt idx="8">
                  <c:v>2.41</c:v>
                </c:pt>
                <c:pt idx="9">
                  <c:v>2.69</c:v>
                </c:pt>
                <c:pt idx="10">
                  <c:v>2.98</c:v>
                </c:pt>
                <c:pt idx="11">
                  <c:v>3.26</c:v>
                </c:pt>
                <c:pt idx="12">
                  <c:v>3.54</c:v>
                </c:pt>
                <c:pt idx="13">
                  <c:v>3.82</c:v>
                </c:pt>
                <c:pt idx="14">
                  <c:v>4.0999999999999996</c:v>
                </c:pt>
                <c:pt idx="15">
                  <c:v>4.38</c:v>
                </c:pt>
                <c:pt idx="16">
                  <c:v>4.66</c:v>
                </c:pt>
                <c:pt idx="17">
                  <c:v>4.9400000000000004</c:v>
                </c:pt>
                <c:pt idx="18">
                  <c:v>5.22</c:v>
                </c:pt>
                <c:pt idx="19">
                  <c:v>5.5</c:v>
                </c:pt>
                <c:pt idx="20">
                  <c:v>5.78</c:v>
                </c:pt>
                <c:pt idx="21">
                  <c:v>6.07</c:v>
                </c:pt>
                <c:pt idx="22">
                  <c:v>6.34</c:v>
                </c:pt>
                <c:pt idx="23">
                  <c:v>6.62</c:v>
                </c:pt>
                <c:pt idx="24">
                  <c:v>6.9</c:v>
                </c:pt>
                <c:pt idx="25">
                  <c:v>7.19</c:v>
                </c:pt>
                <c:pt idx="26">
                  <c:v>7.46</c:v>
                </c:pt>
                <c:pt idx="27">
                  <c:v>7.75</c:v>
                </c:pt>
                <c:pt idx="28">
                  <c:v>8.0299999999999994</c:v>
                </c:pt>
                <c:pt idx="29">
                  <c:v>8.31</c:v>
                </c:pt>
                <c:pt idx="30">
                  <c:v>8.59</c:v>
                </c:pt>
                <c:pt idx="31">
                  <c:v>8.8699999999999992</c:v>
                </c:pt>
                <c:pt idx="32">
                  <c:v>9.15</c:v>
                </c:pt>
                <c:pt idx="33">
                  <c:v>9.43</c:v>
                </c:pt>
                <c:pt idx="34">
                  <c:v>9.7100000000000009</c:v>
                </c:pt>
                <c:pt idx="35">
                  <c:v>9.99</c:v>
                </c:pt>
                <c:pt idx="36">
                  <c:v>10.27</c:v>
                </c:pt>
                <c:pt idx="37">
                  <c:v>10.55</c:v>
                </c:pt>
                <c:pt idx="38">
                  <c:v>10.84</c:v>
                </c:pt>
                <c:pt idx="39">
                  <c:v>11.12</c:v>
                </c:pt>
                <c:pt idx="40">
                  <c:v>11.39</c:v>
                </c:pt>
                <c:pt idx="41">
                  <c:v>11.68</c:v>
                </c:pt>
                <c:pt idx="42">
                  <c:v>11.96</c:v>
                </c:pt>
                <c:pt idx="43">
                  <c:v>12.24</c:v>
                </c:pt>
                <c:pt idx="44">
                  <c:v>12.52</c:v>
                </c:pt>
                <c:pt idx="45">
                  <c:v>12.8</c:v>
                </c:pt>
                <c:pt idx="46">
                  <c:v>13.08</c:v>
                </c:pt>
                <c:pt idx="47">
                  <c:v>13.36</c:v>
                </c:pt>
                <c:pt idx="48">
                  <c:v>13.65</c:v>
                </c:pt>
                <c:pt idx="49">
                  <c:v>13.92</c:v>
                </c:pt>
                <c:pt idx="50">
                  <c:v>14.21</c:v>
                </c:pt>
                <c:pt idx="51">
                  <c:v>14.48</c:v>
                </c:pt>
                <c:pt idx="52">
                  <c:v>14.77</c:v>
                </c:pt>
                <c:pt idx="53">
                  <c:v>15.05</c:v>
                </c:pt>
                <c:pt idx="54">
                  <c:v>15.33</c:v>
                </c:pt>
                <c:pt idx="55">
                  <c:v>15.61</c:v>
                </c:pt>
                <c:pt idx="56">
                  <c:v>15.89</c:v>
                </c:pt>
                <c:pt idx="57">
                  <c:v>16.170000000000002</c:v>
                </c:pt>
                <c:pt idx="58">
                  <c:v>16.45</c:v>
                </c:pt>
                <c:pt idx="59">
                  <c:v>16.73</c:v>
                </c:pt>
                <c:pt idx="60">
                  <c:v>17.010000000000002</c:v>
                </c:pt>
                <c:pt idx="61">
                  <c:v>17.3</c:v>
                </c:pt>
                <c:pt idx="62">
                  <c:v>17.57</c:v>
                </c:pt>
                <c:pt idx="63">
                  <c:v>17.86</c:v>
                </c:pt>
                <c:pt idx="64">
                  <c:v>18.13</c:v>
                </c:pt>
                <c:pt idx="65">
                  <c:v>18.41</c:v>
                </c:pt>
                <c:pt idx="66">
                  <c:v>18.7</c:v>
                </c:pt>
                <c:pt idx="67">
                  <c:v>18.98</c:v>
                </c:pt>
                <c:pt idx="68">
                  <c:v>19.260000000000002</c:v>
                </c:pt>
                <c:pt idx="69">
                  <c:v>19.54</c:v>
                </c:pt>
                <c:pt idx="70">
                  <c:v>19.82</c:v>
                </c:pt>
                <c:pt idx="71">
                  <c:v>20.11</c:v>
                </c:pt>
                <c:pt idx="72">
                  <c:v>20.39</c:v>
                </c:pt>
                <c:pt idx="73">
                  <c:v>20.66</c:v>
                </c:pt>
                <c:pt idx="74">
                  <c:v>20.94</c:v>
                </c:pt>
                <c:pt idx="75">
                  <c:v>21.23</c:v>
                </c:pt>
                <c:pt idx="76">
                  <c:v>21.51</c:v>
                </c:pt>
                <c:pt idx="77">
                  <c:v>21.79</c:v>
                </c:pt>
                <c:pt idx="78">
                  <c:v>22.07</c:v>
                </c:pt>
                <c:pt idx="79">
                  <c:v>22.35</c:v>
                </c:pt>
                <c:pt idx="80">
                  <c:v>22.63</c:v>
                </c:pt>
                <c:pt idx="81">
                  <c:v>22.91</c:v>
                </c:pt>
                <c:pt idx="82">
                  <c:v>23.19</c:v>
                </c:pt>
                <c:pt idx="83">
                  <c:v>23.47</c:v>
                </c:pt>
                <c:pt idx="84">
                  <c:v>23.75</c:v>
                </c:pt>
                <c:pt idx="85">
                  <c:v>24.03</c:v>
                </c:pt>
                <c:pt idx="86">
                  <c:v>24.32</c:v>
                </c:pt>
                <c:pt idx="87">
                  <c:v>24.59</c:v>
                </c:pt>
                <c:pt idx="88">
                  <c:v>24.88</c:v>
                </c:pt>
                <c:pt idx="89">
                  <c:v>25.15</c:v>
                </c:pt>
                <c:pt idx="90">
                  <c:v>25.44</c:v>
                </c:pt>
                <c:pt idx="91">
                  <c:v>25.72</c:v>
                </c:pt>
                <c:pt idx="92">
                  <c:v>26</c:v>
                </c:pt>
                <c:pt idx="93">
                  <c:v>26.28</c:v>
                </c:pt>
                <c:pt idx="94">
                  <c:v>26.56</c:v>
                </c:pt>
                <c:pt idx="95">
                  <c:v>26.84</c:v>
                </c:pt>
                <c:pt idx="96">
                  <c:v>27.12</c:v>
                </c:pt>
                <c:pt idx="97">
                  <c:v>27.41</c:v>
                </c:pt>
                <c:pt idx="98">
                  <c:v>27.68</c:v>
                </c:pt>
                <c:pt idx="99">
                  <c:v>27.96</c:v>
                </c:pt>
                <c:pt idx="100">
                  <c:v>28.25</c:v>
                </c:pt>
                <c:pt idx="101">
                  <c:v>28.53</c:v>
                </c:pt>
                <c:pt idx="102">
                  <c:v>28.81</c:v>
                </c:pt>
                <c:pt idx="103">
                  <c:v>29.09</c:v>
                </c:pt>
                <c:pt idx="104">
                  <c:v>29.37</c:v>
                </c:pt>
                <c:pt idx="105">
                  <c:v>29.65</c:v>
                </c:pt>
                <c:pt idx="106">
                  <c:v>29.93</c:v>
                </c:pt>
                <c:pt idx="107">
                  <c:v>30.21</c:v>
                </c:pt>
                <c:pt idx="108">
                  <c:v>30.5</c:v>
                </c:pt>
                <c:pt idx="109">
                  <c:v>30.77</c:v>
                </c:pt>
                <c:pt idx="110">
                  <c:v>31.05</c:v>
                </c:pt>
                <c:pt idx="111">
                  <c:v>31.34</c:v>
                </c:pt>
                <c:pt idx="112">
                  <c:v>31.61</c:v>
                </c:pt>
                <c:pt idx="113">
                  <c:v>31.9</c:v>
                </c:pt>
                <c:pt idx="114">
                  <c:v>32.18</c:v>
                </c:pt>
                <c:pt idx="115">
                  <c:v>32.46</c:v>
                </c:pt>
                <c:pt idx="116">
                  <c:v>32.74</c:v>
                </c:pt>
                <c:pt idx="117">
                  <c:v>33.020000000000003</c:v>
                </c:pt>
                <c:pt idx="118">
                  <c:v>33.299999999999997</c:v>
                </c:pt>
                <c:pt idx="119">
                  <c:v>33.58</c:v>
                </c:pt>
                <c:pt idx="120">
                  <c:v>33.86</c:v>
                </c:pt>
                <c:pt idx="121">
                  <c:v>34.14</c:v>
                </c:pt>
                <c:pt idx="122">
                  <c:v>34.42</c:v>
                </c:pt>
                <c:pt idx="123">
                  <c:v>34.700000000000003</c:v>
                </c:pt>
                <c:pt idx="124">
                  <c:v>34.979999999999997</c:v>
                </c:pt>
                <c:pt idx="125">
                  <c:v>35.270000000000003</c:v>
                </c:pt>
                <c:pt idx="126">
                  <c:v>35.54</c:v>
                </c:pt>
                <c:pt idx="127">
                  <c:v>35.83</c:v>
                </c:pt>
                <c:pt idx="128">
                  <c:v>36.11</c:v>
                </c:pt>
                <c:pt idx="129">
                  <c:v>36.39</c:v>
                </c:pt>
                <c:pt idx="130">
                  <c:v>36.67</c:v>
                </c:pt>
                <c:pt idx="131">
                  <c:v>36.950000000000003</c:v>
                </c:pt>
                <c:pt idx="132">
                  <c:v>37.229999999999997</c:v>
                </c:pt>
                <c:pt idx="133">
                  <c:v>37.51</c:v>
                </c:pt>
                <c:pt idx="134">
                  <c:v>37.79</c:v>
                </c:pt>
                <c:pt idx="135">
                  <c:v>38.07</c:v>
                </c:pt>
                <c:pt idx="136">
                  <c:v>38.35</c:v>
                </c:pt>
                <c:pt idx="137">
                  <c:v>38.630000000000003</c:v>
                </c:pt>
                <c:pt idx="138">
                  <c:v>38.909999999999997</c:v>
                </c:pt>
                <c:pt idx="139">
                  <c:v>39.200000000000003</c:v>
                </c:pt>
                <c:pt idx="140">
                  <c:v>39.479999999999997</c:v>
                </c:pt>
                <c:pt idx="141">
                  <c:v>39.76</c:v>
                </c:pt>
                <c:pt idx="142">
                  <c:v>40.04</c:v>
                </c:pt>
                <c:pt idx="143">
                  <c:v>40.32</c:v>
                </c:pt>
                <c:pt idx="144">
                  <c:v>40.6</c:v>
                </c:pt>
                <c:pt idx="145">
                  <c:v>40.880000000000003</c:v>
                </c:pt>
                <c:pt idx="146">
                  <c:v>41.16</c:v>
                </c:pt>
                <c:pt idx="147">
                  <c:v>41.44</c:v>
                </c:pt>
                <c:pt idx="148">
                  <c:v>41.72</c:v>
                </c:pt>
                <c:pt idx="149">
                  <c:v>42.01</c:v>
                </c:pt>
                <c:pt idx="150">
                  <c:v>42.29</c:v>
                </c:pt>
                <c:pt idx="151">
                  <c:v>42.56</c:v>
                </c:pt>
                <c:pt idx="152">
                  <c:v>42.85</c:v>
                </c:pt>
                <c:pt idx="153">
                  <c:v>43.13</c:v>
                </c:pt>
                <c:pt idx="154">
                  <c:v>43.41</c:v>
                </c:pt>
                <c:pt idx="155">
                  <c:v>43.69</c:v>
                </c:pt>
                <c:pt idx="156">
                  <c:v>43.97</c:v>
                </c:pt>
                <c:pt idx="157">
                  <c:v>44.25</c:v>
                </c:pt>
                <c:pt idx="158">
                  <c:v>44.54</c:v>
                </c:pt>
                <c:pt idx="159">
                  <c:v>44.82</c:v>
                </c:pt>
                <c:pt idx="160">
                  <c:v>45.1</c:v>
                </c:pt>
                <c:pt idx="161">
                  <c:v>45.38</c:v>
                </c:pt>
                <c:pt idx="162">
                  <c:v>45.65</c:v>
                </c:pt>
                <c:pt idx="163">
                  <c:v>45.94</c:v>
                </c:pt>
                <c:pt idx="164">
                  <c:v>46.22</c:v>
                </c:pt>
                <c:pt idx="165">
                  <c:v>46.5</c:v>
                </c:pt>
                <c:pt idx="166">
                  <c:v>46.78</c:v>
                </c:pt>
                <c:pt idx="167">
                  <c:v>47.06</c:v>
                </c:pt>
                <c:pt idx="168">
                  <c:v>47.34</c:v>
                </c:pt>
                <c:pt idx="169">
                  <c:v>47.62</c:v>
                </c:pt>
                <c:pt idx="170">
                  <c:v>47.9</c:v>
                </c:pt>
                <c:pt idx="171">
                  <c:v>48.18</c:v>
                </c:pt>
                <c:pt idx="172">
                  <c:v>48.46</c:v>
                </c:pt>
                <c:pt idx="173">
                  <c:v>48.74</c:v>
                </c:pt>
                <c:pt idx="174">
                  <c:v>49.03</c:v>
                </c:pt>
                <c:pt idx="175">
                  <c:v>49.31</c:v>
                </c:pt>
                <c:pt idx="176">
                  <c:v>49.58</c:v>
                </c:pt>
                <c:pt idx="177">
                  <c:v>50.09</c:v>
                </c:pt>
                <c:pt idx="178">
                  <c:v>50.37</c:v>
                </c:pt>
                <c:pt idx="179">
                  <c:v>50.65</c:v>
                </c:pt>
                <c:pt idx="180">
                  <c:v>50.93</c:v>
                </c:pt>
                <c:pt idx="181">
                  <c:v>51.21</c:v>
                </c:pt>
                <c:pt idx="182">
                  <c:v>51.49</c:v>
                </c:pt>
                <c:pt idx="183">
                  <c:v>51.77</c:v>
                </c:pt>
                <c:pt idx="184">
                  <c:v>52.05</c:v>
                </c:pt>
                <c:pt idx="185">
                  <c:v>52.33</c:v>
                </c:pt>
                <c:pt idx="186">
                  <c:v>52.61</c:v>
                </c:pt>
                <c:pt idx="187">
                  <c:v>52.89</c:v>
                </c:pt>
                <c:pt idx="188">
                  <c:v>53.17</c:v>
                </c:pt>
                <c:pt idx="189">
                  <c:v>53.45</c:v>
                </c:pt>
                <c:pt idx="190">
                  <c:v>53.74</c:v>
                </c:pt>
                <c:pt idx="191">
                  <c:v>54.02</c:v>
                </c:pt>
                <c:pt idx="192">
                  <c:v>54.3</c:v>
                </c:pt>
                <c:pt idx="193">
                  <c:v>54.58</c:v>
                </c:pt>
                <c:pt idx="194">
                  <c:v>54.86</c:v>
                </c:pt>
                <c:pt idx="195">
                  <c:v>55.14</c:v>
                </c:pt>
                <c:pt idx="196">
                  <c:v>55.42</c:v>
                </c:pt>
                <c:pt idx="197">
                  <c:v>55.7</c:v>
                </c:pt>
                <c:pt idx="198">
                  <c:v>55.98</c:v>
                </c:pt>
                <c:pt idx="199">
                  <c:v>56.27</c:v>
                </c:pt>
                <c:pt idx="200">
                  <c:v>56.55</c:v>
                </c:pt>
                <c:pt idx="201">
                  <c:v>56.82</c:v>
                </c:pt>
                <c:pt idx="202">
                  <c:v>57.11</c:v>
                </c:pt>
                <c:pt idx="203">
                  <c:v>57.38</c:v>
                </c:pt>
                <c:pt idx="204">
                  <c:v>57.66</c:v>
                </c:pt>
                <c:pt idx="205">
                  <c:v>57.94</c:v>
                </c:pt>
                <c:pt idx="206">
                  <c:v>58.23</c:v>
                </c:pt>
                <c:pt idx="207">
                  <c:v>58.51</c:v>
                </c:pt>
                <c:pt idx="208">
                  <c:v>58.79</c:v>
                </c:pt>
                <c:pt idx="209">
                  <c:v>59.07</c:v>
                </c:pt>
                <c:pt idx="210">
                  <c:v>59.36</c:v>
                </c:pt>
                <c:pt idx="211">
                  <c:v>59.63</c:v>
                </c:pt>
                <c:pt idx="212">
                  <c:v>59.91</c:v>
                </c:pt>
                <c:pt idx="213">
                  <c:v>60.19</c:v>
                </c:pt>
                <c:pt idx="214">
                  <c:v>60.48</c:v>
                </c:pt>
                <c:pt idx="215">
                  <c:v>60.76</c:v>
                </c:pt>
                <c:pt idx="216">
                  <c:v>61.04</c:v>
                </c:pt>
                <c:pt idx="217">
                  <c:v>61.32</c:v>
                </c:pt>
                <c:pt idx="218">
                  <c:v>61.6</c:v>
                </c:pt>
                <c:pt idx="219">
                  <c:v>61.88</c:v>
                </c:pt>
                <c:pt idx="220">
                  <c:v>62.16</c:v>
                </c:pt>
                <c:pt idx="221">
                  <c:v>62.44</c:v>
                </c:pt>
                <c:pt idx="222">
                  <c:v>62.72</c:v>
                </c:pt>
                <c:pt idx="223">
                  <c:v>63</c:v>
                </c:pt>
                <c:pt idx="224">
                  <c:v>63.28</c:v>
                </c:pt>
                <c:pt idx="225">
                  <c:v>63.57</c:v>
                </c:pt>
                <c:pt idx="226">
                  <c:v>63.84</c:v>
                </c:pt>
                <c:pt idx="227">
                  <c:v>64.13</c:v>
                </c:pt>
                <c:pt idx="228">
                  <c:v>64.41</c:v>
                </c:pt>
                <c:pt idx="229">
                  <c:v>64.69</c:v>
                </c:pt>
                <c:pt idx="230">
                  <c:v>64.97</c:v>
                </c:pt>
                <c:pt idx="231">
                  <c:v>65.25</c:v>
                </c:pt>
                <c:pt idx="232">
                  <c:v>65.53</c:v>
                </c:pt>
                <c:pt idx="233">
                  <c:v>65.81</c:v>
                </c:pt>
                <c:pt idx="234">
                  <c:v>66.09</c:v>
                </c:pt>
                <c:pt idx="235">
                  <c:v>66.37</c:v>
                </c:pt>
                <c:pt idx="236">
                  <c:v>66.650000000000006</c:v>
                </c:pt>
                <c:pt idx="237">
                  <c:v>66.930000000000007</c:v>
                </c:pt>
                <c:pt idx="238">
                  <c:v>67.22</c:v>
                </c:pt>
                <c:pt idx="239">
                  <c:v>67.5</c:v>
                </c:pt>
                <c:pt idx="240">
                  <c:v>67.78</c:v>
                </c:pt>
                <c:pt idx="241">
                  <c:v>68.06</c:v>
                </c:pt>
                <c:pt idx="242">
                  <c:v>68.34</c:v>
                </c:pt>
                <c:pt idx="243">
                  <c:v>68.62</c:v>
                </c:pt>
                <c:pt idx="244">
                  <c:v>68.900000000000006</c:v>
                </c:pt>
                <c:pt idx="245">
                  <c:v>69.180000000000007</c:v>
                </c:pt>
                <c:pt idx="246">
                  <c:v>69.459999999999994</c:v>
                </c:pt>
                <c:pt idx="247">
                  <c:v>69.739999999999995</c:v>
                </c:pt>
                <c:pt idx="248">
                  <c:v>70.02</c:v>
                </c:pt>
                <c:pt idx="249">
                  <c:v>70.31</c:v>
                </c:pt>
                <c:pt idx="250">
                  <c:v>70.59</c:v>
                </c:pt>
                <c:pt idx="251">
                  <c:v>70.86</c:v>
                </c:pt>
                <c:pt idx="252">
                  <c:v>71.14</c:v>
                </c:pt>
                <c:pt idx="253">
                  <c:v>71.430000000000007</c:v>
                </c:pt>
                <c:pt idx="254">
                  <c:v>71.7</c:v>
                </c:pt>
                <c:pt idx="255">
                  <c:v>71.989999999999995</c:v>
                </c:pt>
                <c:pt idx="256">
                  <c:v>72.27</c:v>
                </c:pt>
                <c:pt idx="257">
                  <c:v>72.55</c:v>
                </c:pt>
                <c:pt idx="258">
                  <c:v>72.83</c:v>
                </c:pt>
                <c:pt idx="259">
                  <c:v>73.11</c:v>
                </c:pt>
                <c:pt idx="260">
                  <c:v>73.39</c:v>
                </c:pt>
                <c:pt idx="261">
                  <c:v>73.67</c:v>
                </c:pt>
                <c:pt idx="262">
                  <c:v>73.95</c:v>
                </c:pt>
                <c:pt idx="263">
                  <c:v>74.239999999999995</c:v>
                </c:pt>
                <c:pt idx="264">
                  <c:v>74.52</c:v>
                </c:pt>
                <c:pt idx="265">
                  <c:v>74.8</c:v>
                </c:pt>
                <c:pt idx="266">
                  <c:v>75.08</c:v>
                </c:pt>
                <c:pt idx="267">
                  <c:v>75.36</c:v>
                </c:pt>
                <c:pt idx="268">
                  <c:v>75.64</c:v>
                </c:pt>
                <c:pt idx="269">
                  <c:v>75.92</c:v>
                </c:pt>
                <c:pt idx="270">
                  <c:v>76.2</c:v>
                </c:pt>
                <c:pt idx="271">
                  <c:v>76.48</c:v>
                </c:pt>
                <c:pt idx="272">
                  <c:v>76.77</c:v>
                </c:pt>
                <c:pt idx="273">
                  <c:v>77.040000000000006</c:v>
                </c:pt>
                <c:pt idx="274">
                  <c:v>77.33</c:v>
                </c:pt>
                <c:pt idx="275">
                  <c:v>77.61</c:v>
                </c:pt>
                <c:pt idx="276">
                  <c:v>77.88</c:v>
                </c:pt>
                <c:pt idx="277">
                  <c:v>78.17</c:v>
                </c:pt>
                <c:pt idx="278">
                  <c:v>78.45</c:v>
                </c:pt>
                <c:pt idx="279">
                  <c:v>78.73</c:v>
                </c:pt>
                <c:pt idx="280">
                  <c:v>79.010000000000005</c:v>
                </c:pt>
                <c:pt idx="281">
                  <c:v>79.290000000000006</c:v>
                </c:pt>
                <c:pt idx="282">
                  <c:v>79.569999999999993</c:v>
                </c:pt>
                <c:pt idx="283">
                  <c:v>79.849999999999994</c:v>
                </c:pt>
                <c:pt idx="284">
                  <c:v>80.13</c:v>
                </c:pt>
                <c:pt idx="285">
                  <c:v>80.41</c:v>
                </c:pt>
                <c:pt idx="286">
                  <c:v>80.69</c:v>
                </c:pt>
                <c:pt idx="287">
                  <c:v>80.98</c:v>
                </c:pt>
                <c:pt idx="288">
                  <c:v>81.25</c:v>
                </c:pt>
                <c:pt idx="289">
                  <c:v>81.53</c:v>
                </c:pt>
                <c:pt idx="290">
                  <c:v>81.819999999999993</c:v>
                </c:pt>
                <c:pt idx="291">
                  <c:v>82.1</c:v>
                </c:pt>
                <c:pt idx="292">
                  <c:v>82.38</c:v>
                </c:pt>
                <c:pt idx="293">
                  <c:v>82.66</c:v>
                </c:pt>
                <c:pt idx="294">
                  <c:v>82.94</c:v>
                </c:pt>
                <c:pt idx="295">
                  <c:v>83.22</c:v>
                </c:pt>
                <c:pt idx="296">
                  <c:v>83.5</c:v>
                </c:pt>
                <c:pt idx="297">
                  <c:v>83.78</c:v>
                </c:pt>
                <c:pt idx="298">
                  <c:v>84.06</c:v>
                </c:pt>
                <c:pt idx="299">
                  <c:v>84.35</c:v>
                </c:pt>
                <c:pt idx="300">
                  <c:v>84.63</c:v>
                </c:pt>
                <c:pt idx="301">
                  <c:v>84.91</c:v>
                </c:pt>
                <c:pt idx="302">
                  <c:v>85.19</c:v>
                </c:pt>
                <c:pt idx="303">
                  <c:v>85.46</c:v>
                </c:pt>
                <c:pt idx="304">
                  <c:v>85.75</c:v>
                </c:pt>
                <c:pt idx="305">
                  <c:v>86.03</c:v>
                </c:pt>
                <c:pt idx="306">
                  <c:v>86.31</c:v>
                </c:pt>
                <c:pt idx="307">
                  <c:v>86.59</c:v>
                </c:pt>
                <c:pt idx="308">
                  <c:v>86.87</c:v>
                </c:pt>
                <c:pt idx="309">
                  <c:v>87.15</c:v>
                </c:pt>
                <c:pt idx="310">
                  <c:v>87.43</c:v>
                </c:pt>
                <c:pt idx="311">
                  <c:v>87.72</c:v>
                </c:pt>
                <c:pt idx="312">
                  <c:v>88</c:v>
                </c:pt>
                <c:pt idx="313">
                  <c:v>88.27</c:v>
                </c:pt>
                <c:pt idx="314">
                  <c:v>88.55</c:v>
                </c:pt>
                <c:pt idx="315">
                  <c:v>88.84</c:v>
                </c:pt>
                <c:pt idx="316">
                  <c:v>89.12</c:v>
                </c:pt>
                <c:pt idx="317">
                  <c:v>89.4</c:v>
                </c:pt>
                <c:pt idx="318">
                  <c:v>89.68</c:v>
                </c:pt>
                <c:pt idx="319">
                  <c:v>89.96</c:v>
                </c:pt>
                <c:pt idx="320">
                  <c:v>90.24</c:v>
                </c:pt>
                <c:pt idx="321">
                  <c:v>90.52</c:v>
                </c:pt>
                <c:pt idx="322">
                  <c:v>90.8</c:v>
                </c:pt>
                <c:pt idx="323">
                  <c:v>91.08</c:v>
                </c:pt>
                <c:pt idx="324">
                  <c:v>91.36</c:v>
                </c:pt>
                <c:pt idx="325">
                  <c:v>91.64</c:v>
                </c:pt>
                <c:pt idx="326">
                  <c:v>91.93</c:v>
                </c:pt>
                <c:pt idx="327">
                  <c:v>92.21</c:v>
                </c:pt>
                <c:pt idx="328">
                  <c:v>92.49</c:v>
                </c:pt>
                <c:pt idx="329">
                  <c:v>92.77</c:v>
                </c:pt>
                <c:pt idx="330">
                  <c:v>93.05</c:v>
                </c:pt>
                <c:pt idx="331">
                  <c:v>93.33</c:v>
                </c:pt>
                <c:pt idx="332">
                  <c:v>93.61</c:v>
                </c:pt>
                <c:pt idx="333">
                  <c:v>93.89</c:v>
                </c:pt>
                <c:pt idx="334">
                  <c:v>94.17</c:v>
                </c:pt>
                <c:pt idx="335">
                  <c:v>94.45</c:v>
                </c:pt>
                <c:pt idx="336">
                  <c:v>94.74</c:v>
                </c:pt>
                <c:pt idx="337">
                  <c:v>95.01</c:v>
                </c:pt>
                <c:pt idx="338">
                  <c:v>95.3</c:v>
                </c:pt>
                <c:pt idx="339">
                  <c:v>95.58</c:v>
                </c:pt>
                <c:pt idx="340">
                  <c:v>95.86</c:v>
                </c:pt>
                <c:pt idx="341">
                  <c:v>96.14</c:v>
                </c:pt>
                <c:pt idx="342">
                  <c:v>96.42</c:v>
                </c:pt>
                <c:pt idx="343">
                  <c:v>96.7</c:v>
                </c:pt>
                <c:pt idx="344">
                  <c:v>96.98</c:v>
                </c:pt>
                <c:pt idx="345">
                  <c:v>97.26</c:v>
                </c:pt>
                <c:pt idx="346">
                  <c:v>97.54</c:v>
                </c:pt>
                <c:pt idx="347">
                  <c:v>97.82</c:v>
                </c:pt>
                <c:pt idx="348">
                  <c:v>98.1</c:v>
                </c:pt>
                <c:pt idx="349">
                  <c:v>98.38</c:v>
                </c:pt>
                <c:pt idx="350">
                  <c:v>98.67</c:v>
                </c:pt>
                <c:pt idx="351">
                  <c:v>98.95</c:v>
                </c:pt>
                <c:pt idx="352">
                  <c:v>99.22</c:v>
                </c:pt>
                <c:pt idx="353">
                  <c:v>99.51</c:v>
                </c:pt>
                <c:pt idx="354">
                  <c:v>99.79</c:v>
                </c:pt>
                <c:pt idx="355">
                  <c:v>100.07</c:v>
                </c:pt>
                <c:pt idx="356">
                  <c:v>100.35</c:v>
                </c:pt>
                <c:pt idx="357">
                  <c:v>100.63</c:v>
                </c:pt>
                <c:pt idx="358">
                  <c:v>100.91</c:v>
                </c:pt>
                <c:pt idx="359">
                  <c:v>101.19</c:v>
                </c:pt>
                <c:pt idx="360">
                  <c:v>101.47</c:v>
                </c:pt>
                <c:pt idx="361">
                  <c:v>101.76</c:v>
                </c:pt>
                <c:pt idx="362">
                  <c:v>102.04</c:v>
                </c:pt>
                <c:pt idx="363">
                  <c:v>102.32</c:v>
                </c:pt>
                <c:pt idx="364">
                  <c:v>102.6</c:v>
                </c:pt>
                <c:pt idx="365">
                  <c:v>102.88</c:v>
                </c:pt>
                <c:pt idx="366">
                  <c:v>103.16</c:v>
                </c:pt>
                <c:pt idx="367">
                  <c:v>103.44</c:v>
                </c:pt>
                <c:pt idx="368">
                  <c:v>103.72</c:v>
                </c:pt>
                <c:pt idx="369">
                  <c:v>104</c:v>
                </c:pt>
                <c:pt idx="370">
                  <c:v>104.28</c:v>
                </c:pt>
                <c:pt idx="371">
                  <c:v>104.56</c:v>
                </c:pt>
                <c:pt idx="372">
                  <c:v>104.84</c:v>
                </c:pt>
                <c:pt idx="373">
                  <c:v>105.13</c:v>
                </c:pt>
                <c:pt idx="374">
                  <c:v>105.4</c:v>
                </c:pt>
                <c:pt idx="375">
                  <c:v>105.69</c:v>
                </c:pt>
                <c:pt idx="376">
                  <c:v>105.97</c:v>
                </c:pt>
                <c:pt idx="377">
                  <c:v>106.25</c:v>
                </c:pt>
                <c:pt idx="378">
                  <c:v>106.53</c:v>
                </c:pt>
                <c:pt idx="379">
                  <c:v>106.81</c:v>
                </c:pt>
                <c:pt idx="380">
                  <c:v>107.09</c:v>
                </c:pt>
                <c:pt idx="381">
                  <c:v>107.37</c:v>
                </c:pt>
                <c:pt idx="382">
                  <c:v>107.65</c:v>
                </c:pt>
                <c:pt idx="383">
                  <c:v>107.93</c:v>
                </c:pt>
                <c:pt idx="384">
                  <c:v>108.21</c:v>
                </c:pt>
                <c:pt idx="385">
                  <c:v>108.5</c:v>
                </c:pt>
                <c:pt idx="386">
                  <c:v>108.78</c:v>
                </c:pt>
                <c:pt idx="387">
                  <c:v>109.05</c:v>
                </c:pt>
                <c:pt idx="388">
                  <c:v>109.34</c:v>
                </c:pt>
                <c:pt idx="389">
                  <c:v>109.61</c:v>
                </c:pt>
                <c:pt idx="390">
                  <c:v>109.89</c:v>
                </c:pt>
                <c:pt idx="391">
                  <c:v>110.18</c:v>
                </c:pt>
                <c:pt idx="392">
                  <c:v>110.46</c:v>
                </c:pt>
                <c:pt idx="393">
                  <c:v>110.74</c:v>
                </c:pt>
                <c:pt idx="394">
                  <c:v>111.02</c:v>
                </c:pt>
                <c:pt idx="395">
                  <c:v>111.3</c:v>
                </c:pt>
                <c:pt idx="396">
                  <c:v>111.58</c:v>
                </c:pt>
                <c:pt idx="397">
                  <c:v>111.86</c:v>
                </c:pt>
                <c:pt idx="398">
                  <c:v>112.14</c:v>
                </c:pt>
                <c:pt idx="399">
                  <c:v>112.42</c:v>
                </c:pt>
                <c:pt idx="400">
                  <c:v>112.7</c:v>
                </c:pt>
                <c:pt idx="401">
                  <c:v>112.98</c:v>
                </c:pt>
                <c:pt idx="402">
                  <c:v>113.27</c:v>
                </c:pt>
                <c:pt idx="403">
                  <c:v>113.55</c:v>
                </c:pt>
                <c:pt idx="404">
                  <c:v>113.83</c:v>
                </c:pt>
                <c:pt idx="405">
                  <c:v>114.11</c:v>
                </c:pt>
                <c:pt idx="406">
                  <c:v>114.39</c:v>
                </c:pt>
                <c:pt idx="407">
                  <c:v>114.67</c:v>
                </c:pt>
                <c:pt idx="408">
                  <c:v>114.95</c:v>
                </c:pt>
                <c:pt idx="409">
                  <c:v>115.23</c:v>
                </c:pt>
                <c:pt idx="410">
                  <c:v>115.51</c:v>
                </c:pt>
                <c:pt idx="411">
                  <c:v>115.8</c:v>
                </c:pt>
                <c:pt idx="412">
                  <c:v>116.08</c:v>
                </c:pt>
                <c:pt idx="413">
                  <c:v>116.36</c:v>
                </c:pt>
                <c:pt idx="414">
                  <c:v>116.64</c:v>
                </c:pt>
                <c:pt idx="415">
                  <c:v>116.92</c:v>
                </c:pt>
                <c:pt idx="416">
                  <c:v>117.2</c:v>
                </c:pt>
                <c:pt idx="417">
                  <c:v>117.48</c:v>
                </c:pt>
                <c:pt idx="418">
                  <c:v>117.76</c:v>
                </c:pt>
                <c:pt idx="419">
                  <c:v>118.04</c:v>
                </c:pt>
                <c:pt idx="420">
                  <c:v>118.32</c:v>
                </c:pt>
                <c:pt idx="421">
                  <c:v>118.6</c:v>
                </c:pt>
                <c:pt idx="422">
                  <c:v>118.88</c:v>
                </c:pt>
                <c:pt idx="423">
                  <c:v>119.16</c:v>
                </c:pt>
                <c:pt idx="424">
                  <c:v>119.44</c:v>
                </c:pt>
                <c:pt idx="425">
                  <c:v>119.73</c:v>
                </c:pt>
                <c:pt idx="426">
                  <c:v>120.01</c:v>
                </c:pt>
                <c:pt idx="427">
                  <c:v>120.29</c:v>
                </c:pt>
                <c:pt idx="428">
                  <c:v>120.57</c:v>
                </c:pt>
                <c:pt idx="429">
                  <c:v>120.85</c:v>
                </c:pt>
                <c:pt idx="430">
                  <c:v>121.13</c:v>
                </c:pt>
                <c:pt idx="431">
                  <c:v>121.41</c:v>
                </c:pt>
                <c:pt idx="432">
                  <c:v>121.69</c:v>
                </c:pt>
                <c:pt idx="433">
                  <c:v>121.97</c:v>
                </c:pt>
                <c:pt idx="434">
                  <c:v>122.25</c:v>
                </c:pt>
                <c:pt idx="435">
                  <c:v>122.53</c:v>
                </c:pt>
                <c:pt idx="436">
                  <c:v>122.82</c:v>
                </c:pt>
                <c:pt idx="437">
                  <c:v>123.09</c:v>
                </c:pt>
                <c:pt idx="438">
                  <c:v>123.38</c:v>
                </c:pt>
                <c:pt idx="439">
                  <c:v>123.65</c:v>
                </c:pt>
                <c:pt idx="440">
                  <c:v>123.94</c:v>
                </c:pt>
                <c:pt idx="441">
                  <c:v>124.22</c:v>
                </c:pt>
                <c:pt idx="442">
                  <c:v>124.58</c:v>
                </c:pt>
                <c:pt idx="443">
                  <c:v>124.82</c:v>
                </c:pt>
                <c:pt idx="444">
                  <c:v>125.06</c:v>
                </c:pt>
                <c:pt idx="445">
                  <c:v>125.34</c:v>
                </c:pt>
                <c:pt idx="446">
                  <c:v>125.62</c:v>
                </c:pt>
                <c:pt idx="447">
                  <c:v>125.9</c:v>
                </c:pt>
                <c:pt idx="448">
                  <c:v>126.18</c:v>
                </c:pt>
                <c:pt idx="449">
                  <c:v>126.46</c:v>
                </c:pt>
                <c:pt idx="450">
                  <c:v>126.75</c:v>
                </c:pt>
                <c:pt idx="451">
                  <c:v>127.02</c:v>
                </c:pt>
                <c:pt idx="452">
                  <c:v>127.3</c:v>
                </c:pt>
                <c:pt idx="453">
                  <c:v>127.59</c:v>
                </c:pt>
                <c:pt idx="454">
                  <c:v>127.87</c:v>
                </c:pt>
                <c:pt idx="455">
                  <c:v>128.15</c:v>
                </c:pt>
                <c:pt idx="456">
                  <c:v>128.43</c:v>
                </c:pt>
                <c:pt idx="457">
                  <c:v>128.71</c:v>
                </c:pt>
                <c:pt idx="458">
                  <c:v>128.99</c:v>
                </c:pt>
                <c:pt idx="459">
                  <c:v>129.27000000000001</c:v>
                </c:pt>
                <c:pt idx="460">
                  <c:v>129.55000000000001</c:v>
                </c:pt>
                <c:pt idx="461">
                  <c:v>129.84</c:v>
                </c:pt>
                <c:pt idx="462">
                  <c:v>130.12</c:v>
                </c:pt>
                <c:pt idx="463">
                  <c:v>130.4</c:v>
                </c:pt>
                <c:pt idx="464">
                  <c:v>130.66999999999999</c:v>
                </c:pt>
                <c:pt idx="465">
                  <c:v>130.96</c:v>
                </c:pt>
                <c:pt idx="466">
                  <c:v>131.24</c:v>
                </c:pt>
                <c:pt idx="467">
                  <c:v>131.52000000000001</c:v>
                </c:pt>
                <c:pt idx="468">
                  <c:v>131.80000000000001</c:v>
                </c:pt>
                <c:pt idx="469">
                  <c:v>132.08000000000001</c:v>
                </c:pt>
                <c:pt idx="470">
                  <c:v>132.36000000000001</c:v>
                </c:pt>
                <c:pt idx="471">
                  <c:v>132.63999999999999</c:v>
                </c:pt>
                <c:pt idx="472">
                  <c:v>132.91999999999999</c:v>
                </c:pt>
                <c:pt idx="473">
                  <c:v>133.19999999999999</c:v>
                </c:pt>
                <c:pt idx="474">
                  <c:v>133.47999999999999</c:v>
                </c:pt>
                <c:pt idx="475">
                  <c:v>133.77000000000001</c:v>
                </c:pt>
                <c:pt idx="476">
                  <c:v>134.05000000000001</c:v>
                </c:pt>
                <c:pt idx="477">
                  <c:v>134.33000000000001</c:v>
                </c:pt>
                <c:pt idx="478">
                  <c:v>134.61000000000001</c:v>
                </c:pt>
                <c:pt idx="479">
                  <c:v>134.88999999999999</c:v>
                </c:pt>
                <c:pt idx="480">
                  <c:v>135.16999999999999</c:v>
                </c:pt>
                <c:pt idx="481">
                  <c:v>135.44999999999999</c:v>
                </c:pt>
                <c:pt idx="482">
                  <c:v>135.72999999999999</c:v>
                </c:pt>
                <c:pt idx="483">
                  <c:v>136.01</c:v>
                </c:pt>
                <c:pt idx="484">
                  <c:v>136.29</c:v>
                </c:pt>
                <c:pt idx="485">
                  <c:v>136.57</c:v>
                </c:pt>
                <c:pt idx="486">
                  <c:v>136.86000000000001</c:v>
                </c:pt>
                <c:pt idx="487">
                  <c:v>137.13999999999999</c:v>
                </c:pt>
                <c:pt idx="488">
                  <c:v>137.41999999999999</c:v>
                </c:pt>
                <c:pt idx="489">
                  <c:v>137.69999999999999</c:v>
                </c:pt>
                <c:pt idx="490">
                  <c:v>137.97999999999999</c:v>
                </c:pt>
                <c:pt idx="491">
                  <c:v>138.26</c:v>
                </c:pt>
                <c:pt idx="492">
                  <c:v>138.54</c:v>
                </c:pt>
                <c:pt idx="493">
                  <c:v>138.82</c:v>
                </c:pt>
                <c:pt idx="494">
                  <c:v>139.1</c:v>
                </c:pt>
                <c:pt idx="495">
                  <c:v>139.38</c:v>
                </c:pt>
                <c:pt idx="496">
                  <c:v>139.66</c:v>
                </c:pt>
                <c:pt idx="497">
                  <c:v>139.94</c:v>
                </c:pt>
                <c:pt idx="498">
                  <c:v>140.22</c:v>
                </c:pt>
                <c:pt idx="499">
                  <c:v>140.51</c:v>
                </c:pt>
                <c:pt idx="500">
                  <c:v>140.78</c:v>
                </c:pt>
                <c:pt idx="501">
                  <c:v>141.07</c:v>
                </c:pt>
                <c:pt idx="502">
                  <c:v>141.35</c:v>
                </c:pt>
                <c:pt idx="503">
                  <c:v>141.63</c:v>
                </c:pt>
                <c:pt idx="504">
                  <c:v>141.9</c:v>
                </c:pt>
                <c:pt idx="505">
                  <c:v>142.19</c:v>
                </c:pt>
                <c:pt idx="506">
                  <c:v>142.47</c:v>
                </c:pt>
                <c:pt idx="507">
                  <c:v>142.75</c:v>
                </c:pt>
                <c:pt idx="508">
                  <c:v>143.03</c:v>
                </c:pt>
                <c:pt idx="509">
                  <c:v>143.32</c:v>
                </c:pt>
                <c:pt idx="510">
                  <c:v>143.59</c:v>
                </c:pt>
                <c:pt idx="511">
                  <c:v>143.88</c:v>
                </c:pt>
                <c:pt idx="512">
                  <c:v>144.16</c:v>
                </c:pt>
                <c:pt idx="513">
                  <c:v>144.43</c:v>
                </c:pt>
                <c:pt idx="514">
                  <c:v>144.72</c:v>
                </c:pt>
                <c:pt idx="515">
                  <c:v>145</c:v>
                </c:pt>
                <c:pt idx="516">
                  <c:v>145.28</c:v>
                </c:pt>
                <c:pt idx="517">
                  <c:v>145.56</c:v>
                </c:pt>
                <c:pt idx="518">
                  <c:v>145.84</c:v>
                </c:pt>
                <c:pt idx="519">
                  <c:v>146.12</c:v>
                </c:pt>
                <c:pt idx="520">
                  <c:v>146.4</c:v>
                </c:pt>
                <c:pt idx="521">
                  <c:v>146.68</c:v>
                </c:pt>
                <c:pt idx="522">
                  <c:v>146.96</c:v>
                </c:pt>
                <c:pt idx="523">
                  <c:v>147.25</c:v>
                </c:pt>
                <c:pt idx="524">
                  <c:v>147.52000000000001</c:v>
                </c:pt>
                <c:pt idx="525">
                  <c:v>147.80000000000001</c:v>
                </c:pt>
                <c:pt idx="526">
                  <c:v>148.09</c:v>
                </c:pt>
                <c:pt idx="527">
                  <c:v>148.37</c:v>
                </c:pt>
                <c:pt idx="528">
                  <c:v>148.65</c:v>
                </c:pt>
                <c:pt idx="529">
                  <c:v>148.93</c:v>
                </c:pt>
                <c:pt idx="530">
                  <c:v>149.21</c:v>
                </c:pt>
                <c:pt idx="531">
                  <c:v>149.49</c:v>
                </c:pt>
                <c:pt idx="532">
                  <c:v>149.77000000000001</c:v>
                </c:pt>
                <c:pt idx="533">
                  <c:v>150.05000000000001</c:v>
                </c:pt>
                <c:pt idx="534">
                  <c:v>150.33000000000001</c:v>
                </c:pt>
                <c:pt idx="535">
                  <c:v>150.61000000000001</c:v>
                </c:pt>
                <c:pt idx="536">
                  <c:v>150.88999999999999</c:v>
                </c:pt>
                <c:pt idx="537">
                  <c:v>151.18</c:v>
                </c:pt>
                <c:pt idx="538">
                  <c:v>151.46</c:v>
                </c:pt>
                <c:pt idx="539">
                  <c:v>151.74</c:v>
                </c:pt>
                <c:pt idx="540">
                  <c:v>152.02000000000001</c:v>
                </c:pt>
                <c:pt idx="541">
                  <c:v>152.30000000000001</c:v>
                </c:pt>
                <c:pt idx="542">
                  <c:v>152.58000000000001</c:v>
                </c:pt>
                <c:pt idx="543">
                  <c:v>152.86000000000001</c:v>
                </c:pt>
                <c:pt idx="544">
                  <c:v>153.13999999999999</c:v>
                </c:pt>
                <c:pt idx="545">
                  <c:v>153.41999999999999</c:v>
                </c:pt>
                <c:pt idx="546">
                  <c:v>153.69999999999999</c:v>
                </c:pt>
                <c:pt idx="547">
                  <c:v>153.97999999999999</c:v>
                </c:pt>
                <c:pt idx="548">
                  <c:v>154.26</c:v>
                </c:pt>
                <c:pt idx="549">
                  <c:v>154.55000000000001</c:v>
                </c:pt>
                <c:pt idx="550">
                  <c:v>154.82</c:v>
                </c:pt>
                <c:pt idx="551">
                  <c:v>155.11000000000001</c:v>
                </c:pt>
                <c:pt idx="552">
                  <c:v>155.38999999999999</c:v>
                </c:pt>
                <c:pt idx="553">
                  <c:v>155.66999999999999</c:v>
                </c:pt>
                <c:pt idx="554">
                  <c:v>155.94999999999999</c:v>
                </c:pt>
                <c:pt idx="555">
                  <c:v>156.22999999999999</c:v>
                </c:pt>
                <c:pt idx="556">
                  <c:v>156.51</c:v>
                </c:pt>
                <c:pt idx="557">
                  <c:v>156.79</c:v>
                </c:pt>
                <c:pt idx="558">
                  <c:v>157.07</c:v>
                </c:pt>
                <c:pt idx="559">
                  <c:v>157.36000000000001</c:v>
                </c:pt>
                <c:pt idx="560">
                  <c:v>157.63</c:v>
                </c:pt>
                <c:pt idx="561">
                  <c:v>157.91</c:v>
                </c:pt>
                <c:pt idx="562">
                  <c:v>158.19</c:v>
                </c:pt>
                <c:pt idx="563">
                  <c:v>158.47999999999999</c:v>
                </c:pt>
                <c:pt idx="564">
                  <c:v>158.76</c:v>
                </c:pt>
                <c:pt idx="565">
                  <c:v>159.04</c:v>
                </c:pt>
                <c:pt idx="566">
                  <c:v>159.32</c:v>
                </c:pt>
                <c:pt idx="567">
                  <c:v>159.6</c:v>
                </c:pt>
                <c:pt idx="568">
                  <c:v>159.88</c:v>
                </c:pt>
                <c:pt idx="569">
                  <c:v>160.16</c:v>
                </c:pt>
                <c:pt idx="570">
                  <c:v>160.44</c:v>
                </c:pt>
                <c:pt idx="571">
                  <c:v>160.72</c:v>
                </c:pt>
                <c:pt idx="572">
                  <c:v>161</c:v>
                </c:pt>
                <c:pt idx="573">
                  <c:v>161.28</c:v>
                </c:pt>
                <c:pt idx="574">
                  <c:v>161.56</c:v>
                </c:pt>
                <c:pt idx="575">
                  <c:v>161.85</c:v>
                </c:pt>
                <c:pt idx="576">
                  <c:v>162.13</c:v>
                </c:pt>
                <c:pt idx="577">
                  <c:v>162.4</c:v>
                </c:pt>
                <c:pt idx="578">
                  <c:v>162.69</c:v>
                </c:pt>
                <c:pt idx="579">
                  <c:v>162.97</c:v>
                </c:pt>
                <c:pt idx="580">
                  <c:v>163.25</c:v>
                </c:pt>
                <c:pt idx="581">
                  <c:v>163.53</c:v>
                </c:pt>
                <c:pt idx="582">
                  <c:v>163.81</c:v>
                </c:pt>
                <c:pt idx="583">
                  <c:v>164.09</c:v>
                </c:pt>
                <c:pt idx="584">
                  <c:v>164.37</c:v>
                </c:pt>
                <c:pt idx="585">
                  <c:v>164.65</c:v>
                </c:pt>
                <c:pt idx="586">
                  <c:v>164.93</c:v>
                </c:pt>
                <c:pt idx="587">
                  <c:v>165.22</c:v>
                </c:pt>
                <c:pt idx="588">
                  <c:v>165.49</c:v>
                </c:pt>
                <c:pt idx="589">
                  <c:v>165.78</c:v>
                </c:pt>
                <c:pt idx="590">
                  <c:v>166.06</c:v>
                </c:pt>
                <c:pt idx="591">
                  <c:v>166.34</c:v>
                </c:pt>
                <c:pt idx="592">
                  <c:v>166.62</c:v>
                </c:pt>
                <c:pt idx="593">
                  <c:v>166.9</c:v>
                </c:pt>
                <c:pt idx="594">
                  <c:v>167.18</c:v>
                </c:pt>
                <c:pt idx="595">
                  <c:v>167.46</c:v>
                </c:pt>
                <c:pt idx="596">
                  <c:v>167.74</c:v>
                </c:pt>
                <c:pt idx="597">
                  <c:v>168.02</c:v>
                </c:pt>
                <c:pt idx="598">
                  <c:v>168.31</c:v>
                </c:pt>
                <c:pt idx="599">
                  <c:v>168.58</c:v>
                </c:pt>
                <c:pt idx="600">
                  <c:v>168.87</c:v>
                </c:pt>
                <c:pt idx="601">
                  <c:v>169.14</c:v>
                </c:pt>
                <c:pt idx="602">
                  <c:v>169.42</c:v>
                </c:pt>
                <c:pt idx="603">
                  <c:v>169.7</c:v>
                </c:pt>
                <c:pt idx="604">
                  <c:v>169.99</c:v>
                </c:pt>
                <c:pt idx="605">
                  <c:v>170.27</c:v>
                </c:pt>
                <c:pt idx="606">
                  <c:v>170.55</c:v>
                </c:pt>
                <c:pt idx="607">
                  <c:v>170.83</c:v>
                </c:pt>
                <c:pt idx="608">
                  <c:v>171.11</c:v>
                </c:pt>
                <c:pt idx="609">
                  <c:v>171.39</c:v>
                </c:pt>
                <c:pt idx="610">
                  <c:v>171.67</c:v>
                </c:pt>
                <c:pt idx="611">
                  <c:v>171.95</c:v>
                </c:pt>
                <c:pt idx="612">
                  <c:v>172.24</c:v>
                </c:pt>
                <c:pt idx="613">
                  <c:v>172.52</c:v>
                </c:pt>
                <c:pt idx="614">
                  <c:v>172.79</c:v>
                </c:pt>
                <c:pt idx="615">
                  <c:v>173.08</c:v>
                </c:pt>
                <c:pt idx="616">
                  <c:v>173.36</c:v>
                </c:pt>
                <c:pt idx="617">
                  <c:v>173.64</c:v>
                </c:pt>
                <c:pt idx="618">
                  <c:v>173.92</c:v>
                </c:pt>
                <c:pt idx="619">
                  <c:v>174.2</c:v>
                </c:pt>
                <c:pt idx="620">
                  <c:v>174.48</c:v>
                </c:pt>
                <c:pt idx="621">
                  <c:v>174.76</c:v>
                </c:pt>
                <c:pt idx="622">
                  <c:v>175.04</c:v>
                </c:pt>
                <c:pt idx="623">
                  <c:v>175.32</c:v>
                </c:pt>
                <c:pt idx="624">
                  <c:v>175.6</c:v>
                </c:pt>
                <c:pt idx="625">
                  <c:v>175.89</c:v>
                </c:pt>
                <c:pt idx="626">
                  <c:v>176.16</c:v>
                </c:pt>
                <c:pt idx="627">
                  <c:v>176.45</c:v>
                </c:pt>
                <c:pt idx="628">
                  <c:v>176.72</c:v>
                </c:pt>
                <c:pt idx="629">
                  <c:v>177.01</c:v>
                </c:pt>
                <c:pt idx="630">
                  <c:v>177.29</c:v>
                </c:pt>
                <c:pt idx="631">
                  <c:v>177.57</c:v>
                </c:pt>
                <c:pt idx="632">
                  <c:v>177.85</c:v>
                </c:pt>
                <c:pt idx="633">
                  <c:v>178.13</c:v>
                </c:pt>
                <c:pt idx="634">
                  <c:v>178.41</c:v>
                </c:pt>
                <c:pt idx="635">
                  <c:v>178.69</c:v>
                </c:pt>
                <c:pt idx="636">
                  <c:v>178.97</c:v>
                </c:pt>
                <c:pt idx="637">
                  <c:v>179.25</c:v>
                </c:pt>
                <c:pt idx="638">
                  <c:v>179.54</c:v>
                </c:pt>
                <c:pt idx="639">
                  <c:v>179.81</c:v>
                </c:pt>
                <c:pt idx="640">
                  <c:v>180.1</c:v>
                </c:pt>
                <c:pt idx="641">
                  <c:v>180.38</c:v>
                </c:pt>
                <c:pt idx="642">
                  <c:v>180.66</c:v>
                </c:pt>
                <c:pt idx="643">
                  <c:v>180.94</c:v>
                </c:pt>
                <c:pt idx="644">
                  <c:v>181.22</c:v>
                </c:pt>
                <c:pt idx="645">
                  <c:v>181.5</c:v>
                </c:pt>
                <c:pt idx="646">
                  <c:v>181.78</c:v>
                </c:pt>
                <c:pt idx="647">
                  <c:v>182.06</c:v>
                </c:pt>
                <c:pt idx="648">
                  <c:v>182.35</c:v>
                </c:pt>
                <c:pt idx="649">
                  <c:v>182.63</c:v>
                </c:pt>
                <c:pt idx="650">
                  <c:v>182.9</c:v>
                </c:pt>
                <c:pt idx="651">
                  <c:v>183.19</c:v>
                </c:pt>
                <c:pt idx="652">
                  <c:v>183.47</c:v>
                </c:pt>
                <c:pt idx="653">
                  <c:v>183.75</c:v>
                </c:pt>
                <c:pt idx="654">
                  <c:v>184.03</c:v>
                </c:pt>
                <c:pt idx="655">
                  <c:v>184.31</c:v>
                </c:pt>
                <c:pt idx="656">
                  <c:v>184.59</c:v>
                </c:pt>
                <c:pt idx="657">
                  <c:v>184.87</c:v>
                </c:pt>
                <c:pt idx="658">
                  <c:v>185.15</c:v>
                </c:pt>
                <c:pt idx="659">
                  <c:v>185.43</c:v>
                </c:pt>
                <c:pt idx="660">
                  <c:v>185.71</c:v>
                </c:pt>
                <c:pt idx="661">
                  <c:v>185.99</c:v>
                </c:pt>
                <c:pt idx="662">
                  <c:v>186.27</c:v>
                </c:pt>
                <c:pt idx="663">
                  <c:v>186.56</c:v>
                </c:pt>
                <c:pt idx="664">
                  <c:v>186.97</c:v>
                </c:pt>
                <c:pt idx="665">
                  <c:v>187.2</c:v>
                </c:pt>
                <c:pt idx="666">
                  <c:v>187.43</c:v>
                </c:pt>
                <c:pt idx="667">
                  <c:v>187.68</c:v>
                </c:pt>
                <c:pt idx="668">
                  <c:v>187.96</c:v>
                </c:pt>
                <c:pt idx="669">
                  <c:v>188.24</c:v>
                </c:pt>
                <c:pt idx="670">
                  <c:v>188.52</c:v>
                </c:pt>
                <c:pt idx="671">
                  <c:v>188.8</c:v>
                </c:pt>
                <c:pt idx="672">
                  <c:v>189.08</c:v>
                </c:pt>
                <c:pt idx="673">
                  <c:v>189.37</c:v>
                </c:pt>
                <c:pt idx="674">
                  <c:v>189.65</c:v>
                </c:pt>
                <c:pt idx="675">
                  <c:v>189.92</c:v>
                </c:pt>
                <c:pt idx="676">
                  <c:v>190.2</c:v>
                </c:pt>
                <c:pt idx="677">
                  <c:v>190.49</c:v>
                </c:pt>
                <c:pt idx="678">
                  <c:v>190.77</c:v>
                </c:pt>
                <c:pt idx="679">
                  <c:v>191.05</c:v>
                </c:pt>
                <c:pt idx="680">
                  <c:v>191.33</c:v>
                </c:pt>
                <c:pt idx="681">
                  <c:v>191.61</c:v>
                </c:pt>
                <c:pt idx="682">
                  <c:v>191.89</c:v>
                </c:pt>
                <c:pt idx="683">
                  <c:v>192.17</c:v>
                </c:pt>
                <c:pt idx="684">
                  <c:v>192.45</c:v>
                </c:pt>
                <c:pt idx="685">
                  <c:v>192.73</c:v>
                </c:pt>
                <c:pt idx="686">
                  <c:v>193.01</c:v>
                </c:pt>
                <c:pt idx="687">
                  <c:v>193.29</c:v>
                </c:pt>
                <c:pt idx="688">
                  <c:v>193.57</c:v>
                </c:pt>
                <c:pt idx="689">
                  <c:v>193.85</c:v>
                </c:pt>
                <c:pt idx="690">
                  <c:v>194.14</c:v>
                </c:pt>
                <c:pt idx="691">
                  <c:v>194.42</c:v>
                </c:pt>
                <c:pt idx="692">
                  <c:v>194.7</c:v>
                </c:pt>
                <c:pt idx="693">
                  <c:v>194.98</c:v>
                </c:pt>
                <c:pt idx="694">
                  <c:v>195.26</c:v>
                </c:pt>
                <c:pt idx="695">
                  <c:v>195.54</c:v>
                </c:pt>
                <c:pt idx="696">
                  <c:v>195.82</c:v>
                </c:pt>
                <c:pt idx="697">
                  <c:v>196.1</c:v>
                </c:pt>
                <c:pt idx="698">
                  <c:v>196.39</c:v>
                </c:pt>
                <c:pt idx="699">
                  <c:v>196.66</c:v>
                </c:pt>
                <c:pt idx="700">
                  <c:v>196.94</c:v>
                </c:pt>
                <c:pt idx="701">
                  <c:v>197.23</c:v>
                </c:pt>
                <c:pt idx="702">
                  <c:v>197.51</c:v>
                </c:pt>
                <c:pt idx="703">
                  <c:v>197.79</c:v>
                </c:pt>
                <c:pt idx="704">
                  <c:v>198.07</c:v>
                </c:pt>
                <c:pt idx="705">
                  <c:v>198.35</c:v>
                </c:pt>
                <c:pt idx="706">
                  <c:v>198.63</c:v>
                </c:pt>
                <c:pt idx="707">
                  <c:v>198.91</c:v>
                </c:pt>
                <c:pt idx="708">
                  <c:v>199.19</c:v>
                </c:pt>
                <c:pt idx="709">
                  <c:v>199.47</c:v>
                </c:pt>
                <c:pt idx="710">
                  <c:v>199.76</c:v>
                </c:pt>
                <c:pt idx="711">
                  <c:v>200.04</c:v>
                </c:pt>
                <c:pt idx="712">
                  <c:v>200.31</c:v>
                </c:pt>
                <c:pt idx="713">
                  <c:v>200.59</c:v>
                </c:pt>
                <c:pt idx="714">
                  <c:v>200.88</c:v>
                </c:pt>
                <c:pt idx="715">
                  <c:v>201.16</c:v>
                </c:pt>
                <c:pt idx="716">
                  <c:v>201.44</c:v>
                </c:pt>
                <c:pt idx="717">
                  <c:v>201.72</c:v>
                </c:pt>
                <c:pt idx="718">
                  <c:v>202</c:v>
                </c:pt>
                <c:pt idx="719">
                  <c:v>202.28</c:v>
                </c:pt>
                <c:pt idx="720">
                  <c:v>202.56</c:v>
                </c:pt>
                <c:pt idx="721">
                  <c:v>202.84</c:v>
                </c:pt>
                <c:pt idx="722">
                  <c:v>203.12</c:v>
                </c:pt>
                <c:pt idx="723">
                  <c:v>203.4</c:v>
                </c:pt>
                <c:pt idx="724">
                  <c:v>203.68</c:v>
                </c:pt>
                <c:pt idx="725">
                  <c:v>203.96</c:v>
                </c:pt>
                <c:pt idx="726">
                  <c:v>204.25</c:v>
                </c:pt>
                <c:pt idx="727">
                  <c:v>204.53</c:v>
                </c:pt>
                <c:pt idx="728">
                  <c:v>204.81</c:v>
                </c:pt>
                <c:pt idx="729">
                  <c:v>205.09</c:v>
                </c:pt>
                <c:pt idx="730">
                  <c:v>205.37</c:v>
                </c:pt>
                <c:pt idx="731">
                  <c:v>205.65</c:v>
                </c:pt>
                <c:pt idx="732">
                  <c:v>205.93</c:v>
                </c:pt>
                <c:pt idx="733">
                  <c:v>206.21</c:v>
                </c:pt>
                <c:pt idx="734">
                  <c:v>206.49</c:v>
                </c:pt>
                <c:pt idx="735">
                  <c:v>206.77</c:v>
                </c:pt>
                <c:pt idx="736">
                  <c:v>207.06</c:v>
                </c:pt>
                <c:pt idx="737">
                  <c:v>207.33</c:v>
                </c:pt>
                <c:pt idx="738">
                  <c:v>207.62</c:v>
                </c:pt>
                <c:pt idx="739">
                  <c:v>207.89</c:v>
                </c:pt>
                <c:pt idx="740">
                  <c:v>208.18</c:v>
                </c:pt>
                <c:pt idx="741">
                  <c:v>208.46</c:v>
                </c:pt>
                <c:pt idx="742">
                  <c:v>208.74</c:v>
                </c:pt>
                <c:pt idx="743">
                  <c:v>209.02</c:v>
                </c:pt>
                <c:pt idx="744">
                  <c:v>209.3</c:v>
                </c:pt>
                <c:pt idx="745">
                  <c:v>209.58</c:v>
                </c:pt>
                <c:pt idx="746">
                  <c:v>209.86</c:v>
                </c:pt>
                <c:pt idx="747">
                  <c:v>210.14</c:v>
                </c:pt>
                <c:pt idx="748">
                  <c:v>210.42</c:v>
                </c:pt>
                <c:pt idx="749">
                  <c:v>210.7</c:v>
                </c:pt>
                <c:pt idx="750">
                  <c:v>210.98</c:v>
                </c:pt>
                <c:pt idx="751">
                  <c:v>211.27</c:v>
                </c:pt>
                <c:pt idx="752">
                  <c:v>211.55</c:v>
                </c:pt>
                <c:pt idx="753">
                  <c:v>211.83</c:v>
                </c:pt>
                <c:pt idx="754">
                  <c:v>212.11</c:v>
                </c:pt>
                <c:pt idx="755">
                  <c:v>212.39</c:v>
                </c:pt>
                <c:pt idx="756">
                  <c:v>212.67</c:v>
                </c:pt>
                <c:pt idx="757">
                  <c:v>212.95</c:v>
                </c:pt>
                <c:pt idx="758">
                  <c:v>213.23</c:v>
                </c:pt>
                <c:pt idx="759">
                  <c:v>213.51</c:v>
                </c:pt>
                <c:pt idx="760">
                  <c:v>213.79</c:v>
                </c:pt>
                <c:pt idx="761">
                  <c:v>214.08</c:v>
                </c:pt>
                <c:pt idx="762">
                  <c:v>214.35</c:v>
                </c:pt>
                <c:pt idx="763">
                  <c:v>214.63</c:v>
                </c:pt>
                <c:pt idx="764">
                  <c:v>214.91</c:v>
                </c:pt>
                <c:pt idx="765">
                  <c:v>215.2</c:v>
                </c:pt>
                <c:pt idx="766">
                  <c:v>215.48</c:v>
                </c:pt>
                <c:pt idx="767">
                  <c:v>215.76</c:v>
                </c:pt>
                <c:pt idx="768">
                  <c:v>216.04</c:v>
                </c:pt>
                <c:pt idx="769">
                  <c:v>216.32</c:v>
                </c:pt>
                <c:pt idx="770">
                  <c:v>216.6</c:v>
                </c:pt>
                <c:pt idx="771">
                  <c:v>216.88</c:v>
                </c:pt>
                <c:pt idx="772">
                  <c:v>217.16</c:v>
                </c:pt>
                <c:pt idx="773">
                  <c:v>217.44</c:v>
                </c:pt>
                <c:pt idx="774">
                  <c:v>217.72</c:v>
                </c:pt>
                <c:pt idx="775">
                  <c:v>218</c:v>
                </c:pt>
                <c:pt idx="776">
                  <c:v>218.29</c:v>
                </c:pt>
                <c:pt idx="777">
                  <c:v>218.57</c:v>
                </c:pt>
                <c:pt idx="778">
                  <c:v>218.85</c:v>
                </c:pt>
                <c:pt idx="779">
                  <c:v>219.13</c:v>
                </c:pt>
                <c:pt idx="780">
                  <c:v>219.41</c:v>
                </c:pt>
                <c:pt idx="781">
                  <c:v>219.69</c:v>
                </c:pt>
                <c:pt idx="782">
                  <c:v>219.97</c:v>
                </c:pt>
                <c:pt idx="783">
                  <c:v>220.25</c:v>
                </c:pt>
                <c:pt idx="784">
                  <c:v>220.53</c:v>
                </c:pt>
                <c:pt idx="785">
                  <c:v>220.81</c:v>
                </c:pt>
                <c:pt idx="786">
                  <c:v>221.09</c:v>
                </c:pt>
                <c:pt idx="787">
                  <c:v>221.38</c:v>
                </c:pt>
                <c:pt idx="788">
                  <c:v>221.65</c:v>
                </c:pt>
                <c:pt idx="789">
                  <c:v>221.93</c:v>
                </c:pt>
                <c:pt idx="790">
                  <c:v>222.21</c:v>
                </c:pt>
                <c:pt idx="791">
                  <c:v>222.5</c:v>
                </c:pt>
                <c:pt idx="792">
                  <c:v>222.78</c:v>
                </c:pt>
                <c:pt idx="793">
                  <c:v>223.06</c:v>
                </c:pt>
                <c:pt idx="794">
                  <c:v>223.34</c:v>
                </c:pt>
                <c:pt idx="795">
                  <c:v>223.62</c:v>
                </c:pt>
                <c:pt idx="796">
                  <c:v>223.9</c:v>
                </c:pt>
                <c:pt idx="797">
                  <c:v>224.18</c:v>
                </c:pt>
                <c:pt idx="798">
                  <c:v>224.47</c:v>
                </c:pt>
                <c:pt idx="799">
                  <c:v>224.75</c:v>
                </c:pt>
                <c:pt idx="800">
                  <c:v>225.02</c:v>
                </c:pt>
                <c:pt idx="801">
                  <c:v>225.31</c:v>
                </c:pt>
                <c:pt idx="802">
                  <c:v>225.59</c:v>
                </c:pt>
                <c:pt idx="803">
                  <c:v>225.87</c:v>
                </c:pt>
                <c:pt idx="804">
                  <c:v>226.15</c:v>
                </c:pt>
                <c:pt idx="805">
                  <c:v>226.43</c:v>
                </c:pt>
                <c:pt idx="806">
                  <c:v>226.71</c:v>
                </c:pt>
                <c:pt idx="807">
                  <c:v>226.99</c:v>
                </c:pt>
                <c:pt idx="808">
                  <c:v>227.27</c:v>
                </c:pt>
                <c:pt idx="809">
                  <c:v>227.55</c:v>
                </c:pt>
                <c:pt idx="810">
                  <c:v>227.83</c:v>
                </c:pt>
                <c:pt idx="811">
                  <c:v>228.11</c:v>
                </c:pt>
                <c:pt idx="812">
                  <c:v>228.39</c:v>
                </c:pt>
                <c:pt idx="813">
                  <c:v>228.67</c:v>
                </c:pt>
                <c:pt idx="814">
                  <c:v>228.96</c:v>
                </c:pt>
                <c:pt idx="815">
                  <c:v>229.24</c:v>
                </c:pt>
                <c:pt idx="816">
                  <c:v>229.52</c:v>
                </c:pt>
                <c:pt idx="817">
                  <c:v>229.8</c:v>
                </c:pt>
                <c:pt idx="818">
                  <c:v>230.08</c:v>
                </c:pt>
                <c:pt idx="819">
                  <c:v>230.36</c:v>
                </c:pt>
                <c:pt idx="820">
                  <c:v>230.64</c:v>
                </c:pt>
                <c:pt idx="821">
                  <c:v>230.92</c:v>
                </c:pt>
                <c:pt idx="822">
                  <c:v>231.2</c:v>
                </c:pt>
                <c:pt idx="823">
                  <c:v>231.48</c:v>
                </c:pt>
                <c:pt idx="824">
                  <c:v>231.76</c:v>
                </c:pt>
                <c:pt idx="825">
                  <c:v>232.05</c:v>
                </c:pt>
                <c:pt idx="826">
                  <c:v>232.33</c:v>
                </c:pt>
                <c:pt idx="827">
                  <c:v>232.61</c:v>
                </c:pt>
                <c:pt idx="828">
                  <c:v>232.89</c:v>
                </c:pt>
                <c:pt idx="829">
                  <c:v>233.17</c:v>
                </c:pt>
                <c:pt idx="830">
                  <c:v>233.45</c:v>
                </c:pt>
                <c:pt idx="831">
                  <c:v>233.73</c:v>
                </c:pt>
                <c:pt idx="832">
                  <c:v>234.01</c:v>
                </c:pt>
                <c:pt idx="833">
                  <c:v>234.29</c:v>
                </c:pt>
                <c:pt idx="834">
                  <c:v>234.57</c:v>
                </c:pt>
                <c:pt idx="835">
                  <c:v>234.85</c:v>
                </c:pt>
                <c:pt idx="836">
                  <c:v>235.13</c:v>
                </c:pt>
                <c:pt idx="837">
                  <c:v>235.42</c:v>
                </c:pt>
                <c:pt idx="838">
                  <c:v>235.7</c:v>
                </c:pt>
                <c:pt idx="839">
                  <c:v>235.98</c:v>
                </c:pt>
                <c:pt idx="840">
                  <c:v>236.26</c:v>
                </c:pt>
                <c:pt idx="841">
                  <c:v>236.54</c:v>
                </c:pt>
                <c:pt idx="842">
                  <c:v>236.82</c:v>
                </c:pt>
                <c:pt idx="843">
                  <c:v>237.1</c:v>
                </c:pt>
                <c:pt idx="844">
                  <c:v>237.38</c:v>
                </c:pt>
                <c:pt idx="845">
                  <c:v>237.66</c:v>
                </c:pt>
                <c:pt idx="846">
                  <c:v>237.94</c:v>
                </c:pt>
                <c:pt idx="847">
                  <c:v>238.22</c:v>
                </c:pt>
                <c:pt idx="848">
                  <c:v>238.5</c:v>
                </c:pt>
                <c:pt idx="849">
                  <c:v>238.78</c:v>
                </c:pt>
                <c:pt idx="850">
                  <c:v>239.06</c:v>
                </c:pt>
                <c:pt idx="851">
                  <c:v>239.35</c:v>
                </c:pt>
                <c:pt idx="852">
                  <c:v>239.63</c:v>
                </c:pt>
                <c:pt idx="853">
                  <c:v>239.91</c:v>
                </c:pt>
                <c:pt idx="854">
                  <c:v>240.19</c:v>
                </c:pt>
                <c:pt idx="855">
                  <c:v>240.47</c:v>
                </c:pt>
                <c:pt idx="856">
                  <c:v>240.75</c:v>
                </c:pt>
                <c:pt idx="857">
                  <c:v>241.03</c:v>
                </c:pt>
                <c:pt idx="858">
                  <c:v>241.31</c:v>
                </c:pt>
                <c:pt idx="859">
                  <c:v>241.59</c:v>
                </c:pt>
                <c:pt idx="860">
                  <c:v>241.87</c:v>
                </c:pt>
                <c:pt idx="861">
                  <c:v>242.15</c:v>
                </c:pt>
                <c:pt idx="862">
                  <c:v>242.44</c:v>
                </c:pt>
                <c:pt idx="863">
                  <c:v>242.71</c:v>
                </c:pt>
                <c:pt idx="864">
                  <c:v>243</c:v>
                </c:pt>
                <c:pt idx="865">
                  <c:v>243.28</c:v>
                </c:pt>
                <c:pt idx="866">
                  <c:v>243.56</c:v>
                </c:pt>
                <c:pt idx="867">
                  <c:v>243.84</c:v>
                </c:pt>
                <c:pt idx="868">
                  <c:v>244.12</c:v>
                </c:pt>
                <c:pt idx="869">
                  <c:v>244.4</c:v>
                </c:pt>
                <c:pt idx="870">
                  <c:v>244.68</c:v>
                </c:pt>
                <c:pt idx="871">
                  <c:v>244.96</c:v>
                </c:pt>
                <c:pt idx="872">
                  <c:v>245.24</c:v>
                </c:pt>
                <c:pt idx="873">
                  <c:v>245.52</c:v>
                </c:pt>
                <c:pt idx="874">
                  <c:v>245.81</c:v>
                </c:pt>
                <c:pt idx="875">
                  <c:v>246.09</c:v>
                </c:pt>
                <c:pt idx="876">
                  <c:v>246.36</c:v>
                </c:pt>
                <c:pt idx="877">
                  <c:v>246.65</c:v>
                </c:pt>
                <c:pt idx="878">
                  <c:v>246.93</c:v>
                </c:pt>
                <c:pt idx="879">
                  <c:v>247.21</c:v>
                </c:pt>
                <c:pt idx="880">
                  <c:v>247.49</c:v>
                </c:pt>
                <c:pt idx="881">
                  <c:v>247.77</c:v>
                </c:pt>
                <c:pt idx="882">
                  <c:v>248.05</c:v>
                </c:pt>
                <c:pt idx="883">
                  <c:v>248.33</c:v>
                </c:pt>
                <c:pt idx="884">
                  <c:v>248.62</c:v>
                </c:pt>
                <c:pt idx="885">
                  <c:v>248.89</c:v>
                </c:pt>
                <c:pt idx="886">
                  <c:v>249.17</c:v>
                </c:pt>
                <c:pt idx="887">
                  <c:v>249.46</c:v>
                </c:pt>
                <c:pt idx="888">
                  <c:v>249.73</c:v>
                </c:pt>
                <c:pt idx="889">
                  <c:v>250.01</c:v>
                </c:pt>
                <c:pt idx="890">
                  <c:v>250.3</c:v>
                </c:pt>
                <c:pt idx="891">
                  <c:v>250.58</c:v>
                </c:pt>
                <c:pt idx="892">
                  <c:v>250.86</c:v>
                </c:pt>
                <c:pt idx="893">
                  <c:v>251.14</c:v>
                </c:pt>
                <c:pt idx="894">
                  <c:v>251.42</c:v>
                </c:pt>
                <c:pt idx="895">
                  <c:v>251.7</c:v>
                </c:pt>
                <c:pt idx="896">
                  <c:v>251.98</c:v>
                </c:pt>
                <c:pt idx="897">
                  <c:v>252.27</c:v>
                </c:pt>
                <c:pt idx="898">
                  <c:v>252.54</c:v>
                </c:pt>
                <c:pt idx="899">
                  <c:v>252.83</c:v>
                </c:pt>
                <c:pt idx="900">
                  <c:v>253.11</c:v>
                </c:pt>
                <c:pt idx="901">
                  <c:v>253.39</c:v>
                </c:pt>
                <c:pt idx="902">
                  <c:v>253.67</c:v>
                </c:pt>
                <c:pt idx="903">
                  <c:v>253.95</c:v>
                </c:pt>
                <c:pt idx="904">
                  <c:v>254.23</c:v>
                </c:pt>
                <c:pt idx="905">
                  <c:v>254.51</c:v>
                </c:pt>
                <c:pt idx="906">
                  <c:v>254.79</c:v>
                </c:pt>
                <c:pt idx="907">
                  <c:v>255.07</c:v>
                </c:pt>
                <c:pt idx="908">
                  <c:v>255.35</c:v>
                </c:pt>
                <c:pt idx="909">
                  <c:v>255.63</c:v>
                </c:pt>
                <c:pt idx="910">
                  <c:v>255.91</c:v>
                </c:pt>
                <c:pt idx="911">
                  <c:v>256.2</c:v>
                </c:pt>
                <c:pt idx="912">
                  <c:v>256.48</c:v>
                </c:pt>
                <c:pt idx="913">
                  <c:v>256.76</c:v>
                </c:pt>
                <c:pt idx="914">
                  <c:v>257.04000000000002</c:v>
                </c:pt>
                <c:pt idx="915">
                  <c:v>257.32</c:v>
                </c:pt>
                <c:pt idx="916">
                  <c:v>257.60000000000002</c:v>
                </c:pt>
                <c:pt idx="917">
                  <c:v>257.88</c:v>
                </c:pt>
                <c:pt idx="918">
                  <c:v>258.16000000000003</c:v>
                </c:pt>
                <c:pt idx="919">
                  <c:v>258.44</c:v>
                </c:pt>
                <c:pt idx="920">
                  <c:v>258.72000000000003</c:v>
                </c:pt>
                <c:pt idx="921">
                  <c:v>259</c:v>
                </c:pt>
                <c:pt idx="922">
                  <c:v>259.29000000000002</c:v>
                </c:pt>
                <c:pt idx="923">
                  <c:v>259.56</c:v>
                </c:pt>
                <c:pt idx="924">
                  <c:v>259.85000000000002</c:v>
                </c:pt>
                <c:pt idx="925">
                  <c:v>260.13</c:v>
                </c:pt>
                <c:pt idx="926">
                  <c:v>260.41000000000003</c:v>
                </c:pt>
                <c:pt idx="927">
                  <c:v>260.69</c:v>
                </c:pt>
                <c:pt idx="928">
                  <c:v>260.97000000000003</c:v>
                </c:pt>
                <c:pt idx="929">
                  <c:v>261.25</c:v>
                </c:pt>
                <c:pt idx="930">
                  <c:v>261.52999999999997</c:v>
                </c:pt>
                <c:pt idx="931">
                  <c:v>261.81</c:v>
                </c:pt>
                <c:pt idx="932">
                  <c:v>262.08999999999997</c:v>
                </c:pt>
                <c:pt idx="933">
                  <c:v>262.37</c:v>
                </c:pt>
                <c:pt idx="934">
                  <c:v>262.64999999999998</c:v>
                </c:pt>
                <c:pt idx="935">
                  <c:v>262.94</c:v>
                </c:pt>
                <c:pt idx="936">
                  <c:v>263.22000000000003</c:v>
                </c:pt>
                <c:pt idx="937">
                  <c:v>263.49</c:v>
                </c:pt>
                <c:pt idx="938">
                  <c:v>263.77999999999997</c:v>
                </c:pt>
                <c:pt idx="939">
                  <c:v>264.06</c:v>
                </c:pt>
                <c:pt idx="940">
                  <c:v>264.33999999999997</c:v>
                </c:pt>
                <c:pt idx="941">
                  <c:v>264.62</c:v>
                </c:pt>
                <c:pt idx="942">
                  <c:v>264.89999999999998</c:v>
                </c:pt>
                <c:pt idx="943">
                  <c:v>265.18</c:v>
                </c:pt>
                <c:pt idx="944">
                  <c:v>265.45999999999998</c:v>
                </c:pt>
                <c:pt idx="945">
                  <c:v>265.74</c:v>
                </c:pt>
                <c:pt idx="946">
                  <c:v>266.02</c:v>
                </c:pt>
                <c:pt idx="947">
                  <c:v>266.31</c:v>
                </c:pt>
                <c:pt idx="948">
                  <c:v>266.58999999999997</c:v>
                </c:pt>
                <c:pt idx="949">
                  <c:v>266.86</c:v>
                </c:pt>
                <c:pt idx="950">
                  <c:v>267.14</c:v>
                </c:pt>
                <c:pt idx="951">
                  <c:v>267.42</c:v>
                </c:pt>
                <c:pt idx="952">
                  <c:v>267.70999999999998</c:v>
                </c:pt>
                <c:pt idx="953">
                  <c:v>267.99</c:v>
                </c:pt>
                <c:pt idx="954">
                  <c:v>268.27</c:v>
                </c:pt>
                <c:pt idx="955">
                  <c:v>268.55</c:v>
                </c:pt>
                <c:pt idx="956">
                  <c:v>268.83</c:v>
                </c:pt>
                <c:pt idx="957">
                  <c:v>269.11</c:v>
                </c:pt>
                <c:pt idx="958">
                  <c:v>269.39</c:v>
                </c:pt>
                <c:pt idx="959">
                  <c:v>269.67</c:v>
                </c:pt>
                <c:pt idx="960">
                  <c:v>269.95</c:v>
                </c:pt>
                <c:pt idx="961">
                  <c:v>270.24</c:v>
                </c:pt>
                <c:pt idx="962">
                  <c:v>270.52</c:v>
                </c:pt>
                <c:pt idx="963">
                  <c:v>270.8</c:v>
                </c:pt>
                <c:pt idx="964">
                  <c:v>271.08</c:v>
                </c:pt>
                <c:pt idx="965">
                  <c:v>271.36</c:v>
                </c:pt>
                <c:pt idx="966">
                  <c:v>271.64</c:v>
                </c:pt>
                <c:pt idx="967">
                  <c:v>271.92</c:v>
                </c:pt>
                <c:pt idx="968">
                  <c:v>272.2</c:v>
                </c:pt>
                <c:pt idx="969">
                  <c:v>272.48</c:v>
                </c:pt>
                <c:pt idx="970">
                  <c:v>272.76</c:v>
                </c:pt>
                <c:pt idx="971">
                  <c:v>273.05</c:v>
                </c:pt>
                <c:pt idx="972">
                  <c:v>273.33</c:v>
                </c:pt>
                <c:pt idx="973">
                  <c:v>273.61</c:v>
                </c:pt>
                <c:pt idx="974">
                  <c:v>273.88</c:v>
                </c:pt>
                <c:pt idx="975">
                  <c:v>274.17</c:v>
                </c:pt>
                <c:pt idx="976">
                  <c:v>274.45</c:v>
                </c:pt>
                <c:pt idx="977">
                  <c:v>274.72000000000003</c:v>
                </c:pt>
                <c:pt idx="978">
                  <c:v>275.01</c:v>
                </c:pt>
                <c:pt idx="979">
                  <c:v>275.29000000000002</c:v>
                </c:pt>
                <c:pt idx="980">
                  <c:v>275.57</c:v>
                </c:pt>
                <c:pt idx="981">
                  <c:v>275.85000000000002</c:v>
                </c:pt>
                <c:pt idx="982">
                  <c:v>276.13</c:v>
                </c:pt>
                <c:pt idx="983">
                  <c:v>276.41000000000003</c:v>
                </c:pt>
                <c:pt idx="984">
                  <c:v>276.69</c:v>
                </c:pt>
                <c:pt idx="985">
                  <c:v>276.97000000000003</c:v>
                </c:pt>
                <c:pt idx="986">
                  <c:v>277.25</c:v>
                </c:pt>
                <c:pt idx="987">
                  <c:v>277.54000000000002</c:v>
                </c:pt>
                <c:pt idx="988">
                  <c:v>277.82</c:v>
                </c:pt>
                <c:pt idx="989">
                  <c:v>278.10000000000002</c:v>
                </c:pt>
                <c:pt idx="990">
                  <c:v>278.38</c:v>
                </c:pt>
                <c:pt idx="991">
                  <c:v>278.66000000000003</c:v>
                </c:pt>
                <c:pt idx="992">
                  <c:v>278.94</c:v>
                </c:pt>
                <c:pt idx="993">
                  <c:v>279.22000000000003</c:v>
                </c:pt>
                <c:pt idx="994">
                  <c:v>279.5</c:v>
                </c:pt>
                <c:pt idx="995">
                  <c:v>279.77999999999997</c:v>
                </c:pt>
                <c:pt idx="996">
                  <c:v>280.06</c:v>
                </c:pt>
                <c:pt idx="997">
                  <c:v>280.56</c:v>
                </c:pt>
                <c:pt idx="998">
                  <c:v>280.79000000000002</c:v>
                </c:pt>
                <c:pt idx="999">
                  <c:v>281.01</c:v>
                </c:pt>
                <c:pt idx="1000">
                  <c:v>281.24</c:v>
                </c:pt>
                <c:pt idx="1001">
                  <c:v>281.47000000000003</c:v>
                </c:pt>
                <c:pt idx="1002">
                  <c:v>281.75</c:v>
                </c:pt>
                <c:pt idx="1003">
                  <c:v>282.02999999999997</c:v>
                </c:pt>
                <c:pt idx="1004">
                  <c:v>282.31</c:v>
                </c:pt>
                <c:pt idx="1005">
                  <c:v>282.58999999999997</c:v>
                </c:pt>
                <c:pt idx="1006">
                  <c:v>282.87</c:v>
                </c:pt>
                <c:pt idx="1007">
                  <c:v>283.14999999999998</c:v>
                </c:pt>
                <c:pt idx="1008">
                  <c:v>283.43</c:v>
                </c:pt>
                <c:pt idx="1009">
                  <c:v>283.70999999999998</c:v>
                </c:pt>
                <c:pt idx="1010">
                  <c:v>283.99</c:v>
                </c:pt>
                <c:pt idx="1011">
                  <c:v>284.27999999999997</c:v>
                </c:pt>
                <c:pt idx="1012">
                  <c:v>284.56</c:v>
                </c:pt>
                <c:pt idx="1013">
                  <c:v>284.83</c:v>
                </c:pt>
                <c:pt idx="1014">
                  <c:v>285.12</c:v>
                </c:pt>
                <c:pt idx="1015">
                  <c:v>285.39999999999998</c:v>
                </c:pt>
                <c:pt idx="1016">
                  <c:v>285.68</c:v>
                </c:pt>
                <c:pt idx="1017">
                  <c:v>285.95999999999998</c:v>
                </c:pt>
                <c:pt idx="1018">
                  <c:v>286.24</c:v>
                </c:pt>
                <c:pt idx="1019">
                  <c:v>286.52</c:v>
                </c:pt>
                <c:pt idx="1020">
                  <c:v>286.8</c:v>
                </c:pt>
                <c:pt idx="1021">
                  <c:v>287.08</c:v>
                </c:pt>
                <c:pt idx="1022">
                  <c:v>287.36</c:v>
                </c:pt>
                <c:pt idx="1023">
                  <c:v>287.64999999999998</c:v>
                </c:pt>
                <c:pt idx="1024">
                  <c:v>287.92</c:v>
                </c:pt>
                <c:pt idx="1025">
                  <c:v>288.2</c:v>
                </c:pt>
                <c:pt idx="1026">
                  <c:v>288.49</c:v>
                </c:pt>
                <c:pt idx="1027">
                  <c:v>288.77</c:v>
                </c:pt>
                <c:pt idx="1028">
                  <c:v>289.05</c:v>
                </c:pt>
                <c:pt idx="1029">
                  <c:v>289.33</c:v>
                </c:pt>
                <c:pt idx="1030">
                  <c:v>289.61</c:v>
                </c:pt>
                <c:pt idx="1031">
                  <c:v>289.89</c:v>
                </c:pt>
                <c:pt idx="1032">
                  <c:v>290.17</c:v>
                </c:pt>
                <c:pt idx="1033">
                  <c:v>290.45</c:v>
                </c:pt>
                <c:pt idx="1034">
                  <c:v>290.73</c:v>
                </c:pt>
                <c:pt idx="1035">
                  <c:v>291.02</c:v>
                </c:pt>
                <c:pt idx="1036">
                  <c:v>291.3</c:v>
                </c:pt>
                <c:pt idx="1037">
                  <c:v>291.58</c:v>
                </c:pt>
                <c:pt idx="1038">
                  <c:v>291.86</c:v>
                </c:pt>
                <c:pt idx="1039">
                  <c:v>292.13</c:v>
                </c:pt>
                <c:pt idx="1040">
                  <c:v>292.42</c:v>
                </c:pt>
                <c:pt idx="1041">
                  <c:v>292.7</c:v>
                </c:pt>
                <c:pt idx="1042">
                  <c:v>292.98</c:v>
                </c:pt>
                <c:pt idx="1043">
                  <c:v>293.26</c:v>
                </c:pt>
                <c:pt idx="1044">
                  <c:v>293.54000000000002</c:v>
                </c:pt>
                <c:pt idx="1045">
                  <c:v>293.82</c:v>
                </c:pt>
                <c:pt idx="1046">
                  <c:v>294.10000000000002</c:v>
                </c:pt>
                <c:pt idx="1047">
                  <c:v>294.38</c:v>
                </c:pt>
                <c:pt idx="1048">
                  <c:v>294.66000000000003</c:v>
                </c:pt>
                <c:pt idx="1049">
                  <c:v>294.95</c:v>
                </c:pt>
                <c:pt idx="1050">
                  <c:v>295.22000000000003</c:v>
                </c:pt>
                <c:pt idx="1051">
                  <c:v>295.51</c:v>
                </c:pt>
                <c:pt idx="1052">
                  <c:v>295.79000000000002</c:v>
                </c:pt>
                <c:pt idx="1053">
                  <c:v>296.07</c:v>
                </c:pt>
                <c:pt idx="1054">
                  <c:v>296.35000000000002</c:v>
                </c:pt>
                <c:pt idx="1055">
                  <c:v>296.63</c:v>
                </c:pt>
                <c:pt idx="1056">
                  <c:v>296.91000000000003</c:v>
                </c:pt>
                <c:pt idx="1057">
                  <c:v>297.19</c:v>
                </c:pt>
                <c:pt idx="1058">
                  <c:v>297.47000000000003</c:v>
                </c:pt>
                <c:pt idx="1059">
                  <c:v>297.75</c:v>
                </c:pt>
                <c:pt idx="1060">
                  <c:v>298.02999999999997</c:v>
                </c:pt>
                <c:pt idx="1061">
                  <c:v>298.32</c:v>
                </c:pt>
                <c:pt idx="1062">
                  <c:v>298.60000000000002</c:v>
                </c:pt>
                <c:pt idx="1063">
                  <c:v>298.88</c:v>
                </c:pt>
                <c:pt idx="1064">
                  <c:v>299.16000000000003</c:v>
                </c:pt>
                <c:pt idx="1065">
                  <c:v>299.44</c:v>
                </c:pt>
                <c:pt idx="1066">
                  <c:v>299.72000000000003</c:v>
                </c:pt>
                <c:pt idx="1067">
                  <c:v>300</c:v>
                </c:pt>
                <c:pt idx="1068">
                  <c:v>300.27999999999997</c:v>
                </c:pt>
                <c:pt idx="1069">
                  <c:v>300.56</c:v>
                </c:pt>
                <c:pt idx="1070">
                  <c:v>300.83999999999997</c:v>
                </c:pt>
                <c:pt idx="1071">
                  <c:v>301.12</c:v>
                </c:pt>
                <c:pt idx="1072">
                  <c:v>301.39999999999998</c:v>
                </c:pt>
                <c:pt idx="1073">
                  <c:v>301.68</c:v>
                </c:pt>
                <c:pt idx="1074">
                  <c:v>301.95999999999998</c:v>
                </c:pt>
                <c:pt idx="1075">
                  <c:v>302.24</c:v>
                </c:pt>
                <c:pt idx="1076">
                  <c:v>302.52999999999997</c:v>
                </c:pt>
                <c:pt idx="1077">
                  <c:v>302.81</c:v>
                </c:pt>
                <c:pt idx="1078">
                  <c:v>303.08999999999997</c:v>
                </c:pt>
                <c:pt idx="1079">
                  <c:v>303.37</c:v>
                </c:pt>
                <c:pt idx="1080">
                  <c:v>303.64999999999998</c:v>
                </c:pt>
                <c:pt idx="1081">
                  <c:v>303.93</c:v>
                </c:pt>
                <c:pt idx="1082">
                  <c:v>304.20999999999998</c:v>
                </c:pt>
                <c:pt idx="1083">
                  <c:v>304.49</c:v>
                </c:pt>
                <c:pt idx="1084">
                  <c:v>304.77</c:v>
                </c:pt>
                <c:pt idx="1085">
                  <c:v>305.05</c:v>
                </c:pt>
                <c:pt idx="1086">
                  <c:v>305.33</c:v>
                </c:pt>
                <c:pt idx="1087">
                  <c:v>305.62</c:v>
                </c:pt>
                <c:pt idx="1088">
                  <c:v>305.89999999999998</c:v>
                </c:pt>
                <c:pt idx="1089">
                  <c:v>306.18</c:v>
                </c:pt>
                <c:pt idx="1090">
                  <c:v>306.45999999999998</c:v>
                </c:pt>
                <c:pt idx="1091">
                  <c:v>306.74</c:v>
                </c:pt>
                <c:pt idx="1092">
                  <c:v>307.02</c:v>
                </c:pt>
                <c:pt idx="1093">
                  <c:v>307.3</c:v>
                </c:pt>
                <c:pt idx="1094">
                  <c:v>307.58</c:v>
                </c:pt>
                <c:pt idx="1095">
                  <c:v>307.86</c:v>
                </c:pt>
                <c:pt idx="1096">
                  <c:v>308.14</c:v>
                </c:pt>
                <c:pt idx="1097">
                  <c:v>308.42</c:v>
                </c:pt>
                <c:pt idx="1098">
                  <c:v>308.7</c:v>
                </c:pt>
                <c:pt idx="1099">
                  <c:v>308.99</c:v>
                </c:pt>
                <c:pt idx="1100">
                  <c:v>309.27</c:v>
                </c:pt>
                <c:pt idx="1101">
                  <c:v>309.55</c:v>
                </c:pt>
                <c:pt idx="1102">
                  <c:v>309.83</c:v>
                </c:pt>
                <c:pt idx="1103">
                  <c:v>310.11</c:v>
                </c:pt>
                <c:pt idx="1104">
                  <c:v>310.39</c:v>
                </c:pt>
                <c:pt idx="1105">
                  <c:v>310.67</c:v>
                </c:pt>
                <c:pt idx="1106">
                  <c:v>310.95</c:v>
                </c:pt>
                <c:pt idx="1107">
                  <c:v>311.23</c:v>
                </c:pt>
                <c:pt idx="1108">
                  <c:v>311.51</c:v>
                </c:pt>
                <c:pt idx="1109">
                  <c:v>311.79000000000002</c:v>
                </c:pt>
                <c:pt idx="1110">
                  <c:v>312.07</c:v>
                </c:pt>
                <c:pt idx="1111">
                  <c:v>312.36</c:v>
                </c:pt>
                <c:pt idx="1112">
                  <c:v>312.64</c:v>
                </c:pt>
                <c:pt idx="1113">
                  <c:v>312.92</c:v>
                </c:pt>
                <c:pt idx="1114">
                  <c:v>313.2</c:v>
                </c:pt>
                <c:pt idx="1115">
                  <c:v>313.47000000000003</c:v>
                </c:pt>
                <c:pt idx="1116">
                  <c:v>313.76</c:v>
                </c:pt>
                <c:pt idx="1117">
                  <c:v>314.04000000000002</c:v>
                </c:pt>
                <c:pt idx="1118">
                  <c:v>314.32</c:v>
                </c:pt>
                <c:pt idx="1119">
                  <c:v>314.60000000000002</c:v>
                </c:pt>
                <c:pt idx="1120">
                  <c:v>314.88</c:v>
                </c:pt>
                <c:pt idx="1121">
                  <c:v>315.16000000000003</c:v>
                </c:pt>
                <c:pt idx="1122">
                  <c:v>315.44</c:v>
                </c:pt>
                <c:pt idx="1123">
                  <c:v>315.73</c:v>
                </c:pt>
                <c:pt idx="1124">
                  <c:v>316.01</c:v>
                </c:pt>
                <c:pt idx="1125">
                  <c:v>316.27999999999997</c:v>
                </c:pt>
                <c:pt idx="1126">
                  <c:v>316.56</c:v>
                </c:pt>
                <c:pt idx="1127">
                  <c:v>316.85000000000002</c:v>
                </c:pt>
                <c:pt idx="1128">
                  <c:v>317.13</c:v>
                </c:pt>
                <c:pt idx="1129">
                  <c:v>317.41000000000003</c:v>
                </c:pt>
                <c:pt idx="1130">
                  <c:v>317.69</c:v>
                </c:pt>
                <c:pt idx="1131">
                  <c:v>317.97000000000003</c:v>
                </c:pt>
                <c:pt idx="1132">
                  <c:v>318.25</c:v>
                </c:pt>
                <c:pt idx="1133">
                  <c:v>318.52999999999997</c:v>
                </c:pt>
                <c:pt idx="1134">
                  <c:v>318.81</c:v>
                </c:pt>
                <c:pt idx="1135">
                  <c:v>319.08999999999997</c:v>
                </c:pt>
                <c:pt idx="1136">
                  <c:v>319.37</c:v>
                </c:pt>
                <c:pt idx="1137">
                  <c:v>319.64999999999998</c:v>
                </c:pt>
                <c:pt idx="1138">
                  <c:v>319.94</c:v>
                </c:pt>
                <c:pt idx="1139">
                  <c:v>320.20999999999998</c:v>
                </c:pt>
                <c:pt idx="1140">
                  <c:v>320.5</c:v>
                </c:pt>
                <c:pt idx="1141">
                  <c:v>320.77999999999997</c:v>
                </c:pt>
                <c:pt idx="1142">
                  <c:v>321.06</c:v>
                </c:pt>
                <c:pt idx="1143">
                  <c:v>321.33999999999997</c:v>
                </c:pt>
                <c:pt idx="1144">
                  <c:v>321.62</c:v>
                </c:pt>
                <c:pt idx="1145">
                  <c:v>321.89999999999998</c:v>
                </c:pt>
                <c:pt idx="1146">
                  <c:v>322.18</c:v>
                </c:pt>
                <c:pt idx="1147">
                  <c:v>322.45999999999998</c:v>
                </c:pt>
                <c:pt idx="1148">
                  <c:v>322.74</c:v>
                </c:pt>
                <c:pt idx="1149">
                  <c:v>323.02999999999997</c:v>
                </c:pt>
                <c:pt idx="1150">
                  <c:v>323.31</c:v>
                </c:pt>
                <c:pt idx="1151">
                  <c:v>323.58999999999997</c:v>
                </c:pt>
                <c:pt idx="1152">
                  <c:v>323.87</c:v>
                </c:pt>
                <c:pt idx="1153">
                  <c:v>324.14999999999998</c:v>
                </c:pt>
                <c:pt idx="1154">
                  <c:v>324.43</c:v>
                </c:pt>
                <c:pt idx="1155">
                  <c:v>324.70999999999998</c:v>
                </c:pt>
                <c:pt idx="1156">
                  <c:v>324.99</c:v>
                </c:pt>
                <c:pt idx="1157">
                  <c:v>325.27</c:v>
                </c:pt>
                <c:pt idx="1158">
                  <c:v>325.55</c:v>
                </c:pt>
                <c:pt idx="1159">
                  <c:v>325.83</c:v>
                </c:pt>
                <c:pt idx="1160">
                  <c:v>326.12</c:v>
                </c:pt>
                <c:pt idx="1161">
                  <c:v>326.39</c:v>
                </c:pt>
                <c:pt idx="1162">
                  <c:v>326.67</c:v>
                </c:pt>
                <c:pt idx="1163">
                  <c:v>326.95999999999998</c:v>
                </c:pt>
                <c:pt idx="1164">
                  <c:v>327.24</c:v>
                </c:pt>
                <c:pt idx="1165">
                  <c:v>327.52</c:v>
                </c:pt>
                <c:pt idx="1166">
                  <c:v>327.8</c:v>
                </c:pt>
                <c:pt idx="1167">
                  <c:v>328.08</c:v>
                </c:pt>
                <c:pt idx="1168">
                  <c:v>328.36</c:v>
                </c:pt>
                <c:pt idx="1169">
                  <c:v>328.64</c:v>
                </c:pt>
                <c:pt idx="1170">
                  <c:v>328.92</c:v>
                </c:pt>
                <c:pt idx="1171">
                  <c:v>329.2</c:v>
                </c:pt>
                <c:pt idx="1172">
                  <c:v>329.49</c:v>
                </c:pt>
                <c:pt idx="1173">
                  <c:v>329.76</c:v>
                </c:pt>
                <c:pt idx="1174">
                  <c:v>330.05</c:v>
                </c:pt>
                <c:pt idx="1175">
                  <c:v>330.33</c:v>
                </c:pt>
                <c:pt idx="1176">
                  <c:v>330.61</c:v>
                </c:pt>
                <c:pt idx="1177">
                  <c:v>330.88</c:v>
                </c:pt>
                <c:pt idx="1178">
                  <c:v>331.17</c:v>
                </c:pt>
                <c:pt idx="1179">
                  <c:v>331.45</c:v>
                </c:pt>
                <c:pt idx="1180">
                  <c:v>331.73</c:v>
                </c:pt>
                <c:pt idx="1181">
                  <c:v>332.01</c:v>
                </c:pt>
                <c:pt idx="1182">
                  <c:v>332.29</c:v>
                </c:pt>
                <c:pt idx="1183">
                  <c:v>332.57</c:v>
                </c:pt>
                <c:pt idx="1184">
                  <c:v>332.85</c:v>
                </c:pt>
                <c:pt idx="1185">
                  <c:v>333.14</c:v>
                </c:pt>
                <c:pt idx="1186">
                  <c:v>333.41</c:v>
                </c:pt>
                <c:pt idx="1187">
                  <c:v>333.7</c:v>
                </c:pt>
                <c:pt idx="1188">
                  <c:v>333.97</c:v>
                </c:pt>
                <c:pt idx="1189">
                  <c:v>334.26</c:v>
                </c:pt>
                <c:pt idx="1190">
                  <c:v>334.54</c:v>
                </c:pt>
                <c:pt idx="1191">
                  <c:v>334.82</c:v>
                </c:pt>
                <c:pt idx="1192">
                  <c:v>335.1</c:v>
                </c:pt>
                <c:pt idx="1193">
                  <c:v>335.38</c:v>
                </c:pt>
                <c:pt idx="1194">
                  <c:v>335.66</c:v>
                </c:pt>
                <c:pt idx="1195">
                  <c:v>335.94</c:v>
                </c:pt>
                <c:pt idx="1196">
                  <c:v>336.22</c:v>
                </c:pt>
                <c:pt idx="1197">
                  <c:v>336.51</c:v>
                </c:pt>
                <c:pt idx="1198">
                  <c:v>336.79</c:v>
                </c:pt>
                <c:pt idx="1199">
                  <c:v>337.07</c:v>
                </c:pt>
                <c:pt idx="1200">
                  <c:v>337.35</c:v>
                </c:pt>
                <c:pt idx="1201">
                  <c:v>337.63</c:v>
                </c:pt>
                <c:pt idx="1202">
                  <c:v>337.9</c:v>
                </c:pt>
                <c:pt idx="1203">
                  <c:v>338.19</c:v>
                </c:pt>
                <c:pt idx="1204">
                  <c:v>338.47</c:v>
                </c:pt>
                <c:pt idx="1205">
                  <c:v>338.75</c:v>
                </c:pt>
                <c:pt idx="1206">
                  <c:v>339.03</c:v>
                </c:pt>
                <c:pt idx="1207">
                  <c:v>339.31</c:v>
                </c:pt>
                <c:pt idx="1208">
                  <c:v>339.59</c:v>
                </c:pt>
                <c:pt idx="1209">
                  <c:v>339.87</c:v>
                </c:pt>
                <c:pt idx="1210">
                  <c:v>340.16</c:v>
                </c:pt>
                <c:pt idx="1211">
                  <c:v>340.43</c:v>
                </c:pt>
                <c:pt idx="1212">
                  <c:v>340.72</c:v>
                </c:pt>
                <c:pt idx="1213">
                  <c:v>340.99</c:v>
                </c:pt>
                <c:pt idx="1214">
                  <c:v>341.28</c:v>
                </c:pt>
                <c:pt idx="1215">
                  <c:v>341.56</c:v>
                </c:pt>
                <c:pt idx="1216">
                  <c:v>341.84</c:v>
                </c:pt>
                <c:pt idx="1217">
                  <c:v>342.12</c:v>
                </c:pt>
                <c:pt idx="1218">
                  <c:v>342.4</c:v>
                </c:pt>
                <c:pt idx="1219">
                  <c:v>342.68</c:v>
                </c:pt>
                <c:pt idx="1220">
                  <c:v>342.96</c:v>
                </c:pt>
                <c:pt idx="1221">
                  <c:v>343.24</c:v>
                </c:pt>
                <c:pt idx="1222">
                  <c:v>343.52</c:v>
                </c:pt>
                <c:pt idx="1223">
                  <c:v>343.81</c:v>
                </c:pt>
                <c:pt idx="1224">
                  <c:v>344.08</c:v>
                </c:pt>
                <c:pt idx="1225">
                  <c:v>344.37</c:v>
                </c:pt>
                <c:pt idx="1226">
                  <c:v>344.64</c:v>
                </c:pt>
                <c:pt idx="1227">
                  <c:v>344.92</c:v>
                </c:pt>
                <c:pt idx="1228">
                  <c:v>345.21</c:v>
                </c:pt>
                <c:pt idx="1229">
                  <c:v>345.49</c:v>
                </c:pt>
                <c:pt idx="1230">
                  <c:v>345.77</c:v>
                </c:pt>
                <c:pt idx="1231">
                  <c:v>346.05</c:v>
                </c:pt>
                <c:pt idx="1232">
                  <c:v>346.33</c:v>
                </c:pt>
                <c:pt idx="1233">
                  <c:v>346.61</c:v>
                </c:pt>
                <c:pt idx="1234">
                  <c:v>346.89</c:v>
                </c:pt>
                <c:pt idx="1235">
                  <c:v>347.17</c:v>
                </c:pt>
                <c:pt idx="1236">
                  <c:v>347.45</c:v>
                </c:pt>
                <c:pt idx="1237">
                  <c:v>347.73</c:v>
                </c:pt>
                <c:pt idx="1238">
                  <c:v>348.01</c:v>
                </c:pt>
                <c:pt idx="1239">
                  <c:v>348.3</c:v>
                </c:pt>
                <c:pt idx="1240">
                  <c:v>348.58</c:v>
                </c:pt>
                <c:pt idx="1241">
                  <c:v>348.86</c:v>
                </c:pt>
                <c:pt idx="1242">
                  <c:v>349.14</c:v>
                </c:pt>
                <c:pt idx="1243">
                  <c:v>349.42</c:v>
                </c:pt>
                <c:pt idx="1244">
                  <c:v>349.7</c:v>
                </c:pt>
                <c:pt idx="1245">
                  <c:v>349.98</c:v>
                </c:pt>
                <c:pt idx="1246">
                  <c:v>350.26</c:v>
                </c:pt>
                <c:pt idx="1247">
                  <c:v>350.54</c:v>
                </c:pt>
                <c:pt idx="1248">
                  <c:v>350.82</c:v>
                </c:pt>
                <c:pt idx="1249">
                  <c:v>351.1</c:v>
                </c:pt>
                <c:pt idx="1250">
                  <c:v>351.39</c:v>
                </c:pt>
                <c:pt idx="1251">
                  <c:v>351.66</c:v>
                </c:pt>
                <c:pt idx="1252">
                  <c:v>351.94</c:v>
                </c:pt>
                <c:pt idx="1253">
                  <c:v>352.23</c:v>
                </c:pt>
                <c:pt idx="1254">
                  <c:v>352.51</c:v>
                </c:pt>
                <c:pt idx="1255">
                  <c:v>352.79</c:v>
                </c:pt>
                <c:pt idx="1256">
                  <c:v>353.07</c:v>
                </c:pt>
                <c:pt idx="1257">
                  <c:v>353.35</c:v>
                </c:pt>
                <c:pt idx="1258">
                  <c:v>353.63</c:v>
                </c:pt>
                <c:pt idx="1259">
                  <c:v>353.91</c:v>
                </c:pt>
                <c:pt idx="1260">
                  <c:v>354.19</c:v>
                </c:pt>
                <c:pt idx="1261">
                  <c:v>354.47</c:v>
                </c:pt>
                <c:pt idx="1262">
                  <c:v>354.75</c:v>
                </c:pt>
                <c:pt idx="1263">
                  <c:v>355.04</c:v>
                </c:pt>
                <c:pt idx="1264">
                  <c:v>355.32</c:v>
                </c:pt>
                <c:pt idx="1265">
                  <c:v>355.6</c:v>
                </c:pt>
                <c:pt idx="1266">
                  <c:v>355.88</c:v>
                </c:pt>
                <c:pt idx="1267">
                  <c:v>356.16</c:v>
                </c:pt>
                <c:pt idx="1268">
                  <c:v>356.44</c:v>
                </c:pt>
                <c:pt idx="1269">
                  <c:v>356.72</c:v>
                </c:pt>
                <c:pt idx="1270">
                  <c:v>357</c:v>
                </c:pt>
                <c:pt idx="1271">
                  <c:v>357.29</c:v>
                </c:pt>
                <c:pt idx="1272">
                  <c:v>357.56</c:v>
                </c:pt>
                <c:pt idx="1273">
                  <c:v>357.84</c:v>
                </c:pt>
                <c:pt idx="1274">
                  <c:v>358.12</c:v>
                </c:pt>
                <c:pt idx="1275">
                  <c:v>358.41</c:v>
                </c:pt>
                <c:pt idx="1276">
                  <c:v>358.69</c:v>
                </c:pt>
                <c:pt idx="1277">
                  <c:v>358.97</c:v>
                </c:pt>
                <c:pt idx="1278">
                  <c:v>359.25</c:v>
                </c:pt>
                <c:pt idx="1279">
                  <c:v>359.53</c:v>
                </c:pt>
                <c:pt idx="1280">
                  <c:v>359.81</c:v>
                </c:pt>
                <c:pt idx="1281">
                  <c:v>360.09</c:v>
                </c:pt>
                <c:pt idx="1282">
                  <c:v>360.37</c:v>
                </c:pt>
                <c:pt idx="1283">
                  <c:v>360.65</c:v>
                </c:pt>
                <c:pt idx="1284">
                  <c:v>360.93</c:v>
                </c:pt>
                <c:pt idx="1285">
                  <c:v>361.21</c:v>
                </c:pt>
                <c:pt idx="1286">
                  <c:v>361.5</c:v>
                </c:pt>
                <c:pt idx="1287">
                  <c:v>361.78</c:v>
                </c:pt>
                <c:pt idx="1288">
                  <c:v>362.05</c:v>
                </c:pt>
                <c:pt idx="1289">
                  <c:v>362.34</c:v>
                </c:pt>
                <c:pt idx="1290">
                  <c:v>362.62</c:v>
                </c:pt>
                <c:pt idx="1291">
                  <c:v>362.9</c:v>
                </c:pt>
                <c:pt idx="1292">
                  <c:v>363.18</c:v>
                </c:pt>
                <c:pt idx="1293">
                  <c:v>363.46</c:v>
                </c:pt>
                <c:pt idx="1294">
                  <c:v>363.74</c:v>
                </c:pt>
                <c:pt idx="1295">
                  <c:v>364.02</c:v>
                </c:pt>
                <c:pt idx="1296">
                  <c:v>364.31</c:v>
                </c:pt>
                <c:pt idx="1297">
                  <c:v>364.58</c:v>
                </c:pt>
                <c:pt idx="1298">
                  <c:v>364.86</c:v>
                </c:pt>
                <c:pt idx="1299">
                  <c:v>365.15</c:v>
                </c:pt>
                <c:pt idx="1300">
                  <c:v>365.43</c:v>
                </c:pt>
                <c:pt idx="1301">
                  <c:v>365.71</c:v>
                </c:pt>
                <c:pt idx="1302">
                  <c:v>365.99</c:v>
                </c:pt>
                <c:pt idx="1303">
                  <c:v>366.27</c:v>
                </c:pt>
                <c:pt idx="1304">
                  <c:v>366.55</c:v>
                </c:pt>
                <c:pt idx="1305">
                  <c:v>366.83</c:v>
                </c:pt>
                <c:pt idx="1306">
                  <c:v>367.11</c:v>
                </c:pt>
                <c:pt idx="1307">
                  <c:v>367.39</c:v>
                </c:pt>
                <c:pt idx="1308">
                  <c:v>367.67</c:v>
                </c:pt>
                <c:pt idx="1309">
                  <c:v>367.95</c:v>
                </c:pt>
                <c:pt idx="1310">
                  <c:v>368.23</c:v>
                </c:pt>
                <c:pt idx="1311">
                  <c:v>368.52</c:v>
                </c:pt>
                <c:pt idx="1312">
                  <c:v>368.79</c:v>
                </c:pt>
                <c:pt idx="1313">
                  <c:v>369.07</c:v>
                </c:pt>
                <c:pt idx="1314">
                  <c:v>369.36</c:v>
                </c:pt>
                <c:pt idx="1315">
                  <c:v>369.64</c:v>
                </c:pt>
                <c:pt idx="1316">
                  <c:v>369.92</c:v>
                </c:pt>
                <c:pt idx="1317">
                  <c:v>370.2</c:v>
                </c:pt>
                <c:pt idx="1318">
                  <c:v>370.48</c:v>
                </c:pt>
                <c:pt idx="1319">
                  <c:v>370.76</c:v>
                </c:pt>
                <c:pt idx="1320">
                  <c:v>371.04</c:v>
                </c:pt>
                <c:pt idx="1321">
                  <c:v>371.33</c:v>
                </c:pt>
                <c:pt idx="1322">
                  <c:v>371.6</c:v>
                </c:pt>
                <c:pt idx="1323">
                  <c:v>371.88</c:v>
                </c:pt>
                <c:pt idx="1324">
                  <c:v>372.16</c:v>
                </c:pt>
                <c:pt idx="1325">
                  <c:v>372.45</c:v>
                </c:pt>
                <c:pt idx="1326">
                  <c:v>372.72</c:v>
                </c:pt>
                <c:pt idx="1327">
                  <c:v>373.01</c:v>
                </c:pt>
                <c:pt idx="1328">
                  <c:v>373.29</c:v>
                </c:pt>
                <c:pt idx="1329">
                  <c:v>373.57</c:v>
                </c:pt>
                <c:pt idx="1330">
                  <c:v>373.85</c:v>
                </c:pt>
                <c:pt idx="1331">
                  <c:v>374.13</c:v>
                </c:pt>
                <c:pt idx="1332">
                  <c:v>374.41</c:v>
                </c:pt>
                <c:pt idx="1333">
                  <c:v>374.69</c:v>
                </c:pt>
                <c:pt idx="1334">
                  <c:v>374.97</c:v>
                </c:pt>
                <c:pt idx="1335">
                  <c:v>375.25</c:v>
                </c:pt>
                <c:pt idx="1336">
                  <c:v>375.54</c:v>
                </c:pt>
                <c:pt idx="1337">
                  <c:v>375.82</c:v>
                </c:pt>
                <c:pt idx="1338">
                  <c:v>376.09</c:v>
                </c:pt>
                <c:pt idx="1339">
                  <c:v>376.38</c:v>
                </c:pt>
                <c:pt idx="1340">
                  <c:v>376.66</c:v>
                </c:pt>
                <c:pt idx="1341">
                  <c:v>376.94</c:v>
                </c:pt>
                <c:pt idx="1342">
                  <c:v>377.22</c:v>
                </c:pt>
                <c:pt idx="1343">
                  <c:v>377.5</c:v>
                </c:pt>
                <c:pt idx="1344">
                  <c:v>377.78</c:v>
                </c:pt>
                <c:pt idx="1345">
                  <c:v>378.06</c:v>
                </c:pt>
                <c:pt idx="1346">
                  <c:v>378.35</c:v>
                </c:pt>
                <c:pt idx="1347">
                  <c:v>378.62</c:v>
                </c:pt>
                <c:pt idx="1348">
                  <c:v>378.9</c:v>
                </c:pt>
                <c:pt idx="1349">
                  <c:v>379.19</c:v>
                </c:pt>
                <c:pt idx="1350">
                  <c:v>379.47</c:v>
                </c:pt>
                <c:pt idx="1351">
                  <c:v>379.75</c:v>
                </c:pt>
                <c:pt idx="1352">
                  <c:v>380.03</c:v>
                </c:pt>
                <c:pt idx="1353">
                  <c:v>380.31</c:v>
                </c:pt>
                <c:pt idx="1354">
                  <c:v>380.59</c:v>
                </c:pt>
                <c:pt idx="1355">
                  <c:v>380.87</c:v>
                </c:pt>
                <c:pt idx="1356">
                  <c:v>381.15</c:v>
                </c:pt>
                <c:pt idx="1357">
                  <c:v>381.43</c:v>
                </c:pt>
                <c:pt idx="1358">
                  <c:v>381.71</c:v>
                </c:pt>
                <c:pt idx="1359">
                  <c:v>381.99</c:v>
                </c:pt>
                <c:pt idx="1360">
                  <c:v>382.28</c:v>
                </c:pt>
                <c:pt idx="1361">
                  <c:v>382.56</c:v>
                </c:pt>
                <c:pt idx="1362">
                  <c:v>382.84</c:v>
                </c:pt>
                <c:pt idx="1363">
                  <c:v>383.11</c:v>
                </c:pt>
                <c:pt idx="1364">
                  <c:v>383.4</c:v>
                </c:pt>
                <c:pt idx="1365">
                  <c:v>383.68</c:v>
                </c:pt>
                <c:pt idx="1366">
                  <c:v>383.96</c:v>
                </c:pt>
                <c:pt idx="1367">
                  <c:v>384.24</c:v>
                </c:pt>
                <c:pt idx="1368">
                  <c:v>384.52</c:v>
                </c:pt>
                <c:pt idx="1369">
                  <c:v>384.8</c:v>
                </c:pt>
                <c:pt idx="1370">
                  <c:v>385.08</c:v>
                </c:pt>
                <c:pt idx="1371">
                  <c:v>385.37</c:v>
                </c:pt>
                <c:pt idx="1372">
                  <c:v>385.64</c:v>
                </c:pt>
                <c:pt idx="1373">
                  <c:v>385.92</c:v>
                </c:pt>
                <c:pt idx="1374">
                  <c:v>386.2</c:v>
                </c:pt>
                <c:pt idx="1375">
                  <c:v>386.48</c:v>
                </c:pt>
                <c:pt idx="1376">
                  <c:v>386.77</c:v>
                </c:pt>
                <c:pt idx="1377">
                  <c:v>387.05</c:v>
                </c:pt>
                <c:pt idx="1378">
                  <c:v>387.33</c:v>
                </c:pt>
                <c:pt idx="1379">
                  <c:v>387.61</c:v>
                </c:pt>
                <c:pt idx="1380">
                  <c:v>387.89</c:v>
                </c:pt>
                <c:pt idx="1381">
                  <c:v>388.17</c:v>
                </c:pt>
                <c:pt idx="1382">
                  <c:v>388.45</c:v>
                </c:pt>
                <c:pt idx="1383">
                  <c:v>388.73</c:v>
                </c:pt>
                <c:pt idx="1384">
                  <c:v>389.01</c:v>
                </c:pt>
                <c:pt idx="1385">
                  <c:v>389.3</c:v>
                </c:pt>
                <c:pt idx="1386">
                  <c:v>389.58</c:v>
                </c:pt>
                <c:pt idx="1387">
                  <c:v>389.86</c:v>
                </c:pt>
                <c:pt idx="1388">
                  <c:v>390.13</c:v>
                </c:pt>
                <c:pt idx="1389">
                  <c:v>390.41</c:v>
                </c:pt>
                <c:pt idx="1390">
                  <c:v>390.7</c:v>
                </c:pt>
                <c:pt idx="1391">
                  <c:v>390.98</c:v>
                </c:pt>
                <c:pt idx="1392">
                  <c:v>391.26</c:v>
                </c:pt>
                <c:pt idx="1393">
                  <c:v>391.54</c:v>
                </c:pt>
                <c:pt idx="1394">
                  <c:v>391.82</c:v>
                </c:pt>
                <c:pt idx="1395">
                  <c:v>392.1</c:v>
                </c:pt>
                <c:pt idx="1396">
                  <c:v>392.38</c:v>
                </c:pt>
                <c:pt idx="1397">
                  <c:v>392.66</c:v>
                </c:pt>
                <c:pt idx="1398">
                  <c:v>392.94</c:v>
                </c:pt>
                <c:pt idx="1399">
                  <c:v>393.23</c:v>
                </c:pt>
                <c:pt idx="1400">
                  <c:v>393.51</c:v>
                </c:pt>
                <c:pt idx="1401">
                  <c:v>393.79</c:v>
                </c:pt>
                <c:pt idx="1402">
                  <c:v>394.07</c:v>
                </c:pt>
                <c:pt idx="1403">
                  <c:v>394.35</c:v>
                </c:pt>
                <c:pt idx="1404">
                  <c:v>394.63</c:v>
                </c:pt>
                <c:pt idx="1405">
                  <c:v>394.91</c:v>
                </c:pt>
                <c:pt idx="1406">
                  <c:v>395.19</c:v>
                </c:pt>
                <c:pt idx="1407">
                  <c:v>395.47</c:v>
                </c:pt>
                <c:pt idx="1408">
                  <c:v>395.75</c:v>
                </c:pt>
                <c:pt idx="1409">
                  <c:v>396.03</c:v>
                </c:pt>
                <c:pt idx="1410">
                  <c:v>396.31</c:v>
                </c:pt>
                <c:pt idx="1411">
                  <c:v>396.6</c:v>
                </c:pt>
                <c:pt idx="1412">
                  <c:v>396.87</c:v>
                </c:pt>
                <c:pt idx="1413">
                  <c:v>397.16</c:v>
                </c:pt>
                <c:pt idx="1414">
                  <c:v>397.43</c:v>
                </c:pt>
                <c:pt idx="1415">
                  <c:v>397.72</c:v>
                </c:pt>
                <c:pt idx="1416">
                  <c:v>398</c:v>
                </c:pt>
                <c:pt idx="1417">
                  <c:v>398.28</c:v>
                </c:pt>
                <c:pt idx="1418">
                  <c:v>398.56</c:v>
                </c:pt>
                <c:pt idx="1419">
                  <c:v>398.84</c:v>
                </c:pt>
                <c:pt idx="1420">
                  <c:v>399.12</c:v>
                </c:pt>
                <c:pt idx="1421">
                  <c:v>399.4</c:v>
                </c:pt>
                <c:pt idx="1422">
                  <c:v>399.69</c:v>
                </c:pt>
                <c:pt idx="1423">
                  <c:v>399.96</c:v>
                </c:pt>
                <c:pt idx="1424">
                  <c:v>400.25</c:v>
                </c:pt>
                <c:pt idx="1425">
                  <c:v>400.53</c:v>
                </c:pt>
                <c:pt idx="1426">
                  <c:v>400.81</c:v>
                </c:pt>
                <c:pt idx="1427">
                  <c:v>401.09</c:v>
                </c:pt>
                <c:pt idx="1428">
                  <c:v>401.37</c:v>
                </c:pt>
                <c:pt idx="1429">
                  <c:v>401.65</c:v>
                </c:pt>
                <c:pt idx="1430">
                  <c:v>401.93</c:v>
                </c:pt>
                <c:pt idx="1431">
                  <c:v>402.21</c:v>
                </c:pt>
                <c:pt idx="1432">
                  <c:v>402.49</c:v>
                </c:pt>
                <c:pt idx="1433">
                  <c:v>402.77</c:v>
                </c:pt>
                <c:pt idx="1434">
                  <c:v>403.05</c:v>
                </c:pt>
                <c:pt idx="1435">
                  <c:v>403.34</c:v>
                </c:pt>
                <c:pt idx="1436">
                  <c:v>403.61</c:v>
                </c:pt>
                <c:pt idx="1437">
                  <c:v>403.9</c:v>
                </c:pt>
                <c:pt idx="1438">
                  <c:v>404.18</c:v>
                </c:pt>
                <c:pt idx="1439">
                  <c:v>404.46</c:v>
                </c:pt>
                <c:pt idx="1440">
                  <c:v>404.74</c:v>
                </c:pt>
                <c:pt idx="1441">
                  <c:v>405.02</c:v>
                </c:pt>
                <c:pt idx="1442">
                  <c:v>405.3</c:v>
                </c:pt>
                <c:pt idx="1443">
                  <c:v>405.58</c:v>
                </c:pt>
                <c:pt idx="1444">
                  <c:v>405.86</c:v>
                </c:pt>
                <c:pt idx="1445">
                  <c:v>406.14</c:v>
                </c:pt>
                <c:pt idx="1446">
                  <c:v>406.42</c:v>
                </c:pt>
                <c:pt idx="1447">
                  <c:v>406.71</c:v>
                </c:pt>
                <c:pt idx="1448">
                  <c:v>406.98</c:v>
                </c:pt>
                <c:pt idx="1449">
                  <c:v>407.26</c:v>
                </c:pt>
                <c:pt idx="1450">
                  <c:v>407.54</c:v>
                </c:pt>
                <c:pt idx="1451">
                  <c:v>407.83</c:v>
                </c:pt>
                <c:pt idx="1452">
                  <c:v>408.11</c:v>
                </c:pt>
                <c:pt idx="1453">
                  <c:v>408.39</c:v>
                </c:pt>
                <c:pt idx="1454">
                  <c:v>408.67</c:v>
                </c:pt>
                <c:pt idx="1455">
                  <c:v>408.95</c:v>
                </c:pt>
                <c:pt idx="1456">
                  <c:v>409.23</c:v>
                </c:pt>
                <c:pt idx="1457">
                  <c:v>409.51</c:v>
                </c:pt>
                <c:pt idx="1458">
                  <c:v>409.79</c:v>
                </c:pt>
                <c:pt idx="1459">
                  <c:v>410.07</c:v>
                </c:pt>
                <c:pt idx="1460">
                  <c:v>410.36</c:v>
                </c:pt>
                <c:pt idx="1461">
                  <c:v>410.64</c:v>
                </c:pt>
                <c:pt idx="1462">
                  <c:v>410.92</c:v>
                </c:pt>
                <c:pt idx="1463">
                  <c:v>411.2</c:v>
                </c:pt>
                <c:pt idx="1464">
                  <c:v>411.48</c:v>
                </c:pt>
                <c:pt idx="1465">
                  <c:v>411.76</c:v>
                </c:pt>
                <c:pt idx="1466">
                  <c:v>412.04</c:v>
                </c:pt>
                <c:pt idx="1467">
                  <c:v>412.32</c:v>
                </c:pt>
                <c:pt idx="1468">
                  <c:v>412.6</c:v>
                </c:pt>
                <c:pt idx="1469">
                  <c:v>412.88</c:v>
                </c:pt>
                <c:pt idx="1470">
                  <c:v>413.16</c:v>
                </c:pt>
                <c:pt idx="1471">
                  <c:v>413.44</c:v>
                </c:pt>
                <c:pt idx="1472">
                  <c:v>413.73</c:v>
                </c:pt>
                <c:pt idx="1473">
                  <c:v>414</c:v>
                </c:pt>
                <c:pt idx="1474">
                  <c:v>414.28</c:v>
                </c:pt>
                <c:pt idx="1475">
                  <c:v>414.56</c:v>
                </c:pt>
                <c:pt idx="1476">
                  <c:v>414.85</c:v>
                </c:pt>
                <c:pt idx="1477">
                  <c:v>415.13</c:v>
                </c:pt>
                <c:pt idx="1478">
                  <c:v>415.41</c:v>
                </c:pt>
                <c:pt idx="1479">
                  <c:v>415.69</c:v>
                </c:pt>
                <c:pt idx="1480">
                  <c:v>415.97</c:v>
                </c:pt>
                <c:pt idx="1481">
                  <c:v>416.25</c:v>
                </c:pt>
                <c:pt idx="1482">
                  <c:v>416.53</c:v>
                </c:pt>
                <c:pt idx="1483">
                  <c:v>416.81</c:v>
                </c:pt>
                <c:pt idx="1484">
                  <c:v>417.1</c:v>
                </c:pt>
                <c:pt idx="1485">
                  <c:v>417.38</c:v>
                </c:pt>
                <c:pt idx="1486">
                  <c:v>417.65</c:v>
                </c:pt>
                <c:pt idx="1487">
                  <c:v>417.94</c:v>
                </c:pt>
                <c:pt idx="1488">
                  <c:v>418.22</c:v>
                </c:pt>
                <c:pt idx="1489">
                  <c:v>418.5</c:v>
                </c:pt>
                <c:pt idx="1490">
                  <c:v>418.78</c:v>
                </c:pt>
                <c:pt idx="1491">
                  <c:v>419.06</c:v>
                </c:pt>
                <c:pt idx="1492">
                  <c:v>419.34</c:v>
                </c:pt>
                <c:pt idx="1493">
                  <c:v>419.62</c:v>
                </c:pt>
                <c:pt idx="1494">
                  <c:v>419.9</c:v>
                </c:pt>
                <c:pt idx="1495">
                  <c:v>420.18</c:v>
                </c:pt>
                <c:pt idx="1496">
                  <c:v>420.83</c:v>
                </c:pt>
                <c:pt idx="1497">
                  <c:v>421.05</c:v>
                </c:pt>
                <c:pt idx="1498">
                  <c:v>421.3</c:v>
                </c:pt>
                <c:pt idx="1499">
                  <c:v>421.58</c:v>
                </c:pt>
                <c:pt idx="1500">
                  <c:v>421.87</c:v>
                </c:pt>
                <c:pt idx="1501">
                  <c:v>422.15</c:v>
                </c:pt>
                <c:pt idx="1502">
                  <c:v>422.43</c:v>
                </c:pt>
                <c:pt idx="1503">
                  <c:v>422.71</c:v>
                </c:pt>
                <c:pt idx="1504">
                  <c:v>422.99</c:v>
                </c:pt>
                <c:pt idx="1505">
                  <c:v>423.27</c:v>
                </c:pt>
                <c:pt idx="1506">
                  <c:v>423.55</c:v>
                </c:pt>
                <c:pt idx="1507">
                  <c:v>423.83</c:v>
                </c:pt>
                <c:pt idx="1508">
                  <c:v>424.11</c:v>
                </c:pt>
                <c:pt idx="1509">
                  <c:v>424.39</c:v>
                </c:pt>
                <c:pt idx="1510">
                  <c:v>424.67</c:v>
                </c:pt>
                <c:pt idx="1511">
                  <c:v>424.95</c:v>
                </c:pt>
                <c:pt idx="1512">
                  <c:v>425.24</c:v>
                </c:pt>
                <c:pt idx="1513">
                  <c:v>425.52</c:v>
                </c:pt>
                <c:pt idx="1514">
                  <c:v>425.8</c:v>
                </c:pt>
                <c:pt idx="1515">
                  <c:v>426.08</c:v>
                </c:pt>
                <c:pt idx="1516">
                  <c:v>426.36</c:v>
                </c:pt>
                <c:pt idx="1517">
                  <c:v>426.64</c:v>
                </c:pt>
                <c:pt idx="1518">
                  <c:v>426.92</c:v>
                </c:pt>
                <c:pt idx="1519">
                  <c:v>427.2</c:v>
                </c:pt>
                <c:pt idx="1520">
                  <c:v>427.48</c:v>
                </c:pt>
                <c:pt idx="1521">
                  <c:v>427.77</c:v>
                </c:pt>
                <c:pt idx="1522">
                  <c:v>428.05</c:v>
                </c:pt>
                <c:pt idx="1523">
                  <c:v>428.32</c:v>
                </c:pt>
                <c:pt idx="1524">
                  <c:v>428.6</c:v>
                </c:pt>
                <c:pt idx="1525">
                  <c:v>428.89</c:v>
                </c:pt>
                <c:pt idx="1526">
                  <c:v>429.17</c:v>
                </c:pt>
                <c:pt idx="1527">
                  <c:v>429.45</c:v>
                </c:pt>
                <c:pt idx="1528">
                  <c:v>429.73</c:v>
                </c:pt>
                <c:pt idx="1529">
                  <c:v>430.01</c:v>
                </c:pt>
                <c:pt idx="1530">
                  <c:v>430.29</c:v>
                </c:pt>
                <c:pt idx="1531">
                  <c:v>430.57</c:v>
                </c:pt>
                <c:pt idx="1532">
                  <c:v>430.86</c:v>
                </c:pt>
                <c:pt idx="1533">
                  <c:v>431.13</c:v>
                </c:pt>
                <c:pt idx="1534">
                  <c:v>431.41</c:v>
                </c:pt>
                <c:pt idx="1535">
                  <c:v>431.69</c:v>
                </c:pt>
                <c:pt idx="1536">
                  <c:v>431.98</c:v>
                </c:pt>
                <c:pt idx="1537">
                  <c:v>432.26</c:v>
                </c:pt>
                <c:pt idx="1538">
                  <c:v>432.54</c:v>
                </c:pt>
                <c:pt idx="1539">
                  <c:v>432.82</c:v>
                </c:pt>
                <c:pt idx="1540">
                  <c:v>433.1</c:v>
                </c:pt>
                <c:pt idx="1541">
                  <c:v>433.38</c:v>
                </c:pt>
                <c:pt idx="1542">
                  <c:v>433.66</c:v>
                </c:pt>
                <c:pt idx="1543">
                  <c:v>433.94</c:v>
                </c:pt>
                <c:pt idx="1544">
                  <c:v>434.22</c:v>
                </c:pt>
                <c:pt idx="1545">
                  <c:v>434.5</c:v>
                </c:pt>
                <c:pt idx="1546">
                  <c:v>434.78</c:v>
                </c:pt>
                <c:pt idx="1547">
                  <c:v>435.07</c:v>
                </c:pt>
                <c:pt idx="1548">
                  <c:v>435.35</c:v>
                </c:pt>
                <c:pt idx="1549">
                  <c:v>435.63</c:v>
                </c:pt>
                <c:pt idx="1550">
                  <c:v>435.91</c:v>
                </c:pt>
                <c:pt idx="1551">
                  <c:v>436.19</c:v>
                </c:pt>
                <c:pt idx="1552">
                  <c:v>436.47</c:v>
                </c:pt>
                <c:pt idx="1553">
                  <c:v>436.75</c:v>
                </c:pt>
                <c:pt idx="1554">
                  <c:v>437.03</c:v>
                </c:pt>
                <c:pt idx="1555">
                  <c:v>437.31</c:v>
                </c:pt>
                <c:pt idx="1556">
                  <c:v>437.59</c:v>
                </c:pt>
                <c:pt idx="1557">
                  <c:v>437.87</c:v>
                </c:pt>
                <c:pt idx="1558">
                  <c:v>438.15</c:v>
                </c:pt>
                <c:pt idx="1559">
                  <c:v>438.44</c:v>
                </c:pt>
                <c:pt idx="1560">
                  <c:v>438.72</c:v>
                </c:pt>
                <c:pt idx="1561">
                  <c:v>438.99</c:v>
                </c:pt>
                <c:pt idx="1562">
                  <c:v>439.28</c:v>
                </c:pt>
                <c:pt idx="1563">
                  <c:v>439.56</c:v>
                </c:pt>
                <c:pt idx="1564">
                  <c:v>439.84</c:v>
                </c:pt>
                <c:pt idx="1565">
                  <c:v>440.12</c:v>
                </c:pt>
                <c:pt idx="1566">
                  <c:v>440.4</c:v>
                </c:pt>
                <c:pt idx="1567">
                  <c:v>440.68</c:v>
                </c:pt>
                <c:pt idx="1568">
                  <c:v>440.96</c:v>
                </c:pt>
                <c:pt idx="1569">
                  <c:v>441.24</c:v>
                </c:pt>
                <c:pt idx="1570">
                  <c:v>441.53</c:v>
                </c:pt>
                <c:pt idx="1571">
                  <c:v>441.81</c:v>
                </c:pt>
                <c:pt idx="1572">
                  <c:v>442.08</c:v>
                </c:pt>
                <c:pt idx="1573">
                  <c:v>442.37</c:v>
                </c:pt>
                <c:pt idx="1574">
                  <c:v>442.64</c:v>
                </c:pt>
                <c:pt idx="1575">
                  <c:v>442.92</c:v>
                </c:pt>
                <c:pt idx="1576">
                  <c:v>443.21</c:v>
                </c:pt>
                <c:pt idx="1577">
                  <c:v>443.49</c:v>
                </c:pt>
                <c:pt idx="1578">
                  <c:v>443.77</c:v>
                </c:pt>
                <c:pt idx="1579">
                  <c:v>444.05</c:v>
                </c:pt>
                <c:pt idx="1580">
                  <c:v>444.33</c:v>
                </c:pt>
                <c:pt idx="1581">
                  <c:v>444.61</c:v>
                </c:pt>
                <c:pt idx="1582">
                  <c:v>444.89</c:v>
                </c:pt>
                <c:pt idx="1583">
                  <c:v>445.17</c:v>
                </c:pt>
                <c:pt idx="1584">
                  <c:v>445.45</c:v>
                </c:pt>
                <c:pt idx="1585">
                  <c:v>445.74</c:v>
                </c:pt>
                <c:pt idx="1586">
                  <c:v>446.02</c:v>
                </c:pt>
                <c:pt idx="1587">
                  <c:v>446.3</c:v>
                </c:pt>
                <c:pt idx="1588">
                  <c:v>446.58</c:v>
                </c:pt>
                <c:pt idx="1589">
                  <c:v>446.86</c:v>
                </c:pt>
                <c:pt idx="1590">
                  <c:v>447.14</c:v>
                </c:pt>
                <c:pt idx="1591">
                  <c:v>447.42</c:v>
                </c:pt>
                <c:pt idx="1592">
                  <c:v>447.7</c:v>
                </c:pt>
                <c:pt idx="1593">
                  <c:v>447.98</c:v>
                </c:pt>
                <c:pt idx="1594">
                  <c:v>448.26</c:v>
                </c:pt>
                <c:pt idx="1595">
                  <c:v>448.54</c:v>
                </c:pt>
                <c:pt idx="1596">
                  <c:v>448.82</c:v>
                </c:pt>
                <c:pt idx="1597">
                  <c:v>449.1</c:v>
                </c:pt>
                <c:pt idx="1598">
                  <c:v>449.38</c:v>
                </c:pt>
                <c:pt idx="1599">
                  <c:v>449.67</c:v>
                </c:pt>
                <c:pt idx="1600">
                  <c:v>449.95</c:v>
                </c:pt>
                <c:pt idx="1601">
                  <c:v>450.23</c:v>
                </c:pt>
                <c:pt idx="1602">
                  <c:v>450.51</c:v>
                </c:pt>
                <c:pt idx="1603">
                  <c:v>450.79</c:v>
                </c:pt>
                <c:pt idx="1604">
                  <c:v>451.07</c:v>
                </c:pt>
                <c:pt idx="1605">
                  <c:v>451.35</c:v>
                </c:pt>
                <c:pt idx="1606">
                  <c:v>451.63</c:v>
                </c:pt>
                <c:pt idx="1607">
                  <c:v>451.91</c:v>
                </c:pt>
                <c:pt idx="1608">
                  <c:v>452.2</c:v>
                </c:pt>
                <c:pt idx="1609">
                  <c:v>452.47</c:v>
                </c:pt>
                <c:pt idx="1610">
                  <c:v>452.75</c:v>
                </c:pt>
                <c:pt idx="1611">
                  <c:v>453.04</c:v>
                </c:pt>
                <c:pt idx="1612">
                  <c:v>453.32</c:v>
                </c:pt>
                <c:pt idx="1613">
                  <c:v>453.6</c:v>
                </c:pt>
                <c:pt idx="1614">
                  <c:v>453.88</c:v>
                </c:pt>
                <c:pt idx="1615">
                  <c:v>454.16</c:v>
                </c:pt>
                <c:pt idx="1616">
                  <c:v>454.44</c:v>
                </c:pt>
                <c:pt idx="1617">
                  <c:v>454.72</c:v>
                </c:pt>
                <c:pt idx="1618">
                  <c:v>455</c:v>
                </c:pt>
                <c:pt idx="1619">
                  <c:v>455.28</c:v>
                </c:pt>
                <c:pt idx="1620">
                  <c:v>455.57</c:v>
                </c:pt>
                <c:pt idx="1621">
                  <c:v>455.85</c:v>
                </c:pt>
                <c:pt idx="1622">
                  <c:v>456.12</c:v>
                </c:pt>
                <c:pt idx="1623">
                  <c:v>456.41</c:v>
                </c:pt>
                <c:pt idx="1624">
                  <c:v>456.68</c:v>
                </c:pt>
                <c:pt idx="1625">
                  <c:v>456.96</c:v>
                </c:pt>
                <c:pt idx="1626">
                  <c:v>457.25</c:v>
                </c:pt>
                <c:pt idx="1627">
                  <c:v>457.53</c:v>
                </c:pt>
                <c:pt idx="1628">
                  <c:v>457.81</c:v>
                </c:pt>
                <c:pt idx="1629">
                  <c:v>458.09</c:v>
                </c:pt>
                <c:pt idx="1630">
                  <c:v>458.37</c:v>
                </c:pt>
                <c:pt idx="1631">
                  <c:v>458.65</c:v>
                </c:pt>
                <c:pt idx="1632">
                  <c:v>458.93</c:v>
                </c:pt>
                <c:pt idx="1633">
                  <c:v>459.21</c:v>
                </c:pt>
                <c:pt idx="1634">
                  <c:v>459.49</c:v>
                </c:pt>
                <c:pt idx="1635">
                  <c:v>459.78</c:v>
                </c:pt>
                <c:pt idx="1636">
                  <c:v>460.06</c:v>
                </c:pt>
                <c:pt idx="1637">
                  <c:v>460.34</c:v>
                </c:pt>
                <c:pt idx="1638">
                  <c:v>460.62</c:v>
                </c:pt>
                <c:pt idx="1639">
                  <c:v>460.9</c:v>
                </c:pt>
                <c:pt idx="1640">
                  <c:v>461.18</c:v>
                </c:pt>
                <c:pt idx="1641">
                  <c:v>461.46</c:v>
                </c:pt>
                <c:pt idx="1642">
                  <c:v>461.74</c:v>
                </c:pt>
                <c:pt idx="1643">
                  <c:v>462.02</c:v>
                </c:pt>
                <c:pt idx="1644">
                  <c:v>462.3</c:v>
                </c:pt>
                <c:pt idx="1645">
                  <c:v>462.59</c:v>
                </c:pt>
                <c:pt idx="1646">
                  <c:v>462.86</c:v>
                </c:pt>
                <c:pt idx="1647">
                  <c:v>463.14</c:v>
                </c:pt>
                <c:pt idx="1648">
                  <c:v>463.42</c:v>
                </c:pt>
                <c:pt idx="1649">
                  <c:v>463.7</c:v>
                </c:pt>
                <c:pt idx="1650">
                  <c:v>463.99</c:v>
                </c:pt>
                <c:pt idx="1651">
                  <c:v>464.27</c:v>
                </c:pt>
                <c:pt idx="1652">
                  <c:v>464.55</c:v>
                </c:pt>
                <c:pt idx="1653">
                  <c:v>464.83</c:v>
                </c:pt>
                <c:pt idx="1654">
                  <c:v>465.11</c:v>
                </c:pt>
                <c:pt idx="1655">
                  <c:v>465.39</c:v>
                </c:pt>
                <c:pt idx="1656">
                  <c:v>465.67</c:v>
                </c:pt>
                <c:pt idx="1657">
                  <c:v>465.95</c:v>
                </c:pt>
                <c:pt idx="1658">
                  <c:v>466.23</c:v>
                </c:pt>
                <c:pt idx="1659">
                  <c:v>466.51</c:v>
                </c:pt>
                <c:pt idx="1660">
                  <c:v>466.8</c:v>
                </c:pt>
                <c:pt idx="1661">
                  <c:v>467.08</c:v>
                </c:pt>
                <c:pt idx="1662">
                  <c:v>467.36</c:v>
                </c:pt>
                <c:pt idx="1663">
                  <c:v>467.64</c:v>
                </c:pt>
                <c:pt idx="1664">
                  <c:v>467.92</c:v>
                </c:pt>
                <c:pt idx="1665">
                  <c:v>468.2</c:v>
                </c:pt>
                <c:pt idx="1666">
                  <c:v>468.48</c:v>
                </c:pt>
                <c:pt idx="1667">
                  <c:v>468.76</c:v>
                </c:pt>
                <c:pt idx="1668">
                  <c:v>469.04</c:v>
                </c:pt>
                <c:pt idx="1669">
                  <c:v>469.32</c:v>
                </c:pt>
                <c:pt idx="1670">
                  <c:v>469.61</c:v>
                </c:pt>
                <c:pt idx="1671">
                  <c:v>469.89</c:v>
                </c:pt>
                <c:pt idx="1672">
                  <c:v>470.17</c:v>
                </c:pt>
                <c:pt idx="1673">
                  <c:v>470.44</c:v>
                </c:pt>
                <c:pt idx="1674">
                  <c:v>470.72</c:v>
                </c:pt>
                <c:pt idx="1675">
                  <c:v>471.01</c:v>
                </c:pt>
                <c:pt idx="1676">
                  <c:v>471.29</c:v>
                </c:pt>
                <c:pt idx="1677">
                  <c:v>471.57</c:v>
                </c:pt>
                <c:pt idx="1678">
                  <c:v>471.85</c:v>
                </c:pt>
                <c:pt idx="1679">
                  <c:v>472.13</c:v>
                </c:pt>
                <c:pt idx="1680">
                  <c:v>472.41</c:v>
                </c:pt>
                <c:pt idx="1681">
                  <c:v>472.69</c:v>
                </c:pt>
                <c:pt idx="1682">
                  <c:v>472.97</c:v>
                </c:pt>
                <c:pt idx="1683">
                  <c:v>473.26</c:v>
                </c:pt>
                <c:pt idx="1684">
                  <c:v>473.53</c:v>
                </c:pt>
                <c:pt idx="1685">
                  <c:v>473.81</c:v>
                </c:pt>
                <c:pt idx="1686">
                  <c:v>474.1</c:v>
                </c:pt>
                <c:pt idx="1687">
                  <c:v>474.38</c:v>
                </c:pt>
                <c:pt idx="1688">
                  <c:v>474.66</c:v>
                </c:pt>
                <c:pt idx="1689">
                  <c:v>474.94</c:v>
                </c:pt>
                <c:pt idx="1690">
                  <c:v>475.22</c:v>
                </c:pt>
                <c:pt idx="1691">
                  <c:v>475.5</c:v>
                </c:pt>
                <c:pt idx="1692">
                  <c:v>475.78</c:v>
                </c:pt>
                <c:pt idx="1693">
                  <c:v>476.06</c:v>
                </c:pt>
                <c:pt idx="1694">
                  <c:v>476.34</c:v>
                </c:pt>
                <c:pt idx="1695">
                  <c:v>476.63</c:v>
                </c:pt>
                <c:pt idx="1696">
                  <c:v>476.9</c:v>
                </c:pt>
                <c:pt idx="1697">
                  <c:v>477.18</c:v>
                </c:pt>
                <c:pt idx="1698">
                  <c:v>477.46</c:v>
                </c:pt>
                <c:pt idx="1699">
                  <c:v>477.75</c:v>
                </c:pt>
                <c:pt idx="1700">
                  <c:v>478.03</c:v>
                </c:pt>
                <c:pt idx="1701">
                  <c:v>478.31</c:v>
                </c:pt>
                <c:pt idx="1702">
                  <c:v>478.59</c:v>
                </c:pt>
                <c:pt idx="1703">
                  <c:v>478.87</c:v>
                </c:pt>
                <c:pt idx="1704">
                  <c:v>479.15</c:v>
                </c:pt>
                <c:pt idx="1705">
                  <c:v>479.43</c:v>
                </c:pt>
                <c:pt idx="1706">
                  <c:v>479.71</c:v>
                </c:pt>
                <c:pt idx="1707">
                  <c:v>480</c:v>
                </c:pt>
                <c:pt idx="1708">
                  <c:v>480.28</c:v>
                </c:pt>
                <c:pt idx="1709">
                  <c:v>480.55</c:v>
                </c:pt>
                <c:pt idx="1710">
                  <c:v>480.84</c:v>
                </c:pt>
                <c:pt idx="1711">
                  <c:v>481.12</c:v>
                </c:pt>
                <c:pt idx="1712">
                  <c:v>481.4</c:v>
                </c:pt>
                <c:pt idx="1713">
                  <c:v>481.68</c:v>
                </c:pt>
                <c:pt idx="1714">
                  <c:v>481.96</c:v>
                </c:pt>
                <c:pt idx="1715">
                  <c:v>482.24</c:v>
                </c:pt>
                <c:pt idx="1716">
                  <c:v>482.52</c:v>
                </c:pt>
                <c:pt idx="1717">
                  <c:v>482.8</c:v>
                </c:pt>
                <c:pt idx="1718">
                  <c:v>483.08</c:v>
                </c:pt>
                <c:pt idx="1719">
                  <c:v>483.37</c:v>
                </c:pt>
                <c:pt idx="1720">
                  <c:v>483.64</c:v>
                </c:pt>
                <c:pt idx="1721">
                  <c:v>483.92</c:v>
                </c:pt>
                <c:pt idx="1722">
                  <c:v>484.21</c:v>
                </c:pt>
                <c:pt idx="1723">
                  <c:v>484.49</c:v>
                </c:pt>
                <c:pt idx="1724">
                  <c:v>484.77</c:v>
                </c:pt>
                <c:pt idx="1725">
                  <c:v>485.05</c:v>
                </c:pt>
                <c:pt idx="1726">
                  <c:v>485.33</c:v>
                </c:pt>
                <c:pt idx="1727">
                  <c:v>485.61</c:v>
                </c:pt>
                <c:pt idx="1728">
                  <c:v>485.89</c:v>
                </c:pt>
                <c:pt idx="1729">
                  <c:v>486.17</c:v>
                </c:pt>
                <c:pt idx="1730">
                  <c:v>486.45</c:v>
                </c:pt>
                <c:pt idx="1731">
                  <c:v>486.74</c:v>
                </c:pt>
                <c:pt idx="1732">
                  <c:v>487.01</c:v>
                </c:pt>
                <c:pt idx="1733">
                  <c:v>487.29</c:v>
                </c:pt>
                <c:pt idx="1734">
                  <c:v>487.58</c:v>
                </c:pt>
                <c:pt idx="1735">
                  <c:v>487.86</c:v>
                </c:pt>
                <c:pt idx="1736">
                  <c:v>488.13</c:v>
                </c:pt>
                <c:pt idx="1737">
                  <c:v>488.42</c:v>
                </c:pt>
                <c:pt idx="1738">
                  <c:v>488.7</c:v>
                </c:pt>
                <c:pt idx="1739">
                  <c:v>488.98</c:v>
                </c:pt>
                <c:pt idx="1740">
                  <c:v>489.26</c:v>
                </c:pt>
                <c:pt idx="1741">
                  <c:v>489.54</c:v>
                </c:pt>
                <c:pt idx="1742">
                  <c:v>489.82</c:v>
                </c:pt>
                <c:pt idx="1743">
                  <c:v>490.1</c:v>
                </c:pt>
                <c:pt idx="1744">
                  <c:v>490.38</c:v>
                </c:pt>
                <c:pt idx="1745">
                  <c:v>490.66</c:v>
                </c:pt>
                <c:pt idx="1746">
                  <c:v>490.94</c:v>
                </c:pt>
                <c:pt idx="1747">
                  <c:v>491.22</c:v>
                </c:pt>
                <c:pt idx="1748">
                  <c:v>491.5</c:v>
                </c:pt>
                <c:pt idx="1749">
                  <c:v>491.79</c:v>
                </c:pt>
                <c:pt idx="1750">
                  <c:v>492.07</c:v>
                </c:pt>
                <c:pt idx="1751">
                  <c:v>492.35</c:v>
                </c:pt>
                <c:pt idx="1752">
                  <c:v>492.63</c:v>
                </c:pt>
                <c:pt idx="1753">
                  <c:v>492.91</c:v>
                </c:pt>
                <c:pt idx="1754">
                  <c:v>493.19</c:v>
                </c:pt>
                <c:pt idx="1755">
                  <c:v>493.47</c:v>
                </c:pt>
                <c:pt idx="1756">
                  <c:v>493.75</c:v>
                </c:pt>
                <c:pt idx="1757">
                  <c:v>494.03</c:v>
                </c:pt>
                <c:pt idx="1758">
                  <c:v>494.32</c:v>
                </c:pt>
                <c:pt idx="1759">
                  <c:v>494.6</c:v>
                </c:pt>
                <c:pt idx="1760">
                  <c:v>494.87</c:v>
                </c:pt>
                <c:pt idx="1761">
                  <c:v>495.15</c:v>
                </c:pt>
                <c:pt idx="1762">
                  <c:v>495.44</c:v>
                </c:pt>
                <c:pt idx="1763">
                  <c:v>495.72</c:v>
                </c:pt>
                <c:pt idx="1764">
                  <c:v>496</c:v>
                </c:pt>
                <c:pt idx="1765">
                  <c:v>496.28</c:v>
                </c:pt>
                <c:pt idx="1766">
                  <c:v>496.56</c:v>
                </c:pt>
                <c:pt idx="1767">
                  <c:v>496.84</c:v>
                </c:pt>
                <c:pt idx="1768">
                  <c:v>497.12</c:v>
                </c:pt>
                <c:pt idx="1769">
                  <c:v>497.4</c:v>
                </c:pt>
                <c:pt idx="1770">
                  <c:v>497.68</c:v>
                </c:pt>
                <c:pt idx="1771">
                  <c:v>497.97</c:v>
                </c:pt>
                <c:pt idx="1772">
                  <c:v>498.24</c:v>
                </c:pt>
                <c:pt idx="1773">
                  <c:v>498.53</c:v>
                </c:pt>
                <c:pt idx="1774">
                  <c:v>498.81</c:v>
                </c:pt>
                <c:pt idx="1775">
                  <c:v>499.09</c:v>
                </c:pt>
                <c:pt idx="1776">
                  <c:v>499.37</c:v>
                </c:pt>
                <c:pt idx="1777">
                  <c:v>499.65</c:v>
                </c:pt>
                <c:pt idx="1778">
                  <c:v>499.93</c:v>
                </c:pt>
                <c:pt idx="1779">
                  <c:v>500.21</c:v>
                </c:pt>
                <c:pt idx="1780">
                  <c:v>500.49</c:v>
                </c:pt>
                <c:pt idx="1781">
                  <c:v>500.77</c:v>
                </c:pt>
                <c:pt idx="1782">
                  <c:v>501.05</c:v>
                </c:pt>
                <c:pt idx="1783">
                  <c:v>501.34</c:v>
                </c:pt>
                <c:pt idx="1784">
                  <c:v>501.62</c:v>
                </c:pt>
                <c:pt idx="1785">
                  <c:v>501.89</c:v>
                </c:pt>
                <c:pt idx="1786">
                  <c:v>502.17</c:v>
                </c:pt>
                <c:pt idx="1787">
                  <c:v>502.46</c:v>
                </c:pt>
                <c:pt idx="1788">
                  <c:v>502.74</c:v>
                </c:pt>
                <c:pt idx="1789">
                  <c:v>503.02</c:v>
                </c:pt>
                <c:pt idx="1790">
                  <c:v>503.3</c:v>
                </c:pt>
                <c:pt idx="1791">
                  <c:v>503.58</c:v>
                </c:pt>
                <c:pt idx="1792">
                  <c:v>503.86</c:v>
                </c:pt>
                <c:pt idx="1793">
                  <c:v>504.14</c:v>
                </c:pt>
                <c:pt idx="1794">
                  <c:v>504.42</c:v>
                </c:pt>
                <c:pt idx="1795">
                  <c:v>504.7</c:v>
                </c:pt>
                <c:pt idx="1796">
                  <c:v>504.98</c:v>
                </c:pt>
                <c:pt idx="1797">
                  <c:v>505.26</c:v>
                </c:pt>
                <c:pt idx="1798">
                  <c:v>505.55</c:v>
                </c:pt>
                <c:pt idx="1799">
                  <c:v>505.83</c:v>
                </c:pt>
                <c:pt idx="1800">
                  <c:v>506.11</c:v>
                </c:pt>
                <c:pt idx="1801">
                  <c:v>506.39</c:v>
                </c:pt>
                <c:pt idx="1802">
                  <c:v>506.67</c:v>
                </c:pt>
                <c:pt idx="1803">
                  <c:v>506.95</c:v>
                </c:pt>
                <c:pt idx="1804">
                  <c:v>507.23</c:v>
                </c:pt>
                <c:pt idx="1805">
                  <c:v>507.51</c:v>
                </c:pt>
                <c:pt idx="1806">
                  <c:v>507.79</c:v>
                </c:pt>
                <c:pt idx="1807">
                  <c:v>508.07</c:v>
                </c:pt>
                <c:pt idx="1808">
                  <c:v>508.35</c:v>
                </c:pt>
                <c:pt idx="1809">
                  <c:v>508.63</c:v>
                </c:pt>
                <c:pt idx="1810">
                  <c:v>508.91</c:v>
                </c:pt>
                <c:pt idx="1811">
                  <c:v>509.19</c:v>
                </c:pt>
                <c:pt idx="1812">
                  <c:v>509.48</c:v>
                </c:pt>
                <c:pt idx="1813">
                  <c:v>509.76</c:v>
                </c:pt>
                <c:pt idx="1814">
                  <c:v>510.04</c:v>
                </c:pt>
                <c:pt idx="1815">
                  <c:v>510.32</c:v>
                </c:pt>
                <c:pt idx="1816">
                  <c:v>510.6</c:v>
                </c:pt>
                <c:pt idx="1817">
                  <c:v>510.88</c:v>
                </c:pt>
                <c:pt idx="1818">
                  <c:v>511.16</c:v>
                </c:pt>
                <c:pt idx="1819">
                  <c:v>511.44</c:v>
                </c:pt>
                <c:pt idx="1820">
                  <c:v>511.72</c:v>
                </c:pt>
                <c:pt idx="1821">
                  <c:v>512</c:v>
                </c:pt>
                <c:pt idx="1822">
                  <c:v>512.29</c:v>
                </c:pt>
                <c:pt idx="1823">
                  <c:v>512.57000000000005</c:v>
                </c:pt>
                <c:pt idx="1824">
                  <c:v>512.85</c:v>
                </c:pt>
                <c:pt idx="1825">
                  <c:v>513.13</c:v>
                </c:pt>
                <c:pt idx="1826">
                  <c:v>513.41</c:v>
                </c:pt>
                <c:pt idx="1827">
                  <c:v>513.69000000000005</c:v>
                </c:pt>
                <c:pt idx="1828">
                  <c:v>513.97</c:v>
                </c:pt>
                <c:pt idx="1829">
                  <c:v>514.25</c:v>
                </c:pt>
                <c:pt idx="1830">
                  <c:v>514.53</c:v>
                </c:pt>
                <c:pt idx="1831">
                  <c:v>514.80999999999995</c:v>
                </c:pt>
                <c:pt idx="1832">
                  <c:v>515.09</c:v>
                </c:pt>
                <c:pt idx="1833">
                  <c:v>515.37</c:v>
                </c:pt>
                <c:pt idx="1834">
                  <c:v>515.65</c:v>
                </c:pt>
                <c:pt idx="1835">
                  <c:v>515.92999999999995</c:v>
                </c:pt>
                <c:pt idx="1836">
                  <c:v>516.22</c:v>
                </c:pt>
                <c:pt idx="1837">
                  <c:v>516.5</c:v>
                </c:pt>
                <c:pt idx="1838">
                  <c:v>516.78</c:v>
                </c:pt>
                <c:pt idx="1839">
                  <c:v>517.05999999999995</c:v>
                </c:pt>
                <c:pt idx="1840">
                  <c:v>517.34</c:v>
                </c:pt>
                <c:pt idx="1841">
                  <c:v>517.62</c:v>
                </c:pt>
                <c:pt idx="1842">
                  <c:v>517.9</c:v>
                </c:pt>
                <c:pt idx="1843">
                  <c:v>518.17999999999995</c:v>
                </c:pt>
                <c:pt idx="1844">
                  <c:v>518.46</c:v>
                </c:pt>
                <c:pt idx="1845">
                  <c:v>518.75</c:v>
                </c:pt>
                <c:pt idx="1846">
                  <c:v>519.02</c:v>
                </c:pt>
                <c:pt idx="1847">
                  <c:v>519.29999999999995</c:v>
                </c:pt>
                <c:pt idx="1848">
                  <c:v>519.58000000000004</c:v>
                </c:pt>
                <c:pt idx="1849">
                  <c:v>519.87</c:v>
                </c:pt>
                <c:pt idx="1850">
                  <c:v>520.15</c:v>
                </c:pt>
                <c:pt idx="1851">
                  <c:v>520.42999999999995</c:v>
                </c:pt>
                <c:pt idx="1852">
                  <c:v>520.71</c:v>
                </c:pt>
                <c:pt idx="1853">
                  <c:v>520.99</c:v>
                </c:pt>
                <c:pt idx="1854">
                  <c:v>521.27</c:v>
                </c:pt>
                <c:pt idx="1855">
                  <c:v>521.54999999999995</c:v>
                </c:pt>
                <c:pt idx="1856">
                  <c:v>521.83000000000004</c:v>
                </c:pt>
                <c:pt idx="1857">
                  <c:v>522.11</c:v>
                </c:pt>
                <c:pt idx="1858">
                  <c:v>522.4</c:v>
                </c:pt>
                <c:pt idx="1859">
                  <c:v>522.67999999999995</c:v>
                </c:pt>
                <c:pt idx="1860">
                  <c:v>522.95000000000005</c:v>
                </c:pt>
                <c:pt idx="1861">
                  <c:v>523.24</c:v>
                </c:pt>
                <c:pt idx="1862">
                  <c:v>523.52</c:v>
                </c:pt>
                <c:pt idx="1863">
                  <c:v>523.79999999999995</c:v>
                </c:pt>
                <c:pt idx="1864">
                  <c:v>524.08000000000004</c:v>
                </c:pt>
                <c:pt idx="1865">
                  <c:v>524.36</c:v>
                </c:pt>
                <c:pt idx="1866">
                  <c:v>524.64</c:v>
                </c:pt>
                <c:pt idx="1867">
                  <c:v>524.91999999999996</c:v>
                </c:pt>
                <c:pt idx="1868">
                  <c:v>525.20000000000005</c:v>
                </c:pt>
                <c:pt idx="1869">
                  <c:v>525.49</c:v>
                </c:pt>
                <c:pt idx="1870">
                  <c:v>525.77</c:v>
                </c:pt>
                <c:pt idx="1871">
                  <c:v>526.04</c:v>
                </c:pt>
                <c:pt idx="1872">
                  <c:v>526.32000000000005</c:v>
                </c:pt>
                <c:pt idx="1873">
                  <c:v>526.61</c:v>
                </c:pt>
                <c:pt idx="1874">
                  <c:v>526.88</c:v>
                </c:pt>
                <c:pt idx="1875">
                  <c:v>527.16999999999996</c:v>
                </c:pt>
                <c:pt idx="1876">
                  <c:v>527.45000000000005</c:v>
                </c:pt>
                <c:pt idx="1877">
                  <c:v>527.73</c:v>
                </c:pt>
                <c:pt idx="1878">
                  <c:v>528.01</c:v>
                </c:pt>
                <c:pt idx="1879">
                  <c:v>528.29</c:v>
                </c:pt>
                <c:pt idx="1880">
                  <c:v>528.57000000000005</c:v>
                </c:pt>
                <c:pt idx="1881">
                  <c:v>528.85</c:v>
                </c:pt>
                <c:pt idx="1882">
                  <c:v>529.13</c:v>
                </c:pt>
                <c:pt idx="1883">
                  <c:v>529.41999999999996</c:v>
                </c:pt>
                <c:pt idx="1884">
                  <c:v>529.70000000000005</c:v>
                </c:pt>
                <c:pt idx="1885">
                  <c:v>529.98</c:v>
                </c:pt>
                <c:pt idx="1886">
                  <c:v>530.26</c:v>
                </c:pt>
                <c:pt idx="1887">
                  <c:v>530.54</c:v>
                </c:pt>
                <c:pt idx="1888">
                  <c:v>530.82000000000005</c:v>
                </c:pt>
                <c:pt idx="1889">
                  <c:v>531.1</c:v>
                </c:pt>
                <c:pt idx="1890">
                  <c:v>531.38</c:v>
                </c:pt>
                <c:pt idx="1891">
                  <c:v>531.66</c:v>
                </c:pt>
                <c:pt idx="1892">
                  <c:v>531.94000000000005</c:v>
                </c:pt>
                <c:pt idx="1893">
                  <c:v>532.22</c:v>
                </c:pt>
                <c:pt idx="1894">
                  <c:v>532.5</c:v>
                </c:pt>
                <c:pt idx="1895">
                  <c:v>532.79</c:v>
                </c:pt>
                <c:pt idx="1896">
                  <c:v>533.05999999999995</c:v>
                </c:pt>
                <c:pt idx="1897">
                  <c:v>533.34</c:v>
                </c:pt>
                <c:pt idx="1898">
                  <c:v>533.63</c:v>
                </c:pt>
                <c:pt idx="1899">
                  <c:v>533.91</c:v>
                </c:pt>
                <c:pt idx="1900">
                  <c:v>534.19000000000005</c:v>
                </c:pt>
                <c:pt idx="1901">
                  <c:v>534.47</c:v>
                </c:pt>
                <c:pt idx="1902">
                  <c:v>534.75</c:v>
                </c:pt>
                <c:pt idx="1903">
                  <c:v>535.03</c:v>
                </c:pt>
                <c:pt idx="1904">
                  <c:v>535.30999999999995</c:v>
                </c:pt>
                <c:pt idx="1905">
                  <c:v>535.59</c:v>
                </c:pt>
                <c:pt idx="1906">
                  <c:v>535.87</c:v>
                </c:pt>
                <c:pt idx="1907">
                  <c:v>536.15</c:v>
                </c:pt>
                <c:pt idx="1908">
                  <c:v>536.42999999999995</c:v>
                </c:pt>
                <c:pt idx="1909">
                  <c:v>536.72</c:v>
                </c:pt>
                <c:pt idx="1910">
                  <c:v>537</c:v>
                </c:pt>
                <c:pt idx="1911">
                  <c:v>537.28</c:v>
                </c:pt>
                <c:pt idx="1912">
                  <c:v>537.55999999999995</c:v>
                </c:pt>
                <c:pt idx="1913">
                  <c:v>537.84</c:v>
                </c:pt>
                <c:pt idx="1914">
                  <c:v>538.12</c:v>
                </c:pt>
                <c:pt idx="1915">
                  <c:v>538.4</c:v>
                </c:pt>
                <c:pt idx="1916">
                  <c:v>538.67999999999995</c:v>
                </c:pt>
                <c:pt idx="1917">
                  <c:v>538.96</c:v>
                </c:pt>
                <c:pt idx="1918">
                  <c:v>539.24</c:v>
                </c:pt>
                <c:pt idx="1919">
                  <c:v>539.52</c:v>
                </c:pt>
                <c:pt idx="1920">
                  <c:v>539.80999999999995</c:v>
                </c:pt>
                <c:pt idx="1921">
                  <c:v>540.08000000000004</c:v>
                </c:pt>
                <c:pt idx="1922">
                  <c:v>540.36</c:v>
                </c:pt>
                <c:pt idx="1923">
                  <c:v>540.65</c:v>
                </c:pt>
                <c:pt idx="1924">
                  <c:v>540.92999999999995</c:v>
                </c:pt>
                <c:pt idx="1925">
                  <c:v>541.21</c:v>
                </c:pt>
                <c:pt idx="1926">
                  <c:v>541.49</c:v>
                </c:pt>
                <c:pt idx="1927">
                  <c:v>541.77</c:v>
                </c:pt>
                <c:pt idx="1928">
                  <c:v>542.04999999999995</c:v>
                </c:pt>
                <c:pt idx="1929">
                  <c:v>542.33000000000004</c:v>
                </c:pt>
                <c:pt idx="1930">
                  <c:v>542.61</c:v>
                </c:pt>
                <c:pt idx="1931">
                  <c:v>542.89</c:v>
                </c:pt>
                <c:pt idx="1932">
                  <c:v>543.16999999999996</c:v>
                </c:pt>
                <c:pt idx="1933">
                  <c:v>543.46</c:v>
                </c:pt>
                <c:pt idx="1934">
                  <c:v>543.73</c:v>
                </c:pt>
                <c:pt idx="1935">
                  <c:v>544.02</c:v>
                </c:pt>
                <c:pt idx="1936">
                  <c:v>544.29999999999995</c:v>
                </c:pt>
                <c:pt idx="1937">
                  <c:v>544.58000000000004</c:v>
                </c:pt>
                <c:pt idx="1938">
                  <c:v>544.86</c:v>
                </c:pt>
                <c:pt idx="1939">
                  <c:v>545.14</c:v>
                </c:pt>
                <c:pt idx="1940">
                  <c:v>545.41999999999996</c:v>
                </c:pt>
                <c:pt idx="1941">
                  <c:v>545.70000000000005</c:v>
                </c:pt>
                <c:pt idx="1942">
                  <c:v>545.98</c:v>
                </c:pt>
                <c:pt idx="1943">
                  <c:v>546.26</c:v>
                </c:pt>
                <c:pt idx="1944">
                  <c:v>546.54</c:v>
                </c:pt>
                <c:pt idx="1945">
                  <c:v>546.83000000000004</c:v>
                </c:pt>
                <c:pt idx="1946">
                  <c:v>547.11</c:v>
                </c:pt>
                <c:pt idx="1947">
                  <c:v>547.38</c:v>
                </c:pt>
                <c:pt idx="1948">
                  <c:v>547.66</c:v>
                </c:pt>
                <c:pt idx="1949">
                  <c:v>547.95000000000005</c:v>
                </c:pt>
                <c:pt idx="1950">
                  <c:v>548.23</c:v>
                </c:pt>
                <c:pt idx="1951">
                  <c:v>548.51</c:v>
                </c:pt>
                <c:pt idx="1952">
                  <c:v>548.79</c:v>
                </c:pt>
                <c:pt idx="1953">
                  <c:v>549.07000000000005</c:v>
                </c:pt>
                <c:pt idx="1954">
                  <c:v>549.35</c:v>
                </c:pt>
                <c:pt idx="1955">
                  <c:v>549.63</c:v>
                </c:pt>
                <c:pt idx="1956">
                  <c:v>549.91</c:v>
                </c:pt>
                <c:pt idx="1957">
                  <c:v>550.19000000000005</c:v>
                </c:pt>
                <c:pt idx="1958">
                  <c:v>550.48</c:v>
                </c:pt>
                <c:pt idx="1959">
                  <c:v>550.75</c:v>
                </c:pt>
                <c:pt idx="1960">
                  <c:v>551.04</c:v>
                </c:pt>
                <c:pt idx="1961">
                  <c:v>551.32000000000005</c:v>
                </c:pt>
                <c:pt idx="1962">
                  <c:v>551.6</c:v>
                </c:pt>
                <c:pt idx="1963">
                  <c:v>551.88</c:v>
                </c:pt>
                <c:pt idx="1964">
                  <c:v>552.16</c:v>
                </c:pt>
                <c:pt idx="1965">
                  <c:v>552.44000000000005</c:v>
                </c:pt>
                <c:pt idx="1966">
                  <c:v>552.72</c:v>
                </c:pt>
                <c:pt idx="1967">
                  <c:v>553</c:v>
                </c:pt>
                <c:pt idx="1968">
                  <c:v>553.28</c:v>
                </c:pt>
                <c:pt idx="1969">
                  <c:v>553.55999999999995</c:v>
                </c:pt>
                <c:pt idx="1970">
                  <c:v>553.85</c:v>
                </c:pt>
                <c:pt idx="1971">
                  <c:v>554.13</c:v>
                </c:pt>
                <c:pt idx="1972">
                  <c:v>554.4</c:v>
                </c:pt>
                <c:pt idx="1973">
                  <c:v>554.67999999999995</c:v>
                </c:pt>
                <c:pt idx="1974">
                  <c:v>554.96</c:v>
                </c:pt>
                <c:pt idx="1975">
                  <c:v>555.25</c:v>
                </c:pt>
                <c:pt idx="1976">
                  <c:v>555.53</c:v>
                </c:pt>
                <c:pt idx="1977">
                  <c:v>555.80999999999995</c:v>
                </c:pt>
                <c:pt idx="1978">
                  <c:v>556.09</c:v>
                </c:pt>
                <c:pt idx="1979">
                  <c:v>556.37</c:v>
                </c:pt>
                <c:pt idx="1980">
                  <c:v>556.65</c:v>
                </c:pt>
                <c:pt idx="1981">
                  <c:v>556.92999999999995</c:v>
                </c:pt>
                <c:pt idx="1982">
                  <c:v>557.21</c:v>
                </c:pt>
                <c:pt idx="1983">
                  <c:v>557.49</c:v>
                </c:pt>
                <c:pt idx="1984">
                  <c:v>557.77</c:v>
                </c:pt>
                <c:pt idx="1985">
                  <c:v>558.05999999999995</c:v>
                </c:pt>
                <c:pt idx="1986">
                  <c:v>558.34</c:v>
                </c:pt>
                <c:pt idx="1987">
                  <c:v>558.62</c:v>
                </c:pt>
                <c:pt idx="1988">
                  <c:v>558.9</c:v>
                </c:pt>
                <c:pt idx="1989">
                  <c:v>559.17999999999995</c:v>
                </c:pt>
                <c:pt idx="1990">
                  <c:v>559.46</c:v>
                </c:pt>
                <c:pt idx="1991">
                  <c:v>559.74</c:v>
                </c:pt>
                <c:pt idx="1992">
                  <c:v>560.02</c:v>
                </c:pt>
                <c:pt idx="1993">
                  <c:v>560.29999999999995</c:v>
                </c:pt>
                <c:pt idx="1994">
                  <c:v>560.59</c:v>
                </c:pt>
                <c:pt idx="1995">
                  <c:v>560.87</c:v>
                </c:pt>
                <c:pt idx="1996">
                  <c:v>561.14</c:v>
                </c:pt>
                <c:pt idx="1997">
                  <c:v>561.41999999999996</c:v>
                </c:pt>
                <c:pt idx="1998">
                  <c:v>561.71</c:v>
                </c:pt>
                <c:pt idx="1999">
                  <c:v>561.99</c:v>
                </c:pt>
                <c:pt idx="2000">
                  <c:v>562.27</c:v>
                </c:pt>
                <c:pt idx="2001">
                  <c:v>562.54999999999995</c:v>
                </c:pt>
                <c:pt idx="2002">
                  <c:v>562.83000000000004</c:v>
                </c:pt>
                <c:pt idx="2003">
                  <c:v>563.11</c:v>
                </c:pt>
                <c:pt idx="2004">
                  <c:v>563.39</c:v>
                </c:pt>
                <c:pt idx="2005">
                  <c:v>563.66999999999996</c:v>
                </c:pt>
                <c:pt idx="2006">
                  <c:v>563.95000000000005</c:v>
                </c:pt>
                <c:pt idx="2007">
                  <c:v>564.23</c:v>
                </c:pt>
                <c:pt idx="2008">
                  <c:v>564.51</c:v>
                </c:pt>
                <c:pt idx="2009">
                  <c:v>564.79</c:v>
                </c:pt>
                <c:pt idx="2010">
                  <c:v>565.08000000000004</c:v>
                </c:pt>
                <c:pt idx="2011">
                  <c:v>565.36</c:v>
                </c:pt>
                <c:pt idx="2012">
                  <c:v>565.64</c:v>
                </c:pt>
                <c:pt idx="2013">
                  <c:v>565.91999999999996</c:v>
                </c:pt>
                <c:pt idx="2014">
                  <c:v>566.20000000000005</c:v>
                </c:pt>
                <c:pt idx="2015">
                  <c:v>566.48</c:v>
                </c:pt>
                <c:pt idx="2016">
                  <c:v>566.76</c:v>
                </c:pt>
                <c:pt idx="2017">
                  <c:v>567.04</c:v>
                </c:pt>
                <c:pt idx="2018">
                  <c:v>567.32000000000005</c:v>
                </c:pt>
                <c:pt idx="2019">
                  <c:v>567.6</c:v>
                </c:pt>
                <c:pt idx="2020">
                  <c:v>567.88</c:v>
                </c:pt>
                <c:pt idx="2021">
                  <c:v>568.16999999999996</c:v>
                </c:pt>
                <c:pt idx="2022">
                  <c:v>568.44000000000005</c:v>
                </c:pt>
                <c:pt idx="2023">
                  <c:v>568.73</c:v>
                </c:pt>
                <c:pt idx="2024">
                  <c:v>569.01</c:v>
                </c:pt>
                <c:pt idx="2025">
                  <c:v>569.29</c:v>
                </c:pt>
                <c:pt idx="2026">
                  <c:v>569.57000000000005</c:v>
                </c:pt>
                <c:pt idx="2027">
                  <c:v>569.85</c:v>
                </c:pt>
                <c:pt idx="2028">
                  <c:v>570.13</c:v>
                </c:pt>
                <c:pt idx="2029">
                  <c:v>570.41</c:v>
                </c:pt>
                <c:pt idx="2030">
                  <c:v>570.69000000000005</c:v>
                </c:pt>
                <c:pt idx="2031">
                  <c:v>570.97</c:v>
                </c:pt>
                <c:pt idx="2032">
                  <c:v>571.25</c:v>
                </c:pt>
                <c:pt idx="2033">
                  <c:v>571.53</c:v>
                </c:pt>
                <c:pt idx="2034">
                  <c:v>571.80999999999995</c:v>
                </c:pt>
                <c:pt idx="2035">
                  <c:v>572.09</c:v>
                </c:pt>
                <c:pt idx="2036">
                  <c:v>572.38</c:v>
                </c:pt>
                <c:pt idx="2037">
                  <c:v>572.66</c:v>
                </c:pt>
                <c:pt idx="2038">
                  <c:v>572.94000000000005</c:v>
                </c:pt>
                <c:pt idx="2039">
                  <c:v>573.22</c:v>
                </c:pt>
                <c:pt idx="2040">
                  <c:v>573.5</c:v>
                </c:pt>
                <c:pt idx="2041">
                  <c:v>573.78</c:v>
                </c:pt>
                <c:pt idx="2042">
                  <c:v>574.05999999999995</c:v>
                </c:pt>
                <c:pt idx="2043">
                  <c:v>574.34</c:v>
                </c:pt>
                <c:pt idx="2044">
                  <c:v>574.62</c:v>
                </c:pt>
                <c:pt idx="2045">
                  <c:v>574.9</c:v>
                </c:pt>
                <c:pt idx="2046">
                  <c:v>575.19000000000005</c:v>
                </c:pt>
                <c:pt idx="2047">
                  <c:v>575.47</c:v>
                </c:pt>
                <c:pt idx="2048">
                  <c:v>575.75</c:v>
                </c:pt>
                <c:pt idx="2049">
                  <c:v>576.03</c:v>
                </c:pt>
                <c:pt idx="2050">
                  <c:v>576.30999999999995</c:v>
                </c:pt>
                <c:pt idx="2051">
                  <c:v>576.59</c:v>
                </c:pt>
                <c:pt idx="2052">
                  <c:v>576.87</c:v>
                </c:pt>
                <c:pt idx="2053">
                  <c:v>577.15</c:v>
                </c:pt>
                <c:pt idx="2054">
                  <c:v>577.42999999999995</c:v>
                </c:pt>
                <c:pt idx="2055">
                  <c:v>577.71</c:v>
                </c:pt>
                <c:pt idx="2056">
                  <c:v>577.99</c:v>
                </c:pt>
                <c:pt idx="2057">
                  <c:v>578.27</c:v>
                </c:pt>
                <c:pt idx="2058">
                  <c:v>578.54999999999995</c:v>
                </c:pt>
                <c:pt idx="2059">
                  <c:v>578.83000000000004</c:v>
                </c:pt>
                <c:pt idx="2060">
                  <c:v>579.12</c:v>
                </c:pt>
                <c:pt idx="2061">
                  <c:v>579.4</c:v>
                </c:pt>
                <c:pt idx="2062">
                  <c:v>579.67999999999995</c:v>
                </c:pt>
                <c:pt idx="2063">
                  <c:v>579.96</c:v>
                </c:pt>
                <c:pt idx="2064">
                  <c:v>580.24</c:v>
                </c:pt>
                <c:pt idx="2065">
                  <c:v>580.52</c:v>
                </c:pt>
                <c:pt idx="2066">
                  <c:v>580.79999999999995</c:v>
                </c:pt>
                <c:pt idx="2067">
                  <c:v>581.09</c:v>
                </c:pt>
                <c:pt idx="2068">
                  <c:v>581.36</c:v>
                </c:pt>
                <c:pt idx="2069">
                  <c:v>581.64</c:v>
                </c:pt>
                <c:pt idx="2070">
                  <c:v>581.91999999999996</c:v>
                </c:pt>
                <c:pt idx="2071">
                  <c:v>582.21</c:v>
                </c:pt>
                <c:pt idx="2072">
                  <c:v>582.49</c:v>
                </c:pt>
                <c:pt idx="2073">
                  <c:v>582.77</c:v>
                </c:pt>
                <c:pt idx="2074">
                  <c:v>583.04999999999995</c:v>
                </c:pt>
                <c:pt idx="2075">
                  <c:v>583.33000000000004</c:v>
                </c:pt>
                <c:pt idx="2076">
                  <c:v>583.61</c:v>
                </c:pt>
                <c:pt idx="2077">
                  <c:v>583.89</c:v>
                </c:pt>
                <c:pt idx="2078">
                  <c:v>584.16999999999996</c:v>
                </c:pt>
                <c:pt idx="2079">
                  <c:v>584.45000000000005</c:v>
                </c:pt>
                <c:pt idx="2080">
                  <c:v>584.73</c:v>
                </c:pt>
                <c:pt idx="2081">
                  <c:v>585.01</c:v>
                </c:pt>
                <c:pt idx="2082">
                  <c:v>585.29999999999995</c:v>
                </c:pt>
                <c:pt idx="2083">
                  <c:v>585.57000000000005</c:v>
                </c:pt>
                <c:pt idx="2084">
                  <c:v>585.85</c:v>
                </c:pt>
                <c:pt idx="2085">
                  <c:v>586.13</c:v>
                </c:pt>
                <c:pt idx="2086">
                  <c:v>586.41999999999996</c:v>
                </c:pt>
                <c:pt idx="2087">
                  <c:v>586.70000000000005</c:v>
                </c:pt>
                <c:pt idx="2088">
                  <c:v>586.98</c:v>
                </c:pt>
                <c:pt idx="2089">
                  <c:v>587.26</c:v>
                </c:pt>
                <c:pt idx="2090">
                  <c:v>587.54</c:v>
                </c:pt>
                <c:pt idx="2091">
                  <c:v>587.82000000000005</c:v>
                </c:pt>
                <c:pt idx="2092">
                  <c:v>588.1</c:v>
                </c:pt>
                <c:pt idx="2093">
                  <c:v>588.38</c:v>
                </c:pt>
                <c:pt idx="2094">
                  <c:v>588.66</c:v>
                </c:pt>
                <c:pt idx="2095">
                  <c:v>588.94000000000005</c:v>
                </c:pt>
                <c:pt idx="2096">
                  <c:v>589.22</c:v>
                </c:pt>
                <c:pt idx="2097">
                  <c:v>589.51</c:v>
                </c:pt>
                <c:pt idx="2098">
                  <c:v>589.79</c:v>
                </c:pt>
                <c:pt idx="2099">
                  <c:v>590.07000000000005</c:v>
                </c:pt>
                <c:pt idx="2100">
                  <c:v>590.35</c:v>
                </c:pt>
                <c:pt idx="2101">
                  <c:v>590.63</c:v>
                </c:pt>
                <c:pt idx="2102">
                  <c:v>590.91</c:v>
                </c:pt>
                <c:pt idx="2103">
                  <c:v>591.19000000000005</c:v>
                </c:pt>
                <c:pt idx="2104">
                  <c:v>591.47</c:v>
                </c:pt>
                <c:pt idx="2105">
                  <c:v>591.75</c:v>
                </c:pt>
                <c:pt idx="2106">
                  <c:v>592.04</c:v>
                </c:pt>
                <c:pt idx="2107">
                  <c:v>592.32000000000005</c:v>
                </c:pt>
                <c:pt idx="2108">
                  <c:v>592.59</c:v>
                </c:pt>
                <c:pt idx="2109">
                  <c:v>592.87</c:v>
                </c:pt>
                <c:pt idx="2110">
                  <c:v>593.15</c:v>
                </c:pt>
                <c:pt idx="2111">
                  <c:v>593.44000000000005</c:v>
                </c:pt>
                <c:pt idx="2112">
                  <c:v>593.72</c:v>
                </c:pt>
                <c:pt idx="2113">
                  <c:v>594</c:v>
                </c:pt>
                <c:pt idx="2114">
                  <c:v>594.28</c:v>
                </c:pt>
                <c:pt idx="2115">
                  <c:v>594.55999999999995</c:v>
                </c:pt>
                <c:pt idx="2116">
                  <c:v>594.84</c:v>
                </c:pt>
                <c:pt idx="2117">
                  <c:v>595.12</c:v>
                </c:pt>
                <c:pt idx="2118">
                  <c:v>595.4</c:v>
                </c:pt>
                <c:pt idx="2119">
                  <c:v>595.67999999999995</c:v>
                </c:pt>
                <c:pt idx="2120">
                  <c:v>595.97</c:v>
                </c:pt>
                <c:pt idx="2121">
                  <c:v>596.25</c:v>
                </c:pt>
                <c:pt idx="2122">
                  <c:v>596.53</c:v>
                </c:pt>
                <c:pt idx="2123">
                  <c:v>596.80999999999995</c:v>
                </c:pt>
                <c:pt idx="2124">
                  <c:v>597.09</c:v>
                </c:pt>
                <c:pt idx="2125">
                  <c:v>597.37</c:v>
                </c:pt>
                <c:pt idx="2126">
                  <c:v>597.65</c:v>
                </c:pt>
                <c:pt idx="2127">
                  <c:v>597.92999999999995</c:v>
                </c:pt>
                <c:pt idx="2128">
                  <c:v>598.21</c:v>
                </c:pt>
                <c:pt idx="2129">
                  <c:v>598.49</c:v>
                </c:pt>
                <c:pt idx="2130">
                  <c:v>598.77</c:v>
                </c:pt>
                <c:pt idx="2131">
                  <c:v>599.04999999999995</c:v>
                </c:pt>
                <c:pt idx="2132">
                  <c:v>599.33000000000004</c:v>
                </c:pt>
                <c:pt idx="2133">
                  <c:v>599.61</c:v>
                </c:pt>
                <c:pt idx="2134">
                  <c:v>599.9</c:v>
                </c:pt>
                <c:pt idx="2135">
                  <c:v>600.17999999999995</c:v>
                </c:pt>
                <c:pt idx="2136">
                  <c:v>600.46</c:v>
                </c:pt>
                <c:pt idx="2137">
                  <c:v>600.74</c:v>
                </c:pt>
                <c:pt idx="2138">
                  <c:v>601.02</c:v>
                </c:pt>
                <c:pt idx="2139">
                  <c:v>601.29999999999995</c:v>
                </c:pt>
                <c:pt idx="2140">
                  <c:v>601.58000000000004</c:v>
                </c:pt>
                <c:pt idx="2141">
                  <c:v>601.86</c:v>
                </c:pt>
                <c:pt idx="2142">
                  <c:v>602.14</c:v>
                </c:pt>
                <c:pt idx="2143">
                  <c:v>602.41999999999996</c:v>
                </c:pt>
                <c:pt idx="2144">
                  <c:v>602.70000000000005</c:v>
                </c:pt>
                <c:pt idx="2145">
                  <c:v>602.99</c:v>
                </c:pt>
                <c:pt idx="2146">
                  <c:v>603.26</c:v>
                </c:pt>
                <c:pt idx="2147">
                  <c:v>603.54999999999995</c:v>
                </c:pt>
                <c:pt idx="2148">
                  <c:v>603.83000000000004</c:v>
                </c:pt>
                <c:pt idx="2149">
                  <c:v>604.11</c:v>
                </c:pt>
                <c:pt idx="2150">
                  <c:v>604.39</c:v>
                </c:pt>
                <c:pt idx="2151">
                  <c:v>604.66999999999996</c:v>
                </c:pt>
                <c:pt idx="2152">
                  <c:v>604.95000000000005</c:v>
                </c:pt>
                <c:pt idx="2153">
                  <c:v>605.23</c:v>
                </c:pt>
                <c:pt idx="2154">
                  <c:v>605.51</c:v>
                </c:pt>
                <c:pt idx="2155">
                  <c:v>605.79</c:v>
                </c:pt>
                <c:pt idx="2156">
                  <c:v>606.07000000000005</c:v>
                </c:pt>
                <c:pt idx="2157">
                  <c:v>606.36</c:v>
                </c:pt>
                <c:pt idx="2158">
                  <c:v>606.64</c:v>
                </c:pt>
                <c:pt idx="2159">
                  <c:v>606.91</c:v>
                </c:pt>
                <c:pt idx="2160">
                  <c:v>607.19000000000005</c:v>
                </c:pt>
                <c:pt idx="2161">
                  <c:v>607.48</c:v>
                </c:pt>
                <c:pt idx="2162">
                  <c:v>607.76</c:v>
                </c:pt>
                <c:pt idx="2163">
                  <c:v>608.04</c:v>
                </c:pt>
                <c:pt idx="2164">
                  <c:v>608.32000000000005</c:v>
                </c:pt>
                <c:pt idx="2165">
                  <c:v>608.6</c:v>
                </c:pt>
                <c:pt idx="2166">
                  <c:v>608.88</c:v>
                </c:pt>
                <c:pt idx="2167">
                  <c:v>609.16</c:v>
                </c:pt>
                <c:pt idx="2168">
                  <c:v>609.44000000000005</c:v>
                </c:pt>
                <c:pt idx="2169">
                  <c:v>609.72</c:v>
                </c:pt>
                <c:pt idx="2170">
                  <c:v>610.01</c:v>
                </c:pt>
                <c:pt idx="2171">
                  <c:v>610.29</c:v>
                </c:pt>
                <c:pt idx="2172">
                  <c:v>610.57000000000005</c:v>
                </c:pt>
                <c:pt idx="2173">
                  <c:v>610.85</c:v>
                </c:pt>
                <c:pt idx="2174">
                  <c:v>611.13</c:v>
                </c:pt>
                <c:pt idx="2175">
                  <c:v>611.41</c:v>
                </c:pt>
                <c:pt idx="2176">
                  <c:v>611.69000000000005</c:v>
                </c:pt>
                <c:pt idx="2177">
                  <c:v>611.97</c:v>
                </c:pt>
                <c:pt idx="2178">
                  <c:v>612.25</c:v>
                </c:pt>
                <c:pt idx="2179">
                  <c:v>612.53</c:v>
                </c:pt>
                <c:pt idx="2180">
                  <c:v>612.82000000000005</c:v>
                </c:pt>
                <c:pt idx="2181">
                  <c:v>613.09</c:v>
                </c:pt>
                <c:pt idx="2182">
                  <c:v>613.37</c:v>
                </c:pt>
                <c:pt idx="2183">
                  <c:v>613.66</c:v>
                </c:pt>
                <c:pt idx="2184">
                  <c:v>613.92999999999995</c:v>
                </c:pt>
                <c:pt idx="2185">
                  <c:v>614.22</c:v>
                </c:pt>
                <c:pt idx="2186">
                  <c:v>614.5</c:v>
                </c:pt>
                <c:pt idx="2187">
                  <c:v>614.78</c:v>
                </c:pt>
                <c:pt idx="2188">
                  <c:v>615.05999999999995</c:v>
                </c:pt>
                <c:pt idx="2189">
                  <c:v>615.34</c:v>
                </c:pt>
                <c:pt idx="2190">
                  <c:v>615.62</c:v>
                </c:pt>
                <c:pt idx="2191">
                  <c:v>615.9</c:v>
                </c:pt>
                <c:pt idx="2192">
                  <c:v>616.17999999999995</c:v>
                </c:pt>
                <c:pt idx="2193">
                  <c:v>616.46</c:v>
                </c:pt>
                <c:pt idx="2194">
                  <c:v>616.74</c:v>
                </c:pt>
                <c:pt idx="2195">
                  <c:v>617.03</c:v>
                </c:pt>
                <c:pt idx="2196">
                  <c:v>617.30999999999995</c:v>
                </c:pt>
                <c:pt idx="2197">
                  <c:v>617.58000000000004</c:v>
                </c:pt>
                <c:pt idx="2198">
                  <c:v>617.87</c:v>
                </c:pt>
                <c:pt idx="2199">
                  <c:v>618.14</c:v>
                </c:pt>
                <c:pt idx="2200">
                  <c:v>618.42999999999995</c:v>
                </c:pt>
                <c:pt idx="2201">
                  <c:v>618.71</c:v>
                </c:pt>
                <c:pt idx="2202">
                  <c:v>618.99</c:v>
                </c:pt>
                <c:pt idx="2203">
                  <c:v>619.27</c:v>
                </c:pt>
                <c:pt idx="2204">
                  <c:v>619.54999999999995</c:v>
                </c:pt>
                <c:pt idx="2205">
                  <c:v>619.83000000000004</c:v>
                </c:pt>
                <c:pt idx="2206">
                  <c:v>620.11</c:v>
                </c:pt>
                <c:pt idx="2207">
                  <c:v>620.39</c:v>
                </c:pt>
                <c:pt idx="2208">
                  <c:v>620.67999999999995</c:v>
                </c:pt>
                <c:pt idx="2209">
                  <c:v>620.95000000000005</c:v>
                </c:pt>
                <c:pt idx="2210">
                  <c:v>621.23</c:v>
                </c:pt>
                <c:pt idx="2211">
                  <c:v>621.52</c:v>
                </c:pt>
                <c:pt idx="2212">
                  <c:v>621.79999999999995</c:v>
                </c:pt>
                <c:pt idx="2213">
                  <c:v>622.08000000000004</c:v>
                </c:pt>
                <c:pt idx="2214">
                  <c:v>622.36</c:v>
                </c:pt>
                <c:pt idx="2215">
                  <c:v>622.64</c:v>
                </c:pt>
                <c:pt idx="2216">
                  <c:v>622.91999999999996</c:v>
                </c:pt>
                <c:pt idx="2217">
                  <c:v>623.20000000000005</c:v>
                </c:pt>
                <c:pt idx="2218">
                  <c:v>623.48</c:v>
                </c:pt>
                <c:pt idx="2219">
                  <c:v>623.76</c:v>
                </c:pt>
                <c:pt idx="2220">
                  <c:v>624.04</c:v>
                </c:pt>
                <c:pt idx="2221">
                  <c:v>624.32000000000005</c:v>
                </c:pt>
                <c:pt idx="2222">
                  <c:v>624.61</c:v>
                </c:pt>
                <c:pt idx="2223">
                  <c:v>624.89</c:v>
                </c:pt>
                <c:pt idx="2224">
                  <c:v>625.16999999999996</c:v>
                </c:pt>
                <c:pt idx="2225">
                  <c:v>625.45000000000005</c:v>
                </c:pt>
                <c:pt idx="2226">
                  <c:v>625.73</c:v>
                </c:pt>
                <c:pt idx="2227">
                  <c:v>626.01</c:v>
                </c:pt>
                <c:pt idx="2228">
                  <c:v>626.29</c:v>
                </c:pt>
                <c:pt idx="2229">
                  <c:v>626.57000000000005</c:v>
                </c:pt>
                <c:pt idx="2230">
                  <c:v>626.85</c:v>
                </c:pt>
                <c:pt idx="2231">
                  <c:v>627.13</c:v>
                </c:pt>
                <c:pt idx="2232">
                  <c:v>627.41</c:v>
                </c:pt>
                <c:pt idx="2233">
                  <c:v>627.70000000000005</c:v>
                </c:pt>
                <c:pt idx="2234">
                  <c:v>627.97</c:v>
                </c:pt>
                <c:pt idx="2235">
                  <c:v>628.26</c:v>
                </c:pt>
                <c:pt idx="2236">
                  <c:v>628.54</c:v>
                </c:pt>
                <c:pt idx="2237">
                  <c:v>628.82000000000005</c:v>
                </c:pt>
                <c:pt idx="2238">
                  <c:v>629.1</c:v>
                </c:pt>
                <c:pt idx="2239">
                  <c:v>629.38</c:v>
                </c:pt>
                <c:pt idx="2240">
                  <c:v>629.66</c:v>
                </c:pt>
                <c:pt idx="2241">
                  <c:v>629.94000000000005</c:v>
                </c:pt>
                <c:pt idx="2242">
                  <c:v>630.22</c:v>
                </c:pt>
                <c:pt idx="2243">
                  <c:v>630.5</c:v>
                </c:pt>
                <c:pt idx="2244">
                  <c:v>631.34</c:v>
                </c:pt>
                <c:pt idx="2245">
                  <c:v>631.55999999999995</c:v>
                </c:pt>
                <c:pt idx="2246">
                  <c:v>631.79</c:v>
                </c:pt>
                <c:pt idx="2247">
                  <c:v>632.02</c:v>
                </c:pt>
                <c:pt idx="2248">
                  <c:v>632.24</c:v>
                </c:pt>
                <c:pt idx="2249">
                  <c:v>632.47</c:v>
                </c:pt>
                <c:pt idx="2250">
                  <c:v>632.75</c:v>
                </c:pt>
                <c:pt idx="2251">
                  <c:v>633.03</c:v>
                </c:pt>
                <c:pt idx="2252">
                  <c:v>633.30999999999995</c:v>
                </c:pt>
                <c:pt idx="2253">
                  <c:v>633.59</c:v>
                </c:pt>
                <c:pt idx="2254">
                  <c:v>633.87</c:v>
                </c:pt>
                <c:pt idx="2255">
                  <c:v>634.15</c:v>
                </c:pt>
                <c:pt idx="2256">
                  <c:v>634.42999999999995</c:v>
                </c:pt>
                <c:pt idx="2257">
                  <c:v>634.71</c:v>
                </c:pt>
                <c:pt idx="2258">
                  <c:v>635</c:v>
                </c:pt>
                <c:pt idx="2259">
                  <c:v>635.27</c:v>
                </c:pt>
                <c:pt idx="2260">
                  <c:v>635.55999999999995</c:v>
                </c:pt>
                <c:pt idx="2261">
                  <c:v>635.84</c:v>
                </c:pt>
                <c:pt idx="2262">
                  <c:v>636.12</c:v>
                </c:pt>
                <c:pt idx="2263">
                  <c:v>636.4</c:v>
                </c:pt>
                <c:pt idx="2264">
                  <c:v>636.67999999999995</c:v>
                </c:pt>
                <c:pt idx="2265">
                  <c:v>636.96</c:v>
                </c:pt>
                <c:pt idx="2266">
                  <c:v>637.24</c:v>
                </c:pt>
                <c:pt idx="2267">
                  <c:v>637.52</c:v>
                </c:pt>
                <c:pt idx="2268">
                  <c:v>637.80999999999995</c:v>
                </c:pt>
                <c:pt idx="2269">
                  <c:v>638.08000000000004</c:v>
                </c:pt>
                <c:pt idx="2270">
                  <c:v>638.37</c:v>
                </c:pt>
                <c:pt idx="2271">
                  <c:v>638.65</c:v>
                </c:pt>
                <c:pt idx="2272">
                  <c:v>638.92999999999995</c:v>
                </c:pt>
                <c:pt idx="2273">
                  <c:v>639.20000000000005</c:v>
                </c:pt>
                <c:pt idx="2274">
                  <c:v>639.49</c:v>
                </c:pt>
                <c:pt idx="2275">
                  <c:v>639.77</c:v>
                </c:pt>
                <c:pt idx="2276">
                  <c:v>640.04999999999995</c:v>
                </c:pt>
                <c:pt idx="2277">
                  <c:v>640.33000000000004</c:v>
                </c:pt>
                <c:pt idx="2278">
                  <c:v>640.61</c:v>
                </c:pt>
                <c:pt idx="2279">
                  <c:v>640.89</c:v>
                </c:pt>
                <c:pt idx="2280">
                  <c:v>641.16999999999996</c:v>
                </c:pt>
                <c:pt idx="2281">
                  <c:v>641.46</c:v>
                </c:pt>
                <c:pt idx="2282">
                  <c:v>641.74</c:v>
                </c:pt>
                <c:pt idx="2283">
                  <c:v>642.01</c:v>
                </c:pt>
                <c:pt idx="2284">
                  <c:v>642.29999999999995</c:v>
                </c:pt>
                <c:pt idx="2285">
                  <c:v>642.58000000000004</c:v>
                </c:pt>
                <c:pt idx="2286">
                  <c:v>642.86</c:v>
                </c:pt>
                <c:pt idx="2287">
                  <c:v>643.14</c:v>
                </c:pt>
                <c:pt idx="2288">
                  <c:v>643.41999999999996</c:v>
                </c:pt>
                <c:pt idx="2289">
                  <c:v>643.70000000000005</c:v>
                </c:pt>
                <c:pt idx="2290">
                  <c:v>643.98</c:v>
                </c:pt>
                <c:pt idx="2291">
                  <c:v>644.26</c:v>
                </c:pt>
                <c:pt idx="2292">
                  <c:v>644.54</c:v>
                </c:pt>
                <c:pt idx="2293">
                  <c:v>644.83000000000004</c:v>
                </c:pt>
                <c:pt idx="2294">
                  <c:v>645.1</c:v>
                </c:pt>
                <c:pt idx="2295">
                  <c:v>645.38</c:v>
                </c:pt>
                <c:pt idx="2296">
                  <c:v>645.66</c:v>
                </c:pt>
                <c:pt idx="2297">
                  <c:v>645.95000000000005</c:v>
                </c:pt>
                <c:pt idx="2298">
                  <c:v>646.22</c:v>
                </c:pt>
                <c:pt idx="2299">
                  <c:v>646.51</c:v>
                </c:pt>
                <c:pt idx="2300">
                  <c:v>646.79</c:v>
                </c:pt>
                <c:pt idx="2301">
                  <c:v>647.07000000000005</c:v>
                </c:pt>
                <c:pt idx="2302">
                  <c:v>647.35</c:v>
                </c:pt>
                <c:pt idx="2303">
                  <c:v>647.63</c:v>
                </c:pt>
                <c:pt idx="2304">
                  <c:v>647.91</c:v>
                </c:pt>
                <c:pt idx="2305">
                  <c:v>648.19000000000005</c:v>
                </c:pt>
                <c:pt idx="2306">
                  <c:v>648.47</c:v>
                </c:pt>
                <c:pt idx="2307">
                  <c:v>648.76</c:v>
                </c:pt>
                <c:pt idx="2308">
                  <c:v>649.04</c:v>
                </c:pt>
                <c:pt idx="2309">
                  <c:v>649.32000000000005</c:v>
                </c:pt>
                <c:pt idx="2310">
                  <c:v>649.6</c:v>
                </c:pt>
                <c:pt idx="2311">
                  <c:v>649.88</c:v>
                </c:pt>
                <c:pt idx="2312">
                  <c:v>650.16</c:v>
                </c:pt>
                <c:pt idx="2313">
                  <c:v>650.44000000000005</c:v>
                </c:pt>
                <c:pt idx="2314">
                  <c:v>650.72</c:v>
                </c:pt>
                <c:pt idx="2315">
                  <c:v>651</c:v>
                </c:pt>
                <c:pt idx="2316">
                  <c:v>651.28</c:v>
                </c:pt>
                <c:pt idx="2317">
                  <c:v>651.57000000000005</c:v>
                </c:pt>
                <c:pt idx="2318">
                  <c:v>651.85</c:v>
                </c:pt>
                <c:pt idx="2319">
                  <c:v>652.12</c:v>
                </c:pt>
                <c:pt idx="2320">
                  <c:v>652.41</c:v>
                </c:pt>
                <c:pt idx="2321">
                  <c:v>652.69000000000005</c:v>
                </c:pt>
                <c:pt idx="2322">
                  <c:v>652.97</c:v>
                </c:pt>
                <c:pt idx="2323">
                  <c:v>653.25</c:v>
                </c:pt>
                <c:pt idx="2324">
                  <c:v>653.53</c:v>
                </c:pt>
                <c:pt idx="2325">
                  <c:v>653.80999999999995</c:v>
                </c:pt>
                <c:pt idx="2326">
                  <c:v>654.09</c:v>
                </c:pt>
                <c:pt idx="2327">
                  <c:v>654.37</c:v>
                </c:pt>
                <c:pt idx="2328">
                  <c:v>654.66</c:v>
                </c:pt>
                <c:pt idx="2329">
                  <c:v>654.92999999999995</c:v>
                </c:pt>
                <c:pt idx="2330">
                  <c:v>655.21</c:v>
                </c:pt>
                <c:pt idx="2331">
                  <c:v>655.5</c:v>
                </c:pt>
                <c:pt idx="2332">
                  <c:v>655.78</c:v>
                </c:pt>
                <c:pt idx="2333">
                  <c:v>656.06</c:v>
                </c:pt>
                <c:pt idx="2334">
                  <c:v>656.34</c:v>
                </c:pt>
                <c:pt idx="2335">
                  <c:v>656.62</c:v>
                </c:pt>
                <c:pt idx="2336">
                  <c:v>656.9</c:v>
                </c:pt>
                <c:pt idx="2337">
                  <c:v>657.18</c:v>
                </c:pt>
                <c:pt idx="2338">
                  <c:v>657.46</c:v>
                </c:pt>
                <c:pt idx="2339">
                  <c:v>657.74</c:v>
                </c:pt>
                <c:pt idx="2340">
                  <c:v>658.02</c:v>
                </c:pt>
                <c:pt idx="2341">
                  <c:v>658.3</c:v>
                </c:pt>
                <c:pt idx="2342">
                  <c:v>658.59</c:v>
                </c:pt>
                <c:pt idx="2343">
                  <c:v>658.87</c:v>
                </c:pt>
                <c:pt idx="2344">
                  <c:v>659.14</c:v>
                </c:pt>
                <c:pt idx="2345">
                  <c:v>659.42</c:v>
                </c:pt>
                <c:pt idx="2346">
                  <c:v>659.71</c:v>
                </c:pt>
                <c:pt idx="2347">
                  <c:v>659.99</c:v>
                </c:pt>
                <c:pt idx="2348">
                  <c:v>660.27</c:v>
                </c:pt>
                <c:pt idx="2349">
                  <c:v>660.55</c:v>
                </c:pt>
                <c:pt idx="2350">
                  <c:v>660.83</c:v>
                </c:pt>
                <c:pt idx="2351">
                  <c:v>661.11</c:v>
                </c:pt>
                <c:pt idx="2352">
                  <c:v>661.39</c:v>
                </c:pt>
                <c:pt idx="2353">
                  <c:v>661.67</c:v>
                </c:pt>
                <c:pt idx="2354">
                  <c:v>661.95</c:v>
                </c:pt>
                <c:pt idx="2355">
                  <c:v>662.24</c:v>
                </c:pt>
                <c:pt idx="2356">
                  <c:v>662.51</c:v>
                </c:pt>
                <c:pt idx="2357">
                  <c:v>662.8</c:v>
                </c:pt>
                <c:pt idx="2358">
                  <c:v>663.07</c:v>
                </c:pt>
                <c:pt idx="2359">
                  <c:v>663.36</c:v>
                </c:pt>
                <c:pt idx="2360">
                  <c:v>663.64</c:v>
                </c:pt>
                <c:pt idx="2361">
                  <c:v>663.92</c:v>
                </c:pt>
                <c:pt idx="2362">
                  <c:v>664.2</c:v>
                </c:pt>
                <c:pt idx="2363">
                  <c:v>664.48</c:v>
                </c:pt>
                <c:pt idx="2364">
                  <c:v>664.76</c:v>
                </c:pt>
                <c:pt idx="2365">
                  <c:v>665.04</c:v>
                </c:pt>
                <c:pt idx="2366">
                  <c:v>665.32</c:v>
                </c:pt>
                <c:pt idx="2367">
                  <c:v>665.6</c:v>
                </c:pt>
                <c:pt idx="2368">
                  <c:v>665.89</c:v>
                </c:pt>
                <c:pt idx="2369">
                  <c:v>666.16</c:v>
                </c:pt>
                <c:pt idx="2370">
                  <c:v>666.44</c:v>
                </c:pt>
                <c:pt idx="2371">
                  <c:v>666.73</c:v>
                </c:pt>
                <c:pt idx="2372">
                  <c:v>667.01</c:v>
                </c:pt>
                <c:pt idx="2373">
                  <c:v>667.29</c:v>
                </c:pt>
                <c:pt idx="2374">
                  <c:v>667.57</c:v>
                </c:pt>
                <c:pt idx="2375">
                  <c:v>667.85</c:v>
                </c:pt>
                <c:pt idx="2376">
                  <c:v>668.13</c:v>
                </c:pt>
                <c:pt idx="2377">
                  <c:v>668.41</c:v>
                </c:pt>
                <c:pt idx="2378">
                  <c:v>668.69</c:v>
                </c:pt>
                <c:pt idx="2379">
                  <c:v>668.97</c:v>
                </c:pt>
                <c:pt idx="2380">
                  <c:v>669.25</c:v>
                </c:pt>
                <c:pt idx="2381">
                  <c:v>669.54</c:v>
                </c:pt>
                <c:pt idx="2382">
                  <c:v>669.82</c:v>
                </c:pt>
                <c:pt idx="2383">
                  <c:v>670.09</c:v>
                </c:pt>
                <c:pt idx="2384">
                  <c:v>670.38</c:v>
                </c:pt>
                <c:pt idx="2385">
                  <c:v>670.66</c:v>
                </c:pt>
                <c:pt idx="2386">
                  <c:v>670.94</c:v>
                </c:pt>
                <c:pt idx="2387">
                  <c:v>671.22</c:v>
                </c:pt>
                <c:pt idx="2388">
                  <c:v>671.5</c:v>
                </c:pt>
                <c:pt idx="2389">
                  <c:v>671.78</c:v>
                </c:pt>
                <c:pt idx="2390">
                  <c:v>672.06</c:v>
                </c:pt>
                <c:pt idx="2391">
                  <c:v>672.34</c:v>
                </c:pt>
                <c:pt idx="2392">
                  <c:v>672.63</c:v>
                </c:pt>
                <c:pt idx="2393">
                  <c:v>672.9</c:v>
                </c:pt>
                <c:pt idx="2394">
                  <c:v>673.18</c:v>
                </c:pt>
                <c:pt idx="2395">
                  <c:v>673.46</c:v>
                </c:pt>
                <c:pt idx="2396">
                  <c:v>673.75</c:v>
                </c:pt>
                <c:pt idx="2397">
                  <c:v>674.03</c:v>
                </c:pt>
                <c:pt idx="2398">
                  <c:v>674.31</c:v>
                </c:pt>
                <c:pt idx="2399">
                  <c:v>674.59</c:v>
                </c:pt>
                <c:pt idx="2400">
                  <c:v>674.87</c:v>
                </c:pt>
                <c:pt idx="2401">
                  <c:v>675.15</c:v>
                </c:pt>
                <c:pt idx="2402">
                  <c:v>675.43</c:v>
                </c:pt>
                <c:pt idx="2403">
                  <c:v>675.71</c:v>
                </c:pt>
                <c:pt idx="2404">
                  <c:v>675.99</c:v>
                </c:pt>
                <c:pt idx="2405">
                  <c:v>676.27</c:v>
                </c:pt>
                <c:pt idx="2406">
                  <c:v>676.55</c:v>
                </c:pt>
                <c:pt idx="2407">
                  <c:v>676.84</c:v>
                </c:pt>
                <c:pt idx="2408">
                  <c:v>677.12</c:v>
                </c:pt>
                <c:pt idx="2409">
                  <c:v>677.4</c:v>
                </c:pt>
                <c:pt idx="2410">
                  <c:v>677.68</c:v>
                </c:pt>
                <c:pt idx="2411">
                  <c:v>677.96</c:v>
                </c:pt>
                <c:pt idx="2412">
                  <c:v>678.24</c:v>
                </c:pt>
                <c:pt idx="2413">
                  <c:v>678.52</c:v>
                </c:pt>
                <c:pt idx="2414">
                  <c:v>678.8</c:v>
                </c:pt>
                <c:pt idx="2415">
                  <c:v>679.08</c:v>
                </c:pt>
                <c:pt idx="2416">
                  <c:v>679.36</c:v>
                </c:pt>
                <c:pt idx="2417">
                  <c:v>679.64</c:v>
                </c:pt>
                <c:pt idx="2418">
                  <c:v>679.93</c:v>
                </c:pt>
                <c:pt idx="2419">
                  <c:v>680.2</c:v>
                </c:pt>
                <c:pt idx="2420">
                  <c:v>680.48</c:v>
                </c:pt>
                <c:pt idx="2421">
                  <c:v>680.77</c:v>
                </c:pt>
                <c:pt idx="2422">
                  <c:v>681.05</c:v>
                </c:pt>
                <c:pt idx="2423">
                  <c:v>681.33</c:v>
                </c:pt>
                <c:pt idx="2424">
                  <c:v>681.61</c:v>
                </c:pt>
                <c:pt idx="2425">
                  <c:v>681.89</c:v>
                </c:pt>
                <c:pt idx="2426">
                  <c:v>682.17</c:v>
                </c:pt>
                <c:pt idx="2427">
                  <c:v>682.45</c:v>
                </c:pt>
                <c:pt idx="2428">
                  <c:v>682.73</c:v>
                </c:pt>
                <c:pt idx="2429">
                  <c:v>683.01</c:v>
                </c:pt>
                <c:pt idx="2430">
                  <c:v>683.29</c:v>
                </c:pt>
                <c:pt idx="2431">
                  <c:v>683.57</c:v>
                </c:pt>
                <c:pt idx="2432">
                  <c:v>683.85</c:v>
                </c:pt>
                <c:pt idx="2433">
                  <c:v>684.14</c:v>
                </c:pt>
                <c:pt idx="2434">
                  <c:v>684.41</c:v>
                </c:pt>
                <c:pt idx="2435">
                  <c:v>684.7</c:v>
                </c:pt>
                <c:pt idx="2436">
                  <c:v>684.98</c:v>
                </c:pt>
                <c:pt idx="2437">
                  <c:v>685.26</c:v>
                </c:pt>
                <c:pt idx="2438">
                  <c:v>685.54</c:v>
                </c:pt>
                <c:pt idx="2439">
                  <c:v>685.82</c:v>
                </c:pt>
                <c:pt idx="2440">
                  <c:v>686.1</c:v>
                </c:pt>
                <c:pt idx="2441">
                  <c:v>686.38</c:v>
                </c:pt>
                <c:pt idx="2442">
                  <c:v>686.66</c:v>
                </c:pt>
                <c:pt idx="2443">
                  <c:v>686.94</c:v>
                </c:pt>
                <c:pt idx="2444">
                  <c:v>687.22</c:v>
                </c:pt>
                <c:pt idx="2445">
                  <c:v>687.51</c:v>
                </c:pt>
                <c:pt idx="2446">
                  <c:v>687.79</c:v>
                </c:pt>
                <c:pt idx="2447">
                  <c:v>688.07</c:v>
                </c:pt>
                <c:pt idx="2448">
                  <c:v>688.35</c:v>
                </c:pt>
                <c:pt idx="2449">
                  <c:v>688.63</c:v>
                </c:pt>
                <c:pt idx="2450">
                  <c:v>688.91</c:v>
                </c:pt>
                <c:pt idx="2451">
                  <c:v>689.19</c:v>
                </c:pt>
                <c:pt idx="2452">
                  <c:v>689.47</c:v>
                </c:pt>
                <c:pt idx="2453">
                  <c:v>689.75</c:v>
                </c:pt>
                <c:pt idx="2454">
                  <c:v>690.03</c:v>
                </c:pt>
                <c:pt idx="2455">
                  <c:v>690.31</c:v>
                </c:pt>
                <c:pt idx="2456">
                  <c:v>690.59</c:v>
                </c:pt>
                <c:pt idx="2457">
                  <c:v>690.88</c:v>
                </c:pt>
                <c:pt idx="2458">
                  <c:v>691.16</c:v>
                </c:pt>
                <c:pt idx="2459">
                  <c:v>691.43</c:v>
                </c:pt>
                <c:pt idx="2460">
                  <c:v>691.72</c:v>
                </c:pt>
                <c:pt idx="2461">
                  <c:v>692</c:v>
                </c:pt>
                <c:pt idx="2462">
                  <c:v>692.28</c:v>
                </c:pt>
                <c:pt idx="2463">
                  <c:v>692.56</c:v>
                </c:pt>
                <c:pt idx="2464">
                  <c:v>692.84</c:v>
                </c:pt>
                <c:pt idx="2465">
                  <c:v>693.12</c:v>
                </c:pt>
                <c:pt idx="2466">
                  <c:v>693.4</c:v>
                </c:pt>
                <c:pt idx="2467">
                  <c:v>693.68</c:v>
                </c:pt>
                <c:pt idx="2468">
                  <c:v>693.97</c:v>
                </c:pt>
                <c:pt idx="2469">
                  <c:v>694.25</c:v>
                </c:pt>
                <c:pt idx="2470">
                  <c:v>694.53</c:v>
                </c:pt>
                <c:pt idx="2471">
                  <c:v>694.81</c:v>
                </c:pt>
                <c:pt idx="2472">
                  <c:v>695.09</c:v>
                </c:pt>
                <c:pt idx="2473">
                  <c:v>695.37</c:v>
                </c:pt>
                <c:pt idx="2474">
                  <c:v>695.65</c:v>
                </c:pt>
                <c:pt idx="2475">
                  <c:v>695.93</c:v>
                </c:pt>
                <c:pt idx="2476">
                  <c:v>696.21</c:v>
                </c:pt>
                <c:pt idx="2477">
                  <c:v>696.49</c:v>
                </c:pt>
                <c:pt idx="2478">
                  <c:v>696.77</c:v>
                </c:pt>
                <c:pt idx="2479">
                  <c:v>697.06</c:v>
                </c:pt>
                <c:pt idx="2480">
                  <c:v>697.33</c:v>
                </c:pt>
                <c:pt idx="2481">
                  <c:v>697.61</c:v>
                </c:pt>
                <c:pt idx="2482">
                  <c:v>697.9</c:v>
                </c:pt>
                <c:pt idx="2483">
                  <c:v>698.18</c:v>
                </c:pt>
                <c:pt idx="2484">
                  <c:v>698.45</c:v>
                </c:pt>
                <c:pt idx="2485">
                  <c:v>698.74</c:v>
                </c:pt>
                <c:pt idx="2486">
                  <c:v>699.02</c:v>
                </c:pt>
                <c:pt idx="2487">
                  <c:v>699.3</c:v>
                </c:pt>
                <c:pt idx="2488">
                  <c:v>699.58</c:v>
                </c:pt>
                <c:pt idx="2489">
                  <c:v>699.86</c:v>
                </c:pt>
                <c:pt idx="2490">
                  <c:v>700.14</c:v>
                </c:pt>
                <c:pt idx="2491">
                  <c:v>700.42</c:v>
                </c:pt>
                <c:pt idx="2492">
                  <c:v>700.7</c:v>
                </c:pt>
                <c:pt idx="2493">
                  <c:v>700.99</c:v>
                </c:pt>
                <c:pt idx="2494">
                  <c:v>701.27</c:v>
                </c:pt>
                <c:pt idx="2495">
                  <c:v>701.55</c:v>
                </c:pt>
                <c:pt idx="2496">
                  <c:v>701.83</c:v>
                </c:pt>
                <c:pt idx="2497">
                  <c:v>702.11</c:v>
                </c:pt>
                <c:pt idx="2498">
                  <c:v>702.39</c:v>
                </c:pt>
                <c:pt idx="2499">
                  <c:v>702.67</c:v>
                </c:pt>
                <c:pt idx="2500">
                  <c:v>702.95</c:v>
                </c:pt>
                <c:pt idx="2501">
                  <c:v>703.23</c:v>
                </c:pt>
                <c:pt idx="2502">
                  <c:v>703.51</c:v>
                </c:pt>
                <c:pt idx="2503">
                  <c:v>703.79</c:v>
                </c:pt>
                <c:pt idx="2504">
                  <c:v>704.08</c:v>
                </c:pt>
                <c:pt idx="2505">
                  <c:v>704.35</c:v>
                </c:pt>
                <c:pt idx="2506">
                  <c:v>704.63</c:v>
                </c:pt>
                <c:pt idx="2507">
                  <c:v>704.92</c:v>
                </c:pt>
                <c:pt idx="2508">
                  <c:v>705.2</c:v>
                </c:pt>
                <c:pt idx="2509">
                  <c:v>705.48</c:v>
                </c:pt>
                <c:pt idx="2510">
                  <c:v>705.76</c:v>
                </c:pt>
                <c:pt idx="2511">
                  <c:v>706.04</c:v>
                </c:pt>
                <c:pt idx="2512">
                  <c:v>706.32</c:v>
                </c:pt>
                <c:pt idx="2513">
                  <c:v>706.6</c:v>
                </c:pt>
                <c:pt idx="2514">
                  <c:v>706.88</c:v>
                </c:pt>
                <c:pt idx="2515">
                  <c:v>707.16</c:v>
                </c:pt>
                <c:pt idx="2516">
                  <c:v>707.44</c:v>
                </c:pt>
                <c:pt idx="2517">
                  <c:v>707.72</c:v>
                </c:pt>
                <c:pt idx="2518">
                  <c:v>708.01</c:v>
                </c:pt>
                <c:pt idx="2519">
                  <c:v>708.29</c:v>
                </c:pt>
                <c:pt idx="2520">
                  <c:v>708.57</c:v>
                </c:pt>
                <c:pt idx="2521">
                  <c:v>708.85</c:v>
                </c:pt>
                <c:pt idx="2522">
                  <c:v>709.13</c:v>
                </c:pt>
                <c:pt idx="2523">
                  <c:v>709.41</c:v>
                </c:pt>
                <c:pt idx="2524">
                  <c:v>709.69</c:v>
                </c:pt>
                <c:pt idx="2525">
                  <c:v>709.97</c:v>
                </c:pt>
                <c:pt idx="2526">
                  <c:v>710.25</c:v>
                </c:pt>
                <c:pt idx="2527">
                  <c:v>710.53</c:v>
                </c:pt>
                <c:pt idx="2528">
                  <c:v>710.81</c:v>
                </c:pt>
                <c:pt idx="2529">
                  <c:v>711.1</c:v>
                </c:pt>
                <c:pt idx="2530">
                  <c:v>711.38</c:v>
                </c:pt>
                <c:pt idx="2531">
                  <c:v>711.65</c:v>
                </c:pt>
                <c:pt idx="2532">
                  <c:v>711.93</c:v>
                </c:pt>
                <c:pt idx="2533">
                  <c:v>712.22</c:v>
                </c:pt>
                <c:pt idx="2534">
                  <c:v>712.5</c:v>
                </c:pt>
                <c:pt idx="2535">
                  <c:v>712.78</c:v>
                </c:pt>
                <c:pt idx="2536">
                  <c:v>713.06</c:v>
                </c:pt>
                <c:pt idx="2537">
                  <c:v>713.34</c:v>
                </c:pt>
                <c:pt idx="2538">
                  <c:v>713.62</c:v>
                </c:pt>
                <c:pt idx="2539">
                  <c:v>713.9</c:v>
                </c:pt>
                <c:pt idx="2540">
                  <c:v>714.18</c:v>
                </c:pt>
                <c:pt idx="2541">
                  <c:v>714.46</c:v>
                </c:pt>
                <c:pt idx="2542">
                  <c:v>714.75</c:v>
                </c:pt>
                <c:pt idx="2543">
                  <c:v>715.02</c:v>
                </c:pt>
                <c:pt idx="2544">
                  <c:v>715.31</c:v>
                </c:pt>
                <c:pt idx="2545">
                  <c:v>715.59</c:v>
                </c:pt>
                <c:pt idx="2546">
                  <c:v>715.87</c:v>
                </c:pt>
                <c:pt idx="2547">
                  <c:v>716.14</c:v>
                </c:pt>
                <c:pt idx="2548">
                  <c:v>716.43</c:v>
                </c:pt>
                <c:pt idx="2549">
                  <c:v>716.71</c:v>
                </c:pt>
                <c:pt idx="2550">
                  <c:v>716.99</c:v>
                </c:pt>
                <c:pt idx="2551">
                  <c:v>717.27</c:v>
                </c:pt>
                <c:pt idx="2552">
                  <c:v>717.55</c:v>
                </c:pt>
                <c:pt idx="2553">
                  <c:v>717.83</c:v>
                </c:pt>
                <c:pt idx="2554">
                  <c:v>718.12</c:v>
                </c:pt>
                <c:pt idx="2555">
                  <c:v>718.39</c:v>
                </c:pt>
                <c:pt idx="2556">
                  <c:v>718.67</c:v>
                </c:pt>
                <c:pt idx="2557">
                  <c:v>718.96</c:v>
                </c:pt>
                <c:pt idx="2558">
                  <c:v>719.24</c:v>
                </c:pt>
                <c:pt idx="2559">
                  <c:v>719.52</c:v>
                </c:pt>
                <c:pt idx="2560">
                  <c:v>719.8</c:v>
                </c:pt>
                <c:pt idx="2561">
                  <c:v>720.08</c:v>
                </c:pt>
                <c:pt idx="2562">
                  <c:v>720.36</c:v>
                </c:pt>
                <c:pt idx="2563">
                  <c:v>720.64</c:v>
                </c:pt>
                <c:pt idx="2564">
                  <c:v>720.92</c:v>
                </c:pt>
                <c:pt idx="2565">
                  <c:v>721.2</c:v>
                </c:pt>
                <c:pt idx="2566">
                  <c:v>721.48</c:v>
                </c:pt>
                <c:pt idx="2567">
                  <c:v>721.76</c:v>
                </c:pt>
                <c:pt idx="2568">
                  <c:v>722.04</c:v>
                </c:pt>
                <c:pt idx="2569">
                  <c:v>722.33</c:v>
                </c:pt>
                <c:pt idx="2570">
                  <c:v>722.61</c:v>
                </c:pt>
                <c:pt idx="2571">
                  <c:v>722.88</c:v>
                </c:pt>
                <c:pt idx="2572">
                  <c:v>723.16</c:v>
                </c:pt>
                <c:pt idx="2573">
                  <c:v>723.45</c:v>
                </c:pt>
                <c:pt idx="2574">
                  <c:v>723.73</c:v>
                </c:pt>
                <c:pt idx="2575">
                  <c:v>724.01</c:v>
                </c:pt>
                <c:pt idx="2576">
                  <c:v>724.29</c:v>
                </c:pt>
                <c:pt idx="2577">
                  <c:v>724.57</c:v>
                </c:pt>
                <c:pt idx="2578">
                  <c:v>724.85</c:v>
                </c:pt>
                <c:pt idx="2579">
                  <c:v>725.13</c:v>
                </c:pt>
                <c:pt idx="2580">
                  <c:v>725.41</c:v>
                </c:pt>
                <c:pt idx="2581">
                  <c:v>725.69</c:v>
                </c:pt>
                <c:pt idx="2582">
                  <c:v>725.98</c:v>
                </c:pt>
                <c:pt idx="2583">
                  <c:v>726.26</c:v>
                </c:pt>
                <c:pt idx="2584">
                  <c:v>726.54</c:v>
                </c:pt>
                <c:pt idx="2585">
                  <c:v>726.82</c:v>
                </c:pt>
                <c:pt idx="2586">
                  <c:v>727.1</c:v>
                </c:pt>
                <c:pt idx="2587">
                  <c:v>727.38</c:v>
                </c:pt>
                <c:pt idx="2588">
                  <c:v>727.66</c:v>
                </c:pt>
                <c:pt idx="2589">
                  <c:v>727.94</c:v>
                </c:pt>
                <c:pt idx="2590">
                  <c:v>728.22</c:v>
                </c:pt>
                <c:pt idx="2591">
                  <c:v>728.5</c:v>
                </c:pt>
                <c:pt idx="2592">
                  <c:v>728.78</c:v>
                </c:pt>
                <c:pt idx="2593">
                  <c:v>729.07</c:v>
                </c:pt>
                <c:pt idx="2594">
                  <c:v>729.35</c:v>
                </c:pt>
                <c:pt idx="2595">
                  <c:v>729.63</c:v>
                </c:pt>
                <c:pt idx="2596">
                  <c:v>729.9</c:v>
                </c:pt>
                <c:pt idx="2597">
                  <c:v>730.19</c:v>
                </c:pt>
                <c:pt idx="2598">
                  <c:v>730.47</c:v>
                </c:pt>
                <c:pt idx="2599">
                  <c:v>730.75</c:v>
                </c:pt>
                <c:pt idx="2600">
                  <c:v>731.03</c:v>
                </c:pt>
                <c:pt idx="2601">
                  <c:v>731.31</c:v>
                </c:pt>
                <c:pt idx="2602">
                  <c:v>731.59</c:v>
                </c:pt>
                <c:pt idx="2603">
                  <c:v>731.87</c:v>
                </c:pt>
                <c:pt idx="2604">
                  <c:v>732.15</c:v>
                </c:pt>
                <c:pt idx="2605">
                  <c:v>732.44</c:v>
                </c:pt>
                <c:pt idx="2606">
                  <c:v>732.71</c:v>
                </c:pt>
                <c:pt idx="2607">
                  <c:v>733</c:v>
                </c:pt>
                <c:pt idx="2608">
                  <c:v>733.27</c:v>
                </c:pt>
                <c:pt idx="2609">
                  <c:v>733.56</c:v>
                </c:pt>
                <c:pt idx="2610">
                  <c:v>733.84</c:v>
                </c:pt>
                <c:pt idx="2611">
                  <c:v>734.12</c:v>
                </c:pt>
                <c:pt idx="2612">
                  <c:v>734.4</c:v>
                </c:pt>
                <c:pt idx="2613">
                  <c:v>734.68</c:v>
                </c:pt>
                <c:pt idx="2614">
                  <c:v>734.96</c:v>
                </c:pt>
                <c:pt idx="2615">
                  <c:v>735.24</c:v>
                </c:pt>
                <c:pt idx="2616">
                  <c:v>735.53</c:v>
                </c:pt>
                <c:pt idx="2617">
                  <c:v>735.8</c:v>
                </c:pt>
                <c:pt idx="2618">
                  <c:v>736.09</c:v>
                </c:pt>
                <c:pt idx="2619">
                  <c:v>736.37</c:v>
                </c:pt>
                <c:pt idx="2620">
                  <c:v>736.65</c:v>
                </c:pt>
                <c:pt idx="2621">
                  <c:v>736.93</c:v>
                </c:pt>
                <c:pt idx="2622">
                  <c:v>737.21</c:v>
                </c:pt>
                <c:pt idx="2623">
                  <c:v>737.49</c:v>
                </c:pt>
                <c:pt idx="2624">
                  <c:v>737.77</c:v>
                </c:pt>
                <c:pt idx="2625">
                  <c:v>738.05</c:v>
                </c:pt>
                <c:pt idx="2626">
                  <c:v>738.33</c:v>
                </c:pt>
                <c:pt idx="2627">
                  <c:v>738.61</c:v>
                </c:pt>
                <c:pt idx="2628">
                  <c:v>738.89</c:v>
                </c:pt>
                <c:pt idx="2629">
                  <c:v>739.17</c:v>
                </c:pt>
                <c:pt idx="2630">
                  <c:v>739.46</c:v>
                </c:pt>
                <c:pt idx="2631">
                  <c:v>739.74</c:v>
                </c:pt>
                <c:pt idx="2632">
                  <c:v>740.01</c:v>
                </c:pt>
                <c:pt idx="2633">
                  <c:v>740.3</c:v>
                </c:pt>
                <c:pt idx="2634">
                  <c:v>740.58</c:v>
                </c:pt>
                <c:pt idx="2635">
                  <c:v>740.86</c:v>
                </c:pt>
                <c:pt idx="2636">
                  <c:v>741.14</c:v>
                </c:pt>
                <c:pt idx="2637">
                  <c:v>741.42</c:v>
                </c:pt>
                <c:pt idx="2638">
                  <c:v>741.7</c:v>
                </c:pt>
                <c:pt idx="2639">
                  <c:v>741.98</c:v>
                </c:pt>
                <c:pt idx="2640">
                  <c:v>742.26</c:v>
                </c:pt>
                <c:pt idx="2641">
                  <c:v>742.55</c:v>
                </c:pt>
                <c:pt idx="2642">
                  <c:v>742.82</c:v>
                </c:pt>
                <c:pt idx="2643">
                  <c:v>743.1</c:v>
                </c:pt>
                <c:pt idx="2644">
                  <c:v>743.39</c:v>
                </c:pt>
                <c:pt idx="2645">
                  <c:v>743.66</c:v>
                </c:pt>
                <c:pt idx="2646">
                  <c:v>743.95</c:v>
                </c:pt>
                <c:pt idx="2647">
                  <c:v>744.23</c:v>
                </c:pt>
                <c:pt idx="2648">
                  <c:v>744.51</c:v>
                </c:pt>
                <c:pt idx="2649">
                  <c:v>744.79</c:v>
                </c:pt>
                <c:pt idx="2650">
                  <c:v>745.07</c:v>
                </c:pt>
                <c:pt idx="2651">
                  <c:v>745.35</c:v>
                </c:pt>
                <c:pt idx="2652">
                  <c:v>745.63</c:v>
                </c:pt>
                <c:pt idx="2653">
                  <c:v>745.91</c:v>
                </c:pt>
                <c:pt idx="2654">
                  <c:v>746.19</c:v>
                </c:pt>
                <c:pt idx="2655">
                  <c:v>746.48</c:v>
                </c:pt>
                <c:pt idx="2656">
                  <c:v>746.76</c:v>
                </c:pt>
                <c:pt idx="2657">
                  <c:v>747.03</c:v>
                </c:pt>
                <c:pt idx="2658">
                  <c:v>747.31</c:v>
                </c:pt>
                <c:pt idx="2659">
                  <c:v>747.6</c:v>
                </c:pt>
                <c:pt idx="2660">
                  <c:v>747.88</c:v>
                </c:pt>
                <c:pt idx="2661">
                  <c:v>748.16</c:v>
                </c:pt>
                <c:pt idx="2662">
                  <c:v>748.44</c:v>
                </c:pt>
                <c:pt idx="2663">
                  <c:v>748.72</c:v>
                </c:pt>
                <c:pt idx="2664">
                  <c:v>749</c:v>
                </c:pt>
                <c:pt idx="2665">
                  <c:v>749.29</c:v>
                </c:pt>
                <c:pt idx="2666">
                  <c:v>749.56</c:v>
                </c:pt>
                <c:pt idx="2667">
                  <c:v>749.84</c:v>
                </c:pt>
                <c:pt idx="2668">
                  <c:v>750.13</c:v>
                </c:pt>
                <c:pt idx="2669">
                  <c:v>750.41</c:v>
                </c:pt>
                <c:pt idx="2670">
                  <c:v>750.69</c:v>
                </c:pt>
                <c:pt idx="2671">
                  <c:v>750.97</c:v>
                </c:pt>
                <c:pt idx="2672">
                  <c:v>751.25</c:v>
                </c:pt>
                <c:pt idx="2673">
                  <c:v>751.53</c:v>
                </c:pt>
                <c:pt idx="2674">
                  <c:v>751.81</c:v>
                </c:pt>
                <c:pt idx="2675">
                  <c:v>752.09</c:v>
                </c:pt>
                <c:pt idx="2676">
                  <c:v>752.37</c:v>
                </c:pt>
                <c:pt idx="2677">
                  <c:v>752.65</c:v>
                </c:pt>
                <c:pt idx="2678">
                  <c:v>752.93</c:v>
                </c:pt>
                <c:pt idx="2679">
                  <c:v>753.21</c:v>
                </c:pt>
                <c:pt idx="2680">
                  <c:v>753.5</c:v>
                </c:pt>
                <c:pt idx="2681">
                  <c:v>753.78</c:v>
                </c:pt>
                <c:pt idx="2682">
                  <c:v>754.06</c:v>
                </c:pt>
                <c:pt idx="2683">
                  <c:v>754.34</c:v>
                </c:pt>
                <c:pt idx="2684">
                  <c:v>754.62</c:v>
                </c:pt>
                <c:pt idx="2685">
                  <c:v>754.9</c:v>
                </c:pt>
                <c:pt idx="2686">
                  <c:v>755.18</c:v>
                </c:pt>
                <c:pt idx="2687">
                  <c:v>755.46</c:v>
                </c:pt>
                <c:pt idx="2688">
                  <c:v>755.74</c:v>
                </c:pt>
                <c:pt idx="2689">
                  <c:v>756.02</c:v>
                </c:pt>
                <c:pt idx="2690">
                  <c:v>756.3</c:v>
                </c:pt>
                <c:pt idx="2691">
                  <c:v>756.58</c:v>
                </c:pt>
                <c:pt idx="2692">
                  <c:v>756.86</c:v>
                </c:pt>
                <c:pt idx="2693">
                  <c:v>757.14</c:v>
                </c:pt>
                <c:pt idx="2694">
                  <c:v>757.43</c:v>
                </c:pt>
                <c:pt idx="2695">
                  <c:v>757.71</c:v>
                </c:pt>
                <c:pt idx="2696">
                  <c:v>757.99</c:v>
                </c:pt>
                <c:pt idx="2697">
                  <c:v>758.27</c:v>
                </c:pt>
                <c:pt idx="2698">
                  <c:v>758.55</c:v>
                </c:pt>
                <c:pt idx="2699">
                  <c:v>758.83</c:v>
                </c:pt>
                <c:pt idx="2700">
                  <c:v>759.11</c:v>
                </c:pt>
                <c:pt idx="2701">
                  <c:v>759.39</c:v>
                </c:pt>
                <c:pt idx="2702">
                  <c:v>759.67</c:v>
                </c:pt>
                <c:pt idx="2703">
                  <c:v>759.95</c:v>
                </c:pt>
                <c:pt idx="2704">
                  <c:v>760.23</c:v>
                </c:pt>
                <c:pt idx="2705">
                  <c:v>760.52</c:v>
                </c:pt>
                <c:pt idx="2706">
                  <c:v>760.8</c:v>
                </c:pt>
                <c:pt idx="2707">
                  <c:v>761.08</c:v>
                </c:pt>
                <c:pt idx="2708">
                  <c:v>761.36</c:v>
                </c:pt>
                <c:pt idx="2709">
                  <c:v>761.64</c:v>
                </c:pt>
                <c:pt idx="2710">
                  <c:v>761.92</c:v>
                </c:pt>
                <c:pt idx="2711">
                  <c:v>762.2</c:v>
                </c:pt>
                <c:pt idx="2712">
                  <c:v>762.48</c:v>
                </c:pt>
                <c:pt idx="2713">
                  <c:v>762.76</c:v>
                </c:pt>
                <c:pt idx="2714">
                  <c:v>763.04</c:v>
                </c:pt>
                <c:pt idx="2715">
                  <c:v>763.32</c:v>
                </c:pt>
                <c:pt idx="2716">
                  <c:v>763.61</c:v>
                </c:pt>
                <c:pt idx="2717">
                  <c:v>763.89</c:v>
                </c:pt>
                <c:pt idx="2718">
                  <c:v>764.16</c:v>
                </c:pt>
                <c:pt idx="2719">
                  <c:v>764.45</c:v>
                </c:pt>
                <c:pt idx="2720">
                  <c:v>764.73</c:v>
                </c:pt>
                <c:pt idx="2721">
                  <c:v>765.01</c:v>
                </c:pt>
                <c:pt idx="2722">
                  <c:v>765.29</c:v>
                </c:pt>
                <c:pt idx="2723">
                  <c:v>765.57</c:v>
                </c:pt>
                <c:pt idx="2724">
                  <c:v>765.85</c:v>
                </c:pt>
                <c:pt idx="2725">
                  <c:v>766.13</c:v>
                </c:pt>
                <c:pt idx="2726">
                  <c:v>766.41</c:v>
                </c:pt>
                <c:pt idx="2727">
                  <c:v>766.69</c:v>
                </c:pt>
                <c:pt idx="2728">
                  <c:v>766.97</c:v>
                </c:pt>
                <c:pt idx="2729">
                  <c:v>767.25</c:v>
                </c:pt>
                <c:pt idx="2730">
                  <c:v>767.54</c:v>
                </c:pt>
                <c:pt idx="2731">
                  <c:v>767.82</c:v>
                </c:pt>
                <c:pt idx="2732">
                  <c:v>768.1</c:v>
                </c:pt>
                <c:pt idx="2733">
                  <c:v>768.38</c:v>
                </c:pt>
                <c:pt idx="2734">
                  <c:v>768.65</c:v>
                </c:pt>
                <c:pt idx="2735">
                  <c:v>768.94</c:v>
                </c:pt>
                <c:pt idx="2736">
                  <c:v>769.22</c:v>
                </c:pt>
                <c:pt idx="2737">
                  <c:v>769.5</c:v>
                </c:pt>
                <c:pt idx="2738">
                  <c:v>769.78</c:v>
                </c:pt>
                <c:pt idx="2739">
                  <c:v>770.06</c:v>
                </c:pt>
                <c:pt idx="2740">
                  <c:v>770.34</c:v>
                </c:pt>
                <c:pt idx="2741">
                  <c:v>770.62</c:v>
                </c:pt>
                <c:pt idx="2742">
                  <c:v>770.91</c:v>
                </c:pt>
                <c:pt idx="2743">
                  <c:v>771.18</c:v>
                </c:pt>
                <c:pt idx="2744">
                  <c:v>771.46</c:v>
                </c:pt>
                <c:pt idx="2745">
                  <c:v>771.75</c:v>
                </c:pt>
                <c:pt idx="2746">
                  <c:v>772.03</c:v>
                </c:pt>
                <c:pt idx="2747">
                  <c:v>772.31</c:v>
                </c:pt>
                <c:pt idx="2748">
                  <c:v>772.59</c:v>
                </c:pt>
                <c:pt idx="2749">
                  <c:v>772.87</c:v>
                </c:pt>
                <c:pt idx="2750">
                  <c:v>773.15</c:v>
                </c:pt>
                <c:pt idx="2751">
                  <c:v>773.43</c:v>
                </c:pt>
                <c:pt idx="2752">
                  <c:v>773.71</c:v>
                </c:pt>
                <c:pt idx="2753">
                  <c:v>773.99</c:v>
                </c:pt>
                <c:pt idx="2754">
                  <c:v>774.27</c:v>
                </c:pt>
                <c:pt idx="2755">
                  <c:v>774.56</c:v>
                </c:pt>
                <c:pt idx="2756">
                  <c:v>774.84</c:v>
                </c:pt>
                <c:pt idx="2757">
                  <c:v>775.12</c:v>
                </c:pt>
                <c:pt idx="2758">
                  <c:v>775.4</c:v>
                </c:pt>
                <c:pt idx="2759">
                  <c:v>775.67</c:v>
                </c:pt>
                <c:pt idx="2760">
                  <c:v>775.96</c:v>
                </c:pt>
                <c:pt idx="2761">
                  <c:v>776.24</c:v>
                </c:pt>
                <c:pt idx="2762">
                  <c:v>776.52</c:v>
                </c:pt>
                <c:pt idx="2763">
                  <c:v>776.8</c:v>
                </c:pt>
                <c:pt idx="2764">
                  <c:v>777.08</c:v>
                </c:pt>
                <c:pt idx="2765">
                  <c:v>777.36</c:v>
                </c:pt>
                <c:pt idx="2766">
                  <c:v>777.64</c:v>
                </c:pt>
                <c:pt idx="2767">
                  <c:v>777.93</c:v>
                </c:pt>
                <c:pt idx="2768">
                  <c:v>778.2</c:v>
                </c:pt>
                <c:pt idx="2769">
                  <c:v>778.48</c:v>
                </c:pt>
                <c:pt idx="2770">
                  <c:v>778.76</c:v>
                </c:pt>
                <c:pt idx="2771">
                  <c:v>779.05</c:v>
                </c:pt>
                <c:pt idx="2772">
                  <c:v>779.33</c:v>
                </c:pt>
                <c:pt idx="2773">
                  <c:v>779.61</c:v>
                </c:pt>
                <c:pt idx="2774">
                  <c:v>779.89</c:v>
                </c:pt>
                <c:pt idx="2775">
                  <c:v>780.17</c:v>
                </c:pt>
                <c:pt idx="2776">
                  <c:v>780.45</c:v>
                </c:pt>
                <c:pt idx="2777">
                  <c:v>780.73</c:v>
                </c:pt>
                <c:pt idx="2778">
                  <c:v>781.01</c:v>
                </c:pt>
                <c:pt idx="2779">
                  <c:v>781.29</c:v>
                </c:pt>
                <c:pt idx="2780">
                  <c:v>781.58</c:v>
                </c:pt>
                <c:pt idx="2781">
                  <c:v>781.86</c:v>
                </c:pt>
                <c:pt idx="2782">
                  <c:v>782.14</c:v>
                </c:pt>
                <c:pt idx="2783">
                  <c:v>782.42</c:v>
                </c:pt>
                <c:pt idx="2784">
                  <c:v>782.69</c:v>
                </c:pt>
                <c:pt idx="2785">
                  <c:v>782.98</c:v>
                </c:pt>
                <c:pt idx="2786">
                  <c:v>783.26</c:v>
                </c:pt>
                <c:pt idx="2787">
                  <c:v>783.54</c:v>
                </c:pt>
                <c:pt idx="2788">
                  <c:v>783.82</c:v>
                </c:pt>
                <c:pt idx="2789">
                  <c:v>784.1</c:v>
                </c:pt>
                <c:pt idx="2790">
                  <c:v>784.38</c:v>
                </c:pt>
                <c:pt idx="2791">
                  <c:v>784.66</c:v>
                </c:pt>
                <c:pt idx="2792">
                  <c:v>784.94</c:v>
                </c:pt>
                <c:pt idx="2793">
                  <c:v>785.22</c:v>
                </c:pt>
                <c:pt idx="2794">
                  <c:v>785.5</c:v>
                </c:pt>
                <c:pt idx="2795">
                  <c:v>785.79</c:v>
                </c:pt>
                <c:pt idx="2796">
                  <c:v>786.07</c:v>
                </c:pt>
                <c:pt idx="2797">
                  <c:v>786.35</c:v>
                </c:pt>
                <c:pt idx="2798">
                  <c:v>786.63</c:v>
                </c:pt>
                <c:pt idx="2799">
                  <c:v>786.91</c:v>
                </c:pt>
                <c:pt idx="2800">
                  <c:v>787.19</c:v>
                </c:pt>
                <c:pt idx="2801">
                  <c:v>787.47</c:v>
                </c:pt>
                <c:pt idx="2802">
                  <c:v>787.75</c:v>
                </c:pt>
                <c:pt idx="2803">
                  <c:v>788.03</c:v>
                </c:pt>
                <c:pt idx="2804">
                  <c:v>788.31</c:v>
                </c:pt>
                <c:pt idx="2805">
                  <c:v>788.6</c:v>
                </c:pt>
                <c:pt idx="2806">
                  <c:v>788.88</c:v>
                </c:pt>
                <c:pt idx="2807">
                  <c:v>789.15</c:v>
                </c:pt>
                <c:pt idx="2808">
                  <c:v>789.44</c:v>
                </c:pt>
                <c:pt idx="2809">
                  <c:v>789.71</c:v>
                </c:pt>
                <c:pt idx="2810">
                  <c:v>790</c:v>
                </c:pt>
                <c:pt idx="2811">
                  <c:v>790.28</c:v>
                </c:pt>
                <c:pt idx="2812">
                  <c:v>790.56</c:v>
                </c:pt>
                <c:pt idx="2813">
                  <c:v>790.84</c:v>
                </c:pt>
                <c:pt idx="2814">
                  <c:v>791.12</c:v>
                </c:pt>
                <c:pt idx="2815">
                  <c:v>791.4</c:v>
                </c:pt>
                <c:pt idx="2816">
                  <c:v>791.68</c:v>
                </c:pt>
                <c:pt idx="2817">
                  <c:v>791.97</c:v>
                </c:pt>
                <c:pt idx="2818">
                  <c:v>792.24</c:v>
                </c:pt>
                <c:pt idx="2819">
                  <c:v>792.53</c:v>
                </c:pt>
                <c:pt idx="2820">
                  <c:v>792.81</c:v>
                </c:pt>
                <c:pt idx="2821">
                  <c:v>793.09</c:v>
                </c:pt>
                <c:pt idx="2822">
                  <c:v>793.37</c:v>
                </c:pt>
                <c:pt idx="2823">
                  <c:v>793.65</c:v>
                </c:pt>
                <c:pt idx="2824">
                  <c:v>793.93</c:v>
                </c:pt>
                <c:pt idx="2825">
                  <c:v>794.21</c:v>
                </c:pt>
                <c:pt idx="2826">
                  <c:v>794.49</c:v>
                </c:pt>
                <c:pt idx="2827">
                  <c:v>794.77</c:v>
                </c:pt>
                <c:pt idx="2828">
                  <c:v>795.05</c:v>
                </c:pt>
                <c:pt idx="2829">
                  <c:v>795.33</c:v>
                </c:pt>
                <c:pt idx="2830">
                  <c:v>795.61</c:v>
                </c:pt>
                <c:pt idx="2831">
                  <c:v>795.9</c:v>
                </c:pt>
                <c:pt idx="2832">
                  <c:v>796.17</c:v>
                </c:pt>
                <c:pt idx="2833">
                  <c:v>796.46</c:v>
                </c:pt>
                <c:pt idx="2834">
                  <c:v>796.74</c:v>
                </c:pt>
                <c:pt idx="2835">
                  <c:v>797.02</c:v>
                </c:pt>
                <c:pt idx="2836">
                  <c:v>797.3</c:v>
                </c:pt>
                <c:pt idx="2837">
                  <c:v>797.58</c:v>
                </c:pt>
                <c:pt idx="2838">
                  <c:v>797.86</c:v>
                </c:pt>
                <c:pt idx="2839">
                  <c:v>798.14</c:v>
                </c:pt>
                <c:pt idx="2840">
                  <c:v>798.42</c:v>
                </c:pt>
                <c:pt idx="2841">
                  <c:v>798.7</c:v>
                </c:pt>
                <c:pt idx="2842">
                  <c:v>798.99</c:v>
                </c:pt>
                <c:pt idx="2843">
                  <c:v>799.26</c:v>
                </c:pt>
                <c:pt idx="2844">
                  <c:v>799.55</c:v>
                </c:pt>
                <c:pt idx="2845">
                  <c:v>799.83</c:v>
                </c:pt>
                <c:pt idx="2846">
                  <c:v>800.11</c:v>
                </c:pt>
                <c:pt idx="2847">
                  <c:v>800.39</c:v>
                </c:pt>
                <c:pt idx="2848">
                  <c:v>800.67</c:v>
                </c:pt>
                <c:pt idx="2849">
                  <c:v>800.95</c:v>
                </c:pt>
                <c:pt idx="2850">
                  <c:v>801.23</c:v>
                </c:pt>
                <c:pt idx="2851">
                  <c:v>801.51</c:v>
                </c:pt>
                <c:pt idx="2852">
                  <c:v>801.79</c:v>
                </c:pt>
                <c:pt idx="2853">
                  <c:v>802.08</c:v>
                </c:pt>
                <c:pt idx="2854">
                  <c:v>802.35</c:v>
                </c:pt>
                <c:pt idx="2855">
                  <c:v>802.63</c:v>
                </c:pt>
                <c:pt idx="2856">
                  <c:v>802.92</c:v>
                </c:pt>
                <c:pt idx="2857">
                  <c:v>803.2</c:v>
                </c:pt>
                <c:pt idx="2858">
                  <c:v>803.48</c:v>
                </c:pt>
                <c:pt idx="2859">
                  <c:v>803.76</c:v>
                </c:pt>
                <c:pt idx="2860">
                  <c:v>804.04</c:v>
                </c:pt>
                <c:pt idx="2861">
                  <c:v>804.32</c:v>
                </c:pt>
                <c:pt idx="2862">
                  <c:v>804.6</c:v>
                </c:pt>
                <c:pt idx="2863">
                  <c:v>804.88</c:v>
                </c:pt>
                <c:pt idx="2864">
                  <c:v>805.16</c:v>
                </c:pt>
                <c:pt idx="2865">
                  <c:v>805.44</c:v>
                </c:pt>
                <c:pt idx="2866">
                  <c:v>805.72</c:v>
                </c:pt>
                <c:pt idx="2867">
                  <c:v>806.01</c:v>
                </c:pt>
                <c:pt idx="2868">
                  <c:v>806.28</c:v>
                </c:pt>
                <c:pt idx="2869">
                  <c:v>806.57</c:v>
                </c:pt>
                <c:pt idx="2870">
                  <c:v>806.85</c:v>
                </c:pt>
                <c:pt idx="2871">
                  <c:v>807.13</c:v>
                </c:pt>
                <c:pt idx="2872">
                  <c:v>807.41</c:v>
                </c:pt>
                <c:pt idx="2873">
                  <c:v>807.69</c:v>
                </c:pt>
                <c:pt idx="2874">
                  <c:v>807.97</c:v>
                </c:pt>
                <c:pt idx="2875">
                  <c:v>808.25</c:v>
                </c:pt>
                <c:pt idx="2876">
                  <c:v>808.53</c:v>
                </c:pt>
                <c:pt idx="2877">
                  <c:v>808.81</c:v>
                </c:pt>
                <c:pt idx="2878">
                  <c:v>809.1</c:v>
                </c:pt>
                <c:pt idx="2879">
                  <c:v>809.37</c:v>
                </c:pt>
                <c:pt idx="2880">
                  <c:v>809.65</c:v>
                </c:pt>
                <c:pt idx="2881">
                  <c:v>809.93</c:v>
                </c:pt>
                <c:pt idx="2882">
                  <c:v>810.22</c:v>
                </c:pt>
                <c:pt idx="2883">
                  <c:v>810.5</c:v>
                </c:pt>
                <c:pt idx="2884">
                  <c:v>810.78</c:v>
                </c:pt>
                <c:pt idx="2885">
                  <c:v>811.06</c:v>
                </c:pt>
                <c:pt idx="2886">
                  <c:v>811.34</c:v>
                </c:pt>
                <c:pt idx="2887">
                  <c:v>811.62</c:v>
                </c:pt>
                <c:pt idx="2888">
                  <c:v>811.9</c:v>
                </c:pt>
                <c:pt idx="2889">
                  <c:v>812.18</c:v>
                </c:pt>
                <c:pt idx="2890">
                  <c:v>812.46</c:v>
                </c:pt>
                <c:pt idx="2891">
                  <c:v>812.74</c:v>
                </c:pt>
                <c:pt idx="2892">
                  <c:v>813.02</c:v>
                </c:pt>
                <c:pt idx="2893">
                  <c:v>813.3</c:v>
                </c:pt>
                <c:pt idx="2894">
                  <c:v>813.59</c:v>
                </c:pt>
                <c:pt idx="2895">
                  <c:v>813.87</c:v>
                </c:pt>
                <c:pt idx="2896">
                  <c:v>814.15</c:v>
                </c:pt>
                <c:pt idx="2897">
                  <c:v>814.43</c:v>
                </c:pt>
                <c:pt idx="2898">
                  <c:v>814.71</c:v>
                </c:pt>
                <c:pt idx="2899">
                  <c:v>814.99</c:v>
                </c:pt>
                <c:pt idx="2900">
                  <c:v>815.27</c:v>
                </c:pt>
                <c:pt idx="2901">
                  <c:v>815.55</c:v>
                </c:pt>
                <c:pt idx="2902">
                  <c:v>815.83</c:v>
                </c:pt>
                <c:pt idx="2903">
                  <c:v>816.11</c:v>
                </c:pt>
                <c:pt idx="2904">
                  <c:v>816.39</c:v>
                </c:pt>
                <c:pt idx="2905">
                  <c:v>816.67</c:v>
                </c:pt>
                <c:pt idx="2906">
                  <c:v>816.96</c:v>
                </c:pt>
                <c:pt idx="2907">
                  <c:v>817.23</c:v>
                </c:pt>
                <c:pt idx="2908">
                  <c:v>817.52</c:v>
                </c:pt>
                <c:pt idx="2909">
                  <c:v>817.8</c:v>
                </c:pt>
                <c:pt idx="2910">
                  <c:v>818.08</c:v>
                </c:pt>
                <c:pt idx="2911">
                  <c:v>818.36</c:v>
                </c:pt>
                <c:pt idx="2912">
                  <c:v>818.64</c:v>
                </c:pt>
                <c:pt idx="2913">
                  <c:v>818.92</c:v>
                </c:pt>
                <c:pt idx="2914">
                  <c:v>819.2</c:v>
                </c:pt>
                <c:pt idx="2915">
                  <c:v>819.48</c:v>
                </c:pt>
                <c:pt idx="2916">
                  <c:v>819.77</c:v>
                </c:pt>
                <c:pt idx="2917">
                  <c:v>820.05</c:v>
                </c:pt>
                <c:pt idx="2918">
                  <c:v>820.32</c:v>
                </c:pt>
                <c:pt idx="2919">
                  <c:v>820.61</c:v>
                </c:pt>
                <c:pt idx="2920">
                  <c:v>820.88</c:v>
                </c:pt>
                <c:pt idx="2921">
                  <c:v>821.16</c:v>
                </c:pt>
                <c:pt idx="2922">
                  <c:v>821.45</c:v>
                </c:pt>
                <c:pt idx="2923">
                  <c:v>821.73</c:v>
                </c:pt>
                <c:pt idx="2924">
                  <c:v>822.01</c:v>
                </c:pt>
                <c:pt idx="2925">
                  <c:v>822.29</c:v>
                </c:pt>
                <c:pt idx="2926">
                  <c:v>822.57</c:v>
                </c:pt>
                <c:pt idx="2927">
                  <c:v>822.85</c:v>
                </c:pt>
                <c:pt idx="2928">
                  <c:v>823.13</c:v>
                </c:pt>
                <c:pt idx="2929">
                  <c:v>823.41</c:v>
                </c:pt>
                <c:pt idx="2930">
                  <c:v>823.69</c:v>
                </c:pt>
                <c:pt idx="2931">
                  <c:v>823.97</c:v>
                </c:pt>
                <c:pt idx="2932">
                  <c:v>824.25</c:v>
                </c:pt>
                <c:pt idx="2933">
                  <c:v>824.54</c:v>
                </c:pt>
                <c:pt idx="2934">
                  <c:v>824.82</c:v>
                </c:pt>
                <c:pt idx="2935">
                  <c:v>825.1</c:v>
                </c:pt>
                <c:pt idx="2936">
                  <c:v>825.38</c:v>
                </c:pt>
                <c:pt idx="2937">
                  <c:v>825.66</c:v>
                </c:pt>
                <c:pt idx="2938">
                  <c:v>825.94</c:v>
                </c:pt>
                <c:pt idx="2939">
                  <c:v>826.22</c:v>
                </c:pt>
                <c:pt idx="2940">
                  <c:v>826.5</c:v>
                </c:pt>
                <c:pt idx="2941">
                  <c:v>826.79</c:v>
                </c:pt>
                <c:pt idx="2942">
                  <c:v>827.07</c:v>
                </c:pt>
                <c:pt idx="2943">
                  <c:v>827.35</c:v>
                </c:pt>
                <c:pt idx="2944">
                  <c:v>827.63</c:v>
                </c:pt>
                <c:pt idx="2945">
                  <c:v>827.91</c:v>
                </c:pt>
                <c:pt idx="2946">
                  <c:v>828.19</c:v>
                </c:pt>
                <c:pt idx="2947">
                  <c:v>828.47</c:v>
                </c:pt>
                <c:pt idx="2948">
                  <c:v>828.75</c:v>
                </c:pt>
                <c:pt idx="2949">
                  <c:v>829.03</c:v>
                </c:pt>
                <c:pt idx="2950">
                  <c:v>829.31</c:v>
                </c:pt>
                <c:pt idx="2951">
                  <c:v>829.59</c:v>
                </c:pt>
                <c:pt idx="2952">
                  <c:v>829.87</c:v>
                </c:pt>
                <c:pt idx="2953">
                  <c:v>830.15</c:v>
                </c:pt>
                <c:pt idx="2954">
                  <c:v>830.43</c:v>
                </c:pt>
                <c:pt idx="2955">
                  <c:v>830.71</c:v>
                </c:pt>
                <c:pt idx="2956">
                  <c:v>830.99</c:v>
                </c:pt>
                <c:pt idx="2957">
                  <c:v>831.28</c:v>
                </c:pt>
                <c:pt idx="2958">
                  <c:v>831.56</c:v>
                </c:pt>
                <c:pt idx="2959">
                  <c:v>831.84</c:v>
                </c:pt>
                <c:pt idx="2960">
                  <c:v>832.12</c:v>
                </c:pt>
                <c:pt idx="2961">
                  <c:v>832.4</c:v>
                </c:pt>
                <c:pt idx="2962">
                  <c:v>832.68</c:v>
                </c:pt>
                <c:pt idx="2963">
                  <c:v>832.96</c:v>
                </c:pt>
                <c:pt idx="2964">
                  <c:v>833.24</c:v>
                </c:pt>
                <c:pt idx="2965">
                  <c:v>833.52</c:v>
                </c:pt>
                <c:pt idx="2966">
                  <c:v>833.8</c:v>
                </c:pt>
                <c:pt idx="2967">
                  <c:v>834.08</c:v>
                </c:pt>
                <c:pt idx="2968">
                  <c:v>834.36</c:v>
                </c:pt>
                <c:pt idx="2969">
                  <c:v>834.65</c:v>
                </c:pt>
                <c:pt idx="2970">
                  <c:v>834.92</c:v>
                </c:pt>
                <c:pt idx="2971">
                  <c:v>835.21</c:v>
                </c:pt>
                <c:pt idx="2972">
                  <c:v>835.49</c:v>
                </c:pt>
                <c:pt idx="2973">
                  <c:v>835.77</c:v>
                </c:pt>
                <c:pt idx="2974">
                  <c:v>836.05</c:v>
                </c:pt>
                <c:pt idx="2975">
                  <c:v>836.33</c:v>
                </c:pt>
                <c:pt idx="2976">
                  <c:v>836.61</c:v>
                </c:pt>
                <c:pt idx="2977">
                  <c:v>836.89</c:v>
                </c:pt>
                <c:pt idx="2978">
                  <c:v>837.17</c:v>
                </c:pt>
                <c:pt idx="2979">
                  <c:v>837.45</c:v>
                </c:pt>
                <c:pt idx="2980">
                  <c:v>837.73</c:v>
                </c:pt>
                <c:pt idx="2981">
                  <c:v>838.01</c:v>
                </c:pt>
                <c:pt idx="2982">
                  <c:v>838.29</c:v>
                </c:pt>
                <c:pt idx="2983">
                  <c:v>838.58</c:v>
                </c:pt>
                <c:pt idx="2984">
                  <c:v>838.86</c:v>
                </c:pt>
                <c:pt idx="2985">
                  <c:v>839.14</c:v>
                </c:pt>
                <c:pt idx="2986">
                  <c:v>839.42</c:v>
                </c:pt>
                <c:pt idx="2987">
                  <c:v>839.7</c:v>
                </c:pt>
                <c:pt idx="2988">
                  <c:v>839.98</c:v>
                </c:pt>
                <c:pt idx="2989">
                  <c:v>840.26</c:v>
                </c:pt>
                <c:pt idx="2990">
                  <c:v>840.54</c:v>
                </c:pt>
                <c:pt idx="2991">
                  <c:v>840.83</c:v>
                </c:pt>
                <c:pt idx="2992">
                  <c:v>841.11</c:v>
                </c:pt>
                <c:pt idx="2993">
                  <c:v>841.38</c:v>
                </c:pt>
                <c:pt idx="2994">
                  <c:v>841.66</c:v>
                </c:pt>
                <c:pt idx="2995">
                  <c:v>841.95</c:v>
                </c:pt>
                <c:pt idx="2996">
                  <c:v>842.23</c:v>
                </c:pt>
                <c:pt idx="2997">
                  <c:v>842.51</c:v>
                </c:pt>
                <c:pt idx="2998">
                  <c:v>842.79</c:v>
                </c:pt>
                <c:pt idx="2999">
                  <c:v>843.07</c:v>
                </c:pt>
                <c:pt idx="3000">
                  <c:v>843.35</c:v>
                </c:pt>
                <c:pt idx="3001">
                  <c:v>843.63</c:v>
                </c:pt>
                <c:pt idx="3002">
                  <c:v>843.91</c:v>
                </c:pt>
                <c:pt idx="3003">
                  <c:v>844.19</c:v>
                </c:pt>
                <c:pt idx="3004">
                  <c:v>844.47</c:v>
                </c:pt>
                <c:pt idx="3005">
                  <c:v>844.75</c:v>
                </c:pt>
                <c:pt idx="3006">
                  <c:v>845.04</c:v>
                </c:pt>
                <c:pt idx="3007">
                  <c:v>845.32</c:v>
                </c:pt>
                <c:pt idx="3008">
                  <c:v>845.6</c:v>
                </c:pt>
                <c:pt idx="3009">
                  <c:v>845.88</c:v>
                </c:pt>
                <c:pt idx="3010">
                  <c:v>846.16</c:v>
                </c:pt>
                <c:pt idx="3011">
                  <c:v>846.44</c:v>
                </c:pt>
                <c:pt idx="3012">
                  <c:v>846.72</c:v>
                </c:pt>
                <c:pt idx="3013">
                  <c:v>847</c:v>
                </c:pt>
                <c:pt idx="3014">
                  <c:v>847.28</c:v>
                </c:pt>
                <c:pt idx="3015">
                  <c:v>847.56</c:v>
                </c:pt>
                <c:pt idx="3016">
                  <c:v>847.84</c:v>
                </c:pt>
                <c:pt idx="3017">
                  <c:v>848.12</c:v>
                </c:pt>
                <c:pt idx="3018">
                  <c:v>848.41</c:v>
                </c:pt>
                <c:pt idx="3019">
                  <c:v>848.68</c:v>
                </c:pt>
                <c:pt idx="3020">
                  <c:v>848.96</c:v>
                </c:pt>
                <c:pt idx="3021">
                  <c:v>849.25</c:v>
                </c:pt>
                <c:pt idx="3022">
                  <c:v>849.53</c:v>
                </c:pt>
                <c:pt idx="3023">
                  <c:v>849.81</c:v>
                </c:pt>
                <c:pt idx="3024">
                  <c:v>850.09</c:v>
                </c:pt>
                <c:pt idx="3025">
                  <c:v>850.37</c:v>
                </c:pt>
                <c:pt idx="3026">
                  <c:v>850.65</c:v>
                </c:pt>
                <c:pt idx="3027">
                  <c:v>850.93</c:v>
                </c:pt>
                <c:pt idx="3028">
                  <c:v>851.21</c:v>
                </c:pt>
                <c:pt idx="3029">
                  <c:v>851.49</c:v>
                </c:pt>
                <c:pt idx="3030">
                  <c:v>851.77</c:v>
                </c:pt>
                <c:pt idx="3031">
                  <c:v>852.05</c:v>
                </c:pt>
                <c:pt idx="3032">
                  <c:v>852.34</c:v>
                </c:pt>
                <c:pt idx="3033">
                  <c:v>852.62</c:v>
                </c:pt>
                <c:pt idx="3034">
                  <c:v>852.9</c:v>
                </c:pt>
                <c:pt idx="3035">
                  <c:v>853.18</c:v>
                </c:pt>
                <c:pt idx="3036">
                  <c:v>853.46</c:v>
                </c:pt>
                <c:pt idx="3037">
                  <c:v>853.74</c:v>
                </c:pt>
                <c:pt idx="3038">
                  <c:v>854.02</c:v>
                </c:pt>
                <c:pt idx="3039">
                  <c:v>854.3</c:v>
                </c:pt>
                <c:pt idx="3040">
                  <c:v>854.58</c:v>
                </c:pt>
                <c:pt idx="3041">
                  <c:v>854.86</c:v>
                </c:pt>
                <c:pt idx="3042">
                  <c:v>855.14</c:v>
                </c:pt>
                <c:pt idx="3043">
                  <c:v>855.43</c:v>
                </c:pt>
                <c:pt idx="3044">
                  <c:v>855.71</c:v>
                </c:pt>
                <c:pt idx="3045">
                  <c:v>855.99</c:v>
                </c:pt>
                <c:pt idx="3046">
                  <c:v>856.27</c:v>
                </c:pt>
                <c:pt idx="3047">
                  <c:v>856.55</c:v>
                </c:pt>
                <c:pt idx="3048">
                  <c:v>856.83</c:v>
                </c:pt>
                <c:pt idx="3049">
                  <c:v>857.11</c:v>
                </c:pt>
                <c:pt idx="3050">
                  <c:v>857.39</c:v>
                </c:pt>
                <c:pt idx="3051">
                  <c:v>857.67</c:v>
                </c:pt>
                <c:pt idx="3052">
                  <c:v>857.95</c:v>
                </c:pt>
                <c:pt idx="3053">
                  <c:v>858.24</c:v>
                </c:pt>
                <c:pt idx="3054">
                  <c:v>858.52</c:v>
                </c:pt>
                <c:pt idx="3055">
                  <c:v>858.79</c:v>
                </c:pt>
                <c:pt idx="3056">
                  <c:v>859.08</c:v>
                </c:pt>
                <c:pt idx="3057">
                  <c:v>859.36</c:v>
                </c:pt>
                <c:pt idx="3058">
                  <c:v>859.63</c:v>
                </c:pt>
                <c:pt idx="3059">
                  <c:v>859.92</c:v>
                </c:pt>
                <c:pt idx="3060">
                  <c:v>860.2</c:v>
                </c:pt>
                <c:pt idx="3061">
                  <c:v>860.48</c:v>
                </c:pt>
                <c:pt idx="3062">
                  <c:v>860.76</c:v>
                </c:pt>
                <c:pt idx="3063">
                  <c:v>861.04</c:v>
                </c:pt>
                <c:pt idx="3064">
                  <c:v>861.32</c:v>
                </c:pt>
                <c:pt idx="3065">
                  <c:v>861.6</c:v>
                </c:pt>
                <c:pt idx="3066">
                  <c:v>861.88</c:v>
                </c:pt>
                <c:pt idx="3067">
                  <c:v>862.16</c:v>
                </c:pt>
                <c:pt idx="3068">
                  <c:v>862.45</c:v>
                </c:pt>
                <c:pt idx="3069">
                  <c:v>862.72</c:v>
                </c:pt>
                <c:pt idx="3070">
                  <c:v>863.01</c:v>
                </c:pt>
                <c:pt idx="3071">
                  <c:v>863.29</c:v>
                </c:pt>
                <c:pt idx="3072">
                  <c:v>863.57</c:v>
                </c:pt>
                <c:pt idx="3073">
                  <c:v>863.85</c:v>
                </c:pt>
                <c:pt idx="3074">
                  <c:v>864.13</c:v>
                </c:pt>
                <c:pt idx="3075">
                  <c:v>864.41</c:v>
                </c:pt>
                <c:pt idx="3076">
                  <c:v>864.69</c:v>
                </c:pt>
                <c:pt idx="3077">
                  <c:v>864.97</c:v>
                </c:pt>
                <c:pt idx="3078">
                  <c:v>865.26</c:v>
                </c:pt>
                <c:pt idx="3079">
                  <c:v>865.53</c:v>
                </c:pt>
                <c:pt idx="3080">
                  <c:v>865.82</c:v>
                </c:pt>
                <c:pt idx="3081">
                  <c:v>866.1</c:v>
                </c:pt>
                <c:pt idx="3082">
                  <c:v>866.38</c:v>
                </c:pt>
                <c:pt idx="3083">
                  <c:v>866.66</c:v>
                </c:pt>
                <c:pt idx="3084">
                  <c:v>866.94</c:v>
                </c:pt>
                <c:pt idx="3085">
                  <c:v>867.22</c:v>
                </c:pt>
                <c:pt idx="3086">
                  <c:v>867.5</c:v>
                </c:pt>
                <c:pt idx="3087">
                  <c:v>867.78</c:v>
                </c:pt>
                <c:pt idx="3088">
                  <c:v>868.06</c:v>
                </c:pt>
                <c:pt idx="3089">
                  <c:v>868.34</c:v>
                </c:pt>
                <c:pt idx="3090">
                  <c:v>868.62</c:v>
                </c:pt>
                <c:pt idx="3091">
                  <c:v>868.9</c:v>
                </c:pt>
                <c:pt idx="3092">
                  <c:v>869.18</c:v>
                </c:pt>
                <c:pt idx="3093">
                  <c:v>869.47</c:v>
                </c:pt>
                <c:pt idx="3094">
                  <c:v>869.74</c:v>
                </c:pt>
                <c:pt idx="3095">
                  <c:v>870.03</c:v>
                </c:pt>
                <c:pt idx="3096">
                  <c:v>870.31</c:v>
                </c:pt>
                <c:pt idx="3097">
                  <c:v>870.59</c:v>
                </c:pt>
                <c:pt idx="3098">
                  <c:v>870.87</c:v>
                </c:pt>
                <c:pt idx="3099">
                  <c:v>871.15</c:v>
                </c:pt>
                <c:pt idx="3100">
                  <c:v>871.43</c:v>
                </c:pt>
                <c:pt idx="3101">
                  <c:v>871.71</c:v>
                </c:pt>
                <c:pt idx="3102">
                  <c:v>871.99</c:v>
                </c:pt>
                <c:pt idx="3103">
                  <c:v>872.28</c:v>
                </c:pt>
                <c:pt idx="3104">
                  <c:v>872.56</c:v>
                </c:pt>
                <c:pt idx="3105">
                  <c:v>872.84</c:v>
                </c:pt>
                <c:pt idx="3106">
                  <c:v>873.12</c:v>
                </c:pt>
                <c:pt idx="3107">
                  <c:v>873.4</c:v>
                </c:pt>
                <c:pt idx="3108">
                  <c:v>873.67</c:v>
                </c:pt>
                <c:pt idx="3109">
                  <c:v>873.96</c:v>
                </c:pt>
                <c:pt idx="3110">
                  <c:v>874.24</c:v>
                </c:pt>
                <c:pt idx="3111">
                  <c:v>874.52</c:v>
                </c:pt>
                <c:pt idx="3112">
                  <c:v>874.8</c:v>
                </c:pt>
                <c:pt idx="3113">
                  <c:v>875.08</c:v>
                </c:pt>
                <c:pt idx="3114">
                  <c:v>875.36</c:v>
                </c:pt>
                <c:pt idx="3115">
                  <c:v>875.64</c:v>
                </c:pt>
                <c:pt idx="3116">
                  <c:v>875.92</c:v>
                </c:pt>
                <c:pt idx="3117">
                  <c:v>876.2</c:v>
                </c:pt>
                <c:pt idx="3118">
                  <c:v>876.48</c:v>
                </c:pt>
                <c:pt idx="3119">
                  <c:v>876.77</c:v>
                </c:pt>
                <c:pt idx="3120">
                  <c:v>877.05</c:v>
                </c:pt>
                <c:pt idx="3121">
                  <c:v>877.33</c:v>
                </c:pt>
                <c:pt idx="3122">
                  <c:v>877.61</c:v>
                </c:pt>
                <c:pt idx="3123">
                  <c:v>877.89</c:v>
                </c:pt>
                <c:pt idx="3124">
                  <c:v>878.17</c:v>
                </c:pt>
                <c:pt idx="3125">
                  <c:v>878.45</c:v>
                </c:pt>
                <c:pt idx="3126">
                  <c:v>878.73</c:v>
                </c:pt>
                <c:pt idx="3127">
                  <c:v>879.01</c:v>
                </c:pt>
                <c:pt idx="3128">
                  <c:v>879.29</c:v>
                </c:pt>
                <c:pt idx="3129">
                  <c:v>879.58</c:v>
                </c:pt>
                <c:pt idx="3130">
                  <c:v>879.85</c:v>
                </c:pt>
                <c:pt idx="3131">
                  <c:v>880.13</c:v>
                </c:pt>
                <c:pt idx="3132">
                  <c:v>880.42</c:v>
                </c:pt>
                <c:pt idx="3133">
                  <c:v>880.7</c:v>
                </c:pt>
                <c:pt idx="3134">
                  <c:v>880.98</c:v>
                </c:pt>
                <c:pt idx="3135">
                  <c:v>881.26</c:v>
                </c:pt>
                <c:pt idx="3136">
                  <c:v>881.54</c:v>
                </c:pt>
                <c:pt idx="3137">
                  <c:v>881.82</c:v>
                </c:pt>
                <c:pt idx="3138">
                  <c:v>882.1</c:v>
                </c:pt>
                <c:pt idx="3139">
                  <c:v>882.38</c:v>
                </c:pt>
                <c:pt idx="3140">
                  <c:v>882.66</c:v>
                </c:pt>
                <c:pt idx="3141">
                  <c:v>882.94</c:v>
                </c:pt>
                <c:pt idx="3142">
                  <c:v>883.22</c:v>
                </c:pt>
                <c:pt idx="3143">
                  <c:v>883.51</c:v>
                </c:pt>
                <c:pt idx="3144">
                  <c:v>883.79</c:v>
                </c:pt>
                <c:pt idx="3145">
                  <c:v>884.07</c:v>
                </c:pt>
                <c:pt idx="3146">
                  <c:v>884.35</c:v>
                </c:pt>
                <c:pt idx="3147">
                  <c:v>884.63</c:v>
                </c:pt>
                <c:pt idx="3148">
                  <c:v>884.91</c:v>
                </c:pt>
                <c:pt idx="3149">
                  <c:v>885.19</c:v>
                </c:pt>
                <c:pt idx="3150">
                  <c:v>885.47</c:v>
                </c:pt>
                <c:pt idx="3151">
                  <c:v>885.75</c:v>
                </c:pt>
                <c:pt idx="3152">
                  <c:v>886.03</c:v>
                </c:pt>
                <c:pt idx="3153">
                  <c:v>886.32</c:v>
                </c:pt>
                <c:pt idx="3154">
                  <c:v>886.6</c:v>
                </c:pt>
                <c:pt idx="3155">
                  <c:v>886.88</c:v>
                </c:pt>
                <c:pt idx="3156">
                  <c:v>887.15</c:v>
                </c:pt>
                <c:pt idx="3157">
                  <c:v>887.44</c:v>
                </c:pt>
                <c:pt idx="3158">
                  <c:v>887.71</c:v>
                </c:pt>
                <c:pt idx="3159">
                  <c:v>888</c:v>
                </c:pt>
                <c:pt idx="3160">
                  <c:v>888.28</c:v>
                </c:pt>
                <c:pt idx="3161">
                  <c:v>888.56</c:v>
                </c:pt>
                <c:pt idx="3162">
                  <c:v>888.84</c:v>
                </c:pt>
                <c:pt idx="3163">
                  <c:v>889.12</c:v>
                </c:pt>
                <c:pt idx="3164">
                  <c:v>889.4</c:v>
                </c:pt>
                <c:pt idx="3165">
                  <c:v>889.68</c:v>
                </c:pt>
                <c:pt idx="3166">
                  <c:v>889.97</c:v>
                </c:pt>
                <c:pt idx="3167">
                  <c:v>890.24</c:v>
                </c:pt>
                <c:pt idx="3168">
                  <c:v>890.53</c:v>
                </c:pt>
                <c:pt idx="3169">
                  <c:v>890.81</c:v>
                </c:pt>
                <c:pt idx="3170">
                  <c:v>891.09</c:v>
                </c:pt>
                <c:pt idx="3171">
                  <c:v>891.37</c:v>
                </c:pt>
                <c:pt idx="3172">
                  <c:v>891.65</c:v>
                </c:pt>
                <c:pt idx="3173">
                  <c:v>891.93</c:v>
                </c:pt>
                <c:pt idx="3174">
                  <c:v>892.21</c:v>
                </c:pt>
                <c:pt idx="3175">
                  <c:v>892.49</c:v>
                </c:pt>
                <c:pt idx="3176">
                  <c:v>892.77</c:v>
                </c:pt>
                <c:pt idx="3177">
                  <c:v>893.05</c:v>
                </c:pt>
                <c:pt idx="3178">
                  <c:v>893.33</c:v>
                </c:pt>
                <c:pt idx="3179">
                  <c:v>893.62</c:v>
                </c:pt>
                <c:pt idx="3180">
                  <c:v>893.89</c:v>
                </c:pt>
                <c:pt idx="3181">
                  <c:v>894.17</c:v>
                </c:pt>
                <c:pt idx="3182">
                  <c:v>894.46</c:v>
                </c:pt>
                <c:pt idx="3183">
                  <c:v>894.74</c:v>
                </c:pt>
                <c:pt idx="3184">
                  <c:v>895.02</c:v>
                </c:pt>
                <c:pt idx="3185">
                  <c:v>895.3</c:v>
                </c:pt>
                <c:pt idx="3186">
                  <c:v>895.58</c:v>
                </c:pt>
                <c:pt idx="3187">
                  <c:v>895.86</c:v>
                </c:pt>
                <c:pt idx="3188">
                  <c:v>896.14</c:v>
                </c:pt>
                <c:pt idx="3189">
                  <c:v>896.42</c:v>
                </c:pt>
                <c:pt idx="3190">
                  <c:v>896.7</c:v>
                </c:pt>
                <c:pt idx="3191">
                  <c:v>896.99</c:v>
                </c:pt>
                <c:pt idx="3192">
                  <c:v>897.26</c:v>
                </c:pt>
                <c:pt idx="3193">
                  <c:v>897.54</c:v>
                </c:pt>
                <c:pt idx="3194">
                  <c:v>897.83</c:v>
                </c:pt>
                <c:pt idx="3195">
                  <c:v>898.11</c:v>
                </c:pt>
                <c:pt idx="3196">
                  <c:v>898.39</c:v>
                </c:pt>
                <c:pt idx="3197">
                  <c:v>898.67</c:v>
                </c:pt>
                <c:pt idx="3198">
                  <c:v>898.95</c:v>
                </c:pt>
                <c:pt idx="3199">
                  <c:v>899.23</c:v>
                </c:pt>
                <c:pt idx="3200">
                  <c:v>899.51</c:v>
                </c:pt>
                <c:pt idx="3201">
                  <c:v>899.79</c:v>
                </c:pt>
                <c:pt idx="3202">
                  <c:v>900.07</c:v>
                </c:pt>
                <c:pt idx="3203">
                  <c:v>900.36</c:v>
                </c:pt>
                <c:pt idx="3204">
                  <c:v>900.64</c:v>
                </c:pt>
                <c:pt idx="3205">
                  <c:v>900.92</c:v>
                </c:pt>
                <c:pt idx="3206">
                  <c:v>901.2</c:v>
                </c:pt>
                <c:pt idx="3207">
                  <c:v>901.48</c:v>
                </c:pt>
                <c:pt idx="3208">
                  <c:v>901.76</c:v>
                </c:pt>
                <c:pt idx="3209">
                  <c:v>902.04</c:v>
                </c:pt>
                <c:pt idx="3210">
                  <c:v>902.32</c:v>
                </c:pt>
                <c:pt idx="3211">
                  <c:v>902.6</c:v>
                </c:pt>
                <c:pt idx="3212">
                  <c:v>902.88</c:v>
                </c:pt>
                <c:pt idx="3213">
                  <c:v>903.16</c:v>
                </c:pt>
                <c:pt idx="3214">
                  <c:v>903.44</c:v>
                </c:pt>
                <c:pt idx="3215">
                  <c:v>903.72</c:v>
                </c:pt>
                <c:pt idx="3216">
                  <c:v>904</c:v>
                </c:pt>
                <c:pt idx="3217">
                  <c:v>904.29</c:v>
                </c:pt>
                <c:pt idx="3218">
                  <c:v>904.57</c:v>
                </c:pt>
                <c:pt idx="3219">
                  <c:v>904.85</c:v>
                </c:pt>
                <c:pt idx="3220">
                  <c:v>905.13</c:v>
                </c:pt>
                <c:pt idx="3221">
                  <c:v>905.41</c:v>
                </c:pt>
                <c:pt idx="3222">
                  <c:v>905.69</c:v>
                </c:pt>
                <c:pt idx="3223">
                  <c:v>905.97</c:v>
                </c:pt>
                <c:pt idx="3224">
                  <c:v>906.25</c:v>
                </c:pt>
                <c:pt idx="3225">
                  <c:v>906.53</c:v>
                </c:pt>
                <c:pt idx="3226">
                  <c:v>906.81</c:v>
                </c:pt>
                <c:pt idx="3227">
                  <c:v>907.09</c:v>
                </c:pt>
                <c:pt idx="3228">
                  <c:v>907.38</c:v>
                </c:pt>
                <c:pt idx="3229">
                  <c:v>907.65</c:v>
                </c:pt>
                <c:pt idx="3230">
                  <c:v>907.93</c:v>
                </c:pt>
                <c:pt idx="3231">
                  <c:v>908.22</c:v>
                </c:pt>
                <c:pt idx="3232">
                  <c:v>908.5</c:v>
                </c:pt>
                <c:pt idx="3233">
                  <c:v>908.78</c:v>
                </c:pt>
                <c:pt idx="3234">
                  <c:v>909.06</c:v>
                </c:pt>
                <c:pt idx="3235">
                  <c:v>909.34</c:v>
                </c:pt>
                <c:pt idx="3236">
                  <c:v>909.62</c:v>
                </c:pt>
                <c:pt idx="3237">
                  <c:v>909.9</c:v>
                </c:pt>
                <c:pt idx="3238">
                  <c:v>910.18</c:v>
                </c:pt>
                <c:pt idx="3239">
                  <c:v>910.46</c:v>
                </c:pt>
                <c:pt idx="3240">
                  <c:v>910.75</c:v>
                </c:pt>
                <c:pt idx="3241">
                  <c:v>911.03</c:v>
                </c:pt>
                <c:pt idx="3242">
                  <c:v>911.3</c:v>
                </c:pt>
                <c:pt idx="3243">
                  <c:v>911.58</c:v>
                </c:pt>
                <c:pt idx="3244">
                  <c:v>911.87</c:v>
                </c:pt>
                <c:pt idx="3245">
                  <c:v>912.15</c:v>
                </c:pt>
                <c:pt idx="3246">
                  <c:v>912.43</c:v>
                </c:pt>
                <c:pt idx="3247">
                  <c:v>912.71</c:v>
                </c:pt>
                <c:pt idx="3248">
                  <c:v>912.99</c:v>
                </c:pt>
                <c:pt idx="3249">
                  <c:v>913.27</c:v>
                </c:pt>
                <c:pt idx="3250">
                  <c:v>913.55</c:v>
                </c:pt>
                <c:pt idx="3251">
                  <c:v>913.83</c:v>
                </c:pt>
                <c:pt idx="3252">
                  <c:v>914.11</c:v>
                </c:pt>
                <c:pt idx="3253">
                  <c:v>914.39</c:v>
                </c:pt>
                <c:pt idx="3254">
                  <c:v>914.67</c:v>
                </c:pt>
                <c:pt idx="3255">
                  <c:v>914.96</c:v>
                </c:pt>
                <c:pt idx="3256">
                  <c:v>915.24</c:v>
                </c:pt>
                <c:pt idx="3257">
                  <c:v>915.52</c:v>
                </c:pt>
                <c:pt idx="3258">
                  <c:v>915.8</c:v>
                </c:pt>
                <c:pt idx="3259">
                  <c:v>916.08</c:v>
                </c:pt>
                <c:pt idx="3260">
                  <c:v>916.36</c:v>
                </c:pt>
                <c:pt idx="3261">
                  <c:v>916.64</c:v>
                </c:pt>
                <c:pt idx="3262">
                  <c:v>916.92</c:v>
                </c:pt>
                <c:pt idx="3263">
                  <c:v>917.2</c:v>
                </c:pt>
                <c:pt idx="3264">
                  <c:v>917.48</c:v>
                </c:pt>
                <c:pt idx="3265">
                  <c:v>917.76</c:v>
                </c:pt>
                <c:pt idx="3266">
                  <c:v>918.05</c:v>
                </c:pt>
                <c:pt idx="3267">
                  <c:v>918.33</c:v>
                </c:pt>
                <c:pt idx="3268">
                  <c:v>918.61</c:v>
                </c:pt>
                <c:pt idx="3269">
                  <c:v>918.89</c:v>
                </c:pt>
                <c:pt idx="3270">
                  <c:v>919.17</c:v>
                </c:pt>
                <c:pt idx="3271">
                  <c:v>919.45</c:v>
                </c:pt>
                <c:pt idx="3272">
                  <c:v>919.73</c:v>
                </c:pt>
                <c:pt idx="3273">
                  <c:v>920.01</c:v>
                </c:pt>
                <c:pt idx="3274">
                  <c:v>920.29</c:v>
                </c:pt>
                <c:pt idx="3275">
                  <c:v>920.57</c:v>
                </c:pt>
                <c:pt idx="3276">
                  <c:v>920.85</c:v>
                </c:pt>
                <c:pt idx="3277">
                  <c:v>921.13</c:v>
                </c:pt>
                <c:pt idx="3278">
                  <c:v>921.41</c:v>
                </c:pt>
                <c:pt idx="3279">
                  <c:v>921.69</c:v>
                </c:pt>
                <c:pt idx="3280">
                  <c:v>921.98</c:v>
                </c:pt>
                <c:pt idx="3281">
                  <c:v>922.26</c:v>
                </c:pt>
                <c:pt idx="3282">
                  <c:v>922.54</c:v>
                </c:pt>
                <c:pt idx="3283">
                  <c:v>922.82</c:v>
                </c:pt>
                <c:pt idx="3284">
                  <c:v>923.1</c:v>
                </c:pt>
                <c:pt idx="3285">
                  <c:v>923.38</c:v>
                </c:pt>
                <c:pt idx="3286">
                  <c:v>923.66</c:v>
                </c:pt>
                <c:pt idx="3287">
                  <c:v>923.94</c:v>
                </c:pt>
                <c:pt idx="3288">
                  <c:v>924.22</c:v>
                </c:pt>
                <c:pt idx="3289">
                  <c:v>924.5</c:v>
                </c:pt>
                <c:pt idx="3290">
                  <c:v>924.78</c:v>
                </c:pt>
                <c:pt idx="3291">
                  <c:v>925.07</c:v>
                </c:pt>
                <c:pt idx="3292">
                  <c:v>925.35</c:v>
                </c:pt>
                <c:pt idx="3293">
                  <c:v>925.62</c:v>
                </c:pt>
                <c:pt idx="3294">
                  <c:v>925.91</c:v>
                </c:pt>
                <c:pt idx="3295">
                  <c:v>926.19</c:v>
                </c:pt>
                <c:pt idx="3296">
                  <c:v>926.47</c:v>
                </c:pt>
                <c:pt idx="3297">
                  <c:v>926.75</c:v>
                </c:pt>
                <c:pt idx="3298">
                  <c:v>927.03</c:v>
                </c:pt>
                <c:pt idx="3299">
                  <c:v>927.31</c:v>
                </c:pt>
                <c:pt idx="3300">
                  <c:v>927.59</c:v>
                </c:pt>
                <c:pt idx="3301">
                  <c:v>927.87</c:v>
                </c:pt>
                <c:pt idx="3302">
                  <c:v>928.15</c:v>
                </c:pt>
                <c:pt idx="3303">
                  <c:v>928.43</c:v>
                </c:pt>
                <c:pt idx="3304">
                  <c:v>928.72</c:v>
                </c:pt>
                <c:pt idx="3305">
                  <c:v>929</c:v>
                </c:pt>
                <c:pt idx="3306">
                  <c:v>929.28</c:v>
                </c:pt>
                <c:pt idx="3307">
                  <c:v>929.56</c:v>
                </c:pt>
                <c:pt idx="3308">
                  <c:v>929.84</c:v>
                </c:pt>
                <c:pt idx="3309">
                  <c:v>930.12</c:v>
                </c:pt>
                <c:pt idx="3310">
                  <c:v>930.4</c:v>
                </c:pt>
                <c:pt idx="3311">
                  <c:v>930.68</c:v>
                </c:pt>
                <c:pt idx="3312">
                  <c:v>930.96</c:v>
                </c:pt>
                <c:pt idx="3313">
                  <c:v>931.24</c:v>
                </c:pt>
                <c:pt idx="3314">
                  <c:v>931.52</c:v>
                </c:pt>
                <c:pt idx="3315">
                  <c:v>931.81</c:v>
                </c:pt>
                <c:pt idx="3316">
                  <c:v>932.09</c:v>
                </c:pt>
                <c:pt idx="3317">
                  <c:v>932.37</c:v>
                </c:pt>
                <c:pt idx="3318">
                  <c:v>932.64</c:v>
                </c:pt>
                <c:pt idx="3319">
                  <c:v>932.92</c:v>
                </c:pt>
                <c:pt idx="3320">
                  <c:v>933.21</c:v>
                </c:pt>
                <c:pt idx="3321">
                  <c:v>933.49</c:v>
                </c:pt>
                <c:pt idx="3322">
                  <c:v>933.77</c:v>
                </c:pt>
                <c:pt idx="3323">
                  <c:v>934.05</c:v>
                </c:pt>
                <c:pt idx="3324">
                  <c:v>934.33</c:v>
                </c:pt>
                <c:pt idx="3325">
                  <c:v>934.61</c:v>
                </c:pt>
                <c:pt idx="3326">
                  <c:v>934.89</c:v>
                </c:pt>
                <c:pt idx="3327">
                  <c:v>935.17</c:v>
                </c:pt>
                <c:pt idx="3328">
                  <c:v>935.45</c:v>
                </c:pt>
                <c:pt idx="3329">
                  <c:v>935.73</c:v>
                </c:pt>
                <c:pt idx="3330">
                  <c:v>936.01</c:v>
                </c:pt>
                <c:pt idx="3331">
                  <c:v>936.3</c:v>
                </c:pt>
                <c:pt idx="3332">
                  <c:v>936.58</c:v>
                </c:pt>
                <c:pt idx="3333">
                  <c:v>936.86</c:v>
                </c:pt>
                <c:pt idx="3334">
                  <c:v>937.14</c:v>
                </c:pt>
                <c:pt idx="3335">
                  <c:v>937.42</c:v>
                </c:pt>
                <c:pt idx="3336">
                  <c:v>937.7</c:v>
                </c:pt>
                <c:pt idx="3337">
                  <c:v>937.98</c:v>
                </c:pt>
                <c:pt idx="3338">
                  <c:v>938.26</c:v>
                </c:pt>
                <c:pt idx="3339">
                  <c:v>938.54</c:v>
                </c:pt>
                <c:pt idx="3340">
                  <c:v>938.83</c:v>
                </c:pt>
                <c:pt idx="3341">
                  <c:v>939.11</c:v>
                </c:pt>
                <c:pt idx="3342">
                  <c:v>939.39</c:v>
                </c:pt>
                <c:pt idx="3343">
                  <c:v>939.66</c:v>
                </c:pt>
                <c:pt idx="3344">
                  <c:v>939.95</c:v>
                </c:pt>
                <c:pt idx="3345">
                  <c:v>940.22</c:v>
                </c:pt>
                <c:pt idx="3346">
                  <c:v>940.51</c:v>
                </c:pt>
                <c:pt idx="3347">
                  <c:v>940.79</c:v>
                </c:pt>
                <c:pt idx="3348">
                  <c:v>941.07</c:v>
                </c:pt>
                <c:pt idx="3349">
                  <c:v>941.35</c:v>
                </c:pt>
                <c:pt idx="3350">
                  <c:v>941.63</c:v>
                </c:pt>
                <c:pt idx="3351">
                  <c:v>941.91</c:v>
                </c:pt>
                <c:pt idx="3352">
                  <c:v>942.19</c:v>
                </c:pt>
                <c:pt idx="3353">
                  <c:v>942.47</c:v>
                </c:pt>
                <c:pt idx="3354">
                  <c:v>942.75</c:v>
                </c:pt>
                <c:pt idx="3355">
                  <c:v>943.03</c:v>
                </c:pt>
                <c:pt idx="3356">
                  <c:v>943.31</c:v>
                </c:pt>
                <c:pt idx="3357">
                  <c:v>943.6</c:v>
                </c:pt>
                <c:pt idx="3358">
                  <c:v>943.88</c:v>
                </c:pt>
                <c:pt idx="3359">
                  <c:v>944.16</c:v>
                </c:pt>
                <c:pt idx="3360">
                  <c:v>944.44</c:v>
                </c:pt>
                <c:pt idx="3361">
                  <c:v>944.72</c:v>
                </c:pt>
                <c:pt idx="3362">
                  <c:v>945</c:v>
                </c:pt>
                <c:pt idx="3363">
                  <c:v>945.28</c:v>
                </c:pt>
                <c:pt idx="3364">
                  <c:v>945.56</c:v>
                </c:pt>
                <c:pt idx="3365">
                  <c:v>945.84</c:v>
                </c:pt>
                <c:pt idx="3366">
                  <c:v>946.97</c:v>
                </c:pt>
                <c:pt idx="3367">
                  <c:v>947.24</c:v>
                </c:pt>
                <c:pt idx="3368">
                  <c:v>947.53</c:v>
                </c:pt>
                <c:pt idx="3369">
                  <c:v>947.81</c:v>
                </c:pt>
                <c:pt idx="3370">
                  <c:v>948.09</c:v>
                </c:pt>
                <c:pt idx="3371">
                  <c:v>948.37</c:v>
                </c:pt>
                <c:pt idx="3372">
                  <c:v>948.65</c:v>
                </c:pt>
                <c:pt idx="3373">
                  <c:v>948.93</c:v>
                </c:pt>
                <c:pt idx="3374">
                  <c:v>949.21</c:v>
                </c:pt>
                <c:pt idx="3375">
                  <c:v>949.49</c:v>
                </c:pt>
                <c:pt idx="3376">
                  <c:v>949.77</c:v>
                </c:pt>
                <c:pt idx="3377">
                  <c:v>950.05</c:v>
                </c:pt>
                <c:pt idx="3378">
                  <c:v>950.33</c:v>
                </c:pt>
                <c:pt idx="3379">
                  <c:v>950.62</c:v>
                </c:pt>
                <c:pt idx="3380">
                  <c:v>950.9</c:v>
                </c:pt>
                <c:pt idx="3381">
                  <c:v>951.18</c:v>
                </c:pt>
                <c:pt idx="3382">
                  <c:v>951.46</c:v>
                </c:pt>
                <c:pt idx="3383">
                  <c:v>951.74</c:v>
                </c:pt>
                <c:pt idx="3384">
                  <c:v>952.02</c:v>
                </c:pt>
                <c:pt idx="3385">
                  <c:v>952.3</c:v>
                </c:pt>
                <c:pt idx="3386">
                  <c:v>952.58</c:v>
                </c:pt>
                <c:pt idx="3387">
                  <c:v>952.86</c:v>
                </c:pt>
                <c:pt idx="3388">
                  <c:v>953.15</c:v>
                </c:pt>
                <c:pt idx="3389">
                  <c:v>953.42</c:v>
                </c:pt>
                <c:pt idx="3390">
                  <c:v>953.71</c:v>
                </c:pt>
                <c:pt idx="3391">
                  <c:v>953.98</c:v>
                </c:pt>
                <c:pt idx="3392">
                  <c:v>954.27</c:v>
                </c:pt>
                <c:pt idx="3393">
                  <c:v>954.55</c:v>
                </c:pt>
                <c:pt idx="3394">
                  <c:v>954.83</c:v>
                </c:pt>
                <c:pt idx="3395">
                  <c:v>955.11</c:v>
                </c:pt>
                <c:pt idx="3396">
                  <c:v>955.39</c:v>
                </c:pt>
                <c:pt idx="3397">
                  <c:v>955.67</c:v>
                </c:pt>
                <c:pt idx="3398">
                  <c:v>955.95</c:v>
                </c:pt>
                <c:pt idx="3399">
                  <c:v>956.24</c:v>
                </c:pt>
                <c:pt idx="3400">
                  <c:v>956.51</c:v>
                </c:pt>
                <c:pt idx="3401">
                  <c:v>956.79</c:v>
                </c:pt>
                <c:pt idx="3402">
                  <c:v>957.08</c:v>
                </c:pt>
                <c:pt idx="3403">
                  <c:v>957.36</c:v>
                </c:pt>
                <c:pt idx="3404">
                  <c:v>957.63</c:v>
                </c:pt>
                <c:pt idx="3405">
                  <c:v>957.92</c:v>
                </c:pt>
                <c:pt idx="3406">
                  <c:v>958.19</c:v>
                </c:pt>
                <c:pt idx="3407">
                  <c:v>958.48</c:v>
                </c:pt>
                <c:pt idx="3408">
                  <c:v>958.76</c:v>
                </c:pt>
                <c:pt idx="3409">
                  <c:v>959.04</c:v>
                </c:pt>
                <c:pt idx="3410">
                  <c:v>959.32</c:v>
                </c:pt>
                <c:pt idx="3411">
                  <c:v>959.6</c:v>
                </c:pt>
                <c:pt idx="3412">
                  <c:v>959.88</c:v>
                </c:pt>
                <c:pt idx="3413">
                  <c:v>960.16</c:v>
                </c:pt>
                <c:pt idx="3414">
                  <c:v>960.44</c:v>
                </c:pt>
                <c:pt idx="3415">
                  <c:v>960.73</c:v>
                </c:pt>
                <c:pt idx="3416">
                  <c:v>961.01</c:v>
                </c:pt>
                <c:pt idx="3417">
                  <c:v>961.29</c:v>
                </c:pt>
                <c:pt idx="3418">
                  <c:v>961.57</c:v>
                </c:pt>
                <c:pt idx="3419">
                  <c:v>961.85</c:v>
                </c:pt>
                <c:pt idx="3420">
                  <c:v>962.13</c:v>
                </c:pt>
                <c:pt idx="3421">
                  <c:v>962.41</c:v>
                </c:pt>
                <c:pt idx="3422">
                  <c:v>962.69</c:v>
                </c:pt>
                <c:pt idx="3423">
                  <c:v>962.97</c:v>
                </c:pt>
                <c:pt idx="3424">
                  <c:v>963.25</c:v>
                </c:pt>
                <c:pt idx="3425">
                  <c:v>963.53</c:v>
                </c:pt>
                <c:pt idx="3426">
                  <c:v>963.81</c:v>
                </c:pt>
                <c:pt idx="3427">
                  <c:v>964.09</c:v>
                </c:pt>
                <c:pt idx="3428">
                  <c:v>964.38</c:v>
                </c:pt>
                <c:pt idx="3429">
                  <c:v>964.65</c:v>
                </c:pt>
                <c:pt idx="3430">
                  <c:v>964.94</c:v>
                </c:pt>
                <c:pt idx="3431">
                  <c:v>965.22</c:v>
                </c:pt>
                <c:pt idx="3432">
                  <c:v>965.5</c:v>
                </c:pt>
                <c:pt idx="3433">
                  <c:v>965.78</c:v>
                </c:pt>
                <c:pt idx="3434">
                  <c:v>966.06</c:v>
                </c:pt>
                <c:pt idx="3435">
                  <c:v>966.34</c:v>
                </c:pt>
                <c:pt idx="3436">
                  <c:v>966.62</c:v>
                </c:pt>
                <c:pt idx="3437">
                  <c:v>966.9</c:v>
                </c:pt>
                <c:pt idx="3438">
                  <c:v>967.19</c:v>
                </c:pt>
                <c:pt idx="3439">
                  <c:v>967.47</c:v>
                </c:pt>
                <c:pt idx="3440">
                  <c:v>967.74</c:v>
                </c:pt>
                <c:pt idx="3441">
                  <c:v>968.03</c:v>
                </c:pt>
                <c:pt idx="3442">
                  <c:v>968.31</c:v>
                </c:pt>
                <c:pt idx="3443">
                  <c:v>968.59</c:v>
                </c:pt>
                <c:pt idx="3444">
                  <c:v>968.87</c:v>
                </c:pt>
                <c:pt idx="3445">
                  <c:v>969.15</c:v>
                </c:pt>
                <c:pt idx="3446">
                  <c:v>969.43</c:v>
                </c:pt>
                <c:pt idx="3447">
                  <c:v>969.71</c:v>
                </c:pt>
                <c:pt idx="3448">
                  <c:v>969.99</c:v>
                </c:pt>
                <c:pt idx="3449">
                  <c:v>970.28</c:v>
                </c:pt>
                <c:pt idx="3450">
                  <c:v>970.55</c:v>
                </c:pt>
                <c:pt idx="3451">
                  <c:v>970.83</c:v>
                </c:pt>
                <c:pt idx="3452">
                  <c:v>971.11</c:v>
                </c:pt>
                <c:pt idx="3453">
                  <c:v>971.39</c:v>
                </c:pt>
                <c:pt idx="3454">
                  <c:v>971.67</c:v>
                </c:pt>
                <c:pt idx="3455">
                  <c:v>971.96</c:v>
                </c:pt>
                <c:pt idx="3456">
                  <c:v>972.24</c:v>
                </c:pt>
                <c:pt idx="3457">
                  <c:v>972.52</c:v>
                </c:pt>
                <c:pt idx="3458">
                  <c:v>972.8</c:v>
                </c:pt>
                <c:pt idx="3459">
                  <c:v>973.08</c:v>
                </c:pt>
                <c:pt idx="3460">
                  <c:v>973.36</c:v>
                </c:pt>
                <c:pt idx="3461">
                  <c:v>973.64</c:v>
                </c:pt>
                <c:pt idx="3462">
                  <c:v>973.92</c:v>
                </c:pt>
                <c:pt idx="3463">
                  <c:v>974.21</c:v>
                </c:pt>
                <c:pt idx="3464">
                  <c:v>974.48</c:v>
                </c:pt>
                <c:pt idx="3465">
                  <c:v>974.76</c:v>
                </c:pt>
                <c:pt idx="3466">
                  <c:v>975.05</c:v>
                </c:pt>
                <c:pt idx="3467">
                  <c:v>975.33</c:v>
                </c:pt>
                <c:pt idx="3468">
                  <c:v>975.61</c:v>
                </c:pt>
                <c:pt idx="3469">
                  <c:v>975.89</c:v>
                </c:pt>
                <c:pt idx="3470">
                  <c:v>976.17</c:v>
                </c:pt>
                <c:pt idx="3471">
                  <c:v>976.45</c:v>
                </c:pt>
                <c:pt idx="3472">
                  <c:v>976.73</c:v>
                </c:pt>
                <c:pt idx="3473">
                  <c:v>977.01</c:v>
                </c:pt>
                <c:pt idx="3474">
                  <c:v>977.29</c:v>
                </c:pt>
                <c:pt idx="3475">
                  <c:v>977.57</c:v>
                </c:pt>
                <c:pt idx="3476">
                  <c:v>977.85</c:v>
                </c:pt>
                <c:pt idx="3477">
                  <c:v>978.13</c:v>
                </c:pt>
                <c:pt idx="3478">
                  <c:v>978.41</c:v>
                </c:pt>
                <c:pt idx="3479">
                  <c:v>978.69</c:v>
                </c:pt>
                <c:pt idx="3480">
                  <c:v>978.98</c:v>
                </c:pt>
                <c:pt idx="3481">
                  <c:v>979.26</c:v>
                </c:pt>
                <c:pt idx="3482">
                  <c:v>979.54</c:v>
                </c:pt>
                <c:pt idx="3483">
                  <c:v>979.82</c:v>
                </c:pt>
                <c:pt idx="3484">
                  <c:v>980.1</c:v>
                </c:pt>
                <c:pt idx="3485">
                  <c:v>980.38</c:v>
                </c:pt>
                <c:pt idx="3486">
                  <c:v>980.66</c:v>
                </c:pt>
                <c:pt idx="3487">
                  <c:v>980.94</c:v>
                </c:pt>
                <c:pt idx="3488">
                  <c:v>981.22</c:v>
                </c:pt>
                <c:pt idx="3489">
                  <c:v>981.5</c:v>
                </c:pt>
                <c:pt idx="3490">
                  <c:v>981.79</c:v>
                </c:pt>
                <c:pt idx="3491">
                  <c:v>982.07</c:v>
                </c:pt>
                <c:pt idx="3492">
                  <c:v>982.35</c:v>
                </c:pt>
                <c:pt idx="3493">
                  <c:v>982.63</c:v>
                </c:pt>
                <c:pt idx="3494">
                  <c:v>982.91</c:v>
                </c:pt>
                <c:pt idx="3495">
                  <c:v>983.19</c:v>
                </c:pt>
                <c:pt idx="3496">
                  <c:v>983.47</c:v>
                </c:pt>
                <c:pt idx="3497">
                  <c:v>983.75</c:v>
                </c:pt>
                <c:pt idx="3498">
                  <c:v>984.03</c:v>
                </c:pt>
                <c:pt idx="3499">
                  <c:v>984.32</c:v>
                </c:pt>
                <c:pt idx="3500">
                  <c:v>984.59</c:v>
                </c:pt>
                <c:pt idx="3501">
                  <c:v>984.88</c:v>
                </c:pt>
                <c:pt idx="3502">
                  <c:v>985.15</c:v>
                </c:pt>
                <c:pt idx="3503">
                  <c:v>985.43</c:v>
                </c:pt>
                <c:pt idx="3504">
                  <c:v>985.72</c:v>
                </c:pt>
                <c:pt idx="3505">
                  <c:v>986</c:v>
                </c:pt>
                <c:pt idx="3506">
                  <c:v>986.28</c:v>
                </c:pt>
                <c:pt idx="3507">
                  <c:v>986.56</c:v>
                </c:pt>
                <c:pt idx="3508">
                  <c:v>986.84</c:v>
                </c:pt>
                <c:pt idx="3509">
                  <c:v>987.12</c:v>
                </c:pt>
                <c:pt idx="3510">
                  <c:v>987.4</c:v>
                </c:pt>
                <c:pt idx="3511">
                  <c:v>987.68</c:v>
                </c:pt>
                <c:pt idx="3512">
                  <c:v>987.96</c:v>
                </c:pt>
                <c:pt idx="3513">
                  <c:v>988.24</c:v>
                </c:pt>
                <c:pt idx="3514">
                  <c:v>988.52</c:v>
                </c:pt>
                <c:pt idx="3515">
                  <c:v>988.8</c:v>
                </c:pt>
                <c:pt idx="3516">
                  <c:v>989.09</c:v>
                </c:pt>
                <c:pt idx="3517">
                  <c:v>989.37</c:v>
                </c:pt>
                <c:pt idx="3518">
                  <c:v>989.65</c:v>
                </c:pt>
                <c:pt idx="3519">
                  <c:v>989.93</c:v>
                </c:pt>
                <c:pt idx="3520">
                  <c:v>990.21</c:v>
                </c:pt>
                <c:pt idx="3521">
                  <c:v>990.49</c:v>
                </c:pt>
                <c:pt idx="3522">
                  <c:v>990.77</c:v>
                </c:pt>
                <c:pt idx="3523">
                  <c:v>991.05</c:v>
                </c:pt>
                <c:pt idx="3524">
                  <c:v>991.33</c:v>
                </c:pt>
                <c:pt idx="3525">
                  <c:v>991.61</c:v>
                </c:pt>
                <c:pt idx="3526">
                  <c:v>991.9</c:v>
                </c:pt>
                <c:pt idx="3527">
                  <c:v>992.17</c:v>
                </c:pt>
                <c:pt idx="3528">
                  <c:v>992.45</c:v>
                </c:pt>
                <c:pt idx="3529">
                  <c:v>992.74</c:v>
                </c:pt>
                <c:pt idx="3530">
                  <c:v>993.02</c:v>
                </c:pt>
                <c:pt idx="3531">
                  <c:v>993.3</c:v>
                </c:pt>
                <c:pt idx="3532">
                  <c:v>993.58</c:v>
                </c:pt>
                <c:pt idx="3533">
                  <c:v>993.86</c:v>
                </c:pt>
                <c:pt idx="3534">
                  <c:v>994.14</c:v>
                </c:pt>
                <c:pt idx="3535">
                  <c:v>994.42</c:v>
                </c:pt>
                <c:pt idx="3536">
                  <c:v>994.7</c:v>
                </c:pt>
                <c:pt idx="3537">
                  <c:v>994.98</c:v>
                </c:pt>
                <c:pt idx="3538">
                  <c:v>995.26</c:v>
                </c:pt>
                <c:pt idx="3539">
                  <c:v>995.54</c:v>
                </c:pt>
                <c:pt idx="3540">
                  <c:v>995.82</c:v>
                </c:pt>
                <c:pt idx="3541">
                  <c:v>996.11</c:v>
                </c:pt>
                <c:pt idx="3542">
                  <c:v>996.39</c:v>
                </c:pt>
                <c:pt idx="3543">
                  <c:v>996.67</c:v>
                </c:pt>
                <c:pt idx="3544">
                  <c:v>996.95</c:v>
                </c:pt>
                <c:pt idx="3545">
                  <c:v>997.23</c:v>
                </c:pt>
                <c:pt idx="3546">
                  <c:v>997.51</c:v>
                </c:pt>
                <c:pt idx="3547">
                  <c:v>997.79</c:v>
                </c:pt>
                <c:pt idx="3548">
                  <c:v>998.07</c:v>
                </c:pt>
                <c:pt idx="3549">
                  <c:v>998.36</c:v>
                </c:pt>
                <c:pt idx="3550">
                  <c:v>998.63</c:v>
                </c:pt>
                <c:pt idx="3551">
                  <c:v>998.92</c:v>
                </c:pt>
                <c:pt idx="3552">
                  <c:v>999.19</c:v>
                </c:pt>
                <c:pt idx="3553">
                  <c:v>999.47</c:v>
                </c:pt>
                <c:pt idx="3554">
                  <c:v>999.76</c:v>
                </c:pt>
                <c:pt idx="3555">
                  <c:v>1000.04</c:v>
                </c:pt>
                <c:pt idx="3556">
                  <c:v>1000.32</c:v>
                </c:pt>
                <c:pt idx="3557">
                  <c:v>1000.6</c:v>
                </c:pt>
                <c:pt idx="3558">
                  <c:v>1000.88</c:v>
                </c:pt>
                <c:pt idx="3559">
                  <c:v>1001.16</c:v>
                </c:pt>
                <c:pt idx="3560">
                  <c:v>1001.44</c:v>
                </c:pt>
                <c:pt idx="3561">
                  <c:v>1001.72</c:v>
                </c:pt>
                <c:pt idx="3562">
                  <c:v>1002</c:v>
                </c:pt>
                <c:pt idx="3563">
                  <c:v>1002.28</c:v>
                </c:pt>
                <c:pt idx="3564">
                  <c:v>1002.57</c:v>
                </c:pt>
                <c:pt idx="3565">
                  <c:v>1002.84</c:v>
                </c:pt>
                <c:pt idx="3566">
                  <c:v>1003.13</c:v>
                </c:pt>
                <c:pt idx="3567">
                  <c:v>1003.41</c:v>
                </c:pt>
                <c:pt idx="3568">
                  <c:v>1003.69</c:v>
                </c:pt>
                <c:pt idx="3569">
                  <c:v>1003.97</c:v>
                </c:pt>
                <c:pt idx="3570">
                  <c:v>1004.25</c:v>
                </c:pt>
                <c:pt idx="3571">
                  <c:v>1004.53</c:v>
                </c:pt>
                <c:pt idx="3572">
                  <c:v>1004.81</c:v>
                </c:pt>
                <c:pt idx="3573">
                  <c:v>1005.09</c:v>
                </c:pt>
                <c:pt idx="3574">
                  <c:v>1005.37</c:v>
                </c:pt>
                <c:pt idx="3575">
                  <c:v>1005.65</c:v>
                </c:pt>
                <c:pt idx="3576">
                  <c:v>1005.93</c:v>
                </c:pt>
                <c:pt idx="3577">
                  <c:v>1006.21</c:v>
                </c:pt>
                <c:pt idx="3578">
                  <c:v>1006.5</c:v>
                </c:pt>
                <c:pt idx="3579">
                  <c:v>1006.78</c:v>
                </c:pt>
                <c:pt idx="3580">
                  <c:v>1007.06</c:v>
                </c:pt>
                <c:pt idx="3581">
                  <c:v>1007.34</c:v>
                </c:pt>
                <c:pt idx="3582">
                  <c:v>1007.62</c:v>
                </c:pt>
                <c:pt idx="3583">
                  <c:v>1007.9</c:v>
                </c:pt>
                <c:pt idx="3584">
                  <c:v>1008.18</c:v>
                </c:pt>
                <c:pt idx="3585">
                  <c:v>1008.46</c:v>
                </c:pt>
                <c:pt idx="3586">
                  <c:v>1008.74</c:v>
                </c:pt>
                <c:pt idx="3587">
                  <c:v>1009.02</c:v>
                </c:pt>
                <c:pt idx="3588">
                  <c:v>1009.31</c:v>
                </c:pt>
                <c:pt idx="3589">
                  <c:v>1009.59</c:v>
                </c:pt>
                <c:pt idx="3590">
                  <c:v>1009.86</c:v>
                </c:pt>
                <c:pt idx="3591">
                  <c:v>1010.15</c:v>
                </c:pt>
                <c:pt idx="3592">
                  <c:v>1010.43</c:v>
                </c:pt>
                <c:pt idx="3593">
                  <c:v>1010.71</c:v>
                </c:pt>
                <c:pt idx="3594">
                  <c:v>1010.99</c:v>
                </c:pt>
                <c:pt idx="3595">
                  <c:v>1011.27</c:v>
                </c:pt>
                <c:pt idx="3596">
                  <c:v>1011.55</c:v>
                </c:pt>
                <c:pt idx="3597">
                  <c:v>1011.83</c:v>
                </c:pt>
                <c:pt idx="3598">
                  <c:v>1012.11</c:v>
                </c:pt>
                <c:pt idx="3599">
                  <c:v>1012.39</c:v>
                </c:pt>
                <c:pt idx="3600">
                  <c:v>1012.68</c:v>
                </c:pt>
                <c:pt idx="3601">
                  <c:v>1012.96</c:v>
                </c:pt>
                <c:pt idx="3602">
                  <c:v>1013.24</c:v>
                </c:pt>
                <c:pt idx="3603">
                  <c:v>1013.52</c:v>
                </c:pt>
                <c:pt idx="3604">
                  <c:v>1013.8</c:v>
                </c:pt>
                <c:pt idx="3605">
                  <c:v>1014.08</c:v>
                </c:pt>
                <c:pt idx="3606">
                  <c:v>1014.36</c:v>
                </c:pt>
                <c:pt idx="3607">
                  <c:v>1014.64</c:v>
                </c:pt>
                <c:pt idx="3608">
                  <c:v>1014.92</c:v>
                </c:pt>
                <c:pt idx="3609">
                  <c:v>1015.2</c:v>
                </c:pt>
                <c:pt idx="3610">
                  <c:v>1015.48</c:v>
                </c:pt>
                <c:pt idx="3611">
                  <c:v>1016</c:v>
                </c:pt>
                <c:pt idx="3612">
                  <c:v>1016.28</c:v>
                </c:pt>
                <c:pt idx="3613">
                  <c:v>1016.56</c:v>
                </c:pt>
                <c:pt idx="3614">
                  <c:v>1016.84</c:v>
                </c:pt>
                <c:pt idx="3615">
                  <c:v>1017.12</c:v>
                </c:pt>
                <c:pt idx="3616">
                  <c:v>1017.4</c:v>
                </c:pt>
                <c:pt idx="3617">
                  <c:v>1017.68</c:v>
                </c:pt>
                <c:pt idx="3618">
                  <c:v>1017.96</c:v>
                </c:pt>
                <c:pt idx="3619">
                  <c:v>1018.24</c:v>
                </c:pt>
                <c:pt idx="3620">
                  <c:v>1018.52</c:v>
                </c:pt>
                <c:pt idx="3621">
                  <c:v>1018.8</c:v>
                </c:pt>
                <c:pt idx="3622">
                  <c:v>1019.09</c:v>
                </c:pt>
                <c:pt idx="3623">
                  <c:v>1019.37</c:v>
                </c:pt>
                <c:pt idx="3624">
                  <c:v>1019.65</c:v>
                </c:pt>
                <c:pt idx="3625">
                  <c:v>1019.93</c:v>
                </c:pt>
                <c:pt idx="3626">
                  <c:v>1020.21</c:v>
                </c:pt>
                <c:pt idx="3627">
                  <c:v>1020.49</c:v>
                </c:pt>
                <c:pt idx="3628">
                  <c:v>1020.77</c:v>
                </c:pt>
                <c:pt idx="3629">
                  <c:v>1021.05</c:v>
                </c:pt>
                <c:pt idx="3630">
                  <c:v>1021.33</c:v>
                </c:pt>
                <c:pt idx="3631">
                  <c:v>1021.61</c:v>
                </c:pt>
                <c:pt idx="3632">
                  <c:v>1021.89</c:v>
                </c:pt>
                <c:pt idx="3633">
                  <c:v>1022.17</c:v>
                </c:pt>
                <c:pt idx="3634">
                  <c:v>1022.46</c:v>
                </c:pt>
                <c:pt idx="3635">
                  <c:v>1022.74</c:v>
                </c:pt>
                <c:pt idx="3636">
                  <c:v>1023.02</c:v>
                </c:pt>
                <c:pt idx="3637">
                  <c:v>1023.3</c:v>
                </c:pt>
                <c:pt idx="3638">
                  <c:v>1023.58</c:v>
                </c:pt>
                <c:pt idx="3639">
                  <c:v>1023.86</c:v>
                </c:pt>
                <c:pt idx="3640">
                  <c:v>1024.1400000000001</c:v>
                </c:pt>
                <c:pt idx="3641">
                  <c:v>1024.42</c:v>
                </c:pt>
                <c:pt idx="3642">
                  <c:v>1024.7</c:v>
                </c:pt>
                <c:pt idx="3643">
                  <c:v>1024.98</c:v>
                </c:pt>
                <c:pt idx="3644">
                  <c:v>1025.26</c:v>
                </c:pt>
                <c:pt idx="3645">
                  <c:v>1025.54</c:v>
                </c:pt>
                <c:pt idx="3646">
                  <c:v>1025.83</c:v>
                </c:pt>
                <c:pt idx="3647">
                  <c:v>1026.1099999999999</c:v>
                </c:pt>
                <c:pt idx="3648">
                  <c:v>1026.3800000000001</c:v>
                </c:pt>
                <c:pt idx="3649">
                  <c:v>1026.67</c:v>
                </c:pt>
                <c:pt idx="3650">
                  <c:v>1026.95</c:v>
                </c:pt>
                <c:pt idx="3651">
                  <c:v>1027.23</c:v>
                </c:pt>
                <c:pt idx="3652">
                  <c:v>1027.51</c:v>
                </c:pt>
                <c:pt idx="3653">
                  <c:v>1027.79</c:v>
                </c:pt>
                <c:pt idx="3654">
                  <c:v>1028.07</c:v>
                </c:pt>
                <c:pt idx="3655">
                  <c:v>1028.3499999999999</c:v>
                </c:pt>
                <c:pt idx="3656">
                  <c:v>1028.6300000000001</c:v>
                </c:pt>
                <c:pt idx="3657">
                  <c:v>1028.9100000000001</c:v>
                </c:pt>
                <c:pt idx="3658">
                  <c:v>1029.19</c:v>
                </c:pt>
                <c:pt idx="3659">
                  <c:v>1029.48</c:v>
                </c:pt>
                <c:pt idx="3660">
                  <c:v>1029.76</c:v>
                </c:pt>
                <c:pt idx="3661">
                  <c:v>1030.04</c:v>
                </c:pt>
                <c:pt idx="3662">
                  <c:v>1030.32</c:v>
                </c:pt>
                <c:pt idx="3663">
                  <c:v>1030.5999999999999</c:v>
                </c:pt>
                <c:pt idx="3664">
                  <c:v>1030.8800000000001</c:v>
                </c:pt>
                <c:pt idx="3665">
                  <c:v>1031.1600000000001</c:v>
                </c:pt>
                <c:pt idx="3666">
                  <c:v>1031.44</c:v>
                </c:pt>
                <c:pt idx="3667">
                  <c:v>1031.72</c:v>
                </c:pt>
                <c:pt idx="3668">
                  <c:v>1032</c:v>
                </c:pt>
                <c:pt idx="3669">
                  <c:v>1032.28</c:v>
                </c:pt>
                <c:pt idx="3670">
                  <c:v>1032.57</c:v>
                </c:pt>
                <c:pt idx="3671">
                  <c:v>1032.8499999999999</c:v>
                </c:pt>
                <c:pt idx="3672">
                  <c:v>1033.1199999999999</c:v>
                </c:pt>
                <c:pt idx="3673">
                  <c:v>1033.4100000000001</c:v>
                </c:pt>
                <c:pt idx="3674">
                  <c:v>1033.69</c:v>
                </c:pt>
                <c:pt idx="3675">
                  <c:v>1033.97</c:v>
                </c:pt>
                <c:pt idx="3676">
                  <c:v>1034.25</c:v>
                </c:pt>
                <c:pt idx="3677">
                  <c:v>1034.53</c:v>
                </c:pt>
                <c:pt idx="3678">
                  <c:v>1034.81</c:v>
                </c:pt>
                <c:pt idx="3679">
                  <c:v>1035.0899999999999</c:v>
                </c:pt>
                <c:pt idx="3680">
                  <c:v>1035.3699999999999</c:v>
                </c:pt>
                <c:pt idx="3681">
                  <c:v>1035.6500000000001</c:v>
                </c:pt>
                <c:pt idx="3682">
                  <c:v>1035.93</c:v>
                </c:pt>
                <c:pt idx="3683">
                  <c:v>1036.21</c:v>
                </c:pt>
                <c:pt idx="3684">
                  <c:v>1036.5</c:v>
                </c:pt>
                <c:pt idx="3685">
                  <c:v>1036.77</c:v>
                </c:pt>
                <c:pt idx="3686">
                  <c:v>1037.06</c:v>
                </c:pt>
                <c:pt idx="3687">
                  <c:v>1037.3399999999999</c:v>
                </c:pt>
                <c:pt idx="3688">
                  <c:v>1037.6199999999999</c:v>
                </c:pt>
                <c:pt idx="3689">
                  <c:v>1037.9000000000001</c:v>
                </c:pt>
                <c:pt idx="3690">
                  <c:v>1038.18</c:v>
                </c:pt>
                <c:pt idx="3691">
                  <c:v>1038.46</c:v>
                </c:pt>
                <c:pt idx="3692">
                  <c:v>1038.74</c:v>
                </c:pt>
                <c:pt idx="3693">
                  <c:v>1039.02</c:v>
                </c:pt>
                <c:pt idx="3694">
                  <c:v>1039.31</c:v>
                </c:pt>
                <c:pt idx="3695">
                  <c:v>1039.5899999999999</c:v>
                </c:pt>
                <c:pt idx="3696">
                  <c:v>1039.8699999999999</c:v>
                </c:pt>
                <c:pt idx="3697">
                  <c:v>1040.1500000000001</c:v>
                </c:pt>
                <c:pt idx="3698">
                  <c:v>1040.42</c:v>
                </c:pt>
                <c:pt idx="3699">
                  <c:v>1040.7</c:v>
                </c:pt>
                <c:pt idx="3700">
                  <c:v>1040.99</c:v>
                </c:pt>
                <c:pt idx="3701">
                  <c:v>1041.27</c:v>
                </c:pt>
                <c:pt idx="3702">
                  <c:v>1041.55</c:v>
                </c:pt>
                <c:pt idx="3703">
                  <c:v>1041.83</c:v>
                </c:pt>
                <c:pt idx="3704">
                  <c:v>1042.1099999999999</c:v>
                </c:pt>
                <c:pt idx="3705">
                  <c:v>1042.3900000000001</c:v>
                </c:pt>
                <c:pt idx="3706">
                  <c:v>1042.67</c:v>
                </c:pt>
                <c:pt idx="3707">
                  <c:v>1042.95</c:v>
                </c:pt>
                <c:pt idx="3708">
                  <c:v>1043.24</c:v>
                </c:pt>
                <c:pt idx="3709">
                  <c:v>1043.52</c:v>
                </c:pt>
                <c:pt idx="3710">
                  <c:v>1043.8</c:v>
                </c:pt>
                <c:pt idx="3711">
                  <c:v>1044.08</c:v>
                </c:pt>
                <c:pt idx="3712">
                  <c:v>1044.3599999999999</c:v>
                </c:pt>
                <c:pt idx="3713">
                  <c:v>1044.6400000000001</c:v>
                </c:pt>
                <c:pt idx="3714">
                  <c:v>1044.92</c:v>
                </c:pt>
                <c:pt idx="3715">
                  <c:v>1045.2</c:v>
                </c:pt>
                <c:pt idx="3716">
                  <c:v>1045.48</c:v>
                </c:pt>
                <c:pt idx="3717">
                  <c:v>1045.76</c:v>
                </c:pt>
                <c:pt idx="3718">
                  <c:v>1046.04</c:v>
                </c:pt>
                <c:pt idx="3719">
                  <c:v>1046.32</c:v>
                </c:pt>
                <c:pt idx="3720">
                  <c:v>1046.5999999999999</c:v>
                </c:pt>
                <c:pt idx="3721">
                  <c:v>1046.8900000000001</c:v>
                </c:pt>
                <c:pt idx="3722">
                  <c:v>1047.17</c:v>
                </c:pt>
                <c:pt idx="3723">
                  <c:v>1047.44</c:v>
                </c:pt>
                <c:pt idx="3724">
                  <c:v>1047.73</c:v>
                </c:pt>
                <c:pt idx="3725">
                  <c:v>1048.01</c:v>
                </c:pt>
                <c:pt idx="3726">
                  <c:v>1048.29</c:v>
                </c:pt>
                <c:pt idx="3727">
                  <c:v>1048.57</c:v>
                </c:pt>
                <c:pt idx="3728">
                  <c:v>1048.8499999999999</c:v>
                </c:pt>
                <c:pt idx="3729">
                  <c:v>1049.1300000000001</c:v>
                </c:pt>
                <c:pt idx="3730">
                  <c:v>1049.4100000000001</c:v>
                </c:pt>
                <c:pt idx="3731">
                  <c:v>1049.69</c:v>
                </c:pt>
                <c:pt idx="3732">
                  <c:v>1049.97</c:v>
                </c:pt>
                <c:pt idx="3733">
                  <c:v>1050.26</c:v>
                </c:pt>
                <c:pt idx="3734">
                  <c:v>1050.54</c:v>
                </c:pt>
                <c:pt idx="3735">
                  <c:v>1050.81</c:v>
                </c:pt>
                <c:pt idx="3736">
                  <c:v>1051.0999999999999</c:v>
                </c:pt>
                <c:pt idx="3737">
                  <c:v>1051.3800000000001</c:v>
                </c:pt>
                <c:pt idx="3738">
                  <c:v>1051.6600000000001</c:v>
                </c:pt>
                <c:pt idx="3739">
                  <c:v>1051.94</c:v>
                </c:pt>
                <c:pt idx="3740">
                  <c:v>1052.22</c:v>
                </c:pt>
                <c:pt idx="3741">
                  <c:v>1052.5</c:v>
                </c:pt>
                <c:pt idx="3742">
                  <c:v>1052.78</c:v>
                </c:pt>
                <c:pt idx="3743">
                  <c:v>1053.06</c:v>
                </c:pt>
                <c:pt idx="3744">
                  <c:v>1053.3399999999999</c:v>
                </c:pt>
                <c:pt idx="3745">
                  <c:v>1053.6300000000001</c:v>
                </c:pt>
                <c:pt idx="3746">
                  <c:v>1053.9100000000001</c:v>
                </c:pt>
                <c:pt idx="3747">
                  <c:v>1054.19</c:v>
                </c:pt>
                <c:pt idx="3748">
                  <c:v>1054.46</c:v>
                </c:pt>
                <c:pt idx="3749">
                  <c:v>1054.75</c:v>
                </c:pt>
                <c:pt idx="3750">
                  <c:v>1055.03</c:v>
                </c:pt>
                <c:pt idx="3751">
                  <c:v>1055.31</c:v>
                </c:pt>
                <c:pt idx="3752">
                  <c:v>1055.5899999999999</c:v>
                </c:pt>
                <c:pt idx="3753">
                  <c:v>1055.8699999999999</c:v>
                </c:pt>
                <c:pt idx="3754">
                  <c:v>1056.1500000000001</c:v>
                </c:pt>
                <c:pt idx="3755">
                  <c:v>1056.43</c:v>
                </c:pt>
                <c:pt idx="3756">
                  <c:v>1056.71</c:v>
                </c:pt>
                <c:pt idx="3757">
                  <c:v>1057</c:v>
                </c:pt>
                <c:pt idx="3758">
                  <c:v>1057.28</c:v>
                </c:pt>
                <c:pt idx="3759">
                  <c:v>1057.55</c:v>
                </c:pt>
                <c:pt idx="3760">
                  <c:v>1057.83</c:v>
                </c:pt>
                <c:pt idx="3761">
                  <c:v>1058.1199999999999</c:v>
                </c:pt>
                <c:pt idx="3762">
                  <c:v>1058.4000000000001</c:v>
                </c:pt>
                <c:pt idx="3763">
                  <c:v>1058.68</c:v>
                </c:pt>
                <c:pt idx="3764">
                  <c:v>1058.96</c:v>
                </c:pt>
                <c:pt idx="3765">
                  <c:v>1059.24</c:v>
                </c:pt>
                <c:pt idx="3766">
                  <c:v>1059.52</c:v>
                </c:pt>
                <c:pt idx="3767">
                  <c:v>1059.8</c:v>
                </c:pt>
                <c:pt idx="3768">
                  <c:v>1060.0899999999999</c:v>
                </c:pt>
                <c:pt idx="3769">
                  <c:v>1060.3599999999999</c:v>
                </c:pt>
                <c:pt idx="3770">
                  <c:v>1060.6400000000001</c:v>
                </c:pt>
                <c:pt idx="3771">
                  <c:v>1060.92</c:v>
                </c:pt>
                <c:pt idx="3772">
                  <c:v>1061.21</c:v>
                </c:pt>
                <c:pt idx="3773">
                  <c:v>1061.49</c:v>
                </c:pt>
                <c:pt idx="3774">
                  <c:v>1061.77</c:v>
                </c:pt>
                <c:pt idx="3775">
                  <c:v>1062.05</c:v>
                </c:pt>
                <c:pt idx="3776">
                  <c:v>1062.33</c:v>
                </c:pt>
                <c:pt idx="3777">
                  <c:v>1062.6099999999999</c:v>
                </c:pt>
                <c:pt idx="3778">
                  <c:v>1062.8900000000001</c:v>
                </c:pt>
                <c:pt idx="3779">
                  <c:v>1063.17</c:v>
                </c:pt>
                <c:pt idx="3780">
                  <c:v>1063.45</c:v>
                </c:pt>
                <c:pt idx="3781">
                  <c:v>1063.73</c:v>
                </c:pt>
                <c:pt idx="3782">
                  <c:v>1064.02</c:v>
                </c:pt>
                <c:pt idx="3783">
                  <c:v>1064.3</c:v>
                </c:pt>
                <c:pt idx="3784">
                  <c:v>1064.57</c:v>
                </c:pt>
                <c:pt idx="3785">
                  <c:v>1064.8599999999999</c:v>
                </c:pt>
                <c:pt idx="3786">
                  <c:v>1065.1300000000001</c:v>
                </c:pt>
                <c:pt idx="3787">
                  <c:v>1065.42</c:v>
                </c:pt>
                <c:pt idx="3788">
                  <c:v>1065.7</c:v>
                </c:pt>
                <c:pt idx="3789">
                  <c:v>1065.98</c:v>
                </c:pt>
                <c:pt idx="3790">
                  <c:v>1066.26</c:v>
                </c:pt>
                <c:pt idx="3791">
                  <c:v>1066.54</c:v>
                </c:pt>
                <c:pt idx="3792">
                  <c:v>1066.82</c:v>
                </c:pt>
                <c:pt idx="3793">
                  <c:v>1067.0999999999999</c:v>
                </c:pt>
                <c:pt idx="3794">
                  <c:v>1067.3800000000001</c:v>
                </c:pt>
                <c:pt idx="3795">
                  <c:v>1067.67</c:v>
                </c:pt>
                <c:pt idx="3796">
                  <c:v>1067.95</c:v>
                </c:pt>
                <c:pt idx="3797">
                  <c:v>1068.23</c:v>
                </c:pt>
                <c:pt idx="3798">
                  <c:v>1068.51</c:v>
                </c:pt>
                <c:pt idx="3799">
                  <c:v>1068.79</c:v>
                </c:pt>
                <c:pt idx="3800">
                  <c:v>1069.07</c:v>
                </c:pt>
                <c:pt idx="3801">
                  <c:v>1069.3499999999999</c:v>
                </c:pt>
                <c:pt idx="3802">
                  <c:v>1069.6300000000001</c:v>
                </c:pt>
                <c:pt idx="3803">
                  <c:v>1069.9100000000001</c:v>
                </c:pt>
                <c:pt idx="3804">
                  <c:v>1070.19</c:v>
                </c:pt>
                <c:pt idx="3805">
                  <c:v>1070.47</c:v>
                </c:pt>
                <c:pt idx="3806">
                  <c:v>1070.76</c:v>
                </c:pt>
                <c:pt idx="3807">
                  <c:v>1071.03</c:v>
                </c:pt>
                <c:pt idx="3808">
                  <c:v>1071.32</c:v>
                </c:pt>
                <c:pt idx="3809">
                  <c:v>1071.5999999999999</c:v>
                </c:pt>
                <c:pt idx="3810">
                  <c:v>1071.8800000000001</c:v>
                </c:pt>
                <c:pt idx="3811">
                  <c:v>1072.1600000000001</c:v>
                </c:pt>
                <c:pt idx="3812">
                  <c:v>1072.44</c:v>
                </c:pt>
                <c:pt idx="3813">
                  <c:v>1072.72</c:v>
                </c:pt>
                <c:pt idx="3814">
                  <c:v>1073</c:v>
                </c:pt>
                <c:pt idx="3815">
                  <c:v>1073.28</c:v>
                </c:pt>
                <c:pt idx="3816">
                  <c:v>1073.56</c:v>
                </c:pt>
                <c:pt idx="3817">
                  <c:v>1073.8399999999999</c:v>
                </c:pt>
                <c:pt idx="3818">
                  <c:v>1074.1300000000001</c:v>
                </c:pt>
                <c:pt idx="3819">
                  <c:v>1074.4000000000001</c:v>
                </c:pt>
                <c:pt idx="3820">
                  <c:v>1074.68</c:v>
                </c:pt>
                <c:pt idx="3821">
                  <c:v>1074.96</c:v>
                </c:pt>
                <c:pt idx="3822">
                  <c:v>1075.25</c:v>
                </c:pt>
                <c:pt idx="3823">
                  <c:v>1075.53</c:v>
                </c:pt>
                <c:pt idx="3824">
                  <c:v>1075.81</c:v>
                </c:pt>
                <c:pt idx="3825">
                  <c:v>1076.0899999999999</c:v>
                </c:pt>
                <c:pt idx="3826">
                  <c:v>1076.3699999999999</c:v>
                </c:pt>
                <c:pt idx="3827">
                  <c:v>1076.6500000000001</c:v>
                </c:pt>
                <c:pt idx="3828">
                  <c:v>1076.93</c:v>
                </c:pt>
                <c:pt idx="3829">
                  <c:v>1077.21</c:v>
                </c:pt>
                <c:pt idx="3830">
                  <c:v>1077.49</c:v>
                </c:pt>
                <c:pt idx="3831">
                  <c:v>1077.77</c:v>
                </c:pt>
                <c:pt idx="3832">
                  <c:v>1078.06</c:v>
                </c:pt>
                <c:pt idx="3833">
                  <c:v>1078.3399999999999</c:v>
                </c:pt>
                <c:pt idx="3834">
                  <c:v>1078.6199999999999</c:v>
                </c:pt>
                <c:pt idx="3835">
                  <c:v>1078.9000000000001</c:v>
                </c:pt>
                <c:pt idx="3836">
                  <c:v>1079.18</c:v>
                </c:pt>
                <c:pt idx="3837">
                  <c:v>1079.46</c:v>
                </c:pt>
                <c:pt idx="3838">
                  <c:v>1079.74</c:v>
                </c:pt>
                <c:pt idx="3839">
                  <c:v>1080.02</c:v>
                </c:pt>
                <c:pt idx="3840">
                  <c:v>1080.3</c:v>
                </c:pt>
                <c:pt idx="3841">
                  <c:v>1080.58</c:v>
                </c:pt>
                <c:pt idx="3842">
                  <c:v>1080.8599999999999</c:v>
                </c:pt>
                <c:pt idx="3843">
                  <c:v>1081.1400000000001</c:v>
                </c:pt>
                <c:pt idx="3844">
                  <c:v>1081.42</c:v>
                </c:pt>
                <c:pt idx="3845">
                  <c:v>1081.7</c:v>
                </c:pt>
                <c:pt idx="3846">
                  <c:v>1081.98</c:v>
                </c:pt>
                <c:pt idx="3847">
                  <c:v>1082.27</c:v>
                </c:pt>
                <c:pt idx="3848">
                  <c:v>1082.55</c:v>
                </c:pt>
                <c:pt idx="3849">
                  <c:v>1082.83</c:v>
                </c:pt>
                <c:pt idx="3850">
                  <c:v>1083.1099999999999</c:v>
                </c:pt>
                <c:pt idx="3851">
                  <c:v>1083.3900000000001</c:v>
                </c:pt>
                <c:pt idx="3852">
                  <c:v>1083.67</c:v>
                </c:pt>
                <c:pt idx="3853">
                  <c:v>1083.95</c:v>
                </c:pt>
                <c:pt idx="3854">
                  <c:v>1084.23</c:v>
                </c:pt>
                <c:pt idx="3855">
                  <c:v>1084.51</c:v>
                </c:pt>
                <c:pt idx="3856">
                  <c:v>1084.79</c:v>
                </c:pt>
                <c:pt idx="3857">
                  <c:v>1085.07</c:v>
                </c:pt>
                <c:pt idx="3858">
                  <c:v>1085.3599999999999</c:v>
                </c:pt>
                <c:pt idx="3859">
                  <c:v>1085.6400000000001</c:v>
                </c:pt>
                <c:pt idx="3860">
                  <c:v>1085.9100000000001</c:v>
                </c:pt>
                <c:pt idx="3861">
                  <c:v>1086.2</c:v>
                </c:pt>
                <c:pt idx="3862">
                  <c:v>1086.48</c:v>
                </c:pt>
                <c:pt idx="3863">
                  <c:v>1086.76</c:v>
                </c:pt>
                <c:pt idx="3864">
                  <c:v>1087.04</c:v>
                </c:pt>
                <c:pt idx="3865">
                  <c:v>1087.32</c:v>
                </c:pt>
                <c:pt idx="3866">
                  <c:v>1087.5999999999999</c:v>
                </c:pt>
                <c:pt idx="3867">
                  <c:v>1087.8800000000001</c:v>
                </c:pt>
                <c:pt idx="3868">
                  <c:v>1088.1600000000001</c:v>
                </c:pt>
                <c:pt idx="3869">
                  <c:v>1088.45</c:v>
                </c:pt>
              </c:numCache>
            </c:numRef>
          </c:xVal>
          <c:yVal>
            <c:numRef>
              <c:f>'Sheet2 control'!$DB$92:$DB$3961</c:f>
              <c:numCache>
                <c:formatCode>General</c:formatCode>
                <c:ptCount val="3870"/>
                <c:pt idx="0">
                  <c:v>1</c:v>
                </c:pt>
                <c:pt idx="1">
                  <c:v>0.97159188339525582</c:v>
                </c:pt>
                <c:pt idx="2">
                  <c:v>0.97890825950271509</c:v>
                </c:pt>
                <c:pt idx="3">
                  <c:v>0.97490711631894822</c:v>
                </c:pt>
                <c:pt idx="4">
                  <c:v>0.97313518148042299</c:v>
                </c:pt>
                <c:pt idx="5">
                  <c:v>0.99582737925121467</c:v>
                </c:pt>
                <c:pt idx="6">
                  <c:v>0.98159474135467273</c:v>
                </c:pt>
                <c:pt idx="7">
                  <c:v>0.95078593883966844</c:v>
                </c:pt>
                <c:pt idx="8">
                  <c:v>0.96187482137753644</c:v>
                </c:pt>
                <c:pt idx="9">
                  <c:v>0.99594169762789364</c:v>
                </c:pt>
                <c:pt idx="10">
                  <c:v>0.96884824235495859</c:v>
                </c:pt>
                <c:pt idx="11">
                  <c:v>0.97416404687053448</c:v>
                </c:pt>
                <c:pt idx="12">
                  <c:v>0.95935981709059737</c:v>
                </c:pt>
                <c:pt idx="13">
                  <c:v>0.9927979422692198</c:v>
                </c:pt>
                <c:pt idx="14">
                  <c:v>0.96513289511288936</c:v>
                </c:pt>
                <c:pt idx="15">
                  <c:v>0.9850814518433838</c:v>
                </c:pt>
                <c:pt idx="16">
                  <c:v>0.9730780222920834</c:v>
                </c:pt>
                <c:pt idx="17">
                  <c:v>0.98953986853386677</c:v>
                </c:pt>
                <c:pt idx="18">
                  <c:v>1.0047442126321806</c:v>
                </c:pt>
                <c:pt idx="19">
                  <c:v>0.94529865675907399</c:v>
                </c:pt>
                <c:pt idx="20">
                  <c:v>0.96661903400971705</c:v>
                </c:pt>
                <c:pt idx="21">
                  <c:v>0.97770791654758504</c:v>
                </c:pt>
                <c:pt idx="22">
                  <c:v>0.97576450414404114</c:v>
                </c:pt>
                <c:pt idx="23">
                  <c:v>0.97330665904544156</c:v>
                </c:pt>
                <c:pt idx="24">
                  <c:v>0.97850814518433837</c:v>
                </c:pt>
                <c:pt idx="25">
                  <c:v>0.96701914832809377</c:v>
                </c:pt>
                <c:pt idx="26">
                  <c:v>0.98239496999142617</c:v>
                </c:pt>
                <c:pt idx="27">
                  <c:v>0.97410688768219489</c:v>
                </c:pt>
                <c:pt idx="28">
                  <c:v>0.94501286081737634</c:v>
                </c:pt>
                <c:pt idx="29">
                  <c:v>0.97490711631894822</c:v>
                </c:pt>
                <c:pt idx="30">
                  <c:v>0.97050585881680485</c:v>
                </c:pt>
                <c:pt idx="31">
                  <c:v>0.97027722206344669</c:v>
                </c:pt>
                <c:pt idx="32">
                  <c:v>0.99188339525578739</c:v>
                </c:pt>
                <c:pt idx="33">
                  <c:v>0.98616747642183478</c:v>
                </c:pt>
                <c:pt idx="34">
                  <c:v>0.95890254358388116</c:v>
                </c:pt>
                <c:pt idx="35">
                  <c:v>0.95884538439554157</c:v>
                </c:pt>
                <c:pt idx="36">
                  <c:v>0.95461560445841664</c:v>
                </c:pt>
                <c:pt idx="37">
                  <c:v>0.96930551586167479</c:v>
                </c:pt>
                <c:pt idx="38">
                  <c:v>0.95673049442697911</c:v>
                </c:pt>
                <c:pt idx="39">
                  <c:v>0.96799085452986566</c:v>
                </c:pt>
                <c:pt idx="40">
                  <c:v>0.95187196341811942</c:v>
                </c:pt>
                <c:pt idx="41">
                  <c:v>0.95667333523863962</c:v>
                </c:pt>
                <c:pt idx="42">
                  <c:v>0.9735352957987996</c:v>
                </c:pt>
                <c:pt idx="43">
                  <c:v>0.97496427550728781</c:v>
                </c:pt>
                <c:pt idx="44">
                  <c:v>0.95415833095170044</c:v>
                </c:pt>
                <c:pt idx="45">
                  <c:v>0.97313518148042299</c:v>
                </c:pt>
                <c:pt idx="46">
                  <c:v>0.97273506716204627</c:v>
                </c:pt>
                <c:pt idx="47">
                  <c:v>0.95524435553015152</c:v>
                </c:pt>
                <c:pt idx="48">
                  <c:v>0.98170905973135181</c:v>
                </c:pt>
                <c:pt idx="49">
                  <c:v>0.97210631609031151</c:v>
                </c:pt>
                <c:pt idx="50">
                  <c:v>0.95747356387539295</c:v>
                </c:pt>
                <c:pt idx="51">
                  <c:v>0.96273220920262936</c:v>
                </c:pt>
                <c:pt idx="52">
                  <c:v>0.95958845384395541</c:v>
                </c:pt>
                <c:pt idx="53">
                  <c:v>0.965418691054587</c:v>
                </c:pt>
                <c:pt idx="54">
                  <c:v>0.97770791654758504</c:v>
                </c:pt>
                <c:pt idx="55">
                  <c:v>0.95015718776793368</c:v>
                </c:pt>
                <c:pt idx="56">
                  <c:v>0.93952557873678189</c:v>
                </c:pt>
                <c:pt idx="57">
                  <c:v>0.95781651900543008</c:v>
                </c:pt>
                <c:pt idx="58">
                  <c:v>0.96427550728779654</c:v>
                </c:pt>
                <c:pt idx="59">
                  <c:v>0.95461560445841664</c:v>
                </c:pt>
                <c:pt idx="60">
                  <c:v>0.95358673906830527</c:v>
                </c:pt>
                <c:pt idx="61">
                  <c:v>0.95370105744498423</c:v>
                </c:pt>
                <c:pt idx="62">
                  <c:v>0.95461560445841664</c:v>
                </c:pt>
                <c:pt idx="63">
                  <c:v>0.96290368676764793</c:v>
                </c:pt>
                <c:pt idx="64">
                  <c:v>0.95764504144041152</c:v>
                </c:pt>
                <c:pt idx="65">
                  <c:v>0.95878822520720208</c:v>
                </c:pt>
                <c:pt idx="66">
                  <c:v>0.96130322949414115</c:v>
                </c:pt>
                <c:pt idx="67">
                  <c:v>0.96490425835953131</c:v>
                </c:pt>
                <c:pt idx="68">
                  <c:v>0.9851386110317234</c:v>
                </c:pt>
                <c:pt idx="69">
                  <c:v>0.97136324664189766</c:v>
                </c:pt>
                <c:pt idx="70">
                  <c:v>0.95232923692483562</c:v>
                </c:pt>
                <c:pt idx="71">
                  <c:v>0.9529579879965705</c:v>
                </c:pt>
                <c:pt idx="72">
                  <c:v>0.95587310660188629</c:v>
                </c:pt>
                <c:pt idx="73">
                  <c:v>0.94621320377250639</c:v>
                </c:pt>
                <c:pt idx="74">
                  <c:v>0.95152900828808229</c:v>
                </c:pt>
                <c:pt idx="75">
                  <c:v>0.98262360674478422</c:v>
                </c:pt>
                <c:pt idx="76">
                  <c:v>0.96347527865104321</c:v>
                </c:pt>
                <c:pt idx="77">
                  <c:v>0.94707059159759932</c:v>
                </c:pt>
                <c:pt idx="78">
                  <c:v>0.95970277222063449</c:v>
                </c:pt>
                <c:pt idx="79">
                  <c:v>0.9692483566733352</c:v>
                </c:pt>
                <c:pt idx="80">
                  <c:v>0.94821377536438978</c:v>
                </c:pt>
                <c:pt idx="81">
                  <c:v>0.95130037153472424</c:v>
                </c:pt>
                <c:pt idx="82">
                  <c:v>0.95090025721634752</c:v>
                </c:pt>
                <c:pt idx="83">
                  <c:v>0.95975993140897398</c:v>
                </c:pt>
                <c:pt idx="84">
                  <c:v>0.95272935124321234</c:v>
                </c:pt>
                <c:pt idx="85">
                  <c:v>0.95490140040011429</c:v>
                </c:pt>
                <c:pt idx="86">
                  <c:v>0.96347527865104321</c:v>
                </c:pt>
                <c:pt idx="87">
                  <c:v>0.9490711631894827</c:v>
                </c:pt>
                <c:pt idx="88">
                  <c:v>0.96176050300085736</c:v>
                </c:pt>
                <c:pt idx="89">
                  <c:v>0.95987424978565306</c:v>
                </c:pt>
                <c:pt idx="90">
                  <c:v>0.92803658188053728</c:v>
                </c:pt>
                <c:pt idx="91">
                  <c:v>0.965418691054587</c:v>
                </c:pt>
                <c:pt idx="92">
                  <c:v>0.95815947413546732</c:v>
                </c:pt>
                <c:pt idx="93">
                  <c:v>0.95855958845384392</c:v>
                </c:pt>
                <c:pt idx="94">
                  <c:v>0.97347813661046012</c:v>
                </c:pt>
                <c:pt idx="95">
                  <c:v>0.93666761931980569</c:v>
                </c:pt>
                <c:pt idx="96">
                  <c:v>0.96141754787082023</c:v>
                </c:pt>
                <c:pt idx="97">
                  <c:v>0.94352672192054876</c:v>
                </c:pt>
                <c:pt idx="98">
                  <c:v>0.92969419834238354</c:v>
                </c:pt>
                <c:pt idx="99">
                  <c:v>0.92437839382680764</c:v>
                </c:pt>
                <c:pt idx="100">
                  <c:v>0.94535581594741358</c:v>
                </c:pt>
                <c:pt idx="101">
                  <c:v>0.95307230637324947</c:v>
                </c:pt>
                <c:pt idx="102">
                  <c:v>0.96250357244927121</c:v>
                </c:pt>
                <c:pt idx="103">
                  <c:v>0.95284366961989142</c:v>
                </c:pt>
                <c:pt idx="104">
                  <c:v>0.92815090025721636</c:v>
                </c:pt>
                <c:pt idx="105">
                  <c:v>0.958673906830523</c:v>
                </c:pt>
                <c:pt idx="106">
                  <c:v>0.95547299228350957</c:v>
                </c:pt>
                <c:pt idx="107">
                  <c:v>0.93266647613603881</c:v>
                </c:pt>
                <c:pt idx="108">
                  <c:v>0.96170334381251787</c:v>
                </c:pt>
                <c:pt idx="109">
                  <c:v>0.95673049442697911</c:v>
                </c:pt>
                <c:pt idx="110">
                  <c:v>0.96456130322949418</c:v>
                </c:pt>
                <c:pt idx="111">
                  <c:v>0.93501000285795943</c:v>
                </c:pt>
                <c:pt idx="112">
                  <c:v>0.94009717062017717</c:v>
                </c:pt>
                <c:pt idx="113">
                  <c:v>0.95524435553015152</c:v>
                </c:pt>
                <c:pt idx="114">
                  <c:v>0.93272363532437841</c:v>
                </c:pt>
                <c:pt idx="115">
                  <c:v>0.93878250928836815</c:v>
                </c:pt>
                <c:pt idx="116">
                  <c:v>0.94512717919405542</c:v>
                </c:pt>
                <c:pt idx="117">
                  <c:v>0.96770505858816802</c:v>
                </c:pt>
                <c:pt idx="118">
                  <c:v>0.93941126036010292</c:v>
                </c:pt>
                <c:pt idx="119">
                  <c:v>0.93763932552157758</c:v>
                </c:pt>
                <c:pt idx="120">
                  <c:v>0.93632466418976845</c:v>
                </c:pt>
                <c:pt idx="121">
                  <c:v>0.93278079451271789</c:v>
                </c:pt>
                <c:pt idx="122">
                  <c:v>0.95398685338668188</c:v>
                </c:pt>
                <c:pt idx="123">
                  <c:v>0.95753072306373255</c:v>
                </c:pt>
                <c:pt idx="124">
                  <c:v>0.94489854244069738</c:v>
                </c:pt>
                <c:pt idx="125">
                  <c:v>0.96027436410402978</c:v>
                </c:pt>
                <c:pt idx="126">
                  <c:v>0.92289225492997995</c:v>
                </c:pt>
                <c:pt idx="127">
                  <c:v>0.94809945698771081</c:v>
                </c:pt>
                <c:pt idx="128">
                  <c:v>0.95410117176336096</c:v>
                </c:pt>
                <c:pt idx="129">
                  <c:v>0.93792512146327522</c:v>
                </c:pt>
                <c:pt idx="130">
                  <c:v>0.94684195484424116</c:v>
                </c:pt>
                <c:pt idx="131">
                  <c:v>0.94689911403258076</c:v>
                </c:pt>
                <c:pt idx="132">
                  <c:v>0.95878822520720208</c:v>
                </c:pt>
                <c:pt idx="133">
                  <c:v>0.95084309802800804</c:v>
                </c:pt>
                <c:pt idx="134">
                  <c:v>0.91849099742783658</c:v>
                </c:pt>
                <c:pt idx="135">
                  <c:v>0.92597885110031442</c:v>
                </c:pt>
                <c:pt idx="136">
                  <c:v>0.93380965990282938</c:v>
                </c:pt>
                <c:pt idx="137">
                  <c:v>0.90774507002000571</c:v>
                </c:pt>
                <c:pt idx="138">
                  <c:v>0.93380965990282938</c:v>
                </c:pt>
                <c:pt idx="139">
                  <c:v>0.92512146327522149</c:v>
                </c:pt>
                <c:pt idx="140">
                  <c:v>0.9336953415261503</c:v>
                </c:pt>
                <c:pt idx="141">
                  <c:v>0.94352672192054876</c:v>
                </c:pt>
                <c:pt idx="142">
                  <c:v>0.95130037153472424</c:v>
                </c:pt>
                <c:pt idx="143">
                  <c:v>0.935181480422978</c:v>
                </c:pt>
                <c:pt idx="144">
                  <c:v>0.92820805944555584</c:v>
                </c:pt>
                <c:pt idx="145">
                  <c:v>0.94004001143183769</c:v>
                </c:pt>
                <c:pt idx="146">
                  <c:v>0.94581308945412979</c:v>
                </c:pt>
                <c:pt idx="147">
                  <c:v>0.93558159474135472</c:v>
                </c:pt>
                <c:pt idx="148">
                  <c:v>0.92500714489854241</c:v>
                </c:pt>
                <c:pt idx="149">
                  <c:v>0.96238925407259213</c:v>
                </c:pt>
                <c:pt idx="150">
                  <c:v>0.93701057444984281</c:v>
                </c:pt>
                <c:pt idx="151">
                  <c:v>0.94849957130608742</c:v>
                </c:pt>
                <c:pt idx="152">
                  <c:v>0.9639897113460989</c:v>
                </c:pt>
                <c:pt idx="153">
                  <c:v>0.94209774221206055</c:v>
                </c:pt>
                <c:pt idx="154">
                  <c:v>0.93586739068305225</c:v>
                </c:pt>
                <c:pt idx="155">
                  <c:v>0.9337525007144899</c:v>
                </c:pt>
                <c:pt idx="156">
                  <c:v>0.91277507859388396</c:v>
                </c:pt>
                <c:pt idx="157">
                  <c:v>0.94678479565590168</c:v>
                </c:pt>
                <c:pt idx="158">
                  <c:v>0.93621034581308948</c:v>
                </c:pt>
                <c:pt idx="159">
                  <c:v>0.92929408402400682</c:v>
                </c:pt>
                <c:pt idx="160">
                  <c:v>0.91391826236067453</c:v>
                </c:pt>
                <c:pt idx="161">
                  <c:v>0.91140325807373535</c:v>
                </c:pt>
                <c:pt idx="162">
                  <c:v>0.92037725064304088</c:v>
                </c:pt>
                <c:pt idx="163">
                  <c:v>0.93798228065161471</c:v>
                </c:pt>
                <c:pt idx="164">
                  <c:v>0.94238353815375819</c:v>
                </c:pt>
                <c:pt idx="165">
                  <c:v>0.93020863103743923</c:v>
                </c:pt>
                <c:pt idx="166">
                  <c:v>0.92306373249499862</c:v>
                </c:pt>
                <c:pt idx="167">
                  <c:v>0.94838525292940845</c:v>
                </c:pt>
                <c:pt idx="168">
                  <c:v>0.95713060874535583</c:v>
                </c:pt>
                <c:pt idx="169">
                  <c:v>0.94101171763360958</c:v>
                </c:pt>
                <c:pt idx="170">
                  <c:v>0.9226636181766219</c:v>
                </c:pt>
                <c:pt idx="171">
                  <c:v>0.90305801657616458</c:v>
                </c:pt>
                <c:pt idx="172">
                  <c:v>0.94729922835095737</c:v>
                </c:pt>
                <c:pt idx="173">
                  <c:v>0.90791654758502427</c:v>
                </c:pt>
                <c:pt idx="174">
                  <c:v>0.93678193769648466</c:v>
                </c:pt>
                <c:pt idx="175">
                  <c:v>0.93472420691626179</c:v>
                </c:pt>
                <c:pt idx="176">
                  <c:v>0.927464989997142</c:v>
                </c:pt>
                <c:pt idx="177">
                  <c:v>0.94581308945412979</c:v>
                </c:pt>
                <c:pt idx="178">
                  <c:v>0.90940268648185196</c:v>
                </c:pt>
                <c:pt idx="179">
                  <c:v>0.93958273792512148</c:v>
                </c:pt>
                <c:pt idx="180">
                  <c:v>0.93826807659331235</c:v>
                </c:pt>
                <c:pt idx="181">
                  <c:v>0.93409545584452702</c:v>
                </c:pt>
                <c:pt idx="182">
                  <c:v>0.92786510431551872</c:v>
                </c:pt>
                <c:pt idx="183">
                  <c:v>0.92740783080880251</c:v>
                </c:pt>
                <c:pt idx="184">
                  <c:v>0.92192054872820806</c:v>
                </c:pt>
                <c:pt idx="185">
                  <c:v>0.93878250928836815</c:v>
                </c:pt>
                <c:pt idx="186">
                  <c:v>0.90911689054015432</c:v>
                </c:pt>
                <c:pt idx="187">
                  <c:v>0.90460131466133176</c:v>
                </c:pt>
                <c:pt idx="188">
                  <c:v>0.92254929979994282</c:v>
                </c:pt>
                <c:pt idx="189">
                  <c:v>0.94552729351243214</c:v>
                </c:pt>
                <c:pt idx="190">
                  <c:v>0.93272363532437841</c:v>
                </c:pt>
                <c:pt idx="191">
                  <c:v>0.94369819948556732</c:v>
                </c:pt>
                <c:pt idx="192">
                  <c:v>0.92912260645898825</c:v>
                </c:pt>
                <c:pt idx="193">
                  <c:v>0.935181480422978</c:v>
                </c:pt>
                <c:pt idx="194">
                  <c:v>0.91454701343240929</c:v>
                </c:pt>
                <c:pt idx="195">
                  <c:v>0.92626464704201206</c:v>
                </c:pt>
                <c:pt idx="196">
                  <c:v>0.90905973135181484</c:v>
                </c:pt>
                <c:pt idx="197">
                  <c:v>0.92786510431551872</c:v>
                </c:pt>
                <c:pt idx="198">
                  <c:v>0.92523578165190057</c:v>
                </c:pt>
                <c:pt idx="199">
                  <c:v>0.94564161188911122</c:v>
                </c:pt>
                <c:pt idx="200">
                  <c:v>0.91894827093455278</c:v>
                </c:pt>
                <c:pt idx="201">
                  <c:v>0.92883681051729061</c:v>
                </c:pt>
                <c:pt idx="202">
                  <c:v>0.92277793655330098</c:v>
                </c:pt>
                <c:pt idx="203">
                  <c:v>0.92809374106887688</c:v>
                </c:pt>
                <c:pt idx="204">
                  <c:v>0.91677622177765072</c:v>
                </c:pt>
                <c:pt idx="205">
                  <c:v>0.92700771649042579</c:v>
                </c:pt>
                <c:pt idx="206">
                  <c:v>0.93472420691626179</c:v>
                </c:pt>
                <c:pt idx="207">
                  <c:v>0.91774792797942273</c:v>
                </c:pt>
                <c:pt idx="208">
                  <c:v>0.92294941411831954</c:v>
                </c:pt>
                <c:pt idx="209">
                  <c:v>0.92454987139182621</c:v>
                </c:pt>
                <c:pt idx="210">
                  <c:v>0.94038296656187481</c:v>
                </c:pt>
                <c:pt idx="211">
                  <c:v>0.92312089168333811</c:v>
                </c:pt>
                <c:pt idx="212">
                  <c:v>0.92957987996570446</c:v>
                </c:pt>
                <c:pt idx="213">
                  <c:v>0.94547013432409255</c:v>
                </c:pt>
                <c:pt idx="214">
                  <c:v>0.94609888539582743</c:v>
                </c:pt>
                <c:pt idx="215">
                  <c:v>0.92935124321234641</c:v>
                </c:pt>
                <c:pt idx="216">
                  <c:v>0.90791654758502427</c:v>
                </c:pt>
                <c:pt idx="217">
                  <c:v>0.96193198056587592</c:v>
                </c:pt>
                <c:pt idx="218">
                  <c:v>0.92980851671906262</c:v>
                </c:pt>
                <c:pt idx="219">
                  <c:v>0.93318090883109461</c:v>
                </c:pt>
                <c:pt idx="220">
                  <c:v>0.95495855958845388</c:v>
                </c:pt>
                <c:pt idx="221">
                  <c:v>0.93861103172334948</c:v>
                </c:pt>
                <c:pt idx="222">
                  <c:v>0.94198342383538158</c:v>
                </c:pt>
                <c:pt idx="223">
                  <c:v>0.94912832237782219</c:v>
                </c:pt>
                <c:pt idx="224">
                  <c:v>0.92517862246356097</c:v>
                </c:pt>
                <c:pt idx="225">
                  <c:v>0.93289511288939697</c:v>
                </c:pt>
                <c:pt idx="226">
                  <c:v>0.95118605315804516</c:v>
                </c:pt>
                <c:pt idx="227">
                  <c:v>0.92683623892540723</c:v>
                </c:pt>
                <c:pt idx="228">
                  <c:v>0.91363246641897689</c:v>
                </c:pt>
                <c:pt idx="229">
                  <c:v>0.93306659045441553</c:v>
                </c:pt>
                <c:pt idx="230">
                  <c:v>0.92763646756216067</c:v>
                </c:pt>
                <c:pt idx="231">
                  <c:v>0.92386396113175195</c:v>
                </c:pt>
                <c:pt idx="232">
                  <c:v>0.92757930837382108</c:v>
                </c:pt>
                <c:pt idx="233">
                  <c:v>0.93781080308659615</c:v>
                </c:pt>
                <c:pt idx="234">
                  <c:v>0.90402972277793658</c:v>
                </c:pt>
                <c:pt idx="235">
                  <c:v>0.91008859674192621</c:v>
                </c:pt>
                <c:pt idx="236">
                  <c:v>0.91900543012289226</c:v>
                </c:pt>
                <c:pt idx="237">
                  <c:v>0.90311517576450417</c:v>
                </c:pt>
                <c:pt idx="238">
                  <c:v>0.91900543012289226</c:v>
                </c:pt>
                <c:pt idx="239">
                  <c:v>0.91866247499285514</c:v>
                </c:pt>
                <c:pt idx="240">
                  <c:v>0.88539582737925127</c:v>
                </c:pt>
                <c:pt idx="241">
                  <c:v>0.9091740497284938</c:v>
                </c:pt>
                <c:pt idx="242">
                  <c:v>0.92054872820805944</c:v>
                </c:pt>
                <c:pt idx="243">
                  <c:v>0.90860245784509863</c:v>
                </c:pt>
                <c:pt idx="244">
                  <c:v>0.90100028579594171</c:v>
                </c:pt>
                <c:pt idx="245">
                  <c:v>0.9068305230065733</c:v>
                </c:pt>
                <c:pt idx="246">
                  <c:v>0.90231494712775073</c:v>
                </c:pt>
                <c:pt idx="247">
                  <c:v>0.90248642469276941</c:v>
                </c:pt>
                <c:pt idx="248">
                  <c:v>0.89968562446413258</c:v>
                </c:pt>
                <c:pt idx="249">
                  <c:v>0.91203200914547011</c:v>
                </c:pt>
                <c:pt idx="250">
                  <c:v>0.91048871106030294</c:v>
                </c:pt>
                <c:pt idx="251">
                  <c:v>0.90220062875107176</c:v>
                </c:pt>
                <c:pt idx="252">
                  <c:v>0.92540725921691913</c:v>
                </c:pt>
                <c:pt idx="253">
                  <c:v>0.89276936267505003</c:v>
                </c:pt>
                <c:pt idx="254">
                  <c:v>0.89854244069734213</c:v>
                </c:pt>
                <c:pt idx="255">
                  <c:v>0.91849099742783658</c:v>
                </c:pt>
                <c:pt idx="256">
                  <c:v>0.89871391826236069</c:v>
                </c:pt>
                <c:pt idx="257">
                  <c:v>0.90271506144612745</c:v>
                </c:pt>
                <c:pt idx="258">
                  <c:v>0.89116890540154325</c:v>
                </c:pt>
                <c:pt idx="259">
                  <c:v>0.91237496427550724</c:v>
                </c:pt>
                <c:pt idx="260">
                  <c:v>0.91208916833380971</c:v>
                </c:pt>
                <c:pt idx="261">
                  <c:v>0.90974564161188909</c:v>
                </c:pt>
                <c:pt idx="262">
                  <c:v>0.89408402400685916</c:v>
                </c:pt>
                <c:pt idx="263">
                  <c:v>0.90128608173763936</c:v>
                </c:pt>
                <c:pt idx="264">
                  <c:v>0.8914547013432409</c:v>
                </c:pt>
                <c:pt idx="265">
                  <c:v>0.90671620462989422</c:v>
                </c:pt>
                <c:pt idx="266">
                  <c:v>0.92323521006001719</c:v>
                </c:pt>
                <c:pt idx="267">
                  <c:v>0.88562446413260931</c:v>
                </c:pt>
                <c:pt idx="268">
                  <c:v>0.89848528150900253</c:v>
                </c:pt>
                <c:pt idx="269">
                  <c:v>0.88773935410117177</c:v>
                </c:pt>
                <c:pt idx="270">
                  <c:v>0.87745070020005711</c:v>
                </c:pt>
                <c:pt idx="271">
                  <c:v>0.89939982852243494</c:v>
                </c:pt>
                <c:pt idx="272">
                  <c:v>0.8957416404687053</c:v>
                </c:pt>
                <c:pt idx="273">
                  <c:v>0.8866533295227208</c:v>
                </c:pt>
                <c:pt idx="274">
                  <c:v>0.90911689054015432</c:v>
                </c:pt>
                <c:pt idx="275">
                  <c:v>0.89494141183195197</c:v>
                </c:pt>
                <c:pt idx="276">
                  <c:v>0.88488139468419547</c:v>
                </c:pt>
                <c:pt idx="277">
                  <c:v>0.89757073449557012</c:v>
                </c:pt>
                <c:pt idx="278">
                  <c:v>0.90848813946841955</c:v>
                </c:pt>
                <c:pt idx="279">
                  <c:v>0.88168048013718203</c:v>
                </c:pt>
                <c:pt idx="280">
                  <c:v>0.89677050585881679</c:v>
                </c:pt>
                <c:pt idx="281">
                  <c:v>0.89065447270648757</c:v>
                </c:pt>
                <c:pt idx="282">
                  <c:v>0.88533866819091167</c:v>
                </c:pt>
                <c:pt idx="283">
                  <c:v>0.88608173763932552</c:v>
                </c:pt>
                <c:pt idx="284">
                  <c:v>0.87024864246927691</c:v>
                </c:pt>
                <c:pt idx="285">
                  <c:v>0.8808802515004287</c:v>
                </c:pt>
                <c:pt idx="286">
                  <c:v>0.88190911689054019</c:v>
                </c:pt>
                <c:pt idx="287">
                  <c:v>0.88048013718205198</c:v>
                </c:pt>
                <c:pt idx="288">
                  <c:v>0.90420120034295515</c:v>
                </c:pt>
                <c:pt idx="289">
                  <c:v>0.89488425264361249</c:v>
                </c:pt>
                <c:pt idx="290">
                  <c:v>0.86881966276078881</c:v>
                </c:pt>
                <c:pt idx="291">
                  <c:v>0.87516433266647609</c:v>
                </c:pt>
                <c:pt idx="292">
                  <c:v>0.87619319805658757</c:v>
                </c:pt>
                <c:pt idx="293">
                  <c:v>0.87779365533009435</c:v>
                </c:pt>
                <c:pt idx="294">
                  <c:v>0.86418976850528717</c:v>
                </c:pt>
                <c:pt idx="295">
                  <c:v>0.8621320377250643</c:v>
                </c:pt>
                <c:pt idx="296">
                  <c:v>0.86899114032580738</c:v>
                </c:pt>
                <c:pt idx="297">
                  <c:v>0.8861960560160046</c:v>
                </c:pt>
                <c:pt idx="298">
                  <c:v>0.86801943412403548</c:v>
                </c:pt>
                <c:pt idx="299">
                  <c:v>0.8880823092312089</c:v>
                </c:pt>
                <c:pt idx="300">
                  <c:v>0.86859102600743066</c:v>
                </c:pt>
                <c:pt idx="301">
                  <c:v>0.88168048013718203</c:v>
                </c:pt>
                <c:pt idx="302">
                  <c:v>0.8640754501286082</c:v>
                </c:pt>
                <c:pt idx="303">
                  <c:v>0.8919119748499571</c:v>
                </c:pt>
                <c:pt idx="304">
                  <c:v>0.86327522149185476</c:v>
                </c:pt>
                <c:pt idx="305">
                  <c:v>0.87184909974278368</c:v>
                </c:pt>
                <c:pt idx="306">
                  <c:v>0.88608173763932552</c:v>
                </c:pt>
                <c:pt idx="307">
                  <c:v>0.88899685624464131</c:v>
                </c:pt>
                <c:pt idx="308">
                  <c:v>0.87979422692197773</c:v>
                </c:pt>
                <c:pt idx="309">
                  <c:v>0.88430980280080018</c:v>
                </c:pt>
                <c:pt idx="310">
                  <c:v>0.84864246927693632</c:v>
                </c:pt>
                <c:pt idx="311">
                  <c:v>0.86253215204344102</c:v>
                </c:pt>
                <c:pt idx="312">
                  <c:v>0.86270362960845959</c:v>
                </c:pt>
                <c:pt idx="313">
                  <c:v>0.84286939125464422</c:v>
                </c:pt>
                <c:pt idx="314">
                  <c:v>0.84464132609316944</c:v>
                </c:pt>
                <c:pt idx="315">
                  <c:v>0.87424978565304368</c:v>
                </c:pt>
                <c:pt idx="316">
                  <c:v>0.8535010002857959</c:v>
                </c:pt>
                <c:pt idx="317">
                  <c:v>0.87779365533009435</c:v>
                </c:pt>
                <c:pt idx="318">
                  <c:v>0.86281794798513856</c:v>
                </c:pt>
                <c:pt idx="319">
                  <c:v>0.86418976850528717</c:v>
                </c:pt>
                <c:pt idx="320">
                  <c:v>0.86070305801657621</c:v>
                </c:pt>
                <c:pt idx="321">
                  <c:v>0.8539582737925121</c:v>
                </c:pt>
                <c:pt idx="322">
                  <c:v>0.86270362960845959</c:v>
                </c:pt>
                <c:pt idx="323">
                  <c:v>0.84469848528150904</c:v>
                </c:pt>
                <c:pt idx="324">
                  <c:v>0.84664189768505282</c:v>
                </c:pt>
                <c:pt idx="325">
                  <c:v>0.85224349814232636</c:v>
                </c:pt>
                <c:pt idx="326">
                  <c:v>0.87299228350957414</c:v>
                </c:pt>
                <c:pt idx="327">
                  <c:v>0.84069734209774216</c:v>
                </c:pt>
                <c:pt idx="328">
                  <c:v>0.8770505858816805</c:v>
                </c:pt>
                <c:pt idx="329">
                  <c:v>0.88636753358102316</c:v>
                </c:pt>
                <c:pt idx="330">
                  <c:v>0.87379251214632747</c:v>
                </c:pt>
                <c:pt idx="331">
                  <c:v>0.86904829951414686</c:v>
                </c:pt>
                <c:pt idx="332">
                  <c:v>0.85458702486424698</c:v>
                </c:pt>
                <c:pt idx="333">
                  <c:v>0.84326950557302083</c:v>
                </c:pt>
                <c:pt idx="334">
                  <c:v>0.83000857387825089</c:v>
                </c:pt>
                <c:pt idx="335">
                  <c:v>0.86133180908831097</c:v>
                </c:pt>
                <c:pt idx="336">
                  <c:v>0.83595312946556155</c:v>
                </c:pt>
                <c:pt idx="337">
                  <c:v>0.83778222349242637</c:v>
                </c:pt>
                <c:pt idx="338">
                  <c:v>0.83035152900828813</c:v>
                </c:pt>
                <c:pt idx="339">
                  <c:v>0.85298656759074021</c:v>
                </c:pt>
                <c:pt idx="340">
                  <c:v>0.82966561874821376</c:v>
                </c:pt>
                <c:pt idx="341">
                  <c:v>0.86030294369819948</c:v>
                </c:pt>
                <c:pt idx="342">
                  <c:v>0.82515004286939131</c:v>
                </c:pt>
                <c:pt idx="343">
                  <c:v>0.82623606744784228</c:v>
                </c:pt>
                <c:pt idx="344">
                  <c:v>0.82412117747927982</c:v>
                </c:pt>
                <c:pt idx="345">
                  <c:v>0.84595598742497857</c:v>
                </c:pt>
                <c:pt idx="346">
                  <c:v>0.84864246927693632</c:v>
                </c:pt>
                <c:pt idx="347">
                  <c:v>0.82234924264075449</c:v>
                </c:pt>
                <c:pt idx="348">
                  <c:v>0.83223778222349243</c:v>
                </c:pt>
                <c:pt idx="349">
                  <c:v>0.84401257502143467</c:v>
                </c:pt>
                <c:pt idx="350">
                  <c:v>0.82795084309802802</c:v>
                </c:pt>
                <c:pt idx="351">
                  <c:v>0.84515575878822524</c:v>
                </c:pt>
                <c:pt idx="352">
                  <c:v>0.81114604172620752</c:v>
                </c:pt>
                <c:pt idx="353">
                  <c:v>0.85367247785081457</c:v>
                </c:pt>
                <c:pt idx="354">
                  <c:v>0.85195770220062872</c:v>
                </c:pt>
                <c:pt idx="355">
                  <c:v>0.82720777364961418</c:v>
                </c:pt>
                <c:pt idx="356">
                  <c:v>0.85698771077450697</c:v>
                </c:pt>
                <c:pt idx="357">
                  <c:v>0.817947985138611</c:v>
                </c:pt>
                <c:pt idx="358">
                  <c:v>0.82406401829094023</c:v>
                </c:pt>
                <c:pt idx="359">
                  <c:v>0.82509288368105171</c:v>
                </c:pt>
                <c:pt idx="360">
                  <c:v>0.83280937410688771</c:v>
                </c:pt>
                <c:pt idx="361">
                  <c:v>0.84138325235781652</c:v>
                </c:pt>
                <c:pt idx="362">
                  <c:v>0.80491569019719922</c:v>
                </c:pt>
                <c:pt idx="363">
                  <c:v>0.83383823949699909</c:v>
                </c:pt>
                <c:pt idx="364">
                  <c:v>0.81903400971706197</c:v>
                </c:pt>
                <c:pt idx="365">
                  <c:v>0.84469848528150904</c:v>
                </c:pt>
                <c:pt idx="366">
                  <c:v>0.8174907116318948</c:v>
                </c:pt>
                <c:pt idx="367">
                  <c:v>0.83749642755072873</c:v>
                </c:pt>
                <c:pt idx="368">
                  <c:v>0.84069734209774216</c:v>
                </c:pt>
                <c:pt idx="369">
                  <c:v>0.82720777364961418</c:v>
                </c:pt>
                <c:pt idx="370">
                  <c:v>0.83818233781080309</c:v>
                </c:pt>
                <c:pt idx="371">
                  <c:v>0.83949699914261222</c:v>
                </c:pt>
                <c:pt idx="372">
                  <c:v>0.8107459274078308</c:v>
                </c:pt>
                <c:pt idx="373">
                  <c:v>0.83698199485567304</c:v>
                </c:pt>
                <c:pt idx="374">
                  <c:v>0.81960560160045726</c:v>
                </c:pt>
                <c:pt idx="375">
                  <c:v>0.85550157187767939</c:v>
                </c:pt>
                <c:pt idx="376">
                  <c:v>0.82480708773935407</c:v>
                </c:pt>
                <c:pt idx="377">
                  <c:v>0.82063446699056875</c:v>
                </c:pt>
                <c:pt idx="378">
                  <c:v>0.83383823949699909</c:v>
                </c:pt>
                <c:pt idx="379">
                  <c:v>0.81880537296370393</c:v>
                </c:pt>
                <c:pt idx="380">
                  <c:v>0.83012289225492997</c:v>
                </c:pt>
                <c:pt idx="381">
                  <c:v>0.82023435267219202</c:v>
                </c:pt>
                <c:pt idx="382">
                  <c:v>0.81046013146613316</c:v>
                </c:pt>
                <c:pt idx="383">
                  <c:v>0.82983709631323233</c:v>
                </c:pt>
                <c:pt idx="384">
                  <c:v>0.81880537296370393</c:v>
                </c:pt>
                <c:pt idx="385">
                  <c:v>0.8328665332952272</c:v>
                </c:pt>
                <c:pt idx="386">
                  <c:v>0.81720491569019715</c:v>
                </c:pt>
                <c:pt idx="387">
                  <c:v>0.81491854815661613</c:v>
                </c:pt>
                <c:pt idx="388">
                  <c:v>0.83703915404401252</c:v>
                </c:pt>
                <c:pt idx="389">
                  <c:v>0.81766218919691336</c:v>
                </c:pt>
                <c:pt idx="390">
                  <c:v>0.83400971706201776</c:v>
                </c:pt>
                <c:pt idx="391">
                  <c:v>0.84344098313803939</c:v>
                </c:pt>
                <c:pt idx="392">
                  <c:v>0.82269219777079161</c:v>
                </c:pt>
                <c:pt idx="393">
                  <c:v>0.83738210917404976</c:v>
                </c:pt>
                <c:pt idx="394">
                  <c:v>0.81943412403543869</c:v>
                </c:pt>
                <c:pt idx="395">
                  <c:v>0.81646184624178342</c:v>
                </c:pt>
                <c:pt idx="396">
                  <c:v>0.80337239211203204</c:v>
                </c:pt>
                <c:pt idx="397">
                  <c:v>0.82515004286939131</c:v>
                </c:pt>
                <c:pt idx="398">
                  <c:v>0.81743355244355531</c:v>
                </c:pt>
                <c:pt idx="399">
                  <c:v>0.81143183766790516</c:v>
                </c:pt>
                <c:pt idx="400">
                  <c:v>0.82149185481566167</c:v>
                </c:pt>
                <c:pt idx="401">
                  <c:v>0.83652472134895683</c:v>
                </c:pt>
                <c:pt idx="402">
                  <c:v>0.80028579594169758</c:v>
                </c:pt>
                <c:pt idx="403">
                  <c:v>0.79754215490140035</c:v>
                </c:pt>
                <c:pt idx="404">
                  <c:v>0.83818233781080309</c:v>
                </c:pt>
                <c:pt idx="405">
                  <c:v>0.82829379822806515</c:v>
                </c:pt>
                <c:pt idx="406">
                  <c:v>0.83943983995427263</c:v>
                </c:pt>
                <c:pt idx="407">
                  <c:v>0.814575593026579</c:v>
                </c:pt>
                <c:pt idx="408">
                  <c:v>0.8333238068019434</c:v>
                </c:pt>
                <c:pt idx="409">
                  <c:v>0.80234352672192055</c:v>
                </c:pt>
                <c:pt idx="410">
                  <c:v>0.81388968276650475</c:v>
                </c:pt>
                <c:pt idx="411">
                  <c:v>0.81954844241211777</c:v>
                </c:pt>
                <c:pt idx="412">
                  <c:v>0.83383823949699909</c:v>
                </c:pt>
                <c:pt idx="413">
                  <c:v>0.81406116033152331</c:v>
                </c:pt>
                <c:pt idx="414">
                  <c:v>0.82937982280651612</c:v>
                </c:pt>
                <c:pt idx="415">
                  <c:v>0.83178050871677622</c:v>
                </c:pt>
                <c:pt idx="416">
                  <c:v>0.82257787939411264</c:v>
                </c:pt>
                <c:pt idx="417">
                  <c:v>0.80445841669048301</c:v>
                </c:pt>
                <c:pt idx="418">
                  <c:v>0.82503572449271223</c:v>
                </c:pt>
                <c:pt idx="419">
                  <c:v>0.81303229494141183</c:v>
                </c:pt>
                <c:pt idx="420">
                  <c:v>0.82377822234924269</c:v>
                </c:pt>
                <c:pt idx="421">
                  <c:v>0.81543298085167193</c:v>
                </c:pt>
                <c:pt idx="422">
                  <c:v>0.80171477565018578</c:v>
                </c:pt>
                <c:pt idx="423">
                  <c:v>0.82206344669905684</c:v>
                </c:pt>
                <c:pt idx="424">
                  <c:v>0.81880537296370393</c:v>
                </c:pt>
                <c:pt idx="425">
                  <c:v>0.80508716776221778</c:v>
                </c:pt>
                <c:pt idx="426">
                  <c:v>0.82297799371248925</c:v>
                </c:pt>
                <c:pt idx="427">
                  <c:v>0.80045727350671625</c:v>
                </c:pt>
                <c:pt idx="428">
                  <c:v>0.81806230351529008</c:v>
                </c:pt>
                <c:pt idx="429">
                  <c:v>0.79399828522434979</c:v>
                </c:pt>
                <c:pt idx="430">
                  <c:v>0.82440697342097746</c:v>
                </c:pt>
                <c:pt idx="431">
                  <c:v>0.78016576164618467</c:v>
                </c:pt>
                <c:pt idx="432">
                  <c:v>0.8275507287796513</c:v>
                </c:pt>
                <c:pt idx="433">
                  <c:v>0.78136610460131461</c:v>
                </c:pt>
                <c:pt idx="434">
                  <c:v>0.8174907116318948</c:v>
                </c:pt>
                <c:pt idx="435">
                  <c:v>0.79399828522434979</c:v>
                </c:pt>
                <c:pt idx="436">
                  <c:v>0.81097456416118896</c:v>
                </c:pt>
                <c:pt idx="437">
                  <c:v>0.80125750214346958</c:v>
                </c:pt>
                <c:pt idx="438">
                  <c:v>0.81914832809374105</c:v>
                </c:pt>
                <c:pt idx="439">
                  <c:v>0.79319805658759646</c:v>
                </c:pt>
                <c:pt idx="440">
                  <c:v>0.82440697342097746</c:v>
                </c:pt>
                <c:pt idx="441">
                  <c:v>0.79182623606744784</c:v>
                </c:pt>
                <c:pt idx="442">
                  <c:v>0.81474707059159757</c:v>
                </c:pt>
                <c:pt idx="443">
                  <c:v>0.80080022863675338</c:v>
                </c:pt>
                <c:pt idx="444">
                  <c:v>0.80331523292369245</c:v>
                </c:pt>
                <c:pt idx="445">
                  <c:v>0.79559874249785656</c:v>
                </c:pt>
                <c:pt idx="446">
                  <c:v>0.79371248928265214</c:v>
                </c:pt>
                <c:pt idx="447">
                  <c:v>0.7987424978565304</c:v>
                </c:pt>
                <c:pt idx="448">
                  <c:v>0.78993998285224354</c:v>
                </c:pt>
                <c:pt idx="449">
                  <c:v>0.83012289225492997</c:v>
                </c:pt>
                <c:pt idx="450">
                  <c:v>0.78159474135467277</c:v>
                </c:pt>
                <c:pt idx="451">
                  <c:v>0.78839668476707636</c:v>
                </c:pt>
                <c:pt idx="452">
                  <c:v>0.80371534724206917</c:v>
                </c:pt>
                <c:pt idx="453">
                  <c:v>0.79034009717062015</c:v>
                </c:pt>
                <c:pt idx="454">
                  <c:v>0.818919691340383</c:v>
                </c:pt>
                <c:pt idx="455">
                  <c:v>0.8107459274078308</c:v>
                </c:pt>
                <c:pt idx="456">
                  <c:v>0.80131466133180906</c:v>
                </c:pt>
                <c:pt idx="457">
                  <c:v>0.81057444984281224</c:v>
                </c:pt>
                <c:pt idx="458">
                  <c:v>0.7891397542154901</c:v>
                </c:pt>
                <c:pt idx="459">
                  <c:v>0.80725921691911973</c:v>
                </c:pt>
                <c:pt idx="460">
                  <c:v>0.80537296370391542</c:v>
                </c:pt>
                <c:pt idx="461">
                  <c:v>0.82623606744784228</c:v>
                </c:pt>
                <c:pt idx="462">
                  <c:v>0.78993998285224354</c:v>
                </c:pt>
                <c:pt idx="463">
                  <c:v>0.80411546156044589</c:v>
                </c:pt>
                <c:pt idx="464">
                  <c:v>0.80520148613889686</c:v>
                </c:pt>
                <c:pt idx="465">
                  <c:v>0.80165761646184619</c:v>
                </c:pt>
                <c:pt idx="466">
                  <c:v>0.82480708773935407</c:v>
                </c:pt>
                <c:pt idx="467">
                  <c:v>0.82366390397256362</c:v>
                </c:pt>
                <c:pt idx="468">
                  <c:v>0.81337525007144895</c:v>
                </c:pt>
                <c:pt idx="469">
                  <c:v>0.77925121463275226</c:v>
                </c:pt>
                <c:pt idx="470">
                  <c:v>0.80994569877107747</c:v>
                </c:pt>
                <c:pt idx="471">
                  <c:v>0.80794512717919409</c:v>
                </c:pt>
                <c:pt idx="472">
                  <c:v>0.79256930551586169</c:v>
                </c:pt>
                <c:pt idx="473">
                  <c:v>0.79531294655615892</c:v>
                </c:pt>
                <c:pt idx="474">
                  <c:v>0.79194055444412692</c:v>
                </c:pt>
                <c:pt idx="475">
                  <c:v>0.79062589311231779</c:v>
                </c:pt>
                <c:pt idx="476">
                  <c:v>0.80337239211203204</c:v>
                </c:pt>
                <c:pt idx="477">
                  <c:v>0.78656759074021154</c:v>
                </c:pt>
                <c:pt idx="478">
                  <c:v>0.78393826807659328</c:v>
                </c:pt>
                <c:pt idx="479">
                  <c:v>0.78833952557873677</c:v>
                </c:pt>
                <c:pt idx="480">
                  <c:v>0.80731637610745932</c:v>
                </c:pt>
                <c:pt idx="481">
                  <c:v>0.7824521291797657</c:v>
                </c:pt>
                <c:pt idx="482">
                  <c:v>0.7819376964847099</c:v>
                </c:pt>
                <c:pt idx="483">
                  <c:v>0.79645613032294937</c:v>
                </c:pt>
                <c:pt idx="484">
                  <c:v>0.80182909402686486</c:v>
                </c:pt>
                <c:pt idx="485">
                  <c:v>0.80285795941697624</c:v>
                </c:pt>
                <c:pt idx="486">
                  <c:v>0.77650757359245504</c:v>
                </c:pt>
                <c:pt idx="487">
                  <c:v>0.78285224349814231</c:v>
                </c:pt>
                <c:pt idx="488">
                  <c:v>0.79148328093741072</c:v>
                </c:pt>
                <c:pt idx="489">
                  <c:v>0.78742497856530436</c:v>
                </c:pt>
                <c:pt idx="490">
                  <c:v>0.77016290368676765</c:v>
                </c:pt>
                <c:pt idx="491">
                  <c:v>0.78976850528722498</c:v>
                </c:pt>
                <c:pt idx="492">
                  <c:v>0.77022006287510714</c:v>
                </c:pt>
                <c:pt idx="493">
                  <c:v>0.79817090597313523</c:v>
                </c:pt>
                <c:pt idx="494">
                  <c:v>0.78165190054301226</c:v>
                </c:pt>
                <c:pt idx="495">
                  <c:v>0.80474421263218066</c:v>
                </c:pt>
                <c:pt idx="496">
                  <c:v>0.79376964847099174</c:v>
                </c:pt>
                <c:pt idx="497">
                  <c:v>0.77799371248928262</c:v>
                </c:pt>
                <c:pt idx="498">
                  <c:v>0.80800228636753357</c:v>
                </c:pt>
                <c:pt idx="499">
                  <c:v>0.76118891111746212</c:v>
                </c:pt>
                <c:pt idx="500">
                  <c:v>0.79479851386110312</c:v>
                </c:pt>
                <c:pt idx="501">
                  <c:v>0.7949128322377822</c:v>
                </c:pt>
                <c:pt idx="502">
                  <c:v>0.76781937696484714</c:v>
                </c:pt>
                <c:pt idx="503">
                  <c:v>0.7891397542154901</c:v>
                </c:pt>
                <c:pt idx="504">
                  <c:v>0.78536724778508149</c:v>
                </c:pt>
                <c:pt idx="505">
                  <c:v>0.78696770505858815</c:v>
                </c:pt>
                <c:pt idx="506">
                  <c:v>0.78811088882537872</c:v>
                </c:pt>
                <c:pt idx="507">
                  <c:v>0.7742783652472135</c:v>
                </c:pt>
                <c:pt idx="508">
                  <c:v>0.77885110031437554</c:v>
                </c:pt>
                <c:pt idx="509">
                  <c:v>0.78399542726493288</c:v>
                </c:pt>
                <c:pt idx="510">
                  <c:v>0.77925121463275226</c:v>
                </c:pt>
                <c:pt idx="511">
                  <c:v>0.77067733638182334</c:v>
                </c:pt>
                <c:pt idx="512">
                  <c:v>0.79725635895970282</c:v>
                </c:pt>
                <c:pt idx="513">
                  <c:v>0.79039725635895974</c:v>
                </c:pt>
                <c:pt idx="514">
                  <c:v>0.78142326378965421</c:v>
                </c:pt>
                <c:pt idx="515">
                  <c:v>0.77387825092883678</c:v>
                </c:pt>
                <c:pt idx="516">
                  <c:v>0.77696484709917124</c:v>
                </c:pt>
                <c:pt idx="517">
                  <c:v>0.76604744212632181</c:v>
                </c:pt>
                <c:pt idx="518">
                  <c:v>0.77610745927407832</c:v>
                </c:pt>
                <c:pt idx="519">
                  <c:v>0.7819376964847099</c:v>
                </c:pt>
                <c:pt idx="520">
                  <c:v>0.77319234066876252</c:v>
                </c:pt>
                <c:pt idx="521">
                  <c:v>0.78428122320663052</c:v>
                </c:pt>
                <c:pt idx="522">
                  <c:v>0.76741926264647042</c:v>
                </c:pt>
                <c:pt idx="523">
                  <c:v>0.79125464418405256</c:v>
                </c:pt>
                <c:pt idx="524">
                  <c:v>0.79382680765933122</c:v>
                </c:pt>
                <c:pt idx="525">
                  <c:v>0.77096313232352098</c:v>
                </c:pt>
                <c:pt idx="526">
                  <c:v>0.75735924549871392</c:v>
                </c:pt>
                <c:pt idx="527">
                  <c:v>0.78353815375821667</c:v>
                </c:pt>
                <c:pt idx="528">
                  <c:v>0.77610745927407832</c:v>
                </c:pt>
                <c:pt idx="529">
                  <c:v>0.77696484709917124</c:v>
                </c:pt>
                <c:pt idx="530">
                  <c:v>0.76999142612174909</c:v>
                </c:pt>
                <c:pt idx="531">
                  <c:v>0.76393255215775935</c:v>
                </c:pt>
                <c:pt idx="532">
                  <c:v>0.78948270934552733</c:v>
                </c:pt>
                <c:pt idx="533">
                  <c:v>0.80017147756501861</c:v>
                </c:pt>
                <c:pt idx="534">
                  <c:v>0.78691054587024867</c:v>
                </c:pt>
                <c:pt idx="535">
                  <c:v>0.78393826807659328</c:v>
                </c:pt>
                <c:pt idx="536">
                  <c:v>0.7612460703058016</c:v>
                </c:pt>
                <c:pt idx="537">
                  <c:v>0.77976564732780795</c:v>
                </c:pt>
                <c:pt idx="538">
                  <c:v>0.76444698485281504</c:v>
                </c:pt>
                <c:pt idx="539">
                  <c:v>0.76347527865104314</c:v>
                </c:pt>
                <c:pt idx="540">
                  <c:v>0.78325235781651903</c:v>
                </c:pt>
                <c:pt idx="541">
                  <c:v>0.76524721348956848</c:v>
                </c:pt>
                <c:pt idx="542">
                  <c:v>0.77690768791083165</c:v>
                </c:pt>
                <c:pt idx="543">
                  <c:v>0.78633895398685338</c:v>
                </c:pt>
                <c:pt idx="544">
                  <c:v>0.7727922263503858</c:v>
                </c:pt>
                <c:pt idx="545">
                  <c:v>0.78536724778508149</c:v>
                </c:pt>
                <c:pt idx="546">
                  <c:v>0.76478993998285227</c:v>
                </c:pt>
                <c:pt idx="547">
                  <c:v>0.77490711631894826</c:v>
                </c:pt>
                <c:pt idx="548">
                  <c:v>0.77976564732780795</c:v>
                </c:pt>
                <c:pt idx="549">
                  <c:v>0.75850242926550449</c:v>
                </c:pt>
                <c:pt idx="550">
                  <c:v>0.78159474135467277</c:v>
                </c:pt>
                <c:pt idx="551">
                  <c:v>0.76861960560160048</c:v>
                </c:pt>
                <c:pt idx="552">
                  <c:v>0.75724492712203484</c:v>
                </c:pt>
                <c:pt idx="553">
                  <c:v>0.77936553300943123</c:v>
                </c:pt>
                <c:pt idx="554">
                  <c:v>0.77107745070020006</c:v>
                </c:pt>
                <c:pt idx="555">
                  <c:v>0.79159759931408979</c:v>
                </c:pt>
                <c:pt idx="556">
                  <c:v>0.76158902543583884</c:v>
                </c:pt>
                <c:pt idx="557">
                  <c:v>0.78856816233209492</c:v>
                </c:pt>
                <c:pt idx="558">
                  <c:v>0.76501857673621032</c:v>
                </c:pt>
                <c:pt idx="559">
                  <c:v>0.76336096027436406</c:v>
                </c:pt>
                <c:pt idx="560">
                  <c:v>0.77862246356101739</c:v>
                </c:pt>
                <c:pt idx="561">
                  <c:v>0.75947413546727638</c:v>
                </c:pt>
                <c:pt idx="562">
                  <c:v>0.77073449557016294</c:v>
                </c:pt>
                <c:pt idx="563">
                  <c:v>0.75953129465561586</c:v>
                </c:pt>
                <c:pt idx="564">
                  <c:v>0.7593598170905973</c:v>
                </c:pt>
                <c:pt idx="565">
                  <c:v>0.74266933409545588</c:v>
                </c:pt>
                <c:pt idx="566">
                  <c:v>0.75450128608173761</c:v>
                </c:pt>
                <c:pt idx="567">
                  <c:v>0.74661331809088316</c:v>
                </c:pt>
                <c:pt idx="568">
                  <c:v>0.77290654472706488</c:v>
                </c:pt>
                <c:pt idx="569">
                  <c:v>0.76021720491569023</c:v>
                </c:pt>
                <c:pt idx="570">
                  <c:v>0.76981994855673053</c:v>
                </c:pt>
                <c:pt idx="571">
                  <c:v>0.72843669619891394</c:v>
                </c:pt>
                <c:pt idx="572">
                  <c:v>0.74341240354386973</c:v>
                </c:pt>
                <c:pt idx="573">
                  <c:v>0.77925121463275226</c:v>
                </c:pt>
                <c:pt idx="574">
                  <c:v>0.74895684481280367</c:v>
                </c:pt>
                <c:pt idx="575">
                  <c:v>0.74547013432409259</c:v>
                </c:pt>
                <c:pt idx="576">
                  <c:v>0.75998856816233207</c:v>
                </c:pt>
                <c:pt idx="577">
                  <c:v>0.77222063446699052</c:v>
                </c:pt>
                <c:pt idx="578">
                  <c:v>0.73615318662474993</c:v>
                </c:pt>
                <c:pt idx="579">
                  <c:v>0.75787367819376961</c:v>
                </c:pt>
                <c:pt idx="580">
                  <c:v>0.7406116033152329</c:v>
                </c:pt>
                <c:pt idx="581">
                  <c:v>0.75644469848528151</c:v>
                </c:pt>
                <c:pt idx="582">
                  <c:v>0.74564161188911116</c:v>
                </c:pt>
                <c:pt idx="583">
                  <c:v>0.76387539296941986</c:v>
                </c:pt>
                <c:pt idx="584">
                  <c:v>0.71906258931123179</c:v>
                </c:pt>
                <c:pt idx="585">
                  <c:v>0.74169762789368388</c:v>
                </c:pt>
                <c:pt idx="586">
                  <c:v>0.74695627322092029</c:v>
                </c:pt>
                <c:pt idx="587">
                  <c:v>0.76221777650757361</c:v>
                </c:pt>
                <c:pt idx="588">
                  <c:v>0.76341811946270366</c:v>
                </c:pt>
                <c:pt idx="589">
                  <c:v>0.76690482995141473</c:v>
                </c:pt>
                <c:pt idx="590">
                  <c:v>0.74381251786224634</c:v>
                </c:pt>
                <c:pt idx="591">
                  <c:v>0.75112889396970561</c:v>
                </c:pt>
                <c:pt idx="592">
                  <c:v>0.73649614175478706</c:v>
                </c:pt>
                <c:pt idx="593">
                  <c:v>0.74672763646756213</c:v>
                </c:pt>
                <c:pt idx="594">
                  <c:v>0.73969705630180049</c:v>
                </c:pt>
                <c:pt idx="595">
                  <c:v>0.74489854244069731</c:v>
                </c:pt>
                <c:pt idx="596">
                  <c:v>0.73758216633323803</c:v>
                </c:pt>
                <c:pt idx="597">
                  <c:v>0.73329522720777363</c:v>
                </c:pt>
                <c:pt idx="598">
                  <c:v>0.73592454987139178</c:v>
                </c:pt>
                <c:pt idx="599">
                  <c:v>0.76107459274078304</c:v>
                </c:pt>
                <c:pt idx="600">
                  <c:v>0.74718490997427833</c:v>
                </c:pt>
                <c:pt idx="601">
                  <c:v>0.74809945698771074</c:v>
                </c:pt>
                <c:pt idx="602">
                  <c:v>0.73581023149471281</c:v>
                </c:pt>
                <c:pt idx="603">
                  <c:v>0.750728779651329</c:v>
                </c:pt>
                <c:pt idx="604">
                  <c:v>0.75221491854815659</c:v>
                </c:pt>
                <c:pt idx="605">
                  <c:v>0.75084309802800797</c:v>
                </c:pt>
                <c:pt idx="606">
                  <c:v>0.77216347527865103</c:v>
                </c:pt>
                <c:pt idx="607">
                  <c:v>0.73175192912260645</c:v>
                </c:pt>
                <c:pt idx="608">
                  <c:v>0.74998571020291516</c:v>
                </c:pt>
                <c:pt idx="609">
                  <c:v>0.75404401257502141</c:v>
                </c:pt>
                <c:pt idx="610">
                  <c:v>0.73609602743641045</c:v>
                </c:pt>
                <c:pt idx="611">
                  <c:v>0.73215204344098317</c:v>
                </c:pt>
                <c:pt idx="612">
                  <c:v>0.72929408402400686</c:v>
                </c:pt>
                <c:pt idx="613">
                  <c:v>0.72820805944555589</c:v>
                </c:pt>
                <c:pt idx="614">
                  <c:v>0.7598170905973135</c:v>
                </c:pt>
                <c:pt idx="615">
                  <c:v>0.72323521006001712</c:v>
                </c:pt>
                <c:pt idx="616">
                  <c:v>0.72266361817662195</c:v>
                </c:pt>
                <c:pt idx="617">
                  <c:v>0.73158045155758789</c:v>
                </c:pt>
                <c:pt idx="618">
                  <c:v>0.74221206058873967</c:v>
                </c:pt>
                <c:pt idx="619">
                  <c:v>0.74198342383538152</c:v>
                </c:pt>
                <c:pt idx="620">
                  <c:v>0.73472420691626183</c:v>
                </c:pt>
                <c:pt idx="621">
                  <c:v>0.74044012575021434</c:v>
                </c:pt>
                <c:pt idx="622">
                  <c:v>0.74426979136896254</c:v>
                </c:pt>
                <c:pt idx="623">
                  <c:v>0.73398113746784799</c:v>
                </c:pt>
                <c:pt idx="624">
                  <c:v>0.74004001143183762</c:v>
                </c:pt>
                <c:pt idx="625">
                  <c:v>0.74507002000571587</c:v>
                </c:pt>
                <c:pt idx="626">
                  <c:v>0.7247785081451843</c:v>
                </c:pt>
                <c:pt idx="627">
                  <c:v>0.74084024006859106</c:v>
                </c:pt>
                <c:pt idx="628">
                  <c:v>0.71723349528436697</c:v>
                </c:pt>
                <c:pt idx="629">
                  <c:v>0.72409259788511005</c:v>
                </c:pt>
                <c:pt idx="630">
                  <c:v>0.72609316947699343</c:v>
                </c:pt>
                <c:pt idx="631">
                  <c:v>0.71134609888539579</c:v>
                </c:pt>
                <c:pt idx="632">
                  <c:v>0.71734781366104605</c:v>
                </c:pt>
                <c:pt idx="633">
                  <c:v>0.74141183195198623</c:v>
                </c:pt>
                <c:pt idx="634">
                  <c:v>0.71203200914547016</c:v>
                </c:pt>
                <c:pt idx="635">
                  <c:v>0.72489282652186338</c:v>
                </c:pt>
                <c:pt idx="636">
                  <c:v>0.72243498142326379</c:v>
                </c:pt>
                <c:pt idx="637">
                  <c:v>0.71454701343240923</c:v>
                </c:pt>
                <c:pt idx="638">
                  <c:v>0.72643612460703055</c:v>
                </c:pt>
                <c:pt idx="639">
                  <c:v>0.70442983709631324</c:v>
                </c:pt>
                <c:pt idx="640">
                  <c:v>0.72723635324378388</c:v>
                </c:pt>
                <c:pt idx="641">
                  <c:v>0.72649328379537015</c:v>
                </c:pt>
                <c:pt idx="642">
                  <c:v>0.71454701343240923</c:v>
                </c:pt>
                <c:pt idx="643">
                  <c:v>0.71071734781366103</c:v>
                </c:pt>
                <c:pt idx="644">
                  <c:v>0.70037153472420688</c:v>
                </c:pt>
                <c:pt idx="645">
                  <c:v>0.73009431266076019</c:v>
                </c:pt>
                <c:pt idx="646">
                  <c:v>0.73701057444984286</c:v>
                </c:pt>
                <c:pt idx="647">
                  <c:v>0.71791940554444122</c:v>
                </c:pt>
                <c:pt idx="648">
                  <c:v>0.71340382966561877</c:v>
                </c:pt>
                <c:pt idx="649">
                  <c:v>0.71677622177765077</c:v>
                </c:pt>
                <c:pt idx="650">
                  <c:v>0.72940840240068594</c:v>
                </c:pt>
                <c:pt idx="651">
                  <c:v>0.70568733923978277</c:v>
                </c:pt>
                <c:pt idx="652">
                  <c:v>0.7276364675621606</c:v>
                </c:pt>
                <c:pt idx="653">
                  <c:v>0.69951414689911406</c:v>
                </c:pt>
                <c:pt idx="654">
                  <c:v>0.71014575593026574</c:v>
                </c:pt>
                <c:pt idx="655">
                  <c:v>0.72432123463846809</c:v>
                </c:pt>
                <c:pt idx="656">
                  <c:v>0.71408973992569302</c:v>
                </c:pt>
                <c:pt idx="657">
                  <c:v>0.71031723349528442</c:v>
                </c:pt>
                <c:pt idx="658">
                  <c:v>0.70385824521291795</c:v>
                </c:pt>
                <c:pt idx="659">
                  <c:v>0.71026007430694482</c:v>
                </c:pt>
                <c:pt idx="660">
                  <c:v>0.71048871106030298</c:v>
                </c:pt>
                <c:pt idx="661">
                  <c:v>0.72580737353529579</c:v>
                </c:pt>
                <c:pt idx="662">
                  <c:v>0.71986281794798512</c:v>
                </c:pt>
                <c:pt idx="663">
                  <c:v>0.71849099742783651</c:v>
                </c:pt>
                <c:pt idx="664">
                  <c:v>0.71151757645041436</c:v>
                </c:pt>
                <c:pt idx="665">
                  <c:v>0.71174621320377252</c:v>
                </c:pt>
                <c:pt idx="666">
                  <c:v>0.70431551871963416</c:v>
                </c:pt>
                <c:pt idx="667">
                  <c:v>0.70248642469276934</c:v>
                </c:pt>
                <c:pt idx="668">
                  <c:v>0.72277793655330091</c:v>
                </c:pt>
                <c:pt idx="669">
                  <c:v>0.70968848242354954</c:v>
                </c:pt>
                <c:pt idx="670">
                  <c:v>0.72403543869677056</c:v>
                </c:pt>
                <c:pt idx="671">
                  <c:v>0.70540154329808513</c:v>
                </c:pt>
                <c:pt idx="672">
                  <c:v>0.7156901971991998</c:v>
                </c:pt>
                <c:pt idx="673">
                  <c:v>0.72254929979994287</c:v>
                </c:pt>
                <c:pt idx="674">
                  <c:v>0.70625893112317806</c:v>
                </c:pt>
                <c:pt idx="675">
                  <c:v>0.70745927407830811</c:v>
                </c:pt>
                <c:pt idx="676">
                  <c:v>0.7070020005715919</c:v>
                </c:pt>
                <c:pt idx="677">
                  <c:v>0.70065733066590452</c:v>
                </c:pt>
                <c:pt idx="678">
                  <c:v>0.70282937982280647</c:v>
                </c:pt>
                <c:pt idx="679">
                  <c:v>0.70980280080022862</c:v>
                </c:pt>
                <c:pt idx="680">
                  <c:v>0.70214346956273221</c:v>
                </c:pt>
                <c:pt idx="681">
                  <c:v>0.71403258073735354</c:v>
                </c:pt>
                <c:pt idx="682">
                  <c:v>0.712775078593884</c:v>
                </c:pt>
                <c:pt idx="683">
                  <c:v>0.70774507002000575</c:v>
                </c:pt>
                <c:pt idx="684">
                  <c:v>0.68596741926264648</c:v>
                </c:pt>
                <c:pt idx="685">
                  <c:v>0.67990854529865674</c:v>
                </c:pt>
                <c:pt idx="686">
                  <c:v>0.69071163189482709</c:v>
                </c:pt>
                <c:pt idx="687">
                  <c:v>0.71300371534724205</c:v>
                </c:pt>
                <c:pt idx="688">
                  <c:v>0.67779365533009428</c:v>
                </c:pt>
                <c:pt idx="689">
                  <c:v>0.71923406687625036</c:v>
                </c:pt>
                <c:pt idx="690">
                  <c:v>0.70923120891683333</c:v>
                </c:pt>
                <c:pt idx="691">
                  <c:v>0.70334381251786227</c:v>
                </c:pt>
                <c:pt idx="692">
                  <c:v>0.7027150614461275</c:v>
                </c:pt>
                <c:pt idx="693">
                  <c:v>0.71208916833380964</c:v>
                </c:pt>
                <c:pt idx="694">
                  <c:v>0.6800800228636753</c:v>
                </c:pt>
                <c:pt idx="695">
                  <c:v>0.68682480708773941</c:v>
                </c:pt>
                <c:pt idx="696">
                  <c:v>0.69728493855387252</c:v>
                </c:pt>
                <c:pt idx="697">
                  <c:v>0.71174621320377252</c:v>
                </c:pt>
                <c:pt idx="698">
                  <c:v>0.68025150042869387</c:v>
                </c:pt>
                <c:pt idx="699">
                  <c:v>0.70145755930265785</c:v>
                </c:pt>
                <c:pt idx="700">
                  <c:v>0.69534152615032863</c:v>
                </c:pt>
                <c:pt idx="701">
                  <c:v>0.69534152615032863</c:v>
                </c:pt>
                <c:pt idx="702">
                  <c:v>0.6863675335810232</c:v>
                </c:pt>
                <c:pt idx="703">
                  <c:v>0.6968848242354958</c:v>
                </c:pt>
                <c:pt idx="704">
                  <c:v>0.69494141183195202</c:v>
                </c:pt>
                <c:pt idx="705">
                  <c:v>0.69551300371534719</c:v>
                </c:pt>
                <c:pt idx="706">
                  <c:v>0.67602172049156906</c:v>
                </c:pt>
                <c:pt idx="707">
                  <c:v>0.68442412117747931</c:v>
                </c:pt>
                <c:pt idx="708">
                  <c:v>0.70454415547299232</c:v>
                </c:pt>
                <c:pt idx="709">
                  <c:v>0.69094026864818514</c:v>
                </c:pt>
                <c:pt idx="710">
                  <c:v>0.69065447270648761</c:v>
                </c:pt>
                <c:pt idx="711">
                  <c:v>0.68116604744212628</c:v>
                </c:pt>
                <c:pt idx="712">
                  <c:v>0.70002857959416975</c:v>
                </c:pt>
                <c:pt idx="713">
                  <c:v>0.67750785938839664</c:v>
                </c:pt>
                <c:pt idx="714">
                  <c:v>0.68122320663046587</c:v>
                </c:pt>
                <c:pt idx="715">
                  <c:v>0.68362389254072597</c:v>
                </c:pt>
                <c:pt idx="716">
                  <c:v>0.68190911689054012</c:v>
                </c:pt>
                <c:pt idx="717">
                  <c:v>0.7060302943698199</c:v>
                </c:pt>
                <c:pt idx="718">
                  <c:v>0.69802800800228637</c:v>
                </c:pt>
                <c:pt idx="719">
                  <c:v>0.68511003143755356</c:v>
                </c:pt>
                <c:pt idx="720">
                  <c:v>0.67350671620462987</c:v>
                </c:pt>
                <c:pt idx="721">
                  <c:v>0.68030865961703346</c:v>
                </c:pt>
                <c:pt idx="722">
                  <c:v>0.70545870248642473</c:v>
                </c:pt>
                <c:pt idx="723">
                  <c:v>0.65144326950557307</c:v>
                </c:pt>
                <c:pt idx="724">
                  <c:v>0.6993426693340955</c:v>
                </c:pt>
                <c:pt idx="725">
                  <c:v>0.67756501857673623</c:v>
                </c:pt>
                <c:pt idx="726">
                  <c:v>0.68265218633895397</c:v>
                </c:pt>
                <c:pt idx="727">
                  <c:v>0.68568162332094884</c:v>
                </c:pt>
                <c:pt idx="728">
                  <c:v>0.68122320663046587</c:v>
                </c:pt>
                <c:pt idx="729">
                  <c:v>0.66853386681909122</c:v>
                </c:pt>
                <c:pt idx="730">
                  <c:v>0.67213489568448126</c:v>
                </c:pt>
                <c:pt idx="731">
                  <c:v>0.70717347813661047</c:v>
                </c:pt>
                <c:pt idx="732">
                  <c:v>0.66899114032580742</c:v>
                </c:pt>
                <c:pt idx="733">
                  <c:v>0.69448413832523581</c:v>
                </c:pt>
                <c:pt idx="734">
                  <c:v>0.67716490425835951</c:v>
                </c:pt>
                <c:pt idx="735">
                  <c:v>0.67727922263503859</c:v>
                </c:pt>
                <c:pt idx="736">
                  <c:v>0.68293798228065161</c:v>
                </c:pt>
                <c:pt idx="737">
                  <c:v>0.6575593026579023</c:v>
                </c:pt>
                <c:pt idx="738">
                  <c:v>0.68408116604744218</c:v>
                </c:pt>
                <c:pt idx="739">
                  <c:v>0.66407545012860814</c:v>
                </c:pt>
                <c:pt idx="740">
                  <c:v>0.68505287224921407</c:v>
                </c:pt>
                <c:pt idx="741">
                  <c:v>0.66110317233495286</c:v>
                </c:pt>
                <c:pt idx="742">
                  <c:v>0.6801371820520149</c:v>
                </c:pt>
                <c:pt idx="743">
                  <c:v>0.68499571306087459</c:v>
                </c:pt>
                <c:pt idx="744">
                  <c:v>0.6858531008859674</c:v>
                </c:pt>
                <c:pt idx="745">
                  <c:v>0.66921977707916547</c:v>
                </c:pt>
                <c:pt idx="746">
                  <c:v>0.66110317233495286</c:v>
                </c:pt>
                <c:pt idx="747">
                  <c:v>0.66527579308373819</c:v>
                </c:pt>
                <c:pt idx="748">
                  <c:v>0.67127750785938844</c:v>
                </c:pt>
                <c:pt idx="749">
                  <c:v>0.67887967990854525</c:v>
                </c:pt>
                <c:pt idx="750">
                  <c:v>0.65435838811088887</c:v>
                </c:pt>
                <c:pt idx="751">
                  <c:v>0.67402114889968567</c:v>
                </c:pt>
                <c:pt idx="752">
                  <c:v>0.66127464989997142</c:v>
                </c:pt>
                <c:pt idx="753">
                  <c:v>0.67802229208345244</c:v>
                </c:pt>
                <c:pt idx="754">
                  <c:v>0.67459274078308085</c:v>
                </c:pt>
                <c:pt idx="755">
                  <c:v>0.67322092026293223</c:v>
                </c:pt>
                <c:pt idx="756">
                  <c:v>0.69991426121749067</c:v>
                </c:pt>
                <c:pt idx="757">
                  <c:v>0.65687339239782794</c:v>
                </c:pt>
                <c:pt idx="758">
                  <c:v>0.6968848242354958</c:v>
                </c:pt>
                <c:pt idx="759">
                  <c:v>0.67950843098028013</c:v>
                </c:pt>
                <c:pt idx="760">
                  <c:v>0.65653043726779081</c:v>
                </c:pt>
                <c:pt idx="761">
                  <c:v>0.67213489568448126</c:v>
                </c:pt>
                <c:pt idx="762">
                  <c:v>0.66430408688196629</c:v>
                </c:pt>
                <c:pt idx="763">
                  <c:v>0.66881966276078875</c:v>
                </c:pt>
                <c:pt idx="764">
                  <c:v>0.6647613603886825</c:v>
                </c:pt>
                <c:pt idx="765">
                  <c:v>0.68168048013718208</c:v>
                </c:pt>
                <c:pt idx="766">
                  <c:v>0.68882537867962279</c:v>
                </c:pt>
                <c:pt idx="767">
                  <c:v>0.67396398971134608</c:v>
                </c:pt>
                <c:pt idx="768">
                  <c:v>0.67602172049156906</c:v>
                </c:pt>
                <c:pt idx="769">
                  <c:v>0.66156044584166906</c:v>
                </c:pt>
                <c:pt idx="770">
                  <c:v>0.67830808802515008</c:v>
                </c:pt>
                <c:pt idx="771">
                  <c:v>0.65950271506144609</c:v>
                </c:pt>
                <c:pt idx="772">
                  <c:v>0.65567304944269789</c:v>
                </c:pt>
                <c:pt idx="773">
                  <c:v>0.67213489568448126</c:v>
                </c:pt>
                <c:pt idx="774">
                  <c:v>0.6609316947699343</c:v>
                </c:pt>
                <c:pt idx="775">
                  <c:v>0.66504715633038014</c:v>
                </c:pt>
                <c:pt idx="776">
                  <c:v>0.65687339239782794</c:v>
                </c:pt>
                <c:pt idx="777">
                  <c:v>0.68642469276936269</c:v>
                </c:pt>
                <c:pt idx="778">
                  <c:v>0.69082595027150617</c:v>
                </c:pt>
                <c:pt idx="779">
                  <c:v>0.66636181766218916</c:v>
                </c:pt>
                <c:pt idx="780">
                  <c:v>0.63623892540725924</c:v>
                </c:pt>
                <c:pt idx="781">
                  <c:v>0.681566161760503</c:v>
                </c:pt>
                <c:pt idx="782">
                  <c:v>0.66539011146041727</c:v>
                </c:pt>
                <c:pt idx="783">
                  <c:v>0.67585024292655049</c:v>
                </c:pt>
                <c:pt idx="784">
                  <c:v>0.65841669048299512</c:v>
                </c:pt>
                <c:pt idx="785">
                  <c:v>0.65361531866247502</c:v>
                </c:pt>
                <c:pt idx="786">
                  <c:v>0.67230637324949982</c:v>
                </c:pt>
                <c:pt idx="787">
                  <c:v>0.67613603886824802</c:v>
                </c:pt>
                <c:pt idx="788">
                  <c:v>0.65904544155472988</c:v>
                </c:pt>
                <c:pt idx="789">
                  <c:v>0.66699056873392393</c:v>
                </c:pt>
                <c:pt idx="790">
                  <c:v>0.67093455272935121</c:v>
                </c:pt>
                <c:pt idx="791">
                  <c:v>0.64098313803943985</c:v>
                </c:pt>
                <c:pt idx="792">
                  <c:v>0.65075735924549871</c:v>
                </c:pt>
                <c:pt idx="793">
                  <c:v>0.64664189768505287</c:v>
                </c:pt>
                <c:pt idx="794">
                  <c:v>0.63915404401257503</c:v>
                </c:pt>
                <c:pt idx="795">
                  <c:v>0.65172906544727061</c:v>
                </c:pt>
                <c:pt idx="796">
                  <c:v>0.66453272363532434</c:v>
                </c:pt>
                <c:pt idx="797">
                  <c:v>0.66413260931694773</c:v>
                </c:pt>
                <c:pt idx="798">
                  <c:v>0.65315804515575882</c:v>
                </c:pt>
                <c:pt idx="799">
                  <c:v>0.64441268933981133</c:v>
                </c:pt>
                <c:pt idx="800">
                  <c:v>0.63966847670763072</c:v>
                </c:pt>
                <c:pt idx="801">
                  <c:v>0.65247213489568445</c:v>
                </c:pt>
                <c:pt idx="802">
                  <c:v>0.63612460703058016</c:v>
                </c:pt>
                <c:pt idx="803">
                  <c:v>0.65984567019148332</c:v>
                </c:pt>
                <c:pt idx="804">
                  <c:v>0.66230351529008291</c:v>
                </c:pt>
                <c:pt idx="805">
                  <c:v>0.65607316376107461</c:v>
                </c:pt>
                <c:pt idx="806">
                  <c:v>0.6589882823663904</c:v>
                </c:pt>
                <c:pt idx="807">
                  <c:v>0.63983995427264928</c:v>
                </c:pt>
                <c:pt idx="808">
                  <c:v>0.65287224921406117</c:v>
                </c:pt>
                <c:pt idx="809">
                  <c:v>0.65624464132609317</c:v>
                </c:pt>
                <c:pt idx="810">
                  <c:v>0.64441268933981133</c:v>
                </c:pt>
                <c:pt idx="811">
                  <c:v>0.65355815947413542</c:v>
                </c:pt>
                <c:pt idx="812">
                  <c:v>0.65595884538439553</c:v>
                </c:pt>
                <c:pt idx="813">
                  <c:v>0.62423549585595883</c:v>
                </c:pt>
                <c:pt idx="814">
                  <c:v>0.64475564446984857</c:v>
                </c:pt>
                <c:pt idx="815">
                  <c:v>0.65567304944269789</c:v>
                </c:pt>
                <c:pt idx="816">
                  <c:v>0.64995713060874538</c:v>
                </c:pt>
                <c:pt idx="817">
                  <c:v>0.64064018290940272</c:v>
                </c:pt>
                <c:pt idx="818">
                  <c:v>0.64915690197199205</c:v>
                </c:pt>
                <c:pt idx="819">
                  <c:v>0.64258359531294651</c:v>
                </c:pt>
                <c:pt idx="820">
                  <c:v>0.64344098313803944</c:v>
                </c:pt>
                <c:pt idx="821">
                  <c:v>0.63898256644755647</c:v>
                </c:pt>
                <c:pt idx="822">
                  <c:v>0.65412975135753071</c:v>
                </c:pt>
                <c:pt idx="823">
                  <c:v>0.63681051729065452</c:v>
                </c:pt>
                <c:pt idx="824">
                  <c:v>0.64138325235781657</c:v>
                </c:pt>
                <c:pt idx="825">
                  <c:v>0.63435267219205482</c:v>
                </c:pt>
                <c:pt idx="826">
                  <c:v>0.65458702486424691</c:v>
                </c:pt>
                <c:pt idx="827">
                  <c:v>0.65990282937982281</c:v>
                </c:pt>
                <c:pt idx="828">
                  <c:v>0.64687053443841103</c:v>
                </c:pt>
                <c:pt idx="829">
                  <c:v>0.65578736781937697</c:v>
                </c:pt>
                <c:pt idx="830">
                  <c:v>0.64475564446984857</c:v>
                </c:pt>
                <c:pt idx="831">
                  <c:v>0.65481566161760507</c:v>
                </c:pt>
                <c:pt idx="832">
                  <c:v>0.64881394684195481</c:v>
                </c:pt>
                <c:pt idx="833">
                  <c:v>0.63412403543869678</c:v>
                </c:pt>
                <c:pt idx="834">
                  <c:v>0.66418976850528721</c:v>
                </c:pt>
                <c:pt idx="835">
                  <c:v>0.64784224064018292</c:v>
                </c:pt>
                <c:pt idx="836">
                  <c:v>0.64784224064018292</c:v>
                </c:pt>
                <c:pt idx="837">
                  <c:v>0.62360674478422407</c:v>
                </c:pt>
                <c:pt idx="838">
                  <c:v>0.64761360388682476</c:v>
                </c:pt>
                <c:pt idx="839">
                  <c:v>0.64595598742497862</c:v>
                </c:pt>
                <c:pt idx="840">
                  <c:v>0.63932552157759359</c:v>
                </c:pt>
                <c:pt idx="841">
                  <c:v>0.63418119462703626</c:v>
                </c:pt>
                <c:pt idx="842">
                  <c:v>0.62840811660474416</c:v>
                </c:pt>
                <c:pt idx="843">
                  <c:v>0.63298085167190621</c:v>
                </c:pt>
                <c:pt idx="844">
                  <c:v>0.63561017433552447</c:v>
                </c:pt>
                <c:pt idx="845">
                  <c:v>0.62286367533581022</c:v>
                </c:pt>
                <c:pt idx="846">
                  <c:v>0.63863961131751934</c:v>
                </c:pt>
                <c:pt idx="847">
                  <c:v>0.63623892540725924</c:v>
                </c:pt>
                <c:pt idx="848">
                  <c:v>0.61348956844812808</c:v>
                </c:pt>
                <c:pt idx="849">
                  <c:v>0.65092883681051728</c:v>
                </c:pt>
                <c:pt idx="850">
                  <c:v>0.64435553015147184</c:v>
                </c:pt>
                <c:pt idx="851">
                  <c:v>0.6397827950843098</c:v>
                </c:pt>
                <c:pt idx="852">
                  <c:v>0.63772506430408693</c:v>
                </c:pt>
                <c:pt idx="853">
                  <c:v>0.65007144898542446</c:v>
                </c:pt>
                <c:pt idx="854">
                  <c:v>0.64224064018290938</c:v>
                </c:pt>
                <c:pt idx="855">
                  <c:v>0.64967133466704774</c:v>
                </c:pt>
                <c:pt idx="856">
                  <c:v>0.63029436981994857</c:v>
                </c:pt>
                <c:pt idx="857">
                  <c:v>0.62755072877965135</c:v>
                </c:pt>
                <c:pt idx="858">
                  <c:v>0.63583881108888252</c:v>
                </c:pt>
                <c:pt idx="859">
                  <c:v>0.63458130894541298</c:v>
                </c:pt>
                <c:pt idx="860">
                  <c:v>0.62217776507573597</c:v>
                </c:pt>
                <c:pt idx="861">
                  <c:v>0.64126893398113749</c:v>
                </c:pt>
                <c:pt idx="862">
                  <c:v>0.64635610174335523</c:v>
                </c:pt>
                <c:pt idx="863">
                  <c:v>0.65464418405258651</c:v>
                </c:pt>
                <c:pt idx="864">
                  <c:v>0.64515575878822518</c:v>
                </c:pt>
                <c:pt idx="865">
                  <c:v>0.64864246927693625</c:v>
                </c:pt>
                <c:pt idx="866">
                  <c:v>0.65167190625893112</c:v>
                </c:pt>
                <c:pt idx="867">
                  <c:v>0.66161760503000855</c:v>
                </c:pt>
                <c:pt idx="868">
                  <c:v>0.64527007716490425</c:v>
                </c:pt>
                <c:pt idx="869">
                  <c:v>0.63103743926836242</c:v>
                </c:pt>
                <c:pt idx="870">
                  <c:v>0.63618176621891964</c:v>
                </c:pt>
                <c:pt idx="871">
                  <c:v>0.6440697342097742</c:v>
                </c:pt>
                <c:pt idx="872">
                  <c:v>0.63766790511574734</c:v>
                </c:pt>
                <c:pt idx="873">
                  <c:v>0.63675335810231493</c:v>
                </c:pt>
                <c:pt idx="874">
                  <c:v>0.65012860817376394</c:v>
                </c:pt>
                <c:pt idx="875">
                  <c:v>0.61771934838525289</c:v>
                </c:pt>
                <c:pt idx="876">
                  <c:v>0.63469562732209206</c:v>
                </c:pt>
                <c:pt idx="877">
                  <c:v>0.65350100028579594</c:v>
                </c:pt>
                <c:pt idx="878">
                  <c:v>0.64389825664475564</c:v>
                </c:pt>
                <c:pt idx="879">
                  <c:v>0.62835095741640468</c:v>
                </c:pt>
                <c:pt idx="880">
                  <c:v>0.65601600457273501</c:v>
                </c:pt>
                <c:pt idx="881">
                  <c:v>0.62377822234924263</c:v>
                </c:pt>
                <c:pt idx="882">
                  <c:v>0.63218062303515288</c:v>
                </c:pt>
                <c:pt idx="883">
                  <c:v>0.64258359531294651</c:v>
                </c:pt>
                <c:pt idx="884">
                  <c:v>0.64321234638468139</c:v>
                </c:pt>
                <c:pt idx="885">
                  <c:v>0.64664189768505287</c:v>
                </c:pt>
                <c:pt idx="886">
                  <c:v>0.64309802800800231</c:v>
                </c:pt>
                <c:pt idx="887">
                  <c:v>0.64544155472992282</c:v>
                </c:pt>
                <c:pt idx="888">
                  <c:v>0.64978565304372682</c:v>
                </c:pt>
                <c:pt idx="889">
                  <c:v>0.65195770220062876</c:v>
                </c:pt>
                <c:pt idx="890">
                  <c:v>0.63761074592740785</c:v>
                </c:pt>
                <c:pt idx="891">
                  <c:v>0.62503572449271216</c:v>
                </c:pt>
                <c:pt idx="892">
                  <c:v>0.66361817662189193</c:v>
                </c:pt>
                <c:pt idx="893">
                  <c:v>0.65401543298085163</c:v>
                </c:pt>
                <c:pt idx="894">
                  <c:v>0.63692483566733349</c:v>
                </c:pt>
                <c:pt idx="895">
                  <c:v>0.64904258359531297</c:v>
                </c:pt>
                <c:pt idx="896">
                  <c:v>0.61880537296370397</c:v>
                </c:pt>
                <c:pt idx="897">
                  <c:v>0.62160617319234068</c:v>
                </c:pt>
                <c:pt idx="898">
                  <c:v>0.62817947985138611</c:v>
                </c:pt>
                <c:pt idx="899">
                  <c:v>0.62194912832237781</c:v>
                </c:pt>
                <c:pt idx="900">
                  <c:v>0.63320948842526437</c:v>
                </c:pt>
                <c:pt idx="901">
                  <c:v>0.62600743069448417</c:v>
                </c:pt>
                <c:pt idx="902">
                  <c:v>0.62857959416976283</c:v>
                </c:pt>
                <c:pt idx="903">
                  <c:v>0.63143755358673903</c:v>
                </c:pt>
                <c:pt idx="904">
                  <c:v>0.63000857387825093</c:v>
                </c:pt>
                <c:pt idx="905">
                  <c:v>0.63943983995427267</c:v>
                </c:pt>
                <c:pt idx="906">
                  <c:v>0.63972563589597031</c:v>
                </c:pt>
                <c:pt idx="907">
                  <c:v>0.62526436124607032</c:v>
                </c:pt>
                <c:pt idx="908">
                  <c:v>0.62829379822806519</c:v>
                </c:pt>
                <c:pt idx="909">
                  <c:v>0.61851957702200633</c:v>
                </c:pt>
                <c:pt idx="910">
                  <c:v>0.63435267219205482</c:v>
                </c:pt>
                <c:pt idx="911">
                  <c:v>0.63263789654186908</c:v>
                </c:pt>
                <c:pt idx="912">
                  <c:v>0.62983709631323237</c:v>
                </c:pt>
                <c:pt idx="913">
                  <c:v>0.62903686767647904</c:v>
                </c:pt>
                <c:pt idx="914">
                  <c:v>0.63772506430408693</c:v>
                </c:pt>
                <c:pt idx="915">
                  <c:v>0.62474992855101452</c:v>
                </c:pt>
                <c:pt idx="916">
                  <c:v>0.63492426407545011</c:v>
                </c:pt>
                <c:pt idx="917">
                  <c:v>0.62886539011146037</c:v>
                </c:pt>
                <c:pt idx="918">
                  <c:v>0.6268076593312375</c:v>
                </c:pt>
                <c:pt idx="919">
                  <c:v>0.63726779079737073</c:v>
                </c:pt>
                <c:pt idx="920">
                  <c:v>0.62177765075735925</c:v>
                </c:pt>
                <c:pt idx="921">
                  <c:v>0.6325807373535296</c:v>
                </c:pt>
                <c:pt idx="922">
                  <c:v>0.62097742212060592</c:v>
                </c:pt>
                <c:pt idx="923">
                  <c:v>0.64235495855958846</c:v>
                </c:pt>
                <c:pt idx="924">
                  <c:v>0.61971991997713638</c:v>
                </c:pt>
                <c:pt idx="925">
                  <c:v>0.63132323521006006</c:v>
                </c:pt>
                <c:pt idx="926">
                  <c:v>0.61983423835381535</c:v>
                </c:pt>
                <c:pt idx="927">
                  <c:v>0.61023149471277505</c:v>
                </c:pt>
                <c:pt idx="928">
                  <c:v>0.62697913689625606</c:v>
                </c:pt>
                <c:pt idx="929">
                  <c:v>0.61589025435838807</c:v>
                </c:pt>
                <c:pt idx="930">
                  <c:v>0.62400685910260079</c:v>
                </c:pt>
                <c:pt idx="931">
                  <c:v>0.63126607602172047</c:v>
                </c:pt>
                <c:pt idx="932">
                  <c:v>0.61451843383823945</c:v>
                </c:pt>
                <c:pt idx="933">
                  <c:v>0.6421834809945699</c:v>
                </c:pt>
                <c:pt idx="934">
                  <c:v>0.63646756216061728</c:v>
                </c:pt>
                <c:pt idx="935">
                  <c:v>0.60891683338096603</c:v>
                </c:pt>
                <c:pt idx="936">
                  <c:v>0.62252072020577309</c:v>
                </c:pt>
                <c:pt idx="937">
                  <c:v>0.63286653329522724</c:v>
                </c:pt>
                <c:pt idx="938">
                  <c:v>0.62469276936267504</c:v>
                </c:pt>
                <c:pt idx="939">
                  <c:v>0.62532152043440981</c:v>
                </c:pt>
                <c:pt idx="940">
                  <c:v>0.63486710488711062</c:v>
                </c:pt>
                <c:pt idx="941">
                  <c:v>0.62903686767647904</c:v>
                </c:pt>
                <c:pt idx="942">
                  <c:v>0.61994855673049443</c:v>
                </c:pt>
                <c:pt idx="943">
                  <c:v>0.60983138039439844</c:v>
                </c:pt>
                <c:pt idx="944">
                  <c:v>0.63343812517862241</c:v>
                </c:pt>
                <c:pt idx="945">
                  <c:v>0.61891969134038294</c:v>
                </c:pt>
                <c:pt idx="946">
                  <c:v>0.6253786796227494</c:v>
                </c:pt>
                <c:pt idx="947">
                  <c:v>0.63389539868533862</c:v>
                </c:pt>
                <c:pt idx="948">
                  <c:v>0.61857673621034581</c:v>
                </c:pt>
                <c:pt idx="949">
                  <c:v>0.63509574164046867</c:v>
                </c:pt>
                <c:pt idx="950">
                  <c:v>0.62863675335810232</c:v>
                </c:pt>
                <c:pt idx="951">
                  <c:v>0.62332094884252642</c:v>
                </c:pt>
                <c:pt idx="952">
                  <c:v>0.6229208345241497</c:v>
                </c:pt>
                <c:pt idx="953">
                  <c:v>0.6229208345241497</c:v>
                </c:pt>
                <c:pt idx="954">
                  <c:v>0.62977993712489277</c:v>
                </c:pt>
                <c:pt idx="955">
                  <c:v>0.62434981423263791</c:v>
                </c:pt>
                <c:pt idx="956">
                  <c:v>0.62177765075735925</c:v>
                </c:pt>
                <c:pt idx="957">
                  <c:v>0.61783366676193197</c:v>
                </c:pt>
                <c:pt idx="958">
                  <c:v>0.60583023721063156</c:v>
                </c:pt>
                <c:pt idx="959">
                  <c:v>0.60051443269505578</c:v>
                </c:pt>
                <c:pt idx="960">
                  <c:v>0.63286653329522724</c:v>
                </c:pt>
                <c:pt idx="961">
                  <c:v>0.62069162617890827</c:v>
                </c:pt>
                <c:pt idx="962">
                  <c:v>0.6124035438696771</c:v>
                </c:pt>
                <c:pt idx="963">
                  <c:v>0.63755358673906826</c:v>
                </c:pt>
                <c:pt idx="964">
                  <c:v>0.63235210060017144</c:v>
                </c:pt>
                <c:pt idx="965">
                  <c:v>0.63423835381537585</c:v>
                </c:pt>
                <c:pt idx="966">
                  <c:v>0.63378108030865965</c:v>
                </c:pt>
                <c:pt idx="967">
                  <c:v>0.63886824807087739</c:v>
                </c:pt>
                <c:pt idx="968">
                  <c:v>0.6345241497570735</c:v>
                </c:pt>
                <c:pt idx="969">
                  <c:v>0.62715061446127462</c:v>
                </c:pt>
                <c:pt idx="970">
                  <c:v>0.61977707916547586</c:v>
                </c:pt>
                <c:pt idx="971">
                  <c:v>0.63475278651043154</c:v>
                </c:pt>
                <c:pt idx="972">
                  <c:v>0.61749071163189484</c:v>
                </c:pt>
                <c:pt idx="973">
                  <c:v>0.60988853958273792</c:v>
                </c:pt>
                <c:pt idx="974">
                  <c:v>0.62029151186053155</c:v>
                </c:pt>
                <c:pt idx="975">
                  <c:v>0.61651900543012295</c:v>
                </c:pt>
                <c:pt idx="976">
                  <c:v>0.62046298942555012</c:v>
                </c:pt>
                <c:pt idx="977">
                  <c:v>0.61634752786510427</c:v>
                </c:pt>
                <c:pt idx="978">
                  <c:v>0.63252357816519</c:v>
                </c:pt>
                <c:pt idx="979">
                  <c:v>0.64275507287796518</c:v>
                </c:pt>
                <c:pt idx="980">
                  <c:v>0.61886253215204345</c:v>
                </c:pt>
                <c:pt idx="981">
                  <c:v>0.60720205773078018</c:v>
                </c:pt>
                <c:pt idx="982">
                  <c:v>0.63183766790511575</c:v>
                </c:pt>
                <c:pt idx="983">
                  <c:v>0.62234924264075453</c:v>
                </c:pt>
                <c:pt idx="984">
                  <c:v>0.6421263218062303</c:v>
                </c:pt>
                <c:pt idx="985">
                  <c:v>0.62577879394112601</c:v>
                </c:pt>
                <c:pt idx="986">
                  <c:v>0.61177479279794222</c:v>
                </c:pt>
                <c:pt idx="987">
                  <c:v>0.6210345813089454</c:v>
                </c:pt>
                <c:pt idx="988">
                  <c:v>0.62743641040297227</c:v>
                </c:pt>
                <c:pt idx="989">
                  <c:v>0.63995427264932836</c:v>
                </c:pt>
                <c:pt idx="990">
                  <c:v>0.61749071163189484</c:v>
                </c:pt>
                <c:pt idx="991">
                  <c:v>0.60725921691911977</c:v>
                </c:pt>
                <c:pt idx="992">
                  <c:v>0.62566447556444693</c:v>
                </c:pt>
                <c:pt idx="993">
                  <c:v>0.60337239211203197</c:v>
                </c:pt>
                <c:pt idx="994">
                  <c:v>0.61886253215204345</c:v>
                </c:pt>
                <c:pt idx="995">
                  <c:v>0.61446127464989997</c:v>
                </c:pt>
                <c:pt idx="996">
                  <c:v>0.62080594455558735</c:v>
                </c:pt>
                <c:pt idx="997">
                  <c:v>0.60394398399542726</c:v>
                </c:pt>
                <c:pt idx="998">
                  <c:v>0.61183195198628182</c:v>
                </c:pt>
                <c:pt idx="999">
                  <c:v>0.61068876821949125</c:v>
                </c:pt>
                <c:pt idx="1000">
                  <c:v>0.61771934838525289</c:v>
                </c:pt>
                <c:pt idx="1001">
                  <c:v>0.6224635610174335</c:v>
                </c:pt>
                <c:pt idx="1002">
                  <c:v>0.64384109745641616</c:v>
                </c:pt>
                <c:pt idx="1003">
                  <c:v>0.60108602457845095</c:v>
                </c:pt>
                <c:pt idx="1004">
                  <c:v>0.61977707916547586</c:v>
                </c:pt>
                <c:pt idx="1005">
                  <c:v>0.63526721920548723</c:v>
                </c:pt>
                <c:pt idx="1006">
                  <c:v>0.62412117747927975</c:v>
                </c:pt>
                <c:pt idx="1007">
                  <c:v>0.60977422120605884</c:v>
                </c:pt>
                <c:pt idx="1008">
                  <c:v>0.60480137182052018</c:v>
                </c:pt>
                <c:pt idx="1009">
                  <c:v>0.61634752786510427</c:v>
                </c:pt>
                <c:pt idx="1010">
                  <c:v>0.6094884252643612</c:v>
                </c:pt>
                <c:pt idx="1011">
                  <c:v>0.62017719348385258</c:v>
                </c:pt>
                <c:pt idx="1012">
                  <c:v>0.59742783652472131</c:v>
                </c:pt>
                <c:pt idx="1013">
                  <c:v>0.60851671906258931</c:v>
                </c:pt>
                <c:pt idx="1014">
                  <c:v>0.61806230351529012</c:v>
                </c:pt>
                <c:pt idx="1015">
                  <c:v>0.64818519577022005</c:v>
                </c:pt>
                <c:pt idx="1016">
                  <c:v>0.63183766790511575</c:v>
                </c:pt>
                <c:pt idx="1017">
                  <c:v>0.61754787082023432</c:v>
                </c:pt>
                <c:pt idx="1018">
                  <c:v>0.62566447556444693</c:v>
                </c:pt>
                <c:pt idx="1019">
                  <c:v>0.62143469562732212</c:v>
                </c:pt>
                <c:pt idx="1020">
                  <c:v>0.60354386967705054</c:v>
                </c:pt>
                <c:pt idx="1021">
                  <c:v>0.59234066876250357</c:v>
                </c:pt>
                <c:pt idx="1022">
                  <c:v>0.59708488139468419</c:v>
                </c:pt>
                <c:pt idx="1023">
                  <c:v>0.62040583023721063</c:v>
                </c:pt>
                <c:pt idx="1024">
                  <c:v>0.63578165190054303</c:v>
                </c:pt>
                <c:pt idx="1025">
                  <c:v>0.62000571591883391</c:v>
                </c:pt>
                <c:pt idx="1026">
                  <c:v>0.59617033438125178</c:v>
                </c:pt>
                <c:pt idx="1027">
                  <c:v>0.61783366676193197</c:v>
                </c:pt>
                <c:pt idx="1028">
                  <c:v>0.59954272649328377</c:v>
                </c:pt>
                <c:pt idx="1029">
                  <c:v>0.60754501286081741</c:v>
                </c:pt>
                <c:pt idx="1030">
                  <c:v>0.61108888253786797</c:v>
                </c:pt>
                <c:pt idx="1031">
                  <c:v>0.61663332380680191</c:v>
                </c:pt>
                <c:pt idx="1032">
                  <c:v>0.59211203200914542</c:v>
                </c:pt>
                <c:pt idx="1033">
                  <c:v>0.62137753643898253</c:v>
                </c:pt>
                <c:pt idx="1034">
                  <c:v>0.60548728208059444</c:v>
                </c:pt>
                <c:pt idx="1035">
                  <c:v>0.6061160331523292</c:v>
                </c:pt>
                <c:pt idx="1036">
                  <c:v>0.61148899685624469</c:v>
                </c:pt>
                <c:pt idx="1037">
                  <c:v>0.6249214061160332</c:v>
                </c:pt>
                <c:pt idx="1038">
                  <c:v>0.63126607602172047</c:v>
                </c:pt>
                <c:pt idx="1039">
                  <c:v>0.62480708773935412</c:v>
                </c:pt>
                <c:pt idx="1040">
                  <c:v>0.59416976278936839</c:v>
                </c:pt>
                <c:pt idx="1041">
                  <c:v>0.60920262932266367</c:v>
                </c:pt>
                <c:pt idx="1042">
                  <c:v>0.62549299799942837</c:v>
                </c:pt>
                <c:pt idx="1043">
                  <c:v>0.60417262074878542</c:v>
                </c:pt>
                <c:pt idx="1044">
                  <c:v>0.62320663046584734</c:v>
                </c:pt>
                <c:pt idx="1045">
                  <c:v>0.60703058016576161</c:v>
                </c:pt>
                <c:pt idx="1046">
                  <c:v>0.60451557587882254</c:v>
                </c:pt>
                <c:pt idx="1047">
                  <c:v>0.63149471277507863</c:v>
                </c:pt>
                <c:pt idx="1048">
                  <c:v>0.61634752786510427</c:v>
                </c:pt>
                <c:pt idx="1049">
                  <c:v>0.61789082595027156</c:v>
                </c:pt>
                <c:pt idx="1050">
                  <c:v>0.62314947127750786</c:v>
                </c:pt>
                <c:pt idx="1051">
                  <c:v>0.60331523292369249</c:v>
                </c:pt>
                <c:pt idx="1052">
                  <c:v>0.62840811660474416</c:v>
                </c:pt>
                <c:pt idx="1053">
                  <c:v>0.61148899685624469</c:v>
                </c:pt>
                <c:pt idx="1054">
                  <c:v>0.61371820520148612</c:v>
                </c:pt>
                <c:pt idx="1055">
                  <c:v>0.59496999142612172</c:v>
                </c:pt>
                <c:pt idx="1056">
                  <c:v>0.61983423835381535</c:v>
                </c:pt>
                <c:pt idx="1057">
                  <c:v>0.61560445841669054</c:v>
                </c:pt>
                <c:pt idx="1058">
                  <c:v>0.60697342097742213</c:v>
                </c:pt>
                <c:pt idx="1059">
                  <c:v>0.60508716776221783</c:v>
                </c:pt>
                <c:pt idx="1060">
                  <c:v>0.6186338953986853</c:v>
                </c:pt>
                <c:pt idx="1061">
                  <c:v>0.60503000857387823</c:v>
                </c:pt>
                <c:pt idx="1062">
                  <c:v>0.60028579594169762</c:v>
                </c:pt>
                <c:pt idx="1063">
                  <c:v>0.63440983138039442</c:v>
                </c:pt>
                <c:pt idx="1064">
                  <c:v>0.61560445841669054</c:v>
                </c:pt>
                <c:pt idx="1065">
                  <c:v>0.6186338953986853</c:v>
                </c:pt>
                <c:pt idx="1066">
                  <c:v>0.60245784509859956</c:v>
                </c:pt>
                <c:pt idx="1067">
                  <c:v>0.62400685910260079</c:v>
                </c:pt>
                <c:pt idx="1068">
                  <c:v>0.59365533009431271</c:v>
                </c:pt>
                <c:pt idx="1069">
                  <c:v>0.62697913689625606</c:v>
                </c:pt>
                <c:pt idx="1070">
                  <c:v>0.61417547870820233</c:v>
                </c:pt>
                <c:pt idx="1071">
                  <c:v>0.61211774792797946</c:v>
                </c:pt>
                <c:pt idx="1072">
                  <c:v>0.6196056016004573</c:v>
                </c:pt>
                <c:pt idx="1073">
                  <c:v>0.62795084309802796</c:v>
                </c:pt>
                <c:pt idx="1074">
                  <c:v>0.60411546156044582</c:v>
                </c:pt>
                <c:pt idx="1075">
                  <c:v>0.59954272649328377</c:v>
                </c:pt>
                <c:pt idx="1076">
                  <c:v>0.58651043155187199</c:v>
                </c:pt>
                <c:pt idx="1077">
                  <c:v>0.60268648185195772</c:v>
                </c:pt>
                <c:pt idx="1078">
                  <c:v>0.61234638468133751</c:v>
                </c:pt>
                <c:pt idx="1079">
                  <c:v>0.60342955130037157</c:v>
                </c:pt>
                <c:pt idx="1080">
                  <c:v>0.60965990282937987</c:v>
                </c:pt>
                <c:pt idx="1081">
                  <c:v>0.60891683338096603</c:v>
                </c:pt>
                <c:pt idx="1082">
                  <c:v>0.62303515290082878</c:v>
                </c:pt>
                <c:pt idx="1083">
                  <c:v>0.61303229494141187</c:v>
                </c:pt>
                <c:pt idx="1084">
                  <c:v>0.59931408973992573</c:v>
                </c:pt>
                <c:pt idx="1085">
                  <c:v>0.61268933981137463</c:v>
                </c:pt>
                <c:pt idx="1086">
                  <c:v>0.58508145184338378</c:v>
                </c:pt>
                <c:pt idx="1087">
                  <c:v>0.59234066876250357</c:v>
                </c:pt>
                <c:pt idx="1088">
                  <c:v>0.59839954272649332</c:v>
                </c:pt>
                <c:pt idx="1089">
                  <c:v>0.62800800228636755</c:v>
                </c:pt>
                <c:pt idx="1090">
                  <c:v>0.58891111746213198</c:v>
                </c:pt>
                <c:pt idx="1091">
                  <c:v>0.62229208345241493</c:v>
                </c:pt>
                <c:pt idx="1092">
                  <c:v>0.61651900543012295</c:v>
                </c:pt>
                <c:pt idx="1093">
                  <c:v>0.59977136324664193</c:v>
                </c:pt>
                <c:pt idx="1094">
                  <c:v>0.58708202343526716</c:v>
                </c:pt>
                <c:pt idx="1095">
                  <c:v>0.62560731637610745</c:v>
                </c:pt>
                <c:pt idx="1096">
                  <c:v>0.60068591026007434</c:v>
                </c:pt>
                <c:pt idx="1097">
                  <c:v>0.59171191769076881</c:v>
                </c:pt>
                <c:pt idx="1098">
                  <c:v>0.59336953415261506</c:v>
                </c:pt>
                <c:pt idx="1099">
                  <c:v>0.60645898828236644</c:v>
                </c:pt>
                <c:pt idx="1100">
                  <c:v>0.61663332380680191</c:v>
                </c:pt>
                <c:pt idx="1101">
                  <c:v>0.60988853958273792</c:v>
                </c:pt>
                <c:pt idx="1102">
                  <c:v>0.58679622749356963</c:v>
                </c:pt>
                <c:pt idx="1103">
                  <c:v>0.61434695627322089</c:v>
                </c:pt>
                <c:pt idx="1104">
                  <c:v>0.61874821377536438</c:v>
                </c:pt>
                <c:pt idx="1105">
                  <c:v>0.60400114318376674</c:v>
                </c:pt>
                <c:pt idx="1106">
                  <c:v>0.60965990282937987</c:v>
                </c:pt>
                <c:pt idx="1107">
                  <c:v>0.60028579594169762</c:v>
                </c:pt>
                <c:pt idx="1108">
                  <c:v>0.60525864532723639</c:v>
                </c:pt>
                <c:pt idx="1109">
                  <c:v>0.59479851386110316</c:v>
                </c:pt>
                <c:pt idx="1110">
                  <c:v>0.61166047442126326</c:v>
                </c:pt>
                <c:pt idx="1111">
                  <c:v>0.58102314947127753</c:v>
                </c:pt>
                <c:pt idx="1112">
                  <c:v>0.60457273506716203</c:v>
                </c:pt>
                <c:pt idx="1113">
                  <c:v>0.6028008002286368</c:v>
                </c:pt>
                <c:pt idx="1114">
                  <c:v>0.61388968276650469</c:v>
                </c:pt>
                <c:pt idx="1115">
                  <c:v>0.6028008002286368</c:v>
                </c:pt>
                <c:pt idx="1116">
                  <c:v>0.59359817090597311</c:v>
                </c:pt>
                <c:pt idx="1117">
                  <c:v>0.62686481851957698</c:v>
                </c:pt>
                <c:pt idx="1118">
                  <c:v>0.62675050014289801</c:v>
                </c:pt>
                <c:pt idx="1119">
                  <c:v>0.6138325235781652</c:v>
                </c:pt>
                <c:pt idx="1120">
                  <c:v>0.62074878536724776</c:v>
                </c:pt>
                <c:pt idx="1121">
                  <c:v>0.5946270362960846</c:v>
                </c:pt>
                <c:pt idx="1122">
                  <c:v>0.59296941983423834</c:v>
                </c:pt>
                <c:pt idx="1123">
                  <c:v>0.61846241783366673</c:v>
                </c:pt>
                <c:pt idx="1124">
                  <c:v>0.59931408973992573</c:v>
                </c:pt>
                <c:pt idx="1125">
                  <c:v>0.61103172334952849</c:v>
                </c:pt>
                <c:pt idx="1126">
                  <c:v>0.61891969134038294</c:v>
                </c:pt>
                <c:pt idx="1127">
                  <c:v>0.59645613032294942</c:v>
                </c:pt>
                <c:pt idx="1128">
                  <c:v>0.61817662189196909</c:v>
                </c:pt>
                <c:pt idx="1129">
                  <c:v>0.59085452986567588</c:v>
                </c:pt>
                <c:pt idx="1130">
                  <c:v>0.61148899685624469</c:v>
                </c:pt>
                <c:pt idx="1131">
                  <c:v>0.60931694769934264</c:v>
                </c:pt>
                <c:pt idx="1132">
                  <c:v>0.60177193483852531</c:v>
                </c:pt>
                <c:pt idx="1133">
                  <c:v>0.58651043155187199</c:v>
                </c:pt>
                <c:pt idx="1134">
                  <c:v>0.60525864532723639</c:v>
                </c:pt>
                <c:pt idx="1135">
                  <c:v>0.62972277793655329</c:v>
                </c:pt>
                <c:pt idx="1136">
                  <c:v>0.60320091454701341</c:v>
                </c:pt>
                <c:pt idx="1137">
                  <c:v>0.60068591026007434</c:v>
                </c:pt>
                <c:pt idx="1138">
                  <c:v>0.61514718490997433</c:v>
                </c:pt>
                <c:pt idx="1139">
                  <c:v>0.61308945412975135</c:v>
                </c:pt>
                <c:pt idx="1140">
                  <c:v>0.59617033438125178</c:v>
                </c:pt>
                <c:pt idx="1141">
                  <c:v>0.60171477565018572</c:v>
                </c:pt>
                <c:pt idx="1142">
                  <c:v>0.59531294655615885</c:v>
                </c:pt>
                <c:pt idx="1143">
                  <c:v>0.60028579594169762</c:v>
                </c:pt>
                <c:pt idx="1144">
                  <c:v>0.59559874249785649</c:v>
                </c:pt>
                <c:pt idx="1145">
                  <c:v>0.62069162617890827</c:v>
                </c:pt>
                <c:pt idx="1146">
                  <c:v>0.60897399256930551</c:v>
                </c:pt>
                <c:pt idx="1147">
                  <c:v>0.59599885681623321</c:v>
                </c:pt>
                <c:pt idx="1148">
                  <c:v>0.58925407259216922</c:v>
                </c:pt>
                <c:pt idx="1149">
                  <c:v>0.58725350100028584</c:v>
                </c:pt>
                <c:pt idx="1150">
                  <c:v>0.61040297227779361</c:v>
                </c:pt>
                <c:pt idx="1151">
                  <c:v>0.59714204058302367</c:v>
                </c:pt>
                <c:pt idx="1152">
                  <c:v>0.60342955130037157</c:v>
                </c:pt>
                <c:pt idx="1153">
                  <c:v>0.62737925121463278</c:v>
                </c:pt>
                <c:pt idx="1154">
                  <c:v>0.61217490711631894</c:v>
                </c:pt>
                <c:pt idx="1155">
                  <c:v>0.59228350957416409</c:v>
                </c:pt>
                <c:pt idx="1156">
                  <c:v>0.60491569019719915</c:v>
                </c:pt>
                <c:pt idx="1157">
                  <c:v>0.59834238353815372</c:v>
                </c:pt>
                <c:pt idx="1158">
                  <c:v>0.60560160045727351</c:v>
                </c:pt>
                <c:pt idx="1159">
                  <c:v>0.61411831951986284</c:v>
                </c:pt>
                <c:pt idx="1160">
                  <c:v>0.59662760788796798</c:v>
                </c:pt>
                <c:pt idx="1161">
                  <c:v>0.5950843098028008</c:v>
                </c:pt>
                <c:pt idx="1162">
                  <c:v>0.60594455558731064</c:v>
                </c:pt>
                <c:pt idx="1163">
                  <c:v>0.59114032580737352</c:v>
                </c:pt>
                <c:pt idx="1164">
                  <c:v>0.57856530437267795</c:v>
                </c:pt>
                <c:pt idx="1165">
                  <c:v>0.61886253215204345</c:v>
                </c:pt>
                <c:pt idx="1166">
                  <c:v>0.60137182052014859</c:v>
                </c:pt>
                <c:pt idx="1167">
                  <c:v>0.60388682480708777</c:v>
                </c:pt>
                <c:pt idx="1168">
                  <c:v>0.60165761646184623</c:v>
                </c:pt>
                <c:pt idx="1169">
                  <c:v>0.59256930551586162</c:v>
                </c:pt>
                <c:pt idx="1170">
                  <c:v>0.60628751071734777</c:v>
                </c:pt>
                <c:pt idx="1171">
                  <c:v>0.5912546441840526</c:v>
                </c:pt>
                <c:pt idx="1172">
                  <c:v>0.58828236639039722</c:v>
                </c:pt>
                <c:pt idx="1173">
                  <c:v>0.61063160903115177</c:v>
                </c:pt>
                <c:pt idx="1174">
                  <c:v>0.60262932266361813</c:v>
                </c:pt>
                <c:pt idx="1175">
                  <c:v>0.6003429551300371</c:v>
                </c:pt>
                <c:pt idx="1176">
                  <c:v>0.61011717633609608</c:v>
                </c:pt>
                <c:pt idx="1177">
                  <c:v>0.60885967419262643</c:v>
                </c:pt>
                <c:pt idx="1178">
                  <c:v>0.60371534724206921</c:v>
                </c:pt>
                <c:pt idx="1179">
                  <c:v>0.60954558445270079</c:v>
                </c:pt>
                <c:pt idx="1180">
                  <c:v>0.59908545298656757</c:v>
                </c:pt>
                <c:pt idx="1181">
                  <c:v>0.61560445841669054</c:v>
                </c:pt>
                <c:pt idx="1182">
                  <c:v>0.60680194341240357</c:v>
                </c:pt>
                <c:pt idx="1183">
                  <c:v>0.60703058016576161</c:v>
                </c:pt>
                <c:pt idx="1184">
                  <c:v>0.60845955987424982</c:v>
                </c:pt>
                <c:pt idx="1185">
                  <c:v>0.60480137182052018</c:v>
                </c:pt>
                <c:pt idx="1186">
                  <c:v>0.60382966561874818</c:v>
                </c:pt>
                <c:pt idx="1187">
                  <c:v>0.59308373821091742</c:v>
                </c:pt>
                <c:pt idx="1188">
                  <c:v>0.6</c:v>
                </c:pt>
                <c:pt idx="1189">
                  <c:v>0.60914547013432407</c:v>
                </c:pt>
                <c:pt idx="1190">
                  <c:v>0.60600171477565024</c:v>
                </c:pt>
                <c:pt idx="1191">
                  <c:v>0.60823092312089166</c:v>
                </c:pt>
                <c:pt idx="1192">
                  <c:v>0.59479851386110316</c:v>
                </c:pt>
                <c:pt idx="1193">
                  <c:v>0.62835095741640468</c:v>
                </c:pt>
                <c:pt idx="1194">
                  <c:v>0.59879965704486993</c:v>
                </c:pt>
                <c:pt idx="1195">
                  <c:v>0.61926264647042017</c:v>
                </c:pt>
                <c:pt idx="1196">
                  <c:v>0.59828522434981424</c:v>
                </c:pt>
                <c:pt idx="1197">
                  <c:v>0.61183195198628182</c:v>
                </c:pt>
                <c:pt idx="1198">
                  <c:v>0.60583023721063156</c:v>
                </c:pt>
                <c:pt idx="1199">
                  <c:v>0.60560160045727351</c:v>
                </c:pt>
                <c:pt idx="1200">
                  <c:v>0.62132037725064304</c:v>
                </c:pt>
                <c:pt idx="1201">
                  <c:v>0.60308659617033433</c:v>
                </c:pt>
                <c:pt idx="1202">
                  <c:v>0.60691626178908264</c:v>
                </c:pt>
                <c:pt idx="1203">
                  <c:v>0.61640468705344387</c:v>
                </c:pt>
                <c:pt idx="1204">
                  <c:v>0.60914547013432407</c:v>
                </c:pt>
                <c:pt idx="1205">
                  <c:v>0.5946270362960846</c:v>
                </c:pt>
                <c:pt idx="1206">
                  <c:v>0.5965704486996285</c:v>
                </c:pt>
                <c:pt idx="1207">
                  <c:v>0.61183195198628182</c:v>
                </c:pt>
                <c:pt idx="1208">
                  <c:v>0.61440411546156048</c:v>
                </c:pt>
                <c:pt idx="1209">
                  <c:v>0.6037725064304087</c:v>
                </c:pt>
                <c:pt idx="1210">
                  <c:v>0.60748785367247782</c:v>
                </c:pt>
                <c:pt idx="1211">
                  <c:v>0.6118891111746213</c:v>
                </c:pt>
                <c:pt idx="1212">
                  <c:v>0.60577307802229208</c:v>
                </c:pt>
                <c:pt idx="1213">
                  <c:v>0.62515004286939124</c:v>
                </c:pt>
                <c:pt idx="1214">
                  <c:v>0.61686196056016007</c:v>
                </c:pt>
                <c:pt idx="1215">
                  <c:v>0.63280937410688765</c:v>
                </c:pt>
                <c:pt idx="1216">
                  <c:v>0.60051443269505578</c:v>
                </c:pt>
                <c:pt idx="1217">
                  <c:v>0.60285795941697629</c:v>
                </c:pt>
                <c:pt idx="1218">
                  <c:v>0.61537582166333238</c:v>
                </c:pt>
                <c:pt idx="1219">
                  <c:v>0.61154615604458418</c:v>
                </c:pt>
                <c:pt idx="1220">
                  <c:v>0.61308945412975135</c:v>
                </c:pt>
                <c:pt idx="1221">
                  <c:v>0.59679908545298654</c:v>
                </c:pt>
                <c:pt idx="1222">
                  <c:v>0.61903400971706202</c:v>
                </c:pt>
                <c:pt idx="1223">
                  <c:v>0.63972563589597031</c:v>
                </c:pt>
                <c:pt idx="1224">
                  <c:v>0.62663618176621894</c:v>
                </c:pt>
                <c:pt idx="1225">
                  <c:v>0.62120605887396396</c:v>
                </c:pt>
                <c:pt idx="1226">
                  <c:v>0.60943126607602172</c:v>
                </c:pt>
                <c:pt idx="1227">
                  <c:v>0.61360388682480704</c:v>
                </c:pt>
                <c:pt idx="1228">
                  <c:v>0.61886253215204345</c:v>
                </c:pt>
                <c:pt idx="1229">
                  <c:v>0.61411831951986284</c:v>
                </c:pt>
                <c:pt idx="1230">
                  <c:v>0.62452129179765647</c:v>
                </c:pt>
                <c:pt idx="1231">
                  <c:v>0.64132609316947697</c:v>
                </c:pt>
                <c:pt idx="1232">
                  <c:v>0.60725921691911977</c:v>
                </c:pt>
                <c:pt idx="1233">
                  <c:v>0.63949699914261215</c:v>
                </c:pt>
                <c:pt idx="1234">
                  <c:v>0.65007144898542446</c:v>
                </c:pt>
                <c:pt idx="1235">
                  <c:v>0.63721063160903113</c:v>
                </c:pt>
                <c:pt idx="1236">
                  <c:v>0.62583595312946561</c:v>
                </c:pt>
                <c:pt idx="1237">
                  <c:v>0.63435267219205482</c:v>
                </c:pt>
                <c:pt idx="1238">
                  <c:v>0.64115461560445841</c:v>
                </c:pt>
                <c:pt idx="1239">
                  <c:v>0.64138325235781657</c:v>
                </c:pt>
                <c:pt idx="1240">
                  <c:v>0.64012575021434692</c:v>
                </c:pt>
                <c:pt idx="1241">
                  <c:v>0.62497856530437268</c:v>
                </c:pt>
                <c:pt idx="1242">
                  <c:v>0.6118891111746213</c:v>
                </c:pt>
                <c:pt idx="1243">
                  <c:v>0.6210345813089454</c:v>
                </c:pt>
                <c:pt idx="1244">
                  <c:v>0.62109174049728488</c:v>
                </c:pt>
                <c:pt idx="1245">
                  <c:v>0.65527293512432128</c:v>
                </c:pt>
                <c:pt idx="1246">
                  <c:v>0.66047442126321809</c:v>
                </c:pt>
                <c:pt idx="1247">
                  <c:v>0.62835095741640468</c:v>
                </c:pt>
                <c:pt idx="1248">
                  <c:v>0.63200914547013431</c:v>
                </c:pt>
                <c:pt idx="1249">
                  <c:v>0.64252643612460703</c:v>
                </c:pt>
                <c:pt idx="1250">
                  <c:v>0.63612460703058016</c:v>
                </c:pt>
                <c:pt idx="1251">
                  <c:v>0.65401543298085163</c:v>
                </c:pt>
                <c:pt idx="1252">
                  <c:v>0.66396113175192917</c:v>
                </c:pt>
                <c:pt idx="1253">
                  <c:v>0.64538439554158333</c:v>
                </c:pt>
                <c:pt idx="1254">
                  <c:v>0.64292655044298375</c:v>
                </c:pt>
                <c:pt idx="1255">
                  <c:v>0.62915118605315801</c:v>
                </c:pt>
                <c:pt idx="1256">
                  <c:v>0.62515004286939124</c:v>
                </c:pt>
                <c:pt idx="1257">
                  <c:v>0.65007144898542446</c:v>
                </c:pt>
                <c:pt idx="1258">
                  <c:v>0.64475564446984857</c:v>
                </c:pt>
                <c:pt idx="1259">
                  <c:v>0.64115461560445841</c:v>
                </c:pt>
                <c:pt idx="1260">
                  <c:v>0.64201200342955134</c:v>
                </c:pt>
                <c:pt idx="1261">
                  <c:v>0.63726779079737073</c:v>
                </c:pt>
                <c:pt idx="1262">
                  <c:v>0.62617890825950273</c:v>
                </c:pt>
                <c:pt idx="1263">
                  <c:v>0.63326664761360385</c:v>
                </c:pt>
                <c:pt idx="1264">
                  <c:v>0.64852815090025717</c:v>
                </c:pt>
                <c:pt idx="1265">
                  <c:v>0.67859388396684772</c:v>
                </c:pt>
                <c:pt idx="1266">
                  <c:v>0.66744784224064013</c:v>
                </c:pt>
                <c:pt idx="1267">
                  <c:v>0.6512717919405544</c:v>
                </c:pt>
                <c:pt idx="1268">
                  <c:v>0.63812517862246354</c:v>
                </c:pt>
                <c:pt idx="1269">
                  <c:v>0.65275793083738209</c:v>
                </c:pt>
                <c:pt idx="1270">
                  <c:v>0.66167476421834814</c:v>
                </c:pt>
                <c:pt idx="1271">
                  <c:v>0.6647613603886825</c:v>
                </c:pt>
                <c:pt idx="1272">
                  <c:v>0.66076021720491573</c:v>
                </c:pt>
                <c:pt idx="1273">
                  <c:v>0.64366961989139759</c:v>
                </c:pt>
                <c:pt idx="1274">
                  <c:v>0.65538725350100024</c:v>
                </c:pt>
                <c:pt idx="1275">
                  <c:v>0.62972277793655329</c:v>
                </c:pt>
                <c:pt idx="1276">
                  <c:v>0.65767362103458127</c:v>
                </c:pt>
                <c:pt idx="1277">
                  <c:v>0.64949985710202918</c:v>
                </c:pt>
                <c:pt idx="1278">
                  <c:v>0.64881394684195481</c:v>
                </c:pt>
                <c:pt idx="1279">
                  <c:v>0.68419548442412115</c:v>
                </c:pt>
                <c:pt idx="1280">
                  <c:v>0.6570448699628465</c:v>
                </c:pt>
                <c:pt idx="1281">
                  <c:v>0.65521577593598168</c:v>
                </c:pt>
                <c:pt idx="1282">
                  <c:v>0.64092597885110036</c:v>
                </c:pt>
                <c:pt idx="1283">
                  <c:v>0.64064018290940272</c:v>
                </c:pt>
                <c:pt idx="1284">
                  <c:v>0.66064589882823666</c:v>
                </c:pt>
                <c:pt idx="1285">
                  <c:v>0.68716776221777653</c:v>
                </c:pt>
                <c:pt idx="1286">
                  <c:v>0.6757930837382109</c:v>
                </c:pt>
                <c:pt idx="1287">
                  <c:v>0.66150328665332947</c:v>
                </c:pt>
                <c:pt idx="1288">
                  <c:v>0.66744784224064013</c:v>
                </c:pt>
                <c:pt idx="1289">
                  <c:v>0.65807373535295799</c:v>
                </c:pt>
                <c:pt idx="1290">
                  <c:v>0.69105458702486422</c:v>
                </c:pt>
                <c:pt idx="1291">
                  <c:v>0.67550728779651326</c:v>
                </c:pt>
                <c:pt idx="1292">
                  <c:v>0.68470991711917695</c:v>
                </c:pt>
                <c:pt idx="1293">
                  <c:v>0.69722777936553304</c:v>
                </c:pt>
                <c:pt idx="1294">
                  <c:v>0.67693626750500147</c:v>
                </c:pt>
                <c:pt idx="1295">
                  <c:v>0.67150614461274649</c:v>
                </c:pt>
                <c:pt idx="1296">
                  <c:v>0.65818805372963707</c:v>
                </c:pt>
                <c:pt idx="1297">
                  <c:v>0.69414118319519857</c:v>
                </c:pt>
                <c:pt idx="1298">
                  <c:v>0.68368105172906546</c:v>
                </c:pt>
                <c:pt idx="1299">
                  <c:v>0.69557016290368678</c:v>
                </c:pt>
                <c:pt idx="1300">
                  <c:v>0.69328379537010576</c:v>
                </c:pt>
                <c:pt idx="1301">
                  <c:v>0.67093455272935121</c:v>
                </c:pt>
                <c:pt idx="1302">
                  <c:v>0.64246927693626754</c:v>
                </c:pt>
                <c:pt idx="1303">
                  <c:v>0.69962846527579303</c:v>
                </c:pt>
                <c:pt idx="1304">
                  <c:v>0.6949985710202915</c:v>
                </c:pt>
                <c:pt idx="1305">
                  <c:v>0.69631323235210063</c:v>
                </c:pt>
                <c:pt idx="1306">
                  <c:v>0.67007716490425839</c:v>
                </c:pt>
                <c:pt idx="1307">
                  <c:v>0.70202915118605314</c:v>
                </c:pt>
                <c:pt idx="1308">
                  <c:v>0.69625607316376104</c:v>
                </c:pt>
                <c:pt idx="1309">
                  <c:v>0.65412975135753071</c:v>
                </c:pt>
                <c:pt idx="1310">
                  <c:v>0.71654758502429261</c:v>
                </c:pt>
                <c:pt idx="1311">
                  <c:v>0.69648470991711919</c:v>
                </c:pt>
                <c:pt idx="1312">
                  <c:v>0.70254358388110894</c:v>
                </c:pt>
                <c:pt idx="1313">
                  <c:v>0.69265504429837099</c:v>
                </c:pt>
                <c:pt idx="1314">
                  <c:v>0.66853386681909122</c:v>
                </c:pt>
                <c:pt idx="1315">
                  <c:v>0.70534438410974565</c:v>
                </c:pt>
                <c:pt idx="1316">
                  <c:v>0.71637610745927405</c:v>
                </c:pt>
                <c:pt idx="1317">
                  <c:v>0.72123463846813374</c:v>
                </c:pt>
                <c:pt idx="1318">
                  <c:v>0.72883681051729066</c:v>
                </c:pt>
                <c:pt idx="1319">
                  <c:v>0.69734209774221201</c:v>
                </c:pt>
                <c:pt idx="1320">
                  <c:v>0.68905401543298084</c:v>
                </c:pt>
                <c:pt idx="1321">
                  <c:v>0.66910545870248639</c:v>
                </c:pt>
                <c:pt idx="1322">
                  <c:v>0.70597313518148042</c:v>
                </c:pt>
                <c:pt idx="1323">
                  <c:v>0.69214061160331519</c:v>
                </c:pt>
                <c:pt idx="1324">
                  <c:v>0.70294369819948554</c:v>
                </c:pt>
                <c:pt idx="1325">
                  <c:v>0.69225492997999427</c:v>
                </c:pt>
                <c:pt idx="1326">
                  <c:v>0.68448128036581879</c:v>
                </c:pt>
                <c:pt idx="1327">
                  <c:v>0.65847384967133471</c:v>
                </c:pt>
                <c:pt idx="1328">
                  <c:v>0.68596741926264648</c:v>
                </c:pt>
                <c:pt idx="1329">
                  <c:v>0.68225207202057736</c:v>
                </c:pt>
                <c:pt idx="1330">
                  <c:v>0.69991426121749067</c:v>
                </c:pt>
                <c:pt idx="1331">
                  <c:v>0.7012289225492998</c:v>
                </c:pt>
                <c:pt idx="1332">
                  <c:v>0.70168619605601601</c:v>
                </c:pt>
                <c:pt idx="1333">
                  <c:v>0.69368390968848237</c:v>
                </c:pt>
                <c:pt idx="1334">
                  <c:v>0.69225492997999427</c:v>
                </c:pt>
                <c:pt idx="1335">
                  <c:v>0.69842812232066309</c:v>
                </c:pt>
                <c:pt idx="1336">
                  <c:v>0.69151186053158042</c:v>
                </c:pt>
                <c:pt idx="1337">
                  <c:v>0.71723349528436697</c:v>
                </c:pt>
                <c:pt idx="1338">
                  <c:v>0.70968848242354954</c:v>
                </c:pt>
                <c:pt idx="1339">
                  <c:v>0.70100028579594165</c:v>
                </c:pt>
                <c:pt idx="1340">
                  <c:v>0.6993426693340955</c:v>
                </c:pt>
                <c:pt idx="1341">
                  <c:v>0.68528150900257212</c:v>
                </c:pt>
                <c:pt idx="1342">
                  <c:v>0.70168619605601601</c:v>
                </c:pt>
                <c:pt idx="1343">
                  <c:v>0.69196913403829663</c:v>
                </c:pt>
                <c:pt idx="1344">
                  <c:v>0.69008288082309233</c:v>
                </c:pt>
                <c:pt idx="1345">
                  <c:v>0.67179194055444413</c:v>
                </c:pt>
                <c:pt idx="1346">
                  <c:v>0.68711060302943694</c:v>
                </c:pt>
                <c:pt idx="1347">
                  <c:v>0.69014004001143181</c:v>
                </c:pt>
                <c:pt idx="1348">
                  <c:v>0.71437553586739067</c:v>
                </c:pt>
                <c:pt idx="1349">
                  <c:v>0.69779937124892821</c:v>
                </c:pt>
                <c:pt idx="1350">
                  <c:v>0.71334667047727918</c:v>
                </c:pt>
                <c:pt idx="1351">
                  <c:v>0.70671620462989426</c:v>
                </c:pt>
                <c:pt idx="1352">
                  <c:v>0.70985995998856821</c:v>
                </c:pt>
                <c:pt idx="1353">
                  <c:v>0.69174049728493858</c:v>
                </c:pt>
                <c:pt idx="1354">
                  <c:v>0.69316947699342668</c:v>
                </c:pt>
                <c:pt idx="1355">
                  <c:v>0.70597313518148042</c:v>
                </c:pt>
                <c:pt idx="1356">
                  <c:v>0.70322949414118319</c:v>
                </c:pt>
                <c:pt idx="1357">
                  <c:v>0.70162903686767653</c:v>
                </c:pt>
                <c:pt idx="1358">
                  <c:v>0.70037153472420688</c:v>
                </c:pt>
                <c:pt idx="1359">
                  <c:v>0.68716776221777653</c:v>
                </c:pt>
                <c:pt idx="1360">
                  <c:v>0.71117462132037723</c:v>
                </c:pt>
                <c:pt idx="1361">
                  <c:v>0.68665332952272073</c:v>
                </c:pt>
                <c:pt idx="1362">
                  <c:v>0.7103743926836239</c:v>
                </c:pt>
                <c:pt idx="1363">
                  <c:v>0.7137467847956559</c:v>
                </c:pt>
                <c:pt idx="1364">
                  <c:v>0.69362675050014289</c:v>
                </c:pt>
                <c:pt idx="1365">
                  <c:v>0.70557302086310369</c:v>
                </c:pt>
                <c:pt idx="1366">
                  <c:v>0.70905973135181477</c:v>
                </c:pt>
                <c:pt idx="1367">
                  <c:v>0.70340097170620175</c:v>
                </c:pt>
                <c:pt idx="1368">
                  <c:v>0.68962560731637612</c:v>
                </c:pt>
                <c:pt idx="1369">
                  <c:v>0.70385824521291795</c:v>
                </c:pt>
                <c:pt idx="1370">
                  <c:v>0.71271791940554441</c:v>
                </c:pt>
                <c:pt idx="1371">
                  <c:v>0.72500714489854245</c:v>
                </c:pt>
                <c:pt idx="1372">
                  <c:v>0.67950843098028013</c:v>
                </c:pt>
                <c:pt idx="1373">
                  <c:v>0.66796227493569593</c:v>
                </c:pt>
                <c:pt idx="1374">
                  <c:v>0.685910260074307</c:v>
                </c:pt>
                <c:pt idx="1375">
                  <c:v>0.70248642469276934</c:v>
                </c:pt>
                <c:pt idx="1376">
                  <c:v>0.70671620462989426</c:v>
                </c:pt>
                <c:pt idx="1377">
                  <c:v>0.71020291511860534</c:v>
                </c:pt>
                <c:pt idx="1378">
                  <c:v>0.6877965132895113</c:v>
                </c:pt>
                <c:pt idx="1379">
                  <c:v>0.67739354101171767</c:v>
                </c:pt>
                <c:pt idx="1380">
                  <c:v>0.6973992569305516</c:v>
                </c:pt>
                <c:pt idx="1381">
                  <c:v>0.72157759359817086</c:v>
                </c:pt>
                <c:pt idx="1382">
                  <c:v>0.71946270362960851</c:v>
                </c:pt>
                <c:pt idx="1383">
                  <c:v>0.7305515861674764</c:v>
                </c:pt>
                <c:pt idx="1384">
                  <c:v>0.71134609888539579</c:v>
                </c:pt>
                <c:pt idx="1385">
                  <c:v>0.719519862817948</c:v>
                </c:pt>
                <c:pt idx="1386">
                  <c:v>0.70025721634752791</c:v>
                </c:pt>
                <c:pt idx="1387">
                  <c:v>0.6829951414689911</c:v>
                </c:pt>
                <c:pt idx="1388">
                  <c:v>0.71631894827093456</c:v>
                </c:pt>
                <c:pt idx="1389">
                  <c:v>0.69522720777364966</c:v>
                </c:pt>
                <c:pt idx="1390">
                  <c:v>0.70545870248642473</c:v>
                </c:pt>
                <c:pt idx="1391">
                  <c:v>0.71883395255787363</c:v>
                </c:pt>
                <c:pt idx="1392">
                  <c:v>0.69385538725350104</c:v>
                </c:pt>
                <c:pt idx="1393">
                  <c:v>0.70511574735638749</c:v>
                </c:pt>
                <c:pt idx="1394">
                  <c:v>0.69591311803372391</c:v>
                </c:pt>
                <c:pt idx="1395">
                  <c:v>0.7156330380108602</c:v>
                </c:pt>
                <c:pt idx="1396">
                  <c:v>0.72203486710488707</c:v>
                </c:pt>
                <c:pt idx="1397">
                  <c:v>0.73255215775935978</c:v>
                </c:pt>
                <c:pt idx="1398">
                  <c:v>0.69534152615032863</c:v>
                </c:pt>
                <c:pt idx="1399">
                  <c:v>0.71146041726207487</c:v>
                </c:pt>
                <c:pt idx="1400">
                  <c:v>0.70540154329808513</c:v>
                </c:pt>
                <c:pt idx="1401">
                  <c:v>0.70362960845955991</c:v>
                </c:pt>
                <c:pt idx="1402">
                  <c:v>0.70911689054015437</c:v>
                </c:pt>
                <c:pt idx="1403">
                  <c:v>0.71494712775078595</c:v>
                </c:pt>
                <c:pt idx="1404">
                  <c:v>0.7065447270648757</c:v>
                </c:pt>
                <c:pt idx="1405">
                  <c:v>0.69808516719062585</c:v>
                </c:pt>
                <c:pt idx="1406">
                  <c:v>0.69385538725350104</c:v>
                </c:pt>
                <c:pt idx="1407">
                  <c:v>0.70494426979136893</c:v>
                </c:pt>
                <c:pt idx="1408">
                  <c:v>0.70963132323521005</c:v>
                </c:pt>
                <c:pt idx="1409">
                  <c:v>0.67224921406116034</c:v>
                </c:pt>
                <c:pt idx="1410">
                  <c:v>0.70585881680480134</c:v>
                </c:pt>
                <c:pt idx="1411">
                  <c:v>0.71237496427550728</c:v>
                </c:pt>
                <c:pt idx="1412">
                  <c:v>0.71791940554444122</c:v>
                </c:pt>
                <c:pt idx="1413">
                  <c:v>0.69848528150900258</c:v>
                </c:pt>
                <c:pt idx="1414">
                  <c:v>0.70597313518148042</c:v>
                </c:pt>
                <c:pt idx="1415">
                  <c:v>0.69585595884538443</c:v>
                </c:pt>
                <c:pt idx="1416">
                  <c:v>0.72329236924835671</c:v>
                </c:pt>
                <c:pt idx="1417">
                  <c:v>0.71031723349528442</c:v>
                </c:pt>
                <c:pt idx="1418">
                  <c:v>0.71877679336953415</c:v>
                </c:pt>
                <c:pt idx="1419">
                  <c:v>0.69396970563018001</c:v>
                </c:pt>
                <c:pt idx="1420">
                  <c:v>0.71580451557587887</c:v>
                </c:pt>
                <c:pt idx="1421">
                  <c:v>0.73226636181766214</c:v>
                </c:pt>
                <c:pt idx="1422">
                  <c:v>0.70768791083166616</c:v>
                </c:pt>
                <c:pt idx="1423">
                  <c:v>0.70980280080022862</c:v>
                </c:pt>
                <c:pt idx="1424">
                  <c:v>0.73352386396113178</c:v>
                </c:pt>
                <c:pt idx="1425">
                  <c:v>0.72014861388968276</c:v>
                </c:pt>
                <c:pt idx="1426">
                  <c:v>0.69402686481851961</c:v>
                </c:pt>
                <c:pt idx="1427">
                  <c:v>0.69654186910545868</c:v>
                </c:pt>
                <c:pt idx="1428">
                  <c:v>0.69814232637896545</c:v>
                </c:pt>
                <c:pt idx="1429">
                  <c:v>0.74507002000571587</c:v>
                </c:pt>
                <c:pt idx="1430">
                  <c:v>0.71368962560731641</c:v>
                </c:pt>
                <c:pt idx="1431">
                  <c:v>0.70997427836524718</c:v>
                </c:pt>
                <c:pt idx="1432">
                  <c:v>0.71477565018576739</c:v>
                </c:pt>
                <c:pt idx="1433">
                  <c:v>0.7199771363246642</c:v>
                </c:pt>
                <c:pt idx="1434">
                  <c:v>0.7122606458988282</c:v>
                </c:pt>
                <c:pt idx="1435">
                  <c:v>0.72403543869677056</c:v>
                </c:pt>
                <c:pt idx="1436">
                  <c:v>0.72803658188053733</c:v>
                </c:pt>
                <c:pt idx="1437">
                  <c:v>0.68859674192626463</c:v>
                </c:pt>
                <c:pt idx="1438">
                  <c:v>0.70643040868819662</c:v>
                </c:pt>
                <c:pt idx="1439">
                  <c:v>0.72134895684481282</c:v>
                </c:pt>
                <c:pt idx="1440">
                  <c:v>0.71574735638753928</c:v>
                </c:pt>
                <c:pt idx="1441">
                  <c:v>0.70111460417262073</c:v>
                </c:pt>
                <c:pt idx="1442">
                  <c:v>0.69225492997999427</c:v>
                </c:pt>
                <c:pt idx="1443">
                  <c:v>0.72060588739639897</c:v>
                </c:pt>
                <c:pt idx="1444">
                  <c:v>0.7209488425264361</c:v>
                </c:pt>
                <c:pt idx="1445">
                  <c:v>0.7079737067733638</c:v>
                </c:pt>
                <c:pt idx="1446">
                  <c:v>0.71671906258931128</c:v>
                </c:pt>
                <c:pt idx="1447">
                  <c:v>0.72317805087167764</c:v>
                </c:pt>
                <c:pt idx="1448">
                  <c:v>0.71654758502429261</c:v>
                </c:pt>
                <c:pt idx="1449">
                  <c:v>0.70202915118605314</c:v>
                </c:pt>
                <c:pt idx="1450">
                  <c:v>0.70963132323521005</c:v>
                </c:pt>
                <c:pt idx="1451">
                  <c:v>0.7199771363246642</c:v>
                </c:pt>
                <c:pt idx="1452">
                  <c:v>0.72432123463846809</c:v>
                </c:pt>
                <c:pt idx="1453">
                  <c:v>0.712775078593884</c:v>
                </c:pt>
                <c:pt idx="1454">
                  <c:v>0.7276364675621606</c:v>
                </c:pt>
                <c:pt idx="1455">
                  <c:v>0.70803086596170339</c:v>
                </c:pt>
                <c:pt idx="1456">
                  <c:v>0.71448985424406974</c:v>
                </c:pt>
                <c:pt idx="1457">
                  <c:v>0.74181194627036295</c:v>
                </c:pt>
                <c:pt idx="1458">
                  <c:v>0.7214061160331523</c:v>
                </c:pt>
                <c:pt idx="1459">
                  <c:v>0.71786224635610174</c:v>
                </c:pt>
                <c:pt idx="1460">
                  <c:v>0.72443555301514717</c:v>
                </c:pt>
                <c:pt idx="1461">
                  <c:v>0.73272363532437834</c:v>
                </c:pt>
                <c:pt idx="1462">
                  <c:v>0.73095170048585312</c:v>
                </c:pt>
                <c:pt idx="1463">
                  <c:v>0.73135181480422973</c:v>
                </c:pt>
                <c:pt idx="1464">
                  <c:v>0.7502715061446128</c:v>
                </c:pt>
                <c:pt idx="1465">
                  <c:v>0.72152043440983138</c:v>
                </c:pt>
                <c:pt idx="1466">
                  <c:v>0.74764218348099454</c:v>
                </c:pt>
                <c:pt idx="1467">
                  <c:v>0.73260931694769937</c:v>
                </c:pt>
                <c:pt idx="1468">
                  <c:v>0.72374964275507292</c:v>
                </c:pt>
                <c:pt idx="1469">
                  <c:v>0.72186338953986851</c:v>
                </c:pt>
                <c:pt idx="1470">
                  <c:v>0.72483566733352389</c:v>
                </c:pt>
                <c:pt idx="1471">
                  <c:v>0.72557873678193774</c:v>
                </c:pt>
                <c:pt idx="1472">
                  <c:v>0.70963132323521005</c:v>
                </c:pt>
                <c:pt idx="1473">
                  <c:v>0.72637896541869107</c:v>
                </c:pt>
                <c:pt idx="1474">
                  <c:v>0.72249214061160327</c:v>
                </c:pt>
                <c:pt idx="1475">
                  <c:v>0.7238068019434124</c:v>
                </c:pt>
                <c:pt idx="1476">
                  <c:v>0.74038296656187486</c:v>
                </c:pt>
                <c:pt idx="1477">
                  <c:v>0.71346098885395826</c:v>
                </c:pt>
                <c:pt idx="1478">
                  <c:v>0.7180908831094599</c:v>
                </c:pt>
                <c:pt idx="1479">
                  <c:v>0.72712203486710492</c:v>
                </c:pt>
                <c:pt idx="1480">
                  <c:v>0.70980280080022862</c:v>
                </c:pt>
                <c:pt idx="1481">
                  <c:v>0.72437839382680769</c:v>
                </c:pt>
                <c:pt idx="1482">
                  <c:v>0.72249214061160327</c:v>
                </c:pt>
                <c:pt idx="1483">
                  <c:v>0.71911974849957128</c:v>
                </c:pt>
                <c:pt idx="1484">
                  <c:v>0.71300371534724205</c:v>
                </c:pt>
                <c:pt idx="1485">
                  <c:v>0.72620748785367251</c:v>
                </c:pt>
                <c:pt idx="1486">
                  <c:v>0.72540725921691906</c:v>
                </c:pt>
                <c:pt idx="1487">
                  <c:v>0.71849099742783651</c:v>
                </c:pt>
                <c:pt idx="1488">
                  <c:v>0.71660474421263221</c:v>
                </c:pt>
                <c:pt idx="1489">
                  <c:v>0.7099171191769077</c:v>
                </c:pt>
                <c:pt idx="1490">
                  <c:v>0.72112032009145466</c:v>
                </c:pt>
                <c:pt idx="1491">
                  <c:v>0.71077450700200062</c:v>
                </c:pt>
                <c:pt idx="1492">
                  <c:v>0.712775078593884</c:v>
                </c:pt>
                <c:pt idx="1493">
                  <c:v>0.74775650185767362</c:v>
                </c:pt>
                <c:pt idx="1494">
                  <c:v>0.71340382966561877</c:v>
                </c:pt>
                <c:pt idx="1495">
                  <c:v>0.72066304658473845</c:v>
                </c:pt>
                <c:pt idx="1496">
                  <c:v>0.73272363532437834</c:v>
                </c:pt>
                <c:pt idx="1497">
                  <c:v>0.72386396113175189</c:v>
                </c:pt>
                <c:pt idx="1498">
                  <c:v>0.72489282652186338</c:v>
                </c:pt>
                <c:pt idx="1499">
                  <c:v>0.73398113746784799</c:v>
                </c:pt>
                <c:pt idx="1500">
                  <c:v>0.71814804229779938</c:v>
                </c:pt>
                <c:pt idx="1501">
                  <c:v>0.73969705630180049</c:v>
                </c:pt>
                <c:pt idx="1502">
                  <c:v>0.73906830523006573</c:v>
                </c:pt>
                <c:pt idx="1503">
                  <c:v>0.73552443555301517</c:v>
                </c:pt>
                <c:pt idx="1504">
                  <c:v>0.72232066304658471</c:v>
                </c:pt>
                <c:pt idx="1505">
                  <c:v>0.7348385252929408</c:v>
                </c:pt>
                <c:pt idx="1506">
                  <c:v>0.71351814804229785</c:v>
                </c:pt>
                <c:pt idx="1507">
                  <c:v>0.72209202629322666</c:v>
                </c:pt>
                <c:pt idx="1508">
                  <c:v>0.72363532437839384</c:v>
                </c:pt>
                <c:pt idx="1509">
                  <c:v>0.72855101457559301</c:v>
                </c:pt>
                <c:pt idx="1510">
                  <c:v>0.71969134038296656</c:v>
                </c:pt>
                <c:pt idx="1511">
                  <c:v>0.72643612460703055</c:v>
                </c:pt>
                <c:pt idx="1512">
                  <c:v>0.70482995141468996</c:v>
                </c:pt>
                <c:pt idx="1513">
                  <c:v>0.7252357816519005</c:v>
                </c:pt>
                <c:pt idx="1514">
                  <c:v>0.69465561589025437</c:v>
                </c:pt>
                <c:pt idx="1515">
                  <c:v>0.71969134038296656</c:v>
                </c:pt>
                <c:pt idx="1516">
                  <c:v>0.72220634466990574</c:v>
                </c:pt>
                <c:pt idx="1517">
                  <c:v>0.72186338953986851</c:v>
                </c:pt>
                <c:pt idx="1518">
                  <c:v>0.71237496427550728</c:v>
                </c:pt>
                <c:pt idx="1519">
                  <c:v>0.71529008288082307</c:v>
                </c:pt>
                <c:pt idx="1520">
                  <c:v>0.70448699628465272</c:v>
                </c:pt>
                <c:pt idx="1521">
                  <c:v>0.73083738210917404</c:v>
                </c:pt>
                <c:pt idx="1522">
                  <c:v>0.72232066304658471</c:v>
                </c:pt>
                <c:pt idx="1523">
                  <c:v>0.73238068019434122</c:v>
                </c:pt>
                <c:pt idx="1524">
                  <c:v>0.7122606458988282</c:v>
                </c:pt>
                <c:pt idx="1525">
                  <c:v>0.70471563303801088</c:v>
                </c:pt>
                <c:pt idx="1526">
                  <c:v>0.71820520148613887</c:v>
                </c:pt>
                <c:pt idx="1527">
                  <c:v>0.72946556158902542</c:v>
                </c:pt>
                <c:pt idx="1528">
                  <c:v>0.73158045155758789</c:v>
                </c:pt>
                <c:pt idx="1529">
                  <c:v>0.71294655615890257</c:v>
                </c:pt>
                <c:pt idx="1530">
                  <c:v>0.72986567590740214</c:v>
                </c:pt>
                <c:pt idx="1531">
                  <c:v>0.69945698771077447</c:v>
                </c:pt>
                <c:pt idx="1532">
                  <c:v>0.7123178050871678</c:v>
                </c:pt>
                <c:pt idx="1533">
                  <c:v>0.71786224635610174</c:v>
                </c:pt>
                <c:pt idx="1534">
                  <c:v>0.71168905401543303</c:v>
                </c:pt>
                <c:pt idx="1535">
                  <c:v>0.72197770791654758</c:v>
                </c:pt>
                <c:pt idx="1536">
                  <c:v>0.72157759359817086</c:v>
                </c:pt>
                <c:pt idx="1537">
                  <c:v>0.73243783938268081</c:v>
                </c:pt>
                <c:pt idx="1538">
                  <c:v>0.71974849957130604</c:v>
                </c:pt>
                <c:pt idx="1539">
                  <c:v>0.70597313518148042</c:v>
                </c:pt>
                <c:pt idx="1540">
                  <c:v>0.7252929408402401</c:v>
                </c:pt>
                <c:pt idx="1541">
                  <c:v>0.7286081737639325</c:v>
                </c:pt>
                <c:pt idx="1542">
                  <c:v>0.73518148042297804</c:v>
                </c:pt>
                <c:pt idx="1543">
                  <c:v>0.70025721634752791</c:v>
                </c:pt>
                <c:pt idx="1544">
                  <c:v>0.72369248356673332</c:v>
                </c:pt>
                <c:pt idx="1545">
                  <c:v>0.72826521863389537</c:v>
                </c:pt>
                <c:pt idx="1546">
                  <c:v>0.72449271220348666</c:v>
                </c:pt>
                <c:pt idx="1547">
                  <c:v>0.70157187767933693</c:v>
                </c:pt>
                <c:pt idx="1548">
                  <c:v>0.71186053158045159</c:v>
                </c:pt>
                <c:pt idx="1549">
                  <c:v>0.71677622177765077</c:v>
                </c:pt>
                <c:pt idx="1550">
                  <c:v>0.73923978279508429</c:v>
                </c:pt>
                <c:pt idx="1551">
                  <c:v>0.69808516719062585</c:v>
                </c:pt>
                <c:pt idx="1552">
                  <c:v>0.73215204344098317</c:v>
                </c:pt>
                <c:pt idx="1553">
                  <c:v>0.72586453272363527</c:v>
                </c:pt>
                <c:pt idx="1554">
                  <c:v>0.70923120891683333</c:v>
                </c:pt>
                <c:pt idx="1555">
                  <c:v>0.74655615890254357</c:v>
                </c:pt>
                <c:pt idx="1556">
                  <c:v>0.71717633609602749</c:v>
                </c:pt>
                <c:pt idx="1557">
                  <c:v>0.7271791940554444</c:v>
                </c:pt>
                <c:pt idx="1558">
                  <c:v>0.69551300371534719</c:v>
                </c:pt>
                <c:pt idx="1559">
                  <c:v>0.72089168333809661</c:v>
                </c:pt>
                <c:pt idx="1560">
                  <c:v>0.71117462132037723</c:v>
                </c:pt>
                <c:pt idx="1561">
                  <c:v>0.71934838525292943</c:v>
                </c:pt>
                <c:pt idx="1562">
                  <c:v>0.70705915975993139</c:v>
                </c:pt>
                <c:pt idx="1563">
                  <c:v>0.70094312660760216</c:v>
                </c:pt>
                <c:pt idx="1564">
                  <c:v>0.72877965132895117</c:v>
                </c:pt>
                <c:pt idx="1565">
                  <c:v>0.7238068019434124</c:v>
                </c:pt>
                <c:pt idx="1566">
                  <c:v>0.70585881680480134</c:v>
                </c:pt>
                <c:pt idx="1567">
                  <c:v>0.71929122606458984</c:v>
                </c:pt>
                <c:pt idx="1568">
                  <c:v>0.71260360102886544</c:v>
                </c:pt>
                <c:pt idx="1569">
                  <c:v>0.72432123463846809</c:v>
                </c:pt>
                <c:pt idx="1570">
                  <c:v>0.71426121749071159</c:v>
                </c:pt>
                <c:pt idx="1571">
                  <c:v>0.71780508716776226</c:v>
                </c:pt>
                <c:pt idx="1572">
                  <c:v>0.70282937982280647</c:v>
                </c:pt>
                <c:pt idx="1573">
                  <c:v>0.69711346098885396</c:v>
                </c:pt>
                <c:pt idx="1574">
                  <c:v>0.72266361817662195</c:v>
                </c:pt>
                <c:pt idx="1575">
                  <c:v>0.69865675907402114</c:v>
                </c:pt>
                <c:pt idx="1576">
                  <c:v>0.70117176336096032</c:v>
                </c:pt>
                <c:pt idx="1577">
                  <c:v>0.70328665332952267</c:v>
                </c:pt>
                <c:pt idx="1578">
                  <c:v>0.71900543012289231</c:v>
                </c:pt>
                <c:pt idx="1579">
                  <c:v>0.70843098028008</c:v>
                </c:pt>
                <c:pt idx="1580">
                  <c:v>0.72112032009145466</c:v>
                </c:pt>
                <c:pt idx="1581">
                  <c:v>0.71214632752214924</c:v>
                </c:pt>
                <c:pt idx="1582">
                  <c:v>0.72563589597027722</c:v>
                </c:pt>
                <c:pt idx="1583">
                  <c:v>0.71237496427550728</c:v>
                </c:pt>
                <c:pt idx="1584">
                  <c:v>0.7214061160331523</c:v>
                </c:pt>
                <c:pt idx="1585">
                  <c:v>0.70768791083166616</c:v>
                </c:pt>
                <c:pt idx="1586">
                  <c:v>0.71414689911403262</c:v>
                </c:pt>
                <c:pt idx="1587">
                  <c:v>0.70780222920834523</c:v>
                </c:pt>
                <c:pt idx="1588">
                  <c:v>0.72260645898828235</c:v>
                </c:pt>
                <c:pt idx="1589">
                  <c:v>0.71031723349528442</c:v>
                </c:pt>
                <c:pt idx="1590">
                  <c:v>0.72409259788511005</c:v>
                </c:pt>
                <c:pt idx="1591">
                  <c:v>0.71220348671048872</c:v>
                </c:pt>
                <c:pt idx="1592">
                  <c:v>0.72352100600171476</c:v>
                </c:pt>
                <c:pt idx="1593">
                  <c:v>0.70202915118605314</c:v>
                </c:pt>
                <c:pt idx="1594">
                  <c:v>0.7156330380108602</c:v>
                </c:pt>
                <c:pt idx="1595">
                  <c:v>0.72517862246356102</c:v>
                </c:pt>
                <c:pt idx="1596">
                  <c:v>0.7295798799657045</c:v>
                </c:pt>
                <c:pt idx="1597">
                  <c:v>0.71929122606458984</c:v>
                </c:pt>
                <c:pt idx="1598">
                  <c:v>0.7257502143469563</c:v>
                </c:pt>
                <c:pt idx="1599">
                  <c:v>0.71683338096599025</c:v>
                </c:pt>
                <c:pt idx="1600">
                  <c:v>0.72352100600171476</c:v>
                </c:pt>
                <c:pt idx="1601">
                  <c:v>0.7199771363246642</c:v>
                </c:pt>
                <c:pt idx="1602">
                  <c:v>0.71071734781366103</c:v>
                </c:pt>
                <c:pt idx="1603">
                  <c:v>0.7247785081451843</c:v>
                </c:pt>
                <c:pt idx="1604">
                  <c:v>0.70014289797084883</c:v>
                </c:pt>
                <c:pt idx="1605">
                  <c:v>0.7271791940554444</c:v>
                </c:pt>
                <c:pt idx="1606">
                  <c:v>0.74226921977707916</c:v>
                </c:pt>
                <c:pt idx="1607">
                  <c:v>0.7391826236067448</c:v>
                </c:pt>
                <c:pt idx="1608">
                  <c:v>0.71448985424406974</c:v>
                </c:pt>
                <c:pt idx="1609">
                  <c:v>0.71620462989425548</c:v>
                </c:pt>
                <c:pt idx="1610">
                  <c:v>0.73901114604172624</c:v>
                </c:pt>
                <c:pt idx="1611">
                  <c:v>0.72757930837382112</c:v>
                </c:pt>
                <c:pt idx="1612">
                  <c:v>0.70751643326664759</c:v>
                </c:pt>
                <c:pt idx="1613">
                  <c:v>0.7185481566161761</c:v>
                </c:pt>
                <c:pt idx="1614">
                  <c:v>0.70757359245498719</c:v>
                </c:pt>
                <c:pt idx="1615">
                  <c:v>0.69928551014575591</c:v>
                </c:pt>
                <c:pt idx="1616">
                  <c:v>0.7027150614461275</c:v>
                </c:pt>
                <c:pt idx="1617">
                  <c:v>0.72677907973706768</c:v>
                </c:pt>
                <c:pt idx="1618">
                  <c:v>0.73220920262932265</c:v>
                </c:pt>
                <c:pt idx="1619">
                  <c:v>0.70808802515004288</c:v>
                </c:pt>
                <c:pt idx="1620">
                  <c:v>0.70402972277793652</c:v>
                </c:pt>
                <c:pt idx="1621">
                  <c:v>0.70082880823092308</c:v>
                </c:pt>
                <c:pt idx="1622">
                  <c:v>0.71889111174621323</c:v>
                </c:pt>
                <c:pt idx="1623">
                  <c:v>0.71546156044584164</c:v>
                </c:pt>
                <c:pt idx="1624">
                  <c:v>0.71889111174621323</c:v>
                </c:pt>
                <c:pt idx="1625">
                  <c:v>0.71849099742783651</c:v>
                </c:pt>
                <c:pt idx="1626">
                  <c:v>0.70814518433838236</c:v>
                </c:pt>
                <c:pt idx="1627">
                  <c:v>0.72049156901971989</c:v>
                </c:pt>
                <c:pt idx="1628">
                  <c:v>0.68739639897113458</c:v>
                </c:pt>
                <c:pt idx="1629">
                  <c:v>0.70191483280937406</c:v>
                </c:pt>
                <c:pt idx="1630">
                  <c:v>0.72832237782223497</c:v>
                </c:pt>
                <c:pt idx="1631">
                  <c:v>0.71923406687625036</c:v>
                </c:pt>
                <c:pt idx="1632">
                  <c:v>0.70128608173763929</c:v>
                </c:pt>
                <c:pt idx="1633">
                  <c:v>0.71031723349528442</c:v>
                </c:pt>
                <c:pt idx="1634">
                  <c:v>0.71443269505573026</c:v>
                </c:pt>
                <c:pt idx="1635">
                  <c:v>0.74078308088025147</c:v>
                </c:pt>
                <c:pt idx="1636">
                  <c:v>0.68939697056301796</c:v>
                </c:pt>
                <c:pt idx="1637">
                  <c:v>0.71900543012289231</c:v>
                </c:pt>
                <c:pt idx="1638">
                  <c:v>0.71443269505573026</c:v>
                </c:pt>
                <c:pt idx="1639">
                  <c:v>0.72312089168333815</c:v>
                </c:pt>
                <c:pt idx="1640">
                  <c:v>0.69728493855387252</c:v>
                </c:pt>
                <c:pt idx="1641">
                  <c:v>0.71014575593026574</c:v>
                </c:pt>
                <c:pt idx="1642">
                  <c:v>0.73163761074592737</c:v>
                </c:pt>
                <c:pt idx="1643">
                  <c:v>0.70951700485853098</c:v>
                </c:pt>
                <c:pt idx="1644">
                  <c:v>0.70442983709631324</c:v>
                </c:pt>
                <c:pt idx="1645">
                  <c:v>0.71203200914547016</c:v>
                </c:pt>
                <c:pt idx="1646">
                  <c:v>0.71111746213203775</c:v>
                </c:pt>
                <c:pt idx="1647">
                  <c:v>0.71871963418119467</c:v>
                </c:pt>
                <c:pt idx="1648">
                  <c:v>0.70888825378679621</c:v>
                </c:pt>
                <c:pt idx="1649">
                  <c:v>0.72466418976850533</c:v>
                </c:pt>
                <c:pt idx="1650">
                  <c:v>0.70145755930265785</c:v>
                </c:pt>
                <c:pt idx="1651">
                  <c:v>0.71083166619034011</c:v>
                </c:pt>
                <c:pt idx="1652">
                  <c:v>0.70494426979136893</c:v>
                </c:pt>
                <c:pt idx="1653">
                  <c:v>0.69425550157187765</c:v>
                </c:pt>
                <c:pt idx="1654">
                  <c:v>0.69299799942840812</c:v>
                </c:pt>
                <c:pt idx="1655">
                  <c:v>0.72317805087167764</c:v>
                </c:pt>
                <c:pt idx="1656">
                  <c:v>0.70042869391254647</c:v>
                </c:pt>
                <c:pt idx="1657">
                  <c:v>0.70162903686767653</c:v>
                </c:pt>
                <c:pt idx="1658">
                  <c:v>0.71048871106030298</c:v>
                </c:pt>
                <c:pt idx="1659">
                  <c:v>0.70597313518148042</c:v>
                </c:pt>
                <c:pt idx="1660">
                  <c:v>0.69494141183195202</c:v>
                </c:pt>
                <c:pt idx="1661">
                  <c:v>0.72506430408688194</c:v>
                </c:pt>
                <c:pt idx="1662">
                  <c:v>0.71929122606458984</c:v>
                </c:pt>
                <c:pt idx="1663">
                  <c:v>0.7214061160331523</c:v>
                </c:pt>
                <c:pt idx="1664">
                  <c:v>0.7185481566161761</c:v>
                </c:pt>
                <c:pt idx="1665">
                  <c:v>0.68425264361246074</c:v>
                </c:pt>
                <c:pt idx="1666">
                  <c:v>0.71157473563875395</c:v>
                </c:pt>
                <c:pt idx="1667">
                  <c:v>0.71660474421263221</c:v>
                </c:pt>
                <c:pt idx="1668">
                  <c:v>0.70671620462989426</c:v>
                </c:pt>
                <c:pt idx="1669">
                  <c:v>0.71134609888539579</c:v>
                </c:pt>
                <c:pt idx="1670">
                  <c:v>0.71883395255787363</c:v>
                </c:pt>
                <c:pt idx="1671">
                  <c:v>0.69276936267504996</c:v>
                </c:pt>
                <c:pt idx="1672">
                  <c:v>0.7026579022577879</c:v>
                </c:pt>
                <c:pt idx="1673">
                  <c:v>0.68179479851386116</c:v>
                </c:pt>
                <c:pt idx="1674">
                  <c:v>0.69819948556730493</c:v>
                </c:pt>
                <c:pt idx="1675">
                  <c:v>0.70688768219491283</c:v>
                </c:pt>
                <c:pt idx="1676">
                  <c:v>0.70425835953129468</c:v>
                </c:pt>
                <c:pt idx="1677">
                  <c:v>0.68070877393541007</c:v>
                </c:pt>
                <c:pt idx="1678">
                  <c:v>0.69597027722206339</c:v>
                </c:pt>
                <c:pt idx="1679">
                  <c:v>0.71340382966561877</c:v>
                </c:pt>
                <c:pt idx="1680">
                  <c:v>0.71014575593026574</c:v>
                </c:pt>
                <c:pt idx="1681">
                  <c:v>0.71088882537867959</c:v>
                </c:pt>
                <c:pt idx="1682">
                  <c:v>0.70328665332952267</c:v>
                </c:pt>
                <c:pt idx="1683">
                  <c:v>0.70328665332952267</c:v>
                </c:pt>
                <c:pt idx="1684">
                  <c:v>0.70911689054015437</c:v>
                </c:pt>
                <c:pt idx="1685">
                  <c:v>0.70660188625321518</c:v>
                </c:pt>
                <c:pt idx="1686">
                  <c:v>0.70420120034295508</c:v>
                </c:pt>
                <c:pt idx="1687">
                  <c:v>0.69345527293512432</c:v>
                </c:pt>
                <c:pt idx="1688">
                  <c:v>0.72260645898828235</c:v>
                </c:pt>
                <c:pt idx="1689">
                  <c:v>0.69374106887682196</c:v>
                </c:pt>
                <c:pt idx="1690">
                  <c:v>0.7041440411546156</c:v>
                </c:pt>
                <c:pt idx="1691">
                  <c:v>0.69282652186338956</c:v>
                </c:pt>
                <c:pt idx="1692">
                  <c:v>0.6954558445270077</c:v>
                </c:pt>
                <c:pt idx="1693">
                  <c:v>0.70031437553586739</c:v>
                </c:pt>
                <c:pt idx="1694">
                  <c:v>0.69974278365247211</c:v>
                </c:pt>
                <c:pt idx="1695">
                  <c:v>0.70465847384967129</c:v>
                </c:pt>
                <c:pt idx="1696">
                  <c:v>0.69945698771077447</c:v>
                </c:pt>
                <c:pt idx="1697">
                  <c:v>0.69751357530723068</c:v>
                </c:pt>
                <c:pt idx="1698">
                  <c:v>0.70517290654472708</c:v>
                </c:pt>
                <c:pt idx="1699">
                  <c:v>0.6916261789082595</c:v>
                </c:pt>
                <c:pt idx="1700">
                  <c:v>0.7041440411546156</c:v>
                </c:pt>
                <c:pt idx="1701">
                  <c:v>0.69894255501571878</c:v>
                </c:pt>
                <c:pt idx="1702">
                  <c:v>0.70482995141468996</c:v>
                </c:pt>
                <c:pt idx="1703">
                  <c:v>0.70174335524435549</c:v>
                </c:pt>
                <c:pt idx="1704">
                  <c:v>0.69985710202915119</c:v>
                </c:pt>
                <c:pt idx="1705">
                  <c:v>0.69865675907402114</c:v>
                </c:pt>
                <c:pt idx="1706">
                  <c:v>0.72900828808230922</c:v>
                </c:pt>
                <c:pt idx="1707">
                  <c:v>0.70157187767933693</c:v>
                </c:pt>
                <c:pt idx="1708">
                  <c:v>0.71008859674192626</c:v>
                </c:pt>
                <c:pt idx="1709">
                  <c:v>0.70105744498428124</c:v>
                </c:pt>
                <c:pt idx="1710">
                  <c:v>0.69334095455844524</c:v>
                </c:pt>
                <c:pt idx="1711">
                  <c:v>0.69339811374678484</c:v>
                </c:pt>
                <c:pt idx="1712">
                  <c:v>0.69745641611889109</c:v>
                </c:pt>
                <c:pt idx="1713">
                  <c:v>0.7041440411546156</c:v>
                </c:pt>
                <c:pt idx="1714">
                  <c:v>0.69745641611889109</c:v>
                </c:pt>
                <c:pt idx="1715">
                  <c:v>0.69179765647327807</c:v>
                </c:pt>
                <c:pt idx="1716">
                  <c:v>0.68631037439268361</c:v>
                </c:pt>
                <c:pt idx="1717">
                  <c:v>0.69014004001143181</c:v>
                </c:pt>
                <c:pt idx="1718">
                  <c:v>0.7079737067733638</c:v>
                </c:pt>
                <c:pt idx="1719">
                  <c:v>0.7041440411546156</c:v>
                </c:pt>
                <c:pt idx="1720">
                  <c:v>0.70117176336096032</c:v>
                </c:pt>
                <c:pt idx="1721">
                  <c:v>0.68768219491283222</c:v>
                </c:pt>
                <c:pt idx="1722">
                  <c:v>0.70197199199771365</c:v>
                </c:pt>
                <c:pt idx="1723">
                  <c:v>0.70557302086310369</c:v>
                </c:pt>
                <c:pt idx="1724">
                  <c:v>0.7180908831094599</c:v>
                </c:pt>
                <c:pt idx="1725">
                  <c:v>0.69562732209202627</c:v>
                </c:pt>
                <c:pt idx="1726">
                  <c:v>0.70060017147756504</c:v>
                </c:pt>
                <c:pt idx="1727">
                  <c:v>0.70340097170620175</c:v>
                </c:pt>
                <c:pt idx="1728">
                  <c:v>0.70345813089454134</c:v>
                </c:pt>
                <c:pt idx="1729">
                  <c:v>0.69065447270648761</c:v>
                </c:pt>
                <c:pt idx="1730">
                  <c:v>0.69488425264361242</c:v>
                </c:pt>
                <c:pt idx="1731">
                  <c:v>0.71591883395255784</c:v>
                </c:pt>
                <c:pt idx="1732">
                  <c:v>0.70534438410974565</c:v>
                </c:pt>
                <c:pt idx="1733">
                  <c:v>0.70854529865675908</c:v>
                </c:pt>
                <c:pt idx="1734">
                  <c:v>0.6820234352672192</c:v>
                </c:pt>
                <c:pt idx="1735">
                  <c:v>0.70871677622177764</c:v>
                </c:pt>
                <c:pt idx="1736">
                  <c:v>0.70688768219491283</c:v>
                </c:pt>
                <c:pt idx="1737">
                  <c:v>0.70631609031151754</c:v>
                </c:pt>
                <c:pt idx="1738">
                  <c:v>0.70528722492140616</c:v>
                </c:pt>
                <c:pt idx="1739">
                  <c:v>0.69774221206058873</c:v>
                </c:pt>
                <c:pt idx="1740">
                  <c:v>0.72552157759359814</c:v>
                </c:pt>
                <c:pt idx="1741">
                  <c:v>0.70671620462989426</c:v>
                </c:pt>
                <c:pt idx="1742">
                  <c:v>0.70128608173763929</c:v>
                </c:pt>
                <c:pt idx="1743">
                  <c:v>0.70162903686767653</c:v>
                </c:pt>
                <c:pt idx="1744">
                  <c:v>0.68019434124035438</c:v>
                </c:pt>
                <c:pt idx="1745">
                  <c:v>0.71717633609602749</c:v>
                </c:pt>
                <c:pt idx="1746">
                  <c:v>0.72775078593883968</c:v>
                </c:pt>
                <c:pt idx="1747">
                  <c:v>0.70688768219491283</c:v>
                </c:pt>
                <c:pt idx="1748">
                  <c:v>0.73186624749928553</c:v>
                </c:pt>
                <c:pt idx="1749">
                  <c:v>0.69625607316376104</c:v>
                </c:pt>
                <c:pt idx="1750">
                  <c:v>0.70340097170620175</c:v>
                </c:pt>
                <c:pt idx="1751">
                  <c:v>0.7064875678765361</c:v>
                </c:pt>
                <c:pt idx="1752">
                  <c:v>0.7175764504144041</c:v>
                </c:pt>
                <c:pt idx="1753">
                  <c:v>0.72294941411831948</c:v>
                </c:pt>
                <c:pt idx="1754">
                  <c:v>0.71048871106030298</c:v>
                </c:pt>
                <c:pt idx="1755">
                  <c:v>0.71008859674192626</c:v>
                </c:pt>
                <c:pt idx="1756">
                  <c:v>0.71157473563875395</c:v>
                </c:pt>
                <c:pt idx="1757">
                  <c:v>0.69345527293512432</c:v>
                </c:pt>
                <c:pt idx="1758">
                  <c:v>0.71443269505573026</c:v>
                </c:pt>
                <c:pt idx="1759">
                  <c:v>0.70231494712775078</c:v>
                </c:pt>
                <c:pt idx="1760">
                  <c:v>0.70191483280937406</c:v>
                </c:pt>
                <c:pt idx="1761">
                  <c:v>0.70860245784509857</c:v>
                </c:pt>
                <c:pt idx="1762">
                  <c:v>0.70231494712775078</c:v>
                </c:pt>
                <c:pt idx="1763">
                  <c:v>0.69288368105172904</c:v>
                </c:pt>
                <c:pt idx="1764">
                  <c:v>0.70945984567019149</c:v>
                </c:pt>
                <c:pt idx="1765">
                  <c:v>0.7329522720777365</c:v>
                </c:pt>
                <c:pt idx="1766">
                  <c:v>0.71586167476421836</c:v>
                </c:pt>
                <c:pt idx="1767">
                  <c:v>0.68933981137467848</c:v>
                </c:pt>
                <c:pt idx="1768">
                  <c:v>0.68619605601600453</c:v>
                </c:pt>
                <c:pt idx="1769">
                  <c:v>0.6911689054015433</c:v>
                </c:pt>
                <c:pt idx="1770">
                  <c:v>0.70854529865675908</c:v>
                </c:pt>
                <c:pt idx="1771">
                  <c:v>0.70763075164332667</c:v>
                </c:pt>
                <c:pt idx="1772">
                  <c:v>0.70094312660760216</c:v>
                </c:pt>
                <c:pt idx="1773">
                  <c:v>0.69179765647327807</c:v>
                </c:pt>
                <c:pt idx="1774">
                  <c:v>0.67927979422692197</c:v>
                </c:pt>
                <c:pt idx="1775">
                  <c:v>0.69922835095741642</c:v>
                </c:pt>
                <c:pt idx="1776">
                  <c:v>0.71751929122606461</c:v>
                </c:pt>
                <c:pt idx="1777">
                  <c:v>0.69991426121749067</c:v>
                </c:pt>
                <c:pt idx="1778">
                  <c:v>0.70254358388110894</c:v>
                </c:pt>
                <c:pt idx="1779">
                  <c:v>0.69225492997999427</c:v>
                </c:pt>
                <c:pt idx="1780">
                  <c:v>0.70305801657616462</c:v>
                </c:pt>
                <c:pt idx="1781">
                  <c:v>0.71454701343240923</c:v>
                </c:pt>
                <c:pt idx="1782">
                  <c:v>0.69248356673335243</c:v>
                </c:pt>
                <c:pt idx="1783">
                  <c:v>0.68430980280080023</c:v>
                </c:pt>
                <c:pt idx="1784">
                  <c:v>0.68842526436124607</c:v>
                </c:pt>
                <c:pt idx="1785">
                  <c:v>0.69099742783652474</c:v>
                </c:pt>
                <c:pt idx="1786">
                  <c:v>0.70322949414118319</c:v>
                </c:pt>
                <c:pt idx="1787">
                  <c:v>0.71860531580451559</c:v>
                </c:pt>
                <c:pt idx="1788">
                  <c:v>0.69654186910545868</c:v>
                </c:pt>
                <c:pt idx="1789">
                  <c:v>0.70763075164332667</c:v>
                </c:pt>
                <c:pt idx="1790">
                  <c:v>0.69139754215490135</c:v>
                </c:pt>
                <c:pt idx="1791">
                  <c:v>0.66939125464418403</c:v>
                </c:pt>
                <c:pt idx="1792">
                  <c:v>0.69236924835667335</c:v>
                </c:pt>
                <c:pt idx="1793">
                  <c:v>0.69631323235210063</c:v>
                </c:pt>
                <c:pt idx="1794">
                  <c:v>0.69974278365247211</c:v>
                </c:pt>
                <c:pt idx="1795">
                  <c:v>0.68716776221777653</c:v>
                </c:pt>
                <c:pt idx="1796">
                  <c:v>0.70311517576450411</c:v>
                </c:pt>
                <c:pt idx="1797">
                  <c:v>0.69242640754501283</c:v>
                </c:pt>
                <c:pt idx="1798">
                  <c:v>0.69328379537010576</c:v>
                </c:pt>
                <c:pt idx="1799">
                  <c:v>0.69391254644184053</c:v>
                </c:pt>
                <c:pt idx="1800">
                  <c:v>0.70717347813661047</c:v>
                </c:pt>
                <c:pt idx="1801">
                  <c:v>0.68282366390397253</c:v>
                </c:pt>
                <c:pt idx="1802">
                  <c:v>0.70322949414118319</c:v>
                </c:pt>
                <c:pt idx="1803">
                  <c:v>0.68853958273792515</c:v>
                </c:pt>
                <c:pt idx="1804">
                  <c:v>0.70488711060302944</c:v>
                </c:pt>
                <c:pt idx="1805">
                  <c:v>0.69151186053158042</c:v>
                </c:pt>
                <c:pt idx="1806">
                  <c:v>0.66624749928551019</c:v>
                </c:pt>
                <c:pt idx="1807">
                  <c:v>0.69671334667047724</c:v>
                </c:pt>
                <c:pt idx="1808">
                  <c:v>0.6916261789082595</c:v>
                </c:pt>
                <c:pt idx="1809">
                  <c:v>0.66961989139754219</c:v>
                </c:pt>
                <c:pt idx="1810">
                  <c:v>0.68551014575593028</c:v>
                </c:pt>
                <c:pt idx="1811">
                  <c:v>0.67396398971134608</c:v>
                </c:pt>
                <c:pt idx="1812">
                  <c:v>0.69671334667047724</c:v>
                </c:pt>
                <c:pt idx="1813">
                  <c:v>0.67887967990854525</c:v>
                </c:pt>
                <c:pt idx="1814">
                  <c:v>0.68196627607887972</c:v>
                </c:pt>
                <c:pt idx="1815">
                  <c:v>0.69591311803372391</c:v>
                </c:pt>
                <c:pt idx="1816">
                  <c:v>0.6839668476707631</c:v>
                </c:pt>
                <c:pt idx="1817">
                  <c:v>0.69282652186338956</c:v>
                </c:pt>
                <c:pt idx="1818">
                  <c:v>0.68070877393541007</c:v>
                </c:pt>
                <c:pt idx="1819">
                  <c:v>0.70768791083166616</c:v>
                </c:pt>
                <c:pt idx="1820">
                  <c:v>0.70585881680480134</c:v>
                </c:pt>
                <c:pt idx="1821">
                  <c:v>0.69734209774221201</c:v>
                </c:pt>
                <c:pt idx="1822">
                  <c:v>0.69094026864818514</c:v>
                </c:pt>
                <c:pt idx="1823">
                  <c:v>0.6820234352672192</c:v>
                </c:pt>
                <c:pt idx="1824">
                  <c:v>0.68528150900257212</c:v>
                </c:pt>
                <c:pt idx="1825">
                  <c:v>0.67367819376964844</c:v>
                </c:pt>
                <c:pt idx="1826">
                  <c:v>0.69819948556730493</c:v>
                </c:pt>
                <c:pt idx="1827">
                  <c:v>0.66893398113746783</c:v>
                </c:pt>
                <c:pt idx="1828">
                  <c:v>0.65835953129465563</c:v>
                </c:pt>
                <c:pt idx="1829">
                  <c:v>0.66659045441554732</c:v>
                </c:pt>
                <c:pt idx="1830">
                  <c:v>0.68259502715061449</c:v>
                </c:pt>
                <c:pt idx="1831">
                  <c:v>0.68773935410117182</c:v>
                </c:pt>
                <c:pt idx="1832">
                  <c:v>0.69265504429837099</c:v>
                </c:pt>
                <c:pt idx="1833">
                  <c:v>0.68939697056301796</c:v>
                </c:pt>
                <c:pt idx="1834">
                  <c:v>0.68493855387253499</c:v>
                </c:pt>
                <c:pt idx="1835">
                  <c:v>0.69362675050014289</c:v>
                </c:pt>
                <c:pt idx="1836">
                  <c:v>0.67905115747356393</c:v>
                </c:pt>
                <c:pt idx="1837">
                  <c:v>0.69065447270648761</c:v>
                </c:pt>
                <c:pt idx="1838">
                  <c:v>0.6777364961417548</c:v>
                </c:pt>
                <c:pt idx="1839">
                  <c:v>0.69585595884538443</c:v>
                </c:pt>
                <c:pt idx="1840">
                  <c:v>0.67590740211488998</c:v>
                </c:pt>
                <c:pt idx="1841">
                  <c:v>0.68768219491283222</c:v>
                </c:pt>
                <c:pt idx="1842">
                  <c:v>0.69196913403829663</c:v>
                </c:pt>
                <c:pt idx="1843">
                  <c:v>0.6887682194912832</c:v>
                </c:pt>
                <c:pt idx="1844">
                  <c:v>0.70168619605601601</c:v>
                </c:pt>
                <c:pt idx="1845">
                  <c:v>0.68230923120891684</c:v>
                </c:pt>
                <c:pt idx="1846">
                  <c:v>0.67905115747356393</c:v>
                </c:pt>
                <c:pt idx="1847">
                  <c:v>0.69562732209202627</c:v>
                </c:pt>
                <c:pt idx="1848">
                  <c:v>0.66916261789082598</c:v>
                </c:pt>
                <c:pt idx="1849">
                  <c:v>0.68859674192626463</c:v>
                </c:pt>
                <c:pt idx="1850">
                  <c:v>0.69042583595312945</c:v>
                </c:pt>
                <c:pt idx="1851">
                  <c:v>0.68025150042869387</c:v>
                </c:pt>
                <c:pt idx="1852">
                  <c:v>0.68093741068876823</c:v>
                </c:pt>
                <c:pt idx="1853">
                  <c:v>0.67447842240640188</c:v>
                </c:pt>
                <c:pt idx="1854">
                  <c:v>0.69276936267504996</c:v>
                </c:pt>
                <c:pt idx="1855">
                  <c:v>0.69288368105172904</c:v>
                </c:pt>
                <c:pt idx="1856">
                  <c:v>0.65984567019148332</c:v>
                </c:pt>
                <c:pt idx="1857">
                  <c:v>0.67447842240640188</c:v>
                </c:pt>
                <c:pt idx="1858">
                  <c:v>0.66830523006573306</c:v>
                </c:pt>
                <c:pt idx="1859">
                  <c:v>0.66967705058588167</c:v>
                </c:pt>
                <c:pt idx="1860">
                  <c:v>0.67653615318662474</c:v>
                </c:pt>
                <c:pt idx="1861">
                  <c:v>0.67464989997142044</c:v>
                </c:pt>
                <c:pt idx="1862">
                  <c:v>0.67750785938839664</c:v>
                </c:pt>
                <c:pt idx="1863">
                  <c:v>0.68253786796227489</c:v>
                </c:pt>
                <c:pt idx="1864">
                  <c:v>0.69202629322663622</c:v>
                </c:pt>
                <c:pt idx="1865">
                  <c:v>0.69202629322663622</c:v>
                </c:pt>
                <c:pt idx="1866">
                  <c:v>0.6835095741640469</c:v>
                </c:pt>
                <c:pt idx="1867">
                  <c:v>0.68551014575593028</c:v>
                </c:pt>
                <c:pt idx="1868">
                  <c:v>0.67870820234352669</c:v>
                </c:pt>
                <c:pt idx="1869">
                  <c:v>0.68390968848242351</c:v>
                </c:pt>
                <c:pt idx="1870">
                  <c:v>0.68145184338382392</c:v>
                </c:pt>
                <c:pt idx="1871">
                  <c:v>0.67236353243783942</c:v>
                </c:pt>
                <c:pt idx="1872">
                  <c:v>0.66207487853672475</c:v>
                </c:pt>
                <c:pt idx="1873">
                  <c:v>0.68556730494426976</c:v>
                </c:pt>
                <c:pt idx="1874">
                  <c:v>0.68282366390397253</c:v>
                </c:pt>
                <c:pt idx="1875">
                  <c:v>0.66767647899399829</c:v>
                </c:pt>
                <c:pt idx="1876">
                  <c:v>0.68796799085452986</c:v>
                </c:pt>
                <c:pt idx="1877">
                  <c:v>0.69974278365247211</c:v>
                </c:pt>
                <c:pt idx="1878">
                  <c:v>0.66401829094026865</c:v>
                </c:pt>
                <c:pt idx="1879">
                  <c:v>0.67979422692197766</c:v>
                </c:pt>
                <c:pt idx="1880">
                  <c:v>0.68065161474707059</c:v>
                </c:pt>
                <c:pt idx="1881">
                  <c:v>0.69179765647327807</c:v>
                </c:pt>
                <c:pt idx="1882">
                  <c:v>0.69282652186338956</c:v>
                </c:pt>
                <c:pt idx="1883">
                  <c:v>0.69156901971992002</c:v>
                </c:pt>
                <c:pt idx="1884">
                  <c:v>0.66230351529008291</c:v>
                </c:pt>
                <c:pt idx="1885">
                  <c:v>0.67276364675621603</c:v>
                </c:pt>
                <c:pt idx="1886">
                  <c:v>0.68802515004286935</c:v>
                </c:pt>
                <c:pt idx="1887">
                  <c:v>0.6834524149757073</c:v>
                </c:pt>
                <c:pt idx="1888">
                  <c:v>0.67933695341526146</c:v>
                </c:pt>
                <c:pt idx="1889">
                  <c:v>0.68162332094884248</c:v>
                </c:pt>
                <c:pt idx="1890">
                  <c:v>0.66961989139754219</c:v>
                </c:pt>
                <c:pt idx="1891">
                  <c:v>0.6666476136038868</c:v>
                </c:pt>
                <c:pt idx="1892">
                  <c:v>0.66121749071163194</c:v>
                </c:pt>
                <c:pt idx="1893">
                  <c:v>0.68305230065733069</c:v>
                </c:pt>
                <c:pt idx="1894">
                  <c:v>0.69608459559874247</c:v>
                </c:pt>
                <c:pt idx="1895">
                  <c:v>0.68716776221777653</c:v>
                </c:pt>
                <c:pt idx="1896">
                  <c:v>0.66196056016004567</c:v>
                </c:pt>
                <c:pt idx="1897">
                  <c:v>0.66773363818233777</c:v>
                </c:pt>
                <c:pt idx="1898">
                  <c:v>0.67493569591311808</c:v>
                </c:pt>
                <c:pt idx="1899">
                  <c:v>0.68979708488139468</c:v>
                </c:pt>
                <c:pt idx="1900">
                  <c:v>0.70631609031151754</c:v>
                </c:pt>
                <c:pt idx="1901">
                  <c:v>0.67253501000285798</c:v>
                </c:pt>
                <c:pt idx="1902">
                  <c:v>0.69396970563018001</c:v>
                </c:pt>
                <c:pt idx="1903">
                  <c:v>0.67024864246927696</c:v>
                </c:pt>
                <c:pt idx="1904">
                  <c:v>0.68482423549585592</c:v>
                </c:pt>
                <c:pt idx="1905">
                  <c:v>0.65778793941126035</c:v>
                </c:pt>
                <c:pt idx="1906">
                  <c:v>0.67522149185481561</c:v>
                </c:pt>
                <c:pt idx="1907">
                  <c:v>0.70162903686767653</c:v>
                </c:pt>
                <c:pt idx="1908">
                  <c:v>0.68659617033438125</c:v>
                </c:pt>
                <c:pt idx="1909">
                  <c:v>0.68453843955415838</c:v>
                </c:pt>
                <c:pt idx="1910">
                  <c:v>0.67682194912832239</c:v>
                </c:pt>
                <c:pt idx="1911">
                  <c:v>0.68865390111460423</c:v>
                </c:pt>
                <c:pt idx="1912">
                  <c:v>0.67607887967990854</c:v>
                </c:pt>
                <c:pt idx="1913">
                  <c:v>0.66327522149185481</c:v>
                </c:pt>
                <c:pt idx="1914">
                  <c:v>0.66430408688196629</c:v>
                </c:pt>
                <c:pt idx="1915">
                  <c:v>0.67836524721348956</c:v>
                </c:pt>
                <c:pt idx="1916">
                  <c:v>0.68019434124035438</c:v>
                </c:pt>
                <c:pt idx="1917">
                  <c:v>0.69471277507859386</c:v>
                </c:pt>
                <c:pt idx="1918">
                  <c:v>0.6949985710202915</c:v>
                </c:pt>
                <c:pt idx="1919">
                  <c:v>0.68871106030294371</c:v>
                </c:pt>
                <c:pt idx="1920">
                  <c:v>0.69048299514146894</c:v>
                </c:pt>
                <c:pt idx="1921">
                  <c:v>0.70048585310088596</c:v>
                </c:pt>
                <c:pt idx="1922">
                  <c:v>0.66687625035724496</c:v>
                </c:pt>
                <c:pt idx="1923">
                  <c:v>0.66013146613318086</c:v>
                </c:pt>
                <c:pt idx="1924">
                  <c:v>0.6613889682766505</c:v>
                </c:pt>
                <c:pt idx="1925">
                  <c:v>0.66287510717347808</c:v>
                </c:pt>
                <c:pt idx="1926">
                  <c:v>0.67642183480994567</c:v>
                </c:pt>
                <c:pt idx="1927">
                  <c:v>0.69025435838811089</c:v>
                </c:pt>
                <c:pt idx="1928">
                  <c:v>0.67402114889968567</c:v>
                </c:pt>
                <c:pt idx="1929">
                  <c:v>0.6873392397827951</c:v>
                </c:pt>
                <c:pt idx="1930">
                  <c:v>0.6796227493569591</c:v>
                </c:pt>
                <c:pt idx="1931">
                  <c:v>0.68476707630751643</c:v>
                </c:pt>
                <c:pt idx="1932">
                  <c:v>0.67510717347813665</c:v>
                </c:pt>
                <c:pt idx="1933">
                  <c:v>0.68230923120891684</c:v>
                </c:pt>
                <c:pt idx="1934">
                  <c:v>0.67847956559016864</c:v>
                </c:pt>
                <c:pt idx="1935">
                  <c:v>0.66961989139754219</c:v>
                </c:pt>
                <c:pt idx="1936">
                  <c:v>0.67322092026293223</c:v>
                </c:pt>
                <c:pt idx="1937">
                  <c:v>0.70511574735638749</c:v>
                </c:pt>
                <c:pt idx="1938">
                  <c:v>0.67756501857673623</c:v>
                </c:pt>
                <c:pt idx="1939">
                  <c:v>0.66253215204344096</c:v>
                </c:pt>
                <c:pt idx="1940">
                  <c:v>0.67739354101171767</c:v>
                </c:pt>
                <c:pt idx="1941">
                  <c:v>0.65893112317805091</c:v>
                </c:pt>
                <c:pt idx="1942">
                  <c:v>0.66327522149185481</c:v>
                </c:pt>
                <c:pt idx="1943">
                  <c:v>0.67927979422692197</c:v>
                </c:pt>
                <c:pt idx="1944">
                  <c:v>0.67836524721348956</c:v>
                </c:pt>
                <c:pt idx="1945">
                  <c:v>0.6724206916261789</c:v>
                </c:pt>
                <c:pt idx="1946">
                  <c:v>0.70768791083166616</c:v>
                </c:pt>
                <c:pt idx="1947">
                  <c:v>0.67905115747356393</c:v>
                </c:pt>
                <c:pt idx="1948">
                  <c:v>0.69368390968848237</c:v>
                </c:pt>
                <c:pt idx="1949">
                  <c:v>0.66819091168905398</c:v>
                </c:pt>
                <c:pt idx="1950">
                  <c:v>0.67276364675621603</c:v>
                </c:pt>
                <c:pt idx="1951">
                  <c:v>0.66653329522720772</c:v>
                </c:pt>
                <c:pt idx="1952">
                  <c:v>0.67853672477850813</c:v>
                </c:pt>
                <c:pt idx="1953">
                  <c:v>0.68082309231208915</c:v>
                </c:pt>
                <c:pt idx="1954">
                  <c:v>0.6887682194912832</c:v>
                </c:pt>
                <c:pt idx="1955">
                  <c:v>0.68133752500714495</c:v>
                </c:pt>
                <c:pt idx="1956">
                  <c:v>0.67893683909688485</c:v>
                </c:pt>
                <c:pt idx="1957">
                  <c:v>0.70231494712775078</c:v>
                </c:pt>
                <c:pt idx="1958">
                  <c:v>0.70534438410974565</c:v>
                </c:pt>
                <c:pt idx="1959">
                  <c:v>0.68505287224921407</c:v>
                </c:pt>
                <c:pt idx="1960">
                  <c:v>0.65738782509288363</c:v>
                </c:pt>
                <c:pt idx="1961">
                  <c:v>0.68796799085452986</c:v>
                </c:pt>
                <c:pt idx="1962">
                  <c:v>0.67344955701629039</c:v>
                </c:pt>
                <c:pt idx="1963">
                  <c:v>0.67396398971134608</c:v>
                </c:pt>
                <c:pt idx="1964">
                  <c:v>0.68813946841954843</c:v>
                </c:pt>
                <c:pt idx="1965">
                  <c:v>0.67802229208345244</c:v>
                </c:pt>
                <c:pt idx="1966">
                  <c:v>0.67870820234352669</c:v>
                </c:pt>
                <c:pt idx="1967">
                  <c:v>0.70328665332952267</c:v>
                </c:pt>
                <c:pt idx="1968">
                  <c:v>0.6805944555587311</c:v>
                </c:pt>
                <c:pt idx="1969">
                  <c:v>0.68453843955415838</c:v>
                </c:pt>
                <c:pt idx="1970">
                  <c:v>0.66750500142897973</c:v>
                </c:pt>
                <c:pt idx="1971">
                  <c:v>0.69019719919977141</c:v>
                </c:pt>
                <c:pt idx="1972">
                  <c:v>0.66481851957702198</c:v>
                </c:pt>
                <c:pt idx="1973">
                  <c:v>0.66910545870248639</c:v>
                </c:pt>
                <c:pt idx="1974">
                  <c:v>0.67253501000285798</c:v>
                </c:pt>
                <c:pt idx="1975">
                  <c:v>0.66687625035724496</c:v>
                </c:pt>
                <c:pt idx="1976">
                  <c:v>0.68951128893969704</c:v>
                </c:pt>
                <c:pt idx="1977">
                  <c:v>0.67945127179194054</c:v>
                </c:pt>
                <c:pt idx="1978">
                  <c:v>0.6988282366390397</c:v>
                </c:pt>
                <c:pt idx="1979">
                  <c:v>0.69619891397542155</c:v>
                </c:pt>
                <c:pt idx="1980">
                  <c:v>0.69425550157187765</c:v>
                </c:pt>
                <c:pt idx="1981">
                  <c:v>0.67447842240640188</c:v>
                </c:pt>
                <c:pt idx="1982">
                  <c:v>0.68002286367533582</c:v>
                </c:pt>
                <c:pt idx="1983">
                  <c:v>0.67847956559016864</c:v>
                </c:pt>
                <c:pt idx="1984">
                  <c:v>0.68836810517290659</c:v>
                </c:pt>
                <c:pt idx="1985">
                  <c:v>0.67213489568448126</c:v>
                </c:pt>
                <c:pt idx="1986">
                  <c:v>0.67327807945127183</c:v>
                </c:pt>
                <c:pt idx="1987">
                  <c:v>0.67459274078308085</c:v>
                </c:pt>
                <c:pt idx="1988">
                  <c:v>0.69002572163475273</c:v>
                </c:pt>
                <c:pt idx="1989">
                  <c:v>0.68465275793083735</c:v>
                </c:pt>
                <c:pt idx="1990">
                  <c:v>0.6988282366390397</c:v>
                </c:pt>
                <c:pt idx="1991">
                  <c:v>0.66270362960845952</c:v>
                </c:pt>
                <c:pt idx="1992">
                  <c:v>0.68430980280080023</c:v>
                </c:pt>
                <c:pt idx="1993">
                  <c:v>0.67916547585024289</c:v>
                </c:pt>
                <c:pt idx="1994">
                  <c:v>0.68310945984567017</c:v>
                </c:pt>
                <c:pt idx="1995">
                  <c:v>0.65727350671620466</c:v>
                </c:pt>
                <c:pt idx="1996">
                  <c:v>0.67842240640182905</c:v>
                </c:pt>
                <c:pt idx="1997">
                  <c:v>0.66013146613318086</c:v>
                </c:pt>
                <c:pt idx="1998">
                  <c:v>0.65715918833952558</c:v>
                </c:pt>
                <c:pt idx="1999">
                  <c:v>0.67253501000285798</c:v>
                </c:pt>
                <c:pt idx="2000">
                  <c:v>0.69677050585881684</c:v>
                </c:pt>
                <c:pt idx="2001">
                  <c:v>0.67590740211488998</c:v>
                </c:pt>
                <c:pt idx="2002">
                  <c:v>0.68368105172906546</c:v>
                </c:pt>
                <c:pt idx="2003">
                  <c:v>0.67533581023149469</c:v>
                </c:pt>
                <c:pt idx="2004">
                  <c:v>0.66401829094026865</c:v>
                </c:pt>
                <c:pt idx="2005">
                  <c:v>0.67236353243783942</c:v>
                </c:pt>
                <c:pt idx="2006">
                  <c:v>0.66024578450985993</c:v>
                </c:pt>
                <c:pt idx="2007">
                  <c:v>0.68105172906544731</c:v>
                </c:pt>
                <c:pt idx="2008">
                  <c:v>0.68768219491283222</c:v>
                </c:pt>
                <c:pt idx="2009">
                  <c:v>0.69185481566161755</c:v>
                </c:pt>
                <c:pt idx="2010">
                  <c:v>0.66081737639325522</c:v>
                </c:pt>
                <c:pt idx="2011">
                  <c:v>0.68448128036581879</c:v>
                </c:pt>
                <c:pt idx="2012">
                  <c:v>0.67727922263503859</c:v>
                </c:pt>
                <c:pt idx="2013">
                  <c:v>0.67785081451843388</c:v>
                </c:pt>
                <c:pt idx="2014">
                  <c:v>0.69368390968848237</c:v>
                </c:pt>
                <c:pt idx="2015">
                  <c:v>0.64115461560445841</c:v>
                </c:pt>
                <c:pt idx="2016">
                  <c:v>0.68385252929408402</c:v>
                </c:pt>
                <c:pt idx="2017">
                  <c:v>0.68179479851386116</c:v>
                </c:pt>
                <c:pt idx="2018">
                  <c:v>0.68036581880537295</c:v>
                </c:pt>
                <c:pt idx="2019">
                  <c:v>0.69419834238353817</c:v>
                </c:pt>
                <c:pt idx="2020">
                  <c:v>0.66007430694484137</c:v>
                </c:pt>
                <c:pt idx="2021">
                  <c:v>0.66950557302086311</c:v>
                </c:pt>
                <c:pt idx="2022">
                  <c:v>0.6877965132895113</c:v>
                </c:pt>
                <c:pt idx="2023">
                  <c:v>0.65830237210631604</c:v>
                </c:pt>
                <c:pt idx="2024">
                  <c:v>0.66641897685052875</c:v>
                </c:pt>
                <c:pt idx="2025">
                  <c:v>0.67727922263503859</c:v>
                </c:pt>
                <c:pt idx="2026">
                  <c:v>0.66487567876536158</c:v>
                </c:pt>
                <c:pt idx="2027">
                  <c:v>0.67310660188625326</c:v>
                </c:pt>
                <c:pt idx="2028">
                  <c:v>0.64561303229494138</c:v>
                </c:pt>
                <c:pt idx="2029">
                  <c:v>0.69014004001143181</c:v>
                </c:pt>
                <c:pt idx="2030">
                  <c:v>0.68459559874249787</c:v>
                </c:pt>
                <c:pt idx="2031">
                  <c:v>0.67687910831666187</c:v>
                </c:pt>
                <c:pt idx="2032">
                  <c:v>0.67933695341526146</c:v>
                </c:pt>
                <c:pt idx="2033">
                  <c:v>0.67207773649614178</c:v>
                </c:pt>
                <c:pt idx="2034">
                  <c:v>0.65727350671620466</c:v>
                </c:pt>
                <c:pt idx="2035">
                  <c:v>0.6604172620748785</c:v>
                </c:pt>
                <c:pt idx="2036">
                  <c:v>0.67110603029436977</c:v>
                </c:pt>
                <c:pt idx="2037">
                  <c:v>0.66739068305230065</c:v>
                </c:pt>
                <c:pt idx="2038">
                  <c:v>0.65721634752786506</c:v>
                </c:pt>
                <c:pt idx="2039">
                  <c:v>0.68162332094884248</c:v>
                </c:pt>
                <c:pt idx="2040">
                  <c:v>0.68916833380965992</c:v>
                </c:pt>
                <c:pt idx="2041">
                  <c:v>0.66224635610174332</c:v>
                </c:pt>
                <c:pt idx="2042">
                  <c:v>0.67179194055444413</c:v>
                </c:pt>
                <c:pt idx="2043">
                  <c:v>0.6724206916261789</c:v>
                </c:pt>
                <c:pt idx="2044">
                  <c:v>0.69168333809659899</c:v>
                </c:pt>
                <c:pt idx="2045">
                  <c:v>0.67973706773363818</c:v>
                </c:pt>
                <c:pt idx="2046">
                  <c:v>0.67762217776507572</c:v>
                </c:pt>
                <c:pt idx="2047">
                  <c:v>0.67013432409259788</c:v>
                </c:pt>
                <c:pt idx="2048">
                  <c:v>0.67693626750500147</c:v>
                </c:pt>
                <c:pt idx="2049">
                  <c:v>0.67470705915975993</c:v>
                </c:pt>
                <c:pt idx="2050">
                  <c:v>0.6647042012003429</c:v>
                </c:pt>
                <c:pt idx="2051">
                  <c:v>0.67687910831666187</c:v>
                </c:pt>
                <c:pt idx="2052">
                  <c:v>0.67373535295798803</c:v>
                </c:pt>
                <c:pt idx="2053">
                  <c:v>0.69276936267504996</c:v>
                </c:pt>
                <c:pt idx="2054">
                  <c:v>0.6983709631323235</c:v>
                </c:pt>
                <c:pt idx="2055">
                  <c:v>0.65664475564446989</c:v>
                </c:pt>
                <c:pt idx="2056">
                  <c:v>0.66213203772506435</c:v>
                </c:pt>
                <c:pt idx="2057">
                  <c:v>0.66881966276078875</c:v>
                </c:pt>
                <c:pt idx="2058">
                  <c:v>0.67705058588168043</c:v>
                </c:pt>
                <c:pt idx="2059">
                  <c:v>0.66830523006573306</c:v>
                </c:pt>
                <c:pt idx="2060">
                  <c:v>0.67687910831666187</c:v>
                </c:pt>
                <c:pt idx="2061">
                  <c:v>0.69139754215490135</c:v>
                </c:pt>
                <c:pt idx="2062">
                  <c:v>0.66533295227207778</c:v>
                </c:pt>
                <c:pt idx="2063">
                  <c:v>0.66624749928551019</c:v>
                </c:pt>
                <c:pt idx="2064">
                  <c:v>0.6570448699628465</c:v>
                </c:pt>
                <c:pt idx="2065">
                  <c:v>0.66681909116890536</c:v>
                </c:pt>
                <c:pt idx="2066">
                  <c:v>0.67670763075164331</c:v>
                </c:pt>
                <c:pt idx="2067">
                  <c:v>0.66167476421834814</c:v>
                </c:pt>
                <c:pt idx="2068">
                  <c:v>0.65870248642469276</c:v>
                </c:pt>
                <c:pt idx="2069">
                  <c:v>0.66064589882823666</c:v>
                </c:pt>
                <c:pt idx="2070">
                  <c:v>0.68036581880537295</c:v>
                </c:pt>
                <c:pt idx="2071">
                  <c:v>0.68653901114604177</c:v>
                </c:pt>
                <c:pt idx="2072">
                  <c:v>0.66550442983709635</c:v>
                </c:pt>
                <c:pt idx="2073">
                  <c:v>0.68648185195770217</c:v>
                </c:pt>
                <c:pt idx="2074">
                  <c:v>0.67693626750500147</c:v>
                </c:pt>
                <c:pt idx="2075">
                  <c:v>0.68042297799371254</c:v>
                </c:pt>
                <c:pt idx="2076">
                  <c:v>0.68110888825378679</c:v>
                </c:pt>
                <c:pt idx="2077">
                  <c:v>0.68293798228065161</c:v>
                </c:pt>
                <c:pt idx="2078">
                  <c:v>0.66333238068019429</c:v>
                </c:pt>
                <c:pt idx="2079">
                  <c:v>0.65435838811088887</c:v>
                </c:pt>
                <c:pt idx="2080">
                  <c:v>0.6709917119176908</c:v>
                </c:pt>
                <c:pt idx="2081">
                  <c:v>0.66344669905687337</c:v>
                </c:pt>
                <c:pt idx="2082">
                  <c:v>0.66539011146041727</c:v>
                </c:pt>
                <c:pt idx="2083">
                  <c:v>0.68390968848242351</c:v>
                </c:pt>
                <c:pt idx="2084">
                  <c:v>0.68030865961703346</c:v>
                </c:pt>
                <c:pt idx="2085">
                  <c:v>0.6565875964561303</c:v>
                </c:pt>
                <c:pt idx="2086">
                  <c:v>0.65670191483280937</c:v>
                </c:pt>
                <c:pt idx="2087">
                  <c:v>0.67447842240640188</c:v>
                </c:pt>
                <c:pt idx="2088">
                  <c:v>0.65492997999428404</c:v>
                </c:pt>
                <c:pt idx="2089">
                  <c:v>0.67516433266647613</c:v>
                </c:pt>
                <c:pt idx="2090">
                  <c:v>0.66298942555015716</c:v>
                </c:pt>
                <c:pt idx="2091">
                  <c:v>0.64109745641611893</c:v>
                </c:pt>
                <c:pt idx="2092">
                  <c:v>0.67190625893112321</c:v>
                </c:pt>
                <c:pt idx="2093">
                  <c:v>0.66481851957702198</c:v>
                </c:pt>
                <c:pt idx="2094">
                  <c:v>0.66721920548728209</c:v>
                </c:pt>
                <c:pt idx="2095">
                  <c:v>0.6911689054015433</c:v>
                </c:pt>
                <c:pt idx="2096">
                  <c:v>0.689282652186339</c:v>
                </c:pt>
                <c:pt idx="2097">
                  <c:v>0.67453558159474136</c:v>
                </c:pt>
                <c:pt idx="2098">
                  <c:v>0.65184338382394968</c:v>
                </c:pt>
                <c:pt idx="2099">
                  <c:v>0.68505287224921407</c:v>
                </c:pt>
                <c:pt idx="2100">
                  <c:v>0.67985138611031726</c:v>
                </c:pt>
                <c:pt idx="2101">
                  <c:v>0.67785081451843388</c:v>
                </c:pt>
                <c:pt idx="2102">
                  <c:v>0.66710488711060301</c:v>
                </c:pt>
                <c:pt idx="2103">
                  <c:v>0.67333523863961131</c:v>
                </c:pt>
                <c:pt idx="2104">
                  <c:v>0.65841669048299512</c:v>
                </c:pt>
                <c:pt idx="2105">
                  <c:v>0.64989997142040579</c:v>
                </c:pt>
                <c:pt idx="2106">
                  <c:v>0.67693626750500147</c:v>
                </c:pt>
                <c:pt idx="2107">
                  <c:v>0.68653901114604177</c:v>
                </c:pt>
                <c:pt idx="2108">
                  <c:v>0.67653615318662474</c:v>
                </c:pt>
                <c:pt idx="2109">
                  <c:v>0.68465275793083735</c:v>
                </c:pt>
                <c:pt idx="2110">
                  <c:v>0.68122320663046587</c:v>
                </c:pt>
                <c:pt idx="2111">
                  <c:v>0.66870534438410978</c:v>
                </c:pt>
                <c:pt idx="2112">
                  <c:v>0.66104601314661326</c:v>
                </c:pt>
                <c:pt idx="2113">
                  <c:v>0.68362389254072597</c:v>
                </c:pt>
                <c:pt idx="2114">
                  <c:v>0.67533581023149469</c:v>
                </c:pt>
                <c:pt idx="2115">
                  <c:v>0.67899399828522433</c:v>
                </c:pt>
                <c:pt idx="2116">
                  <c:v>0.66630465847384968</c:v>
                </c:pt>
                <c:pt idx="2117">
                  <c:v>0.66699056873392393</c:v>
                </c:pt>
                <c:pt idx="2118">
                  <c:v>0.66807659331237501</c:v>
                </c:pt>
                <c:pt idx="2119">
                  <c:v>0.66161760503000855</c:v>
                </c:pt>
                <c:pt idx="2120">
                  <c:v>0.67299228350957419</c:v>
                </c:pt>
                <c:pt idx="2121">
                  <c:v>0.6478993998285224</c:v>
                </c:pt>
                <c:pt idx="2122">
                  <c:v>0.65744498428122322</c:v>
                </c:pt>
                <c:pt idx="2123">
                  <c:v>0.67487853672477849</c:v>
                </c:pt>
                <c:pt idx="2124">
                  <c:v>0.68991140325807376</c:v>
                </c:pt>
                <c:pt idx="2125">
                  <c:v>0.65795941697627891</c:v>
                </c:pt>
                <c:pt idx="2126">
                  <c:v>0.63812517862246354</c:v>
                </c:pt>
                <c:pt idx="2127">
                  <c:v>0.66310374392683624</c:v>
                </c:pt>
                <c:pt idx="2128">
                  <c:v>0.64881394684195481</c:v>
                </c:pt>
                <c:pt idx="2129">
                  <c:v>0.6642469276936267</c:v>
                </c:pt>
                <c:pt idx="2130">
                  <c:v>0.66853386681909122</c:v>
                </c:pt>
                <c:pt idx="2131">
                  <c:v>0.6796227493569591</c:v>
                </c:pt>
                <c:pt idx="2132">
                  <c:v>0.689282652186339</c:v>
                </c:pt>
                <c:pt idx="2133">
                  <c:v>0.68316661903400977</c:v>
                </c:pt>
                <c:pt idx="2134">
                  <c:v>0.68339525578736782</c:v>
                </c:pt>
                <c:pt idx="2135">
                  <c:v>0.67710774507002003</c:v>
                </c:pt>
                <c:pt idx="2136">
                  <c:v>0.67693626750500147</c:v>
                </c:pt>
                <c:pt idx="2137">
                  <c:v>0.6724206916261789</c:v>
                </c:pt>
                <c:pt idx="2138">
                  <c:v>0.65641611889111173</c:v>
                </c:pt>
                <c:pt idx="2139">
                  <c:v>0.64772792226350384</c:v>
                </c:pt>
                <c:pt idx="2140">
                  <c:v>0.66721920548728209</c:v>
                </c:pt>
                <c:pt idx="2141">
                  <c:v>0.64978565304372682</c:v>
                </c:pt>
                <c:pt idx="2142">
                  <c:v>0.66070305801657614</c:v>
                </c:pt>
                <c:pt idx="2143">
                  <c:v>0.69105458702486422</c:v>
                </c:pt>
                <c:pt idx="2144">
                  <c:v>0.66784795655901685</c:v>
                </c:pt>
                <c:pt idx="2145">
                  <c:v>0.67419262646470424</c:v>
                </c:pt>
                <c:pt idx="2146">
                  <c:v>0.65350100028579594</c:v>
                </c:pt>
                <c:pt idx="2147">
                  <c:v>0.66973420977422116</c:v>
                </c:pt>
                <c:pt idx="2148">
                  <c:v>0.66527579308373819</c:v>
                </c:pt>
                <c:pt idx="2149">
                  <c:v>0.66870534438410978</c:v>
                </c:pt>
                <c:pt idx="2150">
                  <c:v>0.6762503572449271</c:v>
                </c:pt>
                <c:pt idx="2151">
                  <c:v>0.68402400685910258</c:v>
                </c:pt>
                <c:pt idx="2152">
                  <c:v>0.66150328665332947</c:v>
                </c:pt>
                <c:pt idx="2153">
                  <c:v>0.6757930837382109</c:v>
                </c:pt>
                <c:pt idx="2154">
                  <c:v>0.64715633038010856</c:v>
                </c:pt>
                <c:pt idx="2155">
                  <c:v>0.65664475564446989</c:v>
                </c:pt>
                <c:pt idx="2156">
                  <c:v>0.66064589882823666</c:v>
                </c:pt>
                <c:pt idx="2157">
                  <c:v>0.647956559016862</c:v>
                </c:pt>
                <c:pt idx="2158">
                  <c:v>0.65190054301228928</c:v>
                </c:pt>
                <c:pt idx="2159">
                  <c:v>0.64149757073449554</c:v>
                </c:pt>
                <c:pt idx="2160">
                  <c:v>0.68551014575593028</c:v>
                </c:pt>
                <c:pt idx="2161">
                  <c:v>0.66316090311517573</c:v>
                </c:pt>
                <c:pt idx="2162">
                  <c:v>0.66384681337525009</c:v>
                </c:pt>
                <c:pt idx="2163">
                  <c:v>0.65761646184624178</c:v>
                </c:pt>
                <c:pt idx="2164">
                  <c:v>0.66058873963989706</c:v>
                </c:pt>
                <c:pt idx="2165">
                  <c:v>0.65504429837096312</c:v>
                </c:pt>
                <c:pt idx="2166">
                  <c:v>0.65778793941126035</c:v>
                </c:pt>
                <c:pt idx="2167">
                  <c:v>0.65698771077450702</c:v>
                </c:pt>
                <c:pt idx="2168">
                  <c:v>0.67110603029436977</c:v>
                </c:pt>
                <c:pt idx="2169">
                  <c:v>0.65601600457273501</c:v>
                </c:pt>
                <c:pt idx="2170">
                  <c:v>0.64504144041154621</c:v>
                </c:pt>
                <c:pt idx="2171">
                  <c:v>0.64132609316947697</c:v>
                </c:pt>
                <c:pt idx="2172">
                  <c:v>0.66304658473849676</c:v>
                </c:pt>
                <c:pt idx="2173">
                  <c:v>0.66710488711060301</c:v>
                </c:pt>
                <c:pt idx="2174">
                  <c:v>0.64652757930837379</c:v>
                </c:pt>
                <c:pt idx="2175">
                  <c:v>0.67790797370677336</c:v>
                </c:pt>
                <c:pt idx="2176">
                  <c:v>0.6743069448413832</c:v>
                </c:pt>
                <c:pt idx="2177">
                  <c:v>0.67390683052300659</c:v>
                </c:pt>
                <c:pt idx="2178">
                  <c:v>0.67653615318662474</c:v>
                </c:pt>
                <c:pt idx="2179">
                  <c:v>0.66378965418691049</c:v>
                </c:pt>
                <c:pt idx="2180">
                  <c:v>0.67596456130322946</c:v>
                </c:pt>
                <c:pt idx="2181">
                  <c:v>0.66927693626750495</c:v>
                </c:pt>
                <c:pt idx="2182">
                  <c:v>0.66910545870248639</c:v>
                </c:pt>
                <c:pt idx="2183">
                  <c:v>0.63360960274364109</c:v>
                </c:pt>
                <c:pt idx="2184">
                  <c:v>0.66739068305230065</c:v>
                </c:pt>
                <c:pt idx="2185">
                  <c:v>0.66384681337525009</c:v>
                </c:pt>
                <c:pt idx="2186">
                  <c:v>0.66407545012860814</c:v>
                </c:pt>
                <c:pt idx="2187">
                  <c:v>0.6757930837382109</c:v>
                </c:pt>
                <c:pt idx="2188">
                  <c:v>0.68602457845098597</c:v>
                </c:pt>
                <c:pt idx="2189">
                  <c:v>0.65070020005715923</c:v>
                </c:pt>
                <c:pt idx="2190">
                  <c:v>0.66064589882823666</c:v>
                </c:pt>
                <c:pt idx="2191">
                  <c:v>0.66836238925407254</c:v>
                </c:pt>
                <c:pt idx="2192">
                  <c:v>0.66407545012860814</c:v>
                </c:pt>
                <c:pt idx="2193">
                  <c:v>0.65601600457273501</c:v>
                </c:pt>
                <c:pt idx="2194">
                  <c:v>0.66070305801657614</c:v>
                </c:pt>
                <c:pt idx="2195">
                  <c:v>0.65332952272077738</c:v>
                </c:pt>
                <c:pt idx="2196">
                  <c:v>0.66847670763075162</c:v>
                </c:pt>
                <c:pt idx="2197">
                  <c:v>0.66178908259502711</c:v>
                </c:pt>
                <c:pt idx="2198">
                  <c:v>0.66173192340668763</c:v>
                </c:pt>
                <c:pt idx="2199">
                  <c:v>0.65773078022292086</c:v>
                </c:pt>
                <c:pt idx="2200">
                  <c:v>0.69025435838811089</c:v>
                </c:pt>
                <c:pt idx="2201">
                  <c:v>0.66218919691340383</c:v>
                </c:pt>
                <c:pt idx="2202">
                  <c:v>0.67076307516433264</c:v>
                </c:pt>
                <c:pt idx="2203">
                  <c:v>0.65138611031723348</c:v>
                </c:pt>
                <c:pt idx="2204">
                  <c:v>0.67139182623606741</c:v>
                </c:pt>
                <c:pt idx="2205">
                  <c:v>0.64132609316947697</c:v>
                </c:pt>
                <c:pt idx="2206">
                  <c:v>0.65315804515575882</c:v>
                </c:pt>
                <c:pt idx="2207">
                  <c:v>0.66161760503000855</c:v>
                </c:pt>
                <c:pt idx="2208">
                  <c:v>0.67024864246927696</c:v>
                </c:pt>
                <c:pt idx="2209">
                  <c:v>0.65544441268933984</c:v>
                </c:pt>
                <c:pt idx="2210">
                  <c:v>0.66687625035724496</c:v>
                </c:pt>
                <c:pt idx="2211">
                  <c:v>0.64401257502143472</c:v>
                </c:pt>
                <c:pt idx="2212">
                  <c:v>0.67082023435267224</c:v>
                </c:pt>
                <c:pt idx="2213">
                  <c:v>0.67590740211488998</c:v>
                </c:pt>
                <c:pt idx="2214">
                  <c:v>0.66527579308373819</c:v>
                </c:pt>
                <c:pt idx="2215">
                  <c:v>0.67282080594455562</c:v>
                </c:pt>
                <c:pt idx="2216">
                  <c:v>0.65824521291797655</c:v>
                </c:pt>
                <c:pt idx="2217">
                  <c:v>0.67270648756787654</c:v>
                </c:pt>
                <c:pt idx="2218">
                  <c:v>0.6647613603886825</c:v>
                </c:pt>
                <c:pt idx="2219">
                  <c:v>0.67533581023149469</c:v>
                </c:pt>
                <c:pt idx="2220">
                  <c:v>0.69625607316376104</c:v>
                </c:pt>
                <c:pt idx="2221">
                  <c:v>0.65292940840240066</c:v>
                </c:pt>
                <c:pt idx="2222">
                  <c:v>0.70351529008288083</c:v>
                </c:pt>
                <c:pt idx="2223">
                  <c:v>0.67110603029436977</c:v>
                </c:pt>
                <c:pt idx="2224">
                  <c:v>0.67442126321806228</c:v>
                </c:pt>
                <c:pt idx="2225">
                  <c:v>0.68179479851386116</c:v>
                </c:pt>
                <c:pt idx="2226">
                  <c:v>0.66064589882823666</c:v>
                </c:pt>
                <c:pt idx="2227">
                  <c:v>0.67750785938839664</c:v>
                </c:pt>
                <c:pt idx="2228">
                  <c:v>0.64498428122320661</c:v>
                </c:pt>
                <c:pt idx="2229">
                  <c:v>0.67647899399828526</c:v>
                </c:pt>
                <c:pt idx="2230">
                  <c:v>0.63789654186910549</c:v>
                </c:pt>
                <c:pt idx="2231">
                  <c:v>0.66030294369819953</c:v>
                </c:pt>
                <c:pt idx="2232">
                  <c:v>0.67916547585024289</c:v>
                </c:pt>
                <c:pt idx="2233">
                  <c:v>0.65990282937982281</c:v>
                </c:pt>
                <c:pt idx="2234">
                  <c:v>0.66550442983709635</c:v>
                </c:pt>
                <c:pt idx="2235">
                  <c:v>0.67413546727636464</c:v>
                </c:pt>
                <c:pt idx="2236">
                  <c:v>0.68162332094884248</c:v>
                </c:pt>
                <c:pt idx="2237">
                  <c:v>0.6853958273792512</c:v>
                </c:pt>
                <c:pt idx="2238">
                  <c:v>0.65641611889111173</c:v>
                </c:pt>
                <c:pt idx="2239">
                  <c:v>0.65481566161760507</c:v>
                </c:pt>
                <c:pt idx="2240">
                  <c:v>0.64721348956844815</c:v>
                </c:pt>
                <c:pt idx="2241">
                  <c:v>0.6575593026579023</c:v>
                </c:pt>
                <c:pt idx="2242">
                  <c:v>0.64469848528150897</c:v>
                </c:pt>
                <c:pt idx="2243">
                  <c:v>0.64921406116033153</c:v>
                </c:pt>
                <c:pt idx="2244">
                  <c:v>0.67276364675621603</c:v>
                </c:pt>
                <c:pt idx="2245">
                  <c:v>0.66458988282366394</c:v>
                </c:pt>
                <c:pt idx="2246">
                  <c:v>0.6571020291511861</c:v>
                </c:pt>
                <c:pt idx="2247">
                  <c:v>0.65395827379251215</c:v>
                </c:pt>
                <c:pt idx="2248">
                  <c:v>0.66876250357244926</c:v>
                </c:pt>
                <c:pt idx="2249">
                  <c:v>0.65052872249214067</c:v>
                </c:pt>
                <c:pt idx="2250">
                  <c:v>0.67367819376964844</c:v>
                </c:pt>
                <c:pt idx="2251">
                  <c:v>0.66338953986853388</c:v>
                </c:pt>
                <c:pt idx="2252">
                  <c:v>0.64527007716490425</c:v>
                </c:pt>
                <c:pt idx="2253">
                  <c:v>0.67093455272935121</c:v>
                </c:pt>
                <c:pt idx="2254">
                  <c:v>0.63120891683338098</c:v>
                </c:pt>
                <c:pt idx="2255">
                  <c:v>0.6340097170620177</c:v>
                </c:pt>
                <c:pt idx="2256">
                  <c:v>0.64075450128608169</c:v>
                </c:pt>
                <c:pt idx="2257">
                  <c:v>0.68825378679622751</c:v>
                </c:pt>
                <c:pt idx="2258">
                  <c:v>0.66699056873392393</c:v>
                </c:pt>
                <c:pt idx="2259">
                  <c:v>0.65681623320948845</c:v>
                </c:pt>
                <c:pt idx="2260">
                  <c:v>0.67322092026293223</c:v>
                </c:pt>
                <c:pt idx="2261">
                  <c:v>0.67516433266647613</c:v>
                </c:pt>
                <c:pt idx="2262">
                  <c:v>0.66150328665332947</c:v>
                </c:pt>
                <c:pt idx="2263">
                  <c:v>0.65224349814232641</c:v>
                </c:pt>
                <c:pt idx="2264">
                  <c:v>0.67236353243783942</c:v>
                </c:pt>
                <c:pt idx="2265">
                  <c:v>0.66441840525864537</c:v>
                </c:pt>
                <c:pt idx="2266">
                  <c:v>0.64395541583309512</c:v>
                </c:pt>
                <c:pt idx="2267">
                  <c:v>0.65715918833952558</c:v>
                </c:pt>
                <c:pt idx="2268">
                  <c:v>0.66081737639325522</c:v>
                </c:pt>
                <c:pt idx="2269">
                  <c:v>0.65590168619605604</c:v>
                </c:pt>
                <c:pt idx="2270">
                  <c:v>0.65161474707059164</c:v>
                </c:pt>
                <c:pt idx="2271">
                  <c:v>0.65624464132609317</c:v>
                </c:pt>
                <c:pt idx="2272">
                  <c:v>0.66018862532152045</c:v>
                </c:pt>
                <c:pt idx="2273">
                  <c:v>0.68236639039725633</c:v>
                </c:pt>
                <c:pt idx="2274">
                  <c:v>0.66127464989997142</c:v>
                </c:pt>
                <c:pt idx="2275">
                  <c:v>0.66018862532152045</c:v>
                </c:pt>
                <c:pt idx="2276">
                  <c:v>0.65715918833952558</c:v>
                </c:pt>
                <c:pt idx="2277">
                  <c:v>0.68213775364389828</c:v>
                </c:pt>
                <c:pt idx="2278">
                  <c:v>0.64801371820520148</c:v>
                </c:pt>
                <c:pt idx="2279">
                  <c:v>0.64418405258645328</c:v>
                </c:pt>
                <c:pt idx="2280">
                  <c:v>0.65121463275221492</c:v>
                </c:pt>
                <c:pt idx="2281">
                  <c:v>0.65115747356387543</c:v>
                </c:pt>
                <c:pt idx="2282">
                  <c:v>0.63795370105744498</c:v>
                </c:pt>
                <c:pt idx="2283">
                  <c:v>0.64389825664475564</c:v>
                </c:pt>
                <c:pt idx="2284">
                  <c:v>0.64138325235781657</c:v>
                </c:pt>
                <c:pt idx="2285">
                  <c:v>0.66024578450985993</c:v>
                </c:pt>
                <c:pt idx="2286">
                  <c:v>0.66407545012860814</c:v>
                </c:pt>
                <c:pt idx="2287">
                  <c:v>0.65304372677907974</c:v>
                </c:pt>
                <c:pt idx="2288">
                  <c:v>0.66298942555015716</c:v>
                </c:pt>
                <c:pt idx="2289">
                  <c:v>0.65807373535295799</c:v>
                </c:pt>
                <c:pt idx="2290">
                  <c:v>0.65613032294941409</c:v>
                </c:pt>
                <c:pt idx="2291">
                  <c:v>0.67299228350957419</c:v>
                </c:pt>
                <c:pt idx="2292">
                  <c:v>0.65138611031723348</c:v>
                </c:pt>
                <c:pt idx="2293">
                  <c:v>0.66699056873392393</c:v>
                </c:pt>
                <c:pt idx="2294">
                  <c:v>0.65298656759074025</c:v>
                </c:pt>
                <c:pt idx="2295">
                  <c:v>0.63612460703058016</c:v>
                </c:pt>
                <c:pt idx="2296">
                  <c:v>0.64852815090025717</c:v>
                </c:pt>
                <c:pt idx="2297">
                  <c:v>0.62092026293226632</c:v>
                </c:pt>
                <c:pt idx="2298">
                  <c:v>0.62457845098599596</c:v>
                </c:pt>
                <c:pt idx="2299">
                  <c:v>0.66436124607030578</c:v>
                </c:pt>
                <c:pt idx="2300">
                  <c:v>0.64326950557302087</c:v>
                </c:pt>
                <c:pt idx="2301">
                  <c:v>0.65910260074306948</c:v>
                </c:pt>
                <c:pt idx="2302">
                  <c:v>0.66133180908831091</c:v>
                </c:pt>
                <c:pt idx="2303">
                  <c:v>0.65738782509288363</c:v>
                </c:pt>
                <c:pt idx="2304">
                  <c:v>0.65687339239782794</c:v>
                </c:pt>
                <c:pt idx="2305">
                  <c:v>0.65784509859959983</c:v>
                </c:pt>
                <c:pt idx="2306">
                  <c:v>0.65138611031723348</c:v>
                </c:pt>
                <c:pt idx="2307">
                  <c:v>0.65967419262646465</c:v>
                </c:pt>
                <c:pt idx="2308">
                  <c:v>0.6455558731066019</c:v>
                </c:pt>
                <c:pt idx="2309">
                  <c:v>0.64492712203486713</c:v>
                </c:pt>
                <c:pt idx="2310">
                  <c:v>0.64081166047442129</c:v>
                </c:pt>
                <c:pt idx="2311">
                  <c:v>0.65047156330380107</c:v>
                </c:pt>
                <c:pt idx="2312">
                  <c:v>0.63755358673906826</c:v>
                </c:pt>
                <c:pt idx="2313">
                  <c:v>0.65635895970277225</c:v>
                </c:pt>
                <c:pt idx="2314">
                  <c:v>0.64544155472992282</c:v>
                </c:pt>
                <c:pt idx="2315">
                  <c:v>0.64075450128608169</c:v>
                </c:pt>
                <c:pt idx="2316">
                  <c:v>0.65984567019148332</c:v>
                </c:pt>
                <c:pt idx="2317">
                  <c:v>0.65670191483280937</c:v>
                </c:pt>
                <c:pt idx="2318">
                  <c:v>0.64315518719634179</c:v>
                </c:pt>
                <c:pt idx="2319">
                  <c:v>0.66127464989997142</c:v>
                </c:pt>
                <c:pt idx="2320">
                  <c:v>0.65590168619605604</c:v>
                </c:pt>
                <c:pt idx="2321">
                  <c:v>0.64704201200342959</c:v>
                </c:pt>
                <c:pt idx="2322">
                  <c:v>0.64229779937124898</c:v>
                </c:pt>
                <c:pt idx="2323">
                  <c:v>0.6364104029722778</c:v>
                </c:pt>
                <c:pt idx="2324">
                  <c:v>0.63732494998571021</c:v>
                </c:pt>
                <c:pt idx="2325">
                  <c:v>0.63549585595884539</c:v>
                </c:pt>
                <c:pt idx="2326">
                  <c:v>0.6272649328379537</c:v>
                </c:pt>
                <c:pt idx="2327">
                  <c:v>0.63086596170334386</c:v>
                </c:pt>
                <c:pt idx="2328">
                  <c:v>0.63309517004858529</c:v>
                </c:pt>
                <c:pt idx="2329">
                  <c:v>0.64161188911117462</c:v>
                </c:pt>
                <c:pt idx="2330">
                  <c:v>0.65121463275221492</c:v>
                </c:pt>
                <c:pt idx="2331">
                  <c:v>0.63658188053729636</c:v>
                </c:pt>
                <c:pt idx="2332">
                  <c:v>0.65018576736210343</c:v>
                </c:pt>
                <c:pt idx="2333">
                  <c:v>0.63046584738496714</c:v>
                </c:pt>
                <c:pt idx="2334">
                  <c:v>0.63961131751929123</c:v>
                </c:pt>
                <c:pt idx="2335">
                  <c:v>0.65841669048299512</c:v>
                </c:pt>
                <c:pt idx="2336">
                  <c:v>0.64915690197199205</c:v>
                </c:pt>
                <c:pt idx="2337">
                  <c:v>0.64527007716490425</c:v>
                </c:pt>
                <c:pt idx="2338">
                  <c:v>0.65727350671620466</c:v>
                </c:pt>
                <c:pt idx="2339">
                  <c:v>0.64424121177479277</c:v>
                </c:pt>
                <c:pt idx="2340">
                  <c:v>0.64578450985995994</c:v>
                </c:pt>
                <c:pt idx="2341">
                  <c:v>0.63766790511574734</c:v>
                </c:pt>
                <c:pt idx="2342">
                  <c:v>0.6287510717347814</c:v>
                </c:pt>
                <c:pt idx="2343">
                  <c:v>0.63915404401257503</c:v>
                </c:pt>
                <c:pt idx="2344">
                  <c:v>0.65190054301228928</c:v>
                </c:pt>
                <c:pt idx="2345">
                  <c:v>0.62526436124607032</c:v>
                </c:pt>
                <c:pt idx="2346">
                  <c:v>0.64441268933981133</c:v>
                </c:pt>
                <c:pt idx="2347">
                  <c:v>0.64521291797656477</c:v>
                </c:pt>
                <c:pt idx="2348">
                  <c:v>0.65715918833952558</c:v>
                </c:pt>
                <c:pt idx="2349">
                  <c:v>0.64469848528150897</c:v>
                </c:pt>
                <c:pt idx="2350">
                  <c:v>0.65075735924549871</c:v>
                </c:pt>
                <c:pt idx="2351">
                  <c:v>0.64675621606173195</c:v>
                </c:pt>
                <c:pt idx="2352">
                  <c:v>0.64184052586453277</c:v>
                </c:pt>
                <c:pt idx="2353">
                  <c:v>0.64572735067162046</c:v>
                </c:pt>
                <c:pt idx="2354">
                  <c:v>0.62274935695913114</c:v>
                </c:pt>
                <c:pt idx="2355">
                  <c:v>0.64618462417833666</c:v>
                </c:pt>
                <c:pt idx="2356">
                  <c:v>0.63532437839382683</c:v>
                </c:pt>
                <c:pt idx="2357">
                  <c:v>0.63080880251500426</c:v>
                </c:pt>
                <c:pt idx="2358">
                  <c:v>0.65761646184624178</c:v>
                </c:pt>
                <c:pt idx="2359">
                  <c:v>0.62269219777079166</c:v>
                </c:pt>
                <c:pt idx="2360">
                  <c:v>0.63383823949699913</c:v>
                </c:pt>
                <c:pt idx="2361">
                  <c:v>0.63646756216061728</c:v>
                </c:pt>
                <c:pt idx="2362">
                  <c:v>0.63852529294084026</c:v>
                </c:pt>
                <c:pt idx="2363">
                  <c:v>0.64195484424121174</c:v>
                </c:pt>
                <c:pt idx="2364">
                  <c:v>0.62046298942555012</c:v>
                </c:pt>
                <c:pt idx="2365">
                  <c:v>0.65904544155472988</c:v>
                </c:pt>
                <c:pt idx="2366">
                  <c:v>0.63469562732209206</c:v>
                </c:pt>
                <c:pt idx="2367">
                  <c:v>0.65978851100314373</c:v>
                </c:pt>
                <c:pt idx="2368">
                  <c:v>0.63898256644755647</c:v>
                </c:pt>
                <c:pt idx="2369">
                  <c:v>0.65287224921406117</c:v>
                </c:pt>
                <c:pt idx="2370">
                  <c:v>0.64109745641611893</c:v>
                </c:pt>
                <c:pt idx="2371">
                  <c:v>0.6345241497570735</c:v>
                </c:pt>
                <c:pt idx="2372">
                  <c:v>0.62766504715633042</c:v>
                </c:pt>
                <c:pt idx="2373">
                  <c:v>0.63875392969419831</c:v>
                </c:pt>
                <c:pt idx="2374">
                  <c:v>0.60891683338096603</c:v>
                </c:pt>
                <c:pt idx="2375">
                  <c:v>0.64292655044298375</c:v>
                </c:pt>
                <c:pt idx="2376">
                  <c:v>0.64852815090025717</c:v>
                </c:pt>
                <c:pt idx="2377">
                  <c:v>0.66076021720491573</c:v>
                </c:pt>
                <c:pt idx="2378">
                  <c:v>0.63726779079737073</c:v>
                </c:pt>
                <c:pt idx="2379">
                  <c:v>0.65927407830808804</c:v>
                </c:pt>
                <c:pt idx="2380">
                  <c:v>0.6478993998285224</c:v>
                </c:pt>
                <c:pt idx="2381">
                  <c:v>0.6493855387253501</c:v>
                </c:pt>
                <c:pt idx="2382">
                  <c:v>0.6512717919405544</c:v>
                </c:pt>
                <c:pt idx="2383">
                  <c:v>0.64052586453272364</c:v>
                </c:pt>
                <c:pt idx="2384">
                  <c:v>0.6191483280937411</c:v>
                </c:pt>
                <c:pt idx="2385">
                  <c:v>0.64618462417833666</c:v>
                </c:pt>
                <c:pt idx="2386">
                  <c:v>0.62509288368105176</c:v>
                </c:pt>
                <c:pt idx="2387">
                  <c:v>0.64635610174335523</c:v>
                </c:pt>
                <c:pt idx="2388">
                  <c:v>0.60314375535867393</c:v>
                </c:pt>
                <c:pt idx="2389">
                  <c:v>0.62337810803086591</c:v>
                </c:pt>
                <c:pt idx="2390">
                  <c:v>0.63486710488711062</c:v>
                </c:pt>
                <c:pt idx="2391">
                  <c:v>0.61754787082023432</c:v>
                </c:pt>
                <c:pt idx="2392">
                  <c:v>0.6325807373535296</c:v>
                </c:pt>
                <c:pt idx="2393">
                  <c:v>0.64549871391826241</c:v>
                </c:pt>
                <c:pt idx="2394">
                  <c:v>0.62046298942555012</c:v>
                </c:pt>
                <c:pt idx="2395">
                  <c:v>0.63178050871677627</c:v>
                </c:pt>
                <c:pt idx="2396">
                  <c:v>0.63949699914261215</c:v>
                </c:pt>
                <c:pt idx="2397">
                  <c:v>0.64989997142040579</c:v>
                </c:pt>
                <c:pt idx="2398">
                  <c:v>0.64955701629036866</c:v>
                </c:pt>
                <c:pt idx="2399">
                  <c:v>0.6378393826807659</c:v>
                </c:pt>
                <c:pt idx="2400">
                  <c:v>0.63681051729065452</c:v>
                </c:pt>
                <c:pt idx="2401">
                  <c:v>0.63583881108888252</c:v>
                </c:pt>
                <c:pt idx="2402">
                  <c:v>0.65630180051443265</c:v>
                </c:pt>
                <c:pt idx="2403">
                  <c:v>0.64035438696770508</c:v>
                </c:pt>
                <c:pt idx="2404">
                  <c:v>0.63023721063160898</c:v>
                </c:pt>
                <c:pt idx="2405">
                  <c:v>0.62652186338953986</c:v>
                </c:pt>
                <c:pt idx="2406">
                  <c:v>0.63212346384681339</c:v>
                </c:pt>
                <c:pt idx="2407">
                  <c:v>0.62606458988282365</c:v>
                </c:pt>
                <c:pt idx="2408">
                  <c:v>0.6349814232637897</c:v>
                </c:pt>
                <c:pt idx="2409">
                  <c:v>0.61451843383823945</c:v>
                </c:pt>
                <c:pt idx="2410">
                  <c:v>0.65670191483280937</c:v>
                </c:pt>
                <c:pt idx="2411">
                  <c:v>0.63343812517862241</c:v>
                </c:pt>
                <c:pt idx="2412">
                  <c:v>0.647956559016862</c:v>
                </c:pt>
                <c:pt idx="2413">
                  <c:v>0.65487282080594456</c:v>
                </c:pt>
                <c:pt idx="2414">
                  <c:v>0.65287224921406117</c:v>
                </c:pt>
                <c:pt idx="2415">
                  <c:v>0.65001428979708487</c:v>
                </c:pt>
                <c:pt idx="2416">
                  <c:v>0.68053729637039151</c:v>
                </c:pt>
                <c:pt idx="2417">
                  <c:v>0.63989711346098888</c:v>
                </c:pt>
                <c:pt idx="2418">
                  <c:v>0.65830237210631604</c:v>
                </c:pt>
                <c:pt idx="2419">
                  <c:v>0.65247213489568445</c:v>
                </c:pt>
                <c:pt idx="2420">
                  <c:v>0.63715347242069165</c:v>
                </c:pt>
                <c:pt idx="2421">
                  <c:v>0.63149471277507863</c:v>
                </c:pt>
                <c:pt idx="2422">
                  <c:v>0.64252643612460703</c:v>
                </c:pt>
                <c:pt idx="2423">
                  <c:v>0.62309231208916838</c:v>
                </c:pt>
                <c:pt idx="2424">
                  <c:v>0.64452700771649041</c:v>
                </c:pt>
                <c:pt idx="2425">
                  <c:v>0.6498428122320663</c:v>
                </c:pt>
                <c:pt idx="2426">
                  <c:v>0.65870248642469276</c:v>
                </c:pt>
                <c:pt idx="2427">
                  <c:v>0.63823949699914262</c:v>
                </c:pt>
                <c:pt idx="2428">
                  <c:v>0.62286367533581022</c:v>
                </c:pt>
                <c:pt idx="2429">
                  <c:v>0.66373249499857101</c:v>
                </c:pt>
                <c:pt idx="2430">
                  <c:v>0.63503858245212919</c:v>
                </c:pt>
                <c:pt idx="2431">
                  <c:v>0.61114604172620746</c:v>
                </c:pt>
                <c:pt idx="2432">
                  <c:v>0.62520720205773073</c:v>
                </c:pt>
                <c:pt idx="2433">
                  <c:v>0.61937696484709914</c:v>
                </c:pt>
                <c:pt idx="2434">
                  <c:v>0.6301800514432695</c:v>
                </c:pt>
                <c:pt idx="2435">
                  <c:v>0.61777650757359248</c:v>
                </c:pt>
                <c:pt idx="2436">
                  <c:v>0.63406687625035729</c:v>
                </c:pt>
                <c:pt idx="2437">
                  <c:v>0.63023721063160898</c:v>
                </c:pt>
                <c:pt idx="2438">
                  <c:v>0.64578450985995994</c:v>
                </c:pt>
                <c:pt idx="2439">
                  <c:v>0.6460131466133181</c:v>
                </c:pt>
                <c:pt idx="2440">
                  <c:v>0.63841097456416118</c:v>
                </c:pt>
                <c:pt idx="2441">
                  <c:v>0.63383823949699913</c:v>
                </c:pt>
                <c:pt idx="2442">
                  <c:v>0.63823949699914262</c:v>
                </c:pt>
                <c:pt idx="2443">
                  <c:v>0.63372392112032006</c:v>
                </c:pt>
                <c:pt idx="2444">
                  <c:v>0.63646756216061728</c:v>
                </c:pt>
                <c:pt idx="2445">
                  <c:v>0.64378393826807656</c:v>
                </c:pt>
                <c:pt idx="2446">
                  <c:v>0.61789082595027156</c:v>
                </c:pt>
                <c:pt idx="2447">
                  <c:v>0.63240925978851104</c:v>
                </c:pt>
                <c:pt idx="2448">
                  <c:v>0.6282366390397256</c:v>
                </c:pt>
                <c:pt idx="2449">
                  <c:v>0.61468991140325813</c:v>
                </c:pt>
                <c:pt idx="2450">
                  <c:v>0.62909402686481852</c:v>
                </c:pt>
                <c:pt idx="2451">
                  <c:v>0.63503858245212919</c:v>
                </c:pt>
                <c:pt idx="2452">
                  <c:v>0.65338668190911686</c:v>
                </c:pt>
                <c:pt idx="2453">
                  <c:v>0.65698771077450702</c:v>
                </c:pt>
                <c:pt idx="2454">
                  <c:v>0.64561303229494138</c:v>
                </c:pt>
                <c:pt idx="2455">
                  <c:v>0.64052586453272364</c:v>
                </c:pt>
                <c:pt idx="2456">
                  <c:v>0.66230351529008291</c:v>
                </c:pt>
                <c:pt idx="2457">
                  <c:v>0.63732494998571021</c:v>
                </c:pt>
                <c:pt idx="2458">
                  <c:v>0.64921406116033153</c:v>
                </c:pt>
                <c:pt idx="2459">
                  <c:v>0.60543012289225495</c:v>
                </c:pt>
                <c:pt idx="2460">
                  <c:v>0.62812232066304663</c:v>
                </c:pt>
                <c:pt idx="2461">
                  <c:v>0.63509574164046867</c:v>
                </c:pt>
                <c:pt idx="2462">
                  <c:v>0.64904258359531297</c:v>
                </c:pt>
                <c:pt idx="2463">
                  <c:v>0.61880537296370397</c:v>
                </c:pt>
                <c:pt idx="2464">
                  <c:v>0.6306373249499857</c:v>
                </c:pt>
                <c:pt idx="2465">
                  <c:v>0.62932266361817657</c:v>
                </c:pt>
                <c:pt idx="2466">
                  <c:v>0.64092597885110036</c:v>
                </c:pt>
                <c:pt idx="2467">
                  <c:v>0.63160903115175759</c:v>
                </c:pt>
                <c:pt idx="2468">
                  <c:v>0.63269505573020868</c:v>
                </c:pt>
                <c:pt idx="2469">
                  <c:v>0.64692769362675051</c:v>
                </c:pt>
                <c:pt idx="2470">
                  <c:v>0.63492426407545011</c:v>
                </c:pt>
                <c:pt idx="2471">
                  <c:v>0.63149471277507863</c:v>
                </c:pt>
                <c:pt idx="2472">
                  <c:v>0.66247499285510147</c:v>
                </c:pt>
                <c:pt idx="2473">
                  <c:v>0.62915118605315801</c:v>
                </c:pt>
                <c:pt idx="2474">
                  <c:v>0.62583595312946561</c:v>
                </c:pt>
                <c:pt idx="2475">
                  <c:v>0.62120605887396396</c:v>
                </c:pt>
                <c:pt idx="2476">
                  <c:v>0.60725921691911977</c:v>
                </c:pt>
                <c:pt idx="2477">
                  <c:v>0.63080880251500426</c:v>
                </c:pt>
                <c:pt idx="2478">
                  <c:v>0.63766790511574734</c:v>
                </c:pt>
                <c:pt idx="2479">
                  <c:v>0.63103743926836242</c:v>
                </c:pt>
                <c:pt idx="2480">
                  <c:v>0.63578165190054303</c:v>
                </c:pt>
                <c:pt idx="2481">
                  <c:v>0.6214918548156616</c:v>
                </c:pt>
                <c:pt idx="2482">
                  <c:v>0.63521006001714775</c:v>
                </c:pt>
                <c:pt idx="2483">
                  <c:v>0.65150042869391256</c:v>
                </c:pt>
                <c:pt idx="2484">
                  <c:v>0.64504144041154621</c:v>
                </c:pt>
                <c:pt idx="2485">
                  <c:v>0.62777936553300939</c:v>
                </c:pt>
                <c:pt idx="2486">
                  <c:v>0.65190054301228928</c:v>
                </c:pt>
                <c:pt idx="2487">
                  <c:v>0.64189768505287226</c:v>
                </c:pt>
                <c:pt idx="2488">
                  <c:v>0.62549299799942837</c:v>
                </c:pt>
                <c:pt idx="2489">
                  <c:v>0.65990282937982281</c:v>
                </c:pt>
                <c:pt idx="2490">
                  <c:v>0.63178050871677627</c:v>
                </c:pt>
                <c:pt idx="2491">
                  <c:v>0.64698485281508999</c:v>
                </c:pt>
                <c:pt idx="2492">
                  <c:v>0.6248642469276936</c:v>
                </c:pt>
                <c:pt idx="2493">
                  <c:v>0.60342955130037157</c:v>
                </c:pt>
                <c:pt idx="2494">
                  <c:v>0.62669334095455842</c:v>
                </c:pt>
                <c:pt idx="2495">
                  <c:v>0.63075164332666478</c:v>
                </c:pt>
                <c:pt idx="2496">
                  <c:v>0.62560731637610745</c:v>
                </c:pt>
                <c:pt idx="2497">
                  <c:v>0.62412117747927975</c:v>
                </c:pt>
                <c:pt idx="2498">
                  <c:v>0.6172049156901972</c:v>
                </c:pt>
                <c:pt idx="2499">
                  <c:v>0.62052014861388971</c:v>
                </c:pt>
                <c:pt idx="2500">
                  <c:v>0.6325807373535296</c:v>
                </c:pt>
                <c:pt idx="2501">
                  <c:v>0.62383538153758211</c:v>
                </c:pt>
                <c:pt idx="2502">
                  <c:v>0.63726779079737073</c:v>
                </c:pt>
                <c:pt idx="2503">
                  <c:v>0.63275221491854816</c:v>
                </c:pt>
                <c:pt idx="2504">
                  <c:v>0.65504429837096312</c:v>
                </c:pt>
                <c:pt idx="2505">
                  <c:v>0.62092026293226632</c:v>
                </c:pt>
                <c:pt idx="2506">
                  <c:v>0.65487282080594456</c:v>
                </c:pt>
                <c:pt idx="2507">
                  <c:v>0.62497856530437268</c:v>
                </c:pt>
                <c:pt idx="2508">
                  <c:v>0.63389539868533862</c:v>
                </c:pt>
                <c:pt idx="2509">
                  <c:v>0.63320948842526437</c:v>
                </c:pt>
                <c:pt idx="2510">
                  <c:v>0.63538153758216631</c:v>
                </c:pt>
                <c:pt idx="2511">
                  <c:v>0.62172049156901976</c:v>
                </c:pt>
                <c:pt idx="2512">
                  <c:v>0.61314661331809084</c:v>
                </c:pt>
                <c:pt idx="2513">
                  <c:v>0.6282366390397256</c:v>
                </c:pt>
                <c:pt idx="2514">
                  <c:v>0.59519862817947988</c:v>
                </c:pt>
                <c:pt idx="2515">
                  <c:v>0.6004001143183767</c:v>
                </c:pt>
                <c:pt idx="2516">
                  <c:v>0.61080308659617033</c:v>
                </c:pt>
                <c:pt idx="2517">
                  <c:v>0.61549014004001146</c:v>
                </c:pt>
                <c:pt idx="2518">
                  <c:v>0.63875392969419831</c:v>
                </c:pt>
                <c:pt idx="2519">
                  <c:v>0.62034867104887115</c:v>
                </c:pt>
                <c:pt idx="2520">
                  <c:v>0.63909688482423554</c:v>
                </c:pt>
                <c:pt idx="2521">
                  <c:v>0.64326950557302087</c:v>
                </c:pt>
                <c:pt idx="2522">
                  <c:v>0.61977707916547586</c:v>
                </c:pt>
                <c:pt idx="2523">
                  <c:v>0.63463846813375246</c:v>
                </c:pt>
                <c:pt idx="2524">
                  <c:v>0.61926264647042017</c:v>
                </c:pt>
                <c:pt idx="2525">
                  <c:v>0.60771649042583598</c:v>
                </c:pt>
                <c:pt idx="2526">
                  <c:v>0.61543298085167186</c:v>
                </c:pt>
                <c:pt idx="2527">
                  <c:v>0.62732209202629319</c:v>
                </c:pt>
                <c:pt idx="2528">
                  <c:v>0.61263218062303515</c:v>
                </c:pt>
                <c:pt idx="2529">
                  <c:v>0.63069448413832518</c:v>
                </c:pt>
                <c:pt idx="2530">
                  <c:v>0.62023435267219207</c:v>
                </c:pt>
                <c:pt idx="2531">
                  <c:v>0.64126893398113749</c:v>
                </c:pt>
                <c:pt idx="2532">
                  <c:v>0.61994855673049443</c:v>
                </c:pt>
                <c:pt idx="2533">
                  <c:v>0.62206344669905689</c:v>
                </c:pt>
                <c:pt idx="2534">
                  <c:v>0.62812232066304663</c:v>
                </c:pt>
                <c:pt idx="2535">
                  <c:v>0.63389539868533862</c:v>
                </c:pt>
                <c:pt idx="2536">
                  <c:v>0.61851957702200633</c:v>
                </c:pt>
                <c:pt idx="2537">
                  <c:v>0.63458130894541298</c:v>
                </c:pt>
                <c:pt idx="2538">
                  <c:v>0.64715633038010856</c:v>
                </c:pt>
                <c:pt idx="2539">
                  <c:v>0.62509288368105176</c:v>
                </c:pt>
                <c:pt idx="2540">
                  <c:v>0.60097170620177198</c:v>
                </c:pt>
                <c:pt idx="2541">
                  <c:v>0.62412117747927975</c:v>
                </c:pt>
                <c:pt idx="2542">
                  <c:v>0.60148613889682767</c:v>
                </c:pt>
                <c:pt idx="2543">
                  <c:v>0.62743641040297227</c:v>
                </c:pt>
                <c:pt idx="2544">
                  <c:v>0.61783366676193197</c:v>
                </c:pt>
                <c:pt idx="2545">
                  <c:v>0.60411546156044582</c:v>
                </c:pt>
                <c:pt idx="2546">
                  <c:v>0.62406401829094027</c:v>
                </c:pt>
                <c:pt idx="2547">
                  <c:v>0.61823378108030869</c:v>
                </c:pt>
                <c:pt idx="2548">
                  <c:v>0.63269505573020868</c:v>
                </c:pt>
                <c:pt idx="2549">
                  <c:v>0.63995427264932836</c:v>
                </c:pt>
                <c:pt idx="2550">
                  <c:v>0.62109174049728488</c:v>
                </c:pt>
                <c:pt idx="2551">
                  <c:v>0.61749071163189484</c:v>
                </c:pt>
                <c:pt idx="2552">
                  <c:v>0.62189196913403832</c:v>
                </c:pt>
                <c:pt idx="2553">
                  <c:v>0.62240640182909401</c:v>
                </c:pt>
                <c:pt idx="2554">
                  <c:v>0.60783080880251505</c:v>
                </c:pt>
                <c:pt idx="2555">
                  <c:v>0.61617605030008571</c:v>
                </c:pt>
                <c:pt idx="2556">
                  <c:v>0.61983423835381535</c:v>
                </c:pt>
                <c:pt idx="2557">
                  <c:v>0.60777364961417546</c:v>
                </c:pt>
                <c:pt idx="2558">
                  <c:v>0.62034867104887115</c:v>
                </c:pt>
                <c:pt idx="2559">
                  <c:v>0.61028865390111464</c:v>
                </c:pt>
                <c:pt idx="2560">
                  <c:v>0.59456987710774512</c:v>
                </c:pt>
                <c:pt idx="2561">
                  <c:v>0.61686196056016007</c:v>
                </c:pt>
                <c:pt idx="2562">
                  <c:v>0.6061160331523292</c:v>
                </c:pt>
                <c:pt idx="2563">
                  <c:v>0.61171763360960274</c:v>
                </c:pt>
                <c:pt idx="2564">
                  <c:v>0.63103743926836242</c:v>
                </c:pt>
                <c:pt idx="2565">
                  <c:v>0.59514146899114029</c:v>
                </c:pt>
                <c:pt idx="2566">
                  <c:v>0.63292369248356672</c:v>
                </c:pt>
                <c:pt idx="2567">
                  <c:v>0.61709059731351812</c:v>
                </c:pt>
                <c:pt idx="2568">
                  <c:v>0.62995141468991145</c:v>
                </c:pt>
                <c:pt idx="2569">
                  <c:v>0.62383538153758211</c:v>
                </c:pt>
                <c:pt idx="2570">
                  <c:v>0.61771934838525289</c:v>
                </c:pt>
                <c:pt idx="2571">
                  <c:v>0.63326664761360385</c:v>
                </c:pt>
                <c:pt idx="2572">
                  <c:v>0.60051443269505578</c:v>
                </c:pt>
                <c:pt idx="2573">
                  <c:v>0.61589025435838807</c:v>
                </c:pt>
                <c:pt idx="2574">
                  <c:v>0.59542726493283793</c:v>
                </c:pt>
                <c:pt idx="2575">
                  <c:v>0.60297227779365536</c:v>
                </c:pt>
                <c:pt idx="2576">
                  <c:v>0.59862817947985136</c:v>
                </c:pt>
                <c:pt idx="2577">
                  <c:v>0.60320091454701341</c:v>
                </c:pt>
                <c:pt idx="2578">
                  <c:v>0.61434695627322089</c:v>
                </c:pt>
                <c:pt idx="2579">
                  <c:v>0.6210345813089454</c:v>
                </c:pt>
                <c:pt idx="2580">
                  <c:v>0.60337239211203197</c:v>
                </c:pt>
                <c:pt idx="2581">
                  <c:v>0.61903400971706202</c:v>
                </c:pt>
                <c:pt idx="2582">
                  <c:v>0.5902829379822806</c:v>
                </c:pt>
                <c:pt idx="2583">
                  <c:v>0.62166333238068017</c:v>
                </c:pt>
                <c:pt idx="2584">
                  <c:v>0.60908831094598459</c:v>
                </c:pt>
                <c:pt idx="2585">
                  <c:v>0.63703915404401257</c:v>
                </c:pt>
                <c:pt idx="2586">
                  <c:v>0.62120605887396396</c:v>
                </c:pt>
                <c:pt idx="2587">
                  <c:v>0.63458130894541298</c:v>
                </c:pt>
                <c:pt idx="2588">
                  <c:v>0.62469276936267504</c:v>
                </c:pt>
                <c:pt idx="2589">
                  <c:v>0.61440411546156048</c:v>
                </c:pt>
                <c:pt idx="2590">
                  <c:v>0.61440411546156048</c:v>
                </c:pt>
                <c:pt idx="2591">
                  <c:v>0.61697627893683915</c:v>
                </c:pt>
                <c:pt idx="2592">
                  <c:v>0.60891683338096603</c:v>
                </c:pt>
                <c:pt idx="2593">
                  <c:v>0.59388396684767075</c:v>
                </c:pt>
                <c:pt idx="2594">
                  <c:v>0.60971706201771936</c:v>
                </c:pt>
                <c:pt idx="2595">
                  <c:v>0.61286081737639331</c:v>
                </c:pt>
                <c:pt idx="2596">
                  <c:v>0.60371534724206921</c:v>
                </c:pt>
                <c:pt idx="2597">
                  <c:v>0.61103172334952849</c:v>
                </c:pt>
                <c:pt idx="2598">
                  <c:v>0.61211774792797946</c:v>
                </c:pt>
                <c:pt idx="2599">
                  <c:v>0.60788796799085454</c:v>
                </c:pt>
                <c:pt idx="2600">
                  <c:v>0.60583023721063156</c:v>
                </c:pt>
                <c:pt idx="2601">
                  <c:v>0.62743641040297227</c:v>
                </c:pt>
                <c:pt idx="2602">
                  <c:v>0.60405830237210634</c:v>
                </c:pt>
                <c:pt idx="2603">
                  <c:v>0.61108888253786797</c:v>
                </c:pt>
                <c:pt idx="2604">
                  <c:v>0.63143755358673903</c:v>
                </c:pt>
                <c:pt idx="2605">
                  <c:v>0.61926264647042017</c:v>
                </c:pt>
                <c:pt idx="2606">
                  <c:v>0.6124035438696771</c:v>
                </c:pt>
                <c:pt idx="2607">
                  <c:v>0.63383823949699913</c:v>
                </c:pt>
                <c:pt idx="2608">
                  <c:v>0.61646184624178335</c:v>
                </c:pt>
                <c:pt idx="2609">
                  <c:v>0.62052014861388971</c:v>
                </c:pt>
                <c:pt idx="2610">
                  <c:v>0.62332094884252642</c:v>
                </c:pt>
                <c:pt idx="2611">
                  <c:v>0.61080308659617033</c:v>
                </c:pt>
                <c:pt idx="2612">
                  <c:v>0.58862532152043445</c:v>
                </c:pt>
                <c:pt idx="2613">
                  <c:v>0.61543298085167186</c:v>
                </c:pt>
                <c:pt idx="2614">
                  <c:v>0.60548728208059444</c:v>
                </c:pt>
                <c:pt idx="2615">
                  <c:v>0.59668476707630747</c:v>
                </c:pt>
                <c:pt idx="2616">
                  <c:v>0.6076021720491569</c:v>
                </c:pt>
                <c:pt idx="2617">
                  <c:v>0.62012003429551299</c:v>
                </c:pt>
                <c:pt idx="2618">
                  <c:v>0.63275221491854816</c:v>
                </c:pt>
                <c:pt idx="2619">
                  <c:v>0.60920262932266367</c:v>
                </c:pt>
                <c:pt idx="2620">
                  <c:v>0.62960845955987421</c:v>
                </c:pt>
                <c:pt idx="2621">
                  <c:v>0.62314947127750786</c:v>
                </c:pt>
                <c:pt idx="2622">
                  <c:v>0.62623606744784222</c:v>
                </c:pt>
                <c:pt idx="2623">
                  <c:v>0.61411831951986284</c:v>
                </c:pt>
                <c:pt idx="2624">
                  <c:v>0.6320663046584738</c:v>
                </c:pt>
                <c:pt idx="2625">
                  <c:v>0.61177479279794222</c:v>
                </c:pt>
                <c:pt idx="2626">
                  <c:v>0.62863675335810232</c:v>
                </c:pt>
                <c:pt idx="2627">
                  <c:v>0.6416690482995141</c:v>
                </c:pt>
                <c:pt idx="2628">
                  <c:v>0.6186338953986853</c:v>
                </c:pt>
                <c:pt idx="2629">
                  <c:v>0.63212346384681339</c:v>
                </c:pt>
                <c:pt idx="2630">
                  <c:v>0.60897399256930551</c:v>
                </c:pt>
                <c:pt idx="2631">
                  <c:v>0.60462989425550162</c:v>
                </c:pt>
                <c:pt idx="2632">
                  <c:v>0.62274935695913114</c:v>
                </c:pt>
                <c:pt idx="2633">
                  <c:v>0.63126607602172047</c:v>
                </c:pt>
                <c:pt idx="2634">
                  <c:v>0.61074592740783085</c:v>
                </c:pt>
                <c:pt idx="2635">
                  <c:v>0.62429265504429832</c:v>
                </c:pt>
                <c:pt idx="2636">
                  <c:v>0.6008573878250929</c:v>
                </c:pt>
                <c:pt idx="2637">
                  <c:v>0.61491854815661617</c:v>
                </c:pt>
                <c:pt idx="2638">
                  <c:v>0.58508145184338378</c:v>
                </c:pt>
                <c:pt idx="2639">
                  <c:v>0.62497856530437268</c:v>
                </c:pt>
                <c:pt idx="2640">
                  <c:v>0.602286367533581</c:v>
                </c:pt>
                <c:pt idx="2641">
                  <c:v>0.63069448413832518</c:v>
                </c:pt>
                <c:pt idx="2642">
                  <c:v>0.64544155472992282</c:v>
                </c:pt>
                <c:pt idx="2643">
                  <c:v>0.60440125750214346</c:v>
                </c:pt>
                <c:pt idx="2644">
                  <c:v>0.60731637610745925</c:v>
                </c:pt>
                <c:pt idx="2645">
                  <c:v>0.62509288368105176</c:v>
                </c:pt>
                <c:pt idx="2646">
                  <c:v>0.60440125750214346</c:v>
                </c:pt>
                <c:pt idx="2647">
                  <c:v>0.59994284081166049</c:v>
                </c:pt>
                <c:pt idx="2648">
                  <c:v>0.61320377250643043</c:v>
                </c:pt>
                <c:pt idx="2649">
                  <c:v>0.59176907687910829</c:v>
                </c:pt>
                <c:pt idx="2650">
                  <c:v>0.62280651614747073</c:v>
                </c:pt>
                <c:pt idx="2651">
                  <c:v>0.62320663046584734</c:v>
                </c:pt>
                <c:pt idx="2652">
                  <c:v>0.61177479279794222</c:v>
                </c:pt>
                <c:pt idx="2653">
                  <c:v>0.60977422120605884</c:v>
                </c:pt>
                <c:pt idx="2654">
                  <c:v>0.61646184624178335</c:v>
                </c:pt>
                <c:pt idx="2655">
                  <c:v>0.60194341240354388</c:v>
                </c:pt>
                <c:pt idx="2656">
                  <c:v>0.60885967419262643</c:v>
                </c:pt>
                <c:pt idx="2657">
                  <c:v>0.58485281509002573</c:v>
                </c:pt>
                <c:pt idx="2658">
                  <c:v>0.61897685052872253</c:v>
                </c:pt>
                <c:pt idx="2659">
                  <c:v>0.61520434409831382</c:v>
                </c:pt>
                <c:pt idx="2660">
                  <c:v>0.61874821377536438</c:v>
                </c:pt>
                <c:pt idx="2661">
                  <c:v>0.60348671048871105</c:v>
                </c:pt>
                <c:pt idx="2662">
                  <c:v>0.60057159188339526</c:v>
                </c:pt>
                <c:pt idx="2663">
                  <c:v>0.60531580451557587</c:v>
                </c:pt>
                <c:pt idx="2664">
                  <c:v>0.6157759359817091</c:v>
                </c:pt>
                <c:pt idx="2665">
                  <c:v>0.60354386967705054</c:v>
                </c:pt>
                <c:pt idx="2666">
                  <c:v>0.58771077450700204</c:v>
                </c:pt>
                <c:pt idx="2667">
                  <c:v>0.59474135467276368</c:v>
                </c:pt>
                <c:pt idx="2668">
                  <c:v>0.60405830237210634</c:v>
                </c:pt>
                <c:pt idx="2669">
                  <c:v>0.60274364104029721</c:v>
                </c:pt>
                <c:pt idx="2670">
                  <c:v>0.57559302657902256</c:v>
                </c:pt>
                <c:pt idx="2671">
                  <c:v>0.58776793369534153</c:v>
                </c:pt>
                <c:pt idx="2672">
                  <c:v>0.58622463561017435</c:v>
                </c:pt>
                <c:pt idx="2673">
                  <c:v>0.60200057159188336</c:v>
                </c:pt>
                <c:pt idx="2674">
                  <c:v>0.60445841669048295</c:v>
                </c:pt>
                <c:pt idx="2675">
                  <c:v>0.57719348385252933</c:v>
                </c:pt>
                <c:pt idx="2676">
                  <c:v>0.605658759645613</c:v>
                </c:pt>
                <c:pt idx="2677">
                  <c:v>0.60102886539011147</c:v>
                </c:pt>
                <c:pt idx="2678">
                  <c:v>0.60817376393255218</c:v>
                </c:pt>
                <c:pt idx="2679">
                  <c:v>0.5965132895112889</c:v>
                </c:pt>
                <c:pt idx="2680">
                  <c:v>0.5946270362960846</c:v>
                </c:pt>
                <c:pt idx="2681">
                  <c:v>0.60885967419262643</c:v>
                </c:pt>
                <c:pt idx="2682">
                  <c:v>0.59754215490140039</c:v>
                </c:pt>
                <c:pt idx="2683">
                  <c:v>0.6176621891969134</c:v>
                </c:pt>
                <c:pt idx="2684">
                  <c:v>0.60451557587882254</c:v>
                </c:pt>
                <c:pt idx="2685">
                  <c:v>0.59885681623320952</c:v>
                </c:pt>
                <c:pt idx="2686">
                  <c:v>0.62389254072592171</c:v>
                </c:pt>
                <c:pt idx="2687">
                  <c:v>0.60400114318376674</c:v>
                </c:pt>
                <c:pt idx="2688">
                  <c:v>0.60428693912546438</c:v>
                </c:pt>
                <c:pt idx="2689">
                  <c:v>0.60491569019719915</c:v>
                </c:pt>
                <c:pt idx="2690">
                  <c:v>0.59588453843955413</c:v>
                </c:pt>
                <c:pt idx="2691">
                  <c:v>0.60880251500428695</c:v>
                </c:pt>
                <c:pt idx="2692">
                  <c:v>0.60680194341240357</c:v>
                </c:pt>
                <c:pt idx="2693">
                  <c:v>0.59308373821091742</c:v>
                </c:pt>
                <c:pt idx="2694">
                  <c:v>0.60691626178908264</c:v>
                </c:pt>
                <c:pt idx="2695">
                  <c:v>0.58799657044869957</c:v>
                </c:pt>
                <c:pt idx="2696">
                  <c:v>0.62789368390968847</c:v>
                </c:pt>
                <c:pt idx="2697">
                  <c:v>0.60520148613889679</c:v>
                </c:pt>
                <c:pt idx="2698">
                  <c:v>0.59205487282080593</c:v>
                </c:pt>
                <c:pt idx="2699">
                  <c:v>0.6008573878250929</c:v>
                </c:pt>
                <c:pt idx="2700">
                  <c:v>0.6157759359817091</c:v>
                </c:pt>
                <c:pt idx="2701">
                  <c:v>0.59691340382966562</c:v>
                </c:pt>
                <c:pt idx="2702">
                  <c:v>0.59188339525578737</c:v>
                </c:pt>
                <c:pt idx="2703">
                  <c:v>0.57599314089739928</c:v>
                </c:pt>
                <c:pt idx="2704">
                  <c:v>0.58822520720205773</c:v>
                </c:pt>
                <c:pt idx="2705">
                  <c:v>0.59228350957416409</c:v>
                </c:pt>
                <c:pt idx="2706">
                  <c:v>0.61348956844812808</c:v>
                </c:pt>
                <c:pt idx="2707">
                  <c:v>0.60120034295513003</c:v>
                </c:pt>
                <c:pt idx="2708">
                  <c:v>0.59965704486996285</c:v>
                </c:pt>
                <c:pt idx="2709">
                  <c:v>0.61674764218348099</c:v>
                </c:pt>
                <c:pt idx="2710">
                  <c:v>0.61268933981137463</c:v>
                </c:pt>
                <c:pt idx="2711">
                  <c:v>0.59742783652472131</c:v>
                </c:pt>
                <c:pt idx="2712">
                  <c:v>0.60531580451557587</c:v>
                </c:pt>
                <c:pt idx="2713">
                  <c:v>0.59754215490140039</c:v>
                </c:pt>
                <c:pt idx="2714">
                  <c:v>0.60491569019719915</c:v>
                </c:pt>
                <c:pt idx="2715">
                  <c:v>0.59108316661903404</c:v>
                </c:pt>
                <c:pt idx="2716">
                  <c:v>0.61251786224635607</c:v>
                </c:pt>
                <c:pt idx="2717">
                  <c:v>0.60171477565018572</c:v>
                </c:pt>
                <c:pt idx="2718">
                  <c:v>0.60577307802229208</c:v>
                </c:pt>
                <c:pt idx="2719">
                  <c:v>0.60342955130037157</c:v>
                </c:pt>
                <c:pt idx="2720">
                  <c:v>0.60697342097742213</c:v>
                </c:pt>
                <c:pt idx="2721">
                  <c:v>0.56919119748499569</c:v>
                </c:pt>
                <c:pt idx="2722">
                  <c:v>0.58976850528722491</c:v>
                </c:pt>
                <c:pt idx="2723">
                  <c:v>0.59708488139468419</c:v>
                </c:pt>
                <c:pt idx="2724">
                  <c:v>0.61183195198628182</c:v>
                </c:pt>
                <c:pt idx="2725">
                  <c:v>0.58719634181194624</c:v>
                </c:pt>
                <c:pt idx="2726">
                  <c:v>0.58170905973135179</c:v>
                </c:pt>
                <c:pt idx="2727">
                  <c:v>0.59382680765933127</c:v>
                </c:pt>
                <c:pt idx="2728">
                  <c:v>0.57296370391540441</c:v>
                </c:pt>
                <c:pt idx="2729">
                  <c:v>0.58776793369534153</c:v>
                </c:pt>
                <c:pt idx="2730">
                  <c:v>0.57382109174049734</c:v>
                </c:pt>
                <c:pt idx="2731">
                  <c:v>0.59777079165475855</c:v>
                </c:pt>
                <c:pt idx="2732">
                  <c:v>0.61800514432695053</c:v>
                </c:pt>
                <c:pt idx="2733">
                  <c:v>0.57719348385252933</c:v>
                </c:pt>
                <c:pt idx="2734">
                  <c:v>0.60880251500428695</c:v>
                </c:pt>
                <c:pt idx="2735">
                  <c:v>0.59251214632752214</c:v>
                </c:pt>
                <c:pt idx="2736">
                  <c:v>0.59879965704486993</c:v>
                </c:pt>
                <c:pt idx="2737">
                  <c:v>0.59954272649328377</c:v>
                </c:pt>
                <c:pt idx="2738">
                  <c:v>0.58765361531866245</c:v>
                </c:pt>
                <c:pt idx="2739">
                  <c:v>0.58450985995998861</c:v>
                </c:pt>
                <c:pt idx="2740">
                  <c:v>0.58719634181194624</c:v>
                </c:pt>
                <c:pt idx="2741">
                  <c:v>0.57696484709917117</c:v>
                </c:pt>
                <c:pt idx="2742">
                  <c:v>0.58125178622463558</c:v>
                </c:pt>
                <c:pt idx="2743">
                  <c:v>0.59251214632752214</c:v>
                </c:pt>
                <c:pt idx="2744">
                  <c:v>0.59194055444412685</c:v>
                </c:pt>
                <c:pt idx="2745">
                  <c:v>0.59679908545298654</c:v>
                </c:pt>
                <c:pt idx="2746">
                  <c:v>0.59131180337239209</c:v>
                </c:pt>
                <c:pt idx="2747">
                  <c:v>0.60148613889682767</c:v>
                </c:pt>
                <c:pt idx="2748">
                  <c:v>0.59068305230065732</c:v>
                </c:pt>
                <c:pt idx="2749">
                  <c:v>0.60714489854244069</c:v>
                </c:pt>
                <c:pt idx="2750">
                  <c:v>0.6162332094884253</c:v>
                </c:pt>
                <c:pt idx="2751">
                  <c:v>0.61537582166333238</c:v>
                </c:pt>
                <c:pt idx="2752">
                  <c:v>0.59719919977136326</c:v>
                </c:pt>
                <c:pt idx="2753">
                  <c:v>0.61823378108030869</c:v>
                </c:pt>
                <c:pt idx="2754">
                  <c:v>0.56987710774507006</c:v>
                </c:pt>
                <c:pt idx="2755">
                  <c:v>0.58239496999142615</c:v>
                </c:pt>
                <c:pt idx="2756">
                  <c:v>0.60325807373535301</c:v>
                </c:pt>
                <c:pt idx="2757">
                  <c:v>0.59719919977136326</c:v>
                </c:pt>
                <c:pt idx="2758">
                  <c:v>0.55724492712203488</c:v>
                </c:pt>
                <c:pt idx="2759">
                  <c:v>0.56364675621606175</c:v>
                </c:pt>
                <c:pt idx="2760">
                  <c:v>0.57913689625607312</c:v>
                </c:pt>
                <c:pt idx="2761">
                  <c:v>0.56376107459274083</c:v>
                </c:pt>
                <c:pt idx="2762">
                  <c:v>0.5888539582737925</c:v>
                </c:pt>
                <c:pt idx="2763">
                  <c:v>0.57473563875392975</c:v>
                </c:pt>
                <c:pt idx="2764">
                  <c:v>0.57759359817090594</c:v>
                </c:pt>
                <c:pt idx="2765">
                  <c:v>0.59537010574449845</c:v>
                </c:pt>
                <c:pt idx="2766">
                  <c:v>0.59742783652472131</c:v>
                </c:pt>
                <c:pt idx="2767">
                  <c:v>0.58719634181194624</c:v>
                </c:pt>
                <c:pt idx="2768">
                  <c:v>0.58679622749356963</c:v>
                </c:pt>
                <c:pt idx="2769">
                  <c:v>0.59325521577593598</c:v>
                </c:pt>
                <c:pt idx="2770">
                  <c:v>0.5902829379822806</c:v>
                </c:pt>
                <c:pt idx="2771">
                  <c:v>0.61068876821949125</c:v>
                </c:pt>
                <c:pt idx="2772">
                  <c:v>0.59228350957416409</c:v>
                </c:pt>
                <c:pt idx="2773">
                  <c:v>0.59371248928265219</c:v>
                </c:pt>
                <c:pt idx="2774">
                  <c:v>0.56564732780794513</c:v>
                </c:pt>
                <c:pt idx="2775">
                  <c:v>0.58811088882537865</c:v>
                </c:pt>
                <c:pt idx="2776">
                  <c:v>0.59628465275793086</c:v>
                </c:pt>
                <c:pt idx="2777">
                  <c:v>0.58370963132323517</c:v>
                </c:pt>
                <c:pt idx="2778">
                  <c:v>0.57639325521577589</c:v>
                </c:pt>
                <c:pt idx="2779">
                  <c:v>0.59622749356959126</c:v>
                </c:pt>
                <c:pt idx="2780">
                  <c:v>0.55404401257502145</c:v>
                </c:pt>
                <c:pt idx="2781">
                  <c:v>0.57547870820234348</c:v>
                </c:pt>
                <c:pt idx="2782">
                  <c:v>0.57553586739068308</c:v>
                </c:pt>
                <c:pt idx="2783">
                  <c:v>0.57742212060588738</c:v>
                </c:pt>
                <c:pt idx="2784">
                  <c:v>0.58382394969991425</c:v>
                </c:pt>
                <c:pt idx="2785">
                  <c:v>0.57759359817090594</c:v>
                </c:pt>
                <c:pt idx="2786">
                  <c:v>0.55518719634181191</c:v>
                </c:pt>
                <c:pt idx="2787">
                  <c:v>0.60131466133180911</c:v>
                </c:pt>
                <c:pt idx="2788">
                  <c:v>0.5835381537582166</c:v>
                </c:pt>
                <c:pt idx="2789">
                  <c:v>0.59697056301800511</c:v>
                </c:pt>
                <c:pt idx="2790">
                  <c:v>0.59194055444412685</c:v>
                </c:pt>
                <c:pt idx="2791">
                  <c:v>0.59531294655615885</c:v>
                </c:pt>
                <c:pt idx="2792">
                  <c:v>0.59719919977136326</c:v>
                </c:pt>
                <c:pt idx="2793">
                  <c:v>0.61040297227779361</c:v>
                </c:pt>
                <c:pt idx="2794">
                  <c:v>0.58702486424692768</c:v>
                </c:pt>
                <c:pt idx="2795">
                  <c:v>0.59285510145755926</c:v>
                </c:pt>
                <c:pt idx="2796">
                  <c:v>0.60251500428693916</c:v>
                </c:pt>
                <c:pt idx="2797">
                  <c:v>0.5777650757359245</c:v>
                </c:pt>
                <c:pt idx="2798">
                  <c:v>0.59136896256073168</c:v>
                </c:pt>
                <c:pt idx="2799">
                  <c:v>0.57713632466418974</c:v>
                </c:pt>
                <c:pt idx="2800">
                  <c:v>0.59176907687910829</c:v>
                </c:pt>
                <c:pt idx="2801">
                  <c:v>0.57416404687053446</c:v>
                </c:pt>
                <c:pt idx="2802">
                  <c:v>0.57770791654758502</c:v>
                </c:pt>
                <c:pt idx="2803">
                  <c:v>0.57273506716204625</c:v>
                </c:pt>
                <c:pt idx="2804">
                  <c:v>0.58588168048013722</c:v>
                </c:pt>
                <c:pt idx="2805">
                  <c:v>0.55947413546727631</c:v>
                </c:pt>
                <c:pt idx="2806">
                  <c:v>0.58222349242640759</c:v>
                </c:pt>
                <c:pt idx="2807">
                  <c:v>0.57719348385252933</c:v>
                </c:pt>
                <c:pt idx="2808">
                  <c:v>0.57816519005430123</c:v>
                </c:pt>
                <c:pt idx="2809">
                  <c:v>0.57170620177193487</c:v>
                </c:pt>
                <c:pt idx="2810">
                  <c:v>0.58462417833666758</c:v>
                </c:pt>
                <c:pt idx="2811">
                  <c:v>0.58719634181194624</c:v>
                </c:pt>
                <c:pt idx="2812">
                  <c:v>0.60171477565018572</c:v>
                </c:pt>
                <c:pt idx="2813">
                  <c:v>0.56604744212632185</c:v>
                </c:pt>
                <c:pt idx="2814">
                  <c:v>0.58673906830523004</c:v>
                </c:pt>
                <c:pt idx="2815">
                  <c:v>0.58250928836810523</c:v>
                </c:pt>
                <c:pt idx="2816">
                  <c:v>0.5739354101171763</c:v>
                </c:pt>
                <c:pt idx="2817">
                  <c:v>0.58159474135467282</c:v>
                </c:pt>
                <c:pt idx="2818">
                  <c:v>0.58142326378965414</c:v>
                </c:pt>
                <c:pt idx="2819">
                  <c:v>0.58016576164618461</c:v>
                </c:pt>
                <c:pt idx="2820">
                  <c:v>0.58433838239497005</c:v>
                </c:pt>
                <c:pt idx="2821">
                  <c:v>0.57890825950271507</c:v>
                </c:pt>
                <c:pt idx="2822">
                  <c:v>0.56427550728779652</c:v>
                </c:pt>
                <c:pt idx="2823">
                  <c:v>0.57559302657902256</c:v>
                </c:pt>
                <c:pt idx="2824">
                  <c:v>0.57090597313518143</c:v>
                </c:pt>
                <c:pt idx="2825">
                  <c:v>0.56570448699628462</c:v>
                </c:pt>
                <c:pt idx="2826">
                  <c:v>0.57799371248928266</c:v>
                </c:pt>
                <c:pt idx="2827">
                  <c:v>0.5681623320948842</c:v>
                </c:pt>
                <c:pt idx="2828">
                  <c:v>0.57404972849385538</c:v>
                </c:pt>
                <c:pt idx="2829">
                  <c:v>0.58376679051157476</c:v>
                </c:pt>
                <c:pt idx="2830">
                  <c:v>0.59325521577593598</c:v>
                </c:pt>
                <c:pt idx="2831">
                  <c:v>0.5701629036867677</c:v>
                </c:pt>
                <c:pt idx="2832">
                  <c:v>0.6003429551300371</c:v>
                </c:pt>
                <c:pt idx="2833">
                  <c:v>0.58679622749356963</c:v>
                </c:pt>
                <c:pt idx="2834">
                  <c:v>0.57959416976278932</c:v>
                </c:pt>
                <c:pt idx="2835">
                  <c:v>0.59022577879394111</c:v>
                </c:pt>
                <c:pt idx="2836">
                  <c:v>0.56501857673621037</c:v>
                </c:pt>
                <c:pt idx="2837">
                  <c:v>0.58342383538153764</c:v>
                </c:pt>
                <c:pt idx="2838">
                  <c:v>0.57553586739068308</c:v>
                </c:pt>
                <c:pt idx="2839">
                  <c:v>0.57593598170905969</c:v>
                </c:pt>
                <c:pt idx="2840">
                  <c:v>0.57605030008573876</c:v>
                </c:pt>
                <c:pt idx="2841">
                  <c:v>0.57810803086596174</c:v>
                </c:pt>
                <c:pt idx="2842">
                  <c:v>0.55947413546727631</c:v>
                </c:pt>
                <c:pt idx="2843">
                  <c:v>0.55130037153472422</c:v>
                </c:pt>
                <c:pt idx="2844">
                  <c:v>0.56667619319805662</c:v>
                </c:pt>
                <c:pt idx="2845">
                  <c:v>0.58222349242640759</c:v>
                </c:pt>
                <c:pt idx="2846">
                  <c:v>0.57027722206344666</c:v>
                </c:pt>
                <c:pt idx="2847">
                  <c:v>0.60520148613889679</c:v>
                </c:pt>
                <c:pt idx="2848">
                  <c:v>0.5874249785653044</c:v>
                </c:pt>
                <c:pt idx="2849">
                  <c:v>0.60365818805372962</c:v>
                </c:pt>
                <c:pt idx="2850">
                  <c:v>0.60028579594169762</c:v>
                </c:pt>
                <c:pt idx="2851">
                  <c:v>0.57142040583023723</c:v>
                </c:pt>
                <c:pt idx="2852">
                  <c:v>0.57559302657902256</c:v>
                </c:pt>
                <c:pt idx="2853">
                  <c:v>0.57650757359245497</c:v>
                </c:pt>
                <c:pt idx="2854">
                  <c:v>0.58891111746213198</c:v>
                </c:pt>
                <c:pt idx="2855">
                  <c:v>0.575421549014004</c:v>
                </c:pt>
                <c:pt idx="2856">
                  <c:v>0.56084595598742493</c:v>
                </c:pt>
                <c:pt idx="2857">
                  <c:v>0.56130322949414113</c:v>
                </c:pt>
                <c:pt idx="2858">
                  <c:v>0.56107459274078308</c:v>
                </c:pt>
                <c:pt idx="2859">
                  <c:v>0.55450128608173765</c:v>
                </c:pt>
                <c:pt idx="2860">
                  <c:v>0.57084881394684195</c:v>
                </c:pt>
                <c:pt idx="2861">
                  <c:v>0.55495855958845386</c:v>
                </c:pt>
                <c:pt idx="2862">
                  <c:v>0.57427836524721354</c:v>
                </c:pt>
                <c:pt idx="2863">
                  <c:v>0.5734781366104601</c:v>
                </c:pt>
                <c:pt idx="2864">
                  <c:v>0.56867676478994</c:v>
                </c:pt>
                <c:pt idx="2865">
                  <c:v>0.57439268362389251</c:v>
                </c:pt>
                <c:pt idx="2866">
                  <c:v>0.60005715918833957</c:v>
                </c:pt>
                <c:pt idx="2867">
                  <c:v>0.56164618462417837</c:v>
                </c:pt>
                <c:pt idx="2868">
                  <c:v>0.60354386967705054</c:v>
                </c:pt>
                <c:pt idx="2869">
                  <c:v>0.58028008002286369</c:v>
                </c:pt>
                <c:pt idx="2870">
                  <c:v>0.58971134609888542</c:v>
                </c:pt>
                <c:pt idx="2871">
                  <c:v>0.57410688768219487</c:v>
                </c:pt>
                <c:pt idx="2872">
                  <c:v>0.55484424121177478</c:v>
                </c:pt>
                <c:pt idx="2873">
                  <c:v>0.55735924549871396</c:v>
                </c:pt>
                <c:pt idx="2874">
                  <c:v>0.56587596456130318</c:v>
                </c:pt>
                <c:pt idx="2875">
                  <c:v>0.56850528722492144</c:v>
                </c:pt>
                <c:pt idx="2876">
                  <c:v>0.53541011717633613</c:v>
                </c:pt>
                <c:pt idx="2877">
                  <c:v>0.57056301800514431</c:v>
                </c:pt>
                <c:pt idx="2878">
                  <c:v>0.54872820805944555</c:v>
                </c:pt>
                <c:pt idx="2879">
                  <c:v>0.55775935981709057</c:v>
                </c:pt>
                <c:pt idx="2880">
                  <c:v>0.57096313232352103</c:v>
                </c:pt>
                <c:pt idx="2881">
                  <c:v>0.53866819091168905</c:v>
                </c:pt>
                <c:pt idx="2882">
                  <c:v>0.58159474135467282</c:v>
                </c:pt>
                <c:pt idx="2883">
                  <c:v>0.56370391540440123</c:v>
                </c:pt>
                <c:pt idx="2884">
                  <c:v>0.57673621034581313</c:v>
                </c:pt>
                <c:pt idx="2885">
                  <c:v>0.58348099456987712</c:v>
                </c:pt>
                <c:pt idx="2886">
                  <c:v>0.57610745927407836</c:v>
                </c:pt>
                <c:pt idx="2887">
                  <c:v>0.57439268362389251</c:v>
                </c:pt>
                <c:pt idx="2888">
                  <c:v>0.55998856816233211</c:v>
                </c:pt>
                <c:pt idx="2889">
                  <c:v>0.58519577022006286</c:v>
                </c:pt>
                <c:pt idx="2890">
                  <c:v>0.5715918833952558</c:v>
                </c:pt>
                <c:pt idx="2891">
                  <c:v>0.58108030865961702</c:v>
                </c:pt>
                <c:pt idx="2892">
                  <c:v>0.58079451271791938</c:v>
                </c:pt>
                <c:pt idx="2893">
                  <c:v>0.56124607030580165</c:v>
                </c:pt>
                <c:pt idx="2894">
                  <c:v>0.55061446127464986</c:v>
                </c:pt>
                <c:pt idx="2895">
                  <c:v>0.54878536724778504</c:v>
                </c:pt>
                <c:pt idx="2896">
                  <c:v>0.57279222635038585</c:v>
                </c:pt>
                <c:pt idx="2897">
                  <c:v>0.56461846241783364</c:v>
                </c:pt>
                <c:pt idx="2898">
                  <c:v>0.56313232352100595</c:v>
                </c:pt>
                <c:pt idx="2899">
                  <c:v>0.55027150614461273</c:v>
                </c:pt>
                <c:pt idx="2900">
                  <c:v>0.5547299228350957</c:v>
                </c:pt>
                <c:pt idx="2901">
                  <c:v>0.55290082880823088</c:v>
                </c:pt>
                <c:pt idx="2902">
                  <c:v>0.55307230637324944</c:v>
                </c:pt>
                <c:pt idx="2903">
                  <c:v>0.55335810231494709</c:v>
                </c:pt>
                <c:pt idx="2904">
                  <c:v>0.57187767933695344</c:v>
                </c:pt>
                <c:pt idx="2905">
                  <c:v>0.56273220920262934</c:v>
                </c:pt>
                <c:pt idx="2906">
                  <c:v>0.5777650757359245</c:v>
                </c:pt>
                <c:pt idx="2907">
                  <c:v>0.58771077450700204</c:v>
                </c:pt>
                <c:pt idx="2908">
                  <c:v>0.56604744212632185</c:v>
                </c:pt>
                <c:pt idx="2909">
                  <c:v>0.57330665904544154</c:v>
                </c:pt>
                <c:pt idx="2910">
                  <c:v>0.56747642183480995</c:v>
                </c:pt>
                <c:pt idx="2911">
                  <c:v>0.56507573592454985</c:v>
                </c:pt>
                <c:pt idx="2912">
                  <c:v>0.58319519862817948</c:v>
                </c:pt>
                <c:pt idx="2913">
                  <c:v>0.57639325521577589</c:v>
                </c:pt>
                <c:pt idx="2914">
                  <c:v>0.55627322092026288</c:v>
                </c:pt>
                <c:pt idx="2915">
                  <c:v>0.57027722206344666</c:v>
                </c:pt>
                <c:pt idx="2916">
                  <c:v>0.57193483852529292</c:v>
                </c:pt>
                <c:pt idx="2917">
                  <c:v>0.56038868248070872</c:v>
                </c:pt>
                <c:pt idx="2918">
                  <c:v>0.54781366104601315</c:v>
                </c:pt>
                <c:pt idx="2919">
                  <c:v>0.55204344098313807</c:v>
                </c:pt>
                <c:pt idx="2920">
                  <c:v>0.56336096027436411</c:v>
                </c:pt>
                <c:pt idx="2921">
                  <c:v>0.56753358102314944</c:v>
                </c:pt>
                <c:pt idx="2922">
                  <c:v>0.54404115461560443</c:v>
                </c:pt>
                <c:pt idx="2923">
                  <c:v>0.58445270077164901</c:v>
                </c:pt>
                <c:pt idx="2924">
                  <c:v>0.57433552443555302</c:v>
                </c:pt>
                <c:pt idx="2925">
                  <c:v>0.58130894541297518</c:v>
                </c:pt>
                <c:pt idx="2926">
                  <c:v>0.57805087167762215</c:v>
                </c:pt>
                <c:pt idx="2927">
                  <c:v>0.57833666761931979</c:v>
                </c:pt>
                <c:pt idx="2928">
                  <c:v>0.59411260360102891</c:v>
                </c:pt>
                <c:pt idx="2929">
                  <c:v>0.57090597313518143</c:v>
                </c:pt>
                <c:pt idx="2930">
                  <c:v>0.57416404687053446</c:v>
                </c:pt>
                <c:pt idx="2931">
                  <c:v>0.58525292940840246</c:v>
                </c:pt>
                <c:pt idx="2932">
                  <c:v>0.56787653615318667</c:v>
                </c:pt>
                <c:pt idx="2933">
                  <c:v>0.56673335238639611</c:v>
                </c:pt>
                <c:pt idx="2934">
                  <c:v>0.56747642183480995</c:v>
                </c:pt>
                <c:pt idx="2935">
                  <c:v>0.5514146899114033</c:v>
                </c:pt>
                <c:pt idx="2936">
                  <c:v>0.5547299228350957</c:v>
                </c:pt>
                <c:pt idx="2937">
                  <c:v>0.53929694198342382</c:v>
                </c:pt>
                <c:pt idx="2938">
                  <c:v>0.54581308945412976</c:v>
                </c:pt>
                <c:pt idx="2939">
                  <c:v>0.54524149757073448</c:v>
                </c:pt>
                <c:pt idx="2940">
                  <c:v>0.54964275507287796</c:v>
                </c:pt>
                <c:pt idx="2941">
                  <c:v>0.54478422406401827</c:v>
                </c:pt>
                <c:pt idx="2942">
                  <c:v>0.56490425835953129</c:v>
                </c:pt>
                <c:pt idx="2943">
                  <c:v>0.55095741640468709</c:v>
                </c:pt>
                <c:pt idx="2944">
                  <c:v>0.57513575307230635</c:v>
                </c:pt>
                <c:pt idx="2945">
                  <c:v>0.56307516433266647</c:v>
                </c:pt>
                <c:pt idx="2946">
                  <c:v>0.56873392397827949</c:v>
                </c:pt>
                <c:pt idx="2947">
                  <c:v>0.54272649328379541</c:v>
                </c:pt>
                <c:pt idx="2948">
                  <c:v>0.56764789939982851</c:v>
                </c:pt>
                <c:pt idx="2949">
                  <c:v>0.56238925407259222</c:v>
                </c:pt>
                <c:pt idx="2950">
                  <c:v>0.54415547299228351</c:v>
                </c:pt>
                <c:pt idx="2951">
                  <c:v>0.5662760788796799</c:v>
                </c:pt>
                <c:pt idx="2952">
                  <c:v>0.54575593026579028</c:v>
                </c:pt>
                <c:pt idx="2953">
                  <c:v>0.5518719634181195</c:v>
                </c:pt>
                <c:pt idx="2954">
                  <c:v>0.57627893683909692</c:v>
                </c:pt>
                <c:pt idx="2955">
                  <c:v>0.5662760788796799</c:v>
                </c:pt>
                <c:pt idx="2956">
                  <c:v>0.55970277222063447</c:v>
                </c:pt>
                <c:pt idx="2957">
                  <c:v>0.54929979994284084</c:v>
                </c:pt>
                <c:pt idx="2958">
                  <c:v>0.53260931694769931</c:v>
                </c:pt>
                <c:pt idx="2959">
                  <c:v>0.53781080308659612</c:v>
                </c:pt>
                <c:pt idx="2960">
                  <c:v>0.56330380108602462</c:v>
                </c:pt>
                <c:pt idx="2961">
                  <c:v>0.56593312374964277</c:v>
                </c:pt>
                <c:pt idx="2962">
                  <c:v>0.54621320377250648</c:v>
                </c:pt>
                <c:pt idx="2963">
                  <c:v>0.55215775935981704</c:v>
                </c:pt>
                <c:pt idx="2964">
                  <c:v>0.56844812803658185</c:v>
                </c:pt>
                <c:pt idx="2965">
                  <c:v>0.56021720491569016</c:v>
                </c:pt>
                <c:pt idx="2966">
                  <c:v>0.56507573592454985</c:v>
                </c:pt>
                <c:pt idx="2967">
                  <c:v>0.57222063446699056</c:v>
                </c:pt>
                <c:pt idx="2968">
                  <c:v>0.55833095170048586</c:v>
                </c:pt>
                <c:pt idx="2969">
                  <c:v>0.55467276364675622</c:v>
                </c:pt>
                <c:pt idx="2970">
                  <c:v>0.57142040583023723</c:v>
                </c:pt>
                <c:pt idx="2971">
                  <c:v>0.55495855958845386</c:v>
                </c:pt>
                <c:pt idx="2972">
                  <c:v>0.5509002572163475</c:v>
                </c:pt>
                <c:pt idx="2973">
                  <c:v>0.56621891969134042</c:v>
                </c:pt>
                <c:pt idx="2974">
                  <c:v>0.54066876250357243</c:v>
                </c:pt>
                <c:pt idx="2975">
                  <c:v>0.55804515575878821</c:v>
                </c:pt>
                <c:pt idx="2976">
                  <c:v>0.55107173478136606</c:v>
                </c:pt>
                <c:pt idx="2977">
                  <c:v>0.54421263218062299</c:v>
                </c:pt>
                <c:pt idx="2978">
                  <c:v>0.54632752214918545</c:v>
                </c:pt>
                <c:pt idx="2979">
                  <c:v>0.5379822806516148</c:v>
                </c:pt>
                <c:pt idx="2980">
                  <c:v>0.5552443555301515</c:v>
                </c:pt>
                <c:pt idx="2981">
                  <c:v>0.55895970277222062</c:v>
                </c:pt>
                <c:pt idx="2982">
                  <c:v>0.55221491854815663</c:v>
                </c:pt>
                <c:pt idx="2983">
                  <c:v>0.53506716204629889</c:v>
                </c:pt>
                <c:pt idx="2984">
                  <c:v>0.56216061731923406</c:v>
                </c:pt>
                <c:pt idx="2985">
                  <c:v>0.56513289511288944</c:v>
                </c:pt>
                <c:pt idx="2986">
                  <c:v>0.54152615032866536</c:v>
                </c:pt>
                <c:pt idx="2987">
                  <c:v>0.55770220062875109</c:v>
                </c:pt>
                <c:pt idx="2988">
                  <c:v>0.55741640468705345</c:v>
                </c:pt>
                <c:pt idx="2989">
                  <c:v>0.54735638753929694</c:v>
                </c:pt>
                <c:pt idx="2990">
                  <c:v>0.54255501571877685</c:v>
                </c:pt>
                <c:pt idx="2991">
                  <c:v>0.54787082023435263</c:v>
                </c:pt>
                <c:pt idx="2992">
                  <c:v>0.55101457559302658</c:v>
                </c:pt>
                <c:pt idx="2993">
                  <c:v>0.54787082023435263</c:v>
                </c:pt>
                <c:pt idx="2994">
                  <c:v>0.53003715347242064</c:v>
                </c:pt>
                <c:pt idx="2995">
                  <c:v>0.54867104887110607</c:v>
                </c:pt>
                <c:pt idx="2996">
                  <c:v>0.53752500714489859</c:v>
                </c:pt>
                <c:pt idx="2997">
                  <c:v>0.53038010860245788</c:v>
                </c:pt>
                <c:pt idx="2998">
                  <c:v>0.51814804229779932</c:v>
                </c:pt>
                <c:pt idx="2999">
                  <c:v>0.53683909688482423</c:v>
                </c:pt>
                <c:pt idx="3000">
                  <c:v>0.53575307230637326</c:v>
                </c:pt>
                <c:pt idx="3001">
                  <c:v>0.53123749642755069</c:v>
                </c:pt>
                <c:pt idx="3002">
                  <c:v>0.53563875392969418</c:v>
                </c:pt>
                <c:pt idx="3003">
                  <c:v>0.53878250928836813</c:v>
                </c:pt>
                <c:pt idx="3004">
                  <c:v>0.53958273792512146</c:v>
                </c:pt>
                <c:pt idx="3005">
                  <c:v>0.54198342383538156</c:v>
                </c:pt>
                <c:pt idx="3006">
                  <c:v>0.53300943126607603</c:v>
                </c:pt>
                <c:pt idx="3007">
                  <c:v>0.54718490997427838</c:v>
                </c:pt>
                <c:pt idx="3008">
                  <c:v>0.56021720491569016</c:v>
                </c:pt>
                <c:pt idx="3009">
                  <c:v>0.56033152329236924</c:v>
                </c:pt>
                <c:pt idx="3010">
                  <c:v>0.55227207773649611</c:v>
                </c:pt>
                <c:pt idx="3011">
                  <c:v>0.55673049442697908</c:v>
                </c:pt>
                <c:pt idx="3012">
                  <c:v>0.55587310660188627</c:v>
                </c:pt>
                <c:pt idx="3013">
                  <c:v>0.55518719634181191</c:v>
                </c:pt>
                <c:pt idx="3014">
                  <c:v>0.53638182337810802</c:v>
                </c:pt>
                <c:pt idx="3015">
                  <c:v>0.54318376679051161</c:v>
                </c:pt>
                <c:pt idx="3016">
                  <c:v>0.55301514718490996</c:v>
                </c:pt>
                <c:pt idx="3017">
                  <c:v>0.54135467276364679</c:v>
                </c:pt>
                <c:pt idx="3018">
                  <c:v>0.54541297513575304</c:v>
                </c:pt>
                <c:pt idx="3019">
                  <c:v>0.52940840240068587</c:v>
                </c:pt>
                <c:pt idx="3020">
                  <c:v>0.54792797942269222</c:v>
                </c:pt>
                <c:pt idx="3021">
                  <c:v>0.53015147184909972</c:v>
                </c:pt>
                <c:pt idx="3022">
                  <c:v>0.54352672192054874</c:v>
                </c:pt>
                <c:pt idx="3023">
                  <c:v>0.54884252643612463</c:v>
                </c:pt>
                <c:pt idx="3024">
                  <c:v>0.54392683623892546</c:v>
                </c:pt>
                <c:pt idx="3025">
                  <c:v>0.56393255215775939</c:v>
                </c:pt>
                <c:pt idx="3026">
                  <c:v>0.53541011717633613</c:v>
                </c:pt>
                <c:pt idx="3027">
                  <c:v>0.56799085452986564</c:v>
                </c:pt>
                <c:pt idx="3028">
                  <c:v>0.53661046013146618</c:v>
                </c:pt>
                <c:pt idx="3029">
                  <c:v>0.54335524435553018</c:v>
                </c:pt>
                <c:pt idx="3030">
                  <c:v>0.53958273792512146</c:v>
                </c:pt>
                <c:pt idx="3031">
                  <c:v>0.53346670477279223</c:v>
                </c:pt>
                <c:pt idx="3032">
                  <c:v>0.57633609602743641</c:v>
                </c:pt>
                <c:pt idx="3033">
                  <c:v>0.5509002572163475</c:v>
                </c:pt>
                <c:pt idx="3034">
                  <c:v>0.53815375821663336</c:v>
                </c:pt>
                <c:pt idx="3035">
                  <c:v>0.55341526150328668</c:v>
                </c:pt>
                <c:pt idx="3036">
                  <c:v>0.53369534152615028</c:v>
                </c:pt>
                <c:pt idx="3037">
                  <c:v>0.54101171763360956</c:v>
                </c:pt>
                <c:pt idx="3038">
                  <c:v>0.51677622177765081</c:v>
                </c:pt>
                <c:pt idx="3039">
                  <c:v>0.54541297513575304</c:v>
                </c:pt>
                <c:pt idx="3040">
                  <c:v>0.53175192912260649</c:v>
                </c:pt>
                <c:pt idx="3041">
                  <c:v>0.53380965990282936</c:v>
                </c:pt>
                <c:pt idx="3042">
                  <c:v>0.53112317805087172</c:v>
                </c:pt>
                <c:pt idx="3043">
                  <c:v>0.52129179765647327</c:v>
                </c:pt>
                <c:pt idx="3044">
                  <c:v>0.52666476136038864</c:v>
                </c:pt>
                <c:pt idx="3045">
                  <c:v>0.52466418976850526</c:v>
                </c:pt>
                <c:pt idx="3046">
                  <c:v>0.53569591311803377</c:v>
                </c:pt>
                <c:pt idx="3047">
                  <c:v>0.52277793655330096</c:v>
                </c:pt>
                <c:pt idx="3048">
                  <c:v>0.56153186624749929</c:v>
                </c:pt>
                <c:pt idx="3049">
                  <c:v>0.54335524435553018</c:v>
                </c:pt>
                <c:pt idx="3050">
                  <c:v>0.54215490140040012</c:v>
                </c:pt>
                <c:pt idx="3051">
                  <c:v>0.52872249214061162</c:v>
                </c:pt>
                <c:pt idx="3052">
                  <c:v>0.56336096027436411</c:v>
                </c:pt>
                <c:pt idx="3053">
                  <c:v>0.55575878822520719</c:v>
                </c:pt>
                <c:pt idx="3054">
                  <c:v>0.55684481280365816</c:v>
                </c:pt>
                <c:pt idx="3055">
                  <c:v>0.54238353815375817</c:v>
                </c:pt>
                <c:pt idx="3056">
                  <c:v>0.53849671334667049</c:v>
                </c:pt>
                <c:pt idx="3057">
                  <c:v>0.5490140040011432</c:v>
                </c:pt>
                <c:pt idx="3058">
                  <c:v>0.53563875392969418</c:v>
                </c:pt>
                <c:pt idx="3059">
                  <c:v>0.52483566733352383</c:v>
                </c:pt>
                <c:pt idx="3060">
                  <c:v>0.52323521006001716</c:v>
                </c:pt>
                <c:pt idx="3061">
                  <c:v>0.50757359245498712</c:v>
                </c:pt>
                <c:pt idx="3062">
                  <c:v>0.52540725921691911</c:v>
                </c:pt>
                <c:pt idx="3063">
                  <c:v>0.52152043440983142</c:v>
                </c:pt>
                <c:pt idx="3064">
                  <c:v>0.5302657902257788</c:v>
                </c:pt>
                <c:pt idx="3065">
                  <c:v>0.52483566733352383</c:v>
                </c:pt>
                <c:pt idx="3066">
                  <c:v>0.53483852529294085</c:v>
                </c:pt>
                <c:pt idx="3067">
                  <c:v>0.54495570162903684</c:v>
                </c:pt>
                <c:pt idx="3068">
                  <c:v>0.52677907973706772</c:v>
                </c:pt>
                <c:pt idx="3069">
                  <c:v>0.52757930837382105</c:v>
                </c:pt>
                <c:pt idx="3070">
                  <c:v>0.54198342383538156</c:v>
                </c:pt>
                <c:pt idx="3071">
                  <c:v>0.53095170048585305</c:v>
                </c:pt>
                <c:pt idx="3072">
                  <c:v>0.55152900828808227</c:v>
                </c:pt>
                <c:pt idx="3073">
                  <c:v>0.53866819091168905</c:v>
                </c:pt>
                <c:pt idx="3074">
                  <c:v>0.53032294941411828</c:v>
                </c:pt>
                <c:pt idx="3075">
                  <c:v>0.5514146899114033</c:v>
                </c:pt>
                <c:pt idx="3076">
                  <c:v>0.54381251786224638</c:v>
                </c:pt>
                <c:pt idx="3077">
                  <c:v>0.55004286939125469</c:v>
                </c:pt>
                <c:pt idx="3078">
                  <c:v>0.55718776793369529</c:v>
                </c:pt>
                <c:pt idx="3079">
                  <c:v>0.53106601886253213</c:v>
                </c:pt>
                <c:pt idx="3080">
                  <c:v>0.52249214061160332</c:v>
                </c:pt>
                <c:pt idx="3081">
                  <c:v>0.52866533295227203</c:v>
                </c:pt>
                <c:pt idx="3082">
                  <c:v>0.53701057444984279</c:v>
                </c:pt>
                <c:pt idx="3083">
                  <c:v>0.52226350385824516</c:v>
                </c:pt>
                <c:pt idx="3084">
                  <c:v>0.51746213203772506</c:v>
                </c:pt>
                <c:pt idx="3085">
                  <c:v>0.5168333809659903</c:v>
                </c:pt>
                <c:pt idx="3086">
                  <c:v>0.54432695055730207</c:v>
                </c:pt>
                <c:pt idx="3087">
                  <c:v>0.52454987139182618</c:v>
                </c:pt>
                <c:pt idx="3088">
                  <c:v>0.52980851671906259</c:v>
                </c:pt>
                <c:pt idx="3089">
                  <c:v>0.52414975707344957</c:v>
                </c:pt>
                <c:pt idx="3090">
                  <c:v>0.53300943126607603</c:v>
                </c:pt>
                <c:pt idx="3091">
                  <c:v>0.53455272935124321</c:v>
                </c:pt>
                <c:pt idx="3092">
                  <c:v>0.53089454129751357</c:v>
                </c:pt>
                <c:pt idx="3093">
                  <c:v>0.52695055730208629</c:v>
                </c:pt>
                <c:pt idx="3094">
                  <c:v>0.54284081166047438</c:v>
                </c:pt>
                <c:pt idx="3095">
                  <c:v>0.53346670477279223</c:v>
                </c:pt>
                <c:pt idx="3096">
                  <c:v>0.52552157759359819</c:v>
                </c:pt>
                <c:pt idx="3097">
                  <c:v>0.5398685338668191</c:v>
                </c:pt>
                <c:pt idx="3098">
                  <c:v>0.50328665332952272</c:v>
                </c:pt>
                <c:pt idx="3099">
                  <c:v>0.53558159474135469</c:v>
                </c:pt>
                <c:pt idx="3100">
                  <c:v>0.54392683623892546</c:v>
                </c:pt>
                <c:pt idx="3101">
                  <c:v>0.51649042583595317</c:v>
                </c:pt>
                <c:pt idx="3102">
                  <c:v>0.52380680194341245</c:v>
                </c:pt>
                <c:pt idx="3103">
                  <c:v>0.5364961417547871</c:v>
                </c:pt>
                <c:pt idx="3104">
                  <c:v>0.51111746213203768</c:v>
                </c:pt>
                <c:pt idx="3105">
                  <c:v>0.52243498142326383</c:v>
                </c:pt>
                <c:pt idx="3106">
                  <c:v>0.5211203200914547</c:v>
                </c:pt>
                <c:pt idx="3107">
                  <c:v>0.53015147184909972</c:v>
                </c:pt>
                <c:pt idx="3108">
                  <c:v>0.54066876250357243</c:v>
                </c:pt>
                <c:pt idx="3109">
                  <c:v>0.53180908831094598</c:v>
                </c:pt>
                <c:pt idx="3110">
                  <c:v>0.53735352957987992</c:v>
                </c:pt>
                <c:pt idx="3111">
                  <c:v>0.5288368105172907</c:v>
                </c:pt>
                <c:pt idx="3112">
                  <c:v>0.526378965418691</c:v>
                </c:pt>
                <c:pt idx="3113">
                  <c:v>0.52917976564732783</c:v>
                </c:pt>
                <c:pt idx="3114">
                  <c:v>0.53049442697913685</c:v>
                </c:pt>
                <c:pt idx="3115">
                  <c:v>0.52020577307802229</c:v>
                </c:pt>
                <c:pt idx="3116">
                  <c:v>0.541811946270363</c:v>
                </c:pt>
                <c:pt idx="3117">
                  <c:v>0.52203486710488711</c:v>
                </c:pt>
                <c:pt idx="3118">
                  <c:v>0.51883395255787368</c:v>
                </c:pt>
                <c:pt idx="3119">
                  <c:v>0.5206630465847385</c:v>
                </c:pt>
                <c:pt idx="3120">
                  <c:v>0.5148899685624464</c:v>
                </c:pt>
                <c:pt idx="3121">
                  <c:v>0.50117176336096025</c:v>
                </c:pt>
                <c:pt idx="3122">
                  <c:v>0.5139182623606745</c:v>
                </c:pt>
                <c:pt idx="3123">
                  <c:v>0.51517576450414404</c:v>
                </c:pt>
                <c:pt idx="3124">
                  <c:v>0.52912260645898823</c:v>
                </c:pt>
                <c:pt idx="3125">
                  <c:v>0.52769362675050013</c:v>
                </c:pt>
                <c:pt idx="3126">
                  <c:v>0.53895398685338669</c:v>
                </c:pt>
                <c:pt idx="3127">
                  <c:v>0.53861103172334956</c:v>
                </c:pt>
                <c:pt idx="3128">
                  <c:v>0.52952272077736495</c:v>
                </c:pt>
                <c:pt idx="3129">
                  <c:v>0.50368676764789944</c:v>
                </c:pt>
                <c:pt idx="3130">
                  <c:v>0.52923692483566731</c:v>
                </c:pt>
                <c:pt idx="3131">
                  <c:v>0.54581308945412976</c:v>
                </c:pt>
                <c:pt idx="3132">
                  <c:v>0.53112317805087172</c:v>
                </c:pt>
                <c:pt idx="3133">
                  <c:v>0.54061160331523295</c:v>
                </c:pt>
                <c:pt idx="3134">
                  <c:v>0.53558159474135469</c:v>
                </c:pt>
                <c:pt idx="3135">
                  <c:v>0.52146327522149183</c:v>
                </c:pt>
                <c:pt idx="3136">
                  <c:v>0.51997713632466414</c:v>
                </c:pt>
                <c:pt idx="3137">
                  <c:v>0.51420405830237215</c:v>
                </c:pt>
                <c:pt idx="3138">
                  <c:v>0.5134609888539583</c:v>
                </c:pt>
                <c:pt idx="3139">
                  <c:v>0.52706487567876537</c:v>
                </c:pt>
                <c:pt idx="3140">
                  <c:v>0.51820520148613891</c:v>
                </c:pt>
                <c:pt idx="3141">
                  <c:v>0.5278651043155187</c:v>
                </c:pt>
                <c:pt idx="3142">
                  <c:v>0.51426121749071163</c:v>
                </c:pt>
                <c:pt idx="3143">
                  <c:v>0.51128893969705635</c:v>
                </c:pt>
                <c:pt idx="3144">
                  <c:v>0.52197770791654763</c:v>
                </c:pt>
                <c:pt idx="3145">
                  <c:v>0.54547013432409264</c:v>
                </c:pt>
                <c:pt idx="3146">
                  <c:v>0.5019148328093741</c:v>
                </c:pt>
                <c:pt idx="3147">
                  <c:v>0.53655330094312659</c:v>
                </c:pt>
                <c:pt idx="3148">
                  <c:v>0.51963418119462701</c:v>
                </c:pt>
                <c:pt idx="3149">
                  <c:v>0.54266933409545581</c:v>
                </c:pt>
                <c:pt idx="3150">
                  <c:v>0.52740783080880249</c:v>
                </c:pt>
                <c:pt idx="3151">
                  <c:v>0.5355244355530151</c:v>
                </c:pt>
                <c:pt idx="3152">
                  <c:v>0.50294369819948559</c:v>
                </c:pt>
                <c:pt idx="3153">
                  <c:v>0.51883395255787368</c:v>
                </c:pt>
                <c:pt idx="3154">
                  <c:v>0.50740211488996856</c:v>
                </c:pt>
                <c:pt idx="3155">
                  <c:v>0.51803372392112035</c:v>
                </c:pt>
                <c:pt idx="3156">
                  <c:v>0.52803658188053726</c:v>
                </c:pt>
                <c:pt idx="3157">
                  <c:v>0.52695055730208629</c:v>
                </c:pt>
                <c:pt idx="3158">
                  <c:v>0.5422692197770792</c:v>
                </c:pt>
                <c:pt idx="3159">
                  <c:v>0.52437839382680762</c:v>
                </c:pt>
                <c:pt idx="3160">
                  <c:v>0.52117747927979419</c:v>
                </c:pt>
                <c:pt idx="3161">
                  <c:v>0.51551871963418117</c:v>
                </c:pt>
                <c:pt idx="3162">
                  <c:v>0.5154044012575022</c:v>
                </c:pt>
                <c:pt idx="3163">
                  <c:v>0.50934552729351246</c:v>
                </c:pt>
                <c:pt idx="3164">
                  <c:v>0.50414404115461564</c:v>
                </c:pt>
                <c:pt idx="3165">
                  <c:v>0.53963989711346094</c:v>
                </c:pt>
                <c:pt idx="3166">
                  <c:v>0.51529008288082312</c:v>
                </c:pt>
                <c:pt idx="3167">
                  <c:v>0.53403829665618752</c:v>
                </c:pt>
                <c:pt idx="3168">
                  <c:v>0.52272077736496136</c:v>
                </c:pt>
                <c:pt idx="3169">
                  <c:v>0.53009431266076024</c:v>
                </c:pt>
                <c:pt idx="3170">
                  <c:v>0.53049442697913685</c:v>
                </c:pt>
                <c:pt idx="3171">
                  <c:v>0.52506430408688198</c:v>
                </c:pt>
                <c:pt idx="3172">
                  <c:v>0.5283795370105745</c:v>
                </c:pt>
                <c:pt idx="3173">
                  <c:v>0.54009717062017715</c:v>
                </c:pt>
                <c:pt idx="3174">
                  <c:v>0.51609031151757645</c:v>
                </c:pt>
                <c:pt idx="3175">
                  <c:v>0.50545870248642466</c:v>
                </c:pt>
                <c:pt idx="3176">
                  <c:v>0.50814518433838241</c:v>
                </c:pt>
                <c:pt idx="3177">
                  <c:v>0.54278365247213489</c:v>
                </c:pt>
                <c:pt idx="3178">
                  <c:v>0.50591597599314087</c:v>
                </c:pt>
                <c:pt idx="3179">
                  <c:v>0.51351814804229778</c:v>
                </c:pt>
                <c:pt idx="3180">
                  <c:v>0.50763075164332672</c:v>
                </c:pt>
                <c:pt idx="3181">
                  <c:v>0.52369248356673337</c:v>
                </c:pt>
                <c:pt idx="3182">
                  <c:v>0.51883395255787368</c:v>
                </c:pt>
                <c:pt idx="3183">
                  <c:v>0.52100600171477562</c:v>
                </c:pt>
                <c:pt idx="3184">
                  <c:v>0.51723349528436691</c:v>
                </c:pt>
                <c:pt idx="3185">
                  <c:v>0.48762503572449273</c:v>
                </c:pt>
                <c:pt idx="3186">
                  <c:v>0.50900257216347533</c:v>
                </c:pt>
                <c:pt idx="3187">
                  <c:v>0.52283509574164044</c:v>
                </c:pt>
                <c:pt idx="3188">
                  <c:v>0.51077450700200056</c:v>
                </c:pt>
                <c:pt idx="3189">
                  <c:v>0.50374392683623892</c:v>
                </c:pt>
                <c:pt idx="3190">
                  <c:v>0.51083166619034015</c:v>
                </c:pt>
                <c:pt idx="3191">
                  <c:v>0.52603601028865388</c:v>
                </c:pt>
                <c:pt idx="3192">
                  <c:v>0.52186338953986855</c:v>
                </c:pt>
                <c:pt idx="3193">
                  <c:v>0.53569591311803377</c:v>
                </c:pt>
                <c:pt idx="3194">
                  <c:v>0.53535295798799654</c:v>
                </c:pt>
                <c:pt idx="3195">
                  <c:v>0.52952272077736495</c:v>
                </c:pt>
                <c:pt idx="3196">
                  <c:v>0.52980851671906259</c:v>
                </c:pt>
                <c:pt idx="3197">
                  <c:v>0.51746213203772506</c:v>
                </c:pt>
                <c:pt idx="3198">
                  <c:v>0.50711631894827092</c:v>
                </c:pt>
                <c:pt idx="3199">
                  <c:v>0.50917404972849389</c:v>
                </c:pt>
                <c:pt idx="3200">
                  <c:v>0.50705915975993143</c:v>
                </c:pt>
                <c:pt idx="3201">
                  <c:v>0.50568733923978282</c:v>
                </c:pt>
                <c:pt idx="3202">
                  <c:v>0.51237496427550733</c:v>
                </c:pt>
                <c:pt idx="3203">
                  <c:v>0.4956844812803658</c:v>
                </c:pt>
                <c:pt idx="3204">
                  <c:v>0.49494141183195201</c:v>
                </c:pt>
                <c:pt idx="3205">
                  <c:v>0.50940268648185194</c:v>
                </c:pt>
                <c:pt idx="3206">
                  <c:v>0.50157187767933697</c:v>
                </c:pt>
                <c:pt idx="3207">
                  <c:v>0.51117462132037728</c:v>
                </c:pt>
                <c:pt idx="3208">
                  <c:v>0.49951414689911405</c:v>
                </c:pt>
                <c:pt idx="3209">
                  <c:v>0.5000285795941698</c:v>
                </c:pt>
                <c:pt idx="3210">
                  <c:v>0.50014289797084877</c:v>
                </c:pt>
                <c:pt idx="3211">
                  <c:v>0.50128608173763933</c:v>
                </c:pt>
                <c:pt idx="3212">
                  <c:v>0.51054587024864251</c:v>
                </c:pt>
                <c:pt idx="3213">
                  <c:v>0.51946270362960845</c:v>
                </c:pt>
                <c:pt idx="3214">
                  <c:v>0.5148899685624464</c:v>
                </c:pt>
                <c:pt idx="3215">
                  <c:v>0.51803372392112035</c:v>
                </c:pt>
                <c:pt idx="3216">
                  <c:v>0.53672477850814515</c:v>
                </c:pt>
                <c:pt idx="3217">
                  <c:v>0.52757930837382105</c:v>
                </c:pt>
                <c:pt idx="3218">
                  <c:v>0.50928836810517286</c:v>
                </c:pt>
                <c:pt idx="3219">
                  <c:v>0.49608459559874252</c:v>
                </c:pt>
                <c:pt idx="3220">
                  <c:v>0.50705915975993143</c:v>
                </c:pt>
                <c:pt idx="3221">
                  <c:v>0.48722492140611601</c:v>
                </c:pt>
                <c:pt idx="3222">
                  <c:v>0.51997713632466414</c:v>
                </c:pt>
                <c:pt idx="3223">
                  <c:v>0.4887110603029437</c:v>
                </c:pt>
                <c:pt idx="3224">
                  <c:v>0.51088882537867963</c:v>
                </c:pt>
                <c:pt idx="3225">
                  <c:v>0.50494426979136897</c:v>
                </c:pt>
                <c:pt idx="3226">
                  <c:v>0.48356673335238637</c:v>
                </c:pt>
                <c:pt idx="3227">
                  <c:v>0.4956844812803658</c:v>
                </c:pt>
                <c:pt idx="3228">
                  <c:v>0.49202629322663616</c:v>
                </c:pt>
                <c:pt idx="3229">
                  <c:v>0.47790797370677335</c:v>
                </c:pt>
                <c:pt idx="3230">
                  <c:v>0.47745070020005714</c:v>
                </c:pt>
                <c:pt idx="3231">
                  <c:v>0.52032009145470137</c:v>
                </c:pt>
                <c:pt idx="3232">
                  <c:v>0.48671048871106032</c:v>
                </c:pt>
                <c:pt idx="3233">
                  <c:v>0.49882823663903975</c:v>
                </c:pt>
                <c:pt idx="3234">
                  <c:v>0.50060017147756497</c:v>
                </c:pt>
                <c:pt idx="3235">
                  <c:v>0.51351814804229778</c:v>
                </c:pt>
                <c:pt idx="3236">
                  <c:v>0.50643040868819666</c:v>
                </c:pt>
                <c:pt idx="3237">
                  <c:v>0.5076879108316662</c:v>
                </c:pt>
                <c:pt idx="3238">
                  <c:v>0.50894541297513574</c:v>
                </c:pt>
                <c:pt idx="3239">
                  <c:v>0.49671334667047728</c:v>
                </c:pt>
                <c:pt idx="3240">
                  <c:v>0.49396970563018006</c:v>
                </c:pt>
                <c:pt idx="3241">
                  <c:v>0.50454415547299225</c:v>
                </c:pt>
                <c:pt idx="3242">
                  <c:v>0.48048013718205201</c:v>
                </c:pt>
                <c:pt idx="3243">
                  <c:v>0.49528436696198913</c:v>
                </c:pt>
                <c:pt idx="3244">
                  <c:v>0.50277222063446703</c:v>
                </c:pt>
                <c:pt idx="3245">
                  <c:v>0.48602457845098601</c:v>
                </c:pt>
                <c:pt idx="3246">
                  <c:v>0.5000285795941698</c:v>
                </c:pt>
                <c:pt idx="3247">
                  <c:v>0.49139754215490139</c:v>
                </c:pt>
                <c:pt idx="3248">
                  <c:v>0.4944841383252358</c:v>
                </c:pt>
                <c:pt idx="3249">
                  <c:v>0.48996856244641324</c:v>
                </c:pt>
                <c:pt idx="3250">
                  <c:v>0.50940268648185194</c:v>
                </c:pt>
                <c:pt idx="3251">
                  <c:v>0.50894541297513574</c:v>
                </c:pt>
                <c:pt idx="3252">
                  <c:v>0.48002286367533581</c:v>
                </c:pt>
                <c:pt idx="3253">
                  <c:v>0.51100314375535871</c:v>
                </c:pt>
                <c:pt idx="3254">
                  <c:v>0.50694484138325235</c:v>
                </c:pt>
                <c:pt idx="3255">
                  <c:v>0.51271791940554445</c:v>
                </c:pt>
                <c:pt idx="3256">
                  <c:v>0.51991997713632465</c:v>
                </c:pt>
                <c:pt idx="3257">
                  <c:v>0.50391540440125748</c:v>
                </c:pt>
                <c:pt idx="3258">
                  <c:v>0.49511288939697057</c:v>
                </c:pt>
                <c:pt idx="3259">
                  <c:v>0.49882823663903975</c:v>
                </c:pt>
                <c:pt idx="3260">
                  <c:v>0.49128322377822237</c:v>
                </c:pt>
                <c:pt idx="3261">
                  <c:v>0.50985995998856815</c:v>
                </c:pt>
                <c:pt idx="3262">
                  <c:v>0.50282937982280651</c:v>
                </c:pt>
                <c:pt idx="3263">
                  <c:v>0.50202915118605318</c:v>
                </c:pt>
                <c:pt idx="3264">
                  <c:v>0.48888253786796226</c:v>
                </c:pt>
                <c:pt idx="3265">
                  <c:v>0.4812803658188054</c:v>
                </c:pt>
                <c:pt idx="3266">
                  <c:v>0.50654472706487563</c:v>
                </c:pt>
                <c:pt idx="3267">
                  <c:v>0.51471849099742784</c:v>
                </c:pt>
                <c:pt idx="3268">
                  <c:v>0.48779651328951129</c:v>
                </c:pt>
                <c:pt idx="3269">
                  <c:v>0.49745641611889113</c:v>
                </c:pt>
                <c:pt idx="3270">
                  <c:v>0.48648185195770222</c:v>
                </c:pt>
                <c:pt idx="3271">
                  <c:v>0.4737925121463275</c:v>
                </c:pt>
                <c:pt idx="3272">
                  <c:v>0.4963703915404401</c:v>
                </c:pt>
                <c:pt idx="3273">
                  <c:v>0.51026007430694487</c:v>
                </c:pt>
                <c:pt idx="3274">
                  <c:v>0.51283223778222353</c:v>
                </c:pt>
                <c:pt idx="3275">
                  <c:v>0.48436696198913975</c:v>
                </c:pt>
                <c:pt idx="3276">
                  <c:v>0.50254358388110887</c:v>
                </c:pt>
                <c:pt idx="3277">
                  <c:v>0.49945698771077451</c:v>
                </c:pt>
                <c:pt idx="3278">
                  <c:v>0.48745355815947411</c:v>
                </c:pt>
                <c:pt idx="3279">
                  <c:v>0.48042297799371247</c:v>
                </c:pt>
                <c:pt idx="3280">
                  <c:v>0.50242926550442979</c:v>
                </c:pt>
                <c:pt idx="3281">
                  <c:v>0.50305801657616467</c:v>
                </c:pt>
                <c:pt idx="3282">
                  <c:v>0.4795655901686196</c:v>
                </c:pt>
                <c:pt idx="3283">
                  <c:v>0.49922835095741641</c:v>
                </c:pt>
                <c:pt idx="3284">
                  <c:v>0.48642469276936268</c:v>
                </c:pt>
                <c:pt idx="3285">
                  <c:v>0.50111460417262077</c:v>
                </c:pt>
                <c:pt idx="3286">
                  <c:v>0.48219491283223781</c:v>
                </c:pt>
                <c:pt idx="3287">
                  <c:v>0.498313803943984</c:v>
                </c:pt>
                <c:pt idx="3288">
                  <c:v>0.46979136896256074</c:v>
                </c:pt>
                <c:pt idx="3289">
                  <c:v>0.48739639897113463</c:v>
                </c:pt>
                <c:pt idx="3290">
                  <c:v>0.48168048013718207</c:v>
                </c:pt>
                <c:pt idx="3291">
                  <c:v>0.500485853100886</c:v>
                </c:pt>
                <c:pt idx="3292">
                  <c:v>0.48882537867962272</c:v>
                </c:pt>
                <c:pt idx="3293">
                  <c:v>0.48385252929408401</c:v>
                </c:pt>
                <c:pt idx="3294">
                  <c:v>0.48573878250928837</c:v>
                </c:pt>
                <c:pt idx="3295">
                  <c:v>0.49065447270648754</c:v>
                </c:pt>
                <c:pt idx="3296">
                  <c:v>0.4851100314375536</c:v>
                </c:pt>
                <c:pt idx="3297">
                  <c:v>0.5019148328093741</c:v>
                </c:pt>
                <c:pt idx="3298">
                  <c:v>0.49008288082309232</c:v>
                </c:pt>
                <c:pt idx="3299">
                  <c:v>0.48962560731637611</c:v>
                </c:pt>
                <c:pt idx="3300">
                  <c:v>0.49396970563018006</c:v>
                </c:pt>
                <c:pt idx="3301">
                  <c:v>0.48482423549585596</c:v>
                </c:pt>
                <c:pt idx="3302">
                  <c:v>0.48076593312374966</c:v>
                </c:pt>
                <c:pt idx="3303">
                  <c:v>0.48516719062589309</c:v>
                </c:pt>
                <c:pt idx="3304">
                  <c:v>0.49025435838811088</c:v>
                </c:pt>
                <c:pt idx="3305">
                  <c:v>0.48979708488139467</c:v>
                </c:pt>
                <c:pt idx="3306">
                  <c:v>0.49242640754501288</c:v>
                </c:pt>
                <c:pt idx="3307">
                  <c:v>0.50054301228922549</c:v>
                </c:pt>
                <c:pt idx="3308">
                  <c:v>0.48448128036581878</c:v>
                </c:pt>
                <c:pt idx="3309">
                  <c:v>0.50774507002000568</c:v>
                </c:pt>
                <c:pt idx="3310">
                  <c:v>0.49888539582737923</c:v>
                </c:pt>
                <c:pt idx="3311">
                  <c:v>0.47447842240640181</c:v>
                </c:pt>
                <c:pt idx="3312">
                  <c:v>0.46990568733923976</c:v>
                </c:pt>
                <c:pt idx="3313">
                  <c:v>0.48899685624464134</c:v>
                </c:pt>
                <c:pt idx="3314">
                  <c:v>0.49436981994855672</c:v>
                </c:pt>
                <c:pt idx="3315">
                  <c:v>0.48190911689054017</c:v>
                </c:pt>
                <c:pt idx="3316">
                  <c:v>0.48265218633895401</c:v>
                </c:pt>
                <c:pt idx="3317">
                  <c:v>0.49311231780508719</c:v>
                </c:pt>
                <c:pt idx="3318">
                  <c:v>0.49551300371534723</c:v>
                </c:pt>
                <c:pt idx="3319">
                  <c:v>0.49065447270648754</c:v>
                </c:pt>
                <c:pt idx="3320">
                  <c:v>0.5076879108316662</c:v>
                </c:pt>
                <c:pt idx="3321">
                  <c:v>0.50362960845955984</c:v>
                </c:pt>
                <c:pt idx="3322">
                  <c:v>0.50345813089454128</c:v>
                </c:pt>
                <c:pt idx="3323">
                  <c:v>0.49814232637896544</c:v>
                </c:pt>
                <c:pt idx="3324">
                  <c:v>0.49705630180051441</c:v>
                </c:pt>
                <c:pt idx="3325">
                  <c:v>0.49454129751357528</c:v>
                </c:pt>
                <c:pt idx="3326">
                  <c:v>0.49539868533866821</c:v>
                </c:pt>
                <c:pt idx="3327">
                  <c:v>0.49065447270648754</c:v>
                </c:pt>
                <c:pt idx="3328">
                  <c:v>0.48139468419548442</c:v>
                </c:pt>
                <c:pt idx="3329">
                  <c:v>0.49014004001143185</c:v>
                </c:pt>
                <c:pt idx="3330">
                  <c:v>0.47773649614175479</c:v>
                </c:pt>
                <c:pt idx="3331">
                  <c:v>0.48836810517290652</c:v>
                </c:pt>
                <c:pt idx="3332">
                  <c:v>0.47539296941983422</c:v>
                </c:pt>
                <c:pt idx="3333">
                  <c:v>0.47339239782795084</c:v>
                </c:pt>
                <c:pt idx="3334">
                  <c:v>0.47150614461274648</c:v>
                </c:pt>
                <c:pt idx="3335">
                  <c:v>0.46150328665332951</c:v>
                </c:pt>
                <c:pt idx="3336">
                  <c:v>0.47236353243783941</c:v>
                </c:pt>
                <c:pt idx="3337">
                  <c:v>0.51157473563875389</c:v>
                </c:pt>
                <c:pt idx="3338">
                  <c:v>0.50648756787653615</c:v>
                </c:pt>
                <c:pt idx="3339">
                  <c:v>0.49219777079165478</c:v>
                </c:pt>
                <c:pt idx="3340">
                  <c:v>0.48733923978279509</c:v>
                </c:pt>
                <c:pt idx="3341">
                  <c:v>0.48933981137467847</c:v>
                </c:pt>
                <c:pt idx="3342">
                  <c:v>0.4889396970563018</c:v>
                </c:pt>
                <c:pt idx="3343">
                  <c:v>0.48853958273792514</c:v>
                </c:pt>
                <c:pt idx="3344">
                  <c:v>0.49671334667047728</c:v>
                </c:pt>
                <c:pt idx="3345">
                  <c:v>0.50494426979136897</c:v>
                </c:pt>
                <c:pt idx="3346">
                  <c:v>0.46904829951414689</c:v>
                </c:pt>
                <c:pt idx="3347">
                  <c:v>0.48225207202057729</c:v>
                </c:pt>
                <c:pt idx="3348">
                  <c:v>0.4831666190340097</c:v>
                </c:pt>
                <c:pt idx="3349">
                  <c:v>0.48722492140611601</c:v>
                </c:pt>
                <c:pt idx="3350">
                  <c:v>0.46773363818233782</c:v>
                </c:pt>
                <c:pt idx="3351">
                  <c:v>0.48888253786796226</c:v>
                </c:pt>
                <c:pt idx="3352">
                  <c:v>0.48213775364389827</c:v>
                </c:pt>
                <c:pt idx="3353">
                  <c:v>0.47476421834809945</c:v>
                </c:pt>
                <c:pt idx="3354">
                  <c:v>0.4827093455272935</c:v>
                </c:pt>
                <c:pt idx="3355">
                  <c:v>0.47242069162617889</c:v>
                </c:pt>
                <c:pt idx="3356">
                  <c:v>0.4882537867962275</c:v>
                </c:pt>
                <c:pt idx="3357">
                  <c:v>0.498313803943984</c:v>
                </c:pt>
                <c:pt idx="3358">
                  <c:v>0.4824807087739354</c:v>
                </c:pt>
                <c:pt idx="3359">
                  <c:v>0.50180051443269502</c:v>
                </c:pt>
                <c:pt idx="3360">
                  <c:v>0.4959131180337239</c:v>
                </c:pt>
                <c:pt idx="3361">
                  <c:v>0.5058016576164619</c:v>
                </c:pt>
                <c:pt idx="3362">
                  <c:v>0.4750500142897971</c:v>
                </c:pt>
                <c:pt idx="3363">
                  <c:v>0.51031723349528435</c:v>
                </c:pt>
                <c:pt idx="3364">
                  <c:v>0.49511288939697057</c:v>
                </c:pt>
                <c:pt idx="3365">
                  <c:v>0.48413832523578165</c:v>
                </c:pt>
                <c:pt idx="3366">
                  <c:v>0.47002000571591884</c:v>
                </c:pt>
                <c:pt idx="3367">
                  <c:v>0.500485853100886</c:v>
                </c:pt>
                <c:pt idx="3368">
                  <c:v>0.49819948556730492</c:v>
                </c:pt>
                <c:pt idx="3369">
                  <c:v>0.48705344384109744</c:v>
                </c:pt>
                <c:pt idx="3370">
                  <c:v>0.48905401543298083</c:v>
                </c:pt>
                <c:pt idx="3371">
                  <c:v>0.48911117462132037</c:v>
                </c:pt>
                <c:pt idx="3372">
                  <c:v>0.49174049728493857</c:v>
                </c:pt>
                <c:pt idx="3373">
                  <c:v>0.49877107745070021</c:v>
                </c:pt>
                <c:pt idx="3374">
                  <c:v>0.4848813946841955</c:v>
                </c:pt>
                <c:pt idx="3375">
                  <c:v>0.47785081451843386</c:v>
                </c:pt>
                <c:pt idx="3376">
                  <c:v>0.49196913403829667</c:v>
                </c:pt>
                <c:pt idx="3377">
                  <c:v>0.49305515861674765</c:v>
                </c:pt>
                <c:pt idx="3378">
                  <c:v>0.51071734781366107</c:v>
                </c:pt>
                <c:pt idx="3379">
                  <c:v>0.49048299514146898</c:v>
                </c:pt>
                <c:pt idx="3380">
                  <c:v>0.48802515004286939</c:v>
                </c:pt>
                <c:pt idx="3381">
                  <c:v>0.49442697913689626</c:v>
                </c:pt>
                <c:pt idx="3382">
                  <c:v>0.48522434981423263</c:v>
                </c:pt>
                <c:pt idx="3383">
                  <c:v>0.50568733923978282</c:v>
                </c:pt>
                <c:pt idx="3384">
                  <c:v>0.47184909974278366</c:v>
                </c:pt>
                <c:pt idx="3385">
                  <c:v>0.4963703915404401</c:v>
                </c:pt>
                <c:pt idx="3386">
                  <c:v>0.4923120891683338</c:v>
                </c:pt>
                <c:pt idx="3387">
                  <c:v>0.46876250357244925</c:v>
                </c:pt>
                <c:pt idx="3388">
                  <c:v>0.46921977707916546</c:v>
                </c:pt>
                <c:pt idx="3389">
                  <c:v>0.48185195770220063</c:v>
                </c:pt>
                <c:pt idx="3390">
                  <c:v>0.47133466704772792</c:v>
                </c:pt>
                <c:pt idx="3391">
                  <c:v>0.52214918548156619</c:v>
                </c:pt>
                <c:pt idx="3392">
                  <c:v>0.48362389254072591</c:v>
                </c:pt>
                <c:pt idx="3393">
                  <c:v>0.49328379537010575</c:v>
                </c:pt>
                <c:pt idx="3394">
                  <c:v>0.49962846527579308</c:v>
                </c:pt>
                <c:pt idx="3395">
                  <c:v>0.49797084881394682</c:v>
                </c:pt>
                <c:pt idx="3396">
                  <c:v>0.48585310088596739</c:v>
                </c:pt>
                <c:pt idx="3397">
                  <c:v>0.49025435838811088</c:v>
                </c:pt>
                <c:pt idx="3398">
                  <c:v>0.49705630180051441</c:v>
                </c:pt>
                <c:pt idx="3399">
                  <c:v>0.50208631037439266</c:v>
                </c:pt>
                <c:pt idx="3400">
                  <c:v>0.4869962846527579</c:v>
                </c:pt>
                <c:pt idx="3401">
                  <c:v>0.49339811374678477</c:v>
                </c:pt>
                <c:pt idx="3402">
                  <c:v>0.49882823663903975</c:v>
                </c:pt>
                <c:pt idx="3403">
                  <c:v>0.48179479851386109</c:v>
                </c:pt>
                <c:pt idx="3404">
                  <c:v>0.48208059445555873</c:v>
                </c:pt>
                <c:pt idx="3405">
                  <c:v>0.50797370677336384</c:v>
                </c:pt>
                <c:pt idx="3406">
                  <c:v>0.47516433266647612</c:v>
                </c:pt>
                <c:pt idx="3407">
                  <c:v>0.48739639897113463</c:v>
                </c:pt>
                <c:pt idx="3408">
                  <c:v>0.46801943412403546</c:v>
                </c:pt>
                <c:pt idx="3409">
                  <c:v>0.47767933695341525</c:v>
                </c:pt>
                <c:pt idx="3410">
                  <c:v>0.47836524721348955</c:v>
                </c:pt>
                <c:pt idx="3411">
                  <c:v>0.48802515004286939</c:v>
                </c:pt>
                <c:pt idx="3412">
                  <c:v>0.4791083166619034</c:v>
                </c:pt>
                <c:pt idx="3413">
                  <c:v>0.47716490425835956</c:v>
                </c:pt>
                <c:pt idx="3414">
                  <c:v>0.45510145755930265</c:v>
                </c:pt>
                <c:pt idx="3415">
                  <c:v>0.47499285510145756</c:v>
                </c:pt>
                <c:pt idx="3416">
                  <c:v>0.47653615318662473</c:v>
                </c:pt>
                <c:pt idx="3417">
                  <c:v>0.48225207202057729</c:v>
                </c:pt>
                <c:pt idx="3418">
                  <c:v>0.48528150900257216</c:v>
                </c:pt>
                <c:pt idx="3419">
                  <c:v>0.49837096313232354</c:v>
                </c:pt>
                <c:pt idx="3420">
                  <c:v>0.49997142040583026</c:v>
                </c:pt>
                <c:pt idx="3421">
                  <c:v>0.46916261789082597</c:v>
                </c:pt>
                <c:pt idx="3422">
                  <c:v>0.51031723349528435</c:v>
                </c:pt>
                <c:pt idx="3423">
                  <c:v>0.49454129751357528</c:v>
                </c:pt>
                <c:pt idx="3424">
                  <c:v>0.51037439268362395</c:v>
                </c:pt>
                <c:pt idx="3425">
                  <c:v>0.47653615318662473</c:v>
                </c:pt>
                <c:pt idx="3426">
                  <c:v>0.49311231780508719</c:v>
                </c:pt>
                <c:pt idx="3427">
                  <c:v>0.48013718205201489</c:v>
                </c:pt>
                <c:pt idx="3428">
                  <c:v>0.48991140325807375</c:v>
                </c:pt>
                <c:pt idx="3429">
                  <c:v>0.47676478993998284</c:v>
                </c:pt>
                <c:pt idx="3430">
                  <c:v>0.47470705915975991</c:v>
                </c:pt>
                <c:pt idx="3431">
                  <c:v>0.46721920548728207</c:v>
                </c:pt>
                <c:pt idx="3432">
                  <c:v>0.48076593312374966</c:v>
                </c:pt>
                <c:pt idx="3433">
                  <c:v>0.4788796799085453</c:v>
                </c:pt>
                <c:pt idx="3434">
                  <c:v>0.47024864246927695</c:v>
                </c:pt>
                <c:pt idx="3435">
                  <c:v>0.48156616176050299</c:v>
                </c:pt>
                <c:pt idx="3436">
                  <c:v>0.48253786796227494</c:v>
                </c:pt>
                <c:pt idx="3437">
                  <c:v>0.47070591597599315</c:v>
                </c:pt>
                <c:pt idx="3438">
                  <c:v>0.46876250357244925</c:v>
                </c:pt>
                <c:pt idx="3439">
                  <c:v>0.4851100314375536</c:v>
                </c:pt>
                <c:pt idx="3440">
                  <c:v>0.47442126321806233</c:v>
                </c:pt>
                <c:pt idx="3441">
                  <c:v>0.46836238925407259</c:v>
                </c:pt>
                <c:pt idx="3442">
                  <c:v>0.49917119176907687</c:v>
                </c:pt>
                <c:pt idx="3443">
                  <c:v>0.4757359245498714</c:v>
                </c:pt>
                <c:pt idx="3444">
                  <c:v>0.50197199199771358</c:v>
                </c:pt>
                <c:pt idx="3445">
                  <c:v>0.50054301228922549</c:v>
                </c:pt>
                <c:pt idx="3446">
                  <c:v>0.48648185195770222</c:v>
                </c:pt>
                <c:pt idx="3447">
                  <c:v>0.49196913403829667</c:v>
                </c:pt>
                <c:pt idx="3448">
                  <c:v>0.49311231780508719</c:v>
                </c:pt>
                <c:pt idx="3449">
                  <c:v>0.47567876536153186</c:v>
                </c:pt>
                <c:pt idx="3450">
                  <c:v>0.48225207202057729</c:v>
                </c:pt>
                <c:pt idx="3451">
                  <c:v>0.47367819376964848</c:v>
                </c:pt>
                <c:pt idx="3452">
                  <c:v>0.4737925121463275</c:v>
                </c:pt>
                <c:pt idx="3453">
                  <c:v>0.48522434981423263</c:v>
                </c:pt>
                <c:pt idx="3454">
                  <c:v>0.4831666190340097</c:v>
                </c:pt>
                <c:pt idx="3455">
                  <c:v>0.48025150042869391</c:v>
                </c:pt>
                <c:pt idx="3456">
                  <c:v>0.46933409545584454</c:v>
                </c:pt>
                <c:pt idx="3457">
                  <c:v>0.47859388396684766</c:v>
                </c:pt>
                <c:pt idx="3458">
                  <c:v>0.47510717347813664</c:v>
                </c:pt>
                <c:pt idx="3459">
                  <c:v>0.48459559874249786</c:v>
                </c:pt>
                <c:pt idx="3460">
                  <c:v>0.46910545870248643</c:v>
                </c:pt>
                <c:pt idx="3461">
                  <c:v>0.46887682194912833</c:v>
                </c:pt>
                <c:pt idx="3462">
                  <c:v>0.48951128893969703</c:v>
                </c:pt>
                <c:pt idx="3463">
                  <c:v>0.49059731351814806</c:v>
                </c:pt>
                <c:pt idx="3464">
                  <c:v>0.48470991711917688</c:v>
                </c:pt>
                <c:pt idx="3465">
                  <c:v>0.49156901971991995</c:v>
                </c:pt>
                <c:pt idx="3466">
                  <c:v>0.49116890540154329</c:v>
                </c:pt>
                <c:pt idx="3467">
                  <c:v>0.5014575593026579</c:v>
                </c:pt>
                <c:pt idx="3468">
                  <c:v>0.48236639039725637</c:v>
                </c:pt>
                <c:pt idx="3469">
                  <c:v>0.49962846527579308</c:v>
                </c:pt>
                <c:pt idx="3470">
                  <c:v>0.4925407259216919</c:v>
                </c:pt>
                <c:pt idx="3471">
                  <c:v>0.4731066018862532</c:v>
                </c:pt>
                <c:pt idx="3472">
                  <c:v>0.48373821091740499</c:v>
                </c:pt>
                <c:pt idx="3473">
                  <c:v>0.4923120891683338</c:v>
                </c:pt>
                <c:pt idx="3474">
                  <c:v>0.46813375250071448</c:v>
                </c:pt>
                <c:pt idx="3475">
                  <c:v>0.46704772792226351</c:v>
                </c:pt>
                <c:pt idx="3476">
                  <c:v>0.47699342669334094</c:v>
                </c:pt>
                <c:pt idx="3477">
                  <c:v>0.47876536153186627</c:v>
                </c:pt>
                <c:pt idx="3478">
                  <c:v>0.4601314661331809</c:v>
                </c:pt>
                <c:pt idx="3479">
                  <c:v>0.48322377822234924</c:v>
                </c:pt>
                <c:pt idx="3480">
                  <c:v>0.47196341811946269</c:v>
                </c:pt>
                <c:pt idx="3481">
                  <c:v>0.47179194055444412</c:v>
                </c:pt>
                <c:pt idx="3482">
                  <c:v>0.47122034867104889</c:v>
                </c:pt>
                <c:pt idx="3483">
                  <c:v>0.4731066018862532</c:v>
                </c:pt>
                <c:pt idx="3484">
                  <c:v>0.47487853672477853</c:v>
                </c:pt>
                <c:pt idx="3485">
                  <c:v>0.47173478136610458</c:v>
                </c:pt>
                <c:pt idx="3486">
                  <c:v>0.47779365533009432</c:v>
                </c:pt>
                <c:pt idx="3487">
                  <c:v>0.48013718205201489</c:v>
                </c:pt>
                <c:pt idx="3488">
                  <c:v>0.48916833380965991</c:v>
                </c:pt>
                <c:pt idx="3489">
                  <c:v>0.49877107745070021</c:v>
                </c:pt>
                <c:pt idx="3490">
                  <c:v>0.48933981137467847</c:v>
                </c:pt>
                <c:pt idx="3491">
                  <c:v>0.48876821949128324</c:v>
                </c:pt>
                <c:pt idx="3492">
                  <c:v>0.48242354958559591</c:v>
                </c:pt>
                <c:pt idx="3493">
                  <c:v>0.47402114889968561</c:v>
                </c:pt>
                <c:pt idx="3494">
                  <c:v>0.47122034867104889</c:v>
                </c:pt>
                <c:pt idx="3495">
                  <c:v>0.48579594169762791</c:v>
                </c:pt>
                <c:pt idx="3496">
                  <c:v>0.4944841383252358</c:v>
                </c:pt>
                <c:pt idx="3497">
                  <c:v>0.45904544155472993</c:v>
                </c:pt>
                <c:pt idx="3498">
                  <c:v>0.4545870248642469</c:v>
                </c:pt>
                <c:pt idx="3499">
                  <c:v>0.48099456987710776</c:v>
                </c:pt>
                <c:pt idx="3500">
                  <c:v>0.46819091168905402</c:v>
                </c:pt>
                <c:pt idx="3501">
                  <c:v>0.47007716490425838</c:v>
                </c:pt>
                <c:pt idx="3502">
                  <c:v>0.46264647042012003</c:v>
                </c:pt>
                <c:pt idx="3503">
                  <c:v>0.47224921406116033</c:v>
                </c:pt>
                <c:pt idx="3504">
                  <c:v>0.48088025150042868</c:v>
                </c:pt>
                <c:pt idx="3505">
                  <c:v>0.47007716490425838</c:v>
                </c:pt>
                <c:pt idx="3506">
                  <c:v>0.4697342097742212</c:v>
                </c:pt>
                <c:pt idx="3507">
                  <c:v>0.48528150900257216</c:v>
                </c:pt>
                <c:pt idx="3508">
                  <c:v>0.48448128036581878</c:v>
                </c:pt>
                <c:pt idx="3509">
                  <c:v>0.49379822806516149</c:v>
                </c:pt>
                <c:pt idx="3510">
                  <c:v>0.48928265218633893</c:v>
                </c:pt>
                <c:pt idx="3511">
                  <c:v>0.49585595884538441</c:v>
                </c:pt>
                <c:pt idx="3512">
                  <c:v>0.49871391826236067</c:v>
                </c:pt>
                <c:pt idx="3513">
                  <c:v>0.4925407259216919</c:v>
                </c:pt>
                <c:pt idx="3514">
                  <c:v>0.48396684767076309</c:v>
                </c:pt>
                <c:pt idx="3515">
                  <c:v>0.48951128893969703</c:v>
                </c:pt>
                <c:pt idx="3516">
                  <c:v>0.48819662760788796</c:v>
                </c:pt>
                <c:pt idx="3517">
                  <c:v>0.47173478136610458</c:v>
                </c:pt>
                <c:pt idx="3518">
                  <c:v>0.48048013718205201</c:v>
                </c:pt>
                <c:pt idx="3519">
                  <c:v>0.47716490425835956</c:v>
                </c:pt>
                <c:pt idx="3520">
                  <c:v>0.48065161474707058</c:v>
                </c:pt>
                <c:pt idx="3521">
                  <c:v>0.4728779651328951</c:v>
                </c:pt>
                <c:pt idx="3522">
                  <c:v>0.46670477279222633</c:v>
                </c:pt>
                <c:pt idx="3523">
                  <c:v>0.47905115747356386</c:v>
                </c:pt>
                <c:pt idx="3524">
                  <c:v>0.4543583881108888</c:v>
                </c:pt>
                <c:pt idx="3525">
                  <c:v>0.46213203772506428</c:v>
                </c:pt>
                <c:pt idx="3526">
                  <c:v>0.48762503572449273</c:v>
                </c:pt>
                <c:pt idx="3527">
                  <c:v>0.46327522149185479</c:v>
                </c:pt>
                <c:pt idx="3528">
                  <c:v>0.46784795655901684</c:v>
                </c:pt>
                <c:pt idx="3529">
                  <c:v>0.46721920548728207</c:v>
                </c:pt>
                <c:pt idx="3530">
                  <c:v>0.50082880823092313</c:v>
                </c:pt>
                <c:pt idx="3531">
                  <c:v>0.49116890540154329</c:v>
                </c:pt>
                <c:pt idx="3532">
                  <c:v>0.48088025150042868</c:v>
                </c:pt>
                <c:pt idx="3533">
                  <c:v>0.49099742783652472</c:v>
                </c:pt>
                <c:pt idx="3534">
                  <c:v>0.47796513289511289</c:v>
                </c:pt>
                <c:pt idx="3535">
                  <c:v>0.50288653901114599</c:v>
                </c:pt>
                <c:pt idx="3536">
                  <c:v>0.48230923120891683</c:v>
                </c:pt>
                <c:pt idx="3537">
                  <c:v>0.47762217776507576</c:v>
                </c:pt>
                <c:pt idx="3538">
                  <c:v>0.47585024292655043</c:v>
                </c:pt>
                <c:pt idx="3539">
                  <c:v>0.46116033152329239</c:v>
                </c:pt>
                <c:pt idx="3540">
                  <c:v>0.47430694484138325</c:v>
                </c:pt>
                <c:pt idx="3541">
                  <c:v>0.45830237210631608</c:v>
                </c:pt>
                <c:pt idx="3542">
                  <c:v>0.46801943412403546</c:v>
                </c:pt>
                <c:pt idx="3543">
                  <c:v>0.47019148328093741</c:v>
                </c:pt>
                <c:pt idx="3544">
                  <c:v>0.46018862532152044</c:v>
                </c:pt>
                <c:pt idx="3545">
                  <c:v>0.46841954844241213</c:v>
                </c:pt>
                <c:pt idx="3546">
                  <c:v>0.47179194055444412</c:v>
                </c:pt>
                <c:pt idx="3547">
                  <c:v>0.48156616176050299</c:v>
                </c:pt>
                <c:pt idx="3548">
                  <c:v>0.47710774507002002</c:v>
                </c:pt>
                <c:pt idx="3549">
                  <c:v>0.47939411260360104</c:v>
                </c:pt>
                <c:pt idx="3550">
                  <c:v>0.4793369534152615</c:v>
                </c:pt>
                <c:pt idx="3551">
                  <c:v>0.49997142040583026</c:v>
                </c:pt>
                <c:pt idx="3552">
                  <c:v>0.49722777936553303</c:v>
                </c:pt>
                <c:pt idx="3553">
                  <c:v>0.48253786796227494</c:v>
                </c:pt>
                <c:pt idx="3554">
                  <c:v>0.48705344384109744</c:v>
                </c:pt>
                <c:pt idx="3555">
                  <c:v>0.47807945127179197</c:v>
                </c:pt>
                <c:pt idx="3556">
                  <c:v>0.50065733066590457</c:v>
                </c:pt>
                <c:pt idx="3557">
                  <c:v>0.49094026864818519</c:v>
                </c:pt>
                <c:pt idx="3558">
                  <c:v>0.47002000571591884</c:v>
                </c:pt>
                <c:pt idx="3559">
                  <c:v>0.46664761360388685</c:v>
                </c:pt>
                <c:pt idx="3560">
                  <c:v>0.46933409545584454</c:v>
                </c:pt>
                <c:pt idx="3561">
                  <c:v>0.46138896827665049</c:v>
                </c:pt>
                <c:pt idx="3562">
                  <c:v>0.45550157187767931</c:v>
                </c:pt>
                <c:pt idx="3563">
                  <c:v>0.48642469276936268</c:v>
                </c:pt>
                <c:pt idx="3564">
                  <c:v>0.45264361246070306</c:v>
                </c:pt>
                <c:pt idx="3565">
                  <c:v>0.45613032294941414</c:v>
                </c:pt>
                <c:pt idx="3566">
                  <c:v>0.46196056016004572</c:v>
                </c:pt>
                <c:pt idx="3567">
                  <c:v>0.47059159759931407</c:v>
                </c:pt>
                <c:pt idx="3568">
                  <c:v>0.47442126321806233</c:v>
                </c:pt>
                <c:pt idx="3569">
                  <c:v>0.45584452700771649</c:v>
                </c:pt>
                <c:pt idx="3570">
                  <c:v>0.46093169476993429</c:v>
                </c:pt>
                <c:pt idx="3571">
                  <c:v>0.47179194055444412</c:v>
                </c:pt>
                <c:pt idx="3572">
                  <c:v>0.45578736781937695</c:v>
                </c:pt>
                <c:pt idx="3573">
                  <c:v>0.47647899399828525</c:v>
                </c:pt>
                <c:pt idx="3574">
                  <c:v>0.47510717347813664</c:v>
                </c:pt>
                <c:pt idx="3575">
                  <c:v>0.49139754215490139</c:v>
                </c:pt>
                <c:pt idx="3576">
                  <c:v>0.47384967133466704</c:v>
                </c:pt>
                <c:pt idx="3577">
                  <c:v>0.48133752500714488</c:v>
                </c:pt>
                <c:pt idx="3578">
                  <c:v>0.48602457845098601</c:v>
                </c:pt>
                <c:pt idx="3579">
                  <c:v>0.48162332094884253</c:v>
                </c:pt>
                <c:pt idx="3580">
                  <c:v>0.47436410402972279</c:v>
                </c:pt>
                <c:pt idx="3581">
                  <c:v>0.47522149185481566</c:v>
                </c:pt>
                <c:pt idx="3582">
                  <c:v>0.47116318948270935</c:v>
                </c:pt>
                <c:pt idx="3583">
                  <c:v>0.44567019148328096</c:v>
                </c:pt>
                <c:pt idx="3584">
                  <c:v>0.44904258359531296</c:v>
                </c:pt>
                <c:pt idx="3585">
                  <c:v>0.47013432409259787</c:v>
                </c:pt>
                <c:pt idx="3586">
                  <c:v>0.46944841383252356</c:v>
                </c:pt>
                <c:pt idx="3587">
                  <c:v>0.47207773649614176</c:v>
                </c:pt>
                <c:pt idx="3588">
                  <c:v>0.44989997142040583</c:v>
                </c:pt>
                <c:pt idx="3589">
                  <c:v>0.4661331809088311</c:v>
                </c:pt>
                <c:pt idx="3590">
                  <c:v>0.44984281223206629</c:v>
                </c:pt>
                <c:pt idx="3591">
                  <c:v>0.45178622463561019</c:v>
                </c:pt>
                <c:pt idx="3592">
                  <c:v>0.47133466704772792</c:v>
                </c:pt>
                <c:pt idx="3593">
                  <c:v>0.47436410402972279</c:v>
                </c:pt>
                <c:pt idx="3594">
                  <c:v>0.48476707630751642</c:v>
                </c:pt>
                <c:pt idx="3595">
                  <c:v>0.46659045441554731</c:v>
                </c:pt>
                <c:pt idx="3596">
                  <c:v>0.46801943412403546</c:v>
                </c:pt>
                <c:pt idx="3597">
                  <c:v>0.47562160617319232</c:v>
                </c:pt>
                <c:pt idx="3598">
                  <c:v>0.47825092883681053</c:v>
                </c:pt>
                <c:pt idx="3599">
                  <c:v>0.48579594169762791</c:v>
                </c:pt>
                <c:pt idx="3600">
                  <c:v>0.46956273220920264</c:v>
                </c:pt>
                <c:pt idx="3601">
                  <c:v>0.47219205487282079</c:v>
                </c:pt>
                <c:pt idx="3602">
                  <c:v>0.46710488711060305</c:v>
                </c:pt>
                <c:pt idx="3603">
                  <c:v>0.46298942555015721</c:v>
                </c:pt>
                <c:pt idx="3604">
                  <c:v>0.46504715633038013</c:v>
                </c:pt>
                <c:pt idx="3605">
                  <c:v>0.45847384967133464</c:v>
                </c:pt>
                <c:pt idx="3606">
                  <c:v>0.45155758788225209</c:v>
                </c:pt>
                <c:pt idx="3607">
                  <c:v>0.4728779651328951</c:v>
                </c:pt>
                <c:pt idx="3608">
                  <c:v>0.46630465847384966</c:v>
                </c:pt>
                <c:pt idx="3609">
                  <c:v>0.47264932837953699</c:v>
                </c:pt>
                <c:pt idx="3610">
                  <c:v>0.44452700771649045</c:v>
                </c:pt>
                <c:pt idx="3611">
                  <c:v>0.45875964561303229</c:v>
                </c:pt>
                <c:pt idx="3612">
                  <c:v>0.47745070020005714</c:v>
                </c:pt>
                <c:pt idx="3613">
                  <c:v>0.4824807087739354</c:v>
                </c:pt>
                <c:pt idx="3614">
                  <c:v>0.46316090311517577</c:v>
                </c:pt>
                <c:pt idx="3615">
                  <c:v>0.4810517290654473</c:v>
                </c:pt>
                <c:pt idx="3616">
                  <c:v>0.46241783366676192</c:v>
                </c:pt>
                <c:pt idx="3617">
                  <c:v>0.46533295227207772</c:v>
                </c:pt>
                <c:pt idx="3618">
                  <c:v>0.46521863389539869</c:v>
                </c:pt>
                <c:pt idx="3619">
                  <c:v>0.47642183480994571</c:v>
                </c:pt>
                <c:pt idx="3620">
                  <c:v>0.49248356673335236</c:v>
                </c:pt>
                <c:pt idx="3621">
                  <c:v>0.4831666190340097</c:v>
                </c:pt>
                <c:pt idx="3622">
                  <c:v>0.48642469276936268</c:v>
                </c:pt>
                <c:pt idx="3623">
                  <c:v>0.47596456130322951</c:v>
                </c:pt>
                <c:pt idx="3624">
                  <c:v>0.45778793941126034</c:v>
                </c:pt>
                <c:pt idx="3625">
                  <c:v>0.43938268076593312</c:v>
                </c:pt>
                <c:pt idx="3626">
                  <c:v>0.47042012003429551</c:v>
                </c:pt>
                <c:pt idx="3627">
                  <c:v>0.47202057730780222</c:v>
                </c:pt>
                <c:pt idx="3628">
                  <c:v>0.45858816804801372</c:v>
                </c:pt>
                <c:pt idx="3629">
                  <c:v>0.45235781651900542</c:v>
                </c:pt>
                <c:pt idx="3630">
                  <c:v>0.46264647042012003</c:v>
                </c:pt>
                <c:pt idx="3631">
                  <c:v>0.45441554729922834</c:v>
                </c:pt>
                <c:pt idx="3632">
                  <c:v>0.44904258359531296</c:v>
                </c:pt>
                <c:pt idx="3633">
                  <c:v>0.44184052586453271</c:v>
                </c:pt>
                <c:pt idx="3634">
                  <c:v>0.46190340097170618</c:v>
                </c:pt>
                <c:pt idx="3635">
                  <c:v>0.47087739354101171</c:v>
                </c:pt>
                <c:pt idx="3636">
                  <c:v>0.46659045441554731</c:v>
                </c:pt>
                <c:pt idx="3637">
                  <c:v>0.4752786510431552</c:v>
                </c:pt>
                <c:pt idx="3638">
                  <c:v>0.46544727064875679</c:v>
                </c:pt>
                <c:pt idx="3639">
                  <c:v>0.47876536153186627</c:v>
                </c:pt>
                <c:pt idx="3640">
                  <c:v>0.47716490425835956</c:v>
                </c:pt>
                <c:pt idx="3641">
                  <c:v>0.48522434981423263</c:v>
                </c:pt>
                <c:pt idx="3642">
                  <c:v>0.47242069162617889</c:v>
                </c:pt>
                <c:pt idx="3643">
                  <c:v>0.46384681337525008</c:v>
                </c:pt>
                <c:pt idx="3644">
                  <c:v>0.45338668190911691</c:v>
                </c:pt>
                <c:pt idx="3645">
                  <c:v>0.46167476421834808</c:v>
                </c:pt>
                <c:pt idx="3646">
                  <c:v>0.46624749928551013</c:v>
                </c:pt>
                <c:pt idx="3647">
                  <c:v>0.46550442983709633</c:v>
                </c:pt>
                <c:pt idx="3648">
                  <c:v>0.46664761360388685</c:v>
                </c:pt>
                <c:pt idx="3649">
                  <c:v>0.44326950557302086</c:v>
                </c:pt>
                <c:pt idx="3650">
                  <c:v>0.45584452700771649</c:v>
                </c:pt>
                <c:pt idx="3651">
                  <c:v>0.44538439554158332</c:v>
                </c:pt>
                <c:pt idx="3652">
                  <c:v>0.45492997999428408</c:v>
                </c:pt>
                <c:pt idx="3653">
                  <c:v>0.45927407830808803</c:v>
                </c:pt>
                <c:pt idx="3654">
                  <c:v>0.44561303229494142</c:v>
                </c:pt>
                <c:pt idx="3655">
                  <c:v>0.45961703343812516</c:v>
                </c:pt>
                <c:pt idx="3656">
                  <c:v>0.45384395541583311</c:v>
                </c:pt>
                <c:pt idx="3657">
                  <c:v>0.46676193198056587</c:v>
                </c:pt>
                <c:pt idx="3658">
                  <c:v>0.45955987424978567</c:v>
                </c:pt>
                <c:pt idx="3659">
                  <c:v>0.46836238925407259</c:v>
                </c:pt>
                <c:pt idx="3660">
                  <c:v>0.48545298656759073</c:v>
                </c:pt>
                <c:pt idx="3661">
                  <c:v>0.50460131466133185</c:v>
                </c:pt>
                <c:pt idx="3662">
                  <c:v>0.47247785081451843</c:v>
                </c:pt>
                <c:pt idx="3663">
                  <c:v>0.49202629322663616</c:v>
                </c:pt>
                <c:pt idx="3664">
                  <c:v>0.50677336381823379</c:v>
                </c:pt>
                <c:pt idx="3665">
                  <c:v>0.53992569305515858</c:v>
                </c:pt>
                <c:pt idx="3666">
                  <c:v>0.53855387253500997</c:v>
                </c:pt>
                <c:pt idx="3667">
                  <c:v>0.54266933409545581</c:v>
                </c:pt>
                <c:pt idx="3668">
                  <c:v>0.52575021434695624</c:v>
                </c:pt>
                <c:pt idx="3669">
                  <c:v>0.55798799657044873</c:v>
                </c:pt>
                <c:pt idx="3670">
                  <c:v>0.55444412689339806</c:v>
                </c:pt>
                <c:pt idx="3671">
                  <c:v>0.54061160331523295</c:v>
                </c:pt>
                <c:pt idx="3672">
                  <c:v>0.57742212060588738</c:v>
                </c:pt>
                <c:pt idx="3673">
                  <c:v>0.58725350100028584</c:v>
                </c:pt>
                <c:pt idx="3674">
                  <c:v>0.58262360674478419</c:v>
                </c:pt>
                <c:pt idx="3675">
                  <c:v>0.60880251500428695</c:v>
                </c:pt>
                <c:pt idx="3676">
                  <c:v>0.6152615032866533</c:v>
                </c:pt>
                <c:pt idx="3677">
                  <c:v>0.59925693055158613</c:v>
                </c:pt>
                <c:pt idx="3678">
                  <c:v>0.62983709631323237</c:v>
                </c:pt>
                <c:pt idx="3679">
                  <c:v>0.6340097170620177</c:v>
                </c:pt>
                <c:pt idx="3680">
                  <c:v>0.62234924264075453</c:v>
                </c:pt>
                <c:pt idx="3681">
                  <c:v>0.65721634752786506</c:v>
                </c:pt>
                <c:pt idx="3682">
                  <c:v>0.6537296370391541</c:v>
                </c:pt>
                <c:pt idx="3683">
                  <c:v>0.65973135181480425</c:v>
                </c:pt>
                <c:pt idx="3684">
                  <c:v>0.65887396398971132</c:v>
                </c:pt>
                <c:pt idx="3685">
                  <c:v>0.65110031437553584</c:v>
                </c:pt>
                <c:pt idx="3686">
                  <c:v>0.67116318948270937</c:v>
                </c:pt>
                <c:pt idx="3687">
                  <c:v>0.6541869105458703</c:v>
                </c:pt>
                <c:pt idx="3688">
                  <c:v>0.65452986567590743</c:v>
                </c:pt>
                <c:pt idx="3689">
                  <c:v>0.69031151757645037</c:v>
                </c:pt>
                <c:pt idx="3690">
                  <c:v>0.67024864246927696</c:v>
                </c:pt>
                <c:pt idx="3691">
                  <c:v>0.66396113175192917</c:v>
                </c:pt>
                <c:pt idx="3692">
                  <c:v>0.69825664475564442</c:v>
                </c:pt>
                <c:pt idx="3693">
                  <c:v>0.69894255501571878</c:v>
                </c:pt>
                <c:pt idx="3694">
                  <c:v>0.68791083166619038</c:v>
                </c:pt>
                <c:pt idx="3695">
                  <c:v>0.68162332094884248</c:v>
                </c:pt>
                <c:pt idx="3696">
                  <c:v>0.70545870248642473</c:v>
                </c:pt>
                <c:pt idx="3697">
                  <c:v>0.71626178908259508</c:v>
                </c:pt>
                <c:pt idx="3698">
                  <c:v>0.70677336381823375</c:v>
                </c:pt>
                <c:pt idx="3699">
                  <c:v>0.71077450700200062</c:v>
                </c:pt>
                <c:pt idx="3700">
                  <c:v>0.70905973135181477</c:v>
                </c:pt>
                <c:pt idx="3701">
                  <c:v>0.7007716490425836</c:v>
                </c:pt>
                <c:pt idx="3702">
                  <c:v>0.71603315232923692</c:v>
                </c:pt>
                <c:pt idx="3703">
                  <c:v>0.68065161474707059</c:v>
                </c:pt>
                <c:pt idx="3704">
                  <c:v>0.71123178050871683</c:v>
                </c:pt>
                <c:pt idx="3705">
                  <c:v>0.70385824521291795</c:v>
                </c:pt>
                <c:pt idx="3706">
                  <c:v>0.70723063732494995</c:v>
                </c:pt>
                <c:pt idx="3707">
                  <c:v>0.71391826236067446</c:v>
                </c:pt>
                <c:pt idx="3708">
                  <c:v>0.72655044298370963</c:v>
                </c:pt>
                <c:pt idx="3709">
                  <c:v>0.75833095170048581</c:v>
                </c:pt>
                <c:pt idx="3710">
                  <c:v>0.71643326664761364</c:v>
                </c:pt>
                <c:pt idx="3711">
                  <c:v>0.7315232923692484</c:v>
                </c:pt>
                <c:pt idx="3712">
                  <c:v>0.72306373249499856</c:v>
                </c:pt>
                <c:pt idx="3713">
                  <c:v>0.73472420691626183</c:v>
                </c:pt>
                <c:pt idx="3714">
                  <c:v>0.72832237782223497</c:v>
                </c:pt>
                <c:pt idx="3715">
                  <c:v>0.73586739068305229</c:v>
                </c:pt>
                <c:pt idx="3716">
                  <c:v>0.73975421549014009</c:v>
                </c:pt>
                <c:pt idx="3717">
                  <c:v>0.72992283509574163</c:v>
                </c:pt>
                <c:pt idx="3718">
                  <c:v>0.74072592169191198</c:v>
                </c:pt>
                <c:pt idx="3719">
                  <c:v>0.73912546441840521</c:v>
                </c:pt>
                <c:pt idx="3720">
                  <c:v>0.74306944841383249</c:v>
                </c:pt>
                <c:pt idx="3721">
                  <c:v>0.75090025721634757</c:v>
                </c:pt>
                <c:pt idx="3722">
                  <c:v>0.7247785081451843</c:v>
                </c:pt>
                <c:pt idx="3723">
                  <c:v>0.74226921977707916</c:v>
                </c:pt>
                <c:pt idx="3724">
                  <c:v>0.74861388968276654</c:v>
                </c:pt>
                <c:pt idx="3725">
                  <c:v>0.73803943983995424</c:v>
                </c:pt>
                <c:pt idx="3726">
                  <c:v>0.71751929122606461</c:v>
                </c:pt>
                <c:pt idx="3727">
                  <c:v>0.7536438982566448</c:v>
                </c:pt>
                <c:pt idx="3728">
                  <c:v>0.74569877107745075</c:v>
                </c:pt>
                <c:pt idx="3729">
                  <c:v>0.73375250071448983</c:v>
                </c:pt>
                <c:pt idx="3730">
                  <c:v>0.74032580737353526</c:v>
                </c:pt>
                <c:pt idx="3731">
                  <c:v>0.7517004858531009</c:v>
                </c:pt>
                <c:pt idx="3732">
                  <c:v>0.72626464704201199</c:v>
                </c:pt>
                <c:pt idx="3733">
                  <c:v>0.7439839954272649</c:v>
                </c:pt>
                <c:pt idx="3734">
                  <c:v>0.77484995713060878</c:v>
                </c:pt>
                <c:pt idx="3735">
                  <c:v>0.75421549014003997</c:v>
                </c:pt>
                <c:pt idx="3736">
                  <c:v>0.73849671334667044</c:v>
                </c:pt>
                <c:pt idx="3737">
                  <c:v>0.74684195484424121</c:v>
                </c:pt>
                <c:pt idx="3738">
                  <c:v>0.73781080308659619</c:v>
                </c:pt>
                <c:pt idx="3739">
                  <c:v>0.73506716204629896</c:v>
                </c:pt>
                <c:pt idx="3740">
                  <c:v>0.7478708202343527</c:v>
                </c:pt>
                <c:pt idx="3741">
                  <c:v>0.75495855958845381</c:v>
                </c:pt>
                <c:pt idx="3742">
                  <c:v>0.7295798799657045</c:v>
                </c:pt>
                <c:pt idx="3743">
                  <c:v>0.74009717062017721</c:v>
                </c:pt>
                <c:pt idx="3744">
                  <c:v>0.75570162903686766</c:v>
                </c:pt>
                <c:pt idx="3745">
                  <c:v>0.74004001143183762</c:v>
                </c:pt>
                <c:pt idx="3746">
                  <c:v>0.74632752214918552</c:v>
                </c:pt>
                <c:pt idx="3747">
                  <c:v>0.75855958845384397</c:v>
                </c:pt>
                <c:pt idx="3748">
                  <c:v>0.74958559588453844</c:v>
                </c:pt>
                <c:pt idx="3749">
                  <c:v>0.75267219205487279</c:v>
                </c:pt>
                <c:pt idx="3750">
                  <c:v>0.74552729351243208</c:v>
                </c:pt>
                <c:pt idx="3751">
                  <c:v>0.72769362675050009</c:v>
                </c:pt>
                <c:pt idx="3752">
                  <c:v>0.75375821663332376</c:v>
                </c:pt>
                <c:pt idx="3753">
                  <c:v>0.75187196341811946</c:v>
                </c:pt>
                <c:pt idx="3754">
                  <c:v>0.76050300085738787</c:v>
                </c:pt>
                <c:pt idx="3755">
                  <c:v>0.7387253501000286</c:v>
                </c:pt>
                <c:pt idx="3756">
                  <c:v>0.74838525292940838</c:v>
                </c:pt>
                <c:pt idx="3757">
                  <c:v>0.76004572735067166</c:v>
                </c:pt>
                <c:pt idx="3758">
                  <c:v>0.75844527007716489</c:v>
                </c:pt>
                <c:pt idx="3759">
                  <c:v>0.74221206058873967</c:v>
                </c:pt>
                <c:pt idx="3760">
                  <c:v>0.76261789082595022</c:v>
                </c:pt>
                <c:pt idx="3761">
                  <c:v>0.73215204344098317</c:v>
                </c:pt>
                <c:pt idx="3762">
                  <c:v>0.75221491854815659</c:v>
                </c:pt>
                <c:pt idx="3763">
                  <c:v>0.76416118891111751</c:v>
                </c:pt>
                <c:pt idx="3764">
                  <c:v>0.73958273792512141</c:v>
                </c:pt>
                <c:pt idx="3765">
                  <c:v>0.7444984281223207</c:v>
                </c:pt>
                <c:pt idx="3766">
                  <c:v>0.74101171763360962</c:v>
                </c:pt>
                <c:pt idx="3767">
                  <c:v>0.74009717062017721</c:v>
                </c:pt>
                <c:pt idx="3768">
                  <c:v>0.74981423263789659</c:v>
                </c:pt>
                <c:pt idx="3769">
                  <c:v>0.75438696770505864</c:v>
                </c:pt>
                <c:pt idx="3770">
                  <c:v>0.7483280937410689</c:v>
                </c:pt>
                <c:pt idx="3771">
                  <c:v>0.72935124321234635</c:v>
                </c:pt>
                <c:pt idx="3772">
                  <c:v>0.76593312374964273</c:v>
                </c:pt>
                <c:pt idx="3773">
                  <c:v>0.72923692483566738</c:v>
                </c:pt>
                <c:pt idx="3774">
                  <c:v>0.73981137467847957</c:v>
                </c:pt>
                <c:pt idx="3775">
                  <c:v>0.74181194627036295</c:v>
                </c:pt>
                <c:pt idx="3776">
                  <c:v>0.76907687910831668</c:v>
                </c:pt>
                <c:pt idx="3777">
                  <c:v>0.74947127750785936</c:v>
                </c:pt>
                <c:pt idx="3778">
                  <c:v>0.74615604458416696</c:v>
                </c:pt>
                <c:pt idx="3779">
                  <c:v>0.77216347527865103</c:v>
                </c:pt>
                <c:pt idx="3780">
                  <c:v>0.72917976564732778</c:v>
                </c:pt>
                <c:pt idx="3781">
                  <c:v>0.72969419834238358</c:v>
                </c:pt>
                <c:pt idx="3782">
                  <c:v>0.73306659045441558</c:v>
                </c:pt>
                <c:pt idx="3783">
                  <c:v>0.76427550728779647</c:v>
                </c:pt>
                <c:pt idx="3784">
                  <c:v>0.72369248356673332</c:v>
                </c:pt>
                <c:pt idx="3785">
                  <c:v>0.73946841954844245</c:v>
                </c:pt>
                <c:pt idx="3786">
                  <c:v>0.74701343240925977</c:v>
                </c:pt>
                <c:pt idx="3787">
                  <c:v>0.74466990568733926</c:v>
                </c:pt>
                <c:pt idx="3788">
                  <c:v>0.76147470705915976</c:v>
                </c:pt>
                <c:pt idx="3789">
                  <c:v>0.72969419834238358</c:v>
                </c:pt>
                <c:pt idx="3790">
                  <c:v>0.72615032866533291</c:v>
                </c:pt>
                <c:pt idx="3791">
                  <c:v>0.73369534152615035</c:v>
                </c:pt>
                <c:pt idx="3792">
                  <c:v>0.7411260360102887</c:v>
                </c:pt>
                <c:pt idx="3793">
                  <c:v>0.75152900828808233</c:v>
                </c:pt>
                <c:pt idx="3794">
                  <c:v>0.77833666761931986</c:v>
                </c:pt>
                <c:pt idx="3795">
                  <c:v>0.75781651900543012</c:v>
                </c:pt>
                <c:pt idx="3796">
                  <c:v>0.75895970277222058</c:v>
                </c:pt>
                <c:pt idx="3797">
                  <c:v>0.76101743355244356</c:v>
                </c:pt>
                <c:pt idx="3798">
                  <c:v>0.75495855958845381</c:v>
                </c:pt>
                <c:pt idx="3799">
                  <c:v>0.72306373249499856</c:v>
                </c:pt>
                <c:pt idx="3800">
                  <c:v>0.75158616747642182</c:v>
                </c:pt>
                <c:pt idx="3801">
                  <c:v>0.74769934266933413</c:v>
                </c:pt>
                <c:pt idx="3802">
                  <c:v>0.76187482137753648</c:v>
                </c:pt>
                <c:pt idx="3803">
                  <c:v>0.75232923692483566</c:v>
                </c:pt>
                <c:pt idx="3804">
                  <c:v>0.75684481280365823</c:v>
                </c:pt>
                <c:pt idx="3805">
                  <c:v>0.74644184052586449</c:v>
                </c:pt>
                <c:pt idx="3806">
                  <c:v>0.754101171763361</c:v>
                </c:pt>
                <c:pt idx="3807">
                  <c:v>0.7685052872249214</c:v>
                </c:pt>
                <c:pt idx="3808">
                  <c:v>0.75524435553015146</c:v>
                </c:pt>
                <c:pt idx="3809">
                  <c:v>0.75061446127464992</c:v>
                </c:pt>
                <c:pt idx="3810">
                  <c:v>0.74998571020291516</c:v>
                </c:pt>
                <c:pt idx="3811">
                  <c:v>0.74244069734209772</c:v>
                </c:pt>
                <c:pt idx="3812">
                  <c:v>0.76421834809945699</c:v>
                </c:pt>
                <c:pt idx="3813">
                  <c:v>0.7795370105744498</c:v>
                </c:pt>
                <c:pt idx="3814">
                  <c:v>0.757473563875393</c:v>
                </c:pt>
                <c:pt idx="3815">
                  <c:v>0.74564161188911116</c:v>
                </c:pt>
                <c:pt idx="3816">
                  <c:v>0.75415833095170048</c:v>
                </c:pt>
                <c:pt idx="3817">
                  <c:v>0.77387825092883678</c:v>
                </c:pt>
                <c:pt idx="3818">
                  <c:v>0.75107173478136613</c:v>
                </c:pt>
                <c:pt idx="3819">
                  <c:v>0.74947127750785936</c:v>
                </c:pt>
                <c:pt idx="3820">
                  <c:v>0.75267219205487279</c:v>
                </c:pt>
                <c:pt idx="3821">
                  <c:v>0.7310088596741926</c:v>
                </c:pt>
                <c:pt idx="3822">
                  <c:v>0.73581023149471281</c:v>
                </c:pt>
                <c:pt idx="3823">
                  <c:v>0.75152900828808233</c:v>
                </c:pt>
                <c:pt idx="3824">
                  <c:v>0.76541869105458704</c:v>
                </c:pt>
                <c:pt idx="3825">
                  <c:v>0.76358959702772222</c:v>
                </c:pt>
                <c:pt idx="3826">
                  <c:v>0.74644184052586449</c:v>
                </c:pt>
                <c:pt idx="3827">
                  <c:v>0.76347527865104314</c:v>
                </c:pt>
                <c:pt idx="3828">
                  <c:v>0.7555301514718491</c:v>
                </c:pt>
                <c:pt idx="3829">
                  <c:v>0.76016004572735063</c:v>
                </c:pt>
                <c:pt idx="3830">
                  <c:v>0.76627607887967986</c:v>
                </c:pt>
                <c:pt idx="3831">
                  <c:v>0.75913118033723925</c:v>
                </c:pt>
                <c:pt idx="3832">
                  <c:v>0.75781651900543012</c:v>
                </c:pt>
                <c:pt idx="3833">
                  <c:v>0.77982280651614744</c:v>
                </c:pt>
                <c:pt idx="3834">
                  <c:v>0.75147184909974274</c:v>
                </c:pt>
                <c:pt idx="3835">
                  <c:v>0.75987424978565299</c:v>
                </c:pt>
                <c:pt idx="3836">
                  <c:v>0.75387253501000284</c:v>
                </c:pt>
                <c:pt idx="3837">
                  <c:v>0.76747642183480991</c:v>
                </c:pt>
                <c:pt idx="3838">
                  <c:v>0.76090311517576448</c:v>
                </c:pt>
                <c:pt idx="3839">
                  <c:v>0.76747642183480991</c:v>
                </c:pt>
                <c:pt idx="3840">
                  <c:v>0.75261503286653331</c:v>
                </c:pt>
                <c:pt idx="3841">
                  <c:v>0.7574164046870534</c:v>
                </c:pt>
                <c:pt idx="3842">
                  <c:v>0.75758788225207208</c:v>
                </c:pt>
                <c:pt idx="3843">
                  <c:v>0.76461846241783371</c:v>
                </c:pt>
                <c:pt idx="3844">
                  <c:v>0.77816519005430118</c:v>
                </c:pt>
                <c:pt idx="3845">
                  <c:v>0.77507859388396683</c:v>
                </c:pt>
                <c:pt idx="3846">
                  <c:v>0.75581594741354674</c:v>
                </c:pt>
                <c:pt idx="3847">
                  <c:v>0.75267219205487279</c:v>
                </c:pt>
                <c:pt idx="3848">
                  <c:v>0.75833095170048581</c:v>
                </c:pt>
                <c:pt idx="3849">
                  <c:v>0.76244641326093165</c:v>
                </c:pt>
                <c:pt idx="3850">
                  <c:v>0.75490140040011433</c:v>
                </c:pt>
                <c:pt idx="3851">
                  <c:v>0.78165190054301226</c:v>
                </c:pt>
                <c:pt idx="3852">
                  <c:v>0.74415547299228346</c:v>
                </c:pt>
                <c:pt idx="3853">
                  <c:v>0.77742212060588745</c:v>
                </c:pt>
                <c:pt idx="3854">
                  <c:v>0.76621891969134037</c:v>
                </c:pt>
                <c:pt idx="3855">
                  <c:v>0.76004572735067166</c:v>
                </c:pt>
                <c:pt idx="3856">
                  <c:v>0.76839096884824232</c:v>
                </c:pt>
                <c:pt idx="3857">
                  <c:v>0.76930551586167473</c:v>
                </c:pt>
                <c:pt idx="3858">
                  <c:v>0.75318662474992859</c:v>
                </c:pt>
                <c:pt idx="3859">
                  <c:v>0.78096599028293801</c:v>
                </c:pt>
                <c:pt idx="3860">
                  <c:v>0.7589025435838811</c:v>
                </c:pt>
                <c:pt idx="3861">
                  <c:v>0.75255787367819382</c:v>
                </c:pt>
                <c:pt idx="3862">
                  <c:v>0.7483280937410689</c:v>
                </c:pt>
                <c:pt idx="3863">
                  <c:v>0.76027436410402971</c:v>
                </c:pt>
                <c:pt idx="3864">
                  <c:v>0.77456416118891114</c:v>
                </c:pt>
                <c:pt idx="3865">
                  <c:v>0.76576164618462417</c:v>
                </c:pt>
                <c:pt idx="3866">
                  <c:v>0.7771363246641898</c:v>
                </c:pt>
                <c:pt idx="3867">
                  <c:v>0.75781651900543012</c:v>
                </c:pt>
                <c:pt idx="3868">
                  <c:v>0.74901400400114315</c:v>
                </c:pt>
                <c:pt idx="3869">
                  <c:v>0.74992855101457556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0-D312-4A68-A0AD-B13EE46C663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978318784"/>
        <c:axId val="1978319616"/>
      </c:scatterChart>
      <c:valAx>
        <c:axId val="1978318784"/>
        <c:scaling>
          <c:orientation val="minMax"/>
          <c:max val="800"/>
          <c:min val="250"/>
        </c:scaling>
        <c:delete val="1"/>
        <c:axPos val="b"/>
        <c:numFmt formatCode="General" sourceLinked="1"/>
        <c:majorTickMark val="out"/>
        <c:minorTickMark val="none"/>
        <c:tickLblPos val="nextTo"/>
        <c:crossAx val="1978319616"/>
        <c:crosses val="autoZero"/>
        <c:crossBetween val="midCat"/>
        <c:majorUnit val="200"/>
      </c:valAx>
      <c:valAx>
        <c:axId val="1978319616"/>
        <c:scaling>
          <c:orientation val="minMax"/>
          <c:max val="2"/>
          <c:min val="0.5"/>
        </c:scaling>
        <c:delete val="1"/>
        <c:axPos val="l"/>
        <c:numFmt formatCode="General" sourceLinked="1"/>
        <c:majorTickMark val="out"/>
        <c:minorTickMark val="none"/>
        <c:tickLblPos val="nextTo"/>
        <c:crossAx val="1978318784"/>
        <c:crosses val="autoZero"/>
        <c:crossBetween val="midCat"/>
      </c:valAx>
      <c:spPr>
        <a:noFill/>
        <a:ln w="25400">
          <a:noFill/>
        </a:ln>
      </c:spPr>
    </c:plotArea>
    <c:plotVisOnly val="1"/>
    <c:dispBlanksAs val="gap"/>
    <c:showDLblsOverMax val="0"/>
  </c:chart>
  <c:txPr>
    <a:bodyPr/>
    <a:lstStyle/>
    <a:p>
      <a:pPr>
        <a:defRPr sz="1400">
          <a:solidFill>
            <a:sysClr val="windowText" lastClr="000000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4"/>
    </mc:Choice>
    <mc:Fallback>
      <c:style val="4"/>
    </mc:Fallback>
  </mc:AlternateContent>
  <c:chart>
    <c:autoTitleDeleted val="1"/>
    <c:plotArea>
      <c:layout>
        <c:manualLayout>
          <c:layoutTarget val="inner"/>
          <c:xMode val="edge"/>
          <c:yMode val="edge"/>
          <c:x val="9.9752405949256356E-2"/>
          <c:y val="7.7557961504811909E-2"/>
          <c:w val="0.8308031496062992"/>
          <c:h val="0.80058216681248173"/>
        </c:manualLayout>
      </c:layout>
      <c:scatterChart>
        <c:scatterStyle val="smoothMarker"/>
        <c:varyColors val="0"/>
        <c:ser>
          <c:idx val="15"/>
          <c:order val="0"/>
          <c:tx>
            <c:strRef>
              <c:f>'Sheet6 GSK'!$AK$43</c:f>
              <c:strCache>
                <c:ptCount val="1"/>
                <c:pt idx="0">
                  <c:v>   Object[16]</c:v>
                </c:pt>
              </c:strCache>
            </c:strRef>
          </c:tx>
          <c:spPr>
            <a:ln w="3175" cap="rnd">
              <a:solidFill>
                <a:srgbClr val="C76009"/>
              </a:solidFill>
              <a:round/>
            </a:ln>
            <a:effectLst/>
          </c:spPr>
          <c:marker>
            <c:symbol val="none"/>
          </c:marker>
          <c:xVal>
            <c:numRef>
              <c:f>'Sheet6 GSK'!$U$44:$U$2718</c:f>
              <c:numCache>
                <c:formatCode>General</c:formatCode>
                <c:ptCount val="2675"/>
                <c:pt idx="0">
                  <c:v>0.33</c:v>
                </c:pt>
                <c:pt idx="1">
                  <c:v>0.74</c:v>
                </c:pt>
                <c:pt idx="2">
                  <c:v>1.1399999999999999</c:v>
                </c:pt>
                <c:pt idx="3">
                  <c:v>1.55</c:v>
                </c:pt>
                <c:pt idx="4">
                  <c:v>1.95</c:v>
                </c:pt>
                <c:pt idx="5">
                  <c:v>2.36</c:v>
                </c:pt>
                <c:pt idx="6">
                  <c:v>2.76</c:v>
                </c:pt>
                <c:pt idx="7">
                  <c:v>3.17</c:v>
                </c:pt>
                <c:pt idx="8">
                  <c:v>3.57</c:v>
                </c:pt>
                <c:pt idx="9">
                  <c:v>3.98</c:v>
                </c:pt>
                <c:pt idx="10">
                  <c:v>4.38</c:v>
                </c:pt>
                <c:pt idx="11">
                  <c:v>4.79</c:v>
                </c:pt>
                <c:pt idx="12">
                  <c:v>5.2</c:v>
                </c:pt>
                <c:pt idx="13">
                  <c:v>5.6</c:v>
                </c:pt>
                <c:pt idx="14">
                  <c:v>6.01</c:v>
                </c:pt>
                <c:pt idx="15">
                  <c:v>6.41</c:v>
                </c:pt>
                <c:pt idx="16">
                  <c:v>6.82</c:v>
                </c:pt>
                <c:pt idx="17">
                  <c:v>7.22</c:v>
                </c:pt>
                <c:pt idx="18">
                  <c:v>7.63</c:v>
                </c:pt>
                <c:pt idx="19">
                  <c:v>8.0399999999999991</c:v>
                </c:pt>
                <c:pt idx="20">
                  <c:v>8.44</c:v>
                </c:pt>
                <c:pt idx="21">
                  <c:v>8.85</c:v>
                </c:pt>
                <c:pt idx="22">
                  <c:v>9.25</c:v>
                </c:pt>
                <c:pt idx="23">
                  <c:v>9.66</c:v>
                </c:pt>
                <c:pt idx="24">
                  <c:v>10.06</c:v>
                </c:pt>
                <c:pt idx="25">
                  <c:v>10.47</c:v>
                </c:pt>
                <c:pt idx="26">
                  <c:v>10.87</c:v>
                </c:pt>
                <c:pt idx="27">
                  <c:v>11.28</c:v>
                </c:pt>
                <c:pt idx="28">
                  <c:v>11.69</c:v>
                </c:pt>
                <c:pt idx="29">
                  <c:v>12.09</c:v>
                </c:pt>
                <c:pt idx="30">
                  <c:v>12.5</c:v>
                </c:pt>
                <c:pt idx="31">
                  <c:v>12.9</c:v>
                </c:pt>
                <c:pt idx="32">
                  <c:v>13.31</c:v>
                </c:pt>
                <c:pt idx="33">
                  <c:v>13.71</c:v>
                </c:pt>
                <c:pt idx="34">
                  <c:v>14.12</c:v>
                </c:pt>
                <c:pt idx="35">
                  <c:v>14.53</c:v>
                </c:pt>
                <c:pt idx="36">
                  <c:v>14.93</c:v>
                </c:pt>
                <c:pt idx="37">
                  <c:v>15.34</c:v>
                </c:pt>
                <c:pt idx="38">
                  <c:v>15.74</c:v>
                </c:pt>
                <c:pt idx="39">
                  <c:v>16.149999999999999</c:v>
                </c:pt>
                <c:pt idx="40">
                  <c:v>16.55</c:v>
                </c:pt>
                <c:pt idx="41">
                  <c:v>16.96</c:v>
                </c:pt>
                <c:pt idx="42">
                  <c:v>17.37</c:v>
                </c:pt>
                <c:pt idx="43">
                  <c:v>17.77</c:v>
                </c:pt>
                <c:pt idx="44">
                  <c:v>18.18</c:v>
                </c:pt>
                <c:pt idx="45">
                  <c:v>18.579999999999998</c:v>
                </c:pt>
                <c:pt idx="46">
                  <c:v>18.989999999999998</c:v>
                </c:pt>
                <c:pt idx="47">
                  <c:v>19.39</c:v>
                </c:pt>
                <c:pt idx="48">
                  <c:v>19.8</c:v>
                </c:pt>
                <c:pt idx="49">
                  <c:v>20.2</c:v>
                </c:pt>
                <c:pt idx="50">
                  <c:v>20.61</c:v>
                </c:pt>
                <c:pt idx="51">
                  <c:v>21.01</c:v>
                </c:pt>
                <c:pt idx="52">
                  <c:v>21.42</c:v>
                </c:pt>
                <c:pt idx="53">
                  <c:v>21.83</c:v>
                </c:pt>
                <c:pt idx="54">
                  <c:v>22.23</c:v>
                </c:pt>
                <c:pt idx="55">
                  <c:v>22.64</c:v>
                </c:pt>
                <c:pt idx="56">
                  <c:v>23.04</c:v>
                </c:pt>
                <c:pt idx="57">
                  <c:v>23.45</c:v>
                </c:pt>
                <c:pt idx="58">
                  <c:v>23.86</c:v>
                </c:pt>
                <c:pt idx="59">
                  <c:v>24.26</c:v>
                </c:pt>
                <c:pt idx="60">
                  <c:v>24.67</c:v>
                </c:pt>
                <c:pt idx="61">
                  <c:v>25.07</c:v>
                </c:pt>
                <c:pt idx="62">
                  <c:v>25.48</c:v>
                </c:pt>
                <c:pt idx="63">
                  <c:v>25.88</c:v>
                </c:pt>
                <c:pt idx="64">
                  <c:v>26.29</c:v>
                </c:pt>
                <c:pt idx="65">
                  <c:v>26.69</c:v>
                </c:pt>
                <c:pt idx="66">
                  <c:v>27.1</c:v>
                </c:pt>
                <c:pt idx="67">
                  <c:v>27.51</c:v>
                </c:pt>
                <c:pt idx="68">
                  <c:v>27.91</c:v>
                </c:pt>
                <c:pt idx="69">
                  <c:v>28.32</c:v>
                </c:pt>
                <c:pt idx="70">
                  <c:v>28.72</c:v>
                </c:pt>
                <c:pt idx="71">
                  <c:v>29.13</c:v>
                </c:pt>
                <c:pt idx="72">
                  <c:v>29.53</c:v>
                </c:pt>
                <c:pt idx="73">
                  <c:v>29.94</c:v>
                </c:pt>
                <c:pt idx="74">
                  <c:v>30.34</c:v>
                </c:pt>
                <c:pt idx="75">
                  <c:v>30.75</c:v>
                </c:pt>
                <c:pt idx="76">
                  <c:v>31.15</c:v>
                </c:pt>
                <c:pt idx="77">
                  <c:v>31.56</c:v>
                </c:pt>
                <c:pt idx="78">
                  <c:v>31.97</c:v>
                </c:pt>
                <c:pt idx="79">
                  <c:v>32.369999999999997</c:v>
                </c:pt>
                <c:pt idx="80">
                  <c:v>32.78</c:v>
                </c:pt>
                <c:pt idx="81">
                  <c:v>33.19</c:v>
                </c:pt>
                <c:pt idx="82">
                  <c:v>33.590000000000003</c:v>
                </c:pt>
                <c:pt idx="83">
                  <c:v>33.99</c:v>
                </c:pt>
                <c:pt idx="84">
                  <c:v>34.4</c:v>
                </c:pt>
                <c:pt idx="85">
                  <c:v>34.81</c:v>
                </c:pt>
                <c:pt idx="86">
                  <c:v>35.21</c:v>
                </c:pt>
                <c:pt idx="87">
                  <c:v>35.619999999999997</c:v>
                </c:pt>
                <c:pt idx="88">
                  <c:v>36.020000000000003</c:v>
                </c:pt>
                <c:pt idx="89">
                  <c:v>36.43</c:v>
                </c:pt>
                <c:pt idx="90">
                  <c:v>36.83</c:v>
                </c:pt>
                <c:pt idx="91">
                  <c:v>37.24</c:v>
                </c:pt>
                <c:pt idx="92">
                  <c:v>37.65</c:v>
                </c:pt>
                <c:pt idx="93">
                  <c:v>38.049999999999997</c:v>
                </c:pt>
                <c:pt idx="94">
                  <c:v>38.46</c:v>
                </c:pt>
                <c:pt idx="95">
                  <c:v>38.86</c:v>
                </c:pt>
                <c:pt idx="96">
                  <c:v>39.270000000000003</c:v>
                </c:pt>
                <c:pt idx="97">
                  <c:v>39.67</c:v>
                </c:pt>
                <c:pt idx="98">
                  <c:v>40.08</c:v>
                </c:pt>
                <c:pt idx="99">
                  <c:v>40.479999999999997</c:v>
                </c:pt>
                <c:pt idx="100">
                  <c:v>40.89</c:v>
                </c:pt>
                <c:pt idx="101">
                  <c:v>41.29</c:v>
                </c:pt>
                <c:pt idx="102">
                  <c:v>41.7</c:v>
                </c:pt>
                <c:pt idx="103">
                  <c:v>42.11</c:v>
                </c:pt>
                <c:pt idx="104">
                  <c:v>42.51</c:v>
                </c:pt>
                <c:pt idx="105">
                  <c:v>42.92</c:v>
                </c:pt>
                <c:pt idx="106">
                  <c:v>43.32</c:v>
                </c:pt>
                <c:pt idx="107">
                  <c:v>43.73</c:v>
                </c:pt>
                <c:pt idx="108">
                  <c:v>44.13</c:v>
                </c:pt>
                <c:pt idx="109">
                  <c:v>44.54</c:v>
                </c:pt>
                <c:pt idx="110">
                  <c:v>44.95</c:v>
                </c:pt>
                <c:pt idx="111">
                  <c:v>45.35</c:v>
                </c:pt>
                <c:pt idx="112">
                  <c:v>45.75</c:v>
                </c:pt>
                <c:pt idx="113">
                  <c:v>46.16</c:v>
                </c:pt>
                <c:pt idx="114">
                  <c:v>46.57</c:v>
                </c:pt>
                <c:pt idx="115">
                  <c:v>46.97</c:v>
                </c:pt>
                <c:pt idx="116">
                  <c:v>47.38</c:v>
                </c:pt>
                <c:pt idx="117">
                  <c:v>47.78</c:v>
                </c:pt>
                <c:pt idx="118">
                  <c:v>48.19</c:v>
                </c:pt>
                <c:pt idx="119">
                  <c:v>48.6</c:v>
                </c:pt>
                <c:pt idx="120">
                  <c:v>49</c:v>
                </c:pt>
                <c:pt idx="121">
                  <c:v>49.41</c:v>
                </c:pt>
                <c:pt idx="122">
                  <c:v>49.81</c:v>
                </c:pt>
                <c:pt idx="123">
                  <c:v>50.22</c:v>
                </c:pt>
                <c:pt idx="124">
                  <c:v>50.62</c:v>
                </c:pt>
                <c:pt idx="125">
                  <c:v>51.03</c:v>
                </c:pt>
                <c:pt idx="126">
                  <c:v>51.44</c:v>
                </c:pt>
                <c:pt idx="127">
                  <c:v>51.84</c:v>
                </c:pt>
                <c:pt idx="128">
                  <c:v>52.25</c:v>
                </c:pt>
                <c:pt idx="129">
                  <c:v>52.65</c:v>
                </c:pt>
                <c:pt idx="130">
                  <c:v>53.06</c:v>
                </c:pt>
                <c:pt idx="131">
                  <c:v>53.46</c:v>
                </c:pt>
                <c:pt idx="132">
                  <c:v>53.87</c:v>
                </c:pt>
                <c:pt idx="133">
                  <c:v>54.27</c:v>
                </c:pt>
                <c:pt idx="134">
                  <c:v>54.67</c:v>
                </c:pt>
                <c:pt idx="135">
                  <c:v>55.09</c:v>
                </c:pt>
                <c:pt idx="136">
                  <c:v>55.49</c:v>
                </c:pt>
                <c:pt idx="137">
                  <c:v>55.9</c:v>
                </c:pt>
                <c:pt idx="138">
                  <c:v>56.3</c:v>
                </c:pt>
                <c:pt idx="139">
                  <c:v>56.71</c:v>
                </c:pt>
                <c:pt idx="140">
                  <c:v>57.12</c:v>
                </c:pt>
                <c:pt idx="141">
                  <c:v>57.52</c:v>
                </c:pt>
                <c:pt idx="142">
                  <c:v>57.93</c:v>
                </c:pt>
                <c:pt idx="143">
                  <c:v>58.69</c:v>
                </c:pt>
                <c:pt idx="144">
                  <c:v>59.1</c:v>
                </c:pt>
                <c:pt idx="145">
                  <c:v>59.5</c:v>
                </c:pt>
                <c:pt idx="146">
                  <c:v>59.91</c:v>
                </c:pt>
                <c:pt idx="147">
                  <c:v>60.31</c:v>
                </c:pt>
                <c:pt idx="148">
                  <c:v>60.72</c:v>
                </c:pt>
                <c:pt idx="149">
                  <c:v>61.12</c:v>
                </c:pt>
                <c:pt idx="150">
                  <c:v>61.53</c:v>
                </c:pt>
                <c:pt idx="151">
                  <c:v>61.93</c:v>
                </c:pt>
                <c:pt idx="152">
                  <c:v>62.34</c:v>
                </c:pt>
                <c:pt idx="153">
                  <c:v>62.75</c:v>
                </c:pt>
                <c:pt idx="154">
                  <c:v>63.15</c:v>
                </c:pt>
                <c:pt idx="155">
                  <c:v>63.56</c:v>
                </c:pt>
                <c:pt idx="156">
                  <c:v>63.96</c:v>
                </c:pt>
                <c:pt idx="157">
                  <c:v>64.37</c:v>
                </c:pt>
                <c:pt idx="158">
                  <c:v>64.77</c:v>
                </c:pt>
                <c:pt idx="159">
                  <c:v>65.17</c:v>
                </c:pt>
                <c:pt idx="160">
                  <c:v>65.58</c:v>
                </c:pt>
                <c:pt idx="161">
                  <c:v>65.989999999999995</c:v>
                </c:pt>
                <c:pt idx="162">
                  <c:v>66.400000000000006</c:v>
                </c:pt>
                <c:pt idx="163">
                  <c:v>66.8</c:v>
                </c:pt>
                <c:pt idx="164">
                  <c:v>67.209999999999994</c:v>
                </c:pt>
                <c:pt idx="165">
                  <c:v>67.61</c:v>
                </c:pt>
                <c:pt idx="166">
                  <c:v>68.02</c:v>
                </c:pt>
                <c:pt idx="167">
                  <c:v>68.42</c:v>
                </c:pt>
                <c:pt idx="168">
                  <c:v>68.83</c:v>
                </c:pt>
                <c:pt idx="169">
                  <c:v>69.239999999999995</c:v>
                </c:pt>
                <c:pt idx="170">
                  <c:v>69.64</c:v>
                </c:pt>
                <c:pt idx="171">
                  <c:v>70.05</c:v>
                </c:pt>
                <c:pt idx="172">
                  <c:v>70.45</c:v>
                </c:pt>
                <c:pt idx="173">
                  <c:v>70.86</c:v>
                </c:pt>
                <c:pt idx="174">
                  <c:v>71.27</c:v>
                </c:pt>
                <c:pt idx="175">
                  <c:v>71.67</c:v>
                </c:pt>
                <c:pt idx="176">
                  <c:v>72.069999999999993</c:v>
                </c:pt>
                <c:pt idx="177">
                  <c:v>72.48</c:v>
                </c:pt>
                <c:pt idx="178">
                  <c:v>72.88</c:v>
                </c:pt>
                <c:pt idx="179">
                  <c:v>73.290000000000006</c:v>
                </c:pt>
                <c:pt idx="180">
                  <c:v>73.7</c:v>
                </c:pt>
                <c:pt idx="181">
                  <c:v>74.099999999999994</c:v>
                </c:pt>
                <c:pt idx="182">
                  <c:v>74.510000000000005</c:v>
                </c:pt>
                <c:pt idx="183">
                  <c:v>74.91</c:v>
                </c:pt>
                <c:pt idx="184">
                  <c:v>75.319999999999993</c:v>
                </c:pt>
                <c:pt idx="185">
                  <c:v>75.72</c:v>
                </c:pt>
                <c:pt idx="186">
                  <c:v>76.13</c:v>
                </c:pt>
                <c:pt idx="187">
                  <c:v>76.540000000000006</c:v>
                </c:pt>
                <c:pt idx="188">
                  <c:v>76.94</c:v>
                </c:pt>
                <c:pt idx="189">
                  <c:v>77.34</c:v>
                </c:pt>
                <c:pt idx="190">
                  <c:v>77.75</c:v>
                </c:pt>
                <c:pt idx="191">
                  <c:v>78.16</c:v>
                </c:pt>
                <c:pt idx="192">
                  <c:v>78.56</c:v>
                </c:pt>
                <c:pt idx="193">
                  <c:v>78.97</c:v>
                </c:pt>
                <c:pt idx="194">
                  <c:v>79.37</c:v>
                </c:pt>
                <c:pt idx="195">
                  <c:v>79.78</c:v>
                </c:pt>
                <c:pt idx="196">
                  <c:v>80.19</c:v>
                </c:pt>
                <c:pt idx="197">
                  <c:v>80.59</c:v>
                </c:pt>
                <c:pt idx="198">
                  <c:v>81</c:v>
                </c:pt>
                <c:pt idx="199">
                  <c:v>81.41</c:v>
                </c:pt>
                <c:pt idx="200">
                  <c:v>81.81</c:v>
                </c:pt>
                <c:pt idx="201">
                  <c:v>82.21</c:v>
                </c:pt>
                <c:pt idx="202">
                  <c:v>82.62</c:v>
                </c:pt>
                <c:pt idx="203">
                  <c:v>83.02</c:v>
                </c:pt>
                <c:pt idx="204">
                  <c:v>83.43</c:v>
                </c:pt>
                <c:pt idx="205">
                  <c:v>83.84</c:v>
                </c:pt>
                <c:pt idx="206">
                  <c:v>84.24</c:v>
                </c:pt>
                <c:pt idx="207">
                  <c:v>84.65</c:v>
                </c:pt>
                <c:pt idx="208">
                  <c:v>85.05</c:v>
                </c:pt>
                <c:pt idx="209">
                  <c:v>85.45</c:v>
                </c:pt>
                <c:pt idx="210">
                  <c:v>85.86</c:v>
                </c:pt>
                <c:pt idx="211">
                  <c:v>86.27</c:v>
                </c:pt>
                <c:pt idx="212">
                  <c:v>86.68</c:v>
                </c:pt>
                <c:pt idx="213">
                  <c:v>87.08</c:v>
                </c:pt>
                <c:pt idx="214">
                  <c:v>87.49</c:v>
                </c:pt>
                <c:pt idx="215">
                  <c:v>87.89</c:v>
                </c:pt>
                <c:pt idx="216">
                  <c:v>88.3</c:v>
                </c:pt>
                <c:pt idx="217">
                  <c:v>88.7</c:v>
                </c:pt>
                <c:pt idx="218">
                  <c:v>89.11</c:v>
                </c:pt>
                <c:pt idx="219">
                  <c:v>89.51</c:v>
                </c:pt>
                <c:pt idx="220">
                  <c:v>89.92</c:v>
                </c:pt>
                <c:pt idx="221">
                  <c:v>90.33</c:v>
                </c:pt>
                <c:pt idx="222">
                  <c:v>90.73</c:v>
                </c:pt>
                <c:pt idx="223">
                  <c:v>91.14</c:v>
                </c:pt>
                <c:pt idx="224">
                  <c:v>91.54</c:v>
                </c:pt>
                <c:pt idx="225">
                  <c:v>91.95</c:v>
                </c:pt>
                <c:pt idx="226">
                  <c:v>92.35</c:v>
                </c:pt>
                <c:pt idx="227">
                  <c:v>92.76</c:v>
                </c:pt>
                <c:pt idx="228">
                  <c:v>93.16</c:v>
                </c:pt>
                <c:pt idx="229">
                  <c:v>93.57</c:v>
                </c:pt>
                <c:pt idx="230">
                  <c:v>93.98</c:v>
                </c:pt>
                <c:pt idx="231">
                  <c:v>94.38</c:v>
                </c:pt>
                <c:pt idx="232">
                  <c:v>94.79</c:v>
                </c:pt>
                <c:pt idx="233">
                  <c:v>95.19</c:v>
                </c:pt>
                <c:pt idx="234">
                  <c:v>95.6</c:v>
                </c:pt>
                <c:pt idx="235">
                  <c:v>96</c:v>
                </c:pt>
                <c:pt idx="236">
                  <c:v>96.41</c:v>
                </c:pt>
                <c:pt idx="237">
                  <c:v>96.82</c:v>
                </c:pt>
                <c:pt idx="238">
                  <c:v>97.22</c:v>
                </c:pt>
                <c:pt idx="239">
                  <c:v>97.62</c:v>
                </c:pt>
                <c:pt idx="240">
                  <c:v>98.03</c:v>
                </c:pt>
                <c:pt idx="241">
                  <c:v>98.44</c:v>
                </c:pt>
                <c:pt idx="242">
                  <c:v>98.84</c:v>
                </c:pt>
                <c:pt idx="243">
                  <c:v>99.25</c:v>
                </c:pt>
                <c:pt idx="244">
                  <c:v>99.66</c:v>
                </c:pt>
                <c:pt idx="245">
                  <c:v>100.06</c:v>
                </c:pt>
                <c:pt idx="246">
                  <c:v>100.47</c:v>
                </c:pt>
                <c:pt idx="247">
                  <c:v>100.87</c:v>
                </c:pt>
                <c:pt idx="248">
                  <c:v>101.28</c:v>
                </c:pt>
                <c:pt idx="249">
                  <c:v>101.69</c:v>
                </c:pt>
                <c:pt idx="250">
                  <c:v>102.09</c:v>
                </c:pt>
                <c:pt idx="251">
                  <c:v>102.5</c:v>
                </c:pt>
                <c:pt idx="252">
                  <c:v>102.9</c:v>
                </c:pt>
                <c:pt idx="253">
                  <c:v>103.3</c:v>
                </c:pt>
                <c:pt idx="254">
                  <c:v>103.71</c:v>
                </c:pt>
                <c:pt idx="255">
                  <c:v>104.12</c:v>
                </c:pt>
                <c:pt idx="256">
                  <c:v>104.52</c:v>
                </c:pt>
                <c:pt idx="257">
                  <c:v>104.93</c:v>
                </c:pt>
                <c:pt idx="258">
                  <c:v>105.33</c:v>
                </c:pt>
                <c:pt idx="259">
                  <c:v>105.74</c:v>
                </c:pt>
                <c:pt idx="260">
                  <c:v>106.14</c:v>
                </c:pt>
                <c:pt idx="261">
                  <c:v>106.55</c:v>
                </c:pt>
                <c:pt idx="262">
                  <c:v>106.96</c:v>
                </c:pt>
                <c:pt idx="263">
                  <c:v>107.36</c:v>
                </c:pt>
                <c:pt idx="264">
                  <c:v>107.76</c:v>
                </c:pt>
                <c:pt idx="265">
                  <c:v>108.17</c:v>
                </c:pt>
                <c:pt idx="266">
                  <c:v>108.58</c:v>
                </c:pt>
                <c:pt idx="267">
                  <c:v>108.98</c:v>
                </c:pt>
                <c:pt idx="268">
                  <c:v>109.39</c:v>
                </c:pt>
                <c:pt idx="269">
                  <c:v>109.8</c:v>
                </c:pt>
                <c:pt idx="270">
                  <c:v>110.2</c:v>
                </c:pt>
                <c:pt idx="271">
                  <c:v>110.61</c:v>
                </c:pt>
                <c:pt idx="272">
                  <c:v>111.01</c:v>
                </c:pt>
                <c:pt idx="273">
                  <c:v>111.42</c:v>
                </c:pt>
                <c:pt idx="274">
                  <c:v>111.83</c:v>
                </c:pt>
                <c:pt idx="275">
                  <c:v>112.23</c:v>
                </c:pt>
                <c:pt idx="276">
                  <c:v>112.63</c:v>
                </c:pt>
                <c:pt idx="277">
                  <c:v>113.04</c:v>
                </c:pt>
                <c:pt idx="278">
                  <c:v>113.45</c:v>
                </c:pt>
                <c:pt idx="279">
                  <c:v>113.86</c:v>
                </c:pt>
                <c:pt idx="280">
                  <c:v>114.26</c:v>
                </c:pt>
                <c:pt idx="281">
                  <c:v>114.66</c:v>
                </c:pt>
                <c:pt idx="282">
                  <c:v>115.07</c:v>
                </c:pt>
                <c:pt idx="283">
                  <c:v>115.47</c:v>
                </c:pt>
                <c:pt idx="284">
                  <c:v>115.88</c:v>
                </c:pt>
                <c:pt idx="285">
                  <c:v>116.28</c:v>
                </c:pt>
                <c:pt idx="286">
                  <c:v>116.69</c:v>
                </c:pt>
                <c:pt idx="287">
                  <c:v>117.09</c:v>
                </c:pt>
                <c:pt idx="288">
                  <c:v>117.5</c:v>
                </c:pt>
                <c:pt idx="289">
                  <c:v>117.91</c:v>
                </c:pt>
                <c:pt idx="290">
                  <c:v>118.31</c:v>
                </c:pt>
                <c:pt idx="291">
                  <c:v>118.72</c:v>
                </c:pt>
                <c:pt idx="292">
                  <c:v>119.12</c:v>
                </c:pt>
                <c:pt idx="293">
                  <c:v>119.53</c:v>
                </c:pt>
                <c:pt idx="294">
                  <c:v>119.94</c:v>
                </c:pt>
                <c:pt idx="295">
                  <c:v>120.34</c:v>
                </c:pt>
                <c:pt idx="296">
                  <c:v>120.75</c:v>
                </c:pt>
                <c:pt idx="297">
                  <c:v>121.15</c:v>
                </c:pt>
                <c:pt idx="298">
                  <c:v>121.56</c:v>
                </c:pt>
                <c:pt idx="299">
                  <c:v>121.97</c:v>
                </c:pt>
                <c:pt idx="300">
                  <c:v>122.37</c:v>
                </c:pt>
                <c:pt idx="301">
                  <c:v>122.77</c:v>
                </c:pt>
                <c:pt idx="302">
                  <c:v>123.18</c:v>
                </c:pt>
                <c:pt idx="303">
                  <c:v>123.58</c:v>
                </c:pt>
                <c:pt idx="304">
                  <c:v>123.99</c:v>
                </c:pt>
                <c:pt idx="305">
                  <c:v>124.4</c:v>
                </c:pt>
                <c:pt idx="306">
                  <c:v>124.8</c:v>
                </c:pt>
                <c:pt idx="307">
                  <c:v>125.21</c:v>
                </c:pt>
                <c:pt idx="308">
                  <c:v>125.61</c:v>
                </c:pt>
                <c:pt idx="309">
                  <c:v>126.02</c:v>
                </c:pt>
                <c:pt idx="310">
                  <c:v>126.42</c:v>
                </c:pt>
                <c:pt idx="311">
                  <c:v>126.83</c:v>
                </c:pt>
                <c:pt idx="312">
                  <c:v>127.24</c:v>
                </c:pt>
                <c:pt idx="313">
                  <c:v>127.64</c:v>
                </c:pt>
                <c:pt idx="314">
                  <c:v>128.05000000000001</c:v>
                </c:pt>
                <c:pt idx="315">
                  <c:v>128.44999999999999</c:v>
                </c:pt>
                <c:pt idx="316">
                  <c:v>128.86000000000001</c:v>
                </c:pt>
                <c:pt idx="317">
                  <c:v>129.26</c:v>
                </c:pt>
                <c:pt idx="318">
                  <c:v>129.66999999999999</c:v>
                </c:pt>
                <c:pt idx="319">
                  <c:v>130.08000000000001</c:v>
                </c:pt>
                <c:pt idx="320">
                  <c:v>130.47999999999999</c:v>
                </c:pt>
                <c:pt idx="321">
                  <c:v>130.88999999999999</c:v>
                </c:pt>
                <c:pt idx="322">
                  <c:v>131.29</c:v>
                </c:pt>
                <c:pt idx="323">
                  <c:v>131.69999999999999</c:v>
                </c:pt>
                <c:pt idx="324">
                  <c:v>132.11000000000001</c:v>
                </c:pt>
                <c:pt idx="325">
                  <c:v>132.51</c:v>
                </c:pt>
                <c:pt idx="326">
                  <c:v>132.91</c:v>
                </c:pt>
                <c:pt idx="327">
                  <c:v>133.32</c:v>
                </c:pt>
                <c:pt idx="328">
                  <c:v>133.72999999999999</c:v>
                </c:pt>
                <c:pt idx="329">
                  <c:v>134.13999999999999</c:v>
                </c:pt>
                <c:pt idx="330">
                  <c:v>134.54</c:v>
                </c:pt>
                <c:pt idx="331">
                  <c:v>134.94</c:v>
                </c:pt>
                <c:pt idx="332">
                  <c:v>135.35</c:v>
                </c:pt>
                <c:pt idx="333">
                  <c:v>135.75</c:v>
                </c:pt>
                <c:pt idx="334">
                  <c:v>136.16</c:v>
                </c:pt>
                <c:pt idx="335">
                  <c:v>136.56</c:v>
                </c:pt>
                <c:pt idx="336">
                  <c:v>136.97</c:v>
                </c:pt>
                <c:pt idx="337">
                  <c:v>137.38</c:v>
                </c:pt>
                <c:pt idx="338">
                  <c:v>137.78</c:v>
                </c:pt>
                <c:pt idx="339">
                  <c:v>138.19</c:v>
                </c:pt>
                <c:pt idx="340">
                  <c:v>138.59</c:v>
                </c:pt>
                <c:pt idx="341">
                  <c:v>139</c:v>
                </c:pt>
                <c:pt idx="342">
                  <c:v>139.4</c:v>
                </c:pt>
                <c:pt idx="343">
                  <c:v>139.81</c:v>
                </c:pt>
                <c:pt idx="344">
                  <c:v>140.22</c:v>
                </c:pt>
                <c:pt idx="345">
                  <c:v>140.62</c:v>
                </c:pt>
                <c:pt idx="346">
                  <c:v>141.03</c:v>
                </c:pt>
                <c:pt idx="347">
                  <c:v>141.43</c:v>
                </c:pt>
                <c:pt idx="348">
                  <c:v>141.84</c:v>
                </c:pt>
                <c:pt idx="349">
                  <c:v>142.25</c:v>
                </c:pt>
                <c:pt idx="350">
                  <c:v>142.65</c:v>
                </c:pt>
                <c:pt idx="351">
                  <c:v>143.05000000000001</c:v>
                </c:pt>
                <c:pt idx="352">
                  <c:v>143.46</c:v>
                </c:pt>
                <c:pt idx="353">
                  <c:v>143.86000000000001</c:v>
                </c:pt>
                <c:pt idx="354">
                  <c:v>144.28</c:v>
                </c:pt>
                <c:pt idx="355">
                  <c:v>144.68</c:v>
                </c:pt>
                <c:pt idx="356">
                  <c:v>145.08000000000001</c:v>
                </c:pt>
                <c:pt idx="357">
                  <c:v>145.49</c:v>
                </c:pt>
                <c:pt idx="358">
                  <c:v>145.88999999999999</c:v>
                </c:pt>
                <c:pt idx="359">
                  <c:v>146.30000000000001</c:v>
                </c:pt>
                <c:pt idx="360">
                  <c:v>146.69999999999999</c:v>
                </c:pt>
                <c:pt idx="361">
                  <c:v>147.11000000000001</c:v>
                </c:pt>
                <c:pt idx="362">
                  <c:v>147.52000000000001</c:v>
                </c:pt>
                <c:pt idx="363">
                  <c:v>147.91999999999999</c:v>
                </c:pt>
                <c:pt idx="364">
                  <c:v>148.33000000000001</c:v>
                </c:pt>
                <c:pt idx="365">
                  <c:v>148.72999999999999</c:v>
                </c:pt>
                <c:pt idx="366">
                  <c:v>149.13999999999999</c:v>
                </c:pt>
                <c:pt idx="367">
                  <c:v>149.55000000000001</c:v>
                </c:pt>
                <c:pt idx="368">
                  <c:v>149.94999999999999</c:v>
                </c:pt>
                <c:pt idx="369">
                  <c:v>150.36000000000001</c:v>
                </c:pt>
                <c:pt idx="370">
                  <c:v>150.76</c:v>
                </c:pt>
                <c:pt idx="371">
                  <c:v>151.16999999999999</c:v>
                </c:pt>
                <c:pt idx="372">
                  <c:v>151.57</c:v>
                </c:pt>
                <c:pt idx="373">
                  <c:v>151.97999999999999</c:v>
                </c:pt>
                <c:pt idx="374">
                  <c:v>152.38999999999999</c:v>
                </c:pt>
                <c:pt idx="375">
                  <c:v>152.79</c:v>
                </c:pt>
                <c:pt idx="376">
                  <c:v>153.19</c:v>
                </c:pt>
                <c:pt idx="377">
                  <c:v>153.6</c:v>
                </c:pt>
                <c:pt idx="378">
                  <c:v>154.01</c:v>
                </c:pt>
                <c:pt idx="379">
                  <c:v>154.41999999999999</c:v>
                </c:pt>
                <c:pt idx="380">
                  <c:v>154.82</c:v>
                </c:pt>
                <c:pt idx="381">
                  <c:v>155.22</c:v>
                </c:pt>
                <c:pt idx="382">
                  <c:v>155.63</c:v>
                </c:pt>
                <c:pt idx="383">
                  <c:v>156.03</c:v>
                </c:pt>
                <c:pt idx="384">
                  <c:v>156.44</c:v>
                </c:pt>
                <c:pt idx="385">
                  <c:v>156.84</c:v>
                </c:pt>
                <c:pt idx="386">
                  <c:v>157.25</c:v>
                </c:pt>
                <c:pt idx="387">
                  <c:v>157.66</c:v>
                </c:pt>
                <c:pt idx="388">
                  <c:v>158.06</c:v>
                </c:pt>
                <c:pt idx="389">
                  <c:v>158.47</c:v>
                </c:pt>
                <c:pt idx="390">
                  <c:v>158.87</c:v>
                </c:pt>
                <c:pt idx="391">
                  <c:v>159.28</c:v>
                </c:pt>
                <c:pt idx="392">
                  <c:v>159.68</c:v>
                </c:pt>
                <c:pt idx="393">
                  <c:v>160.09</c:v>
                </c:pt>
                <c:pt idx="394">
                  <c:v>160.5</c:v>
                </c:pt>
                <c:pt idx="395">
                  <c:v>160.9</c:v>
                </c:pt>
                <c:pt idx="396">
                  <c:v>161.31</c:v>
                </c:pt>
                <c:pt idx="397">
                  <c:v>161.71</c:v>
                </c:pt>
                <c:pt idx="398">
                  <c:v>162.12</c:v>
                </c:pt>
                <c:pt idx="399">
                  <c:v>162.53</c:v>
                </c:pt>
                <c:pt idx="400">
                  <c:v>162.93</c:v>
                </c:pt>
                <c:pt idx="401">
                  <c:v>163.33000000000001</c:v>
                </c:pt>
                <c:pt idx="402">
                  <c:v>163.74</c:v>
                </c:pt>
                <c:pt idx="403">
                  <c:v>164.14</c:v>
                </c:pt>
                <c:pt idx="404">
                  <c:v>164.56</c:v>
                </c:pt>
                <c:pt idx="405">
                  <c:v>164.96</c:v>
                </c:pt>
                <c:pt idx="406">
                  <c:v>165.36</c:v>
                </c:pt>
                <c:pt idx="407">
                  <c:v>165.77</c:v>
                </c:pt>
                <c:pt idx="408">
                  <c:v>166.17</c:v>
                </c:pt>
                <c:pt idx="409">
                  <c:v>166.58</c:v>
                </c:pt>
                <c:pt idx="410">
                  <c:v>166.98</c:v>
                </c:pt>
                <c:pt idx="411">
                  <c:v>167.39</c:v>
                </c:pt>
                <c:pt idx="412">
                  <c:v>167.8</c:v>
                </c:pt>
                <c:pt idx="413">
                  <c:v>168.2</c:v>
                </c:pt>
                <c:pt idx="414">
                  <c:v>168.61</c:v>
                </c:pt>
                <c:pt idx="415">
                  <c:v>169.01</c:v>
                </c:pt>
                <c:pt idx="416">
                  <c:v>169.42</c:v>
                </c:pt>
                <c:pt idx="417">
                  <c:v>169.82</c:v>
                </c:pt>
                <c:pt idx="418">
                  <c:v>170.23</c:v>
                </c:pt>
                <c:pt idx="419">
                  <c:v>170.64</c:v>
                </c:pt>
                <c:pt idx="420">
                  <c:v>171.04</c:v>
                </c:pt>
                <c:pt idx="421">
                  <c:v>171.45</c:v>
                </c:pt>
                <c:pt idx="422">
                  <c:v>171.85</c:v>
                </c:pt>
                <c:pt idx="423">
                  <c:v>172.26</c:v>
                </c:pt>
                <c:pt idx="424">
                  <c:v>172.66</c:v>
                </c:pt>
                <c:pt idx="425">
                  <c:v>173.07</c:v>
                </c:pt>
                <c:pt idx="426">
                  <c:v>173.47</c:v>
                </c:pt>
                <c:pt idx="427">
                  <c:v>173.88</c:v>
                </c:pt>
                <c:pt idx="428">
                  <c:v>174.29</c:v>
                </c:pt>
                <c:pt idx="429">
                  <c:v>174.69</c:v>
                </c:pt>
                <c:pt idx="430">
                  <c:v>175.1</c:v>
                </c:pt>
                <c:pt idx="431">
                  <c:v>175.5</c:v>
                </c:pt>
                <c:pt idx="432">
                  <c:v>175.91</c:v>
                </c:pt>
                <c:pt idx="433">
                  <c:v>176.31</c:v>
                </c:pt>
                <c:pt idx="434">
                  <c:v>176.72</c:v>
                </c:pt>
                <c:pt idx="435">
                  <c:v>177.13</c:v>
                </c:pt>
                <c:pt idx="436">
                  <c:v>177.53</c:v>
                </c:pt>
                <c:pt idx="437">
                  <c:v>177.94</c:v>
                </c:pt>
                <c:pt idx="438">
                  <c:v>178.34</c:v>
                </c:pt>
                <c:pt idx="439">
                  <c:v>178.75</c:v>
                </c:pt>
                <c:pt idx="440">
                  <c:v>179.15</c:v>
                </c:pt>
                <c:pt idx="441">
                  <c:v>179.57</c:v>
                </c:pt>
                <c:pt idx="442">
                  <c:v>179.96</c:v>
                </c:pt>
                <c:pt idx="443">
                  <c:v>180.37</c:v>
                </c:pt>
                <c:pt idx="444">
                  <c:v>180.78</c:v>
                </c:pt>
                <c:pt idx="445">
                  <c:v>181.18</c:v>
                </c:pt>
                <c:pt idx="446">
                  <c:v>181.59</c:v>
                </c:pt>
                <c:pt idx="447">
                  <c:v>181.99</c:v>
                </c:pt>
                <c:pt idx="448">
                  <c:v>182.4</c:v>
                </c:pt>
                <c:pt idx="449">
                  <c:v>182.81</c:v>
                </c:pt>
                <c:pt idx="450">
                  <c:v>183.21</c:v>
                </c:pt>
                <c:pt idx="451">
                  <c:v>183.61</c:v>
                </c:pt>
                <c:pt idx="452">
                  <c:v>184.02</c:v>
                </c:pt>
                <c:pt idx="453">
                  <c:v>184.43</c:v>
                </c:pt>
                <c:pt idx="454">
                  <c:v>184.84</c:v>
                </c:pt>
                <c:pt idx="455">
                  <c:v>185.24</c:v>
                </c:pt>
                <c:pt idx="456">
                  <c:v>185.64</c:v>
                </c:pt>
                <c:pt idx="457">
                  <c:v>186.05</c:v>
                </c:pt>
                <c:pt idx="458">
                  <c:v>186.45</c:v>
                </c:pt>
                <c:pt idx="459">
                  <c:v>186.86</c:v>
                </c:pt>
                <c:pt idx="460">
                  <c:v>187.26</c:v>
                </c:pt>
                <c:pt idx="461">
                  <c:v>187.67</c:v>
                </c:pt>
                <c:pt idx="462">
                  <c:v>188.08</c:v>
                </c:pt>
                <c:pt idx="463">
                  <c:v>188.48</c:v>
                </c:pt>
                <c:pt idx="464">
                  <c:v>188.89</c:v>
                </c:pt>
                <c:pt idx="465">
                  <c:v>189.29</c:v>
                </c:pt>
                <c:pt idx="466">
                  <c:v>189.7</c:v>
                </c:pt>
                <c:pt idx="467">
                  <c:v>190.1</c:v>
                </c:pt>
                <c:pt idx="468">
                  <c:v>190.51</c:v>
                </c:pt>
                <c:pt idx="469">
                  <c:v>190.92</c:v>
                </c:pt>
                <c:pt idx="470">
                  <c:v>191.32</c:v>
                </c:pt>
                <c:pt idx="471">
                  <c:v>191.73</c:v>
                </c:pt>
                <c:pt idx="472">
                  <c:v>192.13</c:v>
                </c:pt>
                <c:pt idx="473">
                  <c:v>192.54</c:v>
                </c:pt>
                <c:pt idx="474">
                  <c:v>192.95</c:v>
                </c:pt>
                <c:pt idx="475">
                  <c:v>193.35</c:v>
                </c:pt>
                <c:pt idx="476">
                  <c:v>193.75</c:v>
                </c:pt>
                <c:pt idx="477">
                  <c:v>194.16</c:v>
                </c:pt>
                <c:pt idx="478">
                  <c:v>194.57</c:v>
                </c:pt>
                <c:pt idx="479">
                  <c:v>194.98</c:v>
                </c:pt>
                <c:pt idx="480">
                  <c:v>195.38</c:v>
                </c:pt>
                <c:pt idx="481">
                  <c:v>195.78</c:v>
                </c:pt>
                <c:pt idx="482">
                  <c:v>196.19</c:v>
                </c:pt>
                <c:pt idx="483">
                  <c:v>196.59</c:v>
                </c:pt>
                <c:pt idx="484">
                  <c:v>197</c:v>
                </c:pt>
                <c:pt idx="485">
                  <c:v>197.41</c:v>
                </c:pt>
                <c:pt idx="486">
                  <c:v>197.81</c:v>
                </c:pt>
                <c:pt idx="487">
                  <c:v>198.22</c:v>
                </c:pt>
                <c:pt idx="488">
                  <c:v>198.62</c:v>
                </c:pt>
                <c:pt idx="489">
                  <c:v>199.03</c:v>
                </c:pt>
                <c:pt idx="490">
                  <c:v>199.43</c:v>
                </c:pt>
                <c:pt idx="491">
                  <c:v>199.84</c:v>
                </c:pt>
                <c:pt idx="492">
                  <c:v>200.24</c:v>
                </c:pt>
                <c:pt idx="493">
                  <c:v>200.65</c:v>
                </c:pt>
                <c:pt idx="494">
                  <c:v>201.06</c:v>
                </c:pt>
                <c:pt idx="495">
                  <c:v>201.46</c:v>
                </c:pt>
                <c:pt idx="496">
                  <c:v>201.87</c:v>
                </c:pt>
                <c:pt idx="497">
                  <c:v>202.27</c:v>
                </c:pt>
                <c:pt idx="498">
                  <c:v>202.68</c:v>
                </c:pt>
                <c:pt idx="499">
                  <c:v>203.09</c:v>
                </c:pt>
                <c:pt idx="500">
                  <c:v>203.49</c:v>
                </c:pt>
                <c:pt idx="501">
                  <c:v>203.89</c:v>
                </c:pt>
                <c:pt idx="502">
                  <c:v>204.3</c:v>
                </c:pt>
                <c:pt idx="503">
                  <c:v>204.71</c:v>
                </c:pt>
                <c:pt idx="504">
                  <c:v>205.12</c:v>
                </c:pt>
                <c:pt idx="505">
                  <c:v>205.52</c:v>
                </c:pt>
                <c:pt idx="506">
                  <c:v>205.92</c:v>
                </c:pt>
                <c:pt idx="507">
                  <c:v>206.33</c:v>
                </c:pt>
                <c:pt idx="508">
                  <c:v>206.73</c:v>
                </c:pt>
                <c:pt idx="509">
                  <c:v>207.13</c:v>
                </c:pt>
                <c:pt idx="510">
                  <c:v>207.54</c:v>
                </c:pt>
                <c:pt idx="511">
                  <c:v>207.95</c:v>
                </c:pt>
                <c:pt idx="512">
                  <c:v>208.36</c:v>
                </c:pt>
                <c:pt idx="513">
                  <c:v>208.76</c:v>
                </c:pt>
                <c:pt idx="514">
                  <c:v>209.16</c:v>
                </c:pt>
                <c:pt idx="515">
                  <c:v>209.57</c:v>
                </c:pt>
                <c:pt idx="516">
                  <c:v>209.98</c:v>
                </c:pt>
                <c:pt idx="517">
                  <c:v>210.38</c:v>
                </c:pt>
                <c:pt idx="518">
                  <c:v>210.79</c:v>
                </c:pt>
                <c:pt idx="519">
                  <c:v>211.2</c:v>
                </c:pt>
                <c:pt idx="520">
                  <c:v>211.6</c:v>
                </c:pt>
                <c:pt idx="521">
                  <c:v>212.01</c:v>
                </c:pt>
                <c:pt idx="522">
                  <c:v>212.41</c:v>
                </c:pt>
                <c:pt idx="523">
                  <c:v>212.82</c:v>
                </c:pt>
                <c:pt idx="524">
                  <c:v>213.22</c:v>
                </c:pt>
                <c:pt idx="525">
                  <c:v>213.63</c:v>
                </c:pt>
                <c:pt idx="526">
                  <c:v>214.03</c:v>
                </c:pt>
                <c:pt idx="527">
                  <c:v>214.44</c:v>
                </c:pt>
                <c:pt idx="528">
                  <c:v>214.85</c:v>
                </c:pt>
                <c:pt idx="529">
                  <c:v>215.25</c:v>
                </c:pt>
                <c:pt idx="530">
                  <c:v>215.65</c:v>
                </c:pt>
                <c:pt idx="531">
                  <c:v>216.06</c:v>
                </c:pt>
                <c:pt idx="532">
                  <c:v>216.47</c:v>
                </c:pt>
                <c:pt idx="533">
                  <c:v>216.87</c:v>
                </c:pt>
                <c:pt idx="534">
                  <c:v>217.27</c:v>
                </c:pt>
                <c:pt idx="535">
                  <c:v>217.69</c:v>
                </c:pt>
                <c:pt idx="536">
                  <c:v>218.09</c:v>
                </c:pt>
                <c:pt idx="537">
                  <c:v>218.5</c:v>
                </c:pt>
                <c:pt idx="538">
                  <c:v>218.9</c:v>
                </c:pt>
                <c:pt idx="539">
                  <c:v>219.31</c:v>
                </c:pt>
                <c:pt idx="540">
                  <c:v>219.72</c:v>
                </c:pt>
                <c:pt idx="541">
                  <c:v>220.12</c:v>
                </c:pt>
                <c:pt idx="542">
                  <c:v>220.52</c:v>
                </c:pt>
                <c:pt idx="543">
                  <c:v>220.93</c:v>
                </c:pt>
                <c:pt idx="544">
                  <c:v>221.33</c:v>
                </c:pt>
                <c:pt idx="545">
                  <c:v>221.74</c:v>
                </c:pt>
                <c:pt idx="546">
                  <c:v>222.15</c:v>
                </c:pt>
                <c:pt idx="547">
                  <c:v>222.55</c:v>
                </c:pt>
                <c:pt idx="548">
                  <c:v>222.96</c:v>
                </c:pt>
                <c:pt idx="549">
                  <c:v>223.36</c:v>
                </c:pt>
                <c:pt idx="550">
                  <c:v>223.77</c:v>
                </c:pt>
                <c:pt idx="551">
                  <c:v>224.17</c:v>
                </c:pt>
                <c:pt idx="552">
                  <c:v>224.58</c:v>
                </c:pt>
                <c:pt idx="553">
                  <c:v>224.99</c:v>
                </c:pt>
                <c:pt idx="554">
                  <c:v>225.39</c:v>
                </c:pt>
                <c:pt idx="555">
                  <c:v>225.79</c:v>
                </c:pt>
                <c:pt idx="556">
                  <c:v>226.2</c:v>
                </c:pt>
                <c:pt idx="557">
                  <c:v>226.61</c:v>
                </c:pt>
                <c:pt idx="558">
                  <c:v>227.02</c:v>
                </c:pt>
                <c:pt idx="559">
                  <c:v>227.41</c:v>
                </c:pt>
                <c:pt idx="560">
                  <c:v>227.83</c:v>
                </c:pt>
                <c:pt idx="561">
                  <c:v>228.23</c:v>
                </c:pt>
                <c:pt idx="562">
                  <c:v>228.64</c:v>
                </c:pt>
                <c:pt idx="563">
                  <c:v>229.04</c:v>
                </c:pt>
                <c:pt idx="564">
                  <c:v>229.44</c:v>
                </c:pt>
                <c:pt idx="565">
                  <c:v>229.86</c:v>
                </c:pt>
                <c:pt idx="566">
                  <c:v>230.26</c:v>
                </c:pt>
                <c:pt idx="567">
                  <c:v>230.66</c:v>
                </c:pt>
                <c:pt idx="568">
                  <c:v>231.07</c:v>
                </c:pt>
                <c:pt idx="569">
                  <c:v>231.47</c:v>
                </c:pt>
                <c:pt idx="570">
                  <c:v>231.88</c:v>
                </c:pt>
                <c:pt idx="571">
                  <c:v>232.29</c:v>
                </c:pt>
                <c:pt idx="572">
                  <c:v>232.69</c:v>
                </c:pt>
                <c:pt idx="573">
                  <c:v>233.1</c:v>
                </c:pt>
                <c:pt idx="574">
                  <c:v>233.5</c:v>
                </c:pt>
                <c:pt idx="575">
                  <c:v>233.91</c:v>
                </c:pt>
                <c:pt idx="576">
                  <c:v>234.31</c:v>
                </c:pt>
                <c:pt idx="577">
                  <c:v>234.72</c:v>
                </c:pt>
                <c:pt idx="578">
                  <c:v>235.13</c:v>
                </c:pt>
                <c:pt idx="579">
                  <c:v>235.53</c:v>
                </c:pt>
                <c:pt idx="580">
                  <c:v>235.94</c:v>
                </c:pt>
                <c:pt idx="581">
                  <c:v>236.34</c:v>
                </c:pt>
                <c:pt idx="582">
                  <c:v>236.75</c:v>
                </c:pt>
                <c:pt idx="583">
                  <c:v>237.15</c:v>
                </c:pt>
                <c:pt idx="584">
                  <c:v>237.56</c:v>
                </c:pt>
                <c:pt idx="585">
                  <c:v>237.97</c:v>
                </c:pt>
                <c:pt idx="586">
                  <c:v>238.37</c:v>
                </c:pt>
                <c:pt idx="587">
                  <c:v>238.78</c:v>
                </c:pt>
                <c:pt idx="588">
                  <c:v>239.18</c:v>
                </c:pt>
                <c:pt idx="589">
                  <c:v>239.59</c:v>
                </c:pt>
                <c:pt idx="590">
                  <c:v>239.99</c:v>
                </c:pt>
                <c:pt idx="591">
                  <c:v>240.4</c:v>
                </c:pt>
                <c:pt idx="592">
                  <c:v>240.8</c:v>
                </c:pt>
                <c:pt idx="593">
                  <c:v>241.21</c:v>
                </c:pt>
                <c:pt idx="594">
                  <c:v>241.62</c:v>
                </c:pt>
                <c:pt idx="595">
                  <c:v>242.02</c:v>
                </c:pt>
                <c:pt idx="596">
                  <c:v>242.43</c:v>
                </c:pt>
                <c:pt idx="597">
                  <c:v>242.83</c:v>
                </c:pt>
                <c:pt idx="598">
                  <c:v>243.24</c:v>
                </c:pt>
                <c:pt idx="599">
                  <c:v>243.64</c:v>
                </c:pt>
                <c:pt idx="600">
                  <c:v>244.05</c:v>
                </c:pt>
                <c:pt idx="601">
                  <c:v>244.45</c:v>
                </c:pt>
                <c:pt idx="602">
                  <c:v>244.86</c:v>
                </c:pt>
                <c:pt idx="603">
                  <c:v>245.27</c:v>
                </c:pt>
                <c:pt idx="604">
                  <c:v>245.67</c:v>
                </c:pt>
                <c:pt idx="605">
                  <c:v>246.08</c:v>
                </c:pt>
                <c:pt idx="606">
                  <c:v>246.48</c:v>
                </c:pt>
                <c:pt idx="607">
                  <c:v>246.89</c:v>
                </c:pt>
                <c:pt idx="608">
                  <c:v>247.29</c:v>
                </c:pt>
                <c:pt idx="609">
                  <c:v>247.7</c:v>
                </c:pt>
                <c:pt idx="610">
                  <c:v>248.11</c:v>
                </c:pt>
                <c:pt idx="611">
                  <c:v>248.51</c:v>
                </c:pt>
                <c:pt idx="612">
                  <c:v>248.92</c:v>
                </c:pt>
                <c:pt idx="613">
                  <c:v>249.32</c:v>
                </c:pt>
                <c:pt idx="614">
                  <c:v>249.73</c:v>
                </c:pt>
                <c:pt idx="615">
                  <c:v>250.13</c:v>
                </c:pt>
                <c:pt idx="616">
                  <c:v>250.54</c:v>
                </c:pt>
                <c:pt idx="617">
                  <c:v>250.94</c:v>
                </c:pt>
                <c:pt idx="618">
                  <c:v>251.35</c:v>
                </c:pt>
                <c:pt idx="619">
                  <c:v>251.76</c:v>
                </c:pt>
                <c:pt idx="620">
                  <c:v>252.16</c:v>
                </c:pt>
                <c:pt idx="621">
                  <c:v>252.57</c:v>
                </c:pt>
                <c:pt idx="622">
                  <c:v>252.97</c:v>
                </c:pt>
                <c:pt idx="623">
                  <c:v>253.38</c:v>
                </c:pt>
                <c:pt idx="624">
                  <c:v>253.79</c:v>
                </c:pt>
                <c:pt idx="625">
                  <c:v>254.19</c:v>
                </c:pt>
                <c:pt idx="626">
                  <c:v>254.6</c:v>
                </c:pt>
                <c:pt idx="627">
                  <c:v>255</c:v>
                </c:pt>
                <c:pt idx="628">
                  <c:v>255.41</c:v>
                </c:pt>
                <c:pt idx="629">
                  <c:v>255.82</c:v>
                </c:pt>
                <c:pt idx="630">
                  <c:v>256.22000000000003</c:v>
                </c:pt>
                <c:pt idx="631">
                  <c:v>256.62</c:v>
                </c:pt>
                <c:pt idx="632">
                  <c:v>257.02999999999997</c:v>
                </c:pt>
                <c:pt idx="633">
                  <c:v>257.43</c:v>
                </c:pt>
                <c:pt idx="634">
                  <c:v>257.83</c:v>
                </c:pt>
                <c:pt idx="635">
                  <c:v>258.25</c:v>
                </c:pt>
                <c:pt idx="636">
                  <c:v>258.64999999999998</c:v>
                </c:pt>
                <c:pt idx="637">
                  <c:v>259.06</c:v>
                </c:pt>
                <c:pt idx="638">
                  <c:v>259.45999999999998</c:v>
                </c:pt>
                <c:pt idx="639">
                  <c:v>259.87</c:v>
                </c:pt>
                <c:pt idx="640">
                  <c:v>260.27</c:v>
                </c:pt>
                <c:pt idx="641">
                  <c:v>260.68</c:v>
                </c:pt>
                <c:pt idx="642">
                  <c:v>261.08</c:v>
                </c:pt>
                <c:pt idx="643">
                  <c:v>261.49</c:v>
                </c:pt>
                <c:pt idx="644">
                  <c:v>261.89999999999998</c:v>
                </c:pt>
                <c:pt idx="645">
                  <c:v>262.3</c:v>
                </c:pt>
                <c:pt idx="646">
                  <c:v>262.70999999999998</c:v>
                </c:pt>
                <c:pt idx="647">
                  <c:v>263.11</c:v>
                </c:pt>
                <c:pt idx="648">
                  <c:v>263.52</c:v>
                </c:pt>
                <c:pt idx="649">
                  <c:v>263.92</c:v>
                </c:pt>
                <c:pt idx="650">
                  <c:v>264.33</c:v>
                </c:pt>
                <c:pt idx="651">
                  <c:v>264.74</c:v>
                </c:pt>
                <c:pt idx="652">
                  <c:v>265.14</c:v>
                </c:pt>
                <c:pt idx="653">
                  <c:v>265.55</c:v>
                </c:pt>
                <c:pt idx="654">
                  <c:v>265.95999999999998</c:v>
                </c:pt>
                <c:pt idx="655">
                  <c:v>266.36</c:v>
                </c:pt>
                <c:pt idx="656">
                  <c:v>266.76</c:v>
                </c:pt>
                <c:pt idx="657">
                  <c:v>267.17</c:v>
                </c:pt>
                <c:pt idx="658">
                  <c:v>267.57</c:v>
                </c:pt>
                <c:pt idx="659">
                  <c:v>267.98</c:v>
                </c:pt>
                <c:pt idx="660">
                  <c:v>268.38</c:v>
                </c:pt>
                <c:pt idx="661">
                  <c:v>268.79000000000002</c:v>
                </c:pt>
                <c:pt idx="662">
                  <c:v>269.24</c:v>
                </c:pt>
                <c:pt idx="663">
                  <c:v>269.60000000000002</c:v>
                </c:pt>
                <c:pt idx="664">
                  <c:v>270.01</c:v>
                </c:pt>
                <c:pt idx="665">
                  <c:v>270.41000000000003</c:v>
                </c:pt>
                <c:pt idx="666">
                  <c:v>270.82</c:v>
                </c:pt>
                <c:pt idx="667">
                  <c:v>271.22000000000003</c:v>
                </c:pt>
                <c:pt idx="668">
                  <c:v>271.63</c:v>
                </c:pt>
                <c:pt idx="669">
                  <c:v>272.04000000000002</c:v>
                </c:pt>
                <c:pt idx="670">
                  <c:v>272.44</c:v>
                </c:pt>
                <c:pt idx="671">
                  <c:v>272.85000000000002</c:v>
                </c:pt>
                <c:pt idx="672">
                  <c:v>273.25</c:v>
                </c:pt>
                <c:pt idx="673">
                  <c:v>273.66000000000003</c:v>
                </c:pt>
                <c:pt idx="674">
                  <c:v>274.06</c:v>
                </c:pt>
                <c:pt idx="675">
                  <c:v>274.47000000000003</c:v>
                </c:pt>
                <c:pt idx="676">
                  <c:v>274.88</c:v>
                </c:pt>
                <c:pt idx="677">
                  <c:v>275.27999999999997</c:v>
                </c:pt>
                <c:pt idx="678">
                  <c:v>275.69</c:v>
                </c:pt>
                <c:pt idx="679">
                  <c:v>276.08999999999997</c:v>
                </c:pt>
                <c:pt idx="680">
                  <c:v>276.5</c:v>
                </c:pt>
                <c:pt idx="681">
                  <c:v>276.89999999999998</c:v>
                </c:pt>
                <c:pt idx="682">
                  <c:v>277.31</c:v>
                </c:pt>
                <c:pt idx="683">
                  <c:v>277.70999999999998</c:v>
                </c:pt>
                <c:pt idx="684">
                  <c:v>278.12</c:v>
                </c:pt>
                <c:pt idx="685">
                  <c:v>278.52999999999997</c:v>
                </c:pt>
                <c:pt idx="686">
                  <c:v>278.93</c:v>
                </c:pt>
                <c:pt idx="687">
                  <c:v>279.33999999999997</c:v>
                </c:pt>
                <c:pt idx="688">
                  <c:v>279.74</c:v>
                </c:pt>
                <c:pt idx="689">
                  <c:v>280.14999999999998</c:v>
                </c:pt>
                <c:pt idx="690">
                  <c:v>280.55</c:v>
                </c:pt>
                <c:pt idx="691">
                  <c:v>280.95999999999998</c:v>
                </c:pt>
                <c:pt idx="692">
                  <c:v>281.36</c:v>
                </c:pt>
                <c:pt idx="693">
                  <c:v>281.77</c:v>
                </c:pt>
                <c:pt idx="694">
                  <c:v>282.18</c:v>
                </c:pt>
                <c:pt idx="695">
                  <c:v>282.58</c:v>
                </c:pt>
                <c:pt idx="696">
                  <c:v>282.98</c:v>
                </c:pt>
                <c:pt idx="697">
                  <c:v>283.39</c:v>
                </c:pt>
                <c:pt idx="698">
                  <c:v>283.8</c:v>
                </c:pt>
                <c:pt idx="699">
                  <c:v>284.20999999999998</c:v>
                </c:pt>
                <c:pt idx="700">
                  <c:v>284.61</c:v>
                </c:pt>
                <c:pt idx="701">
                  <c:v>285.02</c:v>
                </c:pt>
                <c:pt idx="702">
                  <c:v>285.42</c:v>
                </c:pt>
                <c:pt idx="703">
                  <c:v>285.83</c:v>
                </c:pt>
                <c:pt idx="704">
                  <c:v>286.23</c:v>
                </c:pt>
                <c:pt idx="705">
                  <c:v>286.64</c:v>
                </c:pt>
                <c:pt idx="706">
                  <c:v>287.04000000000002</c:v>
                </c:pt>
                <c:pt idx="707">
                  <c:v>287.45</c:v>
                </c:pt>
                <c:pt idx="708">
                  <c:v>287.85000000000002</c:v>
                </c:pt>
                <c:pt idx="709">
                  <c:v>288.26</c:v>
                </c:pt>
                <c:pt idx="710">
                  <c:v>288.67</c:v>
                </c:pt>
                <c:pt idx="711">
                  <c:v>289.07</c:v>
                </c:pt>
                <c:pt idx="712">
                  <c:v>289.48</c:v>
                </c:pt>
                <c:pt idx="713">
                  <c:v>289.88</c:v>
                </c:pt>
                <c:pt idx="714">
                  <c:v>290.29000000000002</c:v>
                </c:pt>
                <c:pt idx="715">
                  <c:v>290.69</c:v>
                </c:pt>
                <c:pt idx="716">
                  <c:v>291.10000000000002</c:v>
                </c:pt>
                <c:pt idx="717">
                  <c:v>291.51</c:v>
                </c:pt>
                <c:pt idx="718">
                  <c:v>291.91000000000003</c:v>
                </c:pt>
                <c:pt idx="719">
                  <c:v>292.32</c:v>
                </c:pt>
                <c:pt idx="720">
                  <c:v>292.72000000000003</c:v>
                </c:pt>
                <c:pt idx="721">
                  <c:v>293.13</c:v>
                </c:pt>
                <c:pt idx="722">
                  <c:v>293.52999999999997</c:v>
                </c:pt>
                <c:pt idx="723">
                  <c:v>293.94</c:v>
                </c:pt>
                <c:pt idx="724">
                  <c:v>294.35000000000002</c:v>
                </c:pt>
                <c:pt idx="725">
                  <c:v>294.75</c:v>
                </c:pt>
                <c:pt idx="726">
                  <c:v>295.14999999999998</c:v>
                </c:pt>
                <c:pt idx="727">
                  <c:v>295.56</c:v>
                </c:pt>
                <c:pt idx="728">
                  <c:v>295.97000000000003</c:v>
                </c:pt>
                <c:pt idx="729">
                  <c:v>296.37</c:v>
                </c:pt>
                <c:pt idx="730">
                  <c:v>296.77999999999997</c:v>
                </c:pt>
                <c:pt idx="731">
                  <c:v>297.18</c:v>
                </c:pt>
                <c:pt idx="732">
                  <c:v>297.58999999999997</c:v>
                </c:pt>
                <c:pt idx="733">
                  <c:v>297.99</c:v>
                </c:pt>
                <c:pt idx="734">
                  <c:v>298.39999999999998</c:v>
                </c:pt>
                <c:pt idx="735">
                  <c:v>298.81</c:v>
                </c:pt>
                <c:pt idx="736">
                  <c:v>299.20999999999998</c:v>
                </c:pt>
                <c:pt idx="737">
                  <c:v>299.62</c:v>
                </c:pt>
                <c:pt idx="738">
                  <c:v>300.02</c:v>
                </c:pt>
                <c:pt idx="739">
                  <c:v>300.43</c:v>
                </c:pt>
                <c:pt idx="740">
                  <c:v>300.83</c:v>
                </c:pt>
                <c:pt idx="741">
                  <c:v>301.24</c:v>
                </c:pt>
                <c:pt idx="742">
                  <c:v>301.64999999999998</c:v>
                </c:pt>
                <c:pt idx="743">
                  <c:v>302.05</c:v>
                </c:pt>
                <c:pt idx="744">
                  <c:v>302.45999999999998</c:v>
                </c:pt>
                <c:pt idx="745">
                  <c:v>302.86</c:v>
                </c:pt>
                <c:pt idx="746">
                  <c:v>303.27</c:v>
                </c:pt>
                <c:pt idx="747">
                  <c:v>303.67</c:v>
                </c:pt>
                <c:pt idx="748">
                  <c:v>304.08</c:v>
                </c:pt>
                <c:pt idx="749">
                  <c:v>304.48</c:v>
                </c:pt>
                <c:pt idx="750">
                  <c:v>304.89</c:v>
                </c:pt>
                <c:pt idx="751">
                  <c:v>305.3</c:v>
                </c:pt>
                <c:pt idx="752">
                  <c:v>305.7</c:v>
                </c:pt>
                <c:pt idx="753">
                  <c:v>306.11</c:v>
                </c:pt>
                <c:pt idx="754">
                  <c:v>306.51</c:v>
                </c:pt>
                <c:pt idx="755">
                  <c:v>306.92</c:v>
                </c:pt>
                <c:pt idx="756">
                  <c:v>307.32</c:v>
                </c:pt>
                <c:pt idx="757">
                  <c:v>307.73</c:v>
                </c:pt>
                <c:pt idx="758">
                  <c:v>308.13</c:v>
                </c:pt>
                <c:pt idx="759">
                  <c:v>308.54000000000002</c:v>
                </c:pt>
                <c:pt idx="760">
                  <c:v>308.95</c:v>
                </c:pt>
                <c:pt idx="761">
                  <c:v>309.35000000000002</c:v>
                </c:pt>
                <c:pt idx="762">
                  <c:v>309.76</c:v>
                </c:pt>
                <c:pt idx="763">
                  <c:v>310.17</c:v>
                </c:pt>
                <c:pt idx="764">
                  <c:v>310.57</c:v>
                </c:pt>
                <c:pt idx="765">
                  <c:v>310.97000000000003</c:v>
                </c:pt>
                <c:pt idx="766">
                  <c:v>311.38</c:v>
                </c:pt>
                <c:pt idx="767">
                  <c:v>311.79000000000002</c:v>
                </c:pt>
                <c:pt idx="768">
                  <c:v>312.19</c:v>
                </c:pt>
                <c:pt idx="769">
                  <c:v>312.60000000000002</c:v>
                </c:pt>
                <c:pt idx="770">
                  <c:v>313</c:v>
                </c:pt>
                <c:pt idx="771">
                  <c:v>313.41000000000003</c:v>
                </c:pt>
                <c:pt idx="772">
                  <c:v>313.81</c:v>
                </c:pt>
                <c:pt idx="773">
                  <c:v>314.22000000000003</c:v>
                </c:pt>
                <c:pt idx="774">
                  <c:v>314.62</c:v>
                </c:pt>
                <c:pt idx="775">
                  <c:v>315.02999999999997</c:v>
                </c:pt>
                <c:pt idx="776">
                  <c:v>315.44</c:v>
                </c:pt>
                <c:pt idx="777">
                  <c:v>315.83999999999997</c:v>
                </c:pt>
                <c:pt idx="778">
                  <c:v>316.25</c:v>
                </c:pt>
                <c:pt idx="779">
                  <c:v>316.64999999999998</c:v>
                </c:pt>
                <c:pt idx="780">
                  <c:v>317.06</c:v>
                </c:pt>
                <c:pt idx="781">
                  <c:v>317.45999999999998</c:v>
                </c:pt>
                <c:pt idx="782">
                  <c:v>317.87</c:v>
                </c:pt>
                <c:pt idx="783">
                  <c:v>318.27</c:v>
                </c:pt>
                <c:pt idx="784">
                  <c:v>318.68</c:v>
                </c:pt>
                <c:pt idx="785">
                  <c:v>319.08999999999997</c:v>
                </c:pt>
                <c:pt idx="786">
                  <c:v>319.49</c:v>
                </c:pt>
                <c:pt idx="787">
                  <c:v>319.89999999999998</c:v>
                </c:pt>
                <c:pt idx="788">
                  <c:v>320.3</c:v>
                </c:pt>
                <c:pt idx="789">
                  <c:v>320.70999999999998</c:v>
                </c:pt>
                <c:pt idx="790">
                  <c:v>321.11</c:v>
                </c:pt>
                <c:pt idx="791">
                  <c:v>321.52</c:v>
                </c:pt>
                <c:pt idx="792">
                  <c:v>321.93</c:v>
                </c:pt>
                <c:pt idx="793">
                  <c:v>322.33</c:v>
                </c:pt>
                <c:pt idx="794">
                  <c:v>322.73</c:v>
                </c:pt>
                <c:pt idx="795">
                  <c:v>323.14</c:v>
                </c:pt>
                <c:pt idx="796">
                  <c:v>323.55</c:v>
                </c:pt>
                <c:pt idx="797">
                  <c:v>323.95</c:v>
                </c:pt>
                <c:pt idx="798">
                  <c:v>324.36</c:v>
                </c:pt>
                <c:pt idx="799">
                  <c:v>324.76</c:v>
                </c:pt>
                <c:pt idx="800">
                  <c:v>325.17</c:v>
                </c:pt>
                <c:pt idx="801">
                  <c:v>325.57</c:v>
                </c:pt>
                <c:pt idx="802">
                  <c:v>325.98</c:v>
                </c:pt>
                <c:pt idx="803">
                  <c:v>326.38</c:v>
                </c:pt>
                <c:pt idx="804">
                  <c:v>326.8</c:v>
                </c:pt>
                <c:pt idx="805">
                  <c:v>327.2</c:v>
                </c:pt>
                <c:pt idx="806">
                  <c:v>327.60000000000002</c:v>
                </c:pt>
                <c:pt idx="807">
                  <c:v>328.01</c:v>
                </c:pt>
                <c:pt idx="808">
                  <c:v>328.42</c:v>
                </c:pt>
                <c:pt idx="809">
                  <c:v>328.82</c:v>
                </c:pt>
                <c:pt idx="810">
                  <c:v>329.23</c:v>
                </c:pt>
                <c:pt idx="811">
                  <c:v>329.63</c:v>
                </c:pt>
                <c:pt idx="812">
                  <c:v>330.04</c:v>
                </c:pt>
                <c:pt idx="813">
                  <c:v>330.44</c:v>
                </c:pt>
                <c:pt idx="814">
                  <c:v>330.85</c:v>
                </c:pt>
                <c:pt idx="815">
                  <c:v>331.26</c:v>
                </c:pt>
                <c:pt idx="816">
                  <c:v>331.66</c:v>
                </c:pt>
                <c:pt idx="817">
                  <c:v>332.07</c:v>
                </c:pt>
                <c:pt idx="818">
                  <c:v>332.47</c:v>
                </c:pt>
                <c:pt idx="819">
                  <c:v>332.88</c:v>
                </c:pt>
                <c:pt idx="820">
                  <c:v>333.28</c:v>
                </c:pt>
                <c:pt idx="821">
                  <c:v>333.69</c:v>
                </c:pt>
                <c:pt idx="822">
                  <c:v>334.09</c:v>
                </c:pt>
                <c:pt idx="823">
                  <c:v>334.5</c:v>
                </c:pt>
                <c:pt idx="824">
                  <c:v>334.91</c:v>
                </c:pt>
                <c:pt idx="825">
                  <c:v>335.31</c:v>
                </c:pt>
                <c:pt idx="826">
                  <c:v>335.72</c:v>
                </c:pt>
                <c:pt idx="827">
                  <c:v>336.12</c:v>
                </c:pt>
                <c:pt idx="828">
                  <c:v>336.53</c:v>
                </c:pt>
                <c:pt idx="829">
                  <c:v>336.94</c:v>
                </c:pt>
                <c:pt idx="830">
                  <c:v>337.34</c:v>
                </c:pt>
                <c:pt idx="831">
                  <c:v>337.74</c:v>
                </c:pt>
                <c:pt idx="832">
                  <c:v>338.15</c:v>
                </c:pt>
                <c:pt idx="833">
                  <c:v>338.55</c:v>
                </c:pt>
                <c:pt idx="834">
                  <c:v>338.96</c:v>
                </c:pt>
                <c:pt idx="835">
                  <c:v>339.37</c:v>
                </c:pt>
                <c:pt idx="836">
                  <c:v>339.77</c:v>
                </c:pt>
                <c:pt idx="837">
                  <c:v>340.18</c:v>
                </c:pt>
                <c:pt idx="838">
                  <c:v>340.58</c:v>
                </c:pt>
                <c:pt idx="839">
                  <c:v>340.99</c:v>
                </c:pt>
                <c:pt idx="840">
                  <c:v>341.4</c:v>
                </c:pt>
                <c:pt idx="841">
                  <c:v>341.8</c:v>
                </c:pt>
                <c:pt idx="842">
                  <c:v>342.21</c:v>
                </c:pt>
                <c:pt idx="843">
                  <c:v>342.61</c:v>
                </c:pt>
                <c:pt idx="844">
                  <c:v>343.02</c:v>
                </c:pt>
                <c:pt idx="845">
                  <c:v>343.42</c:v>
                </c:pt>
                <c:pt idx="846">
                  <c:v>343.83</c:v>
                </c:pt>
                <c:pt idx="847">
                  <c:v>344.23</c:v>
                </c:pt>
                <c:pt idx="848">
                  <c:v>344.64</c:v>
                </c:pt>
                <c:pt idx="849">
                  <c:v>345.05</c:v>
                </c:pt>
                <c:pt idx="850">
                  <c:v>345.45</c:v>
                </c:pt>
                <c:pt idx="851">
                  <c:v>345.86</c:v>
                </c:pt>
                <c:pt idx="852">
                  <c:v>346.26</c:v>
                </c:pt>
                <c:pt idx="853">
                  <c:v>346.67</c:v>
                </c:pt>
                <c:pt idx="854">
                  <c:v>347.08</c:v>
                </c:pt>
                <c:pt idx="855">
                  <c:v>347.48</c:v>
                </c:pt>
                <c:pt idx="856">
                  <c:v>347.88</c:v>
                </c:pt>
                <c:pt idx="857">
                  <c:v>348.29</c:v>
                </c:pt>
                <c:pt idx="858">
                  <c:v>348.69</c:v>
                </c:pt>
                <c:pt idx="859">
                  <c:v>349.11</c:v>
                </c:pt>
                <c:pt idx="860">
                  <c:v>349.51</c:v>
                </c:pt>
                <c:pt idx="861">
                  <c:v>349.91</c:v>
                </c:pt>
                <c:pt idx="862">
                  <c:v>350.32</c:v>
                </c:pt>
                <c:pt idx="863">
                  <c:v>350.72</c:v>
                </c:pt>
                <c:pt idx="864">
                  <c:v>351.13</c:v>
                </c:pt>
                <c:pt idx="865">
                  <c:v>351.54</c:v>
                </c:pt>
                <c:pt idx="866">
                  <c:v>351.94</c:v>
                </c:pt>
                <c:pt idx="867">
                  <c:v>352.35</c:v>
                </c:pt>
                <c:pt idx="868">
                  <c:v>352.75</c:v>
                </c:pt>
                <c:pt idx="869">
                  <c:v>353.16</c:v>
                </c:pt>
                <c:pt idx="870">
                  <c:v>353.56</c:v>
                </c:pt>
                <c:pt idx="871">
                  <c:v>353.97</c:v>
                </c:pt>
                <c:pt idx="872">
                  <c:v>354.37</c:v>
                </c:pt>
                <c:pt idx="873">
                  <c:v>354.78</c:v>
                </c:pt>
                <c:pt idx="874">
                  <c:v>355.19</c:v>
                </c:pt>
                <c:pt idx="875">
                  <c:v>355.59</c:v>
                </c:pt>
                <c:pt idx="876">
                  <c:v>356</c:v>
                </c:pt>
                <c:pt idx="877">
                  <c:v>356.4</c:v>
                </c:pt>
                <c:pt idx="878">
                  <c:v>356.81</c:v>
                </c:pt>
                <c:pt idx="879">
                  <c:v>357.22</c:v>
                </c:pt>
                <c:pt idx="880">
                  <c:v>357.62</c:v>
                </c:pt>
                <c:pt idx="881">
                  <c:v>358.02</c:v>
                </c:pt>
                <c:pt idx="882">
                  <c:v>358.43</c:v>
                </c:pt>
                <c:pt idx="883">
                  <c:v>358.83</c:v>
                </c:pt>
                <c:pt idx="884">
                  <c:v>359.24</c:v>
                </c:pt>
                <c:pt idx="885">
                  <c:v>359.65</c:v>
                </c:pt>
                <c:pt idx="886">
                  <c:v>360.05</c:v>
                </c:pt>
                <c:pt idx="887">
                  <c:v>360.46</c:v>
                </c:pt>
                <c:pt idx="888">
                  <c:v>360.86</c:v>
                </c:pt>
                <c:pt idx="889">
                  <c:v>361.26</c:v>
                </c:pt>
                <c:pt idx="890">
                  <c:v>361.67</c:v>
                </c:pt>
                <c:pt idx="891">
                  <c:v>362.08</c:v>
                </c:pt>
                <c:pt idx="892">
                  <c:v>362.49</c:v>
                </c:pt>
                <c:pt idx="893">
                  <c:v>362.89</c:v>
                </c:pt>
                <c:pt idx="894">
                  <c:v>363.29</c:v>
                </c:pt>
                <c:pt idx="895">
                  <c:v>363.7</c:v>
                </c:pt>
                <c:pt idx="896">
                  <c:v>364.11</c:v>
                </c:pt>
                <c:pt idx="897">
                  <c:v>364.51</c:v>
                </c:pt>
                <c:pt idx="898">
                  <c:v>364.92</c:v>
                </c:pt>
                <c:pt idx="899">
                  <c:v>365.32</c:v>
                </c:pt>
                <c:pt idx="900">
                  <c:v>365.73</c:v>
                </c:pt>
                <c:pt idx="901">
                  <c:v>366.13</c:v>
                </c:pt>
                <c:pt idx="902">
                  <c:v>366.54</c:v>
                </c:pt>
                <c:pt idx="903">
                  <c:v>366.95</c:v>
                </c:pt>
                <c:pt idx="904">
                  <c:v>367.35</c:v>
                </c:pt>
                <c:pt idx="905">
                  <c:v>367.76</c:v>
                </c:pt>
                <c:pt idx="906">
                  <c:v>368.16</c:v>
                </c:pt>
                <c:pt idx="907">
                  <c:v>368.57</c:v>
                </c:pt>
                <c:pt idx="908">
                  <c:v>368.98</c:v>
                </c:pt>
                <c:pt idx="909">
                  <c:v>369.38</c:v>
                </c:pt>
                <c:pt idx="910">
                  <c:v>369.79</c:v>
                </c:pt>
                <c:pt idx="911">
                  <c:v>370.19</c:v>
                </c:pt>
                <c:pt idx="912">
                  <c:v>370.6</c:v>
                </c:pt>
                <c:pt idx="913">
                  <c:v>371</c:v>
                </c:pt>
                <c:pt idx="914">
                  <c:v>371.4</c:v>
                </c:pt>
                <c:pt idx="915">
                  <c:v>371.81</c:v>
                </c:pt>
                <c:pt idx="916">
                  <c:v>372.22</c:v>
                </c:pt>
                <c:pt idx="917">
                  <c:v>372.62</c:v>
                </c:pt>
                <c:pt idx="918">
                  <c:v>373.03</c:v>
                </c:pt>
                <c:pt idx="919">
                  <c:v>373.44</c:v>
                </c:pt>
                <c:pt idx="920">
                  <c:v>373.84</c:v>
                </c:pt>
                <c:pt idx="921">
                  <c:v>374.25</c:v>
                </c:pt>
                <c:pt idx="922">
                  <c:v>374.65</c:v>
                </c:pt>
                <c:pt idx="923">
                  <c:v>375.06</c:v>
                </c:pt>
                <c:pt idx="924">
                  <c:v>375.46</c:v>
                </c:pt>
                <c:pt idx="925">
                  <c:v>375.87</c:v>
                </c:pt>
                <c:pt idx="926">
                  <c:v>376.28</c:v>
                </c:pt>
                <c:pt idx="927">
                  <c:v>376.68</c:v>
                </c:pt>
                <c:pt idx="928">
                  <c:v>377.09</c:v>
                </c:pt>
                <c:pt idx="929">
                  <c:v>377.49</c:v>
                </c:pt>
                <c:pt idx="930">
                  <c:v>377.9</c:v>
                </c:pt>
                <c:pt idx="931">
                  <c:v>378.3</c:v>
                </c:pt>
                <c:pt idx="932">
                  <c:v>378.71</c:v>
                </c:pt>
                <c:pt idx="933">
                  <c:v>379.12</c:v>
                </c:pt>
                <c:pt idx="934">
                  <c:v>379.52</c:v>
                </c:pt>
                <c:pt idx="935">
                  <c:v>379.93</c:v>
                </c:pt>
                <c:pt idx="936">
                  <c:v>380.33</c:v>
                </c:pt>
                <c:pt idx="937">
                  <c:v>380.74</c:v>
                </c:pt>
                <c:pt idx="938">
                  <c:v>381.14</c:v>
                </c:pt>
                <c:pt idx="939">
                  <c:v>381.54</c:v>
                </c:pt>
                <c:pt idx="940">
                  <c:v>381.95</c:v>
                </c:pt>
                <c:pt idx="941">
                  <c:v>382.36</c:v>
                </c:pt>
                <c:pt idx="942">
                  <c:v>382.76</c:v>
                </c:pt>
                <c:pt idx="943">
                  <c:v>383.17</c:v>
                </c:pt>
                <c:pt idx="944">
                  <c:v>383.57</c:v>
                </c:pt>
                <c:pt idx="945">
                  <c:v>383.98</c:v>
                </c:pt>
                <c:pt idx="946">
                  <c:v>384.39</c:v>
                </c:pt>
                <c:pt idx="947">
                  <c:v>384.79</c:v>
                </c:pt>
                <c:pt idx="948">
                  <c:v>385.2</c:v>
                </c:pt>
                <c:pt idx="949">
                  <c:v>385.61</c:v>
                </c:pt>
                <c:pt idx="950">
                  <c:v>386.01</c:v>
                </c:pt>
                <c:pt idx="951">
                  <c:v>386.41</c:v>
                </c:pt>
                <c:pt idx="952">
                  <c:v>386.82</c:v>
                </c:pt>
                <c:pt idx="953">
                  <c:v>387.23</c:v>
                </c:pt>
                <c:pt idx="954">
                  <c:v>387.63</c:v>
                </c:pt>
                <c:pt idx="955">
                  <c:v>388.04</c:v>
                </c:pt>
                <c:pt idx="956">
                  <c:v>388.44</c:v>
                </c:pt>
                <c:pt idx="957">
                  <c:v>388.85</c:v>
                </c:pt>
                <c:pt idx="958">
                  <c:v>389.26</c:v>
                </c:pt>
                <c:pt idx="959">
                  <c:v>389.66</c:v>
                </c:pt>
                <c:pt idx="960">
                  <c:v>390.07</c:v>
                </c:pt>
                <c:pt idx="961">
                  <c:v>390.47</c:v>
                </c:pt>
                <c:pt idx="962">
                  <c:v>390.88</c:v>
                </c:pt>
                <c:pt idx="963">
                  <c:v>391.28</c:v>
                </c:pt>
                <c:pt idx="964">
                  <c:v>391.69</c:v>
                </c:pt>
                <c:pt idx="965">
                  <c:v>392.09</c:v>
                </c:pt>
                <c:pt idx="966">
                  <c:v>392.5</c:v>
                </c:pt>
                <c:pt idx="967">
                  <c:v>392.91</c:v>
                </c:pt>
                <c:pt idx="968">
                  <c:v>393.31</c:v>
                </c:pt>
                <c:pt idx="969">
                  <c:v>393.72</c:v>
                </c:pt>
                <c:pt idx="970">
                  <c:v>394.12</c:v>
                </c:pt>
                <c:pt idx="971">
                  <c:v>394.53</c:v>
                </c:pt>
                <c:pt idx="972">
                  <c:v>394.93</c:v>
                </c:pt>
                <c:pt idx="973">
                  <c:v>395.34</c:v>
                </c:pt>
                <c:pt idx="974">
                  <c:v>395.74</c:v>
                </c:pt>
                <c:pt idx="975">
                  <c:v>396.15</c:v>
                </c:pt>
                <c:pt idx="976">
                  <c:v>396.56</c:v>
                </c:pt>
                <c:pt idx="977">
                  <c:v>396.96</c:v>
                </c:pt>
                <c:pt idx="978">
                  <c:v>397.37</c:v>
                </c:pt>
                <c:pt idx="979">
                  <c:v>397.77</c:v>
                </c:pt>
                <c:pt idx="980">
                  <c:v>398.18</c:v>
                </c:pt>
                <c:pt idx="981">
                  <c:v>398.58</c:v>
                </c:pt>
                <c:pt idx="982">
                  <c:v>398.99</c:v>
                </c:pt>
                <c:pt idx="983">
                  <c:v>399.4</c:v>
                </c:pt>
                <c:pt idx="984">
                  <c:v>399.8</c:v>
                </c:pt>
                <c:pt idx="985">
                  <c:v>400.21</c:v>
                </c:pt>
                <c:pt idx="986">
                  <c:v>400.62</c:v>
                </c:pt>
                <c:pt idx="987">
                  <c:v>401.02</c:v>
                </c:pt>
                <c:pt idx="988">
                  <c:v>401.42</c:v>
                </c:pt>
                <c:pt idx="989">
                  <c:v>401.82</c:v>
                </c:pt>
                <c:pt idx="990">
                  <c:v>402.23</c:v>
                </c:pt>
                <c:pt idx="991">
                  <c:v>402.64</c:v>
                </c:pt>
                <c:pt idx="992">
                  <c:v>403.05</c:v>
                </c:pt>
                <c:pt idx="993">
                  <c:v>403.45</c:v>
                </c:pt>
                <c:pt idx="994">
                  <c:v>403.91</c:v>
                </c:pt>
                <c:pt idx="995">
                  <c:v>404.28</c:v>
                </c:pt>
                <c:pt idx="996">
                  <c:v>404.67</c:v>
                </c:pt>
                <c:pt idx="997">
                  <c:v>405.07</c:v>
                </c:pt>
                <c:pt idx="998">
                  <c:v>405.48</c:v>
                </c:pt>
                <c:pt idx="999">
                  <c:v>405.88</c:v>
                </c:pt>
                <c:pt idx="1000">
                  <c:v>406.29</c:v>
                </c:pt>
                <c:pt idx="1001">
                  <c:v>406.7</c:v>
                </c:pt>
                <c:pt idx="1002">
                  <c:v>407.1</c:v>
                </c:pt>
                <c:pt idx="1003">
                  <c:v>407.51</c:v>
                </c:pt>
                <c:pt idx="1004">
                  <c:v>407.92</c:v>
                </c:pt>
                <c:pt idx="1005">
                  <c:v>408.32</c:v>
                </c:pt>
                <c:pt idx="1006">
                  <c:v>408.72</c:v>
                </c:pt>
                <c:pt idx="1007">
                  <c:v>409.13</c:v>
                </c:pt>
                <c:pt idx="1008">
                  <c:v>409.54</c:v>
                </c:pt>
                <c:pt idx="1009">
                  <c:v>409.94</c:v>
                </c:pt>
                <c:pt idx="1010">
                  <c:v>410.35</c:v>
                </c:pt>
                <c:pt idx="1011">
                  <c:v>410.75</c:v>
                </c:pt>
                <c:pt idx="1012">
                  <c:v>411.16</c:v>
                </c:pt>
                <c:pt idx="1013">
                  <c:v>411.56</c:v>
                </c:pt>
                <c:pt idx="1014">
                  <c:v>411.96</c:v>
                </c:pt>
                <c:pt idx="1015">
                  <c:v>412.37</c:v>
                </c:pt>
                <c:pt idx="1016">
                  <c:v>412.78</c:v>
                </c:pt>
                <c:pt idx="1017">
                  <c:v>413.19</c:v>
                </c:pt>
                <c:pt idx="1018">
                  <c:v>413.59</c:v>
                </c:pt>
                <c:pt idx="1019">
                  <c:v>413.99</c:v>
                </c:pt>
                <c:pt idx="1020">
                  <c:v>414.4</c:v>
                </c:pt>
                <c:pt idx="1021">
                  <c:v>414.81</c:v>
                </c:pt>
                <c:pt idx="1022">
                  <c:v>415.21</c:v>
                </c:pt>
                <c:pt idx="1023">
                  <c:v>415.62</c:v>
                </c:pt>
                <c:pt idx="1024">
                  <c:v>416.03</c:v>
                </c:pt>
                <c:pt idx="1025">
                  <c:v>416.43</c:v>
                </c:pt>
                <c:pt idx="1026">
                  <c:v>416.84</c:v>
                </c:pt>
                <c:pt idx="1027">
                  <c:v>417.24</c:v>
                </c:pt>
                <c:pt idx="1028">
                  <c:v>417.65</c:v>
                </c:pt>
                <c:pt idx="1029">
                  <c:v>418.06</c:v>
                </c:pt>
                <c:pt idx="1030">
                  <c:v>418.46</c:v>
                </c:pt>
                <c:pt idx="1031">
                  <c:v>418.86</c:v>
                </c:pt>
                <c:pt idx="1032">
                  <c:v>419.27</c:v>
                </c:pt>
                <c:pt idx="1033">
                  <c:v>419.67</c:v>
                </c:pt>
                <c:pt idx="1034">
                  <c:v>420.08</c:v>
                </c:pt>
                <c:pt idx="1035">
                  <c:v>420.49</c:v>
                </c:pt>
                <c:pt idx="1036">
                  <c:v>420.89</c:v>
                </c:pt>
                <c:pt idx="1037">
                  <c:v>421.3</c:v>
                </c:pt>
                <c:pt idx="1038">
                  <c:v>421.7</c:v>
                </c:pt>
                <c:pt idx="1039">
                  <c:v>422.11</c:v>
                </c:pt>
                <c:pt idx="1040">
                  <c:v>422.51</c:v>
                </c:pt>
                <c:pt idx="1041">
                  <c:v>422.92</c:v>
                </c:pt>
                <c:pt idx="1042">
                  <c:v>423.33</c:v>
                </c:pt>
                <c:pt idx="1043">
                  <c:v>423.73</c:v>
                </c:pt>
                <c:pt idx="1044">
                  <c:v>424.14</c:v>
                </c:pt>
                <c:pt idx="1045">
                  <c:v>424.54</c:v>
                </c:pt>
                <c:pt idx="1046">
                  <c:v>424.95</c:v>
                </c:pt>
                <c:pt idx="1047">
                  <c:v>425.35</c:v>
                </c:pt>
                <c:pt idx="1048">
                  <c:v>425.76</c:v>
                </c:pt>
                <c:pt idx="1049">
                  <c:v>426.17</c:v>
                </c:pt>
                <c:pt idx="1050">
                  <c:v>426.57</c:v>
                </c:pt>
                <c:pt idx="1051">
                  <c:v>426.98</c:v>
                </c:pt>
                <c:pt idx="1052">
                  <c:v>427.38</c:v>
                </c:pt>
                <c:pt idx="1053">
                  <c:v>427.79</c:v>
                </c:pt>
                <c:pt idx="1054">
                  <c:v>428.2</c:v>
                </c:pt>
                <c:pt idx="1055">
                  <c:v>428.6</c:v>
                </c:pt>
                <c:pt idx="1056">
                  <c:v>429</c:v>
                </c:pt>
                <c:pt idx="1057">
                  <c:v>429.41</c:v>
                </c:pt>
                <c:pt idx="1058">
                  <c:v>429.81</c:v>
                </c:pt>
                <c:pt idx="1059">
                  <c:v>430.23</c:v>
                </c:pt>
                <c:pt idx="1060">
                  <c:v>430.63</c:v>
                </c:pt>
                <c:pt idx="1061">
                  <c:v>431.03</c:v>
                </c:pt>
                <c:pt idx="1062">
                  <c:v>431.44</c:v>
                </c:pt>
                <c:pt idx="1063">
                  <c:v>431.84</c:v>
                </c:pt>
                <c:pt idx="1064">
                  <c:v>432.25</c:v>
                </c:pt>
                <c:pt idx="1065">
                  <c:v>432.65</c:v>
                </c:pt>
                <c:pt idx="1066">
                  <c:v>433.06</c:v>
                </c:pt>
                <c:pt idx="1067">
                  <c:v>433.47</c:v>
                </c:pt>
                <c:pt idx="1068">
                  <c:v>433.87</c:v>
                </c:pt>
                <c:pt idx="1069">
                  <c:v>434.28</c:v>
                </c:pt>
                <c:pt idx="1070">
                  <c:v>434.68</c:v>
                </c:pt>
                <c:pt idx="1071">
                  <c:v>435.09</c:v>
                </c:pt>
                <c:pt idx="1072">
                  <c:v>435.49</c:v>
                </c:pt>
                <c:pt idx="1073">
                  <c:v>435.9</c:v>
                </c:pt>
                <c:pt idx="1074">
                  <c:v>436.31</c:v>
                </c:pt>
                <c:pt idx="1075">
                  <c:v>436.71</c:v>
                </c:pt>
                <c:pt idx="1076">
                  <c:v>437.12</c:v>
                </c:pt>
                <c:pt idx="1077">
                  <c:v>437.52</c:v>
                </c:pt>
                <c:pt idx="1078">
                  <c:v>437.93</c:v>
                </c:pt>
                <c:pt idx="1079">
                  <c:v>438.34</c:v>
                </c:pt>
                <c:pt idx="1080">
                  <c:v>438.74</c:v>
                </c:pt>
                <c:pt idx="1081">
                  <c:v>439.14</c:v>
                </c:pt>
                <c:pt idx="1082">
                  <c:v>439.54</c:v>
                </c:pt>
                <c:pt idx="1083">
                  <c:v>439.95</c:v>
                </c:pt>
                <c:pt idx="1084">
                  <c:v>440.36</c:v>
                </c:pt>
                <c:pt idx="1085">
                  <c:v>440.77</c:v>
                </c:pt>
                <c:pt idx="1086">
                  <c:v>441.17</c:v>
                </c:pt>
                <c:pt idx="1087">
                  <c:v>441.58</c:v>
                </c:pt>
                <c:pt idx="1088">
                  <c:v>441.98</c:v>
                </c:pt>
                <c:pt idx="1089">
                  <c:v>442.39</c:v>
                </c:pt>
                <c:pt idx="1090">
                  <c:v>442.79</c:v>
                </c:pt>
                <c:pt idx="1091">
                  <c:v>443.2</c:v>
                </c:pt>
                <c:pt idx="1092">
                  <c:v>443.61</c:v>
                </c:pt>
                <c:pt idx="1093">
                  <c:v>444.01</c:v>
                </c:pt>
                <c:pt idx="1094">
                  <c:v>444.42</c:v>
                </c:pt>
                <c:pt idx="1095">
                  <c:v>444.82</c:v>
                </c:pt>
                <c:pt idx="1096">
                  <c:v>445.23</c:v>
                </c:pt>
                <c:pt idx="1097">
                  <c:v>445.63</c:v>
                </c:pt>
                <c:pt idx="1098">
                  <c:v>446.04</c:v>
                </c:pt>
                <c:pt idx="1099">
                  <c:v>446.44</c:v>
                </c:pt>
                <c:pt idx="1100">
                  <c:v>446.85</c:v>
                </c:pt>
                <c:pt idx="1101">
                  <c:v>447.26</c:v>
                </c:pt>
                <c:pt idx="1102">
                  <c:v>447.66</c:v>
                </c:pt>
                <c:pt idx="1103">
                  <c:v>448.07</c:v>
                </c:pt>
                <c:pt idx="1104">
                  <c:v>448.48</c:v>
                </c:pt>
                <c:pt idx="1105">
                  <c:v>448.88</c:v>
                </c:pt>
                <c:pt idx="1106">
                  <c:v>449.28</c:v>
                </c:pt>
                <c:pt idx="1107">
                  <c:v>449.69</c:v>
                </c:pt>
                <c:pt idx="1108">
                  <c:v>450.1</c:v>
                </c:pt>
                <c:pt idx="1109">
                  <c:v>450.51</c:v>
                </c:pt>
                <c:pt idx="1110">
                  <c:v>450.91</c:v>
                </c:pt>
                <c:pt idx="1111">
                  <c:v>451.31</c:v>
                </c:pt>
                <c:pt idx="1112">
                  <c:v>451.72</c:v>
                </c:pt>
                <c:pt idx="1113">
                  <c:v>452.12</c:v>
                </c:pt>
                <c:pt idx="1114">
                  <c:v>452.53</c:v>
                </c:pt>
                <c:pt idx="1115">
                  <c:v>452.93</c:v>
                </c:pt>
                <c:pt idx="1116">
                  <c:v>453.34</c:v>
                </c:pt>
                <c:pt idx="1117">
                  <c:v>453.75</c:v>
                </c:pt>
                <c:pt idx="1118">
                  <c:v>454.15</c:v>
                </c:pt>
                <c:pt idx="1119">
                  <c:v>454.56</c:v>
                </c:pt>
                <c:pt idx="1120">
                  <c:v>454.96</c:v>
                </c:pt>
                <c:pt idx="1121">
                  <c:v>455.37</c:v>
                </c:pt>
                <c:pt idx="1122">
                  <c:v>455.77</c:v>
                </c:pt>
                <c:pt idx="1123">
                  <c:v>456.18</c:v>
                </c:pt>
                <c:pt idx="1124">
                  <c:v>456.59</c:v>
                </c:pt>
                <c:pt idx="1125">
                  <c:v>456.99</c:v>
                </c:pt>
                <c:pt idx="1126">
                  <c:v>457.4</c:v>
                </c:pt>
                <c:pt idx="1127">
                  <c:v>457.8</c:v>
                </c:pt>
                <c:pt idx="1128">
                  <c:v>458.21</c:v>
                </c:pt>
                <c:pt idx="1129">
                  <c:v>458.62</c:v>
                </c:pt>
                <c:pt idx="1130">
                  <c:v>459.02</c:v>
                </c:pt>
                <c:pt idx="1131">
                  <c:v>459.42</c:v>
                </c:pt>
                <c:pt idx="1132">
                  <c:v>459.83</c:v>
                </c:pt>
                <c:pt idx="1133">
                  <c:v>460.23</c:v>
                </c:pt>
                <c:pt idx="1134">
                  <c:v>460.64</c:v>
                </c:pt>
                <c:pt idx="1135">
                  <c:v>461.05</c:v>
                </c:pt>
                <c:pt idx="1136">
                  <c:v>461.45</c:v>
                </c:pt>
                <c:pt idx="1137">
                  <c:v>461.86</c:v>
                </c:pt>
                <c:pt idx="1138">
                  <c:v>462.26</c:v>
                </c:pt>
                <c:pt idx="1139">
                  <c:v>462.67</c:v>
                </c:pt>
                <c:pt idx="1140">
                  <c:v>463.07</c:v>
                </c:pt>
                <c:pt idx="1141">
                  <c:v>463.48</c:v>
                </c:pt>
                <c:pt idx="1142">
                  <c:v>463.89</c:v>
                </c:pt>
                <c:pt idx="1143">
                  <c:v>464.29</c:v>
                </c:pt>
                <c:pt idx="1144">
                  <c:v>464.7</c:v>
                </c:pt>
                <c:pt idx="1145">
                  <c:v>465.1</c:v>
                </c:pt>
                <c:pt idx="1146">
                  <c:v>465.51</c:v>
                </c:pt>
                <c:pt idx="1147">
                  <c:v>465.91</c:v>
                </c:pt>
                <c:pt idx="1148">
                  <c:v>466.32</c:v>
                </c:pt>
                <c:pt idx="1149">
                  <c:v>466.73</c:v>
                </c:pt>
                <c:pt idx="1150">
                  <c:v>467.13</c:v>
                </c:pt>
                <c:pt idx="1151">
                  <c:v>467.54</c:v>
                </c:pt>
                <c:pt idx="1152">
                  <c:v>467.94</c:v>
                </c:pt>
                <c:pt idx="1153">
                  <c:v>468.35</c:v>
                </c:pt>
                <c:pt idx="1154">
                  <c:v>468.76</c:v>
                </c:pt>
                <c:pt idx="1155">
                  <c:v>469.16</c:v>
                </c:pt>
                <c:pt idx="1156">
                  <c:v>469.56</c:v>
                </c:pt>
                <c:pt idx="1157">
                  <c:v>469.97</c:v>
                </c:pt>
                <c:pt idx="1158">
                  <c:v>470.37</c:v>
                </c:pt>
                <c:pt idx="1159">
                  <c:v>470.78</c:v>
                </c:pt>
                <c:pt idx="1160">
                  <c:v>471.19</c:v>
                </c:pt>
                <c:pt idx="1161">
                  <c:v>471.59</c:v>
                </c:pt>
                <c:pt idx="1162">
                  <c:v>472</c:v>
                </c:pt>
                <c:pt idx="1163">
                  <c:v>472.4</c:v>
                </c:pt>
                <c:pt idx="1164">
                  <c:v>472.81</c:v>
                </c:pt>
                <c:pt idx="1165">
                  <c:v>473.21</c:v>
                </c:pt>
                <c:pt idx="1166">
                  <c:v>473.62</c:v>
                </c:pt>
                <c:pt idx="1167">
                  <c:v>474.03</c:v>
                </c:pt>
                <c:pt idx="1168">
                  <c:v>474.43</c:v>
                </c:pt>
                <c:pt idx="1169">
                  <c:v>474.84</c:v>
                </c:pt>
                <c:pt idx="1170">
                  <c:v>475.24</c:v>
                </c:pt>
                <c:pt idx="1171">
                  <c:v>475.65</c:v>
                </c:pt>
                <c:pt idx="1172">
                  <c:v>476.05</c:v>
                </c:pt>
                <c:pt idx="1173">
                  <c:v>476.46</c:v>
                </c:pt>
                <c:pt idx="1174">
                  <c:v>476.87</c:v>
                </c:pt>
                <c:pt idx="1175">
                  <c:v>477.27</c:v>
                </c:pt>
                <c:pt idx="1176">
                  <c:v>477.68</c:v>
                </c:pt>
                <c:pt idx="1177">
                  <c:v>478.08</c:v>
                </c:pt>
                <c:pt idx="1178">
                  <c:v>478.49</c:v>
                </c:pt>
                <c:pt idx="1179">
                  <c:v>478.9</c:v>
                </c:pt>
                <c:pt idx="1180">
                  <c:v>479.3</c:v>
                </c:pt>
                <c:pt idx="1181">
                  <c:v>479.7</c:v>
                </c:pt>
                <c:pt idx="1182">
                  <c:v>480.11</c:v>
                </c:pt>
                <c:pt idx="1183">
                  <c:v>480.51</c:v>
                </c:pt>
                <c:pt idx="1184">
                  <c:v>480.92</c:v>
                </c:pt>
                <c:pt idx="1185">
                  <c:v>481.33</c:v>
                </c:pt>
                <c:pt idx="1186">
                  <c:v>481.74</c:v>
                </c:pt>
                <c:pt idx="1187">
                  <c:v>482.14</c:v>
                </c:pt>
                <c:pt idx="1188">
                  <c:v>482.54</c:v>
                </c:pt>
                <c:pt idx="1189">
                  <c:v>482.95</c:v>
                </c:pt>
                <c:pt idx="1190">
                  <c:v>483.35</c:v>
                </c:pt>
                <c:pt idx="1191">
                  <c:v>483.76</c:v>
                </c:pt>
                <c:pt idx="1192">
                  <c:v>484.17</c:v>
                </c:pt>
                <c:pt idx="1193">
                  <c:v>484.57</c:v>
                </c:pt>
                <c:pt idx="1194">
                  <c:v>484.98</c:v>
                </c:pt>
                <c:pt idx="1195">
                  <c:v>485.38</c:v>
                </c:pt>
                <c:pt idx="1196">
                  <c:v>485.79</c:v>
                </c:pt>
                <c:pt idx="1197">
                  <c:v>486.19</c:v>
                </c:pt>
                <c:pt idx="1198">
                  <c:v>486.6</c:v>
                </c:pt>
                <c:pt idx="1199">
                  <c:v>487.01</c:v>
                </c:pt>
                <c:pt idx="1200">
                  <c:v>487.41</c:v>
                </c:pt>
                <c:pt idx="1201">
                  <c:v>487.82</c:v>
                </c:pt>
                <c:pt idx="1202">
                  <c:v>488.22</c:v>
                </c:pt>
                <c:pt idx="1203">
                  <c:v>488.63</c:v>
                </c:pt>
                <c:pt idx="1204">
                  <c:v>489.04</c:v>
                </c:pt>
                <c:pt idx="1205">
                  <c:v>489.44</c:v>
                </c:pt>
                <c:pt idx="1206">
                  <c:v>489.84</c:v>
                </c:pt>
                <c:pt idx="1207">
                  <c:v>490.25</c:v>
                </c:pt>
                <c:pt idx="1208">
                  <c:v>490.66</c:v>
                </c:pt>
                <c:pt idx="1209">
                  <c:v>491.06</c:v>
                </c:pt>
                <c:pt idx="1210">
                  <c:v>491.47</c:v>
                </c:pt>
                <c:pt idx="1211">
                  <c:v>491.87</c:v>
                </c:pt>
                <c:pt idx="1212">
                  <c:v>492.28</c:v>
                </c:pt>
                <c:pt idx="1213">
                  <c:v>492.68</c:v>
                </c:pt>
                <c:pt idx="1214">
                  <c:v>493.09</c:v>
                </c:pt>
                <c:pt idx="1215">
                  <c:v>493.5</c:v>
                </c:pt>
                <c:pt idx="1216">
                  <c:v>493.9</c:v>
                </c:pt>
                <c:pt idx="1217">
                  <c:v>494.31</c:v>
                </c:pt>
                <c:pt idx="1218">
                  <c:v>494.71</c:v>
                </c:pt>
                <c:pt idx="1219">
                  <c:v>495.12</c:v>
                </c:pt>
                <c:pt idx="1220">
                  <c:v>495.52</c:v>
                </c:pt>
                <c:pt idx="1221">
                  <c:v>495.93</c:v>
                </c:pt>
                <c:pt idx="1222">
                  <c:v>496.33</c:v>
                </c:pt>
                <c:pt idx="1223">
                  <c:v>496.74</c:v>
                </c:pt>
                <c:pt idx="1224">
                  <c:v>497.15</c:v>
                </c:pt>
                <c:pt idx="1225">
                  <c:v>497.55</c:v>
                </c:pt>
                <c:pt idx="1226">
                  <c:v>497.96</c:v>
                </c:pt>
                <c:pt idx="1227">
                  <c:v>498.36</c:v>
                </c:pt>
                <c:pt idx="1228">
                  <c:v>498.77</c:v>
                </c:pt>
                <c:pt idx="1229">
                  <c:v>499.18</c:v>
                </c:pt>
                <c:pt idx="1230">
                  <c:v>499.58</c:v>
                </c:pt>
                <c:pt idx="1231">
                  <c:v>499.98</c:v>
                </c:pt>
                <c:pt idx="1232">
                  <c:v>500.39</c:v>
                </c:pt>
                <c:pt idx="1233">
                  <c:v>500.79</c:v>
                </c:pt>
                <c:pt idx="1234">
                  <c:v>501.21</c:v>
                </c:pt>
                <c:pt idx="1235">
                  <c:v>501.61</c:v>
                </c:pt>
                <c:pt idx="1236">
                  <c:v>502.01</c:v>
                </c:pt>
                <c:pt idx="1237">
                  <c:v>502.42</c:v>
                </c:pt>
                <c:pt idx="1238">
                  <c:v>502.82</c:v>
                </c:pt>
                <c:pt idx="1239">
                  <c:v>503.22</c:v>
                </c:pt>
                <c:pt idx="1240">
                  <c:v>503.64</c:v>
                </c:pt>
                <c:pt idx="1241">
                  <c:v>504.04</c:v>
                </c:pt>
                <c:pt idx="1242">
                  <c:v>504.45</c:v>
                </c:pt>
                <c:pt idx="1243">
                  <c:v>504.85</c:v>
                </c:pt>
                <c:pt idx="1244">
                  <c:v>505.26</c:v>
                </c:pt>
                <c:pt idx="1245">
                  <c:v>505.66</c:v>
                </c:pt>
                <c:pt idx="1246">
                  <c:v>506.07</c:v>
                </c:pt>
                <c:pt idx="1247">
                  <c:v>506.47</c:v>
                </c:pt>
                <c:pt idx="1248">
                  <c:v>506.88</c:v>
                </c:pt>
                <c:pt idx="1249">
                  <c:v>507.29</c:v>
                </c:pt>
                <c:pt idx="1250">
                  <c:v>507.69</c:v>
                </c:pt>
                <c:pt idx="1251">
                  <c:v>508.1</c:v>
                </c:pt>
                <c:pt idx="1252">
                  <c:v>508.5</c:v>
                </c:pt>
                <c:pt idx="1253">
                  <c:v>508.91</c:v>
                </c:pt>
                <c:pt idx="1254">
                  <c:v>509.32</c:v>
                </c:pt>
                <c:pt idx="1255">
                  <c:v>509.72</c:v>
                </c:pt>
                <c:pt idx="1256">
                  <c:v>510.12</c:v>
                </c:pt>
                <c:pt idx="1257">
                  <c:v>510.53</c:v>
                </c:pt>
                <c:pt idx="1258">
                  <c:v>510.93</c:v>
                </c:pt>
                <c:pt idx="1259">
                  <c:v>511.35</c:v>
                </c:pt>
                <c:pt idx="1260">
                  <c:v>511.75</c:v>
                </c:pt>
                <c:pt idx="1261">
                  <c:v>512.15</c:v>
                </c:pt>
                <c:pt idx="1262">
                  <c:v>512.55999999999995</c:v>
                </c:pt>
                <c:pt idx="1263">
                  <c:v>512.96</c:v>
                </c:pt>
                <c:pt idx="1264">
                  <c:v>513.37</c:v>
                </c:pt>
                <c:pt idx="1265">
                  <c:v>513.78</c:v>
                </c:pt>
                <c:pt idx="1266">
                  <c:v>514.17999999999995</c:v>
                </c:pt>
                <c:pt idx="1267">
                  <c:v>514.59</c:v>
                </c:pt>
                <c:pt idx="1268">
                  <c:v>514.99</c:v>
                </c:pt>
                <c:pt idx="1269">
                  <c:v>515.4</c:v>
                </c:pt>
                <c:pt idx="1270">
                  <c:v>515.79999999999995</c:v>
                </c:pt>
                <c:pt idx="1271">
                  <c:v>516.21</c:v>
                </c:pt>
                <c:pt idx="1272">
                  <c:v>516.61</c:v>
                </c:pt>
                <c:pt idx="1273">
                  <c:v>517.02</c:v>
                </c:pt>
                <c:pt idx="1274">
                  <c:v>517.42999999999995</c:v>
                </c:pt>
                <c:pt idx="1275">
                  <c:v>517.83000000000004</c:v>
                </c:pt>
                <c:pt idx="1276">
                  <c:v>518.24</c:v>
                </c:pt>
                <c:pt idx="1277">
                  <c:v>518.64</c:v>
                </c:pt>
                <c:pt idx="1278">
                  <c:v>519.04999999999995</c:v>
                </c:pt>
                <c:pt idx="1279">
                  <c:v>519.45000000000005</c:v>
                </c:pt>
                <c:pt idx="1280">
                  <c:v>519.86</c:v>
                </c:pt>
                <c:pt idx="1281">
                  <c:v>520.26</c:v>
                </c:pt>
                <c:pt idx="1282">
                  <c:v>520.66999999999996</c:v>
                </c:pt>
                <c:pt idx="1283">
                  <c:v>521.08000000000004</c:v>
                </c:pt>
                <c:pt idx="1284">
                  <c:v>521.48</c:v>
                </c:pt>
                <c:pt idx="1285">
                  <c:v>521.89</c:v>
                </c:pt>
                <c:pt idx="1286">
                  <c:v>522.29</c:v>
                </c:pt>
                <c:pt idx="1287">
                  <c:v>522.70000000000005</c:v>
                </c:pt>
                <c:pt idx="1288">
                  <c:v>523.1</c:v>
                </c:pt>
                <c:pt idx="1289">
                  <c:v>523.5</c:v>
                </c:pt>
                <c:pt idx="1290">
                  <c:v>523.91999999999996</c:v>
                </c:pt>
                <c:pt idx="1291">
                  <c:v>524.32000000000005</c:v>
                </c:pt>
                <c:pt idx="1292">
                  <c:v>524.73</c:v>
                </c:pt>
                <c:pt idx="1293">
                  <c:v>525.13</c:v>
                </c:pt>
                <c:pt idx="1294">
                  <c:v>525.53</c:v>
                </c:pt>
                <c:pt idx="1295">
                  <c:v>525.94000000000005</c:v>
                </c:pt>
                <c:pt idx="1296">
                  <c:v>526.35</c:v>
                </c:pt>
                <c:pt idx="1297">
                  <c:v>526.75</c:v>
                </c:pt>
                <c:pt idx="1298">
                  <c:v>527.16</c:v>
                </c:pt>
                <c:pt idx="1299">
                  <c:v>527.55999999999995</c:v>
                </c:pt>
                <c:pt idx="1300">
                  <c:v>527.97</c:v>
                </c:pt>
                <c:pt idx="1301">
                  <c:v>528.38</c:v>
                </c:pt>
                <c:pt idx="1302">
                  <c:v>528.78</c:v>
                </c:pt>
                <c:pt idx="1303">
                  <c:v>529.19000000000005</c:v>
                </c:pt>
                <c:pt idx="1304">
                  <c:v>529.59</c:v>
                </c:pt>
                <c:pt idx="1305">
                  <c:v>530</c:v>
                </c:pt>
                <c:pt idx="1306">
                  <c:v>530.4</c:v>
                </c:pt>
                <c:pt idx="1307">
                  <c:v>530.80999999999995</c:v>
                </c:pt>
                <c:pt idx="1308">
                  <c:v>531.22</c:v>
                </c:pt>
                <c:pt idx="1309">
                  <c:v>531.62</c:v>
                </c:pt>
                <c:pt idx="1310">
                  <c:v>532.03</c:v>
                </c:pt>
                <c:pt idx="1311">
                  <c:v>532.42999999999995</c:v>
                </c:pt>
                <c:pt idx="1312">
                  <c:v>532.84</c:v>
                </c:pt>
                <c:pt idx="1313">
                  <c:v>533.24</c:v>
                </c:pt>
                <c:pt idx="1314">
                  <c:v>533.65</c:v>
                </c:pt>
                <c:pt idx="1315">
                  <c:v>534.04999999999995</c:v>
                </c:pt>
                <c:pt idx="1316">
                  <c:v>534.46</c:v>
                </c:pt>
                <c:pt idx="1317">
                  <c:v>534.87</c:v>
                </c:pt>
                <c:pt idx="1318">
                  <c:v>535.27</c:v>
                </c:pt>
                <c:pt idx="1319">
                  <c:v>535.67999999999995</c:v>
                </c:pt>
                <c:pt idx="1320">
                  <c:v>536.08000000000004</c:v>
                </c:pt>
                <c:pt idx="1321">
                  <c:v>536.49</c:v>
                </c:pt>
                <c:pt idx="1322">
                  <c:v>536.89</c:v>
                </c:pt>
                <c:pt idx="1323">
                  <c:v>537.29999999999995</c:v>
                </c:pt>
                <c:pt idx="1324">
                  <c:v>537.71</c:v>
                </c:pt>
                <c:pt idx="1325">
                  <c:v>538.11</c:v>
                </c:pt>
                <c:pt idx="1326">
                  <c:v>538.52</c:v>
                </c:pt>
                <c:pt idx="1327">
                  <c:v>538.91999999999996</c:v>
                </c:pt>
                <c:pt idx="1328">
                  <c:v>539.33000000000004</c:v>
                </c:pt>
                <c:pt idx="1329">
                  <c:v>539.73</c:v>
                </c:pt>
                <c:pt idx="1330">
                  <c:v>540.14</c:v>
                </c:pt>
                <c:pt idx="1331">
                  <c:v>540.54</c:v>
                </c:pt>
                <c:pt idx="1332">
                  <c:v>540.95000000000005</c:v>
                </c:pt>
                <c:pt idx="1333">
                  <c:v>541.36</c:v>
                </c:pt>
                <c:pt idx="1334">
                  <c:v>541.76</c:v>
                </c:pt>
                <c:pt idx="1335">
                  <c:v>542.16999999999996</c:v>
                </c:pt>
                <c:pt idx="1336">
                  <c:v>542.57000000000005</c:v>
                </c:pt>
                <c:pt idx="1337">
                  <c:v>542.98</c:v>
                </c:pt>
                <c:pt idx="1338">
                  <c:v>543.38</c:v>
                </c:pt>
                <c:pt idx="1339">
                  <c:v>543.79</c:v>
                </c:pt>
                <c:pt idx="1340">
                  <c:v>544.19000000000005</c:v>
                </c:pt>
                <c:pt idx="1341">
                  <c:v>544.6</c:v>
                </c:pt>
                <c:pt idx="1342">
                  <c:v>545.01</c:v>
                </c:pt>
                <c:pt idx="1343">
                  <c:v>545.41</c:v>
                </c:pt>
                <c:pt idx="1344">
                  <c:v>545.82000000000005</c:v>
                </c:pt>
                <c:pt idx="1345">
                  <c:v>546.22</c:v>
                </c:pt>
                <c:pt idx="1346">
                  <c:v>546.63</c:v>
                </c:pt>
                <c:pt idx="1347">
                  <c:v>547.03</c:v>
                </c:pt>
                <c:pt idx="1348">
                  <c:v>547.44000000000005</c:v>
                </c:pt>
                <c:pt idx="1349">
                  <c:v>547.85</c:v>
                </c:pt>
                <c:pt idx="1350">
                  <c:v>548.25</c:v>
                </c:pt>
                <c:pt idx="1351">
                  <c:v>548.66</c:v>
                </c:pt>
                <c:pt idx="1352">
                  <c:v>549.05999999999995</c:v>
                </c:pt>
                <c:pt idx="1353">
                  <c:v>549.47</c:v>
                </c:pt>
                <c:pt idx="1354">
                  <c:v>549.87</c:v>
                </c:pt>
                <c:pt idx="1355">
                  <c:v>550.28</c:v>
                </c:pt>
                <c:pt idx="1356">
                  <c:v>550.67999999999995</c:v>
                </c:pt>
                <c:pt idx="1357">
                  <c:v>551.09</c:v>
                </c:pt>
                <c:pt idx="1358">
                  <c:v>551.5</c:v>
                </c:pt>
                <c:pt idx="1359">
                  <c:v>551.9</c:v>
                </c:pt>
                <c:pt idx="1360">
                  <c:v>552.30999999999995</c:v>
                </c:pt>
                <c:pt idx="1361">
                  <c:v>552.71</c:v>
                </c:pt>
                <c:pt idx="1362">
                  <c:v>553.12</c:v>
                </c:pt>
                <c:pt idx="1363">
                  <c:v>553.52</c:v>
                </c:pt>
                <c:pt idx="1364">
                  <c:v>553.92999999999995</c:v>
                </c:pt>
                <c:pt idx="1365">
                  <c:v>554.33000000000004</c:v>
                </c:pt>
                <c:pt idx="1366">
                  <c:v>554.74</c:v>
                </c:pt>
                <c:pt idx="1367">
                  <c:v>555.15</c:v>
                </c:pt>
                <c:pt idx="1368">
                  <c:v>555.54999999999995</c:v>
                </c:pt>
                <c:pt idx="1369">
                  <c:v>555.96</c:v>
                </c:pt>
                <c:pt idx="1370">
                  <c:v>556.36</c:v>
                </c:pt>
                <c:pt idx="1371">
                  <c:v>556.77</c:v>
                </c:pt>
                <c:pt idx="1372">
                  <c:v>557.16999999999996</c:v>
                </c:pt>
                <c:pt idx="1373">
                  <c:v>557.58000000000004</c:v>
                </c:pt>
                <c:pt idx="1374">
                  <c:v>557.99</c:v>
                </c:pt>
                <c:pt idx="1375">
                  <c:v>558.39</c:v>
                </c:pt>
                <c:pt idx="1376">
                  <c:v>558.79999999999995</c:v>
                </c:pt>
                <c:pt idx="1377">
                  <c:v>559.20000000000005</c:v>
                </c:pt>
                <c:pt idx="1378">
                  <c:v>559.61</c:v>
                </c:pt>
                <c:pt idx="1379">
                  <c:v>560.01</c:v>
                </c:pt>
                <c:pt idx="1380">
                  <c:v>560.41999999999996</c:v>
                </c:pt>
                <c:pt idx="1381">
                  <c:v>560.82000000000005</c:v>
                </c:pt>
                <c:pt idx="1382">
                  <c:v>561.23</c:v>
                </c:pt>
                <c:pt idx="1383">
                  <c:v>561.63</c:v>
                </c:pt>
                <c:pt idx="1384">
                  <c:v>562.04</c:v>
                </c:pt>
                <c:pt idx="1385">
                  <c:v>562.45000000000005</c:v>
                </c:pt>
                <c:pt idx="1386">
                  <c:v>562.85</c:v>
                </c:pt>
                <c:pt idx="1387">
                  <c:v>563.26</c:v>
                </c:pt>
                <c:pt idx="1388">
                  <c:v>563.66</c:v>
                </c:pt>
                <c:pt idx="1389">
                  <c:v>564.07000000000005</c:v>
                </c:pt>
                <c:pt idx="1390">
                  <c:v>564.48</c:v>
                </c:pt>
                <c:pt idx="1391">
                  <c:v>564.88</c:v>
                </c:pt>
                <c:pt idx="1392">
                  <c:v>565.29</c:v>
                </c:pt>
                <c:pt idx="1393">
                  <c:v>565.69000000000005</c:v>
                </c:pt>
                <c:pt idx="1394">
                  <c:v>566.1</c:v>
                </c:pt>
                <c:pt idx="1395">
                  <c:v>566.5</c:v>
                </c:pt>
                <c:pt idx="1396">
                  <c:v>566.91</c:v>
                </c:pt>
                <c:pt idx="1397">
                  <c:v>567.30999999999995</c:v>
                </c:pt>
                <c:pt idx="1398">
                  <c:v>567.72</c:v>
                </c:pt>
                <c:pt idx="1399">
                  <c:v>568.13</c:v>
                </c:pt>
                <c:pt idx="1400">
                  <c:v>568.53</c:v>
                </c:pt>
                <c:pt idx="1401">
                  <c:v>568.94000000000005</c:v>
                </c:pt>
                <c:pt idx="1402">
                  <c:v>569.34</c:v>
                </c:pt>
                <c:pt idx="1403">
                  <c:v>569.75</c:v>
                </c:pt>
                <c:pt idx="1404">
                  <c:v>570.15</c:v>
                </c:pt>
                <c:pt idx="1405">
                  <c:v>570.55999999999995</c:v>
                </c:pt>
                <c:pt idx="1406">
                  <c:v>570.96</c:v>
                </c:pt>
                <c:pt idx="1407">
                  <c:v>571.37</c:v>
                </c:pt>
                <c:pt idx="1408">
                  <c:v>571.77</c:v>
                </c:pt>
                <c:pt idx="1409">
                  <c:v>572.17999999999995</c:v>
                </c:pt>
                <c:pt idx="1410">
                  <c:v>572.59</c:v>
                </c:pt>
                <c:pt idx="1411">
                  <c:v>572.99</c:v>
                </c:pt>
                <c:pt idx="1412">
                  <c:v>573.4</c:v>
                </c:pt>
                <c:pt idx="1413">
                  <c:v>573.79999999999995</c:v>
                </c:pt>
                <c:pt idx="1414">
                  <c:v>574.21</c:v>
                </c:pt>
                <c:pt idx="1415">
                  <c:v>574.62</c:v>
                </c:pt>
                <c:pt idx="1416">
                  <c:v>575.02</c:v>
                </c:pt>
                <c:pt idx="1417">
                  <c:v>575.42999999999995</c:v>
                </c:pt>
                <c:pt idx="1418">
                  <c:v>575.83000000000004</c:v>
                </c:pt>
                <c:pt idx="1419">
                  <c:v>576.24</c:v>
                </c:pt>
                <c:pt idx="1420">
                  <c:v>576.64</c:v>
                </c:pt>
                <c:pt idx="1421">
                  <c:v>577.04999999999995</c:v>
                </c:pt>
                <c:pt idx="1422">
                  <c:v>577.46</c:v>
                </c:pt>
                <c:pt idx="1423">
                  <c:v>577.86</c:v>
                </c:pt>
                <c:pt idx="1424">
                  <c:v>578.26</c:v>
                </c:pt>
                <c:pt idx="1425">
                  <c:v>578.66999999999996</c:v>
                </c:pt>
                <c:pt idx="1426">
                  <c:v>579.08000000000004</c:v>
                </c:pt>
                <c:pt idx="1427">
                  <c:v>579.48</c:v>
                </c:pt>
                <c:pt idx="1428">
                  <c:v>579.89</c:v>
                </c:pt>
                <c:pt idx="1429">
                  <c:v>580.29</c:v>
                </c:pt>
                <c:pt idx="1430">
                  <c:v>580.70000000000005</c:v>
                </c:pt>
                <c:pt idx="1431">
                  <c:v>581.1</c:v>
                </c:pt>
                <c:pt idx="1432">
                  <c:v>581.51</c:v>
                </c:pt>
                <c:pt idx="1433">
                  <c:v>581.91</c:v>
                </c:pt>
                <c:pt idx="1434">
                  <c:v>582.32000000000005</c:v>
                </c:pt>
                <c:pt idx="1435">
                  <c:v>582.73</c:v>
                </c:pt>
                <c:pt idx="1436">
                  <c:v>583.13</c:v>
                </c:pt>
                <c:pt idx="1437">
                  <c:v>583.54</c:v>
                </c:pt>
                <c:pt idx="1438">
                  <c:v>583.94000000000005</c:v>
                </c:pt>
                <c:pt idx="1439">
                  <c:v>584.35</c:v>
                </c:pt>
                <c:pt idx="1440">
                  <c:v>584.76</c:v>
                </c:pt>
                <c:pt idx="1441">
                  <c:v>585.16</c:v>
                </c:pt>
                <c:pt idx="1442">
                  <c:v>585.57000000000005</c:v>
                </c:pt>
                <c:pt idx="1443">
                  <c:v>585.97</c:v>
                </c:pt>
                <c:pt idx="1444">
                  <c:v>586.38</c:v>
                </c:pt>
                <c:pt idx="1445">
                  <c:v>586.78</c:v>
                </c:pt>
                <c:pt idx="1446">
                  <c:v>587.19000000000005</c:v>
                </c:pt>
                <c:pt idx="1447">
                  <c:v>587.59</c:v>
                </c:pt>
                <c:pt idx="1448">
                  <c:v>588</c:v>
                </c:pt>
                <c:pt idx="1449">
                  <c:v>588.41</c:v>
                </c:pt>
                <c:pt idx="1450">
                  <c:v>588.80999999999995</c:v>
                </c:pt>
                <c:pt idx="1451">
                  <c:v>589.22</c:v>
                </c:pt>
                <c:pt idx="1452">
                  <c:v>589.62</c:v>
                </c:pt>
                <c:pt idx="1453">
                  <c:v>590.03</c:v>
                </c:pt>
                <c:pt idx="1454">
                  <c:v>590.44000000000005</c:v>
                </c:pt>
                <c:pt idx="1455">
                  <c:v>590.84</c:v>
                </c:pt>
                <c:pt idx="1456">
                  <c:v>591.24</c:v>
                </c:pt>
                <c:pt idx="1457">
                  <c:v>591.65</c:v>
                </c:pt>
                <c:pt idx="1458">
                  <c:v>592.05999999999995</c:v>
                </c:pt>
                <c:pt idx="1459">
                  <c:v>592.47</c:v>
                </c:pt>
                <c:pt idx="1460">
                  <c:v>592.87</c:v>
                </c:pt>
                <c:pt idx="1461">
                  <c:v>593.27</c:v>
                </c:pt>
                <c:pt idx="1462">
                  <c:v>593.67999999999995</c:v>
                </c:pt>
                <c:pt idx="1463">
                  <c:v>594.08000000000004</c:v>
                </c:pt>
                <c:pt idx="1464">
                  <c:v>594.49</c:v>
                </c:pt>
                <c:pt idx="1465">
                  <c:v>594.9</c:v>
                </c:pt>
                <c:pt idx="1466">
                  <c:v>595.29999999999995</c:v>
                </c:pt>
                <c:pt idx="1467">
                  <c:v>595.71</c:v>
                </c:pt>
                <c:pt idx="1468">
                  <c:v>596.11</c:v>
                </c:pt>
                <c:pt idx="1469">
                  <c:v>596.52</c:v>
                </c:pt>
                <c:pt idx="1470">
                  <c:v>596.91999999999996</c:v>
                </c:pt>
                <c:pt idx="1471">
                  <c:v>597.33000000000004</c:v>
                </c:pt>
                <c:pt idx="1472">
                  <c:v>597.73</c:v>
                </c:pt>
                <c:pt idx="1473">
                  <c:v>598.14</c:v>
                </c:pt>
                <c:pt idx="1474">
                  <c:v>598.54999999999995</c:v>
                </c:pt>
                <c:pt idx="1475">
                  <c:v>598.95000000000005</c:v>
                </c:pt>
                <c:pt idx="1476">
                  <c:v>599.36</c:v>
                </c:pt>
                <c:pt idx="1477">
                  <c:v>599.76</c:v>
                </c:pt>
                <c:pt idx="1478">
                  <c:v>600.16999999999996</c:v>
                </c:pt>
                <c:pt idx="1479">
                  <c:v>600.58000000000004</c:v>
                </c:pt>
                <c:pt idx="1480">
                  <c:v>600.98</c:v>
                </c:pt>
                <c:pt idx="1481">
                  <c:v>601.38</c:v>
                </c:pt>
                <c:pt idx="1482">
                  <c:v>601.79</c:v>
                </c:pt>
                <c:pt idx="1483">
                  <c:v>602.20000000000005</c:v>
                </c:pt>
                <c:pt idx="1484">
                  <c:v>602.6</c:v>
                </c:pt>
                <c:pt idx="1485">
                  <c:v>603.01</c:v>
                </c:pt>
                <c:pt idx="1486">
                  <c:v>603.41</c:v>
                </c:pt>
                <c:pt idx="1487">
                  <c:v>603.82000000000005</c:v>
                </c:pt>
                <c:pt idx="1488">
                  <c:v>604.22</c:v>
                </c:pt>
                <c:pt idx="1489">
                  <c:v>604.63</c:v>
                </c:pt>
                <c:pt idx="1490">
                  <c:v>605.04</c:v>
                </c:pt>
                <c:pt idx="1491">
                  <c:v>605.44000000000005</c:v>
                </c:pt>
                <c:pt idx="1492">
                  <c:v>605.94000000000005</c:v>
                </c:pt>
                <c:pt idx="1493">
                  <c:v>606.30999999999995</c:v>
                </c:pt>
                <c:pt idx="1494">
                  <c:v>606.66999999999996</c:v>
                </c:pt>
                <c:pt idx="1495">
                  <c:v>607.05999999999995</c:v>
                </c:pt>
                <c:pt idx="1496">
                  <c:v>607.47</c:v>
                </c:pt>
                <c:pt idx="1497">
                  <c:v>607.87</c:v>
                </c:pt>
                <c:pt idx="1498">
                  <c:v>608.28</c:v>
                </c:pt>
                <c:pt idx="1499">
                  <c:v>608.69000000000005</c:v>
                </c:pt>
                <c:pt idx="1500">
                  <c:v>609.09</c:v>
                </c:pt>
                <c:pt idx="1501">
                  <c:v>609.5</c:v>
                </c:pt>
                <c:pt idx="1502">
                  <c:v>609.9</c:v>
                </c:pt>
                <c:pt idx="1503">
                  <c:v>610.30999999999995</c:v>
                </c:pt>
                <c:pt idx="1504">
                  <c:v>610.72</c:v>
                </c:pt>
                <c:pt idx="1505">
                  <c:v>611.12</c:v>
                </c:pt>
                <c:pt idx="1506">
                  <c:v>611.52</c:v>
                </c:pt>
                <c:pt idx="1507">
                  <c:v>611.92999999999995</c:v>
                </c:pt>
                <c:pt idx="1508">
                  <c:v>612.33000000000004</c:v>
                </c:pt>
                <c:pt idx="1509">
                  <c:v>612.75</c:v>
                </c:pt>
                <c:pt idx="1510">
                  <c:v>613.15</c:v>
                </c:pt>
                <c:pt idx="1511">
                  <c:v>613.54999999999995</c:v>
                </c:pt>
                <c:pt idx="1512">
                  <c:v>613.96</c:v>
                </c:pt>
                <c:pt idx="1513">
                  <c:v>614.36</c:v>
                </c:pt>
                <c:pt idx="1514">
                  <c:v>614.77</c:v>
                </c:pt>
                <c:pt idx="1515">
                  <c:v>615.17999999999995</c:v>
                </c:pt>
                <c:pt idx="1516">
                  <c:v>615.58000000000004</c:v>
                </c:pt>
                <c:pt idx="1517">
                  <c:v>615.99</c:v>
                </c:pt>
                <c:pt idx="1518">
                  <c:v>616.39</c:v>
                </c:pt>
                <c:pt idx="1519">
                  <c:v>616.79999999999995</c:v>
                </c:pt>
                <c:pt idx="1520">
                  <c:v>617.20000000000005</c:v>
                </c:pt>
                <c:pt idx="1521">
                  <c:v>617.61</c:v>
                </c:pt>
                <c:pt idx="1522">
                  <c:v>618.01</c:v>
                </c:pt>
                <c:pt idx="1523">
                  <c:v>618.41999999999996</c:v>
                </c:pt>
                <c:pt idx="1524">
                  <c:v>618.83000000000004</c:v>
                </c:pt>
                <c:pt idx="1525">
                  <c:v>619.23</c:v>
                </c:pt>
                <c:pt idx="1526">
                  <c:v>619.64</c:v>
                </c:pt>
                <c:pt idx="1527">
                  <c:v>620.04</c:v>
                </c:pt>
                <c:pt idx="1528">
                  <c:v>620.45000000000005</c:v>
                </c:pt>
                <c:pt idx="1529">
                  <c:v>620.86</c:v>
                </c:pt>
                <c:pt idx="1530">
                  <c:v>621.26</c:v>
                </c:pt>
                <c:pt idx="1531">
                  <c:v>621.66</c:v>
                </c:pt>
                <c:pt idx="1532">
                  <c:v>622.07000000000005</c:v>
                </c:pt>
                <c:pt idx="1533">
                  <c:v>622.47</c:v>
                </c:pt>
                <c:pt idx="1534">
                  <c:v>622.88</c:v>
                </c:pt>
                <c:pt idx="1535">
                  <c:v>623.29</c:v>
                </c:pt>
                <c:pt idx="1536">
                  <c:v>623.69000000000005</c:v>
                </c:pt>
                <c:pt idx="1537">
                  <c:v>624.1</c:v>
                </c:pt>
                <c:pt idx="1538">
                  <c:v>624.5</c:v>
                </c:pt>
                <c:pt idx="1539">
                  <c:v>624.91</c:v>
                </c:pt>
                <c:pt idx="1540">
                  <c:v>625.32000000000005</c:v>
                </c:pt>
                <c:pt idx="1541">
                  <c:v>625.72</c:v>
                </c:pt>
                <c:pt idx="1542">
                  <c:v>626.13</c:v>
                </c:pt>
                <c:pt idx="1543">
                  <c:v>626.53</c:v>
                </c:pt>
                <c:pt idx="1544">
                  <c:v>626.94000000000005</c:v>
                </c:pt>
                <c:pt idx="1545">
                  <c:v>627.34</c:v>
                </c:pt>
                <c:pt idx="1546">
                  <c:v>627.75</c:v>
                </c:pt>
                <c:pt idx="1547">
                  <c:v>628.16</c:v>
                </c:pt>
                <c:pt idx="1548">
                  <c:v>628.55999999999995</c:v>
                </c:pt>
                <c:pt idx="1549">
                  <c:v>628.97</c:v>
                </c:pt>
                <c:pt idx="1550">
                  <c:v>629.37</c:v>
                </c:pt>
                <c:pt idx="1551">
                  <c:v>629.78</c:v>
                </c:pt>
                <c:pt idx="1552">
                  <c:v>630.17999999999995</c:v>
                </c:pt>
                <c:pt idx="1553">
                  <c:v>630.59</c:v>
                </c:pt>
                <c:pt idx="1554">
                  <c:v>631</c:v>
                </c:pt>
                <c:pt idx="1555">
                  <c:v>631.4</c:v>
                </c:pt>
                <c:pt idx="1556">
                  <c:v>631.80999999999995</c:v>
                </c:pt>
                <c:pt idx="1557">
                  <c:v>632.21</c:v>
                </c:pt>
                <c:pt idx="1558">
                  <c:v>632.62</c:v>
                </c:pt>
                <c:pt idx="1559">
                  <c:v>633.03</c:v>
                </c:pt>
                <c:pt idx="1560">
                  <c:v>633.42999999999995</c:v>
                </c:pt>
                <c:pt idx="1561">
                  <c:v>633.83000000000004</c:v>
                </c:pt>
                <c:pt idx="1562">
                  <c:v>634.23</c:v>
                </c:pt>
                <c:pt idx="1563">
                  <c:v>634.64</c:v>
                </c:pt>
                <c:pt idx="1564">
                  <c:v>635.04999999999995</c:v>
                </c:pt>
                <c:pt idx="1565">
                  <c:v>635.46</c:v>
                </c:pt>
                <c:pt idx="1566">
                  <c:v>635.86</c:v>
                </c:pt>
                <c:pt idx="1567">
                  <c:v>636.27</c:v>
                </c:pt>
                <c:pt idx="1568">
                  <c:v>636.66999999999996</c:v>
                </c:pt>
                <c:pt idx="1569">
                  <c:v>637.08000000000004</c:v>
                </c:pt>
                <c:pt idx="1570">
                  <c:v>637.48</c:v>
                </c:pt>
                <c:pt idx="1571">
                  <c:v>637.89</c:v>
                </c:pt>
                <c:pt idx="1572">
                  <c:v>638.29</c:v>
                </c:pt>
                <c:pt idx="1573">
                  <c:v>638.70000000000005</c:v>
                </c:pt>
                <c:pt idx="1574">
                  <c:v>639.11</c:v>
                </c:pt>
                <c:pt idx="1575">
                  <c:v>639.51</c:v>
                </c:pt>
                <c:pt idx="1576">
                  <c:v>639.91999999999996</c:v>
                </c:pt>
                <c:pt idx="1577">
                  <c:v>640.32000000000005</c:v>
                </c:pt>
                <c:pt idx="1578">
                  <c:v>640.73</c:v>
                </c:pt>
                <c:pt idx="1579">
                  <c:v>641.13</c:v>
                </c:pt>
                <c:pt idx="1580">
                  <c:v>641.54</c:v>
                </c:pt>
                <c:pt idx="1581">
                  <c:v>641.95000000000005</c:v>
                </c:pt>
                <c:pt idx="1582">
                  <c:v>642.35</c:v>
                </c:pt>
                <c:pt idx="1583">
                  <c:v>642.76</c:v>
                </c:pt>
                <c:pt idx="1584">
                  <c:v>643.16999999999996</c:v>
                </c:pt>
                <c:pt idx="1585">
                  <c:v>643.57000000000005</c:v>
                </c:pt>
                <c:pt idx="1586">
                  <c:v>643.97</c:v>
                </c:pt>
                <c:pt idx="1587">
                  <c:v>644.38</c:v>
                </c:pt>
                <c:pt idx="1588">
                  <c:v>644.78</c:v>
                </c:pt>
                <c:pt idx="1589">
                  <c:v>645.19000000000005</c:v>
                </c:pt>
                <c:pt idx="1590">
                  <c:v>645.6</c:v>
                </c:pt>
                <c:pt idx="1591">
                  <c:v>646</c:v>
                </c:pt>
                <c:pt idx="1592">
                  <c:v>646.41</c:v>
                </c:pt>
                <c:pt idx="1593">
                  <c:v>646.80999999999995</c:v>
                </c:pt>
                <c:pt idx="1594">
                  <c:v>647.22</c:v>
                </c:pt>
                <c:pt idx="1595">
                  <c:v>647.62</c:v>
                </c:pt>
                <c:pt idx="1596">
                  <c:v>648.03</c:v>
                </c:pt>
                <c:pt idx="1597">
                  <c:v>648.44000000000005</c:v>
                </c:pt>
                <c:pt idx="1598">
                  <c:v>648.84</c:v>
                </c:pt>
                <c:pt idx="1599">
                  <c:v>649.25</c:v>
                </c:pt>
                <c:pt idx="1600">
                  <c:v>649.65</c:v>
                </c:pt>
                <c:pt idx="1601">
                  <c:v>650.05999999999995</c:v>
                </c:pt>
                <c:pt idx="1602">
                  <c:v>650.46</c:v>
                </c:pt>
                <c:pt idx="1603">
                  <c:v>650.87</c:v>
                </c:pt>
                <c:pt idx="1604">
                  <c:v>651.28</c:v>
                </c:pt>
                <c:pt idx="1605">
                  <c:v>651.67999999999995</c:v>
                </c:pt>
                <c:pt idx="1606">
                  <c:v>652.09</c:v>
                </c:pt>
                <c:pt idx="1607">
                  <c:v>652.49</c:v>
                </c:pt>
                <c:pt idx="1608">
                  <c:v>652.9</c:v>
                </c:pt>
                <c:pt idx="1609">
                  <c:v>653.30999999999995</c:v>
                </c:pt>
                <c:pt idx="1610">
                  <c:v>653.71</c:v>
                </c:pt>
                <c:pt idx="1611">
                  <c:v>654.11</c:v>
                </c:pt>
                <c:pt idx="1612">
                  <c:v>654.52</c:v>
                </c:pt>
                <c:pt idx="1613">
                  <c:v>654.91999999999996</c:v>
                </c:pt>
                <c:pt idx="1614">
                  <c:v>655.33000000000004</c:v>
                </c:pt>
                <c:pt idx="1615">
                  <c:v>655.74</c:v>
                </c:pt>
                <c:pt idx="1616">
                  <c:v>656.14</c:v>
                </c:pt>
                <c:pt idx="1617">
                  <c:v>656.55</c:v>
                </c:pt>
                <c:pt idx="1618">
                  <c:v>656.95</c:v>
                </c:pt>
                <c:pt idx="1619">
                  <c:v>657.36</c:v>
                </c:pt>
                <c:pt idx="1620">
                  <c:v>657.76</c:v>
                </c:pt>
                <c:pt idx="1621">
                  <c:v>658.17</c:v>
                </c:pt>
                <c:pt idx="1622">
                  <c:v>658.57</c:v>
                </c:pt>
                <c:pt idx="1623">
                  <c:v>658.98</c:v>
                </c:pt>
                <c:pt idx="1624">
                  <c:v>659.39</c:v>
                </c:pt>
                <c:pt idx="1625">
                  <c:v>659.79</c:v>
                </c:pt>
                <c:pt idx="1626">
                  <c:v>660.2</c:v>
                </c:pt>
                <c:pt idx="1627">
                  <c:v>660.6</c:v>
                </c:pt>
                <c:pt idx="1628">
                  <c:v>661.01</c:v>
                </c:pt>
                <c:pt idx="1629">
                  <c:v>661.41</c:v>
                </c:pt>
                <c:pt idx="1630">
                  <c:v>661.82</c:v>
                </c:pt>
                <c:pt idx="1631">
                  <c:v>662.23</c:v>
                </c:pt>
                <c:pt idx="1632">
                  <c:v>662.63</c:v>
                </c:pt>
                <c:pt idx="1633">
                  <c:v>663.04</c:v>
                </c:pt>
                <c:pt idx="1634">
                  <c:v>663.45</c:v>
                </c:pt>
                <c:pt idx="1635">
                  <c:v>663.85</c:v>
                </c:pt>
                <c:pt idx="1636">
                  <c:v>664.25</c:v>
                </c:pt>
                <c:pt idx="1637">
                  <c:v>664.66</c:v>
                </c:pt>
                <c:pt idx="1638">
                  <c:v>665.06</c:v>
                </c:pt>
                <c:pt idx="1639">
                  <c:v>665.47</c:v>
                </c:pt>
                <c:pt idx="1640">
                  <c:v>665.88</c:v>
                </c:pt>
                <c:pt idx="1641">
                  <c:v>666.28</c:v>
                </c:pt>
                <c:pt idx="1642">
                  <c:v>666.69</c:v>
                </c:pt>
                <c:pt idx="1643">
                  <c:v>667.09</c:v>
                </c:pt>
                <c:pt idx="1644">
                  <c:v>667.5</c:v>
                </c:pt>
                <c:pt idx="1645">
                  <c:v>667.9</c:v>
                </c:pt>
                <c:pt idx="1646">
                  <c:v>668.31</c:v>
                </c:pt>
                <c:pt idx="1647">
                  <c:v>668.71</c:v>
                </c:pt>
                <c:pt idx="1648">
                  <c:v>669.12</c:v>
                </c:pt>
                <c:pt idx="1649">
                  <c:v>669.53</c:v>
                </c:pt>
                <c:pt idx="1650">
                  <c:v>669.93</c:v>
                </c:pt>
                <c:pt idx="1651">
                  <c:v>670.34</c:v>
                </c:pt>
                <c:pt idx="1652">
                  <c:v>670.74</c:v>
                </c:pt>
                <c:pt idx="1653">
                  <c:v>671.15</c:v>
                </c:pt>
                <c:pt idx="1654">
                  <c:v>671.56</c:v>
                </c:pt>
                <c:pt idx="1655">
                  <c:v>671.96</c:v>
                </c:pt>
                <c:pt idx="1656">
                  <c:v>672.37</c:v>
                </c:pt>
                <c:pt idx="1657">
                  <c:v>672.77</c:v>
                </c:pt>
                <c:pt idx="1658">
                  <c:v>673.18</c:v>
                </c:pt>
                <c:pt idx="1659">
                  <c:v>673.59</c:v>
                </c:pt>
                <c:pt idx="1660">
                  <c:v>673.99</c:v>
                </c:pt>
                <c:pt idx="1661">
                  <c:v>674.39</c:v>
                </c:pt>
                <c:pt idx="1662">
                  <c:v>674.8</c:v>
                </c:pt>
                <c:pt idx="1663">
                  <c:v>675.21</c:v>
                </c:pt>
                <c:pt idx="1664">
                  <c:v>675.61</c:v>
                </c:pt>
                <c:pt idx="1665">
                  <c:v>676.02</c:v>
                </c:pt>
                <c:pt idx="1666">
                  <c:v>676.42</c:v>
                </c:pt>
                <c:pt idx="1667">
                  <c:v>676.83</c:v>
                </c:pt>
                <c:pt idx="1668">
                  <c:v>677.23</c:v>
                </c:pt>
                <c:pt idx="1669">
                  <c:v>677.64</c:v>
                </c:pt>
                <c:pt idx="1670">
                  <c:v>678.04</c:v>
                </c:pt>
                <c:pt idx="1671">
                  <c:v>678.45</c:v>
                </c:pt>
                <c:pt idx="1672">
                  <c:v>678.85</c:v>
                </c:pt>
                <c:pt idx="1673">
                  <c:v>679.26</c:v>
                </c:pt>
                <c:pt idx="1674">
                  <c:v>679.66</c:v>
                </c:pt>
                <c:pt idx="1675">
                  <c:v>680.07</c:v>
                </c:pt>
                <c:pt idx="1676">
                  <c:v>680.48</c:v>
                </c:pt>
                <c:pt idx="1677">
                  <c:v>680.88</c:v>
                </c:pt>
                <c:pt idx="1678">
                  <c:v>681.29</c:v>
                </c:pt>
                <c:pt idx="1679">
                  <c:v>681.69</c:v>
                </c:pt>
                <c:pt idx="1680">
                  <c:v>682.1</c:v>
                </c:pt>
                <c:pt idx="1681">
                  <c:v>682.5</c:v>
                </c:pt>
                <c:pt idx="1682">
                  <c:v>682.91</c:v>
                </c:pt>
                <c:pt idx="1683">
                  <c:v>683.32</c:v>
                </c:pt>
                <c:pt idx="1684">
                  <c:v>683.72</c:v>
                </c:pt>
                <c:pt idx="1685">
                  <c:v>684.13</c:v>
                </c:pt>
                <c:pt idx="1686">
                  <c:v>684.53</c:v>
                </c:pt>
                <c:pt idx="1687">
                  <c:v>684.94</c:v>
                </c:pt>
                <c:pt idx="1688">
                  <c:v>685.35</c:v>
                </c:pt>
                <c:pt idx="1689">
                  <c:v>685.75</c:v>
                </c:pt>
                <c:pt idx="1690">
                  <c:v>686.16</c:v>
                </c:pt>
                <c:pt idx="1691">
                  <c:v>686.56</c:v>
                </c:pt>
                <c:pt idx="1692">
                  <c:v>686.97</c:v>
                </c:pt>
                <c:pt idx="1693">
                  <c:v>687.37</c:v>
                </c:pt>
                <c:pt idx="1694">
                  <c:v>687.77</c:v>
                </c:pt>
                <c:pt idx="1695">
                  <c:v>688.18</c:v>
                </c:pt>
                <c:pt idx="1696">
                  <c:v>688.59</c:v>
                </c:pt>
                <c:pt idx="1697">
                  <c:v>689</c:v>
                </c:pt>
                <c:pt idx="1698">
                  <c:v>689.4</c:v>
                </c:pt>
                <c:pt idx="1699">
                  <c:v>689.81</c:v>
                </c:pt>
                <c:pt idx="1700">
                  <c:v>690.21</c:v>
                </c:pt>
                <c:pt idx="1701">
                  <c:v>690.62</c:v>
                </c:pt>
                <c:pt idx="1702">
                  <c:v>691.02</c:v>
                </c:pt>
                <c:pt idx="1703">
                  <c:v>691.43</c:v>
                </c:pt>
                <c:pt idx="1704">
                  <c:v>691.83</c:v>
                </c:pt>
                <c:pt idx="1705">
                  <c:v>692.24</c:v>
                </c:pt>
                <c:pt idx="1706">
                  <c:v>692.65</c:v>
                </c:pt>
                <c:pt idx="1707">
                  <c:v>693.05</c:v>
                </c:pt>
                <c:pt idx="1708">
                  <c:v>693.46</c:v>
                </c:pt>
                <c:pt idx="1709">
                  <c:v>693.86</c:v>
                </c:pt>
                <c:pt idx="1710">
                  <c:v>694.27</c:v>
                </c:pt>
                <c:pt idx="1711">
                  <c:v>694.67</c:v>
                </c:pt>
                <c:pt idx="1712">
                  <c:v>695.08</c:v>
                </c:pt>
                <c:pt idx="1713">
                  <c:v>695.48</c:v>
                </c:pt>
                <c:pt idx="1714">
                  <c:v>695.89</c:v>
                </c:pt>
                <c:pt idx="1715">
                  <c:v>696.3</c:v>
                </c:pt>
                <c:pt idx="1716">
                  <c:v>696.7</c:v>
                </c:pt>
                <c:pt idx="1717">
                  <c:v>697.11</c:v>
                </c:pt>
                <c:pt idx="1718">
                  <c:v>697.51</c:v>
                </c:pt>
                <c:pt idx="1719">
                  <c:v>697.91</c:v>
                </c:pt>
                <c:pt idx="1720">
                  <c:v>698.32</c:v>
                </c:pt>
                <c:pt idx="1721">
                  <c:v>698.73</c:v>
                </c:pt>
                <c:pt idx="1722">
                  <c:v>699.13</c:v>
                </c:pt>
                <c:pt idx="1723">
                  <c:v>699.54</c:v>
                </c:pt>
                <c:pt idx="1724">
                  <c:v>699.94</c:v>
                </c:pt>
                <c:pt idx="1725">
                  <c:v>700.35</c:v>
                </c:pt>
                <c:pt idx="1726">
                  <c:v>700.76</c:v>
                </c:pt>
                <c:pt idx="1727">
                  <c:v>701.16</c:v>
                </c:pt>
                <c:pt idx="1728">
                  <c:v>701.57</c:v>
                </c:pt>
                <c:pt idx="1729">
                  <c:v>701.97</c:v>
                </c:pt>
                <c:pt idx="1730">
                  <c:v>702.38</c:v>
                </c:pt>
                <c:pt idx="1731">
                  <c:v>702.79</c:v>
                </c:pt>
                <c:pt idx="1732">
                  <c:v>703.19</c:v>
                </c:pt>
                <c:pt idx="1733">
                  <c:v>703.6</c:v>
                </c:pt>
                <c:pt idx="1734">
                  <c:v>704</c:v>
                </c:pt>
                <c:pt idx="1735">
                  <c:v>704.41</c:v>
                </c:pt>
                <c:pt idx="1736">
                  <c:v>704.81</c:v>
                </c:pt>
                <c:pt idx="1737">
                  <c:v>705.22</c:v>
                </c:pt>
                <c:pt idx="1738">
                  <c:v>705.62</c:v>
                </c:pt>
                <c:pt idx="1739">
                  <c:v>706.03</c:v>
                </c:pt>
                <c:pt idx="1740">
                  <c:v>706.44</c:v>
                </c:pt>
                <c:pt idx="1741">
                  <c:v>706.84</c:v>
                </c:pt>
                <c:pt idx="1742">
                  <c:v>707.25</c:v>
                </c:pt>
                <c:pt idx="1743">
                  <c:v>707.65</c:v>
                </c:pt>
                <c:pt idx="1744">
                  <c:v>708.05</c:v>
                </c:pt>
                <c:pt idx="1745">
                  <c:v>708.46</c:v>
                </c:pt>
                <c:pt idx="1746">
                  <c:v>708.87</c:v>
                </c:pt>
                <c:pt idx="1747">
                  <c:v>709.28</c:v>
                </c:pt>
                <c:pt idx="1748">
                  <c:v>709.68</c:v>
                </c:pt>
                <c:pt idx="1749">
                  <c:v>710.08</c:v>
                </c:pt>
                <c:pt idx="1750">
                  <c:v>710.49</c:v>
                </c:pt>
                <c:pt idx="1751">
                  <c:v>710.9</c:v>
                </c:pt>
                <c:pt idx="1752">
                  <c:v>711.3</c:v>
                </c:pt>
                <c:pt idx="1753">
                  <c:v>711.71</c:v>
                </c:pt>
                <c:pt idx="1754">
                  <c:v>712.12</c:v>
                </c:pt>
                <c:pt idx="1755">
                  <c:v>712.52</c:v>
                </c:pt>
                <c:pt idx="1756">
                  <c:v>712.93</c:v>
                </c:pt>
                <c:pt idx="1757">
                  <c:v>713.33</c:v>
                </c:pt>
                <c:pt idx="1758">
                  <c:v>713.74</c:v>
                </c:pt>
                <c:pt idx="1759">
                  <c:v>714.14</c:v>
                </c:pt>
                <c:pt idx="1760">
                  <c:v>714.55</c:v>
                </c:pt>
                <c:pt idx="1761">
                  <c:v>714.96</c:v>
                </c:pt>
                <c:pt idx="1762">
                  <c:v>715.36</c:v>
                </c:pt>
                <c:pt idx="1763">
                  <c:v>715.77</c:v>
                </c:pt>
                <c:pt idx="1764">
                  <c:v>716.16</c:v>
                </c:pt>
                <c:pt idx="1765">
                  <c:v>716.58</c:v>
                </c:pt>
                <c:pt idx="1766">
                  <c:v>716.98</c:v>
                </c:pt>
                <c:pt idx="1767">
                  <c:v>717.39</c:v>
                </c:pt>
                <c:pt idx="1768">
                  <c:v>717.79</c:v>
                </c:pt>
                <c:pt idx="1769">
                  <c:v>718.2</c:v>
                </c:pt>
                <c:pt idx="1770">
                  <c:v>718.6</c:v>
                </c:pt>
                <c:pt idx="1771">
                  <c:v>719.01</c:v>
                </c:pt>
                <c:pt idx="1772">
                  <c:v>719.41</c:v>
                </c:pt>
                <c:pt idx="1773">
                  <c:v>719.82</c:v>
                </c:pt>
                <c:pt idx="1774">
                  <c:v>720.23</c:v>
                </c:pt>
                <c:pt idx="1775">
                  <c:v>720.63</c:v>
                </c:pt>
                <c:pt idx="1776">
                  <c:v>721.04</c:v>
                </c:pt>
                <c:pt idx="1777">
                  <c:v>721.44</c:v>
                </c:pt>
                <c:pt idx="1778">
                  <c:v>721.85</c:v>
                </c:pt>
                <c:pt idx="1779">
                  <c:v>722.26</c:v>
                </c:pt>
                <c:pt idx="1780">
                  <c:v>722.66</c:v>
                </c:pt>
                <c:pt idx="1781">
                  <c:v>723.07</c:v>
                </c:pt>
                <c:pt idx="1782">
                  <c:v>723.47</c:v>
                </c:pt>
                <c:pt idx="1783">
                  <c:v>723.88</c:v>
                </c:pt>
                <c:pt idx="1784">
                  <c:v>724.29</c:v>
                </c:pt>
                <c:pt idx="1785">
                  <c:v>724.69</c:v>
                </c:pt>
                <c:pt idx="1786">
                  <c:v>725.09</c:v>
                </c:pt>
                <c:pt idx="1787">
                  <c:v>725.5</c:v>
                </c:pt>
                <c:pt idx="1788">
                  <c:v>725.9</c:v>
                </c:pt>
                <c:pt idx="1789">
                  <c:v>726.31</c:v>
                </c:pt>
                <c:pt idx="1790">
                  <c:v>726.72</c:v>
                </c:pt>
                <c:pt idx="1791">
                  <c:v>727.12</c:v>
                </c:pt>
                <c:pt idx="1792">
                  <c:v>727.53</c:v>
                </c:pt>
                <c:pt idx="1793">
                  <c:v>727.93</c:v>
                </c:pt>
                <c:pt idx="1794">
                  <c:v>728.34</c:v>
                </c:pt>
                <c:pt idx="1795">
                  <c:v>728.74</c:v>
                </c:pt>
                <c:pt idx="1796">
                  <c:v>729.15</c:v>
                </c:pt>
                <c:pt idx="1797">
                  <c:v>729.56</c:v>
                </c:pt>
                <c:pt idx="1798">
                  <c:v>729.96</c:v>
                </c:pt>
                <c:pt idx="1799">
                  <c:v>730.36</c:v>
                </c:pt>
                <c:pt idx="1800">
                  <c:v>730.77</c:v>
                </c:pt>
                <c:pt idx="1801">
                  <c:v>731.18</c:v>
                </c:pt>
                <c:pt idx="1802">
                  <c:v>731.58</c:v>
                </c:pt>
                <c:pt idx="1803">
                  <c:v>731.99</c:v>
                </c:pt>
                <c:pt idx="1804">
                  <c:v>732.4</c:v>
                </c:pt>
                <c:pt idx="1805">
                  <c:v>732.8</c:v>
                </c:pt>
                <c:pt idx="1806">
                  <c:v>733.21</c:v>
                </c:pt>
                <c:pt idx="1807">
                  <c:v>733.61</c:v>
                </c:pt>
                <c:pt idx="1808">
                  <c:v>734.02</c:v>
                </c:pt>
                <c:pt idx="1809">
                  <c:v>734.43</c:v>
                </c:pt>
                <c:pt idx="1810">
                  <c:v>734.83</c:v>
                </c:pt>
                <c:pt idx="1811">
                  <c:v>735.23</c:v>
                </c:pt>
                <c:pt idx="1812">
                  <c:v>735.64</c:v>
                </c:pt>
                <c:pt idx="1813">
                  <c:v>736.05</c:v>
                </c:pt>
                <c:pt idx="1814">
                  <c:v>736.46</c:v>
                </c:pt>
                <c:pt idx="1815">
                  <c:v>736.86</c:v>
                </c:pt>
                <c:pt idx="1816">
                  <c:v>737.26</c:v>
                </c:pt>
                <c:pt idx="1817">
                  <c:v>737.67</c:v>
                </c:pt>
                <c:pt idx="1818">
                  <c:v>738.07</c:v>
                </c:pt>
                <c:pt idx="1819">
                  <c:v>738.48</c:v>
                </c:pt>
                <c:pt idx="1820">
                  <c:v>738.88</c:v>
                </c:pt>
                <c:pt idx="1821">
                  <c:v>739.29</c:v>
                </c:pt>
                <c:pt idx="1822">
                  <c:v>739.69</c:v>
                </c:pt>
                <c:pt idx="1823">
                  <c:v>740.1</c:v>
                </c:pt>
                <c:pt idx="1824">
                  <c:v>740.51</c:v>
                </c:pt>
                <c:pt idx="1825">
                  <c:v>740.91</c:v>
                </c:pt>
                <c:pt idx="1826">
                  <c:v>741.32</c:v>
                </c:pt>
                <c:pt idx="1827">
                  <c:v>741.72</c:v>
                </c:pt>
                <c:pt idx="1828">
                  <c:v>742.13</c:v>
                </c:pt>
                <c:pt idx="1829">
                  <c:v>742.54</c:v>
                </c:pt>
                <c:pt idx="1830">
                  <c:v>742.94</c:v>
                </c:pt>
                <c:pt idx="1831">
                  <c:v>743.35</c:v>
                </c:pt>
                <c:pt idx="1832">
                  <c:v>743.75</c:v>
                </c:pt>
                <c:pt idx="1833">
                  <c:v>744.16</c:v>
                </c:pt>
                <c:pt idx="1834">
                  <c:v>744.57</c:v>
                </c:pt>
                <c:pt idx="1835">
                  <c:v>744.97</c:v>
                </c:pt>
                <c:pt idx="1836">
                  <c:v>745.37</c:v>
                </c:pt>
                <c:pt idx="1837">
                  <c:v>745.78</c:v>
                </c:pt>
                <c:pt idx="1838">
                  <c:v>746.19</c:v>
                </c:pt>
                <c:pt idx="1839">
                  <c:v>746.59</c:v>
                </c:pt>
                <c:pt idx="1840">
                  <c:v>747</c:v>
                </c:pt>
                <c:pt idx="1841">
                  <c:v>747.4</c:v>
                </c:pt>
                <c:pt idx="1842">
                  <c:v>747.81</c:v>
                </c:pt>
                <c:pt idx="1843">
                  <c:v>748.21</c:v>
                </c:pt>
                <c:pt idx="1844">
                  <c:v>748.62</c:v>
                </c:pt>
                <c:pt idx="1845">
                  <c:v>749.02</c:v>
                </c:pt>
                <c:pt idx="1846">
                  <c:v>749.43</c:v>
                </c:pt>
                <c:pt idx="1847">
                  <c:v>749.84</c:v>
                </c:pt>
                <c:pt idx="1848">
                  <c:v>750.24</c:v>
                </c:pt>
                <c:pt idx="1849">
                  <c:v>750.65</c:v>
                </c:pt>
                <c:pt idx="1850">
                  <c:v>751.05</c:v>
                </c:pt>
                <c:pt idx="1851">
                  <c:v>751.46</c:v>
                </c:pt>
                <c:pt idx="1852">
                  <c:v>751.86</c:v>
                </c:pt>
                <c:pt idx="1853">
                  <c:v>752.27</c:v>
                </c:pt>
                <c:pt idx="1854">
                  <c:v>752.67</c:v>
                </c:pt>
                <c:pt idx="1855">
                  <c:v>753.08</c:v>
                </c:pt>
                <c:pt idx="1856">
                  <c:v>753.48</c:v>
                </c:pt>
                <c:pt idx="1857">
                  <c:v>753.89</c:v>
                </c:pt>
                <c:pt idx="1858">
                  <c:v>754.3</c:v>
                </c:pt>
                <c:pt idx="1859">
                  <c:v>754.71</c:v>
                </c:pt>
                <c:pt idx="1860">
                  <c:v>755.1</c:v>
                </c:pt>
                <c:pt idx="1861">
                  <c:v>755.51</c:v>
                </c:pt>
                <c:pt idx="1862">
                  <c:v>755.92</c:v>
                </c:pt>
                <c:pt idx="1863">
                  <c:v>756.33</c:v>
                </c:pt>
                <c:pt idx="1864">
                  <c:v>756.74</c:v>
                </c:pt>
                <c:pt idx="1865">
                  <c:v>757.14</c:v>
                </c:pt>
                <c:pt idx="1866">
                  <c:v>757.54</c:v>
                </c:pt>
                <c:pt idx="1867">
                  <c:v>757.95</c:v>
                </c:pt>
                <c:pt idx="1868">
                  <c:v>758.35</c:v>
                </c:pt>
                <c:pt idx="1869">
                  <c:v>758.76</c:v>
                </c:pt>
                <c:pt idx="1870">
                  <c:v>759.16</c:v>
                </c:pt>
                <c:pt idx="1871">
                  <c:v>759.57</c:v>
                </c:pt>
                <c:pt idx="1872">
                  <c:v>759.98</c:v>
                </c:pt>
                <c:pt idx="1873">
                  <c:v>760.38</c:v>
                </c:pt>
                <c:pt idx="1874">
                  <c:v>760.79</c:v>
                </c:pt>
                <c:pt idx="1875">
                  <c:v>761.19</c:v>
                </c:pt>
                <c:pt idx="1876">
                  <c:v>761.6</c:v>
                </c:pt>
                <c:pt idx="1877">
                  <c:v>762</c:v>
                </c:pt>
                <c:pt idx="1878">
                  <c:v>762.41</c:v>
                </c:pt>
                <c:pt idx="1879">
                  <c:v>762.82</c:v>
                </c:pt>
                <c:pt idx="1880">
                  <c:v>763.22</c:v>
                </c:pt>
                <c:pt idx="1881">
                  <c:v>763.63</c:v>
                </c:pt>
                <c:pt idx="1882">
                  <c:v>764.03</c:v>
                </c:pt>
                <c:pt idx="1883">
                  <c:v>764.44</c:v>
                </c:pt>
                <c:pt idx="1884">
                  <c:v>764.85</c:v>
                </c:pt>
                <c:pt idx="1885">
                  <c:v>765.25</c:v>
                </c:pt>
                <c:pt idx="1886">
                  <c:v>765.65</c:v>
                </c:pt>
                <c:pt idx="1887">
                  <c:v>766.06</c:v>
                </c:pt>
                <c:pt idx="1888">
                  <c:v>766.47</c:v>
                </c:pt>
                <c:pt idx="1889">
                  <c:v>766.87</c:v>
                </c:pt>
                <c:pt idx="1890">
                  <c:v>767.28</c:v>
                </c:pt>
                <c:pt idx="1891">
                  <c:v>767.68</c:v>
                </c:pt>
                <c:pt idx="1892">
                  <c:v>768.09</c:v>
                </c:pt>
                <c:pt idx="1893">
                  <c:v>768.49</c:v>
                </c:pt>
                <c:pt idx="1894">
                  <c:v>768.9</c:v>
                </c:pt>
                <c:pt idx="1895">
                  <c:v>769.3</c:v>
                </c:pt>
                <c:pt idx="1896">
                  <c:v>769.71</c:v>
                </c:pt>
                <c:pt idx="1897">
                  <c:v>770.12</c:v>
                </c:pt>
                <c:pt idx="1898">
                  <c:v>770.52</c:v>
                </c:pt>
                <c:pt idx="1899">
                  <c:v>770.93</c:v>
                </c:pt>
                <c:pt idx="1900">
                  <c:v>771.33</c:v>
                </c:pt>
                <c:pt idx="1901">
                  <c:v>771.74</c:v>
                </c:pt>
                <c:pt idx="1902">
                  <c:v>772.14</c:v>
                </c:pt>
                <c:pt idx="1903">
                  <c:v>772.55</c:v>
                </c:pt>
                <c:pt idx="1904">
                  <c:v>772.96</c:v>
                </c:pt>
                <c:pt idx="1905">
                  <c:v>773.36</c:v>
                </c:pt>
                <c:pt idx="1906">
                  <c:v>773.77</c:v>
                </c:pt>
                <c:pt idx="1907">
                  <c:v>774.17</c:v>
                </c:pt>
                <c:pt idx="1908">
                  <c:v>774.58</c:v>
                </c:pt>
                <c:pt idx="1909">
                  <c:v>774.99</c:v>
                </c:pt>
                <c:pt idx="1910">
                  <c:v>775.39</c:v>
                </c:pt>
                <c:pt idx="1911">
                  <c:v>775.79</c:v>
                </c:pt>
                <c:pt idx="1912">
                  <c:v>776.2</c:v>
                </c:pt>
                <c:pt idx="1913">
                  <c:v>776.6</c:v>
                </c:pt>
                <c:pt idx="1914">
                  <c:v>777.01</c:v>
                </c:pt>
                <c:pt idx="1915">
                  <c:v>777.42</c:v>
                </c:pt>
                <c:pt idx="1916">
                  <c:v>777.82</c:v>
                </c:pt>
                <c:pt idx="1917">
                  <c:v>778.23</c:v>
                </c:pt>
                <c:pt idx="1918">
                  <c:v>778.63</c:v>
                </c:pt>
                <c:pt idx="1919">
                  <c:v>779.04</c:v>
                </c:pt>
                <c:pt idx="1920">
                  <c:v>779.44</c:v>
                </c:pt>
                <c:pt idx="1921">
                  <c:v>779.85</c:v>
                </c:pt>
                <c:pt idx="1922">
                  <c:v>780.26</c:v>
                </c:pt>
                <c:pt idx="1923">
                  <c:v>780.66</c:v>
                </c:pt>
                <c:pt idx="1924">
                  <c:v>781.07</c:v>
                </c:pt>
                <c:pt idx="1925">
                  <c:v>781.47</c:v>
                </c:pt>
                <c:pt idx="1926">
                  <c:v>781.88</c:v>
                </c:pt>
                <c:pt idx="1927">
                  <c:v>782.28</c:v>
                </c:pt>
                <c:pt idx="1928">
                  <c:v>782.69</c:v>
                </c:pt>
                <c:pt idx="1929">
                  <c:v>783.1</c:v>
                </c:pt>
                <c:pt idx="1930">
                  <c:v>783.5</c:v>
                </c:pt>
                <c:pt idx="1931">
                  <c:v>783.91</c:v>
                </c:pt>
                <c:pt idx="1932">
                  <c:v>784.31</c:v>
                </c:pt>
                <c:pt idx="1933">
                  <c:v>784.72</c:v>
                </c:pt>
                <c:pt idx="1934">
                  <c:v>785.13</c:v>
                </c:pt>
                <c:pt idx="1935">
                  <c:v>785.53</c:v>
                </c:pt>
                <c:pt idx="1936">
                  <c:v>785.94</c:v>
                </c:pt>
                <c:pt idx="1937">
                  <c:v>786.34</c:v>
                </c:pt>
                <c:pt idx="1938">
                  <c:v>786.74</c:v>
                </c:pt>
                <c:pt idx="1939">
                  <c:v>787.15</c:v>
                </c:pt>
                <c:pt idx="1940">
                  <c:v>787.56</c:v>
                </c:pt>
                <c:pt idx="1941">
                  <c:v>787.96</c:v>
                </c:pt>
                <c:pt idx="1942">
                  <c:v>788.37</c:v>
                </c:pt>
                <c:pt idx="1943">
                  <c:v>788.77</c:v>
                </c:pt>
                <c:pt idx="1944">
                  <c:v>789.18</c:v>
                </c:pt>
                <c:pt idx="1945">
                  <c:v>789.58</c:v>
                </c:pt>
                <c:pt idx="1946">
                  <c:v>789.99</c:v>
                </c:pt>
                <c:pt idx="1947">
                  <c:v>790.4</c:v>
                </c:pt>
                <c:pt idx="1948">
                  <c:v>790.8</c:v>
                </c:pt>
                <c:pt idx="1949">
                  <c:v>791.2</c:v>
                </c:pt>
                <c:pt idx="1950">
                  <c:v>791.61</c:v>
                </c:pt>
                <c:pt idx="1951">
                  <c:v>792.02</c:v>
                </c:pt>
                <c:pt idx="1952">
                  <c:v>792.42</c:v>
                </c:pt>
                <c:pt idx="1953">
                  <c:v>792.83</c:v>
                </c:pt>
                <c:pt idx="1954">
                  <c:v>793.23</c:v>
                </c:pt>
                <c:pt idx="1955">
                  <c:v>793.64</c:v>
                </c:pt>
                <c:pt idx="1956">
                  <c:v>794.05</c:v>
                </c:pt>
                <c:pt idx="1957">
                  <c:v>794.45</c:v>
                </c:pt>
                <c:pt idx="1958">
                  <c:v>794.86</c:v>
                </c:pt>
                <c:pt idx="1959">
                  <c:v>795.26</c:v>
                </c:pt>
                <c:pt idx="1960">
                  <c:v>795.67</c:v>
                </c:pt>
                <c:pt idx="1961">
                  <c:v>796.07</c:v>
                </c:pt>
                <c:pt idx="1962">
                  <c:v>796.48</c:v>
                </c:pt>
                <c:pt idx="1963">
                  <c:v>796.88</c:v>
                </c:pt>
                <c:pt idx="1964">
                  <c:v>797.29</c:v>
                </c:pt>
                <c:pt idx="1965">
                  <c:v>797.7</c:v>
                </c:pt>
                <c:pt idx="1966">
                  <c:v>798.1</c:v>
                </c:pt>
                <c:pt idx="1967">
                  <c:v>798.51</c:v>
                </c:pt>
                <c:pt idx="1968">
                  <c:v>798.91</c:v>
                </c:pt>
                <c:pt idx="1969">
                  <c:v>799.32</c:v>
                </c:pt>
                <c:pt idx="1970">
                  <c:v>799.72</c:v>
                </c:pt>
                <c:pt idx="1971">
                  <c:v>800.13</c:v>
                </c:pt>
                <c:pt idx="1972">
                  <c:v>800.54</c:v>
                </c:pt>
                <c:pt idx="1973">
                  <c:v>800.94</c:v>
                </c:pt>
                <c:pt idx="1974">
                  <c:v>801.35</c:v>
                </c:pt>
                <c:pt idx="1975">
                  <c:v>801.75</c:v>
                </c:pt>
                <c:pt idx="1976">
                  <c:v>802.16</c:v>
                </c:pt>
                <c:pt idx="1977">
                  <c:v>802.56</c:v>
                </c:pt>
                <c:pt idx="1978">
                  <c:v>802.97</c:v>
                </c:pt>
                <c:pt idx="1979">
                  <c:v>803.37</c:v>
                </c:pt>
                <c:pt idx="1980">
                  <c:v>803.78</c:v>
                </c:pt>
                <c:pt idx="1981">
                  <c:v>804.19</c:v>
                </c:pt>
                <c:pt idx="1982">
                  <c:v>804.59</c:v>
                </c:pt>
                <c:pt idx="1983">
                  <c:v>805</c:v>
                </c:pt>
                <c:pt idx="1984">
                  <c:v>805.4</c:v>
                </c:pt>
                <c:pt idx="1985">
                  <c:v>805.81</c:v>
                </c:pt>
                <c:pt idx="1986">
                  <c:v>806.21</c:v>
                </c:pt>
                <c:pt idx="1987">
                  <c:v>806.62</c:v>
                </c:pt>
                <c:pt idx="1988">
                  <c:v>807.03</c:v>
                </c:pt>
                <c:pt idx="1989">
                  <c:v>807.43</c:v>
                </c:pt>
                <c:pt idx="1990">
                  <c:v>807.84</c:v>
                </c:pt>
                <c:pt idx="1991">
                  <c:v>808.24</c:v>
                </c:pt>
                <c:pt idx="1992">
                  <c:v>808.65</c:v>
                </c:pt>
                <c:pt idx="1993">
                  <c:v>809.05</c:v>
                </c:pt>
                <c:pt idx="1994">
                  <c:v>809.46</c:v>
                </c:pt>
                <c:pt idx="1995">
                  <c:v>809.86</c:v>
                </c:pt>
                <c:pt idx="1996">
                  <c:v>810.27</c:v>
                </c:pt>
                <c:pt idx="1997">
                  <c:v>810.68</c:v>
                </c:pt>
                <c:pt idx="1998">
                  <c:v>811.08</c:v>
                </c:pt>
                <c:pt idx="1999">
                  <c:v>811.49</c:v>
                </c:pt>
                <c:pt idx="2000">
                  <c:v>811.89</c:v>
                </c:pt>
                <c:pt idx="2001">
                  <c:v>812.3</c:v>
                </c:pt>
                <c:pt idx="2002">
                  <c:v>812.7</c:v>
                </c:pt>
                <c:pt idx="2003">
                  <c:v>813.11</c:v>
                </c:pt>
                <c:pt idx="2004">
                  <c:v>813.51</c:v>
                </c:pt>
                <c:pt idx="2005">
                  <c:v>813.92</c:v>
                </c:pt>
                <c:pt idx="2006">
                  <c:v>814.33</c:v>
                </c:pt>
                <c:pt idx="2007">
                  <c:v>814.73</c:v>
                </c:pt>
                <c:pt idx="2008">
                  <c:v>815.14</c:v>
                </c:pt>
                <c:pt idx="2009">
                  <c:v>815.55</c:v>
                </c:pt>
                <c:pt idx="2010">
                  <c:v>815.95</c:v>
                </c:pt>
                <c:pt idx="2011">
                  <c:v>816.35</c:v>
                </c:pt>
                <c:pt idx="2012">
                  <c:v>816.76</c:v>
                </c:pt>
                <c:pt idx="2013">
                  <c:v>817.17</c:v>
                </c:pt>
                <c:pt idx="2014">
                  <c:v>817.57</c:v>
                </c:pt>
                <c:pt idx="2015">
                  <c:v>817.98</c:v>
                </c:pt>
                <c:pt idx="2016">
                  <c:v>818.38</c:v>
                </c:pt>
                <c:pt idx="2017">
                  <c:v>818.79</c:v>
                </c:pt>
                <c:pt idx="2018">
                  <c:v>819.2</c:v>
                </c:pt>
                <c:pt idx="2019">
                  <c:v>819.6</c:v>
                </c:pt>
                <c:pt idx="2020">
                  <c:v>820</c:v>
                </c:pt>
                <c:pt idx="2021">
                  <c:v>820.41</c:v>
                </c:pt>
                <c:pt idx="2022">
                  <c:v>820.82</c:v>
                </c:pt>
                <c:pt idx="2023">
                  <c:v>821.22</c:v>
                </c:pt>
                <c:pt idx="2024">
                  <c:v>821.63</c:v>
                </c:pt>
                <c:pt idx="2025">
                  <c:v>822.03</c:v>
                </c:pt>
                <c:pt idx="2026">
                  <c:v>822.44</c:v>
                </c:pt>
                <c:pt idx="2027">
                  <c:v>822.84</c:v>
                </c:pt>
                <c:pt idx="2028">
                  <c:v>823.25</c:v>
                </c:pt>
                <c:pt idx="2029">
                  <c:v>823.66</c:v>
                </c:pt>
                <c:pt idx="2030">
                  <c:v>824.06</c:v>
                </c:pt>
                <c:pt idx="2031">
                  <c:v>824.47</c:v>
                </c:pt>
                <c:pt idx="2032">
                  <c:v>824.87</c:v>
                </c:pt>
                <c:pt idx="2033">
                  <c:v>825.28</c:v>
                </c:pt>
                <c:pt idx="2034">
                  <c:v>825.68</c:v>
                </c:pt>
                <c:pt idx="2035">
                  <c:v>826.09</c:v>
                </c:pt>
                <c:pt idx="2036">
                  <c:v>826.49</c:v>
                </c:pt>
                <c:pt idx="2037">
                  <c:v>826.9</c:v>
                </c:pt>
                <c:pt idx="2038">
                  <c:v>827.31</c:v>
                </c:pt>
                <c:pt idx="2039">
                  <c:v>827.71</c:v>
                </c:pt>
                <c:pt idx="2040">
                  <c:v>828.12</c:v>
                </c:pt>
                <c:pt idx="2041">
                  <c:v>828.52</c:v>
                </c:pt>
                <c:pt idx="2042">
                  <c:v>828.93</c:v>
                </c:pt>
                <c:pt idx="2043">
                  <c:v>829.33</c:v>
                </c:pt>
                <c:pt idx="2044">
                  <c:v>829.74</c:v>
                </c:pt>
                <c:pt idx="2045">
                  <c:v>830.14</c:v>
                </c:pt>
                <c:pt idx="2046">
                  <c:v>830.55</c:v>
                </c:pt>
                <c:pt idx="2047">
                  <c:v>830.95</c:v>
                </c:pt>
                <c:pt idx="2048">
                  <c:v>831.36</c:v>
                </c:pt>
                <c:pt idx="2049">
                  <c:v>831.77</c:v>
                </c:pt>
                <c:pt idx="2050">
                  <c:v>832.17</c:v>
                </c:pt>
                <c:pt idx="2051">
                  <c:v>832.58</c:v>
                </c:pt>
                <c:pt idx="2052">
                  <c:v>832.98</c:v>
                </c:pt>
                <c:pt idx="2053">
                  <c:v>833.39</c:v>
                </c:pt>
                <c:pt idx="2054">
                  <c:v>833.8</c:v>
                </c:pt>
                <c:pt idx="2055">
                  <c:v>834.2</c:v>
                </c:pt>
                <c:pt idx="2056">
                  <c:v>834.61</c:v>
                </c:pt>
                <c:pt idx="2057">
                  <c:v>835.01</c:v>
                </c:pt>
                <c:pt idx="2058">
                  <c:v>835.42</c:v>
                </c:pt>
                <c:pt idx="2059">
                  <c:v>835.82</c:v>
                </c:pt>
                <c:pt idx="2060">
                  <c:v>836.23</c:v>
                </c:pt>
                <c:pt idx="2061">
                  <c:v>836.63</c:v>
                </c:pt>
                <c:pt idx="2062">
                  <c:v>837.04</c:v>
                </c:pt>
                <c:pt idx="2063">
                  <c:v>837.45</c:v>
                </c:pt>
                <c:pt idx="2064">
                  <c:v>837.85</c:v>
                </c:pt>
                <c:pt idx="2065">
                  <c:v>838.26</c:v>
                </c:pt>
                <c:pt idx="2066">
                  <c:v>838.66</c:v>
                </c:pt>
                <c:pt idx="2067">
                  <c:v>839.07</c:v>
                </c:pt>
                <c:pt idx="2068">
                  <c:v>839.47</c:v>
                </c:pt>
                <c:pt idx="2069">
                  <c:v>839.88</c:v>
                </c:pt>
                <c:pt idx="2070">
                  <c:v>840.28</c:v>
                </c:pt>
                <c:pt idx="2071">
                  <c:v>840.69</c:v>
                </c:pt>
                <c:pt idx="2072">
                  <c:v>841.1</c:v>
                </c:pt>
                <c:pt idx="2073">
                  <c:v>841.5</c:v>
                </c:pt>
                <c:pt idx="2074">
                  <c:v>841.91</c:v>
                </c:pt>
                <c:pt idx="2075">
                  <c:v>842.31</c:v>
                </c:pt>
                <c:pt idx="2076">
                  <c:v>842.72</c:v>
                </c:pt>
                <c:pt idx="2077">
                  <c:v>843.12</c:v>
                </c:pt>
                <c:pt idx="2078">
                  <c:v>843.52</c:v>
                </c:pt>
                <c:pt idx="2079">
                  <c:v>843.94</c:v>
                </c:pt>
                <c:pt idx="2080">
                  <c:v>844.34</c:v>
                </c:pt>
                <c:pt idx="2081">
                  <c:v>844.75</c:v>
                </c:pt>
                <c:pt idx="2082">
                  <c:v>845.15</c:v>
                </c:pt>
                <c:pt idx="2083">
                  <c:v>845.56</c:v>
                </c:pt>
                <c:pt idx="2084">
                  <c:v>845.97</c:v>
                </c:pt>
                <c:pt idx="2085">
                  <c:v>846.37</c:v>
                </c:pt>
                <c:pt idx="2086">
                  <c:v>846.77</c:v>
                </c:pt>
                <c:pt idx="2087">
                  <c:v>847.18</c:v>
                </c:pt>
                <c:pt idx="2088">
                  <c:v>847.59</c:v>
                </c:pt>
                <c:pt idx="2089">
                  <c:v>847.99</c:v>
                </c:pt>
                <c:pt idx="2090">
                  <c:v>848.4</c:v>
                </c:pt>
                <c:pt idx="2091">
                  <c:v>848.8</c:v>
                </c:pt>
                <c:pt idx="2092">
                  <c:v>849.21</c:v>
                </c:pt>
                <c:pt idx="2093">
                  <c:v>849.61</c:v>
                </c:pt>
                <c:pt idx="2094">
                  <c:v>850.01</c:v>
                </c:pt>
                <c:pt idx="2095">
                  <c:v>850.42</c:v>
                </c:pt>
                <c:pt idx="2096">
                  <c:v>850.83</c:v>
                </c:pt>
                <c:pt idx="2097">
                  <c:v>851.24</c:v>
                </c:pt>
                <c:pt idx="2098">
                  <c:v>851.64</c:v>
                </c:pt>
                <c:pt idx="2099">
                  <c:v>852.05</c:v>
                </c:pt>
                <c:pt idx="2100">
                  <c:v>852.45</c:v>
                </c:pt>
                <c:pt idx="2101">
                  <c:v>852.86</c:v>
                </c:pt>
                <c:pt idx="2102">
                  <c:v>853.26</c:v>
                </c:pt>
                <c:pt idx="2103">
                  <c:v>853.67</c:v>
                </c:pt>
                <c:pt idx="2104">
                  <c:v>854.07</c:v>
                </c:pt>
                <c:pt idx="2105">
                  <c:v>854.48</c:v>
                </c:pt>
                <c:pt idx="2106">
                  <c:v>854.89</c:v>
                </c:pt>
                <c:pt idx="2107">
                  <c:v>855.29</c:v>
                </c:pt>
                <c:pt idx="2108">
                  <c:v>855.7</c:v>
                </c:pt>
                <c:pt idx="2109">
                  <c:v>856.11</c:v>
                </c:pt>
                <c:pt idx="2110">
                  <c:v>856.51</c:v>
                </c:pt>
                <c:pt idx="2111">
                  <c:v>856.91</c:v>
                </c:pt>
                <c:pt idx="2112">
                  <c:v>857.32</c:v>
                </c:pt>
                <c:pt idx="2113">
                  <c:v>857.73</c:v>
                </c:pt>
                <c:pt idx="2114">
                  <c:v>858.13</c:v>
                </c:pt>
                <c:pt idx="2115">
                  <c:v>858.54</c:v>
                </c:pt>
                <c:pt idx="2116">
                  <c:v>858.94</c:v>
                </c:pt>
                <c:pt idx="2117">
                  <c:v>859.35</c:v>
                </c:pt>
                <c:pt idx="2118">
                  <c:v>859.75</c:v>
                </c:pt>
                <c:pt idx="2119">
                  <c:v>860.15</c:v>
                </c:pt>
                <c:pt idx="2120">
                  <c:v>860.56</c:v>
                </c:pt>
                <c:pt idx="2121">
                  <c:v>860.97</c:v>
                </c:pt>
                <c:pt idx="2122">
                  <c:v>861.38</c:v>
                </c:pt>
                <c:pt idx="2123">
                  <c:v>861.78</c:v>
                </c:pt>
                <c:pt idx="2124">
                  <c:v>862.19</c:v>
                </c:pt>
                <c:pt idx="2125">
                  <c:v>862.59</c:v>
                </c:pt>
                <c:pt idx="2126">
                  <c:v>863</c:v>
                </c:pt>
                <c:pt idx="2127">
                  <c:v>863.4</c:v>
                </c:pt>
                <c:pt idx="2128">
                  <c:v>863.81</c:v>
                </c:pt>
                <c:pt idx="2129">
                  <c:v>864.21</c:v>
                </c:pt>
                <c:pt idx="2130">
                  <c:v>864.62</c:v>
                </c:pt>
                <c:pt idx="2131">
                  <c:v>865.03</c:v>
                </c:pt>
                <c:pt idx="2132">
                  <c:v>865.43</c:v>
                </c:pt>
                <c:pt idx="2133">
                  <c:v>865.84</c:v>
                </c:pt>
                <c:pt idx="2134">
                  <c:v>866.24</c:v>
                </c:pt>
                <c:pt idx="2135">
                  <c:v>866.65</c:v>
                </c:pt>
                <c:pt idx="2136">
                  <c:v>867.05</c:v>
                </c:pt>
                <c:pt idx="2137">
                  <c:v>867.46</c:v>
                </c:pt>
                <c:pt idx="2138">
                  <c:v>867.87</c:v>
                </c:pt>
                <c:pt idx="2139">
                  <c:v>868.27</c:v>
                </c:pt>
                <c:pt idx="2140">
                  <c:v>868.68</c:v>
                </c:pt>
                <c:pt idx="2141">
                  <c:v>869.08</c:v>
                </c:pt>
                <c:pt idx="2142">
                  <c:v>869.49</c:v>
                </c:pt>
                <c:pt idx="2143">
                  <c:v>869.89</c:v>
                </c:pt>
                <c:pt idx="2144">
                  <c:v>870.3</c:v>
                </c:pt>
                <c:pt idx="2145">
                  <c:v>870.7</c:v>
                </c:pt>
                <c:pt idx="2146">
                  <c:v>871.11</c:v>
                </c:pt>
                <c:pt idx="2147">
                  <c:v>871.52</c:v>
                </c:pt>
                <c:pt idx="2148">
                  <c:v>871.92</c:v>
                </c:pt>
                <c:pt idx="2149">
                  <c:v>872.32</c:v>
                </c:pt>
                <c:pt idx="2150">
                  <c:v>872.73</c:v>
                </c:pt>
                <c:pt idx="2151">
                  <c:v>873.14</c:v>
                </c:pt>
                <c:pt idx="2152">
                  <c:v>873.54</c:v>
                </c:pt>
                <c:pt idx="2153">
                  <c:v>873.95</c:v>
                </c:pt>
                <c:pt idx="2154">
                  <c:v>874.36</c:v>
                </c:pt>
                <c:pt idx="2155">
                  <c:v>874.76</c:v>
                </c:pt>
                <c:pt idx="2156">
                  <c:v>875.17</c:v>
                </c:pt>
                <c:pt idx="2157">
                  <c:v>875.57</c:v>
                </c:pt>
                <c:pt idx="2158">
                  <c:v>875.98</c:v>
                </c:pt>
                <c:pt idx="2159">
                  <c:v>876.39</c:v>
                </c:pt>
                <c:pt idx="2160">
                  <c:v>876.79</c:v>
                </c:pt>
                <c:pt idx="2161">
                  <c:v>877.19</c:v>
                </c:pt>
                <c:pt idx="2162">
                  <c:v>877.6</c:v>
                </c:pt>
                <c:pt idx="2163">
                  <c:v>878.01</c:v>
                </c:pt>
                <c:pt idx="2164">
                  <c:v>878.42</c:v>
                </c:pt>
                <c:pt idx="2165">
                  <c:v>878.82</c:v>
                </c:pt>
                <c:pt idx="2166">
                  <c:v>879.22</c:v>
                </c:pt>
                <c:pt idx="2167">
                  <c:v>879.63</c:v>
                </c:pt>
                <c:pt idx="2168">
                  <c:v>880.03</c:v>
                </c:pt>
                <c:pt idx="2169">
                  <c:v>880.43</c:v>
                </c:pt>
                <c:pt idx="2170">
                  <c:v>880.84</c:v>
                </c:pt>
                <c:pt idx="2171">
                  <c:v>881.25</c:v>
                </c:pt>
                <c:pt idx="2172">
                  <c:v>881.66</c:v>
                </c:pt>
                <c:pt idx="2173">
                  <c:v>882.06</c:v>
                </c:pt>
                <c:pt idx="2174">
                  <c:v>882.47</c:v>
                </c:pt>
                <c:pt idx="2175">
                  <c:v>882.87</c:v>
                </c:pt>
                <c:pt idx="2176">
                  <c:v>883.28</c:v>
                </c:pt>
                <c:pt idx="2177">
                  <c:v>883.68</c:v>
                </c:pt>
                <c:pt idx="2178">
                  <c:v>884.09</c:v>
                </c:pt>
                <c:pt idx="2179">
                  <c:v>884.49</c:v>
                </c:pt>
                <c:pt idx="2180">
                  <c:v>884.9</c:v>
                </c:pt>
                <c:pt idx="2181">
                  <c:v>885.31</c:v>
                </c:pt>
                <c:pt idx="2182">
                  <c:v>885.71</c:v>
                </c:pt>
                <c:pt idx="2183">
                  <c:v>886.12</c:v>
                </c:pt>
                <c:pt idx="2184">
                  <c:v>886.53</c:v>
                </c:pt>
                <c:pt idx="2185">
                  <c:v>886.93</c:v>
                </c:pt>
                <c:pt idx="2186">
                  <c:v>887.33</c:v>
                </c:pt>
                <c:pt idx="2187">
                  <c:v>887.74</c:v>
                </c:pt>
                <c:pt idx="2188">
                  <c:v>888.15</c:v>
                </c:pt>
                <c:pt idx="2189">
                  <c:v>888.55</c:v>
                </c:pt>
                <c:pt idx="2190">
                  <c:v>888.96</c:v>
                </c:pt>
                <c:pt idx="2191">
                  <c:v>889.36</c:v>
                </c:pt>
                <c:pt idx="2192">
                  <c:v>889.77</c:v>
                </c:pt>
                <c:pt idx="2193">
                  <c:v>890.17</c:v>
                </c:pt>
                <c:pt idx="2194">
                  <c:v>890.58</c:v>
                </c:pt>
                <c:pt idx="2195">
                  <c:v>890.99</c:v>
                </c:pt>
                <c:pt idx="2196">
                  <c:v>891.39</c:v>
                </c:pt>
                <c:pt idx="2197">
                  <c:v>891.8</c:v>
                </c:pt>
                <c:pt idx="2198">
                  <c:v>892.2</c:v>
                </c:pt>
                <c:pt idx="2199">
                  <c:v>892.61</c:v>
                </c:pt>
                <c:pt idx="2200">
                  <c:v>893.01</c:v>
                </c:pt>
                <c:pt idx="2201">
                  <c:v>893.42</c:v>
                </c:pt>
                <c:pt idx="2202">
                  <c:v>893.82</c:v>
                </c:pt>
                <c:pt idx="2203">
                  <c:v>894.23</c:v>
                </c:pt>
                <c:pt idx="2204">
                  <c:v>894.64</c:v>
                </c:pt>
                <c:pt idx="2205">
                  <c:v>895.04</c:v>
                </c:pt>
                <c:pt idx="2206">
                  <c:v>895.45</c:v>
                </c:pt>
                <c:pt idx="2207">
                  <c:v>895.85</c:v>
                </c:pt>
                <c:pt idx="2208">
                  <c:v>896.26</c:v>
                </c:pt>
                <c:pt idx="2209">
                  <c:v>896.67</c:v>
                </c:pt>
                <c:pt idx="2210">
                  <c:v>897.07</c:v>
                </c:pt>
                <c:pt idx="2211">
                  <c:v>897.47</c:v>
                </c:pt>
                <c:pt idx="2212">
                  <c:v>897.88</c:v>
                </c:pt>
                <c:pt idx="2213">
                  <c:v>898.29</c:v>
                </c:pt>
                <c:pt idx="2214">
                  <c:v>898.7</c:v>
                </c:pt>
                <c:pt idx="2215">
                  <c:v>899.1</c:v>
                </c:pt>
                <c:pt idx="2216">
                  <c:v>899.5</c:v>
                </c:pt>
                <c:pt idx="2217">
                  <c:v>899.91</c:v>
                </c:pt>
                <c:pt idx="2218">
                  <c:v>900.32</c:v>
                </c:pt>
                <c:pt idx="2219">
                  <c:v>900.72</c:v>
                </c:pt>
                <c:pt idx="2220">
                  <c:v>901.13</c:v>
                </c:pt>
                <c:pt idx="2221">
                  <c:v>901.53</c:v>
                </c:pt>
                <c:pt idx="2222">
                  <c:v>901.94</c:v>
                </c:pt>
                <c:pt idx="2223">
                  <c:v>902.34</c:v>
                </c:pt>
                <c:pt idx="2224">
                  <c:v>902.75</c:v>
                </c:pt>
                <c:pt idx="2225">
                  <c:v>903.15</c:v>
                </c:pt>
                <c:pt idx="2226">
                  <c:v>903.56</c:v>
                </c:pt>
                <c:pt idx="2227">
                  <c:v>903.96</c:v>
                </c:pt>
                <c:pt idx="2228">
                  <c:v>904.37</c:v>
                </c:pt>
                <c:pt idx="2229">
                  <c:v>904.78</c:v>
                </c:pt>
                <c:pt idx="2230">
                  <c:v>905.18</c:v>
                </c:pt>
                <c:pt idx="2231">
                  <c:v>905.59</c:v>
                </c:pt>
                <c:pt idx="2232">
                  <c:v>905.99</c:v>
                </c:pt>
                <c:pt idx="2233">
                  <c:v>906.4</c:v>
                </c:pt>
                <c:pt idx="2234">
                  <c:v>906.8</c:v>
                </c:pt>
                <c:pt idx="2235">
                  <c:v>907.21</c:v>
                </c:pt>
                <c:pt idx="2236">
                  <c:v>907.62</c:v>
                </c:pt>
                <c:pt idx="2237">
                  <c:v>908.02</c:v>
                </c:pt>
                <c:pt idx="2238">
                  <c:v>908.43</c:v>
                </c:pt>
                <c:pt idx="2239">
                  <c:v>908.96</c:v>
                </c:pt>
                <c:pt idx="2240">
                  <c:v>909.33</c:v>
                </c:pt>
                <c:pt idx="2241">
                  <c:v>909.69</c:v>
                </c:pt>
                <c:pt idx="2242">
                  <c:v>910.05</c:v>
                </c:pt>
                <c:pt idx="2243">
                  <c:v>910.45</c:v>
                </c:pt>
                <c:pt idx="2244">
                  <c:v>910.86</c:v>
                </c:pt>
                <c:pt idx="2245">
                  <c:v>911.26</c:v>
                </c:pt>
                <c:pt idx="2246">
                  <c:v>911.67</c:v>
                </c:pt>
                <c:pt idx="2247">
                  <c:v>912.08</c:v>
                </c:pt>
                <c:pt idx="2248">
                  <c:v>912.48</c:v>
                </c:pt>
                <c:pt idx="2249">
                  <c:v>912.89</c:v>
                </c:pt>
                <c:pt idx="2250">
                  <c:v>913.29</c:v>
                </c:pt>
                <c:pt idx="2251">
                  <c:v>913.7</c:v>
                </c:pt>
                <c:pt idx="2252">
                  <c:v>914.1</c:v>
                </c:pt>
                <c:pt idx="2253">
                  <c:v>914.51</c:v>
                </c:pt>
                <c:pt idx="2254">
                  <c:v>914.92</c:v>
                </c:pt>
                <c:pt idx="2255">
                  <c:v>915.32</c:v>
                </c:pt>
                <c:pt idx="2256">
                  <c:v>915.73</c:v>
                </c:pt>
                <c:pt idx="2257">
                  <c:v>916.13</c:v>
                </c:pt>
                <c:pt idx="2258">
                  <c:v>916.54</c:v>
                </c:pt>
                <c:pt idx="2259">
                  <c:v>916.95</c:v>
                </c:pt>
                <c:pt idx="2260">
                  <c:v>917.35</c:v>
                </c:pt>
                <c:pt idx="2261">
                  <c:v>917.76</c:v>
                </c:pt>
                <c:pt idx="2262">
                  <c:v>918.16</c:v>
                </c:pt>
                <c:pt idx="2263">
                  <c:v>918.57</c:v>
                </c:pt>
                <c:pt idx="2264">
                  <c:v>918.98</c:v>
                </c:pt>
                <c:pt idx="2265">
                  <c:v>919.38</c:v>
                </c:pt>
                <c:pt idx="2266">
                  <c:v>919.78</c:v>
                </c:pt>
                <c:pt idx="2267">
                  <c:v>920.19</c:v>
                </c:pt>
                <c:pt idx="2268">
                  <c:v>920.59</c:v>
                </c:pt>
                <c:pt idx="2269">
                  <c:v>921</c:v>
                </c:pt>
                <c:pt idx="2270">
                  <c:v>921.41</c:v>
                </c:pt>
                <c:pt idx="2271">
                  <c:v>921.81</c:v>
                </c:pt>
                <c:pt idx="2272">
                  <c:v>922.22</c:v>
                </c:pt>
                <c:pt idx="2273">
                  <c:v>922.62</c:v>
                </c:pt>
                <c:pt idx="2274">
                  <c:v>923.03</c:v>
                </c:pt>
                <c:pt idx="2275">
                  <c:v>923.43</c:v>
                </c:pt>
                <c:pt idx="2276">
                  <c:v>923.84</c:v>
                </c:pt>
                <c:pt idx="2277">
                  <c:v>924.24</c:v>
                </c:pt>
                <c:pt idx="2278">
                  <c:v>924.65</c:v>
                </c:pt>
                <c:pt idx="2279">
                  <c:v>925.06</c:v>
                </c:pt>
                <c:pt idx="2280">
                  <c:v>925.46</c:v>
                </c:pt>
                <c:pt idx="2281">
                  <c:v>925.87</c:v>
                </c:pt>
                <c:pt idx="2282">
                  <c:v>926.27</c:v>
                </c:pt>
                <c:pt idx="2283">
                  <c:v>926.68</c:v>
                </c:pt>
                <c:pt idx="2284">
                  <c:v>927.08</c:v>
                </c:pt>
                <c:pt idx="2285">
                  <c:v>927.49</c:v>
                </c:pt>
                <c:pt idx="2286">
                  <c:v>927.89</c:v>
                </c:pt>
                <c:pt idx="2287">
                  <c:v>928.3</c:v>
                </c:pt>
                <c:pt idx="2288">
                  <c:v>928.71</c:v>
                </c:pt>
                <c:pt idx="2289">
                  <c:v>929.12</c:v>
                </c:pt>
                <c:pt idx="2290">
                  <c:v>929.52</c:v>
                </c:pt>
                <c:pt idx="2291">
                  <c:v>929.92</c:v>
                </c:pt>
                <c:pt idx="2292">
                  <c:v>930.33</c:v>
                </c:pt>
                <c:pt idx="2293">
                  <c:v>930.73</c:v>
                </c:pt>
                <c:pt idx="2294">
                  <c:v>931.14</c:v>
                </c:pt>
                <c:pt idx="2295">
                  <c:v>931.55</c:v>
                </c:pt>
                <c:pt idx="2296">
                  <c:v>931.95</c:v>
                </c:pt>
                <c:pt idx="2297">
                  <c:v>932.36</c:v>
                </c:pt>
                <c:pt idx="2298">
                  <c:v>932.76</c:v>
                </c:pt>
                <c:pt idx="2299">
                  <c:v>933.17</c:v>
                </c:pt>
                <c:pt idx="2300">
                  <c:v>933.57</c:v>
                </c:pt>
                <c:pt idx="2301">
                  <c:v>933.98</c:v>
                </c:pt>
                <c:pt idx="2302">
                  <c:v>934.38</c:v>
                </c:pt>
                <c:pt idx="2303">
                  <c:v>934.79</c:v>
                </c:pt>
                <c:pt idx="2304">
                  <c:v>935.19</c:v>
                </c:pt>
                <c:pt idx="2305">
                  <c:v>935.6</c:v>
                </c:pt>
                <c:pt idx="2306">
                  <c:v>936.01</c:v>
                </c:pt>
                <c:pt idx="2307">
                  <c:v>936.41</c:v>
                </c:pt>
                <c:pt idx="2308">
                  <c:v>936.82</c:v>
                </c:pt>
                <c:pt idx="2309">
                  <c:v>937.23</c:v>
                </c:pt>
                <c:pt idx="2310">
                  <c:v>937.63</c:v>
                </c:pt>
                <c:pt idx="2311">
                  <c:v>938.04</c:v>
                </c:pt>
                <c:pt idx="2312">
                  <c:v>938.44</c:v>
                </c:pt>
                <c:pt idx="2313">
                  <c:v>938.85</c:v>
                </c:pt>
                <c:pt idx="2314">
                  <c:v>939.25</c:v>
                </c:pt>
                <c:pt idx="2315">
                  <c:v>939.66</c:v>
                </c:pt>
                <c:pt idx="2316">
                  <c:v>940.06</c:v>
                </c:pt>
                <c:pt idx="2317">
                  <c:v>940.47</c:v>
                </c:pt>
                <c:pt idx="2318">
                  <c:v>940.87</c:v>
                </c:pt>
                <c:pt idx="2319">
                  <c:v>941.28</c:v>
                </c:pt>
                <c:pt idx="2320">
                  <c:v>941.69</c:v>
                </c:pt>
                <c:pt idx="2321">
                  <c:v>942.09</c:v>
                </c:pt>
                <c:pt idx="2322">
                  <c:v>942.5</c:v>
                </c:pt>
                <c:pt idx="2323">
                  <c:v>942.9</c:v>
                </c:pt>
                <c:pt idx="2324">
                  <c:v>943.31</c:v>
                </c:pt>
                <c:pt idx="2325">
                  <c:v>943.71</c:v>
                </c:pt>
                <c:pt idx="2326">
                  <c:v>944.12</c:v>
                </c:pt>
                <c:pt idx="2327">
                  <c:v>944.53</c:v>
                </c:pt>
                <c:pt idx="2328">
                  <c:v>944.93</c:v>
                </c:pt>
                <c:pt idx="2329">
                  <c:v>945.34</c:v>
                </c:pt>
                <c:pt idx="2330">
                  <c:v>945.74</c:v>
                </c:pt>
                <c:pt idx="2331">
                  <c:v>946.15</c:v>
                </c:pt>
                <c:pt idx="2332">
                  <c:v>946.55</c:v>
                </c:pt>
                <c:pt idx="2333">
                  <c:v>946.96</c:v>
                </c:pt>
                <c:pt idx="2334">
                  <c:v>947.37</c:v>
                </c:pt>
                <c:pt idx="2335">
                  <c:v>947.77</c:v>
                </c:pt>
                <c:pt idx="2336">
                  <c:v>948.17</c:v>
                </c:pt>
                <c:pt idx="2337">
                  <c:v>948.58</c:v>
                </c:pt>
                <c:pt idx="2338">
                  <c:v>948.99</c:v>
                </c:pt>
                <c:pt idx="2339">
                  <c:v>949.4</c:v>
                </c:pt>
                <c:pt idx="2340">
                  <c:v>949.8</c:v>
                </c:pt>
                <c:pt idx="2341">
                  <c:v>950.2</c:v>
                </c:pt>
                <c:pt idx="2342">
                  <c:v>950.61</c:v>
                </c:pt>
                <c:pt idx="2343">
                  <c:v>951.02</c:v>
                </c:pt>
                <c:pt idx="2344">
                  <c:v>951.42</c:v>
                </c:pt>
                <c:pt idx="2345">
                  <c:v>951.82</c:v>
                </c:pt>
                <c:pt idx="2346">
                  <c:v>952.23</c:v>
                </c:pt>
                <c:pt idx="2347">
                  <c:v>952.64</c:v>
                </c:pt>
                <c:pt idx="2348">
                  <c:v>953.04</c:v>
                </c:pt>
                <c:pt idx="2349">
                  <c:v>953.44</c:v>
                </c:pt>
                <c:pt idx="2350">
                  <c:v>953.85</c:v>
                </c:pt>
                <c:pt idx="2351">
                  <c:v>954.26</c:v>
                </c:pt>
                <c:pt idx="2352">
                  <c:v>954.66</c:v>
                </c:pt>
                <c:pt idx="2353">
                  <c:v>955.07</c:v>
                </c:pt>
                <c:pt idx="2354">
                  <c:v>955.48</c:v>
                </c:pt>
                <c:pt idx="2355">
                  <c:v>955.88</c:v>
                </c:pt>
                <c:pt idx="2356">
                  <c:v>956.29</c:v>
                </c:pt>
                <c:pt idx="2357">
                  <c:v>956.69</c:v>
                </c:pt>
                <c:pt idx="2358">
                  <c:v>957.1</c:v>
                </c:pt>
                <c:pt idx="2359">
                  <c:v>957.51</c:v>
                </c:pt>
                <c:pt idx="2360">
                  <c:v>957.91</c:v>
                </c:pt>
                <c:pt idx="2361">
                  <c:v>958.31</c:v>
                </c:pt>
                <c:pt idx="2362">
                  <c:v>958.72</c:v>
                </c:pt>
                <c:pt idx="2363">
                  <c:v>959.13</c:v>
                </c:pt>
                <c:pt idx="2364">
                  <c:v>959.54</c:v>
                </c:pt>
                <c:pt idx="2365">
                  <c:v>959.94</c:v>
                </c:pt>
                <c:pt idx="2366">
                  <c:v>960.34</c:v>
                </c:pt>
                <c:pt idx="2367">
                  <c:v>960.75</c:v>
                </c:pt>
                <c:pt idx="2368">
                  <c:v>961.51</c:v>
                </c:pt>
                <c:pt idx="2369">
                  <c:v>961.92</c:v>
                </c:pt>
                <c:pt idx="2370">
                  <c:v>962.32</c:v>
                </c:pt>
                <c:pt idx="2371">
                  <c:v>962.73</c:v>
                </c:pt>
                <c:pt idx="2372">
                  <c:v>963.14</c:v>
                </c:pt>
                <c:pt idx="2373">
                  <c:v>963.54</c:v>
                </c:pt>
                <c:pt idx="2374">
                  <c:v>963.95</c:v>
                </c:pt>
                <c:pt idx="2375">
                  <c:v>964.35</c:v>
                </c:pt>
                <c:pt idx="2376">
                  <c:v>964.76</c:v>
                </c:pt>
                <c:pt idx="2377">
                  <c:v>965.16</c:v>
                </c:pt>
                <c:pt idx="2378">
                  <c:v>965.56</c:v>
                </c:pt>
                <c:pt idx="2379">
                  <c:v>965.97</c:v>
                </c:pt>
                <c:pt idx="2380">
                  <c:v>966.38</c:v>
                </c:pt>
                <c:pt idx="2381">
                  <c:v>966.79</c:v>
                </c:pt>
                <c:pt idx="2382">
                  <c:v>967.19</c:v>
                </c:pt>
                <c:pt idx="2383">
                  <c:v>967.59</c:v>
                </c:pt>
                <c:pt idx="2384">
                  <c:v>968</c:v>
                </c:pt>
                <c:pt idx="2385">
                  <c:v>968.41</c:v>
                </c:pt>
                <c:pt idx="2386">
                  <c:v>968.81</c:v>
                </c:pt>
                <c:pt idx="2387">
                  <c:v>969.22</c:v>
                </c:pt>
                <c:pt idx="2388">
                  <c:v>969.63</c:v>
                </c:pt>
                <c:pt idx="2389">
                  <c:v>970.03</c:v>
                </c:pt>
                <c:pt idx="2390">
                  <c:v>970.44</c:v>
                </c:pt>
                <c:pt idx="2391">
                  <c:v>970.84</c:v>
                </c:pt>
                <c:pt idx="2392">
                  <c:v>971.25</c:v>
                </c:pt>
                <c:pt idx="2393">
                  <c:v>971.65</c:v>
                </c:pt>
                <c:pt idx="2394">
                  <c:v>972.06</c:v>
                </c:pt>
                <c:pt idx="2395">
                  <c:v>972.46</c:v>
                </c:pt>
                <c:pt idx="2396">
                  <c:v>972.87</c:v>
                </c:pt>
                <c:pt idx="2397">
                  <c:v>973.28</c:v>
                </c:pt>
                <c:pt idx="2398">
                  <c:v>973.68</c:v>
                </c:pt>
                <c:pt idx="2399">
                  <c:v>974.09</c:v>
                </c:pt>
                <c:pt idx="2400">
                  <c:v>974.49</c:v>
                </c:pt>
                <c:pt idx="2401">
                  <c:v>974.9</c:v>
                </c:pt>
                <c:pt idx="2402">
                  <c:v>975.3</c:v>
                </c:pt>
                <c:pt idx="2403">
                  <c:v>975.71</c:v>
                </c:pt>
                <c:pt idx="2404">
                  <c:v>976.11</c:v>
                </c:pt>
                <c:pt idx="2405">
                  <c:v>976.52</c:v>
                </c:pt>
                <c:pt idx="2406">
                  <c:v>976.93</c:v>
                </c:pt>
                <c:pt idx="2407">
                  <c:v>977.33</c:v>
                </c:pt>
                <c:pt idx="2408">
                  <c:v>977.73</c:v>
                </c:pt>
                <c:pt idx="2409">
                  <c:v>978.14</c:v>
                </c:pt>
                <c:pt idx="2410">
                  <c:v>978.55</c:v>
                </c:pt>
                <c:pt idx="2411">
                  <c:v>978.95</c:v>
                </c:pt>
                <c:pt idx="2412">
                  <c:v>979.36</c:v>
                </c:pt>
                <c:pt idx="2413">
                  <c:v>979.76</c:v>
                </c:pt>
                <c:pt idx="2414">
                  <c:v>980.17</c:v>
                </c:pt>
                <c:pt idx="2415">
                  <c:v>980.58</c:v>
                </c:pt>
                <c:pt idx="2416">
                  <c:v>980.98</c:v>
                </c:pt>
                <c:pt idx="2417">
                  <c:v>981.39</c:v>
                </c:pt>
                <c:pt idx="2418">
                  <c:v>981.79</c:v>
                </c:pt>
                <c:pt idx="2419">
                  <c:v>982.2</c:v>
                </c:pt>
                <c:pt idx="2420">
                  <c:v>982.6</c:v>
                </c:pt>
                <c:pt idx="2421">
                  <c:v>983.01</c:v>
                </c:pt>
                <c:pt idx="2422">
                  <c:v>983.42</c:v>
                </c:pt>
                <c:pt idx="2423">
                  <c:v>983.82</c:v>
                </c:pt>
                <c:pt idx="2424">
                  <c:v>984.23</c:v>
                </c:pt>
                <c:pt idx="2425">
                  <c:v>984.63</c:v>
                </c:pt>
                <c:pt idx="2426">
                  <c:v>985.04</c:v>
                </c:pt>
                <c:pt idx="2427">
                  <c:v>985.44</c:v>
                </c:pt>
                <c:pt idx="2428">
                  <c:v>985.84</c:v>
                </c:pt>
                <c:pt idx="2429">
                  <c:v>986.25</c:v>
                </c:pt>
                <c:pt idx="2430">
                  <c:v>986.66</c:v>
                </c:pt>
                <c:pt idx="2431">
                  <c:v>987.07</c:v>
                </c:pt>
                <c:pt idx="2432">
                  <c:v>987.47</c:v>
                </c:pt>
                <c:pt idx="2433">
                  <c:v>987.88</c:v>
                </c:pt>
                <c:pt idx="2434">
                  <c:v>988.28</c:v>
                </c:pt>
                <c:pt idx="2435">
                  <c:v>988.69</c:v>
                </c:pt>
                <c:pt idx="2436">
                  <c:v>989.09</c:v>
                </c:pt>
                <c:pt idx="2437">
                  <c:v>989.5</c:v>
                </c:pt>
                <c:pt idx="2438">
                  <c:v>989.9</c:v>
                </c:pt>
                <c:pt idx="2439">
                  <c:v>990.31</c:v>
                </c:pt>
                <c:pt idx="2440">
                  <c:v>990.72</c:v>
                </c:pt>
                <c:pt idx="2441">
                  <c:v>991.12</c:v>
                </c:pt>
                <c:pt idx="2442">
                  <c:v>991.53</c:v>
                </c:pt>
                <c:pt idx="2443">
                  <c:v>991.93</c:v>
                </c:pt>
                <c:pt idx="2444">
                  <c:v>992.34</c:v>
                </c:pt>
                <c:pt idx="2445">
                  <c:v>992.75</c:v>
                </c:pt>
                <c:pt idx="2446">
                  <c:v>993.15</c:v>
                </c:pt>
                <c:pt idx="2447">
                  <c:v>993.56</c:v>
                </c:pt>
                <c:pt idx="2448">
                  <c:v>993.97</c:v>
                </c:pt>
                <c:pt idx="2449">
                  <c:v>994.37</c:v>
                </c:pt>
                <c:pt idx="2450">
                  <c:v>994.77</c:v>
                </c:pt>
                <c:pt idx="2451">
                  <c:v>995.18</c:v>
                </c:pt>
                <c:pt idx="2452">
                  <c:v>995.58</c:v>
                </c:pt>
                <c:pt idx="2453">
                  <c:v>995.98</c:v>
                </c:pt>
                <c:pt idx="2454">
                  <c:v>996.39</c:v>
                </c:pt>
                <c:pt idx="2455">
                  <c:v>996.8</c:v>
                </c:pt>
                <c:pt idx="2456">
                  <c:v>997.21</c:v>
                </c:pt>
                <c:pt idx="2457">
                  <c:v>997.61</c:v>
                </c:pt>
                <c:pt idx="2458">
                  <c:v>998.01</c:v>
                </c:pt>
                <c:pt idx="2459">
                  <c:v>998.42</c:v>
                </c:pt>
                <c:pt idx="2460">
                  <c:v>998.83</c:v>
                </c:pt>
                <c:pt idx="2461">
                  <c:v>999.23</c:v>
                </c:pt>
                <c:pt idx="2462">
                  <c:v>999.64</c:v>
                </c:pt>
                <c:pt idx="2463">
                  <c:v>1000.04</c:v>
                </c:pt>
                <c:pt idx="2464">
                  <c:v>1000.45</c:v>
                </c:pt>
                <c:pt idx="2465">
                  <c:v>1000.86</c:v>
                </c:pt>
                <c:pt idx="2466">
                  <c:v>1001.26</c:v>
                </c:pt>
                <c:pt idx="2467">
                  <c:v>1001.67</c:v>
                </c:pt>
                <c:pt idx="2468">
                  <c:v>1002.07</c:v>
                </c:pt>
                <c:pt idx="2469">
                  <c:v>1002.48</c:v>
                </c:pt>
                <c:pt idx="2470">
                  <c:v>1002.88</c:v>
                </c:pt>
                <c:pt idx="2471">
                  <c:v>1003.29</c:v>
                </c:pt>
                <c:pt idx="2472">
                  <c:v>1003.7</c:v>
                </c:pt>
                <c:pt idx="2473">
                  <c:v>1004.1</c:v>
                </c:pt>
                <c:pt idx="2474">
                  <c:v>1004.51</c:v>
                </c:pt>
                <c:pt idx="2475">
                  <c:v>1004.91</c:v>
                </c:pt>
                <c:pt idx="2476">
                  <c:v>1005.32</c:v>
                </c:pt>
                <c:pt idx="2477">
                  <c:v>1005.72</c:v>
                </c:pt>
                <c:pt idx="2478">
                  <c:v>1006.12</c:v>
                </c:pt>
                <c:pt idx="2479">
                  <c:v>1006.53</c:v>
                </c:pt>
                <c:pt idx="2480">
                  <c:v>1006.94</c:v>
                </c:pt>
                <c:pt idx="2481">
                  <c:v>1007.34</c:v>
                </c:pt>
                <c:pt idx="2482">
                  <c:v>1007.75</c:v>
                </c:pt>
                <c:pt idx="2483">
                  <c:v>1008.15</c:v>
                </c:pt>
                <c:pt idx="2484">
                  <c:v>1008.56</c:v>
                </c:pt>
                <c:pt idx="2485">
                  <c:v>1008.97</c:v>
                </c:pt>
                <c:pt idx="2486">
                  <c:v>1009.37</c:v>
                </c:pt>
                <c:pt idx="2487">
                  <c:v>1009.78</c:v>
                </c:pt>
                <c:pt idx="2488">
                  <c:v>1010.18</c:v>
                </c:pt>
                <c:pt idx="2489">
                  <c:v>1010.59</c:v>
                </c:pt>
                <c:pt idx="2490">
                  <c:v>1011</c:v>
                </c:pt>
                <c:pt idx="2491">
                  <c:v>1011.4</c:v>
                </c:pt>
                <c:pt idx="2492">
                  <c:v>1011.81</c:v>
                </c:pt>
                <c:pt idx="2493">
                  <c:v>1012.21</c:v>
                </c:pt>
                <c:pt idx="2494">
                  <c:v>1012.62</c:v>
                </c:pt>
                <c:pt idx="2495">
                  <c:v>1013.03</c:v>
                </c:pt>
                <c:pt idx="2496">
                  <c:v>1013.43</c:v>
                </c:pt>
                <c:pt idx="2497">
                  <c:v>1013.84</c:v>
                </c:pt>
                <c:pt idx="2498">
                  <c:v>1014.25</c:v>
                </c:pt>
                <c:pt idx="2499">
                  <c:v>1014.65</c:v>
                </c:pt>
                <c:pt idx="2500">
                  <c:v>1015.05</c:v>
                </c:pt>
                <c:pt idx="2501">
                  <c:v>1015.46</c:v>
                </c:pt>
                <c:pt idx="2502">
                  <c:v>1015.86</c:v>
                </c:pt>
                <c:pt idx="2503">
                  <c:v>1016.27</c:v>
                </c:pt>
                <c:pt idx="2504">
                  <c:v>1016.68</c:v>
                </c:pt>
                <c:pt idx="2505">
                  <c:v>1017.08</c:v>
                </c:pt>
                <c:pt idx="2506">
                  <c:v>1017.49</c:v>
                </c:pt>
                <c:pt idx="2507">
                  <c:v>1017.89</c:v>
                </c:pt>
                <c:pt idx="2508">
                  <c:v>1018.3</c:v>
                </c:pt>
                <c:pt idx="2509">
                  <c:v>1018.7</c:v>
                </c:pt>
                <c:pt idx="2510">
                  <c:v>1019.11</c:v>
                </c:pt>
                <c:pt idx="2511">
                  <c:v>1019.51</c:v>
                </c:pt>
                <c:pt idx="2512">
                  <c:v>1019.92</c:v>
                </c:pt>
                <c:pt idx="2513">
                  <c:v>1020.33</c:v>
                </c:pt>
                <c:pt idx="2514">
                  <c:v>1020.73</c:v>
                </c:pt>
                <c:pt idx="2515">
                  <c:v>1021.14</c:v>
                </c:pt>
                <c:pt idx="2516">
                  <c:v>1021.54</c:v>
                </c:pt>
                <c:pt idx="2517">
                  <c:v>1021.95</c:v>
                </c:pt>
                <c:pt idx="2518">
                  <c:v>1022.36</c:v>
                </c:pt>
                <c:pt idx="2519">
                  <c:v>1022.76</c:v>
                </c:pt>
                <c:pt idx="2520">
                  <c:v>1023.16</c:v>
                </c:pt>
                <c:pt idx="2521">
                  <c:v>1023.57</c:v>
                </c:pt>
                <c:pt idx="2522">
                  <c:v>1023.97</c:v>
                </c:pt>
                <c:pt idx="2523">
                  <c:v>1024.3800000000001</c:v>
                </c:pt>
                <c:pt idx="2524">
                  <c:v>1024.79</c:v>
                </c:pt>
                <c:pt idx="2525">
                  <c:v>1025.19</c:v>
                </c:pt>
                <c:pt idx="2526">
                  <c:v>1025.5999999999999</c:v>
                </c:pt>
                <c:pt idx="2527">
                  <c:v>1026</c:v>
                </c:pt>
                <c:pt idx="2528">
                  <c:v>1026.4100000000001</c:v>
                </c:pt>
                <c:pt idx="2529">
                  <c:v>1026.81</c:v>
                </c:pt>
                <c:pt idx="2530">
                  <c:v>1027.22</c:v>
                </c:pt>
                <c:pt idx="2531">
                  <c:v>1027.6300000000001</c:v>
                </c:pt>
                <c:pt idx="2532">
                  <c:v>1028.03</c:v>
                </c:pt>
                <c:pt idx="2533">
                  <c:v>1028.44</c:v>
                </c:pt>
                <c:pt idx="2534">
                  <c:v>1028.8499999999999</c:v>
                </c:pt>
                <c:pt idx="2535">
                  <c:v>1029.25</c:v>
                </c:pt>
                <c:pt idx="2536">
                  <c:v>1029.6500000000001</c:v>
                </c:pt>
                <c:pt idx="2537">
                  <c:v>1030.06</c:v>
                </c:pt>
                <c:pt idx="2538">
                  <c:v>1030.47</c:v>
                </c:pt>
                <c:pt idx="2539">
                  <c:v>1030.8699999999999</c:v>
                </c:pt>
                <c:pt idx="2540">
                  <c:v>1031.28</c:v>
                </c:pt>
                <c:pt idx="2541">
                  <c:v>1031.68</c:v>
                </c:pt>
                <c:pt idx="2542">
                  <c:v>1032.0899999999999</c:v>
                </c:pt>
                <c:pt idx="2543">
                  <c:v>1032.5</c:v>
                </c:pt>
                <c:pt idx="2544">
                  <c:v>1032.9000000000001</c:v>
                </c:pt>
                <c:pt idx="2545">
                  <c:v>1033.3</c:v>
                </c:pt>
                <c:pt idx="2546">
                  <c:v>1033.71</c:v>
                </c:pt>
                <c:pt idx="2547">
                  <c:v>1034.1099999999999</c:v>
                </c:pt>
                <c:pt idx="2548">
                  <c:v>1034.53</c:v>
                </c:pt>
                <c:pt idx="2549">
                  <c:v>1034.93</c:v>
                </c:pt>
                <c:pt idx="2550">
                  <c:v>1035.33</c:v>
                </c:pt>
                <c:pt idx="2551">
                  <c:v>1035.74</c:v>
                </c:pt>
                <c:pt idx="2552">
                  <c:v>1036.1400000000001</c:v>
                </c:pt>
                <c:pt idx="2553">
                  <c:v>1036.55</c:v>
                </c:pt>
                <c:pt idx="2554">
                  <c:v>1036.95</c:v>
                </c:pt>
                <c:pt idx="2555">
                  <c:v>1037.3599999999999</c:v>
                </c:pt>
                <c:pt idx="2556">
                  <c:v>1037.77</c:v>
                </c:pt>
                <c:pt idx="2557">
                  <c:v>1038.17</c:v>
                </c:pt>
                <c:pt idx="2558">
                  <c:v>1038.58</c:v>
                </c:pt>
                <c:pt idx="2559">
                  <c:v>1038.99</c:v>
                </c:pt>
                <c:pt idx="2560">
                  <c:v>1039.3900000000001</c:v>
                </c:pt>
                <c:pt idx="2561">
                  <c:v>1039.79</c:v>
                </c:pt>
                <c:pt idx="2562">
                  <c:v>1040.2</c:v>
                </c:pt>
                <c:pt idx="2563">
                  <c:v>1040.6099999999999</c:v>
                </c:pt>
                <c:pt idx="2564">
                  <c:v>1041.01</c:v>
                </c:pt>
                <c:pt idx="2565">
                  <c:v>1041.42</c:v>
                </c:pt>
                <c:pt idx="2566">
                  <c:v>1041.82</c:v>
                </c:pt>
                <c:pt idx="2567">
                  <c:v>1042.23</c:v>
                </c:pt>
                <c:pt idx="2568">
                  <c:v>1042.6400000000001</c:v>
                </c:pt>
                <c:pt idx="2569">
                  <c:v>1043.04</c:v>
                </c:pt>
                <c:pt idx="2570">
                  <c:v>1043.44</c:v>
                </c:pt>
                <c:pt idx="2571">
                  <c:v>1043.8499999999999</c:v>
                </c:pt>
                <c:pt idx="2572">
                  <c:v>1044.26</c:v>
                </c:pt>
                <c:pt idx="2573">
                  <c:v>1044.67</c:v>
                </c:pt>
                <c:pt idx="2574">
                  <c:v>1045.07</c:v>
                </c:pt>
                <c:pt idx="2575">
                  <c:v>1045.47</c:v>
                </c:pt>
                <c:pt idx="2576">
                  <c:v>1045.8800000000001</c:v>
                </c:pt>
                <c:pt idx="2577">
                  <c:v>1046.28</c:v>
                </c:pt>
                <c:pt idx="2578">
                  <c:v>1046.69</c:v>
                </c:pt>
                <c:pt idx="2579">
                  <c:v>1047.0999999999999</c:v>
                </c:pt>
                <c:pt idx="2580">
                  <c:v>1047.5</c:v>
                </c:pt>
                <c:pt idx="2581">
                  <c:v>1047.9100000000001</c:v>
                </c:pt>
                <c:pt idx="2582">
                  <c:v>1048.31</c:v>
                </c:pt>
                <c:pt idx="2583">
                  <c:v>1048.72</c:v>
                </c:pt>
                <c:pt idx="2584">
                  <c:v>1049.1199999999999</c:v>
                </c:pt>
                <c:pt idx="2585">
                  <c:v>1049.53</c:v>
                </c:pt>
                <c:pt idx="2586">
                  <c:v>1049.94</c:v>
                </c:pt>
                <c:pt idx="2587">
                  <c:v>1050.3399999999999</c:v>
                </c:pt>
                <c:pt idx="2588">
                  <c:v>1050.74</c:v>
                </c:pt>
                <c:pt idx="2589">
                  <c:v>1051.1500000000001</c:v>
                </c:pt>
                <c:pt idx="2590">
                  <c:v>1051.56</c:v>
                </c:pt>
                <c:pt idx="2591">
                  <c:v>1051.96</c:v>
                </c:pt>
                <c:pt idx="2592">
                  <c:v>1052.3699999999999</c:v>
                </c:pt>
                <c:pt idx="2593">
                  <c:v>1052.78</c:v>
                </c:pt>
                <c:pt idx="2594">
                  <c:v>1053.18</c:v>
                </c:pt>
                <c:pt idx="2595">
                  <c:v>1053.5899999999999</c:v>
                </c:pt>
                <c:pt idx="2596">
                  <c:v>1053.99</c:v>
                </c:pt>
                <c:pt idx="2597">
                  <c:v>1054.3900000000001</c:v>
                </c:pt>
                <c:pt idx="2598">
                  <c:v>1054.81</c:v>
                </c:pt>
                <c:pt idx="2599">
                  <c:v>1055.21</c:v>
                </c:pt>
                <c:pt idx="2600">
                  <c:v>1055.6099999999999</c:v>
                </c:pt>
                <c:pt idx="2601">
                  <c:v>1056.02</c:v>
                </c:pt>
                <c:pt idx="2602">
                  <c:v>1056.42</c:v>
                </c:pt>
                <c:pt idx="2603">
                  <c:v>1056.83</c:v>
                </c:pt>
                <c:pt idx="2604">
                  <c:v>1057.24</c:v>
                </c:pt>
                <c:pt idx="2605">
                  <c:v>1057.6400000000001</c:v>
                </c:pt>
                <c:pt idx="2606">
                  <c:v>1058.05</c:v>
                </c:pt>
                <c:pt idx="2607">
                  <c:v>1058.45</c:v>
                </c:pt>
                <c:pt idx="2608">
                  <c:v>1058.8499999999999</c:v>
                </c:pt>
                <c:pt idx="2609">
                  <c:v>1059.26</c:v>
                </c:pt>
                <c:pt idx="2610">
                  <c:v>1059.67</c:v>
                </c:pt>
                <c:pt idx="2611">
                  <c:v>1060.08</c:v>
                </c:pt>
                <c:pt idx="2612">
                  <c:v>1060.48</c:v>
                </c:pt>
                <c:pt idx="2613">
                  <c:v>1060.8800000000001</c:v>
                </c:pt>
                <c:pt idx="2614">
                  <c:v>1061.29</c:v>
                </c:pt>
                <c:pt idx="2615">
                  <c:v>1061.7</c:v>
                </c:pt>
                <c:pt idx="2616">
                  <c:v>1062.0999999999999</c:v>
                </c:pt>
                <c:pt idx="2617">
                  <c:v>1062.51</c:v>
                </c:pt>
                <c:pt idx="2618">
                  <c:v>1062.92</c:v>
                </c:pt>
                <c:pt idx="2619">
                  <c:v>1063.32</c:v>
                </c:pt>
                <c:pt idx="2620">
                  <c:v>1063.73</c:v>
                </c:pt>
                <c:pt idx="2621">
                  <c:v>1064.1300000000001</c:v>
                </c:pt>
                <c:pt idx="2622">
                  <c:v>1064.54</c:v>
                </c:pt>
                <c:pt idx="2623">
                  <c:v>1064.94</c:v>
                </c:pt>
                <c:pt idx="2624">
                  <c:v>1065.3499999999999</c:v>
                </c:pt>
                <c:pt idx="2625">
                  <c:v>1065.75</c:v>
                </c:pt>
                <c:pt idx="2626">
                  <c:v>1066.1600000000001</c:v>
                </c:pt>
                <c:pt idx="2627">
                  <c:v>1066.56</c:v>
                </c:pt>
                <c:pt idx="2628">
                  <c:v>1066.97</c:v>
                </c:pt>
                <c:pt idx="2629">
                  <c:v>1067.3800000000001</c:v>
                </c:pt>
                <c:pt idx="2630">
                  <c:v>1067.78</c:v>
                </c:pt>
                <c:pt idx="2631">
                  <c:v>1068.19</c:v>
                </c:pt>
                <c:pt idx="2632">
                  <c:v>1068.5899999999999</c:v>
                </c:pt>
                <c:pt idx="2633">
                  <c:v>1069</c:v>
                </c:pt>
                <c:pt idx="2634">
                  <c:v>1069.4000000000001</c:v>
                </c:pt>
                <c:pt idx="2635">
                  <c:v>1069.81</c:v>
                </c:pt>
                <c:pt idx="2636">
                  <c:v>1070.22</c:v>
                </c:pt>
                <c:pt idx="2637">
                  <c:v>1070.6199999999999</c:v>
                </c:pt>
                <c:pt idx="2638">
                  <c:v>1071.03</c:v>
                </c:pt>
                <c:pt idx="2639">
                  <c:v>1071.43</c:v>
                </c:pt>
                <c:pt idx="2640">
                  <c:v>1071.8399999999999</c:v>
                </c:pt>
                <c:pt idx="2641">
                  <c:v>1072.24</c:v>
                </c:pt>
                <c:pt idx="2642">
                  <c:v>1072.6500000000001</c:v>
                </c:pt>
                <c:pt idx="2643">
                  <c:v>1073.05</c:v>
                </c:pt>
                <c:pt idx="2644">
                  <c:v>1073.46</c:v>
                </c:pt>
                <c:pt idx="2645">
                  <c:v>1073.8699999999999</c:v>
                </c:pt>
                <c:pt idx="2646">
                  <c:v>1074.27</c:v>
                </c:pt>
                <c:pt idx="2647">
                  <c:v>1074.68</c:v>
                </c:pt>
                <c:pt idx="2648">
                  <c:v>1075.08</c:v>
                </c:pt>
                <c:pt idx="2649">
                  <c:v>1075.49</c:v>
                </c:pt>
                <c:pt idx="2650">
                  <c:v>1075.8900000000001</c:v>
                </c:pt>
                <c:pt idx="2651">
                  <c:v>1076.3</c:v>
                </c:pt>
                <c:pt idx="2652">
                  <c:v>1076.7</c:v>
                </c:pt>
                <c:pt idx="2653">
                  <c:v>1077.1099999999999</c:v>
                </c:pt>
                <c:pt idx="2654">
                  <c:v>1077.51</c:v>
                </c:pt>
                <c:pt idx="2655">
                  <c:v>1077.92</c:v>
                </c:pt>
                <c:pt idx="2656">
                  <c:v>1078.33</c:v>
                </c:pt>
                <c:pt idx="2657">
                  <c:v>1078.73</c:v>
                </c:pt>
                <c:pt idx="2658">
                  <c:v>1079.1400000000001</c:v>
                </c:pt>
                <c:pt idx="2659">
                  <c:v>1079.54</c:v>
                </c:pt>
                <c:pt idx="2660">
                  <c:v>1079.95</c:v>
                </c:pt>
                <c:pt idx="2661">
                  <c:v>1080.3599999999999</c:v>
                </c:pt>
                <c:pt idx="2662">
                  <c:v>1080.76</c:v>
                </c:pt>
                <c:pt idx="2663">
                  <c:v>1081.17</c:v>
                </c:pt>
                <c:pt idx="2664">
                  <c:v>1081.57</c:v>
                </c:pt>
                <c:pt idx="2665">
                  <c:v>1081.98</c:v>
                </c:pt>
                <c:pt idx="2666">
                  <c:v>1082.3800000000001</c:v>
                </c:pt>
                <c:pt idx="2667">
                  <c:v>1082.79</c:v>
                </c:pt>
                <c:pt idx="2668">
                  <c:v>1083.19</c:v>
                </c:pt>
                <c:pt idx="2669">
                  <c:v>1083.5999999999999</c:v>
                </c:pt>
                <c:pt idx="2670">
                  <c:v>1084.01</c:v>
                </c:pt>
                <c:pt idx="2671">
                  <c:v>1084.4100000000001</c:v>
                </c:pt>
                <c:pt idx="2672">
                  <c:v>1084.82</c:v>
                </c:pt>
                <c:pt idx="2673">
                  <c:v>1085.22</c:v>
                </c:pt>
                <c:pt idx="2674">
                  <c:v>1085.6300000000001</c:v>
                </c:pt>
              </c:numCache>
            </c:numRef>
          </c:xVal>
          <c:yVal>
            <c:numRef>
              <c:f>'Sheet6 GSK'!$AK$44:$AK$2718</c:f>
              <c:numCache>
                <c:formatCode>General</c:formatCode>
                <c:ptCount val="2675"/>
                <c:pt idx="0">
                  <c:v>1</c:v>
                </c:pt>
                <c:pt idx="1">
                  <c:v>0.97703313253012047</c:v>
                </c:pt>
                <c:pt idx="2">
                  <c:v>0.97910391566265065</c:v>
                </c:pt>
                <c:pt idx="3">
                  <c:v>1.0065888554216869</c:v>
                </c:pt>
                <c:pt idx="4">
                  <c:v>0.99962349397590367</c:v>
                </c:pt>
                <c:pt idx="5">
                  <c:v>1.0030120481927711</c:v>
                </c:pt>
                <c:pt idx="6">
                  <c:v>0.99792921686746983</c:v>
                </c:pt>
                <c:pt idx="7">
                  <c:v>0.98550451807228912</c:v>
                </c:pt>
                <c:pt idx="8">
                  <c:v>0.984375</c:v>
                </c:pt>
                <c:pt idx="9">
                  <c:v>1.0028237951807228</c:v>
                </c:pt>
                <c:pt idx="10">
                  <c:v>0.99303463855421692</c:v>
                </c:pt>
                <c:pt idx="11">
                  <c:v>0.98682228915662651</c:v>
                </c:pt>
                <c:pt idx="12">
                  <c:v>0.99830572289156627</c:v>
                </c:pt>
                <c:pt idx="13">
                  <c:v>1.0064006024096386</c:v>
                </c:pt>
                <c:pt idx="14">
                  <c:v>0.99830572289156627</c:v>
                </c:pt>
                <c:pt idx="15">
                  <c:v>1.0137424698795181</c:v>
                </c:pt>
                <c:pt idx="16">
                  <c:v>1.0175075301204819</c:v>
                </c:pt>
                <c:pt idx="17">
                  <c:v>1.005835843373494</c:v>
                </c:pt>
                <c:pt idx="18">
                  <c:v>0.99736445783132532</c:v>
                </c:pt>
                <c:pt idx="19">
                  <c:v>1.0077183734939759</c:v>
                </c:pt>
                <c:pt idx="20">
                  <c:v>0.99322289156626509</c:v>
                </c:pt>
                <c:pt idx="21">
                  <c:v>1.0001882530120483</c:v>
                </c:pt>
                <c:pt idx="22">
                  <c:v>1.0114834337349397</c:v>
                </c:pt>
                <c:pt idx="23">
                  <c:v>1.0035768072289157</c:v>
                </c:pt>
                <c:pt idx="24">
                  <c:v>1.0080948795180722</c:v>
                </c:pt>
                <c:pt idx="25">
                  <c:v>1.0160015060240963</c:v>
                </c:pt>
                <c:pt idx="26">
                  <c:v>0.99924698795180722</c:v>
                </c:pt>
                <c:pt idx="27">
                  <c:v>0.98343373493975905</c:v>
                </c:pt>
                <c:pt idx="28">
                  <c:v>0.9981174698795181</c:v>
                </c:pt>
                <c:pt idx="29">
                  <c:v>1.0011295180722892</c:v>
                </c:pt>
                <c:pt idx="30">
                  <c:v>1.0077183734939759</c:v>
                </c:pt>
                <c:pt idx="31">
                  <c:v>0.98324548192771088</c:v>
                </c:pt>
                <c:pt idx="32">
                  <c:v>0.99454066265060237</c:v>
                </c:pt>
                <c:pt idx="33">
                  <c:v>0.98719879518072284</c:v>
                </c:pt>
                <c:pt idx="34">
                  <c:v>0.97853915662650603</c:v>
                </c:pt>
                <c:pt idx="35">
                  <c:v>0.99303463855421692</c:v>
                </c:pt>
                <c:pt idx="36">
                  <c:v>1.0009412650602409</c:v>
                </c:pt>
                <c:pt idx="37">
                  <c:v>0.99849397590361444</c:v>
                </c:pt>
                <c:pt idx="38">
                  <c:v>1.0005647590361446</c:v>
                </c:pt>
                <c:pt idx="39">
                  <c:v>0.98569277108433739</c:v>
                </c:pt>
                <c:pt idx="40">
                  <c:v>0.97195030120481929</c:v>
                </c:pt>
                <c:pt idx="41">
                  <c:v>0.96592620481927716</c:v>
                </c:pt>
                <c:pt idx="42">
                  <c:v>0.94145331325301207</c:v>
                </c:pt>
                <c:pt idx="43">
                  <c:v>0.96460843373493976</c:v>
                </c:pt>
                <c:pt idx="44">
                  <c:v>0.97929216867469882</c:v>
                </c:pt>
                <c:pt idx="45">
                  <c:v>0.9587725903614458</c:v>
                </c:pt>
                <c:pt idx="46">
                  <c:v>0.99792921686746983</c:v>
                </c:pt>
                <c:pt idx="47">
                  <c:v>0.99529367469879515</c:v>
                </c:pt>
                <c:pt idx="48">
                  <c:v>0.99981174698795183</c:v>
                </c:pt>
                <c:pt idx="49">
                  <c:v>0.99039909638554213</c:v>
                </c:pt>
                <c:pt idx="50">
                  <c:v>0.96987951807228912</c:v>
                </c:pt>
                <c:pt idx="51">
                  <c:v>0.99416415662650603</c:v>
                </c:pt>
                <c:pt idx="52">
                  <c:v>0.96724397590361444</c:v>
                </c:pt>
                <c:pt idx="53">
                  <c:v>0.98343373493975905</c:v>
                </c:pt>
                <c:pt idx="54">
                  <c:v>0.99021084337349397</c:v>
                </c:pt>
                <c:pt idx="55">
                  <c:v>0.97571536144578308</c:v>
                </c:pt>
                <c:pt idx="56">
                  <c:v>0.99077560240963858</c:v>
                </c:pt>
                <c:pt idx="57">
                  <c:v>0.96762048192771088</c:v>
                </c:pt>
                <c:pt idx="58">
                  <c:v>0.9900225903614458</c:v>
                </c:pt>
                <c:pt idx="59">
                  <c:v>0.9862575301204819</c:v>
                </c:pt>
                <c:pt idx="60">
                  <c:v>0.96931475903614461</c:v>
                </c:pt>
                <c:pt idx="61">
                  <c:v>0.98324548192771088</c:v>
                </c:pt>
                <c:pt idx="62">
                  <c:v>0.96159638554216864</c:v>
                </c:pt>
                <c:pt idx="63">
                  <c:v>1.004894578313253</c:v>
                </c:pt>
                <c:pt idx="64">
                  <c:v>0.97383283132530118</c:v>
                </c:pt>
                <c:pt idx="65">
                  <c:v>0.97835090361445787</c:v>
                </c:pt>
                <c:pt idx="66">
                  <c:v>0.98550451807228912</c:v>
                </c:pt>
                <c:pt idx="67">
                  <c:v>0.97496234939759041</c:v>
                </c:pt>
                <c:pt idx="68">
                  <c:v>0.98173945783132532</c:v>
                </c:pt>
                <c:pt idx="69">
                  <c:v>0.9668674698795181</c:v>
                </c:pt>
                <c:pt idx="70">
                  <c:v>0.96705572289156627</c:v>
                </c:pt>
                <c:pt idx="71">
                  <c:v>1.0013177710843373</c:v>
                </c:pt>
                <c:pt idx="72">
                  <c:v>0.96649096385542166</c:v>
                </c:pt>
                <c:pt idx="73">
                  <c:v>0.97213855421686746</c:v>
                </c:pt>
                <c:pt idx="74">
                  <c:v>0.98945783132530118</c:v>
                </c:pt>
                <c:pt idx="75">
                  <c:v>0.98042168674698793</c:v>
                </c:pt>
                <c:pt idx="76">
                  <c:v>0.99887048192771088</c:v>
                </c:pt>
                <c:pt idx="77">
                  <c:v>0.96875</c:v>
                </c:pt>
                <c:pt idx="78">
                  <c:v>0.9862575301204819</c:v>
                </c:pt>
                <c:pt idx="79">
                  <c:v>0.97759789156626509</c:v>
                </c:pt>
                <c:pt idx="80">
                  <c:v>0.97853915662650603</c:v>
                </c:pt>
                <c:pt idx="81">
                  <c:v>0.98512801204819278</c:v>
                </c:pt>
                <c:pt idx="82">
                  <c:v>0.97044427710843373</c:v>
                </c:pt>
                <c:pt idx="83">
                  <c:v>0.98268072289156627</c:v>
                </c:pt>
                <c:pt idx="84">
                  <c:v>0.96103162650602414</c:v>
                </c:pt>
                <c:pt idx="85">
                  <c:v>0.99359939759036142</c:v>
                </c:pt>
                <c:pt idx="86">
                  <c:v>0.97195030120481929</c:v>
                </c:pt>
                <c:pt idx="87">
                  <c:v>0.9725150602409639</c:v>
                </c:pt>
                <c:pt idx="88">
                  <c:v>0.96404367469879515</c:v>
                </c:pt>
                <c:pt idx="89">
                  <c:v>0.97665662650602414</c:v>
                </c:pt>
                <c:pt idx="90">
                  <c:v>0.94860692771084343</c:v>
                </c:pt>
                <c:pt idx="91">
                  <c:v>0.97496234939759041</c:v>
                </c:pt>
                <c:pt idx="92">
                  <c:v>0.99039909638554213</c:v>
                </c:pt>
                <c:pt idx="93">
                  <c:v>0.96799698795180722</c:v>
                </c:pt>
                <c:pt idx="94">
                  <c:v>0.98701054216867468</c:v>
                </c:pt>
                <c:pt idx="95">
                  <c:v>0.94766566265060237</c:v>
                </c:pt>
                <c:pt idx="96">
                  <c:v>0.97100903614457834</c:v>
                </c:pt>
                <c:pt idx="97">
                  <c:v>0.98324548192771088</c:v>
                </c:pt>
                <c:pt idx="98">
                  <c:v>0.96667921686746983</c:v>
                </c:pt>
                <c:pt idx="99">
                  <c:v>0.96837349397590367</c:v>
                </c:pt>
                <c:pt idx="100">
                  <c:v>0.99887048192771088</c:v>
                </c:pt>
                <c:pt idx="101">
                  <c:v>0.97232680722891562</c:v>
                </c:pt>
                <c:pt idx="102">
                  <c:v>0.97157379518072284</c:v>
                </c:pt>
                <c:pt idx="103">
                  <c:v>0.96762048192771088</c:v>
                </c:pt>
                <c:pt idx="104">
                  <c:v>0.99585843373493976</c:v>
                </c:pt>
                <c:pt idx="105">
                  <c:v>0.98343373493975905</c:v>
                </c:pt>
                <c:pt idx="106">
                  <c:v>0.98719879518072284</c:v>
                </c:pt>
                <c:pt idx="107">
                  <c:v>0.96724397590361444</c:v>
                </c:pt>
                <c:pt idx="108">
                  <c:v>0.96799698795180722</c:v>
                </c:pt>
                <c:pt idx="109">
                  <c:v>0.95801957831325302</c:v>
                </c:pt>
                <c:pt idx="110">
                  <c:v>0.98305722891566261</c:v>
                </c:pt>
                <c:pt idx="111">
                  <c:v>0.96046686746987953</c:v>
                </c:pt>
                <c:pt idx="112">
                  <c:v>0.95481927710843373</c:v>
                </c:pt>
                <c:pt idx="113">
                  <c:v>0.97345632530120485</c:v>
                </c:pt>
                <c:pt idx="114">
                  <c:v>0.96159638554216864</c:v>
                </c:pt>
                <c:pt idx="115">
                  <c:v>0.98851656626506024</c:v>
                </c:pt>
                <c:pt idx="116">
                  <c:v>0.9800451807228916</c:v>
                </c:pt>
                <c:pt idx="117">
                  <c:v>0.96366716867469882</c:v>
                </c:pt>
                <c:pt idx="118">
                  <c:v>0.9806099397590361</c:v>
                </c:pt>
                <c:pt idx="119">
                  <c:v>0.96216114457831325</c:v>
                </c:pt>
                <c:pt idx="120">
                  <c:v>0.97383283132530118</c:v>
                </c:pt>
                <c:pt idx="121">
                  <c:v>0.96347891566265065</c:v>
                </c:pt>
                <c:pt idx="122">
                  <c:v>0.97740963855421692</c:v>
                </c:pt>
                <c:pt idx="123">
                  <c:v>0.94578313253012047</c:v>
                </c:pt>
                <c:pt idx="124">
                  <c:v>0.96987951807228912</c:v>
                </c:pt>
                <c:pt idx="125">
                  <c:v>0.97533885542168675</c:v>
                </c:pt>
                <c:pt idx="126">
                  <c:v>0.97778614457831325</c:v>
                </c:pt>
                <c:pt idx="127">
                  <c:v>0.96423192771084343</c:v>
                </c:pt>
                <c:pt idx="128">
                  <c:v>0.97496234939759041</c:v>
                </c:pt>
                <c:pt idx="129">
                  <c:v>0.94860692771084343</c:v>
                </c:pt>
                <c:pt idx="130">
                  <c:v>0.97609186746987953</c:v>
                </c:pt>
                <c:pt idx="131">
                  <c:v>0.96253765060240959</c:v>
                </c:pt>
                <c:pt idx="132">
                  <c:v>0.9375</c:v>
                </c:pt>
                <c:pt idx="133">
                  <c:v>0.99058734939759041</c:v>
                </c:pt>
                <c:pt idx="134">
                  <c:v>0.96517319277108438</c:v>
                </c:pt>
                <c:pt idx="135">
                  <c:v>0.98079819277108438</c:v>
                </c:pt>
                <c:pt idx="136">
                  <c:v>0.98757530120481929</c:v>
                </c:pt>
                <c:pt idx="137">
                  <c:v>0.95670180722891562</c:v>
                </c:pt>
                <c:pt idx="138">
                  <c:v>0.95594879518072284</c:v>
                </c:pt>
                <c:pt idx="139">
                  <c:v>0.9706325301204819</c:v>
                </c:pt>
                <c:pt idx="140">
                  <c:v>0.95726656626506024</c:v>
                </c:pt>
                <c:pt idx="141">
                  <c:v>0.94051204819277112</c:v>
                </c:pt>
                <c:pt idx="142">
                  <c:v>0.97364457831325302</c:v>
                </c:pt>
                <c:pt idx="143">
                  <c:v>0.97232680722891562</c:v>
                </c:pt>
                <c:pt idx="144">
                  <c:v>0.95030120481927716</c:v>
                </c:pt>
                <c:pt idx="145">
                  <c:v>0.95990210843373491</c:v>
                </c:pt>
                <c:pt idx="146">
                  <c:v>0.95557228915662651</c:v>
                </c:pt>
                <c:pt idx="147">
                  <c:v>0.93994728915662651</c:v>
                </c:pt>
                <c:pt idx="148">
                  <c:v>0.95801957831325302</c:v>
                </c:pt>
                <c:pt idx="149">
                  <c:v>0.95368975903614461</c:v>
                </c:pt>
                <c:pt idx="150">
                  <c:v>0.97533885542168675</c:v>
                </c:pt>
                <c:pt idx="151">
                  <c:v>0.95914909638554213</c:v>
                </c:pt>
                <c:pt idx="152">
                  <c:v>0.97176204819277112</c:v>
                </c:pt>
                <c:pt idx="153">
                  <c:v>0.95293674698795183</c:v>
                </c:pt>
                <c:pt idx="154">
                  <c:v>0.96969126506024095</c:v>
                </c:pt>
                <c:pt idx="155">
                  <c:v>0.98155120481927716</c:v>
                </c:pt>
                <c:pt idx="156">
                  <c:v>0.99265813253012047</c:v>
                </c:pt>
                <c:pt idx="157">
                  <c:v>0.98832831325301207</c:v>
                </c:pt>
                <c:pt idx="158">
                  <c:v>0.98418674698795183</c:v>
                </c:pt>
                <c:pt idx="159">
                  <c:v>0.97402108433734935</c:v>
                </c:pt>
                <c:pt idx="160">
                  <c:v>0.95990210843373491</c:v>
                </c:pt>
                <c:pt idx="161">
                  <c:v>0.9568900602409639</c:v>
                </c:pt>
                <c:pt idx="162">
                  <c:v>0.99265813253012047</c:v>
                </c:pt>
                <c:pt idx="163">
                  <c:v>0.97740963855421692</c:v>
                </c:pt>
                <c:pt idx="164">
                  <c:v>0.9574548192771084</c:v>
                </c:pt>
                <c:pt idx="165">
                  <c:v>0.98268072289156627</c:v>
                </c:pt>
                <c:pt idx="166">
                  <c:v>0.97383283132530118</c:v>
                </c:pt>
                <c:pt idx="167">
                  <c:v>0.98475150602409633</c:v>
                </c:pt>
                <c:pt idx="168">
                  <c:v>0.97402108433734935</c:v>
                </c:pt>
                <c:pt idx="169">
                  <c:v>0.97910391566265065</c:v>
                </c:pt>
                <c:pt idx="170">
                  <c:v>0.97402108433734935</c:v>
                </c:pt>
                <c:pt idx="171">
                  <c:v>0.98192771084337349</c:v>
                </c:pt>
                <c:pt idx="172">
                  <c:v>0.9743975903614458</c:v>
                </c:pt>
                <c:pt idx="173">
                  <c:v>0.95632530120481929</c:v>
                </c:pt>
                <c:pt idx="174">
                  <c:v>0.96762048192771088</c:v>
                </c:pt>
                <c:pt idx="175">
                  <c:v>0.9706325301204819</c:v>
                </c:pt>
                <c:pt idx="176">
                  <c:v>0.97740963855421692</c:v>
                </c:pt>
                <c:pt idx="177">
                  <c:v>0.9725150602409639</c:v>
                </c:pt>
                <c:pt idx="178">
                  <c:v>0.96969126506024095</c:v>
                </c:pt>
                <c:pt idx="179">
                  <c:v>0.98286897590361444</c:v>
                </c:pt>
                <c:pt idx="180">
                  <c:v>0.97176204819277112</c:v>
                </c:pt>
                <c:pt idx="181">
                  <c:v>0.93844126506024095</c:v>
                </c:pt>
                <c:pt idx="182">
                  <c:v>0.96630271084337349</c:v>
                </c:pt>
                <c:pt idx="183">
                  <c:v>0.93693524096385539</c:v>
                </c:pt>
                <c:pt idx="184">
                  <c:v>0.95105421686746983</c:v>
                </c:pt>
                <c:pt idx="185">
                  <c:v>0.93542921686746983</c:v>
                </c:pt>
                <c:pt idx="186">
                  <c:v>0.93128765060240959</c:v>
                </c:pt>
                <c:pt idx="187">
                  <c:v>0.91415662650602414</c:v>
                </c:pt>
                <c:pt idx="188">
                  <c:v>0.94917168674698793</c:v>
                </c:pt>
                <c:pt idx="189">
                  <c:v>0.93222891566265065</c:v>
                </c:pt>
                <c:pt idx="190">
                  <c:v>0.94371234939759041</c:v>
                </c:pt>
                <c:pt idx="191">
                  <c:v>0.94277108433734935</c:v>
                </c:pt>
                <c:pt idx="192">
                  <c:v>0.94917168674698793</c:v>
                </c:pt>
                <c:pt idx="193">
                  <c:v>0.94691265060240959</c:v>
                </c:pt>
                <c:pt idx="194">
                  <c:v>0.95519578313253017</c:v>
                </c:pt>
                <c:pt idx="195">
                  <c:v>0.93919427710843373</c:v>
                </c:pt>
                <c:pt idx="196">
                  <c:v>0.9493599397590361</c:v>
                </c:pt>
                <c:pt idx="197">
                  <c:v>0.95538403614457834</c:v>
                </c:pt>
                <c:pt idx="198">
                  <c:v>0.93637048192771088</c:v>
                </c:pt>
                <c:pt idx="199">
                  <c:v>0.95274849397590367</c:v>
                </c:pt>
                <c:pt idx="200">
                  <c:v>0.96780873493975905</c:v>
                </c:pt>
                <c:pt idx="201">
                  <c:v>0.96234939759036142</c:v>
                </c:pt>
                <c:pt idx="202">
                  <c:v>0.94164156626506024</c:v>
                </c:pt>
                <c:pt idx="203">
                  <c:v>0.93844126506024095</c:v>
                </c:pt>
                <c:pt idx="204">
                  <c:v>0.94766566265060237</c:v>
                </c:pt>
                <c:pt idx="205">
                  <c:v>0.95538403614457834</c:v>
                </c:pt>
                <c:pt idx="206">
                  <c:v>0.9337349397590361</c:v>
                </c:pt>
                <c:pt idx="207">
                  <c:v>0.96856174698795183</c:v>
                </c:pt>
                <c:pt idx="208">
                  <c:v>0.95839608433734935</c:v>
                </c:pt>
                <c:pt idx="209">
                  <c:v>0.94841867469879515</c:v>
                </c:pt>
                <c:pt idx="210">
                  <c:v>0.94672439759036142</c:v>
                </c:pt>
                <c:pt idx="211">
                  <c:v>0.94785391566265065</c:v>
                </c:pt>
                <c:pt idx="212">
                  <c:v>0.99416415662650603</c:v>
                </c:pt>
                <c:pt idx="213">
                  <c:v>0.97232680722891562</c:v>
                </c:pt>
                <c:pt idx="214">
                  <c:v>0.96046686746987953</c:v>
                </c:pt>
                <c:pt idx="215">
                  <c:v>0.95180722891566261</c:v>
                </c:pt>
                <c:pt idx="216">
                  <c:v>0.96140813253012047</c:v>
                </c:pt>
                <c:pt idx="217">
                  <c:v>0.95613704819277112</c:v>
                </c:pt>
                <c:pt idx="218">
                  <c:v>0.95632530120481929</c:v>
                </c:pt>
                <c:pt idx="219">
                  <c:v>0.93091114457831325</c:v>
                </c:pt>
                <c:pt idx="220">
                  <c:v>0.95557228915662651</c:v>
                </c:pt>
                <c:pt idx="221">
                  <c:v>0.94484186746987953</c:v>
                </c:pt>
                <c:pt idx="222">
                  <c:v>0.9487951807228916</c:v>
                </c:pt>
                <c:pt idx="223">
                  <c:v>0.98079819277108438</c:v>
                </c:pt>
                <c:pt idx="224">
                  <c:v>0.95613704819277112</c:v>
                </c:pt>
                <c:pt idx="225">
                  <c:v>0.96121987951807231</c:v>
                </c:pt>
                <c:pt idx="226">
                  <c:v>0.98475150602409633</c:v>
                </c:pt>
                <c:pt idx="227">
                  <c:v>0.97910391566265065</c:v>
                </c:pt>
                <c:pt idx="228">
                  <c:v>0.95933734939759041</c:v>
                </c:pt>
                <c:pt idx="229">
                  <c:v>0.96159638554216864</c:v>
                </c:pt>
                <c:pt idx="230">
                  <c:v>0.97213855421686746</c:v>
                </c:pt>
                <c:pt idx="231">
                  <c:v>0.98211596385542166</c:v>
                </c:pt>
                <c:pt idx="232">
                  <c:v>0.96893825301204817</c:v>
                </c:pt>
                <c:pt idx="233">
                  <c:v>0.99284638554216864</c:v>
                </c:pt>
                <c:pt idx="234">
                  <c:v>0.97816265060240959</c:v>
                </c:pt>
                <c:pt idx="235">
                  <c:v>0.99265813253012047</c:v>
                </c:pt>
                <c:pt idx="236">
                  <c:v>0.98173945783132532</c:v>
                </c:pt>
                <c:pt idx="237">
                  <c:v>0.98493975903614461</c:v>
                </c:pt>
                <c:pt idx="238">
                  <c:v>0.9800451807228916</c:v>
                </c:pt>
                <c:pt idx="239">
                  <c:v>0.97703313253012047</c:v>
                </c:pt>
                <c:pt idx="240">
                  <c:v>0.99491716867469882</c:v>
                </c:pt>
                <c:pt idx="241">
                  <c:v>0.98569277108433739</c:v>
                </c:pt>
                <c:pt idx="242">
                  <c:v>0.98908132530120485</c:v>
                </c:pt>
                <c:pt idx="243">
                  <c:v>0.95199548192771088</c:v>
                </c:pt>
                <c:pt idx="244">
                  <c:v>0.9493599397590361</c:v>
                </c:pt>
                <c:pt idx="245">
                  <c:v>0.94634789156626509</c:v>
                </c:pt>
                <c:pt idx="246">
                  <c:v>0.9431475903614458</c:v>
                </c:pt>
                <c:pt idx="247">
                  <c:v>0.94521837349397586</c:v>
                </c:pt>
                <c:pt idx="248">
                  <c:v>0.95783132530120485</c:v>
                </c:pt>
                <c:pt idx="249">
                  <c:v>0.94484186746987953</c:v>
                </c:pt>
                <c:pt idx="250">
                  <c:v>0.96178463855421692</c:v>
                </c:pt>
                <c:pt idx="251">
                  <c:v>0.95180722891566261</c:v>
                </c:pt>
                <c:pt idx="252">
                  <c:v>0.93618222891566261</c:v>
                </c:pt>
                <c:pt idx="253">
                  <c:v>0.95801957831325302</c:v>
                </c:pt>
                <c:pt idx="254">
                  <c:v>0.95143072289156627</c:v>
                </c:pt>
                <c:pt idx="255">
                  <c:v>0.93637048192771088</c:v>
                </c:pt>
                <c:pt idx="256">
                  <c:v>0.95218373493975905</c:v>
                </c:pt>
                <c:pt idx="257">
                  <c:v>0.94973644578313254</c:v>
                </c:pt>
                <c:pt idx="258">
                  <c:v>0.97100903614457834</c:v>
                </c:pt>
                <c:pt idx="259">
                  <c:v>0.9824924698795181</c:v>
                </c:pt>
                <c:pt idx="260">
                  <c:v>0.97213855421686746</c:v>
                </c:pt>
                <c:pt idx="261">
                  <c:v>0.98795180722891562</c:v>
                </c:pt>
                <c:pt idx="262">
                  <c:v>0.95048945783132532</c:v>
                </c:pt>
                <c:pt idx="263">
                  <c:v>0.96611445783132532</c:v>
                </c:pt>
                <c:pt idx="264">
                  <c:v>0.95406626506024095</c:v>
                </c:pt>
                <c:pt idx="265">
                  <c:v>0.9706325301204819</c:v>
                </c:pt>
                <c:pt idx="266">
                  <c:v>0.96329066265060237</c:v>
                </c:pt>
                <c:pt idx="267">
                  <c:v>0.96046686746987953</c:v>
                </c:pt>
                <c:pt idx="268">
                  <c:v>0.96234939759036142</c:v>
                </c:pt>
                <c:pt idx="269">
                  <c:v>0.98889307228915657</c:v>
                </c:pt>
                <c:pt idx="270">
                  <c:v>0.96216114457831325</c:v>
                </c:pt>
                <c:pt idx="271">
                  <c:v>0.984375</c:v>
                </c:pt>
                <c:pt idx="272">
                  <c:v>0.97458584337349397</c:v>
                </c:pt>
                <c:pt idx="273">
                  <c:v>0.97082078313253017</c:v>
                </c:pt>
                <c:pt idx="274">
                  <c:v>0.96799698795180722</c:v>
                </c:pt>
                <c:pt idx="275">
                  <c:v>0.96272590361445787</c:v>
                </c:pt>
                <c:pt idx="276">
                  <c:v>0.96140813253012047</c:v>
                </c:pt>
                <c:pt idx="277">
                  <c:v>0.95971385542168675</c:v>
                </c:pt>
                <c:pt idx="278">
                  <c:v>0.97552710843373491</c:v>
                </c:pt>
                <c:pt idx="279">
                  <c:v>0.97684487951807231</c:v>
                </c:pt>
                <c:pt idx="280">
                  <c:v>0.97665662650602414</c:v>
                </c:pt>
                <c:pt idx="281">
                  <c:v>1.0111069277108433</c:v>
                </c:pt>
                <c:pt idx="282">
                  <c:v>0.97326807228915657</c:v>
                </c:pt>
                <c:pt idx="283">
                  <c:v>0.98324548192771088</c:v>
                </c:pt>
                <c:pt idx="284">
                  <c:v>0.95274849397590367</c:v>
                </c:pt>
                <c:pt idx="285">
                  <c:v>0.96347891566265065</c:v>
                </c:pt>
                <c:pt idx="286">
                  <c:v>0.97100903614457834</c:v>
                </c:pt>
                <c:pt idx="287">
                  <c:v>0.98795180722891562</c:v>
                </c:pt>
                <c:pt idx="288">
                  <c:v>0.98851656626506024</c:v>
                </c:pt>
                <c:pt idx="289">
                  <c:v>0.98324548192771088</c:v>
                </c:pt>
                <c:pt idx="290">
                  <c:v>0.99039909638554213</c:v>
                </c:pt>
                <c:pt idx="291">
                  <c:v>0.97910391566265065</c:v>
                </c:pt>
                <c:pt idx="292">
                  <c:v>0.98719879518072284</c:v>
                </c:pt>
                <c:pt idx="293">
                  <c:v>0.98757530120481929</c:v>
                </c:pt>
                <c:pt idx="294">
                  <c:v>0.97157379518072284</c:v>
                </c:pt>
                <c:pt idx="295">
                  <c:v>0.9806099397590361</c:v>
                </c:pt>
                <c:pt idx="296">
                  <c:v>0.96065512048192769</c:v>
                </c:pt>
                <c:pt idx="297">
                  <c:v>0.98418674698795183</c:v>
                </c:pt>
                <c:pt idx="298">
                  <c:v>0.98042168674698793</c:v>
                </c:pt>
                <c:pt idx="299">
                  <c:v>0.96178463855421692</c:v>
                </c:pt>
                <c:pt idx="300">
                  <c:v>0.98268072289156627</c:v>
                </c:pt>
                <c:pt idx="301">
                  <c:v>0.97100903614457834</c:v>
                </c:pt>
                <c:pt idx="302">
                  <c:v>0.96272590361445787</c:v>
                </c:pt>
                <c:pt idx="303">
                  <c:v>0.95331325301204817</c:v>
                </c:pt>
                <c:pt idx="304">
                  <c:v>0.97722138554216864</c:v>
                </c:pt>
                <c:pt idx="305">
                  <c:v>0.97176204819277112</c:v>
                </c:pt>
                <c:pt idx="306">
                  <c:v>0.9787274096385542</c:v>
                </c:pt>
                <c:pt idx="307">
                  <c:v>0.96649096385542166</c:v>
                </c:pt>
                <c:pt idx="308">
                  <c:v>0.95519578313253017</c:v>
                </c:pt>
                <c:pt idx="309">
                  <c:v>0.94841867469879515</c:v>
                </c:pt>
                <c:pt idx="310">
                  <c:v>0.98173945783132532</c:v>
                </c:pt>
                <c:pt idx="311">
                  <c:v>0.95594879518072284</c:v>
                </c:pt>
                <c:pt idx="312">
                  <c:v>0.9493599397590361</c:v>
                </c:pt>
                <c:pt idx="313">
                  <c:v>0.94766566265060237</c:v>
                </c:pt>
                <c:pt idx="314">
                  <c:v>0.92921686746987953</c:v>
                </c:pt>
                <c:pt idx="315">
                  <c:v>0.95331325301204817</c:v>
                </c:pt>
                <c:pt idx="316">
                  <c:v>0.9550075301204819</c:v>
                </c:pt>
                <c:pt idx="317">
                  <c:v>0.92978162650602414</c:v>
                </c:pt>
                <c:pt idx="318">
                  <c:v>0.92921686746987953</c:v>
                </c:pt>
                <c:pt idx="319">
                  <c:v>0.95651355421686746</c:v>
                </c:pt>
                <c:pt idx="320">
                  <c:v>0.93655873493975905</c:v>
                </c:pt>
                <c:pt idx="321">
                  <c:v>0.92451054216867468</c:v>
                </c:pt>
                <c:pt idx="322">
                  <c:v>0.94145331325301207</c:v>
                </c:pt>
                <c:pt idx="323">
                  <c:v>0.94408885542168675</c:v>
                </c:pt>
                <c:pt idx="324">
                  <c:v>0.94446536144578308</c:v>
                </c:pt>
                <c:pt idx="325">
                  <c:v>0.94371234939759041</c:v>
                </c:pt>
                <c:pt idx="326">
                  <c:v>0.93693524096385539</c:v>
                </c:pt>
                <c:pt idx="327">
                  <c:v>0.92658132530120485</c:v>
                </c:pt>
                <c:pt idx="328">
                  <c:v>0.96197289156626509</c:v>
                </c:pt>
                <c:pt idx="329">
                  <c:v>0.93881777108433739</c:v>
                </c:pt>
                <c:pt idx="330">
                  <c:v>0.91679216867469882</c:v>
                </c:pt>
                <c:pt idx="331">
                  <c:v>0.93392319277108438</c:v>
                </c:pt>
                <c:pt idx="332">
                  <c:v>0.93862951807228912</c:v>
                </c:pt>
                <c:pt idx="333">
                  <c:v>0.92112198795180722</c:v>
                </c:pt>
                <c:pt idx="334">
                  <c:v>0.93392319277108438</c:v>
                </c:pt>
                <c:pt idx="335">
                  <c:v>0.9237575301204819</c:v>
                </c:pt>
                <c:pt idx="336">
                  <c:v>0.92338102409638556</c:v>
                </c:pt>
                <c:pt idx="337">
                  <c:v>0.91829819277108438</c:v>
                </c:pt>
                <c:pt idx="338">
                  <c:v>0.92413403614457834</c:v>
                </c:pt>
                <c:pt idx="339">
                  <c:v>0.89363704819277112</c:v>
                </c:pt>
                <c:pt idx="340">
                  <c:v>0.91415662650602414</c:v>
                </c:pt>
                <c:pt idx="341">
                  <c:v>0.93072289156626509</c:v>
                </c:pt>
                <c:pt idx="342">
                  <c:v>0.90794427710843373</c:v>
                </c:pt>
                <c:pt idx="343">
                  <c:v>0.90945030120481929</c:v>
                </c:pt>
                <c:pt idx="344">
                  <c:v>0.90417921686746983</c:v>
                </c:pt>
                <c:pt idx="345">
                  <c:v>0.92074548192771088</c:v>
                </c:pt>
                <c:pt idx="346">
                  <c:v>0.90794427710843373</c:v>
                </c:pt>
                <c:pt idx="347">
                  <c:v>0.8768825301204819</c:v>
                </c:pt>
                <c:pt idx="348">
                  <c:v>0.90982680722891562</c:v>
                </c:pt>
                <c:pt idx="349">
                  <c:v>0.90097891566265065</c:v>
                </c:pt>
                <c:pt idx="350">
                  <c:v>0.90079066265060237</c:v>
                </c:pt>
                <c:pt idx="351">
                  <c:v>0.88384789156626509</c:v>
                </c:pt>
                <c:pt idx="352">
                  <c:v>0.89608433734939763</c:v>
                </c:pt>
                <c:pt idx="353">
                  <c:v>0.87631777108433739</c:v>
                </c:pt>
                <c:pt idx="354">
                  <c:v>0.86652861445783136</c:v>
                </c:pt>
                <c:pt idx="355">
                  <c:v>0.87481174698795183</c:v>
                </c:pt>
                <c:pt idx="356">
                  <c:v>0.90097891566265065</c:v>
                </c:pt>
                <c:pt idx="357">
                  <c:v>0.88328313253012047</c:v>
                </c:pt>
                <c:pt idx="358">
                  <c:v>0.89231927710843373</c:v>
                </c:pt>
                <c:pt idx="359">
                  <c:v>0.91076807228915657</c:v>
                </c:pt>
                <c:pt idx="360">
                  <c:v>0.89194277108433739</c:v>
                </c:pt>
                <c:pt idx="361">
                  <c:v>0.85071536144578308</c:v>
                </c:pt>
                <c:pt idx="362">
                  <c:v>0.88949548192771088</c:v>
                </c:pt>
                <c:pt idx="363">
                  <c:v>0.88855421686746983</c:v>
                </c:pt>
                <c:pt idx="364">
                  <c:v>0.89702560240963858</c:v>
                </c:pt>
                <c:pt idx="365">
                  <c:v>0.90794427710843373</c:v>
                </c:pt>
                <c:pt idx="366">
                  <c:v>0.87782379518072284</c:v>
                </c:pt>
                <c:pt idx="367">
                  <c:v>0.8706701807228916</c:v>
                </c:pt>
                <c:pt idx="368">
                  <c:v>0.85805722891566261</c:v>
                </c:pt>
                <c:pt idx="369">
                  <c:v>0.85805722891566261</c:v>
                </c:pt>
                <c:pt idx="370">
                  <c:v>0.86746987951807231</c:v>
                </c:pt>
                <c:pt idx="371">
                  <c:v>0.87951807228915657</c:v>
                </c:pt>
                <c:pt idx="372">
                  <c:v>0.86276355421686746</c:v>
                </c:pt>
                <c:pt idx="373">
                  <c:v>0.85222138554216864</c:v>
                </c:pt>
                <c:pt idx="374">
                  <c:v>0.88083584337349397</c:v>
                </c:pt>
                <c:pt idx="375">
                  <c:v>0.85824548192771088</c:v>
                </c:pt>
                <c:pt idx="376">
                  <c:v>0.8849774096385542</c:v>
                </c:pt>
                <c:pt idx="377">
                  <c:v>0.90361445783132532</c:v>
                </c:pt>
                <c:pt idx="378">
                  <c:v>0.88591867469879515</c:v>
                </c:pt>
                <c:pt idx="379">
                  <c:v>0.86803463855421692</c:v>
                </c:pt>
                <c:pt idx="380">
                  <c:v>0.87970632530120485</c:v>
                </c:pt>
                <c:pt idx="381">
                  <c:v>0.8650225903614458</c:v>
                </c:pt>
                <c:pt idx="382">
                  <c:v>0.87349397590361444</c:v>
                </c:pt>
                <c:pt idx="383">
                  <c:v>0.88253012048192769</c:v>
                </c:pt>
                <c:pt idx="384">
                  <c:v>0.86295180722891562</c:v>
                </c:pt>
                <c:pt idx="385">
                  <c:v>0.84826807228915657</c:v>
                </c:pt>
                <c:pt idx="386">
                  <c:v>0.85466867469879515</c:v>
                </c:pt>
                <c:pt idx="387">
                  <c:v>0.89909638554216864</c:v>
                </c:pt>
                <c:pt idx="388">
                  <c:v>0.86521084337349397</c:v>
                </c:pt>
                <c:pt idx="389">
                  <c:v>0.87142319277108438</c:v>
                </c:pt>
                <c:pt idx="390">
                  <c:v>0.88403614457831325</c:v>
                </c:pt>
                <c:pt idx="391">
                  <c:v>0.87424698795180722</c:v>
                </c:pt>
                <c:pt idx="392">
                  <c:v>0.89834337349397586</c:v>
                </c:pt>
                <c:pt idx="393">
                  <c:v>0.86389307228915657</c:v>
                </c:pt>
                <c:pt idx="394">
                  <c:v>0.88083584337349397</c:v>
                </c:pt>
                <c:pt idx="395">
                  <c:v>0.88968373493975905</c:v>
                </c:pt>
                <c:pt idx="396">
                  <c:v>0.88648343373493976</c:v>
                </c:pt>
                <c:pt idx="397">
                  <c:v>0.88667168674698793</c:v>
                </c:pt>
                <c:pt idx="398">
                  <c:v>0.87462349397590367</c:v>
                </c:pt>
                <c:pt idx="399">
                  <c:v>0.86897590361445787</c:v>
                </c:pt>
                <c:pt idx="400">
                  <c:v>0.8806475903614458</c:v>
                </c:pt>
                <c:pt idx="401">
                  <c:v>0.87387048192771088</c:v>
                </c:pt>
                <c:pt idx="402">
                  <c:v>0.88083584337349397</c:v>
                </c:pt>
                <c:pt idx="403">
                  <c:v>0.88460090361445787</c:v>
                </c:pt>
                <c:pt idx="404">
                  <c:v>0.88610692771084343</c:v>
                </c:pt>
                <c:pt idx="405">
                  <c:v>0.89194277108433739</c:v>
                </c:pt>
                <c:pt idx="406">
                  <c:v>0.8712349397590361</c:v>
                </c:pt>
                <c:pt idx="407">
                  <c:v>0.86257530120481929</c:v>
                </c:pt>
                <c:pt idx="408">
                  <c:v>0.88121234939759041</c:v>
                </c:pt>
                <c:pt idx="409">
                  <c:v>0.85391566265060237</c:v>
                </c:pt>
                <c:pt idx="410">
                  <c:v>0.87763554216867468</c:v>
                </c:pt>
                <c:pt idx="411">
                  <c:v>0.85448042168674698</c:v>
                </c:pt>
                <c:pt idx="412">
                  <c:v>0.86690512048192769</c:v>
                </c:pt>
                <c:pt idx="413">
                  <c:v>0.87462349397590367</c:v>
                </c:pt>
                <c:pt idx="414">
                  <c:v>0.88460090361445787</c:v>
                </c:pt>
                <c:pt idx="415">
                  <c:v>0.88610692771084343</c:v>
                </c:pt>
                <c:pt idx="416">
                  <c:v>0.87838855421686746</c:v>
                </c:pt>
                <c:pt idx="417">
                  <c:v>0.86295180722891562</c:v>
                </c:pt>
                <c:pt idx="418">
                  <c:v>0.88271837349397586</c:v>
                </c:pt>
                <c:pt idx="419">
                  <c:v>0.87387048192771088</c:v>
                </c:pt>
                <c:pt idx="420">
                  <c:v>0.84826807228915657</c:v>
                </c:pt>
                <c:pt idx="421">
                  <c:v>0.84318524096385539</c:v>
                </c:pt>
                <c:pt idx="422">
                  <c:v>0.88403614457831325</c:v>
                </c:pt>
                <c:pt idx="423">
                  <c:v>0.85730421686746983</c:v>
                </c:pt>
                <c:pt idx="424">
                  <c:v>0.86596385542168675</c:v>
                </c:pt>
                <c:pt idx="425">
                  <c:v>0.85184487951807231</c:v>
                </c:pt>
                <c:pt idx="426">
                  <c:v>0.86652861445783136</c:v>
                </c:pt>
                <c:pt idx="427">
                  <c:v>0.88911897590361444</c:v>
                </c:pt>
                <c:pt idx="428">
                  <c:v>0.8868599397590361</c:v>
                </c:pt>
                <c:pt idx="429">
                  <c:v>0.87085843373493976</c:v>
                </c:pt>
                <c:pt idx="430">
                  <c:v>0.87782379518072284</c:v>
                </c:pt>
                <c:pt idx="431">
                  <c:v>0.87048192771084343</c:v>
                </c:pt>
                <c:pt idx="432">
                  <c:v>0.84732680722891562</c:v>
                </c:pt>
                <c:pt idx="433">
                  <c:v>0.85165662650602414</c:v>
                </c:pt>
                <c:pt idx="434">
                  <c:v>0.87405873493975905</c:v>
                </c:pt>
                <c:pt idx="435">
                  <c:v>0.85975150602409633</c:v>
                </c:pt>
                <c:pt idx="436">
                  <c:v>0.86746987951807231</c:v>
                </c:pt>
                <c:pt idx="437">
                  <c:v>0.8650225903614458</c:v>
                </c:pt>
                <c:pt idx="438">
                  <c:v>0.87951807228915657</c:v>
                </c:pt>
                <c:pt idx="439">
                  <c:v>0.8731174698795181</c:v>
                </c:pt>
                <c:pt idx="440">
                  <c:v>0.85015060240963858</c:v>
                </c:pt>
                <c:pt idx="441">
                  <c:v>0.85542168674698793</c:v>
                </c:pt>
                <c:pt idx="442">
                  <c:v>0.85805722891566261</c:v>
                </c:pt>
                <c:pt idx="443">
                  <c:v>0.84243222891566261</c:v>
                </c:pt>
                <c:pt idx="444">
                  <c:v>0.8612575301204819</c:v>
                </c:pt>
                <c:pt idx="445">
                  <c:v>0.84375</c:v>
                </c:pt>
                <c:pt idx="446">
                  <c:v>0.85090361445783136</c:v>
                </c:pt>
                <c:pt idx="447">
                  <c:v>0.86144578313253017</c:v>
                </c:pt>
                <c:pt idx="448">
                  <c:v>0.8493975903614458</c:v>
                </c:pt>
                <c:pt idx="449">
                  <c:v>0.87330572289156627</c:v>
                </c:pt>
                <c:pt idx="450">
                  <c:v>0.88121234939759041</c:v>
                </c:pt>
                <c:pt idx="451">
                  <c:v>0.87255271084337349</c:v>
                </c:pt>
                <c:pt idx="452">
                  <c:v>0.85448042168674698</c:v>
                </c:pt>
                <c:pt idx="453">
                  <c:v>0.87631777108433739</c:v>
                </c:pt>
                <c:pt idx="454">
                  <c:v>0.87612951807228912</c:v>
                </c:pt>
                <c:pt idx="455">
                  <c:v>0.87292921686746983</c:v>
                </c:pt>
                <c:pt idx="456">
                  <c:v>0.84770331325301207</c:v>
                </c:pt>
                <c:pt idx="457">
                  <c:v>0.8731174698795181</c:v>
                </c:pt>
                <c:pt idx="458">
                  <c:v>0.86445783132530118</c:v>
                </c:pt>
                <c:pt idx="459">
                  <c:v>0.85429216867469882</c:v>
                </c:pt>
                <c:pt idx="460">
                  <c:v>0.87029367469879515</c:v>
                </c:pt>
                <c:pt idx="461">
                  <c:v>0.85391566265060237</c:v>
                </c:pt>
                <c:pt idx="462">
                  <c:v>0.88045933734939763</c:v>
                </c:pt>
                <c:pt idx="463">
                  <c:v>0.85843373493975905</c:v>
                </c:pt>
                <c:pt idx="464">
                  <c:v>0.87763554216867468</c:v>
                </c:pt>
                <c:pt idx="465">
                  <c:v>0.86332831325301207</c:v>
                </c:pt>
                <c:pt idx="466">
                  <c:v>0.86050451807228912</c:v>
                </c:pt>
                <c:pt idx="467">
                  <c:v>0.85165662650602414</c:v>
                </c:pt>
                <c:pt idx="468">
                  <c:v>0.87010542168674698</c:v>
                </c:pt>
                <c:pt idx="469">
                  <c:v>0.84638554216867468</c:v>
                </c:pt>
                <c:pt idx="470">
                  <c:v>0.81852409638554213</c:v>
                </c:pt>
                <c:pt idx="471">
                  <c:v>0.87707078313253017</c:v>
                </c:pt>
                <c:pt idx="472">
                  <c:v>0.86671686746987953</c:v>
                </c:pt>
                <c:pt idx="473">
                  <c:v>0.84149096385542166</c:v>
                </c:pt>
                <c:pt idx="474">
                  <c:v>0.86238704819277112</c:v>
                </c:pt>
                <c:pt idx="475">
                  <c:v>0.85993975903614461</c:v>
                </c:pt>
                <c:pt idx="476">
                  <c:v>0.86012801204819278</c:v>
                </c:pt>
                <c:pt idx="477">
                  <c:v>0.86332831325301207</c:v>
                </c:pt>
                <c:pt idx="478">
                  <c:v>0.84017319277108438</c:v>
                </c:pt>
                <c:pt idx="479">
                  <c:v>0.89269578313253017</c:v>
                </c:pt>
                <c:pt idx="480">
                  <c:v>0.84205572289156627</c:v>
                </c:pt>
                <c:pt idx="481">
                  <c:v>0.84920933734939763</c:v>
                </c:pt>
                <c:pt idx="482">
                  <c:v>0.84544427710843373</c:v>
                </c:pt>
                <c:pt idx="483">
                  <c:v>0.8712349397590361</c:v>
                </c:pt>
                <c:pt idx="484">
                  <c:v>0.86426957831325302</c:v>
                </c:pt>
                <c:pt idx="485">
                  <c:v>0.86351656626506024</c:v>
                </c:pt>
                <c:pt idx="486">
                  <c:v>0.83979668674698793</c:v>
                </c:pt>
                <c:pt idx="487">
                  <c:v>0.85975150602409633</c:v>
                </c:pt>
                <c:pt idx="488">
                  <c:v>0.84864457831325302</c:v>
                </c:pt>
                <c:pt idx="489">
                  <c:v>0.8537274096385542</c:v>
                </c:pt>
                <c:pt idx="490">
                  <c:v>0.84469126506024095</c:v>
                </c:pt>
                <c:pt idx="491">
                  <c:v>0.85033885542168675</c:v>
                </c:pt>
                <c:pt idx="492">
                  <c:v>0.84054969879518071</c:v>
                </c:pt>
                <c:pt idx="493">
                  <c:v>0.84450301204819278</c:v>
                </c:pt>
                <c:pt idx="494">
                  <c:v>0.84262048192771088</c:v>
                </c:pt>
                <c:pt idx="495">
                  <c:v>0.83264307228915657</c:v>
                </c:pt>
                <c:pt idx="496">
                  <c:v>0.84205572289156627</c:v>
                </c:pt>
                <c:pt idx="497">
                  <c:v>0.83829066265060237</c:v>
                </c:pt>
                <c:pt idx="498">
                  <c:v>0.84977409638554213</c:v>
                </c:pt>
                <c:pt idx="499">
                  <c:v>0.84224397590361444</c:v>
                </c:pt>
                <c:pt idx="500">
                  <c:v>0.8537274096385542</c:v>
                </c:pt>
                <c:pt idx="501">
                  <c:v>0.85109186746987953</c:v>
                </c:pt>
                <c:pt idx="502">
                  <c:v>0.8631400602409639</c:v>
                </c:pt>
                <c:pt idx="503">
                  <c:v>0.85805722891566261</c:v>
                </c:pt>
                <c:pt idx="504">
                  <c:v>0.83678463855421692</c:v>
                </c:pt>
                <c:pt idx="505">
                  <c:v>0.82680722891566261</c:v>
                </c:pt>
                <c:pt idx="506">
                  <c:v>0.82304216867469882</c:v>
                </c:pt>
                <c:pt idx="507">
                  <c:v>0.83170180722891562</c:v>
                </c:pt>
                <c:pt idx="508">
                  <c:v>0.83885542168674698</c:v>
                </c:pt>
                <c:pt idx="509">
                  <c:v>0.81852409638554213</c:v>
                </c:pt>
                <c:pt idx="510">
                  <c:v>0.84036144578313254</c:v>
                </c:pt>
                <c:pt idx="511">
                  <c:v>0.86012801204819278</c:v>
                </c:pt>
                <c:pt idx="512">
                  <c:v>0.83471385542168675</c:v>
                </c:pt>
                <c:pt idx="513">
                  <c:v>0.84111445783132532</c:v>
                </c:pt>
                <c:pt idx="514">
                  <c:v>0.84544427710843373</c:v>
                </c:pt>
                <c:pt idx="515">
                  <c:v>0.81306475903614461</c:v>
                </c:pt>
                <c:pt idx="516">
                  <c:v>0.86069277108433739</c:v>
                </c:pt>
                <c:pt idx="517">
                  <c:v>0.8381024096385542</c:v>
                </c:pt>
                <c:pt idx="518">
                  <c:v>0.84506777108433739</c:v>
                </c:pt>
                <c:pt idx="519">
                  <c:v>0.8574924698795181</c:v>
                </c:pt>
                <c:pt idx="520">
                  <c:v>0.82473644578313254</c:v>
                </c:pt>
                <c:pt idx="521">
                  <c:v>0.83904367469879515</c:v>
                </c:pt>
                <c:pt idx="522">
                  <c:v>0.83753765060240959</c:v>
                </c:pt>
                <c:pt idx="523">
                  <c:v>0.83923192771084343</c:v>
                </c:pt>
                <c:pt idx="524">
                  <c:v>0.84657379518072284</c:v>
                </c:pt>
                <c:pt idx="525">
                  <c:v>0.83396084337349397</c:v>
                </c:pt>
                <c:pt idx="526">
                  <c:v>0.84224397590361444</c:v>
                </c:pt>
                <c:pt idx="527">
                  <c:v>0.83396084337349397</c:v>
                </c:pt>
                <c:pt idx="528">
                  <c:v>0.83471385542168675</c:v>
                </c:pt>
                <c:pt idx="529">
                  <c:v>0.80986445783132532</c:v>
                </c:pt>
                <c:pt idx="530">
                  <c:v>0.82793674698795183</c:v>
                </c:pt>
                <c:pt idx="531">
                  <c:v>0.82868975903614461</c:v>
                </c:pt>
                <c:pt idx="532">
                  <c:v>0.80948795180722888</c:v>
                </c:pt>
                <c:pt idx="533">
                  <c:v>0.83960843373493976</c:v>
                </c:pt>
                <c:pt idx="534">
                  <c:v>0.83057228915662651</c:v>
                </c:pt>
                <c:pt idx="535">
                  <c:v>0.82417168674698793</c:v>
                </c:pt>
                <c:pt idx="536">
                  <c:v>0.84167921686746983</c:v>
                </c:pt>
                <c:pt idx="537">
                  <c:v>0.84412650602409633</c:v>
                </c:pt>
                <c:pt idx="538">
                  <c:v>0.82774849397590367</c:v>
                </c:pt>
                <c:pt idx="539">
                  <c:v>0.83678463855421692</c:v>
                </c:pt>
                <c:pt idx="540">
                  <c:v>0.83640813253012047</c:v>
                </c:pt>
                <c:pt idx="541">
                  <c:v>0.8381024096385542</c:v>
                </c:pt>
                <c:pt idx="542">
                  <c:v>0.80421686746987953</c:v>
                </c:pt>
                <c:pt idx="543">
                  <c:v>0.82040662650602414</c:v>
                </c:pt>
                <c:pt idx="544">
                  <c:v>0.81607680722891562</c:v>
                </c:pt>
                <c:pt idx="545">
                  <c:v>0.82774849397590367</c:v>
                </c:pt>
                <c:pt idx="546">
                  <c:v>0.82774849397590367</c:v>
                </c:pt>
                <c:pt idx="547">
                  <c:v>0.84732680722891562</c:v>
                </c:pt>
                <c:pt idx="548">
                  <c:v>0.80572289156626509</c:v>
                </c:pt>
                <c:pt idx="549">
                  <c:v>0.81362951807228912</c:v>
                </c:pt>
                <c:pt idx="550">
                  <c:v>0.81795933734939763</c:v>
                </c:pt>
                <c:pt idx="551">
                  <c:v>0.81965361445783136</c:v>
                </c:pt>
                <c:pt idx="552">
                  <c:v>0.8087349397590361</c:v>
                </c:pt>
                <c:pt idx="553">
                  <c:v>0.82454819277108438</c:v>
                </c:pt>
                <c:pt idx="554">
                  <c:v>0.81137048192771088</c:v>
                </c:pt>
                <c:pt idx="555">
                  <c:v>0.80609939759036142</c:v>
                </c:pt>
                <c:pt idx="556">
                  <c:v>0.82567771084337349</c:v>
                </c:pt>
                <c:pt idx="557">
                  <c:v>0.79819277108433739</c:v>
                </c:pt>
                <c:pt idx="558">
                  <c:v>0.85033885542168675</c:v>
                </c:pt>
                <c:pt idx="559">
                  <c:v>0.83433734939759041</c:v>
                </c:pt>
                <c:pt idx="560">
                  <c:v>0.82228915662650603</c:v>
                </c:pt>
                <c:pt idx="561">
                  <c:v>0.82868975903614461</c:v>
                </c:pt>
                <c:pt idx="562">
                  <c:v>0.81532379518072284</c:v>
                </c:pt>
                <c:pt idx="563">
                  <c:v>0.81645331325301207</c:v>
                </c:pt>
                <c:pt idx="564">
                  <c:v>0.84356174698795183</c:v>
                </c:pt>
                <c:pt idx="565">
                  <c:v>0.82228915662650603</c:v>
                </c:pt>
                <c:pt idx="566">
                  <c:v>0.80496987951807231</c:v>
                </c:pt>
                <c:pt idx="567">
                  <c:v>0.82454819277108438</c:v>
                </c:pt>
                <c:pt idx="568">
                  <c:v>0.81645331325301207</c:v>
                </c:pt>
                <c:pt idx="569">
                  <c:v>0.80609939759036142</c:v>
                </c:pt>
                <c:pt idx="570">
                  <c:v>0.82172439759036142</c:v>
                </c:pt>
                <c:pt idx="571">
                  <c:v>0.80384036144578308</c:v>
                </c:pt>
                <c:pt idx="572">
                  <c:v>0.81946536144578308</c:v>
                </c:pt>
                <c:pt idx="573">
                  <c:v>0.82304216867469882</c:v>
                </c:pt>
                <c:pt idx="574">
                  <c:v>0.84262048192771088</c:v>
                </c:pt>
                <c:pt idx="575">
                  <c:v>0.80591114457831325</c:v>
                </c:pt>
                <c:pt idx="576">
                  <c:v>0.81607680722891562</c:v>
                </c:pt>
                <c:pt idx="577">
                  <c:v>0.82285391566265065</c:v>
                </c:pt>
                <c:pt idx="578">
                  <c:v>0.80892319277108438</c:v>
                </c:pt>
                <c:pt idx="579">
                  <c:v>0.79856927710843373</c:v>
                </c:pt>
                <c:pt idx="580">
                  <c:v>0.80948795180722888</c:v>
                </c:pt>
                <c:pt idx="581">
                  <c:v>0.82078313253012047</c:v>
                </c:pt>
                <c:pt idx="582">
                  <c:v>0.82530120481927716</c:v>
                </c:pt>
                <c:pt idx="583">
                  <c:v>0.81381777108433739</c:v>
                </c:pt>
                <c:pt idx="584">
                  <c:v>0.82680722891566261</c:v>
                </c:pt>
                <c:pt idx="585">
                  <c:v>0.82323042168674698</c:v>
                </c:pt>
                <c:pt idx="586">
                  <c:v>0.81287650602409633</c:v>
                </c:pt>
                <c:pt idx="587">
                  <c:v>0.83151355421686746</c:v>
                </c:pt>
                <c:pt idx="588">
                  <c:v>0.81325301204819278</c:v>
                </c:pt>
                <c:pt idx="589">
                  <c:v>0.82078313253012047</c:v>
                </c:pt>
                <c:pt idx="590">
                  <c:v>0.8243599397590361</c:v>
                </c:pt>
                <c:pt idx="591">
                  <c:v>0.83509036144578308</c:v>
                </c:pt>
                <c:pt idx="592">
                  <c:v>0.82021837349397586</c:v>
                </c:pt>
                <c:pt idx="593">
                  <c:v>0.79235692771084343</c:v>
                </c:pt>
                <c:pt idx="594">
                  <c:v>0.81212349397590367</c:v>
                </c:pt>
                <c:pt idx="595">
                  <c:v>0.81871234939759041</c:v>
                </c:pt>
                <c:pt idx="596">
                  <c:v>0.80948795180722888</c:v>
                </c:pt>
                <c:pt idx="597">
                  <c:v>0.80101656626506024</c:v>
                </c:pt>
                <c:pt idx="598">
                  <c:v>0.79047439759036142</c:v>
                </c:pt>
                <c:pt idx="599">
                  <c:v>0.82398343373493976</c:v>
                </c:pt>
                <c:pt idx="600">
                  <c:v>0.81645331325301207</c:v>
                </c:pt>
                <c:pt idx="601">
                  <c:v>0.82191265060240959</c:v>
                </c:pt>
                <c:pt idx="602">
                  <c:v>0.82417168674698793</c:v>
                </c:pt>
                <c:pt idx="603">
                  <c:v>0.83113704819277112</c:v>
                </c:pt>
                <c:pt idx="604">
                  <c:v>0.81871234939759041</c:v>
                </c:pt>
                <c:pt idx="605">
                  <c:v>0.7912274096385542</c:v>
                </c:pt>
                <c:pt idx="606">
                  <c:v>0.80666415662650603</c:v>
                </c:pt>
                <c:pt idx="607">
                  <c:v>0.82191265060240959</c:v>
                </c:pt>
                <c:pt idx="608">
                  <c:v>0.80986445783132532</c:v>
                </c:pt>
                <c:pt idx="609">
                  <c:v>0.8125</c:v>
                </c:pt>
                <c:pt idx="610">
                  <c:v>0.79725150602409633</c:v>
                </c:pt>
                <c:pt idx="611">
                  <c:v>0.81024096385542166</c:v>
                </c:pt>
                <c:pt idx="612">
                  <c:v>0.79762801204819278</c:v>
                </c:pt>
                <c:pt idx="613">
                  <c:v>0.8181475903614458</c:v>
                </c:pt>
                <c:pt idx="614">
                  <c:v>0.80402861445783136</c:v>
                </c:pt>
                <c:pt idx="615">
                  <c:v>0.80911144578313254</c:v>
                </c:pt>
                <c:pt idx="616">
                  <c:v>0.81777108433734935</c:v>
                </c:pt>
                <c:pt idx="617">
                  <c:v>0.81325301204819278</c:v>
                </c:pt>
                <c:pt idx="618">
                  <c:v>0.80553463855421692</c:v>
                </c:pt>
                <c:pt idx="619">
                  <c:v>0.8025225903614458</c:v>
                </c:pt>
                <c:pt idx="620">
                  <c:v>0.80929969879518071</c:v>
                </c:pt>
                <c:pt idx="621">
                  <c:v>0.80421686746987953</c:v>
                </c:pt>
                <c:pt idx="622">
                  <c:v>0.79762801204819278</c:v>
                </c:pt>
                <c:pt idx="623">
                  <c:v>0.80271084337349397</c:v>
                </c:pt>
                <c:pt idx="624">
                  <c:v>0.79329819277108438</c:v>
                </c:pt>
                <c:pt idx="625">
                  <c:v>0.81268825301204817</c:v>
                </c:pt>
                <c:pt idx="626">
                  <c:v>0.78953313253012047</c:v>
                </c:pt>
                <c:pt idx="627">
                  <c:v>0.80534638554216864</c:v>
                </c:pt>
                <c:pt idx="628">
                  <c:v>0.79103915662650603</c:v>
                </c:pt>
                <c:pt idx="629">
                  <c:v>0.78463855421686746</c:v>
                </c:pt>
                <c:pt idx="630">
                  <c:v>0.79593373493975905</c:v>
                </c:pt>
                <c:pt idx="631">
                  <c:v>0.79329819277108438</c:v>
                </c:pt>
                <c:pt idx="632">
                  <c:v>0.79725150602409633</c:v>
                </c:pt>
                <c:pt idx="633">
                  <c:v>0.81381777108433739</c:v>
                </c:pt>
                <c:pt idx="634">
                  <c:v>0.80929969879518071</c:v>
                </c:pt>
                <c:pt idx="635">
                  <c:v>0.81080572289156627</c:v>
                </c:pt>
                <c:pt idx="636">
                  <c:v>0.80459337349397586</c:v>
                </c:pt>
                <c:pt idx="637">
                  <c:v>0.82266566265060237</c:v>
                </c:pt>
                <c:pt idx="638">
                  <c:v>0.80572289156626509</c:v>
                </c:pt>
                <c:pt idx="639">
                  <c:v>0.796875</c:v>
                </c:pt>
                <c:pt idx="640">
                  <c:v>0.78445030120481929</c:v>
                </c:pt>
                <c:pt idx="641">
                  <c:v>0.77635542168674698</c:v>
                </c:pt>
                <c:pt idx="642">
                  <c:v>0.8025225903614458</c:v>
                </c:pt>
                <c:pt idx="643">
                  <c:v>0.80967620481927716</c:v>
                </c:pt>
                <c:pt idx="644">
                  <c:v>0.79706325301204817</c:v>
                </c:pt>
                <c:pt idx="645">
                  <c:v>0.80911144578313254</c:v>
                </c:pt>
                <c:pt idx="646">
                  <c:v>0.80365210843373491</c:v>
                </c:pt>
                <c:pt idx="647">
                  <c:v>0.80045180722891562</c:v>
                </c:pt>
                <c:pt idx="648">
                  <c:v>0.78915662650602414</c:v>
                </c:pt>
                <c:pt idx="649">
                  <c:v>0.79405120481927716</c:v>
                </c:pt>
                <c:pt idx="650">
                  <c:v>0.79555722891566261</c:v>
                </c:pt>
                <c:pt idx="651">
                  <c:v>0.78708584337349397</c:v>
                </c:pt>
                <c:pt idx="652">
                  <c:v>0.7949924698795181</c:v>
                </c:pt>
                <c:pt idx="653">
                  <c:v>0.80440512048192769</c:v>
                </c:pt>
                <c:pt idx="654">
                  <c:v>0.82605421686746983</c:v>
                </c:pt>
                <c:pt idx="655">
                  <c:v>0.81758283132530118</c:v>
                </c:pt>
                <c:pt idx="656">
                  <c:v>0.77899096385542166</c:v>
                </c:pt>
                <c:pt idx="657">
                  <c:v>0.76863704819277112</c:v>
                </c:pt>
                <c:pt idx="658">
                  <c:v>0.79235692771084343</c:v>
                </c:pt>
                <c:pt idx="659">
                  <c:v>0.76826054216867468</c:v>
                </c:pt>
                <c:pt idx="660">
                  <c:v>0.79762801204819278</c:v>
                </c:pt>
                <c:pt idx="661">
                  <c:v>0.80139307228915657</c:v>
                </c:pt>
                <c:pt idx="662">
                  <c:v>0.76788403614457834</c:v>
                </c:pt>
                <c:pt idx="663">
                  <c:v>0.78840361445783136</c:v>
                </c:pt>
                <c:pt idx="664">
                  <c:v>0.77334337349397586</c:v>
                </c:pt>
                <c:pt idx="665">
                  <c:v>0.78445030120481929</c:v>
                </c:pt>
                <c:pt idx="666">
                  <c:v>0.78030873493975905</c:v>
                </c:pt>
                <c:pt idx="667">
                  <c:v>0.80101656626506024</c:v>
                </c:pt>
                <c:pt idx="668">
                  <c:v>0.77899096385542166</c:v>
                </c:pt>
                <c:pt idx="669">
                  <c:v>0.76355421686746983</c:v>
                </c:pt>
                <c:pt idx="670">
                  <c:v>0.7850150602409639</c:v>
                </c:pt>
                <c:pt idx="671">
                  <c:v>0.79631024096385539</c:v>
                </c:pt>
                <c:pt idx="672">
                  <c:v>0.79894578313253017</c:v>
                </c:pt>
                <c:pt idx="673">
                  <c:v>0.80214608433734935</c:v>
                </c:pt>
                <c:pt idx="674">
                  <c:v>0.80007530120481929</c:v>
                </c:pt>
                <c:pt idx="675">
                  <c:v>0.77861445783132532</c:v>
                </c:pt>
                <c:pt idx="676">
                  <c:v>0.76976656626506024</c:v>
                </c:pt>
                <c:pt idx="677">
                  <c:v>0.78859186746987953</c:v>
                </c:pt>
                <c:pt idx="678">
                  <c:v>0.78746234939759041</c:v>
                </c:pt>
                <c:pt idx="679">
                  <c:v>0.80421686746987953</c:v>
                </c:pt>
                <c:pt idx="680">
                  <c:v>0.78426204819277112</c:v>
                </c:pt>
                <c:pt idx="681">
                  <c:v>0.7912274096385542</c:v>
                </c:pt>
                <c:pt idx="682">
                  <c:v>0.77164909638554213</c:v>
                </c:pt>
                <c:pt idx="683">
                  <c:v>0.78162650602409633</c:v>
                </c:pt>
                <c:pt idx="684">
                  <c:v>0.78237951807228912</c:v>
                </c:pt>
                <c:pt idx="685">
                  <c:v>0.78915662650602414</c:v>
                </c:pt>
                <c:pt idx="686">
                  <c:v>0.78332078313253017</c:v>
                </c:pt>
                <c:pt idx="687">
                  <c:v>0.7855798192771084</c:v>
                </c:pt>
                <c:pt idx="688">
                  <c:v>0.80139307228915657</c:v>
                </c:pt>
                <c:pt idx="689">
                  <c:v>0.77315512048192769</c:v>
                </c:pt>
                <c:pt idx="690">
                  <c:v>0.79179216867469882</c:v>
                </c:pt>
                <c:pt idx="691">
                  <c:v>0.76637801204819278</c:v>
                </c:pt>
                <c:pt idx="692">
                  <c:v>0.76920180722891562</c:v>
                </c:pt>
                <c:pt idx="693">
                  <c:v>0.79555722891566261</c:v>
                </c:pt>
                <c:pt idx="694">
                  <c:v>0.78727409638554213</c:v>
                </c:pt>
                <c:pt idx="695">
                  <c:v>0.76844879518072284</c:v>
                </c:pt>
                <c:pt idx="696">
                  <c:v>0.80082831325301207</c:v>
                </c:pt>
                <c:pt idx="697">
                  <c:v>0.77823795180722888</c:v>
                </c:pt>
                <c:pt idx="698">
                  <c:v>0.79593373493975905</c:v>
                </c:pt>
                <c:pt idx="699">
                  <c:v>0.80101656626506024</c:v>
                </c:pt>
                <c:pt idx="700">
                  <c:v>0.78426204819277112</c:v>
                </c:pt>
                <c:pt idx="701">
                  <c:v>0.76355421686746983</c:v>
                </c:pt>
                <c:pt idx="702">
                  <c:v>0.79198042168674698</c:v>
                </c:pt>
                <c:pt idx="703">
                  <c:v>0.76731927710843373</c:v>
                </c:pt>
                <c:pt idx="704">
                  <c:v>0.75847138554216864</c:v>
                </c:pt>
                <c:pt idx="705">
                  <c:v>0.78125</c:v>
                </c:pt>
                <c:pt idx="706">
                  <c:v>0.78143825301204817</c:v>
                </c:pt>
                <c:pt idx="707">
                  <c:v>0.77221385542168675</c:v>
                </c:pt>
                <c:pt idx="708">
                  <c:v>0.77673192771084343</c:v>
                </c:pt>
                <c:pt idx="709">
                  <c:v>0.78802710843373491</c:v>
                </c:pt>
                <c:pt idx="710">
                  <c:v>0.78106174698795183</c:v>
                </c:pt>
                <c:pt idx="711">
                  <c:v>0.76449548192771088</c:v>
                </c:pt>
                <c:pt idx="712">
                  <c:v>0.78576807228915657</c:v>
                </c:pt>
                <c:pt idx="713">
                  <c:v>0.77428463855421692</c:v>
                </c:pt>
                <c:pt idx="714">
                  <c:v>0.79800451807228912</c:v>
                </c:pt>
                <c:pt idx="715">
                  <c:v>0.77409638554216864</c:v>
                </c:pt>
                <c:pt idx="716">
                  <c:v>0.76411897590361444</c:v>
                </c:pt>
                <c:pt idx="717">
                  <c:v>0.79216867469879515</c:v>
                </c:pt>
                <c:pt idx="718">
                  <c:v>0.81381777108433739</c:v>
                </c:pt>
                <c:pt idx="719">
                  <c:v>0.77522590361445787</c:v>
                </c:pt>
                <c:pt idx="720">
                  <c:v>0.79273343373493976</c:v>
                </c:pt>
                <c:pt idx="721">
                  <c:v>0.80195783132530118</c:v>
                </c:pt>
                <c:pt idx="722">
                  <c:v>0.79423945783132532</c:v>
                </c:pt>
                <c:pt idx="723">
                  <c:v>0.76411897590361444</c:v>
                </c:pt>
                <c:pt idx="724">
                  <c:v>0.76713102409638556</c:v>
                </c:pt>
                <c:pt idx="725">
                  <c:v>0.74868222891566261</c:v>
                </c:pt>
                <c:pt idx="726">
                  <c:v>0.77880271084337349</c:v>
                </c:pt>
                <c:pt idx="727">
                  <c:v>0.76882530120481929</c:v>
                </c:pt>
                <c:pt idx="728">
                  <c:v>0.78256777108433739</c:v>
                </c:pt>
                <c:pt idx="729">
                  <c:v>0.79216867469879515</c:v>
                </c:pt>
                <c:pt idx="730">
                  <c:v>0.75884789156626509</c:v>
                </c:pt>
                <c:pt idx="731">
                  <c:v>0.78652108433734935</c:v>
                </c:pt>
                <c:pt idx="732">
                  <c:v>0.77390813253012047</c:v>
                </c:pt>
                <c:pt idx="733">
                  <c:v>0.7774849397590361</c:v>
                </c:pt>
                <c:pt idx="734">
                  <c:v>0.74962349397590367</c:v>
                </c:pt>
                <c:pt idx="735">
                  <c:v>0.77616716867469882</c:v>
                </c:pt>
                <c:pt idx="736">
                  <c:v>0.77786144578313254</c:v>
                </c:pt>
                <c:pt idx="737">
                  <c:v>0.76863704819277112</c:v>
                </c:pt>
                <c:pt idx="738">
                  <c:v>0.76637801204819278</c:v>
                </c:pt>
                <c:pt idx="739">
                  <c:v>0.75395331325301207</c:v>
                </c:pt>
                <c:pt idx="740">
                  <c:v>0.75451807228915657</c:v>
                </c:pt>
                <c:pt idx="741">
                  <c:v>0.78125</c:v>
                </c:pt>
                <c:pt idx="742">
                  <c:v>0.7537650602409639</c:v>
                </c:pt>
                <c:pt idx="743">
                  <c:v>0.76656626506024095</c:v>
                </c:pt>
                <c:pt idx="744">
                  <c:v>0.76713102409638556</c:v>
                </c:pt>
                <c:pt idx="745">
                  <c:v>0.77108433734939763</c:v>
                </c:pt>
                <c:pt idx="746">
                  <c:v>0.75301204819277112</c:v>
                </c:pt>
                <c:pt idx="747">
                  <c:v>0.7699548192771084</c:v>
                </c:pt>
                <c:pt idx="748">
                  <c:v>0.74981174698795183</c:v>
                </c:pt>
                <c:pt idx="749">
                  <c:v>0.74077560240963858</c:v>
                </c:pt>
                <c:pt idx="750">
                  <c:v>0.76223644578313254</c:v>
                </c:pt>
                <c:pt idx="751">
                  <c:v>0.76167168674698793</c:v>
                </c:pt>
                <c:pt idx="752">
                  <c:v>0.77823795180722888</c:v>
                </c:pt>
                <c:pt idx="753">
                  <c:v>0.7543298192771084</c:v>
                </c:pt>
                <c:pt idx="754">
                  <c:v>0.77635542168674698</c:v>
                </c:pt>
                <c:pt idx="755">
                  <c:v>0.7556475903614458</c:v>
                </c:pt>
                <c:pt idx="756">
                  <c:v>0.76110692771084343</c:v>
                </c:pt>
                <c:pt idx="757">
                  <c:v>0.75470632530120485</c:v>
                </c:pt>
                <c:pt idx="758">
                  <c:v>0.77447289156626509</c:v>
                </c:pt>
                <c:pt idx="759">
                  <c:v>0.76298945783132532</c:v>
                </c:pt>
                <c:pt idx="760">
                  <c:v>0.74209337349397586</c:v>
                </c:pt>
                <c:pt idx="761">
                  <c:v>0.73983433734939763</c:v>
                </c:pt>
                <c:pt idx="762">
                  <c:v>0.77579066265060237</c:v>
                </c:pt>
                <c:pt idx="763">
                  <c:v>0.75922439759036142</c:v>
                </c:pt>
                <c:pt idx="764">
                  <c:v>0.76731927710843373</c:v>
                </c:pt>
                <c:pt idx="765">
                  <c:v>0.75903614457831325</c:v>
                </c:pt>
                <c:pt idx="766">
                  <c:v>0.75545933734939763</c:v>
                </c:pt>
                <c:pt idx="767">
                  <c:v>0.74077560240963858</c:v>
                </c:pt>
                <c:pt idx="768">
                  <c:v>0.7793674698795181</c:v>
                </c:pt>
                <c:pt idx="769">
                  <c:v>0.77353162650602414</c:v>
                </c:pt>
                <c:pt idx="770">
                  <c:v>0.77296686746987953</c:v>
                </c:pt>
                <c:pt idx="771">
                  <c:v>0.76204819277108438</c:v>
                </c:pt>
                <c:pt idx="772">
                  <c:v>0.77710843373493976</c:v>
                </c:pt>
                <c:pt idx="773">
                  <c:v>0.76826054216867468</c:v>
                </c:pt>
                <c:pt idx="774">
                  <c:v>0.7855798192771084</c:v>
                </c:pt>
                <c:pt idx="775">
                  <c:v>0.76167168674698793</c:v>
                </c:pt>
                <c:pt idx="776">
                  <c:v>0.75338855421686746</c:v>
                </c:pt>
                <c:pt idx="777">
                  <c:v>0.77880271084337349</c:v>
                </c:pt>
                <c:pt idx="778">
                  <c:v>0.7756024096385542</c:v>
                </c:pt>
                <c:pt idx="779">
                  <c:v>0.77484939759036142</c:v>
                </c:pt>
                <c:pt idx="780">
                  <c:v>0.77296686746987953</c:v>
                </c:pt>
                <c:pt idx="781">
                  <c:v>0.76091867469879515</c:v>
                </c:pt>
                <c:pt idx="782">
                  <c:v>0.75790662650602414</c:v>
                </c:pt>
                <c:pt idx="783">
                  <c:v>0.76920180722891562</c:v>
                </c:pt>
                <c:pt idx="784">
                  <c:v>0.77466114457831325</c:v>
                </c:pt>
                <c:pt idx="785">
                  <c:v>0.77259036144578308</c:v>
                </c:pt>
                <c:pt idx="786">
                  <c:v>0.77880271084337349</c:v>
                </c:pt>
                <c:pt idx="787">
                  <c:v>0.7850150602409639</c:v>
                </c:pt>
                <c:pt idx="788">
                  <c:v>0.77164909638554213</c:v>
                </c:pt>
                <c:pt idx="789">
                  <c:v>0.7699548192771084</c:v>
                </c:pt>
                <c:pt idx="790">
                  <c:v>0.77108433734939763</c:v>
                </c:pt>
                <c:pt idx="791">
                  <c:v>0.76656626506024095</c:v>
                </c:pt>
                <c:pt idx="792">
                  <c:v>0.75715361445783136</c:v>
                </c:pt>
                <c:pt idx="793">
                  <c:v>0.75734186746987953</c:v>
                </c:pt>
                <c:pt idx="794">
                  <c:v>0.75037650602409633</c:v>
                </c:pt>
                <c:pt idx="795">
                  <c:v>0.7912274096385542</c:v>
                </c:pt>
                <c:pt idx="796">
                  <c:v>0.77974397590361444</c:v>
                </c:pt>
                <c:pt idx="797">
                  <c:v>0.76807228915662651</c:v>
                </c:pt>
                <c:pt idx="798">
                  <c:v>0.75715361445783136</c:v>
                </c:pt>
                <c:pt idx="799">
                  <c:v>0.77673192771084343</c:v>
                </c:pt>
                <c:pt idx="800">
                  <c:v>0.77334337349397586</c:v>
                </c:pt>
                <c:pt idx="801">
                  <c:v>0.7712725903614458</c:v>
                </c:pt>
                <c:pt idx="802">
                  <c:v>0.76393072289156627</c:v>
                </c:pt>
                <c:pt idx="803">
                  <c:v>0.76317771084337349</c:v>
                </c:pt>
                <c:pt idx="804">
                  <c:v>0.78802710843373491</c:v>
                </c:pt>
                <c:pt idx="805">
                  <c:v>0.7793674698795181</c:v>
                </c:pt>
                <c:pt idx="806">
                  <c:v>0.76826054216867468</c:v>
                </c:pt>
                <c:pt idx="807">
                  <c:v>0.77616716867469882</c:v>
                </c:pt>
                <c:pt idx="808">
                  <c:v>0.78162650602409633</c:v>
                </c:pt>
                <c:pt idx="809">
                  <c:v>0.76336596385542166</c:v>
                </c:pt>
                <c:pt idx="810">
                  <c:v>0.78162650602409633</c:v>
                </c:pt>
                <c:pt idx="811">
                  <c:v>0.7769201807228916</c:v>
                </c:pt>
                <c:pt idx="812">
                  <c:v>0.76863704819277112</c:v>
                </c:pt>
                <c:pt idx="813">
                  <c:v>0.76826054216867468</c:v>
                </c:pt>
                <c:pt idx="814">
                  <c:v>0.75734186746987953</c:v>
                </c:pt>
                <c:pt idx="815">
                  <c:v>0.7774849397590361</c:v>
                </c:pt>
                <c:pt idx="816">
                  <c:v>0.78576807228915657</c:v>
                </c:pt>
                <c:pt idx="817">
                  <c:v>0.76882530120481929</c:v>
                </c:pt>
                <c:pt idx="818">
                  <c:v>0.77051957831325302</c:v>
                </c:pt>
                <c:pt idx="819">
                  <c:v>0.77993222891566261</c:v>
                </c:pt>
                <c:pt idx="820">
                  <c:v>0.76731927710843373</c:v>
                </c:pt>
                <c:pt idx="821">
                  <c:v>0.77089608433734935</c:v>
                </c:pt>
                <c:pt idx="822">
                  <c:v>0.76223644578313254</c:v>
                </c:pt>
                <c:pt idx="823">
                  <c:v>0.78294427710843373</c:v>
                </c:pt>
                <c:pt idx="824">
                  <c:v>0.75753012048192769</c:v>
                </c:pt>
                <c:pt idx="825">
                  <c:v>0.77842620481927716</c:v>
                </c:pt>
                <c:pt idx="826">
                  <c:v>0.7543298192771084</c:v>
                </c:pt>
                <c:pt idx="827">
                  <c:v>0.76844879518072284</c:v>
                </c:pt>
                <c:pt idx="828">
                  <c:v>0.78087349397590367</c:v>
                </c:pt>
                <c:pt idx="829">
                  <c:v>0.76957831325301207</c:v>
                </c:pt>
                <c:pt idx="830">
                  <c:v>0.76449548192771088</c:v>
                </c:pt>
                <c:pt idx="831">
                  <c:v>0.74981174698795183</c:v>
                </c:pt>
                <c:pt idx="832">
                  <c:v>0.76656626506024095</c:v>
                </c:pt>
                <c:pt idx="833">
                  <c:v>0.76882530120481929</c:v>
                </c:pt>
                <c:pt idx="834">
                  <c:v>0.77164909638554213</c:v>
                </c:pt>
                <c:pt idx="835">
                  <c:v>0.77484939759036142</c:v>
                </c:pt>
                <c:pt idx="836">
                  <c:v>0.74736445783132532</c:v>
                </c:pt>
                <c:pt idx="837">
                  <c:v>0.75715361445783136</c:v>
                </c:pt>
                <c:pt idx="838">
                  <c:v>0.75489457831325302</c:v>
                </c:pt>
                <c:pt idx="839">
                  <c:v>0.74096385542168675</c:v>
                </c:pt>
                <c:pt idx="840">
                  <c:v>0.76430722891566261</c:v>
                </c:pt>
                <c:pt idx="841">
                  <c:v>0.77974397590361444</c:v>
                </c:pt>
                <c:pt idx="842">
                  <c:v>0.76430722891566261</c:v>
                </c:pt>
                <c:pt idx="843">
                  <c:v>0.76844879518072284</c:v>
                </c:pt>
                <c:pt idx="844">
                  <c:v>0.77033132530120485</c:v>
                </c:pt>
                <c:pt idx="845">
                  <c:v>0.77353162650602414</c:v>
                </c:pt>
                <c:pt idx="846">
                  <c:v>0.76261295180722888</c:v>
                </c:pt>
                <c:pt idx="847">
                  <c:v>0.77654367469879515</c:v>
                </c:pt>
                <c:pt idx="848">
                  <c:v>0.76882530120481929</c:v>
                </c:pt>
                <c:pt idx="849">
                  <c:v>0.7793674698795181</c:v>
                </c:pt>
                <c:pt idx="850">
                  <c:v>0.76355421686746983</c:v>
                </c:pt>
                <c:pt idx="851">
                  <c:v>0.79725150602409633</c:v>
                </c:pt>
                <c:pt idx="852">
                  <c:v>0.76148343373493976</c:v>
                </c:pt>
                <c:pt idx="853">
                  <c:v>0.78162650602409633</c:v>
                </c:pt>
                <c:pt idx="854">
                  <c:v>0.76487198795180722</c:v>
                </c:pt>
                <c:pt idx="855">
                  <c:v>0.77823795180722888</c:v>
                </c:pt>
                <c:pt idx="856">
                  <c:v>0.7774849397590361</c:v>
                </c:pt>
                <c:pt idx="857">
                  <c:v>0.76298945783132532</c:v>
                </c:pt>
                <c:pt idx="858">
                  <c:v>0.75922439759036142</c:v>
                </c:pt>
                <c:pt idx="859">
                  <c:v>0.74115210843373491</c:v>
                </c:pt>
                <c:pt idx="860">
                  <c:v>0.76355421686746983</c:v>
                </c:pt>
                <c:pt idx="861">
                  <c:v>0.77033132530120485</c:v>
                </c:pt>
                <c:pt idx="862">
                  <c:v>0.7556475903614458</c:v>
                </c:pt>
                <c:pt idx="863">
                  <c:v>0.74962349397590367</c:v>
                </c:pt>
                <c:pt idx="864">
                  <c:v>0.77541415662650603</c:v>
                </c:pt>
                <c:pt idx="865">
                  <c:v>0.76524849397590367</c:v>
                </c:pt>
                <c:pt idx="866">
                  <c:v>0.75018825301204817</c:v>
                </c:pt>
                <c:pt idx="867">
                  <c:v>0.73983433734939763</c:v>
                </c:pt>
                <c:pt idx="868">
                  <c:v>0.74491716867469882</c:v>
                </c:pt>
                <c:pt idx="869">
                  <c:v>0.75658885542168675</c:v>
                </c:pt>
                <c:pt idx="870">
                  <c:v>0.76016566265060237</c:v>
                </c:pt>
                <c:pt idx="871">
                  <c:v>0.77635542168674698</c:v>
                </c:pt>
                <c:pt idx="872">
                  <c:v>0.79235692771084343</c:v>
                </c:pt>
                <c:pt idx="873">
                  <c:v>0.78294427710843373</c:v>
                </c:pt>
                <c:pt idx="874">
                  <c:v>0.76769578313253017</c:v>
                </c:pt>
                <c:pt idx="875">
                  <c:v>0.77579066265060237</c:v>
                </c:pt>
                <c:pt idx="876">
                  <c:v>0.76581325301204817</c:v>
                </c:pt>
                <c:pt idx="877">
                  <c:v>0.76957831325301207</c:v>
                </c:pt>
                <c:pt idx="878">
                  <c:v>0.76731927710843373</c:v>
                </c:pt>
                <c:pt idx="879">
                  <c:v>0.76675451807228912</c:v>
                </c:pt>
                <c:pt idx="880">
                  <c:v>0.77014307228915657</c:v>
                </c:pt>
                <c:pt idx="881">
                  <c:v>0.7443524096385542</c:v>
                </c:pt>
                <c:pt idx="882">
                  <c:v>0.75922439759036142</c:v>
                </c:pt>
                <c:pt idx="883">
                  <c:v>0.77371987951807231</c:v>
                </c:pt>
                <c:pt idx="884">
                  <c:v>0.77955572289156627</c:v>
                </c:pt>
                <c:pt idx="885">
                  <c:v>0.78388554216867468</c:v>
                </c:pt>
                <c:pt idx="886">
                  <c:v>0.7756024096385542</c:v>
                </c:pt>
                <c:pt idx="887">
                  <c:v>0.77503765060240959</c:v>
                </c:pt>
                <c:pt idx="888">
                  <c:v>0.75508283132530118</c:v>
                </c:pt>
                <c:pt idx="889">
                  <c:v>0.77880271084337349</c:v>
                </c:pt>
                <c:pt idx="890">
                  <c:v>0.78445030120481929</c:v>
                </c:pt>
                <c:pt idx="891">
                  <c:v>0.79800451807228912</c:v>
                </c:pt>
                <c:pt idx="892">
                  <c:v>0.77955572289156627</c:v>
                </c:pt>
                <c:pt idx="893">
                  <c:v>0.78746234939759041</c:v>
                </c:pt>
                <c:pt idx="894">
                  <c:v>0.78369728915662651</c:v>
                </c:pt>
                <c:pt idx="895">
                  <c:v>0.77353162650602414</c:v>
                </c:pt>
                <c:pt idx="896">
                  <c:v>0.79066265060240959</c:v>
                </c:pt>
                <c:pt idx="897">
                  <c:v>0.78463855421686746</c:v>
                </c:pt>
                <c:pt idx="898">
                  <c:v>0.75677710843373491</c:v>
                </c:pt>
                <c:pt idx="899">
                  <c:v>0.76449548192771088</c:v>
                </c:pt>
                <c:pt idx="900">
                  <c:v>0.77409638554216864</c:v>
                </c:pt>
                <c:pt idx="901">
                  <c:v>0.7518825301204819</c:v>
                </c:pt>
                <c:pt idx="902">
                  <c:v>0.73908132530120485</c:v>
                </c:pt>
                <c:pt idx="903">
                  <c:v>0.77861445783132532</c:v>
                </c:pt>
                <c:pt idx="904">
                  <c:v>0.78181475903614461</c:v>
                </c:pt>
                <c:pt idx="905">
                  <c:v>0.79781626506024095</c:v>
                </c:pt>
                <c:pt idx="906">
                  <c:v>0.78012048192771088</c:v>
                </c:pt>
                <c:pt idx="907">
                  <c:v>0.76920180722891562</c:v>
                </c:pt>
                <c:pt idx="908">
                  <c:v>0.76355421686746983</c:v>
                </c:pt>
                <c:pt idx="909">
                  <c:v>0.77842620481927716</c:v>
                </c:pt>
                <c:pt idx="910">
                  <c:v>0.77729668674698793</c:v>
                </c:pt>
                <c:pt idx="911">
                  <c:v>0.76298945783132532</c:v>
                </c:pt>
                <c:pt idx="912">
                  <c:v>0.79179216867469882</c:v>
                </c:pt>
                <c:pt idx="913">
                  <c:v>0.8006400602409639</c:v>
                </c:pt>
                <c:pt idx="914">
                  <c:v>0.76393072289156627</c:v>
                </c:pt>
                <c:pt idx="915">
                  <c:v>0.77729668674698793</c:v>
                </c:pt>
                <c:pt idx="916">
                  <c:v>0.80346385542168675</c:v>
                </c:pt>
                <c:pt idx="917">
                  <c:v>0.78746234939759041</c:v>
                </c:pt>
                <c:pt idx="918">
                  <c:v>0.77635542168674698</c:v>
                </c:pt>
                <c:pt idx="919">
                  <c:v>0.76468373493975905</c:v>
                </c:pt>
                <c:pt idx="920">
                  <c:v>0.76882530120481929</c:v>
                </c:pt>
                <c:pt idx="921">
                  <c:v>0.78783885542168675</c:v>
                </c:pt>
                <c:pt idx="922">
                  <c:v>0.78068524096385539</c:v>
                </c:pt>
                <c:pt idx="923">
                  <c:v>0.76110692771084343</c:v>
                </c:pt>
                <c:pt idx="924">
                  <c:v>0.77447289156626509</c:v>
                </c:pt>
                <c:pt idx="925">
                  <c:v>0.76675451807228912</c:v>
                </c:pt>
                <c:pt idx="926">
                  <c:v>0.75131777108433739</c:v>
                </c:pt>
                <c:pt idx="927">
                  <c:v>0.78990963855421692</c:v>
                </c:pt>
                <c:pt idx="928">
                  <c:v>0.76581325301204817</c:v>
                </c:pt>
                <c:pt idx="929">
                  <c:v>0.78350903614457834</c:v>
                </c:pt>
                <c:pt idx="930">
                  <c:v>0.76882530120481929</c:v>
                </c:pt>
                <c:pt idx="931">
                  <c:v>0.77710843373493976</c:v>
                </c:pt>
                <c:pt idx="932">
                  <c:v>0.78181475903614461</c:v>
                </c:pt>
                <c:pt idx="933">
                  <c:v>0.77804969879518071</c:v>
                </c:pt>
                <c:pt idx="934">
                  <c:v>0.78878012048192769</c:v>
                </c:pt>
                <c:pt idx="935">
                  <c:v>0.77729668674698793</c:v>
                </c:pt>
                <c:pt idx="936">
                  <c:v>0.78030873493975905</c:v>
                </c:pt>
                <c:pt idx="937">
                  <c:v>0.75583584337349397</c:v>
                </c:pt>
                <c:pt idx="938">
                  <c:v>0.78670933734939763</c:v>
                </c:pt>
                <c:pt idx="939">
                  <c:v>0.79216867469879515</c:v>
                </c:pt>
                <c:pt idx="940">
                  <c:v>0.78369728915662651</c:v>
                </c:pt>
                <c:pt idx="941">
                  <c:v>0.75941265060240959</c:v>
                </c:pt>
                <c:pt idx="942">
                  <c:v>0.76844879518072284</c:v>
                </c:pt>
                <c:pt idx="943">
                  <c:v>0.77917921686746983</c:v>
                </c:pt>
                <c:pt idx="944">
                  <c:v>0.77522590361445787</c:v>
                </c:pt>
                <c:pt idx="945">
                  <c:v>0.75112951807228912</c:v>
                </c:pt>
                <c:pt idx="946">
                  <c:v>0.76976656626506024</c:v>
                </c:pt>
                <c:pt idx="947">
                  <c:v>0.77014307228915657</c:v>
                </c:pt>
                <c:pt idx="948">
                  <c:v>0.77070783132530118</c:v>
                </c:pt>
                <c:pt idx="949">
                  <c:v>0.79028614457831325</c:v>
                </c:pt>
                <c:pt idx="950">
                  <c:v>0.7693900602409639</c:v>
                </c:pt>
                <c:pt idx="951">
                  <c:v>0.74322289156626509</c:v>
                </c:pt>
                <c:pt idx="952">
                  <c:v>0.76731927710843373</c:v>
                </c:pt>
                <c:pt idx="953">
                  <c:v>0.77014307228915657</c:v>
                </c:pt>
                <c:pt idx="954">
                  <c:v>0.77880271084337349</c:v>
                </c:pt>
                <c:pt idx="955">
                  <c:v>0.77259036144578308</c:v>
                </c:pt>
                <c:pt idx="956">
                  <c:v>0.77654367469879515</c:v>
                </c:pt>
                <c:pt idx="957">
                  <c:v>0.78878012048192769</c:v>
                </c:pt>
                <c:pt idx="958">
                  <c:v>0.77710843373493976</c:v>
                </c:pt>
                <c:pt idx="959">
                  <c:v>0.80176957831325302</c:v>
                </c:pt>
                <c:pt idx="960">
                  <c:v>0.78595632530120485</c:v>
                </c:pt>
                <c:pt idx="961">
                  <c:v>0.76788403614457834</c:v>
                </c:pt>
                <c:pt idx="962">
                  <c:v>0.76430722891566261</c:v>
                </c:pt>
                <c:pt idx="963">
                  <c:v>0.77503765060240959</c:v>
                </c:pt>
                <c:pt idx="964">
                  <c:v>0.76694277108433739</c:v>
                </c:pt>
                <c:pt idx="965">
                  <c:v>0.78614457831325302</c:v>
                </c:pt>
                <c:pt idx="966">
                  <c:v>0.76920180722891562</c:v>
                </c:pt>
                <c:pt idx="967">
                  <c:v>0.78162650602409633</c:v>
                </c:pt>
                <c:pt idx="968">
                  <c:v>0.77353162650602414</c:v>
                </c:pt>
                <c:pt idx="969">
                  <c:v>0.76091867469879515</c:v>
                </c:pt>
                <c:pt idx="970">
                  <c:v>0.76449548192771088</c:v>
                </c:pt>
                <c:pt idx="971">
                  <c:v>0.78219126506024095</c:v>
                </c:pt>
                <c:pt idx="972">
                  <c:v>0.75112951807228912</c:v>
                </c:pt>
                <c:pt idx="973">
                  <c:v>0.7637424698795181</c:v>
                </c:pt>
                <c:pt idx="974">
                  <c:v>0.73192771084337349</c:v>
                </c:pt>
                <c:pt idx="975">
                  <c:v>0.74679969879518071</c:v>
                </c:pt>
                <c:pt idx="976">
                  <c:v>0.77108433734939763</c:v>
                </c:pt>
                <c:pt idx="977">
                  <c:v>0.76901355421686746</c:v>
                </c:pt>
                <c:pt idx="978">
                  <c:v>0.76298945783132532</c:v>
                </c:pt>
                <c:pt idx="979">
                  <c:v>0.75978915662650603</c:v>
                </c:pt>
                <c:pt idx="980">
                  <c:v>0.77522590361445787</c:v>
                </c:pt>
                <c:pt idx="981">
                  <c:v>0.77710843373493976</c:v>
                </c:pt>
                <c:pt idx="982">
                  <c:v>0.75395331325301207</c:v>
                </c:pt>
                <c:pt idx="983">
                  <c:v>0.79179216867469882</c:v>
                </c:pt>
                <c:pt idx="984">
                  <c:v>0.75301204819277112</c:v>
                </c:pt>
                <c:pt idx="985">
                  <c:v>0.78030873493975905</c:v>
                </c:pt>
                <c:pt idx="986">
                  <c:v>0.74717620481927716</c:v>
                </c:pt>
                <c:pt idx="987">
                  <c:v>0.74736445783132532</c:v>
                </c:pt>
                <c:pt idx="988">
                  <c:v>0.77315512048192769</c:v>
                </c:pt>
                <c:pt idx="989">
                  <c:v>0.7868975903614458</c:v>
                </c:pt>
                <c:pt idx="990">
                  <c:v>0.77899096385542166</c:v>
                </c:pt>
                <c:pt idx="991">
                  <c:v>0.77089608433734935</c:v>
                </c:pt>
                <c:pt idx="992">
                  <c:v>0.76976656626506024</c:v>
                </c:pt>
                <c:pt idx="993">
                  <c:v>0.76355421686746983</c:v>
                </c:pt>
                <c:pt idx="994">
                  <c:v>0.75640060240963858</c:v>
                </c:pt>
                <c:pt idx="995">
                  <c:v>0.77202560240963858</c:v>
                </c:pt>
                <c:pt idx="996">
                  <c:v>0.77541415662650603</c:v>
                </c:pt>
                <c:pt idx="997">
                  <c:v>0.76506024096385539</c:v>
                </c:pt>
                <c:pt idx="998">
                  <c:v>0.77484939759036142</c:v>
                </c:pt>
                <c:pt idx="999">
                  <c:v>0.77428463855421692</c:v>
                </c:pt>
                <c:pt idx="1000">
                  <c:v>0.77522590361445787</c:v>
                </c:pt>
                <c:pt idx="1001">
                  <c:v>0.7637424698795181</c:v>
                </c:pt>
                <c:pt idx="1002">
                  <c:v>0.77315512048192769</c:v>
                </c:pt>
                <c:pt idx="1003">
                  <c:v>0.75037650602409633</c:v>
                </c:pt>
                <c:pt idx="1004">
                  <c:v>0.78162650602409633</c:v>
                </c:pt>
                <c:pt idx="1005">
                  <c:v>0.77334337349397586</c:v>
                </c:pt>
                <c:pt idx="1006">
                  <c:v>0.77804969879518071</c:v>
                </c:pt>
                <c:pt idx="1007">
                  <c:v>0.75828313253012047</c:v>
                </c:pt>
                <c:pt idx="1008">
                  <c:v>0.76148343373493976</c:v>
                </c:pt>
                <c:pt idx="1009">
                  <c:v>0.77089608433734935</c:v>
                </c:pt>
                <c:pt idx="1010">
                  <c:v>0.74642319277108438</c:v>
                </c:pt>
                <c:pt idx="1011">
                  <c:v>0.76656626506024095</c:v>
                </c:pt>
                <c:pt idx="1012">
                  <c:v>0.76543674698795183</c:v>
                </c:pt>
                <c:pt idx="1013">
                  <c:v>0.77484939759036142</c:v>
                </c:pt>
                <c:pt idx="1014">
                  <c:v>0.79235692771084343</c:v>
                </c:pt>
                <c:pt idx="1015">
                  <c:v>0.79442771084337349</c:v>
                </c:pt>
                <c:pt idx="1016">
                  <c:v>0.76355421686746983</c:v>
                </c:pt>
                <c:pt idx="1017">
                  <c:v>0.76637801204819278</c:v>
                </c:pt>
                <c:pt idx="1018">
                  <c:v>0.75696536144578308</c:v>
                </c:pt>
                <c:pt idx="1019">
                  <c:v>0.75884789156626509</c:v>
                </c:pt>
                <c:pt idx="1020">
                  <c:v>0.74548192771084343</c:v>
                </c:pt>
                <c:pt idx="1021">
                  <c:v>0.78087349397590367</c:v>
                </c:pt>
                <c:pt idx="1022">
                  <c:v>0.75771837349397586</c:v>
                </c:pt>
                <c:pt idx="1023">
                  <c:v>0.7712725903614458</c:v>
                </c:pt>
                <c:pt idx="1024">
                  <c:v>0.78200301204819278</c:v>
                </c:pt>
                <c:pt idx="1025">
                  <c:v>0.74246987951807231</c:v>
                </c:pt>
                <c:pt idx="1026">
                  <c:v>0.7793674698795181</c:v>
                </c:pt>
                <c:pt idx="1027">
                  <c:v>0.73042168674698793</c:v>
                </c:pt>
                <c:pt idx="1028">
                  <c:v>0.7699548192771084</c:v>
                </c:pt>
                <c:pt idx="1029">
                  <c:v>0.7712725903614458</c:v>
                </c:pt>
                <c:pt idx="1030">
                  <c:v>0.77409638554216864</c:v>
                </c:pt>
                <c:pt idx="1031">
                  <c:v>0.75545933734939763</c:v>
                </c:pt>
                <c:pt idx="1032">
                  <c:v>0.77673192771084343</c:v>
                </c:pt>
                <c:pt idx="1033">
                  <c:v>0.77353162650602414</c:v>
                </c:pt>
                <c:pt idx="1034">
                  <c:v>0.78896837349397586</c:v>
                </c:pt>
                <c:pt idx="1035">
                  <c:v>0.78652108433734935</c:v>
                </c:pt>
                <c:pt idx="1036">
                  <c:v>0.76261295180722888</c:v>
                </c:pt>
                <c:pt idx="1037">
                  <c:v>0.76468373493975905</c:v>
                </c:pt>
                <c:pt idx="1038">
                  <c:v>0.7693900602409639</c:v>
                </c:pt>
                <c:pt idx="1039">
                  <c:v>0.7699548192771084</c:v>
                </c:pt>
                <c:pt idx="1040">
                  <c:v>0.77164909638554213</c:v>
                </c:pt>
                <c:pt idx="1041">
                  <c:v>0.78802710843373491</c:v>
                </c:pt>
                <c:pt idx="1042">
                  <c:v>0.79348644578313254</c:v>
                </c:pt>
                <c:pt idx="1043">
                  <c:v>0.75056475903614461</c:v>
                </c:pt>
                <c:pt idx="1044">
                  <c:v>0.75790662650602414</c:v>
                </c:pt>
                <c:pt idx="1045">
                  <c:v>0.77673192771084343</c:v>
                </c:pt>
                <c:pt idx="1046">
                  <c:v>0.77334337349397586</c:v>
                </c:pt>
                <c:pt idx="1047">
                  <c:v>0.76656626506024095</c:v>
                </c:pt>
                <c:pt idx="1048">
                  <c:v>0.78369728915662651</c:v>
                </c:pt>
                <c:pt idx="1049">
                  <c:v>0.76110692771084343</c:v>
                </c:pt>
                <c:pt idx="1050">
                  <c:v>0.75263554216867468</c:v>
                </c:pt>
                <c:pt idx="1051">
                  <c:v>0.76411897590361444</c:v>
                </c:pt>
                <c:pt idx="1052">
                  <c:v>0.77428463855421692</c:v>
                </c:pt>
                <c:pt idx="1053">
                  <c:v>0.7612951807228916</c:v>
                </c:pt>
                <c:pt idx="1054">
                  <c:v>0.77710843373493976</c:v>
                </c:pt>
                <c:pt idx="1055">
                  <c:v>0.78708584337349397</c:v>
                </c:pt>
                <c:pt idx="1056">
                  <c:v>0.80101656626506024</c:v>
                </c:pt>
                <c:pt idx="1057">
                  <c:v>0.79951054216867468</c:v>
                </c:pt>
                <c:pt idx="1058">
                  <c:v>0.77767319277108438</c:v>
                </c:pt>
                <c:pt idx="1059">
                  <c:v>0.80572289156626509</c:v>
                </c:pt>
                <c:pt idx="1060">
                  <c:v>0.79442771084337349</c:v>
                </c:pt>
                <c:pt idx="1061">
                  <c:v>0.81042921686746983</c:v>
                </c:pt>
                <c:pt idx="1062">
                  <c:v>0.81777108433734935</c:v>
                </c:pt>
                <c:pt idx="1063">
                  <c:v>0.84262048192771088</c:v>
                </c:pt>
                <c:pt idx="1064">
                  <c:v>0.83923192771084343</c:v>
                </c:pt>
                <c:pt idx="1065">
                  <c:v>0.81645331325301207</c:v>
                </c:pt>
                <c:pt idx="1066">
                  <c:v>0.84789156626506024</c:v>
                </c:pt>
                <c:pt idx="1067">
                  <c:v>0.859375</c:v>
                </c:pt>
                <c:pt idx="1068">
                  <c:v>0.84958584337349397</c:v>
                </c:pt>
                <c:pt idx="1069">
                  <c:v>0.82530120481927716</c:v>
                </c:pt>
                <c:pt idx="1070">
                  <c:v>0.85203313253012047</c:v>
                </c:pt>
                <c:pt idx="1071">
                  <c:v>0.84337349397590367</c:v>
                </c:pt>
                <c:pt idx="1072">
                  <c:v>0.84902108433734935</c:v>
                </c:pt>
                <c:pt idx="1073">
                  <c:v>0.87048192771084343</c:v>
                </c:pt>
                <c:pt idx="1074">
                  <c:v>0.85033885542168675</c:v>
                </c:pt>
                <c:pt idx="1075">
                  <c:v>0.86803463855421692</c:v>
                </c:pt>
                <c:pt idx="1076">
                  <c:v>0.87820030120481929</c:v>
                </c:pt>
                <c:pt idx="1077">
                  <c:v>0.87801204819277112</c:v>
                </c:pt>
                <c:pt idx="1078">
                  <c:v>0.859375</c:v>
                </c:pt>
                <c:pt idx="1079">
                  <c:v>0.85636295180722888</c:v>
                </c:pt>
                <c:pt idx="1080">
                  <c:v>0.8787650602409639</c:v>
                </c:pt>
                <c:pt idx="1081">
                  <c:v>0.88403614457831325</c:v>
                </c:pt>
                <c:pt idx="1082">
                  <c:v>0.87179969879518071</c:v>
                </c:pt>
                <c:pt idx="1083">
                  <c:v>0.87556475903614461</c:v>
                </c:pt>
                <c:pt idx="1084">
                  <c:v>0.88215361445783136</c:v>
                </c:pt>
                <c:pt idx="1085">
                  <c:v>0.88422439759036142</c:v>
                </c:pt>
                <c:pt idx="1086">
                  <c:v>0.88855421686746983</c:v>
                </c:pt>
                <c:pt idx="1087">
                  <c:v>0.87443524096385539</c:v>
                </c:pt>
                <c:pt idx="1088">
                  <c:v>0.86954066265060237</c:v>
                </c:pt>
                <c:pt idx="1089">
                  <c:v>0.90493222891566261</c:v>
                </c:pt>
                <c:pt idx="1090">
                  <c:v>0.86897590361445787</c:v>
                </c:pt>
                <c:pt idx="1091">
                  <c:v>0.88535391566265065</c:v>
                </c:pt>
                <c:pt idx="1092">
                  <c:v>0.85636295180722888</c:v>
                </c:pt>
                <c:pt idx="1093">
                  <c:v>0.8712349397590361</c:v>
                </c:pt>
                <c:pt idx="1094">
                  <c:v>0.8806475903614458</c:v>
                </c:pt>
                <c:pt idx="1095">
                  <c:v>0.85824548192771088</c:v>
                </c:pt>
                <c:pt idx="1096">
                  <c:v>0.84883283132530118</c:v>
                </c:pt>
                <c:pt idx="1097">
                  <c:v>0.86088102409638556</c:v>
                </c:pt>
                <c:pt idx="1098">
                  <c:v>0.87085843373493976</c:v>
                </c:pt>
                <c:pt idx="1099">
                  <c:v>0.87725903614457834</c:v>
                </c:pt>
                <c:pt idx="1100">
                  <c:v>0.87669427710843373</c:v>
                </c:pt>
                <c:pt idx="1101">
                  <c:v>0.88422439759036142</c:v>
                </c:pt>
                <c:pt idx="1102">
                  <c:v>0.90530873493975905</c:v>
                </c:pt>
                <c:pt idx="1103">
                  <c:v>0.86803463855421692</c:v>
                </c:pt>
                <c:pt idx="1104">
                  <c:v>0.86577560240963858</c:v>
                </c:pt>
                <c:pt idx="1105">
                  <c:v>0.87575301204819278</c:v>
                </c:pt>
                <c:pt idx="1106">
                  <c:v>0.89533132530120485</c:v>
                </c:pt>
                <c:pt idx="1107">
                  <c:v>0.91227409638554213</c:v>
                </c:pt>
                <c:pt idx="1108">
                  <c:v>0.8480798192771084</c:v>
                </c:pt>
                <c:pt idx="1109">
                  <c:v>0.8556099397590361</c:v>
                </c:pt>
                <c:pt idx="1110">
                  <c:v>0.89476656626506024</c:v>
                </c:pt>
                <c:pt idx="1111">
                  <c:v>0.89570783132530118</c:v>
                </c:pt>
                <c:pt idx="1112">
                  <c:v>0.92676957831325302</c:v>
                </c:pt>
                <c:pt idx="1113">
                  <c:v>0.90587349397590367</c:v>
                </c:pt>
                <c:pt idx="1114">
                  <c:v>0.89382530120481929</c:v>
                </c:pt>
                <c:pt idx="1115">
                  <c:v>0.89664909638554213</c:v>
                </c:pt>
                <c:pt idx="1116">
                  <c:v>0.90003765060240959</c:v>
                </c:pt>
                <c:pt idx="1117">
                  <c:v>0.90380271084337349</c:v>
                </c:pt>
                <c:pt idx="1118">
                  <c:v>0.87669427710843373</c:v>
                </c:pt>
                <c:pt idx="1119">
                  <c:v>0.89533132530120485</c:v>
                </c:pt>
                <c:pt idx="1120">
                  <c:v>0.85730421686746983</c:v>
                </c:pt>
                <c:pt idx="1121">
                  <c:v>0.87838855421686746</c:v>
                </c:pt>
                <c:pt idx="1122">
                  <c:v>0.90041415662650603</c:v>
                </c:pt>
                <c:pt idx="1123">
                  <c:v>0.90323795180722888</c:v>
                </c:pt>
                <c:pt idx="1124">
                  <c:v>0.88911897590361444</c:v>
                </c:pt>
                <c:pt idx="1125">
                  <c:v>0.89928463855421692</c:v>
                </c:pt>
                <c:pt idx="1126">
                  <c:v>0.89269578313253017</c:v>
                </c:pt>
                <c:pt idx="1127">
                  <c:v>0.93392319277108438</c:v>
                </c:pt>
                <c:pt idx="1128">
                  <c:v>0.92432228915662651</c:v>
                </c:pt>
                <c:pt idx="1129">
                  <c:v>0.91867469879518071</c:v>
                </c:pt>
                <c:pt idx="1130">
                  <c:v>0.89759036144578308</c:v>
                </c:pt>
                <c:pt idx="1131">
                  <c:v>0.86972891566265065</c:v>
                </c:pt>
                <c:pt idx="1132">
                  <c:v>0.89382530120481929</c:v>
                </c:pt>
                <c:pt idx="1133">
                  <c:v>0.94164156626506024</c:v>
                </c:pt>
                <c:pt idx="1134">
                  <c:v>0.96046686746987953</c:v>
                </c:pt>
                <c:pt idx="1135">
                  <c:v>0.93844126506024095</c:v>
                </c:pt>
                <c:pt idx="1136">
                  <c:v>0.90963855421686746</c:v>
                </c:pt>
                <c:pt idx="1137">
                  <c:v>0.90079066265060237</c:v>
                </c:pt>
                <c:pt idx="1138">
                  <c:v>0.89006024096385539</c:v>
                </c:pt>
                <c:pt idx="1139">
                  <c:v>0.91867469879518071</c:v>
                </c:pt>
                <c:pt idx="1140">
                  <c:v>0.92902861445783136</c:v>
                </c:pt>
                <c:pt idx="1141">
                  <c:v>0.91886295180722888</c:v>
                </c:pt>
                <c:pt idx="1142">
                  <c:v>0.91905120481927716</c:v>
                </c:pt>
                <c:pt idx="1143">
                  <c:v>0.88968373493975905</c:v>
                </c:pt>
                <c:pt idx="1144">
                  <c:v>0.95067771084337349</c:v>
                </c:pt>
                <c:pt idx="1145">
                  <c:v>0.91265060240963858</c:v>
                </c:pt>
                <c:pt idx="1146">
                  <c:v>0.95481927710843373</c:v>
                </c:pt>
                <c:pt idx="1147">
                  <c:v>0.92413403614457834</c:v>
                </c:pt>
                <c:pt idx="1148">
                  <c:v>0.90493222891566261</c:v>
                </c:pt>
                <c:pt idx="1149">
                  <c:v>0.90587349397590367</c:v>
                </c:pt>
                <c:pt idx="1150">
                  <c:v>0.90982680722891562</c:v>
                </c:pt>
                <c:pt idx="1151">
                  <c:v>0.94804216867469882</c:v>
                </c:pt>
                <c:pt idx="1152">
                  <c:v>0.99077560240963858</c:v>
                </c:pt>
                <c:pt idx="1153">
                  <c:v>0.93655873493975905</c:v>
                </c:pt>
                <c:pt idx="1154">
                  <c:v>0.95274849397590367</c:v>
                </c:pt>
                <c:pt idx="1155">
                  <c:v>0.94277108433734935</c:v>
                </c:pt>
                <c:pt idx="1156">
                  <c:v>0.9175451807228916</c:v>
                </c:pt>
                <c:pt idx="1157">
                  <c:v>0.94540662650602414</c:v>
                </c:pt>
                <c:pt idx="1158">
                  <c:v>0.9806099397590361</c:v>
                </c:pt>
                <c:pt idx="1159">
                  <c:v>0.95444277108433739</c:v>
                </c:pt>
                <c:pt idx="1160">
                  <c:v>0.94088855421686746</c:v>
                </c:pt>
                <c:pt idx="1161">
                  <c:v>0.91227409638554213</c:v>
                </c:pt>
                <c:pt idx="1162">
                  <c:v>0.9331701807228916</c:v>
                </c:pt>
                <c:pt idx="1163">
                  <c:v>0.90342620481927716</c:v>
                </c:pt>
                <c:pt idx="1164">
                  <c:v>0.9181099397590361</c:v>
                </c:pt>
                <c:pt idx="1165">
                  <c:v>0.94446536144578308</c:v>
                </c:pt>
                <c:pt idx="1166">
                  <c:v>0.94973644578313254</c:v>
                </c:pt>
                <c:pt idx="1167">
                  <c:v>0.97100903614457834</c:v>
                </c:pt>
                <c:pt idx="1168">
                  <c:v>0.93128765060240959</c:v>
                </c:pt>
                <c:pt idx="1169">
                  <c:v>0.97176204819277112</c:v>
                </c:pt>
                <c:pt idx="1170">
                  <c:v>0.93015813253012047</c:v>
                </c:pt>
                <c:pt idx="1171">
                  <c:v>0.99416415662650603</c:v>
                </c:pt>
                <c:pt idx="1172">
                  <c:v>0.97402108433734935</c:v>
                </c:pt>
                <c:pt idx="1173">
                  <c:v>1.0225903614457832</c:v>
                </c:pt>
                <c:pt idx="1174">
                  <c:v>0.96762048192771088</c:v>
                </c:pt>
                <c:pt idx="1175">
                  <c:v>0.953125</c:v>
                </c:pt>
                <c:pt idx="1176">
                  <c:v>0.94521837349397586</c:v>
                </c:pt>
                <c:pt idx="1177">
                  <c:v>0.9725150602409639</c:v>
                </c:pt>
                <c:pt idx="1178">
                  <c:v>1.0175075301204819</c:v>
                </c:pt>
                <c:pt idx="1179">
                  <c:v>0.92545180722891562</c:v>
                </c:pt>
                <c:pt idx="1180">
                  <c:v>0.9568900602409639</c:v>
                </c:pt>
                <c:pt idx="1181">
                  <c:v>0.96423192771084343</c:v>
                </c:pt>
                <c:pt idx="1182">
                  <c:v>0.97966867469879515</c:v>
                </c:pt>
                <c:pt idx="1183">
                  <c:v>0.97044427710843373</c:v>
                </c:pt>
                <c:pt idx="1184">
                  <c:v>0.94728915662650603</c:v>
                </c:pt>
                <c:pt idx="1185">
                  <c:v>0.96818524096385539</c:v>
                </c:pt>
                <c:pt idx="1186">
                  <c:v>0.93599397590361444</c:v>
                </c:pt>
                <c:pt idx="1187">
                  <c:v>0.9512424698795181</c:v>
                </c:pt>
                <c:pt idx="1188">
                  <c:v>0.9706325301204819</c:v>
                </c:pt>
                <c:pt idx="1189">
                  <c:v>0.9962349397590361</c:v>
                </c:pt>
                <c:pt idx="1190">
                  <c:v>0.9887048192771084</c:v>
                </c:pt>
                <c:pt idx="1191">
                  <c:v>0.93335843373493976</c:v>
                </c:pt>
                <c:pt idx="1192">
                  <c:v>0.94145331325301207</c:v>
                </c:pt>
                <c:pt idx="1193">
                  <c:v>0.92262801204819278</c:v>
                </c:pt>
                <c:pt idx="1194">
                  <c:v>0.93335843373493976</c:v>
                </c:pt>
                <c:pt idx="1195">
                  <c:v>0.93505271084337349</c:v>
                </c:pt>
                <c:pt idx="1196">
                  <c:v>1.0096009036144578</c:v>
                </c:pt>
                <c:pt idx="1197">
                  <c:v>0.96272590361445787</c:v>
                </c:pt>
                <c:pt idx="1198">
                  <c:v>0.96197289156626509</c:v>
                </c:pt>
                <c:pt idx="1199">
                  <c:v>0.953125</c:v>
                </c:pt>
                <c:pt idx="1200">
                  <c:v>0.9275225903614458</c:v>
                </c:pt>
                <c:pt idx="1201">
                  <c:v>0.92676957831325302</c:v>
                </c:pt>
                <c:pt idx="1202">
                  <c:v>0.95557228915662651</c:v>
                </c:pt>
                <c:pt idx="1203">
                  <c:v>0.96856174698795183</c:v>
                </c:pt>
                <c:pt idx="1204">
                  <c:v>1.0065888554216869</c:v>
                </c:pt>
                <c:pt idx="1205">
                  <c:v>0.98719879518072284</c:v>
                </c:pt>
                <c:pt idx="1206">
                  <c:v>0.95350150602409633</c:v>
                </c:pt>
                <c:pt idx="1207">
                  <c:v>0.9237575301204819</c:v>
                </c:pt>
                <c:pt idx="1208">
                  <c:v>0.94107680722891562</c:v>
                </c:pt>
                <c:pt idx="1209">
                  <c:v>0.95613704819277112</c:v>
                </c:pt>
                <c:pt idx="1210">
                  <c:v>1.0088478915662651</c:v>
                </c:pt>
                <c:pt idx="1211">
                  <c:v>0.96366716867469882</c:v>
                </c:pt>
                <c:pt idx="1212">
                  <c:v>0.9512424698795181</c:v>
                </c:pt>
                <c:pt idx="1213">
                  <c:v>0.95820783132530118</c:v>
                </c:pt>
                <c:pt idx="1214">
                  <c:v>0.9356174698795181</c:v>
                </c:pt>
                <c:pt idx="1215">
                  <c:v>0.98173945783132532</c:v>
                </c:pt>
                <c:pt idx="1216">
                  <c:v>0.96762048192771088</c:v>
                </c:pt>
                <c:pt idx="1217">
                  <c:v>0.92168674698795183</c:v>
                </c:pt>
                <c:pt idx="1218">
                  <c:v>0.9493599397590361</c:v>
                </c:pt>
                <c:pt idx="1219">
                  <c:v>0.92789909638554213</c:v>
                </c:pt>
                <c:pt idx="1220">
                  <c:v>0.91923945783132532</c:v>
                </c:pt>
                <c:pt idx="1221">
                  <c:v>0.94051204819277112</c:v>
                </c:pt>
                <c:pt idx="1222">
                  <c:v>0.97458584337349397</c:v>
                </c:pt>
                <c:pt idx="1223">
                  <c:v>0.94992469879518071</c:v>
                </c:pt>
                <c:pt idx="1224">
                  <c:v>0.97891566265060237</c:v>
                </c:pt>
                <c:pt idx="1225">
                  <c:v>0.95801957831325302</c:v>
                </c:pt>
                <c:pt idx="1226">
                  <c:v>0.94051204819277112</c:v>
                </c:pt>
                <c:pt idx="1227">
                  <c:v>0.94013554216867468</c:v>
                </c:pt>
                <c:pt idx="1228">
                  <c:v>0.93618222891566261</c:v>
                </c:pt>
                <c:pt idx="1229">
                  <c:v>0.94277108433734935</c:v>
                </c:pt>
                <c:pt idx="1230">
                  <c:v>0.93618222891566261</c:v>
                </c:pt>
                <c:pt idx="1231">
                  <c:v>0.98983433734939763</c:v>
                </c:pt>
                <c:pt idx="1232">
                  <c:v>0.99604668674698793</c:v>
                </c:pt>
                <c:pt idx="1233">
                  <c:v>0.9787274096385542</c:v>
                </c:pt>
                <c:pt idx="1234">
                  <c:v>0.96329066265060237</c:v>
                </c:pt>
                <c:pt idx="1235">
                  <c:v>0.95557228915662651</c:v>
                </c:pt>
                <c:pt idx="1236">
                  <c:v>0.91227409638554213</c:v>
                </c:pt>
                <c:pt idx="1237">
                  <c:v>0.91792168674698793</c:v>
                </c:pt>
                <c:pt idx="1238">
                  <c:v>0.94860692771084343</c:v>
                </c:pt>
                <c:pt idx="1239">
                  <c:v>1.0564759036144578</c:v>
                </c:pt>
                <c:pt idx="1240">
                  <c:v>1.0195783132530121</c:v>
                </c:pt>
                <c:pt idx="1241">
                  <c:v>0.95557228915662651</c:v>
                </c:pt>
                <c:pt idx="1242">
                  <c:v>0.9431475903614458</c:v>
                </c:pt>
                <c:pt idx="1243">
                  <c:v>0.97025602409638556</c:v>
                </c:pt>
                <c:pt idx="1244">
                  <c:v>0.94785391566265065</c:v>
                </c:pt>
                <c:pt idx="1245">
                  <c:v>0.90945030120481929</c:v>
                </c:pt>
                <c:pt idx="1246">
                  <c:v>0.94559487951807231</c:v>
                </c:pt>
                <c:pt idx="1247">
                  <c:v>0.96253765060240959</c:v>
                </c:pt>
                <c:pt idx="1248">
                  <c:v>0.99755271084337349</c:v>
                </c:pt>
                <c:pt idx="1249">
                  <c:v>0.96084337349397586</c:v>
                </c:pt>
                <c:pt idx="1250">
                  <c:v>0.9574548192771084</c:v>
                </c:pt>
                <c:pt idx="1251">
                  <c:v>0.9743975903614458</c:v>
                </c:pt>
                <c:pt idx="1252">
                  <c:v>0.95933734939759041</c:v>
                </c:pt>
                <c:pt idx="1253">
                  <c:v>1.0165662650602409</c:v>
                </c:pt>
                <c:pt idx="1254">
                  <c:v>1.0011295180722892</c:v>
                </c:pt>
                <c:pt idx="1255">
                  <c:v>1.0045180722891567</c:v>
                </c:pt>
                <c:pt idx="1256">
                  <c:v>0.9943524096385542</c:v>
                </c:pt>
                <c:pt idx="1257">
                  <c:v>0.94540662650602414</c:v>
                </c:pt>
                <c:pt idx="1258">
                  <c:v>0.95914909638554213</c:v>
                </c:pt>
                <c:pt idx="1259">
                  <c:v>0.97740963855421692</c:v>
                </c:pt>
                <c:pt idx="1260">
                  <c:v>0.96329066265060237</c:v>
                </c:pt>
                <c:pt idx="1261">
                  <c:v>1.0069653614457832</c:v>
                </c:pt>
                <c:pt idx="1262">
                  <c:v>1.0109186746987953</c:v>
                </c:pt>
                <c:pt idx="1263">
                  <c:v>1.0096009036144578</c:v>
                </c:pt>
                <c:pt idx="1264">
                  <c:v>0.99472891566265065</c:v>
                </c:pt>
                <c:pt idx="1265">
                  <c:v>0.92959337349397586</c:v>
                </c:pt>
                <c:pt idx="1266">
                  <c:v>0.95350150602409633</c:v>
                </c:pt>
                <c:pt idx="1267">
                  <c:v>1.0037650602409638</c:v>
                </c:pt>
                <c:pt idx="1268">
                  <c:v>0.95538403614457834</c:v>
                </c:pt>
                <c:pt idx="1269">
                  <c:v>0.98569277108433739</c:v>
                </c:pt>
                <c:pt idx="1270">
                  <c:v>1.0225903614457832</c:v>
                </c:pt>
                <c:pt idx="1271">
                  <c:v>0.97420933734939763</c:v>
                </c:pt>
                <c:pt idx="1272">
                  <c:v>0.95387801204819278</c:v>
                </c:pt>
                <c:pt idx="1273">
                  <c:v>0.9631024096385542</c:v>
                </c:pt>
                <c:pt idx="1274">
                  <c:v>0.94371234939759041</c:v>
                </c:pt>
                <c:pt idx="1275">
                  <c:v>0.9668674698795181</c:v>
                </c:pt>
                <c:pt idx="1276">
                  <c:v>1.0054593373493976</c:v>
                </c:pt>
                <c:pt idx="1277">
                  <c:v>1.0229668674698795</c:v>
                </c:pt>
                <c:pt idx="1278">
                  <c:v>1.0129894578313252</c:v>
                </c:pt>
                <c:pt idx="1279">
                  <c:v>0.95651355421686746</c:v>
                </c:pt>
                <c:pt idx="1280">
                  <c:v>0.9587725903614458</c:v>
                </c:pt>
                <c:pt idx="1281">
                  <c:v>0.95425451807228912</c:v>
                </c:pt>
                <c:pt idx="1282">
                  <c:v>0.94070030120481929</c:v>
                </c:pt>
                <c:pt idx="1283">
                  <c:v>0.97759789156626509</c:v>
                </c:pt>
                <c:pt idx="1284">
                  <c:v>1.0144954819277108</c:v>
                </c:pt>
                <c:pt idx="1285">
                  <c:v>0.98512801204819278</c:v>
                </c:pt>
                <c:pt idx="1286">
                  <c:v>1.0397213855421688</c:v>
                </c:pt>
                <c:pt idx="1287">
                  <c:v>1.0039533132530121</c:v>
                </c:pt>
                <c:pt idx="1288">
                  <c:v>0.99962349397590367</c:v>
                </c:pt>
                <c:pt idx="1289">
                  <c:v>0.9824924698795181</c:v>
                </c:pt>
                <c:pt idx="1290">
                  <c:v>0.97213855421686746</c:v>
                </c:pt>
                <c:pt idx="1291">
                  <c:v>0.96084337349397586</c:v>
                </c:pt>
                <c:pt idx="1292">
                  <c:v>0.95519578313253017</c:v>
                </c:pt>
                <c:pt idx="1293">
                  <c:v>0.94164156626506024</c:v>
                </c:pt>
                <c:pt idx="1294">
                  <c:v>1.0071536144578312</c:v>
                </c:pt>
                <c:pt idx="1295">
                  <c:v>0.97703313253012047</c:v>
                </c:pt>
                <c:pt idx="1296">
                  <c:v>0.98343373493975905</c:v>
                </c:pt>
                <c:pt idx="1297">
                  <c:v>0.95199548192771088</c:v>
                </c:pt>
                <c:pt idx="1298">
                  <c:v>0.92432228915662651</c:v>
                </c:pt>
                <c:pt idx="1299">
                  <c:v>0.94992469879518071</c:v>
                </c:pt>
                <c:pt idx="1300">
                  <c:v>0.97835090361445787</c:v>
                </c:pt>
                <c:pt idx="1301">
                  <c:v>0.99171686746987953</c:v>
                </c:pt>
                <c:pt idx="1302">
                  <c:v>1.0212725903614457</c:v>
                </c:pt>
                <c:pt idx="1303">
                  <c:v>1.0011295180722892</c:v>
                </c:pt>
                <c:pt idx="1304">
                  <c:v>0.99454066265060237</c:v>
                </c:pt>
                <c:pt idx="1305">
                  <c:v>0.9881400602409639</c:v>
                </c:pt>
                <c:pt idx="1306">
                  <c:v>0.9412650602409639</c:v>
                </c:pt>
                <c:pt idx="1307">
                  <c:v>0.95011295180722888</c:v>
                </c:pt>
                <c:pt idx="1308">
                  <c:v>0.9706325301204819</c:v>
                </c:pt>
                <c:pt idx="1309">
                  <c:v>0.97891566265060237</c:v>
                </c:pt>
                <c:pt idx="1310">
                  <c:v>0.97232680722891562</c:v>
                </c:pt>
                <c:pt idx="1311">
                  <c:v>1.0306852409638554</c:v>
                </c:pt>
                <c:pt idx="1312">
                  <c:v>0.9862575301204819</c:v>
                </c:pt>
                <c:pt idx="1313">
                  <c:v>0.97213855421686746</c:v>
                </c:pt>
                <c:pt idx="1314">
                  <c:v>0.93919427710843373</c:v>
                </c:pt>
                <c:pt idx="1315">
                  <c:v>0.91679216867469882</c:v>
                </c:pt>
                <c:pt idx="1316">
                  <c:v>0.93411144578313254</c:v>
                </c:pt>
                <c:pt idx="1317">
                  <c:v>0.94465361445783136</c:v>
                </c:pt>
                <c:pt idx="1318">
                  <c:v>0.93015813253012047</c:v>
                </c:pt>
                <c:pt idx="1319">
                  <c:v>1.0047063253012047</c:v>
                </c:pt>
                <c:pt idx="1320">
                  <c:v>0.99115210843373491</c:v>
                </c:pt>
                <c:pt idx="1321">
                  <c:v>0.95218373493975905</c:v>
                </c:pt>
                <c:pt idx="1322">
                  <c:v>0.95387801204819278</c:v>
                </c:pt>
                <c:pt idx="1323">
                  <c:v>0.94164156626506024</c:v>
                </c:pt>
                <c:pt idx="1324">
                  <c:v>0.9862575301204819</c:v>
                </c:pt>
                <c:pt idx="1325">
                  <c:v>0.9800451807228916</c:v>
                </c:pt>
                <c:pt idx="1326">
                  <c:v>1.0020707831325302</c:v>
                </c:pt>
                <c:pt idx="1327">
                  <c:v>1.0259789156626506</c:v>
                </c:pt>
                <c:pt idx="1328">
                  <c:v>0.99246987951807231</c:v>
                </c:pt>
                <c:pt idx="1329">
                  <c:v>0.95594879518072284</c:v>
                </c:pt>
                <c:pt idx="1330">
                  <c:v>0.94917168674698793</c:v>
                </c:pt>
                <c:pt idx="1331">
                  <c:v>0.94653614457831325</c:v>
                </c:pt>
                <c:pt idx="1332">
                  <c:v>0.96404367469879515</c:v>
                </c:pt>
                <c:pt idx="1333">
                  <c:v>0.94691265060240959</c:v>
                </c:pt>
                <c:pt idx="1334">
                  <c:v>0.99077560240963858</c:v>
                </c:pt>
                <c:pt idx="1335">
                  <c:v>1.0154367469879517</c:v>
                </c:pt>
                <c:pt idx="1336">
                  <c:v>1.0404743975903614</c:v>
                </c:pt>
                <c:pt idx="1337">
                  <c:v>1.015625</c:v>
                </c:pt>
                <c:pt idx="1338">
                  <c:v>0.9743975903614458</c:v>
                </c:pt>
                <c:pt idx="1339">
                  <c:v>0.93222891566265065</c:v>
                </c:pt>
                <c:pt idx="1340">
                  <c:v>0.93806475903614461</c:v>
                </c:pt>
                <c:pt idx="1341">
                  <c:v>0.92827560240963858</c:v>
                </c:pt>
                <c:pt idx="1342">
                  <c:v>0.97383283132530118</c:v>
                </c:pt>
                <c:pt idx="1343">
                  <c:v>1.0080948795180722</c:v>
                </c:pt>
                <c:pt idx="1344">
                  <c:v>1.0333207831325302</c:v>
                </c:pt>
                <c:pt idx="1345">
                  <c:v>0.9787274096385542</c:v>
                </c:pt>
                <c:pt idx="1346">
                  <c:v>0.99134036144578308</c:v>
                </c:pt>
                <c:pt idx="1347">
                  <c:v>0.93994728915662651</c:v>
                </c:pt>
                <c:pt idx="1348">
                  <c:v>0.97420933734939763</c:v>
                </c:pt>
                <c:pt idx="1349">
                  <c:v>0.98173945783132532</c:v>
                </c:pt>
                <c:pt idx="1350">
                  <c:v>0.97100903614457834</c:v>
                </c:pt>
                <c:pt idx="1351">
                  <c:v>0.95726656626506024</c:v>
                </c:pt>
                <c:pt idx="1352">
                  <c:v>0.95444277108433739</c:v>
                </c:pt>
                <c:pt idx="1353">
                  <c:v>0.95764307228915657</c:v>
                </c:pt>
                <c:pt idx="1354">
                  <c:v>0.95293674698795183</c:v>
                </c:pt>
                <c:pt idx="1355">
                  <c:v>0.99830572289156627</c:v>
                </c:pt>
                <c:pt idx="1356">
                  <c:v>0.98324548192771088</c:v>
                </c:pt>
                <c:pt idx="1357">
                  <c:v>0.97100903614457834</c:v>
                </c:pt>
                <c:pt idx="1358">
                  <c:v>1.0129894578313252</c:v>
                </c:pt>
                <c:pt idx="1359">
                  <c:v>0.9887048192771084</c:v>
                </c:pt>
                <c:pt idx="1360">
                  <c:v>0.98983433734939763</c:v>
                </c:pt>
                <c:pt idx="1361">
                  <c:v>0.96178463855421692</c:v>
                </c:pt>
                <c:pt idx="1362">
                  <c:v>0.93429969879518071</c:v>
                </c:pt>
                <c:pt idx="1363">
                  <c:v>0.91020331325301207</c:v>
                </c:pt>
                <c:pt idx="1364">
                  <c:v>0.9631024096385542</c:v>
                </c:pt>
                <c:pt idx="1365">
                  <c:v>0.96291415662650603</c:v>
                </c:pt>
                <c:pt idx="1366">
                  <c:v>0.96140813253012047</c:v>
                </c:pt>
                <c:pt idx="1367">
                  <c:v>0.98155120481927716</c:v>
                </c:pt>
                <c:pt idx="1368">
                  <c:v>1.0274849397590362</c:v>
                </c:pt>
                <c:pt idx="1369">
                  <c:v>1.0432981927710843</c:v>
                </c:pt>
                <c:pt idx="1370">
                  <c:v>0.98644578313253017</c:v>
                </c:pt>
                <c:pt idx="1371">
                  <c:v>0.96234939759036142</c:v>
                </c:pt>
                <c:pt idx="1372">
                  <c:v>0.97364457831325302</c:v>
                </c:pt>
                <c:pt idx="1373">
                  <c:v>0.98399849397590367</c:v>
                </c:pt>
                <c:pt idx="1374">
                  <c:v>1.0144954819277108</c:v>
                </c:pt>
                <c:pt idx="1375">
                  <c:v>0.96649096385542166</c:v>
                </c:pt>
                <c:pt idx="1376">
                  <c:v>0.95651355421686746</c:v>
                </c:pt>
                <c:pt idx="1377">
                  <c:v>1.0082831325301205</c:v>
                </c:pt>
                <c:pt idx="1378">
                  <c:v>1.0408509036144578</c:v>
                </c:pt>
                <c:pt idx="1379">
                  <c:v>1.0280496987951808</c:v>
                </c:pt>
                <c:pt idx="1380">
                  <c:v>1.0150602409638554</c:v>
                </c:pt>
                <c:pt idx="1381">
                  <c:v>0.97176204819277112</c:v>
                </c:pt>
                <c:pt idx="1382">
                  <c:v>0.94597138554216864</c:v>
                </c:pt>
                <c:pt idx="1383">
                  <c:v>0.953125</c:v>
                </c:pt>
                <c:pt idx="1384">
                  <c:v>0.93542921686746983</c:v>
                </c:pt>
                <c:pt idx="1385">
                  <c:v>0.98418674698795183</c:v>
                </c:pt>
                <c:pt idx="1386">
                  <c:v>1.0096009036144578</c:v>
                </c:pt>
                <c:pt idx="1387">
                  <c:v>1.0143072289156627</c:v>
                </c:pt>
                <c:pt idx="1388">
                  <c:v>0.96272590361445787</c:v>
                </c:pt>
                <c:pt idx="1389">
                  <c:v>0.97213855421686746</c:v>
                </c:pt>
                <c:pt idx="1390">
                  <c:v>0.97100903614457834</c:v>
                </c:pt>
                <c:pt idx="1391">
                  <c:v>0.96630271084337349</c:v>
                </c:pt>
                <c:pt idx="1392">
                  <c:v>0.96084337349397586</c:v>
                </c:pt>
                <c:pt idx="1393">
                  <c:v>0.97006777108433739</c:v>
                </c:pt>
                <c:pt idx="1394">
                  <c:v>0.9887048192771084</c:v>
                </c:pt>
                <c:pt idx="1395">
                  <c:v>1.0480045180722892</c:v>
                </c:pt>
                <c:pt idx="1396">
                  <c:v>1.0210843373493976</c:v>
                </c:pt>
                <c:pt idx="1397">
                  <c:v>0.98117469879518071</c:v>
                </c:pt>
                <c:pt idx="1398">
                  <c:v>0.9412650602409639</c:v>
                </c:pt>
                <c:pt idx="1399">
                  <c:v>0.95425451807228912</c:v>
                </c:pt>
                <c:pt idx="1400">
                  <c:v>0.9412650602409639</c:v>
                </c:pt>
                <c:pt idx="1401">
                  <c:v>0.95331325301204817</c:v>
                </c:pt>
                <c:pt idx="1402">
                  <c:v>0.94503012048192769</c:v>
                </c:pt>
                <c:pt idx="1403">
                  <c:v>0.92865210843373491</c:v>
                </c:pt>
                <c:pt idx="1404">
                  <c:v>0.97722138554216864</c:v>
                </c:pt>
                <c:pt idx="1405">
                  <c:v>1.0276731927710843</c:v>
                </c:pt>
                <c:pt idx="1406">
                  <c:v>1.0498870481927711</c:v>
                </c:pt>
                <c:pt idx="1407">
                  <c:v>1.0355798192771084</c:v>
                </c:pt>
                <c:pt idx="1408">
                  <c:v>1.0082831325301205</c:v>
                </c:pt>
                <c:pt idx="1409">
                  <c:v>0.97082078313253017</c:v>
                </c:pt>
                <c:pt idx="1410">
                  <c:v>0.97044427710843373</c:v>
                </c:pt>
                <c:pt idx="1411">
                  <c:v>0.94352409638554213</c:v>
                </c:pt>
                <c:pt idx="1412">
                  <c:v>0.95538403614457834</c:v>
                </c:pt>
                <c:pt idx="1413">
                  <c:v>0.96084337349397586</c:v>
                </c:pt>
                <c:pt idx="1414">
                  <c:v>0.96479668674698793</c:v>
                </c:pt>
                <c:pt idx="1415">
                  <c:v>1.021460843373494</c:v>
                </c:pt>
                <c:pt idx="1416">
                  <c:v>1.0190135542168675</c:v>
                </c:pt>
                <c:pt idx="1417">
                  <c:v>0.99981174698795183</c:v>
                </c:pt>
                <c:pt idx="1418">
                  <c:v>0.99228162650602414</c:v>
                </c:pt>
                <c:pt idx="1419">
                  <c:v>0.9574548192771084</c:v>
                </c:pt>
                <c:pt idx="1420">
                  <c:v>0.94728915662650603</c:v>
                </c:pt>
                <c:pt idx="1421">
                  <c:v>0.9393825301204819</c:v>
                </c:pt>
                <c:pt idx="1422">
                  <c:v>0.97985692771084343</c:v>
                </c:pt>
                <c:pt idx="1423">
                  <c:v>0.95105421686746983</c:v>
                </c:pt>
                <c:pt idx="1424">
                  <c:v>0.94258283132530118</c:v>
                </c:pt>
                <c:pt idx="1425">
                  <c:v>0.94597138554216864</c:v>
                </c:pt>
                <c:pt idx="1426">
                  <c:v>0.97797439759036142</c:v>
                </c:pt>
                <c:pt idx="1427">
                  <c:v>1.0342620481927711</c:v>
                </c:pt>
                <c:pt idx="1428">
                  <c:v>1.0495105421686748</c:v>
                </c:pt>
                <c:pt idx="1429">
                  <c:v>1.0400978915662651</c:v>
                </c:pt>
                <c:pt idx="1430">
                  <c:v>1.0474397590361446</c:v>
                </c:pt>
                <c:pt idx="1431">
                  <c:v>0.99284638554216864</c:v>
                </c:pt>
                <c:pt idx="1432">
                  <c:v>0.9800451807228916</c:v>
                </c:pt>
                <c:pt idx="1433">
                  <c:v>0.96347891566265065</c:v>
                </c:pt>
                <c:pt idx="1434">
                  <c:v>0.95952560240963858</c:v>
                </c:pt>
                <c:pt idx="1435">
                  <c:v>0.9487951807228916</c:v>
                </c:pt>
                <c:pt idx="1436">
                  <c:v>0.94070030120481929</c:v>
                </c:pt>
                <c:pt idx="1437">
                  <c:v>0.9568900602409639</c:v>
                </c:pt>
                <c:pt idx="1438">
                  <c:v>0.9418298192771084</c:v>
                </c:pt>
                <c:pt idx="1439">
                  <c:v>0.98926957831325302</c:v>
                </c:pt>
                <c:pt idx="1440">
                  <c:v>1.0359563253012047</c:v>
                </c:pt>
                <c:pt idx="1441">
                  <c:v>1.0481927710843373</c:v>
                </c:pt>
                <c:pt idx="1442">
                  <c:v>1.0363328313253013</c:v>
                </c:pt>
                <c:pt idx="1443">
                  <c:v>0.99284638554216864</c:v>
                </c:pt>
                <c:pt idx="1444">
                  <c:v>0.98155120481927716</c:v>
                </c:pt>
                <c:pt idx="1445">
                  <c:v>0.99209337349397586</c:v>
                </c:pt>
                <c:pt idx="1446">
                  <c:v>0.9806099397590361</c:v>
                </c:pt>
                <c:pt idx="1447">
                  <c:v>0.96649096385542166</c:v>
                </c:pt>
                <c:pt idx="1448">
                  <c:v>0.96329066265060237</c:v>
                </c:pt>
                <c:pt idx="1449">
                  <c:v>0.93975903614457834</c:v>
                </c:pt>
                <c:pt idx="1450">
                  <c:v>0.96893825301204817</c:v>
                </c:pt>
                <c:pt idx="1451">
                  <c:v>1.0549698795180722</c:v>
                </c:pt>
                <c:pt idx="1452">
                  <c:v>1.0835843373493976</c:v>
                </c:pt>
                <c:pt idx="1453">
                  <c:v>1.0382153614457832</c:v>
                </c:pt>
                <c:pt idx="1454">
                  <c:v>1.0028237951807228</c:v>
                </c:pt>
                <c:pt idx="1455">
                  <c:v>0.98795180722891562</c:v>
                </c:pt>
                <c:pt idx="1456">
                  <c:v>0.99510542168674698</c:v>
                </c:pt>
                <c:pt idx="1457">
                  <c:v>0.95632530120481929</c:v>
                </c:pt>
                <c:pt idx="1458">
                  <c:v>0.99096385542168675</c:v>
                </c:pt>
                <c:pt idx="1459">
                  <c:v>0.98305722891566261</c:v>
                </c:pt>
                <c:pt idx="1460">
                  <c:v>0.9631024096385542</c:v>
                </c:pt>
                <c:pt idx="1461">
                  <c:v>0.98268072289156627</c:v>
                </c:pt>
                <c:pt idx="1462">
                  <c:v>1.0297439759036144</c:v>
                </c:pt>
                <c:pt idx="1463">
                  <c:v>1.0606174698795181</c:v>
                </c:pt>
                <c:pt idx="1464">
                  <c:v>1.052710843373494</c:v>
                </c:pt>
                <c:pt idx="1465">
                  <c:v>1.0303087349397591</c:v>
                </c:pt>
                <c:pt idx="1466">
                  <c:v>1.0141189759036144</c:v>
                </c:pt>
                <c:pt idx="1467">
                  <c:v>0.9725150602409639</c:v>
                </c:pt>
                <c:pt idx="1468">
                  <c:v>1.0224021084337349</c:v>
                </c:pt>
                <c:pt idx="1469">
                  <c:v>0.97835090361445787</c:v>
                </c:pt>
                <c:pt idx="1470">
                  <c:v>0.96253765060240959</c:v>
                </c:pt>
                <c:pt idx="1471">
                  <c:v>0.9806099397590361</c:v>
                </c:pt>
                <c:pt idx="1472">
                  <c:v>0.99303463855421692</c:v>
                </c:pt>
                <c:pt idx="1473">
                  <c:v>1.0412274096385543</c:v>
                </c:pt>
                <c:pt idx="1474">
                  <c:v>1.0534638554216869</c:v>
                </c:pt>
                <c:pt idx="1475">
                  <c:v>1.0252259036144578</c:v>
                </c:pt>
                <c:pt idx="1476">
                  <c:v>1.0344503012048192</c:v>
                </c:pt>
                <c:pt idx="1477">
                  <c:v>1.0220256024096386</c:v>
                </c:pt>
                <c:pt idx="1478">
                  <c:v>0.98738704819277112</c:v>
                </c:pt>
                <c:pt idx="1479">
                  <c:v>0.99491716867469882</c:v>
                </c:pt>
                <c:pt idx="1480">
                  <c:v>0.99679969879518071</c:v>
                </c:pt>
                <c:pt idx="1481">
                  <c:v>1.0018825301204819</c:v>
                </c:pt>
                <c:pt idx="1482">
                  <c:v>0.98211596385542166</c:v>
                </c:pt>
                <c:pt idx="1483">
                  <c:v>1.0144954819277108</c:v>
                </c:pt>
                <c:pt idx="1484">
                  <c:v>1.0348268072289157</c:v>
                </c:pt>
                <c:pt idx="1485">
                  <c:v>1.0713478915662651</c:v>
                </c:pt>
                <c:pt idx="1486">
                  <c:v>1.0423569277108433</c:v>
                </c:pt>
                <c:pt idx="1487">
                  <c:v>1.0769954819277108</c:v>
                </c:pt>
                <c:pt idx="1488">
                  <c:v>1.0286144578313252</c:v>
                </c:pt>
                <c:pt idx="1489">
                  <c:v>1.0257906626506024</c:v>
                </c:pt>
                <c:pt idx="1490">
                  <c:v>1.0199548192771084</c:v>
                </c:pt>
                <c:pt idx="1491">
                  <c:v>0.99679969879518071</c:v>
                </c:pt>
                <c:pt idx="1492">
                  <c:v>0.99849397590361444</c:v>
                </c:pt>
                <c:pt idx="1493">
                  <c:v>1.0148719879518073</c:v>
                </c:pt>
                <c:pt idx="1494">
                  <c:v>0.98569277108433739</c:v>
                </c:pt>
                <c:pt idx="1495">
                  <c:v>1.0045180722891567</c:v>
                </c:pt>
                <c:pt idx="1496">
                  <c:v>1.0096009036144578</c:v>
                </c:pt>
                <c:pt idx="1497">
                  <c:v>1.0754894578313252</c:v>
                </c:pt>
                <c:pt idx="1498">
                  <c:v>1.0704066265060241</c:v>
                </c:pt>
                <c:pt idx="1499">
                  <c:v>1.0521460843373494</c:v>
                </c:pt>
                <c:pt idx="1500">
                  <c:v>1.0067771084337349</c:v>
                </c:pt>
                <c:pt idx="1501">
                  <c:v>1.0295557228915662</c:v>
                </c:pt>
                <c:pt idx="1502">
                  <c:v>1.0180722891566265</c:v>
                </c:pt>
                <c:pt idx="1503">
                  <c:v>0.99868222891566261</c:v>
                </c:pt>
                <c:pt idx="1504">
                  <c:v>1.0073418674698795</c:v>
                </c:pt>
                <c:pt idx="1505">
                  <c:v>1.0092243975903614</c:v>
                </c:pt>
                <c:pt idx="1506">
                  <c:v>1.0173192771084338</c:v>
                </c:pt>
                <c:pt idx="1507">
                  <c:v>1.0598644578313252</c:v>
                </c:pt>
                <c:pt idx="1508">
                  <c:v>1.0327560240963856</c:v>
                </c:pt>
                <c:pt idx="1509">
                  <c:v>1.0355798192771084</c:v>
                </c:pt>
                <c:pt idx="1510">
                  <c:v>1.0291792168674698</c:v>
                </c:pt>
                <c:pt idx="1511">
                  <c:v>1.0052710843373494</c:v>
                </c:pt>
                <c:pt idx="1512">
                  <c:v>1.0124246987951808</c:v>
                </c:pt>
                <c:pt idx="1513">
                  <c:v>0.99454066265060237</c:v>
                </c:pt>
                <c:pt idx="1514">
                  <c:v>1.0079066265060241</c:v>
                </c:pt>
                <c:pt idx="1515">
                  <c:v>0.98945783132530118</c:v>
                </c:pt>
                <c:pt idx="1516">
                  <c:v>1.0073418674698795</c:v>
                </c:pt>
                <c:pt idx="1517">
                  <c:v>0.98851656626506024</c:v>
                </c:pt>
                <c:pt idx="1518">
                  <c:v>0.98983433734939763</c:v>
                </c:pt>
                <c:pt idx="1519">
                  <c:v>1.0416039156626506</c:v>
                </c:pt>
                <c:pt idx="1520">
                  <c:v>1.0318147590361446</c:v>
                </c:pt>
                <c:pt idx="1521">
                  <c:v>1.0201430722891567</c:v>
                </c:pt>
                <c:pt idx="1522">
                  <c:v>0.99661144578313254</c:v>
                </c:pt>
                <c:pt idx="1523">
                  <c:v>0.99962349397590367</c:v>
                </c:pt>
                <c:pt idx="1524">
                  <c:v>0.99755271084337349</c:v>
                </c:pt>
                <c:pt idx="1525">
                  <c:v>1.0139307228915662</c:v>
                </c:pt>
                <c:pt idx="1526">
                  <c:v>0.99698795180722888</c:v>
                </c:pt>
                <c:pt idx="1527">
                  <c:v>0.9981174698795181</c:v>
                </c:pt>
                <c:pt idx="1528">
                  <c:v>0.97985692771084343</c:v>
                </c:pt>
                <c:pt idx="1529">
                  <c:v>0.98531626506024095</c:v>
                </c:pt>
                <c:pt idx="1530">
                  <c:v>0.9824924698795181</c:v>
                </c:pt>
                <c:pt idx="1531">
                  <c:v>0.97646837349397586</c:v>
                </c:pt>
                <c:pt idx="1532">
                  <c:v>1.0096009036144578</c:v>
                </c:pt>
                <c:pt idx="1533">
                  <c:v>1.0436746987951808</c:v>
                </c:pt>
                <c:pt idx="1534">
                  <c:v>1.0308734939759037</c:v>
                </c:pt>
                <c:pt idx="1535">
                  <c:v>1.0655120481927711</c:v>
                </c:pt>
                <c:pt idx="1536">
                  <c:v>1.0252259036144578</c:v>
                </c:pt>
                <c:pt idx="1537">
                  <c:v>0.98795180722891562</c:v>
                </c:pt>
                <c:pt idx="1538">
                  <c:v>0.99472891566265065</c:v>
                </c:pt>
                <c:pt idx="1539">
                  <c:v>1.0175075301204819</c:v>
                </c:pt>
                <c:pt idx="1540">
                  <c:v>0.99115210843373491</c:v>
                </c:pt>
                <c:pt idx="1541">
                  <c:v>0.97590361445783136</c:v>
                </c:pt>
                <c:pt idx="1542">
                  <c:v>0.98324548192771088</c:v>
                </c:pt>
                <c:pt idx="1543">
                  <c:v>0.96536144578313254</c:v>
                </c:pt>
                <c:pt idx="1544">
                  <c:v>1.0037650602409638</c:v>
                </c:pt>
                <c:pt idx="1545">
                  <c:v>1.0050828313253013</c:v>
                </c:pt>
                <c:pt idx="1546">
                  <c:v>0.97910391566265065</c:v>
                </c:pt>
                <c:pt idx="1547">
                  <c:v>0.99830572289156627</c:v>
                </c:pt>
                <c:pt idx="1548">
                  <c:v>1.0440512048192772</c:v>
                </c:pt>
                <c:pt idx="1549">
                  <c:v>1.0212725903614457</c:v>
                </c:pt>
                <c:pt idx="1550">
                  <c:v>0.99303463855421692</c:v>
                </c:pt>
                <c:pt idx="1551">
                  <c:v>0.97270331325301207</c:v>
                </c:pt>
                <c:pt idx="1552">
                  <c:v>0.95463102409638556</c:v>
                </c:pt>
                <c:pt idx="1553">
                  <c:v>0.98192771084337349</c:v>
                </c:pt>
                <c:pt idx="1554">
                  <c:v>0.95256024096385539</c:v>
                </c:pt>
                <c:pt idx="1555">
                  <c:v>0.95481927710843373</c:v>
                </c:pt>
                <c:pt idx="1556">
                  <c:v>0.95820783132530118</c:v>
                </c:pt>
                <c:pt idx="1557">
                  <c:v>0.99905873493975905</c:v>
                </c:pt>
                <c:pt idx="1558">
                  <c:v>0.94615963855421692</c:v>
                </c:pt>
                <c:pt idx="1559">
                  <c:v>0.9730798192771084</c:v>
                </c:pt>
                <c:pt idx="1560">
                  <c:v>0.96009036144578308</c:v>
                </c:pt>
                <c:pt idx="1561">
                  <c:v>0.97326807228915657</c:v>
                </c:pt>
                <c:pt idx="1562">
                  <c:v>1.0271084337349397</c:v>
                </c:pt>
                <c:pt idx="1563">
                  <c:v>1.0495105421686748</c:v>
                </c:pt>
                <c:pt idx="1564">
                  <c:v>1.0143072289156627</c:v>
                </c:pt>
                <c:pt idx="1565">
                  <c:v>0.99679969879518071</c:v>
                </c:pt>
                <c:pt idx="1566">
                  <c:v>0.9493599397590361</c:v>
                </c:pt>
                <c:pt idx="1567">
                  <c:v>0.98644578313253017</c:v>
                </c:pt>
                <c:pt idx="1568">
                  <c:v>0.96366716867469882</c:v>
                </c:pt>
                <c:pt idx="1569">
                  <c:v>0.95820783132530118</c:v>
                </c:pt>
                <c:pt idx="1570">
                  <c:v>0.97684487951807231</c:v>
                </c:pt>
                <c:pt idx="1571">
                  <c:v>0.95086596385542166</c:v>
                </c:pt>
                <c:pt idx="1572">
                  <c:v>0.95858433734939763</c:v>
                </c:pt>
                <c:pt idx="1573">
                  <c:v>0.98399849397590367</c:v>
                </c:pt>
                <c:pt idx="1574">
                  <c:v>1.0060240963855422</c:v>
                </c:pt>
                <c:pt idx="1575">
                  <c:v>1.0086596385542168</c:v>
                </c:pt>
                <c:pt idx="1576">
                  <c:v>1.0269201807228916</c:v>
                </c:pt>
                <c:pt idx="1577">
                  <c:v>0.98211596385542166</c:v>
                </c:pt>
                <c:pt idx="1578">
                  <c:v>0.96931475903614461</c:v>
                </c:pt>
                <c:pt idx="1579">
                  <c:v>0.96065512048192769</c:v>
                </c:pt>
                <c:pt idx="1580">
                  <c:v>0.96272590361445787</c:v>
                </c:pt>
                <c:pt idx="1581">
                  <c:v>0.96046686746987953</c:v>
                </c:pt>
                <c:pt idx="1582">
                  <c:v>0.94634789156626509</c:v>
                </c:pt>
                <c:pt idx="1583">
                  <c:v>0.95218373493975905</c:v>
                </c:pt>
                <c:pt idx="1584">
                  <c:v>0.92789909638554213</c:v>
                </c:pt>
                <c:pt idx="1585">
                  <c:v>0.9550075301204819</c:v>
                </c:pt>
                <c:pt idx="1586">
                  <c:v>0.92451054216867468</c:v>
                </c:pt>
                <c:pt idx="1587">
                  <c:v>0.96479668674698793</c:v>
                </c:pt>
                <c:pt idx="1588">
                  <c:v>0.95594879518072284</c:v>
                </c:pt>
                <c:pt idx="1589">
                  <c:v>0.94521837349397586</c:v>
                </c:pt>
                <c:pt idx="1590">
                  <c:v>0.92168674698795183</c:v>
                </c:pt>
                <c:pt idx="1591">
                  <c:v>0.97044427710843373</c:v>
                </c:pt>
                <c:pt idx="1592">
                  <c:v>0.9393825301204819</c:v>
                </c:pt>
                <c:pt idx="1593">
                  <c:v>0.95218373493975905</c:v>
                </c:pt>
                <c:pt idx="1594">
                  <c:v>1.015625</c:v>
                </c:pt>
                <c:pt idx="1595">
                  <c:v>1.0436746987951808</c:v>
                </c:pt>
                <c:pt idx="1596">
                  <c:v>1.0583584337349397</c:v>
                </c:pt>
                <c:pt idx="1597">
                  <c:v>1.0542168674698795</c:v>
                </c:pt>
                <c:pt idx="1598">
                  <c:v>0.98795180722891562</c:v>
                </c:pt>
                <c:pt idx="1599">
                  <c:v>0.98588102409638556</c:v>
                </c:pt>
                <c:pt idx="1600">
                  <c:v>0.94371234939759041</c:v>
                </c:pt>
                <c:pt idx="1601">
                  <c:v>0.96743222891566261</c:v>
                </c:pt>
                <c:pt idx="1602">
                  <c:v>0.95105421686746983</c:v>
                </c:pt>
                <c:pt idx="1603">
                  <c:v>0.92319277108433739</c:v>
                </c:pt>
                <c:pt idx="1604">
                  <c:v>0.94710090361445787</c:v>
                </c:pt>
                <c:pt idx="1605">
                  <c:v>0.95274849397590367</c:v>
                </c:pt>
                <c:pt idx="1606">
                  <c:v>0.94559487951807231</c:v>
                </c:pt>
                <c:pt idx="1607">
                  <c:v>0.94841867469879515</c:v>
                </c:pt>
                <c:pt idx="1608">
                  <c:v>0.95594879518072284</c:v>
                </c:pt>
                <c:pt idx="1609">
                  <c:v>1.0050828313253013</c:v>
                </c:pt>
                <c:pt idx="1610">
                  <c:v>1.0269201807228916</c:v>
                </c:pt>
                <c:pt idx="1611">
                  <c:v>1.0382153614457832</c:v>
                </c:pt>
                <c:pt idx="1612">
                  <c:v>1.0016942771084338</c:v>
                </c:pt>
                <c:pt idx="1613">
                  <c:v>0.95783132530120485</c:v>
                </c:pt>
                <c:pt idx="1614">
                  <c:v>0.95387801204819278</c:v>
                </c:pt>
                <c:pt idx="1615">
                  <c:v>0.96705572289156627</c:v>
                </c:pt>
                <c:pt idx="1616">
                  <c:v>0.9706325301204819</c:v>
                </c:pt>
                <c:pt idx="1617">
                  <c:v>0.95726656626506024</c:v>
                </c:pt>
                <c:pt idx="1618">
                  <c:v>0.93166415662650603</c:v>
                </c:pt>
                <c:pt idx="1619">
                  <c:v>0.93712349397590367</c:v>
                </c:pt>
                <c:pt idx="1620">
                  <c:v>0.94992469879518071</c:v>
                </c:pt>
                <c:pt idx="1621">
                  <c:v>0.94634789156626509</c:v>
                </c:pt>
                <c:pt idx="1622">
                  <c:v>0.9512424698795181</c:v>
                </c:pt>
                <c:pt idx="1623">
                  <c:v>0.96216114457831325</c:v>
                </c:pt>
                <c:pt idx="1624">
                  <c:v>1.0359563253012047</c:v>
                </c:pt>
                <c:pt idx="1625">
                  <c:v>1.0436746987951808</c:v>
                </c:pt>
                <c:pt idx="1626">
                  <c:v>1.0598644578313252</c:v>
                </c:pt>
                <c:pt idx="1627">
                  <c:v>0.99736445783132532</c:v>
                </c:pt>
                <c:pt idx="1628">
                  <c:v>0.98550451807228912</c:v>
                </c:pt>
                <c:pt idx="1629">
                  <c:v>1.0028237951807228</c:v>
                </c:pt>
                <c:pt idx="1630">
                  <c:v>0.98964608433734935</c:v>
                </c:pt>
                <c:pt idx="1631">
                  <c:v>0.99924698795180722</c:v>
                </c:pt>
                <c:pt idx="1632">
                  <c:v>0.97289156626506024</c:v>
                </c:pt>
                <c:pt idx="1633">
                  <c:v>0.94973644578313254</c:v>
                </c:pt>
                <c:pt idx="1634">
                  <c:v>0.9824924698795181</c:v>
                </c:pt>
                <c:pt idx="1635">
                  <c:v>0.98399849397590367</c:v>
                </c:pt>
                <c:pt idx="1636">
                  <c:v>0.9668674698795181</c:v>
                </c:pt>
                <c:pt idx="1637">
                  <c:v>1.0248493975903614</c:v>
                </c:pt>
                <c:pt idx="1638">
                  <c:v>0.9962349397590361</c:v>
                </c:pt>
                <c:pt idx="1639">
                  <c:v>1.0075301204819278</c:v>
                </c:pt>
                <c:pt idx="1640">
                  <c:v>1.067394578313253</c:v>
                </c:pt>
                <c:pt idx="1641">
                  <c:v>1.0344503012048192</c:v>
                </c:pt>
                <c:pt idx="1642">
                  <c:v>1.0438629518072289</c:v>
                </c:pt>
                <c:pt idx="1643">
                  <c:v>1.0432981927710843</c:v>
                </c:pt>
                <c:pt idx="1644">
                  <c:v>1.0376506024096386</c:v>
                </c:pt>
                <c:pt idx="1645">
                  <c:v>1.0096009036144578</c:v>
                </c:pt>
                <c:pt idx="1646">
                  <c:v>1.0088478915662651</c:v>
                </c:pt>
                <c:pt idx="1647">
                  <c:v>0.99378765060240959</c:v>
                </c:pt>
                <c:pt idx="1648">
                  <c:v>0.95858433734939763</c:v>
                </c:pt>
                <c:pt idx="1649">
                  <c:v>0.9730798192771084</c:v>
                </c:pt>
                <c:pt idx="1650">
                  <c:v>0.95199548192771088</c:v>
                </c:pt>
                <c:pt idx="1651">
                  <c:v>0.95368975903614461</c:v>
                </c:pt>
                <c:pt idx="1652">
                  <c:v>0.94352409638554213</c:v>
                </c:pt>
                <c:pt idx="1653">
                  <c:v>0.91735692771084343</c:v>
                </c:pt>
                <c:pt idx="1654">
                  <c:v>0.9824924698795181</c:v>
                </c:pt>
                <c:pt idx="1655">
                  <c:v>0.95180722891566261</c:v>
                </c:pt>
                <c:pt idx="1656">
                  <c:v>1.0338855421686748</c:v>
                </c:pt>
                <c:pt idx="1657">
                  <c:v>0.99849397590361444</c:v>
                </c:pt>
                <c:pt idx="1658">
                  <c:v>1.0242846385542168</c:v>
                </c:pt>
                <c:pt idx="1659">
                  <c:v>1.0323795180722892</c:v>
                </c:pt>
                <c:pt idx="1660">
                  <c:v>0.99981174698795183</c:v>
                </c:pt>
                <c:pt idx="1661">
                  <c:v>0.97571536144578308</c:v>
                </c:pt>
                <c:pt idx="1662">
                  <c:v>0.97891566265060237</c:v>
                </c:pt>
                <c:pt idx="1663">
                  <c:v>0.97176204819277112</c:v>
                </c:pt>
                <c:pt idx="1664">
                  <c:v>0.96366716867469882</c:v>
                </c:pt>
                <c:pt idx="1665">
                  <c:v>0.96875</c:v>
                </c:pt>
                <c:pt idx="1666">
                  <c:v>0.95632530120481929</c:v>
                </c:pt>
                <c:pt idx="1667">
                  <c:v>0.94390060240963858</c:v>
                </c:pt>
                <c:pt idx="1668">
                  <c:v>0.94371234939759041</c:v>
                </c:pt>
                <c:pt idx="1669">
                  <c:v>0.94352409638554213</c:v>
                </c:pt>
                <c:pt idx="1670">
                  <c:v>0.9550075301204819</c:v>
                </c:pt>
                <c:pt idx="1671">
                  <c:v>0.96856174698795183</c:v>
                </c:pt>
                <c:pt idx="1672">
                  <c:v>1.0035768072289157</c:v>
                </c:pt>
                <c:pt idx="1673">
                  <c:v>1.0007530120481927</c:v>
                </c:pt>
                <c:pt idx="1674">
                  <c:v>1.0118599397590362</c:v>
                </c:pt>
                <c:pt idx="1675">
                  <c:v>1.0060240963855422</c:v>
                </c:pt>
                <c:pt idx="1676">
                  <c:v>0.98757530120481929</c:v>
                </c:pt>
                <c:pt idx="1677">
                  <c:v>0.97496234939759041</c:v>
                </c:pt>
                <c:pt idx="1678">
                  <c:v>0.9644201807228916</c:v>
                </c:pt>
                <c:pt idx="1679">
                  <c:v>0.93166415662650603</c:v>
                </c:pt>
                <c:pt idx="1680">
                  <c:v>0.93486445783132532</c:v>
                </c:pt>
                <c:pt idx="1681">
                  <c:v>0.94540662650602414</c:v>
                </c:pt>
                <c:pt idx="1682">
                  <c:v>0.94465361445783136</c:v>
                </c:pt>
                <c:pt idx="1683">
                  <c:v>0.94615963855421692</c:v>
                </c:pt>
                <c:pt idx="1684">
                  <c:v>0.93806475903614461</c:v>
                </c:pt>
                <c:pt idx="1685">
                  <c:v>0.98512801204819278</c:v>
                </c:pt>
                <c:pt idx="1686">
                  <c:v>0.99830572289156627</c:v>
                </c:pt>
                <c:pt idx="1687">
                  <c:v>1.0131777108433735</c:v>
                </c:pt>
                <c:pt idx="1688">
                  <c:v>1.0105421686746987</c:v>
                </c:pt>
                <c:pt idx="1689">
                  <c:v>0.97985692771084343</c:v>
                </c:pt>
                <c:pt idx="1690">
                  <c:v>0.93825301204819278</c:v>
                </c:pt>
                <c:pt idx="1691">
                  <c:v>0.95199548192771088</c:v>
                </c:pt>
                <c:pt idx="1692">
                  <c:v>0.94578313253012047</c:v>
                </c:pt>
                <c:pt idx="1693">
                  <c:v>0.93222891566265065</c:v>
                </c:pt>
                <c:pt idx="1694">
                  <c:v>0.95218373493975905</c:v>
                </c:pt>
                <c:pt idx="1695">
                  <c:v>0.94427710843373491</c:v>
                </c:pt>
                <c:pt idx="1696">
                  <c:v>0.92168674698795183</c:v>
                </c:pt>
                <c:pt idx="1697">
                  <c:v>0.93637048192771088</c:v>
                </c:pt>
                <c:pt idx="1698">
                  <c:v>0.93015813253012047</c:v>
                </c:pt>
                <c:pt idx="1699">
                  <c:v>0.95594879518072284</c:v>
                </c:pt>
                <c:pt idx="1700">
                  <c:v>0.94710090361445787</c:v>
                </c:pt>
                <c:pt idx="1701">
                  <c:v>0.92225150602409633</c:v>
                </c:pt>
                <c:pt idx="1702">
                  <c:v>0.93279367469879515</c:v>
                </c:pt>
                <c:pt idx="1703">
                  <c:v>0.93806475903614461</c:v>
                </c:pt>
                <c:pt idx="1704">
                  <c:v>0.94145331325301207</c:v>
                </c:pt>
                <c:pt idx="1705">
                  <c:v>0.96140813253012047</c:v>
                </c:pt>
                <c:pt idx="1706">
                  <c:v>0.99661144578313254</c:v>
                </c:pt>
                <c:pt idx="1707">
                  <c:v>0.99341114457831325</c:v>
                </c:pt>
                <c:pt idx="1708">
                  <c:v>1.0086596385542168</c:v>
                </c:pt>
                <c:pt idx="1709">
                  <c:v>1.0035768072289157</c:v>
                </c:pt>
                <c:pt idx="1710">
                  <c:v>0.94841867469879515</c:v>
                </c:pt>
                <c:pt idx="1711">
                  <c:v>0.94070030120481929</c:v>
                </c:pt>
                <c:pt idx="1712">
                  <c:v>0.96272590361445787</c:v>
                </c:pt>
                <c:pt idx="1713">
                  <c:v>0.94540662650602414</c:v>
                </c:pt>
                <c:pt idx="1714">
                  <c:v>0.93204066265060237</c:v>
                </c:pt>
                <c:pt idx="1715">
                  <c:v>0.9105798192771084</c:v>
                </c:pt>
                <c:pt idx="1716">
                  <c:v>0.90380271084337349</c:v>
                </c:pt>
                <c:pt idx="1717">
                  <c:v>0.93298192771084343</c:v>
                </c:pt>
                <c:pt idx="1718">
                  <c:v>0.91340361445783136</c:v>
                </c:pt>
                <c:pt idx="1719">
                  <c:v>0.93128765060240959</c:v>
                </c:pt>
                <c:pt idx="1720">
                  <c:v>0.94408885542168675</c:v>
                </c:pt>
                <c:pt idx="1721">
                  <c:v>1.0197665662650603</c:v>
                </c:pt>
                <c:pt idx="1722">
                  <c:v>1.0220256024096386</c:v>
                </c:pt>
                <c:pt idx="1723">
                  <c:v>0.99209337349397586</c:v>
                </c:pt>
                <c:pt idx="1724">
                  <c:v>0.97722138554216864</c:v>
                </c:pt>
                <c:pt idx="1725">
                  <c:v>1.0186370481927711</c:v>
                </c:pt>
                <c:pt idx="1726">
                  <c:v>1.0028237951807228</c:v>
                </c:pt>
                <c:pt idx="1727">
                  <c:v>0.96479668674698793</c:v>
                </c:pt>
                <c:pt idx="1728">
                  <c:v>0.95331325301204817</c:v>
                </c:pt>
                <c:pt idx="1729">
                  <c:v>0.9550075301204819</c:v>
                </c:pt>
                <c:pt idx="1730">
                  <c:v>0.9487951807228916</c:v>
                </c:pt>
                <c:pt idx="1731">
                  <c:v>0.92507530120481929</c:v>
                </c:pt>
                <c:pt idx="1732">
                  <c:v>0.9331701807228916</c:v>
                </c:pt>
                <c:pt idx="1733">
                  <c:v>0.92432228915662651</c:v>
                </c:pt>
                <c:pt idx="1734">
                  <c:v>0.92225150602409633</c:v>
                </c:pt>
                <c:pt idx="1735">
                  <c:v>0.93053463855421692</c:v>
                </c:pt>
                <c:pt idx="1736">
                  <c:v>0.95952560240963858</c:v>
                </c:pt>
                <c:pt idx="1737">
                  <c:v>0.99661144578313254</c:v>
                </c:pt>
                <c:pt idx="1738">
                  <c:v>1.0240963855421688</c:v>
                </c:pt>
                <c:pt idx="1739">
                  <c:v>1.0052710843373494</c:v>
                </c:pt>
                <c:pt idx="1740">
                  <c:v>1.0579819277108433</c:v>
                </c:pt>
                <c:pt idx="1741">
                  <c:v>1.0013177710843373</c:v>
                </c:pt>
                <c:pt idx="1742">
                  <c:v>0.98042168674698793</c:v>
                </c:pt>
                <c:pt idx="1743">
                  <c:v>0.96084337349397586</c:v>
                </c:pt>
                <c:pt idx="1744">
                  <c:v>0.9568900602409639</c:v>
                </c:pt>
                <c:pt idx="1745">
                  <c:v>0.95613704819277112</c:v>
                </c:pt>
                <c:pt idx="1746">
                  <c:v>0.92338102409638556</c:v>
                </c:pt>
                <c:pt idx="1747">
                  <c:v>0.95161897590361444</c:v>
                </c:pt>
                <c:pt idx="1748">
                  <c:v>0.92488704819277112</c:v>
                </c:pt>
                <c:pt idx="1749">
                  <c:v>0.953125</c:v>
                </c:pt>
                <c:pt idx="1750">
                  <c:v>0.91434487951807231</c:v>
                </c:pt>
                <c:pt idx="1751">
                  <c:v>0.9181099397590361</c:v>
                </c:pt>
                <c:pt idx="1752">
                  <c:v>0.93806475903614461</c:v>
                </c:pt>
                <c:pt idx="1753">
                  <c:v>0.91509789156626509</c:v>
                </c:pt>
                <c:pt idx="1754">
                  <c:v>0.90210843373493976</c:v>
                </c:pt>
                <c:pt idx="1755">
                  <c:v>0.89853162650602414</c:v>
                </c:pt>
                <c:pt idx="1756">
                  <c:v>0.92921686746987953</c:v>
                </c:pt>
                <c:pt idx="1757">
                  <c:v>0.93260542168674698</c:v>
                </c:pt>
                <c:pt idx="1758">
                  <c:v>0.96818524096385539</c:v>
                </c:pt>
                <c:pt idx="1759">
                  <c:v>0.98268072289156627</c:v>
                </c:pt>
                <c:pt idx="1760">
                  <c:v>1.0250376506024097</c:v>
                </c:pt>
                <c:pt idx="1761">
                  <c:v>1.0041415662650603</c:v>
                </c:pt>
                <c:pt idx="1762">
                  <c:v>0.97402108433734935</c:v>
                </c:pt>
                <c:pt idx="1763">
                  <c:v>0.93637048192771088</c:v>
                </c:pt>
                <c:pt idx="1764">
                  <c:v>0.92771084337349397</c:v>
                </c:pt>
                <c:pt idx="1765">
                  <c:v>0.94484186746987953</c:v>
                </c:pt>
                <c:pt idx="1766">
                  <c:v>0.93241716867469882</c:v>
                </c:pt>
                <c:pt idx="1767">
                  <c:v>0.9356174698795181</c:v>
                </c:pt>
                <c:pt idx="1768">
                  <c:v>0.92356927710843373</c:v>
                </c:pt>
                <c:pt idx="1769">
                  <c:v>0.8949548192771084</c:v>
                </c:pt>
                <c:pt idx="1770">
                  <c:v>0.90963855421686746</c:v>
                </c:pt>
                <c:pt idx="1771">
                  <c:v>0.9118975903614458</c:v>
                </c:pt>
                <c:pt idx="1772">
                  <c:v>0.9024849397590361</c:v>
                </c:pt>
                <c:pt idx="1773">
                  <c:v>0.91641566265060237</c:v>
                </c:pt>
                <c:pt idx="1774">
                  <c:v>0.94277108433734935</c:v>
                </c:pt>
                <c:pt idx="1775">
                  <c:v>0.98983433734939763</c:v>
                </c:pt>
                <c:pt idx="1776">
                  <c:v>1.0084713855421688</c:v>
                </c:pt>
                <c:pt idx="1777">
                  <c:v>1.0237198795180722</c:v>
                </c:pt>
                <c:pt idx="1778">
                  <c:v>0.9887048192771084</c:v>
                </c:pt>
                <c:pt idx="1779">
                  <c:v>0.97383283132530118</c:v>
                </c:pt>
                <c:pt idx="1780">
                  <c:v>0.93279367469879515</c:v>
                </c:pt>
                <c:pt idx="1781">
                  <c:v>0.94521837349397586</c:v>
                </c:pt>
                <c:pt idx="1782">
                  <c:v>0.94088855421686746</c:v>
                </c:pt>
                <c:pt idx="1783">
                  <c:v>0.92526355421686746</c:v>
                </c:pt>
                <c:pt idx="1784">
                  <c:v>0.94766566265060237</c:v>
                </c:pt>
                <c:pt idx="1785">
                  <c:v>0.90643825301204817</c:v>
                </c:pt>
                <c:pt idx="1786">
                  <c:v>0.89589608433734935</c:v>
                </c:pt>
                <c:pt idx="1787">
                  <c:v>0.90643825301204817</c:v>
                </c:pt>
                <c:pt idx="1788">
                  <c:v>0.90530873493975905</c:v>
                </c:pt>
                <c:pt idx="1789">
                  <c:v>0.9331701807228916</c:v>
                </c:pt>
                <c:pt idx="1790">
                  <c:v>0.91660391566265065</c:v>
                </c:pt>
                <c:pt idx="1791">
                  <c:v>0.91792168674698793</c:v>
                </c:pt>
                <c:pt idx="1792">
                  <c:v>0.94559487951807231</c:v>
                </c:pt>
                <c:pt idx="1793">
                  <c:v>0.92451054216867468</c:v>
                </c:pt>
                <c:pt idx="1794">
                  <c:v>0.94559487951807231</c:v>
                </c:pt>
                <c:pt idx="1795">
                  <c:v>0.98531626506024095</c:v>
                </c:pt>
                <c:pt idx="1796">
                  <c:v>1.0197665662650603</c:v>
                </c:pt>
                <c:pt idx="1797">
                  <c:v>0.99397590361445787</c:v>
                </c:pt>
                <c:pt idx="1798">
                  <c:v>0.98192771084337349</c:v>
                </c:pt>
                <c:pt idx="1799">
                  <c:v>0.95670180722891562</c:v>
                </c:pt>
                <c:pt idx="1800">
                  <c:v>0.94503012048192769</c:v>
                </c:pt>
                <c:pt idx="1801">
                  <c:v>0.92131024096385539</c:v>
                </c:pt>
                <c:pt idx="1802">
                  <c:v>0.93655873493975905</c:v>
                </c:pt>
                <c:pt idx="1803">
                  <c:v>0.91528614457831325</c:v>
                </c:pt>
                <c:pt idx="1804">
                  <c:v>0.89570783132530118</c:v>
                </c:pt>
                <c:pt idx="1805">
                  <c:v>0.9256400602409639</c:v>
                </c:pt>
                <c:pt idx="1806">
                  <c:v>0.89608433734939763</c:v>
                </c:pt>
                <c:pt idx="1807">
                  <c:v>0.89909638554216864</c:v>
                </c:pt>
                <c:pt idx="1808">
                  <c:v>0.90455572289156627</c:v>
                </c:pt>
                <c:pt idx="1809">
                  <c:v>0.90681475903614461</c:v>
                </c:pt>
                <c:pt idx="1810">
                  <c:v>0.95990210843373491</c:v>
                </c:pt>
                <c:pt idx="1811">
                  <c:v>0.99228162650602414</c:v>
                </c:pt>
                <c:pt idx="1812">
                  <c:v>1.0035768072289157</c:v>
                </c:pt>
                <c:pt idx="1813">
                  <c:v>0.99510542168674698</c:v>
                </c:pt>
                <c:pt idx="1814">
                  <c:v>0.94691265060240959</c:v>
                </c:pt>
                <c:pt idx="1815">
                  <c:v>0.93241716867469882</c:v>
                </c:pt>
                <c:pt idx="1816">
                  <c:v>0.97552710843373491</c:v>
                </c:pt>
                <c:pt idx="1817">
                  <c:v>1.010730421686747</c:v>
                </c:pt>
                <c:pt idx="1818">
                  <c:v>0.99755271084337349</c:v>
                </c:pt>
                <c:pt idx="1819">
                  <c:v>1.0114834337349397</c:v>
                </c:pt>
                <c:pt idx="1820">
                  <c:v>0.96818524096385539</c:v>
                </c:pt>
                <c:pt idx="1821">
                  <c:v>0.97289156626506024</c:v>
                </c:pt>
                <c:pt idx="1822">
                  <c:v>0.94145331325301207</c:v>
                </c:pt>
                <c:pt idx="1823">
                  <c:v>0.90399096385542166</c:v>
                </c:pt>
                <c:pt idx="1824">
                  <c:v>0.93486445783132532</c:v>
                </c:pt>
                <c:pt idx="1825">
                  <c:v>0.93712349397590367</c:v>
                </c:pt>
                <c:pt idx="1826">
                  <c:v>0.97157379518072284</c:v>
                </c:pt>
                <c:pt idx="1827">
                  <c:v>0.96065512048192769</c:v>
                </c:pt>
                <c:pt idx="1828">
                  <c:v>0.97289156626506024</c:v>
                </c:pt>
                <c:pt idx="1829">
                  <c:v>0.94992469879518071</c:v>
                </c:pt>
                <c:pt idx="1830">
                  <c:v>0.92601656626506024</c:v>
                </c:pt>
                <c:pt idx="1831">
                  <c:v>0.92639307228915657</c:v>
                </c:pt>
                <c:pt idx="1832">
                  <c:v>0.9331701807228916</c:v>
                </c:pt>
                <c:pt idx="1833">
                  <c:v>0.94540662650602414</c:v>
                </c:pt>
                <c:pt idx="1834">
                  <c:v>0.95952560240963858</c:v>
                </c:pt>
                <c:pt idx="1835">
                  <c:v>0.97100903614457834</c:v>
                </c:pt>
                <c:pt idx="1836">
                  <c:v>1.0073418674698795</c:v>
                </c:pt>
                <c:pt idx="1837">
                  <c:v>1.0261671686746987</c:v>
                </c:pt>
                <c:pt idx="1838">
                  <c:v>1.0316265060240963</c:v>
                </c:pt>
                <c:pt idx="1839">
                  <c:v>0.97966867469879515</c:v>
                </c:pt>
                <c:pt idx="1840">
                  <c:v>0.96385542168674698</c:v>
                </c:pt>
                <c:pt idx="1841">
                  <c:v>0.94653614457831325</c:v>
                </c:pt>
                <c:pt idx="1842">
                  <c:v>0.94917168674698793</c:v>
                </c:pt>
                <c:pt idx="1843">
                  <c:v>0.92319277108433739</c:v>
                </c:pt>
                <c:pt idx="1844">
                  <c:v>0.96272590361445787</c:v>
                </c:pt>
                <c:pt idx="1845">
                  <c:v>0.93354668674698793</c:v>
                </c:pt>
                <c:pt idx="1846">
                  <c:v>0.91321536144578308</c:v>
                </c:pt>
                <c:pt idx="1847">
                  <c:v>0.93900602409638556</c:v>
                </c:pt>
                <c:pt idx="1848">
                  <c:v>0.9393825301204819</c:v>
                </c:pt>
                <c:pt idx="1849">
                  <c:v>0.93279367469879515</c:v>
                </c:pt>
                <c:pt idx="1850">
                  <c:v>0.92676957831325302</c:v>
                </c:pt>
                <c:pt idx="1851">
                  <c:v>0.91660391566265065</c:v>
                </c:pt>
                <c:pt idx="1852">
                  <c:v>0.90945030120481929</c:v>
                </c:pt>
                <c:pt idx="1853">
                  <c:v>0.90003765060240959</c:v>
                </c:pt>
                <c:pt idx="1854">
                  <c:v>0.90304969879518071</c:v>
                </c:pt>
                <c:pt idx="1855">
                  <c:v>0.90417921686746983</c:v>
                </c:pt>
                <c:pt idx="1856">
                  <c:v>0.92676957831325302</c:v>
                </c:pt>
                <c:pt idx="1857">
                  <c:v>0.94860692771084343</c:v>
                </c:pt>
                <c:pt idx="1858">
                  <c:v>0.93279367469879515</c:v>
                </c:pt>
                <c:pt idx="1859">
                  <c:v>0.93787650602409633</c:v>
                </c:pt>
                <c:pt idx="1860">
                  <c:v>0.99454066265060237</c:v>
                </c:pt>
                <c:pt idx="1861">
                  <c:v>0.93524096385542166</c:v>
                </c:pt>
                <c:pt idx="1862">
                  <c:v>0.93655873493975905</c:v>
                </c:pt>
                <c:pt idx="1863">
                  <c:v>0.94446536144578308</c:v>
                </c:pt>
                <c:pt idx="1864">
                  <c:v>0.92262801204819278</c:v>
                </c:pt>
                <c:pt idx="1865">
                  <c:v>0.91340361445783136</c:v>
                </c:pt>
                <c:pt idx="1866">
                  <c:v>0.91302710843373491</c:v>
                </c:pt>
                <c:pt idx="1867">
                  <c:v>0.92432228915662651</c:v>
                </c:pt>
                <c:pt idx="1868">
                  <c:v>0.91905120481927716</c:v>
                </c:pt>
                <c:pt idx="1869">
                  <c:v>0.92884036144578308</c:v>
                </c:pt>
                <c:pt idx="1870">
                  <c:v>0.93599397590361444</c:v>
                </c:pt>
                <c:pt idx="1871">
                  <c:v>0.91942771084337349</c:v>
                </c:pt>
                <c:pt idx="1872">
                  <c:v>0.91585090361445787</c:v>
                </c:pt>
                <c:pt idx="1873">
                  <c:v>0.9706325301204819</c:v>
                </c:pt>
                <c:pt idx="1874">
                  <c:v>1.0037650602409638</c:v>
                </c:pt>
                <c:pt idx="1875">
                  <c:v>0.95726656626506024</c:v>
                </c:pt>
                <c:pt idx="1876">
                  <c:v>0.99491716867469882</c:v>
                </c:pt>
                <c:pt idx="1877">
                  <c:v>0.98136295180722888</c:v>
                </c:pt>
                <c:pt idx="1878">
                  <c:v>0.94766566265060237</c:v>
                </c:pt>
                <c:pt idx="1879">
                  <c:v>0.93335843373493976</c:v>
                </c:pt>
                <c:pt idx="1880">
                  <c:v>0.92526355421686746</c:v>
                </c:pt>
                <c:pt idx="1881">
                  <c:v>0.94672439759036142</c:v>
                </c:pt>
                <c:pt idx="1882">
                  <c:v>0.89871987951807231</c:v>
                </c:pt>
                <c:pt idx="1883">
                  <c:v>0.91246234939759041</c:v>
                </c:pt>
                <c:pt idx="1884">
                  <c:v>0.90549698795180722</c:v>
                </c:pt>
                <c:pt idx="1885">
                  <c:v>0.93222891566265065</c:v>
                </c:pt>
                <c:pt idx="1886">
                  <c:v>0.90568524096385539</c:v>
                </c:pt>
                <c:pt idx="1887">
                  <c:v>0.92865210843373491</c:v>
                </c:pt>
                <c:pt idx="1888">
                  <c:v>0.93091114457831325</c:v>
                </c:pt>
                <c:pt idx="1889">
                  <c:v>0.93919427710843373</c:v>
                </c:pt>
                <c:pt idx="1890">
                  <c:v>0.96517319277108438</c:v>
                </c:pt>
                <c:pt idx="1891">
                  <c:v>0.95519578313253017</c:v>
                </c:pt>
                <c:pt idx="1892">
                  <c:v>0.96178463855421692</c:v>
                </c:pt>
                <c:pt idx="1893">
                  <c:v>0.95218373493975905</c:v>
                </c:pt>
                <c:pt idx="1894">
                  <c:v>0.96027861445783136</c:v>
                </c:pt>
                <c:pt idx="1895">
                  <c:v>0.93542921686746983</c:v>
                </c:pt>
                <c:pt idx="1896">
                  <c:v>0.93072289156626509</c:v>
                </c:pt>
                <c:pt idx="1897">
                  <c:v>0.92432228915662651</c:v>
                </c:pt>
                <c:pt idx="1898">
                  <c:v>0.91547439759036142</c:v>
                </c:pt>
                <c:pt idx="1899">
                  <c:v>0.88290662650602414</c:v>
                </c:pt>
                <c:pt idx="1900">
                  <c:v>0.91905120481927716</c:v>
                </c:pt>
                <c:pt idx="1901">
                  <c:v>0.90737951807228912</c:v>
                </c:pt>
                <c:pt idx="1902">
                  <c:v>0.9162274096385542</c:v>
                </c:pt>
                <c:pt idx="1903">
                  <c:v>0.91848644578313254</c:v>
                </c:pt>
                <c:pt idx="1904">
                  <c:v>0.9356174698795181</c:v>
                </c:pt>
                <c:pt idx="1905">
                  <c:v>0.92131024096385539</c:v>
                </c:pt>
                <c:pt idx="1906">
                  <c:v>0.98362198795180722</c:v>
                </c:pt>
                <c:pt idx="1907">
                  <c:v>0.99284638554216864</c:v>
                </c:pt>
                <c:pt idx="1908">
                  <c:v>1.0086596385542168</c:v>
                </c:pt>
                <c:pt idx="1909">
                  <c:v>0.96573795180722888</c:v>
                </c:pt>
                <c:pt idx="1910">
                  <c:v>0.92319277108433739</c:v>
                </c:pt>
                <c:pt idx="1911">
                  <c:v>0.96818524096385539</c:v>
                </c:pt>
                <c:pt idx="1912">
                  <c:v>0.96931475903614461</c:v>
                </c:pt>
                <c:pt idx="1913">
                  <c:v>0.94804216867469882</c:v>
                </c:pt>
                <c:pt idx="1914">
                  <c:v>0.92112198795180722</c:v>
                </c:pt>
                <c:pt idx="1915">
                  <c:v>0.94013554216867468</c:v>
                </c:pt>
                <c:pt idx="1916">
                  <c:v>0.92413403614457834</c:v>
                </c:pt>
                <c:pt idx="1917">
                  <c:v>0.92225150602409633</c:v>
                </c:pt>
                <c:pt idx="1918">
                  <c:v>0.9375</c:v>
                </c:pt>
                <c:pt idx="1919">
                  <c:v>0.9356174698795181</c:v>
                </c:pt>
                <c:pt idx="1920">
                  <c:v>0.90926204819277112</c:v>
                </c:pt>
                <c:pt idx="1921">
                  <c:v>0.90003765060240959</c:v>
                </c:pt>
                <c:pt idx="1922">
                  <c:v>0.90530873493975905</c:v>
                </c:pt>
                <c:pt idx="1923">
                  <c:v>0.91716867469879515</c:v>
                </c:pt>
                <c:pt idx="1924">
                  <c:v>0.97270331325301207</c:v>
                </c:pt>
                <c:pt idx="1925">
                  <c:v>0.97797439759036142</c:v>
                </c:pt>
                <c:pt idx="1926">
                  <c:v>0.97835090361445787</c:v>
                </c:pt>
                <c:pt idx="1927">
                  <c:v>0.98832831325301207</c:v>
                </c:pt>
                <c:pt idx="1928">
                  <c:v>0.9743975903614458</c:v>
                </c:pt>
                <c:pt idx="1929">
                  <c:v>0.97006777108433739</c:v>
                </c:pt>
                <c:pt idx="1930">
                  <c:v>0.93109939759036142</c:v>
                </c:pt>
                <c:pt idx="1931">
                  <c:v>0.93279367469879515</c:v>
                </c:pt>
                <c:pt idx="1932">
                  <c:v>0.91867469879518071</c:v>
                </c:pt>
                <c:pt idx="1933">
                  <c:v>0.9256400602409639</c:v>
                </c:pt>
                <c:pt idx="1934">
                  <c:v>0.90361445783132532</c:v>
                </c:pt>
                <c:pt idx="1935">
                  <c:v>0.92865210843373491</c:v>
                </c:pt>
                <c:pt idx="1936">
                  <c:v>0.92601656626506024</c:v>
                </c:pt>
                <c:pt idx="1937">
                  <c:v>0.9100150602409639</c:v>
                </c:pt>
                <c:pt idx="1938">
                  <c:v>0.92846385542168675</c:v>
                </c:pt>
                <c:pt idx="1939">
                  <c:v>0.9887048192771084</c:v>
                </c:pt>
                <c:pt idx="1940">
                  <c:v>1.0338855421686748</c:v>
                </c:pt>
                <c:pt idx="1941">
                  <c:v>1.036144578313253</c:v>
                </c:pt>
                <c:pt idx="1942">
                  <c:v>1.0116716867469879</c:v>
                </c:pt>
                <c:pt idx="1943">
                  <c:v>0.9743975903614458</c:v>
                </c:pt>
                <c:pt idx="1944">
                  <c:v>0.97797439759036142</c:v>
                </c:pt>
                <c:pt idx="1945">
                  <c:v>0.93900602409638556</c:v>
                </c:pt>
                <c:pt idx="1946">
                  <c:v>0.94277108433734935</c:v>
                </c:pt>
                <c:pt idx="1947">
                  <c:v>0.90493222891566261</c:v>
                </c:pt>
                <c:pt idx="1948">
                  <c:v>0.93298192771084343</c:v>
                </c:pt>
                <c:pt idx="1949">
                  <c:v>0.93053463855421692</c:v>
                </c:pt>
                <c:pt idx="1950">
                  <c:v>0.92055722891566261</c:v>
                </c:pt>
                <c:pt idx="1951">
                  <c:v>0.9418298192771084</c:v>
                </c:pt>
                <c:pt idx="1952">
                  <c:v>0.92074548192771088</c:v>
                </c:pt>
                <c:pt idx="1953">
                  <c:v>0.93618222891566261</c:v>
                </c:pt>
                <c:pt idx="1954">
                  <c:v>0.93354668674698793</c:v>
                </c:pt>
                <c:pt idx="1955">
                  <c:v>0.98230421686746983</c:v>
                </c:pt>
                <c:pt idx="1956">
                  <c:v>1.0176957831325302</c:v>
                </c:pt>
                <c:pt idx="1957">
                  <c:v>0.97966867469879515</c:v>
                </c:pt>
                <c:pt idx="1958">
                  <c:v>0.98644578313253017</c:v>
                </c:pt>
                <c:pt idx="1959">
                  <c:v>1.0210843373493976</c:v>
                </c:pt>
                <c:pt idx="1960">
                  <c:v>0.95368975903614461</c:v>
                </c:pt>
                <c:pt idx="1961">
                  <c:v>0.96987951807228912</c:v>
                </c:pt>
                <c:pt idx="1962">
                  <c:v>0.9550075301204819</c:v>
                </c:pt>
                <c:pt idx="1963">
                  <c:v>0.93787650602409633</c:v>
                </c:pt>
                <c:pt idx="1964">
                  <c:v>0.95368975903614461</c:v>
                </c:pt>
                <c:pt idx="1965">
                  <c:v>0.9331701807228916</c:v>
                </c:pt>
                <c:pt idx="1966">
                  <c:v>0.95858433734939763</c:v>
                </c:pt>
                <c:pt idx="1967">
                  <c:v>0.93618222891566261</c:v>
                </c:pt>
                <c:pt idx="1968">
                  <c:v>0.90963855421686746</c:v>
                </c:pt>
                <c:pt idx="1969">
                  <c:v>0.91020331325301207</c:v>
                </c:pt>
                <c:pt idx="1970">
                  <c:v>0.91848644578313254</c:v>
                </c:pt>
                <c:pt idx="1971">
                  <c:v>0.92074548192771088</c:v>
                </c:pt>
                <c:pt idx="1972">
                  <c:v>0.93957078313253017</c:v>
                </c:pt>
                <c:pt idx="1973">
                  <c:v>0.92827560240963858</c:v>
                </c:pt>
                <c:pt idx="1974">
                  <c:v>0.9418298192771084</c:v>
                </c:pt>
                <c:pt idx="1975">
                  <c:v>0.97571536144578308</c:v>
                </c:pt>
                <c:pt idx="1976">
                  <c:v>1.0301204819277108</c:v>
                </c:pt>
                <c:pt idx="1977">
                  <c:v>1.0103539156626506</c:v>
                </c:pt>
                <c:pt idx="1978">
                  <c:v>0.96573795180722888</c:v>
                </c:pt>
                <c:pt idx="1979">
                  <c:v>0.94352409638554213</c:v>
                </c:pt>
                <c:pt idx="1980">
                  <c:v>0.92959337349397586</c:v>
                </c:pt>
                <c:pt idx="1981">
                  <c:v>0.94804216867469882</c:v>
                </c:pt>
                <c:pt idx="1982">
                  <c:v>0.9337349397590361</c:v>
                </c:pt>
                <c:pt idx="1983">
                  <c:v>0.91698042168674698</c:v>
                </c:pt>
                <c:pt idx="1984">
                  <c:v>0.92959337349397586</c:v>
                </c:pt>
                <c:pt idx="1985">
                  <c:v>0.88930722891566261</c:v>
                </c:pt>
                <c:pt idx="1986">
                  <c:v>0.92413403614457834</c:v>
                </c:pt>
                <c:pt idx="1987">
                  <c:v>0.93015813253012047</c:v>
                </c:pt>
                <c:pt idx="1988">
                  <c:v>0.92149849397590367</c:v>
                </c:pt>
                <c:pt idx="1989">
                  <c:v>1.0146837349397591</c:v>
                </c:pt>
                <c:pt idx="1990">
                  <c:v>0.98908132530120485</c:v>
                </c:pt>
                <c:pt idx="1991">
                  <c:v>1.0073418674698795</c:v>
                </c:pt>
                <c:pt idx="1992">
                  <c:v>1.0158132530120483</c:v>
                </c:pt>
                <c:pt idx="1993">
                  <c:v>1.0165662650602409</c:v>
                </c:pt>
                <c:pt idx="1994">
                  <c:v>0.9787274096385542</c:v>
                </c:pt>
                <c:pt idx="1995">
                  <c:v>0.95143072289156627</c:v>
                </c:pt>
                <c:pt idx="1996">
                  <c:v>0.97044427710843373</c:v>
                </c:pt>
                <c:pt idx="1997">
                  <c:v>0.94785391566265065</c:v>
                </c:pt>
                <c:pt idx="1998">
                  <c:v>0.98926957831325302</c:v>
                </c:pt>
                <c:pt idx="1999">
                  <c:v>0.97552710843373491</c:v>
                </c:pt>
                <c:pt idx="2000">
                  <c:v>0.95011295180722888</c:v>
                </c:pt>
                <c:pt idx="2001">
                  <c:v>0.95576054216867468</c:v>
                </c:pt>
                <c:pt idx="2002">
                  <c:v>0.92639307228915657</c:v>
                </c:pt>
                <c:pt idx="2003">
                  <c:v>0.96347891566265065</c:v>
                </c:pt>
                <c:pt idx="2004">
                  <c:v>0.94201807228915657</c:v>
                </c:pt>
                <c:pt idx="2005">
                  <c:v>0.94710090361445787</c:v>
                </c:pt>
                <c:pt idx="2006">
                  <c:v>0.96404367469879515</c:v>
                </c:pt>
                <c:pt idx="2007">
                  <c:v>1.0178840361445782</c:v>
                </c:pt>
                <c:pt idx="2008">
                  <c:v>1.0363328313253013</c:v>
                </c:pt>
                <c:pt idx="2009">
                  <c:v>1.0508283132530121</c:v>
                </c:pt>
                <c:pt idx="2010">
                  <c:v>0.98606927710843373</c:v>
                </c:pt>
                <c:pt idx="2011">
                  <c:v>0.99510542168674698</c:v>
                </c:pt>
                <c:pt idx="2012">
                  <c:v>0.9356174698795181</c:v>
                </c:pt>
                <c:pt idx="2013">
                  <c:v>0.93768825301204817</c:v>
                </c:pt>
                <c:pt idx="2014">
                  <c:v>0.93411144578313254</c:v>
                </c:pt>
                <c:pt idx="2015">
                  <c:v>0.93467620481927716</c:v>
                </c:pt>
                <c:pt idx="2016">
                  <c:v>0.93053463855421692</c:v>
                </c:pt>
                <c:pt idx="2017">
                  <c:v>0.94823042168674698</c:v>
                </c:pt>
                <c:pt idx="2018">
                  <c:v>0.9331701807228916</c:v>
                </c:pt>
                <c:pt idx="2019">
                  <c:v>0.93637048192771088</c:v>
                </c:pt>
                <c:pt idx="2020">
                  <c:v>0.93109939759036142</c:v>
                </c:pt>
                <c:pt idx="2021">
                  <c:v>1.0180722891566265</c:v>
                </c:pt>
                <c:pt idx="2022">
                  <c:v>1.0269201807228916</c:v>
                </c:pt>
                <c:pt idx="2023">
                  <c:v>1.0681475903614457</c:v>
                </c:pt>
                <c:pt idx="2024">
                  <c:v>1.0474397590361446</c:v>
                </c:pt>
                <c:pt idx="2025">
                  <c:v>1.0124246987951808</c:v>
                </c:pt>
                <c:pt idx="2026">
                  <c:v>0.98042168674698793</c:v>
                </c:pt>
                <c:pt idx="2027">
                  <c:v>0.97100903614457834</c:v>
                </c:pt>
                <c:pt idx="2028">
                  <c:v>0.96724397590361444</c:v>
                </c:pt>
                <c:pt idx="2029">
                  <c:v>0.95839608433734935</c:v>
                </c:pt>
                <c:pt idx="2030">
                  <c:v>0.94691265060240959</c:v>
                </c:pt>
                <c:pt idx="2031">
                  <c:v>0.93768825301204817</c:v>
                </c:pt>
                <c:pt idx="2032">
                  <c:v>0.95030120481927716</c:v>
                </c:pt>
                <c:pt idx="2033">
                  <c:v>0.93712349397590367</c:v>
                </c:pt>
                <c:pt idx="2034">
                  <c:v>0.94597138554216864</c:v>
                </c:pt>
                <c:pt idx="2035">
                  <c:v>0.95011295180722888</c:v>
                </c:pt>
                <c:pt idx="2036">
                  <c:v>0.93674698795180722</c:v>
                </c:pt>
                <c:pt idx="2037">
                  <c:v>0.93448795180722888</c:v>
                </c:pt>
                <c:pt idx="2038">
                  <c:v>0.95368975903614461</c:v>
                </c:pt>
                <c:pt idx="2039">
                  <c:v>0.96216114457831325</c:v>
                </c:pt>
                <c:pt idx="2040">
                  <c:v>0.92262801204819278</c:v>
                </c:pt>
                <c:pt idx="2041">
                  <c:v>0.95293674698795183</c:v>
                </c:pt>
                <c:pt idx="2042">
                  <c:v>1.0378388554216869</c:v>
                </c:pt>
                <c:pt idx="2043">
                  <c:v>1.0611822289156627</c:v>
                </c:pt>
                <c:pt idx="2044">
                  <c:v>1.0736069277108433</c:v>
                </c:pt>
                <c:pt idx="2045">
                  <c:v>1.0288027108433735</c:v>
                </c:pt>
                <c:pt idx="2046">
                  <c:v>1.0020707831325302</c:v>
                </c:pt>
                <c:pt idx="2047">
                  <c:v>0.9881400602409639</c:v>
                </c:pt>
                <c:pt idx="2048">
                  <c:v>0.94446536144578308</c:v>
                </c:pt>
                <c:pt idx="2049">
                  <c:v>0.96423192771084343</c:v>
                </c:pt>
                <c:pt idx="2050">
                  <c:v>0.9644201807228916</c:v>
                </c:pt>
                <c:pt idx="2051">
                  <c:v>0.94465361445783136</c:v>
                </c:pt>
                <c:pt idx="2052">
                  <c:v>0.95933734939759041</c:v>
                </c:pt>
                <c:pt idx="2053">
                  <c:v>0.92469879518072284</c:v>
                </c:pt>
                <c:pt idx="2054">
                  <c:v>0.95331325301204817</c:v>
                </c:pt>
                <c:pt idx="2055">
                  <c:v>0.95011295180722888</c:v>
                </c:pt>
                <c:pt idx="2056">
                  <c:v>0.96234939759036142</c:v>
                </c:pt>
                <c:pt idx="2057">
                  <c:v>0.95896084337349397</c:v>
                </c:pt>
                <c:pt idx="2058">
                  <c:v>1.0244728915662651</c:v>
                </c:pt>
                <c:pt idx="2059">
                  <c:v>1.0252259036144578</c:v>
                </c:pt>
                <c:pt idx="2060">
                  <c:v>1.0350150602409638</c:v>
                </c:pt>
                <c:pt idx="2061">
                  <c:v>1.0141189759036144</c:v>
                </c:pt>
                <c:pt idx="2062">
                  <c:v>1.0446159638554218</c:v>
                </c:pt>
                <c:pt idx="2063">
                  <c:v>1.0233433734939759</c:v>
                </c:pt>
                <c:pt idx="2064">
                  <c:v>0.98983433734939763</c:v>
                </c:pt>
                <c:pt idx="2065">
                  <c:v>0.96272590361445787</c:v>
                </c:pt>
                <c:pt idx="2066">
                  <c:v>0.97364457831325302</c:v>
                </c:pt>
                <c:pt idx="2067">
                  <c:v>0.97458584337349397</c:v>
                </c:pt>
                <c:pt idx="2068">
                  <c:v>0.95519578313253017</c:v>
                </c:pt>
                <c:pt idx="2069">
                  <c:v>0.94051204819277112</c:v>
                </c:pt>
                <c:pt idx="2070">
                  <c:v>0.95538403614457834</c:v>
                </c:pt>
                <c:pt idx="2071">
                  <c:v>0.93768825301204817</c:v>
                </c:pt>
                <c:pt idx="2072">
                  <c:v>0.93486445783132532</c:v>
                </c:pt>
                <c:pt idx="2073">
                  <c:v>0.93392319277108438</c:v>
                </c:pt>
                <c:pt idx="2074">
                  <c:v>0.93862951807228912</c:v>
                </c:pt>
                <c:pt idx="2075">
                  <c:v>0.93222891566265065</c:v>
                </c:pt>
                <c:pt idx="2076">
                  <c:v>0.93392319277108438</c:v>
                </c:pt>
                <c:pt idx="2077">
                  <c:v>0.95350150602409633</c:v>
                </c:pt>
                <c:pt idx="2078">
                  <c:v>0.94634789156626509</c:v>
                </c:pt>
                <c:pt idx="2079">
                  <c:v>0.92940512048192769</c:v>
                </c:pt>
                <c:pt idx="2080">
                  <c:v>0.95594879518072284</c:v>
                </c:pt>
                <c:pt idx="2081">
                  <c:v>1.0274849397590362</c:v>
                </c:pt>
                <c:pt idx="2082">
                  <c:v>1.0220256024096386</c:v>
                </c:pt>
                <c:pt idx="2083">
                  <c:v>1.0336972891566265</c:v>
                </c:pt>
                <c:pt idx="2084">
                  <c:v>1.0082831325301205</c:v>
                </c:pt>
                <c:pt idx="2085">
                  <c:v>1.0045180722891567</c:v>
                </c:pt>
                <c:pt idx="2086">
                  <c:v>1.0207078313253013</c:v>
                </c:pt>
                <c:pt idx="2087">
                  <c:v>0.96667921686746983</c:v>
                </c:pt>
                <c:pt idx="2088">
                  <c:v>0.94220632530120485</c:v>
                </c:pt>
                <c:pt idx="2089">
                  <c:v>0.97157379518072284</c:v>
                </c:pt>
                <c:pt idx="2090">
                  <c:v>0.95538403614457834</c:v>
                </c:pt>
                <c:pt idx="2091">
                  <c:v>0.94973644578313254</c:v>
                </c:pt>
                <c:pt idx="2092">
                  <c:v>0.95594879518072284</c:v>
                </c:pt>
                <c:pt idx="2093">
                  <c:v>0.94070030120481929</c:v>
                </c:pt>
                <c:pt idx="2094">
                  <c:v>0.96046686746987953</c:v>
                </c:pt>
                <c:pt idx="2095">
                  <c:v>0.95161897590361444</c:v>
                </c:pt>
                <c:pt idx="2096">
                  <c:v>0.94766566265060237</c:v>
                </c:pt>
                <c:pt idx="2097">
                  <c:v>0.9725150602409639</c:v>
                </c:pt>
                <c:pt idx="2098">
                  <c:v>1.0291792168674698</c:v>
                </c:pt>
                <c:pt idx="2099">
                  <c:v>1.0333207831325302</c:v>
                </c:pt>
                <c:pt idx="2100">
                  <c:v>1.0626882530120483</c:v>
                </c:pt>
                <c:pt idx="2101">
                  <c:v>1.0244728915662651</c:v>
                </c:pt>
                <c:pt idx="2102">
                  <c:v>0.97402108433734935</c:v>
                </c:pt>
                <c:pt idx="2103">
                  <c:v>0.97025602409638556</c:v>
                </c:pt>
                <c:pt idx="2104">
                  <c:v>0.97345632530120485</c:v>
                </c:pt>
                <c:pt idx="2105">
                  <c:v>0.97552710843373491</c:v>
                </c:pt>
                <c:pt idx="2106">
                  <c:v>0.95726656626506024</c:v>
                </c:pt>
                <c:pt idx="2107">
                  <c:v>0.95331325301204817</c:v>
                </c:pt>
                <c:pt idx="2108">
                  <c:v>0.96103162650602414</c:v>
                </c:pt>
                <c:pt idx="2109">
                  <c:v>0.92206325301204817</c:v>
                </c:pt>
                <c:pt idx="2110">
                  <c:v>0.97891566265060237</c:v>
                </c:pt>
                <c:pt idx="2111">
                  <c:v>0.98324548192771088</c:v>
                </c:pt>
                <c:pt idx="2112">
                  <c:v>0.95406626506024095</c:v>
                </c:pt>
                <c:pt idx="2113">
                  <c:v>1.0030120481927711</c:v>
                </c:pt>
                <c:pt idx="2114">
                  <c:v>0.99303463855421692</c:v>
                </c:pt>
                <c:pt idx="2115">
                  <c:v>1.0231551204819278</c:v>
                </c:pt>
                <c:pt idx="2116">
                  <c:v>1.0474397590361446</c:v>
                </c:pt>
                <c:pt idx="2117">
                  <c:v>1.0082831325301205</c:v>
                </c:pt>
                <c:pt idx="2118">
                  <c:v>0.99905873493975905</c:v>
                </c:pt>
                <c:pt idx="2119">
                  <c:v>1.0163780120481927</c:v>
                </c:pt>
                <c:pt idx="2120">
                  <c:v>1.0054593373493976</c:v>
                </c:pt>
                <c:pt idx="2121">
                  <c:v>0.96931475903614461</c:v>
                </c:pt>
                <c:pt idx="2122">
                  <c:v>0.96291415662650603</c:v>
                </c:pt>
                <c:pt idx="2123">
                  <c:v>0.95463102409638556</c:v>
                </c:pt>
                <c:pt idx="2124">
                  <c:v>0.9393825301204819</c:v>
                </c:pt>
                <c:pt idx="2125">
                  <c:v>0.9644201807228916</c:v>
                </c:pt>
                <c:pt idx="2126">
                  <c:v>0.96799698795180722</c:v>
                </c:pt>
                <c:pt idx="2127">
                  <c:v>0.95764307228915657</c:v>
                </c:pt>
                <c:pt idx="2128">
                  <c:v>0.95481927710843373</c:v>
                </c:pt>
                <c:pt idx="2129">
                  <c:v>0.97477409638554213</c:v>
                </c:pt>
                <c:pt idx="2130">
                  <c:v>0.93806475903614461</c:v>
                </c:pt>
                <c:pt idx="2131">
                  <c:v>1.0056475903614457</c:v>
                </c:pt>
                <c:pt idx="2132">
                  <c:v>1.0564759036144578</c:v>
                </c:pt>
                <c:pt idx="2133">
                  <c:v>1.0679593373493976</c:v>
                </c:pt>
                <c:pt idx="2134">
                  <c:v>1.0581701807228916</c:v>
                </c:pt>
                <c:pt idx="2135">
                  <c:v>1.0086596385542168</c:v>
                </c:pt>
                <c:pt idx="2136">
                  <c:v>0.96611445783132532</c:v>
                </c:pt>
                <c:pt idx="2137">
                  <c:v>0.97345632530120485</c:v>
                </c:pt>
                <c:pt idx="2138">
                  <c:v>0.97703313253012047</c:v>
                </c:pt>
                <c:pt idx="2139">
                  <c:v>0.93712349397590367</c:v>
                </c:pt>
                <c:pt idx="2140">
                  <c:v>0.97345632530120485</c:v>
                </c:pt>
                <c:pt idx="2141">
                  <c:v>0.96065512048192769</c:v>
                </c:pt>
                <c:pt idx="2142">
                  <c:v>0.95707831325301207</c:v>
                </c:pt>
                <c:pt idx="2143">
                  <c:v>0.94841867469879515</c:v>
                </c:pt>
                <c:pt idx="2144">
                  <c:v>0.95952560240963858</c:v>
                </c:pt>
                <c:pt idx="2145">
                  <c:v>0.95896084337349397</c:v>
                </c:pt>
                <c:pt idx="2146">
                  <c:v>0.93881777108433739</c:v>
                </c:pt>
                <c:pt idx="2147">
                  <c:v>0.92789909638554213</c:v>
                </c:pt>
                <c:pt idx="2148">
                  <c:v>0.94597138554216864</c:v>
                </c:pt>
                <c:pt idx="2149">
                  <c:v>0.93542921686746983</c:v>
                </c:pt>
                <c:pt idx="2150">
                  <c:v>0.99209337349397586</c:v>
                </c:pt>
                <c:pt idx="2151">
                  <c:v>1.0220256024096386</c:v>
                </c:pt>
                <c:pt idx="2152">
                  <c:v>1.0698418674698795</c:v>
                </c:pt>
                <c:pt idx="2153">
                  <c:v>1.0540286144578312</c:v>
                </c:pt>
                <c:pt idx="2154">
                  <c:v>0.99077560240963858</c:v>
                </c:pt>
                <c:pt idx="2155">
                  <c:v>0.99717620481927716</c:v>
                </c:pt>
                <c:pt idx="2156">
                  <c:v>0.96253765060240959</c:v>
                </c:pt>
                <c:pt idx="2157">
                  <c:v>0.97082078313253017</c:v>
                </c:pt>
                <c:pt idx="2158">
                  <c:v>0.92978162650602414</c:v>
                </c:pt>
                <c:pt idx="2159">
                  <c:v>0.96366716867469882</c:v>
                </c:pt>
                <c:pt idx="2160">
                  <c:v>0.94860692771084343</c:v>
                </c:pt>
                <c:pt idx="2161">
                  <c:v>0.92488704819277112</c:v>
                </c:pt>
                <c:pt idx="2162">
                  <c:v>0.96197289156626509</c:v>
                </c:pt>
                <c:pt idx="2163">
                  <c:v>0.94691265060240959</c:v>
                </c:pt>
                <c:pt idx="2164">
                  <c:v>0.94521837349397586</c:v>
                </c:pt>
                <c:pt idx="2165">
                  <c:v>0.93900602409638556</c:v>
                </c:pt>
                <c:pt idx="2166">
                  <c:v>0.94728915662650603</c:v>
                </c:pt>
                <c:pt idx="2167">
                  <c:v>0.92319277108433739</c:v>
                </c:pt>
                <c:pt idx="2168">
                  <c:v>0.93166415662650603</c:v>
                </c:pt>
                <c:pt idx="2169">
                  <c:v>0.94521837349397586</c:v>
                </c:pt>
                <c:pt idx="2170">
                  <c:v>0.97270331325301207</c:v>
                </c:pt>
                <c:pt idx="2171">
                  <c:v>0.99661144578313254</c:v>
                </c:pt>
                <c:pt idx="2172">
                  <c:v>1.0444277108433735</c:v>
                </c:pt>
                <c:pt idx="2173">
                  <c:v>1.0171310240963856</c:v>
                </c:pt>
                <c:pt idx="2174">
                  <c:v>1.0143072289156627</c:v>
                </c:pt>
                <c:pt idx="2175">
                  <c:v>1.0327560240963856</c:v>
                </c:pt>
                <c:pt idx="2176">
                  <c:v>0.99717620481927716</c:v>
                </c:pt>
                <c:pt idx="2177">
                  <c:v>0.98795180722891562</c:v>
                </c:pt>
                <c:pt idx="2178">
                  <c:v>0.97402108433734935</c:v>
                </c:pt>
                <c:pt idx="2179">
                  <c:v>0.92978162650602414</c:v>
                </c:pt>
                <c:pt idx="2180">
                  <c:v>0.96347891566265065</c:v>
                </c:pt>
                <c:pt idx="2181">
                  <c:v>0.9493599397590361</c:v>
                </c:pt>
                <c:pt idx="2182">
                  <c:v>0.93109939759036142</c:v>
                </c:pt>
                <c:pt idx="2183">
                  <c:v>0.93768825301204817</c:v>
                </c:pt>
                <c:pt idx="2184">
                  <c:v>0.93392319277108438</c:v>
                </c:pt>
                <c:pt idx="2185">
                  <c:v>0.93674698795180722</c:v>
                </c:pt>
                <c:pt idx="2186">
                  <c:v>0.91886295180722888</c:v>
                </c:pt>
                <c:pt idx="2187">
                  <c:v>0.92488704819277112</c:v>
                </c:pt>
                <c:pt idx="2188">
                  <c:v>0.9175451807228916</c:v>
                </c:pt>
                <c:pt idx="2189">
                  <c:v>0.93862951807228912</c:v>
                </c:pt>
                <c:pt idx="2190">
                  <c:v>0.92789909638554213</c:v>
                </c:pt>
                <c:pt idx="2191">
                  <c:v>0.94898343373493976</c:v>
                </c:pt>
                <c:pt idx="2192">
                  <c:v>0.96140813253012047</c:v>
                </c:pt>
                <c:pt idx="2193">
                  <c:v>1.0169427710843373</c:v>
                </c:pt>
                <c:pt idx="2194">
                  <c:v>0.99472891566265065</c:v>
                </c:pt>
                <c:pt idx="2195">
                  <c:v>1.0340737951807228</c:v>
                </c:pt>
                <c:pt idx="2196">
                  <c:v>0.97722138554216864</c:v>
                </c:pt>
                <c:pt idx="2197">
                  <c:v>0.95463102409638556</c:v>
                </c:pt>
                <c:pt idx="2198">
                  <c:v>0.96253765060240959</c:v>
                </c:pt>
                <c:pt idx="2199">
                  <c:v>0.97458584337349397</c:v>
                </c:pt>
                <c:pt idx="2200">
                  <c:v>0.94521837349397586</c:v>
                </c:pt>
                <c:pt idx="2201">
                  <c:v>0.9474774096385542</c:v>
                </c:pt>
                <c:pt idx="2202">
                  <c:v>0.95011295180722888</c:v>
                </c:pt>
                <c:pt idx="2203">
                  <c:v>0.96291415662650603</c:v>
                </c:pt>
                <c:pt idx="2204">
                  <c:v>0.93467620481927716</c:v>
                </c:pt>
                <c:pt idx="2205">
                  <c:v>1.0003765060240963</c:v>
                </c:pt>
                <c:pt idx="2206">
                  <c:v>1.0222138554216869</c:v>
                </c:pt>
                <c:pt idx="2207">
                  <c:v>1.0463102409638554</c:v>
                </c:pt>
                <c:pt idx="2208">
                  <c:v>1.0393448795180722</c:v>
                </c:pt>
                <c:pt idx="2209">
                  <c:v>1.0256024096385543</c:v>
                </c:pt>
                <c:pt idx="2210">
                  <c:v>0.99228162650602414</c:v>
                </c:pt>
                <c:pt idx="2211">
                  <c:v>0.9806099397590361</c:v>
                </c:pt>
                <c:pt idx="2212">
                  <c:v>0.96837349397590367</c:v>
                </c:pt>
                <c:pt idx="2213">
                  <c:v>0.96291415662650603</c:v>
                </c:pt>
                <c:pt idx="2214">
                  <c:v>0.9574548192771084</c:v>
                </c:pt>
                <c:pt idx="2215">
                  <c:v>0.9706325301204819</c:v>
                </c:pt>
                <c:pt idx="2216">
                  <c:v>0.93975903614457834</c:v>
                </c:pt>
                <c:pt idx="2217">
                  <c:v>0.97119728915662651</c:v>
                </c:pt>
                <c:pt idx="2218">
                  <c:v>0.9668674698795181</c:v>
                </c:pt>
                <c:pt idx="2219">
                  <c:v>0.97910391566265065</c:v>
                </c:pt>
                <c:pt idx="2220">
                  <c:v>0.96592620481927716</c:v>
                </c:pt>
                <c:pt idx="2221">
                  <c:v>0.92451054216867468</c:v>
                </c:pt>
                <c:pt idx="2222">
                  <c:v>0.99585843373493976</c:v>
                </c:pt>
                <c:pt idx="2223">
                  <c:v>1.0175075301204819</c:v>
                </c:pt>
                <c:pt idx="2224">
                  <c:v>1.0342620481927711</c:v>
                </c:pt>
                <c:pt idx="2225">
                  <c:v>0.99604668674698793</c:v>
                </c:pt>
                <c:pt idx="2226">
                  <c:v>0.98757530120481929</c:v>
                </c:pt>
                <c:pt idx="2227">
                  <c:v>0.98926957831325302</c:v>
                </c:pt>
                <c:pt idx="2228">
                  <c:v>0.96385542168674698</c:v>
                </c:pt>
                <c:pt idx="2229">
                  <c:v>0.96762048192771088</c:v>
                </c:pt>
                <c:pt idx="2230">
                  <c:v>0.96291415662650603</c:v>
                </c:pt>
                <c:pt idx="2231">
                  <c:v>0.94465361445783136</c:v>
                </c:pt>
                <c:pt idx="2232">
                  <c:v>0.95161897590361444</c:v>
                </c:pt>
                <c:pt idx="2233">
                  <c:v>0.95481927710843373</c:v>
                </c:pt>
                <c:pt idx="2234">
                  <c:v>0.95425451807228912</c:v>
                </c:pt>
                <c:pt idx="2235">
                  <c:v>0.92940512048192769</c:v>
                </c:pt>
                <c:pt idx="2236">
                  <c:v>0.96667921686746983</c:v>
                </c:pt>
                <c:pt idx="2237">
                  <c:v>0.92827560240963858</c:v>
                </c:pt>
                <c:pt idx="2238">
                  <c:v>0.91076807228915657</c:v>
                </c:pt>
                <c:pt idx="2239">
                  <c:v>0.93618222891566261</c:v>
                </c:pt>
                <c:pt idx="2240">
                  <c:v>0.91698042168674698</c:v>
                </c:pt>
                <c:pt idx="2241">
                  <c:v>0.94352409638554213</c:v>
                </c:pt>
                <c:pt idx="2242">
                  <c:v>0.9644201807228916</c:v>
                </c:pt>
                <c:pt idx="2243">
                  <c:v>1.0120481927710843</c:v>
                </c:pt>
                <c:pt idx="2244">
                  <c:v>1.0404743975903614</c:v>
                </c:pt>
                <c:pt idx="2245">
                  <c:v>1.0444277108433735</c:v>
                </c:pt>
                <c:pt idx="2246">
                  <c:v>0.984375</c:v>
                </c:pt>
                <c:pt idx="2247">
                  <c:v>0.97383283132530118</c:v>
                </c:pt>
                <c:pt idx="2248">
                  <c:v>0.93524096385542166</c:v>
                </c:pt>
                <c:pt idx="2249">
                  <c:v>0.93957078313253017</c:v>
                </c:pt>
                <c:pt idx="2250">
                  <c:v>0.94917168674698793</c:v>
                </c:pt>
                <c:pt idx="2251">
                  <c:v>0.93825301204819278</c:v>
                </c:pt>
                <c:pt idx="2252">
                  <c:v>0.95783132530120485</c:v>
                </c:pt>
                <c:pt idx="2253">
                  <c:v>0.93580572289156627</c:v>
                </c:pt>
                <c:pt idx="2254">
                  <c:v>0.93298192771084343</c:v>
                </c:pt>
                <c:pt idx="2255">
                  <c:v>0.93147590361445787</c:v>
                </c:pt>
                <c:pt idx="2256">
                  <c:v>0.93919427710843373</c:v>
                </c:pt>
                <c:pt idx="2257">
                  <c:v>0.92884036144578308</c:v>
                </c:pt>
                <c:pt idx="2258">
                  <c:v>0.93712349397590367</c:v>
                </c:pt>
                <c:pt idx="2259">
                  <c:v>0.93467620481927716</c:v>
                </c:pt>
                <c:pt idx="2260">
                  <c:v>0.93241716867469882</c:v>
                </c:pt>
                <c:pt idx="2261">
                  <c:v>0.95481927710843373</c:v>
                </c:pt>
                <c:pt idx="2262">
                  <c:v>1.0071536144578312</c:v>
                </c:pt>
                <c:pt idx="2263">
                  <c:v>1.0173192771084338</c:v>
                </c:pt>
                <c:pt idx="2264">
                  <c:v>0.96987951807228912</c:v>
                </c:pt>
                <c:pt idx="2265">
                  <c:v>0.99868222891566261</c:v>
                </c:pt>
                <c:pt idx="2266">
                  <c:v>0.96404367469879515</c:v>
                </c:pt>
                <c:pt idx="2267">
                  <c:v>0.95764307228915657</c:v>
                </c:pt>
                <c:pt idx="2268">
                  <c:v>0.94992469879518071</c:v>
                </c:pt>
                <c:pt idx="2269">
                  <c:v>0.95406626506024095</c:v>
                </c:pt>
                <c:pt idx="2270">
                  <c:v>0.93298192771084343</c:v>
                </c:pt>
                <c:pt idx="2271">
                  <c:v>1.0118599397590362</c:v>
                </c:pt>
                <c:pt idx="2272">
                  <c:v>0.98155120481927716</c:v>
                </c:pt>
                <c:pt idx="2273">
                  <c:v>0.96009036144578308</c:v>
                </c:pt>
                <c:pt idx="2274">
                  <c:v>0.96140813253012047</c:v>
                </c:pt>
                <c:pt idx="2275">
                  <c:v>0.96046686746987953</c:v>
                </c:pt>
                <c:pt idx="2276">
                  <c:v>0.94634789156626509</c:v>
                </c:pt>
                <c:pt idx="2277">
                  <c:v>0.94352409638554213</c:v>
                </c:pt>
                <c:pt idx="2278">
                  <c:v>0.9237575301204819</c:v>
                </c:pt>
                <c:pt idx="2279">
                  <c:v>0.95820783132530118</c:v>
                </c:pt>
                <c:pt idx="2280">
                  <c:v>0.93053463855421692</c:v>
                </c:pt>
                <c:pt idx="2281">
                  <c:v>0.92902861445783136</c:v>
                </c:pt>
                <c:pt idx="2282">
                  <c:v>0.93768825301204817</c:v>
                </c:pt>
                <c:pt idx="2283">
                  <c:v>0.92789909638554213</c:v>
                </c:pt>
                <c:pt idx="2284">
                  <c:v>0.91434487951807231</c:v>
                </c:pt>
                <c:pt idx="2285">
                  <c:v>0.93109939759036142</c:v>
                </c:pt>
                <c:pt idx="2286">
                  <c:v>0.9318524096385542</c:v>
                </c:pt>
                <c:pt idx="2287">
                  <c:v>0.91942771084337349</c:v>
                </c:pt>
                <c:pt idx="2288">
                  <c:v>0.91886295180722888</c:v>
                </c:pt>
                <c:pt idx="2289">
                  <c:v>0.92018072289156627</c:v>
                </c:pt>
                <c:pt idx="2290">
                  <c:v>0.9199924698795181</c:v>
                </c:pt>
                <c:pt idx="2291">
                  <c:v>0.95105421686746983</c:v>
                </c:pt>
                <c:pt idx="2292">
                  <c:v>0.98512801204819278</c:v>
                </c:pt>
                <c:pt idx="2293">
                  <c:v>1.025414156626506</c:v>
                </c:pt>
                <c:pt idx="2294">
                  <c:v>0.99303463855421692</c:v>
                </c:pt>
                <c:pt idx="2295">
                  <c:v>0.96027861445783136</c:v>
                </c:pt>
                <c:pt idx="2296">
                  <c:v>0.93015813253012047</c:v>
                </c:pt>
                <c:pt idx="2297">
                  <c:v>0.9568900602409639</c:v>
                </c:pt>
                <c:pt idx="2298">
                  <c:v>0.921875</c:v>
                </c:pt>
                <c:pt idx="2299">
                  <c:v>0.93787650602409633</c:v>
                </c:pt>
                <c:pt idx="2300">
                  <c:v>0.9081325301204819</c:v>
                </c:pt>
                <c:pt idx="2301">
                  <c:v>0.9393825301204819</c:v>
                </c:pt>
                <c:pt idx="2302">
                  <c:v>0.93109939759036142</c:v>
                </c:pt>
                <c:pt idx="2303">
                  <c:v>0.92093373493975905</c:v>
                </c:pt>
                <c:pt idx="2304">
                  <c:v>0.95576054216867468</c:v>
                </c:pt>
                <c:pt idx="2305">
                  <c:v>0.90982680722891562</c:v>
                </c:pt>
                <c:pt idx="2306">
                  <c:v>0.90907379518072284</c:v>
                </c:pt>
                <c:pt idx="2307">
                  <c:v>0.90926204819277112</c:v>
                </c:pt>
                <c:pt idx="2308">
                  <c:v>0.91415662650602414</c:v>
                </c:pt>
                <c:pt idx="2309">
                  <c:v>0.91603915662650603</c:v>
                </c:pt>
                <c:pt idx="2310">
                  <c:v>0.93128765060240959</c:v>
                </c:pt>
                <c:pt idx="2311">
                  <c:v>0.96705572289156627</c:v>
                </c:pt>
                <c:pt idx="2312">
                  <c:v>0.9887048192771084</c:v>
                </c:pt>
                <c:pt idx="2313">
                  <c:v>1.0331325301204819</c:v>
                </c:pt>
                <c:pt idx="2314">
                  <c:v>1.0137424698795181</c:v>
                </c:pt>
                <c:pt idx="2315">
                  <c:v>0.9981174698795181</c:v>
                </c:pt>
                <c:pt idx="2316">
                  <c:v>0.98042168674698793</c:v>
                </c:pt>
                <c:pt idx="2317">
                  <c:v>0.95048945783132532</c:v>
                </c:pt>
                <c:pt idx="2318">
                  <c:v>0.94503012048192769</c:v>
                </c:pt>
                <c:pt idx="2319">
                  <c:v>0.91547439759036142</c:v>
                </c:pt>
                <c:pt idx="2320">
                  <c:v>0.92356927710843373</c:v>
                </c:pt>
                <c:pt idx="2321">
                  <c:v>0.92789909638554213</c:v>
                </c:pt>
                <c:pt idx="2322">
                  <c:v>0.95801957831325302</c:v>
                </c:pt>
                <c:pt idx="2323">
                  <c:v>0.92902861445783136</c:v>
                </c:pt>
                <c:pt idx="2324">
                  <c:v>0.92262801204819278</c:v>
                </c:pt>
                <c:pt idx="2325">
                  <c:v>0.93429969879518071</c:v>
                </c:pt>
                <c:pt idx="2326">
                  <c:v>0.9256400602409639</c:v>
                </c:pt>
                <c:pt idx="2327">
                  <c:v>0.92300451807228912</c:v>
                </c:pt>
                <c:pt idx="2328">
                  <c:v>0.89909638554216864</c:v>
                </c:pt>
                <c:pt idx="2329">
                  <c:v>0.93806475903614461</c:v>
                </c:pt>
                <c:pt idx="2330">
                  <c:v>0.92036897590361444</c:v>
                </c:pt>
                <c:pt idx="2331">
                  <c:v>0.99303463855421692</c:v>
                </c:pt>
                <c:pt idx="2332">
                  <c:v>1.0131777108433735</c:v>
                </c:pt>
                <c:pt idx="2333">
                  <c:v>1.0152484939759037</c:v>
                </c:pt>
                <c:pt idx="2334">
                  <c:v>1.0210843373493976</c:v>
                </c:pt>
                <c:pt idx="2335">
                  <c:v>0.98776355421686746</c:v>
                </c:pt>
                <c:pt idx="2336">
                  <c:v>0.94277108433734935</c:v>
                </c:pt>
                <c:pt idx="2337">
                  <c:v>0.94201807228915657</c:v>
                </c:pt>
                <c:pt idx="2338">
                  <c:v>0.92996987951807231</c:v>
                </c:pt>
                <c:pt idx="2339">
                  <c:v>0.92733433734939763</c:v>
                </c:pt>
                <c:pt idx="2340">
                  <c:v>0.95444277108433739</c:v>
                </c:pt>
                <c:pt idx="2341">
                  <c:v>0.93505271084337349</c:v>
                </c:pt>
                <c:pt idx="2342">
                  <c:v>0.93862951807228912</c:v>
                </c:pt>
                <c:pt idx="2343">
                  <c:v>0.92545180722891562</c:v>
                </c:pt>
                <c:pt idx="2344">
                  <c:v>0.94145331325301207</c:v>
                </c:pt>
                <c:pt idx="2345">
                  <c:v>0.96404367469879515</c:v>
                </c:pt>
                <c:pt idx="2346">
                  <c:v>0.97044427710843373</c:v>
                </c:pt>
                <c:pt idx="2347">
                  <c:v>1.0208960843373494</c:v>
                </c:pt>
                <c:pt idx="2348">
                  <c:v>0.96762048192771088</c:v>
                </c:pt>
                <c:pt idx="2349">
                  <c:v>0.97270331325301207</c:v>
                </c:pt>
                <c:pt idx="2350">
                  <c:v>0.98493975903614461</c:v>
                </c:pt>
                <c:pt idx="2351">
                  <c:v>0.96724397590361444</c:v>
                </c:pt>
                <c:pt idx="2352">
                  <c:v>0.97138554216867468</c:v>
                </c:pt>
                <c:pt idx="2353">
                  <c:v>0.95030120481927716</c:v>
                </c:pt>
                <c:pt idx="2354">
                  <c:v>0.97515060240963858</c:v>
                </c:pt>
                <c:pt idx="2355">
                  <c:v>0.92582831325301207</c:v>
                </c:pt>
                <c:pt idx="2356">
                  <c:v>0.93768825301204817</c:v>
                </c:pt>
                <c:pt idx="2357">
                  <c:v>0.92808734939759041</c:v>
                </c:pt>
                <c:pt idx="2358">
                  <c:v>0.94088855421686746</c:v>
                </c:pt>
                <c:pt idx="2359">
                  <c:v>0.94634789156626509</c:v>
                </c:pt>
                <c:pt idx="2360">
                  <c:v>0.94013554216867468</c:v>
                </c:pt>
                <c:pt idx="2361">
                  <c:v>0.93580572289156627</c:v>
                </c:pt>
                <c:pt idx="2362">
                  <c:v>0.93693524096385539</c:v>
                </c:pt>
                <c:pt idx="2363">
                  <c:v>0.9487951807228916</c:v>
                </c:pt>
                <c:pt idx="2364">
                  <c:v>1.020519578313253</c:v>
                </c:pt>
                <c:pt idx="2365">
                  <c:v>0.99774096385542166</c:v>
                </c:pt>
                <c:pt idx="2366">
                  <c:v>0.95914909638554213</c:v>
                </c:pt>
                <c:pt idx="2367">
                  <c:v>0.96234939759036142</c:v>
                </c:pt>
                <c:pt idx="2368">
                  <c:v>0.96969126506024095</c:v>
                </c:pt>
                <c:pt idx="2369">
                  <c:v>0.9375</c:v>
                </c:pt>
                <c:pt idx="2370">
                  <c:v>0.95331325301204817</c:v>
                </c:pt>
                <c:pt idx="2371">
                  <c:v>0.96046686746987953</c:v>
                </c:pt>
                <c:pt idx="2372">
                  <c:v>0.98795180722891562</c:v>
                </c:pt>
                <c:pt idx="2373">
                  <c:v>0.9806099397590361</c:v>
                </c:pt>
                <c:pt idx="2374">
                  <c:v>0.94070030120481929</c:v>
                </c:pt>
                <c:pt idx="2375">
                  <c:v>0.97383283132530118</c:v>
                </c:pt>
                <c:pt idx="2376">
                  <c:v>0.96969126506024095</c:v>
                </c:pt>
                <c:pt idx="2377">
                  <c:v>1.0032003012048192</c:v>
                </c:pt>
                <c:pt idx="2378">
                  <c:v>1.0489457831325302</c:v>
                </c:pt>
                <c:pt idx="2379">
                  <c:v>1.0208960843373494</c:v>
                </c:pt>
                <c:pt idx="2380">
                  <c:v>0.99303463855421692</c:v>
                </c:pt>
                <c:pt idx="2381">
                  <c:v>1.0043298192771084</c:v>
                </c:pt>
                <c:pt idx="2382">
                  <c:v>0.97966867469879515</c:v>
                </c:pt>
                <c:pt idx="2383">
                  <c:v>0.96554969879518071</c:v>
                </c:pt>
                <c:pt idx="2384">
                  <c:v>0.96009036144578308</c:v>
                </c:pt>
                <c:pt idx="2385">
                  <c:v>0.96950301204819278</c:v>
                </c:pt>
                <c:pt idx="2386">
                  <c:v>0.9730798192771084</c:v>
                </c:pt>
                <c:pt idx="2387">
                  <c:v>0.96046686746987953</c:v>
                </c:pt>
                <c:pt idx="2388">
                  <c:v>0.96479668674698793</c:v>
                </c:pt>
                <c:pt idx="2389">
                  <c:v>0.95425451807228912</c:v>
                </c:pt>
                <c:pt idx="2390">
                  <c:v>0.94841867469879515</c:v>
                </c:pt>
                <c:pt idx="2391">
                  <c:v>0.9337349397590361</c:v>
                </c:pt>
                <c:pt idx="2392">
                  <c:v>0.93919427710843373</c:v>
                </c:pt>
                <c:pt idx="2393">
                  <c:v>0.93166415662650603</c:v>
                </c:pt>
                <c:pt idx="2394">
                  <c:v>0.95952560240963858</c:v>
                </c:pt>
                <c:pt idx="2395">
                  <c:v>1.0220256024096386</c:v>
                </c:pt>
                <c:pt idx="2396">
                  <c:v>1.0600527108433735</c:v>
                </c:pt>
                <c:pt idx="2397">
                  <c:v>1.0459337349397591</c:v>
                </c:pt>
                <c:pt idx="2398">
                  <c:v>1.0743599397590362</c:v>
                </c:pt>
                <c:pt idx="2399">
                  <c:v>1.1172816265060241</c:v>
                </c:pt>
                <c:pt idx="2400">
                  <c:v>1.1547439759036144</c:v>
                </c:pt>
                <c:pt idx="2401">
                  <c:v>1.2125376506024097</c:v>
                </c:pt>
                <c:pt idx="2402">
                  <c:v>1.2567771084337349</c:v>
                </c:pt>
                <c:pt idx="2403">
                  <c:v>1.2914156626506024</c:v>
                </c:pt>
                <c:pt idx="2404">
                  <c:v>1.3106174698795181</c:v>
                </c:pt>
                <c:pt idx="2405">
                  <c:v>1.3283132530120483</c:v>
                </c:pt>
                <c:pt idx="2406">
                  <c:v>1.3992846385542168</c:v>
                </c:pt>
                <c:pt idx="2407">
                  <c:v>1.4262048192771084</c:v>
                </c:pt>
                <c:pt idx="2408">
                  <c:v>1.4591490963855422</c:v>
                </c:pt>
                <c:pt idx="2409">
                  <c:v>1.4698795180722892</c:v>
                </c:pt>
                <c:pt idx="2410">
                  <c:v>1.5491340361445782</c:v>
                </c:pt>
                <c:pt idx="2411">
                  <c:v>1.537085843373494</c:v>
                </c:pt>
                <c:pt idx="2412">
                  <c:v>1.5572289156626506</c:v>
                </c:pt>
                <c:pt idx="2413">
                  <c:v>1.6274472891566265</c:v>
                </c:pt>
                <c:pt idx="2414">
                  <c:v>1.6317771084337349</c:v>
                </c:pt>
                <c:pt idx="2415">
                  <c:v>1.6792168674698795</c:v>
                </c:pt>
                <c:pt idx="2416">
                  <c:v>1.713855421686747</c:v>
                </c:pt>
                <c:pt idx="2417">
                  <c:v>1.7518825301204819</c:v>
                </c:pt>
                <c:pt idx="2418">
                  <c:v>1.7564006024096386</c:v>
                </c:pt>
                <c:pt idx="2419">
                  <c:v>1.8166415662650603</c:v>
                </c:pt>
                <c:pt idx="2420">
                  <c:v>1.8345256024096386</c:v>
                </c:pt>
                <c:pt idx="2421">
                  <c:v>1.8646460843373494</c:v>
                </c:pt>
                <c:pt idx="2422">
                  <c:v>1.8516566265060241</c:v>
                </c:pt>
                <c:pt idx="2423">
                  <c:v>1.9038027108433735</c:v>
                </c:pt>
                <c:pt idx="2424">
                  <c:v>1.9194277108433735</c:v>
                </c:pt>
                <c:pt idx="2425">
                  <c:v>1.9480421686746987</c:v>
                </c:pt>
                <c:pt idx="2426">
                  <c:v>1.9171686746987953</c:v>
                </c:pt>
                <c:pt idx="2427">
                  <c:v>1.948230421686747</c:v>
                </c:pt>
                <c:pt idx="2428">
                  <c:v>1.9280873493975903</c:v>
                </c:pt>
                <c:pt idx="2429">
                  <c:v>1.9977409638554218</c:v>
                </c:pt>
                <c:pt idx="2430">
                  <c:v>1.9593373493975903</c:v>
                </c:pt>
                <c:pt idx="2431">
                  <c:v>1.9894578313253013</c:v>
                </c:pt>
                <c:pt idx="2432">
                  <c:v>2.0039533132530121</c:v>
                </c:pt>
                <c:pt idx="2433">
                  <c:v>2.0175075301204819</c:v>
                </c:pt>
                <c:pt idx="2434">
                  <c:v>2.005835843373494</c:v>
                </c:pt>
                <c:pt idx="2435">
                  <c:v>1.962914156626506</c:v>
                </c:pt>
                <c:pt idx="2436">
                  <c:v>1.9674322289156627</c:v>
                </c:pt>
                <c:pt idx="2437">
                  <c:v>2.0128012048192772</c:v>
                </c:pt>
                <c:pt idx="2438">
                  <c:v>1.9875753012048192</c:v>
                </c:pt>
                <c:pt idx="2439">
                  <c:v>2.0088478915662651</c:v>
                </c:pt>
                <c:pt idx="2440">
                  <c:v>2.0271084337349397</c:v>
                </c:pt>
                <c:pt idx="2441">
                  <c:v>2.0009412650602409</c:v>
                </c:pt>
                <c:pt idx="2442">
                  <c:v>2.0126129518072289</c:v>
                </c:pt>
                <c:pt idx="2443">
                  <c:v>1.984375</c:v>
                </c:pt>
                <c:pt idx="2444">
                  <c:v>1.9851280120481927</c:v>
                </c:pt>
                <c:pt idx="2445">
                  <c:v>1.9711972891566265</c:v>
                </c:pt>
                <c:pt idx="2446">
                  <c:v>1.9463478915662651</c:v>
                </c:pt>
                <c:pt idx="2447">
                  <c:v>1.9561370481927711</c:v>
                </c:pt>
                <c:pt idx="2448">
                  <c:v>1.9762801204819278</c:v>
                </c:pt>
                <c:pt idx="2449">
                  <c:v>1.9646084337349397</c:v>
                </c:pt>
                <c:pt idx="2450">
                  <c:v>1.9491716867469879</c:v>
                </c:pt>
                <c:pt idx="2451">
                  <c:v>1.9463478915662651</c:v>
                </c:pt>
                <c:pt idx="2452">
                  <c:v>1.9397590361445782</c:v>
                </c:pt>
                <c:pt idx="2453">
                  <c:v>1.9386295180722892</c:v>
                </c:pt>
                <c:pt idx="2454">
                  <c:v>1.9262048192771084</c:v>
                </c:pt>
                <c:pt idx="2455">
                  <c:v>1.9256400602409638</c:v>
                </c:pt>
                <c:pt idx="2456">
                  <c:v>1.9344879518072289</c:v>
                </c:pt>
                <c:pt idx="2457">
                  <c:v>1.9207454819277108</c:v>
                </c:pt>
                <c:pt idx="2458">
                  <c:v>1.9214984939759037</c:v>
                </c:pt>
                <c:pt idx="2459">
                  <c:v>1.9497364457831325</c:v>
                </c:pt>
                <c:pt idx="2460">
                  <c:v>1.9382530120481927</c:v>
                </c:pt>
                <c:pt idx="2461">
                  <c:v>1.9401355421686748</c:v>
                </c:pt>
                <c:pt idx="2462">
                  <c:v>1.9011671686746987</c:v>
                </c:pt>
                <c:pt idx="2463">
                  <c:v>1.8911897590361446</c:v>
                </c:pt>
                <c:pt idx="2464">
                  <c:v>1.8889307228915662</c:v>
                </c:pt>
                <c:pt idx="2465">
                  <c:v>1.8842243975903614</c:v>
                </c:pt>
                <c:pt idx="2466">
                  <c:v>1.9045557228915662</c:v>
                </c:pt>
                <c:pt idx="2467">
                  <c:v>1.8846009036144578</c:v>
                </c:pt>
                <c:pt idx="2468">
                  <c:v>1.8902484939759037</c:v>
                </c:pt>
                <c:pt idx="2469">
                  <c:v>1.8655873493975903</c:v>
                </c:pt>
                <c:pt idx="2470">
                  <c:v>1.8646460843373494</c:v>
                </c:pt>
                <c:pt idx="2471">
                  <c:v>1.8571159638554218</c:v>
                </c:pt>
                <c:pt idx="2472">
                  <c:v>1.8518448795180722</c:v>
                </c:pt>
                <c:pt idx="2473">
                  <c:v>1.8409262048192772</c:v>
                </c:pt>
                <c:pt idx="2474">
                  <c:v>1.8332078313253013</c:v>
                </c:pt>
                <c:pt idx="2475">
                  <c:v>1.8431852409638554</c:v>
                </c:pt>
                <c:pt idx="2476">
                  <c:v>1.8578689759036144</c:v>
                </c:pt>
                <c:pt idx="2477">
                  <c:v>1.8490210843373494</c:v>
                </c:pt>
                <c:pt idx="2478">
                  <c:v>1.8445030120481927</c:v>
                </c:pt>
                <c:pt idx="2479">
                  <c:v>1.8405496987951808</c:v>
                </c:pt>
                <c:pt idx="2480">
                  <c:v>1.8616340361445782</c:v>
                </c:pt>
                <c:pt idx="2481">
                  <c:v>1.8429969879518073</c:v>
                </c:pt>
                <c:pt idx="2482">
                  <c:v>1.8477033132530121</c:v>
                </c:pt>
                <c:pt idx="2483">
                  <c:v>1.8426204819277108</c:v>
                </c:pt>
                <c:pt idx="2484">
                  <c:v>1.8627635542168675</c:v>
                </c:pt>
                <c:pt idx="2485">
                  <c:v>1.8333960843373494</c:v>
                </c:pt>
                <c:pt idx="2486">
                  <c:v>1.8307605421686748</c:v>
                </c:pt>
                <c:pt idx="2487">
                  <c:v>1.8499623493975903</c:v>
                </c:pt>
                <c:pt idx="2488">
                  <c:v>1.8454442771084338</c:v>
                </c:pt>
                <c:pt idx="2489">
                  <c:v>1.8418674698795181</c:v>
                </c:pt>
                <c:pt idx="2490">
                  <c:v>1.8177710843373494</c:v>
                </c:pt>
                <c:pt idx="2491">
                  <c:v>1.8492093373493976</c:v>
                </c:pt>
                <c:pt idx="2492">
                  <c:v>1.8527861445783131</c:v>
                </c:pt>
                <c:pt idx="2493">
                  <c:v>1.8492093373493976</c:v>
                </c:pt>
                <c:pt idx="2494">
                  <c:v>1.8452560240963856</c:v>
                </c:pt>
                <c:pt idx="2495">
                  <c:v>1.8429969879518073</c:v>
                </c:pt>
                <c:pt idx="2496">
                  <c:v>1.8576807228915662</c:v>
                </c:pt>
                <c:pt idx="2497">
                  <c:v>1.8510918674698795</c:v>
                </c:pt>
                <c:pt idx="2498">
                  <c:v>1.8382906626506024</c:v>
                </c:pt>
                <c:pt idx="2499">
                  <c:v>1.8424322289156627</c:v>
                </c:pt>
                <c:pt idx="2500">
                  <c:v>1.8446912650602409</c:v>
                </c:pt>
                <c:pt idx="2501">
                  <c:v>1.8202183734939759</c:v>
                </c:pt>
                <c:pt idx="2502">
                  <c:v>1.8493975903614457</c:v>
                </c:pt>
                <c:pt idx="2503">
                  <c:v>1.8375376506024097</c:v>
                </c:pt>
                <c:pt idx="2504">
                  <c:v>1.8157003012048192</c:v>
                </c:pt>
                <c:pt idx="2505">
                  <c:v>1.8115587349397591</c:v>
                </c:pt>
                <c:pt idx="2506">
                  <c:v>1.7993222891566265</c:v>
                </c:pt>
                <c:pt idx="2507">
                  <c:v>1.8179593373493976</c:v>
                </c:pt>
                <c:pt idx="2508">
                  <c:v>1.8194653614457832</c:v>
                </c:pt>
                <c:pt idx="2509">
                  <c:v>1.817394578313253</c:v>
                </c:pt>
                <c:pt idx="2510">
                  <c:v>1.8098644578313252</c:v>
                </c:pt>
                <c:pt idx="2511">
                  <c:v>1.8015813253012047</c:v>
                </c:pt>
                <c:pt idx="2512">
                  <c:v>1.7961219879518073</c:v>
                </c:pt>
                <c:pt idx="2513">
                  <c:v>1.7868975903614457</c:v>
                </c:pt>
                <c:pt idx="2514">
                  <c:v>1.7848268072289157</c:v>
                </c:pt>
                <c:pt idx="2515">
                  <c:v>1.7978162650602409</c:v>
                </c:pt>
                <c:pt idx="2516">
                  <c:v>1.8145707831325302</c:v>
                </c:pt>
                <c:pt idx="2517">
                  <c:v>1.8283132530120483</c:v>
                </c:pt>
                <c:pt idx="2518">
                  <c:v>1.791980421686747</c:v>
                </c:pt>
                <c:pt idx="2519">
                  <c:v>1.8049698795180722</c:v>
                </c:pt>
                <c:pt idx="2520">
                  <c:v>1.791039156626506</c:v>
                </c:pt>
                <c:pt idx="2521">
                  <c:v>1.7806852409638554</c:v>
                </c:pt>
                <c:pt idx="2522">
                  <c:v>1.8143825301204819</c:v>
                </c:pt>
                <c:pt idx="2523">
                  <c:v>1.776355421686747</c:v>
                </c:pt>
                <c:pt idx="2524">
                  <c:v>1.7838855421686748</c:v>
                </c:pt>
                <c:pt idx="2525">
                  <c:v>1.7712725903614457</c:v>
                </c:pt>
                <c:pt idx="2526">
                  <c:v>1.7676957831325302</c:v>
                </c:pt>
                <c:pt idx="2527">
                  <c:v>1.7475527108433735</c:v>
                </c:pt>
                <c:pt idx="2528">
                  <c:v>1.7569653614457832</c:v>
                </c:pt>
                <c:pt idx="2529">
                  <c:v>1.7498117469879517</c:v>
                </c:pt>
                <c:pt idx="2530">
                  <c:v>1.7665662650602409</c:v>
                </c:pt>
                <c:pt idx="2531">
                  <c:v>1.7959337349397591</c:v>
                </c:pt>
                <c:pt idx="2532">
                  <c:v>1.7629894578313252</c:v>
                </c:pt>
                <c:pt idx="2533">
                  <c:v>1.7652484939759037</c:v>
                </c:pt>
                <c:pt idx="2534">
                  <c:v>1.7784262048192772</c:v>
                </c:pt>
                <c:pt idx="2535">
                  <c:v>1.7522590361445782</c:v>
                </c:pt>
                <c:pt idx="2536">
                  <c:v>1.7644954819277108</c:v>
                </c:pt>
                <c:pt idx="2537">
                  <c:v>1.7415286144578312</c:v>
                </c:pt>
                <c:pt idx="2538">
                  <c:v>1.75</c:v>
                </c:pt>
                <c:pt idx="2539">
                  <c:v>1.7712725903614457</c:v>
                </c:pt>
                <c:pt idx="2540">
                  <c:v>1.7481174698795181</c:v>
                </c:pt>
                <c:pt idx="2541">
                  <c:v>1.7577183734939759</c:v>
                </c:pt>
                <c:pt idx="2542">
                  <c:v>1.7780496987951808</c:v>
                </c:pt>
                <c:pt idx="2543">
                  <c:v>1.7545180722891567</c:v>
                </c:pt>
                <c:pt idx="2544">
                  <c:v>1.7582831325301205</c:v>
                </c:pt>
                <c:pt idx="2545">
                  <c:v>1.7541415662650603</c:v>
                </c:pt>
                <c:pt idx="2546">
                  <c:v>1.7520707831325302</c:v>
                </c:pt>
                <c:pt idx="2547">
                  <c:v>1.7688253012048192</c:v>
                </c:pt>
                <c:pt idx="2548">
                  <c:v>1.7556475903614457</c:v>
                </c:pt>
                <c:pt idx="2549">
                  <c:v>1.7275978915662651</c:v>
                </c:pt>
                <c:pt idx="2550">
                  <c:v>1.7526355421686748</c:v>
                </c:pt>
                <c:pt idx="2551">
                  <c:v>1.7524472891566265</c:v>
                </c:pt>
                <c:pt idx="2552">
                  <c:v>1.7443524096385543</c:v>
                </c:pt>
                <c:pt idx="2553">
                  <c:v>1.7791792168674698</c:v>
                </c:pt>
                <c:pt idx="2554">
                  <c:v>1.7648719879518073</c:v>
                </c:pt>
                <c:pt idx="2555">
                  <c:v>1.7765436746987953</c:v>
                </c:pt>
                <c:pt idx="2556">
                  <c:v>1.7654367469879517</c:v>
                </c:pt>
                <c:pt idx="2557">
                  <c:v>1.7609186746987953</c:v>
                </c:pt>
                <c:pt idx="2558">
                  <c:v>1.7710843373493976</c:v>
                </c:pt>
                <c:pt idx="2559">
                  <c:v>1.7447289156626506</c:v>
                </c:pt>
                <c:pt idx="2560">
                  <c:v>1.7524472891566265</c:v>
                </c:pt>
                <c:pt idx="2561">
                  <c:v>1.7522590361445782</c:v>
                </c:pt>
                <c:pt idx="2562">
                  <c:v>1.7515060240963856</c:v>
                </c:pt>
                <c:pt idx="2563">
                  <c:v>1.7554593373493976</c:v>
                </c:pt>
                <c:pt idx="2564">
                  <c:v>1.7716490963855422</c:v>
                </c:pt>
                <c:pt idx="2565">
                  <c:v>1.7626129518072289</c:v>
                </c:pt>
                <c:pt idx="2566">
                  <c:v>1.7880271084337349</c:v>
                </c:pt>
                <c:pt idx="2567">
                  <c:v>1.7505647590361446</c:v>
                </c:pt>
                <c:pt idx="2568">
                  <c:v>1.7330572289156627</c:v>
                </c:pt>
                <c:pt idx="2569">
                  <c:v>1.7424698795180722</c:v>
                </c:pt>
                <c:pt idx="2570">
                  <c:v>1.7279743975903614</c:v>
                </c:pt>
                <c:pt idx="2571">
                  <c:v>1.7287274096385543</c:v>
                </c:pt>
                <c:pt idx="2572">
                  <c:v>1.7533885542168675</c:v>
                </c:pt>
                <c:pt idx="2573">
                  <c:v>1.7584713855421688</c:v>
                </c:pt>
                <c:pt idx="2574">
                  <c:v>1.7259036144578312</c:v>
                </c:pt>
                <c:pt idx="2575">
                  <c:v>1.7311746987951808</c:v>
                </c:pt>
                <c:pt idx="2576">
                  <c:v>1.7266566265060241</c:v>
                </c:pt>
                <c:pt idx="2577">
                  <c:v>1.7616716867469879</c:v>
                </c:pt>
                <c:pt idx="2578">
                  <c:v>1.7311746987951808</c:v>
                </c:pt>
                <c:pt idx="2579">
                  <c:v>1.7292921686746987</c:v>
                </c:pt>
                <c:pt idx="2580">
                  <c:v>1.7313629518072289</c:v>
                </c:pt>
                <c:pt idx="2581">
                  <c:v>1.7492469879518073</c:v>
                </c:pt>
                <c:pt idx="2582">
                  <c:v>1.7309864457831325</c:v>
                </c:pt>
                <c:pt idx="2583">
                  <c:v>1.6991716867469879</c:v>
                </c:pt>
                <c:pt idx="2584">
                  <c:v>1.708960843373494</c:v>
                </c:pt>
                <c:pt idx="2585">
                  <c:v>1.7106551204819278</c:v>
                </c:pt>
                <c:pt idx="2586">
                  <c:v>1.7259036144578312</c:v>
                </c:pt>
                <c:pt idx="2587">
                  <c:v>1.6991716867469879</c:v>
                </c:pt>
                <c:pt idx="2588">
                  <c:v>1.7403990963855422</c:v>
                </c:pt>
                <c:pt idx="2589">
                  <c:v>1.698230421686747</c:v>
                </c:pt>
                <c:pt idx="2590">
                  <c:v>1.7477409638554218</c:v>
                </c:pt>
                <c:pt idx="2591">
                  <c:v>1.7330572289156627</c:v>
                </c:pt>
                <c:pt idx="2592">
                  <c:v>1.7196912650602409</c:v>
                </c:pt>
                <c:pt idx="2593">
                  <c:v>1.7215737951807228</c:v>
                </c:pt>
                <c:pt idx="2594">
                  <c:v>1.7464231927710843</c:v>
                </c:pt>
                <c:pt idx="2595">
                  <c:v>1.7417168674698795</c:v>
                </c:pt>
                <c:pt idx="2596">
                  <c:v>1.6942771084337349</c:v>
                </c:pt>
                <c:pt idx="2597">
                  <c:v>1.7112198795180722</c:v>
                </c:pt>
                <c:pt idx="2598">
                  <c:v>1.6959713855421688</c:v>
                </c:pt>
                <c:pt idx="2599">
                  <c:v>1.7134789156626506</c:v>
                </c:pt>
                <c:pt idx="2600">
                  <c:v>1.7260918674698795</c:v>
                </c:pt>
                <c:pt idx="2601">
                  <c:v>1.7053840361445782</c:v>
                </c:pt>
                <c:pt idx="2602">
                  <c:v>1.7228915662650603</c:v>
                </c:pt>
                <c:pt idx="2603">
                  <c:v>1.7085843373493976</c:v>
                </c:pt>
                <c:pt idx="2604">
                  <c:v>1.7119728915662651</c:v>
                </c:pt>
                <c:pt idx="2605">
                  <c:v>1.7309864457831325</c:v>
                </c:pt>
                <c:pt idx="2606">
                  <c:v>1.7019954819277108</c:v>
                </c:pt>
                <c:pt idx="2607">
                  <c:v>1.7104668674698795</c:v>
                </c:pt>
                <c:pt idx="2608">
                  <c:v>1.713855421686747</c:v>
                </c:pt>
                <c:pt idx="2609">
                  <c:v>1.7296686746987953</c:v>
                </c:pt>
                <c:pt idx="2610">
                  <c:v>1.7260918674698795</c:v>
                </c:pt>
                <c:pt idx="2611">
                  <c:v>1.7106551204819278</c:v>
                </c:pt>
                <c:pt idx="2612">
                  <c:v>1.7185617469879517</c:v>
                </c:pt>
                <c:pt idx="2613">
                  <c:v>1.6890060240963856</c:v>
                </c:pt>
                <c:pt idx="2614">
                  <c:v>1.7176204819277108</c:v>
                </c:pt>
                <c:pt idx="2615">
                  <c:v>1.7198795180722892</c:v>
                </c:pt>
                <c:pt idx="2616">
                  <c:v>1.6824171686746987</c:v>
                </c:pt>
                <c:pt idx="2617">
                  <c:v>1.7193147590361446</c:v>
                </c:pt>
                <c:pt idx="2618">
                  <c:v>1.7131024096385543</c:v>
                </c:pt>
                <c:pt idx="2619">
                  <c:v>1.6852409638554218</c:v>
                </c:pt>
                <c:pt idx="2620">
                  <c:v>1.7008659638554218</c:v>
                </c:pt>
                <c:pt idx="2621">
                  <c:v>1.6842996987951808</c:v>
                </c:pt>
                <c:pt idx="2622">
                  <c:v>1.7210090361445782</c:v>
                </c:pt>
                <c:pt idx="2623">
                  <c:v>1.6995481927710843</c:v>
                </c:pt>
                <c:pt idx="2624">
                  <c:v>1.7275978915662651</c:v>
                </c:pt>
                <c:pt idx="2625">
                  <c:v>1.6865587349397591</c:v>
                </c:pt>
                <c:pt idx="2626">
                  <c:v>1.703125</c:v>
                </c:pt>
                <c:pt idx="2627">
                  <c:v>1.7132906626506024</c:v>
                </c:pt>
                <c:pt idx="2628">
                  <c:v>1.7213855421686748</c:v>
                </c:pt>
                <c:pt idx="2629">
                  <c:v>1.7110316265060241</c:v>
                </c:pt>
                <c:pt idx="2630">
                  <c:v>1.7149849397590362</c:v>
                </c:pt>
                <c:pt idx="2631">
                  <c:v>1.7001129518072289</c:v>
                </c:pt>
                <c:pt idx="2632">
                  <c:v>1.7172439759036144</c:v>
                </c:pt>
                <c:pt idx="2633">
                  <c:v>1.7134789156626506</c:v>
                </c:pt>
                <c:pt idx="2634">
                  <c:v>1.6891942771084338</c:v>
                </c:pt>
                <c:pt idx="2635">
                  <c:v>1.7172439759036144</c:v>
                </c:pt>
                <c:pt idx="2636">
                  <c:v>1.6989834337349397</c:v>
                </c:pt>
                <c:pt idx="2637">
                  <c:v>1.6903237951807228</c:v>
                </c:pt>
                <c:pt idx="2638">
                  <c:v>1.7219503012048192</c:v>
                </c:pt>
                <c:pt idx="2639">
                  <c:v>1.7044427710843373</c:v>
                </c:pt>
                <c:pt idx="2640">
                  <c:v>1.6963478915662651</c:v>
                </c:pt>
                <c:pt idx="2641">
                  <c:v>1.7097138554216869</c:v>
                </c:pt>
                <c:pt idx="2642">
                  <c:v>1.7260918674698795</c:v>
                </c:pt>
                <c:pt idx="2643">
                  <c:v>1.712914156626506</c:v>
                </c:pt>
                <c:pt idx="2644">
                  <c:v>1.6848644578313252</c:v>
                </c:pt>
                <c:pt idx="2645">
                  <c:v>1.7053840361445782</c:v>
                </c:pt>
                <c:pt idx="2646">
                  <c:v>1.7023719879518073</c:v>
                </c:pt>
                <c:pt idx="2647">
                  <c:v>1.6848644578313252</c:v>
                </c:pt>
                <c:pt idx="2648">
                  <c:v>1.6971009036144578</c:v>
                </c:pt>
                <c:pt idx="2649">
                  <c:v>1.697289156626506</c:v>
                </c:pt>
                <c:pt idx="2650">
                  <c:v>1.6927710843373494</c:v>
                </c:pt>
                <c:pt idx="2651">
                  <c:v>1.7003012048192772</c:v>
                </c:pt>
                <c:pt idx="2652">
                  <c:v>1.6971009036144578</c:v>
                </c:pt>
                <c:pt idx="2653">
                  <c:v>1.7159262048192772</c:v>
                </c:pt>
                <c:pt idx="2654">
                  <c:v>1.6905120481927711</c:v>
                </c:pt>
                <c:pt idx="2655">
                  <c:v>1.692394578313253</c:v>
                </c:pt>
                <c:pt idx="2656">
                  <c:v>1.6763930722891567</c:v>
                </c:pt>
                <c:pt idx="2657">
                  <c:v>1.7149849397590362</c:v>
                </c:pt>
                <c:pt idx="2658">
                  <c:v>1.7155496987951808</c:v>
                </c:pt>
                <c:pt idx="2659">
                  <c:v>1.7104668674698795</c:v>
                </c:pt>
                <c:pt idx="2660">
                  <c:v>1.6886295180722892</c:v>
                </c:pt>
                <c:pt idx="2661">
                  <c:v>1.692394578313253</c:v>
                </c:pt>
                <c:pt idx="2662">
                  <c:v>1.6955948795180722</c:v>
                </c:pt>
                <c:pt idx="2663">
                  <c:v>1.7093373493975903</c:v>
                </c:pt>
                <c:pt idx="2664">
                  <c:v>1.7100903614457832</c:v>
                </c:pt>
                <c:pt idx="2665">
                  <c:v>1.7151731927710843</c:v>
                </c:pt>
                <c:pt idx="2666">
                  <c:v>1.6876882530120483</c:v>
                </c:pt>
                <c:pt idx="2667">
                  <c:v>1.7025602409638554</c:v>
                </c:pt>
                <c:pt idx="2668">
                  <c:v>1.7240210843373494</c:v>
                </c:pt>
                <c:pt idx="2669">
                  <c:v>1.7006777108433735</c:v>
                </c:pt>
                <c:pt idx="2670">
                  <c:v>1.6961596385542168</c:v>
                </c:pt>
                <c:pt idx="2671">
                  <c:v>1.7257153614457832</c:v>
                </c:pt>
                <c:pt idx="2672">
                  <c:v>1.7072665662650603</c:v>
                </c:pt>
                <c:pt idx="2673">
                  <c:v>1.7010542168674698</c:v>
                </c:pt>
                <c:pt idx="2674">
                  <c:v>1.6844879518072289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0-6B6F-4FE9-8DB8-2985C27EC40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715938639"/>
        <c:axId val="715950287"/>
      </c:scatterChart>
      <c:valAx>
        <c:axId val="715938639"/>
        <c:scaling>
          <c:orientation val="minMax"/>
          <c:max val="950"/>
          <c:min val="300"/>
        </c:scaling>
        <c:delete val="1"/>
        <c:axPos val="b"/>
        <c:numFmt formatCode="General" sourceLinked="1"/>
        <c:majorTickMark val="out"/>
        <c:minorTickMark val="none"/>
        <c:tickLblPos val="nextTo"/>
        <c:crossAx val="715950287"/>
        <c:crosses val="autoZero"/>
        <c:crossBetween val="midCat"/>
        <c:majorUnit val="200"/>
      </c:valAx>
      <c:valAx>
        <c:axId val="715950287"/>
        <c:scaling>
          <c:orientation val="minMax"/>
          <c:max val="2"/>
          <c:min val="0.5"/>
        </c:scaling>
        <c:delete val="1"/>
        <c:axPos val="l"/>
        <c:numFmt formatCode="General" sourceLinked="1"/>
        <c:majorTickMark val="out"/>
        <c:minorTickMark val="none"/>
        <c:tickLblPos val="nextTo"/>
        <c:crossAx val="715938639"/>
        <c:crosses val="autoZero"/>
        <c:crossBetween val="midCat"/>
        <c:majorUnit val="0.2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400">
          <a:solidFill>
            <a:schemeClr val="tx1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8"/>
    </mc:Choice>
    <mc:Fallback>
      <c:style val="8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1171654424544912"/>
          <c:y val="4.7825627229800521E-2"/>
          <c:w val="0.8308031496062992"/>
          <c:h val="0.80058216681248173"/>
        </c:manualLayout>
      </c:layout>
      <c:scatterChart>
        <c:scatterStyle val="smoothMarker"/>
        <c:varyColors val="0"/>
        <c:ser>
          <c:idx val="17"/>
          <c:order val="0"/>
          <c:tx>
            <c:strRef>
              <c:f>'Sheet1 SKF'!$AO$45</c:f>
              <c:strCache>
                <c:ptCount val="1"/>
                <c:pt idx="0">
                  <c:v>   Object[18]</c:v>
                </c:pt>
              </c:strCache>
            </c:strRef>
          </c:tx>
          <c:spPr>
            <a:ln w="3175" cap="rnd">
              <a:solidFill>
                <a:srgbClr val="B5E4FF"/>
              </a:solidFill>
              <a:round/>
            </a:ln>
            <a:effectLst/>
          </c:spPr>
          <c:marker>
            <c:symbol val="none"/>
          </c:marker>
          <c:xVal>
            <c:numRef>
              <c:f>'Sheet1 SKF'!$W$46:$W$4060</c:f>
              <c:numCache>
                <c:formatCode>General</c:formatCode>
                <c:ptCount val="4015"/>
                <c:pt idx="0">
                  <c:v>0</c:v>
                </c:pt>
                <c:pt idx="1">
                  <c:v>0.5</c:v>
                </c:pt>
                <c:pt idx="2">
                  <c:v>1</c:v>
                </c:pt>
                <c:pt idx="3">
                  <c:v>1.5</c:v>
                </c:pt>
                <c:pt idx="4">
                  <c:v>2</c:v>
                </c:pt>
                <c:pt idx="5">
                  <c:v>2.5</c:v>
                </c:pt>
                <c:pt idx="6">
                  <c:v>3</c:v>
                </c:pt>
                <c:pt idx="7">
                  <c:v>3.5</c:v>
                </c:pt>
                <c:pt idx="8">
                  <c:v>4</c:v>
                </c:pt>
                <c:pt idx="9">
                  <c:v>4.5</c:v>
                </c:pt>
                <c:pt idx="10">
                  <c:v>5</c:v>
                </c:pt>
                <c:pt idx="11">
                  <c:v>5.5</c:v>
                </c:pt>
                <c:pt idx="12">
                  <c:v>6</c:v>
                </c:pt>
                <c:pt idx="13">
                  <c:v>6.5</c:v>
                </c:pt>
                <c:pt idx="14">
                  <c:v>7</c:v>
                </c:pt>
                <c:pt idx="15">
                  <c:v>7.5</c:v>
                </c:pt>
                <c:pt idx="16">
                  <c:v>8</c:v>
                </c:pt>
                <c:pt idx="17">
                  <c:v>8.5</c:v>
                </c:pt>
                <c:pt idx="18">
                  <c:v>9</c:v>
                </c:pt>
                <c:pt idx="19">
                  <c:v>9.5</c:v>
                </c:pt>
                <c:pt idx="20">
                  <c:v>10</c:v>
                </c:pt>
                <c:pt idx="21">
                  <c:v>10.5</c:v>
                </c:pt>
                <c:pt idx="22">
                  <c:v>11</c:v>
                </c:pt>
                <c:pt idx="23">
                  <c:v>11.5</c:v>
                </c:pt>
                <c:pt idx="24">
                  <c:v>12</c:v>
                </c:pt>
                <c:pt idx="25">
                  <c:v>12.5</c:v>
                </c:pt>
                <c:pt idx="26">
                  <c:v>13</c:v>
                </c:pt>
                <c:pt idx="27">
                  <c:v>13.5</c:v>
                </c:pt>
                <c:pt idx="28">
                  <c:v>14</c:v>
                </c:pt>
                <c:pt idx="29">
                  <c:v>14.5</c:v>
                </c:pt>
                <c:pt idx="30">
                  <c:v>15</c:v>
                </c:pt>
                <c:pt idx="31">
                  <c:v>15.5</c:v>
                </c:pt>
                <c:pt idx="32">
                  <c:v>16</c:v>
                </c:pt>
                <c:pt idx="33">
                  <c:v>16.5</c:v>
                </c:pt>
                <c:pt idx="34">
                  <c:v>17</c:v>
                </c:pt>
                <c:pt idx="35">
                  <c:v>17.5</c:v>
                </c:pt>
                <c:pt idx="36">
                  <c:v>18</c:v>
                </c:pt>
                <c:pt idx="37">
                  <c:v>18.5</c:v>
                </c:pt>
                <c:pt idx="38">
                  <c:v>19</c:v>
                </c:pt>
                <c:pt idx="39">
                  <c:v>19.5</c:v>
                </c:pt>
                <c:pt idx="40">
                  <c:v>20</c:v>
                </c:pt>
                <c:pt idx="41">
                  <c:v>20.5</c:v>
                </c:pt>
                <c:pt idx="42">
                  <c:v>21</c:v>
                </c:pt>
                <c:pt idx="43">
                  <c:v>21.5</c:v>
                </c:pt>
                <c:pt idx="44">
                  <c:v>22</c:v>
                </c:pt>
                <c:pt idx="45">
                  <c:v>22.5</c:v>
                </c:pt>
                <c:pt idx="46">
                  <c:v>23</c:v>
                </c:pt>
                <c:pt idx="47">
                  <c:v>23.5</c:v>
                </c:pt>
                <c:pt idx="48">
                  <c:v>24</c:v>
                </c:pt>
                <c:pt idx="49">
                  <c:v>24.5</c:v>
                </c:pt>
                <c:pt idx="50">
                  <c:v>25</c:v>
                </c:pt>
                <c:pt idx="51">
                  <c:v>25.5</c:v>
                </c:pt>
                <c:pt idx="52">
                  <c:v>26</c:v>
                </c:pt>
                <c:pt idx="53">
                  <c:v>26.5</c:v>
                </c:pt>
                <c:pt idx="54">
                  <c:v>27</c:v>
                </c:pt>
                <c:pt idx="55">
                  <c:v>27.5</c:v>
                </c:pt>
                <c:pt idx="56">
                  <c:v>28</c:v>
                </c:pt>
                <c:pt idx="57">
                  <c:v>28.5</c:v>
                </c:pt>
                <c:pt idx="58">
                  <c:v>29</c:v>
                </c:pt>
                <c:pt idx="59">
                  <c:v>29.5</c:v>
                </c:pt>
                <c:pt idx="60">
                  <c:v>30</c:v>
                </c:pt>
                <c:pt idx="61">
                  <c:v>30.5</c:v>
                </c:pt>
                <c:pt idx="62">
                  <c:v>31</c:v>
                </c:pt>
                <c:pt idx="63">
                  <c:v>31.5</c:v>
                </c:pt>
                <c:pt idx="64">
                  <c:v>32</c:v>
                </c:pt>
                <c:pt idx="65">
                  <c:v>32.5</c:v>
                </c:pt>
                <c:pt idx="66">
                  <c:v>33</c:v>
                </c:pt>
                <c:pt idx="67">
                  <c:v>33.5</c:v>
                </c:pt>
                <c:pt idx="68">
                  <c:v>34</c:v>
                </c:pt>
                <c:pt idx="69">
                  <c:v>34.5</c:v>
                </c:pt>
                <c:pt idx="70">
                  <c:v>35</c:v>
                </c:pt>
                <c:pt idx="71">
                  <c:v>35.5</c:v>
                </c:pt>
                <c:pt idx="72">
                  <c:v>36</c:v>
                </c:pt>
                <c:pt idx="73">
                  <c:v>36.5</c:v>
                </c:pt>
                <c:pt idx="74">
                  <c:v>37</c:v>
                </c:pt>
                <c:pt idx="75">
                  <c:v>37.5</c:v>
                </c:pt>
                <c:pt idx="76">
                  <c:v>38</c:v>
                </c:pt>
                <c:pt idx="77">
                  <c:v>38.5</c:v>
                </c:pt>
                <c:pt idx="78">
                  <c:v>39</c:v>
                </c:pt>
                <c:pt idx="79">
                  <c:v>39.5</c:v>
                </c:pt>
                <c:pt idx="80">
                  <c:v>40</c:v>
                </c:pt>
                <c:pt idx="81">
                  <c:v>40.5</c:v>
                </c:pt>
                <c:pt idx="82">
                  <c:v>41</c:v>
                </c:pt>
                <c:pt idx="83">
                  <c:v>41.5</c:v>
                </c:pt>
                <c:pt idx="84">
                  <c:v>42</c:v>
                </c:pt>
                <c:pt idx="85">
                  <c:v>42.5</c:v>
                </c:pt>
                <c:pt idx="86">
                  <c:v>43</c:v>
                </c:pt>
                <c:pt idx="87">
                  <c:v>43.5</c:v>
                </c:pt>
                <c:pt idx="88">
                  <c:v>44</c:v>
                </c:pt>
                <c:pt idx="89">
                  <c:v>44.5</c:v>
                </c:pt>
                <c:pt idx="90">
                  <c:v>45</c:v>
                </c:pt>
                <c:pt idx="91">
                  <c:v>45.5</c:v>
                </c:pt>
                <c:pt idx="92">
                  <c:v>46</c:v>
                </c:pt>
                <c:pt idx="93">
                  <c:v>46.5</c:v>
                </c:pt>
                <c:pt idx="94">
                  <c:v>47</c:v>
                </c:pt>
                <c:pt idx="95">
                  <c:v>47.5</c:v>
                </c:pt>
                <c:pt idx="96">
                  <c:v>48</c:v>
                </c:pt>
                <c:pt idx="97">
                  <c:v>48.5</c:v>
                </c:pt>
                <c:pt idx="98">
                  <c:v>49</c:v>
                </c:pt>
                <c:pt idx="99">
                  <c:v>49.5</c:v>
                </c:pt>
                <c:pt idx="100">
                  <c:v>50</c:v>
                </c:pt>
                <c:pt idx="101">
                  <c:v>50.5</c:v>
                </c:pt>
                <c:pt idx="102">
                  <c:v>51</c:v>
                </c:pt>
                <c:pt idx="103">
                  <c:v>51.5</c:v>
                </c:pt>
                <c:pt idx="104">
                  <c:v>52</c:v>
                </c:pt>
                <c:pt idx="105">
                  <c:v>52.5</c:v>
                </c:pt>
                <c:pt idx="106">
                  <c:v>53</c:v>
                </c:pt>
                <c:pt idx="107">
                  <c:v>53.5</c:v>
                </c:pt>
                <c:pt idx="108">
                  <c:v>54</c:v>
                </c:pt>
                <c:pt idx="109">
                  <c:v>54.5</c:v>
                </c:pt>
                <c:pt idx="110">
                  <c:v>55</c:v>
                </c:pt>
                <c:pt idx="111">
                  <c:v>55.5</c:v>
                </c:pt>
                <c:pt idx="112">
                  <c:v>56</c:v>
                </c:pt>
                <c:pt idx="113">
                  <c:v>56.5</c:v>
                </c:pt>
                <c:pt idx="114">
                  <c:v>57</c:v>
                </c:pt>
                <c:pt idx="115">
                  <c:v>57.5</c:v>
                </c:pt>
                <c:pt idx="116">
                  <c:v>58</c:v>
                </c:pt>
                <c:pt idx="117">
                  <c:v>58.5</c:v>
                </c:pt>
                <c:pt idx="118">
                  <c:v>59</c:v>
                </c:pt>
                <c:pt idx="119">
                  <c:v>59.5</c:v>
                </c:pt>
                <c:pt idx="120">
                  <c:v>60</c:v>
                </c:pt>
                <c:pt idx="121">
                  <c:v>60.5</c:v>
                </c:pt>
                <c:pt idx="122">
                  <c:v>61</c:v>
                </c:pt>
                <c:pt idx="123">
                  <c:v>61.5</c:v>
                </c:pt>
                <c:pt idx="124">
                  <c:v>62</c:v>
                </c:pt>
                <c:pt idx="125">
                  <c:v>62.5</c:v>
                </c:pt>
                <c:pt idx="126">
                  <c:v>63</c:v>
                </c:pt>
                <c:pt idx="127">
                  <c:v>63.5</c:v>
                </c:pt>
                <c:pt idx="128">
                  <c:v>64</c:v>
                </c:pt>
                <c:pt idx="129">
                  <c:v>64.5</c:v>
                </c:pt>
                <c:pt idx="130">
                  <c:v>65</c:v>
                </c:pt>
                <c:pt idx="131">
                  <c:v>65.5</c:v>
                </c:pt>
                <c:pt idx="132">
                  <c:v>66</c:v>
                </c:pt>
                <c:pt idx="133">
                  <c:v>66.5</c:v>
                </c:pt>
                <c:pt idx="134">
                  <c:v>67</c:v>
                </c:pt>
                <c:pt idx="135">
                  <c:v>67.5</c:v>
                </c:pt>
                <c:pt idx="136">
                  <c:v>68</c:v>
                </c:pt>
                <c:pt idx="137">
                  <c:v>68.5</c:v>
                </c:pt>
                <c:pt idx="138">
                  <c:v>69</c:v>
                </c:pt>
                <c:pt idx="139">
                  <c:v>69.5</c:v>
                </c:pt>
                <c:pt idx="140">
                  <c:v>70</c:v>
                </c:pt>
                <c:pt idx="141">
                  <c:v>70.5</c:v>
                </c:pt>
                <c:pt idx="142">
                  <c:v>71</c:v>
                </c:pt>
                <c:pt idx="143">
                  <c:v>71.5</c:v>
                </c:pt>
                <c:pt idx="144">
                  <c:v>72</c:v>
                </c:pt>
                <c:pt idx="145">
                  <c:v>72.5</c:v>
                </c:pt>
                <c:pt idx="146">
                  <c:v>73</c:v>
                </c:pt>
                <c:pt idx="147">
                  <c:v>73.5</c:v>
                </c:pt>
                <c:pt idx="148">
                  <c:v>74</c:v>
                </c:pt>
                <c:pt idx="149">
                  <c:v>74.5</c:v>
                </c:pt>
                <c:pt idx="150">
                  <c:v>75</c:v>
                </c:pt>
                <c:pt idx="151">
                  <c:v>75.5</c:v>
                </c:pt>
                <c:pt idx="152">
                  <c:v>76</c:v>
                </c:pt>
                <c:pt idx="153">
                  <c:v>76.5</c:v>
                </c:pt>
                <c:pt idx="154">
                  <c:v>77</c:v>
                </c:pt>
                <c:pt idx="155">
                  <c:v>77.5</c:v>
                </c:pt>
                <c:pt idx="156">
                  <c:v>78</c:v>
                </c:pt>
                <c:pt idx="157">
                  <c:v>78.5</c:v>
                </c:pt>
                <c:pt idx="158">
                  <c:v>79</c:v>
                </c:pt>
                <c:pt idx="159">
                  <c:v>79.5</c:v>
                </c:pt>
                <c:pt idx="160">
                  <c:v>80</c:v>
                </c:pt>
                <c:pt idx="161">
                  <c:v>80.5</c:v>
                </c:pt>
                <c:pt idx="162">
                  <c:v>81</c:v>
                </c:pt>
                <c:pt idx="163">
                  <c:v>81.5</c:v>
                </c:pt>
                <c:pt idx="164">
                  <c:v>82</c:v>
                </c:pt>
                <c:pt idx="165">
                  <c:v>82.5</c:v>
                </c:pt>
                <c:pt idx="166">
                  <c:v>83</c:v>
                </c:pt>
                <c:pt idx="167">
                  <c:v>83.5</c:v>
                </c:pt>
                <c:pt idx="168">
                  <c:v>84</c:v>
                </c:pt>
                <c:pt idx="169">
                  <c:v>84.5</c:v>
                </c:pt>
                <c:pt idx="170">
                  <c:v>85</c:v>
                </c:pt>
                <c:pt idx="171">
                  <c:v>85.5</c:v>
                </c:pt>
                <c:pt idx="172">
                  <c:v>86</c:v>
                </c:pt>
                <c:pt idx="173">
                  <c:v>86.5</c:v>
                </c:pt>
                <c:pt idx="174">
                  <c:v>87</c:v>
                </c:pt>
                <c:pt idx="175">
                  <c:v>87.5</c:v>
                </c:pt>
                <c:pt idx="176">
                  <c:v>88</c:v>
                </c:pt>
                <c:pt idx="177">
                  <c:v>88.5</c:v>
                </c:pt>
                <c:pt idx="178">
                  <c:v>89</c:v>
                </c:pt>
                <c:pt idx="179">
                  <c:v>89.5</c:v>
                </c:pt>
                <c:pt idx="180">
                  <c:v>90</c:v>
                </c:pt>
                <c:pt idx="181">
                  <c:v>90.5</c:v>
                </c:pt>
                <c:pt idx="182">
                  <c:v>91</c:v>
                </c:pt>
                <c:pt idx="183">
                  <c:v>91.5</c:v>
                </c:pt>
                <c:pt idx="184">
                  <c:v>92</c:v>
                </c:pt>
                <c:pt idx="185">
                  <c:v>92.5</c:v>
                </c:pt>
                <c:pt idx="186">
                  <c:v>93</c:v>
                </c:pt>
                <c:pt idx="187">
                  <c:v>93.5</c:v>
                </c:pt>
                <c:pt idx="188">
                  <c:v>94</c:v>
                </c:pt>
                <c:pt idx="189">
                  <c:v>94.5</c:v>
                </c:pt>
                <c:pt idx="190">
                  <c:v>95</c:v>
                </c:pt>
                <c:pt idx="191">
                  <c:v>95.5</c:v>
                </c:pt>
                <c:pt idx="192">
                  <c:v>96</c:v>
                </c:pt>
                <c:pt idx="193">
                  <c:v>96.5</c:v>
                </c:pt>
                <c:pt idx="194">
                  <c:v>97</c:v>
                </c:pt>
                <c:pt idx="195">
                  <c:v>97.5</c:v>
                </c:pt>
                <c:pt idx="196">
                  <c:v>98</c:v>
                </c:pt>
                <c:pt idx="197">
                  <c:v>98.5</c:v>
                </c:pt>
                <c:pt idx="198">
                  <c:v>99</c:v>
                </c:pt>
                <c:pt idx="199">
                  <c:v>99.5</c:v>
                </c:pt>
                <c:pt idx="200">
                  <c:v>100</c:v>
                </c:pt>
                <c:pt idx="201">
                  <c:v>100.5</c:v>
                </c:pt>
                <c:pt idx="202">
                  <c:v>101</c:v>
                </c:pt>
                <c:pt idx="203">
                  <c:v>101.5</c:v>
                </c:pt>
                <c:pt idx="204">
                  <c:v>102</c:v>
                </c:pt>
                <c:pt idx="205">
                  <c:v>102.5</c:v>
                </c:pt>
                <c:pt idx="206">
                  <c:v>103</c:v>
                </c:pt>
                <c:pt idx="207">
                  <c:v>103.5</c:v>
                </c:pt>
                <c:pt idx="208">
                  <c:v>104</c:v>
                </c:pt>
                <c:pt idx="209">
                  <c:v>104.5</c:v>
                </c:pt>
                <c:pt idx="210">
                  <c:v>105</c:v>
                </c:pt>
                <c:pt idx="211">
                  <c:v>105.5</c:v>
                </c:pt>
                <c:pt idx="212">
                  <c:v>106</c:v>
                </c:pt>
                <c:pt idx="213">
                  <c:v>106.5</c:v>
                </c:pt>
                <c:pt idx="214">
                  <c:v>107</c:v>
                </c:pt>
                <c:pt idx="215">
                  <c:v>107.5</c:v>
                </c:pt>
                <c:pt idx="216">
                  <c:v>108</c:v>
                </c:pt>
                <c:pt idx="217">
                  <c:v>108.5</c:v>
                </c:pt>
                <c:pt idx="218">
                  <c:v>109</c:v>
                </c:pt>
                <c:pt idx="219">
                  <c:v>109.5</c:v>
                </c:pt>
                <c:pt idx="220">
                  <c:v>110</c:v>
                </c:pt>
                <c:pt idx="221">
                  <c:v>110.5</c:v>
                </c:pt>
                <c:pt idx="222">
                  <c:v>111</c:v>
                </c:pt>
                <c:pt idx="223">
                  <c:v>111.5</c:v>
                </c:pt>
                <c:pt idx="224">
                  <c:v>112</c:v>
                </c:pt>
                <c:pt idx="225">
                  <c:v>112.5</c:v>
                </c:pt>
                <c:pt idx="226">
                  <c:v>113</c:v>
                </c:pt>
                <c:pt idx="227">
                  <c:v>113.5</c:v>
                </c:pt>
                <c:pt idx="228">
                  <c:v>114</c:v>
                </c:pt>
                <c:pt idx="229">
                  <c:v>114.5</c:v>
                </c:pt>
                <c:pt idx="230">
                  <c:v>115</c:v>
                </c:pt>
                <c:pt idx="231">
                  <c:v>115.5</c:v>
                </c:pt>
                <c:pt idx="232">
                  <c:v>116</c:v>
                </c:pt>
                <c:pt idx="233">
                  <c:v>116.5</c:v>
                </c:pt>
                <c:pt idx="234">
                  <c:v>117</c:v>
                </c:pt>
                <c:pt idx="235">
                  <c:v>117.5</c:v>
                </c:pt>
                <c:pt idx="236">
                  <c:v>118</c:v>
                </c:pt>
                <c:pt idx="237">
                  <c:v>118.5</c:v>
                </c:pt>
                <c:pt idx="238">
                  <c:v>119</c:v>
                </c:pt>
                <c:pt idx="239">
                  <c:v>119.5</c:v>
                </c:pt>
                <c:pt idx="240">
                  <c:v>120</c:v>
                </c:pt>
                <c:pt idx="241">
                  <c:v>120.5</c:v>
                </c:pt>
                <c:pt idx="242">
                  <c:v>121</c:v>
                </c:pt>
                <c:pt idx="243">
                  <c:v>121.5</c:v>
                </c:pt>
                <c:pt idx="244">
                  <c:v>122</c:v>
                </c:pt>
                <c:pt idx="245">
                  <c:v>122.5</c:v>
                </c:pt>
                <c:pt idx="246">
                  <c:v>123</c:v>
                </c:pt>
                <c:pt idx="247">
                  <c:v>123.5</c:v>
                </c:pt>
                <c:pt idx="248">
                  <c:v>124</c:v>
                </c:pt>
                <c:pt idx="249">
                  <c:v>124.5</c:v>
                </c:pt>
                <c:pt idx="250">
                  <c:v>125</c:v>
                </c:pt>
                <c:pt idx="251">
                  <c:v>125.5</c:v>
                </c:pt>
                <c:pt idx="252">
                  <c:v>126</c:v>
                </c:pt>
                <c:pt idx="253">
                  <c:v>126.5</c:v>
                </c:pt>
                <c:pt idx="254">
                  <c:v>127</c:v>
                </c:pt>
                <c:pt idx="255">
                  <c:v>127.5</c:v>
                </c:pt>
                <c:pt idx="256">
                  <c:v>128</c:v>
                </c:pt>
                <c:pt idx="257">
                  <c:v>128.5</c:v>
                </c:pt>
                <c:pt idx="258">
                  <c:v>129</c:v>
                </c:pt>
                <c:pt idx="259">
                  <c:v>129.5</c:v>
                </c:pt>
                <c:pt idx="260">
                  <c:v>130</c:v>
                </c:pt>
                <c:pt idx="261">
                  <c:v>130.5</c:v>
                </c:pt>
                <c:pt idx="262">
                  <c:v>131</c:v>
                </c:pt>
                <c:pt idx="263">
                  <c:v>131.5</c:v>
                </c:pt>
                <c:pt idx="264">
                  <c:v>132</c:v>
                </c:pt>
                <c:pt idx="265">
                  <c:v>132.5</c:v>
                </c:pt>
                <c:pt idx="266">
                  <c:v>133</c:v>
                </c:pt>
                <c:pt idx="267">
                  <c:v>133.5</c:v>
                </c:pt>
                <c:pt idx="268">
                  <c:v>134</c:v>
                </c:pt>
                <c:pt idx="269">
                  <c:v>134.5</c:v>
                </c:pt>
                <c:pt idx="270">
                  <c:v>135</c:v>
                </c:pt>
                <c:pt idx="271">
                  <c:v>135.5</c:v>
                </c:pt>
                <c:pt idx="272">
                  <c:v>136</c:v>
                </c:pt>
                <c:pt idx="273">
                  <c:v>136.5</c:v>
                </c:pt>
                <c:pt idx="274">
                  <c:v>137</c:v>
                </c:pt>
                <c:pt idx="275">
                  <c:v>137.5</c:v>
                </c:pt>
                <c:pt idx="276">
                  <c:v>138</c:v>
                </c:pt>
                <c:pt idx="277">
                  <c:v>138.5</c:v>
                </c:pt>
                <c:pt idx="278">
                  <c:v>139</c:v>
                </c:pt>
                <c:pt idx="279">
                  <c:v>139.5</c:v>
                </c:pt>
                <c:pt idx="280">
                  <c:v>140</c:v>
                </c:pt>
                <c:pt idx="281">
                  <c:v>140.5</c:v>
                </c:pt>
                <c:pt idx="282">
                  <c:v>141</c:v>
                </c:pt>
                <c:pt idx="283">
                  <c:v>141.5</c:v>
                </c:pt>
                <c:pt idx="284">
                  <c:v>142</c:v>
                </c:pt>
                <c:pt idx="285">
                  <c:v>142.5</c:v>
                </c:pt>
                <c:pt idx="286">
                  <c:v>143</c:v>
                </c:pt>
                <c:pt idx="287">
                  <c:v>143.5</c:v>
                </c:pt>
                <c:pt idx="288">
                  <c:v>144</c:v>
                </c:pt>
                <c:pt idx="289">
                  <c:v>144.5</c:v>
                </c:pt>
                <c:pt idx="290">
                  <c:v>145</c:v>
                </c:pt>
                <c:pt idx="291">
                  <c:v>145.5</c:v>
                </c:pt>
                <c:pt idx="292">
                  <c:v>146</c:v>
                </c:pt>
                <c:pt idx="293">
                  <c:v>146.5</c:v>
                </c:pt>
                <c:pt idx="294">
                  <c:v>147</c:v>
                </c:pt>
                <c:pt idx="295">
                  <c:v>147.5</c:v>
                </c:pt>
                <c:pt idx="296">
                  <c:v>148</c:v>
                </c:pt>
                <c:pt idx="297">
                  <c:v>148.5</c:v>
                </c:pt>
                <c:pt idx="298">
                  <c:v>149</c:v>
                </c:pt>
                <c:pt idx="299">
                  <c:v>149.5</c:v>
                </c:pt>
                <c:pt idx="300">
                  <c:v>150</c:v>
                </c:pt>
                <c:pt idx="301">
                  <c:v>150.5</c:v>
                </c:pt>
                <c:pt idx="302">
                  <c:v>151</c:v>
                </c:pt>
                <c:pt idx="303">
                  <c:v>151.5</c:v>
                </c:pt>
                <c:pt idx="304">
                  <c:v>152</c:v>
                </c:pt>
                <c:pt idx="305">
                  <c:v>152.5</c:v>
                </c:pt>
                <c:pt idx="306">
                  <c:v>153</c:v>
                </c:pt>
                <c:pt idx="307">
                  <c:v>153.5</c:v>
                </c:pt>
                <c:pt idx="308">
                  <c:v>154</c:v>
                </c:pt>
                <c:pt idx="309">
                  <c:v>154.5</c:v>
                </c:pt>
                <c:pt idx="310">
                  <c:v>155</c:v>
                </c:pt>
                <c:pt idx="311">
                  <c:v>155.5</c:v>
                </c:pt>
                <c:pt idx="312">
                  <c:v>156</c:v>
                </c:pt>
                <c:pt idx="313">
                  <c:v>156.5</c:v>
                </c:pt>
                <c:pt idx="314">
                  <c:v>157</c:v>
                </c:pt>
                <c:pt idx="315">
                  <c:v>157.5</c:v>
                </c:pt>
                <c:pt idx="316">
                  <c:v>158</c:v>
                </c:pt>
                <c:pt idx="317">
                  <c:v>158.5</c:v>
                </c:pt>
                <c:pt idx="318">
                  <c:v>159</c:v>
                </c:pt>
                <c:pt idx="319">
                  <c:v>159.5</c:v>
                </c:pt>
                <c:pt idx="320">
                  <c:v>160</c:v>
                </c:pt>
                <c:pt idx="321">
                  <c:v>160.5</c:v>
                </c:pt>
                <c:pt idx="322">
                  <c:v>161</c:v>
                </c:pt>
                <c:pt idx="323">
                  <c:v>161.5</c:v>
                </c:pt>
                <c:pt idx="324">
                  <c:v>162</c:v>
                </c:pt>
                <c:pt idx="325">
                  <c:v>162.5</c:v>
                </c:pt>
                <c:pt idx="326">
                  <c:v>163</c:v>
                </c:pt>
                <c:pt idx="327">
                  <c:v>163.5</c:v>
                </c:pt>
                <c:pt idx="328">
                  <c:v>164</c:v>
                </c:pt>
                <c:pt idx="329">
                  <c:v>164.5</c:v>
                </c:pt>
                <c:pt idx="330">
                  <c:v>165</c:v>
                </c:pt>
                <c:pt idx="331">
                  <c:v>165.5</c:v>
                </c:pt>
                <c:pt idx="332">
                  <c:v>166</c:v>
                </c:pt>
                <c:pt idx="333">
                  <c:v>166.5</c:v>
                </c:pt>
                <c:pt idx="334">
                  <c:v>167</c:v>
                </c:pt>
                <c:pt idx="335">
                  <c:v>167.5</c:v>
                </c:pt>
                <c:pt idx="336">
                  <c:v>168</c:v>
                </c:pt>
                <c:pt idx="337">
                  <c:v>168.5</c:v>
                </c:pt>
                <c:pt idx="338">
                  <c:v>169</c:v>
                </c:pt>
                <c:pt idx="339">
                  <c:v>169.5</c:v>
                </c:pt>
                <c:pt idx="340">
                  <c:v>170</c:v>
                </c:pt>
                <c:pt idx="341">
                  <c:v>170.5</c:v>
                </c:pt>
                <c:pt idx="342">
                  <c:v>171</c:v>
                </c:pt>
                <c:pt idx="343">
                  <c:v>171.5</c:v>
                </c:pt>
                <c:pt idx="344">
                  <c:v>172</c:v>
                </c:pt>
                <c:pt idx="345">
                  <c:v>172.5</c:v>
                </c:pt>
                <c:pt idx="346">
                  <c:v>173</c:v>
                </c:pt>
                <c:pt idx="347">
                  <c:v>173.5</c:v>
                </c:pt>
                <c:pt idx="348">
                  <c:v>174</c:v>
                </c:pt>
                <c:pt idx="349">
                  <c:v>174.5</c:v>
                </c:pt>
                <c:pt idx="350">
                  <c:v>175</c:v>
                </c:pt>
                <c:pt idx="351">
                  <c:v>175.5</c:v>
                </c:pt>
                <c:pt idx="352">
                  <c:v>176</c:v>
                </c:pt>
                <c:pt idx="353">
                  <c:v>176.5</c:v>
                </c:pt>
                <c:pt idx="354">
                  <c:v>177</c:v>
                </c:pt>
                <c:pt idx="355">
                  <c:v>177.5</c:v>
                </c:pt>
                <c:pt idx="356">
                  <c:v>178</c:v>
                </c:pt>
                <c:pt idx="357">
                  <c:v>178.5</c:v>
                </c:pt>
                <c:pt idx="358">
                  <c:v>179</c:v>
                </c:pt>
                <c:pt idx="359">
                  <c:v>179.5</c:v>
                </c:pt>
                <c:pt idx="360">
                  <c:v>180</c:v>
                </c:pt>
                <c:pt idx="361">
                  <c:v>180.5</c:v>
                </c:pt>
                <c:pt idx="362">
                  <c:v>181</c:v>
                </c:pt>
                <c:pt idx="363">
                  <c:v>181.5</c:v>
                </c:pt>
                <c:pt idx="364">
                  <c:v>182</c:v>
                </c:pt>
                <c:pt idx="365">
                  <c:v>182.5</c:v>
                </c:pt>
                <c:pt idx="366">
                  <c:v>183</c:v>
                </c:pt>
                <c:pt idx="367">
                  <c:v>183.5</c:v>
                </c:pt>
                <c:pt idx="368">
                  <c:v>184</c:v>
                </c:pt>
                <c:pt idx="369">
                  <c:v>184.5</c:v>
                </c:pt>
                <c:pt idx="370">
                  <c:v>185</c:v>
                </c:pt>
                <c:pt idx="371">
                  <c:v>185.5</c:v>
                </c:pt>
                <c:pt idx="372">
                  <c:v>186</c:v>
                </c:pt>
                <c:pt idx="373">
                  <c:v>186.5</c:v>
                </c:pt>
                <c:pt idx="374">
                  <c:v>187</c:v>
                </c:pt>
                <c:pt idx="375">
                  <c:v>187.5</c:v>
                </c:pt>
                <c:pt idx="376">
                  <c:v>188</c:v>
                </c:pt>
                <c:pt idx="377">
                  <c:v>188.5</c:v>
                </c:pt>
                <c:pt idx="378">
                  <c:v>189</c:v>
                </c:pt>
                <c:pt idx="379">
                  <c:v>189.5</c:v>
                </c:pt>
                <c:pt idx="380">
                  <c:v>190</c:v>
                </c:pt>
                <c:pt idx="381">
                  <c:v>190.5</c:v>
                </c:pt>
                <c:pt idx="382">
                  <c:v>191</c:v>
                </c:pt>
                <c:pt idx="383">
                  <c:v>191.5</c:v>
                </c:pt>
                <c:pt idx="384">
                  <c:v>192</c:v>
                </c:pt>
                <c:pt idx="385">
                  <c:v>192.5</c:v>
                </c:pt>
                <c:pt idx="386">
                  <c:v>193</c:v>
                </c:pt>
                <c:pt idx="387">
                  <c:v>193.5</c:v>
                </c:pt>
                <c:pt idx="388">
                  <c:v>194</c:v>
                </c:pt>
                <c:pt idx="389">
                  <c:v>194.5</c:v>
                </c:pt>
                <c:pt idx="390">
                  <c:v>195</c:v>
                </c:pt>
                <c:pt idx="391">
                  <c:v>195.5</c:v>
                </c:pt>
                <c:pt idx="392">
                  <c:v>196</c:v>
                </c:pt>
                <c:pt idx="393">
                  <c:v>196.5</c:v>
                </c:pt>
                <c:pt idx="394">
                  <c:v>197</c:v>
                </c:pt>
                <c:pt idx="395">
                  <c:v>197.5</c:v>
                </c:pt>
                <c:pt idx="396">
                  <c:v>198</c:v>
                </c:pt>
                <c:pt idx="397">
                  <c:v>198.5</c:v>
                </c:pt>
                <c:pt idx="398">
                  <c:v>199</c:v>
                </c:pt>
                <c:pt idx="399">
                  <c:v>199.5</c:v>
                </c:pt>
                <c:pt idx="400">
                  <c:v>200</c:v>
                </c:pt>
                <c:pt idx="401">
                  <c:v>200.5</c:v>
                </c:pt>
                <c:pt idx="402">
                  <c:v>201</c:v>
                </c:pt>
                <c:pt idx="403">
                  <c:v>201.5</c:v>
                </c:pt>
                <c:pt idx="404">
                  <c:v>202</c:v>
                </c:pt>
                <c:pt idx="405">
                  <c:v>202.5</c:v>
                </c:pt>
                <c:pt idx="406">
                  <c:v>203</c:v>
                </c:pt>
                <c:pt idx="407">
                  <c:v>203.5</c:v>
                </c:pt>
                <c:pt idx="408">
                  <c:v>204</c:v>
                </c:pt>
                <c:pt idx="409">
                  <c:v>204.5</c:v>
                </c:pt>
                <c:pt idx="410">
                  <c:v>205</c:v>
                </c:pt>
                <c:pt idx="411">
                  <c:v>205.5</c:v>
                </c:pt>
                <c:pt idx="412">
                  <c:v>206</c:v>
                </c:pt>
                <c:pt idx="413">
                  <c:v>206.5</c:v>
                </c:pt>
                <c:pt idx="414">
                  <c:v>207</c:v>
                </c:pt>
                <c:pt idx="415">
                  <c:v>207.5</c:v>
                </c:pt>
                <c:pt idx="416">
                  <c:v>208</c:v>
                </c:pt>
                <c:pt idx="417">
                  <c:v>208.5</c:v>
                </c:pt>
                <c:pt idx="418">
                  <c:v>209</c:v>
                </c:pt>
                <c:pt idx="419">
                  <c:v>209.5</c:v>
                </c:pt>
                <c:pt idx="420">
                  <c:v>210</c:v>
                </c:pt>
                <c:pt idx="421">
                  <c:v>210.5</c:v>
                </c:pt>
                <c:pt idx="422">
                  <c:v>211</c:v>
                </c:pt>
                <c:pt idx="423">
                  <c:v>211.5</c:v>
                </c:pt>
                <c:pt idx="424">
                  <c:v>212</c:v>
                </c:pt>
                <c:pt idx="425">
                  <c:v>212.5</c:v>
                </c:pt>
                <c:pt idx="426">
                  <c:v>213</c:v>
                </c:pt>
                <c:pt idx="427">
                  <c:v>213.5</c:v>
                </c:pt>
                <c:pt idx="428">
                  <c:v>214</c:v>
                </c:pt>
                <c:pt idx="429">
                  <c:v>214.5</c:v>
                </c:pt>
                <c:pt idx="430">
                  <c:v>215</c:v>
                </c:pt>
                <c:pt idx="431">
                  <c:v>215.5</c:v>
                </c:pt>
                <c:pt idx="432">
                  <c:v>216</c:v>
                </c:pt>
                <c:pt idx="433">
                  <c:v>216.5</c:v>
                </c:pt>
                <c:pt idx="434">
                  <c:v>217</c:v>
                </c:pt>
                <c:pt idx="435">
                  <c:v>217.5</c:v>
                </c:pt>
                <c:pt idx="436">
                  <c:v>218</c:v>
                </c:pt>
                <c:pt idx="437">
                  <c:v>218.5</c:v>
                </c:pt>
                <c:pt idx="438">
                  <c:v>219</c:v>
                </c:pt>
                <c:pt idx="439">
                  <c:v>219.5</c:v>
                </c:pt>
                <c:pt idx="440">
                  <c:v>220</c:v>
                </c:pt>
                <c:pt idx="441">
                  <c:v>220.5</c:v>
                </c:pt>
                <c:pt idx="442">
                  <c:v>221</c:v>
                </c:pt>
                <c:pt idx="443">
                  <c:v>221.5</c:v>
                </c:pt>
                <c:pt idx="444">
                  <c:v>222</c:v>
                </c:pt>
                <c:pt idx="445">
                  <c:v>222.5</c:v>
                </c:pt>
                <c:pt idx="446">
                  <c:v>223</c:v>
                </c:pt>
                <c:pt idx="447">
                  <c:v>223.5</c:v>
                </c:pt>
                <c:pt idx="448">
                  <c:v>224</c:v>
                </c:pt>
                <c:pt idx="449">
                  <c:v>224.5</c:v>
                </c:pt>
                <c:pt idx="450">
                  <c:v>225</c:v>
                </c:pt>
                <c:pt idx="451">
                  <c:v>225.5</c:v>
                </c:pt>
                <c:pt idx="452">
                  <c:v>226</c:v>
                </c:pt>
                <c:pt idx="453">
                  <c:v>226.5</c:v>
                </c:pt>
                <c:pt idx="454">
                  <c:v>227</c:v>
                </c:pt>
                <c:pt idx="455">
                  <c:v>227.5</c:v>
                </c:pt>
                <c:pt idx="456">
                  <c:v>228</c:v>
                </c:pt>
                <c:pt idx="457">
                  <c:v>228.5</c:v>
                </c:pt>
                <c:pt idx="458">
                  <c:v>229</c:v>
                </c:pt>
                <c:pt idx="459">
                  <c:v>229.5</c:v>
                </c:pt>
                <c:pt idx="460">
                  <c:v>230</c:v>
                </c:pt>
                <c:pt idx="461">
                  <c:v>230.5</c:v>
                </c:pt>
                <c:pt idx="462">
                  <c:v>231</c:v>
                </c:pt>
                <c:pt idx="463">
                  <c:v>231.5</c:v>
                </c:pt>
                <c:pt idx="464">
                  <c:v>232</c:v>
                </c:pt>
                <c:pt idx="465">
                  <c:v>232.5</c:v>
                </c:pt>
                <c:pt idx="466">
                  <c:v>233</c:v>
                </c:pt>
                <c:pt idx="467">
                  <c:v>233.5</c:v>
                </c:pt>
                <c:pt idx="468">
                  <c:v>234</c:v>
                </c:pt>
                <c:pt idx="469">
                  <c:v>234.5</c:v>
                </c:pt>
                <c:pt idx="470">
                  <c:v>235</c:v>
                </c:pt>
                <c:pt idx="471">
                  <c:v>235.5</c:v>
                </c:pt>
                <c:pt idx="472">
                  <c:v>236</c:v>
                </c:pt>
                <c:pt idx="473">
                  <c:v>236.5</c:v>
                </c:pt>
                <c:pt idx="474">
                  <c:v>237</c:v>
                </c:pt>
                <c:pt idx="475">
                  <c:v>237.5</c:v>
                </c:pt>
                <c:pt idx="476">
                  <c:v>238</c:v>
                </c:pt>
                <c:pt idx="477">
                  <c:v>238.5</c:v>
                </c:pt>
                <c:pt idx="478">
                  <c:v>239</c:v>
                </c:pt>
                <c:pt idx="479">
                  <c:v>239.5</c:v>
                </c:pt>
                <c:pt idx="480">
                  <c:v>240</c:v>
                </c:pt>
                <c:pt idx="481">
                  <c:v>240.5</c:v>
                </c:pt>
                <c:pt idx="482">
                  <c:v>241</c:v>
                </c:pt>
                <c:pt idx="483">
                  <c:v>241.5</c:v>
                </c:pt>
                <c:pt idx="484">
                  <c:v>242</c:v>
                </c:pt>
                <c:pt idx="485">
                  <c:v>242.5</c:v>
                </c:pt>
                <c:pt idx="486">
                  <c:v>243</c:v>
                </c:pt>
                <c:pt idx="487">
                  <c:v>243.5</c:v>
                </c:pt>
                <c:pt idx="488">
                  <c:v>244</c:v>
                </c:pt>
                <c:pt idx="489">
                  <c:v>244.5</c:v>
                </c:pt>
                <c:pt idx="490">
                  <c:v>245</c:v>
                </c:pt>
                <c:pt idx="491">
                  <c:v>245.5</c:v>
                </c:pt>
                <c:pt idx="492">
                  <c:v>246</c:v>
                </c:pt>
                <c:pt idx="493">
                  <c:v>246.5</c:v>
                </c:pt>
                <c:pt idx="494">
                  <c:v>247</c:v>
                </c:pt>
                <c:pt idx="495">
                  <c:v>247.5</c:v>
                </c:pt>
                <c:pt idx="496">
                  <c:v>248</c:v>
                </c:pt>
                <c:pt idx="497">
                  <c:v>248.5</c:v>
                </c:pt>
                <c:pt idx="498">
                  <c:v>249</c:v>
                </c:pt>
                <c:pt idx="499">
                  <c:v>249.5</c:v>
                </c:pt>
                <c:pt idx="500">
                  <c:v>250</c:v>
                </c:pt>
                <c:pt idx="501">
                  <c:v>250.5</c:v>
                </c:pt>
                <c:pt idx="502">
                  <c:v>251</c:v>
                </c:pt>
                <c:pt idx="503">
                  <c:v>251.5</c:v>
                </c:pt>
                <c:pt idx="504">
                  <c:v>252</c:v>
                </c:pt>
                <c:pt idx="505">
                  <c:v>252.5</c:v>
                </c:pt>
                <c:pt idx="506">
                  <c:v>253</c:v>
                </c:pt>
                <c:pt idx="507">
                  <c:v>253.5</c:v>
                </c:pt>
                <c:pt idx="508">
                  <c:v>254</c:v>
                </c:pt>
                <c:pt idx="509">
                  <c:v>254.5</c:v>
                </c:pt>
                <c:pt idx="510">
                  <c:v>255</c:v>
                </c:pt>
                <c:pt idx="511">
                  <c:v>255.5</c:v>
                </c:pt>
                <c:pt idx="512">
                  <c:v>256</c:v>
                </c:pt>
                <c:pt idx="513">
                  <c:v>256.5</c:v>
                </c:pt>
                <c:pt idx="514">
                  <c:v>257</c:v>
                </c:pt>
                <c:pt idx="515">
                  <c:v>257.5</c:v>
                </c:pt>
                <c:pt idx="516">
                  <c:v>258</c:v>
                </c:pt>
                <c:pt idx="517">
                  <c:v>258.5</c:v>
                </c:pt>
                <c:pt idx="518">
                  <c:v>259</c:v>
                </c:pt>
                <c:pt idx="519">
                  <c:v>259.5</c:v>
                </c:pt>
                <c:pt idx="520">
                  <c:v>260</c:v>
                </c:pt>
                <c:pt idx="521">
                  <c:v>260.5</c:v>
                </c:pt>
                <c:pt idx="522">
                  <c:v>261</c:v>
                </c:pt>
                <c:pt idx="523">
                  <c:v>261.5</c:v>
                </c:pt>
                <c:pt idx="524">
                  <c:v>262</c:v>
                </c:pt>
                <c:pt idx="525">
                  <c:v>262.5</c:v>
                </c:pt>
                <c:pt idx="526">
                  <c:v>263</c:v>
                </c:pt>
                <c:pt idx="527">
                  <c:v>263.5</c:v>
                </c:pt>
                <c:pt idx="528">
                  <c:v>264</c:v>
                </c:pt>
                <c:pt idx="529">
                  <c:v>264.5</c:v>
                </c:pt>
                <c:pt idx="530">
                  <c:v>265</c:v>
                </c:pt>
                <c:pt idx="531">
                  <c:v>265.5</c:v>
                </c:pt>
                <c:pt idx="532">
                  <c:v>266</c:v>
                </c:pt>
                <c:pt idx="533">
                  <c:v>266.5</c:v>
                </c:pt>
                <c:pt idx="534">
                  <c:v>267</c:v>
                </c:pt>
                <c:pt idx="535">
                  <c:v>267.5</c:v>
                </c:pt>
                <c:pt idx="536">
                  <c:v>268</c:v>
                </c:pt>
                <c:pt idx="537">
                  <c:v>268.5</c:v>
                </c:pt>
                <c:pt idx="538">
                  <c:v>269</c:v>
                </c:pt>
                <c:pt idx="539">
                  <c:v>269.5</c:v>
                </c:pt>
                <c:pt idx="540">
                  <c:v>270</c:v>
                </c:pt>
                <c:pt idx="541">
                  <c:v>270.5</c:v>
                </c:pt>
                <c:pt idx="542">
                  <c:v>271</c:v>
                </c:pt>
                <c:pt idx="543">
                  <c:v>271.5</c:v>
                </c:pt>
                <c:pt idx="544">
                  <c:v>272</c:v>
                </c:pt>
                <c:pt idx="545">
                  <c:v>272.5</c:v>
                </c:pt>
                <c:pt idx="546">
                  <c:v>273</c:v>
                </c:pt>
                <c:pt idx="547">
                  <c:v>273.5</c:v>
                </c:pt>
                <c:pt idx="548">
                  <c:v>274</c:v>
                </c:pt>
                <c:pt idx="549">
                  <c:v>274.5</c:v>
                </c:pt>
                <c:pt idx="550">
                  <c:v>275</c:v>
                </c:pt>
                <c:pt idx="551">
                  <c:v>275.5</c:v>
                </c:pt>
                <c:pt idx="552">
                  <c:v>276</c:v>
                </c:pt>
                <c:pt idx="553">
                  <c:v>276.5</c:v>
                </c:pt>
                <c:pt idx="554">
                  <c:v>277</c:v>
                </c:pt>
                <c:pt idx="555">
                  <c:v>277.5</c:v>
                </c:pt>
                <c:pt idx="556">
                  <c:v>278</c:v>
                </c:pt>
                <c:pt idx="557">
                  <c:v>278.5</c:v>
                </c:pt>
                <c:pt idx="558">
                  <c:v>279</c:v>
                </c:pt>
                <c:pt idx="559">
                  <c:v>279.5</c:v>
                </c:pt>
                <c:pt idx="560">
                  <c:v>280</c:v>
                </c:pt>
                <c:pt idx="561">
                  <c:v>280.5</c:v>
                </c:pt>
                <c:pt idx="562">
                  <c:v>281</c:v>
                </c:pt>
                <c:pt idx="563">
                  <c:v>281.5</c:v>
                </c:pt>
                <c:pt idx="564">
                  <c:v>282</c:v>
                </c:pt>
                <c:pt idx="565">
                  <c:v>282.5</c:v>
                </c:pt>
                <c:pt idx="566">
                  <c:v>283</c:v>
                </c:pt>
                <c:pt idx="567">
                  <c:v>283.5</c:v>
                </c:pt>
                <c:pt idx="568">
                  <c:v>284</c:v>
                </c:pt>
                <c:pt idx="569">
                  <c:v>284.5</c:v>
                </c:pt>
                <c:pt idx="570">
                  <c:v>285</c:v>
                </c:pt>
                <c:pt idx="571">
                  <c:v>285.5</c:v>
                </c:pt>
                <c:pt idx="572">
                  <c:v>286</c:v>
                </c:pt>
                <c:pt idx="573">
                  <c:v>286.5</c:v>
                </c:pt>
                <c:pt idx="574">
                  <c:v>287</c:v>
                </c:pt>
                <c:pt idx="575">
                  <c:v>287.5</c:v>
                </c:pt>
                <c:pt idx="576">
                  <c:v>288</c:v>
                </c:pt>
                <c:pt idx="577">
                  <c:v>288.5</c:v>
                </c:pt>
                <c:pt idx="578">
                  <c:v>289</c:v>
                </c:pt>
                <c:pt idx="579">
                  <c:v>289.5</c:v>
                </c:pt>
                <c:pt idx="580">
                  <c:v>290</c:v>
                </c:pt>
                <c:pt idx="581">
                  <c:v>290.5</c:v>
                </c:pt>
                <c:pt idx="582">
                  <c:v>291</c:v>
                </c:pt>
                <c:pt idx="583">
                  <c:v>291.5</c:v>
                </c:pt>
                <c:pt idx="584">
                  <c:v>292</c:v>
                </c:pt>
                <c:pt idx="585">
                  <c:v>292.5</c:v>
                </c:pt>
                <c:pt idx="586">
                  <c:v>293</c:v>
                </c:pt>
                <c:pt idx="587">
                  <c:v>293.5</c:v>
                </c:pt>
                <c:pt idx="588">
                  <c:v>294</c:v>
                </c:pt>
                <c:pt idx="589">
                  <c:v>294.5</c:v>
                </c:pt>
                <c:pt idx="590">
                  <c:v>295</c:v>
                </c:pt>
                <c:pt idx="591">
                  <c:v>295.5</c:v>
                </c:pt>
                <c:pt idx="592">
                  <c:v>296</c:v>
                </c:pt>
                <c:pt idx="593">
                  <c:v>296.5</c:v>
                </c:pt>
                <c:pt idx="594">
                  <c:v>297</c:v>
                </c:pt>
                <c:pt idx="595">
                  <c:v>297.5</c:v>
                </c:pt>
                <c:pt idx="596">
                  <c:v>298</c:v>
                </c:pt>
                <c:pt idx="597">
                  <c:v>298.5</c:v>
                </c:pt>
                <c:pt idx="598">
                  <c:v>299</c:v>
                </c:pt>
                <c:pt idx="599">
                  <c:v>299.5</c:v>
                </c:pt>
                <c:pt idx="600">
                  <c:v>300</c:v>
                </c:pt>
                <c:pt idx="601">
                  <c:v>300.5</c:v>
                </c:pt>
                <c:pt idx="602">
                  <c:v>301</c:v>
                </c:pt>
                <c:pt idx="603">
                  <c:v>301.5</c:v>
                </c:pt>
                <c:pt idx="604">
                  <c:v>302</c:v>
                </c:pt>
                <c:pt idx="605">
                  <c:v>302.5</c:v>
                </c:pt>
                <c:pt idx="606">
                  <c:v>303</c:v>
                </c:pt>
                <c:pt idx="607">
                  <c:v>303.5</c:v>
                </c:pt>
                <c:pt idx="608">
                  <c:v>304</c:v>
                </c:pt>
                <c:pt idx="609">
                  <c:v>304.5</c:v>
                </c:pt>
                <c:pt idx="610">
                  <c:v>305</c:v>
                </c:pt>
                <c:pt idx="611">
                  <c:v>305.5</c:v>
                </c:pt>
                <c:pt idx="612">
                  <c:v>306</c:v>
                </c:pt>
                <c:pt idx="613">
                  <c:v>306.5</c:v>
                </c:pt>
                <c:pt idx="614">
                  <c:v>307</c:v>
                </c:pt>
                <c:pt idx="615">
                  <c:v>307.5</c:v>
                </c:pt>
                <c:pt idx="616">
                  <c:v>308</c:v>
                </c:pt>
                <c:pt idx="617">
                  <c:v>308.5</c:v>
                </c:pt>
                <c:pt idx="618">
                  <c:v>309</c:v>
                </c:pt>
                <c:pt idx="619">
                  <c:v>309.5</c:v>
                </c:pt>
                <c:pt idx="620">
                  <c:v>310</c:v>
                </c:pt>
                <c:pt idx="621">
                  <c:v>310.5</c:v>
                </c:pt>
                <c:pt idx="622">
                  <c:v>311</c:v>
                </c:pt>
                <c:pt idx="623">
                  <c:v>311.5</c:v>
                </c:pt>
                <c:pt idx="624">
                  <c:v>312</c:v>
                </c:pt>
                <c:pt idx="625">
                  <c:v>312.5</c:v>
                </c:pt>
                <c:pt idx="626">
                  <c:v>313</c:v>
                </c:pt>
                <c:pt idx="627">
                  <c:v>313.5</c:v>
                </c:pt>
                <c:pt idx="628">
                  <c:v>314</c:v>
                </c:pt>
                <c:pt idx="629">
                  <c:v>314.5</c:v>
                </c:pt>
                <c:pt idx="630">
                  <c:v>315</c:v>
                </c:pt>
                <c:pt idx="631">
                  <c:v>315.5</c:v>
                </c:pt>
                <c:pt idx="632">
                  <c:v>316</c:v>
                </c:pt>
                <c:pt idx="633">
                  <c:v>316.5</c:v>
                </c:pt>
                <c:pt idx="634">
                  <c:v>317</c:v>
                </c:pt>
                <c:pt idx="635">
                  <c:v>317.5</c:v>
                </c:pt>
                <c:pt idx="636">
                  <c:v>318</c:v>
                </c:pt>
                <c:pt idx="637">
                  <c:v>318.5</c:v>
                </c:pt>
                <c:pt idx="638">
                  <c:v>319</c:v>
                </c:pt>
                <c:pt idx="639">
                  <c:v>319.5</c:v>
                </c:pt>
                <c:pt idx="640">
                  <c:v>320</c:v>
                </c:pt>
                <c:pt idx="641">
                  <c:v>320.5</c:v>
                </c:pt>
                <c:pt idx="642">
                  <c:v>321</c:v>
                </c:pt>
                <c:pt idx="643">
                  <c:v>321.5</c:v>
                </c:pt>
                <c:pt idx="644">
                  <c:v>322</c:v>
                </c:pt>
                <c:pt idx="645">
                  <c:v>322.5</c:v>
                </c:pt>
                <c:pt idx="646">
                  <c:v>323</c:v>
                </c:pt>
                <c:pt idx="647">
                  <c:v>323.5</c:v>
                </c:pt>
                <c:pt idx="648">
                  <c:v>324</c:v>
                </c:pt>
                <c:pt idx="649">
                  <c:v>324.5</c:v>
                </c:pt>
                <c:pt idx="650">
                  <c:v>325</c:v>
                </c:pt>
                <c:pt idx="651">
                  <c:v>325.5</c:v>
                </c:pt>
                <c:pt idx="652">
                  <c:v>326</c:v>
                </c:pt>
                <c:pt idx="653">
                  <c:v>326.5</c:v>
                </c:pt>
                <c:pt idx="654">
                  <c:v>327</c:v>
                </c:pt>
                <c:pt idx="655">
                  <c:v>327.5</c:v>
                </c:pt>
                <c:pt idx="656">
                  <c:v>328</c:v>
                </c:pt>
                <c:pt idx="657">
                  <c:v>328.5</c:v>
                </c:pt>
                <c:pt idx="658">
                  <c:v>329</c:v>
                </c:pt>
                <c:pt idx="659">
                  <c:v>329.5</c:v>
                </c:pt>
                <c:pt idx="660">
                  <c:v>330</c:v>
                </c:pt>
                <c:pt idx="661">
                  <c:v>330.5</c:v>
                </c:pt>
                <c:pt idx="662">
                  <c:v>331</c:v>
                </c:pt>
                <c:pt idx="663">
                  <c:v>331.5</c:v>
                </c:pt>
                <c:pt idx="664">
                  <c:v>332</c:v>
                </c:pt>
                <c:pt idx="665">
                  <c:v>332.5</c:v>
                </c:pt>
                <c:pt idx="666">
                  <c:v>333</c:v>
                </c:pt>
                <c:pt idx="667">
                  <c:v>333.5</c:v>
                </c:pt>
                <c:pt idx="668">
                  <c:v>334</c:v>
                </c:pt>
                <c:pt idx="669">
                  <c:v>334.5</c:v>
                </c:pt>
                <c:pt idx="670">
                  <c:v>335</c:v>
                </c:pt>
                <c:pt idx="671">
                  <c:v>335.5</c:v>
                </c:pt>
                <c:pt idx="672">
                  <c:v>336</c:v>
                </c:pt>
                <c:pt idx="673">
                  <c:v>336.5</c:v>
                </c:pt>
                <c:pt idx="674">
                  <c:v>337</c:v>
                </c:pt>
                <c:pt idx="675">
                  <c:v>337.5</c:v>
                </c:pt>
                <c:pt idx="676">
                  <c:v>338</c:v>
                </c:pt>
                <c:pt idx="677">
                  <c:v>338.5</c:v>
                </c:pt>
                <c:pt idx="678">
                  <c:v>339</c:v>
                </c:pt>
                <c:pt idx="679">
                  <c:v>339.5</c:v>
                </c:pt>
                <c:pt idx="680">
                  <c:v>340</c:v>
                </c:pt>
                <c:pt idx="681">
                  <c:v>340.5</c:v>
                </c:pt>
                <c:pt idx="682">
                  <c:v>341</c:v>
                </c:pt>
                <c:pt idx="683">
                  <c:v>341.5</c:v>
                </c:pt>
                <c:pt idx="684">
                  <c:v>342</c:v>
                </c:pt>
                <c:pt idx="685">
                  <c:v>342.5</c:v>
                </c:pt>
                <c:pt idx="686">
                  <c:v>343</c:v>
                </c:pt>
                <c:pt idx="687">
                  <c:v>343.5</c:v>
                </c:pt>
                <c:pt idx="688">
                  <c:v>344</c:v>
                </c:pt>
                <c:pt idx="689">
                  <c:v>344.5</c:v>
                </c:pt>
                <c:pt idx="690">
                  <c:v>345</c:v>
                </c:pt>
                <c:pt idx="691">
                  <c:v>345.5</c:v>
                </c:pt>
                <c:pt idx="692">
                  <c:v>346</c:v>
                </c:pt>
                <c:pt idx="693">
                  <c:v>346.5</c:v>
                </c:pt>
                <c:pt idx="694">
                  <c:v>347</c:v>
                </c:pt>
                <c:pt idx="695">
                  <c:v>347.5</c:v>
                </c:pt>
                <c:pt idx="696">
                  <c:v>348</c:v>
                </c:pt>
                <c:pt idx="697">
                  <c:v>348.5</c:v>
                </c:pt>
                <c:pt idx="698">
                  <c:v>349</c:v>
                </c:pt>
                <c:pt idx="699">
                  <c:v>349.5</c:v>
                </c:pt>
                <c:pt idx="700">
                  <c:v>350</c:v>
                </c:pt>
                <c:pt idx="701">
                  <c:v>350.5</c:v>
                </c:pt>
                <c:pt idx="702">
                  <c:v>351</c:v>
                </c:pt>
                <c:pt idx="703">
                  <c:v>351.5</c:v>
                </c:pt>
                <c:pt idx="704">
                  <c:v>352</c:v>
                </c:pt>
                <c:pt idx="705">
                  <c:v>352.5</c:v>
                </c:pt>
                <c:pt idx="706">
                  <c:v>353</c:v>
                </c:pt>
                <c:pt idx="707">
                  <c:v>353.5</c:v>
                </c:pt>
                <c:pt idx="708">
                  <c:v>354</c:v>
                </c:pt>
                <c:pt idx="709">
                  <c:v>354.5</c:v>
                </c:pt>
                <c:pt idx="710">
                  <c:v>355</c:v>
                </c:pt>
                <c:pt idx="711">
                  <c:v>355.5</c:v>
                </c:pt>
                <c:pt idx="712">
                  <c:v>356</c:v>
                </c:pt>
                <c:pt idx="713">
                  <c:v>356.5</c:v>
                </c:pt>
                <c:pt idx="714">
                  <c:v>357</c:v>
                </c:pt>
                <c:pt idx="715">
                  <c:v>357.5</c:v>
                </c:pt>
                <c:pt idx="716">
                  <c:v>358</c:v>
                </c:pt>
                <c:pt idx="717">
                  <c:v>358.5</c:v>
                </c:pt>
                <c:pt idx="718">
                  <c:v>359</c:v>
                </c:pt>
                <c:pt idx="719">
                  <c:v>359.5</c:v>
                </c:pt>
                <c:pt idx="720">
                  <c:v>360</c:v>
                </c:pt>
                <c:pt idx="721">
                  <c:v>360.5</c:v>
                </c:pt>
                <c:pt idx="722">
                  <c:v>361</c:v>
                </c:pt>
                <c:pt idx="723">
                  <c:v>361.5</c:v>
                </c:pt>
                <c:pt idx="724">
                  <c:v>362</c:v>
                </c:pt>
                <c:pt idx="725">
                  <c:v>362.5</c:v>
                </c:pt>
                <c:pt idx="726">
                  <c:v>363</c:v>
                </c:pt>
                <c:pt idx="727">
                  <c:v>363.5</c:v>
                </c:pt>
                <c:pt idx="728">
                  <c:v>364</c:v>
                </c:pt>
                <c:pt idx="729">
                  <c:v>364.5</c:v>
                </c:pt>
                <c:pt idx="730">
                  <c:v>365</c:v>
                </c:pt>
                <c:pt idx="731">
                  <c:v>365.5</c:v>
                </c:pt>
                <c:pt idx="732">
                  <c:v>366</c:v>
                </c:pt>
                <c:pt idx="733">
                  <c:v>366.5</c:v>
                </c:pt>
                <c:pt idx="734">
                  <c:v>367</c:v>
                </c:pt>
                <c:pt idx="735">
                  <c:v>367.5</c:v>
                </c:pt>
                <c:pt idx="736">
                  <c:v>368</c:v>
                </c:pt>
                <c:pt idx="737">
                  <c:v>368.5</c:v>
                </c:pt>
                <c:pt idx="738">
                  <c:v>369</c:v>
                </c:pt>
                <c:pt idx="739">
                  <c:v>369.5</c:v>
                </c:pt>
                <c:pt idx="740">
                  <c:v>370</c:v>
                </c:pt>
                <c:pt idx="741">
                  <c:v>370.5</c:v>
                </c:pt>
                <c:pt idx="742">
                  <c:v>371</c:v>
                </c:pt>
                <c:pt idx="743">
                  <c:v>371.5</c:v>
                </c:pt>
                <c:pt idx="744">
                  <c:v>372</c:v>
                </c:pt>
                <c:pt idx="745">
                  <c:v>372.5</c:v>
                </c:pt>
                <c:pt idx="746">
                  <c:v>373</c:v>
                </c:pt>
                <c:pt idx="747">
                  <c:v>373.5</c:v>
                </c:pt>
                <c:pt idx="748">
                  <c:v>374</c:v>
                </c:pt>
                <c:pt idx="749">
                  <c:v>374.5</c:v>
                </c:pt>
                <c:pt idx="750">
                  <c:v>375</c:v>
                </c:pt>
                <c:pt idx="751">
                  <c:v>375.5</c:v>
                </c:pt>
                <c:pt idx="752">
                  <c:v>376</c:v>
                </c:pt>
                <c:pt idx="753">
                  <c:v>376.5</c:v>
                </c:pt>
                <c:pt idx="754">
                  <c:v>377</c:v>
                </c:pt>
                <c:pt idx="755">
                  <c:v>377.5</c:v>
                </c:pt>
                <c:pt idx="756">
                  <c:v>378</c:v>
                </c:pt>
                <c:pt idx="757">
                  <c:v>378.5</c:v>
                </c:pt>
                <c:pt idx="758">
                  <c:v>379</c:v>
                </c:pt>
                <c:pt idx="759">
                  <c:v>379.5</c:v>
                </c:pt>
                <c:pt idx="760">
                  <c:v>380</c:v>
                </c:pt>
                <c:pt idx="761">
                  <c:v>380.5</c:v>
                </c:pt>
                <c:pt idx="762">
                  <c:v>381</c:v>
                </c:pt>
                <c:pt idx="763">
                  <c:v>381.5</c:v>
                </c:pt>
                <c:pt idx="764">
                  <c:v>382</c:v>
                </c:pt>
                <c:pt idx="765">
                  <c:v>382.5</c:v>
                </c:pt>
                <c:pt idx="766">
                  <c:v>383</c:v>
                </c:pt>
                <c:pt idx="767">
                  <c:v>383.5</c:v>
                </c:pt>
                <c:pt idx="768">
                  <c:v>384</c:v>
                </c:pt>
                <c:pt idx="769">
                  <c:v>384.5</c:v>
                </c:pt>
                <c:pt idx="770">
                  <c:v>385</c:v>
                </c:pt>
                <c:pt idx="771">
                  <c:v>385.5</c:v>
                </c:pt>
                <c:pt idx="772">
                  <c:v>386</c:v>
                </c:pt>
                <c:pt idx="773">
                  <c:v>386.5</c:v>
                </c:pt>
                <c:pt idx="774">
                  <c:v>387</c:v>
                </c:pt>
                <c:pt idx="775">
                  <c:v>387.5</c:v>
                </c:pt>
                <c:pt idx="776">
                  <c:v>388</c:v>
                </c:pt>
                <c:pt idx="777">
                  <c:v>388.5</c:v>
                </c:pt>
                <c:pt idx="778">
                  <c:v>389</c:v>
                </c:pt>
                <c:pt idx="779">
                  <c:v>389.5</c:v>
                </c:pt>
                <c:pt idx="780">
                  <c:v>390</c:v>
                </c:pt>
                <c:pt idx="781">
                  <c:v>390.5</c:v>
                </c:pt>
                <c:pt idx="782">
                  <c:v>391</c:v>
                </c:pt>
                <c:pt idx="783">
                  <c:v>391.5</c:v>
                </c:pt>
                <c:pt idx="784">
                  <c:v>392</c:v>
                </c:pt>
                <c:pt idx="785">
                  <c:v>392.5</c:v>
                </c:pt>
                <c:pt idx="786">
                  <c:v>393</c:v>
                </c:pt>
                <c:pt idx="787">
                  <c:v>393.5</c:v>
                </c:pt>
                <c:pt idx="788">
                  <c:v>394</c:v>
                </c:pt>
                <c:pt idx="789">
                  <c:v>394.5</c:v>
                </c:pt>
                <c:pt idx="790">
                  <c:v>395</c:v>
                </c:pt>
                <c:pt idx="791">
                  <c:v>395.5</c:v>
                </c:pt>
                <c:pt idx="792">
                  <c:v>396</c:v>
                </c:pt>
                <c:pt idx="793">
                  <c:v>396.5</c:v>
                </c:pt>
                <c:pt idx="794">
                  <c:v>397</c:v>
                </c:pt>
                <c:pt idx="795">
                  <c:v>397.5</c:v>
                </c:pt>
                <c:pt idx="796">
                  <c:v>398</c:v>
                </c:pt>
                <c:pt idx="797">
                  <c:v>398.5</c:v>
                </c:pt>
                <c:pt idx="798">
                  <c:v>399</c:v>
                </c:pt>
                <c:pt idx="799">
                  <c:v>399.5</c:v>
                </c:pt>
                <c:pt idx="800">
                  <c:v>400</c:v>
                </c:pt>
                <c:pt idx="801">
                  <c:v>400.5</c:v>
                </c:pt>
                <c:pt idx="802">
                  <c:v>401</c:v>
                </c:pt>
                <c:pt idx="803">
                  <c:v>401.5</c:v>
                </c:pt>
                <c:pt idx="804">
                  <c:v>402</c:v>
                </c:pt>
                <c:pt idx="805">
                  <c:v>402.5</c:v>
                </c:pt>
                <c:pt idx="806">
                  <c:v>403</c:v>
                </c:pt>
                <c:pt idx="807">
                  <c:v>403.5</c:v>
                </c:pt>
                <c:pt idx="808">
                  <c:v>404</c:v>
                </c:pt>
                <c:pt idx="809">
                  <c:v>404.5</c:v>
                </c:pt>
                <c:pt idx="810">
                  <c:v>405</c:v>
                </c:pt>
                <c:pt idx="811">
                  <c:v>405.5</c:v>
                </c:pt>
                <c:pt idx="812">
                  <c:v>406</c:v>
                </c:pt>
                <c:pt idx="813">
                  <c:v>406.5</c:v>
                </c:pt>
                <c:pt idx="814">
                  <c:v>407</c:v>
                </c:pt>
                <c:pt idx="815">
                  <c:v>407.5</c:v>
                </c:pt>
                <c:pt idx="816">
                  <c:v>408</c:v>
                </c:pt>
                <c:pt idx="817">
                  <c:v>408.5</c:v>
                </c:pt>
                <c:pt idx="818">
                  <c:v>409</c:v>
                </c:pt>
                <c:pt idx="819">
                  <c:v>409.5</c:v>
                </c:pt>
                <c:pt idx="820">
                  <c:v>410</c:v>
                </c:pt>
                <c:pt idx="821">
                  <c:v>410.5</c:v>
                </c:pt>
                <c:pt idx="822">
                  <c:v>411</c:v>
                </c:pt>
                <c:pt idx="823">
                  <c:v>411.5</c:v>
                </c:pt>
                <c:pt idx="824">
                  <c:v>412</c:v>
                </c:pt>
                <c:pt idx="825">
                  <c:v>412.5</c:v>
                </c:pt>
                <c:pt idx="826">
                  <c:v>413</c:v>
                </c:pt>
                <c:pt idx="827">
                  <c:v>413.5</c:v>
                </c:pt>
                <c:pt idx="828">
                  <c:v>414</c:v>
                </c:pt>
                <c:pt idx="829">
                  <c:v>414.5</c:v>
                </c:pt>
                <c:pt idx="830">
                  <c:v>415</c:v>
                </c:pt>
                <c:pt idx="831">
                  <c:v>415.5</c:v>
                </c:pt>
                <c:pt idx="832">
                  <c:v>416</c:v>
                </c:pt>
                <c:pt idx="833">
                  <c:v>416.5</c:v>
                </c:pt>
                <c:pt idx="834">
                  <c:v>417</c:v>
                </c:pt>
                <c:pt idx="835">
                  <c:v>417.5</c:v>
                </c:pt>
                <c:pt idx="836">
                  <c:v>418</c:v>
                </c:pt>
                <c:pt idx="837">
                  <c:v>418.5</c:v>
                </c:pt>
                <c:pt idx="838">
                  <c:v>419</c:v>
                </c:pt>
                <c:pt idx="839">
                  <c:v>419.5</c:v>
                </c:pt>
                <c:pt idx="840">
                  <c:v>420</c:v>
                </c:pt>
                <c:pt idx="841">
                  <c:v>420.5</c:v>
                </c:pt>
                <c:pt idx="842">
                  <c:v>421</c:v>
                </c:pt>
                <c:pt idx="843">
                  <c:v>421.5</c:v>
                </c:pt>
                <c:pt idx="844">
                  <c:v>422</c:v>
                </c:pt>
                <c:pt idx="845">
                  <c:v>422.5</c:v>
                </c:pt>
                <c:pt idx="846">
                  <c:v>423</c:v>
                </c:pt>
                <c:pt idx="847">
                  <c:v>423.5</c:v>
                </c:pt>
                <c:pt idx="848">
                  <c:v>424</c:v>
                </c:pt>
                <c:pt idx="849">
                  <c:v>424.5</c:v>
                </c:pt>
                <c:pt idx="850">
                  <c:v>425</c:v>
                </c:pt>
                <c:pt idx="851">
                  <c:v>425.5</c:v>
                </c:pt>
                <c:pt idx="852">
                  <c:v>426</c:v>
                </c:pt>
                <c:pt idx="853">
                  <c:v>426.5</c:v>
                </c:pt>
                <c:pt idx="854">
                  <c:v>427</c:v>
                </c:pt>
                <c:pt idx="855">
                  <c:v>427.5</c:v>
                </c:pt>
                <c:pt idx="856">
                  <c:v>428</c:v>
                </c:pt>
                <c:pt idx="857">
                  <c:v>428.5</c:v>
                </c:pt>
                <c:pt idx="858">
                  <c:v>429</c:v>
                </c:pt>
                <c:pt idx="859">
                  <c:v>429.5</c:v>
                </c:pt>
                <c:pt idx="860">
                  <c:v>430</c:v>
                </c:pt>
                <c:pt idx="861">
                  <c:v>430.5</c:v>
                </c:pt>
                <c:pt idx="862">
                  <c:v>431</c:v>
                </c:pt>
                <c:pt idx="863">
                  <c:v>431.5</c:v>
                </c:pt>
                <c:pt idx="864">
                  <c:v>432</c:v>
                </c:pt>
                <c:pt idx="865">
                  <c:v>432.5</c:v>
                </c:pt>
                <c:pt idx="866">
                  <c:v>433</c:v>
                </c:pt>
                <c:pt idx="867">
                  <c:v>433.5</c:v>
                </c:pt>
                <c:pt idx="868">
                  <c:v>434</c:v>
                </c:pt>
                <c:pt idx="869">
                  <c:v>434.5</c:v>
                </c:pt>
                <c:pt idx="870">
                  <c:v>435</c:v>
                </c:pt>
                <c:pt idx="871">
                  <c:v>435.5</c:v>
                </c:pt>
                <c:pt idx="872">
                  <c:v>436</c:v>
                </c:pt>
                <c:pt idx="873">
                  <c:v>436.5</c:v>
                </c:pt>
                <c:pt idx="874">
                  <c:v>437</c:v>
                </c:pt>
                <c:pt idx="875">
                  <c:v>437.5</c:v>
                </c:pt>
                <c:pt idx="876">
                  <c:v>438</c:v>
                </c:pt>
                <c:pt idx="877">
                  <c:v>438.5</c:v>
                </c:pt>
                <c:pt idx="878">
                  <c:v>439</c:v>
                </c:pt>
                <c:pt idx="879">
                  <c:v>439.5</c:v>
                </c:pt>
                <c:pt idx="880">
                  <c:v>440</c:v>
                </c:pt>
                <c:pt idx="881">
                  <c:v>440.5</c:v>
                </c:pt>
                <c:pt idx="882">
                  <c:v>441</c:v>
                </c:pt>
                <c:pt idx="883">
                  <c:v>441.5</c:v>
                </c:pt>
                <c:pt idx="884">
                  <c:v>442</c:v>
                </c:pt>
                <c:pt idx="885">
                  <c:v>442.5</c:v>
                </c:pt>
                <c:pt idx="886">
                  <c:v>443</c:v>
                </c:pt>
                <c:pt idx="887">
                  <c:v>443.5</c:v>
                </c:pt>
                <c:pt idx="888">
                  <c:v>444</c:v>
                </c:pt>
                <c:pt idx="889">
                  <c:v>444.5</c:v>
                </c:pt>
                <c:pt idx="890">
                  <c:v>445</c:v>
                </c:pt>
                <c:pt idx="891">
                  <c:v>445.5</c:v>
                </c:pt>
                <c:pt idx="892">
                  <c:v>446</c:v>
                </c:pt>
                <c:pt idx="893">
                  <c:v>446.5</c:v>
                </c:pt>
                <c:pt idx="894">
                  <c:v>447</c:v>
                </c:pt>
                <c:pt idx="895">
                  <c:v>447.5</c:v>
                </c:pt>
                <c:pt idx="896">
                  <c:v>448</c:v>
                </c:pt>
                <c:pt idx="897">
                  <c:v>448.5</c:v>
                </c:pt>
                <c:pt idx="898">
                  <c:v>449</c:v>
                </c:pt>
                <c:pt idx="899">
                  <c:v>449.5</c:v>
                </c:pt>
                <c:pt idx="900">
                  <c:v>450</c:v>
                </c:pt>
                <c:pt idx="901">
                  <c:v>450.5</c:v>
                </c:pt>
                <c:pt idx="902">
                  <c:v>451</c:v>
                </c:pt>
                <c:pt idx="903">
                  <c:v>451.5</c:v>
                </c:pt>
                <c:pt idx="904">
                  <c:v>452</c:v>
                </c:pt>
                <c:pt idx="905">
                  <c:v>452.5</c:v>
                </c:pt>
                <c:pt idx="906">
                  <c:v>453</c:v>
                </c:pt>
                <c:pt idx="907">
                  <c:v>453.5</c:v>
                </c:pt>
                <c:pt idx="908">
                  <c:v>454</c:v>
                </c:pt>
                <c:pt idx="909">
                  <c:v>454.5</c:v>
                </c:pt>
                <c:pt idx="910">
                  <c:v>455</c:v>
                </c:pt>
                <c:pt idx="911">
                  <c:v>455.5</c:v>
                </c:pt>
                <c:pt idx="912">
                  <c:v>456</c:v>
                </c:pt>
                <c:pt idx="913">
                  <c:v>456.5</c:v>
                </c:pt>
                <c:pt idx="914">
                  <c:v>457</c:v>
                </c:pt>
                <c:pt idx="915">
                  <c:v>457.5</c:v>
                </c:pt>
                <c:pt idx="916">
                  <c:v>458</c:v>
                </c:pt>
                <c:pt idx="917">
                  <c:v>458.5</c:v>
                </c:pt>
                <c:pt idx="918">
                  <c:v>459</c:v>
                </c:pt>
                <c:pt idx="919">
                  <c:v>459.5</c:v>
                </c:pt>
                <c:pt idx="920">
                  <c:v>460</c:v>
                </c:pt>
                <c:pt idx="921">
                  <c:v>460.5</c:v>
                </c:pt>
                <c:pt idx="922">
                  <c:v>461</c:v>
                </c:pt>
                <c:pt idx="923">
                  <c:v>461.5</c:v>
                </c:pt>
                <c:pt idx="924">
                  <c:v>462</c:v>
                </c:pt>
                <c:pt idx="925">
                  <c:v>462.5</c:v>
                </c:pt>
                <c:pt idx="926">
                  <c:v>463</c:v>
                </c:pt>
                <c:pt idx="927">
                  <c:v>463.5</c:v>
                </c:pt>
                <c:pt idx="928">
                  <c:v>464</c:v>
                </c:pt>
                <c:pt idx="929">
                  <c:v>464.5</c:v>
                </c:pt>
                <c:pt idx="930">
                  <c:v>465</c:v>
                </c:pt>
                <c:pt idx="931">
                  <c:v>465.5</c:v>
                </c:pt>
                <c:pt idx="932">
                  <c:v>466</c:v>
                </c:pt>
                <c:pt idx="933">
                  <c:v>466.5</c:v>
                </c:pt>
                <c:pt idx="934">
                  <c:v>467</c:v>
                </c:pt>
                <c:pt idx="935">
                  <c:v>467.5</c:v>
                </c:pt>
                <c:pt idx="936">
                  <c:v>468</c:v>
                </c:pt>
                <c:pt idx="937">
                  <c:v>468.5</c:v>
                </c:pt>
                <c:pt idx="938">
                  <c:v>469</c:v>
                </c:pt>
                <c:pt idx="939">
                  <c:v>469.5</c:v>
                </c:pt>
                <c:pt idx="940">
                  <c:v>470</c:v>
                </c:pt>
                <c:pt idx="941">
                  <c:v>470.5</c:v>
                </c:pt>
                <c:pt idx="942">
                  <c:v>471</c:v>
                </c:pt>
                <c:pt idx="943">
                  <c:v>471.5</c:v>
                </c:pt>
                <c:pt idx="944">
                  <c:v>472</c:v>
                </c:pt>
                <c:pt idx="945">
                  <c:v>472.5</c:v>
                </c:pt>
                <c:pt idx="946">
                  <c:v>473</c:v>
                </c:pt>
                <c:pt idx="947">
                  <c:v>473.5</c:v>
                </c:pt>
                <c:pt idx="948">
                  <c:v>474</c:v>
                </c:pt>
                <c:pt idx="949">
                  <c:v>474.5</c:v>
                </c:pt>
                <c:pt idx="950">
                  <c:v>475</c:v>
                </c:pt>
                <c:pt idx="951">
                  <c:v>475.5</c:v>
                </c:pt>
                <c:pt idx="952">
                  <c:v>476</c:v>
                </c:pt>
                <c:pt idx="953">
                  <c:v>476.5</c:v>
                </c:pt>
                <c:pt idx="954">
                  <c:v>477</c:v>
                </c:pt>
                <c:pt idx="955">
                  <c:v>477.5</c:v>
                </c:pt>
                <c:pt idx="956">
                  <c:v>478</c:v>
                </c:pt>
                <c:pt idx="957">
                  <c:v>478.5</c:v>
                </c:pt>
                <c:pt idx="958">
                  <c:v>479</c:v>
                </c:pt>
                <c:pt idx="959">
                  <c:v>479.5</c:v>
                </c:pt>
                <c:pt idx="960">
                  <c:v>480</c:v>
                </c:pt>
                <c:pt idx="961">
                  <c:v>480.5</c:v>
                </c:pt>
                <c:pt idx="962">
                  <c:v>481</c:v>
                </c:pt>
                <c:pt idx="963">
                  <c:v>481.5</c:v>
                </c:pt>
                <c:pt idx="964">
                  <c:v>482</c:v>
                </c:pt>
                <c:pt idx="965">
                  <c:v>482.5</c:v>
                </c:pt>
                <c:pt idx="966">
                  <c:v>483</c:v>
                </c:pt>
                <c:pt idx="967">
                  <c:v>483.5</c:v>
                </c:pt>
                <c:pt idx="968">
                  <c:v>484</c:v>
                </c:pt>
                <c:pt idx="969">
                  <c:v>484.5</c:v>
                </c:pt>
                <c:pt idx="970">
                  <c:v>485</c:v>
                </c:pt>
                <c:pt idx="971">
                  <c:v>485.5</c:v>
                </c:pt>
                <c:pt idx="972">
                  <c:v>486</c:v>
                </c:pt>
                <c:pt idx="973">
                  <c:v>486.5</c:v>
                </c:pt>
                <c:pt idx="974">
                  <c:v>487</c:v>
                </c:pt>
                <c:pt idx="975">
                  <c:v>487.5</c:v>
                </c:pt>
                <c:pt idx="976">
                  <c:v>488</c:v>
                </c:pt>
                <c:pt idx="977">
                  <c:v>488.5</c:v>
                </c:pt>
                <c:pt idx="978">
                  <c:v>489</c:v>
                </c:pt>
                <c:pt idx="979">
                  <c:v>489.5</c:v>
                </c:pt>
                <c:pt idx="980">
                  <c:v>490</c:v>
                </c:pt>
                <c:pt idx="981">
                  <c:v>490.5</c:v>
                </c:pt>
                <c:pt idx="982">
                  <c:v>491</c:v>
                </c:pt>
                <c:pt idx="983">
                  <c:v>491.5</c:v>
                </c:pt>
                <c:pt idx="984">
                  <c:v>492</c:v>
                </c:pt>
                <c:pt idx="985">
                  <c:v>492.5</c:v>
                </c:pt>
                <c:pt idx="986">
                  <c:v>493</c:v>
                </c:pt>
                <c:pt idx="987">
                  <c:v>493.5</c:v>
                </c:pt>
                <c:pt idx="988">
                  <c:v>494</c:v>
                </c:pt>
                <c:pt idx="989">
                  <c:v>494.5</c:v>
                </c:pt>
                <c:pt idx="990">
                  <c:v>495</c:v>
                </c:pt>
                <c:pt idx="991">
                  <c:v>495.5</c:v>
                </c:pt>
                <c:pt idx="992">
                  <c:v>496</c:v>
                </c:pt>
                <c:pt idx="993">
                  <c:v>496.5</c:v>
                </c:pt>
                <c:pt idx="994">
                  <c:v>497</c:v>
                </c:pt>
                <c:pt idx="995">
                  <c:v>497.5</c:v>
                </c:pt>
                <c:pt idx="996">
                  <c:v>498</c:v>
                </c:pt>
                <c:pt idx="997">
                  <c:v>498.5</c:v>
                </c:pt>
                <c:pt idx="998">
                  <c:v>499</c:v>
                </c:pt>
                <c:pt idx="999">
                  <c:v>499.5</c:v>
                </c:pt>
                <c:pt idx="1000">
                  <c:v>500</c:v>
                </c:pt>
                <c:pt idx="1001">
                  <c:v>500.5</c:v>
                </c:pt>
                <c:pt idx="1002">
                  <c:v>501</c:v>
                </c:pt>
                <c:pt idx="1003">
                  <c:v>501.5</c:v>
                </c:pt>
                <c:pt idx="1004">
                  <c:v>502</c:v>
                </c:pt>
                <c:pt idx="1005">
                  <c:v>502.5</c:v>
                </c:pt>
                <c:pt idx="1006">
                  <c:v>503</c:v>
                </c:pt>
                <c:pt idx="1007">
                  <c:v>503.5</c:v>
                </c:pt>
                <c:pt idx="1008">
                  <c:v>504</c:v>
                </c:pt>
                <c:pt idx="1009">
                  <c:v>504.5</c:v>
                </c:pt>
                <c:pt idx="1010">
                  <c:v>505</c:v>
                </c:pt>
                <c:pt idx="1011">
                  <c:v>505.5</c:v>
                </c:pt>
                <c:pt idx="1012">
                  <c:v>506</c:v>
                </c:pt>
                <c:pt idx="1013">
                  <c:v>506.5</c:v>
                </c:pt>
                <c:pt idx="1014">
                  <c:v>507</c:v>
                </c:pt>
                <c:pt idx="1015">
                  <c:v>507.5</c:v>
                </c:pt>
                <c:pt idx="1016">
                  <c:v>508</c:v>
                </c:pt>
                <c:pt idx="1017">
                  <c:v>508.5</c:v>
                </c:pt>
                <c:pt idx="1018">
                  <c:v>509</c:v>
                </c:pt>
                <c:pt idx="1019">
                  <c:v>509.5</c:v>
                </c:pt>
                <c:pt idx="1020">
                  <c:v>510</c:v>
                </c:pt>
                <c:pt idx="1021">
                  <c:v>510.5</c:v>
                </c:pt>
                <c:pt idx="1022">
                  <c:v>511</c:v>
                </c:pt>
                <c:pt idx="1023">
                  <c:v>511.5</c:v>
                </c:pt>
                <c:pt idx="1024">
                  <c:v>512</c:v>
                </c:pt>
                <c:pt idx="1025">
                  <c:v>512.5</c:v>
                </c:pt>
                <c:pt idx="1026">
                  <c:v>513</c:v>
                </c:pt>
                <c:pt idx="1027">
                  <c:v>513.5</c:v>
                </c:pt>
                <c:pt idx="1028">
                  <c:v>514</c:v>
                </c:pt>
                <c:pt idx="1029">
                  <c:v>514.5</c:v>
                </c:pt>
                <c:pt idx="1030">
                  <c:v>515</c:v>
                </c:pt>
                <c:pt idx="1031">
                  <c:v>515.5</c:v>
                </c:pt>
                <c:pt idx="1032">
                  <c:v>516</c:v>
                </c:pt>
                <c:pt idx="1033">
                  <c:v>516.5</c:v>
                </c:pt>
                <c:pt idx="1034">
                  <c:v>517</c:v>
                </c:pt>
                <c:pt idx="1035">
                  <c:v>517.5</c:v>
                </c:pt>
                <c:pt idx="1036">
                  <c:v>518</c:v>
                </c:pt>
                <c:pt idx="1037">
                  <c:v>518.5</c:v>
                </c:pt>
                <c:pt idx="1038">
                  <c:v>519</c:v>
                </c:pt>
                <c:pt idx="1039">
                  <c:v>519.5</c:v>
                </c:pt>
                <c:pt idx="1040">
                  <c:v>520</c:v>
                </c:pt>
                <c:pt idx="1041">
                  <c:v>520.5</c:v>
                </c:pt>
                <c:pt idx="1042">
                  <c:v>521</c:v>
                </c:pt>
                <c:pt idx="1043">
                  <c:v>521.5</c:v>
                </c:pt>
                <c:pt idx="1044">
                  <c:v>522</c:v>
                </c:pt>
                <c:pt idx="1045">
                  <c:v>522.5</c:v>
                </c:pt>
                <c:pt idx="1046">
                  <c:v>523</c:v>
                </c:pt>
                <c:pt idx="1047">
                  <c:v>523.5</c:v>
                </c:pt>
                <c:pt idx="1048">
                  <c:v>524</c:v>
                </c:pt>
                <c:pt idx="1049">
                  <c:v>524.5</c:v>
                </c:pt>
                <c:pt idx="1050">
                  <c:v>525</c:v>
                </c:pt>
                <c:pt idx="1051">
                  <c:v>525.5</c:v>
                </c:pt>
                <c:pt idx="1052">
                  <c:v>526</c:v>
                </c:pt>
                <c:pt idx="1053">
                  <c:v>526.5</c:v>
                </c:pt>
                <c:pt idx="1054">
                  <c:v>527</c:v>
                </c:pt>
                <c:pt idx="1055">
                  <c:v>527.5</c:v>
                </c:pt>
                <c:pt idx="1056">
                  <c:v>528</c:v>
                </c:pt>
                <c:pt idx="1057">
                  <c:v>528.5</c:v>
                </c:pt>
                <c:pt idx="1058">
                  <c:v>529</c:v>
                </c:pt>
                <c:pt idx="1059">
                  <c:v>529.5</c:v>
                </c:pt>
                <c:pt idx="1060">
                  <c:v>530</c:v>
                </c:pt>
                <c:pt idx="1061">
                  <c:v>530.5</c:v>
                </c:pt>
                <c:pt idx="1062">
                  <c:v>531</c:v>
                </c:pt>
                <c:pt idx="1063">
                  <c:v>531.5</c:v>
                </c:pt>
                <c:pt idx="1064">
                  <c:v>532</c:v>
                </c:pt>
                <c:pt idx="1065">
                  <c:v>532.5</c:v>
                </c:pt>
                <c:pt idx="1066">
                  <c:v>533</c:v>
                </c:pt>
                <c:pt idx="1067">
                  <c:v>533.5</c:v>
                </c:pt>
                <c:pt idx="1068">
                  <c:v>534</c:v>
                </c:pt>
                <c:pt idx="1069">
                  <c:v>534.5</c:v>
                </c:pt>
                <c:pt idx="1070">
                  <c:v>535</c:v>
                </c:pt>
                <c:pt idx="1071">
                  <c:v>535.5</c:v>
                </c:pt>
                <c:pt idx="1072">
                  <c:v>536</c:v>
                </c:pt>
                <c:pt idx="1073">
                  <c:v>536.5</c:v>
                </c:pt>
                <c:pt idx="1074">
                  <c:v>537</c:v>
                </c:pt>
                <c:pt idx="1075">
                  <c:v>537.5</c:v>
                </c:pt>
                <c:pt idx="1076">
                  <c:v>538</c:v>
                </c:pt>
                <c:pt idx="1077">
                  <c:v>538.5</c:v>
                </c:pt>
                <c:pt idx="1078">
                  <c:v>539</c:v>
                </c:pt>
                <c:pt idx="1079">
                  <c:v>539.5</c:v>
                </c:pt>
                <c:pt idx="1080">
                  <c:v>540</c:v>
                </c:pt>
                <c:pt idx="1081">
                  <c:v>540.5</c:v>
                </c:pt>
                <c:pt idx="1082">
                  <c:v>541</c:v>
                </c:pt>
                <c:pt idx="1083">
                  <c:v>541.5</c:v>
                </c:pt>
                <c:pt idx="1084">
                  <c:v>542</c:v>
                </c:pt>
                <c:pt idx="1085">
                  <c:v>542.5</c:v>
                </c:pt>
                <c:pt idx="1086">
                  <c:v>543</c:v>
                </c:pt>
                <c:pt idx="1087">
                  <c:v>543.5</c:v>
                </c:pt>
                <c:pt idx="1088">
                  <c:v>544</c:v>
                </c:pt>
                <c:pt idx="1089">
                  <c:v>544.5</c:v>
                </c:pt>
                <c:pt idx="1090">
                  <c:v>545</c:v>
                </c:pt>
                <c:pt idx="1091">
                  <c:v>545.5</c:v>
                </c:pt>
                <c:pt idx="1092">
                  <c:v>546</c:v>
                </c:pt>
                <c:pt idx="1093">
                  <c:v>546.5</c:v>
                </c:pt>
                <c:pt idx="1094">
                  <c:v>547</c:v>
                </c:pt>
                <c:pt idx="1095">
                  <c:v>547.5</c:v>
                </c:pt>
                <c:pt idx="1096">
                  <c:v>548</c:v>
                </c:pt>
                <c:pt idx="1097">
                  <c:v>548.5</c:v>
                </c:pt>
                <c:pt idx="1098">
                  <c:v>549</c:v>
                </c:pt>
                <c:pt idx="1099">
                  <c:v>549.5</c:v>
                </c:pt>
                <c:pt idx="1100">
                  <c:v>550</c:v>
                </c:pt>
                <c:pt idx="1101">
                  <c:v>550.5</c:v>
                </c:pt>
                <c:pt idx="1102">
                  <c:v>551</c:v>
                </c:pt>
                <c:pt idx="1103">
                  <c:v>551.5</c:v>
                </c:pt>
                <c:pt idx="1104">
                  <c:v>552</c:v>
                </c:pt>
                <c:pt idx="1105">
                  <c:v>552.5</c:v>
                </c:pt>
                <c:pt idx="1106">
                  <c:v>553</c:v>
                </c:pt>
                <c:pt idx="1107">
                  <c:v>553.5</c:v>
                </c:pt>
                <c:pt idx="1108">
                  <c:v>554</c:v>
                </c:pt>
                <c:pt idx="1109">
                  <c:v>554.5</c:v>
                </c:pt>
                <c:pt idx="1110">
                  <c:v>555</c:v>
                </c:pt>
                <c:pt idx="1111">
                  <c:v>555.5</c:v>
                </c:pt>
                <c:pt idx="1112">
                  <c:v>556</c:v>
                </c:pt>
                <c:pt idx="1113">
                  <c:v>556.5</c:v>
                </c:pt>
                <c:pt idx="1114">
                  <c:v>557</c:v>
                </c:pt>
                <c:pt idx="1115">
                  <c:v>557.5</c:v>
                </c:pt>
                <c:pt idx="1116">
                  <c:v>558</c:v>
                </c:pt>
                <c:pt idx="1117">
                  <c:v>558.5</c:v>
                </c:pt>
                <c:pt idx="1118">
                  <c:v>559</c:v>
                </c:pt>
                <c:pt idx="1119">
                  <c:v>559.5</c:v>
                </c:pt>
                <c:pt idx="1120">
                  <c:v>560</c:v>
                </c:pt>
                <c:pt idx="1121">
                  <c:v>560.5</c:v>
                </c:pt>
                <c:pt idx="1122">
                  <c:v>561</c:v>
                </c:pt>
                <c:pt idx="1123">
                  <c:v>561.5</c:v>
                </c:pt>
                <c:pt idx="1124">
                  <c:v>562</c:v>
                </c:pt>
                <c:pt idx="1125">
                  <c:v>562.5</c:v>
                </c:pt>
                <c:pt idx="1126">
                  <c:v>563</c:v>
                </c:pt>
                <c:pt idx="1127">
                  <c:v>563.5</c:v>
                </c:pt>
                <c:pt idx="1128">
                  <c:v>564</c:v>
                </c:pt>
                <c:pt idx="1129">
                  <c:v>564.5</c:v>
                </c:pt>
                <c:pt idx="1130">
                  <c:v>565</c:v>
                </c:pt>
                <c:pt idx="1131">
                  <c:v>565.5</c:v>
                </c:pt>
                <c:pt idx="1132">
                  <c:v>566</c:v>
                </c:pt>
                <c:pt idx="1133">
                  <c:v>566.5</c:v>
                </c:pt>
                <c:pt idx="1134">
                  <c:v>567</c:v>
                </c:pt>
                <c:pt idx="1135">
                  <c:v>567.5</c:v>
                </c:pt>
                <c:pt idx="1136">
                  <c:v>568</c:v>
                </c:pt>
                <c:pt idx="1137">
                  <c:v>568.5</c:v>
                </c:pt>
                <c:pt idx="1138">
                  <c:v>569</c:v>
                </c:pt>
                <c:pt idx="1139">
                  <c:v>569.5</c:v>
                </c:pt>
                <c:pt idx="1140">
                  <c:v>570</c:v>
                </c:pt>
                <c:pt idx="1141">
                  <c:v>570.5</c:v>
                </c:pt>
                <c:pt idx="1142">
                  <c:v>571</c:v>
                </c:pt>
                <c:pt idx="1143">
                  <c:v>571.5</c:v>
                </c:pt>
                <c:pt idx="1144">
                  <c:v>572</c:v>
                </c:pt>
                <c:pt idx="1145">
                  <c:v>572.5</c:v>
                </c:pt>
                <c:pt idx="1146">
                  <c:v>573</c:v>
                </c:pt>
                <c:pt idx="1147">
                  <c:v>573.5</c:v>
                </c:pt>
                <c:pt idx="1148">
                  <c:v>574</c:v>
                </c:pt>
                <c:pt idx="1149">
                  <c:v>574.5</c:v>
                </c:pt>
                <c:pt idx="1150">
                  <c:v>575</c:v>
                </c:pt>
                <c:pt idx="1151">
                  <c:v>575.5</c:v>
                </c:pt>
                <c:pt idx="1152">
                  <c:v>576</c:v>
                </c:pt>
                <c:pt idx="1153">
                  <c:v>576.5</c:v>
                </c:pt>
                <c:pt idx="1154">
                  <c:v>577</c:v>
                </c:pt>
                <c:pt idx="1155">
                  <c:v>577.5</c:v>
                </c:pt>
                <c:pt idx="1156">
                  <c:v>578</c:v>
                </c:pt>
                <c:pt idx="1157">
                  <c:v>578.5</c:v>
                </c:pt>
                <c:pt idx="1158">
                  <c:v>579</c:v>
                </c:pt>
                <c:pt idx="1159">
                  <c:v>579.5</c:v>
                </c:pt>
                <c:pt idx="1160">
                  <c:v>580</c:v>
                </c:pt>
                <c:pt idx="1161">
                  <c:v>580.5</c:v>
                </c:pt>
                <c:pt idx="1162">
                  <c:v>581</c:v>
                </c:pt>
                <c:pt idx="1163">
                  <c:v>581.5</c:v>
                </c:pt>
                <c:pt idx="1164">
                  <c:v>582</c:v>
                </c:pt>
                <c:pt idx="1165">
                  <c:v>582.5</c:v>
                </c:pt>
                <c:pt idx="1166">
                  <c:v>583</c:v>
                </c:pt>
                <c:pt idx="1167">
                  <c:v>583.5</c:v>
                </c:pt>
                <c:pt idx="1168">
                  <c:v>584</c:v>
                </c:pt>
                <c:pt idx="1169">
                  <c:v>584.5</c:v>
                </c:pt>
                <c:pt idx="1170">
                  <c:v>585</c:v>
                </c:pt>
                <c:pt idx="1171">
                  <c:v>585.5</c:v>
                </c:pt>
                <c:pt idx="1172">
                  <c:v>586</c:v>
                </c:pt>
                <c:pt idx="1173">
                  <c:v>586.5</c:v>
                </c:pt>
                <c:pt idx="1174">
                  <c:v>587</c:v>
                </c:pt>
                <c:pt idx="1175">
                  <c:v>587.5</c:v>
                </c:pt>
                <c:pt idx="1176">
                  <c:v>588</c:v>
                </c:pt>
                <c:pt idx="1177">
                  <c:v>588.5</c:v>
                </c:pt>
                <c:pt idx="1178">
                  <c:v>589</c:v>
                </c:pt>
                <c:pt idx="1179">
                  <c:v>589.5</c:v>
                </c:pt>
                <c:pt idx="1180">
                  <c:v>590</c:v>
                </c:pt>
                <c:pt idx="1181">
                  <c:v>590.5</c:v>
                </c:pt>
                <c:pt idx="1182">
                  <c:v>591</c:v>
                </c:pt>
                <c:pt idx="1183">
                  <c:v>591.5</c:v>
                </c:pt>
                <c:pt idx="1184">
                  <c:v>592</c:v>
                </c:pt>
                <c:pt idx="1185">
                  <c:v>592.5</c:v>
                </c:pt>
                <c:pt idx="1186">
                  <c:v>593</c:v>
                </c:pt>
                <c:pt idx="1187">
                  <c:v>593.5</c:v>
                </c:pt>
                <c:pt idx="1188">
                  <c:v>594</c:v>
                </c:pt>
                <c:pt idx="1189">
                  <c:v>594.5</c:v>
                </c:pt>
                <c:pt idx="1190">
                  <c:v>595</c:v>
                </c:pt>
                <c:pt idx="1191">
                  <c:v>595.5</c:v>
                </c:pt>
                <c:pt idx="1192">
                  <c:v>596</c:v>
                </c:pt>
                <c:pt idx="1193">
                  <c:v>596.5</c:v>
                </c:pt>
                <c:pt idx="1194">
                  <c:v>597</c:v>
                </c:pt>
                <c:pt idx="1195">
                  <c:v>597.5</c:v>
                </c:pt>
                <c:pt idx="1196">
                  <c:v>598</c:v>
                </c:pt>
                <c:pt idx="1197">
                  <c:v>598.5</c:v>
                </c:pt>
                <c:pt idx="1198">
                  <c:v>599</c:v>
                </c:pt>
                <c:pt idx="1199">
                  <c:v>599.5</c:v>
                </c:pt>
                <c:pt idx="1200">
                  <c:v>600</c:v>
                </c:pt>
                <c:pt idx="1201">
                  <c:v>600.5</c:v>
                </c:pt>
                <c:pt idx="1202">
                  <c:v>601</c:v>
                </c:pt>
                <c:pt idx="1203">
                  <c:v>601.5</c:v>
                </c:pt>
                <c:pt idx="1204">
                  <c:v>602</c:v>
                </c:pt>
                <c:pt idx="1205">
                  <c:v>602.5</c:v>
                </c:pt>
                <c:pt idx="1206">
                  <c:v>603</c:v>
                </c:pt>
                <c:pt idx="1207">
                  <c:v>603.5</c:v>
                </c:pt>
                <c:pt idx="1208">
                  <c:v>604</c:v>
                </c:pt>
                <c:pt idx="1209">
                  <c:v>604.5</c:v>
                </c:pt>
                <c:pt idx="1210">
                  <c:v>605</c:v>
                </c:pt>
                <c:pt idx="1211">
                  <c:v>605.5</c:v>
                </c:pt>
                <c:pt idx="1212">
                  <c:v>606</c:v>
                </c:pt>
                <c:pt idx="1213">
                  <c:v>606.5</c:v>
                </c:pt>
                <c:pt idx="1214">
                  <c:v>607</c:v>
                </c:pt>
                <c:pt idx="1215">
                  <c:v>607.5</c:v>
                </c:pt>
                <c:pt idx="1216">
                  <c:v>608</c:v>
                </c:pt>
                <c:pt idx="1217">
                  <c:v>608.5</c:v>
                </c:pt>
                <c:pt idx="1218">
                  <c:v>609</c:v>
                </c:pt>
                <c:pt idx="1219">
                  <c:v>609.5</c:v>
                </c:pt>
                <c:pt idx="1220">
                  <c:v>610</c:v>
                </c:pt>
                <c:pt idx="1221">
                  <c:v>610.5</c:v>
                </c:pt>
                <c:pt idx="1222">
                  <c:v>611</c:v>
                </c:pt>
                <c:pt idx="1223">
                  <c:v>611.5</c:v>
                </c:pt>
                <c:pt idx="1224">
                  <c:v>612</c:v>
                </c:pt>
                <c:pt idx="1225">
                  <c:v>612.5</c:v>
                </c:pt>
                <c:pt idx="1226">
                  <c:v>613</c:v>
                </c:pt>
                <c:pt idx="1227">
                  <c:v>613.5</c:v>
                </c:pt>
                <c:pt idx="1228">
                  <c:v>614</c:v>
                </c:pt>
                <c:pt idx="1229">
                  <c:v>614.5</c:v>
                </c:pt>
                <c:pt idx="1230">
                  <c:v>615</c:v>
                </c:pt>
                <c:pt idx="1231">
                  <c:v>615.5</c:v>
                </c:pt>
                <c:pt idx="1232">
                  <c:v>616</c:v>
                </c:pt>
                <c:pt idx="1233">
                  <c:v>616.5</c:v>
                </c:pt>
                <c:pt idx="1234">
                  <c:v>617</c:v>
                </c:pt>
                <c:pt idx="1235">
                  <c:v>617.5</c:v>
                </c:pt>
                <c:pt idx="1236">
                  <c:v>618</c:v>
                </c:pt>
                <c:pt idx="1237">
                  <c:v>618.5</c:v>
                </c:pt>
                <c:pt idx="1238">
                  <c:v>619</c:v>
                </c:pt>
                <c:pt idx="1239">
                  <c:v>619.5</c:v>
                </c:pt>
                <c:pt idx="1240">
                  <c:v>620</c:v>
                </c:pt>
                <c:pt idx="1241">
                  <c:v>620.5</c:v>
                </c:pt>
                <c:pt idx="1242">
                  <c:v>621</c:v>
                </c:pt>
                <c:pt idx="1243">
                  <c:v>621.5</c:v>
                </c:pt>
                <c:pt idx="1244">
                  <c:v>622</c:v>
                </c:pt>
                <c:pt idx="1245">
                  <c:v>622.5</c:v>
                </c:pt>
                <c:pt idx="1246">
                  <c:v>623</c:v>
                </c:pt>
                <c:pt idx="1247">
                  <c:v>623.5</c:v>
                </c:pt>
                <c:pt idx="1248">
                  <c:v>624</c:v>
                </c:pt>
                <c:pt idx="1249">
                  <c:v>624.5</c:v>
                </c:pt>
                <c:pt idx="1250">
                  <c:v>625</c:v>
                </c:pt>
                <c:pt idx="1251">
                  <c:v>625.5</c:v>
                </c:pt>
                <c:pt idx="1252">
                  <c:v>626</c:v>
                </c:pt>
                <c:pt idx="1253">
                  <c:v>626.5</c:v>
                </c:pt>
                <c:pt idx="1254">
                  <c:v>627</c:v>
                </c:pt>
                <c:pt idx="1255">
                  <c:v>627.5</c:v>
                </c:pt>
                <c:pt idx="1256">
                  <c:v>628</c:v>
                </c:pt>
                <c:pt idx="1257">
                  <c:v>628.5</c:v>
                </c:pt>
                <c:pt idx="1258">
                  <c:v>629</c:v>
                </c:pt>
                <c:pt idx="1259">
                  <c:v>629.5</c:v>
                </c:pt>
                <c:pt idx="1260">
                  <c:v>630</c:v>
                </c:pt>
                <c:pt idx="1261">
                  <c:v>630.5</c:v>
                </c:pt>
                <c:pt idx="1262">
                  <c:v>631</c:v>
                </c:pt>
                <c:pt idx="1263">
                  <c:v>631.5</c:v>
                </c:pt>
                <c:pt idx="1264">
                  <c:v>632</c:v>
                </c:pt>
                <c:pt idx="1265">
                  <c:v>632.5</c:v>
                </c:pt>
                <c:pt idx="1266">
                  <c:v>633</c:v>
                </c:pt>
                <c:pt idx="1267">
                  <c:v>633.5</c:v>
                </c:pt>
                <c:pt idx="1268">
                  <c:v>634</c:v>
                </c:pt>
                <c:pt idx="1269">
                  <c:v>634.5</c:v>
                </c:pt>
                <c:pt idx="1270">
                  <c:v>635</c:v>
                </c:pt>
                <c:pt idx="1271">
                  <c:v>635.5</c:v>
                </c:pt>
                <c:pt idx="1272">
                  <c:v>636</c:v>
                </c:pt>
                <c:pt idx="1273">
                  <c:v>636.5</c:v>
                </c:pt>
                <c:pt idx="1274">
                  <c:v>637</c:v>
                </c:pt>
                <c:pt idx="1275">
                  <c:v>637.5</c:v>
                </c:pt>
                <c:pt idx="1276">
                  <c:v>638</c:v>
                </c:pt>
                <c:pt idx="1277">
                  <c:v>638.5</c:v>
                </c:pt>
                <c:pt idx="1278">
                  <c:v>639</c:v>
                </c:pt>
                <c:pt idx="1279">
                  <c:v>639.5</c:v>
                </c:pt>
                <c:pt idx="1280">
                  <c:v>640</c:v>
                </c:pt>
                <c:pt idx="1281">
                  <c:v>640.5</c:v>
                </c:pt>
                <c:pt idx="1282">
                  <c:v>641</c:v>
                </c:pt>
                <c:pt idx="1283">
                  <c:v>641.5</c:v>
                </c:pt>
                <c:pt idx="1284">
                  <c:v>642</c:v>
                </c:pt>
                <c:pt idx="1285">
                  <c:v>642.5</c:v>
                </c:pt>
                <c:pt idx="1286">
                  <c:v>643</c:v>
                </c:pt>
                <c:pt idx="1287">
                  <c:v>643.5</c:v>
                </c:pt>
                <c:pt idx="1288">
                  <c:v>644</c:v>
                </c:pt>
                <c:pt idx="1289">
                  <c:v>644.5</c:v>
                </c:pt>
                <c:pt idx="1290">
                  <c:v>645</c:v>
                </c:pt>
                <c:pt idx="1291">
                  <c:v>645.5</c:v>
                </c:pt>
                <c:pt idx="1292">
                  <c:v>646</c:v>
                </c:pt>
                <c:pt idx="1293">
                  <c:v>646.5</c:v>
                </c:pt>
                <c:pt idx="1294">
                  <c:v>647</c:v>
                </c:pt>
                <c:pt idx="1295">
                  <c:v>647.5</c:v>
                </c:pt>
                <c:pt idx="1296">
                  <c:v>648</c:v>
                </c:pt>
                <c:pt idx="1297">
                  <c:v>648.5</c:v>
                </c:pt>
                <c:pt idx="1298">
                  <c:v>649</c:v>
                </c:pt>
                <c:pt idx="1299">
                  <c:v>649.5</c:v>
                </c:pt>
                <c:pt idx="1300">
                  <c:v>650</c:v>
                </c:pt>
                <c:pt idx="1301">
                  <c:v>650.5</c:v>
                </c:pt>
                <c:pt idx="1302">
                  <c:v>651</c:v>
                </c:pt>
                <c:pt idx="1303">
                  <c:v>651.5</c:v>
                </c:pt>
                <c:pt idx="1304">
                  <c:v>652</c:v>
                </c:pt>
                <c:pt idx="1305">
                  <c:v>652.5</c:v>
                </c:pt>
                <c:pt idx="1306">
                  <c:v>653</c:v>
                </c:pt>
                <c:pt idx="1307">
                  <c:v>653.5</c:v>
                </c:pt>
                <c:pt idx="1308">
                  <c:v>654</c:v>
                </c:pt>
                <c:pt idx="1309">
                  <c:v>654.5</c:v>
                </c:pt>
                <c:pt idx="1310">
                  <c:v>655</c:v>
                </c:pt>
                <c:pt idx="1311">
                  <c:v>655.5</c:v>
                </c:pt>
                <c:pt idx="1312">
                  <c:v>656</c:v>
                </c:pt>
                <c:pt idx="1313">
                  <c:v>656.5</c:v>
                </c:pt>
                <c:pt idx="1314">
                  <c:v>657</c:v>
                </c:pt>
                <c:pt idx="1315">
                  <c:v>657.5</c:v>
                </c:pt>
                <c:pt idx="1316">
                  <c:v>658</c:v>
                </c:pt>
                <c:pt idx="1317">
                  <c:v>658.5</c:v>
                </c:pt>
                <c:pt idx="1318">
                  <c:v>659</c:v>
                </c:pt>
                <c:pt idx="1319">
                  <c:v>659.5</c:v>
                </c:pt>
                <c:pt idx="1320">
                  <c:v>660</c:v>
                </c:pt>
                <c:pt idx="1321">
                  <c:v>660.5</c:v>
                </c:pt>
                <c:pt idx="1322">
                  <c:v>661</c:v>
                </c:pt>
                <c:pt idx="1323">
                  <c:v>661.5</c:v>
                </c:pt>
                <c:pt idx="1324">
                  <c:v>662</c:v>
                </c:pt>
                <c:pt idx="1325">
                  <c:v>662.5</c:v>
                </c:pt>
                <c:pt idx="1326">
                  <c:v>663</c:v>
                </c:pt>
                <c:pt idx="1327">
                  <c:v>663.5</c:v>
                </c:pt>
                <c:pt idx="1328">
                  <c:v>664</c:v>
                </c:pt>
                <c:pt idx="1329">
                  <c:v>664.5</c:v>
                </c:pt>
                <c:pt idx="1330">
                  <c:v>665</c:v>
                </c:pt>
                <c:pt idx="1331">
                  <c:v>665.5</c:v>
                </c:pt>
                <c:pt idx="1332">
                  <c:v>666</c:v>
                </c:pt>
                <c:pt idx="1333">
                  <c:v>666.5</c:v>
                </c:pt>
                <c:pt idx="1334">
                  <c:v>667</c:v>
                </c:pt>
                <c:pt idx="1335">
                  <c:v>667.5</c:v>
                </c:pt>
                <c:pt idx="1336">
                  <c:v>668</c:v>
                </c:pt>
                <c:pt idx="1337">
                  <c:v>668.5</c:v>
                </c:pt>
                <c:pt idx="1338">
                  <c:v>669</c:v>
                </c:pt>
                <c:pt idx="1339">
                  <c:v>669.5</c:v>
                </c:pt>
                <c:pt idx="1340">
                  <c:v>670</c:v>
                </c:pt>
                <c:pt idx="1341">
                  <c:v>670.5</c:v>
                </c:pt>
                <c:pt idx="1342">
                  <c:v>671</c:v>
                </c:pt>
                <c:pt idx="1343">
                  <c:v>671.5</c:v>
                </c:pt>
                <c:pt idx="1344">
                  <c:v>672</c:v>
                </c:pt>
                <c:pt idx="1345">
                  <c:v>672.5</c:v>
                </c:pt>
                <c:pt idx="1346">
                  <c:v>673</c:v>
                </c:pt>
                <c:pt idx="1347">
                  <c:v>673.5</c:v>
                </c:pt>
                <c:pt idx="1348">
                  <c:v>674</c:v>
                </c:pt>
                <c:pt idx="1349">
                  <c:v>674.5</c:v>
                </c:pt>
                <c:pt idx="1350">
                  <c:v>675</c:v>
                </c:pt>
                <c:pt idx="1351">
                  <c:v>675.5</c:v>
                </c:pt>
                <c:pt idx="1352">
                  <c:v>676</c:v>
                </c:pt>
                <c:pt idx="1353">
                  <c:v>676.5</c:v>
                </c:pt>
                <c:pt idx="1354">
                  <c:v>677</c:v>
                </c:pt>
                <c:pt idx="1355">
                  <c:v>677.5</c:v>
                </c:pt>
                <c:pt idx="1356">
                  <c:v>678</c:v>
                </c:pt>
                <c:pt idx="1357">
                  <c:v>678.5</c:v>
                </c:pt>
                <c:pt idx="1358">
                  <c:v>679</c:v>
                </c:pt>
                <c:pt idx="1359">
                  <c:v>679.5</c:v>
                </c:pt>
                <c:pt idx="1360">
                  <c:v>680</c:v>
                </c:pt>
                <c:pt idx="1361">
                  <c:v>680.5</c:v>
                </c:pt>
                <c:pt idx="1362">
                  <c:v>681</c:v>
                </c:pt>
                <c:pt idx="1363">
                  <c:v>681.5</c:v>
                </c:pt>
                <c:pt idx="1364">
                  <c:v>682</c:v>
                </c:pt>
                <c:pt idx="1365">
                  <c:v>682.5</c:v>
                </c:pt>
                <c:pt idx="1366">
                  <c:v>683</c:v>
                </c:pt>
                <c:pt idx="1367">
                  <c:v>683.5</c:v>
                </c:pt>
                <c:pt idx="1368">
                  <c:v>684</c:v>
                </c:pt>
                <c:pt idx="1369">
                  <c:v>684.5</c:v>
                </c:pt>
                <c:pt idx="1370">
                  <c:v>685</c:v>
                </c:pt>
                <c:pt idx="1371">
                  <c:v>685.5</c:v>
                </c:pt>
                <c:pt idx="1372">
                  <c:v>686</c:v>
                </c:pt>
                <c:pt idx="1373">
                  <c:v>686.5</c:v>
                </c:pt>
                <c:pt idx="1374">
                  <c:v>687</c:v>
                </c:pt>
                <c:pt idx="1375">
                  <c:v>687.5</c:v>
                </c:pt>
                <c:pt idx="1376">
                  <c:v>688</c:v>
                </c:pt>
                <c:pt idx="1377">
                  <c:v>688.5</c:v>
                </c:pt>
                <c:pt idx="1378">
                  <c:v>689</c:v>
                </c:pt>
                <c:pt idx="1379">
                  <c:v>689.5</c:v>
                </c:pt>
                <c:pt idx="1380">
                  <c:v>690</c:v>
                </c:pt>
                <c:pt idx="1381">
                  <c:v>690.5</c:v>
                </c:pt>
                <c:pt idx="1382">
                  <c:v>691</c:v>
                </c:pt>
                <c:pt idx="1383">
                  <c:v>691.5</c:v>
                </c:pt>
                <c:pt idx="1384">
                  <c:v>692</c:v>
                </c:pt>
                <c:pt idx="1385">
                  <c:v>692.5</c:v>
                </c:pt>
                <c:pt idx="1386">
                  <c:v>693</c:v>
                </c:pt>
                <c:pt idx="1387">
                  <c:v>693.5</c:v>
                </c:pt>
                <c:pt idx="1388">
                  <c:v>694</c:v>
                </c:pt>
                <c:pt idx="1389">
                  <c:v>694.5</c:v>
                </c:pt>
                <c:pt idx="1390">
                  <c:v>695</c:v>
                </c:pt>
                <c:pt idx="1391">
                  <c:v>695.5</c:v>
                </c:pt>
                <c:pt idx="1392">
                  <c:v>696</c:v>
                </c:pt>
                <c:pt idx="1393">
                  <c:v>696.5</c:v>
                </c:pt>
                <c:pt idx="1394">
                  <c:v>697</c:v>
                </c:pt>
                <c:pt idx="1395">
                  <c:v>697.5</c:v>
                </c:pt>
                <c:pt idx="1396">
                  <c:v>698</c:v>
                </c:pt>
                <c:pt idx="1397">
                  <c:v>698.5</c:v>
                </c:pt>
                <c:pt idx="1398">
                  <c:v>699</c:v>
                </c:pt>
                <c:pt idx="1399">
                  <c:v>699.5</c:v>
                </c:pt>
                <c:pt idx="1400">
                  <c:v>700</c:v>
                </c:pt>
                <c:pt idx="1401">
                  <c:v>700.5</c:v>
                </c:pt>
                <c:pt idx="1402">
                  <c:v>701</c:v>
                </c:pt>
                <c:pt idx="1403">
                  <c:v>701.5</c:v>
                </c:pt>
                <c:pt idx="1404">
                  <c:v>702</c:v>
                </c:pt>
                <c:pt idx="1405">
                  <c:v>702.5</c:v>
                </c:pt>
                <c:pt idx="1406">
                  <c:v>703</c:v>
                </c:pt>
                <c:pt idx="1407">
                  <c:v>703.5</c:v>
                </c:pt>
                <c:pt idx="1408">
                  <c:v>704</c:v>
                </c:pt>
                <c:pt idx="1409">
                  <c:v>704.5</c:v>
                </c:pt>
                <c:pt idx="1410">
                  <c:v>705</c:v>
                </c:pt>
                <c:pt idx="1411">
                  <c:v>705.5</c:v>
                </c:pt>
                <c:pt idx="1412">
                  <c:v>706</c:v>
                </c:pt>
                <c:pt idx="1413">
                  <c:v>706.5</c:v>
                </c:pt>
                <c:pt idx="1414">
                  <c:v>707</c:v>
                </c:pt>
                <c:pt idx="1415">
                  <c:v>707.5</c:v>
                </c:pt>
                <c:pt idx="1416">
                  <c:v>708</c:v>
                </c:pt>
                <c:pt idx="1417">
                  <c:v>708.5</c:v>
                </c:pt>
                <c:pt idx="1418">
                  <c:v>709</c:v>
                </c:pt>
                <c:pt idx="1419">
                  <c:v>709.5</c:v>
                </c:pt>
                <c:pt idx="1420">
                  <c:v>710</c:v>
                </c:pt>
                <c:pt idx="1421">
                  <c:v>710.5</c:v>
                </c:pt>
                <c:pt idx="1422">
                  <c:v>711</c:v>
                </c:pt>
                <c:pt idx="1423">
                  <c:v>711.5</c:v>
                </c:pt>
                <c:pt idx="1424">
                  <c:v>712</c:v>
                </c:pt>
                <c:pt idx="1425">
                  <c:v>712.5</c:v>
                </c:pt>
                <c:pt idx="1426">
                  <c:v>713</c:v>
                </c:pt>
                <c:pt idx="1427">
                  <c:v>713.5</c:v>
                </c:pt>
                <c:pt idx="1428">
                  <c:v>714</c:v>
                </c:pt>
                <c:pt idx="1429">
                  <c:v>714.5</c:v>
                </c:pt>
                <c:pt idx="1430">
                  <c:v>715</c:v>
                </c:pt>
                <c:pt idx="1431">
                  <c:v>715.5</c:v>
                </c:pt>
                <c:pt idx="1432">
                  <c:v>716</c:v>
                </c:pt>
                <c:pt idx="1433">
                  <c:v>716.5</c:v>
                </c:pt>
                <c:pt idx="1434">
                  <c:v>717</c:v>
                </c:pt>
                <c:pt idx="1435">
                  <c:v>717.5</c:v>
                </c:pt>
                <c:pt idx="1436">
                  <c:v>718</c:v>
                </c:pt>
                <c:pt idx="1437">
                  <c:v>718.5</c:v>
                </c:pt>
                <c:pt idx="1438">
                  <c:v>719</c:v>
                </c:pt>
                <c:pt idx="1439">
                  <c:v>719.5</c:v>
                </c:pt>
                <c:pt idx="1440">
                  <c:v>720</c:v>
                </c:pt>
                <c:pt idx="1441">
                  <c:v>720.5</c:v>
                </c:pt>
                <c:pt idx="1442">
                  <c:v>721</c:v>
                </c:pt>
                <c:pt idx="1443">
                  <c:v>721.5</c:v>
                </c:pt>
                <c:pt idx="1444">
                  <c:v>722</c:v>
                </c:pt>
                <c:pt idx="1445">
                  <c:v>722.5</c:v>
                </c:pt>
                <c:pt idx="1446">
                  <c:v>723</c:v>
                </c:pt>
                <c:pt idx="1447">
                  <c:v>723.5</c:v>
                </c:pt>
                <c:pt idx="1448">
                  <c:v>724</c:v>
                </c:pt>
                <c:pt idx="1449">
                  <c:v>724.5</c:v>
                </c:pt>
                <c:pt idx="1450">
                  <c:v>725</c:v>
                </c:pt>
                <c:pt idx="1451">
                  <c:v>725.5</c:v>
                </c:pt>
                <c:pt idx="1452">
                  <c:v>726</c:v>
                </c:pt>
                <c:pt idx="1453">
                  <c:v>726.5</c:v>
                </c:pt>
                <c:pt idx="1454">
                  <c:v>727</c:v>
                </c:pt>
                <c:pt idx="1455">
                  <c:v>727.5</c:v>
                </c:pt>
                <c:pt idx="1456">
                  <c:v>728</c:v>
                </c:pt>
                <c:pt idx="1457">
                  <c:v>728.5</c:v>
                </c:pt>
                <c:pt idx="1458">
                  <c:v>729</c:v>
                </c:pt>
                <c:pt idx="1459">
                  <c:v>729.5</c:v>
                </c:pt>
                <c:pt idx="1460">
                  <c:v>730</c:v>
                </c:pt>
                <c:pt idx="1461">
                  <c:v>730.5</c:v>
                </c:pt>
                <c:pt idx="1462">
                  <c:v>731</c:v>
                </c:pt>
                <c:pt idx="1463">
                  <c:v>731.5</c:v>
                </c:pt>
                <c:pt idx="1464">
                  <c:v>732</c:v>
                </c:pt>
                <c:pt idx="1465">
                  <c:v>732.5</c:v>
                </c:pt>
                <c:pt idx="1466">
                  <c:v>733</c:v>
                </c:pt>
                <c:pt idx="1467">
                  <c:v>733.5</c:v>
                </c:pt>
                <c:pt idx="1468">
                  <c:v>734</c:v>
                </c:pt>
                <c:pt idx="1469">
                  <c:v>734.5</c:v>
                </c:pt>
                <c:pt idx="1470">
                  <c:v>735</c:v>
                </c:pt>
                <c:pt idx="1471">
                  <c:v>735.5</c:v>
                </c:pt>
                <c:pt idx="1472">
                  <c:v>736</c:v>
                </c:pt>
                <c:pt idx="1473">
                  <c:v>736.5</c:v>
                </c:pt>
                <c:pt idx="1474">
                  <c:v>737</c:v>
                </c:pt>
                <c:pt idx="1475">
                  <c:v>737.5</c:v>
                </c:pt>
                <c:pt idx="1476">
                  <c:v>738</c:v>
                </c:pt>
                <c:pt idx="1477">
                  <c:v>738.5</c:v>
                </c:pt>
                <c:pt idx="1478">
                  <c:v>739</c:v>
                </c:pt>
                <c:pt idx="1479">
                  <c:v>739.5</c:v>
                </c:pt>
                <c:pt idx="1480">
                  <c:v>740</c:v>
                </c:pt>
                <c:pt idx="1481">
                  <c:v>740.5</c:v>
                </c:pt>
                <c:pt idx="1482">
                  <c:v>741</c:v>
                </c:pt>
                <c:pt idx="1483">
                  <c:v>741.5</c:v>
                </c:pt>
                <c:pt idx="1484">
                  <c:v>742</c:v>
                </c:pt>
                <c:pt idx="1485">
                  <c:v>742.5</c:v>
                </c:pt>
                <c:pt idx="1486">
                  <c:v>743</c:v>
                </c:pt>
                <c:pt idx="1487">
                  <c:v>743.5</c:v>
                </c:pt>
                <c:pt idx="1488">
                  <c:v>744</c:v>
                </c:pt>
                <c:pt idx="1489">
                  <c:v>744.5</c:v>
                </c:pt>
                <c:pt idx="1490">
                  <c:v>745</c:v>
                </c:pt>
                <c:pt idx="1491">
                  <c:v>745.5</c:v>
                </c:pt>
                <c:pt idx="1492">
                  <c:v>746</c:v>
                </c:pt>
                <c:pt idx="1493">
                  <c:v>746.5</c:v>
                </c:pt>
                <c:pt idx="1494">
                  <c:v>747</c:v>
                </c:pt>
                <c:pt idx="1495">
                  <c:v>747.5</c:v>
                </c:pt>
                <c:pt idx="1496">
                  <c:v>748</c:v>
                </c:pt>
                <c:pt idx="1497">
                  <c:v>748.5</c:v>
                </c:pt>
                <c:pt idx="1498">
                  <c:v>749</c:v>
                </c:pt>
                <c:pt idx="1499">
                  <c:v>749.5</c:v>
                </c:pt>
                <c:pt idx="1500">
                  <c:v>750</c:v>
                </c:pt>
                <c:pt idx="1501">
                  <c:v>750.5</c:v>
                </c:pt>
                <c:pt idx="1502">
                  <c:v>751</c:v>
                </c:pt>
                <c:pt idx="1503">
                  <c:v>751.5</c:v>
                </c:pt>
                <c:pt idx="1504">
                  <c:v>752</c:v>
                </c:pt>
                <c:pt idx="1505">
                  <c:v>752.5</c:v>
                </c:pt>
                <c:pt idx="1506">
                  <c:v>753</c:v>
                </c:pt>
                <c:pt idx="1507">
                  <c:v>753.5</c:v>
                </c:pt>
                <c:pt idx="1508">
                  <c:v>754</c:v>
                </c:pt>
                <c:pt idx="1509">
                  <c:v>754.5</c:v>
                </c:pt>
                <c:pt idx="1510">
                  <c:v>755</c:v>
                </c:pt>
                <c:pt idx="1511">
                  <c:v>755.5</c:v>
                </c:pt>
                <c:pt idx="1512">
                  <c:v>756</c:v>
                </c:pt>
                <c:pt idx="1513">
                  <c:v>756.5</c:v>
                </c:pt>
                <c:pt idx="1514">
                  <c:v>757</c:v>
                </c:pt>
                <c:pt idx="1515">
                  <c:v>757.5</c:v>
                </c:pt>
                <c:pt idx="1516">
                  <c:v>758</c:v>
                </c:pt>
                <c:pt idx="1517">
                  <c:v>758.5</c:v>
                </c:pt>
                <c:pt idx="1518">
                  <c:v>759</c:v>
                </c:pt>
                <c:pt idx="1519">
                  <c:v>759.5</c:v>
                </c:pt>
                <c:pt idx="1520">
                  <c:v>760</c:v>
                </c:pt>
                <c:pt idx="1521">
                  <c:v>760.5</c:v>
                </c:pt>
                <c:pt idx="1522">
                  <c:v>761</c:v>
                </c:pt>
                <c:pt idx="1523">
                  <c:v>761.5</c:v>
                </c:pt>
                <c:pt idx="1524">
                  <c:v>762</c:v>
                </c:pt>
                <c:pt idx="1525">
                  <c:v>762.5</c:v>
                </c:pt>
                <c:pt idx="1526">
                  <c:v>763</c:v>
                </c:pt>
                <c:pt idx="1527">
                  <c:v>763.5</c:v>
                </c:pt>
                <c:pt idx="1528">
                  <c:v>764</c:v>
                </c:pt>
                <c:pt idx="1529">
                  <c:v>764.5</c:v>
                </c:pt>
                <c:pt idx="1530">
                  <c:v>765</c:v>
                </c:pt>
                <c:pt idx="1531">
                  <c:v>765.5</c:v>
                </c:pt>
                <c:pt idx="1532">
                  <c:v>766</c:v>
                </c:pt>
                <c:pt idx="1533">
                  <c:v>766.5</c:v>
                </c:pt>
                <c:pt idx="1534">
                  <c:v>767</c:v>
                </c:pt>
                <c:pt idx="1535">
                  <c:v>767.5</c:v>
                </c:pt>
                <c:pt idx="1536">
                  <c:v>768</c:v>
                </c:pt>
                <c:pt idx="1537">
                  <c:v>768.5</c:v>
                </c:pt>
                <c:pt idx="1538">
                  <c:v>769</c:v>
                </c:pt>
                <c:pt idx="1539">
                  <c:v>769.5</c:v>
                </c:pt>
                <c:pt idx="1540">
                  <c:v>770</c:v>
                </c:pt>
                <c:pt idx="1541">
                  <c:v>770.5</c:v>
                </c:pt>
                <c:pt idx="1542">
                  <c:v>771</c:v>
                </c:pt>
                <c:pt idx="1543">
                  <c:v>771.5</c:v>
                </c:pt>
                <c:pt idx="1544">
                  <c:v>772</c:v>
                </c:pt>
                <c:pt idx="1545">
                  <c:v>772.5</c:v>
                </c:pt>
                <c:pt idx="1546">
                  <c:v>773</c:v>
                </c:pt>
                <c:pt idx="1547">
                  <c:v>773.5</c:v>
                </c:pt>
                <c:pt idx="1548">
                  <c:v>774</c:v>
                </c:pt>
                <c:pt idx="1549">
                  <c:v>774.5</c:v>
                </c:pt>
                <c:pt idx="1550">
                  <c:v>775</c:v>
                </c:pt>
                <c:pt idx="1551">
                  <c:v>775.5</c:v>
                </c:pt>
                <c:pt idx="1552">
                  <c:v>776</c:v>
                </c:pt>
                <c:pt idx="1553">
                  <c:v>776.5</c:v>
                </c:pt>
                <c:pt idx="1554">
                  <c:v>777</c:v>
                </c:pt>
                <c:pt idx="1555">
                  <c:v>777.5</c:v>
                </c:pt>
                <c:pt idx="1556">
                  <c:v>778</c:v>
                </c:pt>
                <c:pt idx="1557">
                  <c:v>778.5</c:v>
                </c:pt>
                <c:pt idx="1558">
                  <c:v>779</c:v>
                </c:pt>
                <c:pt idx="1559">
                  <c:v>779.5</c:v>
                </c:pt>
                <c:pt idx="1560">
                  <c:v>780</c:v>
                </c:pt>
                <c:pt idx="1561">
                  <c:v>780.5</c:v>
                </c:pt>
                <c:pt idx="1562">
                  <c:v>781</c:v>
                </c:pt>
                <c:pt idx="1563">
                  <c:v>781.5</c:v>
                </c:pt>
                <c:pt idx="1564">
                  <c:v>782</c:v>
                </c:pt>
                <c:pt idx="1565">
                  <c:v>782.5</c:v>
                </c:pt>
                <c:pt idx="1566">
                  <c:v>783</c:v>
                </c:pt>
                <c:pt idx="1567">
                  <c:v>783.5</c:v>
                </c:pt>
                <c:pt idx="1568">
                  <c:v>784</c:v>
                </c:pt>
                <c:pt idx="1569">
                  <c:v>784.5</c:v>
                </c:pt>
                <c:pt idx="1570">
                  <c:v>785</c:v>
                </c:pt>
                <c:pt idx="1571">
                  <c:v>785.5</c:v>
                </c:pt>
                <c:pt idx="1572">
                  <c:v>786</c:v>
                </c:pt>
                <c:pt idx="1573">
                  <c:v>786.5</c:v>
                </c:pt>
                <c:pt idx="1574">
                  <c:v>787</c:v>
                </c:pt>
                <c:pt idx="1575">
                  <c:v>787.5</c:v>
                </c:pt>
                <c:pt idx="1576">
                  <c:v>788</c:v>
                </c:pt>
                <c:pt idx="1577">
                  <c:v>788.5</c:v>
                </c:pt>
                <c:pt idx="1578">
                  <c:v>789</c:v>
                </c:pt>
                <c:pt idx="1579">
                  <c:v>789.5</c:v>
                </c:pt>
                <c:pt idx="1580">
                  <c:v>790</c:v>
                </c:pt>
                <c:pt idx="1581">
                  <c:v>790.5</c:v>
                </c:pt>
                <c:pt idx="1582">
                  <c:v>791</c:v>
                </c:pt>
                <c:pt idx="1583">
                  <c:v>791.5</c:v>
                </c:pt>
                <c:pt idx="1584">
                  <c:v>792</c:v>
                </c:pt>
                <c:pt idx="1585">
                  <c:v>792.5</c:v>
                </c:pt>
                <c:pt idx="1586">
                  <c:v>793</c:v>
                </c:pt>
                <c:pt idx="1587">
                  <c:v>793.5</c:v>
                </c:pt>
                <c:pt idx="1588">
                  <c:v>794</c:v>
                </c:pt>
                <c:pt idx="1589">
                  <c:v>794.5</c:v>
                </c:pt>
                <c:pt idx="1590">
                  <c:v>795</c:v>
                </c:pt>
                <c:pt idx="1591">
                  <c:v>795.5</c:v>
                </c:pt>
                <c:pt idx="1592">
                  <c:v>796</c:v>
                </c:pt>
                <c:pt idx="1593">
                  <c:v>796.5</c:v>
                </c:pt>
                <c:pt idx="1594">
                  <c:v>797</c:v>
                </c:pt>
                <c:pt idx="1595">
                  <c:v>797.5</c:v>
                </c:pt>
                <c:pt idx="1596">
                  <c:v>798</c:v>
                </c:pt>
                <c:pt idx="1597">
                  <c:v>798.5</c:v>
                </c:pt>
                <c:pt idx="1598">
                  <c:v>799</c:v>
                </c:pt>
                <c:pt idx="1599">
                  <c:v>799.5</c:v>
                </c:pt>
                <c:pt idx="1600">
                  <c:v>800</c:v>
                </c:pt>
                <c:pt idx="1601">
                  <c:v>800.5</c:v>
                </c:pt>
                <c:pt idx="1602">
                  <c:v>801</c:v>
                </c:pt>
                <c:pt idx="1603">
                  <c:v>801.5</c:v>
                </c:pt>
                <c:pt idx="1604">
                  <c:v>802</c:v>
                </c:pt>
                <c:pt idx="1605">
                  <c:v>802.5</c:v>
                </c:pt>
                <c:pt idx="1606">
                  <c:v>803</c:v>
                </c:pt>
                <c:pt idx="1607">
                  <c:v>803.5</c:v>
                </c:pt>
                <c:pt idx="1608">
                  <c:v>804</c:v>
                </c:pt>
                <c:pt idx="1609">
                  <c:v>804.5</c:v>
                </c:pt>
                <c:pt idx="1610">
                  <c:v>805</c:v>
                </c:pt>
                <c:pt idx="1611">
                  <c:v>805.5</c:v>
                </c:pt>
                <c:pt idx="1612">
                  <c:v>806</c:v>
                </c:pt>
                <c:pt idx="1613">
                  <c:v>806.5</c:v>
                </c:pt>
                <c:pt idx="1614">
                  <c:v>807</c:v>
                </c:pt>
                <c:pt idx="1615">
                  <c:v>807.5</c:v>
                </c:pt>
                <c:pt idx="1616">
                  <c:v>808</c:v>
                </c:pt>
                <c:pt idx="1617">
                  <c:v>808.5</c:v>
                </c:pt>
                <c:pt idx="1618">
                  <c:v>809</c:v>
                </c:pt>
                <c:pt idx="1619">
                  <c:v>809.5</c:v>
                </c:pt>
                <c:pt idx="1620">
                  <c:v>810</c:v>
                </c:pt>
                <c:pt idx="1621">
                  <c:v>810.5</c:v>
                </c:pt>
                <c:pt idx="1622">
                  <c:v>811</c:v>
                </c:pt>
                <c:pt idx="1623">
                  <c:v>811.5</c:v>
                </c:pt>
                <c:pt idx="1624">
                  <c:v>812</c:v>
                </c:pt>
                <c:pt idx="1625">
                  <c:v>812.5</c:v>
                </c:pt>
                <c:pt idx="1626">
                  <c:v>813</c:v>
                </c:pt>
                <c:pt idx="1627">
                  <c:v>813.5</c:v>
                </c:pt>
                <c:pt idx="1628">
                  <c:v>814</c:v>
                </c:pt>
                <c:pt idx="1629">
                  <c:v>814.5</c:v>
                </c:pt>
                <c:pt idx="1630">
                  <c:v>815</c:v>
                </c:pt>
                <c:pt idx="1631">
                  <c:v>815.5</c:v>
                </c:pt>
                <c:pt idx="1632">
                  <c:v>816</c:v>
                </c:pt>
                <c:pt idx="1633">
                  <c:v>816.5</c:v>
                </c:pt>
                <c:pt idx="1634">
                  <c:v>817</c:v>
                </c:pt>
                <c:pt idx="1635">
                  <c:v>817.5</c:v>
                </c:pt>
                <c:pt idx="1636">
                  <c:v>818</c:v>
                </c:pt>
                <c:pt idx="1637">
                  <c:v>818.5</c:v>
                </c:pt>
                <c:pt idx="1638">
                  <c:v>819</c:v>
                </c:pt>
                <c:pt idx="1639">
                  <c:v>819.5</c:v>
                </c:pt>
                <c:pt idx="1640">
                  <c:v>820</c:v>
                </c:pt>
                <c:pt idx="1641">
                  <c:v>820.5</c:v>
                </c:pt>
                <c:pt idx="1642">
                  <c:v>821</c:v>
                </c:pt>
                <c:pt idx="1643">
                  <c:v>821.5</c:v>
                </c:pt>
                <c:pt idx="1644">
                  <c:v>822</c:v>
                </c:pt>
                <c:pt idx="1645">
                  <c:v>822.5</c:v>
                </c:pt>
                <c:pt idx="1646">
                  <c:v>823</c:v>
                </c:pt>
                <c:pt idx="1647">
                  <c:v>823.5</c:v>
                </c:pt>
                <c:pt idx="1648">
                  <c:v>824</c:v>
                </c:pt>
                <c:pt idx="1649">
                  <c:v>824.5</c:v>
                </c:pt>
                <c:pt idx="1650">
                  <c:v>825</c:v>
                </c:pt>
                <c:pt idx="1651">
                  <c:v>825.5</c:v>
                </c:pt>
                <c:pt idx="1652">
                  <c:v>826</c:v>
                </c:pt>
                <c:pt idx="1653">
                  <c:v>826.5</c:v>
                </c:pt>
                <c:pt idx="1654">
                  <c:v>827</c:v>
                </c:pt>
                <c:pt idx="1655">
                  <c:v>827.5</c:v>
                </c:pt>
                <c:pt idx="1656">
                  <c:v>828</c:v>
                </c:pt>
                <c:pt idx="1657">
                  <c:v>828.5</c:v>
                </c:pt>
                <c:pt idx="1658">
                  <c:v>829</c:v>
                </c:pt>
                <c:pt idx="1659">
                  <c:v>829.5</c:v>
                </c:pt>
                <c:pt idx="1660">
                  <c:v>830</c:v>
                </c:pt>
                <c:pt idx="1661">
                  <c:v>830.5</c:v>
                </c:pt>
                <c:pt idx="1662">
                  <c:v>831</c:v>
                </c:pt>
                <c:pt idx="1663">
                  <c:v>831.5</c:v>
                </c:pt>
                <c:pt idx="1664">
                  <c:v>832</c:v>
                </c:pt>
                <c:pt idx="1665">
                  <c:v>832.5</c:v>
                </c:pt>
                <c:pt idx="1666">
                  <c:v>833</c:v>
                </c:pt>
                <c:pt idx="1667">
                  <c:v>833.5</c:v>
                </c:pt>
                <c:pt idx="1668">
                  <c:v>834</c:v>
                </c:pt>
                <c:pt idx="1669">
                  <c:v>834.5</c:v>
                </c:pt>
                <c:pt idx="1670">
                  <c:v>835</c:v>
                </c:pt>
                <c:pt idx="1671">
                  <c:v>835.5</c:v>
                </c:pt>
                <c:pt idx="1672">
                  <c:v>836</c:v>
                </c:pt>
                <c:pt idx="1673">
                  <c:v>836.5</c:v>
                </c:pt>
                <c:pt idx="1674">
                  <c:v>837</c:v>
                </c:pt>
                <c:pt idx="1675">
                  <c:v>837.5</c:v>
                </c:pt>
                <c:pt idx="1676">
                  <c:v>838</c:v>
                </c:pt>
                <c:pt idx="1677">
                  <c:v>838.5</c:v>
                </c:pt>
                <c:pt idx="1678">
                  <c:v>839</c:v>
                </c:pt>
                <c:pt idx="1679">
                  <c:v>839.5</c:v>
                </c:pt>
                <c:pt idx="1680">
                  <c:v>840</c:v>
                </c:pt>
                <c:pt idx="1681">
                  <c:v>840.5</c:v>
                </c:pt>
                <c:pt idx="1682">
                  <c:v>841</c:v>
                </c:pt>
                <c:pt idx="1683">
                  <c:v>841.5</c:v>
                </c:pt>
                <c:pt idx="1684">
                  <c:v>842</c:v>
                </c:pt>
                <c:pt idx="1685">
                  <c:v>842.5</c:v>
                </c:pt>
                <c:pt idx="1686">
                  <c:v>843</c:v>
                </c:pt>
                <c:pt idx="1687">
                  <c:v>843.5</c:v>
                </c:pt>
                <c:pt idx="1688">
                  <c:v>844</c:v>
                </c:pt>
                <c:pt idx="1689">
                  <c:v>844.5</c:v>
                </c:pt>
                <c:pt idx="1690">
                  <c:v>845</c:v>
                </c:pt>
                <c:pt idx="1691">
                  <c:v>845.5</c:v>
                </c:pt>
                <c:pt idx="1692">
                  <c:v>846</c:v>
                </c:pt>
                <c:pt idx="1693">
                  <c:v>846.5</c:v>
                </c:pt>
                <c:pt idx="1694">
                  <c:v>847</c:v>
                </c:pt>
                <c:pt idx="1695">
                  <c:v>847.5</c:v>
                </c:pt>
                <c:pt idx="1696">
                  <c:v>848</c:v>
                </c:pt>
                <c:pt idx="1697">
                  <c:v>848.5</c:v>
                </c:pt>
                <c:pt idx="1698">
                  <c:v>849</c:v>
                </c:pt>
                <c:pt idx="1699">
                  <c:v>849.5</c:v>
                </c:pt>
                <c:pt idx="1700">
                  <c:v>850</c:v>
                </c:pt>
                <c:pt idx="1701">
                  <c:v>850.5</c:v>
                </c:pt>
                <c:pt idx="1702">
                  <c:v>851</c:v>
                </c:pt>
                <c:pt idx="1703">
                  <c:v>851.5</c:v>
                </c:pt>
                <c:pt idx="1704">
                  <c:v>852</c:v>
                </c:pt>
                <c:pt idx="1705">
                  <c:v>852.5</c:v>
                </c:pt>
                <c:pt idx="1706">
                  <c:v>853</c:v>
                </c:pt>
                <c:pt idx="1707">
                  <c:v>853.5</c:v>
                </c:pt>
                <c:pt idx="1708">
                  <c:v>854</c:v>
                </c:pt>
                <c:pt idx="1709">
                  <c:v>854.5</c:v>
                </c:pt>
                <c:pt idx="1710">
                  <c:v>855</c:v>
                </c:pt>
                <c:pt idx="1711">
                  <c:v>855.5</c:v>
                </c:pt>
                <c:pt idx="1712">
                  <c:v>856</c:v>
                </c:pt>
                <c:pt idx="1713">
                  <c:v>856.5</c:v>
                </c:pt>
                <c:pt idx="1714">
                  <c:v>857</c:v>
                </c:pt>
                <c:pt idx="1715">
                  <c:v>857.5</c:v>
                </c:pt>
                <c:pt idx="1716">
                  <c:v>858</c:v>
                </c:pt>
                <c:pt idx="1717">
                  <c:v>858.5</c:v>
                </c:pt>
                <c:pt idx="1718">
                  <c:v>859</c:v>
                </c:pt>
                <c:pt idx="1719">
                  <c:v>859.5</c:v>
                </c:pt>
                <c:pt idx="1720">
                  <c:v>860</c:v>
                </c:pt>
                <c:pt idx="1721">
                  <c:v>860.5</c:v>
                </c:pt>
                <c:pt idx="1722">
                  <c:v>861</c:v>
                </c:pt>
                <c:pt idx="1723">
                  <c:v>861.5</c:v>
                </c:pt>
                <c:pt idx="1724">
                  <c:v>862</c:v>
                </c:pt>
                <c:pt idx="1725">
                  <c:v>862.5</c:v>
                </c:pt>
                <c:pt idx="1726">
                  <c:v>863</c:v>
                </c:pt>
                <c:pt idx="1727">
                  <c:v>863.5</c:v>
                </c:pt>
                <c:pt idx="1728">
                  <c:v>864</c:v>
                </c:pt>
                <c:pt idx="1729">
                  <c:v>864.5</c:v>
                </c:pt>
                <c:pt idx="1730">
                  <c:v>865</c:v>
                </c:pt>
                <c:pt idx="1731">
                  <c:v>865.5</c:v>
                </c:pt>
                <c:pt idx="1732">
                  <c:v>866</c:v>
                </c:pt>
                <c:pt idx="1733">
                  <c:v>866.5</c:v>
                </c:pt>
                <c:pt idx="1734">
                  <c:v>867</c:v>
                </c:pt>
                <c:pt idx="1735">
                  <c:v>867.5</c:v>
                </c:pt>
                <c:pt idx="1736">
                  <c:v>868</c:v>
                </c:pt>
                <c:pt idx="1737">
                  <c:v>868.5</c:v>
                </c:pt>
                <c:pt idx="1738">
                  <c:v>869</c:v>
                </c:pt>
                <c:pt idx="1739">
                  <c:v>869.5</c:v>
                </c:pt>
                <c:pt idx="1740">
                  <c:v>870</c:v>
                </c:pt>
                <c:pt idx="1741">
                  <c:v>870.5</c:v>
                </c:pt>
                <c:pt idx="1742">
                  <c:v>871</c:v>
                </c:pt>
                <c:pt idx="1743">
                  <c:v>871.5</c:v>
                </c:pt>
                <c:pt idx="1744">
                  <c:v>872</c:v>
                </c:pt>
                <c:pt idx="1745">
                  <c:v>872.5</c:v>
                </c:pt>
                <c:pt idx="1746">
                  <c:v>873</c:v>
                </c:pt>
                <c:pt idx="1747">
                  <c:v>873.5</c:v>
                </c:pt>
                <c:pt idx="1748">
                  <c:v>874</c:v>
                </c:pt>
                <c:pt idx="1749">
                  <c:v>874.5</c:v>
                </c:pt>
                <c:pt idx="1750">
                  <c:v>875</c:v>
                </c:pt>
                <c:pt idx="1751">
                  <c:v>875.5</c:v>
                </c:pt>
                <c:pt idx="1752">
                  <c:v>876</c:v>
                </c:pt>
                <c:pt idx="1753">
                  <c:v>876.5</c:v>
                </c:pt>
                <c:pt idx="1754">
                  <c:v>877</c:v>
                </c:pt>
                <c:pt idx="1755">
                  <c:v>877.5</c:v>
                </c:pt>
                <c:pt idx="1756">
                  <c:v>878</c:v>
                </c:pt>
                <c:pt idx="1757">
                  <c:v>878.5</c:v>
                </c:pt>
                <c:pt idx="1758">
                  <c:v>879</c:v>
                </c:pt>
                <c:pt idx="1759">
                  <c:v>879.5</c:v>
                </c:pt>
                <c:pt idx="1760">
                  <c:v>880</c:v>
                </c:pt>
                <c:pt idx="1761">
                  <c:v>880.5</c:v>
                </c:pt>
                <c:pt idx="1762">
                  <c:v>881</c:v>
                </c:pt>
                <c:pt idx="1763">
                  <c:v>881.5</c:v>
                </c:pt>
                <c:pt idx="1764">
                  <c:v>882</c:v>
                </c:pt>
                <c:pt idx="1765">
                  <c:v>882.5</c:v>
                </c:pt>
                <c:pt idx="1766">
                  <c:v>883</c:v>
                </c:pt>
                <c:pt idx="1767">
                  <c:v>883.5</c:v>
                </c:pt>
                <c:pt idx="1768">
                  <c:v>884</c:v>
                </c:pt>
                <c:pt idx="1769">
                  <c:v>884.5</c:v>
                </c:pt>
                <c:pt idx="1770">
                  <c:v>885</c:v>
                </c:pt>
                <c:pt idx="1771">
                  <c:v>885.5</c:v>
                </c:pt>
                <c:pt idx="1772">
                  <c:v>886</c:v>
                </c:pt>
                <c:pt idx="1773">
                  <c:v>886.5</c:v>
                </c:pt>
                <c:pt idx="1774">
                  <c:v>887</c:v>
                </c:pt>
                <c:pt idx="1775">
                  <c:v>887.5</c:v>
                </c:pt>
                <c:pt idx="1776">
                  <c:v>888</c:v>
                </c:pt>
                <c:pt idx="1777">
                  <c:v>888.5</c:v>
                </c:pt>
                <c:pt idx="1778">
                  <c:v>889</c:v>
                </c:pt>
                <c:pt idx="1779">
                  <c:v>889.5</c:v>
                </c:pt>
                <c:pt idx="1780">
                  <c:v>890</c:v>
                </c:pt>
                <c:pt idx="1781">
                  <c:v>890.5</c:v>
                </c:pt>
                <c:pt idx="1782">
                  <c:v>891</c:v>
                </c:pt>
                <c:pt idx="1783">
                  <c:v>891.5</c:v>
                </c:pt>
                <c:pt idx="1784">
                  <c:v>892</c:v>
                </c:pt>
                <c:pt idx="1785">
                  <c:v>892.5</c:v>
                </c:pt>
                <c:pt idx="1786">
                  <c:v>893</c:v>
                </c:pt>
                <c:pt idx="1787">
                  <c:v>893.5</c:v>
                </c:pt>
                <c:pt idx="1788">
                  <c:v>894</c:v>
                </c:pt>
                <c:pt idx="1789">
                  <c:v>894.5</c:v>
                </c:pt>
                <c:pt idx="1790">
                  <c:v>895</c:v>
                </c:pt>
                <c:pt idx="1791">
                  <c:v>895.5</c:v>
                </c:pt>
                <c:pt idx="1792">
                  <c:v>896</c:v>
                </c:pt>
                <c:pt idx="1793">
                  <c:v>896.5</c:v>
                </c:pt>
                <c:pt idx="1794">
                  <c:v>897</c:v>
                </c:pt>
                <c:pt idx="1795">
                  <c:v>897.5</c:v>
                </c:pt>
                <c:pt idx="1796">
                  <c:v>898</c:v>
                </c:pt>
                <c:pt idx="1797">
                  <c:v>898.5</c:v>
                </c:pt>
                <c:pt idx="1798">
                  <c:v>899</c:v>
                </c:pt>
                <c:pt idx="1799">
                  <c:v>899.5</c:v>
                </c:pt>
                <c:pt idx="1800">
                  <c:v>900</c:v>
                </c:pt>
                <c:pt idx="1801">
                  <c:v>900.5</c:v>
                </c:pt>
                <c:pt idx="1802">
                  <c:v>901</c:v>
                </c:pt>
                <c:pt idx="1803">
                  <c:v>901.5</c:v>
                </c:pt>
                <c:pt idx="1804">
                  <c:v>902</c:v>
                </c:pt>
                <c:pt idx="1805">
                  <c:v>902.5</c:v>
                </c:pt>
                <c:pt idx="1806">
                  <c:v>903</c:v>
                </c:pt>
                <c:pt idx="1807">
                  <c:v>903.5</c:v>
                </c:pt>
                <c:pt idx="1808">
                  <c:v>904</c:v>
                </c:pt>
                <c:pt idx="1809">
                  <c:v>904.5</c:v>
                </c:pt>
                <c:pt idx="1810">
                  <c:v>905</c:v>
                </c:pt>
                <c:pt idx="1811">
                  <c:v>905.5</c:v>
                </c:pt>
                <c:pt idx="1812">
                  <c:v>906</c:v>
                </c:pt>
                <c:pt idx="1813">
                  <c:v>906.5</c:v>
                </c:pt>
                <c:pt idx="1814">
                  <c:v>907</c:v>
                </c:pt>
                <c:pt idx="1815">
                  <c:v>907.5</c:v>
                </c:pt>
                <c:pt idx="1816">
                  <c:v>908</c:v>
                </c:pt>
                <c:pt idx="1817">
                  <c:v>908.5</c:v>
                </c:pt>
                <c:pt idx="1818">
                  <c:v>909</c:v>
                </c:pt>
                <c:pt idx="1819">
                  <c:v>909.5</c:v>
                </c:pt>
                <c:pt idx="1820">
                  <c:v>910</c:v>
                </c:pt>
                <c:pt idx="1821">
                  <c:v>910.5</c:v>
                </c:pt>
                <c:pt idx="1822">
                  <c:v>911</c:v>
                </c:pt>
                <c:pt idx="1823">
                  <c:v>911.5</c:v>
                </c:pt>
                <c:pt idx="1824">
                  <c:v>912</c:v>
                </c:pt>
                <c:pt idx="1825">
                  <c:v>912.5</c:v>
                </c:pt>
                <c:pt idx="1826">
                  <c:v>913</c:v>
                </c:pt>
                <c:pt idx="1827">
                  <c:v>913.5</c:v>
                </c:pt>
                <c:pt idx="1828">
                  <c:v>914</c:v>
                </c:pt>
                <c:pt idx="1829">
                  <c:v>914.5</c:v>
                </c:pt>
                <c:pt idx="1830">
                  <c:v>915</c:v>
                </c:pt>
                <c:pt idx="1831">
                  <c:v>915.5</c:v>
                </c:pt>
                <c:pt idx="1832">
                  <c:v>916</c:v>
                </c:pt>
                <c:pt idx="1833">
                  <c:v>916.5</c:v>
                </c:pt>
                <c:pt idx="1834">
                  <c:v>917</c:v>
                </c:pt>
                <c:pt idx="1835">
                  <c:v>917.5</c:v>
                </c:pt>
                <c:pt idx="1836">
                  <c:v>918</c:v>
                </c:pt>
                <c:pt idx="1837">
                  <c:v>918.5</c:v>
                </c:pt>
                <c:pt idx="1838">
                  <c:v>919</c:v>
                </c:pt>
                <c:pt idx="1839">
                  <c:v>919.5</c:v>
                </c:pt>
                <c:pt idx="1840">
                  <c:v>920</c:v>
                </c:pt>
                <c:pt idx="1841">
                  <c:v>920.5</c:v>
                </c:pt>
                <c:pt idx="1842">
                  <c:v>921</c:v>
                </c:pt>
                <c:pt idx="1843">
                  <c:v>921.5</c:v>
                </c:pt>
                <c:pt idx="1844">
                  <c:v>922</c:v>
                </c:pt>
                <c:pt idx="1845">
                  <c:v>922.5</c:v>
                </c:pt>
                <c:pt idx="1846">
                  <c:v>923</c:v>
                </c:pt>
                <c:pt idx="1847">
                  <c:v>923.5</c:v>
                </c:pt>
                <c:pt idx="1848">
                  <c:v>924</c:v>
                </c:pt>
                <c:pt idx="1849">
                  <c:v>924.5</c:v>
                </c:pt>
                <c:pt idx="1850">
                  <c:v>925</c:v>
                </c:pt>
                <c:pt idx="1851">
                  <c:v>925.5</c:v>
                </c:pt>
                <c:pt idx="1852">
                  <c:v>926</c:v>
                </c:pt>
                <c:pt idx="1853">
                  <c:v>926.5</c:v>
                </c:pt>
                <c:pt idx="1854">
                  <c:v>927</c:v>
                </c:pt>
                <c:pt idx="1855">
                  <c:v>927.5</c:v>
                </c:pt>
                <c:pt idx="1856">
                  <c:v>928</c:v>
                </c:pt>
                <c:pt idx="1857">
                  <c:v>928.5</c:v>
                </c:pt>
                <c:pt idx="1858">
                  <c:v>929</c:v>
                </c:pt>
                <c:pt idx="1859">
                  <c:v>929.5</c:v>
                </c:pt>
                <c:pt idx="1860">
                  <c:v>930</c:v>
                </c:pt>
                <c:pt idx="1861">
                  <c:v>930.5</c:v>
                </c:pt>
                <c:pt idx="1862">
                  <c:v>931</c:v>
                </c:pt>
                <c:pt idx="1863">
                  <c:v>931.5</c:v>
                </c:pt>
                <c:pt idx="1864">
                  <c:v>932</c:v>
                </c:pt>
                <c:pt idx="1865">
                  <c:v>932.5</c:v>
                </c:pt>
                <c:pt idx="1866">
                  <c:v>933</c:v>
                </c:pt>
                <c:pt idx="1867">
                  <c:v>933.5</c:v>
                </c:pt>
                <c:pt idx="1868">
                  <c:v>934</c:v>
                </c:pt>
                <c:pt idx="1869">
                  <c:v>934.5</c:v>
                </c:pt>
                <c:pt idx="1870">
                  <c:v>935</c:v>
                </c:pt>
                <c:pt idx="1871">
                  <c:v>935.5</c:v>
                </c:pt>
                <c:pt idx="1872">
                  <c:v>936</c:v>
                </c:pt>
                <c:pt idx="1873">
                  <c:v>936.5</c:v>
                </c:pt>
                <c:pt idx="1874">
                  <c:v>937</c:v>
                </c:pt>
                <c:pt idx="1875">
                  <c:v>937.5</c:v>
                </c:pt>
                <c:pt idx="1876">
                  <c:v>938</c:v>
                </c:pt>
                <c:pt idx="1877">
                  <c:v>938.5</c:v>
                </c:pt>
                <c:pt idx="1878">
                  <c:v>939</c:v>
                </c:pt>
                <c:pt idx="1879">
                  <c:v>939.5</c:v>
                </c:pt>
                <c:pt idx="1880">
                  <c:v>940</c:v>
                </c:pt>
                <c:pt idx="1881">
                  <c:v>940.5</c:v>
                </c:pt>
                <c:pt idx="1882">
                  <c:v>941</c:v>
                </c:pt>
                <c:pt idx="1883">
                  <c:v>941.5</c:v>
                </c:pt>
                <c:pt idx="1884">
                  <c:v>942</c:v>
                </c:pt>
                <c:pt idx="1885">
                  <c:v>942.5</c:v>
                </c:pt>
                <c:pt idx="1886">
                  <c:v>943</c:v>
                </c:pt>
                <c:pt idx="1887">
                  <c:v>943.5</c:v>
                </c:pt>
                <c:pt idx="1888">
                  <c:v>944</c:v>
                </c:pt>
                <c:pt idx="1889">
                  <c:v>944.5</c:v>
                </c:pt>
                <c:pt idx="1890">
                  <c:v>945</c:v>
                </c:pt>
                <c:pt idx="1891">
                  <c:v>945.5</c:v>
                </c:pt>
                <c:pt idx="1892">
                  <c:v>946</c:v>
                </c:pt>
                <c:pt idx="1893">
                  <c:v>946.5</c:v>
                </c:pt>
                <c:pt idx="1894">
                  <c:v>947</c:v>
                </c:pt>
                <c:pt idx="1895">
                  <c:v>947.5</c:v>
                </c:pt>
                <c:pt idx="1896">
                  <c:v>948</c:v>
                </c:pt>
                <c:pt idx="1897">
                  <c:v>948.5</c:v>
                </c:pt>
                <c:pt idx="1898">
                  <c:v>949</c:v>
                </c:pt>
                <c:pt idx="1899">
                  <c:v>949.5</c:v>
                </c:pt>
                <c:pt idx="1900">
                  <c:v>950</c:v>
                </c:pt>
                <c:pt idx="1901">
                  <c:v>950.5</c:v>
                </c:pt>
                <c:pt idx="1902">
                  <c:v>951</c:v>
                </c:pt>
                <c:pt idx="1903">
                  <c:v>951.5</c:v>
                </c:pt>
                <c:pt idx="1904">
                  <c:v>952</c:v>
                </c:pt>
                <c:pt idx="1905">
                  <c:v>952.5</c:v>
                </c:pt>
                <c:pt idx="1906">
                  <c:v>953</c:v>
                </c:pt>
                <c:pt idx="1907">
                  <c:v>953.5</c:v>
                </c:pt>
                <c:pt idx="1908">
                  <c:v>954</c:v>
                </c:pt>
                <c:pt idx="1909">
                  <c:v>954.5</c:v>
                </c:pt>
                <c:pt idx="1910">
                  <c:v>955</c:v>
                </c:pt>
                <c:pt idx="1911">
                  <c:v>955.5</c:v>
                </c:pt>
                <c:pt idx="1912">
                  <c:v>956</c:v>
                </c:pt>
                <c:pt idx="1913">
                  <c:v>956.5</c:v>
                </c:pt>
                <c:pt idx="1914">
                  <c:v>957</c:v>
                </c:pt>
                <c:pt idx="1915">
                  <c:v>957.5</c:v>
                </c:pt>
                <c:pt idx="1916">
                  <c:v>958</c:v>
                </c:pt>
                <c:pt idx="1917">
                  <c:v>958.5</c:v>
                </c:pt>
                <c:pt idx="1918">
                  <c:v>959</c:v>
                </c:pt>
                <c:pt idx="1919">
                  <c:v>959.5</c:v>
                </c:pt>
                <c:pt idx="1920">
                  <c:v>960</c:v>
                </c:pt>
                <c:pt idx="1921">
                  <c:v>960.5</c:v>
                </c:pt>
                <c:pt idx="1922">
                  <c:v>961</c:v>
                </c:pt>
                <c:pt idx="1923">
                  <c:v>961.5</c:v>
                </c:pt>
                <c:pt idx="1924">
                  <c:v>962</c:v>
                </c:pt>
                <c:pt idx="1925">
                  <c:v>962.5</c:v>
                </c:pt>
                <c:pt idx="1926">
                  <c:v>963</c:v>
                </c:pt>
                <c:pt idx="1927">
                  <c:v>963.5</c:v>
                </c:pt>
                <c:pt idx="1928">
                  <c:v>964</c:v>
                </c:pt>
                <c:pt idx="1929">
                  <c:v>964.5</c:v>
                </c:pt>
                <c:pt idx="1930">
                  <c:v>965</c:v>
                </c:pt>
                <c:pt idx="1931">
                  <c:v>965.5</c:v>
                </c:pt>
                <c:pt idx="1932">
                  <c:v>966</c:v>
                </c:pt>
                <c:pt idx="1933">
                  <c:v>966.5</c:v>
                </c:pt>
                <c:pt idx="1934">
                  <c:v>967</c:v>
                </c:pt>
                <c:pt idx="1935">
                  <c:v>967.5</c:v>
                </c:pt>
                <c:pt idx="1936">
                  <c:v>968</c:v>
                </c:pt>
                <c:pt idx="1937">
                  <c:v>968.5</c:v>
                </c:pt>
                <c:pt idx="1938">
                  <c:v>969</c:v>
                </c:pt>
                <c:pt idx="1939">
                  <c:v>969.5</c:v>
                </c:pt>
                <c:pt idx="1940">
                  <c:v>970</c:v>
                </c:pt>
                <c:pt idx="1941">
                  <c:v>970.5</c:v>
                </c:pt>
                <c:pt idx="1942">
                  <c:v>971</c:v>
                </c:pt>
                <c:pt idx="1943">
                  <c:v>971.5</c:v>
                </c:pt>
                <c:pt idx="1944">
                  <c:v>972</c:v>
                </c:pt>
                <c:pt idx="1945">
                  <c:v>972.5</c:v>
                </c:pt>
                <c:pt idx="1946">
                  <c:v>973</c:v>
                </c:pt>
                <c:pt idx="1947">
                  <c:v>973.5</c:v>
                </c:pt>
                <c:pt idx="1948">
                  <c:v>974</c:v>
                </c:pt>
                <c:pt idx="1949">
                  <c:v>974.5</c:v>
                </c:pt>
                <c:pt idx="1950">
                  <c:v>975</c:v>
                </c:pt>
                <c:pt idx="1951">
                  <c:v>975.5</c:v>
                </c:pt>
                <c:pt idx="1952">
                  <c:v>976</c:v>
                </c:pt>
                <c:pt idx="1953">
                  <c:v>976.5</c:v>
                </c:pt>
                <c:pt idx="1954">
                  <c:v>977</c:v>
                </c:pt>
                <c:pt idx="1955">
                  <c:v>977.5</c:v>
                </c:pt>
                <c:pt idx="1956">
                  <c:v>978</c:v>
                </c:pt>
                <c:pt idx="1957">
                  <c:v>978.5</c:v>
                </c:pt>
                <c:pt idx="1958">
                  <c:v>979</c:v>
                </c:pt>
                <c:pt idx="1959">
                  <c:v>979.5</c:v>
                </c:pt>
                <c:pt idx="1960">
                  <c:v>980</c:v>
                </c:pt>
                <c:pt idx="1961">
                  <c:v>980.5</c:v>
                </c:pt>
                <c:pt idx="1962">
                  <c:v>981</c:v>
                </c:pt>
                <c:pt idx="1963">
                  <c:v>981.5</c:v>
                </c:pt>
                <c:pt idx="1964">
                  <c:v>982</c:v>
                </c:pt>
                <c:pt idx="1965">
                  <c:v>982.5</c:v>
                </c:pt>
                <c:pt idx="1966">
                  <c:v>983</c:v>
                </c:pt>
                <c:pt idx="1967">
                  <c:v>983.5</c:v>
                </c:pt>
                <c:pt idx="1968">
                  <c:v>984</c:v>
                </c:pt>
                <c:pt idx="1969">
                  <c:v>984.5</c:v>
                </c:pt>
                <c:pt idx="1970">
                  <c:v>985</c:v>
                </c:pt>
                <c:pt idx="1971">
                  <c:v>985.5</c:v>
                </c:pt>
                <c:pt idx="1972">
                  <c:v>986</c:v>
                </c:pt>
                <c:pt idx="1973">
                  <c:v>986.5</c:v>
                </c:pt>
                <c:pt idx="1974">
                  <c:v>987</c:v>
                </c:pt>
                <c:pt idx="1975">
                  <c:v>987.5</c:v>
                </c:pt>
                <c:pt idx="1976">
                  <c:v>988</c:v>
                </c:pt>
                <c:pt idx="1977">
                  <c:v>988.5</c:v>
                </c:pt>
                <c:pt idx="1978">
                  <c:v>989</c:v>
                </c:pt>
                <c:pt idx="1979">
                  <c:v>989.5</c:v>
                </c:pt>
                <c:pt idx="1980">
                  <c:v>990</c:v>
                </c:pt>
                <c:pt idx="1981">
                  <c:v>990.5</c:v>
                </c:pt>
                <c:pt idx="1982">
                  <c:v>991</c:v>
                </c:pt>
                <c:pt idx="1983">
                  <c:v>991.5</c:v>
                </c:pt>
                <c:pt idx="1984">
                  <c:v>992</c:v>
                </c:pt>
                <c:pt idx="1985">
                  <c:v>992.5</c:v>
                </c:pt>
                <c:pt idx="1986">
                  <c:v>993</c:v>
                </c:pt>
                <c:pt idx="1987">
                  <c:v>993.5</c:v>
                </c:pt>
                <c:pt idx="1988">
                  <c:v>994</c:v>
                </c:pt>
                <c:pt idx="1989">
                  <c:v>994.5</c:v>
                </c:pt>
                <c:pt idx="1990">
                  <c:v>995</c:v>
                </c:pt>
                <c:pt idx="1991">
                  <c:v>995.5</c:v>
                </c:pt>
                <c:pt idx="1992">
                  <c:v>996</c:v>
                </c:pt>
                <c:pt idx="1993">
                  <c:v>996.5</c:v>
                </c:pt>
                <c:pt idx="1994">
                  <c:v>997</c:v>
                </c:pt>
                <c:pt idx="1995">
                  <c:v>997.5</c:v>
                </c:pt>
                <c:pt idx="1996">
                  <c:v>998</c:v>
                </c:pt>
                <c:pt idx="1997">
                  <c:v>998.5</c:v>
                </c:pt>
                <c:pt idx="1998">
                  <c:v>999</c:v>
                </c:pt>
                <c:pt idx="1999">
                  <c:v>999.5</c:v>
                </c:pt>
                <c:pt idx="2000">
                  <c:v>1000</c:v>
                </c:pt>
                <c:pt idx="2001">
                  <c:v>1000.5</c:v>
                </c:pt>
                <c:pt idx="2002">
                  <c:v>1001</c:v>
                </c:pt>
                <c:pt idx="2003">
                  <c:v>1001.5</c:v>
                </c:pt>
                <c:pt idx="2004">
                  <c:v>1002</c:v>
                </c:pt>
                <c:pt idx="2005">
                  <c:v>1002.5</c:v>
                </c:pt>
                <c:pt idx="2006">
                  <c:v>1003</c:v>
                </c:pt>
                <c:pt idx="2007">
                  <c:v>1003.5</c:v>
                </c:pt>
                <c:pt idx="2008">
                  <c:v>1004</c:v>
                </c:pt>
                <c:pt idx="2009">
                  <c:v>1004.5</c:v>
                </c:pt>
                <c:pt idx="2010">
                  <c:v>1005</c:v>
                </c:pt>
                <c:pt idx="2011">
                  <c:v>1005.5</c:v>
                </c:pt>
                <c:pt idx="2012">
                  <c:v>1006</c:v>
                </c:pt>
                <c:pt idx="2013">
                  <c:v>1006.5</c:v>
                </c:pt>
                <c:pt idx="2014">
                  <c:v>1007</c:v>
                </c:pt>
                <c:pt idx="2015">
                  <c:v>1007.5</c:v>
                </c:pt>
                <c:pt idx="2016">
                  <c:v>1008</c:v>
                </c:pt>
                <c:pt idx="2017">
                  <c:v>1008.5</c:v>
                </c:pt>
                <c:pt idx="2018">
                  <c:v>1009</c:v>
                </c:pt>
                <c:pt idx="2019">
                  <c:v>1009.5</c:v>
                </c:pt>
                <c:pt idx="2020">
                  <c:v>1010</c:v>
                </c:pt>
                <c:pt idx="2021">
                  <c:v>1010.5</c:v>
                </c:pt>
                <c:pt idx="2022">
                  <c:v>1011</c:v>
                </c:pt>
                <c:pt idx="2023">
                  <c:v>1011.5</c:v>
                </c:pt>
                <c:pt idx="2024">
                  <c:v>1012</c:v>
                </c:pt>
                <c:pt idx="2025">
                  <c:v>1012.5</c:v>
                </c:pt>
                <c:pt idx="2026">
                  <c:v>1013</c:v>
                </c:pt>
                <c:pt idx="2027">
                  <c:v>1013.5</c:v>
                </c:pt>
                <c:pt idx="2028">
                  <c:v>1014</c:v>
                </c:pt>
                <c:pt idx="2029">
                  <c:v>1014.5</c:v>
                </c:pt>
                <c:pt idx="2030">
                  <c:v>1015</c:v>
                </c:pt>
                <c:pt idx="2031">
                  <c:v>1015.5</c:v>
                </c:pt>
                <c:pt idx="2032">
                  <c:v>1016</c:v>
                </c:pt>
                <c:pt idx="2033">
                  <c:v>1016.5</c:v>
                </c:pt>
                <c:pt idx="2034">
                  <c:v>1017</c:v>
                </c:pt>
                <c:pt idx="2035">
                  <c:v>1017.5</c:v>
                </c:pt>
                <c:pt idx="2036">
                  <c:v>1018</c:v>
                </c:pt>
                <c:pt idx="2037">
                  <c:v>1018.5</c:v>
                </c:pt>
                <c:pt idx="2038">
                  <c:v>1019</c:v>
                </c:pt>
                <c:pt idx="2039">
                  <c:v>1019.5</c:v>
                </c:pt>
                <c:pt idx="2040">
                  <c:v>1020</c:v>
                </c:pt>
                <c:pt idx="2041">
                  <c:v>1020.5</c:v>
                </c:pt>
                <c:pt idx="2042">
                  <c:v>1021</c:v>
                </c:pt>
                <c:pt idx="2043">
                  <c:v>1021.5</c:v>
                </c:pt>
                <c:pt idx="2044">
                  <c:v>1022</c:v>
                </c:pt>
                <c:pt idx="2045">
                  <c:v>1022.5</c:v>
                </c:pt>
                <c:pt idx="2046">
                  <c:v>1023</c:v>
                </c:pt>
                <c:pt idx="2047">
                  <c:v>1023.5</c:v>
                </c:pt>
                <c:pt idx="2048">
                  <c:v>1024</c:v>
                </c:pt>
                <c:pt idx="2049">
                  <c:v>1024.5</c:v>
                </c:pt>
                <c:pt idx="2050">
                  <c:v>1025</c:v>
                </c:pt>
                <c:pt idx="2051">
                  <c:v>1025.5</c:v>
                </c:pt>
                <c:pt idx="2052">
                  <c:v>1026</c:v>
                </c:pt>
                <c:pt idx="2053">
                  <c:v>1026.5</c:v>
                </c:pt>
                <c:pt idx="2054">
                  <c:v>1027</c:v>
                </c:pt>
                <c:pt idx="2055">
                  <c:v>1027.5</c:v>
                </c:pt>
                <c:pt idx="2056">
                  <c:v>1028</c:v>
                </c:pt>
                <c:pt idx="2057">
                  <c:v>1028.5</c:v>
                </c:pt>
                <c:pt idx="2058">
                  <c:v>1029</c:v>
                </c:pt>
                <c:pt idx="2059">
                  <c:v>1029.5</c:v>
                </c:pt>
                <c:pt idx="2060">
                  <c:v>1030</c:v>
                </c:pt>
                <c:pt idx="2061">
                  <c:v>1030.5</c:v>
                </c:pt>
                <c:pt idx="2062">
                  <c:v>1031</c:v>
                </c:pt>
                <c:pt idx="2063">
                  <c:v>1031.5</c:v>
                </c:pt>
                <c:pt idx="2064">
                  <c:v>1032</c:v>
                </c:pt>
                <c:pt idx="2065">
                  <c:v>1032.5</c:v>
                </c:pt>
                <c:pt idx="2066">
                  <c:v>1033</c:v>
                </c:pt>
                <c:pt idx="2067">
                  <c:v>1033.5</c:v>
                </c:pt>
                <c:pt idx="2068">
                  <c:v>1034</c:v>
                </c:pt>
                <c:pt idx="2069">
                  <c:v>1034.5</c:v>
                </c:pt>
                <c:pt idx="2070">
                  <c:v>1035</c:v>
                </c:pt>
                <c:pt idx="2071">
                  <c:v>1035.5</c:v>
                </c:pt>
                <c:pt idx="2072">
                  <c:v>1036</c:v>
                </c:pt>
                <c:pt idx="2073">
                  <c:v>1036.5</c:v>
                </c:pt>
                <c:pt idx="2074">
                  <c:v>1037</c:v>
                </c:pt>
                <c:pt idx="2075">
                  <c:v>1037.5</c:v>
                </c:pt>
                <c:pt idx="2076">
                  <c:v>1038</c:v>
                </c:pt>
                <c:pt idx="2077">
                  <c:v>1038.5</c:v>
                </c:pt>
                <c:pt idx="2078">
                  <c:v>1039</c:v>
                </c:pt>
                <c:pt idx="2079">
                  <c:v>1039.5</c:v>
                </c:pt>
                <c:pt idx="2080">
                  <c:v>1040</c:v>
                </c:pt>
                <c:pt idx="2081">
                  <c:v>1040.5</c:v>
                </c:pt>
                <c:pt idx="2082">
                  <c:v>1041</c:v>
                </c:pt>
                <c:pt idx="2083">
                  <c:v>1041.5</c:v>
                </c:pt>
                <c:pt idx="2084">
                  <c:v>1042</c:v>
                </c:pt>
                <c:pt idx="2085">
                  <c:v>1042.5</c:v>
                </c:pt>
                <c:pt idx="2086">
                  <c:v>1043</c:v>
                </c:pt>
                <c:pt idx="2087">
                  <c:v>1043.5</c:v>
                </c:pt>
                <c:pt idx="2088">
                  <c:v>1044</c:v>
                </c:pt>
                <c:pt idx="2089">
                  <c:v>1044.5</c:v>
                </c:pt>
                <c:pt idx="2090">
                  <c:v>1045</c:v>
                </c:pt>
                <c:pt idx="2091">
                  <c:v>1045.5</c:v>
                </c:pt>
                <c:pt idx="2092">
                  <c:v>1046</c:v>
                </c:pt>
                <c:pt idx="2093">
                  <c:v>1046.5</c:v>
                </c:pt>
                <c:pt idx="2094">
                  <c:v>1047</c:v>
                </c:pt>
                <c:pt idx="2095">
                  <c:v>1047.5</c:v>
                </c:pt>
                <c:pt idx="2096">
                  <c:v>1048</c:v>
                </c:pt>
                <c:pt idx="2097">
                  <c:v>1048.5</c:v>
                </c:pt>
                <c:pt idx="2098">
                  <c:v>1049</c:v>
                </c:pt>
                <c:pt idx="2099">
                  <c:v>1049.5</c:v>
                </c:pt>
                <c:pt idx="2100">
                  <c:v>1050</c:v>
                </c:pt>
                <c:pt idx="2101">
                  <c:v>1050.5</c:v>
                </c:pt>
                <c:pt idx="2102">
                  <c:v>1051</c:v>
                </c:pt>
                <c:pt idx="2103">
                  <c:v>1051.5</c:v>
                </c:pt>
                <c:pt idx="2104">
                  <c:v>1052</c:v>
                </c:pt>
                <c:pt idx="2105">
                  <c:v>1052.5</c:v>
                </c:pt>
                <c:pt idx="2106">
                  <c:v>1053</c:v>
                </c:pt>
                <c:pt idx="2107">
                  <c:v>1053.5</c:v>
                </c:pt>
                <c:pt idx="2108">
                  <c:v>1054</c:v>
                </c:pt>
                <c:pt idx="2109">
                  <c:v>1054.5</c:v>
                </c:pt>
                <c:pt idx="2110">
                  <c:v>1055</c:v>
                </c:pt>
                <c:pt idx="2111">
                  <c:v>1055.5</c:v>
                </c:pt>
                <c:pt idx="2112">
                  <c:v>1056</c:v>
                </c:pt>
                <c:pt idx="2113">
                  <c:v>1056.5</c:v>
                </c:pt>
                <c:pt idx="2114">
                  <c:v>1057</c:v>
                </c:pt>
                <c:pt idx="2115">
                  <c:v>1057.5</c:v>
                </c:pt>
                <c:pt idx="2116">
                  <c:v>1058</c:v>
                </c:pt>
                <c:pt idx="2117">
                  <c:v>1058.5</c:v>
                </c:pt>
                <c:pt idx="2118">
                  <c:v>1059</c:v>
                </c:pt>
                <c:pt idx="2119">
                  <c:v>1059.5</c:v>
                </c:pt>
                <c:pt idx="2120">
                  <c:v>1060</c:v>
                </c:pt>
                <c:pt idx="2121">
                  <c:v>1060.5</c:v>
                </c:pt>
                <c:pt idx="2122">
                  <c:v>1061</c:v>
                </c:pt>
                <c:pt idx="2123">
                  <c:v>1061.5</c:v>
                </c:pt>
                <c:pt idx="2124">
                  <c:v>1062</c:v>
                </c:pt>
                <c:pt idx="2125">
                  <c:v>1062.5</c:v>
                </c:pt>
                <c:pt idx="2126">
                  <c:v>1063</c:v>
                </c:pt>
                <c:pt idx="2127">
                  <c:v>1063.5</c:v>
                </c:pt>
                <c:pt idx="2128">
                  <c:v>1064</c:v>
                </c:pt>
                <c:pt idx="2129">
                  <c:v>1064.5</c:v>
                </c:pt>
                <c:pt idx="2130">
                  <c:v>1065</c:v>
                </c:pt>
                <c:pt idx="2131">
                  <c:v>1065.5</c:v>
                </c:pt>
                <c:pt idx="2132">
                  <c:v>1066</c:v>
                </c:pt>
                <c:pt idx="2133">
                  <c:v>1066.5</c:v>
                </c:pt>
                <c:pt idx="2134">
                  <c:v>1067</c:v>
                </c:pt>
                <c:pt idx="2135">
                  <c:v>1067.5</c:v>
                </c:pt>
                <c:pt idx="2136">
                  <c:v>1068</c:v>
                </c:pt>
                <c:pt idx="2137">
                  <c:v>1068.5</c:v>
                </c:pt>
                <c:pt idx="2138">
                  <c:v>1069</c:v>
                </c:pt>
                <c:pt idx="2139">
                  <c:v>1069.5</c:v>
                </c:pt>
                <c:pt idx="2140">
                  <c:v>1070</c:v>
                </c:pt>
                <c:pt idx="2141">
                  <c:v>1070.5</c:v>
                </c:pt>
                <c:pt idx="2142">
                  <c:v>1071</c:v>
                </c:pt>
                <c:pt idx="2143">
                  <c:v>1071.5</c:v>
                </c:pt>
                <c:pt idx="2144">
                  <c:v>1072</c:v>
                </c:pt>
                <c:pt idx="2145">
                  <c:v>1072.5</c:v>
                </c:pt>
                <c:pt idx="2146">
                  <c:v>1073</c:v>
                </c:pt>
                <c:pt idx="2147">
                  <c:v>1073.5</c:v>
                </c:pt>
                <c:pt idx="2148">
                  <c:v>1074</c:v>
                </c:pt>
                <c:pt idx="2149">
                  <c:v>1074.5</c:v>
                </c:pt>
                <c:pt idx="2150">
                  <c:v>1075</c:v>
                </c:pt>
                <c:pt idx="2151">
                  <c:v>1075.5</c:v>
                </c:pt>
                <c:pt idx="2152">
                  <c:v>1076</c:v>
                </c:pt>
                <c:pt idx="2153">
                  <c:v>1076.5</c:v>
                </c:pt>
                <c:pt idx="2154">
                  <c:v>1077</c:v>
                </c:pt>
                <c:pt idx="2155">
                  <c:v>1077.5</c:v>
                </c:pt>
                <c:pt idx="2156">
                  <c:v>1078</c:v>
                </c:pt>
                <c:pt idx="2157">
                  <c:v>1078.5</c:v>
                </c:pt>
                <c:pt idx="2158">
                  <c:v>1079</c:v>
                </c:pt>
                <c:pt idx="2159">
                  <c:v>1079.5</c:v>
                </c:pt>
                <c:pt idx="2160">
                  <c:v>1080</c:v>
                </c:pt>
                <c:pt idx="2161">
                  <c:v>1080.5</c:v>
                </c:pt>
                <c:pt idx="2162">
                  <c:v>1081</c:v>
                </c:pt>
                <c:pt idx="2163">
                  <c:v>1081.5</c:v>
                </c:pt>
                <c:pt idx="2164">
                  <c:v>1082</c:v>
                </c:pt>
                <c:pt idx="2165">
                  <c:v>1082.5</c:v>
                </c:pt>
                <c:pt idx="2166">
                  <c:v>1083</c:v>
                </c:pt>
                <c:pt idx="2167">
                  <c:v>1083.5</c:v>
                </c:pt>
                <c:pt idx="2168">
                  <c:v>1084</c:v>
                </c:pt>
                <c:pt idx="2169">
                  <c:v>1084.5</c:v>
                </c:pt>
                <c:pt idx="2170">
                  <c:v>1085</c:v>
                </c:pt>
                <c:pt idx="2171">
                  <c:v>1085.5</c:v>
                </c:pt>
                <c:pt idx="2172">
                  <c:v>1086</c:v>
                </c:pt>
                <c:pt idx="2173">
                  <c:v>1086.5</c:v>
                </c:pt>
                <c:pt idx="2174">
                  <c:v>1087</c:v>
                </c:pt>
                <c:pt idx="2175">
                  <c:v>1087.5</c:v>
                </c:pt>
                <c:pt idx="2176">
                  <c:v>1088</c:v>
                </c:pt>
                <c:pt idx="2177">
                  <c:v>1088.5</c:v>
                </c:pt>
                <c:pt idx="2178">
                  <c:v>1089</c:v>
                </c:pt>
                <c:pt idx="2179">
                  <c:v>1089.5</c:v>
                </c:pt>
                <c:pt idx="2180">
                  <c:v>1090</c:v>
                </c:pt>
                <c:pt idx="2181">
                  <c:v>1090.5</c:v>
                </c:pt>
                <c:pt idx="2182">
                  <c:v>1091</c:v>
                </c:pt>
                <c:pt idx="2183">
                  <c:v>1091.5</c:v>
                </c:pt>
                <c:pt idx="2184">
                  <c:v>1092</c:v>
                </c:pt>
                <c:pt idx="2185">
                  <c:v>1092.5</c:v>
                </c:pt>
                <c:pt idx="2186">
                  <c:v>1093</c:v>
                </c:pt>
                <c:pt idx="2187">
                  <c:v>1093.5</c:v>
                </c:pt>
                <c:pt idx="2188">
                  <c:v>1094</c:v>
                </c:pt>
                <c:pt idx="2189">
                  <c:v>1094.5</c:v>
                </c:pt>
                <c:pt idx="2190">
                  <c:v>1095</c:v>
                </c:pt>
                <c:pt idx="2191">
                  <c:v>1095.5</c:v>
                </c:pt>
                <c:pt idx="2192">
                  <c:v>1096</c:v>
                </c:pt>
                <c:pt idx="2193">
                  <c:v>1096.5</c:v>
                </c:pt>
                <c:pt idx="2194">
                  <c:v>1097</c:v>
                </c:pt>
                <c:pt idx="2195">
                  <c:v>1097.5</c:v>
                </c:pt>
                <c:pt idx="2196">
                  <c:v>1098</c:v>
                </c:pt>
                <c:pt idx="2197">
                  <c:v>1098.5</c:v>
                </c:pt>
                <c:pt idx="2198">
                  <c:v>1099</c:v>
                </c:pt>
                <c:pt idx="2199">
                  <c:v>1099.5</c:v>
                </c:pt>
                <c:pt idx="2200">
                  <c:v>1100</c:v>
                </c:pt>
                <c:pt idx="2201">
                  <c:v>1100.5</c:v>
                </c:pt>
                <c:pt idx="2202">
                  <c:v>1101</c:v>
                </c:pt>
                <c:pt idx="2203">
                  <c:v>1101.5</c:v>
                </c:pt>
                <c:pt idx="2204">
                  <c:v>1102</c:v>
                </c:pt>
                <c:pt idx="2205">
                  <c:v>1102.5</c:v>
                </c:pt>
                <c:pt idx="2206">
                  <c:v>1103</c:v>
                </c:pt>
                <c:pt idx="2207">
                  <c:v>1103.5</c:v>
                </c:pt>
                <c:pt idx="2208">
                  <c:v>1104</c:v>
                </c:pt>
                <c:pt idx="2209">
                  <c:v>1104.5</c:v>
                </c:pt>
                <c:pt idx="2210">
                  <c:v>1105</c:v>
                </c:pt>
                <c:pt idx="2211">
                  <c:v>1105.5</c:v>
                </c:pt>
                <c:pt idx="2212">
                  <c:v>1106</c:v>
                </c:pt>
                <c:pt idx="2213">
                  <c:v>1106.5</c:v>
                </c:pt>
                <c:pt idx="2214">
                  <c:v>1107</c:v>
                </c:pt>
                <c:pt idx="2215">
                  <c:v>1107.5</c:v>
                </c:pt>
                <c:pt idx="2216">
                  <c:v>1108</c:v>
                </c:pt>
                <c:pt idx="2217">
                  <c:v>1108.5</c:v>
                </c:pt>
                <c:pt idx="2218">
                  <c:v>1109</c:v>
                </c:pt>
                <c:pt idx="2219">
                  <c:v>1109.5</c:v>
                </c:pt>
                <c:pt idx="2220">
                  <c:v>1110</c:v>
                </c:pt>
                <c:pt idx="2221">
                  <c:v>1110.5</c:v>
                </c:pt>
                <c:pt idx="2222">
                  <c:v>1111</c:v>
                </c:pt>
                <c:pt idx="2223">
                  <c:v>1111.5</c:v>
                </c:pt>
                <c:pt idx="2224">
                  <c:v>1112</c:v>
                </c:pt>
                <c:pt idx="2225">
                  <c:v>1112.5</c:v>
                </c:pt>
                <c:pt idx="2226">
                  <c:v>1113</c:v>
                </c:pt>
                <c:pt idx="2227">
                  <c:v>1113.5</c:v>
                </c:pt>
                <c:pt idx="2228">
                  <c:v>1114</c:v>
                </c:pt>
                <c:pt idx="2229">
                  <c:v>1114.5</c:v>
                </c:pt>
                <c:pt idx="2230">
                  <c:v>1115</c:v>
                </c:pt>
                <c:pt idx="2231">
                  <c:v>1115.5</c:v>
                </c:pt>
                <c:pt idx="2232">
                  <c:v>1116</c:v>
                </c:pt>
                <c:pt idx="2233">
                  <c:v>1116.5</c:v>
                </c:pt>
                <c:pt idx="2234">
                  <c:v>1117</c:v>
                </c:pt>
                <c:pt idx="2235">
                  <c:v>1117.5</c:v>
                </c:pt>
                <c:pt idx="2236">
                  <c:v>1118</c:v>
                </c:pt>
                <c:pt idx="2237">
                  <c:v>1118.5</c:v>
                </c:pt>
                <c:pt idx="2238">
                  <c:v>1119</c:v>
                </c:pt>
                <c:pt idx="2239">
                  <c:v>1119.5</c:v>
                </c:pt>
                <c:pt idx="2240">
                  <c:v>1120</c:v>
                </c:pt>
                <c:pt idx="2241">
                  <c:v>1120.5</c:v>
                </c:pt>
                <c:pt idx="2242">
                  <c:v>1121</c:v>
                </c:pt>
                <c:pt idx="2243">
                  <c:v>1121.5</c:v>
                </c:pt>
                <c:pt idx="2244">
                  <c:v>1122</c:v>
                </c:pt>
                <c:pt idx="2245">
                  <c:v>1122.5</c:v>
                </c:pt>
                <c:pt idx="2246">
                  <c:v>1123</c:v>
                </c:pt>
                <c:pt idx="2247">
                  <c:v>1123.5</c:v>
                </c:pt>
                <c:pt idx="2248">
                  <c:v>1124</c:v>
                </c:pt>
                <c:pt idx="2249">
                  <c:v>1124.5</c:v>
                </c:pt>
                <c:pt idx="2250">
                  <c:v>1125</c:v>
                </c:pt>
                <c:pt idx="2251">
                  <c:v>1125.5</c:v>
                </c:pt>
                <c:pt idx="2252">
                  <c:v>1126</c:v>
                </c:pt>
                <c:pt idx="2253">
                  <c:v>1126.5</c:v>
                </c:pt>
                <c:pt idx="2254">
                  <c:v>1127</c:v>
                </c:pt>
                <c:pt idx="2255">
                  <c:v>1127.5</c:v>
                </c:pt>
                <c:pt idx="2256">
                  <c:v>1128</c:v>
                </c:pt>
                <c:pt idx="2257">
                  <c:v>1128.5</c:v>
                </c:pt>
                <c:pt idx="2258">
                  <c:v>1129</c:v>
                </c:pt>
                <c:pt idx="2259">
                  <c:v>1129.5</c:v>
                </c:pt>
                <c:pt idx="2260">
                  <c:v>1130</c:v>
                </c:pt>
                <c:pt idx="2261">
                  <c:v>1130.5</c:v>
                </c:pt>
                <c:pt idx="2262">
                  <c:v>1131</c:v>
                </c:pt>
                <c:pt idx="2263">
                  <c:v>1131.5</c:v>
                </c:pt>
                <c:pt idx="2264">
                  <c:v>1132</c:v>
                </c:pt>
                <c:pt idx="2265">
                  <c:v>1132.5</c:v>
                </c:pt>
                <c:pt idx="2266">
                  <c:v>1133</c:v>
                </c:pt>
                <c:pt idx="2267">
                  <c:v>1133.5</c:v>
                </c:pt>
                <c:pt idx="2268">
                  <c:v>1134</c:v>
                </c:pt>
                <c:pt idx="2269">
                  <c:v>1134.5</c:v>
                </c:pt>
                <c:pt idx="2270">
                  <c:v>1135</c:v>
                </c:pt>
                <c:pt idx="2271">
                  <c:v>1135.5</c:v>
                </c:pt>
                <c:pt idx="2272">
                  <c:v>1136</c:v>
                </c:pt>
                <c:pt idx="2273">
                  <c:v>1136.5</c:v>
                </c:pt>
                <c:pt idx="2274">
                  <c:v>1137</c:v>
                </c:pt>
                <c:pt idx="2275">
                  <c:v>1137.5</c:v>
                </c:pt>
                <c:pt idx="2276">
                  <c:v>1138</c:v>
                </c:pt>
                <c:pt idx="2277">
                  <c:v>1138.5</c:v>
                </c:pt>
                <c:pt idx="2278">
                  <c:v>1139</c:v>
                </c:pt>
                <c:pt idx="2279">
                  <c:v>1139.5</c:v>
                </c:pt>
                <c:pt idx="2280">
                  <c:v>1140</c:v>
                </c:pt>
                <c:pt idx="2281">
                  <c:v>1140.5</c:v>
                </c:pt>
                <c:pt idx="2282">
                  <c:v>1141</c:v>
                </c:pt>
                <c:pt idx="2283">
                  <c:v>1141.5</c:v>
                </c:pt>
                <c:pt idx="2284">
                  <c:v>1142</c:v>
                </c:pt>
                <c:pt idx="2285">
                  <c:v>1142.5</c:v>
                </c:pt>
                <c:pt idx="2286">
                  <c:v>1143</c:v>
                </c:pt>
                <c:pt idx="2287">
                  <c:v>1143.5</c:v>
                </c:pt>
                <c:pt idx="2288">
                  <c:v>1144</c:v>
                </c:pt>
                <c:pt idx="2289">
                  <c:v>1144.5</c:v>
                </c:pt>
                <c:pt idx="2290">
                  <c:v>1145</c:v>
                </c:pt>
                <c:pt idx="2291">
                  <c:v>1145.5</c:v>
                </c:pt>
                <c:pt idx="2292">
                  <c:v>1146</c:v>
                </c:pt>
                <c:pt idx="2293">
                  <c:v>1146.5</c:v>
                </c:pt>
                <c:pt idx="2294">
                  <c:v>1147</c:v>
                </c:pt>
                <c:pt idx="2295">
                  <c:v>1147.5</c:v>
                </c:pt>
                <c:pt idx="2296">
                  <c:v>1148</c:v>
                </c:pt>
                <c:pt idx="2297">
                  <c:v>1148.5</c:v>
                </c:pt>
                <c:pt idx="2298">
                  <c:v>1149</c:v>
                </c:pt>
                <c:pt idx="2299">
                  <c:v>1149.5</c:v>
                </c:pt>
                <c:pt idx="2300">
                  <c:v>1150</c:v>
                </c:pt>
                <c:pt idx="2301">
                  <c:v>1150.5</c:v>
                </c:pt>
                <c:pt idx="2302">
                  <c:v>1151</c:v>
                </c:pt>
                <c:pt idx="2303">
                  <c:v>1151.5</c:v>
                </c:pt>
                <c:pt idx="2304">
                  <c:v>1152</c:v>
                </c:pt>
                <c:pt idx="2305">
                  <c:v>1152.5</c:v>
                </c:pt>
                <c:pt idx="2306">
                  <c:v>1153</c:v>
                </c:pt>
                <c:pt idx="2307">
                  <c:v>1153.5</c:v>
                </c:pt>
                <c:pt idx="2308">
                  <c:v>1154</c:v>
                </c:pt>
                <c:pt idx="2309">
                  <c:v>1154.5</c:v>
                </c:pt>
                <c:pt idx="2310">
                  <c:v>1155</c:v>
                </c:pt>
                <c:pt idx="2311">
                  <c:v>1155.5</c:v>
                </c:pt>
                <c:pt idx="2312">
                  <c:v>1156</c:v>
                </c:pt>
                <c:pt idx="2313">
                  <c:v>1156.5</c:v>
                </c:pt>
                <c:pt idx="2314">
                  <c:v>1157</c:v>
                </c:pt>
                <c:pt idx="2315">
                  <c:v>1157.5</c:v>
                </c:pt>
                <c:pt idx="2316">
                  <c:v>1158</c:v>
                </c:pt>
                <c:pt idx="2317">
                  <c:v>1158.5</c:v>
                </c:pt>
                <c:pt idx="2318">
                  <c:v>1159</c:v>
                </c:pt>
                <c:pt idx="2319">
                  <c:v>1159.5</c:v>
                </c:pt>
                <c:pt idx="2320">
                  <c:v>1160</c:v>
                </c:pt>
                <c:pt idx="2321">
                  <c:v>1160.5</c:v>
                </c:pt>
                <c:pt idx="2322">
                  <c:v>1161</c:v>
                </c:pt>
                <c:pt idx="2323">
                  <c:v>1161.5</c:v>
                </c:pt>
                <c:pt idx="2324">
                  <c:v>1162</c:v>
                </c:pt>
                <c:pt idx="2325">
                  <c:v>1162.5</c:v>
                </c:pt>
                <c:pt idx="2326">
                  <c:v>1163</c:v>
                </c:pt>
                <c:pt idx="2327">
                  <c:v>1163.5</c:v>
                </c:pt>
                <c:pt idx="2328">
                  <c:v>1164</c:v>
                </c:pt>
                <c:pt idx="2329">
                  <c:v>1164.5</c:v>
                </c:pt>
                <c:pt idx="2330">
                  <c:v>1165</c:v>
                </c:pt>
                <c:pt idx="2331">
                  <c:v>1165.5</c:v>
                </c:pt>
                <c:pt idx="2332">
                  <c:v>1166</c:v>
                </c:pt>
                <c:pt idx="2333">
                  <c:v>1166.5</c:v>
                </c:pt>
                <c:pt idx="2334">
                  <c:v>1167</c:v>
                </c:pt>
                <c:pt idx="2335">
                  <c:v>1167.5</c:v>
                </c:pt>
                <c:pt idx="2336">
                  <c:v>1168</c:v>
                </c:pt>
                <c:pt idx="2337">
                  <c:v>1168.5</c:v>
                </c:pt>
                <c:pt idx="2338">
                  <c:v>1169</c:v>
                </c:pt>
                <c:pt idx="2339">
                  <c:v>1169.5</c:v>
                </c:pt>
                <c:pt idx="2340">
                  <c:v>1170</c:v>
                </c:pt>
                <c:pt idx="2341">
                  <c:v>1170.5</c:v>
                </c:pt>
                <c:pt idx="2342">
                  <c:v>1171</c:v>
                </c:pt>
                <c:pt idx="2343">
                  <c:v>1171.5</c:v>
                </c:pt>
                <c:pt idx="2344">
                  <c:v>1172</c:v>
                </c:pt>
                <c:pt idx="2345">
                  <c:v>1172.5</c:v>
                </c:pt>
                <c:pt idx="2346">
                  <c:v>1173</c:v>
                </c:pt>
                <c:pt idx="2347">
                  <c:v>1173.5</c:v>
                </c:pt>
                <c:pt idx="2348">
                  <c:v>1174</c:v>
                </c:pt>
                <c:pt idx="2349">
                  <c:v>1174.5</c:v>
                </c:pt>
                <c:pt idx="2350">
                  <c:v>1175</c:v>
                </c:pt>
                <c:pt idx="2351">
                  <c:v>1175.5</c:v>
                </c:pt>
                <c:pt idx="2352">
                  <c:v>1176</c:v>
                </c:pt>
                <c:pt idx="2353">
                  <c:v>1176.5</c:v>
                </c:pt>
                <c:pt idx="2354">
                  <c:v>1177</c:v>
                </c:pt>
                <c:pt idx="2355">
                  <c:v>1177.5</c:v>
                </c:pt>
                <c:pt idx="2356">
                  <c:v>1178</c:v>
                </c:pt>
                <c:pt idx="2357">
                  <c:v>1178.5</c:v>
                </c:pt>
                <c:pt idx="2358">
                  <c:v>1179</c:v>
                </c:pt>
                <c:pt idx="2359">
                  <c:v>1179.5</c:v>
                </c:pt>
                <c:pt idx="2360">
                  <c:v>1180</c:v>
                </c:pt>
                <c:pt idx="2361">
                  <c:v>1180.5</c:v>
                </c:pt>
                <c:pt idx="2362">
                  <c:v>1181</c:v>
                </c:pt>
                <c:pt idx="2363">
                  <c:v>1181.5</c:v>
                </c:pt>
                <c:pt idx="2364">
                  <c:v>1182</c:v>
                </c:pt>
                <c:pt idx="2365">
                  <c:v>1182.5</c:v>
                </c:pt>
                <c:pt idx="2366">
                  <c:v>1183</c:v>
                </c:pt>
                <c:pt idx="2367">
                  <c:v>1183.5</c:v>
                </c:pt>
                <c:pt idx="2368">
                  <c:v>1184</c:v>
                </c:pt>
                <c:pt idx="2369">
                  <c:v>1184.5</c:v>
                </c:pt>
                <c:pt idx="2370">
                  <c:v>1185</c:v>
                </c:pt>
                <c:pt idx="2371">
                  <c:v>1185.5</c:v>
                </c:pt>
                <c:pt idx="2372">
                  <c:v>1186</c:v>
                </c:pt>
                <c:pt idx="2373">
                  <c:v>1186.5</c:v>
                </c:pt>
                <c:pt idx="2374">
                  <c:v>1187</c:v>
                </c:pt>
                <c:pt idx="2375">
                  <c:v>1187.5</c:v>
                </c:pt>
                <c:pt idx="2376">
                  <c:v>1188</c:v>
                </c:pt>
                <c:pt idx="2377">
                  <c:v>1188.5</c:v>
                </c:pt>
                <c:pt idx="2378">
                  <c:v>1189</c:v>
                </c:pt>
                <c:pt idx="2379">
                  <c:v>1189.5</c:v>
                </c:pt>
                <c:pt idx="2380">
                  <c:v>1190</c:v>
                </c:pt>
                <c:pt idx="2381">
                  <c:v>1190.5</c:v>
                </c:pt>
                <c:pt idx="2382">
                  <c:v>1191</c:v>
                </c:pt>
                <c:pt idx="2383">
                  <c:v>1191.5</c:v>
                </c:pt>
                <c:pt idx="2384">
                  <c:v>1192</c:v>
                </c:pt>
                <c:pt idx="2385">
                  <c:v>1192.5</c:v>
                </c:pt>
                <c:pt idx="2386">
                  <c:v>1193</c:v>
                </c:pt>
                <c:pt idx="2387">
                  <c:v>1193.5</c:v>
                </c:pt>
                <c:pt idx="2388">
                  <c:v>1194</c:v>
                </c:pt>
                <c:pt idx="2389">
                  <c:v>1194.5</c:v>
                </c:pt>
                <c:pt idx="2390">
                  <c:v>1195</c:v>
                </c:pt>
                <c:pt idx="2391">
                  <c:v>1195.5</c:v>
                </c:pt>
                <c:pt idx="2392">
                  <c:v>1196</c:v>
                </c:pt>
                <c:pt idx="2393">
                  <c:v>1196.5</c:v>
                </c:pt>
                <c:pt idx="2394">
                  <c:v>1197</c:v>
                </c:pt>
                <c:pt idx="2395">
                  <c:v>1197.5</c:v>
                </c:pt>
                <c:pt idx="2396">
                  <c:v>1198</c:v>
                </c:pt>
                <c:pt idx="2397">
                  <c:v>1198.5</c:v>
                </c:pt>
                <c:pt idx="2398">
                  <c:v>1199</c:v>
                </c:pt>
                <c:pt idx="2399">
                  <c:v>1199.5</c:v>
                </c:pt>
                <c:pt idx="2400">
                  <c:v>1200</c:v>
                </c:pt>
                <c:pt idx="2401">
                  <c:v>1200.5</c:v>
                </c:pt>
                <c:pt idx="2402">
                  <c:v>1201</c:v>
                </c:pt>
                <c:pt idx="2403">
                  <c:v>1201.5</c:v>
                </c:pt>
                <c:pt idx="2404">
                  <c:v>1202</c:v>
                </c:pt>
                <c:pt idx="2405">
                  <c:v>1202.5</c:v>
                </c:pt>
                <c:pt idx="2406">
                  <c:v>1203</c:v>
                </c:pt>
                <c:pt idx="2407">
                  <c:v>1203.5</c:v>
                </c:pt>
                <c:pt idx="2408">
                  <c:v>1204</c:v>
                </c:pt>
                <c:pt idx="2409">
                  <c:v>1204.5</c:v>
                </c:pt>
                <c:pt idx="2410">
                  <c:v>1205</c:v>
                </c:pt>
                <c:pt idx="2411">
                  <c:v>1205.5</c:v>
                </c:pt>
                <c:pt idx="2412">
                  <c:v>1206</c:v>
                </c:pt>
                <c:pt idx="2413">
                  <c:v>1206.5</c:v>
                </c:pt>
                <c:pt idx="2414">
                  <c:v>1207</c:v>
                </c:pt>
                <c:pt idx="2415">
                  <c:v>1207.5</c:v>
                </c:pt>
                <c:pt idx="2416">
                  <c:v>1208</c:v>
                </c:pt>
                <c:pt idx="2417">
                  <c:v>1208.5</c:v>
                </c:pt>
                <c:pt idx="2418">
                  <c:v>1209</c:v>
                </c:pt>
                <c:pt idx="2419">
                  <c:v>1209.5</c:v>
                </c:pt>
                <c:pt idx="2420">
                  <c:v>1210</c:v>
                </c:pt>
                <c:pt idx="2421">
                  <c:v>1210.5</c:v>
                </c:pt>
                <c:pt idx="2422">
                  <c:v>1211</c:v>
                </c:pt>
                <c:pt idx="2423">
                  <c:v>1211.5</c:v>
                </c:pt>
                <c:pt idx="2424">
                  <c:v>1212</c:v>
                </c:pt>
                <c:pt idx="2425">
                  <c:v>1212.5</c:v>
                </c:pt>
                <c:pt idx="2426">
                  <c:v>1213</c:v>
                </c:pt>
                <c:pt idx="2427">
                  <c:v>1213.5</c:v>
                </c:pt>
                <c:pt idx="2428">
                  <c:v>1214</c:v>
                </c:pt>
                <c:pt idx="2429">
                  <c:v>1214.5</c:v>
                </c:pt>
                <c:pt idx="2430">
                  <c:v>1215</c:v>
                </c:pt>
                <c:pt idx="2431">
                  <c:v>1215.5</c:v>
                </c:pt>
                <c:pt idx="2432">
                  <c:v>1216</c:v>
                </c:pt>
                <c:pt idx="2433">
                  <c:v>1216.5</c:v>
                </c:pt>
                <c:pt idx="2434">
                  <c:v>1217</c:v>
                </c:pt>
                <c:pt idx="2435">
                  <c:v>1217.5</c:v>
                </c:pt>
                <c:pt idx="2436">
                  <c:v>1218</c:v>
                </c:pt>
                <c:pt idx="2437">
                  <c:v>1218.5</c:v>
                </c:pt>
                <c:pt idx="2438">
                  <c:v>1219</c:v>
                </c:pt>
                <c:pt idx="2439">
                  <c:v>1219.5</c:v>
                </c:pt>
                <c:pt idx="2440">
                  <c:v>1220</c:v>
                </c:pt>
                <c:pt idx="2441">
                  <c:v>1220.5</c:v>
                </c:pt>
                <c:pt idx="2442">
                  <c:v>1221</c:v>
                </c:pt>
                <c:pt idx="2443">
                  <c:v>1221.5</c:v>
                </c:pt>
                <c:pt idx="2444">
                  <c:v>1222</c:v>
                </c:pt>
                <c:pt idx="2445">
                  <c:v>1222.5</c:v>
                </c:pt>
                <c:pt idx="2446">
                  <c:v>1223</c:v>
                </c:pt>
                <c:pt idx="2447">
                  <c:v>1223.5</c:v>
                </c:pt>
                <c:pt idx="2448">
                  <c:v>1224</c:v>
                </c:pt>
                <c:pt idx="2449">
                  <c:v>1224.5</c:v>
                </c:pt>
                <c:pt idx="2450">
                  <c:v>1225</c:v>
                </c:pt>
                <c:pt idx="2451">
                  <c:v>1225.5</c:v>
                </c:pt>
                <c:pt idx="2452">
                  <c:v>1226</c:v>
                </c:pt>
                <c:pt idx="2453">
                  <c:v>1226.5</c:v>
                </c:pt>
                <c:pt idx="2454">
                  <c:v>1227</c:v>
                </c:pt>
                <c:pt idx="2455">
                  <c:v>1227.5</c:v>
                </c:pt>
                <c:pt idx="2456">
                  <c:v>1228</c:v>
                </c:pt>
                <c:pt idx="2457">
                  <c:v>1228.5</c:v>
                </c:pt>
                <c:pt idx="2458">
                  <c:v>1229</c:v>
                </c:pt>
                <c:pt idx="2459">
                  <c:v>1229.5</c:v>
                </c:pt>
                <c:pt idx="2460">
                  <c:v>1230</c:v>
                </c:pt>
                <c:pt idx="2461">
                  <c:v>1230.5</c:v>
                </c:pt>
                <c:pt idx="2462">
                  <c:v>1231</c:v>
                </c:pt>
                <c:pt idx="2463">
                  <c:v>1231.5</c:v>
                </c:pt>
                <c:pt idx="2464">
                  <c:v>1232</c:v>
                </c:pt>
                <c:pt idx="2465">
                  <c:v>1232.5</c:v>
                </c:pt>
                <c:pt idx="2466">
                  <c:v>1233</c:v>
                </c:pt>
                <c:pt idx="2467">
                  <c:v>1233.5</c:v>
                </c:pt>
                <c:pt idx="2468">
                  <c:v>1234</c:v>
                </c:pt>
                <c:pt idx="2469">
                  <c:v>1234.5</c:v>
                </c:pt>
                <c:pt idx="2470">
                  <c:v>1235</c:v>
                </c:pt>
                <c:pt idx="2471">
                  <c:v>1235.5</c:v>
                </c:pt>
                <c:pt idx="2472">
                  <c:v>1236</c:v>
                </c:pt>
                <c:pt idx="2473">
                  <c:v>1236.5</c:v>
                </c:pt>
                <c:pt idx="2474">
                  <c:v>1237</c:v>
                </c:pt>
                <c:pt idx="2475">
                  <c:v>1237.5</c:v>
                </c:pt>
                <c:pt idx="2476">
                  <c:v>1238</c:v>
                </c:pt>
                <c:pt idx="2477">
                  <c:v>1238.5</c:v>
                </c:pt>
                <c:pt idx="2478">
                  <c:v>1239</c:v>
                </c:pt>
                <c:pt idx="2479">
                  <c:v>1239.5</c:v>
                </c:pt>
                <c:pt idx="2480">
                  <c:v>1240</c:v>
                </c:pt>
                <c:pt idx="2481">
                  <c:v>1240.5</c:v>
                </c:pt>
                <c:pt idx="2482">
                  <c:v>1241</c:v>
                </c:pt>
                <c:pt idx="2483">
                  <c:v>1241.5</c:v>
                </c:pt>
                <c:pt idx="2484">
                  <c:v>1242</c:v>
                </c:pt>
                <c:pt idx="2485">
                  <c:v>1242.5</c:v>
                </c:pt>
                <c:pt idx="2486">
                  <c:v>1243</c:v>
                </c:pt>
                <c:pt idx="2487">
                  <c:v>1243.5</c:v>
                </c:pt>
                <c:pt idx="2488">
                  <c:v>1244</c:v>
                </c:pt>
                <c:pt idx="2489">
                  <c:v>1244.5</c:v>
                </c:pt>
                <c:pt idx="2490">
                  <c:v>1245</c:v>
                </c:pt>
                <c:pt idx="2491">
                  <c:v>1245.5</c:v>
                </c:pt>
                <c:pt idx="2492">
                  <c:v>1246</c:v>
                </c:pt>
                <c:pt idx="2493">
                  <c:v>1246.5</c:v>
                </c:pt>
                <c:pt idx="2494">
                  <c:v>1247</c:v>
                </c:pt>
                <c:pt idx="2495">
                  <c:v>1247.5</c:v>
                </c:pt>
                <c:pt idx="2496">
                  <c:v>1248</c:v>
                </c:pt>
                <c:pt idx="2497">
                  <c:v>1248.5</c:v>
                </c:pt>
                <c:pt idx="2498">
                  <c:v>1249</c:v>
                </c:pt>
                <c:pt idx="2499">
                  <c:v>1249.5</c:v>
                </c:pt>
                <c:pt idx="2500">
                  <c:v>1250</c:v>
                </c:pt>
                <c:pt idx="2501">
                  <c:v>1250.5</c:v>
                </c:pt>
                <c:pt idx="2502">
                  <c:v>1251</c:v>
                </c:pt>
                <c:pt idx="2503">
                  <c:v>1251.5</c:v>
                </c:pt>
                <c:pt idx="2504">
                  <c:v>1252</c:v>
                </c:pt>
                <c:pt idx="2505">
                  <c:v>1252.5</c:v>
                </c:pt>
                <c:pt idx="2506">
                  <c:v>1253</c:v>
                </c:pt>
                <c:pt idx="2507">
                  <c:v>1253.5</c:v>
                </c:pt>
                <c:pt idx="2508">
                  <c:v>1254</c:v>
                </c:pt>
                <c:pt idx="2509">
                  <c:v>1254.5</c:v>
                </c:pt>
                <c:pt idx="2510">
                  <c:v>1255</c:v>
                </c:pt>
                <c:pt idx="2511">
                  <c:v>1255.5</c:v>
                </c:pt>
                <c:pt idx="2512">
                  <c:v>1256</c:v>
                </c:pt>
                <c:pt idx="2513">
                  <c:v>1256.5</c:v>
                </c:pt>
                <c:pt idx="2514">
                  <c:v>1257</c:v>
                </c:pt>
                <c:pt idx="2515">
                  <c:v>1257.5</c:v>
                </c:pt>
                <c:pt idx="2516">
                  <c:v>1258</c:v>
                </c:pt>
                <c:pt idx="2517">
                  <c:v>1258.5</c:v>
                </c:pt>
                <c:pt idx="2518">
                  <c:v>1259</c:v>
                </c:pt>
                <c:pt idx="2519">
                  <c:v>1259.5</c:v>
                </c:pt>
                <c:pt idx="2520">
                  <c:v>1260</c:v>
                </c:pt>
                <c:pt idx="2521">
                  <c:v>1260.5</c:v>
                </c:pt>
                <c:pt idx="2522">
                  <c:v>1261</c:v>
                </c:pt>
                <c:pt idx="2523">
                  <c:v>1261.5</c:v>
                </c:pt>
                <c:pt idx="2524">
                  <c:v>1262</c:v>
                </c:pt>
                <c:pt idx="2525">
                  <c:v>1262.5</c:v>
                </c:pt>
                <c:pt idx="2526">
                  <c:v>1263</c:v>
                </c:pt>
                <c:pt idx="2527">
                  <c:v>1263.5</c:v>
                </c:pt>
                <c:pt idx="2528">
                  <c:v>1264</c:v>
                </c:pt>
                <c:pt idx="2529">
                  <c:v>1264.5</c:v>
                </c:pt>
                <c:pt idx="2530">
                  <c:v>1265</c:v>
                </c:pt>
                <c:pt idx="2531">
                  <c:v>1265.5</c:v>
                </c:pt>
                <c:pt idx="2532">
                  <c:v>1266</c:v>
                </c:pt>
                <c:pt idx="2533">
                  <c:v>1266.5</c:v>
                </c:pt>
                <c:pt idx="2534">
                  <c:v>1267</c:v>
                </c:pt>
                <c:pt idx="2535">
                  <c:v>1267.5</c:v>
                </c:pt>
                <c:pt idx="2536">
                  <c:v>1268</c:v>
                </c:pt>
                <c:pt idx="2537">
                  <c:v>1268.5</c:v>
                </c:pt>
                <c:pt idx="2538">
                  <c:v>1269</c:v>
                </c:pt>
                <c:pt idx="2539">
                  <c:v>1269.5</c:v>
                </c:pt>
                <c:pt idx="2540">
                  <c:v>1270</c:v>
                </c:pt>
                <c:pt idx="2541">
                  <c:v>1270.5</c:v>
                </c:pt>
                <c:pt idx="2542">
                  <c:v>1271</c:v>
                </c:pt>
                <c:pt idx="2543">
                  <c:v>1271.5</c:v>
                </c:pt>
                <c:pt idx="2544">
                  <c:v>1272</c:v>
                </c:pt>
                <c:pt idx="2545">
                  <c:v>1272.5</c:v>
                </c:pt>
                <c:pt idx="2546">
                  <c:v>1273</c:v>
                </c:pt>
                <c:pt idx="2547">
                  <c:v>1273.5</c:v>
                </c:pt>
                <c:pt idx="2548">
                  <c:v>1274</c:v>
                </c:pt>
                <c:pt idx="2549">
                  <c:v>1274.5</c:v>
                </c:pt>
                <c:pt idx="2550">
                  <c:v>1275</c:v>
                </c:pt>
                <c:pt idx="2551">
                  <c:v>1275.5</c:v>
                </c:pt>
                <c:pt idx="2552">
                  <c:v>1276</c:v>
                </c:pt>
                <c:pt idx="2553">
                  <c:v>1276.5</c:v>
                </c:pt>
                <c:pt idx="2554">
                  <c:v>1277</c:v>
                </c:pt>
                <c:pt idx="2555">
                  <c:v>1277.5</c:v>
                </c:pt>
                <c:pt idx="2556">
                  <c:v>1278</c:v>
                </c:pt>
                <c:pt idx="2557">
                  <c:v>1278.5</c:v>
                </c:pt>
                <c:pt idx="2558">
                  <c:v>1279</c:v>
                </c:pt>
                <c:pt idx="2559">
                  <c:v>1279.5</c:v>
                </c:pt>
                <c:pt idx="2560">
                  <c:v>1280</c:v>
                </c:pt>
                <c:pt idx="2561">
                  <c:v>1280.5</c:v>
                </c:pt>
                <c:pt idx="2562">
                  <c:v>1281</c:v>
                </c:pt>
                <c:pt idx="2563">
                  <c:v>1281.5</c:v>
                </c:pt>
                <c:pt idx="2564">
                  <c:v>1282</c:v>
                </c:pt>
                <c:pt idx="2565">
                  <c:v>1282.5</c:v>
                </c:pt>
                <c:pt idx="2566">
                  <c:v>1283</c:v>
                </c:pt>
                <c:pt idx="2567">
                  <c:v>1283.5</c:v>
                </c:pt>
                <c:pt idx="2568">
                  <c:v>1284</c:v>
                </c:pt>
                <c:pt idx="2569">
                  <c:v>1284.5</c:v>
                </c:pt>
                <c:pt idx="2570">
                  <c:v>1285</c:v>
                </c:pt>
                <c:pt idx="2571">
                  <c:v>1285.5</c:v>
                </c:pt>
                <c:pt idx="2572">
                  <c:v>1286</c:v>
                </c:pt>
                <c:pt idx="2573">
                  <c:v>1286.5</c:v>
                </c:pt>
                <c:pt idx="2574">
                  <c:v>1287</c:v>
                </c:pt>
                <c:pt idx="2575">
                  <c:v>1287.5</c:v>
                </c:pt>
                <c:pt idx="2576">
                  <c:v>1288</c:v>
                </c:pt>
                <c:pt idx="2577">
                  <c:v>1288.5</c:v>
                </c:pt>
                <c:pt idx="2578">
                  <c:v>1289</c:v>
                </c:pt>
                <c:pt idx="2579">
                  <c:v>1289.5</c:v>
                </c:pt>
                <c:pt idx="2580">
                  <c:v>1290</c:v>
                </c:pt>
                <c:pt idx="2581">
                  <c:v>1290.5</c:v>
                </c:pt>
                <c:pt idx="2582">
                  <c:v>1291</c:v>
                </c:pt>
                <c:pt idx="2583">
                  <c:v>1291.5</c:v>
                </c:pt>
                <c:pt idx="2584">
                  <c:v>1292</c:v>
                </c:pt>
                <c:pt idx="2585">
                  <c:v>1292.5</c:v>
                </c:pt>
                <c:pt idx="2586">
                  <c:v>1293</c:v>
                </c:pt>
                <c:pt idx="2587">
                  <c:v>1293.5</c:v>
                </c:pt>
                <c:pt idx="2588">
                  <c:v>1294</c:v>
                </c:pt>
                <c:pt idx="2589">
                  <c:v>1294.5</c:v>
                </c:pt>
                <c:pt idx="2590">
                  <c:v>1295</c:v>
                </c:pt>
                <c:pt idx="2591">
                  <c:v>1295.5</c:v>
                </c:pt>
                <c:pt idx="2592">
                  <c:v>1296</c:v>
                </c:pt>
                <c:pt idx="2593">
                  <c:v>1296.5</c:v>
                </c:pt>
                <c:pt idx="2594">
                  <c:v>1297</c:v>
                </c:pt>
                <c:pt idx="2595">
                  <c:v>1297.5</c:v>
                </c:pt>
                <c:pt idx="2596">
                  <c:v>1298</c:v>
                </c:pt>
                <c:pt idx="2597">
                  <c:v>1298.5</c:v>
                </c:pt>
                <c:pt idx="2598">
                  <c:v>1299</c:v>
                </c:pt>
                <c:pt idx="2599">
                  <c:v>1299.5</c:v>
                </c:pt>
                <c:pt idx="2600">
                  <c:v>1300</c:v>
                </c:pt>
                <c:pt idx="2601">
                  <c:v>1300.5</c:v>
                </c:pt>
                <c:pt idx="2602">
                  <c:v>1301</c:v>
                </c:pt>
                <c:pt idx="2603">
                  <c:v>1301.5</c:v>
                </c:pt>
                <c:pt idx="2604">
                  <c:v>1302</c:v>
                </c:pt>
                <c:pt idx="2605">
                  <c:v>1302.5</c:v>
                </c:pt>
                <c:pt idx="2606">
                  <c:v>1303</c:v>
                </c:pt>
                <c:pt idx="2607">
                  <c:v>1303.5</c:v>
                </c:pt>
                <c:pt idx="2608">
                  <c:v>1304</c:v>
                </c:pt>
                <c:pt idx="2609">
                  <c:v>1304.5</c:v>
                </c:pt>
                <c:pt idx="2610">
                  <c:v>1305</c:v>
                </c:pt>
                <c:pt idx="2611">
                  <c:v>1305.5</c:v>
                </c:pt>
                <c:pt idx="2612">
                  <c:v>1306</c:v>
                </c:pt>
                <c:pt idx="2613">
                  <c:v>1306.5</c:v>
                </c:pt>
                <c:pt idx="2614">
                  <c:v>1307</c:v>
                </c:pt>
                <c:pt idx="2615">
                  <c:v>1307.5</c:v>
                </c:pt>
                <c:pt idx="2616">
                  <c:v>1308</c:v>
                </c:pt>
                <c:pt idx="2617">
                  <c:v>1308.5</c:v>
                </c:pt>
                <c:pt idx="2618">
                  <c:v>1309</c:v>
                </c:pt>
                <c:pt idx="2619">
                  <c:v>1309.5</c:v>
                </c:pt>
                <c:pt idx="2620">
                  <c:v>1310</c:v>
                </c:pt>
                <c:pt idx="2621">
                  <c:v>1310.5</c:v>
                </c:pt>
                <c:pt idx="2622">
                  <c:v>1311</c:v>
                </c:pt>
                <c:pt idx="2623">
                  <c:v>1311.5</c:v>
                </c:pt>
                <c:pt idx="2624">
                  <c:v>1312</c:v>
                </c:pt>
                <c:pt idx="2625">
                  <c:v>1312.5</c:v>
                </c:pt>
                <c:pt idx="2626">
                  <c:v>1313</c:v>
                </c:pt>
                <c:pt idx="2627">
                  <c:v>1313.5</c:v>
                </c:pt>
                <c:pt idx="2628">
                  <c:v>1314</c:v>
                </c:pt>
                <c:pt idx="2629">
                  <c:v>1314.5</c:v>
                </c:pt>
                <c:pt idx="2630">
                  <c:v>1315</c:v>
                </c:pt>
                <c:pt idx="2631">
                  <c:v>1315.5</c:v>
                </c:pt>
                <c:pt idx="2632">
                  <c:v>1316</c:v>
                </c:pt>
                <c:pt idx="2633">
                  <c:v>1316.5</c:v>
                </c:pt>
                <c:pt idx="2634">
                  <c:v>1317</c:v>
                </c:pt>
                <c:pt idx="2635">
                  <c:v>1317.5</c:v>
                </c:pt>
                <c:pt idx="2636">
                  <c:v>1318</c:v>
                </c:pt>
                <c:pt idx="2637">
                  <c:v>1318.5</c:v>
                </c:pt>
                <c:pt idx="2638">
                  <c:v>1319</c:v>
                </c:pt>
                <c:pt idx="2639">
                  <c:v>1319.5</c:v>
                </c:pt>
                <c:pt idx="2640">
                  <c:v>1320</c:v>
                </c:pt>
                <c:pt idx="2641">
                  <c:v>1320.5</c:v>
                </c:pt>
                <c:pt idx="2642">
                  <c:v>1321</c:v>
                </c:pt>
                <c:pt idx="2643">
                  <c:v>1321.5</c:v>
                </c:pt>
                <c:pt idx="2644">
                  <c:v>1322</c:v>
                </c:pt>
                <c:pt idx="2645">
                  <c:v>1322.5</c:v>
                </c:pt>
                <c:pt idx="2646">
                  <c:v>1323</c:v>
                </c:pt>
                <c:pt idx="2647">
                  <c:v>1323.5</c:v>
                </c:pt>
                <c:pt idx="2648">
                  <c:v>1324</c:v>
                </c:pt>
                <c:pt idx="2649">
                  <c:v>1324.5</c:v>
                </c:pt>
                <c:pt idx="2650">
                  <c:v>1325</c:v>
                </c:pt>
                <c:pt idx="2651">
                  <c:v>1325.5</c:v>
                </c:pt>
                <c:pt idx="2652">
                  <c:v>1326</c:v>
                </c:pt>
                <c:pt idx="2653">
                  <c:v>1326.5</c:v>
                </c:pt>
                <c:pt idx="2654">
                  <c:v>1327</c:v>
                </c:pt>
                <c:pt idx="2655">
                  <c:v>1327.5</c:v>
                </c:pt>
                <c:pt idx="2656">
                  <c:v>1328</c:v>
                </c:pt>
                <c:pt idx="2657">
                  <c:v>1328.5</c:v>
                </c:pt>
                <c:pt idx="2658">
                  <c:v>1329</c:v>
                </c:pt>
                <c:pt idx="2659">
                  <c:v>1329.5</c:v>
                </c:pt>
                <c:pt idx="2660">
                  <c:v>1330</c:v>
                </c:pt>
                <c:pt idx="2661">
                  <c:v>1330.5</c:v>
                </c:pt>
                <c:pt idx="2662">
                  <c:v>1331</c:v>
                </c:pt>
                <c:pt idx="2663">
                  <c:v>1331.5</c:v>
                </c:pt>
                <c:pt idx="2664">
                  <c:v>1332</c:v>
                </c:pt>
                <c:pt idx="2665">
                  <c:v>1332.5</c:v>
                </c:pt>
                <c:pt idx="2666">
                  <c:v>1333</c:v>
                </c:pt>
                <c:pt idx="2667">
                  <c:v>1333.5</c:v>
                </c:pt>
                <c:pt idx="2668">
                  <c:v>1334</c:v>
                </c:pt>
                <c:pt idx="2669">
                  <c:v>1334.5</c:v>
                </c:pt>
                <c:pt idx="2670">
                  <c:v>1335</c:v>
                </c:pt>
                <c:pt idx="2671">
                  <c:v>1335.5</c:v>
                </c:pt>
                <c:pt idx="2672">
                  <c:v>1336</c:v>
                </c:pt>
                <c:pt idx="2673">
                  <c:v>1336.5</c:v>
                </c:pt>
                <c:pt idx="2674">
                  <c:v>1337</c:v>
                </c:pt>
                <c:pt idx="2675">
                  <c:v>1337.5</c:v>
                </c:pt>
                <c:pt idx="2676">
                  <c:v>1338</c:v>
                </c:pt>
                <c:pt idx="2677">
                  <c:v>1338.5</c:v>
                </c:pt>
                <c:pt idx="2678">
                  <c:v>1339</c:v>
                </c:pt>
                <c:pt idx="2679">
                  <c:v>1339.5</c:v>
                </c:pt>
                <c:pt idx="2680">
                  <c:v>1340</c:v>
                </c:pt>
                <c:pt idx="2681">
                  <c:v>1340.5</c:v>
                </c:pt>
                <c:pt idx="2682">
                  <c:v>1341</c:v>
                </c:pt>
                <c:pt idx="2683">
                  <c:v>1341.5</c:v>
                </c:pt>
                <c:pt idx="2684">
                  <c:v>1342</c:v>
                </c:pt>
                <c:pt idx="2685">
                  <c:v>1342.5</c:v>
                </c:pt>
                <c:pt idx="2686">
                  <c:v>1343</c:v>
                </c:pt>
                <c:pt idx="2687">
                  <c:v>1343.5</c:v>
                </c:pt>
                <c:pt idx="2688">
                  <c:v>1344</c:v>
                </c:pt>
                <c:pt idx="2689">
                  <c:v>1344.5</c:v>
                </c:pt>
                <c:pt idx="2690">
                  <c:v>1345</c:v>
                </c:pt>
                <c:pt idx="2691">
                  <c:v>1345.5</c:v>
                </c:pt>
                <c:pt idx="2692">
                  <c:v>1346</c:v>
                </c:pt>
                <c:pt idx="2693">
                  <c:v>1346.5</c:v>
                </c:pt>
                <c:pt idx="2694">
                  <c:v>1347</c:v>
                </c:pt>
                <c:pt idx="2695">
                  <c:v>1347.5</c:v>
                </c:pt>
                <c:pt idx="2696">
                  <c:v>1348</c:v>
                </c:pt>
                <c:pt idx="2697">
                  <c:v>1348.5</c:v>
                </c:pt>
                <c:pt idx="2698">
                  <c:v>1349</c:v>
                </c:pt>
                <c:pt idx="2699">
                  <c:v>1349.5</c:v>
                </c:pt>
                <c:pt idx="2700">
                  <c:v>1350</c:v>
                </c:pt>
                <c:pt idx="2701">
                  <c:v>1350.5</c:v>
                </c:pt>
                <c:pt idx="2702">
                  <c:v>1351</c:v>
                </c:pt>
                <c:pt idx="2703">
                  <c:v>1351.5</c:v>
                </c:pt>
                <c:pt idx="2704">
                  <c:v>1352</c:v>
                </c:pt>
                <c:pt idx="2705">
                  <c:v>1352.5</c:v>
                </c:pt>
                <c:pt idx="2706">
                  <c:v>1353</c:v>
                </c:pt>
                <c:pt idx="2707">
                  <c:v>1353.5</c:v>
                </c:pt>
                <c:pt idx="2708">
                  <c:v>1354</c:v>
                </c:pt>
                <c:pt idx="2709">
                  <c:v>1354.5</c:v>
                </c:pt>
                <c:pt idx="2710">
                  <c:v>1355</c:v>
                </c:pt>
                <c:pt idx="2711">
                  <c:v>1355.5</c:v>
                </c:pt>
                <c:pt idx="2712">
                  <c:v>1356</c:v>
                </c:pt>
                <c:pt idx="2713">
                  <c:v>1356.5</c:v>
                </c:pt>
                <c:pt idx="2714">
                  <c:v>1357</c:v>
                </c:pt>
                <c:pt idx="2715">
                  <c:v>1357.5</c:v>
                </c:pt>
                <c:pt idx="2716">
                  <c:v>1358</c:v>
                </c:pt>
                <c:pt idx="2717">
                  <c:v>1358.5</c:v>
                </c:pt>
                <c:pt idx="2718">
                  <c:v>1359</c:v>
                </c:pt>
                <c:pt idx="2719">
                  <c:v>1359.5</c:v>
                </c:pt>
                <c:pt idx="2720">
                  <c:v>1360</c:v>
                </c:pt>
                <c:pt idx="2721">
                  <c:v>1360.5</c:v>
                </c:pt>
                <c:pt idx="2722">
                  <c:v>1361</c:v>
                </c:pt>
                <c:pt idx="2723">
                  <c:v>1361.5</c:v>
                </c:pt>
                <c:pt idx="2724">
                  <c:v>1362</c:v>
                </c:pt>
                <c:pt idx="2725">
                  <c:v>1362.5</c:v>
                </c:pt>
                <c:pt idx="2726">
                  <c:v>1363</c:v>
                </c:pt>
                <c:pt idx="2727">
                  <c:v>1363.5</c:v>
                </c:pt>
                <c:pt idx="2728">
                  <c:v>1364</c:v>
                </c:pt>
                <c:pt idx="2729">
                  <c:v>1364.5</c:v>
                </c:pt>
                <c:pt idx="2730">
                  <c:v>1365</c:v>
                </c:pt>
                <c:pt idx="2731">
                  <c:v>1365.5</c:v>
                </c:pt>
                <c:pt idx="2732">
                  <c:v>1366</c:v>
                </c:pt>
                <c:pt idx="2733">
                  <c:v>1366.5</c:v>
                </c:pt>
                <c:pt idx="2734">
                  <c:v>1367</c:v>
                </c:pt>
                <c:pt idx="2735">
                  <c:v>1367.5</c:v>
                </c:pt>
                <c:pt idx="2736">
                  <c:v>1368</c:v>
                </c:pt>
                <c:pt idx="2737">
                  <c:v>1368.5</c:v>
                </c:pt>
                <c:pt idx="2738">
                  <c:v>1369</c:v>
                </c:pt>
                <c:pt idx="2739">
                  <c:v>1369.5</c:v>
                </c:pt>
                <c:pt idx="2740">
                  <c:v>1370</c:v>
                </c:pt>
                <c:pt idx="2741">
                  <c:v>1370.5</c:v>
                </c:pt>
                <c:pt idx="2742">
                  <c:v>1371</c:v>
                </c:pt>
                <c:pt idx="2743">
                  <c:v>1371.5</c:v>
                </c:pt>
                <c:pt idx="2744">
                  <c:v>1372</c:v>
                </c:pt>
                <c:pt idx="2745">
                  <c:v>1372.5</c:v>
                </c:pt>
                <c:pt idx="2746">
                  <c:v>1373</c:v>
                </c:pt>
                <c:pt idx="2747">
                  <c:v>1373.5</c:v>
                </c:pt>
                <c:pt idx="2748">
                  <c:v>1374</c:v>
                </c:pt>
                <c:pt idx="2749">
                  <c:v>1374.5</c:v>
                </c:pt>
                <c:pt idx="2750">
                  <c:v>1375</c:v>
                </c:pt>
                <c:pt idx="2751">
                  <c:v>1375.5</c:v>
                </c:pt>
                <c:pt idx="2752">
                  <c:v>1376</c:v>
                </c:pt>
                <c:pt idx="2753">
                  <c:v>1376.5</c:v>
                </c:pt>
                <c:pt idx="2754">
                  <c:v>1377</c:v>
                </c:pt>
                <c:pt idx="2755">
                  <c:v>1377.5</c:v>
                </c:pt>
                <c:pt idx="2756">
                  <c:v>1378</c:v>
                </c:pt>
                <c:pt idx="2757">
                  <c:v>1378.5</c:v>
                </c:pt>
                <c:pt idx="2758">
                  <c:v>1379</c:v>
                </c:pt>
                <c:pt idx="2759">
                  <c:v>1379.5</c:v>
                </c:pt>
                <c:pt idx="2760">
                  <c:v>1380</c:v>
                </c:pt>
                <c:pt idx="2761">
                  <c:v>1380.5</c:v>
                </c:pt>
                <c:pt idx="2762">
                  <c:v>1381</c:v>
                </c:pt>
                <c:pt idx="2763">
                  <c:v>1381.5</c:v>
                </c:pt>
                <c:pt idx="2764">
                  <c:v>1382</c:v>
                </c:pt>
                <c:pt idx="2765">
                  <c:v>1382.5</c:v>
                </c:pt>
                <c:pt idx="2766">
                  <c:v>1383</c:v>
                </c:pt>
                <c:pt idx="2767">
                  <c:v>1383.5</c:v>
                </c:pt>
                <c:pt idx="2768">
                  <c:v>1384</c:v>
                </c:pt>
                <c:pt idx="2769">
                  <c:v>1384.5</c:v>
                </c:pt>
                <c:pt idx="2770">
                  <c:v>1385</c:v>
                </c:pt>
                <c:pt idx="2771">
                  <c:v>1385.5</c:v>
                </c:pt>
                <c:pt idx="2772">
                  <c:v>1386</c:v>
                </c:pt>
                <c:pt idx="2773">
                  <c:v>1386.5</c:v>
                </c:pt>
                <c:pt idx="2774">
                  <c:v>1387</c:v>
                </c:pt>
                <c:pt idx="2775">
                  <c:v>1387.5</c:v>
                </c:pt>
                <c:pt idx="2776">
                  <c:v>1388</c:v>
                </c:pt>
                <c:pt idx="2777">
                  <c:v>1388.5</c:v>
                </c:pt>
                <c:pt idx="2778">
                  <c:v>1389</c:v>
                </c:pt>
                <c:pt idx="2779">
                  <c:v>1389.5</c:v>
                </c:pt>
                <c:pt idx="2780">
                  <c:v>1390</c:v>
                </c:pt>
                <c:pt idx="2781">
                  <c:v>1390.5</c:v>
                </c:pt>
                <c:pt idx="2782">
                  <c:v>1391</c:v>
                </c:pt>
                <c:pt idx="2783">
                  <c:v>1391.5</c:v>
                </c:pt>
                <c:pt idx="2784">
                  <c:v>1392</c:v>
                </c:pt>
                <c:pt idx="2785">
                  <c:v>1392.5</c:v>
                </c:pt>
                <c:pt idx="2786">
                  <c:v>1393</c:v>
                </c:pt>
                <c:pt idx="2787">
                  <c:v>1393.5</c:v>
                </c:pt>
                <c:pt idx="2788">
                  <c:v>1394</c:v>
                </c:pt>
                <c:pt idx="2789">
                  <c:v>1394.5</c:v>
                </c:pt>
                <c:pt idx="2790">
                  <c:v>1395</c:v>
                </c:pt>
                <c:pt idx="2791">
                  <c:v>1395.5</c:v>
                </c:pt>
                <c:pt idx="2792">
                  <c:v>1396</c:v>
                </c:pt>
                <c:pt idx="2793">
                  <c:v>1396.5</c:v>
                </c:pt>
                <c:pt idx="2794">
                  <c:v>1397</c:v>
                </c:pt>
                <c:pt idx="2795">
                  <c:v>1397.5</c:v>
                </c:pt>
                <c:pt idx="2796">
                  <c:v>1398</c:v>
                </c:pt>
                <c:pt idx="2797">
                  <c:v>1398.5</c:v>
                </c:pt>
                <c:pt idx="2798">
                  <c:v>1399</c:v>
                </c:pt>
                <c:pt idx="2799">
                  <c:v>1399.5</c:v>
                </c:pt>
                <c:pt idx="2800">
                  <c:v>1400</c:v>
                </c:pt>
                <c:pt idx="2801">
                  <c:v>1400.5</c:v>
                </c:pt>
                <c:pt idx="2802">
                  <c:v>1401</c:v>
                </c:pt>
                <c:pt idx="2803">
                  <c:v>1401.5</c:v>
                </c:pt>
                <c:pt idx="2804">
                  <c:v>1402</c:v>
                </c:pt>
                <c:pt idx="2805">
                  <c:v>1402.5</c:v>
                </c:pt>
                <c:pt idx="2806">
                  <c:v>1403</c:v>
                </c:pt>
                <c:pt idx="2807">
                  <c:v>1403.5</c:v>
                </c:pt>
                <c:pt idx="2808">
                  <c:v>1404</c:v>
                </c:pt>
                <c:pt idx="2809">
                  <c:v>1404.5</c:v>
                </c:pt>
                <c:pt idx="2810">
                  <c:v>1405</c:v>
                </c:pt>
                <c:pt idx="2811">
                  <c:v>1405.5</c:v>
                </c:pt>
                <c:pt idx="2812">
                  <c:v>1406</c:v>
                </c:pt>
                <c:pt idx="2813">
                  <c:v>1406.5</c:v>
                </c:pt>
                <c:pt idx="2814">
                  <c:v>1407</c:v>
                </c:pt>
                <c:pt idx="2815">
                  <c:v>1407.5</c:v>
                </c:pt>
                <c:pt idx="2816">
                  <c:v>1408</c:v>
                </c:pt>
                <c:pt idx="2817">
                  <c:v>1408.5</c:v>
                </c:pt>
                <c:pt idx="2818">
                  <c:v>1409</c:v>
                </c:pt>
                <c:pt idx="2819">
                  <c:v>1409.5</c:v>
                </c:pt>
                <c:pt idx="2820">
                  <c:v>1410</c:v>
                </c:pt>
                <c:pt idx="2821">
                  <c:v>1410.5</c:v>
                </c:pt>
                <c:pt idx="2822">
                  <c:v>1411</c:v>
                </c:pt>
                <c:pt idx="2823">
                  <c:v>1411.5</c:v>
                </c:pt>
                <c:pt idx="2824">
                  <c:v>1412</c:v>
                </c:pt>
                <c:pt idx="2825">
                  <c:v>1412.5</c:v>
                </c:pt>
                <c:pt idx="2826">
                  <c:v>1413</c:v>
                </c:pt>
                <c:pt idx="2827">
                  <c:v>1413.5</c:v>
                </c:pt>
                <c:pt idx="2828">
                  <c:v>1414</c:v>
                </c:pt>
                <c:pt idx="2829">
                  <c:v>1414.5</c:v>
                </c:pt>
                <c:pt idx="2830">
                  <c:v>1415</c:v>
                </c:pt>
                <c:pt idx="2831">
                  <c:v>1415.5</c:v>
                </c:pt>
                <c:pt idx="2832">
                  <c:v>1416</c:v>
                </c:pt>
                <c:pt idx="2833">
                  <c:v>1416.5</c:v>
                </c:pt>
                <c:pt idx="2834">
                  <c:v>1417</c:v>
                </c:pt>
                <c:pt idx="2835">
                  <c:v>1417.5</c:v>
                </c:pt>
                <c:pt idx="2836">
                  <c:v>1418</c:v>
                </c:pt>
                <c:pt idx="2837">
                  <c:v>1418.5</c:v>
                </c:pt>
                <c:pt idx="2838">
                  <c:v>1419</c:v>
                </c:pt>
                <c:pt idx="2839">
                  <c:v>1419.5</c:v>
                </c:pt>
                <c:pt idx="2840">
                  <c:v>1420</c:v>
                </c:pt>
                <c:pt idx="2841">
                  <c:v>1420.5</c:v>
                </c:pt>
                <c:pt idx="2842">
                  <c:v>1421</c:v>
                </c:pt>
                <c:pt idx="2843">
                  <c:v>1421.5</c:v>
                </c:pt>
                <c:pt idx="2844">
                  <c:v>1422</c:v>
                </c:pt>
                <c:pt idx="2845">
                  <c:v>1422.5</c:v>
                </c:pt>
                <c:pt idx="2846">
                  <c:v>1423</c:v>
                </c:pt>
                <c:pt idx="2847">
                  <c:v>1423.5</c:v>
                </c:pt>
                <c:pt idx="2848">
                  <c:v>1424</c:v>
                </c:pt>
                <c:pt idx="2849">
                  <c:v>1424.5</c:v>
                </c:pt>
                <c:pt idx="2850">
                  <c:v>1425</c:v>
                </c:pt>
                <c:pt idx="2851">
                  <c:v>1425.5</c:v>
                </c:pt>
                <c:pt idx="2852">
                  <c:v>1426</c:v>
                </c:pt>
                <c:pt idx="2853">
                  <c:v>1426.5</c:v>
                </c:pt>
                <c:pt idx="2854">
                  <c:v>1427</c:v>
                </c:pt>
                <c:pt idx="2855">
                  <c:v>1427.5</c:v>
                </c:pt>
                <c:pt idx="2856">
                  <c:v>1428</c:v>
                </c:pt>
                <c:pt idx="2857">
                  <c:v>1428.5</c:v>
                </c:pt>
                <c:pt idx="2858">
                  <c:v>1429</c:v>
                </c:pt>
                <c:pt idx="2859">
                  <c:v>1429.5</c:v>
                </c:pt>
                <c:pt idx="2860">
                  <c:v>1430</c:v>
                </c:pt>
                <c:pt idx="2861">
                  <c:v>1430.5</c:v>
                </c:pt>
                <c:pt idx="2862">
                  <c:v>1431</c:v>
                </c:pt>
                <c:pt idx="2863">
                  <c:v>1431.5</c:v>
                </c:pt>
                <c:pt idx="2864">
                  <c:v>1432</c:v>
                </c:pt>
                <c:pt idx="2865">
                  <c:v>1432.5</c:v>
                </c:pt>
                <c:pt idx="2866">
                  <c:v>1433</c:v>
                </c:pt>
                <c:pt idx="2867">
                  <c:v>1433.5</c:v>
                </c:pt>
                <c:pt idx="2868">
                  <c:v>1434</c:v>
                </c:pt>
                <c:pt idx="2869">
                  <c:v>1434.5</c:v>
                </c:pt>
                <c:pt idx="2870">
                  <c:v>1435</c:v>
                </c:pt>
                <c:pt idx="2871">
                  <c:v>1435.5</c:v>
                </c:pt>
                <c:pt idx="2872">
                  <c:v>1436</c:v>
                </c:pt>
                <c:pt idx="2873">
                  <c:v>1436.5</c:v>
                </c:pt>
                <c:pt idx="2874">
                  <c:v>1437</c:v>
                </c:pt>
                <c:pt idx="2875">
                  <c:v>1437.5</c:v>
                </c:pt>
                <c:pt idx="2876">
                  <c:v>1438</c:v>
                </c:pt>
                <c:pt idx="2877">
                  <c:v>1438.5</c:v>
                </c:pt>
                <c:pt idx="2878">
                  <c:v>1439</c:v>
                </c:pt>
                <c:pt idx="2879">
                  <c:v>1439.5</c:v>
                </c:pt>
                <c:pt idx="2880">
                  <c:v>1440</c:v>
                </c:pt>
                <c:pt idx="2881">
                  <c:v>1440.5</c:v>
                </c:pt>
                <c:pt idx="2882">
                  <c:v>1441</c:v>
                </c:pt>
                <c:pt idx="2883">
                  <c:v>1441.5</c:v>
                </c:pt>
                <c:pt idx="2884">
                  <c:v>1442</c:v>
                </c:pt>
                <c:pt idx="2885">
                  <c:v>1442.5</c:v>
                </c:pt>
                <c:pt idx="2886">
                  <c:v>1443</c:v>
                </c:pt>
                <c:pt idx="2887">
                  <c:v>1443.5</c:v>
                </c:pt>
                <c:pt idx="2888">
                  <c:v>1444</c:v>
                </c:pt>
                <c:pt idx="2889">
                  <c:v>1444.5</c:v>
                </c:pt>
                <c:pt idx="2890">
                  <c:v>1445</c:v>
                </c:pt>
                <c:pt idx="2891">
                  <c:v>1445.5</c:v>
                </c:pt>
                <c:pt idx="2892">
                  <c:v>1446</c:v>
                </c:pt>
                <c:pt idx="2893">
                  <c:v>1446.5</c:v>
                </c:pt>
                <c:pt idx="2894">
                  <c:v>1447</c:v>
                </c:pt>
                <c:pt idx="2895">
                  <c:v>1447.5</c:v>
                </c:pt>
                <c:pt idx="2896">
                  <c:v>1448</c:v>
                </c:pt>
                <c:pt idx="2897">
                  <c:v>1448.5</c:v>
                </c:pt>
                <c:pt idx="2898">
                  <c:v>1449</c:v>
                </c:pt>
                <c:pt idx="2899">
                  <c:v>1449.5</c:v>
                </c:pt>
                <c:pt idx="2900">
                  <c:v>1450</c:v>
                </c:pt>
                <c:pt idx="2901">
                  <c:v>1450.5</c:v>
                </c:pt>
                <c:pt idx="2902">
                  <c:v>1451</c:v>
                </c:pt>
                <c:pt idx="2903">
                  <c:v>1451.5</c:v>
                </c:pt>
                <c:pt idx="2904">
                  <c:v>1452</c:v>
                </c:pt>
                <c:pt idx="2905">
                  <c:v>1452.5</c:v>
                </c:pt>
                <c:pt idx="2906">
                  <c:v>1453</c:v>
                </c:pt>
                <c:pt idx="2907">
                  <c:v>1453.5</c:v>
                </c:pt>
                <c:pt idx="2908">
                  <c:v>1454</c:v>
                </c:pt>
                <c:pt idx="2909">
                  <c:v>1454.5</c:v>
                </c:pt>
                <c:pt idx="2910">
                  <c:v>1455</c:v>
                </c:pt>
                <c:pt idx="2911">
                  <c:v>1455.5</c:v>
                </c:pt>
                <c:pt idx="2912">
                  <c:v>1456</c:v>
                </c:pt>
                <c:pt idx="2913">
                  <c:v>1456.5</c:v>
                </c:pt>
                <c:pt idx="2914">
                  <c:v>1457</c:v>
                </c:pt>
                <c:pt idx="2915">
                  <c:v>1457.5</c:v>
                </c:pt>
                <c:pt idx="2916">
                  <c:v>1458</c:v>
                </c:pt>
                <c:pt idx="2917">
                  <c:v>1458.5</c:v>
                </c:pt>
                <c:pt idx="2918">
                  <c:v>1459</c:v>
                </c:pt>
                <c:pt idx="2919">
                  <c:v>1459.5</c:v>
                </c:pt>
                <c:pt idx="2920">
                  <c:v>1460</c:v>
                </c:pt>
                <c:pt idx="2921">
                  <c:v>1460.5</c:v>
                </c:pt>
                <c:pt idx="2922">
                  <c:v>1461</c:v>
                </c:pt>
                <c:pt idx="2923">
                  <c:v>1461.5</c:v>
                </c:pt>
                <c:pt idx="2924">
                  <c:v>1462</c:v>
                </c:pt>
                <c:pt idx="2925">
                  <c:v>1462.5</c:v>
                </c:pt>
                <c:pt idx="2926">
                  <c:v>1463</c:v>
                </c:pt>
                <c:pt idx="2927">
                  <c:v>1463.5</c:v>
                </c:pt>
                <c:pt idx="2928">
                  <c:v>1464</c:v>
                </c:pt>
                <c:pt idx="2929">
                  <c:v>1464.5</c:v>
                </c:pt>
                <c:pt idx="2930">
                  <c:v>1465</c:v>
                </c:pt>
                <c:pt idx="2931">
                  <c:v>1465.5</c:v>
                </c:pt>
                <c:pt idx="2932">
                  <c:v>1466</c:v>
                </c:pt>
                <c:pt idx="2933">
                  <c:v>1466.5</c:v>
                </c:pt>
                <c:pt idx="2934">
                  <c:v>1467</c:v>
                </c:pt>
                <c:pt idx="2935">
                  <c:v>1467.5</c:v>
                </c:pt>
                <c:pt idx="2936">
                  <c:v>1468</c:v>
                </c:pt>
                <c:pt idx="2937">
                  <c:v>1468.5</c:v>
                </c:pt>
                <c:pt idx="2938">
                  <c:v>1469</c:v>
                </c:pt>
                <c:pt idx="2939">
                  <c:v>1469.5</c:v>
                </c:pt>
                <c:pt idx="2940">
                  <c:v>1470</c:v>
                </c:pt>
                <c:pt idx="2941">
                  <c:v>1470.5</c:v>
                </c:pt>
                <c:pt idx="2942">
                  <c:v>1471</c:v>
                </c:pt>
                <c:pt idx="2943">
                  <c:v>1471.5</c:v>
                </c:pt>
                <c:pt idx="2944">
                  <c:v>1472</c:v>
                </c:pt>
                <c:pt idx="2945">
                  <c:v>1472.5</c:v>
                </c:pt>
                <c:pt idx="2946">
                  <c:v>1473</c:v>
                </c:pt>
                <c:pt idx="2947">
                  <c:v>1473.5</c:v>
                </c:pt>
                <c:pt idx="2948">
                  <c:v>1474</c:v>
                </c:pt>
                <c:pt idx="2949">
                  <c:v>1474.5</c:v>
                </c:pt>
                <c:pt idx="2950">
                  <c:v>1475</c:v>
                </c:pt>
                <c:pt idx="2951">
                  <c:v>1475.5</c:v>
                </c:pt>
                <c:pt idx="2952">
                  <c:v>1476</c:v>
                </c:pt>
                <c:pt idx="2953">
                  <c:v>1476.5</c:v>
                </c:pt>
                <c:pt idx="2954">
                  <c:v>1477</c:v>
                </c:pt>
                <c:pt idx="2955">
                  <c:v>1477.5</c:v>
                </c:pt>
                <c:pt idx="2956">
                  <c:v>1478</c:v>
                </c:pt>
                <c:pt idx="2957">
                  <c:v>1478.5</c:v>
                </c:pt>
                <c:pt idx="2958">
                  <c:v>1479</c:v>
                </c:pt>
                <c:pt idx="2959">
                  <c:v>1479.5</c:v>
                </c:pt>
                <c:pt idx="2960">
                  <c:v>1480</c:v>
                </c:pt>
                <c:pt idx="2961">
                  <c:v>1480.5</c:v>
                </c:pt>
                <c:pt idx="2962">
                  <c:v>1481</c:v>
                </c:pt>
                <c:pt idx="2963">
                  <c:v>1481.5</c:v>
                </c:pt>
                <c:pt idx="2964">
                  <c:v>1482</c:v>
                </c:pt>
                <c:pt idx="2965">
                  <c:v>1482.5</c:v>
                </c:pt>
                <c:pt idx="2966">
                  <c:v>1483</c:v>
                </c:pt>
                <c:pt idx="2967">
                  <c:v>1483.5</c:v>
                </c:pt>
                <c:pt idx="2968">
                  <c:v>1484</c:v>
                </c:pt>
                <c:pt idx="2969">
                  <c:v>1484.5</c:v>
                </c:pt>
                <c:pt idx="2970">
                  <c:v>1485</c:v>
                </c:pt>
                <c:pt idx="2971">
                  <c:v>1485.5</c:v>
                </c:pt>
                <c:pt idx="2972">
                  <c:v>1486</c:v>
                </c:pt>
                <c:pt idx="2973">
                  <c:v>1486.5</c:v>
                </c:pt>
                <c:pt idx="2974">
                  <c:v>1487</c:v>
                </c:pt>
                <c:pt idx="2975">
                  <c:v>1487.5</c:v>
                </c:pt>
                <c:pt idx="2976">
                  <c:v>1488</c:v>
                </c:pt>
                <c:pt idx="2977">
                  <c:v>1488.5</c:v>
                </c:pt>
                <c:pt idx="2978">
                  <c:v>1489</c:v>
                </c:pt>
                <c:pt idx="2979">
                  <c:v>1489.5</c:v>
                </c:pt>
                <c:pt idx="2980">
                  <c:v>1490</c:v>
                </c:pt>
                <c:pt idx="2981">
                  <c:v>1490.5</c:v>
                </c:pt>
                <c:pt idx="2982">
                  <c:v>1491</c:v>
                </c:pt>
                <c:pt idx="2983">
                  <c:v>1491.5</c:v>
                </c:pt>
                <c:pt idx="2984">
                  <c:v>1492</c:v>
                </c:pt>
                <c:pt idx="2985">
                  <c:v>1492.5</c:v>
                </c:pt>
                <c:pt idx="2986">
                  <c:v>1493</c:v>
                </c:pt>
                <c:pt idx="2987">
                  <c:v>1493.5</c:v>
                </c:pt>
                <c:pt idx="2988">
                  <c:v>1494</c:v>
                </c:pt>
                <c:pt idx="2989">
                  <c:v>1494.5</c:v>
                </c:pt>
                <c:pt idx="2990">
                  <c:v>1495</c:v>
                </c:pt>
                <c:pt idx="2991">
                  <c:v>1495.5</c:v>
                </c:pt>
                <c:pt idx="2992">
                  <c:v>1496</c:v>
                </c:pt>
                <c:pt idx="2993">
                  <c:v>1496.5</c:v>
                </c:pt>
                <c:pt idx="2994">
                  <c:v>1497</c:v>
                </c:pt>
                <c:pt idx="2995">
                  <c:v>1497.5</c:v>
                </c:pt>
                <c:pt idx="2996">
                  <c:v>1498</c:v>
                </c:pt>
                <c:pt idx="2997">
                  <c:v>1498.5</c:v>
                </c:pt>
                <c:pt idx="2998">
                  <c:v>1499</c:v>
                </c:pt>
                <c:pt idx="2999">
                  <c:v>1499.5</c:v>
                </c:pt>
                <c:pt idx="3000">
                  <c:v>1500</c:v>
                </c:pt>
                <c:pt idx="3001">
                  <c:v>1500.5</c:v>
                </c:pt>
                <c:pt idx="3002">
                  <c:v>1501</c:v>
                </c:pt>
                <c:pt idx="3003">
                  <c:v>1501.5</c:v>
                </c:pt>
                <c:pt idx="3004">
                  <c:v>1502</c:v>
                </c:pt>
                <c:pt idx="3005">
                  <c:v>1502.5</c:v>
                </c:pt>
                <c:pt idx="3006">
                  <c:v>1503</c:v>
                </c:pt>
                <c:pt idx="3007">
                  <c:v>1503.5</c:v>
                </c:pt>
                <c:pt idx="3008">
                  <c:v>1504</c:v>
                </c:pt>
                <c:pt idx="3009">
                  <c:v>1504.5</c:v>
                </c:pt>
                <c:pt idx="3010">
                  <c:v>1505</c:v>
                </c:pt>
                <c:pt idx="3011">
                  <c:v>1505.5</c:v>
                </c:pt>
                <c:pt idx="3012">
                  <c:v>1506</c:v>
                </c:pt>
                <c:pt idx="3013">
                  <c:v>1506.5</c:v>
                </c:pt>
                <c:pt idx="3014">
                  <c:v>1507</c:v>
                </c:pt>
                <c:pt idx="3015">
                  <c:v>1507.5</c:v>
                </c:pt>
                <c:pt idx="3016">
                  <c:v>1508</c:v>
                </c:pt>
                <c:pt idx="3017">
                  <c:v>1508.5</c:v>
                </c:pt>
                <c:pt idx="3018">
                  <c:v>1509</c:v>
                </c:pt>
                <c:pt idx="3019">
                  <c:v>1509.5</c:v>
                </c:pt>
                <c:pt idx="3020">
                  <c:v>1510</c:v>
                </c:pt>
                <c:pt idx="3021">
                  <c:v>1510.5</c:v>
                </c:pt>
                <c:pt idx="3022">
                  <c:v>1511</c:v>
                </c:pt>
                <c:pt idx="3023">
                  <c:v>1511.5</c:v>
                </c:pt>
                <c:pt idx="3024">
                  <c:v>1512</c:v>
                </c:pt>
                <c:pt idx="3025">
                  <c:v>1512.5</c:v>
                </c:pt>
                <c:pt idx="3026">
                  <c:v>1513</c:v>
                </c:pt>
                <c:pt idx="3027">
                  <c:v>1513.5</c:v>
                </c:pt>
                <c:pt idx="3028">
                  <c:v>1514</c:v>
                </c:pt>
                <c:pt idx="3029">
                  <c:v>1514.5</c:v>
                </c:pt>
                <c:pt idx="3030">
                  <c:v>1515</c:v>
                </c:pt>
                <c:pt idx="3031">
                  <c:v>1515.5</c:v>
                </c:pt>
                <c:pt idx="3032">
                  <c:v>1516</c:v>
                </c:pt>
                <c:pt idx="3033">
                  <c:v>1516.5</c:v>
                </c:pt>
                <c:pt idx="3034">
                  <c:v>1517</c:v>
                </c:pt>
                <c:pt idx="3035">
                  <c:v>1517.5</c:v>
                </c:pt>
                <c:pt idx="3036">
                  <c:v>1518</c:v>
                </c:pt>
                <c:pt idx="3037">
                  <c:v>1518.5</c:v>
                </c:pt>
                <c:pt idx="3038">
                  <c:v>1519</c:v>
                </c:pt>
                <c:pt idx="3039">
                  <c:v>1519.5</c:v>
                </c:pt>
                <c:pt idx="3040">
                  <c:v>1520</c:v>
                </c:pt>
                <c:pt idx="3041">
                  <c:v>1520.5</c:v>
                </c:pt>
                <c:pt idx="3042">
                  <c:v>1521</c:v>
                </c:pt>
                <c:pt idx="3043">
                  <c:v>1521.5</c:v>
                </c:pt>
                <c:pt idx="3044">
                  <c:v>1522</c:v>
                </c:pt>
                <c:pt idx="3045">
                  <c:v>1522.5</c:v>
                </c:pt>
                <c:pt idx="3046">
                  <c:v>1523</c:v>
                </c:pt>
                <c:pt idx="3047">
                  <c:v>1523.5</c:v>
                </c:pt>
                <c:pt idx="3048">
                  <c:v>1524</c:v>
                </c:pt>
                <c:pt idx="3049">
                  <c:v>1524.5</c:v>
                </c:pt>
                <c:pt idx="3050">
                  <c:v>1525</c:v>
                </c:pt>
                <c:pt idx="3051">
                  <c:v>1525.5</c:v>
                </c:pt>
                <c:pt idx="3052">
                  <c:v>1526</c:v>
                </c:pt>
                <c:pt idx="3053">
                  <c:v>1526.5</c:v>
                </c:pt>
                <c:pt idx="3054">
                  <c:v>1527</c:v>
                </c:pt>
                <c:pt idx="3055">
                  <c:v>1527.5</c:v>
                </c:pt>
                <c:pt idx="3056">
                  <c:v>1528</c:v>
                </c:pt>
                <c:pt idx="3057">
                  <c:v>1528.5</c:v>
                </c:pt>
                <c:pt idx="3058">
                  <c:v>1529</c:v>
                </c:pt>
                <c:pt idx="3059">
                  <c:v>1529.5</c:v>
                </c:pt>
                <c:pt idx="3060">
                  <c:v>1530</c:v>
                </c:pt>
                <c:pt idx="3061">
                  <c:v>1530.5</c:v>
                </c:pt>
                <c:pt idx="3062">
                  <c:v>1531</c:v>
                </c:pt>
                <c:pt idx="3063">
                  <c:v>1531.5</c:v>
                </c:pt>
                <c:pt idx="3064">
                  <c:v>1532</c:v>
                </c:pt>
                <c:pt idx="3065">
                  <c:v>1532.5</c:v>
                </c:pt>
                <c:pt idx="3066">
                  <c:v>1533</c:v>
                </c:pt>
                <c:pt idx="3067">
                  <c:v>1533.5</c:v>
                </c:pt>
                <c:pt idx="3068">
                  <c:v>1534</c:v>
                </c:pt>
                <c:pt idx="3069">
                  <c:v>1534.5</c:v>
                </c:pt>
                <c:pt idx="3070">
                  <c:v>1535</c:v>
                </c:pt>
                <c:pt idx="3071">
                  <c:v>1535.5</c:v>
                </c:pt>
                <c:pt idx="3072">
                  <c:v>1536</c:v>
                </c:pt>
                <c:pt idx="3073">
                  <c:v>1536.5</c:v>
                </c:pt>
                <c:pt idx="3074">
                  <c:v>1537</c:v>
                </c:pt>
                <c:pt idx="3075">
                  <c:v>1537.5</c:v>
                </c:pt>
                <c:pt idx="3076">
                  <c:v>1538</c:v>
                </c:pt>
                <c:pt idx="3077">
                  <c:v>1538.5</c:v>
                </c:pt>
                <c:pt idx="3078">
                  <c:v>1539</c:v>
                </c:pt>
                <c:pt idx="3079">
                  <c:v>1539.5</c:v>
                </c:pt>
                <c:pt idx="3080">
                  <c:v>1540</c:v>
                </c:pt>
                <c:pt idx="3081">
                  <c:v>1540.5</c:v>
                </c:pt>
                <c:pt idx="3082">
                  <c:v>1541</c:v>
                </c:pt>
                <c:pt idx="3083">
                  <c:v>1541.5</c:v>
                </c:pt>
                <c:pt idx="3084">
                  <c:v>1542</c:v>
                </c:pt>
                <c:pt idx="3085">
                  <c:v>1542.5</c:v>
                </c:pt>
                <c:pt idx="3086">
                  <c:v>1543</c:v>
                </c:pt>
                <c:pt idx="3087">
                  <c:v>1543.5</c:v>
                </c:pt>
                <c:pt idx="3088">
                  <c:v>1544</c:v>
                </c:pt>
                <c:pt idx="3089">
                  <c:v>1544.5</c:v>
                </c:pt>
                <c:pt idx="3090">
                  <c:v>1545</c:v>
                </c:pt>
                <c:pt idx="3091">
                  <c:v>1545.5</c:v>
                </c:pt>
                <c:pt idx="3092">
                  <c:v>1546</c:v>
                </c:pt>
                <c:pt idx="3093">
                  <c:v>1546.5</c:v>
                </c:pt>
                <c:pt idx="3094">
                  <c:v>1547</c:v>
                </c:pt>
                <c:pt idx="3095">
                  <c:v>1547.5</c:v>
                </c:pt>
                <c:pt idx="3096">
                  <c:v>1548</c:v>
                </c:pt>
                <c:pt idx="3097">
                  <c:v>1548.5</c:v>
                </c:pt>
                <c:pt idx="3098">
                  <c:v>1549</c:v>
                </c:pt>
                <c:pt idx="3099">
                  <c:v>1549.5</c:v>
                </c:pt>
                <c:pt idx="3100">
                  <c:v>1550</c:v>
                </c:pt>
                <c:pt idx="3101">
                  <c:v>1550.5</c:v>
                </c:pt>
                <c:pt idx="3102">
                  <c:v>1551</c:v>
                </c:pt>
                <c:pt idx="3103">
                  <c:v>1551.5</c:v>
                </c:pt>
                <c:pt idx="3104">
                  <c:v>1552</c:v>
                </c:pt>
                <c:pt idx="3105">
                  <c:v>1552.5</c:v>
                </c:pt>
                <c:pt idx="3106">
                  <c:v>1553</c:v>
                </c:pt>
                <c:pt idx="3107">
                  <c:v>1553.5</c:v>
                </c:pt>
                <c:pt idx="3108">
                  <c:v>1554</c:v>
                </c:pt>
                <c:pt idx="3109">
                  <c:v>1554.5</c:v>
                </c:pt>
                <c:pt idx="3110">
                  <c:v>1555</c:v>
                </c:pt>
                <c:pt idx="3111">
                  <c:v>1555.5</c:v>
                </c:pt>
                <c:pt idx="3112">
                  <c:v>1556</c:v>
                </c:pt>
                <c:pt idx="3113">
                  <c:v>1556.5</c:v>
                </c:pt>
                <c:pt idx="3114">
                  <c:v>1557</c:v>
                </c:pt>
                <c:pt idx="3115">
                  <c:v>1557.5</c:v>
                </c:pt>
                <c:pt idx="3116">
                  <c:v>1558</c:v>
                </c:pt>
                <c:pt idx="3117">
                  <c:v>1558.5</c:v>
                </c:pt>
                <c:pt idx="3118">
                  <c:v>1559</c:v>
                </c:pt>
                <c:pt idx="3119">
                  <c:v>1559.5</c:v>
                </c:pt>
                <c:pt idx="3120">
                  <c:v>1560</c:v>
                </c:pt>
                <c:pt idx="3121">
                  <c:v>1560.5</c:v>
                </c:pt>
                <c:pt idx="3122">
                  <c:v>1561</c:v>
                </c:pt>
                <c:pt idx="3123">
                  <c:v>1561.5</c:v>
                </c:pt>
                <c:pt idx="3124">
                  <c:v>1562</c:v>
                </c:pt>
                <c:pt idx="3125">
                  <c:v>1562.5</c:v>
                </c:pt>
                <c:pt idx="3126">
                  <c:v>1563</c:v>
                </c:pt>
                <c:pt idx="3127">
                  <c:v>1563.5</c:v>
                </c:pt>
                <c:pt idx="3128">
                  <c:v>1564</c:v>
                </c:pt>
                <c:pt idx="3129">
                  <c:v>1564.5</c:v>
                </c:pt>
                <c:pt idx="3130">
                  <c:v>1565</c:v>
                </c:pt>
                <c:pt idx="3131">
                  <c:v>1565.5</c:v>
                </c:pt>
                <c:pt idx="3132">
                  <c:v>1566</c:v>
                </c:pt>
                <c:pt idx="3133">
                  <c:v>1566.5</c:v>
                </c:pt>
                <c:pt idx="3134">
                  <c:v>1567</c:v>
                </c:pt>
                <c:pt idx="3135">
                  <c:v>1567.5</c:v>
                </c:pt>
                <c:pt idx="3136">
                  <c:v>1568</c:v>
                </c:pt>
                <c:pt idx="3137">
                  <c:v>1568.5</c:v>
                </c:pt>
                <c:pt idx="3138">
                  <c:v>1569</c:v>
                </c:pt>
                <c:pt idx="3139">
                  <c:v>1569.5</c:v>
                </c:pt>
                <c:pt idx="3140">
                  <c:v>1570</c:v>
                </c:pt>
                <c:pt idx="3141">
                  <c:v>1570.5</c:v>
                </c:pt>
                <c:pt idx="3142">
                  <c:v>1571</c:v>
                </c:pt>
                <c:pt idx="3143">
                  <c:v>1571.5</c:v>
                </c:pt>
                <c:pt idx="3144">
                  <c:v>1572</c:v>
                </c:pt>
                <c:pt idx="3145">
                  <c:v>1572.5</c:v>
                </c:pt>
                <c:pt idx="3146">
                  <c:v>1573</c:v>
                </c:pt>
                <c:pt idx="3147">
                  <c:v>1573.5</c:v>
                </c:pt>
                <c:pt idx="3148">
                  <c:v>1574</c:v>
                </c:pt>
                <c:pt idx="3149">
                  <c:v>1574.5</c:v>
                </c:pt>
                <c:pt idx="3150">
                  <c:v>1575</c:v>
                </c:pt>
                <c:pt idx="3151">
                  <c:v>1575.5</c:v>
                </c:pt>
                <c:pt idx="3152">
                  <c:v>1576</c:v>
                </c:pt>
                <c:pt idx="3153">
                  <c:v>1576.5</c:v>
                </c:pt>
                <c:pt idx="3154">
                  <c:v>1577</c:v>
                </c:pt>
                <c:pt idx="3155">
                  <c:v>1577.5</c:v>
                </c:pt>
                <c:pt idx="3156">
                  <c:v>1578</c:v>
                </c:pt>
                <c:pt idx="3157">
                  <c:v>1578.5</c:v>
                </c:pt>
                <c:pt idx="3158">
                  <c:v>1579</c:v>
                </c:pt>
                <c:pt idx="3159">
                  <c:v>1579.5</c:v>
                </c:pt>
                <c:pt idx="3160">
                  <c:v>1580</c:v>
                </c:pt>
                <c:pt idx="3161">
                  <c:v>1580.5</c:v>
                </c:pt>
                <c:pt idx="3162">
                  <c:v>1581</c:v>
                </c:pt>
                <c:pt idx="3163">
                  <c:v>1581.5</c:v>
                </c:pt>
                <c:pt idx="3164">
                  <c:v>1582</c:v>
                </c:pt>
                <c:pt idx="3165">
                  <c:v>1582.5</c:v>
                </c:pt>
                <c:pt idx="3166">
                  <c:v>1583</c:v>
                </c:pt>
                <c:pt idx="3167">
                  <c:v>1583.5</c:v>
                </c:pt>
                <c:pt idx="3168">
                  <c:v>1584</c:v>
                </c:pt>
                <c:pt idx="3169">
                  <c:v>1584.5</c:v>
                </c:pt>
                <c:pt idx="3170">
                  <c:v>1585</c:v>
                </c:pt>
                <c:pt idx="3171">
                  <c:v>1585.5</c:v>
                </c:pt>
                <c:pt idx="3172">
                  <c:v>1586</c:v>
                </c:pt>
                <c:pt idx="3173">
                  <c:v>1586.5</c:v>
                </c:pt>
                <c:pt idx="3174">
                  <c:v>1587</c:v>
                </c:pt>
                <c:pt idx="3175">
                  <c:v>1587.5</c:v>
                </c:pt>
                <c:pt idx="3176">
                  <c:v>1588</c:v>
                </c:pt>
                <c:pt idx="3177">
                  <c:v>1588.5</c:v>
                </c:pt>
                <c:pt idx="3178">
                  <c:v>1589</c:v>
                </c:pt>
                <c:pt idx="3179">
                  <c:v>1589.5</c:v>
                </c:pt>
                <c:pt idx="3180">
                  <c:v>1590</c:v>
                </c:pt>
                <c:pt idx="3181">
                  <c:v>1590.5</c:v>
                </c:pt>
                <c:pt idx="3182">
                  <c:v>1591</c:v>
                </c:pt>
                <c:pt idx="3183">
                  <c:v>1591.5</c:v>
                </c:pt>
                <c:pt idx="3184">
                  <c:v>1592</c:v>
                </c:pt>
                <c:pt idx="3185">
                  <c:v>1592.5</c:v>
                </c:pt>
                <c:pt idx="3186">
                  <c:v>1593</c:v>
                </c:pt>
                <c:pt idx="3187">
                  <c:v>1593.5</c:v>
                </c:pt>
                <c:pt idx="3188">
                  <c:v>1594</c:v>
                </c:pt>
                <c:pt idx="3189">
                  <c:v>1594.5</c:v>
                </c:pt>
                <c:pt idx="3190">
                  <c:v>1595</c:v>
                </c:pt>
                <c:pt idx="3191">
                  <c:v>1595.5</c:v>
                </c:pt>
                <c:pt idx="3192">
                  <c:v>1596</c:v>
                </c:pt>
                <c:pt idx="3193">
                  <c:v>1596.5</c:v>
                </c:pt>
                <c:pt idx="3194">
                  <c:v>1597</c:v>
                </c:pt>
                <c:pt idx="3195">
                  <c:v>1597.5</c:v>
                </c:pt>
                <c:pt idx="3196">
                  <c:v>1598</c:v>
                </c:pt>
                <c:pt idx="3197">
                  <c:v>1598.5</c:v>
                </c:pt>
                <c:pt idx="3198">
                  <c:v>1599</c:v>
                </c:pt>
                <c:pt idx="3199">
                  <c:v>1599.5</c:v>
                </c:pt>
                <c:pt idx="3200">
                  <c:v>1600</c:v>
                </c:pt>
                <c:pt idx="3201">
                  <c:v>1600.5</c:v>
                </c:pt>
                <c:pt idx="3202">
                  <c:v>1601</c:v>
                </c:pt>
                <c:pt idx="3203">
                  <c:v>1601.5</c:v>
                </c:pt>
                <c:pt idx="3204">
                  <c:v>1602</c:v>
                </c:pt>
                <c:pt idx="3205">
                  <c:v>1602.5</c:v>
                </c:pt>
                <c:pt idx="3206">
                  <c:v>1603</c:v>
                </c:pt>
                <c:pt idx="3207">
                  <c:v>1603.5</c:v>
                </c:pt>
                <c:pt idx="3208">
                  <c:v>1604</c:v>
                </c:pt>
                <c:pt idx="3209">
                  <c:v>1604.5</c:v>
                </c:pt>
                <c:pt idx="3210">
                  <c:v>1605</c:v>
                </c:pt>
                <c:pt idx="3211">
                  <c:v>1605.5</c:v>
                </c:pt>
                <c:pt idx="3212">
                  <c:v>1606</c:v>
                </c:pt>
                <c:pt idx="3213">
                  <c:v>1606.5</c:v>
                </c:pt>
                <c:pt idx="3214">
                  <c:v>1607</c:v>
                </c:pt>
                <c:pt idx="3215">
                  <c:v>1607.5</c:v>
                </c:pt>
                <c:pt idx="3216">
                  <c:v>1608</c:v>
                </c:pt>
                <c:pt idx="3217">
                  <c:v>1608.5</c:v>
                </c:pt>
                <c:pt idx="3218">
                  <c:v>1609</c:v>
                </c:pt>
                <c:pt idx="3219">
                  <c:v>1609.5</c:v>
                </c:pt>
                <c:pt idx="3220">
                  <c:v>1610</c:v>
                </c:pt>
                <c:pt idx="3221">
                  <c:v>1610.5</c:v>
                </c:pt>
                <c:pt idx="3222">
                  <c:v>1611</c:v>
                </c:pt>
                <c:pt idx="3223">
                  <c:v>1611.5</c:v>
                </c:pt>
                <c:pt idx="3224">
                  <c:v>1612</c:v>
                </c:pt>
                <c:pt idx="3225">
                  <c:v>1612.5</c:v>
                </c:pt>
                <c:pt idx="3226">
                  <c:v>1613</c:v>
                </c:pt>
                <c:pt idx="3227">
                  <c:v>1613.5</c:v>
                </c:pt>
                <c:pt idx="3228">
                  <c:v>1614</c:v>
                </c:pt>
                <c:pt idx="3229">
                  <c:v>1614.5</c:v>
                </c:pt>
                <c:pt idx="3230">
                  <c:v>1615</c:v>
                </c:pt>
                <c:pt idx="3231">
                  <c:v>1615.5</c:v>
                </c:pt>
                <c:pt idx="3232">
                  <c:v>1616</c:v>
                </c:pt>
                <c:pt idx="3233">
                  <c:v>1616.5</c:v>
                </c:pt>
                <c:pt idx="3234">
                  <c:v>1617</c:v>
                </c:pt>
                <c:pt idx="3235">
                  <c:v>1617.5</c:v>
                </c:pt>
                <c:pt idx="3236">
                  <c:v>1618</c:v>
                </c:pt>
                <c:pt idx="3237">
                  <c:v>1618.5</c:v>
                </c:pt>
                <c:pt idx="3238">
                  <c:v>1619</c:v>
                </c:pt>
                <c:pt idx="3239">
                  <c:v>1619.5</c:v>
                </c:pt>
                <c:pt idx="3240">
                  <c:v>1620</c:v>
                </c:pt>
                <c:pt idx="3241">
                  <c:v>1620.5</c:v>
                </c:pt>
                <c:pt idx="3242">
                  <c:v>1621</c:v>
                </c:pt>
                <c:pt idx="3243">
                  <c:v>1621.5</c:v>
                </c:pt>
                <c:pt idx="3244">
                  <c:v>1622</c:v>
                </c:pt>
                <c:pt idx="3245">
                  <c:v>1622.5</c:v>
                </c:pt>
                <c:pt idx="3246">
                  <c:v>1623</c:v>
                </c:pt>
                <c:pt idx="3247">
                  <c:v>1623.5</c:v>
                </c:pt>
                <c:pt idx="3248">
                  <c:v>1624</c:v>
                </c:pt>
                <c:pt idx="3249">
                  <c:v>1624.5</c:v>
                </c:pt>
                <c:pt idx="3250">
                  <c:v>1625</c:v>
                </c:pt>
                <c:pt idx="3251">
                  <c:v>1625.5</c:v>
                </c:pt>
                <c:pt idx="3252">
                  <c:v>1626</c:v>
                </c:pt>
                <c:pt idx="3253">
                  <c:v>1626.5</c:v>
                </c:pt>
                <c:pt idx="3254">
                  <c:v>1627</c:v>
                </c:pt>
                <c:pt idx="3255">
                  <c:v>1627.5</c:v>
                </c:pt>
                <c:pt idx="3256">
                  <c:v>1628</c:v>
                </c:pt>
                <c:pt idx="3257">
                  <c:v>1628.5</c:v>
                </c:pt>
                <c:pt idx="3258">
                  <c:v>1629</c:v>
                </c:pt>
                <c:pt idx="3259">
                  <c:v>1629.5</c:v>
                </c:pt>
                <c:pt idx="3260">
                  <c:v>1630</c:v>
                </c:pt>
                <c:pt idx="3261">
                  <c:v>1630.5</c:v>
                </c:pt>
                <c:pt idx="3262">
                  <c:v>1631</c:v>
                </c:pt>
                <c:pt idx="3263">
                  <c:v>1631.5</c:v>
                </c:pt>
                <c:pt idx="3264">
                  <c:v>1632</c:v>
                </c:pt>
                <c:pt idx="3265">
                  <c:v>1632.5</c:v>
                </c:pt>
                <c:pt idx="3266">
                  <c:v>1633</c:v>
                </c:pt>
                <c:pt idx="3267">
                  <c:v>1633.5</c:v>
                </c:pt>
                <c:pt idx="3268">
                  <c:v>1634</c:v>
                </c:pt>
                <c:pt idx="3269">
                  <c:v>1634.5</c:v>
                </c:pt>
                <c:pt idx="3270">
                  <c:v>1635</c:v>
                </c:pt>
                <c:pt idx="3271">
                  <c:v>1635.5</c:v>
                </c:pt>
                <c:pt idx="3272">
                  <c:v>1636</c:v>
                </c:pt>
                <c:pt idx="3273">
                  <c:v>1636.5</c:v>
                </c:pt>
                <c:pt idx="3274">
                  <c:v>1637</c:v>
                </c:pt>
                <c:pt idx="3275">
                  <c:v>1637.5</c:v>
                </c:pt>
                <c:pt idx="3276">
                  <c:v>1638</c:v>
                </c:pt>
                <c:pt idx="3277">
                  <c:v>1638.5</c:v>
                </c:pt>
                <c:pt idx="3278">
                  <c:v>1639</c:v>
                </c:pt>
                <c:pt idx="3279">
                  <c:v>1639.5</c:v>
                </c:pt>
                <c:pt idx="3280">
                  <c:v>1640</c:v>
                </c:pt>
                <c:pt idx="3281">
                  <c:v>1640.5</c:v>
                </c:pt>
                <c:pt idx="3282">
                  <c:v>1641</c:v>
                </c:pt>
                <c:pt idx="3283">
                  <c:v>1641.5</c:v>
                </c:pt>
                <c:pt idx="3284">
                  <c:v>1642</c:v>
                </c:pt>
                <c:pt idx="3285">
                  <c:v>1642.5</c:v>
                </c:pt>
                <c:pt idx="3286">
                  <c:v>1643</c:v>
                </c:pt>
                <c:pt idx="3287">
                  <c:v>1643.5</c:v>
                </c:pt>
                <c:pt idx="3288">
                  <c:v>1644</c:v>
                </c:pt>
                <c:pt idx="3289">
                  <c:v>1644.5</c:v>
                </c:pt>
                <c:pt idx="3290">
                  <c:v>1645</c:v>
                </c:pt>
                <c:pt idx="3291">
                  <c:v>1645.5</c:v>
                </c:pt>
                <c:pt idx="3292">
                  <c:v>1646</c:v>
                </c:pt>
                <c:pt idx="3293">
                  <c:v>1646.5</c:v>
                </c:pt>
                <c:pt idx="3294">
                  <c:v>1647</c:v>
                </c:pt>
                <c:pt idx="3295">
                  <c:v>1647.5</c:v>
                </c:pt>
                <c:pt idx="3296">
                  <c:v>1648</c:v>
                </c:pt>
                <c:pt idx="3297">
                  <c:v>1648.5</c:v>
                </c:pt>
                <c:pt idx="3298">
                  <c:v>1649</c:v>
                </c:pt>
                <c:pt idx="3299">
                  <c:v>1649.5</c:v>
                </c:pt>
                <c:pt idx="3300">
                  <c:v>1650</c:v>
                </c:pt>
                <c:pt idx="3301">
                  <c:v>1650.5</c:v>
                </c:pt>
                <c:pt idx="3302">
                  <c:v>1651</c:v>
                </c:pt>
                <c:pt idx="3303">
                  <c:v>1651.5</c:v>
                </c:pt>
                <c:pt idx="3304">
                  <c:v>1652</c:v>
                </c:pt>
                <c:pt idx="3305">
                  <c:v>1652.5</c:v>
                </c:pt>
                <c:pt idx="3306">
                  <c:v>1653</c:v>
                </c:pt>
                <c:pt idx="3307">
                  <c:v>1653.5</c:v>
                </c:pt>
                <c:pt idx="3308">
                  <c:v>1654</c:v>
                </c:pt>
                <c:pt idx="3309">
                  <c:v>1654.5</c:v>
                </c:pt>
                <c:pt idx="3310">
                  <c:v>1655</c:v>
                </c:pt>
                <c:pt idx="3311">
                  <c:v>1655.5</c:v>
                </c:pt>
                <c:pt idx="3312">
                  <c:v>1656</c:v>
                </c:pt>
                <c:pt idx="3313">
                  <c:v>1656.5</c:v>
                </c:pt>
                <c:pt idx="3314">
                  <c:v>1657</c:v>
                </c:pt>
                <c:pt idx="3315">
                  <c:v>1657.5</c:v>
                </c:pt>
                <c:pt idx="3316">
                  <c:v>1658</c:v>
                </c:pt>
                <c:pt idx="3317">
                  <c:v>1658.5</c:v>
                </c:pt>
                <c:pt idx="3318">
                  <c:v>1659</c:v>
                </c:pt>
                <c:pt idx="3319">
                  <c:v>1659.5</c:v>
                </c:pt>
                <c:pt idx="3320">
                  <c:v>1660</c:v>
                </c:pt>
                <c:pt idx="3321">
                  <c:v>1660.5</c:v>
                </c:pt>
                <c:pt idx="3322">
                  <c:v>1661</c:v>
                </c:pt>
                <c:pt idx="3323">
                  <c:v>1661.5</c:v>
                </c:pt>
                <c:pt idx="3324">
                  <c:v>1662</c:v>
                </c:pt>
                <c:pt idx="3325">
                  <c:v>1662.5</c:v>
                </c:pt>
                <c:pt idx="3326">
                  <c:v>1663</c:v>
                </c:pt>
                <c:pt idx="3327">
                  <c:v>1663.5</c:v>
                </c:pt>
                <c:pt idx="3328">
                  <c:v>1664</c:v>
                </c:pt>
                <c:pt idx="3329">
                  <c:v>1664.5</c:v>
                </c:pt>
                <c:pt idx="3330">
                  <c:v>1665</c:v>
                </c:pt>
                <c:pt idx="3331">
                  <c:v>1665.5</c:v>
                </c:pt>
                <c:pt idx="3332">
                  <c:v>1666</c:v>
                </c:pt>
                <c:pt idx="3333">
                  <c:v>1666.5</c:v>
                </c:pt>
                <c:pt idx="3334">
                  <c:v>1667</c:v>
                </c:pt>
                <c:pt idx="3335">
                  <c:v>1667.5</c:v>
                </c:pt>
                <c:pt idx="3336">
                  <c:v>1668</c:v>
                </c:pt>
                <c:pt idx="3337">
                  <c:v>1668.5</c:v>
                </c:pt>
                <c:pt idx="3338">
                  <c:v>1669</c:v>
                </c:pt>
                <c:pt idx="3339">
                  <c:v>1669.5</c:v>
                </c:pt>
                <c:pt idx="3340">
                  <c:v>1670</c:v>
                </c:pt>
                <c:pt idx="3341">
                  <c:v>1670.5</c:v>
                </c:pt>
                <c:pt idx="3342">
                  <c:v>1671</c:v>
                </c:pt>
                <c:pt idx="3343">
                  <c:v>1671.5</c:v>
                </c:pt>
                <c:pt idx="3344">
                  <c:v>1672</c:v>
                </c:pt>
                <c:pt idx="3345">
                  <c:v>1672.5</c:v>
                </c:pt>
                <c:pt idx="3346">
                  <c:v>1673</c:v>
                </c:pt>
                <c:pt idx="3347">
                  <c:v>1673.5</c:v>
                </c:pt>
                <c:pt idx="3348">
                  <c:v>1674</c:v>
                </c:pt>
                <c:pt idx="3349">
                  <c:v>1674.5</c:v>
                </c:pt>
                <c:pt idx="3350">
                  <c:v>1675</c:v>
                </c:pt>
                <c:pt idx="3351">
                  <c:v>1675.5</c:v>
                </c:pt>
                <c:pt idx="3352">
                  <c:v>1676</c:v>
                </c:pt>
                <c:pt idx="3353">
                  <c:v>1676.5</c:v>
                </c:pt>
                <c:pt idx="3354">
                  <c:v>1677</c:v>
                </c:pt>
                <c:pt idx="3355">
                  <c:v>1677.5</c:v>
                </c:pt>
                <c:pt idx="3356">
                  <c:v>1678</c:v>
                </c:pt>
                <c:pt idx="3357">
                  <c:v>1678.5</c:v>
                </c:pt>
                <c:pt idx="3358">
                  <c:v>1679</c:v>
                </c:pt>
                <c:pt idx="3359">
                  <c:v>1679.5</c:v>
                </c:pt>
                <c:pt idx="3360">
                  <c:v>1680</c:v>
                </c:pt>
                <c:pt idx="3361">
                  <c:v>1680.5</c:v>
                </c:pt>
                <c:pt idx="3362">
                  <c:v>1681</c:v>
                </c:pt>
                <c:pt idx="3363">
                  <c:v>1681.5</c:v>
                </c:pt>
                <c:pt idx="3364">
                  <c:v>1682</c:v>
                </c:pt>
                <c:pt idx="3365">
                  <c:v>1682.5</c:v>
                </c:pt>
                <c:pt idx="3366">
                  <c:v>1683</c:v>
                </c:pt>
                <c:pt idx="3367">
                  <c:v>1683.5</c:v>
                </c:pt>
                <c:pt idx="3368">
                  <c:v>1684</c:v>
                </c:pt>
                <c:pt idx="3369">
                  <c:v>1684.5</c:v>
                </c:pt>
                <c:pt idx="3370">
                  <c:v>1685</c:v>
                </c:pt>
                <c:pt idx="3371">
                  <c:v>1685.5</c:v>
                </c:pt>
                <c:pt idx="3372">
                  <c:v>1686</c:v>
                </c:pt>
                <c:pt idx="3373">
                  <c:v>1686.5</c:v>
                </c:pt>
                <c:pt idx="3374">
                  <c:v>1687</c:v>
                </c:pt>
                <c:pt idx="3375">
                  <c:v>1687.5</c:v>
                </c:pt>
                <c:pt idx="3376">
                  <c:v>1688</c:v>
                </c:pt>
                <c:pt idx="3377">
                  <c:v>1688.5</c:v>
                </c:pt>
                <c:pt idx="3378">
                  <c:v>1689</c:v>
                </c:pt>
                <c:pt idx="3379">
                  <c:v>1689.5</c:v>
                </c:pt>
                <c:pt idx="3380">
                  <c:v>1690</c:v>
                </c:pt>
                <c:pt idx="3381">
                  <c:v>1690.5</c:v>
                </c:pt>
                <c:pt idx="3382">
                  <c:v>1691</c:v>
                </c:pt>
                <c:pt idx="3383">
                  <c:v>1691.5</c:v>
                </c:pt>
                <c:pt idx="3384">
                  <c:v>1692</c:v>
                </c:pt>
                <c:pt idx="3385">
                  <c:v>1692.5</c:v>
                </c:pt>
                <c:pt idx="3386">
                  <c:v>1693</c:v>
                </c:pt>
                <c:pt idx="3387">
                  <c:v>1693.5</c:v>
                </c:pt>
                <c:pt idx="3388">
                  <c:v>1694</c:v>
                </c:pt>
                <c:pt idx="3389">
                  <c:v>1694.5</c:v>
                </c:pt>
                <c:pt idx="3390">
                  <c:v>1695</c:v>
                </c:pt>
                <c:pt idx="3391">
                  <c:v>1695.5</c:v>
                </c:pt>
                <c:pt idx="3392">
                  <c:v>1696</c:v>
                </c:pt>
                <c:pt idx="3393">
                  <c:v>1696.5</c:v>
                </c:pt>
                <c:pt idx="3394">
                  <c:v>1697</c:v>
                </c:pt>
                <c:pt idx="3395">
                  <c:v>1697.5</c:v>
                </c:pt>
                <c:pt idx="3396">
                  <c:v>1698</c:v>
                </c:pt>
                <c:pt idx="3397">
                  <c:v>1698.5</c:v>
                </c:pt>
                <c:pt idx="3398">
                  <c:v>1699</c:v>
                </c:pt>
                <c:pt idx="3399">
                  <c:v>1699.5</c:v>
                </c:pt>
                <c:pt idx="3400">
                  <c:v>1700</c:v>
                </c:pt>
                <c:pt idx="3401">
                  <c:v>1700.5</c:v>
                </c:pt>
                <c:pt idx="3402">
                  <c:v>1701</c:v>
                </c:pt>
                <c:pt idx="3403">
                  <c:v>1701.5</c:v>
                </c:pt>
                <c:pt idx="3404">
                  <c:v>1702</c:v>
                </c:pt>
                <c:pt idx="3405">
                  <c:v>1702.5</c:v>
                </c:pt>
                <c:pt idx="3406">
                  <c:v>1703</c:v>
                </c:pt>
                <c:pt idx="3407">
                  <c:v>1703.5</c:v>
                </c:pt>
                <c:pt idx="3408">
                  <c:v>1704</c:v>
                </c:pt>
                <c:pt idx="3409">
                  <c:v>1704.5</c:v>
                </c:pt>
                <c:pt idx="3410">
                  <c:v>1705</c:v>
                </c:pt>
                <c:pt idx="3411">
                  <c:v>1705.5</c:v>
                </c:pt>
                <c:pt idx="3412">
                  <c:v>1706</c:v>
                </c:pt>
                <c:pt idx="3413">
                  <c:v>1706.5</c:v>
                </c:pt>
                <c:pt idx="3414">
                  <c:v>1707</c:v>
                </c:pt>
                <c:pt idx="3415">
                  <c:v>1707.5</c:v>
                </c:pt>
                <c:pt idx="3416">
                  <c:v>1708</c:v>
                </c:pt>
                <c:pt idx="3417">
                  <c:v>1708.5</c:v>
                </c:pt>
                <c:pt idx="3418">
                  <c:v>1709</c:v>
                </c:pt>
                <c:pt idx="3419">
                  <c:v>1709.5</c:v>
                </c:pt>
                <c:pt idx="3420">
                  <c:v>1710</c:v>
                </c:pt>
                <c:pt idx="3421">
                  <c:v>1710.5</c:v>
                </c:pt>
                <c:pt idx="3422">
                  <c:v>1711</c:v>
                </c:pt>
                <c:pt idx="3423">
                  <c:v>1711.5</c:v>
                </c:pt>
                <c:pt idx="3424">
                  <c:v>1712</c:v>
                </c:pt>
                <c:pt idx="3425">
                  <c:v>1712.5</c:v>
                </c:pt>
                <c:pt idx="3426">
                  <c:v>1713</c:v>
                </c:pt>
                <c:pt idx="3427">
                  <c:v>1713.5</c:v>
                </c:pt>
                <c:pt idx="3428">
                  <c:v>1714</c:v>
                </c:pt>
                <c:pt idx="3429">
                  <c:v>1714.5</c:v>
                </c:pt>
                <c:pt idx="3430">
                  <c:v>1715</c:v>
                </c:pt>
                <c:pt idx="3431">
                  <c:v>1715.5</c:v>
                </c:pt>
                <c:pt idx="3432">
                  <c:v>1716</c:v>
                </c:pt>
                <c:pt idx="3433">
                  <c:v>1716.5</c:v>
                </c:pt>
                <c:pt idx="3434">
                  <c:v>1717</c:v>
                </c:pt>
                <c:pt idx="3435">
                  <c:v>1717.5</c:v>
                </c:pt>
                <c:pt idx="3436">
                  <c:v>1718</c:v>
                </c:pt>
                <c:pt idx="3437">
                  <c:v>1718.5</c:v>
                </c:pt>
                <c:pt idx="3438">
                  <c:v>1719</c:v>
                </c:pt>
                <c:pt idx="3439">
                  <c:v>1719.5</c:v>
                </c:pt>
                <c:pt idx="3440">
                  <c:v>1720</c:v>
                </c:pt>
                <c:pt idx="3441">
                  <c:v>1720.5</c:v>
                </c:pt>
                <c:pt idx="3442">
                  <c:v>1721</c:v>
                </c:pt>
                <c:pt idx="3443">
                  <c:v>1721.5</c:v>
                </c:pt>
                <c:pt idx="3444">
                  <c:v>1722</c:v>
                </c:pt>
                <c:pt idx="3445">
                  <c:v>1722.5</c:v>
                </c:pt>
                <c:pt idx="3446">
                  <c:v>1723</c:v>
                </c:pt>
                <c:pt idx="3447">
                  <c:v>1723.5</c:v>
                </c:pt>
                <c:pt idx="3448">
                  <c:v>1724</c:v>
                </c:pt>
                <c:pt idx="3449">
                  <c:v>1724.5</c:v>
                </c:pt>
                <c:pt idx="3450">
                  <c:v>1725</c:v>
                </c:pt>
                <c:pt idx="3451">
                  <c:v>1725.5</c:v>
                </c:pt>
                <c:pt idx="3452">
                  <c:v>1726</c:v>
                </c:pt>
                <c:pt idx="3453">
                  <c:v>1726.5</c:v>
                </c:pt>
                <c:pt idx="3454">
                  <c:v>1727</c:v>
                </c:pt>
                <c:pt idx="3455">
                  <c:v>1727.5</c:v>
                </c:pt>
                <c:pt idx="3456">
                  <c:v>1728</c:v>
                </c:pt>
                <c:pt idx="3457">
                  <c:v>1728.5</c:v>
                </c:pt>
                <c:pt idx="3458">
                  <c:v>1729</c:v>
                </c:pt>
                <c:pt idx="3459">
                  <c:v>1729.5</c:v>
                </c:pt>
                <c:pt idx="3460">
                  <c:v>1730</c:v>
                </c:pt>
                <c:pt idx="3461">
                  <c:v>1730.5</c:v>
                </c:pt>
                <c:pt idx="3462">
                  <c:v>1731</c:v>
                </c:pt>
                <c:pt idx="3463">
                  <c:v>1731.5</c:v>
                </c:pt>
                <c:pt idx="3464">
                  <c:v>1732</c:v>
                </c:pt>
                <c:pt idx="3465">
                  <c:v>1732.5</c:v>
                </c:pt>
                <c:pt idx="3466">
                  <c:v>1733</c:v>
                </c:pt>
                <c:pt idx="3467">
                  <c:v>1733.5</c:v>
                </c:pt>
                <c:pt idx="3468">
                  <c:v>1734</c:v>
                </c:pt>
                <c:pt idx="3469">
                  <c:v>1734.5</c:v>
                </c:pt>
                <c:pt idx="3470">
                  <c:v>1735</c:v>
                </c:pt>
                <c:pt idx="3471">
                  <c:v>1735.5</c:v>
                </c:pt>
                <c:pt idx="3472">
                  <c:v>1736</c:v>
                </c:pt>
                <c:pt idx="3473">
                  <c:v>1736.5</c:v>
                </c:pt>
                <c:pt idx="3474">
                  <c:v>1737</c:v>
                </c:pt>
                <c:pt idx="3475">
                  <c:v>1737.5</c:v>
                </c:pt>
                <c:pt idx="3476">
                  <c:v>1738</c:v>
                </c:pt>
                <c:pt idx="3477">
                  <c:v>1738.5</c:v>
                </c:pt>
                <c:pt idx="3478">
                  <c:v>1739</c:v>
                </c:pt>
                <c:pt idx="3479">
                  <c:v>1739.5</c:v>
                </c:pt>
                <c:pt idx="3480">
                  <c:v>1740</c:v>
                </c:pt>
                <c:pt idx="3481">
                  <c:v>1740.5</c:v>
                </c:pt>
                <c:pt idx="3482">
                  <c:v>1741</c:v>
                </c:pt>
                <c:pt idx="3483">
                  <c:v>1741.5</c:v>
                </c:pt>
                <c:pt idx="3484">
                  <c:v>1742</c:v>
                </c:pt>
                <c:pt idx="3485">
                  <c:v>1742.5</c:v>
                </c:pt>
                <c:pt idx="3486">
                  <c:v>1743</c:v>
                </c:pt>
                <c:pt idx="3487">
                  <c:v>1743.5</c:v>
                </c:pt>
                <c:pt idx="3488">
                  <c:v>1744</c:v>
                </c:pt>
                <c:pt idx="3489">
                  <c:v>1744.5</c:v>
                </c:pt>
                <c:pt idx="3490">
                  <c:v>1745</c:v>
                </c:pt>
                <c:pt idx="3491">
                  <c:v>1745.5</c:v>
                </c:pt>
                <c:pt idx="3492">
                  <c:v>1746</c:v>
                </c:pt>
                <c:pt idx="3493">
                  <c:v>1746.5</c:v>
                </c:pt>
                <c:pt idx="3494">
                  <c:v>1747</c:v>
                </c:pt>
                <c:pt idx="3495">
                  <c:v>1747.5</c:v>
                </c:pt>
                <c:pt idx="3496">
                  <c:v>1748</c:v>
                </c:pt>
                <c:pt idx="3497">
                  <c:v>1748.5</c:v>
                </c:pt>
                <c:pt idx="3498">
                  <c:v>1749</c:v>
                </c:pt>
                <c:pt idx="3499">
                  <c:v>1749.5</c:v>
                </c:pt>
                <c:pt idx="3500">
                  <c:v>1750</c:v>
                </c:pt>
                <c:pt idx="3501">
                  <c:v>1750.5</c:v>
                </c:pt>
                <c:pt idx="3502">
                  <c:v>1751</c:v>
                </c:pt>
                <c:pt idx="3503">
                  <c:v>1751.5</c:v>
                </c:pt>
                <c:pt idx="3504">
                  <c:v>1752</c:v>
                </c:pt>
                <c:pt idx="3505">
                  <c:v>1752.5</c:v>
                </c:pt>
                <c:pt idx="3506">
                  <c:v>1753</c:v>
                </c:pt>
                <c:pt idx="3507">
                  <c:v>1753.5</c:v>
                </c:pt>
                <c:pt idx="3508">
                  <c:v>1754</c:v>
                </c:pt>
                <c:pt idx="3509">
                  <c:v>1754.5</c:v>
                </c:pt>
                <c:pt idx="3510">
                  <c:v>1755</c:v>
                </c:pt>
                <c:pt idx="3511">
                  <c:v>1755.5</c:v>
                </c:pt>
                <c:pt idx="3512">
                  <c:v>1756</c:v>
                </c:pt>
                <c:pt idx="3513">
                  <c:v>1756.5</c:v>
                </c:pt>
                <c:pt idx="3514">
                  <c:v>1757</c:v>
                </c:pt>
                <c:pt idx="3515">
                  <c:v>1757.5</c:v>
                </c:pt>
                <c:pt idx="3516">
                  <c:v>1758</c:v>
                </c:pt>
                <c:pt idx="3517">
                  <c:v>1758.5</c:v>
                </c:pt>
                <c:pt idx="3518">
                  <c:v>1759</c:v>
                </c:pt>
                <c:pt idx="3519">
                  <c:v>1759.5</c:v>
                </c:pt>
                <c:pt idx="3520">
                  <c:v>1760</c:v>
                </c:pt>
                <c:pt idx="3521">
                  <c:v>1760.5</c:v>
                </c:pt>
                <c:pt idx="3522">
                  <c:v>1761</c:v>
                </c:pt>
                <c:pt idx="3523">
                  <c:v>1761.5</c:v>
                </c:pt>
                <c:pt idx="3524">
                  <c:v>1762</c:v>
                </c:pt>
                <c:pt idx="3525">
                  <c:v>1762.5</c:v>
                </c:pt>
                <c:pt idx="3526">
                  <c:v>1763</c:v>
                </c:pt>
                <c:pt idx="3527">
                  <c:v>1763.5</c:v>
                </c:pt>
                <c:pt idx="3528">
                  <c:v>1764</c:v>
                </c:pt>
                <c:pt idx="3529">
                  <c:v>1764.5</c:v>
                </c:pt>
                <c:pt idx="3530">
                  <c:v>1765</c:v>
                </c:pt>
                <c:pt idx="3531">
                  <c:v>1765.5</c:v>
                </c:pt>
                <c:pt idx="3532">
                  <c:v>1766</c:v>
                </c:pt>
                <c:pt idx="3533">
                  <c:v>1766.5</c:v>
                </c:pt>
                <c:pt idx="3534">
                  <c:v>1767</c:v>
                </c:pt>
                <c:pt idx="3535">
                  <c:v>1767.5</c:v>
                </c:pt>
                <c:pt idx="3536">
                  <c:v>1768</c:v>
                </c:pt>
                <c:pt idx="3537">
                  <c:v>1768.5</c:v>
                </c:pt>
                <c:pt idx="3538">
                  <c:v>1769</c:v>
                </c:pt>
                <c:pt idx="3539">
                  <c:v>1769.5</c:v>
                </c:pt>
                <c:pt idx="3540">
                  <c:v>1770</c:v>
                </c:pt>
                <c:pt idx="3541">
                  <c:v>1770.5</c:v>
                </c:pt>
                <c:pt idx="3542">
                  <c:v>1771</c:v>
                </c:pt>
                <c:pt idx="3543">
                  <c:v>1771.5</c:v>
                </c:pt>
                <c:pt idx="3544">
                  <c:v>1772</c:v>
                </c:pt>
                <c:pt idx="3545">
                  <c:v>1772.5</c:v>
                </c:pt>
                <c:pt idx="3546">
                  <c:v>1773</c:v>
                </c:pt>
                <c:pt idx="3547">
                  <c:v>1773.5</c:v>
                </c:pt>
                <c:pt idx="3548">
                  <c:v>1774</c:v>
                </c:pt>
                <c:pt idx="3549">
                  <c:v>1774.5</c:v>
                </c:pt>
                <c:pt idx="3550">
                  <c:v>1775</c:v>
                </c:pt>
                <c:pt idx="3551">
                  <c:v>1775.5</c:v>
                </c:pt>
                <c:pt idx="3552">
                  <c:v>1776</c:v>
                </c:pt>
                <c:pt idx="3553">
                  <c:v>1776.5</c:v>
                </c:pt>
                <c:pt idx="3554">
                  <c:v>1777</c:v>
                </c:pt>
                <c:pt idx="3555">
                  <c:v>1777.5</c:v>
                </c:pt>
                <c:pt idx="3556">
                  <c:v>1778</c:v>
                </c:pt>
                <c:pt idx="3557">
                  <c:v>1778.5</c:v>
                </c:pt>
                <c:pt idx="3558">
                  <c:v>1779</c:v>
                </c:pt>
                <c:pt idx="3559">
                  <c:v>1779.5</c:v>
                </c:pt>
                <c:pt idx="3560">
                  <c:v>1780</c:v>
                </c:pt>
                <c:pt idx="3561">
                  <c:v>1780.5</c:v>
                </c:pt>
                <c:pt idx="3562">
                  <c:v>1781</c:v>
                </c:pt>
                <c:pt idx="3563">
                  <c:v>1781.5</c:v>
                </c:pt>
                <c:pt idx="3564">
                  <c:v>1782</c:v>
                </c:pt>
                <c:pt idx="3565">
                  <c:v>1782.5</c:v>
                </c:pt>
                <c:pt idx="3566">
                  <c:v>1783</c:v>
                </c:pt>
                <c:pt idx="3567">
                  <c:v>1783.5</c:v>
                </c:pt>
                <c:pt idx="3568">
                  <c:v>1784</c:v>
                </c:pt>
                <c:pt idx="3569">
                  <c:v>1784.5</c:v>
                </c:pt>
                <c:pt idx="3570">
                  <c:v>1785</c:v>
                </c:pt>
                <c:pt idx="3571">
                  <c:v>1785.5</c:v>
                </c:pt>
                <c:pt idx="3572">
                  <c:v>1786</c:v>
                </c:pt>
                <c:pt idx="3573">
                  <c:v>1786.5</c:v>
                </c:pt>
                <c:pt idx="3574">
                  <c:v>1787</c:v>
                </c:pt>
                <c:pt idx="3575">
                  <c:v>1787.5</c:v>
                </c:pt>
                <c:pt idx="3576">
                  <c:v>1788</c:v>
                </c:pt>
                <c:pt idx="3577">
                  <c:v>1788.5</c:v>
                </c:pt>
                <c:pt idx="3578">
                  <c:v>1789</c:v>
                </c:pt>
                <c:pt idx="3579">
                  <c:v>1789.5</c:v>
                </c:pt>
                <c:pt idx="3580">
                  <c:v>1790</c:v>
                </c:pt>
                <c:pt idx="3581">
                  <c:v>1790.5</c:v>
                </c:pt>
                <c:pt idx="3582">
                  <c:v>1791</c:v>
                </c:pt>
                <c:pt idx="3583">
                  <c:v>1791.5</c:v>
                </c:pt>
                <c:pt idx="3584">
                  <c:v>1792</c:v>
                </c:pt>
                <c:pt idx="3585">
                  <c:v>1792.5</c:v>
                </c:pt>
                <c:pt idx="3586">
                  <c:v>1793</c:v>
                </c:pt>
                <c:pt idx="3587">
                  <c:v>1793.5</c:v>
                </c:pt>
                <c:pt idx="3588">
                  <c:v>1794</c:v>
                </c:pt>
                <c:pt idx="3589">
                  <c:v>1794.5</c:v>
                </c:pt>
                <c:pt idx="3590">
                  <c:v>1795</c:v>
                </c:pt>
                <c:pt idx="3591">
                  <c:v>1795.5</c:v>
                </c:pt>
                <c:pt idx="3592">
                  <c:v>1796</c:v>
                </c:pt>
                <c:pt idx="3593">
                  <c:v>1796.5</c:v>
                </c:pt>
                <c:pt idx="3594">
                  <c:v>1797</c:v>
                </c:pt>
                <c:pt idx="3595">
                  <c:v>1797.5</c:v>
                </c:pt>
                <c:pt idx="3596">
                  <c:v>1798</c:v>
                </c:pt>
                <c:pt idx="3597">
                  <c:v>1798.5</c:v>
                </c:pt>
                <c:pt idx="3598">
                  <c:v>1799</c:v>
                </c:pt>
                <c:pt idx="3599">
                  <c:v>1799.5</c:v>
                </c:pt>
                <c:pt idx="3600">
                  <c:v>1800</c:v>
                </c:pt>
                <c:pt idx="3601">
                  <c:v>1800.5</c:v>
                </c:pt>
                <c:pt idx="3602">
                  <c:v>1801</c:v>
                </c:pt>
                <c:pt idx="3603">
                  <c:v>1801.5</c:v>
                </c:pt>
                <c:pt idx="3604">
                  <c:v>1802</c:v>
                </c:pt>
                <c:pt idx="3605">
                  <c:v>1802.5</c:v>
                </c:pt>
                <c:pt idx="3606">
                  <c:v>1803</c:v>
                </c:pt>
                <c:pt idx="3607">
                  <c:v>1803.5</c:v>
                </c:pt>
                <c:pt idx="3608">
                  <c:v>1804</c:v>
                </c:pt>
                <c:pt idx="3609">
                  <c:v>1804.5</c:v>
                </c:pt>
                <c:pt idx="3610">
                  <c:v>1805</c:v>
                </c:pt>
                <c:pt idx="3611">
                  <c:v>1805.5</c:v>
                </c:pt>
                <c:pt idx="3612">
                  <c:v>1806</c:v>
                </c:pt>
                <c:pt idx="3613">
                  <c:v>1806.5</c:v>
                </c:pt>
                <c:pt idx="3614">
                  <c:v>1807</c:v>
                </c:pt>
                <c:pt idx="3615">
                  <c:v>1807.5</c:v>
                </c:pt>
                <c:pt idx="3616">
                  <c:v>1808</c:v>
                </c:pt>
                <c:pt idx="3617">
                  <c:v>1808.5</c:v>
                </c:pt>
                <c:pt idx="3618">
                  <c:v>1809</c:v>
                </c:pt>
                <c:pt idx="3619">
                  <c:v>1809.5</c:v>
                </c:pt>
                <c:pt idx="3620">
                  <c:v>1810</c:v>
                </c:pt>
                <c:pt idx="3621">
                  <c:v>1810.5</c:v>
                </c:pt>
                <c:pt idx="3622">
                  <c:v>1811</c:v>
                </c:pt>
                <c:pt idx="3623">
                  <c:v>1811.5</c:v>
                </c:pt>
                <c:pt idx="3624">
                  <c:v>1812</c:v>
                </c:pt>
                <c:pt idx="3625">
                  <c:v>1812.5</c:v>
                </c:pt>
                <c:pt idx="3626">
                  <c:v>1813</c:v>
                </c:pt>
                <c:pt idx="3627">
                  <c:v>1813.5</c:v>
                </c:pt>
                <c:pt idx="3628">
                  <c:v>1814</c:v>
                </c:pt>
                <c:pt idx="3629">
                  <c:v>1814.5</c:v>
                </c:pt>
                <c:pt idx="3630">
                  <c:v>1815</c:v>
                </c:pt>
                <c:pt idx="3631">
                  <c:v>1815.5</c:v>
                </c:pt>
                <c:pt idx="3632">
                  <c:v>1816</c:v>
                </c:pt>
                <c:pt idx="3633">
                  <c:v>1816.5</c:v>
                </c:pt>
                <c:pt idx="3634">
                  <c:v>1817</c:v>
                </c:pt>
                <c:pt idx="3635">
                  <c:v>1817.5</c:v>
                </c:pt>
                <c:pt idx="3636">
                  <c:v>1818</c:v>
                </c:pt>
                <c:pt idx="3637">
                  <c:v>1818.5</c:v>
                </c:pt>
                <c:pt idx="3638">
                  <c:v>1819</c:v>
                </c:pt>
                <c:pt idx="3639">
                  <c:v>1819.5</c:v>
                </c:pt>
                <c:pt idx="3640">
                  <c:v>1820</c:v>
                </c:pt>
                <c:pt idx="3641">
                  <c:v>1820.5</c:v>
                </c:pt>
                <c:pt idx="3642">
                  <c:v>1821</c:v>
                </c:pt>
                <c:pt idx="3643">
                  <c:v>1821.5</c:v>
                </c:pt>
                <c:pt idx="3644">
                  <c:v>1822</c:v>
                </c:pt>
                <c:pt idx="3645">
                  <c:v>1822.5</c:v>
                </c:pt>
                <c:pt idx="3646">
                  <c:v>1823</c:v>
                </c:pt>
                <c:pt idx="3647">
                  <c:v>1823.5</c:v>
                </c:pt>
                <c:pt idx="3648">
                  <c:v>1824</c:v>
                </c:pt>
                <c:pt idx="3649">
                  <c:v>1824.5</c:v>
                </c:pt>
                <c:pt idx="3650">
                  <c:v>1825</c:v>
                </c:pt>
                <c:pt idx="3651">
                  <c:v>1825.5</c:v>
                </c:pt>
                <c:pt idx="3652">
                  <c:v>1826</c:v>
                </c:pt>
                <c:pt idx="3653">
                  <c:v>1826.5</c:v>
                </c:pt>
                <c:pt idx="3654">
                  <c:v>1827</c:v>
                </c:pt>
                <c:pt idx="3655">
                  <c:v>1827.5</c:v>
                </c:pt>
                <c:pt idx="3656">
                  <c:v>1828</c:v>
                </c:pt>
                <c:pt idx="3657">
                  <c:v>1828.5</c:v>
                </c:pt>
                <c:pt idx="3658">
                  <c:v>1829</c:v>
                </c:pt>
                <c:pt idx="3659">
                  <c:v>1829.5</c:v>
                </c:pt>
                <c:pt idx="3660">
                  <c:v>1830</c:v>
                </c:pt>
                <c:pt idx="3661">
                  <c:v>1830.5</c:v>
                </c:pt>
                <c:pt idx="3662">
                  <c:v>1831</c:v>
                </c:pt>
                <c:pt idx="3663">
                  <c:v>1831.5</c:v>
                </c:pt>
                <c:pt idx="3664">
                  <c:v>1832</c:v>
                </c:pt>
                <c:pt idx="3665">
                  <c:v>1832.5</c:v>
                </c:pt>
                <c:pt idx="3666">
                  <c:v>1833</c:v>
                </c:pt>
                <c:pt idx="3667">
                  <c:v>1833.5</c:v>
                </c:pt>
                <c:pt idx="3668">
                  <c:v>1834</c:v>
                </c:pt>
                <c:pt idx="3669">
                  <c:v>1834.5</c:v>
                </c:pt>
                <c:pt idx="3670">
                  <c:v>1835</c:v>
                </c:pt>
                <c:pt idx="3671">
                  <c:v>1835.5</c:v>
                </c:pt>
                <c:pt idx="3672">
                  <c:v>1836</c:v>
                </c:pt>
                <c:pt idx="3673">
                  <c:v>1836.5</c:v>
                </c:pt>
                <c:pt idx="3674">
                  <c:v>1837</c:v>
                </c:pt>
                <c:pt idx="3675">
                  <c:v>1837.5</c:v>
                </c:pt>
                <c:pt idx="3676">
                  <c:v>1838</c:v>
                </c:pt>
                <c:pt idx="3677">
                  <c:v>1838.5</c:v>
                </c:pt>
                <c:pt idx="3678">
                  <c:v>1839</c:v>
                </c:pt>
                <c:pt idx="3679">
                  <c:v>1839.5</c:v>
                </c:pt>
                <c:pt idx="3680">
                  <c:v>1840</c:v>
                </c:pt>
                <c:pt idx="3681">
                  <c:v>1840.5</c:v>
                </c:pt>
                <c:pt idx="3682">
                  <c:v>1841</c:v>
                </c:pt>
                <c:pt idx="3683">
                  <c:v>1841.5</c:v>
                </c:pt>
                <c:pt idx="3684">
                  <c:v>1842</c:v>
                </c:pt>
                <c:pt idx="3685">
                  <c:v>1842.5</c:v>
                </c:pt>
                <c:pt idx="3686">
                  <c:v>1843</c:v>
                </c:pt>
                <c:pt idx="3687">
                  <c:v>1843.5</c:v>
                </c:pt>
                <c:pt idx="3688">
                  <c:v>1844</c:v>
                </c:pt>
                <c:pt idx="3689">
                  <c:v>1844.5</c:v>
                </c:pt>
                <c:pt idx="3690">
                  <c:v>1845</c:v>
                </c:pt>
                <c:pt idx="3691">
                  <c:v>1845.5</c:v>
                </c:pt>
                <c:pt idx="3692">
                  <c:v>1846</c:v>
                </c:pt>
                <c:pt idx="3693">
                  <c:v>1846.5</c:v>
                </c:pt>
                <c:pt idx="3694">
                  <c:v>1847</c:v>
                </c:pt>
                <c:pt idx="3695">
                  <c:v>1847.5</c:v>
                </c:pt>
                <c:pt idx="3696">
                  <c:v>1848</c:v>
                </c:pt>
                <c:pt idx="3697">
                  <c:v>1848.5</c:v>
                </c:pt>
                <c:pt idx="3698">
                  <c:v>1849</c:v>
                </c:pt>
                <c:pt idx="3699">
                  <c:v>1849.5</c:v>
                </c:pt>
                <c:pt idx="3700">
                  <c:v>1850</c:v>
                </c:pt>
                <c:pt idx="3701">
                  <c:v>1850.5</c:v>
                </c:pt>
                <c:pt idx="3702">
                  <c:v>1851</c:v>
                </c:pt>
                <c:pt idx="3703">
                  <c:v>1851.5</c:v>
                </c:pt>
                <c:pt idx="3704">
                  <c:v>1852</c:v>
                </c:pt>
                <c:pt idx="3705">
                  <c:v>1852.5</c:v>
                </c:pt>
                <c:pt idx="3706">
                  <c:v>1853</c:v>
                </c:pt>
                <c:pt idx="3707">
                  <c:v>1853.5</c:v>
                </c:pt>
                <c:pt idx="3708">
                  <c:v>1854</c:v>
                </c:pt>
                <c:pt idx="3709">
                  <c:v>1854.5</c:v>
                </c:pt>
                <c:pt idx="3710">
                  <c:v>1855</c:v>
                </c:pt>
                <c:pt idx="3711">
                  <c:v>1855.5</c:v>
                </c:pt>
                <c:pt idx="3712">
                  <c:v>1856</c:v>
                </c:pt>
                <c:pt idx="3713">
                  <c:v>1856.5</c:v>
                </c:pt>
                <c:pt idx="3714">
                  <c:v>1857</c:v>
                </c:pt>
                <c:pt idx="3715">
                  <c:v>1857.5</c:v>
                </c:pt>
                <c:pt idx="3716">
                  <c:v>1858</c:v>
                </c:pt>
                <c:pt idx="3717">
                  <c:v>1858.5</c:v>
                </c:pt>
                <c:pt idx="3718">
                  <c:v>1859</c:v>
                </c:pt>
                <c:pt idx="3719">
                  <c:v>1859.5</c:v>
                </c:pt>
                <c:pt idx="3720">
                  <c:v>1860</c:v>
                </c:pt>
                <c:pt idx="3721">
                  <c:v>1860.5</c:v>
                </c:pt>
                <c:pt idx="3722">
                  <c:v>1861</c:v>
                </c:pt>
                <c:pt idx="3723">
                  <c:v>1861.5</c:v>
                </c:pt>
                <c:pt idx="3724">
                  <c:v>1862</c:v>
                </c:pt>
                <c:pt idx="3725">
                  <c:v>1862.5</c:v>
                </c:pt>
                <c:pt idx="3726">
                  <c:v>1863</c:v>
                </c:pt>
                <c:pt idx="3727">
                  <c:v>1863.5</c:v>
                </c:pt>
                <c:pt idx="3728">
                  <c:v>1864</c:v>
                </c:pt>
                <c:pt idx="3729">
                  <c:v>1864.5</c:v>
                </c:pt>
                <c:pt idx="3730">
                  <c:v>1865</c:v>
                </c:pt>
                <c:pt idx="3731">
                  <c:v>1865.5</c:v>
                </c:pt>
                <c:pt idx="3732">
                  <c:v>1866</c:v>
                </c:pt>
                <c:pt idx="3733">
                  <c:v>1866.5</c:v>
                </c:pt>
                <c:pt idx="3734">
                  <c:v>1867</c:v>
                </c:pt>
                <c:pt idx="3735">
                  <c:v>1867.5</c:v>
                </c:pt>
                <c:pt idx="3736">
                  <c:v>1868</c:v>
                </c:pt>
                <c:pt idx="3737">
                  <c:v>1868.5</c:v>
                </c:pt>
                <c:pt idx="3738">
                  <c:v>1869</c:v>
                </c:pt>
                <c:pt idx="3739">
                  <c:v>1869.5</c:v>
                </c:pt>
                <c:pt idx="3740">
                  <c:v>1870</c:v>
                </c:pt>
                <c:pt idx="3741">
                  <c:v>1870.5</c:v>
                </c:pt>
                <c:pt idx="3742">
                  <c:v>1871</c:v>
                </c:pt>
                <c:pt idx="3743">
                  <c:v>1871.5</c:v>
                </c:pt>
                <c:pt idx="3744">
                  <c:v>1872</c:v>
                </c:pt>
                <c:pt idx="3745">
                  <c:v>1872.5</c:v>
                </c:pt>
                <c:pt idx="3746">
                  <c:v>1873</c:v>
                </c:pt>
                <c:pt idx="3747">
                  <c:v>1873.5</c:v>
                </c:pt>
                <c:pt idx="3748">
                  <c:v>1874</c:v>
                </c:pt>
                <c:pt idx="3749">
                  <c:v>1874.5</c:v>
                </c:pt>
                <c:pt idx="3750">
                  <c:v>1875</c:v>
                </c:pt>
                <c:pt idx="3751">
                  <c:v>1875.5</c:v>
                </c:pt>
                <c:pt idx="3752">
                  <c:v>1876</c:v>
                </c:pt>
                <c:pt idx="3753">
                  <c:v>1876.5</c:v>
                </c:pt>
                <c:pt idx="3754">
                  <c:v>1877</c:v>
                </c:pt>
                <c:pt idx="3755">
                  <c:v>1877.5</c:v>
                </c:pt>
                <c:pt idx="3756">
                  <c:v>1878</c:v>
                </c:pt>
                <c:pt idx="3757">
                  <c:v>1878.5</c:v>
                </c:pt>
                <c:pt idx="3758">
                  <c:v>1879</c:v>
                </c:pt>
                <c:pt idx="3759">
                  <c:v>1879.5</c:v>
                </c:pt>
                <c:pt idx="3760">
                  <c:v>1880</c:v>
                </c:pt>
                <c:pt idx="3761">
                  <c:v>1880.5</c:v>
                </c:pt>
                <c:pt idx="3762">
                  <c:v>1881</c:v>
                </c:pt>
                <c:pt idx="3763">
                  <c:v>1881.5</c:v>
                </c:pt>
                <c:pt idx="3764">
                  <c:v>1882</c:v>
                </c:pt>
                <c:pt idx="3765">
                  <c:v>1882.5</c:v>
                </c:pt>
                <c:pt idx="3766">
                  <c:v>1883</c:v>
                </c:pt>
                <c:pt idx="3767">
                  <c:v>1883.5</c:v>
                </c:pt>
                <c:pt idx="3768">
                  <c:v>1884</c:v>
                </c:pt>
                <c:pt idx="3769">
                  <c:v>1884.5</c:v>
                </c:pt>
                <c:pt idx="3770">
                  <c:v>1885</c:v>
                </c:pt>
                <c:pt idx="3771">
                  <c:v>1885.5</c:v>
                </c:pt>
                <c:pt idx="3772">
                  <c:v>1886</c:v>
                </c:pt>
                <c:pt idx="3773">
                  <c:v>1886.5</c:v>
                </c:pt>
                <c:pt idx="3774">
                  <c:v>1887</c:v>
                </c:pt>
                <c:pt idx="3775">
                  <c:v>1887.5</c:v>
                </c:pt>
                <c:pt idx="3776">
                  <c:v>1888</c:v>
                </c:pt>
                <c:pt idx="3777">
                  <c:v>1888.5</c:v>
                </c:pt>
                <c:pt idx="3778">
                  <c:v>1889</c:v>
                </c:pt>
                <c:pt idx="3779">
                  <c:v>1889.5</c:v>
                </c:pt>
                <c:pt idx="3780">
                  <c:v>1890</c:v>
                </c:pt>
                <c:pt idx="3781">
                  <c:v>1890.5</c:v>
                </c:pt>
                <c:pt idx="3782">
                  <c:v>1891</c:v>
                </c:pt>
                <c:pt idx="3783">
                  <c:v>1891.5</c:v>
                </c:pt>
                <c:pt idx="3784">
                  <c:v>1892</c:v>
                </c:pt>
                <c:pt idx="3785">
                  <c:v>1892.5</c:v>
                </c:pt>
                <c:pt idx="3786">
                  <c:v>1893</c:v>
                </c:pt>
                <c:pt idx="3787">
                  <c:v>1893.5</c:v>
                </c:pt>
                <c:pt idx="3788">
                  <c:v>1894</c:v>
                </c:pt>
                <c:pt idx="3789">
                  <c:v>1894.5</c:v>
                </c:pt>
                <c:pt idx="3790">
                  <c:v>1895</c:v>
                </c:pt>
                <c:pt idx="3791">
                  <c:v>1895.5</c:v>
                </c:pt>
                <c:pt idx="3792">
                  <c:v>1896</c:v>
                </c:pt>
                <c:pt idx="3793">
                  <c:v>1896.5</c:v>
                </c:pt>
                <c:pt idx="3794">
                  <c:v>1897</c:v>
                </c:pt>
                <c:pt idx="3795">
                  <c:v>1897.5</c:v>
                </c:pt>
                <c:pt idx="3796">
                  <c:v>1898</c:v>
                </c:pt>
                <c:pt idx="3797">
                  <c:v>1898.5</c:v>
                </c:pt>
                <c:pt idx="3798">
                  <c:v>1899</c:v>
                </c:pt>
                <c:pt idx="3799">
                  <c:v>1899.5</c:v>
                </c:pt>
                <c:pt idx="3800">
                  <c:v>1900</c:v>
                </c:pt>
                <c:pt idx="3801">
                  <c:v>1900.5</c:v>
                </c:pt>
                <c:pt idx="3802">
                  <c:v>1901</c:v>
                </c:pt>
                <c:pt idx="3803">
                  <c:v>1901.5</c:v>
                </c:pt>
                <c:pt idx="3804">
                  <c:v>1902</c:v>
                </c:pt>
                <c:pt idx="3805">
                  <c:v>1902.5</c:v>
                </c:pt>
                <c:pt idx="3806">
                  <c:v>1903</c:v>
                </c:pt>
                <c:pt idx="3807">
                  <c:v>1903.5</c:v>
                </c:pt>
                <c:pt idx="3808">
                  <c:v>1904</c:v>
                </c:pt>
                <c:pt idx="3809">
                  <c:v>1904.5</c:v>
                </c:pt>
                <c:pt idx="3810">
                  <c:v>1905</c:v>
                </c:pt>
                <c:pt idx="3811">
                  <c:v>1905.5</c:v>
                </c:pt>
                <c:pt idx="3812">
                  <c:v>1906</c:v>
                </c:pt>
                <c:pt idx="3813">
                  <c:v>1906.5</c:v>
                </c:pt>
                <c:pt idx="3814">
                  <c:v>1907</c:v>
                </c:pt>
                <c:pt idx="3815">
                  <c:v>1907.5</c:v>
                </c:pt>
                <c:pt idx="3816">
                  <c:v>1908</c:v>
                </c:pt>
                <c:pt idx="3817">
                  <c:v>1908.5</c:v>
                </c:pt>
                <c:pt idx="3818">
                  <c:v>1909</c:v>
                </c:pt>
                <c:pt idx="3819">
                  <c:v>1909.5</c:v>
                </c:pt>
                <c:pt idx="3820">
                  <c:v>1910</c:v>
                </c:pt>
                <c:pt idx="3821">
                  <c:v>1910.5</c:v>
                </c:pt>
                <c:pt idx="3822">
                  <c:v>1911</c:v>
                </c:pt>
                <c:pt idx="3823">
                  <c:v>1911.5</c:v>
                </c:pt>
                <c:pt idx="3824">
                  <c:v>1912</c:v>
                </c:pt>
                <c:pt idx="3825">
                  <c:v>1912.5</c:v>
                </c:pt>
                <c:pt idx="3826">
                  <c:v>1913</c:v>
                </c:pt>
                <c:pt idx="3827">
                  <c:v>1913.5</c:v>
                </c:pt>
                <c:pt idx="3828">
                  <c:v>1914</c:v>
                </c:pt>
                <c:pt idx="3829">
                  <c:v>1914.5</c:v>
                </c:pt>
                <c:pt idx="3830">
                  <c:v>1915</c:v>
                </c:pt>
                <c:pt idx="3831">
                  <c:v>1915.5</c:v>
                </c:pt>
                <c:pt idx="3832">
                  <c:v>1916</c:v>
                </c:pt>
                <c:pt idx="3833">
                  <c:v>1916.5</c:v>
                </c:pt>
                <c:pt idx="3834">
                  <c:v>1917</c:v>
                </c:pt>
                <c:pt idx="3835">
                  <c:v>1917.5</c:v>
                </c:pt>
                <c:pt idx="3836">
                  <c:v>1918</c:v>
                </c:pt>
                <c:pt idx="3837">
                  <c:v>1918.5</c:v>
                </c:pt>
                <c:pt idx="3838">
                  <c:v>1919</c:v>
                </c:pt>
                <c:pt idx="3839">
                  <c:v>1919.5</c:v>
                </c:pt>
                <c:pt idx="3840">
                  <c:v>1920</c:v>
                </c:pt>
                <c:pt idx="3841">
                  <c:v>1920.5</c:v>
                </c:pt>
                <c:pt idx="3842">
                  <c:v>1921</c:v>
                </c:pt>
                <c:pt idx="3843">
                  <c:v>1921.5</c:v>
                </c:pt>
                <c:pt idx="3844">
                  <c:v>1922</c:v>
                </c:pt>
                <c:pt idx="3845">
                  <c:v>1922.5</c:v>
                </c:pt>
                <c:pt idx="3846">
                  <c:v>1923</c:v>
                </c:pt>
                <c:pt idx="3847">
                  <c:v>1923.5</c:v>
                </c:pt>
                <c:pt idx="3848">
                  <c:v>1924</c:v>
                </c:pt>
                <c:pt idx="3849">
                  <c:v>1924.5</c:v>
                </c:pt>
                <c:pt idx="3850">
                  <c:v>1925</c:v>
                </c:pt>
                <c:pt idx="3851">
                  <c:v>1925.5</c:v>
                </c:pt>
                <c:pt idx="3852">
                  <c:v>1926</c:v>
                </c:pt>
                <c:pt idx="3853">
                  <c:v>1926.5</c:v>
                </c:pt>
                <c:pt idx="3854">
                  <c:v>1927</c:v>
                </c:pt>
                <c:pt idx="3855">
                  <c:v>1927.5</c:v>
                </c:pt>
                <c:pt idx="3856">
                  <c:v>1928</c:v>
                </c:pt>
                <c:pt idx="3857">
                  <c:v>1928.5</c:v>
                </c:pt>
                <c:pt idx="3858">
                  <c:v>1929</c:v>
                </c:pt>
                <c:pt idx="3859">
                  <c:v>1929.5</c:v>
                </c:pt>
                <c:pt idx="3860">
                  <c:v>1930</c:v>
                </c:pt>
                <c:pt idx="3861">
                  <c:v>1930.5</c:v>
                </c:pt>
                <c:pt idx="3862">
                  <c:v>1931</c:v>
                </c:pt>
                <c:pt idx="3863">
                  <c:v>1931.5</c:v>
                </c:pt>
                <c:pt idx="3864">
                  <c:v>1932</c:v>
                </c:pt>
                <c:pt idx="3865">
                  <c:v>1932.5</c:v>
                </c:pt>
                <c:pt idx="3866">
                  <c:v>1933</c:v>
                </c:pt>
                <c:pt idx="3867">
                  <c:v>1933.5</c:v>
                </c:pt>
                <c:pt idx="3868">
                  <c:v>1934</c:v>
                </c:pt>
                <c:pt idx="3869">
                  <c:v>1934.5</c:v>
                </c:pt>
                <c:pt idx="3870">
                  <c:v>1935</c:v>
                </c:pt>
                <c:pt idx="3871">
                  <c:v>1935.5</c:v>
                </c:pt>
                <c:pt idx="3872">
                  <c:v>1936</c:v>
                </c:pt>
                <c:pt idx="3873">
                  <c:v>1936.5</c:v>
                </c:pt>
                <c:pt idx="3874">
                  <c:v>1937</c:v>
                </c:pt>
                <c:pt idx="3875">
                  <c:v>1937.5</c:v>
                </c:pt>
                <c:pt idx="3876">
                  <c:v>1938</c:v>
                </c:pt>
                <c:pt idx="3877">
                  <c:v>1938.5</c:v>
                </c:pt>
                <c:pt idx="3878">
                  <c:v>1939</c:v>
                </c:pt>
                <c:pt idx="3879">
                  <c:v>1939.5</c:v>
                </c:pt>
                <c:pt idx="3880">
                  <c:v>1940</c:v>
                </c:pt>
                <c:pt idx="3881">
                  <c:v>1940.5</c:v>
                </c:pt>
                <c:pt idx="3882">
                  <c:v>1941</c:v>
                </c:pt>
                <c:pt idx="3883">
                  <c:v>1941.5</c:v>
                </c:pt>
                <c:pt idx="3884">
                  <c:v>1942</c:v>
                </c:pt>
                <c:pt idx="3885">
                  <c:v>1942.5</c:v>
                </c:pt>
                <c:pt idx="3886">
                  <c:v>1943</c:v>
                </c:pt>
                <c:pt idx="3887">
                  <c:v>1943.5</c:v>
                </c:pt>
                <c:pt idx="3888">
                  <c:v>1944</c:v>
                </c:pt>
                <c:pt idx="3889">
                  <c:v>1944.5</c:v>
                </c:pt>
                <c:pt idx="3890">
                  <c:v>1945</c:v>
                </c:pt>
                <c:pt idx="3891">
                  <c:v>1945.5</c:v>
                </c:pt>
                <c:pt idx="3892">
                  <c:v>1946</c:v>
                </c:pt>
                <c:pt idx="3893">
                  <c:v>1946.5</c:v>
                </c:pt>
                <c:pt idx="3894">
                  <c:v>1947</c:v>
                </c:pt>
                <c:pt idx="3895">
                  <c:v>1947.5</c:v>
                </c:pt>
                <c:pt idx="3896">
                  <c:v>1948</c:v>
                </c:pt>
                <c:pt idx="3897">
                  <c:v>1948.5</c:v>
                </c:pt>
                <c:pt idx="3898">
                  <c:v>1949</c:v>
                </c:pt>
                <c:pt idx="3899">
                  <c:v>1949.5</c:v>
                </c:pt>
                <c:pt idx="3900">
                  <c:v>1950</c:v>
                </c:pt>
                <c:pt idx="3901">
                  <c:v>1950.5</c:v>
                </c:pt>
                <c:pt idx="3902">
                  <c:v>1951</c:v>
                </c:pt>
                <c:pt idx="3903">
                  <c:v>1951.5</c:v>
                </c:pt>
                <c:pt idx="3904">
                  <c:v>1952</c:v>
                </c:pt>
                <c:pt idx="3905">
                  <c:v>1952.5</c:v>
                </c:pt>
                <c:pt idx="3906">
                  <c:v>1953</c:v>
                </c:pt>
                <c:pt idx="3907">
                  <c:v>1953.5</c:v>
                </c:pt>
                <c:pt idx="3908">
                  <c:v>1954</c:v>
                </c:pt>
                <c:pt idx="3909">
                  <c:v>1954.5</c:v>
                </c:pt>
                <c:pt idx="3910">
                  <c:v>1955</c:v>
                </c:pt>
                <c:pt idx="3911">
                  <c:v>1955.5</c:v>
                </c:pt>
                <c:pt idx="3912">
                  <c:v>1956</c:v>
                </c:pt>
                <c:pt idx="3913">
                  <c:v>1956.5</c:v>
                </c:pt>
                <c:pt idx="3914">
                  <c:v>1957</c:v>
                </c:pt>
                <c:pt idx="3915">
                  <c:v>1957.5</c:v>
                </c:pt>
                <c:pt idx="3916">
                  <c:v>1958</c:v>
                </c:pt>
                <c:pt idx="3917">
                  <c:v>1958.5</c:v>
                </c:pt>
                <c:pt idx="3918">
                  <c:v>1959</c:v>
                </c:pt>
                <c:pt idx="3919">
                  <c:v>1959.5</c:v>
                </c:pt>
                <c:pt idx="3920">
                  <c:v>1960</c:v>
                </c:pt>
                <c:pt idx="3921">
                  <c:v>1960.5</c:v>
                </c:pt>
                <c:pt idx="3922">
                  <c:v>1961</c:v>
                </c:pt>
                <c:pt idx="3923">
                  <c:v>1961.5</c:v>
                </c:pt>
                <c:pt idx="3924">
                  <c:v>1962</c:v>
                </c:pt>
                <c:pt idx="3925">
                  <c:v>1962.5</c:v>
                </c:pt>
                <c:pt idx="3926">
                  <c:v>1963</c:v>
                </c:pt>
                <c:pt idx="3927">
                  <c:v>1963.5</c:v>
                </c:pt>
                <c:pt idx="3928">
                  <c:v>1964</c:v>
                </c:pt>
                <c:pt idx="3929">
                  <c:v>1964.5</c:v>
                </c:pt>
                <c:pt idx="3930">
                  <c:v>1965</c:v>
                </c:pt>
                <c:pt idx="3931">
                  <c:v>1965.5</c:v>
                </c:pt>
                <c:pt idx="3932">
                  <c:v>1966</c:v>
                </c:pt>
                <c:pt idx="3933">
                  <c:v>1966.5</c:v>
                </c:pt>
                <c:pt idx="3934">
                  <c:v>1967</c:v>
                </c:pt>
                <c:pt idx="3935">
                  <c:v>1967.5</c:v>
                </c:pt>
                <c:pt idx="3936">
                  <c:v>1968</c:v>
                </c:pt>
                <c:pt idx="3937">
                  <c:v>1968.5</c:v>
                </c:pt>
                <c:pt idx="3938">
                  <c:v>1969</c:v>
                </c:pt>
                <c:pt idx="3939">
                  <c:v>1969.5</c:v>
                </c:pt>
                <c:pt idx="3940">
                  <c:v>1970</c:v>
                </c:pt>
                <c:pt idx="3941">
                  <c:v>1970.5</c:v>
                </c:pt>
                <c:pt idx="3942">
                  <c:v>1971</c:v>
                </c:pt>
                <c:pt idx="3943">
                  <c:v>1971.5</c:v>
                </c:pt>
                <c:pt idx="3944">
                  <c:v>1972</c:v>
                </c:pt>
                <c:pt idx="3945">
                  <c:v>1972.5</c:v>
                </c:pt>
                <c:pt idx="3946">
                  <c:v>1973</c:v>
                </c:pt>
                <c:pt idx="3947">
                  <c:v>1973.5</c:v>
                </c:pt>
                <c:pt idx="3948">
                  <c:v>1974</c:v>
                </c:pt>
                <c:pt idx="3949">
                  <c:v>1974.5</c:v>
                </c:pt>
                <c:pt idx="3950">
                  <c:v>1975</c:v>
                </c:pt>
                <c:pt idx="3951">
                  <c:v>1975.5</c:v>
                </c:pt>
                <c:pt idx="3952">
                  <c:v>1976</c:v>
                </c:pt>
                <c:pt idx="3953">
                  <c:v>1976.5</c:v>
                </c:pt>
                <c:pt idx="3954">
                  <c:v>1977</c:v>
                </c:pt>
                <c:pt idx="3955">
                  <c:v>1977.5</c:v>
                </c:pt>
                <c:pt idx="3956">
                  <c:v>1978</c:v>
                </c:pt>
                <c:pt idx="3957">
                  <c:v>1978.5</c:v>
                </c:pt>
                <c:pt idx="3958">
                  <c:v>1979</c:v>
                </c:pt>
                <c:pt idx="3959">
                  <c:v>1979.5</c:v>
                </c:pt>
                <c:pt idx="3960">
                  <c:v>1980</c:v>
                </c:pt>
                <c:pt idx="3961">
                  <c:v>1980.5</c:v>
                </c:pt>
                <c:pt idx="3962">
                  <c:v>1981</c:v>
                </c:pt>
                <c:pt idx="3963">
                  <c:v>1981.5</c:v>
                </c:pt>
                <c:pt idx="3964">
                  <c:v>1982</c:v>
                </c:pt>
                <c:pt idx="3965">
                  <c:v>1982.5</c:v>
                </c:pt>
                <c:pt idx="3966">
                  <c:v>1983</c:v>
                </c:pt>
                <c:pt idx="3967">
                  <c:v>1983.5</c:v>
                </c:pt>
                <c:pt idx="3968">
                  <c:v>1984</c:v>
                </c:pt>
                <c:pt idx="3969">
                  <c:v>1984.5</c:v>
                </c:pt>
                <c:pt idx="3970">
                  <c:v>1985</c:v>
                </c:pt>
                <c:pt idx="3971">
                  <c:v>1985.5</c:v>
                </c:pt>
                <c:pt idx="3972">
                  <c:v>1986</c:v>
                </c:pt>
                <c:pt idx="3973">
                  <c:v>1986.5</c:v>
                </c:pt>
                <c:pt idx="3974">
                  <c:v>1987</c:v>
                </c:pt>
                <c:pt idx="3975">
                  <c:v>1987.5</c:v>
                </c:pt>
                <c:pt idx="3976">
                  <c:v>1988</c:v>
                </c:pt>
                <c:pt idx="3977">
                  <c:v>1988.5</c:v>
                </c:pt>
                <c:pt idx="3978">
                  <c:v>1989</c:v>
                </c:pt>
                <c:pt idx="3979">
                  <c:v>1989.5</c:v>
                </c:pt>
                <c:pt idx="3980">
                  <c:v>1990</c:v>
                </c:pt>
                <c:pt idx="3981">
                  <c:v>1990.5</c:v>
                </c:pt>
                <c:pt idx="3982">
                  <c:v>1991</c:v>
                </c:pt>
                <c:pt idx="3983">
                  <c:v>1991.5</c:v>
                </c:pt>
                <c:pt idx="3984">
                  <c:v>1992</c:v>
                </c:pt>
                <c:pt idx="3985">
                  <c:v>1992.5</c:v>
                </c:pt>
                <c:pt idx="3986">
                  <c:v>1993</c:v>
                </c:pt>
                <c:pt idx="3987">
                  <c:v>1993.5</c:v>
                </c:pt>
                <c:pt idx="3988">
                  <c:v>1994</c:v>
                </c:pt>
                <c:pt idx="3989">
                  <c:v>1994.5</c:v>
                </c:pt>
                <c:pt idx="3990">
                  <c:v>1995</c:v>
                </c:pt>
                <c:pt idx="3991">
                  <c:v>1995.5</c:v>
                </c:pt>
                <c:pt idx="3992">
                  <c:v>1996</c:v>
                </c:pt>
                <c:pt idx="3993">
                  <c:v>1996.5</c:v>
                </c:pt>
                <c:pt idx="3994">
                  <c:v>1997</c:v>
                </c:pt>
                <c:pt idx="3995">
                  <c:v>1997.5</c:v>
                </c:pt>
                <c:pt idx="3996">
                  <c:v>1998</c:v>
                </c:pt>
                <c:pt idx="3997">
                  <c:v>1998.5</c:v>
                </c:pt>
                <c:pt idx="3998">
                  <c:v>1999</c:v>
                </c:pt>
                <c:pt idx="3999">
                  <c:v>1999.5</c:v>
                </c:pt>
                <c:pt idx="4000">
                  <c:v>2000</c:v>
                </c:pt>
                <c:pt idx="4001">
                  <c:v>2000.5</c:v>
                </c:pt>
                <c:pt idx="4002">
                  <c:v>2001</c:v>
                </c:pt>
                <c:pt idx="4003">
                  <c:v>2001.5</c:v>
                </c:pt>
                <c:pt idx="4004">
                  <c:v>2002</c:v>
                </c:pt>
                <c:pt idx="4005">
                  <c:v>2002.5</c:v>
                </c:pt>
                <c:pt idx="4006">
                  <c:v>2003</c:v>
                </c:pt>
                <c:pt idx="4007">
                  <c:v>2003.5</c:v>
                </c:pt>
                <c:pt idx="4008">
                  <c:v>2004</c:v>
                </c:pt>
                <c:pt idx="4009">
                  <c:v>2004.5</c:v>
                </c:pt>
                <c:pt idx="4010">
                  <c:v>2005</c:v>
                </c:pt>
                <c:pt idx="4011">
                  <c:v>2005.5</c:v>
                </c:pt>
                <c:pt idx="4012">
                  <c:v>2006</c:v>
                </c:pt>
                <c:pt idx="4013">
                  <c:v>2006.5</c:v>
                </c:pt>
                <c:pt idx="4014">
                  <c:v>2007</c:v>
                </c:pt>
              </c:numCache>
            </c:numRef>
          </c:xVal>
          <c:yVal>
            <c:numRef>
              <c:f>'Sheet1 SKF'!$AO$46:$AO$4060</c:f>
              <c:numCache>
                <c:formatCode>General</c:formatCode>
                <c:ptCount val="4015"/>
                <c:pt idx="0">
                  <c:v>1</c:v>
                </c:pt>
                <c:pt idx="1">
                  <c:v>1.0121888825352876</c:v>
                </c:pt>
                <c:pt idx="2">
                  <c:v>1.0154994432238842</c:v>
                </c:pt>
                <c:pt idx="3">
                  <c:v>1.0006320161314592</c:v>
                </c:pt>
                <c:pt idx="4">
                  <c:v>0.98639660517049388</c:v>
                </c:pt>
                <c:pt idx="5">
                  <c:v>1.0087278418153911</c:v>
                </c:pt>
                <c:pt idx="6">
                  <c:v>1.013633490835766</c:v>
                </c:pt>
                <c:pt idx="7">
                  <c:v>1.0149878111174646</c:v>
                </c:pt>
                <c:pt idx="8">
                  <c:v>1.0068618894272729</c:v>
                </c:pt>
                <c:pt idx="9">
                  <c:v>1.0057483371956542</c:v>
                </c:pt>
                <c:pt idx="10">
                  <c:v>1.0080356336714118</c:v>
                </c:pt>
                <c:pt idx="11">
                  <c:v>1.0133325307731664</c:v>
                </c:pt>
                <c:pt idx="12">
                  <c:v>1.004785264995335</c:v>
                </c:pt>
                <c:pt idx="13">
                  <c:v>1.0144460830047852</c:v>
                </c:pt>
                <c:pt idx="14">
                  <c:v>1.0025882565383573</c:v>
                </c:pt>
                <c:pt idx="15">
                  <c:v>1.0080356336714118</c:v>
                </c:pt>
                <c:pt idx="16">
                  <c:v>1.002979504619737</c:v>
                </c:pt>
                <c:pt idx="17">
                  <c:v>1.0117976344539079</c:v>
                </c:pt>
                <c:pt idx="18">
                  <c:v>1.0093899539531104</c:v>
                </c:pt>
                <c:pt idx="19">
                  <c:v>1.0041231528576158</c:v>
                </c:pt>
                <c:pt idx="20">
                  <c:v>1.0014747043067385</c:v>
                </c:pt>
                <c:pt idx="21">
                  <c:v>1.0200138441628797</c:v>
                </c:pt>
                <c:pt idx="22">
                  <c:v>1.0103831221596895</c:v>
                </c:pt>
                <c:pt idx="23">
                  <c:v>1.0067114093959733</c:v>
                </c:pt>
                <c:pt idx="24">
                  <c:v>1.0054473771330545</c:v>
                </c:pt>
                <c:pt idx="25">
                  <c:v>0.99656905528636353</c:v>
                </c:pt>
                <c:pt idx="26">
                  <c:v>1.0052367050892346</c:v>
                </c:pt>
                <c:pt idx="27">
                  <c:v>1.0092695699280705</c:v>
                </c:pt>
                <c:pt idx="28">
                  <c:v>1.0046648809702952</c:v>
                </c:pt>
                <c:pt idx="29">
                  <c:v>1.0041833448701358</c:v>
                </c:pt>
                <c:pt idx="30">
                  <c:v>0.99064014205314954</c:v>
                </c:pt>
                <c:pt idx="31">
                  <c:v>0.98612574111415419</c:v>
                </c:pt>
                <c:pt idx="32">
                  <c:v>1.020525476269299</c:v>
                </c:pt>
                <c:pt idx="33">
                  <c:v>1.0016251843380384</c:v>
                </c:pt>
                <c:pt idx="34">
                  <c:v>1.0055677611580944</c:v>
                </c:pt>
                <c:pt idx="35">
                  <c:v>1.0112860023474886</c:v>
                </c:pt>
                <c:pt idx="36">
                  <c:v>0.99819423962440179</c:v>
                </c:pt>
                <c:pt idx="37">
                  <c:v>1.006019201251994</c:v>
                </c:pt>
                <c:pt idx="38">
                  <c:v>0.99614771119872392</c:v>
                </c:pt>
                <c:pt idx="39">
                  <c:v>0.98868390164625153</c:v>
                </c:pt>
                <c:pt idx="40">
                  <c:v>1.0111957143287085</c:v>
                </c:pt>
                <c:pt idx="41">
                  <c:v>0.98832274957113186</c:v>
                </c:pt>
                <c:pt idx="42">
                  <c:v>1.0120684985102477</c:v>
                </c:pt>
                <c:pt idx="43">
                  <c:v>1.0154392512113644</c:v>
                </c:pt>
                <c:pt idx="44">
                  <c:v>1.012700514641707</c:v>
                </c:pt>
                <c:pt idx="45">
                  <c:v>1.0218797965509976</c:v>
                </c:pt>
                <c:pt idx="46">
                  <c:v>1.0076744815962921</c:v>
                </c:pt>
                <c:pt idx="47">
                  <c:v>1.0212176844132783</c:v>
                </c:pt>
                <c:pt idx="48">
                  <c:v>1.0055677611580944</c:v>
                </c:pt>
                <c:pt idx="49">
                  <c:v>0.99795347157432213</c:v>
                </c:pt>
                <c:pt idx="50">
                  <c:v>1.0070123694585729</c:v>
                </c:pt>
                <c:pt idx="51">
                  <c:v>1.0025581605320975</c:v>
                </c:pt>
                <c:pt idx="52">
                  <c:v>1.0046949769765552</c:v>
                </c:pt>
                <c:pt idx="53">
                  <c:v>1.0150780991362447</c:v>
                </c:pt>
                <c:pt idx="54">
                  <c:v>1.0079152496463719</c:v>
                </c:pt>
                <c:pt idx="55">
                  <c:v>1.0066211213771932</c:v>
                </c:pt>
                <c:pt idx="56">
                  <c:v>1.0142655069672255</c:v>
                </c:pt>
                <c:pt idx="57">
                  <c:v>1.0109850422848887</c:v>
                </c:pt>
                <c:pt idx="58">
                  <c:v>1.0170945315556625</c:v>
                </c:pt>
                <c:pt idx="59">
                  <c:v>1.0087579378216511</c:v>
                </c:pt>
                <c:pt idx="60">
                  <c:v>0.99187407830980834</c:v>
                </c:pt>
                <c:pt idx="61">
                  <c:v>0.99819423962440179</c:v>
                </c:pt>
                <c:pt idx="62">
                  <c:v>1.0095404339844103</c:v>
                </c:pt>
                <c:pt idx="63">
                  <c:v>1.0099316820657898</c:v>
                </c:pt>
                <c:pt idx="64">
                  <c:v>0.99599723116742411</c:v>
                </c:pt>
                <c:pt idx="65">
                  <c:v>1.0028892166009571</c:v>
                </c:pt>
                <c:pt idx="66">
                  <c:v>1.0145664670298251</c:v>
                </c:pt>
                <c:pt idx="67">
                  <c:v>1.0086375537966112</c:v>
                </c:pt>
                <c:pt idx="68">
                  <c:v>1.0148072350799049</c:v>
                </c:pt>
                <c:pt idx="69">
                  <c:v>1.0159809793240437</c:v>
                </c:pt>
                <c:pt idx="70">
                  <c:v>1.0080055376651518</c:v>
                </c:pt>
                <c:pt idx="71">
                  <c:v>1.0049056490203749</c:v>
                </c:pt>
                <c:pt idx="72">
                  <c:v>1.0175760676558221</c:v>
                </c:pt>
                <c:pt idx="73">
                  <c:v>1.0045144009389955</c:v>
                </c:pt>
                <c:pt idx="74">
                  <c:v>1.0080055376651518</c:v>
                </c:pt>
                <c:pt idx="75">
                  <c:v>1.0014747043067385</c:v>
                </c:pt>
                <c:pt idx="76">
                  <c:v>1.0022572004694976</c:v>
                </c:pt>
                <c:pt idx="77">
                  <c:v>0.98389863665091637</c:v>
                </c:pt>
                <c:pt idx="78">
                  <c:v>1.0081560176964517</c:v>
                </c:pt>
                <c:pt idx="79">
                  <c:v>0.99810395160562193</c:v>
                </c:pt>
                <c:pt idx="80">
                  <c:v>1.0128810906792669</c:v>
                </c:pt>
                <c:pt idx="81">
                  <c:v>0.99497396695458518</c:v>
                </c:pt>
                <c:pt idx="82">
                  <c:v>0.99885635176212118</c:v>
                </c:pt>
                <c:pt idx="83">
                  <c:v>0.99831462364944168</c:v>
                </c:pt>
                <c:pt idx="84">
                  <c:v>1.0012941282691787</c:v>
                </c:pt>
                <c:pt idx="85">
                  <c:v>1.0148975230986848</c:v>
                </c:pt>
                <c:pt idx="86">
                  <c:v>1.0149276191049448</c:v>
                </c:pt>
                <c:pt idx="87">
                  <c:v>1.0087880338279109</c:v>
                </c:pt>
                <c:pt idx="88">
                  <c:v>1.0123393625665875</c:v>
                </c:pt>
                <c:pt idx="89">
                  <c:v>1.0045745929515153</c:v>
                </c:pt>
                <c:pt idx="90">
                  <c:v>0.9987660637433412</c:v>
                </c:pt>
                <c:pt idx="91">
                  <c:v>1.0162819393866434</c:v>
                </c:pt>
                <c:pt idx="92">
                  <c:v>1.0195022120564601</c:v>
                </c:pt>
                <c:pt idx="93">
                  <c:v>1.0089385138592109</c:v>
                </c:pt>
                <c:pt idx="94">
                  <c:v>1.0221205646010774</c:v>
                </c:pt>
                <c:pt idx="95">
                  <c:v>1.0222710446323773</c:v>
                </c:pt>
                <c:pt idx="96">
                  <c:v>0.99476329491076532</c:v>
                </c:pt>
                <c:pt idx="97">
                  <c:v>1.0176362596683419</c:v>
                </c:pt>
                <c:pt idx="98">
                  <c:v>1.0172751075932225</c:v>
                </c:pt>
                <c:pt idx="99">
                  <c:v>0.99079062208444935</c:v>
                </c:pt>
                <c:pt idx="100">
                  <c:v>1.0128810906792669</c:v>
                </c:pt>
                <c:pt idx="101">
                  <c:v>1.0055376651518344</c:v>
                </c:pt>
                <c:pt idx="102">
                  <c:v>1.0027989285821772</c:v>
                </c:pt>
                <c:pt idx="103">
                  <c:v>1.0230234447888764</c:v>
                </c:pt>
                <c:pt idx="104">
                  <c:v>1.0330153188671862</c:v>
                </c:pt>
                <c:pt idx="105">
                  <c:v>0.99352935865410663</c:v>
                </c:pt>
                <c:pt idx="106">
                  <c:v>1.0132422427543866</c:v>
                </c:pt>
                <c:pt idx="107">
                  <c:v>1.0248292051644747</c:v>
                </c:pt>
                <c:pt idx="108">
                  <c:v>1.001986336413158</c:v>
                </c:pt>
                <c:pt idx="109">
                  <c:v>0.99819423962440179</c:v>
                </c:pt>
                <c:pt idx="110">
                  <c:v>0.9934992626478466</c:v>
                </c:pt>
                <c:pt idx="111">
                  <c:v>1.0061094892707738</c:v>
                </c:pt>
                <c:pt idx="112">
                  <c:v>1.0130315707105666</c:v>
                </c:pt>
                <c:pt idx="113">
                  <c:v>1.0223914286574172</c:v>
                </c:pt>
                <c:pt idx="114">
                  <c:v>1.0085472657778314</c:v>
                </c:pt>
                <c:pt idx="115">
                  <c:v>0.99343907063532666</c:v>
                </c:pt>
                <c:pt idx="116">
                  <c:v>0.99753212748668252</c:v>
                </c:pt>
                <c:pt idx="117">
                  <c:v>1.0151081951425045</c:v>
                </c:pt>
                <c:pt idx="118">
                  <c:v>1.002829024588437</c:v>
                </c:pt>
                <c:pt idx="119">
                  <c:v>1.0080055376651518</c:v>
                </c:pt>
                <c:pt idx="120">
                  <c:v>1.0087278418153911</c:v>
                </c:pt>
                <c:pt idx="121">
                  <c:v>1.0089084178529508</c:v>
                </c:pt>
                <c:pt idx="122">
                  <c:v>0.99340897462906674</c:v>
                </c:pt>
                <c:pt idx="123">
                  <c:v>0.99355945466036655</c:v>
                </c:pt>
                <c:pt idx="124">
                  <c:v>0.99145273422216873</c:v>
                </c:pt>
                <c:pt idx="125">
                  <c:v>1.0161314593553434</c:v>
                </c:pt>
                <c:pt idx="126">
                  <c:v>0.98940620579649086</c:v>
                </c:pt>
                <c:pt idx="127">
                  <c:v>0.992114846359888</c:v>
                </c:pt>
                <c:pt idx="128">
                  <c:v>0.99650886327384358</c:v>
                </c:pt>
                <c:pt idx="129">
                  <c:v>0.99121196617208895</c:v>
                </c:pt>
                <c:pt idx="130">
                  <c:v>0.99199446233484811</c:v>
                </c:pt>
                <c:pt idx="131">
                  <c:v>1.0029193126072171</c:v>
                </c:pt>
                <c:pt idx="132">
                  <c:v>1.0017455683630783</c:v>
                </c:pt>
                <c:pt idx="133">
                  <c:v>0.99386041472296627</c:v>
                </c:pt>
                <c:pt idx="134">
                  <c:v>1.006922081439793</c:v>
                </c:pt>
                <c:pt idx="135">
                  <c:v>1.0201041321816595</c:v>
                </c:pt>
                <c:pt idx="136">
                  <c:v>0.99894663978090104</c:v>
                </c:pt>
                <c:pt idx="137">
                  <c:v>1.0062599693020735</c:v>
                </c:pt>
                <c:pt idx="138">
                  <c:v>1.0027989285821772</c:v>
                </c:pt>
                <c:pt idx="139">
                  <c:v>0.99042947000932979</c:v>
                </c:pt>
                <c:pt idx="140">
                  <c:v>0.99082071809070937</c:v>
                </c:pt>
                <c:pt idx="141">
                  <c:v>1.0040930568513557</c:v>
                </c:pt>
                <c:pt idx="142">
                  <c:v>0.98468113281367564</c:v>
                </c:pt>
                <c:pt idx="143">
                  <c:v>0.99136244620338876</c:v>
                </c:pt>
                <c:pt idx="144">
                  <c:v>1.002829024588437</c:v>
                </c:pt>
                <c:pt idx="145">
                  <c:v>0.98817226953983206</c:v>
                </c:pt>
                <c:pt idx="146">
                  <c:v>1.0017455683630783</c:v>
                </c:pt>
                <c:pt idx="147">
                  <c:v>1.0075240015649922</c:v>
                </c:pt>
                <c:pt idx="148">
                  <c:v>1.0004815361001596</c:v>
                </c:pt>
                <c:pt idx="149">
                  <c:v>1.0009931682065789</c:v>
                </c:pt>
                <c:pt idx="150">
                  <c:v>1.0128208986667468</c:v>
                </c:pt>
                <c:pt idx="151">
                  <c:v>1.0130014747043068</c:v>
                </c:pt>
                <c:pt idx="152">
                  <c:v>0.99780299154302221</c:v>
                </c:pt>
                <c:pt idx="153">
                  <c:v>0.99828452764318176</c:v>
                </c:pt>
                <c:pt idx="154">
                  <c:v>1.0063803533271134</c:v>
                </c:pt>
                <c:pt idx="155">
                  <c:v>1.0110452342974088</c:v>
                </c:pt>
                <c:pt idx="156">
                  <c:v>0.99696030336774311</c:v>
                </c:pt>
                <c:pt idx="157">
                  <c:v>0.99485358292954529</c:v>
                </c:pt>
                <c:pt idx="158">
                  <c:v>1.0022271044632378</c:v>
                </c:pt>
                <c:pt idx="159">
                  <c:v>1.014686851054865</c:v>
                </c:pt>
                <c:pt idx="160">
                  <c:v>1.005868721220694</c:v>
                </c:pt>
                <c:pt idx="161">
                  <c:v>1.0134529147982063</c:v>
                </c:pt>
                <c:pt idx="162">
                  <c:v>0.99873596773708129</c:v>
                </c:pt>
                <c:pt idx="163">
                  <c:v>1.0011135522316188</c:v>
                </c:pt>
                <c:pt idx="164">
                  <c:v>0.98660727721431363</c:v>
                </c:pt>
                <c:pt idx="165">
                  <c:v>1.0203449002317393</c:v>
                </c:pt>
                <c:pt idx="166">
                  <c:v>1.0071327534836128</c:v>
                </c:pt>
                <c:pt idx="167">
                  <c:v>1.0072531375086526</c:v>
                </c:pt>
                <c:pt idx="168">
                  <c:v>1.0093297619405905</c:v>
                </c:pt>
                <c:pt idx="169">
                  <c:v>0.9866975652330936</c:v>
                </c:pt>
                <c:pt idx="170">
                  <c:v>0.99533511902970473</c:v>
                </c:pt>
                <c:pt idx="171">
                  <c:v>1.0168838595118428</c:v>
                </c:pt>
                <c:pt idx="172">
                  <c:v>1.0061395852770338</c:v>
                </c:pt>
                <c:pt idx="173">
                  <c:v>1.0063201613145936</c:v>
                </c:pt>
                <c:pt idx="174">
                  <c:v>1.0092695699280705</c:v>
                </c:pt>
                <c:pt idx="175">
                  <c:v>0.98678785325187346</c:v>
                </c:pt>
                <c:pt idx="176">
                  <c:v>0.99545550305474462</c:v>
                </c:pt>
                <c:pt idx="177">
                  <c:v>0.99933788786228073</c:v>
                </c:pt>
                <c:pt idx="178">
                  <c:v>0.98447046076985589</c:v>
                </c:pt>
                <c:pt idx="179">
                  <c:v>1.0106539862160291</c:v>
                </c:pt>
                <c:pt idx="180">
                  <c:v>0.98760044542089265</c:v>
                </c:pt>
                <c:pt idx="181">
                  <c:v>1.0023775844945375</c:v>
                </c:pt>
                <c:pt idx="182">
                  <c:v>1.0052668010954946</c:v>
                </c:pt>
                <c:pt idx="183">
                  <c:v>0.99091100610948923</c:v>
                </c:pt>
                <c:pt idx="184">
                  <c:v>1.0173653956120023</c:v>
                </c:pt>
                <c:pt idx="185">
                  <c:v>1.0003310560688596</c:v>
                </c:pt>
                <c:pt idx="186">
                  <c:v>0.99079062208444935</c:v>
                </c:pt>
                <c:pt idx="187">
                  <c:v>0.99461281487946551</c:v>
                </c:pt>
                <c:pt idx="188">
                  <c:v>0.9880819815210522</c:v>
                </c:pt>
                <c:pt idx="189">
                  <c:v>0.99879615974960123</c:v>
                </c:pt>
                <c:pt idx="190">
                  <c:v>0.99148283022842865</c:v>
                </c:pt>
                <c:pt idx="191">
                  <c:v>0.99467300689198546</c:v>
                </c:pt>
                <c:pt idx="192">
                  <c:v>1.0075540975712522</c:v>
                </c:pt>
                <c:pt idx="193">
                  <c:v>0.99434195082312582</c:v>
                </c:pt>
                <c:pt idx="194">
                  <c:v>0.98886447768381136</c:v>
                </c:pt>
                <c:pt idx="195">
                  <c:v>0.99837481566196162</c:v>
                </c:pt>
                <c:pt idx="196">
                  <c:v>0.99569627110482439</c:v>
                </c:pt>
                <c:pt idx="197">
                  <c:v>0.98922562975893102</c:v>
                </c:pt>
                <c:pt idx="198">
                  <c:v>0.99094110211574926</c:v>
                </c:pt>
                <c:pt idx="199">
                  <c:v>0.98612574111415419</c:v>
                </c:pt>
                <c:pt idx="200">
                  <c:v>1.0003912480813797</c:v>
                </c:pt>
                <c:pt idx="201">
                  <c:v>0.98356758058205673</c:v>
                </c:pt>
                <c:pt idx="202">
                  <c:v>0.97532127486682518</c:v>
                </c:pt>
                <c:pt idx="203">
                  <c:v>0.97044572185271016</c:v>
                </c:pt>
                <c:pt idx="204">
                  <c:v>0.98660727721431363</c:v>
                </c:pt>
                <c:pt idx="205">
                  <c:v>0.98314623649441724</c:v>
                </c:pt>
                <c:pt idx="206">
                  <c:v>0.98025701989346015</c:v>
                </c:pt>
                <c:pt idx="207">
                  <c:v>0.97574261895446479</c:v>
                </c:pt>
                <c:pt idx="208">
                  <c:v>1</c:v>
                </c:pt>
                <c:pt idx="209">
                  <c:v>0.98070845998735967</c:v>
                </c:pt>
                <c:pt idx="210">
                  <c:v>0.99831462364944168</c:v>
                </c:pt>
                <c:pt idx="211">
                  <c:v>0.99154302224094859</c:v>
                </c:pt>
                <c:pt idx="212">
                  <c:v>0.99891654377464112</c:v>
                </c:pt>
                <c:pt idx="213">
                  <c:v>0.99726126343034283</c:v>
                </c:pt>
                <c:pt idx="214">
                  <c:v>1.0133024347669064</c:v>
                </c:pt>
                <c:pt idx="215">
                  <c:v>1.0030998886447768</c:v>
                </c:pt>
                <c:pt idx="216">
                  <c:v>0.97432810666024616</c:v>
                </c:pt>
                <c:pt idx="217">
                  <c:v>0.98862370963373158</c:v>
                </c:pt>
                <c:pt idx="218">
                  <c:v>0.98925572576519094</c:v>
                </c:pt>
                <c:pt idx="219">
                  <c:v>0.98561410900773472</c:v>
                </c:pt>
                <c:pt idx="220">
                  <c:v>0.97104764197790949</c:v>
                </c:pt>
                <c:pt idx="221">
                  <c:v>0.99780299154302221</c:v>
                </c:pt>
                <c:pt idx="222">
                  <c:v>0.99500406296084509</c:v>
                </c:pt>
                <c:pt idx="223">
                  <c:v>0.99795347157432213</c:v>
                </c:pt>
                <c:pt idx="224">
                  <c:v>1.0034911367261565</c:v>
                </c:pt>
                <c:pt idx="225">
                  <c:v>0.99497396695458518</c:v>
                </c:pt>
                <c:pt idx="226">
                  <c:v>0.98368796460709662</c:v>
                </c:pt>
                <c:pt idx="227">
                  <c:v>0.99828452764318176</c:v>
                </c:pt>
                <c:pt idx="228">
                  <c:v>0.97643482709844409</c:v>
                </c:pt>
                <c:pt idx="229">
                  <c:v>0.98564420501399463</c:v>
                </c:pt>
                <c:pt idx="230">
                  <c:v>0.9818521082252385</c:v>
                </c:pt>
                <c:pt idx="231">
                  <c:v>0.98106961206247933</c:v>
                </c:pt>
                <c:pt idx="232">
                  <c:v>0.98383844463839654</c:v>
                </c:pt>
                <c:pt idx="233">
                  <c:v>0.99909711981220095</c:v>
                </c:pt>
                <c:pt idx="234">
                  <c:v>0.98404911668221628</c:v>
                </c:pt>
                <c:pt idx="235">
                  <c:v>1.0079453456526319</c:v>
                </c:pt>
                <c:pt idx="236">
                  <c:v>1.0029193126072171</c:v>
                </c:pt>
                <c:pt idx="237">
                  <c:v>0.98167153218767866</c:v>
                </c:pt>
                <c:pt idx="238">
                  <c:v>0.988232461552352</c:v>
                </c:pt>
                <c:pt idx="239">
                  <c:v>0.99082071809070937</c:v>
                </c:pt>
                <c:pt idx="240">
                  <c:v>0.99003822192795021</c:v>
                </c:pt>
                <c:pt idx="241">
                  <c:v>0.99374003069792638</c:v>
                </c:pt>
                <c:pt idx="242">
                  <c:v>0.97176994612814882</c:v>
                </c:pt>
                <c:pt idx="243">
                  <c:v>0.96978360971499078</c:v>
                </c:pt>
                <c:pt idx="244">
                  <c:v>0.98371806061335665</c:v>
                </c:pt>
                <c:pt idx="245">
                  <c:v>1.0102326421283896</c:v>
                </c:pt>
                <c:pt idx="246">
                  <c:v>0.98540343696391486</c:v>
                </c:pt>
                <c:pt idx="247">
                  <c:v>0.97815029945526233</c:v>
                </c:pt>
                <c:pt idx="248">
                  <c:v>0.99322839859150691</c:v>
                </c:pt>
                <c:pt idx="249">
                  <c:v>0.98043759593101998</c:v>
                </c:pt>
                <c:pt idx="250">
                  <c:v>0.98167153218767866</c:v>
                </c:pt>
                <c:pt idx="251">
                  <c:v>0.98055797995605987</c:v>
                </c:pt>
                <c:pt idx="252">
                  <c:v>0.99605742317994406</c:v>
                </c:pt>
                <c:pt idx="253">
                  <c:v>1.0026183525446173</c:v>
                </c:pt>
                <c:pt idx="254">
                  <c:v>1.0149878111174646</c:v>
                </c:pt>
                <c:pt idx="255">
                  <c:v>1.0056279531706143</c:v>
                </c:pt>
                <c:pt idx="256">
                  <c:v>0.99888644776838109</c:v>
                </c:pt>
                <c:pt idx="257">
                  <c:v>1.0120083064977277</c:v>
                </c:pt>
                <c:pt idx="258">
                  <c:v>1.004785264995335</c:v>
                </c:pt>
                <c:pt idx="259">
                  <c:v>0.99169350227224851</c:v>
                </c:pt>
                <c:pt idx="260">
                  <c:v>0.99623799921750389</c:v>
                </c:pt>
                <c:pt idx="261">
                  <c:v>1.0024076805007975</c:v>
                </c:pt>
                <c:pt idx="262">
                  <c:v>0.36536551599602735</c:v>
                </c:pt>
                <c:pt idx="263">
                  <c:v>0.63153459535919587</c:v>
                </c:pt>
                <c:pt idx="264">
                  <c:v>0.8366990700334066</c:v>
                </c:pt>
                <c:pt idx="265">
                  <c:v>0.90784602883197396</c:v>
                </c:pt>
                <c:pt idx="266">
                  <c:v>0.94047009961778072</c:v>
                </c:pt>
                <c:pt idx="267">
                  <c:v>0.95937039154904147</c:v>
                </c:pt>
                <c:pt idx="268">
                  <c:v>0.97369609052878681</c:v>
                </c:pt>
                <c:pt idx="269">
                  <c:v>0.97143889005928918</c:v>
                </c:pt>
                <c:pt idx="270">
                  <c:v>0.9795046197369609</c:v>
                </c:pt>
                <c:pt idx="271">
                  <c:v>0.97351551449122697</c:v>
                </c:pt>
                <c:pt idx="272">
                  <c:v>0.96460709663827615</c:v>
                </c:pt>
                <c:pt idx="273">
                  <c:v>0.97775905137388264</c:v>
                </c:pt>
                <c:pt idx="274">
                  <c:v>0.96824871339573237</c:v>
                </c:pt>
                <c:pt idx="275">
                  <c:v>0.97661540313600381</c:v>
                </c:pt>
                <c:pt idx="276">
                  <c:v>0.97462906672284588</c:v>
                </c:pt>
                <c:pt idx="277">
                  <c:v>0.25018810003912478</c:v>
                </c:pt>
                <c:pt idx="278">
                  <c:v>0.73936858578866582</c:v>
                </c:pt>
                <c:pt idx="279">
                  <c:v>0.87272398952658981</c:v>
                </c:pt>
                <c:pt idx="280">
                  <c:v>0.92506094441267639</c:v>
                </c:pt>
                <c:pt idx="281">
                  <c:v>0.96153730399975923</c:v>
                </c:pt>
                <c:pt idx="282">
                  <c:v>0.94564661269449546</c:v>
                </c:pt>
                <c:pt idx="283">
                  <c:v>0.96511872874469562</c:v>
                </c:pt>
                <c:pt idx="284">
                  <c:v>0.95720347909832371</c:v>
                </c:pt>
                <c:pt idx="285">
                  <c:v>0.92671622475697479</c:v>
                </c:pt>
                <c:pt idx="286">
                  <c:v>0.82751978812411597</c:v>
                </c:pt>
                <c:pt idx="287">
                  <c:v>0.75998435007674481</c:v>
                </c:pt>
                <c:pt idx="288">
                  <c:v>0.75005266801095494</c:v>
                </c:pt>
                <c:pt idx="289">
                  <c:v>0.81641436181418725</c:v>
                </c:pt>
                <c:pt idx="290">
                  <c:v>0.74213741836458302</c:v>
                </c:pt>
                <c:pt idx="291">
                  <c:v>0.28524994733198905</c:v>
                </c:pt>
                <c:pt idx="292">
                  <c:v>0.63192584344057545</c:v>
                </c:pt>
                <c:pt idx="293">
                  <c:v>0.39139856141090079</c:v>
                </c:pt>
                <c:pt idx="294">
                  <c:v>0.67580582056761063</c:v>
                </c:pt>
                <c:pt idx="295">
                  <c:v>0.83678935805218646</c:v>
                </c:pt>
                <c:pt idx="296">
                  <c:v>0.89839588286634364</c:v>
                </c:pt>
                <c:pt idx="297">
                  <c:v>0.81981521052156381</c:v>
                </c:pt>
                <c:pt idx="298">
                  <c:v>0.55274325097059618</c:v>
                </c:pt>
                <c:pt idx="299">
                  <c:v>0.83835435037770489</c:v>
                </c:pt>
                <c:pt idx="300">
                  <c:v>0.90555873235621631</c:v>
                </c:pt>
                <c:pt idx="301">
                  <c:v>0.92274355193065882</c:v>
                </c:pt>
                <c:pt idx="302">
                  <c:v>0.92542209648779605</c:v>
                </c:pt>
                <c:pt idx="303">
                  <c:v>0.91687483070996478</c:v>
                </c:pt>
                <c:pt idx="304">
                  <c:v>0.94706112498871398</c:v>
                </c:pt>
                <c:pt idx="305">
                  <c:v>0.90185692358624014</c:v>
                </c:pt>
                <c:pt idx="306">
                  <c:v>0.84199596713516112</c:v>
                </c:pt>
                <c:pt idx="307">
                  <c:v>0.72028771781984535</c:v>
                </c:pt>
                <c:pt idx="308">
                  <c:v>0.81749781803954613</c:v>
                </c:pt>
                <c:pt idx="309">
                  <c:v>0.87052698106961202</c:v>
                </c:pt>
                <c:pt idx="310">
                  <c:v>0.88762151262527467</c:v>
                </c:pt>
                <c:pt idx="311">
                  <c:v>0.91561079844704607</c:v>
                </c:pt>
                <c:pt idx="312">
                  <c:v>0.89990068317934213</c:v>
                </c:pt>
                <c:pt idx="313">
                  <c:v>0.8900291931260722</c:v>
                </c:pt>
                <c:pt idx="314">
                  <c:v>0.82402865139795944</c:v>
                </c:pt>
                <c:pt idx="315">
                  <c:v>0.78637854756673786</c:v>
                </c:pt>
                <c:pt idx="316">
                  <c:v>0.84130375899118182</c:v>
                </c:pt>
                <c:pt idx="317">
                  <c:v>0.86938333283173319</c:v>
                </c:pt>
                <c:pt idx="318">
                  <c:v>0.8817226953983206</c:v>
                </c:pt>
                <c:pt idx="319">
                  <c:v>0.89336984982092871</c:v>
                </c:pt>
                <c:pt idx="320">
                  <c:v>0.88999909711981218</c:v>
                </c:pt>
                <c:pt idx="321">
                  <c:v>0.82228308303488129</c:v>
                </c:pt>
                <c:pt idx="322">
                  <c:v>0.7030427062328829</c:v>
                </c:pt>
                <c:pt idx="323">
                  <c:v>0.77262467270593194</c:v>
                </c:pt>
                <c:pt idx="324">
                  <c:v>0.8347729256327685</c:v>
                </c:pt>
                <c:pt idx="325">
                  <c:v>0.86748728443735512</c:v>
                </c:pt>
                <c:pt idx="326">
                  <c:v>0.88608661630601615</c:v>
                </c:pt>
                <c:pt idx="327">
                  <c:v>0.88124115929816116</c:v>
                </c:pt>
                <c:pt idx="328">
                  <c:v>0.87305504559544944</c:v>
                </c:pt>
                <c:pt idx="329">
                  <c:v>0.86125741114154153</c:v>
                </c:pt>
                <c:pt idx="330">
                  <c:v>0.85529840190206763</c:v>
                </c:pt>
                <c:pt idx="331">
                  <c:v>0.84964035272519334</c:v>
                </c:pt>
                <c:pt idx="332">
                  <c:v>0.85490715382068805</c:v>
                </c:pt>
                <c:pt idx="333">
                  <c:v>0.8333885093448099</c:v>
                </c:pt>
                <c:pt idx="334">
                  <c:v>0.83703012610226624</c:v>
                </c:pt>
                <c:pt idx="335">
                  <c:v>0.84347067144189969</c:v>
                </c:pt>
                <c:pt idx="336">
                  <c:v>0.83958828663436358</c:v>
                </c:pt>
                <c:pt idx="337">
                  <c:v>0.82845276431817494</c:v>
                </c:pt>
                <c:pt idx="338">
                  <c:v>0.82959641255605376</c:v>
                </c:pt>
                <c:pt idx="339">
                  <c:v>0.827429500105336</c:v>
                </c:pt>
                <c:pt idx="340">
                  <c:v>0.84184548710386131</c:v>
                </c:pt>
                <c:pt idx="341">
                  <c:v>0.83994943870948324</c:v>
                </c:pt>
                <c:pt idx="342">
                  <c:v>0.83597676588316727</c:v>
                </c:pt>
                <c:pt idx="343">
                  <c:v>0.85966232280976318</c:v>
                </c:pt>
                <c:pt idx="344">
                  <c:v>0.83967857465314355</c:v>
                </c:pt>
                <c:pt idx="345">
                  <c:v>0.85337225750142953</c:v>
                </c:pt>
                <c:pt idx="346">
                  <c:v>0.84729286423691574</c:v>
                </c:pt>
                <c:pt idx="347">
                  <c:v>0.85144611310079155</c:v>
                </c:pt>
                <c:pt idx="348">
                  <c:v>0.8524994733198904</c:v>
                </c:pt>
                <c:pt idx="349">
                  <c:v>0.85325187347638964</c:v>
                </c:pt>
                <c:pt idx="350">
                  <c:v>0.85177716916965118</c:v>
                </c:pt>
                <c:pt idx="351">
                  <c:v>0.84976073675023323</c:v>
                </c:pt>
                <c:pt idx="352">
                  <c:v>0.85033256086917264</c:v>
                </c:pt>
                <c:pt idx="353">
                  <c:v>0.85397417762662897</c:v>
                </c:pt>
                <c:pt idx="354">
                  <c:v>0.85746531435278539</c:v>
                </c:pt>
                <c:pt idx="355">
                  <c:v>0.8447347037048184</c:v>
                </c:pt>
                <c:pt idx="356">
                  <c:v>0.8440424955608391</c:v>
                </c:pt>
                <c:pt idx="357">
                  <c:v>0.85620128208986668</c:v>
                </c:pt>
                <c:pt idx="358">
                  <c:v>0.85150630511331149</c:v>
                </c:pt>
                <c:pt idx="359">
                  <c:v>0.85993318686610287</c:v>
                </c:pt>
                <c:pt idx="360">
                  <c:v>0.85493724982694796</c:v>
                </c:pt>
                <c:pt idx="361">
                  <c:v>0.86866102868149397</c:v>
                </c:pt>
                <c:pt idx="362">
                  <c:v>0.88027808709784217</c:v>
                </c:pt>
                <c:pt idx="363">
                  <c:v>0.86143798717910136</c:v>
                </c:pt>
                <c:pt idx="364">
                  <c:v>0.87329581364552922</c:v>
                </c:pt>
                <c:pt idx="365">
                  <c:v>0.85538868992084749</c:v>
                </c:pt>
                <c:pt idx="366">
                  <c:v>0.87067746110091193</c:v>
                </c:pt>
                <c:pt idx="367">
                  <c:v>0.87600445420892648</c:v>
                </c:pt>
                <c:pt idx="368">
                  <c:v>0.86574171607427697</c:v>
                </c:pt>
                <c:pt idx="369">
                  <c:v>0.8565022421524664</c:v>
                </c:pt>
                <c:pt idx="370">
                  <c:v>0.86808920456255456</c:v>
                </c:pt>
                <c:pt idx="371">
                  <c:v>0.87022602100701241</c:v>
                </c:pt>
                <c:pt idx="372">
                  <c:v>0.86303307551087971</c:v>
                </c:pt>
                <c:pt idx="373">
                  <c:v>0.87540253408372704</c:v>
                </c:pt>
                <c:pt idx="374">
                  <c:v>0.87738887049688508</c:v>
                </c:pt>
                <c:pt idx="375">
                  <c:v>0.8851837361182171</c:v>
                </c:pt>
                <c:pt idx="376">
                  <c:v>0.87359677370812894</c:v>
                </c:pt>
                <c:pt idx="377">
                  <c:v>0.86914256478165353</c:v>
                </c:pt>
                <c:pt idx="378">
                  <c:v>0.87305504559544944</c:v>
                </c:pt>
                <c:pt idx="379">
                  <c:v>0.86008366689740268</c:v>
                </c:pt>
                <c:pt idx="380">
                  <c:v>0.86228067535438047</c:v>
                </c:pt>
                <c:pt idx="381">
                  <c:v>0.88097029524182136</c:v>
                </c:pt>
                <c:pt idx="382">
                  <c:v>0.87386763776446863</c:v>
                </c:pt>
                <c:pt idx="383">
                  <c:v>0.86483883588647792</c:v>
                </c:pt>
                <c:pt idx="384">
                  <c:v>0.87787040659704452</c:v>
                </c:pt>
                <c:pt idx="385">
                  <c:v>0.86742709242483518</c:v>
                </c:pt>
                <c:pt idx="386">
                  <c:v>0.86944352484425313</c:v>
                </c:pt>
                <c:pt idx="387">
                  <c:v>0.87540253408372704</c:v>
                </c:pt>
                <c:pt idx="388">
                  <c:v>0.86739699641857526</c:v>
                </c:pt>
                <c:pt idx="389">
                  <c:v>0.8819935594546604</c:v>
                </c:pt>
                <c:pt idx="390">
                  <c:v>0.88416047190537816</c:v>
                </c:pt>
                <c:pt idx="391">
                  <c:v>0.87314533361422941</c:v>
                </c:pt>
                <c:pt idx="392">
                  <c:v>0.89797453877870403</c:v>
                </c:pt>
                <c:pt idx="393">
                  <c:v>0.87790050260330454</c:v>
                </c:pt>
                <c:pt idx="394">
                  <c:v>0.87787040659704452</c:v>
                </c:pt>
                <c:pt idx="395">
                  <c:v>0.88394979986155842</c:v>
                </c:pt>
                <c:pt idx="396">
                  <c:v>0.86832997261263434</c:v>
                </c:pt>
                <c:pt idx="397">
                  <c:v>0.87633551027778611</c:v>
                </c:pt>
                <c:pt idx="398">
                  <c:v>0.88527402413699707</c:v>
                </c:pt>
                <c:pt idx="399">
                  <c:v>0.87750925452192496</c:v>
                </c:pt>
                <c:pt idx="400">
                  <c:v>0.8857254642308966</c:v>
                </c:pt>
                <c:pt idx="401">
                  <c:v>0.87955578294760284</c:v>
                </c:pt>
                <c:pt idx="402">
                  <c:v>0.88259547957985973</c:v>
                </c:pt>
                <c:pt idx="403">
                  <c:v>0.88063923917296172</c:v>
                </c:pt>
                <c:pt idx="404">
                  <c:v>0.8771481024468053</c:v>
                </c:pt>
                <c:pt idx="405">
                  <c:v>0.87446955788966807</c:v>
                </c:pt>
                <c:pt idx="406">
                  <c:v>0.88349835976765878</c:v>
                </c:pt>
                <c:pt idx="407">
                  <c:v>0.87416859782706835</c:v>
                </c:pt>
                <c:pt idx="408">
                  <c:v>0.88828362476299394</c:v>
                </c:pt>
                <c:pt idx="409">
                  <c:v>0.86492912390525778</c:v>
                </c:pt>
                <c:pt idx="410">
                  <c:v>0.87859271074728384</c:v>
                </c:pt>
                <c:pt idx="411">
                  <c:v>0.8916844734703705</c:v>
                </c:pt>
                <c:pt idx="412">
                  <c:v>0.89228639359556983</c:v>
                </c:pt>
                <c:pt idx="413">
                  <c:v>0.87747915851566494</c:v>
                </c:pt>
                <c:pt idx="414">
                  <c:v>0.88984861708851237</c:v>
                </c:pt>
                <c:pt idx="415">
                  <c:v>0.87636560628404614</c:v>
                </c:pt>
                <c:pt idx="416">
                  <c:v>0.88927679296957296</c:v>
                </c:pt>
                <c:pt idx="417">
                  <c:v>0.87871309477232373</c:v>
                </c:pt>
                <c:pt idx="418">
                  <c:v>0.89216600957052994</c:v>
                </c:pt>
                <c:pt idx="419">
                  <c:v>0.87085803713847176</c:v>
                </c:pt>
                <c:pt idx="420">
                  <c:v>0.89005928913233212</c:v>
                </c:pt>
                <c:pt idx="421">
                  <c:v>0.88981852108225234</c:v>
                </c:pt>
                <c:pt idx="422">
                  <c:v>0.86992506094441269</c:v>
                </c:pt>
                <c:pt idx="423">
                  <c:v>0.88419056791163808</c:v>
                </c:pt>
                <c:pt idx="424">
                  <c:v>0.88343816775513895</c:v>
                </c:pt>
                <c:pt idx="425">
                  <c:v>0.88301682366749934</c:v>
                </c:pt>
                <c:pt idx="426">
                  <c:v>0.87976645499142259</c:v>
                </c:pt>
                <c:pt idx="427">
                  <c:v>0.88831372076925397</c:v>
                </c:pt>
                <c:pt idx="428">
                  <c:v>0.90023173924820177</c:v>
                </c:pt>
                <c:pt idx="429">
                  <c:v>0.86348451560477923</c:v>
                </c:pt>
                <c:pt idx="430">
                  <c:v>0.87669666235290578</c:v>
                </c:pt>
                <c:pt idx="431">
                  <c:v>0.88205375146718035</c:v>
                </c:pt>
                <c:pt idx="432">
                  <c:v>0.87988683901646247</c:v>
                </c:pt>
                <c:pt idx="433">
                  <c:v>0.88723026454389498</c:v>
                </c:pt>
                <c:pt idx="434">
                  <c:v>0.89628916242814582</c:v>
                </c:pt>
                <c:pt idx="435">
                  <c:v>0.89177476148915036</c:v>
                </c:pt>
                <c:pt idx="436">
                  <c:v>0.88370903181147864</c:v>
                </c:pt>
                <c:pt idx="437">
                  <c:v>0.89984049116682219</c:v>
                </c:pt>
                <c:pt idx="438">
                  <c:v>0.87552291810876692</c:v>
                </c:pt>
                <c:pt idx="439">
                  <c:v>0.88112077527312127</c:v>
                </c:pt>
                <c:pt idx="440">
                  <c:v>0.8944533060462877</c:v>
                </c:pt>
                <c:pt idx="441">
                  <c:v>0.87510157402112743</c:v>
                </c:pt>
                <c:pt idx="442">
                  <c:v>0.90787612483823399</c:v>
                </c:pt>
                <c:pt idx="443">
                  <c:v>0.87200168537635059</c:v>
                </c:pt>
                <c:pt idx="444">
                  <c:v>0.88187317542962051</c:v>
                </c:pt>
                <c:pt idx="445">
                  <c:v>0.88391970385529839</c:v>
                </c:pt>
                <c:pt idx="446">
                  <c:v>0.89899780299154297</c:v>
                </c:pt>
                <c:pt idx="447">
                  <c:v>0.89875703494146331</c:v>
                </c:pt>
                <c:pt idx="448">
                  <c:v>0.89896770698528305</c:v>
                </c:pt>
                <c:pt idx="449">
                  <c:v>0.87284437355162969</c:v>
                </c:pt>
                <c:pt idx="450">
                  <c:v>0.90260932374273939</c:v>
                </c:pt>
                <c:pt idx="451">
                  <c:v>0.88605652029975623</c:v>
                </c:pt>
                <c:pt idx="452">
                  <c:v>0.87820146266590426</c:v>
                </c:pt>
                <c:pt idx="453">
                  <c:v>0.88638757636861587</c:v>
                </c:pt>
                <c:pt idx="454">
                  <c:v>0.88479248803683752</c:v>
                </c:pt>
                <c:pt idx="455">
                  <c:v>0.88942727300087276</c:v>
                </c:pt>
                <c:pt idx="456">
                  <c:v>0.89087188130135131</c:v>
                </c:pt>
                <c:pt idx="457">
                  <c:v>0.87961597496012278</c:v>
                </c:pt>
                <c:pt idx="458">
                  <c:v>0.88298672766123931</c:v>
                </c:pt>
                <c:pt idx="459">
                  <c:v>0.87687723839046561</c:v>
                </c:pt>
                <c:pt idx="460">
                  <c:v>0.88205375146718035</c:v>
                </c:pt>
                <c:pt idx="461">
                  <c:v>0.88713997652511511</c:v>
                </c:pt>
                <c:pt idx="462">
                  <c:v>0.8753423420712072</c:v>
                </c:pt>
                <c:pt idx="463">
                  <c:v>0.90489662021849704</c:v>
                </c:pt>
                <c:pt idx="464">
                  <c:v>0.88407018388659819</c:v>
                </c:pt>
                <c:pt idx="465">
                  <c:v>0.88319739970505917</c:v>
                </c:pt>
                <c:pt idx="466">
                  <c:v>0.88879525686941341</c:v>
                </c:pt>
                <c:pt idx="467">
                  <c:v>0.883377975742619</c:v>
                </c:pt>
                <c:pt idx="468">
                  <c:v>0.89538628224034666</c:v>
                </c:pt>
                <c:pt idx="469">
                  <c:v>0.88190327143588043</c:v>
                </c:pt>
                <c:pt idx="470">
                  <c:v>0.89285821771450924</c:v>
                </c:pt>
                <c:pt idx="471">
                  <c:v>0.88608661630601615</c:v>
                </c:pt>
                <c:pt idx="472">
                  <c:v>0.89776386673488429</c:v>
                </c:pt>
                <c:pt idx="473">
                  <c:v>0.87835194269720407</c:v>
                </c:pt>
                <c:pt idx="474">
                  <c:v>0.87636560628404614</c:v>
                </c:pt>
                <c:pt idx="475">
                  <c:v>0.88747103259397475</c:v>
                </c:pt>
                <c:pt idx="476">
                  <c:v>0.88307701568001928</c:v>
                </c:pt>
                <c:pt idx="477">
                  <c:v>0.88015770307280228</c:v>
                </c:pt>
                <c:pt idx="478">
                  <c:v>0.88524392813073705</c:v>
                </c:pt>
                <c:pt idx="479">
                  <c:v>0.89315917777710896</c:v>
                </c:pt>
                <c:pt idx="480">
                  <c:v>0.88921660095705302</c:v>
                </c:pt>
                <c:pt idx="481">
                  <c:v>0.87076774911969179</c:v>
                </c:pt>
                <c:pt idx="482">
                  <c:v>0.87964607096638281</c:v>
                </c:pt>
                <c:pt idx="483">
                  <c:v>0.8890661209257531</c:v>
                </c:pt>
                <c:pt idx="484">
                  <c:v>0.87678695037168564</c:v>
                </c:pt>
                <c:pt idx="485">
                  <c:v>0.89198543353297022</c:v>
                </c:pt>
                <c:pt idx="486">
                  <c:v>0.8923766816143498</c:v>
                </c:pt>
                <c:pt idx="487">
                  <c:v>0.88181298341710057</c:v>
                </c:pt>
                <c:pt idx="488">
                  <c:v>0.88792247268787428</c:v>
                </c:pt>
                <c:pt idx="489">
                  <c:v>0.88692930448129537</c:v>
                </c:pt>
                <c:pt idx="490">
                  <c:v>0.8778403105907846</c:v>
                </c:pt>
                <c:pt idx="491">
                  <c:v>0.88581575224967646</c:v>
                </c:pt>
                <c:pt idx="492">
                  <c:v>0.88876516086315349</c:v>
                </c:pt>
                <c:pt idx="493">
                  <c:v>0.88644776838113581</c:v>
                </c:pt>
                <c:pt idx="494">
                  <c:v>0.90095404339844098</c:v>
                </c:pt>
                <c:pt idx="495">
                  <c:v>0.87579378216510673</c:v>
                </c:pt>
                <c:pt idx="496">
                  <c:v>0.87850242272850387</c:v>
                </c:pt>
                <c:pt idx="497">
                  <c:v>0.88786228067535433</c:v>
                </c:pt>
                <c:pt idx="498">
                  <c:v>0.88190327143588043</c:v>
                </c:pt>
                <c:pt idx="499">
                  <c:v>0.88346826376139886</c:v>
                </c:pt>
                <c:pt idx="500">
                  <c:v>0.89123303337647097</c:v>
                </c:pt>
                <c:pt idx="501">
                  <c:v>0.87817136665964424</c:v>
                </c:pt>
                <c:pt idx="502">
                  <c:v>0.89984049116682219</c:v>
                </c:pt>
                <c:pt idx="503">
                  <c:v>0.87588407018388659</c:v>
                </c:pt>
                <c:pt idx="504">
                  <c:v>0.8932193697896289</c:v>
                </c:pt>
                <c:pt idx="505">
                  <c:v>0.89054082523249167</c:v>
                </c:pt>
                <c:pt idx="506">
                  <c:v>0.89297860173954913</c:v>
                </c:pt>
                <c:pt idx="507">
                  <c:v>0.8893369849820929</c:v>
                </c:pt>
                <c:pt idx="508">
                  <c:v>0.88106058326060133</c:v>
                </c:pt>
                <c:pt idx="509">
                  <c:v>0.89944924308544261</c:v>
                </c:pt>
                <c:pt idx="510">
                  <c:v>0.88334787973635898</c:v>
                </c:pt>
                <c:pt idx="511">
                  <c:v>0.88479248803683752</c:v>
                </c:pt>
                <c:pt idx="512">
                  <c:v>0.88458181599301777</c:v>
                </c:pt>
                <c:pt idx="513">
                  <c:v>0.8971017545971649</c:v>
                </c:pt>
                <c:pt idx="514">
                  <c:v>0.89198543353297022</c:v>
                </c:pt>
                <c:pt idx="515">
                  <c:v>0.88443133596171786</c:v>
                </c:pt>
                <c:pt idx="516">
                  <c:v>0.89397176994612815</c:v>
                </c:pt>
                <c:pt idx="517">
                  <c:v>0.8907214012700515</c:v>
                </c:pt>
                <c:pt idx="518">
                  <c:v>0.87474042194600776</c:v>
                </c:pt>
                <c:pt idx="519">
                  <c:v>0.89821530682878381</c:v>
                </c:pt>
                <c:pt idx="520">
                  <c:v>0.87413850182080843</c:v>
                </c:pt>
                <c:pt idx="521">
                  <c:v>0.87449965389592799</c:v>
                </c:pt>
                <c:pt idx="522">
                  <c:v>0.88921660095705302</c:v>
                </c:pt>
                <c:pt idx="523">
                  <c:v>0.88298672766123931</c:v>
                </c:pt>
                <c:pt idx="524">
                  <c:v>0.88024799109158214</c:v>
                </c:pt>
                <c:pt idx="525">
                  <c:v>0.89069130526379148</c:v>
                </c:pt>
                <c:pt idx="526">
                  <c:v>0.89111264935143109</c:v>
                </c:pt>
                <c:pt idx="527">
                  <c:v>0.88807295271917419</c:v>
                </c:pt>
                <c:pt idx="528">
                  <c:v>0.88121106329190113</c:v>
                </c:pt>
                <c:pt idx="529">
                  <c:v>0.89270773768320943</c:v>
                </c:pt>
                <c:pt idx="530">
                  <c:v>0.89033015318867181</c:v>
                </c:pt>
                <c:pt idx="531">
                  <c:v>0.88551479218707674</c:v>
                </c:pt>
                <c:pt idx="532">
                  <c:v>0.89373100189604837</c:v>
                </c:pt>
                <c:pt idx="533">
                  <c:v>0.90107442742348087</c:v>
                </c:pt>
                <c:pt idx="534">
                  <c:v>0.87750925452192496</c:v>
                </c:pt>
                <c:pt idx="535">
                  <c:v>0.88551479218707674</c:v>
                </c:pt>
                <c:pt idx="536">
                  <c:v>0.88325759171757912</c:v>
                </c:pt>
                <c:pt idx="537">
                  <c:v>0.87835194269720407</c:v>
                </c:pt>
                <c:pt idx="538">
                  <c:v>0.89538628224034666</c:v>
                </c:pt>
                <c:pt idx="539">
                  <c:v>0.87073765311343188</c:v>
                </c:pt>
                <c:pt idx="540">
                  <c:v>0.89406205796490801</c:v>
                </c:pt>
                <c:pt idx="541">
                  <c:v>0.87802088662834443</c:v>
                </c:pt>
                <c:pt idx="542">
                  <c:v>0.88635748036235595</c:v>
                </c:pt>
                <c:pt idx="543">
                  <c:v>0.8984861708851235</c:v>
                </c:pt>
                <c:pt idx="544">
                  <c:v>0.89538628224034666</c:v>
                </c:pt>
                <c:pt idx="545">
                  <c:v>0.88075962319800161</c:v>
                </c:pt>
                <c:pt idx="546">
                  <c:v>0.89297860173954913</c:v>
                </c:pt>
                <c:pt idx="547">
                  <c:v>0.88139163932946096</c:v>
                </c:pt>
                <c:pt idx="548">
                  <c:v>0.89361061787100848</c:v>
                </c:pt>
                <c:pt idx="549">
                  <c:v>0.86691546031841571</c:v>
                </c:pt>
                <c:pt idx="550">
                  <c:v>0.8971017545971649</c:v>
                </c:pt>
                <c:pt idx="551">
                  <c:v>0.87910434285370331</c:v>
                </c:pt>
                <c:pt idx="552">
                  <c:v>0.88765160863153458</c:v>
                </c:pt>
                <c:pt idx="553">
                  <c:v>0.87997712703524245</c:v>
                </c:pt>
                <c:pt idx="554">
                  <c:v>0.88033827911036211</c:v>
                </c:pt>
                <c:pt idx="555">
                  <c:v>0.88521383212447713</c:v>
                </c:pt>
                <c:pt idx="556">
                  <c:v>0.88602642429349621</c:v>
                </c:pt>
                <c:pt idx="557">
                  <c:v>0.87759954254070482</c:v>
                </c:pt>
                <c:pt idx="558">
                  <c:v>0.88391970385529839</c:v>
                </c:pt>
                <c:pt idx="559">
                  <c:v>0.88632738435609593</c:v>
                </c:pt>
                <c:pt idx="560">
                  <c:v>0.86688536431215579</c:v>
                </c:pt>
                <c:pt idx="561">
                  <c:v>0.89553676227164658</c:v>
                </c:pt>
                <c:pt idx="562">
                  <c:v>0.8790742468474434</c:v>
                </c:pt>
                <c:pt idx="563">
                  <c:v>0.87967616697264273</c:v>
                </c:pt>
                <c:pt idx="564">
                  <c:v>0.89466397809010745</c:v>
                </c:pt>
                <c:pt idx="565">
                  <c:v>0.88088000722304149</c:v>
                </c:pt>
                <c:pt idx="566">
                  <c:v>0.89063111325127153</c:v>
                </c:pt>
                <c:pt idx="567">
                  <c:v>0.89036024919493184</c:v>
                </c:pt>
                <c:pt idx="568">
                  <c:v>0.89836578686008361</c:v>
                </c:pt>
                <c:pt idx="569">
                  <c:v>0.90059289132332143</c:v>
                </c:pt>
                <c:pt idx="570">
                  <c:v>0.89565714629668647</c:v>
                </c:pt>
                <c:pt idx="571">
                  <c:v>0.88798266470039422</c:v>
                </c:pt>
                <c:pt idx="572">
                  <c:v>0.89189514551419025</c:v>
                </c:pt>
                <c:pt idx="573">
                  <c:v>0.8932193697896289</c:v>
                </c:pt>
                <c:pt idx="574">
                  <c:v>0.88840400878803383</c:v>
                </c:pt>
                <c:pt idx="575">
                  <c:v>0.88858458482559366</c:v>
                </c:pt>
                <c:pt idx="576">
                  <c:v>0.90260932374273939</c:v>
                </c:pt>
                <c:pt idx="577">
                  <c:v>0.89592801035302616</c:v>
                </c:pt>
                <c:pt idx="578">
                  <c:v>0.88623709633731607</c:v>
                </c:pt>
                <c:pt idx="579">
                  <c:v>0.88987871309477229</c:v>
                </c:pt>
                <c:pt idx="580">
                  <c:v>0.87910434285370331</c:v>
                </c:pt>
                <c:pt idx="581">
                  <c:v>0.90712372468173474</c:v>
                </c:pt>
                <c:pt idx="582">
                  <c:v>0.88313720769253923</c:v>
                </c:pt>
                <c:pt idx="583">
                  <c:v>0.86802901255003462</c:v>
                </c:pt>
                <c:pt idx="584">
                  <c:v>0.88298672766123931</c:v>
                </c:pt>
                <c:pt idx="585">
                  <c:v>0.87582387817136664</c:v>
                </c:pt>
                <c:pt idx="586">
                  <c:v>0.89652993047822549</c:v>
                </c:pt>
                <c:pt idx="587">
                  <c:v>0.87775002257200474</c:v>
                </c:pt>
                <c:pt idx="588">
                  <c:v>0.88578565624341654</c:v>
                </c:pt>
                <c:pt idx="589">
                  <c:v>0.89448340205254762</c:v>
                </c:pt>
                <c:pt idx="590">
                  <c:v>0.89135341740151086</c:v>
                </c:pt>
                <c:pt idx="591">
                  <c:v>0.89057092123875159</c:v>
                </c:pt>
                <c:pt idx="592">
                  <c:v>0.88897583290697324</c:v>
                </c:pt>
                <c:pt idx="593">
                  <c:v>0.87805098263460435</c:v>
                </c:pt>
                <c:pt idx="594">
                  <c:v>0.88963794504469262</c:v>
                </c:pt>
                <c:pt idx="595">
                  <c:v>0.87218226141391042</c:v>
                </c:pt>
                <c:pt idx="596">
                  <c:v>0.89303879375206907</c:v>
                </c:pt>
                <c:pt idx="597">
                  <c:v>0.88410027989285822</c:v>
                </c:pt>
                <c:pt idx="598">
                  <c:v>0.87522195804616731</c:v>
                </c:pt>
                <c:pt idx="599">
                  <c:v>0.88118096728564121</c:v>
                </c:pt>
                <c:pt idx="600">
                  <c:v>0.87200168537635059</c:v>
                </c:pt>
                <c:pt idx="601">
                  <c:v>0.88744093658771483</c:v>
                </c:pt>
                <c:pt idx="602">
                  <c:v>0.88563517621211663</c:v>
                </c:pt>
                <c:pt idx="603">
                  <c:v>0.87522195804616731</c:v>
                </c:pt>
                <c:pt idx="604">
                  <c:v>0.88142173533572099</c:v>
                </c:pt>
                <c:pt idx="605">
                  <c:v>0.89132332139525083</c:v>
                </c:pt>
                <c:pt idx="606">
                  <c:v>0.88533421614951691</c:v>
                </c:pt>
                <c:pt idx="607">
                  <c:v>0.88229451951726001</c:v>
                </c:pt>
                <c:pt idx="608">
                  <c:v>0.88106058326060133</c:v>
                </c:pt>
                <c:pt idx="609">
                  <c:v>0.89048063321997173</c:v>
                </c:pt>
                <c:pt idx="610">
                  <c:v>0.86890179673157375</c:v>
                </c:pt>
                <c:pt idx="611">
                  <c:v>0.8896078490384326</c:v>
                </c:pt>
                <c:pt idx="612">
                  <c:v>0.87311523760796939</c:v>
                </c:pt>
                <c:pt idx="613">
                  <c:v>0.87723839046558527</c:v>
                </c:pt>
                <c:pt idx="614">
                  <c:v>0.87970626297890275</c:v>
                </c:pt>
                <c:pt idx="615">
                  <c:v>0.87305504559544944</c:v>
                </c:pt>
                <c:pt idx="616">
                  <c:v>0.87425888584584821</c:v>
                </c:pt>
                <c:pt idx="617">
                  <c:v>0.87558311012128687</c:v>
                </c:pt>
                <c:pt idx="618">
                  <c:v>0.88322749571131909</c:v>
                </c:pt>
                <c:pt idx="619">
                  <c:v>0.87955578294760284</c:v>
                </c:pt>
                <c:pt idx="620">
                  <c:v>0.87895386282240351</c:v>
                </c:pt>
                <c:pt idx="621">
                  <c:v>0.8916844734703705</c:v>
                </c:pt>
                <c:pt idx="622">
                  <c:v>0.88924669696331293</c:v>
                </c:pt>
                <c:pt idx="623">
                  <c:v>0.88683901646251539</c:v>
                </c:pt>
                <c:pt idx="624">
                  <c:v>0.87434917386462818</c:v>
                </c:pt>
                <c:pt idx="625">
                  <c:v>0.86947362085051316</c:v>
                </c:pt>
                <c:pt idx="626">
                  <c:v>0.87955578294760284</c:v>
                </c:pt>
                <c:pt idx="627">
                  <c:v>0.88051885514792183</c:v>
                </c:pt>
                <c:pt idx="628">
                  <c:v>0.8857254642308966</c:v>
                </c:pt>
                <c:pt idx="629">
                  <c:v>0.88744093658771483</c:v>
                </c:pt>
                <c:pt idx="630">
                  <c:v>0.87886357480362354</c:v>
                </c:pt>
                <c:pt idx="631">
                  <c:v>0.88012760706654225</c:v>
                </c:pt>
                <c:pt idx="632">
                  <c:v>0.87046678905709207</c:v>
                </c:pt>
                <c:pt idx="633">
                  <c:v>0.88593613627471635</c:v>
                </c:pt>
                <c:pt idx="634">
                  <c:v>0.88996900111355226</c:v>
                </c:pt>
                <c:pt idx="635">
                  <c:v>0.87624522225900625</c:v>
                </c:pt>
                <c:pt idx="636">
                  <c:v>0.88006741505402231</c:v>
                </c:pt>
                <c:pt idx="637">
                  <c:v>0.88452162398049783</c:v>
                </c:pt>
                <c:pt idx="638">
                  <c:v>0.8771481024468053</c:v>
                </c:pt>
                <c:pt idx="639">
                  <c:v>0.89315917777710896</c:v>
                </c:pt>
                <c:pt idx="640">
                  <c:v>0.87741896650314499</c:v>
                </c:pt>
                <c:pt idx="641">
                  <c:v>0.87985674301020256</c:v>
                </c:pt>
                <c:pt idx="642">
                  <c:v>0.86902218075661364</c:v>
                </c:pt>
                <c:pt idx="643">
                  <c:v>0.87958587895386287</c:v>
                </c:pt>
                <c:pt idx="644">
                  <c:v>0.89652993047822549</c:v>
                </c:pt>
                <c:pt idx="645">
                  <c:v>0.90155596352364042</c:v>
                </c:pt>
                <c:pt idx="646">
                  <c:v>0.86932314081921325</c:v>
                </c:pt>
                <c:pt idx="647">
                  <c:v>0.88124115929816116</c:v>
                </c:pt>
                <c:pt idx="648">
                  <c:v>0.88545460017455679</c:v>
                </c:pt>
                <c:pt idx="649">
                  <c:v>0.87603455021518639</c:v>
                </c:pt>
                <c:pt idx="650">
                  <c:v>0.89011948114485206</c:v>
                </c:pt>
                <c:pt idx="651">
                  <c:v>0.86062539501008217</c:v>
                </c:pt>
                <c:pt idx="652">
                  <c:v>0.87979655099768261</c:v>
                </c:pt>
                <c:pt idx="653">
                  <c:v>0.87880338279110359</c:v>
                </c:pt>
                <c:pt idx="654">
                  <c:v>0.87245312547025011</c:v>
                </c:pt>
                <c:pt idx="655">
                  <c:v>0.87245312547025011</c:v>
                </c:pt>
                <c:pt idx="656">
                  <c:v>0.87356667770186891</c:v>
                </c:pt>
                <c:pt idx="657">
                  <c:v>0.87320552562674936</c:v>
                </c:pt>
                <c:pt idx="658">
                  <c:v>0.8857254642308966</c:v>
                </c:pt>
                <c:pt idx="659">
                  <c:v>0.86965419688807299</c:v>
                </c:pt>
                <c:pt idx="660">
                  <c:v>0.88235471152977996</c:v>
                </c:pt>
                <c:pt idx="661">
                  <c:v>0.89327956180214885</c:v>
                </c:pt>
                <c:pt idx="662">
                  <c:v>0.88106058326060133</c:v>
                </c:pt>
                <c:pt idx="663">
                  <c:v>0.87305504559544944</c:v>
                </c:pt>
                <c:pt idx="664">
                  <c:v>0.87040659704457224</c:v>
                </c:pt>
                <c:pt idx="665">
                  <c:v>0.87829175068468412</c:v>
                </c:pt>
                <c:pt idx="666">
                  <c:v>0.8909922653263912</c:v>
                </c:pt>
                <c:pt idx="667">
                  <c:v>0.88334787973635898</c:v>
                </c:pt>
                <c:pt idx="668">
                  <c:v>0.87901405483492345</c:v>
                </c:pt>
                <c:pt idx="669">
                  <c:v>0.85686339422758595</c:v>
                </c:pt>
                <c:pt idx="670">
                  <c:v>0.87817136665964424</c:v>
                </c:pt>
                <c:pt idx="671">
                  <c:v>0.89189514551419025</c:v>
                </c:pt>
                <c:pt idx="672">
                  <c:v>0.88394979986155842</c:v>
                </c:pt>
                <c:pt idx="673">
                  <c:v>0.87130947723237129</c:v>
                </c:pt>
                <c:pt idx="674">
                  <c:v>0.87434917386462818</c:v>
                </c:pt>
                <c:pt idx="675">
                  <c:v>0.86986486893189274</c:v>
                </c:pt>
                <c:pt idx="676">
                  <c:v>0.87407830980828849</c:v>
                </c:pt>
                <c:pt idx="677">
                  <c:v>0.87164053330123092</c:v>
                </c:pt>
                <c:pt idx="678">
                  <c:v>0.86938333283173319</c:v>
                </c:pt>
                <c:pt idx="679">
                  <c:v>0.87245312547025011</c:v>
                </c:pt>
                <c:pt idx="680">
                  <c:v>0.87073765311343188</c:v>
                </c:pt>
                <c:pt idx="681">
                  <c:v>0.87510157402112743</c:v>
                </c:pt>
                <c:pt idx="682">
                  <c:v>0.88039847112288194</c:v>
                </c:pt>
                <c:pt idx="683">
                  <c:v>0.88139163932946096</c:v>
                </c:pt>
                <c:pt idx="684">
                  <c:v>0.88470220001805755</c:v>
                </c:pt>
                <c:pt idx="685">
                  <c:v>0.86492912390525778</c:v>
                </c:pt>
                <c:pt idx="686">
                  <c:v>0.87717819845306533</c:v>
                </c:pt>
                <c:pt idx="687">
                  <c:v>0.8875312246064947</c:v>
                </c:pt>
                <c:pt idx="688">
                  <c:v>0.88509344809943724</c:v>
                </c:pt>
                <c:pt idx="689">
                  <c:v>0.87826165467842421</c:v>
                </c:pt>
                <c:pt idx="690">
                  <c:v>0.87296475757666958</c:v>
                </c:pt>
                <c:pt idx="691">
                  <c:v>0.88680892045625548</c:v>
                </c:pt>
                <c:pt idx="692">
                  <c:v>0.88334787973635898</c:v>
                </c:pt>
                <c:pt idx="693">
                  <c:v>0.87847232672224396</c:v>
                </c:pt>
                <c:pt idx="694">
                  <c:v>0.87209197339513045</c:v>
                </c:pt>
                <c:pt idx="695">
                  <c:v>0.8614981791916213</c:v>
                </c:pt>
                <c:pt idx="696">
                  <c:v>0.87425888584584821</c:v>
                </c:pt>
                <c:pt idx="697">
                  <c:v>0.89093207331387125</c:v>
                </c:pt>
                <c:pt idx="698">
                  <c:v>0.88987871309477229</c:v>
                </c:pt>
                <c:pt idx="699">
                  <c:v>0.87185120534505067</c:v>
                </c:pt>
                <c:pt idx="700">
                  <c:v>0.88410027989285822</c:v>
                </c:pt>
                <c:pt idx="701">
                  <c:v>0.8829566316549794</c:v>
                </c:pt>
                <c:pt idx="702">
                  <c:v>0.8904505372137117</c:v>
                </c:pt>
                <c:pt idx="703">
                  <c:v>0.87636560628404614</c:v>
                </c:pt>
                <c:pt idx="704">
                  <c:v>0.8824149035422999</c:v>
                </c:pt>
                <c:pt idx="705">
                  <c:v>0.87498118999608754</c:v>
                </c:pt>
                <c:pt idx="706">
                  <c:v>0.88894573690071332</c:v>
                </c:pt>
                <c:pt idx="707">
                  <c:v>0.86983477292563272</c:v>
                </c:pt>
                <c:pt idx="708">
                  <c:v>0.87410840581454841</c:v>
                </c:pt>
                <c:pt idx="709">
                  <c:v>0.86616306016191646</c:v>
                </c:pt>
                <c:pt idx="710">
                  <c:v>0.87633551027778611</c:v>
                </c:pt>
                <c:pt idx="711">
                  <c:v>0.8864176723748759</c:v>
                </c:pt>
                <c:pt idx="712">
                  <c:v>0.88238480753603998</c:v>
                </c:pt>
                <c:pt idx="713">
                  <c:v>0.87537243807746712</c:v>
                </c:pt>
                <c:pt idx="714">
                  <c:v>0.88491287206187741</c:v>
                </c:pt>
                <c:pt idx="715">
                  <c:v>0.87642579829656608</c:v>
                </c:pt>
                <c:pt idx="716">
                  <c:v>0.8732657176392693</c:v>
                </c:pt>
                <c:pt idx="717">
                  <c:v>0.87257350949529</c:v>
                </c:pt>
                <c:pt idx="718">
                  <c:v>0.87537243807746712</c:v>
                </c:pt>
                <c:pt idx="719">
                  <c:v>0.88407018388659819</c:v>
                </c:pt>
                <c:pt idx="720">
                  <c:v>0.88771180064405453</c:v>
                </c:pt>
                <c:pt idx="721">
                  <c:v>0.87771992656574471</c:v>
                </c:pt>
                <c:pt idx="722">
                  <c:v>0.88801276070665425</c:v>
                </c:pt>
                <c:pt idx="723">
                  <c:v>0.88166250338580066</c:v>
                </c:pt>
                <c:pt idx="724">
                  <c:v>0.87094832515725162</c:v>
                </c:pt>
                <c:pt idx="725">
                  <c:v>0.88283624762993951</c:v>
                </c:pt>
                <c:pt idx="726">
                  <c:v>0.87943539892256295</c:v>
                </c:pt>
                <c:pt idx="727">
                  <c:v>0.87648599030908603</c:v>
                </c:pt>
                <c:pt idx="728">
                  <c:v>0.87311523760796939</c:v>
                </c:pt>
                <c:pt idx="729">
                  <c:v>0.87495109398982751</c:v>
                </c:pt>
                <c:pt idx="730">
                  <c:v>0.86504950793029767</c:v>
                </c:pt>
                <c:pt idx="731">
                  <c:v>0.86595238811809672</c:v>
                </c:pt>
                <c:pt idx="732">
                  <c:v>0.87970626297890275</c:v>
                </c:pt>
                <c:pt idx="733">
                  <c:v>0.88124115929816116</c:v>
                </c:pt>
                <c:pt idx="734">
                  <c:v>0.8799169350227225</c:v>
                </c:pt>
                <c:pt idx="735">
                  <c:v>0.87302494958918953</c:v>
                </c:pt>
                <c:pt idx="736">
                  <c:v>0.87877328678484368</c:v>
                </c:pt>
                <c:pt idx="737">
                  <c:v>0.88509344809943724</c:v>
                </c:pt>
                <c:pt idx="738">
                  <c:v>0.88115087127938119</c:v>
                </c:pt>
                <c:pt idx="739">
                  <c:v>0.87242302946399009</c:v>
                </c:pt>
                <c:pt idx="740">
                  <c:v>0.88410027989285822</c:v>
                </c:pt>
                <c:pt idx="741">
                  <c:v>0.88647786438739584</c:v>
                </c:pt>
                <c:pt idx="742">
                  <c:v>0.8692629488066933</c:v>
                </c:pt>
                <c:pt idx="743">
                  <c:v>0.88879525686941341</c:v>
                </c:pt>
                <c:pt idx="744">
                  <c:v>0.8930688897583291</c:v>
                </c:pt>
                <c:pt idx="745">
                  <c:v>0.87802088662834443</c:v>
                </c:pt>
                <c:pt idx="746">
                  <c:v>0.87272398952658981</c:v>
                </c:pt>
                <c:pt idx="747">
                  <c:v>0.8732657176392693</c:v>
                </c:pt>
                <c:pt idx="748">
                  <c:v>0.87227254943269028</c:v>
                </c:pt>
                <c:pt idx="749">
                  <c:v>0.85313148945134976</c:v>
                </c:pt>
                <c:pt idx="750">
                  <c:v>0.87790050260330454</c:v>
                </c:pt>
                <c:pt idx="751">
                  <c:v>0.88455171998675775</c:v>
                </c:pt>
                <c:pt idx="752">
                  <c:v>0.87570349414632676</c:v>
                </c:pt>
                <c:pt idx="753">
                  <c:v>0.8720317813826105</c:v>
                </c:pt>
                <c:pt idx="754">
                  <c:v>0.86968429289433291</c:v>
                </c:pt>
                <c:pt idx="755">
                  <c:v>0.88608661630601615</c:v>
                </c:pt>
                <c:pt idx="756">
                  <c:v>0.87603455021518639</c:v>
                </c:pt>
                <c:pt idx="757">
                  <c:v>0.87741896650314499</c:v>
                </c:pt>
                <c:pt idx="758">
                  <c:v>0.87805098263460435</c:v>
                </c:pt>
                <c:pt idx="759">
                  <c:v>0.888223432750474</c:v>
                </c:pt>
                <c:pt idx="760">
                  <c:v>0.89129322538899092</c:v>
                </c:pt>
                <c:pt idx="761">
                  <c:v>0.88596623228097626</c:v>
                </c:pt>
                <c:pt idx="762">
                  <c:v>0.89442321004002767</c:v>
                </c:pt>
                <c:pt idx="763">
                  <c:v>0.88091010322930152</c:v>
                </c:pt>
                <c:pt idx="764">
                  <c:v>0.8720317813826105</c:v>
                </c:pt>
                <c:pt idx="765">
                  <c:v>0.8822644235110001</c:v>
                </c:pt>
                <c:pt idx="766">
                  <c:v>0.88334787973635898</c:v>
                </c:pt>
                <c:pt idx="767">
                  <c:v>0.89177476148915036</c:v>
                </c:pt>
                <c:pt idx="768">
                  <c:v>0.87952568694134292</c:v>
                </c:pt>
                <c:pt idx="769">
                  <c:v>0.8810304872543413</c:v>
                </c:pt>
                <c:pt idx="770">
                  <c:v>0.86808920456255456</c:v>
                </c:pt>
                <c:pt idx="771">
                  <c:v>0.87949559093508289</c:v>
                </c:pt>
                <c:pt idx="772">
                  <c:v>0.87004544496945257</c:v>
                </c:pt>
                <c:pt idx="773">
                  <c:v>0.88121106329190113</c:v>
                </c:pt>
                <c:pt idx="774">
                  <c:v>0.87841213470972401</c:v>
                </c:pt>
                <c:pt idx="775">
                  <c:v>0.88813314473169414</c:v>
                </c:pt>
                <c:pt idx="776">
                  <c:v>0.87910434285370331</c:v>
                </c:pt>
                <c:pt idx="777">
                  <c:v>0.88578565624341654</c:v>
                </c:pt>
                <c:pt idx="778">
                  <c:v>0.87284437355162969</c:v>
                </c:pt>
                <c:pt idx="779">
                  <c:v>0.88750112860023478</c:v>
                </c:pt>
                <c:pt idx="780">
                  <c:v>0.86805910855629453</c:v>
                </c:pt>
                <c:pt idx="781">
                  <c:v>0.88680892045625548</c:v>
                </c:pt>
                <c:pt idx="782">
                  <c:v>0.88575556023715651</c:v>
                </c:pt>
                <c:pt idx="783">
                  <c:v>0.8763054142715262</c:v>
                </c:pt>
                <c:pt idx="784">
                  <c:v>0.85439552171426847</c:v>
                </c:pt>
                <c:pt idx="785">
                  <c:v>0.8836488397989587</c:v>
                </c:pt>
                <c:pt idx="786">
                  <c:v>0.87790050260330454</c:v>
                </c:pt>
                <c:pt idx="787">
                  <c:v>0.86456797183013812</c:v>
                </c:pt>
                <c:pt idx="788">
                  <c:v>0.89463388208384742</c:v>
                </c:pt>
                <c:pt idx="789">
                  <c:v>0.88978842507599243</c:v>
                </c:pt>
                <c:pt idx="790">
                  <c:v>0.88391970385529839</c:v>
                </c:pt>
                <c:pt idx="791">
                  <c:v>0.88801276070665425</c:v>
                </c:pt>
                <c:pt idx="792">
                  <c:v>0.87678695037168564</c:v>
                </c:pt>
                <c:pt idx="793">
                  <c:v>0.88289643964245945</c:v>
                </c:pt>
                <c:pt idx="794">
                  <c:v>0.87371715773316883</c:v>
                </c:pt>
                <c:pt idx="795">
                  <c:v>0.88154211936076088</c:v>
                </c:pt>
                <c:pt idx="796">
                  <c:v>0.88455171998675775</c:v>
                </c:pt>
                <c:pt idx="797">
                  <c:v>0.89162428145785055</c:v>
                </c:pt>
                <c:pt idx="798">
                  <c:v>0.87428898185210824</c:v>
                </c:pt>
                <c:pt idx="799">
                  <c:v>0.89454359406506756</c:v>
                </c:pt>
                <c:pt idx="800">
                  <c:v>0.86893189273783367</c:v>
                </c:pt>
                <c:pt idx="801">
                  <c:v>0.88999909711981218</c:v>
                </c:pt>
                <c:pt idx="802">
                  <c:v>0.89920847503536283</c:v>
                </c:pt>
                <c:pt idx="803">
                  <c:v>0.87302494958918953</c:v>
                </c:pt>
                <c:pt idx="804">
                  <c:v>0.8771481024468053</c:v>
                </c:pt>
                <c:pt idx="805">
                  <c:v>0.8851837361182171</c:v>
                </c:pt>
                <c:pt idx="806">
                  <c:v>0.87416859782706835</c:v>
                </c:pt>
                <c:pt idx="807">
                  <c:v>0.88000722304150236</c:v>
                </c:pt>
                <c:pt idx="808">
                  <c:v>0.88160231137328071</c:v>
                </c:pt>
                <c:pt idx="809">
                  <c:v>0.86438739579257828</c:v>
                </c:pt>
                <c:pt idx="810">
                  <c:v>0.87997712703524245</c:v>
                </c:pt>
                <c:pt idx="811">
                  <c:v>0.8718813013513107</c:v>
                </c:pt>
                <c:pt idx="812">
                  <c:v>0.88644776838113581</c:v>
                </c:pt>
                <c:pt idx="813">
                  <c:v>0.87949559093508289</c:v>
                </c:pt>
                <c:pt idx="814">
                  <c:v>0.87073765311343188</c:v>
                </c:pt>
                <c:pt idx="815">
                  <c:v>0.87835194269720407</c:v>
                </c:pt>
                <c:pt idx="816">
                  <c:v>0.87112890119481146</c:v>
                </c:pt>
                <c:pt idx="817">
                  <c:v>0.87823155867216418</c:v>
                </c:pt>
                <c:pt idx="818">
                  <c:v>0.88623709633731607</c:v>
                </c:pt>
                <c:pt idx="819">
                  <c:v>0.88328768772383903</c:v>
                </c:pt>
                <c:pt idx="820">
                  <c:v>0.87519186203990729</c:v>
                </c:pt>
                <c:pt idx="821">
                  <c:v>0.8897583290697324</c:v>
                </c:pt>
                <c:pt idx="822">
                  <c:v>0.88443133596171786</c:v>
                </c:pt>
                <c:pt idx="823">
                  <c:v>0.88984861708851237</c:v>
                </c:pt>
                <c:pt idx="824">
                  <c:v>0.87452974990218801</c:v>
                </c:pt>
                <c:pt idx="825">
                  <c:v>0.88262557558611976</c:v>
                </c:pt>
                <c:pt idx="826">
                  <c:v>0.87675685436542572</c:v>
                </c:pt>
                <c:pt idx="827">
                  <c:v>0.88202365546092032</c:v>
                </c:pt>
                <c:pt idx="828">
                  <c:v>0.88855448881933363</c:v>
                </c:pt>
                <c:pt idx="829">
                  <c:v>0.88476239203057749</c:v>
                </c:pt>
                <c:pt idx="830">
                  <c:v>0.88057904716044177</c:v>
                </c:pt>
                <c:pt idx="831">
                  <c:v>0.86667469226833604</c:v>
                </c:pt>
                <c:pt idx="832">
                  <c:v>0.88858458482559366</c:v>
                </c:pt>
                <c:pt idx="833">
                  <c:v>0.87043669305083216</c:v>
                </c:pt>
                <c:pt idx="834">
                  <c:v>0.8779907906220844</c:v>
                </c:pt>
                <c:pt idx="835">
                  <c:v>0.88349835976765878</c:v>
                </c:pt>
                <c:pt idx="836">
                  <c:v>0.87434917386462818</c:v>
                </c:pt>
                <c:pt idx="837">
                  <c:v>0.87537243807746712</c:v>
                </c:pt>
                <c:pt idx="838">
                  <c:v>0.88921660095705302</c:v>
                </c:pt>
                <c:pt idx="839">
                  <c:v>0.88765160863153458</c:v>
                </c:pt>
                <c:pt idx="840">
                  <c:v>0.90074337135462124</c:v>
                </c:pt>
                <c:pt idx="841">
                  <c:v>0.88735064856893486</c:v>
                </c:pt>
                <c:pt idx="842">
                  <c:v>0.89051072922623165</c:v>
                </c:pt>
                <c:pt idx="843">
                  <c:v>0.88376922382399858</c:v>
                </c:pt>
                <c:pt idx="844">
                  <c:v>0.86273211544827999</c:v>
                </c:pt>
                <c:pt idx="845">
                  <c:v>0.89607849038432597</c:v>
                </c:pt>
                <c:pt idx="846">
                  <c:v>0.87847232672224396</c:v>
                </c:pt>
                <c:pt idx="847">
                  <c:v>0.88304691967375926</c:v>
                </c:pt>
                <c:pt idx="848">
                  <c:v>0.87269389352032989</c:v>
                </c:pt>
                <c:pt idx="849">
                  <c:v>0.88623709633731607</c:v>
                </c:pt>
                <c:pt idx="850">
                  <c:v>0.88819333674421408</c:v>
                </c:pt>
                <c:pt idx="851">
                  <c:v>0.88127125530442108</c:v>
                </c:pt>
                <c:pt idx="852">
                  <c:v>0.87723839046558527</c:v>
                </c:pt>
                <c:pt idx="853">
                  <c:v>0.8907214012700515</c:v>
                </c:pt>
                <c:pt idx="854">
                  <c:v>0.87275408553284983</c:v>
                </c:pt>
                <c:pt idx="855">
                  <c:v>0.89243687362686974</c:v>
                </c:pt>
                <c:pt idx="856">
                  <c:v>0.86718632437475551</c:v>
                </c:pt>
                <c:pt idx="857">
                  <c:v>0.88148192734824093</c:v>
                </c:pt>
                <c:pt idx="858">
                  <c:v>0.88253528756733979</c:v>
                </c:pt>
                <c:pt idx="859">
                  <c:v>0.88834381677551388</c:v>
                </c:pt>
                <c:pt idx="860">
                  <c:v>0.8907214012700515</c:v>
                </c:pt>
                <c:pt idx="861">
                  <c:v>0.89060101724501162</c:v>
                </c:pt>
                <c:pt idx="862">
                  <c:v>0.88951756101965274</c:v>
                </c:pt>
                <c:pt idx="863">
                  <c:v>0.87158034128871098</c:v>
                </c:pt>
                <c:pt idx="864">
                  <c:v>0.87979655099768261</c:v>
                </c:pt>
                <c:pt idx="865">
                  <c:v>0.89728233063472473</c:v>
                </c:pt>
                <c:pt idx="866">
                  <c:v>0.87149005326993112</c:v>
                </c:pt>
                <c:pt idx="867">
                  <c:v>0.88756132061275472</c:v>
                </c:pt>
                <c:pt idx="868">
                  <c:v>0.89415234598368798</c:v>
                </c:pt>
                <c:pt idx="869">
                  <c:v>0.8778403105907846</c:v>
                </c:pt>
                <c:pt idx="870">
                  <c:v>0.87820146266590426</c:v>
                </c:pt>
                <c:pt idx="871">
                  <c:v>0.90164625154242029</c:v>
                </c:pt>
                <c:pt idx="872">
                  <c:v>0.87091822915099171</c:v>
                </c:pt>
                <c:pt idx="873">
                  <c:v>0.86682517229963585</c:v>
                </c:pt>
                <c:pt idx="874">
                  <c:v>0.88605652029975623</c:v>
                </c:pt>
                <c:pt idx="875">
                  <c:v>0.88382941583651853</c:v>
                </c:pt>
                <c:pt idx="876">
                  <c:v>0.87194149336383064</c:v>
                </c:pt>
                <c:pt idx="877">
                  <c:v>0.88250519156107987</c:v>
                </c:pt>
                <c:pt idx="878">
                  <c:v>0.87871309477232373</c:v>
                </c:pt>
                <c:pt idx="879">
                  <c:v>0.87895386282240351</c:v>
                </c:pt>
                <c:pt idx="880">
                  <c:v>0.88888554488819338</c:v>
                </c:pt>
                <c:pt idx="881">
                  <c:v>0.87672675835916569</c:v>
                </c:pt>
                <c:pt idx="882">
                  <c:v>0.87817136665964424</c:v>
                </c:pt>
                <c:pt idx="883">
                  <c:v>0.88717007253137503</c:v>
                </c:pt>
                <c:pt idx="884">
                  <c:v>0.88530412014325699</c:v>
                </c:pt>
                <c:pt idx="885">
                  <c:v>0.88542450416829688</c:v>
                </c:pt>
                <c:pt idx="886">
                  <c:v>0.88542450416829688</c:v>
                </c:pt>
                <c:pt idx="887">
                  <c:v>0.88885544888193335</c:v>
                </c:pt>
                <c:pt idx="888">
                  <c:v>0.86754747644987507</c:v>
                </c:pt>
                <c:pt idx="889">
                  <c:v>0.87410840581454841</c:v>
                </c:pt>
                <c:pt idx="890">
                  <c:v>0.8907214012700515</c:v>
                </c:pt>
                <c:pt idx="891">
                  <c:v>0.88042856712914197</c:v>
                </c:pt>
                <c:pt idx="892">
                  <c:v>0.88840400878803383</c:v>
                </c:pt>
                <c:pt idx="893">
                  <c:v>0.88283624762993951</c:v>
                </c:pt>
                <c:pt idx="894">
                  <c:v>0.88611671231227618</c:v>
                </c:pt>
                <c:pt idx="895">
                  <c:v>0.88650796039365576</c:v>
                </c:pt>
                <c:pt idx="896">
                  <c:v>0.89562705029042644</c:v>
                </c:pt>
                <c:pt idx="897">
                  <c:v>0.89773377072862426</c:v>
                </c:pt>
                <c:pt idx="898">
                  <c:v>0.88677882444999545</c:v>
                </c:pt>
                <c:pt idx="899">
                  <c:v>0.87919463087248317</c:v>
                </c:pt>
                <c:pt idx="900">
                  <c:v>0.89102236133265111</c:v>
                </c:pt>
                <c:pt idx="901">
                  <c:v>0.89008938513859215</c:v>
                </c:pt>
                <c:pt idx="902">
                  <c:v>0.88560508020585671</c:v>
                </c:pt>
                <c:pt idx="903">
                  <c:v>0.87549282210250701</c:v>
                </c:pt>
                <c:pt idx="904">
                  <c:v>0.89388148192734829</c:v>
                </c:pt>
                <c:pt idx="905">
                  <c:v>0.88894573690071332</c:v>
                </c:pt>
                <c:pt idx="906">
                  <c:v>0.88957775303217268</c:v>
                </c:pt>
                <c:pt idx="907">
                  <c:v>0.86796882053751467</c:v>
                </c:pt>
                <c:pt idx="908">
                  <c:v>0.89216600957052994</c:v>
                </c:pt>
                <c:pt idx="909">
                  <c:v>0.89637945044692569</c:v>
                </c:pt>
                <c:pt idx="910">
                  <c:v>0.89367080988352843</c:v>
                </c:pt>
                <c:pt idx="911">
                  <c:v>0.88900592891323327</c:v>
                </c:pt>
                <c:pt idx="912">
                  <c:v>0.90242874770517956</c:v>
                </c:pt>
                <c:pt idx="913">
                  <c:v>0.88142173533572099</c:v>
                </c:pt>
                <c:pt idx="914">
                  <c:v>0.88849429680681369</c:v>
                </c:pt>
                <c:pt idx="915">
                  <c:v>0.88780208866283439</c:v>
                </c:pt>
                <c:pt idx="916">
                  <c:v>0.89132332139525083</c:v>
                </c:pt>
                <c:pt idx="917">
                  <c:v>0.88912631293827304</c:v>
                </c:pt>
                <c:pt idx="918">
                  <c:v>0.88334787973635898</c:v>
                </c:pt>
                <c:pt idx="919">
                  <c:v>0.8879525686941343</c:v>
                </c:pt>
                <c:pt idx="920">
                  <c:v>0.88810304872543411</c:v>
                </c:pt>
                <c:pt idx="921">
                  <c:v>0.89033015318867181</c:v>
                </c:pt>
                <c:pt idx="922">
                  <c:v>0.90486652421223701</c:v>
                </c:pt>
                <c:pt idx="923">
                  <c:v>0.89385138592108826</c:v>
                </c:pt>
                <c:pt idx="924">
                  <c:v>0.90561892436873626</c:v>
                </c:pt>
                <c:pt idx="925">
                  <c:v>0.89439311403376776</c:v>
                </c:pt>
                <c:pt idx="926">
                  <c:v>0.90227826767387964</c:v>
                </c:pt>
                <c:pt idx="927">
                  <c:v>0.88894573690071332</c:v>
                </c:pt>
                <c:pt idx="928">
                  <c:v>0.88163240737954074</c:v>
                </c:pt>
                <c:pt idx="929">
                  <c:v>0.89312908177084904</c:v>
                </c:pt>
                <c:pt idx="930">
                  <c:v>0.89770367472236434</c:v>
                </c:pt>
                <c:pt idx="931">
                  <c:v>0.90486652421223701</c:v>
                </c:pt>
                <c:pt idx="932">
                  <c:v>0.8925271616456496</c:v>
                </c:pt>
                <c:pt idx="933">
                  <c:v>0.89493484214644714</c:v>
                </c:pt>
                <c:pt idx="934">
                  <c:v>0.88804285671291416</c:v>
                </c:pt>
                <c:pt idx="935">
                  <c:v>0.8850332560869173</c:v>
                </c:pt>
                <c:pt idx="936">
                  <c:v>0.88840400878803383</c:v>
                </c:pt>
                <c:pt idx="937">
                  <c:v>0.88828362476299394</c:v>
                </c:pt>
                <c:pt idx="938">
                  <c:v>0.89860655491016339</c:v>
                </c:pt>
                <c:pt idx="939">
                  <c:v>0.90119481144852076</c:v>
                </c:pt>
                <c:pt idx="940">
                  <c:v>0.89388148192734829</c:v>
                </c:pt>
                <c:pt idx="941">
                  <c:v>0.90817708490083371</c:v>
                </c:pt>
                <c:pt idx="942">
                  <c:v>0.89677069852830527</c:v>
                </c:pt>
                <c:pt idx="943">
                  <c:v>0.90146567550486045</c:v>
                </c:pt>
                <c:pt idx="944">
                  <c:v>0.90300057182411897</c:v>
                </c:pt>
                <c:pt idx="945">
                  <c:v>0.90260932374273939</c:v>
                </c:pt>
                <c:pt idx="946">
                  <c:v>0.89731242664098476</c:v>
                </c:pt>
                <c:pt idx="947">
                  <c:v>0.90778583681945402</c:v>
                </c:pt>
                <c:pt idx="948">
                  <c:v>0.90351220393053844</c:v>
                </c:pt>
                <c:pt idx="949">
                  <c:v>0.88292653564871937</c:v>
                </c:pt>
                <c:pt idx="950">
                  <c:v>0.90131519547356065</c:v>
                </c:pt>
                <c:pt idx="951">
                  <c:v>0.89406205796490801</c:v>
                </c:pt>
                <c:pt idx="952">
                  <c:v>0.90197730761128003</c:v>
                </c:pt>
                <c:pt idx="953">
                  <c:v>0.89776386673488429</c:v>
                </c:pt>
                <c:pt idx="954">
                  <c:v>0.91431667017786744</c:v>
                </c:pt>
                <c:pt idx="955">
                  <c:v>0.90176663556746017</c:v>
                </c:pt>
                <c:pt idx="956">
                  <c:v>0.92030577542360126</c:v>
                </c:pt>
                <c:pt idx="957">
                  <c:v>0.9056791163812562</c:v>
                </c:pt>
                <c:pt idx="958">
                  <c:v>0.90805670087579382</c:v>
                </c:pt>
                <c:pt idx="959">
                  <c:v>0.90643151653775544</c:v>
                </c:pt>
                <c:pt idx="960">
                  <c:v>0.89484455412766728</c:v>
                </c:pt>
                <c:pt idx="961">
                  <c:v>0.87615493424022628</c:v>
                </c:pt>
                <c:pt idx="962">
                  <c:v>0.89610858639058599</c:v>
                </c:pt>
                <c:pt idx="963">
                  <c:v>0.89932885906040272</c:v>
                </c:pt>
                <c:pt idx="964">
                  <c:v>0.88602642429349621</c:v>
                </c:pt>
                <c:pt idx="965">
                  <c:v>0.8958377223342463</c:v>
                </c:pt>
                <c:pt idx="966">
                  <c:v>0.8930688897583291</c:v>
                </c:pt>
                <c:pt idx="967">
                  <c:v>0.90549854034369637</c:v>
                </c:pt>
                <c:pt idx="968">
                  <c:v>0.89746290667228457</c:v>
                </c:pt>
                <c:pt idx="969">
                  <c:v>0.90375297198061821</c:v>
                </c:pt>
                <c:pt idx="970">
                  <c:v>0.90384325999939807</c:v>
                </c:pt>
                <c:pt idx="971">
                  <c:v>0.90826737291961357</c:v>
                </c:pt>
                <c:pt idx="972">
                  <c:v>0.89890751497276311</c:v>
                </c:pt>
                <c:pt idx="973">
                  <c:v>0.90414422006199779</c:v>
                </c:pt>
                <c:pt idx="974">
                  <c:v>0.90101423541096093</c:v>
                </c:pt>
                <c:pt idx="975">
                  <c:v>0.91088572546423086</c:v>
                </c:pt>
                <c:pt idx="976">
                  <c:v>0.91723598278508445</c:v>
                </c:pt>
                <c:pt idx="977">
                  <c:v>0.8983356908538237</c:v>
                </c:pt>
                <c:pt idx="978">
                  <c:v>0.91708550275378453</c:v>
                </c:pt>
                <c:pt idx="979">
                  <c:v>0.90823727691335365</c:v>
                </c:pt>
                <c:pt idx="980">
                  <c:v>0.92801035302615342</c:v>
                </c:pt>
                <c:pt idx="981">
                  <c:v>0.92864236915761278</c:v>
                </c:pt>
                <c:pt idx="982">
                  <c:v>0.89914828302284289</c:v>
                </c:pt>
                <c:pt idx="983">
                  <c:v>0.92265326391187885</c:v>
                </c:pt>
                <c:pt idx="984">
                  <c:v>0.91172841363951007</c:v>
                </c:pt>
                <c:pt idx="985">
                  <c:v>0.90020164324194174</c:v>
                </c:pt>
                <c:pt idx="986">
                  <c:v>0.92373672013723784</c:v>
                </c:pt>
                <c:pt idx="987">
                  <c:v>0.9065218045565353</c:v>
                </c:pt>
                <c:pt idx="988">
                  <c:v>0.89511541818400697</c:v>
                </c:pt>
                <c:pt idx="989">
                  <c:v>0.88717007253137503</c:v>
                </c:pt>
                <c:pt idx="990">
                  <c:v>0.90700334065669486</c:v>
                </c:pt>
                <c:pt idx="991">
                  <c:v>0.89174466548289044</c:v>
                </c:pt>
                <c:pt idx="992">
                  <c:v>0.91305263791494873</c:v>
                </c:pt>
                <c:pt idx="993">
                  <c:v>0.91172841363951007</c:v>
                </c:pt>
                <c:pt idx="994">
                  <c:v>0.89261744966442957</c:v>
                </c:pt>
                <c:pt idx="995">
                  <c:v>0.90829746892587349</c:v>
                </c:pt>
                <c:pt idx="996">
                  <c:v>0.89138351340777078</c:v>
                </c:pt>
                <c:pt idx="997">
                  <c:v>0.90254913173021944</c:v>
                </c:pt>
                <c:pt idx="998">
                  <c:v>0.90008125921690196</c:v>
                </c:pt>
                <c:pt idx="999">
                  <c:v>0.93204321786498934</c:v>
                </c:pt>
                <c:pt idx="1000">
                  <c:v>0.92196105576789955</c:v>
                </c:pt>
                <c:pt idx="1001">
                  <c:v>0.91868059108556299</c:v>
                </c:pt>
                <c:pt idx="1002">
                  <c:v>0.91106630150179069</c:v>
                </c:pt>
                <c:pt idx="1003">
                  <c:v>0.92373672013723784</c:v>
                </c:pt>
                <c:pt idx="1004">
                  <c:v>0.90625094050019561</c:v>
                </c:pt>
                <c:pt idx="1005">
                  <c:v>0.90965178920757217</c:v>
                </c:pt>
                <c:pt idx="1006">
                  <c:v>0.92704728082583443</c:v>
                </c:pt>
                <c:pt idx="1007">
                  <c:v>0.91239052577722934</c:v>
                </c:pt>
                <c:pt idx="1008">
                  <c:v>0.90510729226231679</c:v>
                </c:pt>
                <c:pt idx="1009">
                  <c:v>0.91552051042826621</c:v>
                </c:pt>
                <c:pt idx="1010">
                  <c:v>0.91109639750805071</c:v>
                </c:pt>
                <c:pt idx="1011">
                  <c:v>0.91272158184608898</c:v>
                </c:pt>
                <c:pt idx="1012">
                  <c:v>0.91765732687272394</c:v>
                </c:pt>
                <c:pt idx="1013">
                  <c:v>0.93114033767719029</c:v>
                </c:pt>
                <c:pt idx="1014">
                  <c:v>0.90790622084449391</c:v>
                </c:pt>
                <c:pt idx="1015">
                  <c:v>0.92000481536100165</c:v>
                </c:pt>
                <c:pt idx="1016">
                  <c:v>0.92545219249405608</c:v>
                </c:pt>
                <c:pt idx="1017">
                  <c:v>0.92150961567400003</c:v>
                </c:pt>
                <c:pt idx="1018">
                  <c:v>0.9167544466849249</c:v>
                </c:pt>
                <c:pt idx="1019">
                  <c:v>0.90381316399313816</c:v>
                </c:pt>
                <c:pt idx="1020">
                  <c:v>0.92172028771781989</c:v>
                </c:pt>
                <c:pt idx="1021">
                  <c:v>0.90339181990549855</c:v>
                </c:pt>
                <c:pt idx="1022">
                  <c:v>0.91780780690402386</c:v>
                </c:pt>
                <c:pt idx="1023">
                  <c:v>0.90182682757998012</c:v>
                </c:pt>
                <c:pt idx="1024">
                  <c:v>0.93098985764589037</c:v>
                </c:pt>
                <c:pt idx="1025">
                  <c:v>0.90137538748608059</c:v>
                </c:pt>
                <c:pt idx="1026">
                  <c:v>0.90676257260661508</c:v>
                </c:pt>
                <c:pt idx="1027">
                  <c:v>0.91386523008396781</c:v>
                </c:pt>
                <c:pt idx="1028">
                  <c:v>0.91248081379600932</c:v>
                </c:pt>
                <c:pt idx="1029">
                  <c:v>0.93508291449724623</c:v>
                </c:pt>
                <c:pt idx="1030">
                  <c:v>0.92957534535167186</c:v>
                </c:pt>
                <c:pt idx="1031">
                  <c:v>0.91537003039696629</c:v>
                </c:pt>
                <c:pt idx="1032">
                  <c:v>0.92611430463177535</c:v>
                </c:pt>
                <c:pt idx="1033">
                  <c:v>0.91630300659102537</c:v>
                </c:pt>
                <c:pt idx="1034">
                  <c:v>0.91636319860354531</c:v>
                </c:pt>
                <c:pt idx="1035">
                  <c:v>0.91278177385860892</c:v>
                </c:pt>
                <c:pt idx="1036">
                  <c:v>0.92500075240015645</c:v>
                </c:pt>
                <c:pt idx="1037">
                  <c:v>0.89926866704788277</c:v>
                </c:pt>
                <c:pt idx="1038">
                  <c:v>0.928401601107533</c:v>
                </c:pt>
                <c:pt idx="1039">
                  <c:v>0.91139735757065032</c:v>
                </c:pt>
                <c:pt idx="1040">
                  <c:v>0.92822102506997317</c:v>
                </c:pt>
                <c:pt idx="1041">
                  <c:v>0.91503897432810666</c:v>
                </c:pt>
                <c:pt idx="1042">
                  <c:v>0.91630300659102537</c:v>
                </c:pt>
                <c:pt idx="1043">
                  <c:v>0.91546031841574627</c:v>
                </c:pt>
                <c:pt idx="1044">
                  <c:v>0.91524964637192641</c:v>
                </c:pt>
                <c:pt idx="1045">
                  <c:v>0.92843169711379303</c:v>
                </c:pt>
                <c:pt idx="1046">
                  <c:v>0.91537003039696629</c:v>
                </c:pt>
                <c:pt idx="1047">
                  <c:v>0.9174466548289042</c:v>
                </c:pt>
                <c:pt idx="1048">
                  <c:v>0.91242062178348937</c:v>
                </c:pt>
                <c:pt idx="1049">
                  <c:v>0.92135913564270022</c:v>
                </c:pt>
                <c:pt idx="1050">
                  <c:v>0.90086375537966112</c:v>
                </c:pt>
                <c:pt idx="1051">
                  <c:v>0.93026755349565116</c:v>
                </c:pt>
                <c:pt idx="1052">
                  <c:v>0.91263129382730912</c:v>
                </c:pt>
                <c:pt idx="1053">
                  <c:v>0.92364643211845787</c:v>
                </c:pt>
                <c:pt idx="1054">
                  <c:v>0.91449724621542716</c:v>
                </c:pt>
                <c:pt idx="1055">
                  <c:v>0.92006500737352148</c:v>
                </c:pt>
                <c:pt idx="1056">
                  <c:v>0.93249465795888886</c:v>
                </c:pt>
                <c:pt idx="1057">
                  <c:v>0.91139735757065032</c:v>
                </c:pt>
                <c:pt idx="1058">
                  <c:v>0.92590363258795561</c:v>
                </c:pt>
                <c:pt idx="1059">
                  <c:v>0.91476811027176697</c:v>
                </c:pt>
                <c:pt idx="1060">
                  <c:v>0.91332350197128842</c:v>
                </c:pt>
                <c:pt idx="1061">
                  <c:v>0.9095615011887922</c:v>
                </c:pt>
                <c:pt idx="1062">
                  <c:v>0.92918409727029228</c:v>
                </c:pt>
                <c:pt idx="1063">
                  <c:v>0.90534806031239656</c:v>
                </c:pt>
                <c:pt idx="1064">
                  <c:v>0.9227134559243988</c:v>
                </c:pt>
                <c:pt idx="1065">
                  <c:v>0.91567099045956601</c:v>
                </c:pt>
                <c:pt idx="1066">
                  <c:v>0.93002678544557138</c:v>
                </c:pt>
                <c:pt idx="1067">
                  <c:v>0.92003491136726157</c:v>
                </c:pt>
                <c:pt idx="1068">
                  <c:v>0.93839347518584282</c:v>
                </c:pt>
                <c:pt idx="1069">
                  <c:v>0.93234417792758906</c:v>
                </c:pt>
                <c:pt idx="1070">
                  <c:v>0.93493243446594632</c:v>
                </c:pt>
                <c:pt idx="1071">
                  <c:v>0.92671622475697479</c:v>
                </c:pt>
                <c:pt idx="1072">
                  <c:v>0.94624853281969479</c:v>
                </c:pt>
                <c:pt idx="1073">
                  <c:v>0.91479820627802688</c:v>
                </c:pt>
                <c:pt idx="1074">
                  <c:v>0.92015529539230145</c:v>
                </c:pt>
                <c:pt idx="1075">
                  <c:v>0.9282511210762332</c:v>
                </c:pt>
                <c:pt idx="1076">
                  <c:v>0.91446715020916725</c:v>
                </c:pt>
                <c:pt idx="1077">
                  <c:v>0.91825924699792338</c:v>
                </c:pt>
                <c:pt idx="1078">
                  <c:v>0.93956721942998167</c:v>
                </c:pt>
                <c:pt idx="1079">
                  <c:v>0.94685045294489423</c:v>
                </c:pt>
                <c:pt idx="1080">
                  <c:v>0.91988443133596176</c:v>
                </c:pt>
                <c:pt idx="1081">
                  <c:v>0.91979414331718179</c:v>
                </c:pt>
                <c:pt idx="1082">
                  <c:v>0.92421825623739728</c:v>
                </c:pt>
                <c:pt idx="1083">
                  <c:v>0.9343606103470069</c:v>
                </c:pt>
                <c:pt idx="1084">
                  <c:v>0.93092966563337043</c:v>
                </c:pt>
                <c:pt idx="1085">
                  <c:v>0.93941673939868175</c:v>
                </c:pt>
                <c:pt idx="1086">
                  <c:v>0.93111024167093026</c:v>
                </c:pt>
                <c:pt idx="1087">
                  <c:v>0.92075721551750078</c:v>
                </c:pt>
                <c:pt idx="1088">
                  <c:v>0.93243446594636892</c:v>
                </c:pt>
                <c:pt idx="1089">
                  <c:v>0.93375869022180757</c:v>
                </c:pt>
                <c:pt idx="1090">
                  <c:v>0.93387907424684746</c:v>
                </c:pt>
                <c:pt idx="1091">
                  <c:v>0.94025942757396097</c:v>
                </c:pt>
                <c:pt idx="1092">
                  <c:v>0.91317302193998862</c:v>
                </c:pt>
                <c:pt idx="1093">
                  <c:v>0.93700905889788422</c:v>
                </c:pt>
                <c:pt idx="1094">
                  <c:v>0.94095163571794027</c:v>
                </c:pt>
                <c:pt idx="1095">
                  <c:v>0.92915400126403225</c:v>
                </c:pt>
                <c:pt idx="1096">
                  <c:v>0.93977789147380142</c:v>
                </c:pt>
                <c:pt idx="1097">
                  <c:v>0.92798025701989351</c:v>
                </c:pt>
                <c:pt idx="1098">
                  <c:v>0.92740843290095409</c:v>
                </c:pt>
                <c:pt idx="1099">
                  <c:v>0.93303638607156836</c:v>
                </c:pt>
                <c:pt idx="1100">
                  <c:v>0.92144942366148008</c:v>
                </c:pt>
                <c:pt idx="1101">
                  <c:v>0.92400758419357754</c:v>
                </c:pt>
                <c:pt idx="1102">
                  <c:v>0.93821289914828299</c:v>
                </c:pt>
                <c:pt idx="1103">
                  <c:v>0.93959731543624159</c:v>
                </c:pt>
                <c:pt idx="1104">
                  <c:v>0.93348782616546788</c:v>
                </c:pt>
                <c:pt idx="1105">
                  <c:v>0.91413609414030761</c:v>
                </c:pt>
                <c:pt idx="1106">
                  <c:v>0.92358624010593793</c:v>
                </c:pt>
                <c:pt idx="1107">
                  <c:v>0.91488849429680685</c:v>
                </c:pt>
                <c:pt idx="1108">
                  <c:v>0.92641526469437507</c:v>
                </c:pt>
                <c:pt idx="1109">
                  <c:v>0.93312667409034822</c:v>
                </c:pt>
                <c:pt idx="1110">
                  <c:v>0.93228398591506911</c:v>
                </c:pt>
                <c:pt idx="1111">
                  <c:v>0.91711559876004456</c:v>
                </c:pt>
                <c:pt idx="1112">
                  <c:v>0.92897342522647242</c:v>
                </c:pt>
                <c:pt idx="1113">
                  <c:v>0.94089144370542033</c:v>
                </c:pt>
                <c:pt idx="1114">
                  <c:v>0.940169139555181</c:v>
                </c:pt>
                <c:pt idx="1115">
                  <c:v>0.93706925091040416</c:v>
                </c:pt>
                <c:pt idx="1116">
                  <c:v>0.94651939687603459</c:v>
                </c:pt>
                <c:pt idx="1117">
                  <c:v>0.93354801817798783</c:v>
                </c:pt>
                <c:pt idx="1118">
                  <c:v>0.94047009961778072</c:v>
                </c:pt>
                <c:pt idx="1119">
                  <c:v>0.9380925151232431</c:v>
                </c:pt>
                <c:pt idx="1120">
                  <c:v>0.93077918560207062</c:v>
                </c:pt>
                <c:pt idx="1121">
                  <c:v>0.93571493062870559</c:v>
                </c:pt>
                <c:pt idx="1122">
                  <c:v>0.92602401661299549</c:v>
                </c:pt>
                <c:pt idx="1123">
                  <c:v>0.92379691214975768</c:v>
                </c:pt>
                <c:pt idx="1124">
                  <c:v>0.92178047973033983</c:v>
                </c:pt>
                <c:pt idx="1125">
                  <c:v>0.91193908568332982</c:v>
                </c:pt>
                <c:pt idx="1126">
                  <c:v>0.9220212477804195</c:v>
                </c:pt>
                <c:pt idx="1127">
                  <c:v>0.91816895897914341</c:v>
                </c:pt>
                <c:pt idx="1128">
                  <c:v>0.9277093929635537</c:v>
                </c:pt>
                <c:pt idx="1129">
                  <c:v>0.91874078309808294</c:v>
                </c:pt>
                <c:pt idx="1130">
                  <c:v>0.92725795286965418</c:v>
                </c:pt>
                <c:pt idx="1131">
                  <c:v>0.92611430463177535</c:v>
                </c:pt>
                <c:pt idx="1132">
                  <c:v>0.93255484997140881</c:v>
                </c:pt>
                <c:pt idx="1133">
                  <c:v>0.94558642068197551</c:v>
                </c:pt>
                <c:pt idx="1134">
                  <c:v>0.95079302976495017</c:v>
                </c:pt>
                <c:pt idx="1135">
                  <c:v>0.92885304120143253</c:v>
                </c:pt>
                <c:pt idx="1136">
                  <c:v>0.9380925151232431</c:v>
                </c:pt>
                <c:pt idx="1137">
                  <c:v>0.93189273783368942</c:v>
                </c:pt>
                <c:pt idx="1138">
                  <c:v>0.94110211574924008</c:v>
                </c:pt>
                <c:pt idx="1139">
                  <c:v>0.92611430463177535</c:v>
                </c:pt>
                <c:pt idx="1140">
                  <c:v>0.91714569476630448</c:v>
                </c:pt>
                <c:pt idx="1141">
                  <c:v>0.93062870557077071</c:v>
                </c:pt>
                <c:pt idx="1142">
                  <c:v>0.93321696210912808</c:v>
                </c:pt>
                <c:pt idx="1143">
                  <c:v>0.93502272248472629</c:v>
                </c:pt>
                <c:pt idx="1144">
                  <c:v>0.94311854816865803</c:v>
                </c:pt>
                <c:pt idx="1145">
                  <c:v>0.93746049899178374</c:v>
                </c:pt>
                <c:pt idx="1146">
                  <c:v>0.93336744214042799</c:v>
                </c:pt>
                <c:pt idx="1147">
                  <c:v>0.94730189303879375</c:v>
                </c:pt>
                <c:pt idx="1148">
                  <c:v>0.94305835615613809</c:v>
                </c:pt>
                <c:pt idx="1149">
                  <c:v>0.93962741144250161</c:v>
                </c:pt>
                <c:pt idx="1150">
                  <c:v>0.91940289523580221</c:v>
                </c:pt>
                <c:pt idx="1151">
                  <c:v>0.92921419327655219</c:v>
                </c:pt>
                <c:pt idx="1152">
                  <c:v>0.9357450266349655</c:v>
                </c:pt>
                <c:pt idx="1153">
                  <c:v>0.92858217714509284</c:v>
                </c:pt>
                <c:pt idx="1154">
                  <c:v>0.93541397056610587</c:v>
                </c:pt>
                <c:pt idx="1155">
                  <c:v>0.94137297980557977</c:v>
                </c:pt>
                <c:pt idx="1156">
                  <c:v>0.93297619405904841</c:v>
                </c:pt>
                <c:pt idx="1157">
                  <c:v>0.93433051434074699</c:v>
                </c:pt>
                <c:pt idx="1158">
                  <c:v>0.93709934691666419</c:v>
                </c:pt>
                <c:pt idx="1159">
                  <c:v>0.92376681614349776</c:v>
                </c:pt>
                <c:pt idx="1160">
                  <c:v>0.96502844072591565</c:v>
                </c:pt>
                <c:pt idx="1161">
                  <c:v>0.95903933548018183</c:v>
                </c:pt>
                <c:pt idx="1162">
                  <c:v>0.94059048364282061</c:v>
                </c:pt>
                <c:pt idx="1163">
                  <c:v>0.94390104433141719</c:v>
                </c:pt>
                <c:pt idx="1164">
                  <c:v>0.93372859421554755</c:v>
                </c:pt>
                <c:pt idx="1165">
                  <c:v>0.92647545670689502</c:v>
                </c:pt>
                <c:pt idx="1166">
                  <c:v>0.93586541066000539</c:v>
                </c:pt>
                <c:pt idx="1167">
                  <c:v>0.929364673307852</c:v>
                </c:pt>
                <c:pt idx="1168">
                  <c:v>0.93258494597766872</c:v>
                </c:pt>
                <c:pt idx="1169">
                  <c:v>0.94200499593703912</c:v>
                </c:pt>
                <c:pt idx="1170">
                  <c:v>0.95633069491678457</c:v>
                </c:pt>
                <c:pt idx="1171">
                  <c:v>0.94152345983687968</c:v>
                </c:pt>
                <c:pt idx="1172">
                  <c:v>0.9354440665723659</c:v>
                </c:pt>
                <c:pt idx="1173">
                  <c:v>0.93899539531104226</c:v>
                </c:pt>
                <c:pt idx="1174">
                  <c:v>0.94004875553014111</c:v>
                </c:pt>
                <c:pt idx="1175">
                  <c:v>0.9578956872423029</c:v>
                </c:pt>
                <c:pt idx="1176">
                  <c:v>0.94167393986817949</c:v>
                </c:pt>
                <c:pt idx="1177">
                  <c:v>0.93818280314202307</c:v>
                </c:pt>
                <c:pt idx="1178">
                  <c:v>0.93607608270382525</c:v>
                </c:pt>
                <c:pt idx="1179">
                  <c:v>0.95530743070394564</c:v>
                </c:pt>
                <c:pt idx="1180">
                  <c:v>0.94353989225629764</c:v>
                </c:pt>
                <c:pt idx="1181">
                  <c:v>0.9494387094832516</c:v>
                </c:pt>
                <c:pt idx="1182">
                  <c:v>0.9387847232672224</c:v>
                </c:pt>
                <c:pt idx="1183">
                  <c:v>0.93700905889788422</c:v>
                </c:pt>
                <c:pt idx="1184">
                  <c:v>0.94558642068197551</c:v>
                </c:pt>
                <c:pt idx="1185">
                  <c:v>0.95398320642850698</c:v>
                </c:pt>
                <c:pt idx="1186">
                  <c:v>0.94757275709513344</c:v>
                </c:pt>
                <c:pt idx="1187">
                  <c:v>0.95386282240346709</c:v>
                </c:pt>
                <c:pt idx="1188">
                  <c:v>0.94558642068197551</c:v>
                </c:pt>
                <c:pt idx="1189">
                  <c:v>0.96180816805609892</c:v>
                </c:pt>
                <c:pt idx="1190">
                  <c:v>0.95879856743010206</c:v>
                </c:pt>
                <c:pt idx="1191">
                  <c:v>0.95566858277906519</c:v>
                </c:pt>
                <c:pt idx="1192">
                  <c:v>0.95175610196526916</c:v>
                </c:pt>
                <c:pt idx="1193">
                  <c:v>0.95943058356156141</c:v>
                </c:pt>
                <c:pt idx="1194">
                  <c:v>0.94600776476961512</c:v>
                </c:pt>
                <c:pt idx="1195">
                  <c:v>0.94390104433141719</c:v>
                </c:pt>
                <c:pt idx="1196">
                  <c:v>0.96668372107021394</c:v>
                </c:pt>
                <c:pt idx="1197">
                  <c:v>0.93971769946128147</c:v>
                </c:pt>
                <c:pt idx="1198">
                  <c:v>0.94989014957715112</c:v>
                </c:pt>
                <c:pt idx="1199">
                  <c:v>0.94835525325789272</c:v>
                </c:pt>
                <c:pt idx="1200">
                  <c:v>0.94170403587443952</c:v>
                </c:pt>
                <c:pt idx="1201">
                  <c:v>0.95323080627200774</c:v>
                </c:pt>
                <c:pt idx="1202">
                  <c:v>0.9682788094019924</c:v>
                </c:pt>
                <c:pt idx="1203">
                  <c:v>0.9434797002437777</c:v>
                </c:pt>
                <c:pt idx="1204">
                  <c:v>0.97279321034098776</c:v>
                </c:pt>
                <c:pt idx="1205">
                  <c:v>0.96867005748337198</c:v>
                </c:pt>
                <c:pt idx="1206">
                  <c:v>0.95741415114214345</c:v>
                </c:pt>
                <c:pt idx="1207">
                  <c:v>0.96526920877599542</c:v>
                </c:pt>
                <c:pt idx="1208">
                  <c:v>0.96409546453185657</c:v>
                </c:pt>
                <c:pt idx="1209">
                  <c:v>0.95765491919222323</c:v>
                </c:pt>
                <c:pt idx="1210">
                  <c:v>0.96201884009991878</c:v>
                </c:pt>
                <c:pt idx="1211">
                  <c:v>0.94438258043157675</c:v>
                </c:pt>
                <c:pt idx="1212">
                  <c:v>0.94907755740813193</c:v>
                </c:pt>
                <c:pt idx="1213">
                  <c:v>0.95843741535498239</c:v>
                </c:pt>
                <c:pt idx="1214">
                  <c:v>0.9466698769073344</c:v>
                </c:pt>
                <c:pt idx="1215">
                  <c:v>0.95344147831582748</c:v>
                </c:pt>
                <c:pt idx="1216">
                  <c:v>0.94444277244409669</c:v>
                </c:pt>
                <c:pt idx="1217">
                  <c:v>0.96247028019381831</c:v>
                </c:pt>
                <c:pt idx="1218">
                  <c:v>0.95593944683540499</c:v>
                </c:pt>
                <c:pt idx="1219">
                  <c:v>0.95335119029704762</c:v>
                </c:pt>
                <c:pt idx="1220">
                  <c:v>0.9585878953862822</c:v>
                </c:pt>
                <c:pt idx="1221">
                  <c:v>0.95133475787762967</c:v>
                </c:pt>
                <c:pt idx="1222">
                  <c:v>0.95708309507328382</c:v>
                </c:pt>
                <c:pt idx="1223">
                  <c:v>0.95563848677280527</c:v>
                </c:pt>
                <c:pt idx="1224">
                  <c:v>0.95019110963975084</c:v>
                </c:pt>
                <c:pt idx="1225">
                  <c:v>0.96099557588707973</c:v>
                </c:pt>
                <c:pt idx="1226">
                  <c:v>0.95753453516718334</c:v>
                </c:pt>
                <c:pt idx="1227">
                  <c:v>0.9721611942095284</c:v>
                </c:pt>
                <c:pt idx="1228">
                  <c:v>0.95834712733620253</c:v>
                </c:pt>
                <c:pt idx="1229">
                  <c:v>0.96538959280103531</c:v>
                </c:pt>
                <c:pt idx="1230">
                  <c:v>0.95289975020314799</c:v>
                </c:pt>
                <c:pt idx="1231">
                  <c:v>0.95575887079784516</c:v>
                </c:pt>
                <c:pt idx="1232">
                  <c:v>0.97107773798416952</c:v>
                </c:pt>
                <c:pt idx="1233">
                  <c:v>0.95988202365546094</c:v>
                </c:pt>
                <c:pt idx="1234">
                  <c:v>0.9689710175459717</c:v>
                </c:pt>
                <c:pt idx="1235">
                  <c:v>0.94955909350829149</c:v>
                </c:pt>
                <c:pt idx="1236">
                  <c:v>0.94618834080717484</c:v>
                </c:pt>
                <c:pt idx="1237">
                  <c:v>0.96933216962109126</c:v>
                </c:pt>
                <c:pt idx="1238">
                  <c:v>0.95350167032834743</c:v>
                </c:pt>
                <c:pt idx="1239">
                  <c:v>0.95918981551148164</c:v>
                </c:pt>
                <c:pt idx="1240">
                  <c:v>0.96340325638787738</c:v>
                </c:pt>
                <c:pt idx="1241">
                  <c:v>0.97321455442862737</c:v>
                </c:pt>
                <c:pt idx="1242">
                  <c:v>0.94829506124537277</c:v>
                </c:pt>
                <c:pt idx="1243">
                  <c:v>0.95828693532368259</c:v>
                </c:pt>
                <c:pt idx="1244">
                  <c:v>0.9317121617961297</c:v>
                </c:pt>
                <c:pt idx="1245">
                  <c:v>0.96328287236283749</c:v>
                </c:pt>
                <c:pt idx="1246">
                  <c:v>0.95873837541758211</c:v>
                </c:pt>
                <c:pt idx="1247">
                  <c:v>0.94859602130797238</c:v>
                </c:pt>
                <c:pt idx="1248">
                  <c:v>0.94853582929545255</c:v>
                </c:pt>
                <c:pt idx="1249">
                  <c:v>0.95921991151774155</c:v>
                </c:pt>
                <c:pt idx="1250">
                  <c:v>0.9508231257712102</c:v>
                </c:pt>
                <c:pt idx="1251">
                  <c:v>0.9555481987540253</c:v>
                </c:pt>
                <c:pt idx="1252">
                  <c:v>0.96316248833779761</c:v>
                </c:pt>
                <c:pt idx="1253">
                  <c:v>0.95846751136124231</c:v>
                </c:pt>
                <c:pt idx="1254">
                  <c:v>0.95774520721100309</c:v>
                </c:pt>
                <c:pt idx="1255">
                  <c:v>0.95798597526108287</c:v>
                </c:pt>
                <c:pt idx="1256">
                  <c:v>0.94269720408101843</c:v>
                </c:pt>
                <c:pt idx="1257">
                  <c:v>0.95590935082914497</c:v>
                </c:pt>
                <c:pt idx="1258">
                  <c:v>0.95380263039094715</c:v>
                </c:pt>
                <c:pt idx="1259">
                  <c:v>0.96216932013121859</c:v>
                </c:pt>
                <c:pt idx="1260">
                  <c:v>0.96502844072591565</c:v>
                </c:pt>
                <c:pt idx="1261">
                  <c:v>0.95931019953652152</c:v>
                </c:pt>
                <c:pt idx="1262">
                  <c:v>0.96493815270713579</c:v>
                </c:pt>
                <c:pt idx="1263">
                  <c:v>0.96842928943329221</c:v>
                </c:pt>
                <c:pt idx="1264">
                  <c:v>0.96063442381196018</c:v>
                </c:pt>
                <c:pt idx="1265">
                  <c:v>0.94877659734553221</c:v>
                </c:pt>
                <c:pt idx="1266">
                  <c:v>0.95943058356156141</c:v>
                </c:pt>
                <c:pt idx="1267">
                  <c:v>0.97267282631594787</c:v>
                </c:pt>
                <c:pt idx="1268">
                  <c:v>0.9613567279621994</c:v>
                </c:pt>
                <c:pt idx="1269">
                  <c:v>0.96541968880729523</c:v>
                </c:pt>
                <c:pt idx="1270">
                  <c:v>0.95982183164294099</c:v>
                </c:pt>
                <c:pt idx="1271">
                  <c:v>0.95271917416558827</c:v>
                </c:pt>
                <c:pt idx="1272">
                  <c:v>0.94248653203719868</c:v>
                </c:pt>
                <c:pt idx="1273">
                  <c:v>0.96436632858819638</c:v>
                </c:pt>
                <c:pt idx="1274">
                  <c:v>0.96322268035031755</c:v>
                </c:pt>
                <c:pt idx="1275">
                  <c:v>0.97101754597164958</c:v>
                </c:pt>
                <c:pt idx="1276">
                  <c:v>0.9707767779215698</c:v>
                </c:pt>
                <c:pt idx="1277">
                  <c:v>0.96629247298883436</c:v>
                </c:pt>
                <c:pt idx="1278">
                  <c:v>0.95434435850362653</c:v>
                </c:pt>
                <c:pt idx="1279">
                  <c:v>0.96228970415625847</c:v>
                </c:pt>
                <c:pt idx="1280">
                  <c:v>0.93595569867878536</c:v>
                </c:pt>
                <c:pt idx="1281">
                  <c:v>0.94284768411231834</c:v>
                </c:pt>
                <c:pt idx="1282">
                  <c:v>0.96253047220633825</c:v>
                </c:pt>
                <c:pt idx="1283">
                  <c:v>0.97234177024708823</c:v>
                </c:pt>
                <c:pt idx="1284">
                  <c:v>0.95320071026574771</c:v>
                </c:pt>
                <c:pt idx="1285">
                  <c:v>0.97327474644114731</c:v>
                </c:pt>
                <c:pt idx="1286">
                  <c:v>0.96650314503265422</c:v>
                </c:pt>
                <c:pt idx="1287">
                  <c:v>0.97258253829716801</c:v>
                </c:pt>
                <c:pt idx="1288">
                  <c:v>0.98465103680741561</c:v>
                </c:pt>
                <c:pt idx="1289">
                  <c:v>0.9746591627291058</c:v>
                </c:pt>
                <c:pt idx="1290">
                  <c:v>0.95909952749270166</c:v>
                </c:pt>
                <c:pt idx="1291">
                  <c:v>0.99184398230354831</c:v>
                </c:pt>
                <c:pt idx="1292">
                  <c:v>0.97059620188400997</c:v>
                </c:pt>
                <c:pt idx="1293">
                  <c:v>0.95076293375869025</c:v>
                </c:pt>
                <c:pt idx="1294">
                  <c:v>0.95326090227826765</c:v>
                </c:pt>
                <c:pt idx="1295">
                  <c:v>0.9533210942907876</c:v>
                </c:pt>
                <c:pt idx="1296">
                  <c:v>0.92954524934541183</c:v>
                </c:pt>
                <c:pt idx="1297">
                  <c:v>0.944171908387757</c:v>
                </c:pt>
                <c:pt idx="1298">
                  <c:v>0.96027327173684052</c:v>
                </c:pt>
                <c:pt idx="1299">
                  <c:v>0.96520901676347548</c:v>
                </c:pt>
                <c:pt idx="1300">
                  <c:v>0.95229783007794866</c:v>
                </c:pt>
                <c:pt idx="1301">
                  <c:v>0.96298191230023777</c:v>
                </c:pt>
                <c:pt idx="1302">
                  <c:v>0.95052216570861048</c:v>
                </c:pt>
                <c:pt idx="1303">
                  <c:v>0.96857976946459201</c:v>
                </c:pt>
                <c:pt idx="1304">
                  <c:v>0.96298191230023777</c:v>
                </c:pt>
                <c:pt idx="1305">
                  <c:v>0.97754837933006289</c:v>
                </c:pt>
                <c:pt idx="1306">
                  <c:v>0.97447858669154608</c:v>
                </c:pt>
                <c:pt idx="1307">
                  <c:v>0.96201884009991878</c:v>
                </c:pt>
                <c:pt idx="1308">
                  <c:v>0.95828693532368259</c:v>
                </c:pt>
                <c:pt idx="1309">
                  <c:v>0.95181629397778911</c:v>
                </c:pt>
                <c:pt idx="1310">
                  <c:v>0.9380925151232431</c:v>
                </c:pt>
                <c:pt idx="1311">
                  <c:v>0.94050019562404064</c:v>
                </c:pt>
                <c:pt idx="1312">
                  <c:v>0.9461281487946549</c:v>
                </c:pt>
                <c:pt idx="1313">
                  <c:v>0.94910765341439196</c:v>
                </c:pt>
                <c:pt idx="1314">
                  <c:v>0.96210912811869864</c:v>
                </c:pt>
                <c:pt idx="1315">
                  <c:v>0.96162759201853909</c:v>
                </c:pt>
                <c:pt idx="1316">
                  <c:v>0.95422397447858665</c:v>
                </c:pt>
                <c:pt idx="1317">
                  <c:v>0.97246215427212812</c:v>
                </c:pt>
                <c:pt idx="1318">
                  <c:v>0.95365215035964723</c:v>
                </c:pt>
                <c:pt idx="1319">
                  <c:v>0.96301200830649769</c:v>
                </c:pt>
                <c:pt idx="1320">
                  <c:v>0.96463719264453607</c:v>
                </c:pt>
                <c:pt idx="1321">
                  <c:v>0.95976163963042105</c:v>
                </c:pt>
                <c:pt idx="1322">
                  <c:v>0.96253047220633825</c:v>
                </c:pt>
                <c:pt idx="1323">
                  <c:v>0.96177807204983901</c:v>
                </c:pt>
                <c:pt idx="1324">
                  <c:v>0.95268907815932824</c:v>
                </c:pt>
                <c:pt idx="1325">
                  <c:v>0.95925000752400158</c:v>
                </c:pt>
                <c:pt idx="1326">
                  <c:v>0.94859602130797238</c:v>
                </c:pt>
                <c:pt idx="1327">
                  <c:v>0.96557016883859514</c:v>
                </c:pt>
                <c:pt idx="1328">
                  <c:v>0.95774520721100309</c:v>
                </c:pt>
                <c:pt idx="1329">
                  <c:v>0.96349354440665724</c:v>
                </c:pt>
                <c:pt idx="1330">
                  <c:v>0.94979986155837115</c:v>
                </c:pt>
                <c:pt idx="1331">
                  <c:v>0.95500647064134592</c:v>
                </c:pt>
                <c:pt idx="1332">
                  <c:v>0.94835525325789272</c:v>
                </c:pt>
                <c:pt idx="1333">
                  <c:v>0.9436301802750775</c:v>
                </c:pt>
                <c:pt idx="1334">
                  <c:v>0.95949077557408136</c:v>
                </c:pt>
                <c:pt idx="1335">
                  <c:v>0.95467541457248628</c:v>
                </c:pt>
                <c:pt idx="1336">
                  <c:v>0.95491618262256595</c:v>
                </c:pt>
                <c:pt idx="1337">
                  <c:v>0.95338128630330754</c:v>
                </c:pt>
                <c:pt idx="1338">
                  <c:v>0.96349354440665724</c:v>
                </c:pt>
                <c:pt idx="1339">
                  <c:v>0.96144701598097937</c:v>
                </c:pt>
                <c:pt idx="1340">
                  <c:v>0.97309417040358748</c:v>
                </c:pt>
                <c:pt idx="1341">
                  <c:v>0.97020495380263039</c:v>
                </c:pt>
                <c:pt idx="1342">
                  <c:v>0.96271104824389808</c:v>
                </c:pt>
                <c:pt idx="1343">
                  <c:v>0.96213922412495867</c:v>
                </c:pt>
                <c:pt idx="1344">
                  <c:v>0.97315436241610742</c:v>
                </c:pt>
                <c:pt idx="1345">
                  <c:v>0.96141691997471934</c:v>
                </c:pt>
                <c:pt idx="1346">
                  <c:v>0.96547988081981517</c:v>
                </c:pt>
                <c:pt idx="1347">
                  <c:v>0.96225960814999845</c:v>
                </c:pt>
                <c:pt idx="1348">
                  <c:v>0.96668372107021394</c:v>
                </c:pt>
                <c:pt idx="1349">
                  <c:v>0.96451680861949618</c:v>
                </c:pt>
                <c:pt idx="1350">
                  <c:v>0.94528546061937579</c:v>
                </c:pt>
                <c:pt idx="1351">
                  <c:v>0.96340325638787738</c:v>
                </c:pt>
                <c:pt idx="1352">
                  <c:v>0.94582718873205529</c:v>
                </c:pt>
                <c:pt idx="1353">
                  <c:v>0.94952899750203146</c:v>
                </c:pt>
                <c:pt idx="1354">
                  <c:v>0.93174225780238962</c:v>
                </c:pt>
                <c:pt idx="1355">
                  <c:v>0.97571252294820476</c:v>
                </c:pt>
                <c:pt idx="1356">
                  <c:v>0.98895476570259122</c:v>
                </c:pt>
                <c:pt idx="1357">
                  <c:v>0.94507478857555605</c:v>
                </c:pt>
                <c:pt idx="1358">
                  <c:v>0.98591506907033433</c:v>
                </c:pt>
                <c:pt idx="1359">
                  <c:v>0.96839919342703218</c:v>
                </c:pt>
                <c:pt idx="1360">
                  <c:v>0.95615011887922474</c:v>
                </c:pt>
                <c:pt idx="1361">
                  <c:v>0.98155114816263878</c:v>
                </c:pt>
                <c:pt idx="1362">
                  <c:v>0.95675203900442407</c:v>
                </c:pt>
                <c:pt idx="1363">
                  <c:v>0.96111595991211962</c:v>
                </c:pt>
                <c:pt idx="1364">
                  <c:v>0.97300388238480751</c:v>
                </c:pt>
                <c:pt idx="1365">
                  <c:v>0.96824871339573237</c:v>
                </c:pt>
                <c:pt idx="1366">
                  <c:v>0.94796400517651302</c:v>
                </c:pt>
                <c:pt idx="1367">
                  <c:v>0.94468354049417647</c:v>
                </c:pt>
                <c:pt idx="1368">
                  <c:v>0.9621994161374785</c:v>
                </c:pt>
                <c:pt idx="1369">
                  <c:v>0.9501309176272309</c:v>
                </c:pt>
                <c:pt idx="1370">
                  <c:v>0.97291359436602765</c:v>
                </c:pt>
                <c:pt idx="1371">
                  <c:v>0.97625425106088426</c:v>
                </c:pt>
                <c:pt idx="1372">
                  <c:v>0.97920365967436118</c:v>
                </c:pt>
                <c:pt idx="1373">
                  <c:v>0.9659313209137147</c:v>
                </c:pt>
                <c:pt idx="1374">
                  <c:v>0.96725554518915335</c:v>
                </c:pt>
                <c:pt idx="1375">
                  <c:v>0.96957293767117103</c:v>
                </c:pt>
                <c:pt idx="1376">
                  <c:v>0.97483973876666563</c:v>
                </c:pt>
                <c:pt idx="1377">
                  <c:v>0.98597526108285427</c:v>
                </c:pt>
                <c:pt idx="1378">
                  <c:v>0.96159749601227917</c:v>
                </c:pt>
                <c:pt idx="1379">
                  <c:v>0.97748818731754294</c:v>
                </c:pt>
                <c:pt idx="1380">
                  <c:v>0.97402714659764644</c:v>
                </c:pt>
                <c:pt idx="1381">
                  <c:v>0.9713185060342493</c:v>
                </c:pt>
                <c:pt idx="1382">
                  <c:v>0.98398892466969634</c:v>
                </c:pt>
                <c:pt idx="1383">
                  <c:v>0.98299575646311732</c:v>
                </c:pt>
                <c:pt idx="1384">
                  <c:v>0.96710506515785355</c:v>
                </c:pt>
                <c:pt idx="1385">
                  <c:v>0.97438829867276611</c:v>
                </c:pt>
                <c:pt idx="1386">
                  <c:v>0.97252234628464806</c:v>
                </c:pt>
                <c:pt idx="1387">
                  <c:v>0.96623228097631442</c:v>
                </c:pt>
                <c:pt idx="1388">
                  <c:v>0.97110783399042944</c:v>
                </c:pt>
                <c:pt idx="1389">
                  <c:v>0.97553194691064493</c:v>
                </c:pt>
                <c:pt idx="1390">
                  <c:v>0.98474132482619559</c:v>
                </c:pt>
                <c:pt idx="1391">
                  <c:v>0.98022692388720012</c:v>
                </c:pt>
                <c:pt idx="1392">
                  <c:v>0.96584103289493484</c:v>
                </c:pt>
                <c:pt idx="1393">
                  <c:v>0.96677400908899391</c:v>
                </c:pt>
                <c:pt idx="1394">
                  <c:v>0.98152105215637886</c:v>
                </c:pt>
                <c:pt idx="1395">
                  <c:v>0.97610377102958434</c:v>
                </c:pt>
                <c:pt idx="1396">
                  <c:v>0.97998615583712045</c:v>
                </c:pt>
                <c:pt idx="1397">
                  <c:v>0.96244018418755828</c:v>
                </c:pt>
                <c:pt idx="1398">
                  <c:v>0.94414181238149697</c:v>
                </c:pt>
                <c:pt idx="1399">
                  <c:v>0.96385469648177691</c:v>
                </c:pt>
                <c:pt idx="1400">
                  <c:v>0.94194480392451918</c:v>
                </c:pt>
                <c:pt idx="1401">
                  <c:v>0.96346344840039722</c:v>
                </c:pt>
                <c:pt idx="1402">
                  <c:v>0.96641285701387425</c:v>
                </c:pt>
                <c:pt idx="1403">
                  <c:v>0.97426791464772622</c:v>
                </c:pt>
                <c:pt idx="1404">
                  <c:v>0.97863183555542177</c:v>
                </c:pt>
                <c:pt idx="1405">
                  <c:v>0.99238571041622781</c:v>
                </c:pt>
                <c:pt idx="1406">
                  <c:v>0.96469738465705601</c:v>
                </c:pt>
                <c:pt idx="1407">
                  <c:v>0.96484786468835582</c:v>
                </c:pt>
                <c:pt idx="1408">
                  <c:v>0.96532940078851537</c:v>
                </c:pt>
                <c:pt idx="1409">
                  <c:v>0.97029524182141025</c:v>
                </c:pt>
                <c:pt idx="1410">
                  <c:v>0.96990399374003067</c:v>
                </c:pt>
                <c:pt idx="1411">
                  <c:v>0.97959490775574076</c:v>
                </c:pt>
                <c:pt idx="1412">
                  <c:v>0.95642098293556443</c:v>
                </c:pt>
                <c:pt idx="1413">
                  <c:v>0.96162759201853909</c:v>
                </c:pt>
                <c:pt idx="1414">
                  <c:v>0.95876847142384203</c:v>
                </c:pt>
                <c:pt idx="1415">
                  <c:v>0.97505041081048549</c:v>
                </c:pt>
                <c:pt idx="1416">
                  <c:v>0.97956481174948085</c:v>
                </c:pt>
                <c:pt idx="1417">
                  <c:v>0.96388479248803682</c:v>
                </c:pt>
                <c:pt idx="1418">
                  <c:v>0.97923375568062121</c:v>
                </c:pt>
                <c:pt idx="1419">
                  <c:v>0.98522286092635503</c:v>
                </c:pt>
                <c:pt idx="1420">
                  <c:v>0.97411743461642641</c:v>
                </c:pt>
                <c:pt idx="1421">
                  <c:v>0.97300388238480751</c:v>
                </c:pt>
                <c:pt idx="1422">
                  <c:v>0.97875221958046166</c:v>
                </c:pt>
                <c:pt idx="1423">
                  <c:v>0.96572064886989495</c:v>
                </c:pt>
                <c:pt idx="1424">
                  <c:v>0.95491618262256595</c:v>
                </c:pt>
                <c:pt idx="1425">
                  <c:v>0.95518704667890575</c:v>
                </c:pt>
                <c:pt idx="1426">
                  <c:v>0.96671381707647397</c:v>
                </c:pt>
                <c:pt idx="1427">
                  <c:v>0.9621994161374785</c:v>
                </c:pt>
                <c:pt idx="1428">
                  <c:v>0.96346344840039722</c:v>
                </c:pt>
                <c:pt idx="1429">
                  <c:v>0.9871189093207331</c:v>
                </c:pt>
                <c:pt idx="1430">
                  <c:v>0.96785746531435279</c:v>
                </c:pt>
                <c:pt idx="1431">
                  <c:v>0.97246215427212812</c:v>
                </c:pt>
                <c:pt idx="1432">
                  <c:v>0.98735967737081287</c:v>
                </c:pt>
                <c:pt idx="1433">
                  <c:v>0.98441026875733595</c:v>
                </c:pt>
                <c:pt idx="1434">
                  <c:v>0.9811599000812592</c:v>
                </c:pt>
                <c:pt idx="1435">
                  <c:v>0.99130225419086893</c:v>
                </c:pt>
                <c:pt idx="1436">
                  <c:v>0.96382460047551688</c:v>
                </c:pt>
                <c:pt idx="1437">
                  <c:v>0.96945255364613114</c:v>
                </c:pt>
                <c:pt idx="1438">
                  <c:v>0.9793541397056611</c:v>
                </c:pt>
                <c:pt idx="1439">
                  <c:v>0.96370421645047699</c:v>
                </c:pt>
                <c:pt idx="1440">
                  <c:v>0.97670569115478378</c:v>
                </c:pt>
                <c:pt idx="1441">
                  <c:v>0.96918168958979145</c:v>
                </c:pt>
                <c:pt idx="1442">
                  <c:v>0.97685617118608359</c:v>
                </c:pt>
                <c:pt idx="1443">
                  <c:v>0.98805188551479217</c:v>
                </c:pt>
                <c:pt idx="1444">
                  <c:v>0.97068648990278994</c:v>
                </c:pt>
                <c:pt idx="1445">
                  <c:v>0.95934029554278144</c:v>
                </c:pt>
                <c:pt idx="1446">
                  <c:v>0.95142504589640953</c:v>
                </c:pt>
                <c:pt idx="1447">
                  <c:v>0.94754266108887353</c:v>
                </c:pt>
                <c:pt idx="1448">
                  <c:v>0.97760857134258283</c:v>
                </c:pt>
                <c:pt idx="1449">
                  <c:v>0.97857164354290183</c:v>
                </c:pt>
                <c:pt idx="1450">
                  <c:v>0.977427995305023</c:v>
                </c:pt>
                <c:pt idx="1451">
                  <c:v>0.96108586390585971</c:v>
                </c:pt>
                <c:pt idx="1452">
                  <c:v>0.97757847533632292</c:v>
                </c:pt>
                <c:pt idx="1453">
                  <c:v>0.97902308363680135</c:v>
                </c:pt>
                <c:pt idx="1454">
                  <c:v>0.97363589851626686</c:v>
                </c:pt>
                <c:pt idx="1455">
                  <c:v>0.96707496915159363</c:v>
                </c:pt>
                <c:pt idx="1456">
                  <c:v>0.97462906672284588</c:v>
                </c:pt>
                <c:pt idx="1457">
                  <c:v>0.98504228488879531</c:v>
                </c:pt>
                <c:pt idx="1458">
                  <c:v>0.96361392843169713</c:v>
                </c:pt>
                <c:pt idx="1459">
                  <c:v>0.98895476570259122</c:v>
                </c:pt>
                <c:pt idx="1460">
                  <c:v>0.97125831402172935</c:v>
                </c:pt>
                <c:pt idx="1461">
                  <c:v>0.96824871339573237</c:v>
                </c:pt>
                <c:pt idx="1462">
                  <c:v>0.96478767267583587</c:v>
                </c:pt>
                <c:pt idx="1463">
                  <c:v>0.96072471183074004</c:v>
                </c:pt>
                <c:pt idx="1464">
                  <c:v>0.97667559514852376</c:v>
                </c:pt>
                <c:pt idx="1465">
                  <c:v>0.96857976946459201</c:v>
                </c:pt>
                <c:pt idx="1466">
                  <c:v>0.99067023805940957</c:v>
                </c:pt>
                <c:pt idx="1467">
                  <c:v>0.9714689860655491</c:v>
                </c:pt>
                <c:pt idx="1468">
                  <c:v>0.96234989616877842</c:v>
                </c:pt>
                <c:pt idx="1469">
                  <c:v>0.96894092153971167</c:v>
                </c:pt>
                <c:pt idx="1470">
                  <c:v>0.97167965810936885</c:v>
                </c:pt>
                <c:pt idx="1471">
                  <c:v>0.95807626327986273</c:v>
                </c:pt>
                <c:pt idx="1472">
                  <c:v>0.95244831010924846</c:v>
                </c:pt>
                <c:pt idx="1473">
                  <c:v>0.9526288861468083</c:v>
                </c:pt>
                <c:pt idx="1474">
                  <c:v>0.95178619797152919</c:v>
                </c:pt>
                <c:pt idx="1475">
                  <c:v>0.95407349444728684</c:v>
                </c:pt>
                <c:pt idx="1476">
                  <c:v>0.95500647064134592</c:v>
                </c:pt>
                <c:pt idx="1477">
                  <c:v>0.98657718120805371</c:v>
                </c:pt>
                <c:pt idx="1478">
                  <c:v>0.96885063352093181</c:v>
                </c:pt>
                <c:pt idx="1479">
                  <c:v>0.97029524182141025</c:v>
                </c:pt>
                <c:pt idx="1480">
                  <c:v>0.98702862130195324</c:v>
                </c:pt>
                <c:pt idx="1481">
                  <c:v>0.97845125951786194</c:v>
                </c:pt>
                <c:pt idx="1482">
                  <c:v>0.98444036476359587</c:v>
                </c:pt>
                <c:pt idx="1483">
                  <c:v>0.98717910133325304</c:v>
                </c:pt>
                <c:pt idx="1484">
                  <c:v>0.95780539922352304</c:v>
                </c:pt>
                <c:pt idx="1485">
                  <c:v>0.9682788094019924</c:v>
                </c:pt>
                <c:pt idx="1486">
                  <c:v>0.95861799139254222</c:v>
                </c:pt>
                <c:pt idx="1487">
                  <c:v>0.97580281096698473</c:v>
                </c:pt>
                <c:pt idx="1488">
                  <c:v>0.96845938543955212</c:v>
                </c:pt>
                <c:pt idx="1489">
                  <c:v>0.9649682487133957</c:v>
                </c:pt>
                <c:pt idx="1490">
                  <c:v>0.96538959280103531</c:v>
                </c:pt>
                <c:pt idx="1491">
                  <c:v>0.95756463117344326</c:v>
                </c:pt>
                <c:pt idx="1492">
                  <c:v>0.96587112890119486</c:v>
                </c:pt>
                <c:pt idx="1493">
                  <c:v>0.98353748457579682</c:v>
                </c:pt>
                <c:pt idx="1494">
                  <c:v>0.98037740391850003</c:v>
                </c:pt>
                <c:pt idx="1495">
                  <c:v>0.97065639389652991</c:v>
                </c:pt>
                <c:pt idx="1496">
                  <c:v>0.97137869804676924</c:v>
                </c:pt>
                <c:pt idx="1497">
                  <c:v>0.98814217353357214</c:v>
                </c:pt>
                <c:pt idx="1498">
                  <c:v>0.96987389773377075</c:v>
                </c:pt>
                <c:pt idx="1499">
                  <c:v>0.9728534023535077</c:v>
                </c:pt>
                <c:pt idx="1500">
                  <c:v>0.97757847533632292</c:v>
                </c:pt>
                <c:pt idx="1501">
                  <c:v>0.97173985012188879</c:v>
                </c:pt>
                <c:pt idx="1502">
                  <c:v>0.98170162819393869</c:v>
                </c:pt>
                <c:pt idx="1503">
                  <c:v>0.96584103289493484</c:v>
                </c:pt>
                <c:pt idx="1504">
                  <c:v>0.95876847142384203</c:v>
                </c:pt>
                <c:pt idx="1505">
                  <c:v>0.96126643994341954</c:v>
                </c:pt>
                <c:pt idx="1506">
                  <c:v>0.96337316038161735</c:v>
                </c:pt>
                <c:pt idx="1507">
                  <c:v>0.96803804135191263</c:v>
                </c:pt>
                <c:pt idx="1508">
                  <c:v>0.95434435850362653</c:v>
                </c:pt>
                <c:pt idx="1509">
                  <c:v>0.94760285310139347</c:v>
                </c:pt>
                <c:pt idx="1510">
                  <c:v>0.98534324495139491</c:v>
                </c:pt>
                <c:pt idx="1511">
                  <c:v>0.98140066813133897</c:v>
                </c:pt>
                <c:pt idx="1512">
                  <c:v>0.98040749992475995</c:v>
                </c:pt>
                <c:pt idx="1513">
                  <c:v>0.99352935865410663</c:v>
                </c:pt>
                <c:pt idx="1514">
                  <c:v>0.98094922803743945</c:v>
                </c:pt>
                <c:pt idx="1515">
                  <c:v>0.98456074878863575</c:v>
                </c:pt>
                <c:pt idx="1516">
                  <c:v>0.98425978872603603</c:v>
                </c:pt>
                <c:pt idx="1517">
                  <c:v>0.99867577572456134</c:v>
                </c:pt>
                <c:pt idx="1518">
                  <c:v>0.97989586781834048</c:v>
                </c:pt>
                <c:pt idx="1519">
                  <c:v>0.99957865591236039</c:v>
                </c:pt>
                <c:pt idx="1520">
                  <c:v>0.97815029945526233</c:v>
                </c:pt>
                <c:pt idx="1521">
                  <c:v>0.99410118277304604</c:v>
                </c:pt>
                <c:pt idx="1522">
                  <c:v>0.96313239233153758</c:v>
                </c:pt>
                <c:pt idx="1523">
                  <c:v>0.95491618262256595</c:v>
                </c:pt>
                <c:pt idx="1524">
                  <c:v>0.96557016883859514</c:v>
                </c:pt>
                <c:pt idx="1525">
                  <c:v>0.9567821350106841</c:v>
                </c:pt>
                <c:pt idx="1526">
                  <c:v>0.98585487705781438</c:v>
                </c:pt>
                <c:pt idx="1527">
                  <c:v>0.98200258825653841</c:v>
                </c:pt>
                <c:pt idx="1528">
                  <c:v>0.97736780329250306</c:v>
                </c:pt>
                <c:pt idx="1529">
                  <c:v>0.99852529569326154</c:v>
                </c:pt>
                <c:pt idx="1530">
                  <c:v>0.96716525717037349</c:v>
                </c:pt>
                <c:pt idx="1531">
                  <c:v>0.97059620188400997</c:v>
                </c:pt>
                <c:pt idx="1532">
                  <c:v>0.98049778794353992</c:v>
                </c:pt>
                <c:pt idx="1533">
                  <c:v>0.97089716194660969</c:v>
                </c:pt>
                <c:pt idx="1534">
                  <c:v>0.98103951605621931</c:v>
                </c:pt>
                <c:pt idx="1535">
                  <c:v>0.97186023414692868</c:v>
                </c:pt>
                <c:pt idx="1536">
                  <c:v>0.97276311433472773</c:v>
                </c:pt>
                <c:pt idx="1537">
                  <c:v>0.96885063352093181</c:v>
                </c:pt>
                <c:pt idx="1538">
                  <c:v>0.97414753062268633</c:v>
                </c:pt>
                <c:pt idx="1539">
                  <c:v>0.99374003069792638</c:v>
                </c:pt>
                <c:pt idx="1540">
                  <c:v>0.98741986938333282</c:v>
                </c:pt>
                <c:pt idx="1541">
                  <c:v>0.98164143618141875</c:v>
                </c:pt>
                <c:pt idx="1542">
                  <c:v>0.96972341770247084</c:v>
                </c:pt>
                <c:pt idx="1543">
                  <c:v>0.95425407048484667</c:v>
                </c:pt>
                <c:pt idx="1544">
                  <c:v>0.9569326150419839</c:v>
                </c:pt>
                <c:pt idx="1545">
                  <c:v>0.97553194691064493</c:v>
                </c:pt>
                <c:pt idx="1546">
                  <c:v>0.97523098684804521</c:v>
                </c:pt>
                <c:pt idx="1547">
                  <c:v>0.97225148222830826</c:v>
                </c:pt>
                <c:pt idx="1548">
                  <c:v>0.97980557979956062</c:v>
                </c:pt>
                <c:pt idx="1549">
                  <c:v>0.97489993077918558</c:v>
                </c:pt>
                <c:pt idx="1550">
                  <c:v>0.98666746922683357</c:v>
                </c:pt>
                <c:pt idx="1551">
                  <c:v>0.96848948144581215</c:v>
                </c:pt>
                <c:pt idx="1552">
                  <c:v>0.99831462364944168</c:v>
                </c:pt>
                <c:pt idx="1553">
                  <c:v>0.98299575646311732</c:v>
                </c:pt>
                <c:pt idx="1554">
                  <c:v>0.98197249225027838</c:v>
                </c:pt>
                <c:pt idx="1555">
                  <c:v>0.96213922412495867</c:v>
                </c:pt>
                <c:pt idx="1556">
                  <c:v>0.97435820266650619</c:v>
                </c:pt>
                <c:pt idx="1557">
                  <c:v>0.96388479248803682</c:v>
                </c:pt>
                <c:pt idx="1558">
                  <c:v>0.95512685466638581</c:v>
                </c:pt>
                <c:pt idx="1559">
                  <c:v>0.96635266500135431</c:v>
                </c:pt>
                <c:pt idx="1560">
                  <c:v>0.97080687392782983</c:v>
                </c:pt>
                <c:pt idx="1561">
                  <c:v>0.97839106750534199</c:v>
                </c:pt>
                <c:pt idx="1562">
                  <c:v>0.97908327564932129</c:v>
                </c:pt>
                <c:pt idx="1563">
                  <c:v>0.97164956210310893</c:v>
                </c:pt>
                <c:pt idx="1564">
                  <c:v>0.98350738856953679</c:v>
                </c:pt>
                <c:pt idx="1565">
                  <c:v>0.98471122881993556</c:v>
                </c:pt>
                <c:pt idx="1566">
                  <c:v>0.99530502302344481</c:v>
                </c:pt>
                <c:pt idx="1567">
                  <c:v>0.97375628254130675</c:v>
                </c:pt>
                <c:pt idx="1568">
                  <c:v>0.99960875191862042</c:v>
                </c:pt>
                <c:pt idx="1569">
                  <c:v>0.97938423571192101</c:v>
                </c:pt>
                <c:pt idx="1570">
                  <c:v>0.96791765732687274</c:v>
                </c:pt>
                <c:pt idx="1571">
                  <c:v>0.96824871339573237</c:v>
                </c:pt>
                <c:pt idx="1572">
                  <c:v>0.97134860204050921</c:v>
                </c:pt>
                <c:pt idx="1573">
                  <c:v>0.96271104824389808</c:v>
                </c:pt>
                <c:pt idx="1574">
                  <c:v>0.95822674331116264</c:v>
                </c:pt>
                <c:pt idx="1575">
                  <c:v>0.9713185060342493</c:v>
                </c:pt>
                <c:pt idx="1576">
                  <c:v>0.97628434706714418</c:v>
                </c:pt>
                <c:pt idx="1577">
                  <c:v>0.98735967737081287</c:v>
                </c:pt>
                <c:pt idx="1578">
                  <c:v>0.99370993469166646</c:v>
                </c:pt>
                <c:pt idx="1579">
                  <c:v>0.96487796069461584</c:v>
                </c:pt>
                <c:pt idx="1580">
                  <c:v>0.97992596382460051</c:v>
                </c:pt>
                <c:pt idx="1581">
                  <c:v>0.97836097149908208</c:v>
                </c:pt>
                <c:pt idx="1582">
                  <c:v>0.973545610497487</c:v>
                </c:pt>
                <c:pt idx="1583">
                  <c:v>0.97468925873536583</c:v>
                </c:pt>
                <c:pt idx="1584">
                  <c:v>0.97607367502332443</c:v>
                </c:pt>
                <c:pt idx="1585">
                  <c:v>0.98480151683871553</c:v>
                </c:pt>
                <c:pt idx="1586">
                  <c:v>0.96818852138321243</c:v>
                </c:pt>
                <c:pt idx="1587">
                  <c:v>0.97947452373070099</c:v>
                </c:pt>
                <c:pt idx="1588">
                  <c:v>0.9815812441688988</c:v>
                </c:pt>
                <c:pt idx="1589">
                  <c:v>0.96584103289493484</c:v>
                </c:pt>
                <c:pt idx="1590">
                  <c:v>0.96851957745207207</c:v>
                </c:pt>
                <c:pt idx="1591">
                  <c:v>0.96036355975562038</c:v>
                </c:pt>
                <c:pt idx="1592">
                  <c:v>0.96538959280103531</c:v>
                </c:pt>
                <c:pt idx="1593">
                  <c:v>0.96836909742077226</c:v>
                </c:pt>
                <c:pt idx="1594">
                  <c:v>0.95512685466638581</c:v>
                </c:pt>
                <c:pt idx="1595">
                  <c:v>0.9728534023535077</c:v>
                </c:pt>
                <c:pt idx="1596">
                  <c:v>0.98585487705781438</c:v>
                </c:pt>
                <c:pt idx="1597">
                  <c:v>0.98034730791224001</c:v>
                </c:pt>
                <c:pt idx="1598">
                  <c:v>0.98799169350227223</c:v>
                </c:pt>
                <c:pt idx="1599">
                  <c:v>0.97929394769314115</c:v>
                </c:pt>
                <c:pt idx="1600">
                  <c:v>0.97616396304210429</c:v>
                </c:pt>
                <c:pt idx="1601">
                  <c:v>0.9752008908417853</c:v>
                </c:pt>
                <c:pt idx="1602">
                  <c:v>0.99346916664158669</c:v>
                </c:pt>
                <c:pt idx="1603">
                  <c:v>0.98898486170885125</c:v>
                </c:pt>
                <c:pt idx="1604">
                  <c:v>0.98131038011255911</c:v>
                </c:pt>
                <c:pt idx="1605">
                  <c:v>0.97989586781834048</c:v>
                </c:pt>
                <c:pt idx="1606">
                  <c:v>0.97799981942396241</c:v>
                </c:pt>
                <c:pt idx="1607">
                  <c:v>0.97399705059138653</c:v>
                </c:pt>
                <c:pt idx="1608">
                  <c:v>0.98290546844433746</c:v>
                </c:pt>
                <c:pt idx="1609">
                  <c:v>0.98784121347097242</c:v>
                </c:pt>
                <c:pt idx="1610">
                  <c:v>0.99259638246004755</c:v>
                </c:pt>
                <c:pt idx="1611">
                  <c:v>0.95461522255996634</c:v>
                </c:pt>
                <c:pt idx="1612">
                  <c:v>0.97231167424082821</c:v>
                </c:pt>
                <c:pt idx="1613">
                  <c:v>0.95326090227826765</c:v>
                </c:pt>
                <c:pt idx="1614">
                  <c:v>0.97441839467902613</c:v>
                </c:pt>
                <c:pt idx="1615">
                  <c:v>0.96954284166491111</c:v>
                </c:pt>
                <c:pt idx="1616">
                  <c:v>0.97538146687934513</c:v>
                </c:pt>
                <c:pt idx="1617">
                  <c:v>0.97258253829716801</c:v>
                </c:pt>
                <c:pt idx="1618">
                  <c:v>0.98335690853823698</c:v>
                </c:pt>
                <c:pt idx="1619">
                  <c:v>0.99295753453516722</c:v>
                </c:pt>
                <c:pt idx="1620">
                  <c:v>0.98356758058205673</c:v>
                </c:pt>
                <c:pt idx="1621">
                  <c:v>0.99045956601558971</c:v>
                </c:pt>
                <c:pt idx="1622">
                  <c:v>0.96123634393715951</c:v>
                </c:pt>
                <c:pt idx="1623">
                  <c:v>0.98507238089505522</c:v>
                </c:pt>
                <c:pt idx="1624">
                  <c:v>0.99259638246004755</c:v>
                </c:pt>
                <c:pt idx="1625">
                  <c:v>0.98305594847563726</c:v>
                </c:pt>
                <c:pt idx="1626">
                  <c:v>0.98982754988413035</c:v>
                </c:pt>
                <c:pt idx="1627">
                  <c:v>0.99726126343034283</c:v>
                </c:pt>
                <c:pt idx="1628">
                  <c:v>0.97447858669154608</c:v>
                </c:pt>
                <c:pt idx="1629">
                  <c:v>0.97327474644114731</c:v>
                </c:pt>
                <c:pt idx="1630">
                  <c:v>0.96972341770247084</c:v>
                </c:pt>
                <c:pt idx="1631">
                  <c:v>0.97751828332380297</c:v>
                </c:pt>
                <c:pt idx="1632">
                  <c:v>0.96183826406235895</c:v>
                </c:pt>
                <c:pt idx="1633">
                  <c:v>0.95639088692930452</c:v>
                </c:pt>
                <c:pt idx="1634">
                  <c:v>0.96653324103891414</c:v>
                </c:pt>
                <c:pt idx="1635">
                  <c:v>0.936286754747645</c:v>
                </c:pt>
                <c:pt idx="1636">
                  <c:v>0.94555632467571549</c:v>
                </c:pt>
                <c:pt idx="1637">
                  <c:v>0.96454690462575621</c:v>
                </c:pt>
                <c:pt idx="1638">
                  <c:v>0.95882866343636197</c:v>
                </c:pt>
                <c:pt idx="1639">
                  <c:v>0.98164143618141875</c:v>
                </c:pt>
                <c:pt idx="1640">
                  <c:v>0.97920365967436118</c:v>
                </c:pt>
                <c:pt idx="1641">
                  <c:v>0.9765853071297439</c:v>
                </c:pt>
                <c:pt idx="1642">
                  <c:v>0.9746591627291058</c:v>
                </c:pt>
                <c:pt idx="1643">
                  <c:v>0.98224335630661808</c:v>
                </c:pt>
                <c:pt idx="1644">
                  <c:v>0.99166340626598848</c:v>
                </c:pt>
                <c:pt idx="1645">
                  <c:v>0.99136244620338876</c:v>
                </c:pt>
                <c:pt idx="1646">
                  <c:v>0.98639660517049388</c:v>
                </c:pt>
                <c:pt idx="1647">
                  <c:v>0.98368796460709662</c:v>
                </c:pt>
                <c:pt idx="1648">
                  <c:v>0.97246215427212812</c:v>
                </c:pt>
                <c:pt idx="1649">
                  <c:v>0.97417762662894636</c:v>
                </c:pt>
                <c:pt idx="1650">
                  <c:v>0.97231167424082821</c:v>
                </c:pt>
                <c:pt idx="1651">
                  <c:v>0.9836578686008367</c:v>
                </c:pt>
                <c:pt idx="1652">
                  <c:v>0.97243205826586809</c:v>
                </c:pt>
                <c:pt idx="1653">
                  <c:v>0.96915159358353142</c:v>
                </c:pt>
                <c:pt idx="1654">
                  <c:v>0.97965509976826071</c:v>
                </c:pt>
                <c:pt idx="1655">
                  <c:v>0.96734583320793333</c:v>
                </c:pt>
                <c:pt idx="1656">
                  <c:v>0.98146086014385892</c:v>
                </c:pt>
                <c:pt idx="1657">
                  <c:v>0.96599151292623464</c:v>
                </c:pt>
                <c:pt idx="1658">
                  <c:v>0.97225148222830826</c:v>
                </c:pt>
                <c:pt idx="1659">
                  <c:v>0.95648117494808438</c:v>
                </c:pt>
                <c:pt idx="1660">
                  <c:v>0.96283143226893786</c:v>
                </c:pt>
                <c:pt idx="1661">
                  <c:v>0.95563848677280527</c:v>
                </c:pt>
                <c:pt idx="1662">
                  <c:v>0.95861799139254222</c:v>
                </c:pt>
                <c:pt idx="1663">
                  <c:v>0.96996418575255061</c:v>
                </c:pt>
                <c:pt idx="1664">
                  <c:v>0.97282330634724767</c:v>
                </c:pt>
                <c:pt idx="1665">
                  <c:v>0.96623228097631442</c:v>
                </c:pt>
                <c:pt idx="1666">
                  <c:v>0.99109158214704907</c:v>
                </c:pt>
                <c:pt idx="1667">
                  <c:v>0.97634453907966412</c:v>
                </c:pt>
                <c:pt idx="1668">
                  <c:v>0.97821049146778227</c:v>
                </c:pt>
                <c:pt idx="1669">
                  <c:v>0.97649501911096392</c:v>
                </c:pt>
                <c:pt idx="1670">
                  <c:v>0.97110783399042944</c:v>
                </c:pt>
                <c:pt idx="1671">
                  <c:v>0.97499021879796555</c:v>
                </c:pt>
                <c:pt idx="1672">
                  <c:v>0.99184398230354831</c:v>
                </c:pt>
                <c:pt idx="1673">
                  <c:v>0.96650314503265422</c:v>
                </c:pt>
                <c:pt idx="1674">
                  <c:v>0.97613386703584437</c:v>
                </c:pt>
                <c:pt idx="1675">
                  <c:v>0.97348541848496706</c:v>
                </c:pt>
                <c:pt idx="1676">
                  <c:v>0.96656333704517405</c:v>
                </c:pt>
                <c:pt idx="1677">
                  <c:v>0.95229783007794866</c:v>
                </c:pt>
                <c:pt idx="1678">
                  <c:v>0.95744424714840337</c:v>
                </c:pt>
                <c:pt idx="1679">
                  <c:v>0.95488608661630603</c:v>
                </c:pt>
                <c:pt idx="1680">
                  <c:v>0.96027327173684052</c:v>
                </c:pt>
                <c:pt idx="1681">
                  <c:v>0.94766304511391342</c:v>
                </c:pt>
                <c:pt idx="1682">
                  <c:v>0.96779727330183285</c:v>
                </c:pt>
                <c:pt idx="1683">
                  <c:v>0.96933216962109126</c:v>
                </c:pt>
                <c:pt idx="1684">
                  <c:v>0.96674391308273389</c:v>
                </c:pt>
                <c:pt idx="1685">
                  <c:v>0.97974538778704068</c:v>
                </c:pt>
                <c:pt idx="1686">
                  <c:v>0.99109158214704907</c:v>
                </c:pt>
                <c:pt idx="1687">
                  <c:v>0.98025701989346015</c:v>
                </c:pt>
                <c:pt idx="1688">
                  <c:v>0.96535949679477528</c:v>
                </c:pt>
                <c:pt idx="1689">
                  <c:v>0.99169350227224851</c:v>
                </c:pt>
                <c:pt idx="1690">
                  <c:v>0.96460709663827615</c:v>
                </c:pt>
                <c:pt idx="1691">
                  <c:v>0.98380834863213651</c:v>
                </c:pt>
                <c:pt idx="1692">
                  <c:v>0.98007644385590031</c:v>
                </c:pt>
                <c:pt idx="1693">
                  <c:v>0.97360580251000695</c:v>
                </c:pt>
                <c:pt idx="1694">
                  <c:v>0.97839106750534199</c:v>
                </c:pt>
                <c:pt idx="1695">
                  <c:v>0.96806813735817254</c:v>
                </c:pt>
                <c:pt idx="1696">
                  <c:v>0.95058235772113042</c:v>
                </c:pt>
                <c:pt idx="1697">
                  <c:v>0.95979173563668096</c:v>
                </c:pt>
                <c:pt idx="1698">
                  <c:v>0.940169139555181</c:v>
                </c:pt>
                <c:pt idx="1699">
                  <c:v>0.95621031089174469</c:v>
                </c:pt>
                <c:pt idx="1700">
                  <c:v>0.95903933548018183</c:v>
                </c:pt>
                <c:pt idx="1701">
                  <c:v>0.95386282240346709</c:v>
                </c:pt>
                <c:pt idx="1702">
                  <c:v>0.97836097149908208</c:v>
                </c:pt>
                <c:pt idx="1703">
                  <c:v>0.98215306828783822</c:v>
                </c:pt>
                <c:pt idx="1704">
                  <c:v>0.96782736930809277</c:v>
                </c:pt>
                <c:pt idx="1705">
                  <c:v>0.97917356366810127</c:v>
                </c:pt>
                <c:pt idx="1706">
                  <c:v>0.98335690853823698</c:v>
                </c:pt>
                <c:pt idx="1707">
                  <c:v>0.98067836398109975</c:v>
                </c:pt>
                <c:pt idx="1708">
                  <c:v>0.96987389773377075</c:v>
                </c:pt>
                <c:pt idx="1709">
                  <c:v>0.97544165889186507</c:v>
                </c:pt>
                <c:pt idx="1710">
                  <c:v>0.98251422036295788</c:v>
                </c:pt>
                <c:pt idx="1711">
                  <c:v>0.98543353297017489</c:v>
                </c:pt>
                <c:pt idx="1712">
                  <c:v>0.98654708520179368</c:v>
                </c:pt>
                <c:pt idx="1713">
                  <c:v>0.96776717729557282</c:v>
                </c:pt>
                <c:pt idx="1714">
                  <c:v>0.96280133626267794</c:v>
                </c:pt>
                <c:pt idx="1715">
                  <c:v>0.96253047220633825</c:v>
                </c:pt>
                <c:pt idx="1716">
                  <c:v>0.96581093688867492</c:v>
                </c:pt>
                <c:pt idx="1717">
                  <c:v>0.96659343305143408</c:v>
                </c:pt>
                <c:pt idx="1718">
                  <c:v>0.95720347909832371</c:v>
                </c:pt>
                <c:pt idx="1719">
                  <c:v>0.94703102898245406</c:v>
                </c:pt>
                <c:pt idx="1720">
                  <c:v>0.97489993077918558</c:v>
                </c:pt>
                <c:pt idx="1721">
                  <c:v>0.96891082553345176</c:v>
                </c:pt>
                <c:pt idx="1722">
                  <c:v>0.99003822192795021</c:v>
                </c:pt>
                <c:pt idx="1723">
                  <c:v>0.97980557979956062</c:v>
                </c:pt>
                <c:pt idx="1724">
                  <c:v>0.96755650525175307</c:v>
                </c:pt>
                <c:pt idx="1725">
                  <c:v>0.98744996538959284</c:v>
                </c:pt>
                <c:pt idx="1726">
                  <c:v>0.97793962741144247</c:v>
                </c:pt>
                <c:pt idx="1727">
                  <c:v>0.97080687392782983</c:v>
                </c:pt>
                <c:pt idx="1728">
                  <c:v>0.98708881331447318</c:v>
                </c:pt>
                <c:pt idx="1729">
                  <c:v>0.97989586781834048</c:v>
                </c:pt>
                <c:pt idx="1730">
                  <c:v>0.96653324103891414</c:v>
                </c:pt>
                <c:pt idx="1731">
                  <c:v>0.97140879405302916</c:v>
                </c:pt>
                <c:pt idx="1732">
                  <c:v>0.97330484244740723</c:v>
                </c:pt>
                <c:pt idx="1733">
                  <c:v>0.96168778403105903</c:v>
                </c:pt>
                <c:pt idx="1734">
                  <c:v>0.95103379781502995</c:v>
                </c:pt>
                <c:pt idx="1735">
                  <c:v>0.97839106750534199</c:v>
                </c:pt>
                <c:pt idx="1736">
                  <c:v>0.96927197760857131</c:v>
                </c:pt>
                <c:pt idx="1737">
                  <c:v>0.97032533782767028</c:v>
                </c:pt>
                <c:pt idx="1738">
                  <c:v>0.97029524182141025</c:v>
                </c:pt>
                <c:pt idx="1739">
                  <c:v>0.97787943539892253</c:v>
                </c:pt>
                <c:pt idx="1740">
                  <c:v>0.97893279561802149</c:v>
                </c:pt>
                <c:pt idx="1741">
                  <c:v>0.98251422036295788</c:v>
                </c:pt>
                <c:pt idx="1742">
                  <c:v>0.96809823336443257</c:v>
                </c:pt>
                <c:pt idx="1743">
                  <c:v>0.9680079453456526</c:v>
                </c:pt>
                <c:pt idx="1744">
                  <c:v>0.94739218105757361</c:v>
                </c:pt>
                <c:pt idx="1745">
                  <c:v>0.96608180094501461</c:v>
                </c:pt>
                <c:pt idx="1746">
                  <c:v>0.95988202365546094</c:v>
                </c:pt>
                <c:pt idx="1747">
                  <c:v>0.96882053751467179</c:v>
                </c:pt>
                <c:pt idx="1748">
                  <c:v>0.96842928943329221</c:v>
                </c:pt>
                <c:pt idx="1749">
                  <c:v>0.97438829867276611</c:v>
                </c:pt>
                <c:pt idx="1750">
                  <c:v>0.9914226382159087</c:v>
                </c:pt>
                <c:pt idx="1751">
                  <c:v>0.99088091010322932</c:v>
                </c:pt>
                <c:pt idx="1752">
                  <c:v>0.9871189093207331</c:v>
                </c:pt>
                <c:pt idx="1753">
                  <c:v>0.98790140548349237</c:v>
                </c:pt>
                <c:pt idx="1754">
                  <c:v>0.97818039546152225</c:v>
                </c:pt>
                <c:pt idx="1755">
                  <c:v>0.96743612122671319</c:v>
                </c:pt>
                <c:pt idx="1756">
                  <c:v>0.96554007283233512</c:v>
                </c:pt>
                <c:pt idx="1757">
                  <c:v>0.95943058356156141</c:v>
                </c:pt>
                <c:pt idx="1758">
                  <c:v>0.95136485388388958</c:v>
                </c:pt>
                <c:pt idx="1759">
                  <c:v>0.96740602522045327</c:v>
                </c:pt>
                <c:pt idx="1760">
                  <c:v>0.96265085623137814</c:v>
                </c:pt>
                <c:pt idx="1761">
                  <c:v>0.98260450838173774</c:v>
                </c:pt>
                <c:pt idx="1762">
                  <c:v>0.99530502302344481</c:v>
                </c:pt>
                <c:pt idx="1763">
                  <c:v>0.96126643994341954</c:v>
                </c:pt>
                <c:pt idx="1764">
                  <c:v>0.97709693923616336</c:v>
                </c:pt>
                <c:pt idx="1765">
                  <c:v>0.98979745387787044</c:v>
                </c:pt>
                <c:pt idx="1766">
                  <c:v>0.98046769193727989</c:v>
                </c:pt>
                <c:pt idx="1767">
                  <c:v>0.97053600987149002</c:v>
                </c:pt>
                <c:pt idx="1768">
                  <c:v>0.99133235019712884</c:v>
                </c:pt>
                <c:pt idx="1769">
                  <c:v>0.97652511511722395</c:v>
                </c:pt>
                <c:pt idx="1770">
                  <c:v>0.95729376711710357</c:v>
                </c:pt>
                <c:pt idx="1771">
                  <c:v>0.9597014476179011</c:v>
                </c:pt>
                <c:pt idx="1772">
                  <c:v>0.96626237698257444</c:v>
                </c:pt>
                <c:pt idx="1773">
                  <c:v>0.96069461582448012</c:v>
                </c:pt>
                <c:pt idx="1774">
                  <c:v>0.9523580220904686</c:v>
                </c:pt>
                <c:pt idx="1775">
                  <c:v>0.9621994161374785</c:v>
                </c:pt>
                <c:pt idx="1776">
                  <c:v>0.95615011887922474</c:v>
                </c:pt>
                <c:pt idx="1777">
                  <c:v>0.97429801065398625</c:v>
                </c:pt>
                <c:pt idx="1778">
                  <c:v>0.9700845697775905</c:v>
                </c:pt>
                <c:pt idx="1779">
                  <c:v>0.97029524182141025</c:v>
                </c:pt>
                <c:pt idx="1780">
                  <c:v>0.96797784933939268</c:v>
                </c:pt>
                <c:pt idx="1781">
                  <c:v>0.9606645198182201</c:v>
                </c:pt>
                <c:pt idx="1782">
                  <c:v>0.98690823727691335</c:v>
                </c:pt>
                <c:pt idx="1783">
                  <c:v>0.98811207752731212</c:v>
                </c:pt>
                <c:pt idx="1784">
                  <c:v>0.97095735395912963</c:v>
                </c:pt>
                <c:pt idx="1785">
                  <c:v>0.97480964276040571</c:v>
                </c:pt>
                <c:pt idx="1786">
                  <c:v>0.96409546453185657</c:v>
                </c:pt>
                <c:pt idx="1787">
                  <c:v>0.97649501911096392</c:v>
                </c:pt>
                <c:pt idx="1788">
                  <c:v>0.99286724651638725</c:v>
                </c:pt>
                <c:pt idx="1789">
                  <c:v>0.97712703524242328</c:v>
                </c:pt>
                <c:pt idx="1790">
                  <c:v>0.96237999217503833</c:v>
                </c:pt>
                <c:pt idx="1791">
                  <c:v>0.95991211966172085</c:v>
                </c:pt>
                <c:pt idx="1792">
                  <c:v>0.95651127095434441</c:v>
                </c:pt>
                <c:pt idx="1793">
                  <c:v>0.95431426249736662</c:v>
                </c:pt>
                <c:pt idx="1794">
                  <c:v>0.96295181629397775</c:v>
                </c:pt>
                <c:pt idx="1795">
                  <c:v>0.9713185060342493</c:v>
                </c:pt>
                <c:pt idx="1796">
                  <c:v>0.97450868269780599</c:v>
                </c:pt>
                <c:pt idx="1797">
                  <c:v>0.97655521112348387</c:v>
                </c:pt>
                <c:pt idx="1798">
                  <c:v>0.97029524182141025</c:v>
                </c:pt>
                <c:pt idx="1799">
                  <c:v>0.96903120955849154</c:v>
                </c:pt>
                <c:pt idx="1800">
                  <c:v>0.9752008908417853</c:v>
                </c:pt>
                <c:pt idx="1801">
                  <c:v>0.97345532247870703</c:v>
                </c:pt>
                <c:pt idx="1802">
                  <c:v>0.99491377494206523</c:v>
                </c:pt>
                <c:pt idx="1803">
                  <c:v>0.98459084479489567</c:v>
                </c:pt>
                <c:pt idx="1804">
                  <c:v>0.97089716194660969</c:v>
                </c:pt>
                <c:pt idx="1805">
                  <c:v>0.99389051072922618</c:v>
                </c:pt>
                <c:pt idx="1806">
                  <c:v>0.97884250759924163</c:v>
                </c:pt>
                <c:pt idx="1807">
                  <c:v>0.97553194691064493</c:v>
                </c:pt>
                <c:pt idx="1808">
                  <c:v>0.96942245763987123</c:v>
                </c:pt>
                <c:pt idx="1809">
                  <c:v>0.95359195834712729</c:v>
                </c:pt>
                <c:pt idx="1810">
                  <c:v>0.94913774942065188</c:v>
                </c:pt>
                <c:pt idx="1811">
                  <c:v>0.95299003822192796</c:v>
                </c:pt>
                <c:pt idx="1812">
                  <c:v>0.95040178168357059</c:v>
                </c:pt>
                <c:pt idx="1813">
                  <c:v>0.95247840611550849</c:v>
                </c:pt>
                <c:pt idx="1814">
                  <c:v>0.96987389773377075</c:v>
                </c:pt>
                <c:pt idx="1815">
                  <c:v>0.98052788394979984</c:v>
                </c:pt>
                <c:pt idx="1816">
                  <c:v>0.96623228097631442</c:v>
                </c:pt>
                <c:pt idx="1817">
                  <c:v>0.97787943539892253</c:v>
                </c:pt>
                <c:pt idx="1818">
                  <c:v>0.97414753062268633</c:v>
                </c:pt>
                <c:pt idx="1819">
                  <c:v>0.973545610497487</c:v>
                </c:pt>
                <c:pt idx="1820">
                  <c:v>0.96909140157101148</c:v>
                </c:pt>
                <c:pt idx="1821">
                  <c:v>0.96809823336443257</c:v>
                </c:pt>
                <c:pt idx="1822">
                  <c:v>0.97089716194660969</c:v>
                </c:pt>
                <c:pt idx="1823">
                  <c:v>0.96237999217503833</c:v>
                </c:pt>
                <c:pt idx="1824">
                  <c:v>0.97255244229090798</c:v>
                </c:pt>
                <c:pt idx="1825">
                  <c:v>0.97026514581515033</c:v>
                </c:pt>
                <c:pt idx="1826">
                  <c:v>0.98212297228157819</c:v>
                </c:pt>
                <c:pt idx="1827">
                  <c:v>0.96873024949589193</c:v>
                </c:pt>
                <c:pt idx="1828">
                  <c:v>0.9603936557618804</c:v>
                </c:pt>
                <c:pt idx="1829">
                  <c:v>0.95434435850362653</c:v>
                </c:pt>
                <c:pt idx="1830">
                  <c:v>0.97324465043488728</c:v>
                </c:pt>
                <c:pt idx="1831">
                  <c:v>0.95768501519848315</c:v>
                </c:pt>
                <c:pt idx="1832">
                  <c:v>0.95509675866012578</c:v>
                </c:pt>
                <c:pt idx="1833">
                  <c:v>0.97715713124868331</c:v>
                </c:pt>
                <c:pt idx="1834">
                  <c:v>0.97559213892316488</c:v>
                </c:pt>
                <c:pt idx="1835">
                  <c:v>0.97204081018448851</c:v>
                </c:pt>
                <c:pt idx="1836">
                  <c:v>0.98970716585909047</c:v>
                </c:pt>
                <c:pt idx="1837">
                  <c:v>0.96514882475095554</c:v>
                </c:pt>
                <c:pt idx="1838">
                  <c:v>0.97986577181208057</c:v>
                </c:pt>
                <c:pt idx="1839">
                  <c:v>0.97751828332380297</c:v>
                </c:pt>
                <c:pt idx="1840">
                  <c:v>0.9765853071297439</c:v>
                </c:pt>
                <c:pt idx="1841">
                  <c:v>0.97893279561802149</c:v>
                </c:pt>
                <c:pt idx="1842">
                  <c:v>0.97198061817196857</c:v>
                </c:pt>
                <c:pt idx="1843">
                  <c:v>0.97372618653504683</c:v>
                </c:pt>
                <c:pt idx="1844">
                  <c:v>0.9822734523128781</c:v>
                </c:pt>
                <c:pt idx="1845">
                  <c:v>0.96773708128931291</c:v>
                </c:pt>
                <c:pt idx="1846">
                  <c:v>0.98094922803743945</c:v>
                </c:pt>
                <c:pt idx="1847">
                  <c:v>0.98585487705781438</c:v>
                </c:pt>
                <c:pt idx="1848">
                  <c:v>0.98648689318927374</c:v>
                </c:pt>
                <c:pt idx="1849">
                  <c:v>0.98916543774641108</c:v>
                </c:pt>
                <c:pt idx="1850">
                  <c:v>1.0071026574773527</c:v>
                </c:pt>
                <c:pt idx="1851">
                  <c:v>0.97499021879796555</c:v>
                </c:pt>
                <c:pt idx="1852">
                  <c:v>0.98441026875733595</c:v>
                </c:pt>
                <c:pt idx="1853">
                  <c:v>0.98468113281367564</c:v>
                </c:pt>
                <c:pt idx="1854">
                  <c:v>0.97736780329250306</c:v>
                </c:pt>
                <c:pt idx="1855">
                  <c:v>0.96186836006861887</c:v>
                </c:pt>
                <c:pt idx="1856">
                  <c:v>0.95094350979625009</c:v>
                </c:pt>
                <c:pt idx="1857">
                  <c:v>0.9673157372016733</c:v>
                </c:pt>
                <c:pt idx="1858">
                  <c:v>0.94188461191199924</c:v>
                </c:pt>
                <c:pt idx="1859">
                  <c:v>0.9786619315616818</c:v>
                </c:pt>
                <c:pt idx="1860">
                  <c:v>0.96280133626267794</c:v>
                </c:pt>
                <c:pt idx="1861">
                  <c:v>0.96394498450055677</c:v>
                </c:pt>
                <c:pt idx="1862">
                  <c:v>0.98293556445059738</c:v>
                </c:pt>
                <c:pt idx="1863">
                  <c:v>0.9878111174647124</c:v>
                </c:pt>
                <c:pt idx="1864">
                  <c:v>0.98155114816263878</c:v>
                </c:pt>
                <c:pt idx="1865">
                  <c:v>0.97655521112348387</c:v>
                </c:pt>
                <c:pt idx="1866">
                  <c:v>0.97670569115478378</c:v>
                </c:pt>
                <c:pt idx="1867">
                  <c:v>0.97616396304210429</c:v>
                </c:pt>
                <c:pt idx="1868">
                  <c:v>0.98118999608751922</c:v>
                </c:pt>
                <c:pt idx="1869">
                  <c:v>0.97122821801546932</c:v>
                </c:pt>
                <c:pt idx="1870">
                  <c:v>0.97824058747404219</c:v>
                </c:pt>
                <c:pt idx="1871">
                  <c:v>0.95897914346766189</c:v>
                </c:pt>
                <c:pt idx="1872">
                  <c:v>0.97827068348030222</c:v>
                </c:pt>
                <c:pt idx="1873">
                  <c:v>0.96487796069461584</c:v>
                </c:pt>
                <c:pt idx="1874">
                  <c:v>0.95639088692930452</c:v>
                </c:pt>
                <c:pt idx="1875">
                  <c:v>0.96463719264453607</c:v>
                </c:pt>
                <c:pt idx="1876">
                  <c:v>0.95729376711710357</c:v>
                </c:pt>
                <c:pt idx="1877">
                  <c:v>0.95422397447858665</c:v>
                </c:pt>
                <c:pt idx="1878">
                  <c:v>0.96325277635657747</c:v>
                </c:pt>
                <c:pt idx="1879">
                  <c:v>0.97899298763054143</c:v>
                </c:pt>
                <c:pt idx="1880">
                  <c:v>0.97249225027838804</c:v>
                </c:pt>
                <c:pt idx="1881">
                  <c:v>0.98329671652571704</c:v>
                </c:pt>
                <c:pt idx="1882">
                  <c:v>0.98471122881993556</c:v>
                </c:pt>
                <c:pt idx="1883">
                  <c:v>0.96629247298883436</c:v>
                </c:pt>
                <c:pt idx="1884">
                  <c:v>0.97219129021578832</c:v>
                </c:pt>
                <c:pt idx="1885">
                  <c:v>0.98438017275107592</c:v>
                </c:pt>
                <c:pt idx="1886">
                  <c:v>0.97836097149908208</c:v>
                </c:pt>
                <c:pt idx="1887">
                  <c:v>0.97149908207180902</c:v>
                </c:pt>
                <c:pt idx="1888">
                  <c:v>0.97477954675414569</c:v>
                </c:pt>
                <c:pt idx="1889">
                  <c:v>0.98889457369007128</c:v>
                </c:pt>
                <c:pt idx="1890">
                  <c:v>0.97649501911096392</c:v>
                </c:pt>
                <c:pt idx="1891">
                  <c:v>0.97459897071658586</c:v>
                </c:pt>
                <c:pt idx="1892">
                  <c:v>0.97845125951786194</c:v>
                </c:pt>
                <c:pt idx="1893">
                  <c:v>0.96978360971499078</c:v>
                </c:pt>
                <c:pt idx="1894">
                  <c:v>0.97065639389652991</c:v>
                </c:pt>
                <c:pt idx="1895">
                  <c:v>0.98064826797483973</c:v>
                </c:pt>
                <c:pt idx="1896">
                  <c:v>0.97225148222830826</c:v>
                </c:pt>
                <c:pt idx="1897">
                  <c:v>0.9986155837120414</c:v>
                </c:pt>
                <c:pt idx="1898">
                  <c:v>0.97595329099828454</c:v>
                </c:pt>
                <c:pt idx="1899">
                  <c:v>0.99801366358684207</c:v>
                </c:pt>
                <c:pt idx="1900">
                  <c:v>0.97890269961176157</c:v>
                </c:pt>
                <c:pt idx="1901">
                  <c:v>0.97306407439732745</c:v>
                </c:pt>
                <c:pt idx="1902">
                  <c:v>0.96328287236283749</c:v>
                </c:pt>
                <c:pt idx="1903">
                  <c:v>0.9635838324254371</c:v>
                </c:pt>
                <c:pt idx="1904">
                  <c:v>0.96033346374936046</c:v>
                </c:pt>
                <c:pt idx="1905">
                  <c:v>0.98281518042555749</c:v>
                </c:pt>
                <c:pt idx="1906">
                  <c:v>0.95172600595900925</c:v>
                </c:pt>
                <c:pt idx="1907">
                  <c:v>0.97655521112348387</c:v>
                </c:pt>
                <c:pt idx="1908">
                  <c:v>0.96247028019381831</c:v>
                </c:pt>
                <c:pt idx="1909">
                  <c:v>0.97324465043488728</c:v>
                </c:pt>
                <c:pt idx="1910">
                  <c:v>0.98901495771511116</c:v>
                </c:pt>
                <c:pt idx="1911">
                  <c:v>0.99410118277304604</c:v>
                </c:pt>
                <c:pt idx="1912">
                  <c:v>0.97276311433472773</c:v>
                </c:pt>
                <c:pt idx="1913">
                  <c:v>0.97938423571192101</c:v>
                </c:pt>
                <c:pt idx="1914">
                  <c:v>0.97893279561802149</c:v>
                </c:pt>
                <c:pt idx="1915">
                  <c:v>0.97183013814066876</c:v>
                </c:pt>
                <c:pt idx="1916">
                  <c:v>0.97887260360550155</c:v>
                </c:pt>
                <c:pt idx="1917">
                  <c:v>0.98555391699521477</c:v>
                </c:pt>
                <c:pt idx="1918">
                  <c:v>0.96228970415625847</c:v>
                </c:pt>
                <c:pt idx="1919">
                  <c:v>0.95615011887922474</c:v>
                </c:pt>
                <c:pt idx="1920">
                  <c:v>0.95753453516718334</c:v>
                </c:pt>
                <c:pt idx="1921">
                  <c:v>0.96331296836909741</c:v>
                </c:pt>
                <c:pt idx="1922">
                  <c:v>0.95407349444728684</c:v>
                </c:pt>
                <c:pt idx="1923">
                  <c:v>0.9680079453456526</c:v>
                </c:pt>
                <c:pt idx="1924">
                  <c:v>0.97225148222830826</c:v>
                </c:pt>
                <c:pt idx="1925">
                  <c:v>0.97357570650374692</c:v>
                </c:pt>
                <c:pt idx="1926">
                  <c:v>0.98040749992475995</c:v>
                </c:pt>
                <c:pt idx="1927">
                  <c:v>0.98492190086375542</c:v>
                </c:pt>
                <c:pt idx="1928">
                  <c:v>0.97550185090438502</c:v>
                </c:pt>
                <c:pt idx="1929">
                  <c:v>0.97333493845366725</c:v>
                </c:pt>
                <c:pt idx="1930">
                  <c:v>0.96803804135191263</c:v>
                </c:pt>
                <c:pt idx="1931">
                  <c:v>0.97667559514852376</c:v>
                </c:pt>
                <c:pt idx="1932">
                  <c:v>0.98031721190598009</c:v>
                </c:pt>
                <c:pt idx="1933">
                  <c:v>0.96544978481355526</c:v>
                </c:pt>
                <c:pt idx="1934">
                  <c:v>0.99154302224094859</c:v>
                </c:pt>
                <c:pt idx="1935">
                  <c:v>0.97207090619074854</c:v>
                </c:pt>
                <c:pt idx="1936">
                  <c:v>0.97688626719234362</c:v>
                </c:pt>
                <c:pt idx="1937">
                  <c:v>1.001053360219099</c:v>
                </c:pt>
                <c:pt idx="1938">
                  <c:v>0.97107773798416952</c:v>
                </c:pt>
                <c:pt idx="1939">
                  <c:v>0.96882053751467179</c:v>
                </c:pt>
                <c:pt idx="1940">
                  <c:v>0.95912962349896169</c:v>
                </c:pt>
                <c:pt idx="1941">
                  <c:v>0.95879856743010206</c:v>
                </c:pt>
                <c:pt idx="1942">
                  <c:v>0.96602160893249467</c:v>
                </c:pt>
                <c:pt idx="1943">
                  <c:v>0.95605983086044477</c:v>
                </c:pt>
                <c:pt idx="1944">
                  <c:v>0.95642098293556443</c:v>
                </c:pt>
                <c:pt idx="1945">
                  <c:v>0.96454690462575621</c:v>
                </c:pt>
                <c:pt idx="1946">
                  <c:v>0.98079874800613953</c:v>
                </c:pt>
                <c:pt idx="1947">
                  <c:v>0.97486983477292566</c:v>
                </c:pt>
                <c:pt idx="1948">
                  <c:v>0.97035543383393019</c:v>
                </c:pt>
                <c:pt idx="1949">
                  <c:v>0.98067836398109975</c:v>
                </c:pt>
                <c:pt idx="1950">
                  <c:v>0.95196677400908902</c:v>
                </c:pt>
                <c:pt idx="1951">
                  <c:v>0.97860173954916185</c:v>
                </c:pt>
                <c:pt idx="1952">
                  <c:v>0.98510247690131525</c:v>
                </c:pt>
                <c:pt idx="1953">
                  <c:v>0.96250037620007822</c:v>
                </c:pt>
                <c:pt idx="1954">
                  <c:v>0.9772775152737232</c:v>
                </c:pt>
                <c:pt idx="1955">
                  <c:v>0.96818852138321243</c:v>
                </c:pt>
                <c:pt idx="1956">
                  <c:v>0.96529930478225534</c:v>
                </c:pt>
                <c:pt idx="1957">
                  <c:v>0.96075480783700007</c:v>
                </c:pt>
                <c:pt idx="1958">
                  <c:v>0.94865621332049233</c:v>
                </c:pt>
                <c:pt idx="1959">
                  <c:v>0.94019923556144103</c:v>
                </c:pt>
                <c:pt idx="1960">
                  <c:v>0.94537574863815577</c:v>
                </c:pt>
                <c:pt idx="1961">
                  <c:v>0.95780539922352304</c:v>
                </c:pt>
                <c:pt idx="1962">
                  <c:v>0.95879856743010206</c:v>
                </c:pt>
                <c:pt idx="1963">
                  <c:v>0.96791765732687274</c:v>
                </c:pt>
                <c:pt idx="1964">
                  <c:v>0.97941433171818104</c:v>
                </c:pt>
                <c:pt idx="1965">
                  <c:v>0.98010653986216034</c:v>
                </c:pt>
                <c:pt idx="1966">
                  <c:v>0.96436632858819638</c:v>
                </c:pt>
                <c:pt idx="1967">
                  <c:v>0.97715713124868331</c:v>
                </c:pt>
                <c:pt idx="1968">
                  <c:v>0.9673157372016733</c:v>
                </c:pt>
                <c:pt idx="1969">
                  <c:v>0.97923375568062121</c:v>
                </c:pt>
                <c:pt idx="1970">
                  <c:v>0.9742378186414663</c:v>
                </c:pt>
                <c:pt idx="1971">
                  <c:v>0.96863996147711195</c:v>
                </c:pt>
                <c:pt idx="1972">
                  <c:v>1.0009931682065789</c:v>
                </c:pt>
                <c:pt idx="1973">
                  <c:v>0.97071658590904986</c:v>
                </c:pt>
                <c:pt idx="1974">
                  <c:v>0.98359767658831676</c:v>
                </c:pt>
                <c:pt idx="1975">
                  <c:v>0.96611189695127453</c:v>
                </c:pt>
                <c:pt idx="1976">
                  <c:v>0.97670569115478378</c:v>
                </c:pt>
                <c:pt idx="1977">
                  <c:v>0.98215306828783822</c:v>
                </c:pt>
                <c:pt idx="1978">
                  <c:v>0.9659313209137147</c:v>
                </c:pt>
                <c:pt idx="1979">
                  <c:v>0.9707767779215698</c:v>
                </c:pt>
                <c:pt idx="1980">
                  <c:v>0.97568242694194485</c:v>
                </c:pt>
                <c:pt idx="1981">
                  <c:v>0.98191230023775844</c:v>
                </c:pt>
                <c:pt idx="1982">
                  <c:v>0.96505853673217568</c:v>
                </c:pt>
                <c:pt idx="1983">
                  <c:v>0.96885063352093181</c:v>
                </c:pt>
                <c:pt idx="1984">
                  <c:v>0.97014476179011044</c:v>
                </c:pt>
                <c:pt idx="1985">
                  <c:v>0.98013663586842026</c:v>
                </c:pt>
                <c:pt idx="1986">
                  <c:v>0.98829265356487195</c:v>
                </c:pt>
                <c:pt idx="1987">
                  <c:v>0.97438829867276611</c:v>
                </c:pt>
                <c:pt idx="1988">
                  <c:v>0.97483973876666563</c:v>
                </c:pt>
                <c:pt idx="1989">
                  <c:v>0.98922562975893102</c:v>
                </c:pt>
                <c:pt idx="1990">
                  <c:v>0.989195533752671</c:v>
                </c:pt>
                <c:pt idx="1991">
                  <c:v>0.98118999608751922</c:v>
                </c:pt>
                <c:pt idx="1992">
                  <c:v>0.966623529057694</c:v>
                </c:pt>
                <c:pt idx="1993">
                  <c:v>0.95482589460378609</c:v>
                </c:pt>
                <c:pt idx="1994">
                  <c:v>0.96247028019381831</c:v>
                </c:pt>
                <c:pt idx="1995">
                  <c:v>0.96153730399975923</c:v>
                </c:pt>
                <c:pt idx="1996">
                  <c:v>0.95741415114214345</c:v>
                </c:pt>
                <c:pt idx="1997">
                  <c:v>0.96647304902639419</c:v>
                </c:pt>
                <c:pt idx="1998">
                  <c:v>0.94964938152707135</c:v>
                </c:pt>
                <c:pt idx="1999">
                  <c:v>0.96367412044421707</c:v>
                </c:pt>
                <c:pt idx="2000">
                  <c:v>0.9526288861468083</c:v>
                </c:pt>
                <c:pt idx="2001">
                  <c:v>0.96075480783700007</c:v>
                </c:pt>
                <c:pt idx="2002">
                  <c:v>0.9537424383784272</c:v>
                </c:pt>
                <c:pt idx="2003">
                  <c:v>0.96719535317663341</c:v>
                </c:pt>
                <c:pt idx="2004">
                  <c:v>0.96529930478225534</c:v>
                </c:pt>
                <c:pt idx="2005">
                  <c:v>0.97068648990278994</c:v>
                </c:pt>
                <c:pt idx="2006">
                  <c:v>0.97499021879796555</c:v>
                </c:pt>
                <c:pt idx="2007">
                  <c:v>0.97026514581515033</c:v>
                </c:pt>
                <c:pt idx="2008">
                  <c:v>0.97691636319860353</c:v>
                </c:pt>
                <c:pt idx="2009">
                  <c:v>0.95344147831582748</c:v>
                </c:pt>
                <c:pt idx="2010">
                  <c:v>0.95852770337376225</c:v>
                </c:pt>
                <c:pt idx="2011">
                  <c:v>0.97619405904836432</c:v>
                </c:pt>
                <c:pt idx="2012">
                  <c:v>0.97258253829716801</c:v>
                </c:pt>
                <c:pt idx="2013">
                  <c:v>0.97571252294820476</c:v>
                </c:pt>
                <c:pt idx="2014">
                  <c:v>0.9576248231859632</c:v>
                </c:pt>
                <c:pt idx="2015">
                  <c:v>0.96674391308273389</c:v>
                </c:pt>
                <c:pt idx="2016">
                  <c:v>0.97625425106088426</c:v>
                </c:pt>
                <c:pt idx="2017">
                  <c:v>0.96930207361483134</c:v>
                </c:pt>
                <c:pt idx="2018">
                  <c:v>0.95973154362416102</c:v>
                </c:pt>
                <c:pt idx="2019">
                  <c:v>0.96605170493875459</c:v>
                </c:pt>
                <c:pt idx="2020">
                  <c:v>0.93746049899178374</c:v>
                </c:pt>
                <c:pt idx="2021">
                  <c:v>0.96960303367743106</c:v>
                </c:pt>
                <c:pt idx="2022">
                  <c:v>0.95311042224696785</c:v>
                </c:pt>
                <c:pt idx="2023">
                  <c:v>0.96186836006861887</c:v>
                </c:pt>
                <c:pt idx="2024">
                  <c:v>0.9756222349294249</c:v>
                </c:pt>
                <c:pt idx="2025">
                  <c:v>0.95226773407168863</c:v>
                </c:pt>
                <c:pt idx="2026">
                  <c:v>0.95010082162097087</c:v>
                </c:pt>
                <c:pt idx="2027">
                  <c:v>0.94940861347699157</c:v>
                </c:pt>
                <c:pt idx="2028">
                  <c:v>0.95581906281036511</c:v>
                </c:pt>
                <c:pt idx="2029">
                  <c:v>0.97661540313600381</c:v>
                </c:pt>
                <c:pt idx="2030">
                  <c:v>0.97345532247870703</c:v>
                </c:pt>
                <c:pt idx="2031">
                  <c:v>0.97041562584645014</c:v>
                </c:pt>
                <c:pt idx="2032">
                  <c:v>0.97977548379330059</c:v>
                </c:pt>
                <c:pt idx="2033">
                  <c:v>0.96617208896379447</c:v>
                </c:pt>
                <c:pt idx="2034">
                  <c:v>0.98085894001865948</c:v>
                </c:pt>
                <c:pt idx="2035">
                  <c:v>0.97083696993408974</c:v>
                </c:pt>
                <c:pt idx="2036">
                  <c:v>0.9613567279621994</c:v>
                </c:pt>
                <c:pt idx="2037">
                  <c:v>0.96090528786829987</c:v>
                </c:pt>
                <c:pt idx="2038">
                  <c:v>0.95903933548018183</c:v>
                </c:pt>
                <c:pt idx="2039">
                  <c:v>0.96806813735817254</c:v>
                </c:pt>
                <c:pt idx="2040">
                  <c:v>0.95840731934872248</c:v>
                </c:pt>
                <c:pt idx="2041">
                  <c:v>0.96879044150841187</c:v>
                </c:pt>
                <c:pt idx="2042">
                  <c:v>0.94946880548951151</c:v>
                </c:pt>
                <c:pt idx="2043">
                  <c:v>0.96842928943329221</c:v>
                </c:pt>
                <c:pt idx="2044">
                  <c:v>0.9523580220904686</c:v>
                </c:pt>
                <c:pt idx="2045">
                  <c:v>0.97715713124868331</c:v>
                </c:pt>
                <c:pt idx="2046">
                  <c:v>0.9682788094019924</c:v>
                </c:pt>
                <c:pt idx="2047">
                  <c:v>0.97213109820326837</c:v>
                </c:pt>
                <c:pt idx="2048">
                  <c:v>0.96809823336443257</c:v>
                </c:pt>
                <c:pt idx="2049">
                  <c:v>0.95214735004664885</c:v>
                </c:pt>
                <c:pt idx="2050">
                  <c:v>0.97679597917356364</c:v>
                </c:pt>
                <c:pt idx="2051">
                  <c:v>0.98371806061335665</c:v>
                </c:pt>
                <c:pt idx="2052">
                  <c:v>0.97730761127998311</c:v>
                </c:pt>
                <c:pt idx="2053">
                  <c:v>0.97691636319860353</c:v>
                </c:pt>
                <c:pt idx="2054">
                  <c:v>0.989195533752671</c:v>
                </c:pt>
                <c:pt idx="2055">
                  <c:v>0.96241008818129836</c:v>
                </c:pt>
                <c:pt idx="2056">
                  <c:v>0.97405724260390647</c:v>
                </c:pt>
                <c:pt idx="2057">
                  <c:v>0.98230354831913802</c:v>
                </c:pt>
                <c:pt idx="2058">
                  <c:v>0.98778102145845248</c:v>
                </c:pt>
                <c:pt idx="2059">
                  <c:v>0.97173985012188879</c:v>
                </c:pt>
                <c:pt idx="2060">
                  <c:v>0.97655521112348387</c:v>
                </c:pt>
                <c:pt idx="2061">
                  <c:v>0.95934029554278144</c:v>
                </c:pt>
                <c:pt idx="2062">
                  <c:v>0.95795587925482284</c:v>
                </c:pt>
                <c:pt idx="2063">
                  <c:v>0.9742378186414663</c:v>
                </c:pt>
                <c:pt idx="2064">
                  <c:v>0.96656333704517405</c:v>
                </c:pt>
                <c:pt idx="2065">
                  <c:v>0.94573690071327532</c:v>
                </c:pt>
                <c:pt idx="2066">
                  <c:v>0.96376440846299694</c:v>
                </c:pt>
                <c:pt idx="2067">
                  <c:v>0.96436632858819638</c:v>
                </c:pt>
                <c:pt idx="2068">
                  <c:v>0.99241580642248772</c:v>
                </c:pt>
                <c:pt idx="2069">
                  <c:v>0.96334306437535744</c:v>
                </c:pt>
                <c:pt idx="2070">
                  <c:v>0.97980557979956062</c:v>
                </c:pt>
                <c:pt idx="2071">
                  <c:v>0.96460709663827615</c:v>
                </c:pt>
                <c:pt idx="2072">
                  <c:v>0.96779727330183285</c:v>
                </c:pt>
                <c:pt idx="2073">
                  <c:v>0.97974538778704068</c:v>
                </c:pt>
                <c:pt idx="2074">
                  <c:v>0.96936226562735128</c:v>
                </c:pt>
                <c:pt idx="2075">
                  <c:v>0.96373431245673702</c:v>
                </c:pt>
                <c:pt idx="2076">
                  <c:v>0.98022692388720012</c:v>
                </c:pt>
                <c:pt idx="2077">
                  <c:v>0.9649682487133957</c:v>
                </c:pt>
                <c:pt idx="2078">
                  <c:v>0.9675866012580131</c:v>
                </c:pt>
                <c:pt idx="2079">
                  <c:v>0.97134860204050921</c:v>
                </c:pt>
                <c:pt idx="2080">
                  <c:v>0.96400517651307671</c:v>
                </c:pt>
                <c:pt idx="2081">
                  <c:v>0.95675203900442407</c:v>
                </c:pt>
                <c:pt idx="2082">
                  <c:v>0.97772895536762272</c:v>
                </c:pt>
                <c:pt idx="2083">
                  <c:v>0.96328287236283749</c:v>
                </c:pt>
                <c:pt idx="2084">
                  <c:v>0.95976163963042105</c:v>
                </c:pt>
                <c:pt idx="2085">
                  <c:v>0.95007072561471095</c:v>
                </c:pt>
                <c:pt idx="2086">
                  <c:v>0.9592801035302615</c:v>
                </c:pt>
                <c:pt idx="2087">
                  <c:v>0.9599723116742408</c:v>
                </c:pt>
                <c:pt idx="2088">
                  <c:v>0.9760435790170644</c:v>
                </c:pt>
                <c:pt idx="2089">
                  <c:v>0.9770066512173835</c:v>
                </c:pt>
                <c:pt idx="2090">
                  <c:v>0.96713516116411358</c:v>
                </c:pt>
                <c:pt idx="2091">
                  <c:v>0.95822674331116264</c:v>
                </c:pt>
                <c:pt idx="2092">
                  <c:v>0.97845125951786194</c:v>
                </c:pt>
                <c:pt idx="2093">
                  <c:v>0.98010653986216034</c:v>
                </c:pt>
                <c:pt idx="2094">
                  <c:v>0.96854967345833209</c:v>
                </c:pt>
                <c:pt idx="2095">
                  <c:v>0.97483973876666563</c:v>
                </c:pt>
                <c:pt idx="2096">
                  <c:v>0.96189845607487889</c:v>
                </c:pt>
                <c:pt idx="2097">
                  <c:v>0.95338128630330754</c:v>
                </c:pt>
                <c:pt idx="2098">
                  <c:v>0.95648117494808438</c:v>
                </c:pt>
                <c:pt idx="2099">
                  <c:v>0.95311042224696785</c:v>
                </c:pt>
                <c:pt idx="2100">
                  <c:v>0.96415565654437652</c:v>
                </c:pt>
                <c:pt idx="2101">
                  <c:v>0.96256056821259817</c:v>
                </c:pt>
                <c:pt idx="2102">
                  <c:v>0.97122821801546932</c:v>
                </c:pt>
                <c:pt idx="2103">
                  <c:v>0.96394498450055677</c:v>
                </c:pt>
                <c:pt idx="2104">
                  <c:v>0.98094922803743945</c:v>
                </c:pt>
                <c:pt idx="2105">
                  <c:v>0.973545610497487</c:v>
                </c:pt>
                <c:pt idx="2106">
                  <c:v>0.9840792126884762</c:v>
                </c:pt>
                <c:pt idx="2107">
                  <c:v>0.98260450838173774</c:v>
                </c:pt>
                <c:pt idx="2108">
                  <c:v>0.96900111355223162</c:v>
                </c:pt>
                <c:pt idx="2109">
                  <c:v>0.96752640924549316</c:v>
                </c:pt>
                <c:pt idx="2110">
                  <c:v>0.95639088692930452</c:v>
                </c:pt>
                <c:pt idx="2111">
                  <c:v>0.96560026484485506</c:v>
                </c:pt>
                <c:pt idx="2112">
                  <c:v>0.95711319107954373</c:v>
                </c:pt>
                <c:pt idx="2113">
                  <c:v>0.95407349444728684</c:v>
                </c:pt>
                <c:pt idx="2114">
                  <c:v>0.96003250368676074</c:v>
                </c:pt>
                <c:pt idx="2115">
                  <c:v>0.97411743461642641</c:v>
                </c:pt>
                <c:pt idx="2116">
                  <c:v>0.96213922412495867</c:v>
                </c:pt>
                <c:pt idx="2117">
                  <c:v>0.96554007283233512</c:v>
                </c:pt>
                <c:pt idx="2118">
                  <c:v>0.95530743070394564</c:v>
                </c:pt>
                <c:pt idx="2119">
                  <c:v>0.96340325638787738</c:v>
                </c:pt>
                <c:pt idx="2120">
                  <c:v>0.9613567279621994</c:v>
                </c:pt>
                <c:pt idx="2121">
                  <c:v>0.96078490384325999</c:v>
                </c:pt>
                <c:pt idx="2122">
                  <c:v>0.96228970415625847</c:v>
                </c:pt>
                <c:pt idx="2123">
                  <c:v>0.96078490384325999</c:v>
                </c:pt>
                <c:pt idx="2124">
                  <c:v>0.9675866012580131</c:v>
                </c:pt>
                <c:pt idx="2125">
                  <c:v>0.9668943931140338</c:v>
                </c:pt>
                <c:pt idx="2126">
                  <c:v>0.97053600987149002</c:v>
                </c:pt>
                <c:pt idx="2127">
                  <c:v>0.96782736930809277</c:v>
                </c:pt>
                <c:pt idx="2128">
                  <c:v>0.9699340897462907</c:v>
                </c:pt>
                <c:pt idx="2129">
                  <c:v>0.97547175489812499</c:v>
                </c:pt>
                <c:pt idx="2130">
                  <c:v>0.97477954675414569</c:v>
                </c:pt>
                <c:pt idx="2131">
                  <c:v>0.9574743431546634</c:v>
                </c:pt>
                <c:pt idx="2132">
                  <c:v>0.96072471183074004</c:v>
                </c:pt>
                <c:pt idx="2133">
                  <c:v>0.94712131700123392</c:v>
                </c:pt>
                <c:pt idx="2134">
                  <c:v>0.9555481987540253</c:v>
                </c:pt>
                <c:pt idx="2135">
                  <c:v>0.96367412044421707</c:v>
                </c:pt>
                <c:pt idx="2136">
                  <c:v>0.95359195834712729</c:v>
                </c:pt>
                <c:pt idx="2137">
                  <c:v>0.95196677400908902</c:v>
                </c:pt>
                <c:pt idx="2138">
                  <c:v>0.95323080627200774</c:v>
                </c:pt>
                <c:pt idx="2139">
                  <c:v>0.95064254973365037</c:v>
                </c:pt>
                <c:pt idx="2140">
                  <c:v>0.95323080627200774</c:v>
                </c:pt>
                <c:pt idx="2141">
                  <c:v>0.9673157372016733</c:v>
                </c:pt>
                <c:pt idx="2142">
                  <c:v>0.97769885936136269</c:v>
                </c:pt>
                <c:pt idx="2143">
                  <c:v>0.96415565654437652</c:v>
                </c:pt>
                <c:pt idx="2144">
                  <c:v>0.96532940078851537</c:v>
                </c:pt>
                <c:pt idx="2145">
                  <c:v>0.9720107141782286</c:v>
                </c:pt>
                <c:pt idx="2146">
                  <c:v>0.97119812200920941</c:v>
                </c:pt>
                <c:pt idx="2147">
                  <c:v>0.96557016883859514</c:v>
                </c:pt>
                <c:pt idx="2148">
                  <c:v>0.98690823727691335</c:v>
                </c:pt>
                <c:pt idx="2149">
                  <c:v>0.97778914738014266</c:v>
                </c:pt>
                <c:pt idx="2150">
                  <c:v>0.96584103289493484</c:v>
                </c:pt>
                <c:pt idx="2151">
                  <c:v>0.97757847533632292</c:v>
                </c:pt>
                <c:pt idx="2152">
                  <c:v>0.97062629789027</c:v>
                </c:pt>
                <c:pt idx="2153">
                  <c:v>0.95843741535498239</c:v>
                </c:pt>
                <c:pt idx="2154">
                  <c:v>0.95335119029704762</c:v>
                </c:pt>
                <c:pt idx="2155">
                  <c:v>0.96803804135191263</c:v>
                </c:pt>
                <c:pt idx="2156">
                  <c:v>0.94856592530171246</c:v>
                </c:pt>
                <c:pt idx="2157">
                  <c:v>0.95840731934872248</c:v>
                </c:pt>
                <c:pt idx="2158">
                  <c:v>0.96737592921419324</c:v>
                </c:pt>
                <c:pt idx="2159">
                  <c:v>0.96704487314533361</c:v>
                </c:pt>
                <c:pt idx="2160">
                  <c:v>0.94979986155837115</c:v>
                </c:pt>
                <c:pt idx="2161">
                  <c:v>0.95750443916092332</c:v>
                </c:pt>
                <c:pt idx="2162">
                  <c:v>0.9649682487133957</c:v>
                </c:pt>
                <c:pt idx="2163">
                  <c:v>0.95672194299816415</c:v>
                </c:pt>
                <c:pt idx="2164">
                  <c:v>0.94648930086977456</c:v>
                </c:pt>
                <c:pt idx="2165">
                  <c:v>0.98182201221897858</c:v>
                </c:pt>
                <c:pt idx="2166">
                  <c:v>0.96906130556475156</c:v>
                </c:pt>
                <c:pt idx="2167">
                  <c:v>0.96833900141451235</c:v>
                </c:pt>
                <c:pt idx="2168">
                  <c:v>0.9714689860655491</c:v>
                </c:pt>
                <c:pt idx="2169">
                  <c:v>0.96854967345833209</c:v>
                </c:pt>
                <c:pt idx="2170">
                  <c:v>0.98775092545219245</c:v>
                </c:pt>
                <c:pt idx="2171">
                  <c:v>0.96734583320793333</c:v>
                </c:pt>
                <c:pt idx="2172">
                  <c:v>0.95681223101694401</c:v>
                </c:pt>
                <c:pt idx="2173">
                  <c:v>0.97186023414692868</c:v>
                </c:pt>
                <c:pt idx="2174">
                  <c:v>0.96578084088241489</c:v>
                </c:pt>
                <c:pt idx="2175">
                  <c:v>0.9641255605381166</c:v>
                </c:pt>
                <c:pt idx="2176">
                  <c:v>0.93869443524844254</c:v>
                </c:pt>
                <c:pt idx="2177">
                  <c:v>0.95750443916092332</c:v>
                </c:pt>
                <c:pt idx="2178">
                  <c:v>0.95431426249736662</c:v>
                </c:pt>
                <c:pt idx="2179">
                  <c:v>0.94065067565534055</c:v>
                </c:pt>
                <c:pt idx="2180">
                  <c:v>0.9628916242814578</c:v>
                </c:pt>
                <c:pt idx="2181">
                  <c:v>0.95124446985884969</c:v>
                </c:pt>
                <c:pt idx="2182">
                  <c:v>0.96030336774310054</c:v>
                </c:pt>
                <c:pt idx="2183">
                  <c:v>0.95891895145514194</c:v>
                </c:pt>
                <c:pt idx="2184">
                  <c:v>0.9595509675866013</c:v>
                </c:pt>
                <c:pt idx="2185">
                  <c:v>0.95906943148644175</c:v>
                </c:pt>
                <c:pt idx="2186">
                  <c:v>0.96906130556475156</c:v>
                </c:pt>
                <c:pt idx="2187">
                  <c:v>0.96439642459445629</c:v>
                </c:pt>
                <c:pt idx="2188">
                  <c:v>0.94459325247539649</c:v>
                </c:pt>
                <c:pt idx="2189">
                  <c:v>0.98248412435669785</c:v>
                </c:pt>
                <c:pt idx="2190">
                  <c:v>0.95497637463508589</c:v>
                </c:pt>
                <c:pt idx="2191">
                  <c:v>0.95912962349896169</c:v>
                </c:pt>
                <c:pt idx="2192">
                  <c:v>0.94019923556144103</c:v>
                </c:pt>
                <c:pt idx="2193">
                  <c:v>0.94982995756463118</c:v>
                </c:pt>
                <c:pt idx="2194">
                  <c:v>0.95232792608420858</c:v>
                </c:pt>
                <c:pt idx="2195">
                  <c:v>0.95473560658500622</c:v>
                </c:pt>
                <c:pt idx="2196">
                  <c:v>0.94350979625003761</c:v>
                </c:pt>
                <c:pt idx="2197">
                  <c:v>0.94128269178679991</c:v>
                </c:pt>
                <c:pt idx="2198">
                  <c:v>0.96012279170554071</c:v>
                </c:pt>
                <c:pt idx="2199">
                  <c:v>0.96668372107021394</c:v>
                </c:pt>
                <c:pt idx="2200">
                  <c:v>0.94998043759593098</c:v>
                </c:pt>
                <c:pt idx="2201">
                  <c:v>0.97390676257260667</c:v>
                </c:pt>
                <c:pt idx="2202">
                  <c:v>0.96376440846299694</c:v>
                </c:pt>
                <c:pt idx="2203">
                  <c:v>0.95882866343636197</c:v>
                </c:pt>
                <c:pt idx="2204">
                  <c:v>0.94007885153640114</c:v>
                </c:pt>
                <c:pt idx="2205">
                  <c:v>0.97321455442862737</c:v>
                </c:pt>
                <c:pt idx="2206">
                  <c:v>0.9641255605381166</c:v>
                </c:pt>
                <c:pt idx="2207">
                  <c:v>0.96761669726427302</c:v>
                </c:pt>
                <c:pt idx="2208">
                  <c:v>0.97541156288560504</c:v>
                </c:pt>
                <c:pt idx="2209">
                  <c:v>0.95810635928612276</c:v>
                </c:pt>
                <c:pt idx="2210">
                  <c:v>0.95593944683540499</c:v>
                </c:pt>
                <c:pt idx="2211">
                  <c:v>0.96003250368676074</c:v>
                </c:pt>
                <c:pt idx="2212">
                  <c:v>0.94164384386191957</c:v>
                </c:pt>
                <c:pt idx="2213">
                  <c:v>0.95943058356156141</c:v>
                </c:pt>
                <c:pt idx="2214">
                  <c:v>0.94119240376801994</c:v>
                </c:pt>
                <c:pt idx="2215">
                  <c:v>0.95587925482288505</c:v>
                </c:pt>
                <c:pt idx="2216">
                  <c:v>0.94979986155837115</c:v>
                </c:pt>
                <c:pt idx="2217">
                  <c:v>0.97119812200920941</c:v>
                </c:pt>
                <c:pt idx="2218">
                  <c:v>0.94730189303879375</c:v>
                </c:pt>
                <c:pt idx="2219">
                  <c:v>0.95630059891052455</c:v>
                </c:pt>
                <c:pt idx="2220">
                  <c:v>0.95612002287296471</c:v>
                </c:pt>
                <c:pt idx="2221">
                  <c:v>0.95004062960845093</c:v>
                </c:pt>
                <c:pt idx="2222">
                  <c:v>0.95837722334246245</c:v>
                </c:pt>
                <c:pt idx="2223">
                  <c:v>0.9854636289764348</c:v>
                </c:pt>
                <c:pt idx="2224">
                  <c:v>0.95666175098564421</c:v>
                </c:pt>
                <c:pt idx="2225">
                  <c:v>0.9673157372016733</c:v>
                </c:pt>
                <c:pt idx="2226">
                  <c:v>0.94862611731423241</c:v>
                </c:pt>
                <c:pt idx="2227">
                  <c:v>0.95864808739880214</c:v>
                </c:pt>
                <c:pt idx="2228">
                  <c:v>0.96352364041291716</c:v>
                </c:pt>
                <c:pt idx="2229">
                  <c:v>0.97062629789027</c:v>
                </c:pt>
                <c:pt idx="2230">
                  <c:v>0.96069461582448012</c:v>
                </c:pt>
                <c:pt idx="2231">
                  <c:v>0.95714328708580376</c:v>
                </c:pt>
                <c:pt idx="2232">
                  <c:v>0.95326090227826765</c:v>
                </c:pt>
                <c:pt idx="2233">
                  <c:v>0.96012279170554071</c:v>
                </c:pt>
                <c:pt idx="2234">
                  <c:v>0.96641285701387425</c:v>
                </c:pt>
                <c:pt idx="2235">
                  <c:v>0.9443223884190568</c:v>
                </c:pt>
                <c:pt idx="2236">
                  <c:v>0.94862611731423241</c:v>
                </c:pt>
                <c:pt idx="2237">
                  <c:v>0.95684232702320404</c:v>
                </c:pt>
                <c:pt idx="2238">
                  <c:v>0.95798597526108287</c:v>
                </c:pt>
                <c:pt idx="2239">
                  <c:v>0.94618834080717484</c:v>
                </c:pt>
                <c:pt idx="2240">
                  <c:v>0.95711319107954373</c:v>
                </c:pt>
                <c:pt idx="2241">
                  <c:v>0.94961928552081143</c:v>
                </c:pt>
                <c:pt idx="2242">
                  <c:v>0.9641255605381166</c:v>
                </c:pt>
                <c:pt idx="2243">
                  <c:v>0.95476570259126614</c:v>
                </c:pt>
                <c:pt idx="2244">
                  <c:v>0.96511872874469562</c:v>
                </c:pt>
                <c:pt idx="2245">
                  <c:v>0.97297378637854759</c:v>
                </c:pt>
                <c:pt idx="2246">
                  <c:v>0.96475757666957596</c:v>
                </c:pt>
                <c:pt idx="2247">
                  <c:v>0.97489993077918558</c:v>
                </c:pt>
                <c:pt idx="2248">
                  <c:v>0.96439642459445629</c:v>
                </c:pt>
                <c:pt idx="2249">
                  <c:v>0.97872212357420174</c:v>
                </c:pt>
                <c:pt idx="2250">
                  <c:v>0.94582718873205529</c:v>
                </c:pt>
                <c:pt idx="2251">
                  <c:v>0.97080687392782983</c:v>
                </c:pt>
                <c:pt idx="2252">
                  <c:v>0.95663165497938418</c:v>
                </c:pt>
                <c:pt idx="2253">
                  <c:v>0.96283143226893786</c:v>
                </c:pt>
                <c:pt idx="2254">
                  <c:v>0.97763866734884286</c:v>
                </c:pt>
                <c:pt idx="2255">
                  <c:v>0.97288349835976762</c:v>
                </c:pt>
                <c:pt idx="2256">
                  <c:v>0.95943058356156141</c:v>
                </c:pt>
                <c:pt idx="2257">
                  <c:v>0.9864267011767538</c:v>
                </c:pt>
                <c:pt idx="2258">
                  <c:v>0.96460709663827615</c:v>
                </c:pt>
                <c:pt idx="2259">
                  <c:v>0.96605170493875459</c:v>
                </c:pt>
                <c:pt idx="2260">
                  <c:v>0.95572877479158513</c:v>
                </c:pt>
                <c:pt idx="2261">
                  <c:v>0.95714328708580376</c:v>
                </c:pt>
                <c:pt idx="2262">
                  <c:v>0.96653324103891414</c:v>
                </c:pt>
                <c:pt idx="2263">
                  <c:v>0.96632256899509439</c:v>
                </c:pt>
                <c:pt idx="2264">
                  <c:v>0.97706684322990334</c:v>
                </c:pt>
                <c:pt idx="2265">
                  <c:v>0.96117615192463957</c:v>
                </c:pt>
                <c:pt idx="2266">
                  <c:v>0.95464531856622625</c:v>
                </c:pt>
                <c:pt idx="2267">
                  <c:v>0.95395311042224695</c:v>
                </c:pt>
                <c:pt idx="2268">
                  <c:v>0.95214735004664885</c:v>
                </c:pt>
                <c:pt idx="2269">
                  <c:v>0.95299003822192796</c:v>
                </c:pt>
                <c:pt idx="2270">
                  <c:v>0.94660968489481445</c:v>
                </c:pt>
                <c:pt idx="2271">
                  <c:v>0.95169590995274922</c:v>
                </c:pt>
                <c:pt idx="2272">
                  <c:v>0.96409546453185657</c:v>
                </c:pt>
                <c:pt idx="2273">
                  <c:v>0.95431426249736662</c:v>
                </c:pt>
                <c:pt idx="2274">
                  <c:v>0.98287537243807743</c:v>
                </c:pt>
                <c:pt idx="2275">
                  <c:v>0.97529117886056516</c:v>
                </c:pt>
                <c:pt idx="2276">
                  <c:v>0.96773708128931291</c:v>
                </c:pt>
                <c:pt idx="2277">
                  <c:v>0.96773708128931291</c:v>
                </c:pt>
                <c:pt idx="2278">
                  <c:v>0.97676588316730373</c:v>
                </c:pt>
                <c:pt idx="2279">
                  <c:v>0.96641285701387425</c:v>
                </c:pt>
                <c:pt idx="2280">
                  <c:v>0.96523911276973551</c:v>
                </c:pt>
                <c:pt idx="2281">
                  <c:v>0.97255244229090798</c:v>
                </c:pt>
                <c:pt idx="2282">
                  <c:v>0.95022120564601076</c:v>
                </c:pt>
                <c:pt idx="2283">
                  <c:v>0.96463719264453607</c:v>
                </c:pt>
                <c:pt idx="2284">
                  <c:v>0.96698468113281366</c:v>
                </c:pt>
                <c:pt idx="2285">
                  <c:v>0.95049206970235045</c:v>
                </c:pt>
                <c:pt idx="2286">
                  <c:v>0.94835525325789272</c:v>
                </c:pt>
                <c:pt idx="2287">
                  <c:v>0.96078490384325999</c:v>
                </c:pt>
                <c:pt idx="2288">
                  <c:v>0.94408162036897703</c:v>
                </c:pt>
                <c:pt idx="2289">
                  <c:v>0.95837722334246245</c:v>
                </c:pt>
                <c:pt idx="2290">
                  <c:v>0.96535949679477528</c:v>
                </c:pt>
                <c:pt idx="2291">
                  <c:v>0.94537574863815577</c:v>
                </c:pt>
                <c:pt idx="2292">
                  <c:v>0.95801607126734278</c:v>
                </c:pt>
                <c:pt idx="2293">
                  <c:v>0.96168778403105903</c:v>
                </c:pt>
                <c:pt idx="2294">
                  <c:v>0.96761669726427302</c:v>
                </c:pt>
                <c:pt idx="2295">
                  <c:v>0.95359195834712729</c:v>
                </c:pt>
                <c:pt idx="2296">
                  <c:v>0.96851957745207207</c:v>
                </c:pt>
                <c:pt idx="2297">
                  <c:v>0.95669184699190413</c:v>
                </c:pt>
                <c:pt idx="2298">
                  <c:v>0.95019110963975084</c:v>
                </c:pt>
                <c:pt idx="2299">
                  <c:v>0.95864808739880214</c:v>
                </c:pt>
                <c:pt idx="2300">
                  <c:v>0.9689710175459717</c:v>
                </c:pt>
                <c:pt idx="2301">
                  <c:v>0.96909140157101148</c:v>
                </c:pt>
                <c:pt idx="2302">
                  <c:v>0.95873837541758211</c:v>
                </c:pt>
                <c:pt idx="2303">
                  <c:v>0.96812832937069249</c:v>
                </c:pt>
                <c:pt idx="2304">
                  <c:v>0.96171788003731906</c:v>
                </c:pt>
                <c:pt idx="2305">
                  <c:v>0.94381075631263733</c:v>
                </c:pt>
                <c:pt idx="2306">
                  <c:v>0.95190658199656908</c:v>
                </c:pt>
                <c:pt idx="2307">
                  <c:v>0.95031149366479073</c:v>
                </c:pt>
                <c:pt idx="2308">
                  <c:v>0.95100370180877003</c:v>
                </c:pt>
                <c:pt idx="2309">
                  <c:v>0.9642760405694164</c:v>
                </c:pt>
                <c:pt idx="2310">
                  <c:v>0.96523911276973551</c:v>
                </c:pt>
                <c:pt idx="2311">
                  <c:v>0.95642098293556443</c:v>
                </c:pt>
                <c:pt idx="2312">
                  <c:v>0.95581906281036511</c:v>
                </c:pt>
                <c:pt idx="2313">
                  <c:v>0.96253047220633825</c:v>
                </c:pt>
                <c:pt idx="2314">
                  <c:v>0.94995034158967107</c:v>
                </c:pt>
                <c:pt idx="2315">
                  <c:v>0.96237999217503833</c:v>
                </c:pt>
                <c:pt idx="2316">
                  <c:v>0.95636079092304449</c:v>
                </c:pt>
                <c:pt idx="2317">
                  <c:v>0.95569867878532522</c:v>
                </c:pt>
                <c:pt idx="2318">
                  <c:v>0.96797784933939268</c:v>
                </c:pt>
                <c:pt idx="2319">
                  <c:v>0.94519517260059593</c:v>
                </c:pt>
                <c:pt idx="2320">
                  <c:v>0.9533210942907876</c:v>
                </c:pt>
                <c:pt idx="2321">
                  <c:v>0.94329912420621786</c:v>
                </c:pt>
                <c:pt idx="2322">
                  <c:v>0.94898726938935207</c:v>
                </c:pt>
                <c:pt idx="2323">
                  <c:v>0.95196677400908902</c:v>
                </c:pt>
                <c:pt idx="2324">
                  <c:v>0.9434797002437777</c:v>
                </c:pt>
                <c:pt idx="2325">
                  <c:v>0.94287778011857826</c:v>
                </c:pt>
                <c:pt idx="2326">
                  <c:v>0.96213922412495867</c:v>
                </c:pt>
                <c:pt idx="2327">
                  <c:v>0.96036355975562038</c:v>
                </c:pt>
                <c:pt idx="2328">
                  <c:v>0.95247840611550849</c:v>
                </c:pt>
                <c:pt idx="2329">
                  <c:v>0.96535949679477528</c:v>
                </c:pt>
                <c:pt idx="2330">
                  <c:v>0.97634453907966412</c:v>
                </c:pt>
                <c:pt idx="2331">
                  <c:v>0.95557829476028533</c:v>
                </c:pt>
                <c:pt idx="2332">
                  <c:v>0.94865621332049233</c:v>
                </c:pt>
                <c:pt idx="2333">
                  <c:v>0.95645107894182446</c:v>
                </c:pt>
                <c:pt idx="2334">
                  <c:v>0.96171788003731906</c:v>
                </c:pt>
                <c:pt idx="2335">
                  <c:v>0.97050591386523011</c:v>
                </c:pt>
                <c:pt idx="2336">
                  <c:v>0.94600776476961512</c:v>
                </c:pt>
                <c:pt idx="2337">
                  <c:v>0.96168778403105903</c:v>
                </c:pt>
                <c:pt idx="2338">
                  <c:v>0.9422457639871189</c:v>
                </c:pt>
                <c:pt idx="2339">
                  <c:v>0.95413368645980678</c:v>
                </c:pt>
                <c:pt idx="2340">
                  <c:v>0.94329912420621786</c:v>
                </c:pt>
                <c:pt idx="2341">
                  <c:v>0.94940861347699157</c:v>
                </c:pt>
                <c:pt idx="2342">
                  <c:v>0.97327474644114731</c:v>
                </c:pt>
                <c:pt idx="2343">
                  <c:v>0.93652752279772478</c:v>
                </c:pt>
                <c:pt idx="2344">
                  <c:v>0.94703102898245406</c:v>
                </c:pt>
                <c:pt idx="2345">
                  <c:v>0.94504469256929602</c:v>
                </c:pt>
                <c:pt idx="2346">
                  <c:v>0.93625665874138497</c:v>
                </c:pt>
                <c:pt idx="2347">
                  <c:v>0.94164384386191957</c:v>
                </c:pt>
                <c:pt idx="2348">
                  <c:v>0.94092153971168024</c:v>
                </c:pt>
                <c:pt idx="2349">
                  <c:v>0.95795587925482284</c:v>
                </c:pt>
                <c:pt idx="2350">
                  <c:v>0.95491618262256595</c:v>
                </c:pt>
                <c:pt idx="2351">
                  <c:v>0.96544978481355526</c:v>
                </c:pt>
                <c:pt idx="2352">
                  <c:v>0.95085322177747011</c:v>
                </c:pt>
                <c:pt idx="2353">
                  <c:v>0.96198874409365875</c:v>
                </c:pt>
                <c:pt idx="2354">
                  <c:v>0.9541637824660667</c:v>
                </c:pt>
                <c:pt idx="2355">
                  <c:v>0.94784362115147325</c:v>
                </c:pt>
                <c:pt idx="2356">
                  <c:v>0.93986817949258128</c:v>
                </c:pt>
                <c:pt idx="2357">
                  <c:v>0.95563848677280527</c:v>
                </c:pt>
                <c:pt idx="2358">
                  <c:v>0.94068077166160047</c:v>
                </c:pt>
                <c:pt idx="2359">
                  <c:v>0.92942486532037194</c:v>
                </c:pt>
                <c:pt idx="2360">
                  <c:v>0.93616637072260511</c:v>
                </c:pt>
                <c:pt idx="2361">
                  <c:v>0.92788996900111353</c:v>
                </c:pt>
                <c:pt idx="2362">
                  <c:v>0.93755078701056371</c:v>
                </c:pt>
                <c:pt idx="2363">
                  <c:v>0.93583531465374548</c:v>
                </c:pt>
                <c:pt idx="2364">
                  <c:v>0.91019351732025155</c:v>
                </c:pt>
                <c:pt idx="2365">
                  <c:v>0.94844554127667258</c:v>
                </c:pt>
                <c:pt idx="2366">
                  <c:v>0.94673006891985434</c:v>
                </c:pt>
                <c:pt idx="2367">
                  <c:v>0.94633882083847476</c:v>
                </c:pt>
                <c:pt idx="2368">
                  <c:v>0.93983808348632136</c:v>
                </c:pt>
                <c:pt idx="2369">
                  <c:v>0.96186836006861887</c:v>
                </c:pt>
                <c:pt idx="2370">
                  <c:v>0.95253859812802844</c:v>
                </c:pt>
                <c:pt idx="2371">
                  <c:v>0.95446474252866642</c:v>
                </c:pt>
                <c:pt idx="2372">
                  <c:v>0.95557829476028533</c:v>
                </c:pt>
                <c:pt idx="2373">
                  <c:v>0.93770126704186352</c:v>
                </c:pt>
                <c:pt idx="2374">
                  <c:v>0.94919794143317182</c:v>
                </c:pt>
                <c:pt idx="2375">
                  <c:v>0.93971769946128147</c:v>
                </c:pt>
                <c:pt idx="2376">
                  <c:v>0.944171908387757</c:v>
                </c:pt>
                <c:pt idx="2377">
                  <c:v>0.94200499593703912</c:v>
                </c:pt>
                <c:pt idx="2378">
                  <c:v>0.95497637463508589</c:v>
                </c:pt>
                <c:pt idx="2379">
                  <c:v>0.95076293375869025</c:v>
                </c:pt>
                <c:pt idx="2380">
                  <c:v>0.94691064495741417</c:v>
                </c:pt>
                <c:pt idx="2381">
                  <c:v>0.93619646672886503</c:v>
                </c:pt>
                <c:pt idx="2382">
                  <c:v>0.94645920486351465</c:v>
                </c:pt>
                <c:pt idx="2383">
                  <c:v>0.93225388990880909</c:v>
                </c:pt>
                <c:pt idx="2384">
                  <c:v>0.94543594065067571</c:v>
                </c:pt>
                <c:pt idx="2385">
                  <c:v>0.93231408192132903</c:v>
                </c:pt>
                <c:pt idx="2386">
                  <c:v>0.94040990760526078</c:v>
                </c:pt>
                <c:pt idx="2387">
                  <c:v>0.91904174316068254</c:v>
                </c:pt>
                <c:pt idx="2388">
                  <c:v>0.93562464260992562</c:v>
                </c:pt>
                <c:pt idx="2389">
                  <c:v>0.92782977698859359</c:v>
                </c:pt>
                <c:pt idx="2390">
                  <c:v>0.95347157432208751</c:v>
                </c:pt>
                <c:pt idx="2391">
                  <c:v>0.92545219249405608</c:v>
                </c:pt>
                <c:pt idx="2392">
                  <c:v>0.92984620940801155</c:v>
                </c:pt>
                <c:pt idx="2393">
                  <c:v>0.93120052968971012</c:v>
                </c:pt>
                <c:pt idx="2394">
                  <c:v>0.95425407048484667</c:v>
                </c:pt>
                <c:pt idx="2395">
                  <c:v>0.95503656664760583</c:v>
                </c:pt>
                <c:pt idx="2396">
                  <c:v>0.93538387455984595</c:v>
                </c:pt>
                <c:pt idx="2397">
                  <c:v>0.94405152436271711</c:v>
                </c:pt>
                <c:pt idx="2398">
                  <c:v>0.96222951214373853</c:v>
                </c:pt>
                <c:pt idx="2399">
                  <c:v>0.96316248833779761</c:v>
                </c:pt>
                <c:pt idx="2400">
                  <c:v>0.94883678935805216</c:v>
                </c:pt>
                <c:pt idx="2401">
                  <c:v>0.94742227706383364</c:v>
                </c:pt>
                <c:pt idx="2402">
                  <c:v>0.95873837541758211</c:v>
                </c:pt>
                <c:pt idx="2403">
                  <c:v>0.95118427784632975</c:v>
                </c:pt>
                <c:pt idx="2404">
                  <c:v>0.96445661660697624</c:v>
                </c:pt>
                <c:pt idx="2405">
                  <c:v>0.94302826014987806</c:v>
                </c:pt>
                <c:pt idx="2406">
                  <c:v>0.95268907815932824</c:v>
                </c:pt>
                <c:pt idx="2407">
                  <c:v>0.9484756372829326</c:v>
                </c:pt>
                <c:pt idx="2408">
                  <c:v>0.94095163571794027</c:v>
                </c:pt>
                <c:pt idx="2409">
                  <c:v>0.94784362115147325</c:v>
                </c:pt>
                <c:pt idx="2410">
                  <c:v>0.93336744214042799</c:v>
                </c:pt>
                <c:pt idx="2411">
                  <c:v>0.93354801817798783</c:v>
                </c:pt>
                <c:pt idx="2412">
                  <c:v>0.93673819484154452</c:v>
                </c:pt>
                <c:pt idx="2413">
                  <c:v>0.93899539531104226</c:v>
                </c:pt>
                <c:pt idx="2414">
                  <c:v>0.94098173172420019</c:v>
                </c:pt>
                <c:pt idx="2415">
                  <c:v>0.93484214644716646</c:v>
                </c:pt>
                <c:pt idx="2416">
                  <c:v>0.9270171848195744</c:v>
                </c:pt>
                <c:pt idx="2417">
                  <c:v>0.92888313720769256</c:v>
                </c:pt>
                <c:pt idx="2418">
                  <c:v>0.95067264573991028</c:v>
                </c:pt>
                <c:pt idx="2419">
                  <c:v>0.94561651668823543</c:v>
                </c:pt>
                <c:pt idx="2420">
                  <c:v>0.93381888223432752</c:v>
                </c:pt>
                <c:pt idx="2421">
                  <c:v>0.93607608270382525</c:v>
                </c:pt>
                <c:pt idx="2422">
                  <c:v>0.9436301802750775</c:v>
                </c:pt>
                <c:pt idx="2423">
                  <c:v>0.9394769314112017</c:v>
                </c:pt>
                <c:pt idx="2424">
                  <c:v>0.95467541457248628</c:v>
                </c:pt>
                <c:pt idx="2425">
                  <c:v>0.94534565263189574</c:v>
                </c:pt>
                <c:pt idx="2426">
                  <c:v>0.95079302976495017</c:v>
                </c:pt>
                <c:pt idx="2427">
                  <c:v>0.9553977187227255</c:v>
                </c:pt>
                <c:pt idx="2428">
                  <c:v>0.93189273783368942</c:v>
                </c:pt>
                <c:pt idx="2429">
                  <c:v>0.95226773407168863</c:v>
                </c:pt>
                <c:pt idx="2430">
                  <c:v>0.93676829084780444</c:v>
                </c:pt>
                <c:pt idx="2431">
                  <c:v>0.94341950823125775</c:v>
                </c:pt>
                <c:pt idx="2432">
                  <c:v>0.94137297980557977</c:v>
                </c:pt>
                <c:pt idx="2433">
                  <c:v>0.95253859812802844</c:v>
                </c:pt>
                <c:pt idx="2434">
                  <c:v>0.92560267252535589</c:v>
                </c:pt>
                <c:pt idx="2435">
                  <c:v>0.93276552201522855</c:v>
                </c:pt>
                <c:pt idx="2436">
                  <c:v>0.95214735004664885</c:v>
                </c:pt>
                <c:pt idx="2437">
                  <c:v>0.94694074096367409</c:v>
                </c:pt>
                <c:pt idx="2438">
                  <c:v>0.94179432389321938</c:v>
                </c:pt>
                <c:pt idx="2439">
                  <c:v>0.95034158967105065</c:v>
                </c:pt>
                <c:pt idx="2440">
                  <c:v>0.91943299124206213</c:v>
                </c:pt>
                <c:pt idx="2441">
                  <c:v>0.93634694676016494</c:v>
                </c:pt>
                <c:pt idx="2442">
                  <c:v>0.94350979625003761</c:v>
                </c:pt>
                <c:pt idx="2443">
                  <c:v>0.94555632467571549</c:v>
                </c:pt>
                <c:pt idx="2444">
                  <c:v>0.94329912420621786</c:v>
                </c:pt>
                <c:pt idx="2445">
                  <c:v>0.94919794143317182</c:v>
                </c:pt>
                <c:pt idx="2446">
                  <c:v>0.94811448520781294</c:v>
                </c:pt>
                <c:pt idx="2447">
                  <c:v>0.94338941222499773</c:v>
                </c:pt>
                <c:pt idx="2448">
                  <c:v>0.94161374785565954</c:v>
                </c:pt>
                <c:pt idx="2449">
                  <c:v>0.95031149366479073</c:v>
                </c:pt>
                <c:pt idx="2450">
                  <c:v>0.94489421253799621</c:v>
                </c:pt>
                <c:pt idx="2451">
                  <c:v>0.94673006891985434</c:v>
                </c:pt>
                <c:pt idx="2452">
                  <c:v>0.94934842146447163</c:v>
                </c:pt>
                <c:pt idx="2453">
                  <c:v>0.94868630932675235</c:v>
                </c:pt>
                <c:pt idx="2454">
                  <c:v>0.95040178168357059</c:v>
                </c:pt>
                <c:pt idx="2455">
                  <c:v>0.93968760345502156</c:v>
                </c:pt>
                <c:pt idx="2456">
                  <c:v>0.94730189303879375</c:v>
                </c:pt>
                <c:pt idx="2457">
                  <c:v>0.96439642459445629</c:v>
                </c:pt>
                <c:pt idx="2458">
                  <c:v>0.94143317181809971</c:v>
                </c:pt>
                <c:pt idx="2459">
                  <c:v>0.9311704336834502</c:v>
                </c:pt>
                <c:pt idx="2460">
                  <c:v>0.9364372347789448</c:v>
                </c:pt>
                <c:pt idx="2461">
                  <c:v>0.95672194299816415</c:v>
                </c:pt>
                <c:pt idx="2462">
                  <c:v>0.9420952839558191</c:v>
                </c:pt>
                <c:pt idx="2463">
                  <c:v>0.93658771481024472</c:v>
                </c:pt>
                <c:pt idx="2464">
                  <c:v>0.95010082162097087</c:v>
                </c:pt>
                <c:pt idx="2465">
                  <c:v>0.94745237307009356</c:v>
                </c:pt>
                <c:pt idx="2466">
                  <c:v>0.93712944292292411</c:v>
                </c:pt>
                <c:pt idx="2467">
                  <c:v>0.94266710807475851</c:v>
                </c:pt>
                <c:pt idx="2468">
                  <c:v>0.95518704667890575</c:v>
                </c:pt>
                <c:pt idx="2469">
                  <c:v>0.94573690071327532</c:v>
                </c:pt>
                <c:pt idx="2470">
                  <c:v>0.96174797604357898</c:v>
                </c:pt>
                <c:pt idx="2471">
                  <c:v>0.95714328708580376</c:v>
                </c:pt>
                <c:pt idx="2472">
                  <c:v>0.97267282631594787</c:v>
                </c:pt>
                <c:pt idx="2473">
                  <c:v>0.95121437385258978</c:v>
                </c:pt>
                <c:pt idx="2474">
                  <c:v>0.93393926625936741</c:v>
                </c:pt>
                <c:pt idx="2475">
                  <c:v>0.91458753423420713</c:v>
                </c:pt>
                <c:pt idx="2476">
                  <c:v>0.93177235380864964</c:v>
                </c:pt>
                <c:pt idx="2477">
                  <c:v>0.93496253047220634</c:v>
                </c:pt>
                <c:pt idx="2478">
                  <c:v>0.92855208113883292</c:v>
                </c:pt>
                <c:pt idx="2479">
                  <c:v>0.93776145905438346</c:v>
                </c:pt>
                <c:pt idx="2480">
                  <c:v>0.93297619405904841</c:v>
                </c:pt>
                <c:pt idx="2481">
                  <c:v>0.93875462726096248</c:v>
                </c:pt>
                <c:pt idx="2482">
                  <c:v>0.93342763415294794</c:v>
                </c:pt>
                <c:pt idx="2483">
                  <c:v>0.92828121708249312</c:v>
                </c:pt>
                <c:pt idx="2484">
                  <c:v>0.93092966563337043</c:v>
                </c:pt>
                <c:pt idx="2485">
                  <c:v>0.94986005357089109</c:v>
                </c:pt>
                <c:pt idx="2486">
                  <c:v>0.92906371324525239</c:v>
                </c:pt>
                <c:pt idx="2487">
                  <c:v>0.92837150510127309</c:v>
                </c:pt>
                <c:pt idx="2488">
                  <c:v>0.93433051434074699</c:v>
                </c:pt>
                <c:pt idx="2489">
                  <c:v>0.9314412977397899</c:v>
                </c:pt>
                <c:pt idx="2490">
                  <c:v>0.93303638607156836</c:v>
                </c:pt>
                <c:pt idx="2491">
                  <c:v>0.94290787612483828</c:v>
                </c:pt>
                <c:pt idx="2492">
                  <c:v>0.94197489993077921</c:v>
                </c:pt>
                <c:pt idx="2493">
                  <c:v>0.951936678002829</c:v>
                </c:pt>
                <c:pt idx="2494">
                  <c:v>0.93354801817798783</c:v>
                </c:pt>
                <c:pt idx="2495">
                  <c:v>0.93026755349565116</c:v>
                </c:pt>
                <c:pt idx="2496">
                  <c:v>0.94673006891985434</c:v>
                </c:pt>
                <c:pt idx="2497">
                  <c:v>0.95115418184006983</c:v>
                </c:pt>
                <c:pt idx="2498">
                  <c:v>0.93318686610286816</c:v>
                </c:pt>
                <c:pt idx="2499">
                  <c:v>0.93842357119210285</c:v>
                </c:pt>
                <c:pt idx="2500">
                  <c:v>0.94636891684473468</c:v>
                </c:pt>
                <c:pt idx="2501">
                  <c:v>0.94462334848165652</c:v>
                </c:pt>
                <c:pt idx="2502">
                  <c:v>0.93872453125470245</c:v>
                </c:pt>
                <c:pt idx="2503">
                  <c:v>0.94227585999337893</c:v>
                </c:pt>
                <c:pt idx="2504">
                  <c:v>0.948054293195293</c:v>
                </c:pt>
                <c:pt idx="2505">
                  <c:v>0.94507478857555605</c:v>
                </c:pt>
                <c:pt idx="2506">
                  <c:v>0.94691064495741417</c:v>
                </c:pt>
                <c:pt idx="2507">
                  <c:v>0.9252114244439763</c:v>
                </c:pt>
                <c:pt idx="2508">
                  <c:v>0.94369037228759745</c:v>
                </c:pt>
                <c:pt idx="2509">
                  <c:v>0.94495440455051616</c:v>
                </c:pt>
                <c:pt idx="2510">
                  <c:v>0.91657387064736506</c:v>
                </c:pt>
                <c:pt idx="2511">
                  <c:v>0.94468354049417647</c:v>
                </c:pt>
                <c:pt idx="2512">
                  <c:v>0.93466157040960662</c:v>
                </c:pt>
                <c:pt idx="2513">
                  <c:v>0.93782165106690341</c:v>
                </c:pt>
                <c:pt idx="2514">
                  <c:v>0.93159177777108981</c:v>
                </c:pt>
                <c:pt idx="2515">
                  <c:v>0.92343576007463812</c:v>
                </c:pt>
                <c:pt idx="2516">
                  <c:v>0.93408974629066721</c:v>
                </c:pt>
                <c:pt idx="2517">
                  <c:v>0.92352604809341798</c:v>
                </c:pt>
                <c:pt idx="2518">
                  <c:v>0.92166009570529994</c:v>
                </c:pt>
                <c:pt idx="2519">
                  <c:v>0.93646733078520483</c:v>
                </c:pt>
                <c:pt idx="2520">
                  <c:v>0.93496253047220634</c:v>
                </c:pt>
                <c:pt idx="2521">
                  <c:v>0.92376681614349776</c:v>
                </c:pt>
                <c:pt idx="2522">
                  <c:v>0.91940289523580221</c:v>
                </c:pt>
                <c:pt idx="2523">
                  <c:v>0.91669425467240495</c:v>
                </c:pt>
                <c:pt idx="2524">
                  <c:v>0.93026755349565116</c:v>
                </c:pt>
                <c:pt idx="2525">
                  <c:v>0.92870256117013272</c:v>
                </c:pt>
                <c:pt idx="2526">
                  <c:v>0.95311042224696785</c:v>
                </c:pt>
                <c:pt idx="2527">
                  <c:v>0.93869443524844254</c:v>
                </c:pt>
                <c:pt idx="2528">
                  <c:v>0.94916784542691179</c:v>
                </c:pt>
                <c:pt idx="2529">
                  <c:v>0.93216360189002923</c:v>
                </c:pt>
                <c:pt idx="2530">
                  <c:v>0.93911577933608215</c:v>
                </c:pt>
                <c:pt idx="2531">
                  <c:v>0.93523339452854604</c:v>
                </c:pt>
                <c:pt idx="2532">
                  <c:v>0.93330725012790805</c:v>
                </c:pt>
                <c:pt idx="2533">
                  <c:v>0.95464531856622625</c:v>
                </c:pt>
                <c:pt idx="2534">
                  <c:v>0.94892707737683213</c:v>
                </c:pt>
                <c:pt idx="2535">
                  <c:v>0.93625665874138497</c:v>
                </c:pt>
                <c:pt idx="2536">
                  <c:v>0.93451109037830682</c:v>
                </c:pt>
                <c:pt idx="2537">
                  <c:v>0.93177235380864964</c:v>
                </c:pt>
                <c:pt idx="2538">
                  <c:v>0.94721160502001389</c:v>
                </c:pt>
                <c:pt idx="2539">
                  <c:v>0.91467782225298699</c:v>
                </c:pt>
                <c:pt idx="2540">
                  <c:v>0.92653564871941496</c:v>
                </c:pt>
                <c:pt idx="2541">
                  <c:v>0.94001865952388119</c:v>
                </c:pt>
                <c:pt idx="2542">
                  <c:v>0.92608420862551544</c:v>
                </c:pt>
                <c:pt idx="2543">
                  <c:v>0.93911577933608215</c:v>
                </c:pt>
                <c:pt idx="2544">
                  <c:v>0.94065067565534055</c:v>
                </c:pt>
                <c:pt idx="2545">
                  <c:v>0.95244831010924846</c:v>
                </c:pt>
                <c:pt idx="2546">
                  <c:v>0.93995846751136125</c:v>
                </c:pt>
                <c:pt idx="2547">
                  <c:v>0.94543594065067571</c:v>
                </c:pt>
                <c:pt idx="2548">
                  <c:v>0.95100370180877003</c:v>
                </c:pt>
                <c:pt idx="2549">
                  <c:v>0.94098173172420019</c:v>
                </c:pt>
                <c:pt idx="2550">
                  <c:v>0.94001865952388119</c:v>
                </c:pt>
                <c:pt idx="2551">
                  <c:v>0.93411984229692724</c:v>
                </c:pt>
                <c:pt idx="2552">
                  <c:v>0.93411984229692724</c:v>
                </c:pt>
                <c:pt idx="2553">
                  <c:v>0.93111024167093026</c:v>
                </c:pt>
                <c:pt idx="2554">
                  <c:v>0.94651939687603459</c:v>
                </c:pt>
                <c:pt idx="2555">
                  <c:v>0.92846179312005295</c:v>
                </c:pt>
                <c:pt idx="2556">
                  <c:v>0.93156168176482979</c:v>
                </c:pt>
                <c:pt idx="2557">
                  <c:v>0.92680651277575465</c:v>
                </c:pt>
                <c:pt idx="2558">
                  <c:v>0.92798025701989351</c:v>
                </c:pt>
                <c:pt idx="2559">
                  <c:v>0.92921419327655219</c:v>
                </c:pt>
                <c:pt idx="2560">
                  <c:v>0.93454118638456674</c:v>
                </c:pt>
                <c:pt idx="2561">
                  <c:v>0.94203509194329915</c:v>
                </c:pt>
                <c:pt idx="2562">
                  <c:v>0.93246456195262883</c:v>
                </c:pt>
                <c:pt idx="2563">
                  <c:v>0.94642910885725462</c:v>
                </c:pt>
                <c:pt idx="2564">
                  <c:v>0.96129653594967945</c:v>
                </c:pt>
                <c:pt idx="2565">
                  <c:v>0.93405965028440729</c:v>
                </c:pt>
                <c:pt idx="2566">
                  <c:v>0.95982183164294099</c:v>
                </c:pt>
                <c:pt idx="2567">
                  <c:v>0.93938664339242184</c:v>
                </c:pt>
                <c:pt idx="2568">
                  <c:v>0.93755078701056371</c:v>
                </c:pt>
                <c:pt idx="2569">
                  <c:v>0.94378066030637731</c:v>
                </c:pt>
                <c:pt idx="2570">
                  <c:v>0.92966563337045172</c:v>
                </c:pt>
                <c:pt idx="2571">
                  <c:v>0.94673006891985434</c:v>
                </c:pt>
                <c:pt idx="2572">
                  <c:v>0.92810064104493328</c:v>
                </c:pt>
                <c:pt idx="2573">
                  <c:v>0.91705540674752462</c:v>
                </c:pt>
                <c:pt idx="2574">
                  <c:v>0.93183254582116948</c:v>
                </c:pt>
                <c:pt idx="2575">
                  <c:v>0.91720588677882442</c:v>
                </c:pt>
                <c:pt idx="2576">
                  <c:v>0.94092153971168024</c:v>
                </c:pt>
                <c:pt idx="2577">
                  <c:v>0.93670809883528461</c:v>
                </c:pt>
                <c:pt idx="2578">
                  <c:v>0.94125259578053988</c:v>
                </c:pt>
                <c:pt idx="2579">
                  <c:v>0.94152345983687968</c:v>
                </c:pt>
                <c:pt idx="2580">
                  <c:v>0.93321696210912808</c:v>
                </c:pt>
                <c:pt idx="2581">
                  <c:v>0.93806241911698318</c:v>
                </c:pt>
                <c:pt idx="2582">
                  <c:v>0.93327715412164802</c:v>
                </c:pt>
                <c:pt idx="2583">
                  <c:v>0.93393926625936741</c:v>
                </c:pt>
                <c:pt idx="2584">
                  <c:v>0.92364643211845787</c:v>
                </c:pt>
                <c:pt idx="2585">
                  <c:v>0.93369849820928763</c:v>
                </c:pt>
                <c:pt idx="2586">
                  <c:v>0.91308273392120864</c:v>
                </c:pt>
                <c:pt idx="2587">
                  <c:v>0.9192524152045024</c:v>
                </c:pt>
                <c:pt idx="2588">
                  <c:v>0.92623468865681524</c:v>
                </c:pt>
                <c:pt idx="2589">
                  <c:v>0.9387847232672224</c:v>
                </c:pt>
                <c:pt idx="2590">
                  <c:v>0.94402142835645708</c:v>
                </c:pt>
                <c:pt idx="2591">
                  <c:v>0.93291600204652847</c:v>
                </c:pt>
                <c:pt idx="2592">
                  <c:v>0.91323321395250845</c:v>
                </c:pt>
                <c:pt idx="2593">
                  <c:v>0.92403768019983745</c:v>
                </c:pt>
                <c:pt idx="2594">
                  <c:v>0.92957534535167186</c:v>
                </c:pt>
                <c:pt idx="2595">
                  <c:v>0.93833328317332287</c:v>
                </c:pt>
                <c:pt idx="2596">
                  <c:v>0.93965750744876153</c:v>
                </c:pt>
                <c:pt idx="2597">
                  <c:v>0.93472176242212657</c:v>
                </c:pt>
                <c:pt idx="2598">
                  <c:v>0.94031961958648091</c:v>
                </c:pt>
                <c:pt idx="2599">
                  <c:v>0.9220212477804195</c:v>
                </c:pt>
                <c:pt idx="2600">
                  <c:v>0.9231348000120384</c:v>
                </c:pt>
                <c:pt idx="2601">
                  <c:v>0.91485839829054683</c:v>
                </c:pt>
                <c:pt idx="2602">
                  <c:v>0.93180244981490956</c:v>
                </c:pt>
                <c:pt idx="2603">
                  <c:v>0.93520329852228612</c:v>
                </c:pt>
                <c:pt idx="2604">
                  <c:v>0.9321335058837692</c:v>
                </c:pt>
                <c:pt idx="2605">
                  <c:v>0.93294609805278839</c:v>
                </c:pt>
                <c:pt idx="2606">
                  <c:v>0.92000481536100165</c:v>
                </c:pt>
                <c:pt idx="2607">
                  <c:v>0.93706925091040416</c:v>
                </c:pt>
                <c:pt idx="2608">
                  <c:v>0.91877087910434285</c:v>
                </c:pt>
                <c:pt idx="2609">
                  <c:v>0.91792819092906375</c:v>
                </c:pt>
                <c:pt idx="2610">
                  <c:v>0.92659584073193491</c:v>
                </c:pt>
                <c:pt idx="2611">
                  <c:v>0.94203509194329915</c:v>
                </c:pt>
                <c:pt idx="2612">
                  <c:v>0.93616637072260511</c:v>
                </c:pt>
                <c:pt idx="2613">
                  <c:v>0.91157793360821016</c:v>
                </c:pt>
                <c:pt idx="2614">
                  <c:v>0.9355945466036657</c:v>
                </c:pt>
                <c:pt idx="2615">
                  <c:v>0.93550425858488584</c:v>
                </c:pt>
                <c:pt idx="2616">
                  <c:v>0.93204321786498934</c:v>
                </c:pt>
                <c:pt idx="2617">
                  <c:v>0.94414181238149697</c:v>
                </c:pt>
                <c:pt idx="2618">
                  <c:v>0.93619646672886503</c:v>
                </c:pt>
                <c:pt idx="2619">
                  <c:v>0.93418003430944718</c:v>
                </c:pt>
                <c:pt idx="2620">
                  <c:v>0.92223191982423935</c:v>
                </c:pt>
                <c:pt idx="2621">
                  <c:v>0.92144942366148008</c:v>
                </c:pt>
                <c:pt idx="2622">
                  <c:v>0.91988443133596176</c:v>
                </c:pt>
                <c:pt idx="2623">
                  <c:v>0.92987630541427158</c:v>
                </c:pt>
                <c:pt idx="2624">
                  <c:v>0.93363830619676769</c:v>
                </c:pt>
                <c:pt idx="2625">
                  <c:v>0.91768742287898397</c:v>
                </c:pt>
                <c:pt idx="2626">
                  <c:v>0.92828121708249312</c:v>
                </c:pt>
                <c:pt idx="2627">
                  <c:v>0.91678454269118492</c:v>
                </c:pt>
                <c:pt idx="2628">
                  <c:v>0.9466698769073344</c:v>
                </c:pt>
                <c:pt idx="2629">
                  <c:v>0.9156408944533061</c:v>
                </c:pt>
                <c:pt idx="2630">
                  <c:v>0.93424022632196713</c:v>
                </c:pt>
                <c:pt idx="2631">
                  <c:v>0.92954524934541183</c:v>
                </c:pt>
                <c:pt idx="2632">
                  <c:v>0.92554248051283594</c:v>
                </c:pt>
                <c:pt idx="2633">
                  <c:v>0.93192283383994945</c:v>
                </c:pt>
                <c:pt idx="2634">
                  <c:v>0.9420952839558191</c:v>
                </c:pt>
                <c:pt idx="2635">
                  <c:v>0.93092966563337043</c:v>
                </c:pt>
                <c:pt idx="2636">
                  <c:v>0.94098173172420019</c:v>
                </c:pt>
                <c:pt idx="2637">
                  <c:v>0.94269720408101843</c:v>
                </c:pt>
                <c:pt idx="2638">
                  <c:v>0.92442892828121703</c:v>
                </c:pt>
                <c:pt idx="2639">
                  <c:v>0.93926625936738195</c:v>
                </c:pt>
                <c:pt idx="2640">
                  <c:v>0.94137297980557977</c:v>
                </c:pt>
                <c:pt idx="2641">
                  <c:v>0.9231348000120384</c:v>
                </c:pt>
                <c:pt idx="2642">
                  <c:v>0.93691877087910436</c:v>
                </c:pt>
                <c:pt idx="2643">
                  <c:v>0.93041803352695096</c:v>
                </c:pt>
                <c:pt idx="2644">
                  <c:v>0.93414993830318716</c:v>
                </c:pt>
                <c:pt idx="2645">
                  <c:v>0.93336744214042799</c:v>
                </c:pt>
                <c:pt idx="2646">
                  <c:v>0.93138110572726995</c:v>
                </c:pt>
                <c:pt idx="2647">
                  <c:v>0.93746049899178374</c:v>
                </c:pt>
                <c:pt idx="2648">
                  <c:v>0.93998856351762117</c:v>
                </c:pt>
                <c:pt idx="2649">
                  <c:v>0.93445089836578688</c:v>
                </c:pt>
                <c:pt idx="2650">
                  <c:v>0.9222921118367593</c:v>
                </c:pt>
                <c:pt idx="2651">
                  <c:v>0.93393926625936741</c:v>
                </c:pt>
                <c:pt idx="2652">
                  <c:v>0.91886116712312271</c:v>
                </c:pt>
                <c:pt idx="2653">
                  <c:v>0.93068889758329065</c:v>
                </c:pt>
                <c:pt idx="2654">
                  <c:v>0.92283383994943868</c:v>
                </c:pt>
                <c:pt idx="2655">
                  <c:v>0.91955337526710201</c:v>
                </c:pt>
                <c:pt idx="2656">
                  <c:v>0.92292412796821865</c:v>
                </c:pt>
                <c:pt idx="2657">
                  <c:v>0.92677641676949474</c:v>
                </c:pt>
                <c:pt idx="2658">
                  <c:v>0.92641526469437507</c:v>
                </c:pt>
                <c:pt idx="2659">
                  <c:v>0.91940289523580221</c:v>
                </c:pt>
                <c:pt idx="2660">
                  <c:v>0.93469166641586665</c:v>
                </c:pt>
                <c:pt idx="2661">
                  <c:v>0.92232220784301922</c:v>
                </c:pt>
                <c:pt idx="2662">
                  <c:v>0.91404580612152764</c:v>
                </c:pt>
                <c:pt idx="2663">
                  <c:v>0.92885304120143253</c:v>
                </c:pt>
                <c:pt idx="2664">
                  <c:v>0.91630300659102537</c:v>
                </c:pt>
                <c:pt idx="2665">
                  <c:v>0.94242634002467873</c:v>
                </c:pt>
                <c:pt idx="2666">
                  <c:v>0.94907755740813193</c:v>
                </c:pt>
                <c:pt idx="2667">
                  <c:v>0.93842357119210285</c:v>
                </c:pt>
                <c:pt idx="2668">
                  <c:v>0.9415535558431396</c:v>
                </c:pt>
                <c:pt idx="2669">
                  <c:v>0.93357811418424774</c:v>
                </c:pt>
                <c:pt idx="2670">
                  <c:v>0.93676829084780444</c:v>
                </c:pt>
                <c:pt idx="2671">
                  <c:v>0.92662593673819482</c:v>
                </c:pt>
                <c:pt idx="2672">
                  <c:v>0.92897342522647242</c:v>
                </c:pt>
                <c:pt idx="2673">
                  <c:v>0.9247900803563367</c:v>
                </c:pt>
                <c:pt idx="2674">
                  <c:v>0.93788184307942335</c:v>
                </c:pt>
                <c:pt idx="2675">
                  <c:v>0.92448912029373698</c:v>
                </c:pt>
                <c:pt idx="2676">
                  <c:v>0.93568483462244556</c:v>
                </c:pt>
                <c:pt idx="2677">
                  <c:v>0.93514310650976618</c:v>
                </c:pt>
                <c:pt idx="2678">
                  <c:v>0.94182441989947929</c:v>
                </c:pt>
                <c:pt idx="2679">
                  <c:v>0.91437686219038738</c:v>
                </c:pt>
                <c:pt idx="2680">
                  <c:v>0.93427032232822704</c:v>
                </c:pt>
                <c:pt idx="2681">
                  <c:v>0.90814698889457368</c:v>
                </c:pt>
                <c:pt idx="2682">
                  <c:v>0.92403768019983745</c:v>
                </c:pt>
                <c:pt idx="2683">
                  <c:v>0.92024558341108131</c:v>
                </c:pt>
                <c:pt idx="2684">
                  <c:v>0.92319499202455835</c:v>
                </c:pt>
                <c:pt idx="2685">
                  <c:v>0.92394739218105759</c:v>
                </c:pt>
                <c:pt idx="2686">
                  <c:v>0.93637704276642486</c:v>
                </c:pt>
                <c:pt idx="2687">
                  <c:v>0.92427844824991723</c:v>
                </c:pt>
                <c:pt idx="2688">
                  <c:v>0.93481205044090654</c:v>
                </c:pt>
                <c:pt idx="2689">
                  <c:v>0.92888313720769256</c:v>
                </c:pt>
                <c:pt idx="2690">
                  <c:v>0.93496253047220634</c:v>
                </c:pt>
                <c:pt idx="2691">
                  <c:v>0.92268335991813888</c:v>
                </c:pt>
                <c:pt idx="2692">
                  <c:v>0.92325518403707829</c:v>
                </c:pt>
                <c:pt idx="2693">
                  <c:v>0.93788184307942335</c:v>
                </c:pt>
                <c:pt idx="2694">
                  <c:v>0.93941673939868175</c:v>
                </c:pt>
                <c:pt idx="2695">
                  <c:v>0.92253287988683896</c:v>
                </c:pt>
                <c:pt idx="2696">
                  <c:v>0.93439070635326693</c:v>
                </c:pt>
                <c:pt idx="2697">
                  <c:v>0.92515123243145636</c:v>
                </c:pt>
                <c:pt idx="2698">
                  <c:v>0.93092966563337043</c:v>
                </c:pt>
                <c:pt idx="2699">
                  <c:v>0.91816895897914341</c:v>
                </c:pt>
                <c:pt idx="2700">
                  <c:v>0.93011707346435124</c:v>
                </c:pt>
                <c:pt idx="2701">
                  <c:v>0.9220212477804195</c:v>
                </c:pt>
                <c:pt idx="2702">
                  <c:v>0.92761910494477384</c:v>
                </c:pt>
                <c:pt idx="2703">
                  <c:v>0.92220182381797933</c:v>
                </c:pt>
                <c:pt idx="2704">
                  <c:v>0.91735636681012434</c:v>
                </c:pt>
                <c:pt idx="2705">
                  <c:v>0.91236042977096943</c:v>
                </c:pt>
                <c:pt idx="2706">
                  <c:v>0.92003491136726157</c:v>
                </c:pt>
                <c:pt idx="2707">
                  <c:v>0.92123875161766033</c:v>
                </c:pt>
                <c:pt idx="2708">
                  <c:v>0.91242062178348937</c:v>
                </c:pt>
                <c:pt idx="2709">
                  <c:v>0.92436873626869709</c:v>
                </c:pt>
                <c:pt idx="2710">
                  <c:v>0.91741655882264428</c:v>
                </c:pt>
                <c:pt idx="2711">
                  <c:v>0.91795828693532366</c:v>
                </c:pt>
                <c:pt idx="2712">
                  <c:v>0.91076534143919097</c:v>
                </c:pt>
                <c:pt idx="2713">
                  <c:v>0.91642339061606526</c:v>
                </c:pt>
                <c:pt idx="2714">
                  <c:v>0.909832365245132</c:v>
                </c:pt>
                <c:pt idx="2715">
                  <c:v>0.90959159719505223</c:v>
                </c:pt>
                <c:pt idx="2716">
                  <c:v>0.90212778764257984</c:v>
                </c:pt>
                <c:pt idx="2717">
                  <c:v>0.9015258675173804</c:v>
                </c:pt>
                <c:pt idx="2718">
                  <c:v>0.91865049507930296</c:v>
                </c:pt>
                <c:pt idx="2719">
                  <c:v>0.92274355193065882</c:v>
                </c:pt>
                <c:pt idx="2720">
                  <c:v>0.91112649351431063</c:v>
                </c:pt>
                <c:pt idx="2721">
                  <c:v>0.9311704336834502</c:v>
                </c:pt>
                <c:pt idx="2722">
                  <c:v>0.91070514942667113</c:v>
                </c:pt>
                <c:pt idx="2723">
                  <c:v>0.90333162789297861</c:v>
                </c:pt>
                <c:pt idx="2724">
                  <c:v>0.91609233454720562</c:v>
                </c:pt>
                <c:pt idx="2725">
                  <c:v>0.90625094050019561</c:v>
                </c:pt>
                <c:pt idx="2726">
                  <c:v>0.91175850964576999</c:v>
                </c:pt>
                <c:pt idx="2727">
                  <c:v>0.91377494206518795</c:v>
                </c:pt>
                <c:pt idx="2728">
                  <c:v>0.91064495741415119</c:v>
                </c:pt>
                <c:pt idx="2729">
                  <c:v>0.93667800282902458</c:v>
                </c:pt>
                <c:pt idx="2730">
                  <c:v>0.92352604809341798</c:v>
                </c:pt>
                <c:pt idx="2731">
                  <c:v>0.92900352123273244</c:v>
                </c:pt>
                <c:pt idx="2732">
                  <c:v>0.92773948896981373</c:v>
                </c:pt>
                <c:pt idx="2733">
                  <c:v>0.92680651277575465</c:v>
                </c:pt>
                <c:pt idx="2734">
                  <c:v>0.92346585608089804</c:v>
                </c:pt>
                <c:pt idx="2735">
                  <c:v>0.93068889758329065</c:v>
                </c:pt>
                <c:pt idx="2736">
                  <c:v>0.9374003069792638</c:v>
                </c:pt>
                <c:pt idx="2737">
                  <c:v>0.92078731152376081</c:v>
                </c:pt>
                <c:pt idx="2738">
                  <c:v>0.92572305655039577</c:v>
                </c:pt>
                <c:pt idx="2739">
                  <c:v>0.93321696210912808</c:v>
                </c:pt>
                <c:pt idx="2740">
                  <c:v>0.92412796821861742</c:v>
                </c:pt>
                <c:pt idx="2741">
                  <c:v>0.91497878231558671</c:v>
                </c:pt>
                <c:pt idx="2742">
                  <c:v>0.91913203117946252</c:v>
                </c:pt>
                <c:pt idx="2743">
                  <c:v>0.92075721551750078</c:v>
                </c:pt>
                <c:pt idx="2744">
                  <c:v>0.91624281457850543</c:v>
                </c:pt>
                <c:pt idx="2745">
                  <c:v>0.91765732687272394</c:v>
                </c:pt>
                <c:pt idx="2746">
                  <c:v>0.90802660486953379</c:v>
                </c:pt>
                <c:pt idx="2747">
                  <c:v>0.91344388599632831</c:v>
                </c:pt>
                <c:pt idx="2748">
                  <c:v>0.9121798537334096</c:v>
                </c:pt>
                <c:pt idx="2749">
                  <c:v>0.92250278388057905</c:v>
                </c:pt>
                <c:pt idx="2750">
                  <c:v>0.906913052637915</c:v>
                </c:pt>
                <c:pt idx="2751">
                  <c:v>0.92018539139856137</c:v>
                </c:pt>
                <c:pt idx="2752">
                  <c:v>0.90742468474433446</c:v>
                </c:pt>
                <c:pt idx="2753">
                  <c:v>0.91663406265988501</c:v>
                </c:pt>
                <c:pt idx="2754">
                  <c:v>0.90998284527643181</c:v>
                </c:pt>
                <c:pt idx="2755">
                  <c:v>0.9164835826285852</c:v>
                </c:pt>
                <c:pt idx="2756">
                  <c:v>0.92638516868811505</c:v>
                </c:pt>
                <c:pt idx="2757">
                  <c:v>0.91139735757065032</c:v>
                </c:pt>
                <c:pt idx="2758">
                  <c:v>0.91615252655972557</c:v>
                </c:pt>
                <c:pt idx="2759">
                  <c:v>0.91100610948927074</c:v>
                </c:pt>
                <c:pt idx="2760">
                  <c:v>0.91503897432810666</c:v>
                </c:pt>
                <c:pt idx="2761">
                  <c:v>0.91524964637192641</c:v>
                </c:pt>
                <c:pt idx="2762">
                  <c:v>0.91470791825924702</c:v>
                </c:pt>
                <c:pt idx="2763">
                  <c:v>0.94149336383061966</c:v>
                </c:pt>
                <c:pt idx="2764">
                  <c:v>0.93026755349565116</c:v>
                </c:pt>
                <c:pt idx="2765">
                  <c:v>0.92915400126403225</c:v>
                </c:pt>
                <c:pt idx="2766">
                  <c:v>0.9049869082372769</c:v>
                </c:pt>
                <c:pt idx="2767">
                  <c:v>0.91630300659102537</c:v>
                </c:pt>
                <c:pt idx="2768">
                  <c:v>0.90926054112619259</c:v>
                </c:pt>
                <c:pt idx="2769">
                  <c:v>0.91398561410900769</c:v>
                </c:pt>
                <c:pt idx="2770">
                  <c:v>0.90802660486953379</c:v>
                </c:pt>
                <c:pt idx="2771">
                  <c:v>0.92500075240015645</c:v>
                </c:pt>
                <c:pt idx="2772">
                  <c:v>0.9011045234297409</c:v>
                </c:pt>
                <c:pt idx="2773">
                  <c:v>0.91561079844704607</c:v>
                </c:pt>
                <c:pt idx="2774">
                  <c:v>0.91076534143919097</c:v>
                </c:pt>
                <c:pt idx="2775">
                  <c:v>0.92638516868811505</c:v>
                </c:pt>
                <c:pt idx="2776">
                  <c:v>0.91533993439070638</c:v>
                </c:pt>
                <c:pt idx="2777">
                  <c:v>0.92560267252535589</c:v>
                </c:pt>
                <c:pt idx="2778">
                  <c:v>0.91395551810274778</c:v>
                </c:pt>
                <c:pt idx="2779">
                  <c:v>0.91865049507930296</c:v>
                </c:pt>
                <c:pt idx="2780">
                  <c:v>0.91296234989616876</c:v>
                </c:pt>
                <c:pt idx="2781">
                  <c:v>0.92436873626869709</c:v>
                </c:pt>
                <c:pt idx="2782">
                  <c:v>0.90450537213711746</c:v>
                </c:pt>
                <c:pt idx="2783">
                  <c:v>0.91458753423420713</c:v>
                </c:pt>
                <c:pt idx="2784">
                  <c:v>0.90763535678815421</c:v>
                </c:pt>
                <c:pt idx="2785">
                  <c:v>0.92782977698859359</c:v>
                </c:pt>
                <c:pt idx="2786">
                  <c:v>0.9095615011887922</c:v>
                </c:pt>
                <c:pt idx="2787">
                  <c:v>0.91696511872874464</c:v>
                </c:pt>
                <c:pt idx="2788">
                  <c:v>0.91332350197128842</c:v>
                </c:pt>
                <c:pt idx="2789">
                  <c:v>0.93035784151443102</c:v>
                </c:pt>
                <c:pt idx="2790">
                  <c:v>0.93095976163963046</c:v>
                </c:pt>
                <c:pt idx="2791">
                  <c:v>0.91558070244078615</c:v>
                </c:pt>
                <c:pt idx="2792">
                  <c:v>0.91789809492280372</c:v>
                </c:pt>
                <c:pt idx="2793">
                  <c:v>0.9004123152857616</c:v>
                </c:pt>
                <c:pt idx="2794">
                  <c:v>0.92614440063803538</c:v>
                </c:pt>
                <c:pt idx="2795">
                  <c:v>0.93038793752069104</c:v>
                </c:pt>
                <c:pt idx="2796">
                  <c:v>0.92081740753002073</c:v>
                </c:pt>
                <c:pt idx="2797">
                  <c:v>0.92000481536100165</c:v>
                </c:pt>
                <c:pt idx="2798">
                  <c:v>0.9196737592921419</c:v>
                </c:pt>
                <c:pt idx="2799">
                  <c:v>0.91115658952057066</c:v>
                </c:pt>
                <c:pt idx="2800">
                  <c:v>0.92259307189935891</c:v>
                </c:pt>
                <c:pt idx="2801">
                  <c:v>0.89842597887260356</c:v>
                </c:pt>
                <c:pt idx="2802">
                  <c:v>0.88428085593041805</c:v>
                </c:pt>
                <c:pt idx="2803">
                  <c:v>0.91979414331718179</c:v>
                </c:pt>
                <c:pt idx="2804">
                  <c:v>0.91792819092906375</c:v>
                </c:pt>
                <c:pt idx="2805">
                  <c:v>0.909832365245132</c:v>
                </c:pt>
                <c:pt idx="2806">
                  <c:v>0.90929063713245251</c:v>
                </c:pt>
                <c:pt idx="2807">
                  <c:v>0.90838775694465346</c:v>
                </c:pt>
                <c:pt idx="2808">
                  <c:v>0.91666415866614503</c:v>
                </c:pt>
                <c:pt idx="2809">
                  <c:v>0.913714750052668</c:v>
                </c:pt>
                <c:pt idx="2810">
                  <c:v>0.92196105576789955</c:v>
                </c:pt>
                <c:pt idx="2811">
                  <c:v>0.91181870165828993</c:v>
                </c:pt>
                <c:pt idx="2812">
                  <c:v>0.9178679989165438</c:v>
                </c:pt>
                <c:pt idx="2813">
                  <c:v>0.91452734222168719</c:v>
                </c:pt>
                <c:pt idx="2814">
                  <c:v>0.9167544466849249</c:v>
                </c:pt>
                <c:pt idx="2815">
                  <c:v>0.89493484214644714</c:v>
                </c:pt>
                <c:pt idx="2816">
                  <c:v>0.9202154874048214</c:v>
                </c:pt>
                <c:pt idx="2817">
                  <c:v>0.89216600957052994</c:v>
                </c:pt>
                <c:pt idx="2818">
                  <c:v>0.89728233063472473</c:v>
                </c:pt>
                <c:pt idx="2819">
                  <c:v>0.91124687753935052</c:v>
                </c:pt>
                <c:pt idx="2820">
                  <c:v>0.88644776838113581</c:v>
                </c:pt>
                <c:pt idx="2821">
                  <c:v>0.89869684292894336</c:v>
                </c:pt>
                <c:pt idx="2822">
                  <c:v>0.90230836368013967</c:v>
                </c:pt>
                <c:pt idx="2823">
                  <c:v>0.90929063713245251</c:v>
                </c:pt>
                <c:pt idx="2824">
                  <c:v>0.91816895897914341</c:v>
                </c:pt>
                <c:pt idx="2825">
                  <c:v>0.92391729617479756</c:v>
                </c:pt>
                <c:pt idx="2826">
                  <c:v>0.91100610948927074</c:v>
                </c:pt>
                <c:pt idx="2827">
                  <c:v>0.92120865561140042</c:v>
                </c:pt>
                <c:pt idx="2828">
                  <c:v>0.90272970776777917</c:v>
                </c:pt>
                <c:pt idx="2829">
                  <c:v>0.91109639750805071</c:v>
                </c:pt>
                <c:pt idx="2830">
                  <c:v>0.91455743822794711</c:v>
                </c:pt>
                <c:pt idx="2831">
                  <c:v>0.9350528184909862</c:v>
                </c:pt>
                <c:pt idx="2832">
                  <c:v>0.91434676618412736</c:v>
                </c:pt>
                <c:pt idx="2833">
                  <c:v>0.90363258795557833</c:v>
                </c:pt>
                <c:pt idx="2834">
                  <c:v>0.91076534143919097</c:v>
                </c:pt>
                <c:pt idx="2835">
                  <c:v>0.90947121317001234</c:v>
                </c:pt>
                <c:pt idx="2836">
                  <c:v>0.89123303337647097</c:v>
                </c:pt>
                <c:pt idx="2837">
                  <c:v>0.91540012640322632</c:v>
                </c:pt>
                <c:pt idx="2838">
                  <c:v>0.90938092515123248</c:v>
                </c:pt>
                <c:pt idx="2839">
                  <c:v>0.9199446233484817</c:v>
                </c:pt>
                <c:pt idx="2840">
                  <c:v>0.90275980377403919</c:v>
                </c:pt>
                <c:pt idx="2841">
                  <c:v>0.9062208444939357</c:v>
                </c:pt>
                <c:pt idx="2842">
                  <c:v>0.9062208444939357</c:v>
                </c:pt>
                <c:pt idx="2843">
                  <c:v>0.90128509946730073</c:v>
                </c:pt>
                <c:pt idx="2844">
                  <c:v>0.90543834833117642</c:v>
                </c:pt>
                <c:pt idx="2845">
                  <c:v>0.90751497276311432</c:v>
                </c:pt>
                <c:pt idx="2846">
                  <c:v>0.89845607487886359</c:v>
                </c:pt>
                <c:pt idx="2847">
                  <c:v>0.9062208444939357</c:v>
                </c:pt>
                <c:pt idx="2848">
                  <c:v>0.91046438137659136</c:v>
                </c:pt>
                <c:pt idx="2849">
                  <c:v>0.93053841755199085</c:v>
                </c:pt>
                <c:pt idx="2850">
                  <c:v>0.91278177385860892</c:v>
                </c:pt>
                <c:pt idx="2851">
                  <c:v>0.93065880157703074</c:v>
                </c:pt>
                <c:pt idx="2852">
                  <c:v>0.91254100580852926</c:v>
                </c:pt>
                <c:pt idx="2853">
                  <c:v>0.90495681223101698</c:v>
                </c:pt>
                <c:pt idx="2854">
                  <c:v>0.91404580612152764</c:v>
                </c:pt>
                <c:pt idx="2855">
                  <c:v>0.92792006500737356</c:v>
                </c:pt>
                <c:pt idx="2856">
                  <c:v>0.90525777229361659</c:v>
                </c:pt>
                <c:pt idx="2857">
                  <c:v>0.9350528184909862</c:v>
                </c:pt>
                <c:pt idx="2858">
                  <c:v>0.91946308724832215</c:v>
                </c:pt>
                <c:pt idx="2859">
                  <c:v>0.91067505342041111</c:v>
                </c:pt>
                <c:pt idx="2860">
                  <c:v>0.91374484605892803</c:v>
                </c:pt>
                <c:pt idx="2861">
                  <c:v>0.91762723086646403</c:v>
                </c:pt>
                <c:pt idx="2862">
                  <c:v>0.91997471935474162</c:v>
                </c:pt>
                <c:pt idx="2863">
                  <c:v>0.92831131308875314</c:v>
                </c:pt>
                <c:pt idx="2864">
                  <c:v>0.9199446233484817</c:v>
                </c:pt>
                <c:pt idx="2865">
                  <c:v>0.9174466548289042</c:v>
                </c:pt>
                <c:pt idx="2866">
                  <c:v>0.91311282992746867</c:v>
                </c:pt>
                <c:pt idx="2867">
                  <c:v>0.91413609414030761</c:v>
                </c:pt>
                <c:pt idx="2868">
                  <c:v>0.89839588286634364</c:v>
                </c:pt>
                <c:pt idx="2869">
                  <c:v>0.89860655491016339</c:v>
                </c:pt>
                <c:pt idx="2870">
                  <c:v>0.91380503807144797</c:v>
                </c:pt>
                <c:pt idx="2871">
                  <c:v>0.90610046046889581</c:v>
                </c:pt>
                <c:pt idx="2872">
                  <c:v>0.91606223854094559</c:v>
                </c:pt>
                <c:pt idx="2873">
                  <c:v>0.92081740753002073</c:v>
                </c:pt>
                <c:pt idx="2874">
                  <c:v>0.92039606344238123</c:v>
                </c:pt>
                <c:pt idx="2875">
                  <c:v>0.8997201071417823</c:v>
                </c:pt>
                <c:pt idx="2876">
                  <c:v>0.91777771089776383</c:v>
                </c:pt>
                <c:pt idx="2877">
                  <c:v>0.91070514942667113</c:v>
                </c:pt>
                <c:pt idx="2878">
                  <c:v>0.90378306798687813</c:v>
                </c:pt>
                <c:pt idx="2879">
                  <c:v>0.90543834833117642</c:v>
                </c:pt>
                <c:pt idx="2880">
                  <c:v>0.91886116712312271</c:v>
                </c:pt>
                <c:pt idx="2881">
                  <c:v>0.90263941974899931</c:v>
                </c:pt>
                <c:pt idx="2882">
                  <c:v>0.90655190056279533</c:v>
                </c:pt>
                <c:pt idx="2883">
                  <c:v>0.9036024919493183</c:v>
                </c:pt>
                <c:pt idx="2884">
                  <c:v>0.92003491136726157</c:v>
                </c:pt>
                <c:pt idx="2885">
                  <c:v>0.89953953110422247</c:v>
                </c:pt>
                <c:pt idx="2886">
                  <c:v>0.92286393595569871</c:v>
                </c:pt>
                <c:pt idx="2887">
                  <c:v>0.9263249766755951</c:v>
                </c:pt>
                <c:pt idx="2888">
                  <c:v>0.92144942366148008</c:v>
                </c:pt>
                <c:pt idx="2889">
                  <c:v>0.91205946970836971</c:v>
                </c:pt>
                <c:pt idx="2890">
                  <c:v>0.90564902037499628</c:v>
                </c:pt>
                <c:pt idx="2891">
                  <c:v>0.91606223854094559</c:v>
                </c:pt>
                <c:pt idx="2892">
                  <c:v>0.91657387064736506</c:v>
                </c:pt>
                <c:pt idx="2893">
                  <c:v>0.91561079844704607</c:v>
                </c:pt>
                <c:pt idx="2894">
                  <c:v>0.91097601348301083</c:v>
                </c:pt>
                <c:pt idx="2895">
                  <c:v>0.90883919703855298</c:v>
                </c:pt>
                <c:pt idx="2896">
                  <c:v>0.9123303337647094</c:v>
                </c:pt>
                <c:pt idx="2897">
                  <c:v>0.90158605952990034</c:v>
                </c:pt>
                <c:pt idx="2898">
                  <c:v>0.92099798356758056</c:v>
                </c:pt>
                <c:pt idx="2899">
                  <c:v>0.90191711559876009</c:v>
                </c:pt>
                <c:pt idx="2900">
                  <c:v>0.89854636289764345</c:v>
                </c:pt>
                <c:pt idx="2901">
                  <c:v>0.89887741896650319</c:v>
                </c:pt>
                <c:pt idx="2902">
                  <c:v>0.9088692930448129</c:v>
                </c:pt>
                <c:pt idx="2903">
                  <c:v>0.90131519547356065</c:v>
                </c:pt>
                <c:pt idx="2904">
                  <c:v>0.90736449273181452</c:v>
                </c:pt>
                <c:pt idx="2905">
                  <c:v>0.92042615944864115</c:v>
                </c:pt>
                <c:pt idx="2906">
                  <c:v>0.90170644355494023</c:v>
                </c:pt>
                <c:pt idx="2907">
                  <c:v>0.90826737291961357</c:v>
                </c:pt>
                <c:pt idx="2908">
                  <c:v>0.89803473079122398</c:v>
                </c:pt>
                <c:pt idx="2909">
                  <c:v>0.9038733560056581</c:v>
                </c:pt>
                <c:pt idx="2910">
                  <c:v>0.90932073313871253</c:v>
                </c:pt>
                <c:pt idx="2911">
                  <c:v>0.92385710416227762</c:v>
                </c:pt>
                <c:pt idx="2912">
                  <c:v>0.90808679688205374</c:v>
                </c:pt>
                <c:pt idx="2913">
                  <c:v>0.90697324465043494</c:v>
                </c:pt>
                <c:pt idx="2914">
                  <c:v>0.90197730761128003</c:v>
                </c:pt>
                <c:pt idx="2915">
                  <c:v>0.89177476148915036</c:v>
                </c:pt>
                <c:pt idx="2916">
                  <c:v>0.91642339061606526</c:v>
                </c:pt>
                <c:pt idx="2917">
                  <c:v>0.8890661209257531</c:v>
                </c:pt>
                <c:pt idx="2918">
                  <c:v>0.89722213862220479</c:v>
                </c:pt>
                <c:pt idx="2919">
                  <c:v>0.89656002648448552</c:v>
                </c:pt>
                <c:pt idx="2920">
                  <c:v>0.90838775694465346</c:v>
                </c:pt>
                <c:pt idx="2921">
                  <c:v>0.89866674692268333</c:v>
                </c:pt>
                <c:pt idx="2922">
                  <c:v>0.89938905107292266</c:v>
                </c:pt>
                <c:pt idx="2923">
                  <c:v>0.90950130917627225</c:v>
                </c:pt>
                <c:pt idx="2924">
                  <c:v>0.90086375537966112</c:v>
                </c:pt>
                <c:pt idx="2925">
                  <c:v>0.91227014175218946</c:v>
                </c:pt>
                <c:pt idx="2926">
                  <c:v>0.89601829837180602</c:v>
                </c:pt>
                <c:pt idx="2927">
                  <c:v>0.8927980257019893</c:v>
                </c:pt>
                <c:pt idx="2928">
                  <c:v>0.90101423541096093</c:v>
                </c:pt>
                <c:pt idx="2929">
                  <c:v>0.89174466548289044</c:v>
                </c:pt>
                <c:pt idx="2930">
                  <c:v>0.89863665091642342</c:v>
                </c:pt>
                <c:pt idx="2931">
                  <c:v>0.9072140127005146</c:v>
                </c:pt>
                <c:pt idx="2932">
                  <c:v>0.9088692930448129</c:v>
                </c:pt>
                <c:pt idx="2933">
                  <c:v>0.8946037860775875</c:v>
                </c:pt>
                <c:pt idx="2934">
                  <c:v>0.89017967315737201</c:v>
                </c:pt>
                <c:pt idx="2935">
                  <c:v>0.89944924308544261</c:v>
                </c:pt>
                <c:pt idx="2936">
                  <c:v>0.89791434676618409</c:v>
                </c:pt>
                <c:pt idx="2937">
                  <c:v>0.91305263791494873</c:v>
                </c:pt>
                <c:pt idx="2938">
                  <c:v>0.89854636289764345</c:v>
                </c:pt>
                <c:pt idx="2939">
                  <c:v>0.90832756493213351</c:v>
                </c:pt>
                <c:pt idx="2940">
                  <c:v>0.90604026845637586</c:v>
                </c:pt>
                <c:pt idx="2941">
                  <c:v>0.89851626689138353</c:v>
                </c:pt>
                <c:pt idx="2942">
                  <c:v>0.89707165859090499</c:v>
                </c:pt>
                <c:pt idx="2943">
                  <c:v>0.90838775694465346</c:v>
                </c:pt>
                <c:pt idx="2944">
                  <c:v>0.90345201191801849</c:v>
                </c:pt>
                <c:pt idx="2945">
                  <c:v>0.89869684292894336</c:v>
                </c:pt>
                <c:pt idx="2946">
                  <c:v>0.90576940440003606</c:v>
                </c:pt>
                <c:pt idx="2947">
                  <c:v>0.89893761097902314</c:v>
                </c:pt>
                <c:pt idx="2948">
                  <c:v>0.91874078309808294</c:v>
                </c:pt>
                <c:pt idx="2949">
                  <c:v>0.88491287206187741</c:v>
                </c:pt>
                <c:pt idx="2950">
                  <c:v>0.89538628224034666</c:v>
                </c:pt>
                <c:pt idx="2951">
                  <c:v>0.90594998043759589</c:v>
                </c:pt>
                <c:pt idx="2952">
                  <c:v>0.89388148192734829</c:v>
                </c:pt>
                <c:pt idx="2953">
                  <c:v>0.8822644235110001</c:v>
                </c:pt>
                <c:pt idx="2954">
                  <c:v>0.90288018779907908</c:v>
                </c:pt>
                <c:pt idx="2955">
                  <c:v>0.90233845968639959</c:v>
                </c:pt>
                <c:pt idx="2956">
                  <c:v>0.89746290667228457</c:v>
                </c:pt>
                <c:pt idx="2957">
                  <c:v>0.91910193517320249</c:v>
                </c:pt>
                <c:pt idx="2958">
                  <c:v>0.87615493424022628</c:v>
                </c:pt>
                <c:pt idx="2959">
                  <c:v>0.90546844433743645</c:v>
                </c:pt>
                <c:pt idx="2960">
                  <c:v>0.8779907906220844</c:v>
                </c:pt>
                <c:pt idx="2961">
                  <c:v>0.90032202726698163</c:v>
                </c:pt>
                <c:pt idx="2962">
                  <c:v>0.89791434676618409</c:v>
                </c:pt>
                <c:pt idx="2963">
                  <c:v>0.88930688897583288</c:v>
                </c:pt>
                <c:pt idx="2964">
                  <c:v>0.90294037981159903</c:v>
                </c:pt>
                <c:pt idx="2965">
                  <c:v>0.89535618623408675</c:v>
                </c:pt>
                <c:pt idx="2966">
                  <c:v>0.92000481536100165</c:v>
                </c:pt>
                <c:pt idx="2967">
                  <c:v>0.89990068317934213</c:v>
                </c:pt>
                <c:pt idx="2968">
                  <c:v>0.90772564480693407</c:v>
                </c:pt>
                <c:pt idx="2969">
                  <c:v>0.90877900502603304</c:v>
                </c:pt>
                <c:pt idx="2970">
                  <c:v>0.89568724230294638</c:v>
                </c:pt>
                <c:pt idx="2971">
                  <c:v>0.89394167393986823</c:v>
                </c:pt>
                <c:pt idx="2972">
                  <c:v>0.90907996508863276</c:v>
                </c:pt>
                <c:pt idx="2973">
                  <c:v>0.8952959942215668</c:v>
                </c:pt>
                <c:pt idx="2974">
                  <c:v>0.89956962711048238</c:v>
                </c:pt>
                <c:pt idx="2975">
                  <c:v>0.90122490745478079</c:v>
                </c:pt>
                <c:pt idx="2976">
                  <c:v>0.8897583290697324</c:v>
                </c:pt>
                <c:pt idx="2977">
                  <c:v>0.90504710024979684</c:v>
                </c:pt>
                <c:pt idx="2978">
                  <c:v>0.89448340205254762</c:v>
                </c:pt>
                <c:pt idx="2979">
                  <c:v>0.89767357871610443</c:v>
                </c:pt>
                <c:pt idx="2980">
                  <c:v>0.89496493815270717</c:v>
                </c:pt>
                <c:pt idx="2981">
                  <c:v>0.89947933909170252</c:v>
                </c:pt>
                <c:pt idx="2982">
                  <c:v>0.89788425075992417</c:v>
                </c:pt>
                <c:pt idx="2983">
                  <c:v>0.90718391669425469</c:v>
                </c:pt>
                <c:pt idx="2984">
                  <c:v>0.87994703102898242</c:v>
                </c:pt>
                <c:pt idx="2985">
                  <c:v>0.89800463478496406</c:v>
                </c:pt>
                <c:pt idx="2986">
                  <c:v>0.89851626689138353</c:v>
                </c:pt>
                <c:pt idx="2987">
                  <c:v>0.90164625154242029</c:v>
                </c:pt>
                <c:pt idx="2988">
                  <c:v>0.91543022240948624</c:v>
                </c:pt>
                <c:pt idx="2989">
                  <c:v>0.90278989978029911</c:v>
                </c:pt>
                <c:pt idx="2990">
                  <c:v>0.90811689288831376</c:v>
                </c:pt>
                <c:pt idx="2991">
                  <c:v>0.89008938513859215</c:v>
                </c:pt>
                <c:pt idx="2992">
                  <c:v>0.90351220393053844</c:v>
                </c:pt>
                <c:pt idx="2993">
                  <c:v>0.90700334065669486</c:v>
                </c:pt>
                <c:pt idx="2994">
                  <c:v>0.90321124386793872</c:v>
                </c:pt>
                <c:pt idx="2995">
                  <c:v>0.90763535678815421</c:v>
                </c:pt>
                <c:pt idx="2996">
                  <c:v>0.90212778764257984</c:v>
                </c:pt>
                <c:pt idx="2997">
                  <c:v>0.90209769163631981</c:v>
                </c:pt>
                <c:pt idx="2998">
                  <c:v>0.91338369398380836</c:v>
                </c:pt>
                <c:pt idx="2999">
                  <c:v>0.90965178920757217</c:v>
                </c:pt>
                <c:pt idx="3000">
                  <c:v>0.90288018779907908</c:v>
                </c:pt>
                <c:pt idx="3001">
                  <c:v>0.89893761097902314</c:v>
                </c:pt>
                <c:pt idx="3002">
                  <c:v>0.88605652029975623</c:v>
                </c:pt>
                <c:pt idx="3003">
                  <c:v>0.88000722304150236</c:v>
                </c:pt>
                <c:pt idx="3004">
                  <c:v>0.90486652421223701</c:v>
                </c:pt>
                <c:pt idx="3005">
                  <c:v>0.89054082523249167</c:v>
                </c:pt>
                <c:pt idx="3006">
                  <c:v>0.89722213862220479</c:v>
                </c:pt>
                <c:pt idx="3007">
                  <c:v>0.89860655491016339</c:v>
                </c:pt>
                <c:pt idx="3008">
                  <c:v>0.91341378999006828</c:v>
                </c:pt>
                <c:pt idx="3009">
                  <c:v>0.90817708490083371</c:v>
                </c:pt>
                <c:pt idx="3010">
                  <c:v>0.88870496885063355</c:v>
                </c:pt>
                <c:pt idx="3011">
                  <c:v>0.90224817166761972</c:v>
                </c:pt>
                <c:pt idx="3012">
                  <c:v>0.90441508411833749</c:v>
                </c:pt>
                <c:pt idx="3013">
                  <c:v>0.90336172389923852</c:v>
                </c:pt>
                <c:pt idx="3014">
                  <c:v>0.91843982303548322</c:v>
                </c:pt>
                <c:pt idx="3015">
                  <c:v>0.89619887440936585</c:v>
                </c:pt>
                <c:pt idx="3016">
                  <c:v>0.90260932374273939</c:v>
                </c:pt>
                <c:pt idx="3017">
                  <c:v>0.90640142053149542</c:v>
                </c:pt>
                <c:pt idx="3018">
                  <c:v>0.90742468474433446</c:v>
                </c:pt>
                <c:pt idx="3019">
                  <c:v>0.89734252264724468</c:v>
                </c:pt>
                <c:pt idx="3020">
                  <c:v>0.88617690432479612</c:v>
                </c:pt>
                <c:pt idx="3021">
                  <c:v>0.88840400878803383</c:v>
                </c:pt>
                <c:pt idx="3022">
                  <c:v>0.89388148192734829</c:v>
                </c:pt>
                <c:pt idx="3023">
                  <c:v>0.90327143588045866</c:v>
                </c:pt>
                <c:pt idx="3024">
                  <c:v>0.89020976916363204</c:v>
                </c:pt>
                <c:pt idx="3025">
                  <c:v>0.89343004183344865</c:v>
                </c:pt>
                <c:pt idx="3026">
                  <c:v>0.89716194660968485</c:v>
                </c:pt>
                <c:pt idx="3027">
                  <c:v>0.87606464622144642</c:v>
                </c:pt>
                <c:pt idx="3028">
                  <c:v>0.89273783368946946</c:v>
                </c:pt>
                <c:pt idx="3029">
                  <c:v>0.88855448881933363</c:v>
                </c:pt>
                <c:pt idx="3030">
                  <c:v>0.89364071387726851</c:v>
                </c:pt>
                <c:pt idx="3031">
                  <c:v>0.89439311403376776</c:v>
                </c:pt>
                <c:pt idx="3032">
                  <c:v>0.90351220393053844</c:v>
                </c:pt>
                <c:pt idx="3033">
                  <c:v>0.90050260330454146</c:v>
                </c:pt>
                <c:pt idx="3034">
                  <c:v>0.90528786829987662</c:v>
                </c:pt>
                <c:pt idx="3035">
                  <c:v>0.9065218045565353</c:v>
                </c:pt>
                <c:pt idx="3036">
                  <c:v>0.8918349535016703</c:v>
                </c:pt>
                <c:pt idx="3037">
                  <c:v>0.89767357871610443</c:v>
                </c:pt>
                <c:pt idx="3038">
                  <c:v>0.89403196195864809</c:v>
                </c:pt>
                <c:pt idx="3039">
                  <c:v>0.89502513016522711</c:v>
                </c:pt>
                <c:pt idx="3040">
                  <c:v>0.89803473079122398</c:v>
                </c:pt>
                <c:pt idx="3041">
                  <c:v>0.90489662021849704</c:v>
                </c:pt>
                <c:pt idx="3042">
                  <c:v>0.91311282992746867</c:v>
                </c:pt>
                <c:pt idx="3043">
                  <c:v>0.91067505342041111</c:v>
                </c:pt>
                <c:pt idx="3044">
                  <c:v>0.91004303728895175</c:v>
                </c:pt>
                <c:pt idx="3045">
                  <c:v>0.88596623228097626</c:v>
                </c:pt>
                <c:pt idx="3046">
                  <c:v>0.89339994582718874</c:v>
                </c:pt>
                <c:pt idx="3047">
                  <c:v>0.88036837511662203</c:v>
                </c:pt>
                <c:pt idx="3048">
                  <c:v>0.89171456947663041</c:v>
                </c:pt>
                <c:pt idx="3049">
                  <c:v>0.88160231137328071</c:v>
                </c:pt>
                <c:pt idx="3050">
                  <c:v>0.90688295663165497</c:v>
                </c:pt>
                <c:pt idx="3051">
                  <c:v>0.88948746501339271</c:v>
                </c:pt>
                <c:pt idx="3052">
                  <c:v>0.88701959250007523</c:v>
                </c:pt>
                <c:pt idx="3053">
                  <c:v>0.88689920847503534</c:v>
                </c:pt>
                <c:pt idx="3054">
                  <c:v>0.90297047581785894</c:v>
                </c:pt>
                <c:pt idx="3055">
                  <c:v>0.89791434676618409</c:v>
                </c:pt>
                <c:pt idx="3056">
                  <c:v>0.90077346736088126</c:v>
                </c:pt>
                <c:pt idx="3057">
                  <c:v>0.89821530682878381</c:v>
                </c:pt>
                <c:pt idx="3058">
                  <c:v>0.8955668582779065</c:v>
                </c:pt>
                <c:pt idx="3059">
                  <c:v>0.88903602491949318</c:v>
                </c:pt>
                <c:pt idx="3060">
                  <c:v>0.90880910103229307</c:v>
                </c:pt>
                <c:pt idx="3061">
                  <c:v>0.89935895506666264</c:v>
                </c:pt>
                <c:pt idx="3062">
                  <c:v>0.90185692358624014</c:v>
                </c:pt>
                <c:pt idx="3063">
                  <c:v>0.90369277996809827</c:v>
                </c:pt>
                <c:pt idx="3064">
                  <c:v>0.89343004183344865</c:v>
                </c:pt>
                <c:pt idx="3065">
                  <c:v>0.89538628224034666</c:v>
                </c:pt>
                <c:pt idx="3066">
                  <c:v>0.89634935444066577</c:v>
                </c:pt>
                <c:pt idx="3067">
                  <c:v>0.8889156408944533</c:v>
                </c:pt>
                <c:pt idx="3068">
                  <c:v>0.89646973846570555</c:v>
                </c:pt>
                <c:pt idx="3069">
                  <c:v>0.89719204261594487</c:v>
                </c:pt>
                <c:pt idx="3070">
                  <c:v>0.90685286062539505</c:v>
                </c:pt>
                <c:pt idx="3071">
                  <c:v>0.89243687362686974</c:v>
                </c:pt>
                <c:pt idx="3072">
                  <c:v>0.90862852499473323</c:v>
                </c:pt>
                <c:pt idx="3073">
                  <c:v>0.89601829837180602</c:v>
                </c:pt>
                <c:pt idx="3074">
                  <c:v>0.90501700424353693</c:v>
                </c:pt>
                <c:pt idx="3075">
                  <c:v>0.90227826767387964</c:v>
                </c:pt>
                <c:pt idx="3076">
                  <c:v>0.90008125921690196</c:v>
                </c:pt>
                <c:pt idx="3077">
                  <c:v>0.88497306407439735</c:v>
                </c:pt>
                <c:pt idx="3078">
                  <c:v>0.9095615011887922</c:v>
                </c:pt>
                <c:pt idx="3079">
                  <c:v>0.88984861708851237</c:v>
                </c:pt>
                <c:pt idx="3080">
                  <c:v>0.89686098654708524</c:v>
                </c:pt>
                <c:pt idx="3081">
                  <c:v>0.90029193126072171</c:v>
                </c:pt>
                <c:pt idx="3082">
                  <c:v>0.89057092123875159</c:v>
                </c:pt>
                <c:pt idx="3083">
                  <c:v>0.89845607487886359</c:v>
                </c:pt>
                <c:pt idx="3084">
                  <c:v>0.88509344809943724</c:v>
                </c:pt>
                <c:pt idx="3085">
                  <c:v>0.90679266861287511</c:v>
                </c:pt>
                <c:pt idx="3086">
                  <c:v>0.89294850573328921</c:v>
                </c:pt>
                <c:pt idx="3087">
                  <c:v>0.88921660095705302</c:v>
                </c:pt>
                <c:pt idx="3088">
                  <c:v>0.88355855178017872</c:v>
                </c:pt>
                <c:pt idx="3089">
                  <c:v>0.88819333674421408</c:v>
                </c:pt>
                <c:pt idx="3090">
                  <c:v>0.90197730761128003</c:v>
                </c:pt>
                <c:pt idx="3091">
                  <c:v>0.91458753423420713</c:v>
                </c:pt>
                <c:pt idx="3092">
                  <c:v>0.887260360550155</c:v>
                </c:pt>
                <c:pt idx="3093">
                  <c:v>0.90297047581785894</c:v>
                </c:pt>
                <c:pt idx="3094">
                  <c:v>0.89944924308544261</c:v>
                </c:pt>
                <c:pt idx="3095">
                  <c:v>0.89926866704788277</c:v>
                </c:pt>
                <c:pt idx="3096">
                  <c:v>0.90182682757998012</c:v>
                </c:pt>
                <c:pt idx="3097">
                  <c:v>0.89120293737021095</c:v>
                </c:pt>
                <c:pt idx="3098">
                  <c:v>0.8976434827098444</c:v>
                </c:pt>
                <c:pt idx="3099">
                  <c:v>0.90005116321064194</c:v>
                </c:pt>
                <c:pt idx="3100">
                  <c:v>0.9031811478616788</c:v>
                </c:pt>
                <c:pt idx="3101">
                  <c:v>0.89866674692268333</c:v>
                </c:pt>
                <c:pt idx="3102">
                  <c:v>0.8952959942215668</c:v>
                </c:pt>
                <c:pt idx="3103">
                  <c:v>0.89782405874740423</c:v>
                </c:pt>
                <c:pt idx="3104">
                  <c:v>0.8934902338459686</c:v>
                </c:pt>
                <c:pt idx="3105">
                  <c:v>0.8962590664218858</c:v>
                </c:pt>
                <c:pt idx="3106">
                  <c:v>0.89023986516989195</c:v>
                </c:pt>
                <c:pt idx="3107">
                  <c:v>0.89920847503536283</c:v>
                </c:pt>
                <c:pt idx="3108">
                  <c:v>0.91004303728895175</c:v>
                </c:pt>
                <c:pt idx="3109">
                  <c:v>0.89953953110422247</c:v>
                </c:pt>
                <c:pt idx="3110">
                  <c:v>0.89929876305414269</c:v>
                </c:pt>
                <c:pt idx="3111">
                  <c:v>0.90170644355494023</c:v>
                </c:pt>
                <c:pt idx="3112">
                  <c:v>0.89969001113552227</c:v>
                </c:pt>
                <c:pt idx="3113">
                  <c:v>0.89788425075992417</c:v>
                </c:pt>
                <c:pt idx="3114">
                  <c:v>0.90585969241881603</c:v>
                </c:pt>
                <c:pt idx="3115">
                  <c:v>0.90543834833117642</c:v>
                </c:pt>
                <c:pt idx="3116">
                  <c:v>0.88253528756733979</c:v>
                </c:pt>
                <c:pt idx="3117">
                  <c:v>0.89662021849700546</c:v>
                </c:pt>
                <c:pt idx="3118">
                  <c:v>0.90561892436873626</c:v>
                </c:pt>
                <c:pt idx="3119">
                  <c:v>0.89845607487886359</c:v>
                </c:pt>
                <c:pt idx="3120">
                  <c:v>0.87829175068468412</c:v>
                </c:pt>
                <c:pt idx="3121">
                  <c:v>0.88993890510729223</c:v>
                </c:pt>
                <c:pt idx="3122">
                  <c:v>0.88735064856893486</c:v>
                </c:pt>
                <c:pt idx="3123">
                  <c:v>0.89379119390856832</c:v>
                </c:pt>
                <c:pt idx="3124">
                  <c:v>0.87455984590844793</c:v>
                </c:pt>
                <c:pt idx="3125">
                  <c:v>0.88629728834983601</c:v>
                </c:pt>
                <c:pt idx="3126">
                  <c:v>0.88635748036235595</c:v>
                </c:pt>
                <c:pt idx="3127">
                  <c:v>0.88443133596171786</c:v>
                </c:pt>
                <c:pt idx="3128">
                  <c:v>0.8927980257019893</c:v>
                </c:pt>
                <c:pt idx="3129">
                  <c:v>0.89875703494146331</c:v>
                </c:pt>
                <c:pt idx="3130">
                  <c:v>0.89207572155175008</c:v>
                </c:pt>
                <c:pt idx="3131">
                  <c:v>0.88476239203057749</c:v>
                </c:pt>
                <c:pt idx="3132">
                  <c:v>0.89017967315737201</c:v>
                </c:pt>
                <c:pt idx="3133">
                  <c:v>0.89490474614018722</c:v>
                </c:pt>
                <c:pt idx="3134">
                  <c:v>0.88843410479429374</c:v>
                </c:pt>
                <c:pt idx="3135">
                  <c:v>0.88521383212447713</c:v>
                </c:pt>
                <c:pt idx="3136">
                  <c:v>0.88190327143588043</c:v>
                </c:pt>
                <c:pt idx="3137">
                  <c:v>0.88497306407439735</c:v>
                </c:pt>
                <c:pt idx="3138">
                  <c:v>0.88057904716044177</c:v>
                </c:pt>
                <c:pt idx="3139">
                  <c:v>0.8879525686941343</c:v>
                </c:pt>
                <c:pt idx="3140">
                  <c:v>0.88319739970505917</c:v>
                </c:pt>
                <c:pt idx="3141">
                  <c:v>0.88358864778643875</c:v>
                </c:pt>
                <c:pt idx="3142">
                  <c:v>0.88713997652511511</c:v>
                </c:pt>
                <c:pt idx="3143">
                  <c:v>0.90501700424353693</c:v>
                </c:pt>
                <c:pt idx="3144">
                  <c:v>0.89643964245944563</c:v>
                </c:pt>
                <c:pt idx="3145">
                  <c:v>0.89782405874740423</c:v>
                </c:pt>
                <c:pt idx="3146">
                  <c:v>0.89312908177084904</c:v>
                </c:pt>
                <c:pt idx="3147">
                  <c:v>0.89538628224034666</c:v>
                </c:pt>
                <c:pt idx="3148">
                  <c:v>0.89394167393986823</c:v>
                </c:pt>
                <c:pt idx="3149">
                  <c:v>0.89457369007132759</c:v>
                </c:pt>
                <c:pt idx="3150">
                  <c:v>0.88253528756733979</c:v>
                </c:pt>
                <c:pt idx="3151">
                  <c:v>0.884341047942938</c:v>
                </c:pt>
                <c:pt idx="3152">
                  <c:v>0.88506335209317721</c:v>
                </c:pt>
                <c:pt idx="3153">
                  <c:v>0.8939115779336082</c:v>
                </c:pt>
                <c:pt idx="3154">
                  <c:v>0.89394167393986823</c:v>
                </c:pt>
                <c:pt idx="3155">
                  <c:v>0.89577753032172636</c:v>
                </c:pt>
                <c:pt idx="3156">
                  <c:v>0.88885544888193335</c:v>
                </c:pt>
                <c:pt idx="3157">
                  <c:v>0.90086375537966112</c:v>
                </c:pt>
                <c:pt idx="3158">
                  <c:v>0.90206759563005989</c:v>
                </c:pt>
                <c:pt idx="3159">
                  <c:v>0.87091822915099171</c:v>
                </c:pt>
                <c:pt idx="3160">
                  <c:v>0.89668041050952541</c:v>
                </c:pt>
                <c:pt idx="3161">
                  <c:v>0.88927679296957296</c:v>
                </c:pt>
                <c:pt idx="3162">
                  <c:v>0.8959882023655461</c:v>
                </c:pt>
                <c:pt idx="3163">
                  <c:v>0.8857254642308966</c:v>
                </c:pt>
                <c:pt idx="3164">
                  <c:v>0.87170072531375087</c:v>
                </c:pt>
                <c:pt idx="3165">
                  <c:v>0.87735877449062505</c:v>
                </c:pt>
                <c:pt idx="3166">
                  <c:v>0.87398802178950852</c:v>
                </c:pt>
                <c:pt idx="3167">
                  <c:v>0.89526589821530678</c:v>
                </c:pt>
                <c:pt idx="3168">
                  <c:v>0.89665031450326538</c:v>
                </c:pt>
                <c:pt idx="3169">
                  <c:v>0.86959400487555305</c:v>
                </c:pt>
                <c:pt idx="3170">
                  <c:v>0.87940530291630303</c:v>
                </c:pt>
                <c:pt idx="3171">
                  <c:v>0.88717007253137503</c:v>
                </c:pt>
                <c:pt idx="3172">
                  <c:v>0.89595810635928608</c:v>
                </c:pt>
                <c:pt idx="3173">
                  <c:v>0.86628344418695635</c:v>
                </c:pt>
                <c:pt idx="3174">
                  <c:v>0.87690733439672552</c:v>
                </c:pt>
                <c:pt idx="3175">
                  <c:v>0.88707978451259517</c:v>
                </c:pt>
                <c:pt idx="3176">
                  <c:v>0.88867487284437352</c:v>
                </c:pt>
                <c:pt idx="3177">
                  <c:v>0.87618503024648631</c:v>
                </c:pt>
                <c:pt idx="3178">
                  <c:v>0.88202365546092032</c:v>
                </c:pt>
                <c:pt idx="3179">
                  <c:v>0.88292653564871937</c:v>
                </c:pt>
                <c:pt idx="3180">
                  <c:v>0.88280615162367959</c:v>
                </c:pt>
                <c:pt idx="3181">
                  <c:v>0.87871309477232373</c:v>
                </c:pt>
                <c:pt idx="3182">
                  <c:v>0.87440936587714813</c:v>
                </c:pt>
                <c:pt idx="3183">
                  <c:v>0.88148192734824093</c:v>
                </c:pt>
                <c:pt idx="3184">
                  <c:v>0.87284437355162969</c:v>
                </c:pt>
                <c:pt idx="3185">
                  <c:v>0.87455984590844793</c:v>
                </c:pt>
                <c:pt idx="3186">
                  <c:v>0.89011948114485206</c:v>
                </c:pt>
                <c:pt idx="3187">
                  <c:v>0.87236283745147014</c:v>
                </c:pt>
                <c:pt idx="3188">
                  <c:v>0.87170072531375087</c:v>
                </c:pt>
                <c:pt idx="3189">
                  <c:v>0.87865290275980379</c:v>
                </c:pt>
                <c:pt idx="3190">
                  <c:v>0.88861468083185358</c:v>
                </c:pt>
                <c:pt idx="3191">
                  <c:v>0.89108255334517106</c:v>
                </c:pt>
                <c:pt idx="3192">
                  <c:v>0.89743281066602465</c:v>
                </c:pt>
                <c:pt idx="3193">
                  <c:v>0.8958377223342463</c:v>
                </c:pt>
                <c:pt idx="3194">
                  <c:v>0.88668853643121559</c:v>
                </c:pt>
                <c:pt idx="3195">
                  <c:v>0.88446143196797788</c:v>
                </c:pt>
                <c:pt idx="3196">
                  <c:v>0.8886447768381136</c:v>
                </c:pt>
                <c:pt idx="3197">
                  <c:v>0.87320552562674936</c:v>
                </c:pt>
                <c:pt idx="3198">
                  <c:v>0.89656002648448552</c:v>
                </c:pt>
                <c:pt idx="3199">
                  <c:v>0.88485268004935747</c:v>
                </c:pt>
                <c:pt idx="3200">
                  <c:v>0.8736870617269088</c:v>
                </c:pt>
                <c:pt idx="3201">
                  <c:v>0.87711800644054538</c:v>
                </c:pt>
                <c:pt idx="3202">
                  <c:v>0.89355042585848854</c:v>
                </c:pt>
                <c:pt idx="3203">
                  <c:v>0.89144370542029072</c:v>
                </c:pt>
                <c:pt idx="3204">
                  <c:v>0.89075149727631142</c:v>
                </c:pt>
                <c:pt idx="3205">
                  <c:v>0.87263370150780994</c:v>
                </c:pt>
                <c:pt idx="3206">
                  <c:v>0.87696752640924547</c:v>
                </c:pt>
                <c:pt idx="3207">
                  <c:v>0.8857254642308966</c:v>
                </c:pt>
                <c:pt idx="3208">
                  <c:v>0.88744093658771483</c:v>
                </c:pt>
                <c:pt idx="3209">
                  <c:v>0.8916844734703705</c:v>
                </c:pt>
                <c:pt idx="3210">
                  <c:v>0.905829596412556</c:v>
                </c:pt>
                <c:pt idx="3211">
                  <c:v>0.89424263400246784</c:v>
                </c:pt>
                <c:pt idx="3212">
                  <c:v>0.8958377223342463</c:v>
                </c:pt>
                <c:pt idx="3213">
                  <c:v>0.88873506485689346</c:v>
                </c:pt>
                <c:pt idx="3214">
                  <c:v>0.88978842507599243</c:v>
                </c:pt>
                <c:pt idx="3215">
                  <c:v>0.88948746501339271</c:v>
                </c:pt>
                <c:pt idx="3216">
                  <c:v>0.88717007253137503</c:v>
                </c:pt>
                <c:pt idx="3217">
                  <c:v>0.89562705029042644</c:v>
                </c:pt>
                <c:pt idx="3218">
                  <c:v>0.90014145122942191</c:v>
                </c:pt>
                <c:pt idx="3219">
                  <c:v>0.88665844042495556</c:v>
                </c:pt>
                <c:pt idx="3220">
                  <c:v>0.89577753032172636</c:v>
                </c:pt>
                <c:pt idx="3221">
                  <c:v>0.87176091732627081</c:v>
                </c:pt>
                <c:pt idx="3222">
                  <c:v>0.89914828302284289</c:v>
                </c:pt>
                <c:pt idx="3223">
                  <c:v>0.87892376681614348</c:v>
                </c:pt>
                <c:pt idx="3224">
                  <c:v>0.89466397809010745</c:v>
                </c:pt>
                <c:pt idx="3225">
                  <c:v>0.88987871309477229</c:v>
                </c:pt>
                <c:pt idx="3226">
                  <c:v>0.91236042977096943</c:v>
                </c:pt>
                <c:pt idx="3227">
                  <c:v>0.89294850573328921</c:v>
                </c:pt>
                <c:pt idx="3228">
                  <c:v>0.89132332139525083</c:v>
                </c:pt>
                <c:pt idx="3229">
                  <c:v>0.8977939627411442</c:v>
                </c:pt>
                <c:pt idx="3230">
                  <c:v>0.89761338670358448</c:v>
                </c:pt>
                <c:pt idx="3231">
                  <c:v>0.87552291810876692</c:v>
                </c:pt>
                <c:pt idx="3232">
                  <c:v>0.89752309868480451</c:v>
                </c:pt>
                <c:pt idx="3233">
                  <c:v>0.89842597887260356</c:v>
                </c:pt>
                <c:pt idx="3234">
                  <c:v>0.88548469618081682</c:v>
                </c:pt>
                <c:pt idx="3235">
                  <c:v>0.89177476148915036</c:v>
                </c:pt>
                <c:pt idx="3236">
                  <c:v>0.90122490745478079</c:v>
                </c:pt>
                <c:pt idx="3237">
                  <c:v>0.8851837361182171</c:v>
                </c:pt>
                <c:pt idx="3238">
                  <c:v>0.89385138592108826</c:v>
                </c:pt>
                <c:pt idx="3239">
                  <c:v>0.88193336744214046</c:v>
                </c:pt>
                <c:pt idx="3240">
                  <c:v>0.8969512745658651</c:v>
                </c:pt>
                <c:pt idx="3241">
                  <c:v>0.87835194269720407</c:v>
                </c:pt>
                <c:pt idx="3242">
                  <c:v>0.89267764167694952</c:v>
                </c:pt>
                <c:pt idx="3243">
                  <c:v>0.88331778373009906</c:v>
                </c:pt>
                <c:pt idx="3244">
                  <c:v>0.88319739970505917</c:v>
                </c:pt>
                <c:pt idx="3245">
                  <c:v>0.90483642820597709</c:v>
                </c:pt>
                <c:pt idx="3246">
                  <c:v>0.88810304872543411</c:v>
                </c:pt>
                <c:pt idx="3247">
                  <c:v>0.88698949649381531</c:v>
                </c:pt>
                <c:pt idx="3248">
                  <c:v>0.88491287206187741</c:v>
                </c:pt>
                <c:pt idx="3249">
                  <c:v>0.90835766093839343</c:v>
                </c:pt>
                <c:pt idx="3250">
                  <c:v>0.89339994582718874</c:v>
                </c:pt>
                <c:pt idx="3251">
                  <c:v>0.88181298341710057</c:v>
                </c:pt>
                <c:pt idx="3252">
                  <c:v>0.90161615553616037</c:v>
                </c:pt>
                <c:pt idx="3253">
                  <c:v>0.89520570620278694</c:v>
                </c:pt>
                <c:pt idx="3254">
                  <c:v>0.9008336593734011</c:v>
                </c:pt>
                <c:pt idx="3255">
                  <c:v>0.88756132061275472</c:v>
                </c:pt>
                <c:pt idx="3256">
                  <c:v>0.88677882444999545</c:v>
                </c:pt>
                <c:pt idx="3257">
                  <c:v>0.89421253799620792</c:v>
                </c:pt>
                <c:pt idx="3258">
                  <c:v>0.89243687362686974</c:v>
                </c:pt>
                <c:pt idx="3259">
                  <c:v>0.88900592891323327</c:v>
                </c:pt>
                <c:pt idx="3260">
                  <c:v>0.88608661630601615</c:v>
                </c:pt>
                <c:pt idx="3261">
                  <c:v>0.88894573690071332</c:v>
                </c:pt>
                <c:pt idx="3262">
                  <c:v>0.89758329069732445</c:v>
                </c:pt>
                <c:pt idx="3263">
                  <c:v>0.89842597887260356</c:v>
                </c:pt>
                <c:pt idx="3264">
                  <c:v>0.87970626297890275</c:v>
                </c:pt>
                <c:pt idx="3265">
                  <c:v>0.888223432750474</c:v>
                </c:pt>
                <c:pt idx="3266">
                  <c:v>0.88888554488819338</c:v>
                </c:pt>
                <c:pt idx="3267">
                  <c:v>0.88957775303217268</c:v>
                </c:pt>
                <c:pt idx="3268">
                  <c:v>0.89595810635928608</c:v>
                </c:pt>
                <c:pt idx="3269">
                  <c:v>0.88485268004935747</c:v>
                </c:pt>
                <c:pt idx="3270">
                  <c:v>0.89008938513859215</c:v>
                </c:pt>
                <c:pt idx="3271">
                  <c:v>0.88036837511662203</c:v>
                </c:pt>
                <c:pt idx="3272">
                  <c:v>0.89523580220904686</c:v>
                </c:pt>
                <c:pt idx="3273">
                  <c:v>0.89364071387726851</c:v>
                </c:pt>
                <c:pt idx="3274">
                  <c:v>0.89014957715111209</c:v>
                </c:pt>
                <c:pt idx="3275">
                  <c:v>0.88075962319800161</c:v>
                </c:pt>
                <c:pt idx="3276">
                  <c:v>0.87311523760796939</c:v>
                </c:pt>
                <c:pt idx="3277">
                  <c:v>0.88759141661901464</c:v>
                </c:pt>
                <c:pt idx="3278">
                  <c:v>0.8977939627411442</c:v>
                </c:pt>
                <c:pt idx="3279">
                  <c:v>0.8826857675986397</c:v>
                </c:pt>
                <c:pt idx="3280">
                  <c:v>0.88626719234357598</c:v>
                </c:pt>
                <c:pt idx="3281">
                  <c:v>0.88331778373009906</c:v>
                </c:pt>
                <c:pt idx="3282">
                  <c:v>0.88367893580521861</c:v>
                </c:pt>
                <c:pt idx="3283">
                  <c:v>0.87185120534505067</c:v>
                </c:pt>
                <c:pt idx="3284">
                  <c:v>0.8889156408944533</c:v>
                </c:pt>
                <c:pt idx="3285">
                  <c:v>0.87865290275980379</c:v>
                </c:pt>
                <c:pt idx="3286">
                  <c:v>0.89379119390856832</c:v>
                </c:pt>
                <c:pt idx="3287">
                  <c:v>0.87723839046558527</c:v>
                </c:pt>
                <c:pt idx="3288">
                  <c:v>0.8837993198302585</c:v>
                </c:pt>
                <c:pt idx="3289">
                  <c:v>0.88879525686941341</c:v>
                </c:pt>
                <c:pt idx="3290">
                  <c:v>0.88178288741084054</c:v>
                </c:pt>
                <c:pt idx="3291">
                  <c:v>0.88602642429349621</c:v>
                </c:pt>
                <c:pt idx="3292">
                  <c:v>0.88554488819333677</c:v>
                </c:pt>
                <c:pt idx="3293">
                  <c:v>0.88563517621211663</c:v>
                </c:pt>
                <c:pt idx="3294">
                  <c:v>0.89824540283504384</c:v>
                </c:pt>
                <c:pt idx="3295">
                  <c:v>0.88861468083185358</c:v>
                </c:pt>
                <c:pt idx="3296">
                  <c:v>0.88843410479429374</c:v>
                </c:pt>
                <c:pt idx="3297">
                  <c:v>0.88548469618081682</c:v>
                </c:pt>
                <c:pt idx="3298">
                  <c:v>0.89652993047822549</c:v>
                </c:pt>
                <c:pt idx="3299">
                  <c:v>0.88340807174887892</c:v>
                </c:pt>
                <c:pt idx="3300">
                  <c:v>0.87455984590844793</c:v>
                </c:pt>
                <c:pt idx="3301">
                  <c:v>0.876455894302826</c:v>
                </c:pt>
                <c:pt idx="3302">
                  <c:v>0.88256538357359982</c:v>
                </c:pt>
                <c:pt idx="3303">
                  <c:v>0.88021789508532222</c:v>
                </c:pt>
                <c:pt idx="3304">
                  <c:v>0.87681704637794566</c:v>
                </c:pt>
                <c:pt idx="3305">
                  <c:v>0.8652300839678575</c:v>
                </c:pt>
                <c:pt idx="3306">
                  <c:v>0.90002106720438202</c:v>
                </c:pt>
                <c:pt idx="3307">
                  <c:v>0.87389773377072866</c:v>
                </c:pt>
                <c:pt idx="3308">
                  <c:v>0.88885544888193335</c:v>
                </c:pt>
                <c:pt idx="3309">
                  <c:v>0.88945736900713279</c:v>
                </c:pt>
                <c:pt idx="3310">
                  <c:v>0.86829987660637431</c:v>
                </c:pt>
                <c:pt idx="3311">
                  <c:v>0.88966804105095254</c:v>
                </c:pt>
                <c:pt idx="3312">
                  <c:v>0.88596623228097626</c:v>
                </c:pt>
                <c:pt idx="3313">
                  <c:v>0.87182110933879076</c:v>
                </c:pt>
                <c:pt idx="3314">
                  <c:v>0.87585397417762667</c:v>
                </c:pt>
                <c:pt idx="3315">
                  <c:v>0.88611671231227618</c:v>
                </c:pt>
                <c:pt idx="3316">
                  <c:v>0.88804285671291416</c:v>
                </c:pt>
                <c:pt idx="3317">
                  <c:v>0.87380744575194869</c:v>
                </c:pt>
                <c:pt idx="3318">
                  <c:v>0.88990880910103232</c:v>
                </c:pt>
                <c:pt idx="3319">
                  <c:v>0.88476239203057749</c:v>
                </c:pt>
                <c:pt idx="3320">
                  <c:v>0.88665844042495556</c:v>
                </c:pt>
                <c:pt idx="3321">
                  <c:v>0.87802088662834443</c:v>
                </c:pt>
                <c:pt idx="3322">
                  <c:v>0.88837391278177391</c:v>
                </c:pt>
                <c:pt idx="3323">
                  <c:v>0.89039034520119176</c:v>
                </c:pt>
                <c:pt idx="3324">
                  <c:v>0.89568724230294638</c:v>
                </c:pt>
                <c:pt idx="3325">
                  <c:v>0.87498118999608754</c:v>
                </c:pt>
                <c:pt idx="3326">
                  <c:v>0.87555301411502695</c:v>
                </c:pt>
                <c:pt idx="3327">
                  <c:v>0.89457369007132759</c:v>
                </c:pt>
                <c:pt idx="3328">
                  <c:v>0.88027808709784217</c:v>
                </c:pt>
                <c:pt idx="3329">
                  <c:v>0.88021789508532222</c:v>
                </c:pt>
                <c:pt idx="3330">
                  <c:v>0.88271586360489962</c:v>
                </c:pt>
                <c:pt idx="3331">
                  <c:v>0.87305504559544944</c:v>
                </c:pt>
                <c:pt idx="3332">
                  <c:v>0.8909922653263912</c:v>
                </c:pt>
                <c:pt idx="3333">
                  <c:v>0.87498118999608754</c:v>
                </c:pt>
                <c:pt idx="3334">
                  <c:v>0.87462003792096787</c:v>
                </c:pt>
                <c:pt idx="3335">
                  <c:v>0.90158605952990034</c:v>
                </c:pt>
                <c:pt idx="3336">
                  <c:v>0.88391970385529839</c:v>
                </c:pt>
                <c:pt idx="3337">
                  <c:v>0.88154211936076088</c:v>
                </c:pt>
                <c:pt idx="3338">
                  <c:v>0.88852439281307372</c:v>
                </c:pt>
                <c:pt idx="3339">
                  <c:v>0.88054895115418186</c:v>
                </c:pt>
                <c:pt idx="3340">
                  <c:v>0.8799169350227225</c:v>
                </c:pt>
                <c:pt idx="3341">
                  <c:v>0.88036837511662203</c:v>
                </c:pt>
                <c:pt idx="3342">
                  <c:v>0.86799891654377459</c:v>
                </c:pt>
                <c:pt idx="3343">
                  <c:v>0.88491287206187741</c:v>
                </c:pt>
                <c:pt idx="3344">
                  <c:v>0.89189514551419025</c:v>
                </c:pt>
                <c:pt idx="3345">
                  <c:v>0.8959882023655461</c:v>
                </c:pt>
                <c:pt idx="3346">
                  <c:v>0.89096216932013117</c:v>
                </c:pt>
                <c:pt idx="3347">
                  <c:v>0.88990880910103232</c:v>
                </c:pt>
                <c:pt idx="3348">
                  <c:v>0.88942727300087276</c:v>
                </c:pt>
                <c:pt idx="3349">
                  <c:v>0.89493484214644714</c:v>
                </c:pt>
                <c:pt idx="3350">
                  <c:v>0.88912631293827304</c:v>
                </c:pt>
                <c:pt idx="3351">
                  <c:v>0.87913443885996323</c:v>
                </c:pt>
                <c:pt idx="3352">
                  <c:v>0.89039034520119176</c:v>
                </c:pt>
                <c:pt idx="3353">
                  <c:v>0.88581575224967646</c:v>
                </c:pt>
                <c:pt idx="3354">
                  <c:v>0.87612483823396636</c:v>
                </c:pt>
                <c:pt idx="3355">
                  <c:v>0.86839016462515428</c:v>
                </c:pt>
                <c:pt idx="3356">
                  <c:v>0.88581575224967646</c:v>
                </c:pt>
                <c:pt idx="3357">
                  <c:v>0.88629728834983601</c:v>
                </c:pt>
                <c:pt idx="3358">
                  <c:v>0.88100039124808138</c:v>
                </c:pt>
                <c:pt idx="3359">
                  <c:v>0.89054082523249167</c:v>
                </c:pt>
                <c:pt idx="3360">
                  <c:v>0.87040659704457224</c:v>
                </c:pt>
                <c:pt idx="3361">
                  <c:v>0.88112077527312127</c:v>
                </c:pt>
                <c:pt idx="3362">
                  <c:v>0.87826165467842421</c:v>
                </c:pt>
                <c:pt idx="3363">
                  <c:v>0.89186504950793033</c:v>
                </c:pt>
                <c:pt idx="3364">
                  <c:v>0.88358864778643875</c:v>
                </c:pt>
                <c:pt idx="3365">
                  <c:v>0.87609474222770634</c:v>
                </c:pt>
                <c:pt idx="3366">
                  <c:v>0.87684714238420558</c:v>
                </c:pt>
                <c:pt idx="3367">
                  <c:v>0.89950943509796255</c:v>
                </c:pt>
                <c:pt idx="3368">
                  <c:v>0.87106870918229151</c:v>
                </c:pt>
                <c:pt idx="3369">
                  <c:v>0.89842597887260356</c:v>
                </c:pt>
                <c:pt idx="3370">
                  <c:v>0.88097029524182136</c:v>
                </c:pt>
                <c:pt idx="3371">
                  <c:v>0.88229451951726001</c:v>
                </c:pt>
                <c:pt idx="3372">
                  <c:v>0.8704968850633521</c:v>
                </c:pt>
                <c:pt idx="3373">
                  <c:v>0.88214403948596021</c:v>
                </c:pt>
                <c:pt idx="3374">
                  <c:v>0.89965991512926236</c:v>
                </c:pt>
                <c:pt idx="3375">
                  <c:v>0.88723026454389498</c:v>
                </c:pt>
                <c:pt idx="3376">
                  <c:v>0.89105245733891114</c:v>
                </c:pt>
                <c:pt idx="3377">
                  <c:v>0.87901405483492345</c:v>
                </c:pt>
                <c:pt idx="3378">
                  <c:v>0.90339181990549855</c:v>
                </c:pt>
                <c:pt idx="3379">
                  <c:v>0.88331778373009906</c:v>
                </c:pt>
                <c:pt idx="3380">
                  <c:v>0.8757636861588467</c:v>
                </c:pt>
                <c:pt idx="3381">
                  <c:v>0.87477051795226768</c:v>
                </c:pt>
                <c:pt idx="3382">
                  <c:v>0.87958587895386287</c:v>
                </c:pt>
                <c:pt idx="3383">
                  <c:v>0.88828362476299394</c:v>
                </c:pt>
                <c:pt idx="3384">
                  <c:v>0.88566527221837665</c:v>
                </c:pt>
                <c:pt idx="3385">
                  <c:v>0.88608661630601615</c:v>
                </c:pt>
                <c:pt idx="3386">
                  <c:v>0.87052698106961202</c:v>
                </c:pt>
                <c:pt idx="3387">
                  <c:v>0.86908237276913358</c:v>
                </c:pt>
                <c:pt idx="3388">
                  <c:v>0.87672675835916569</c:v>
                </c:pt>
                <c:pt idx="3389">
                  <c:v>0.88912631293827304</c:v>
                </c:pt>
                <c:pt idx="3390">
                  <c:v>0.8736870617269088</c:v>
                </c:pt>
                <c:pt idx="3391">
                  <c:v>0.88614680831853609</c:v>
                </c:pt>
                <c:pt idx="3392">
                  <c:v>0.87510157402112743</c:v>
                </c:pt>
                <c:pt idx="3393">
                  <c:v>0.87732867848436513</c:v>
                </c:pt>
                <c:pt idx="3394">
                  <c:v>0.89330965780840887</c:v>
                </c:pt>
                <c:pt idx="3395">
                  <c:v>0.87654618232160597</c:v>
                </c:pt>
                <c:pt idx="3396">
                  <c:v>0.89066120925753156</c:v>
                </c:pt>
                <c:pt idx="3397">
                  <c:v>0.87176091732627081</c:v>
                </c:pt>
                <c:pt idx="3398">
                  <c:v>0.89866674692268333</c:v>
                </c:pt>
                <c:pt idx="3399">
                  <c:v>0.87537243807746712</c:v>
                </c:pt>
                <c:pt idx="3400">
                  <c:v>0.87236283745147014</c:v>
                </c:pt>
                <c:pt idx="3401">
                  <c:v>0.86998525295693263</c:v>
                </c:pt>
                <c:pt idx="3402">
                  <c:v>0.8858759442621964</c:v>
                </c:pt>
                <c:pt idx="3403">
                  <c:v>0.87970626297890275</c:v>
                </c:pt>
                <c:pt idx="3404">
                  <c:v>0.89707165859090499</c:v>
                </c:pt>
                <c:pt idx="3405">
                  <c:v>0.87245312547025011</c:v>
                </c:pt>
                <c:pt idx="3406">
                  <c:v>0.87531224606494717</c:v>
                </c:pt>
                <c:pt idx="3407">
                  <c:v>0.86754747644987507</c:v>
                </c:pt>
                <c:pt idx="3408">
                  <c:v>0.88250519156107987</c:v>
                </c:pt>
                <c:pt idx="3409">
                  <c:v>0.88205375146718035</c:v>
                </c:pt>
                <c:pt idx="3410">
                  <c:v>0.88142173533572099</c:v>
                </c:pt>
                <c:pt idx="3411">
                  <c:v>0.88003731904776239</c:v>
                </c:pt>
                <c:pt idx="3412">
                  <c:v>0.8875312246064947</c:v>
                </c:pt>
                <c:pt idx="3413">
                  <c:v>0.87582387817136664</c:v>
                </c:pt>
                <c:pt idx="3414">
                  <c:v>0.89668041050952541</c:v>
                </c:pt>
                <c:pt idx="3415">
                  <c:v>0.87925482288500312</c:v>
                </c:pt>
                <c:pt idx="3416">
                  <c:v>0.86986486893189274</c:v>
                </c:pt>
                <c:pt idx="3417">
                  <c:v>0.87603455021518639</c:v>
                </c:pt>
                <c:pt idx="3418">
                  <c:v>0.87850242272850387</c:v>
                </c:pt>
                <c:pt idx="3419">
                  <c:v>0.88647786438739584</c:v>
                </c:pt>
                <c:pt idx="3420">
                  <c:v>0.87182110933879076</c:v>
                </c:pt>
                <c:pt idx="3421">
                  <c:v>0.86763776446865504</c:v>
                </c:pt>
                <c:pt idx="3422">
                  <c:v>0.87952568694134292</c:v>
                </c:pt>
                <c:pt idx="3423">
                  <c:v>0.87663647034038583</c:v>
                </c:pt>
                <c:pt idx="3424">
                  <c:v>0.87281427754536978</c:v>
                </c:pt>
                <c:pt idx="3425">
                  <c:v>0.86673488428085588</c:v>
                </c:pt>
                <c:pt idx="3426">
                  <c:v>0.88491287206187741</c:v>
                </c:pt>
                <c:pt idx="3427">
                  <c:v>0.87471032593974785</c:v>
                </c:pt>
                <c:pt idx="3428">
                  <c:v>0.8896078490384326</c:v>
                </c:pt>
                <c:pt idx="3429">
                  <c:v>0.88461191199927769</c:v>
                </c:pt>
                <c:pt idx="3430">
                  <c:v>0.88605652029975623</c:v>
                </c:pt>
                <c:pt idx="3431">
                  <c:v>0.86832997261263434</c:v>
                </c:pt>
                <c:pt idx="3432">
                  <c:v>0.87353658169560899</c:v>
                </c:pt>
                <c:pt idx="3433">
                  <c:v>0.88464200800553772</c:v>
                </c:pt>
                <c:pt idx="3434">
                  <c:v>0.88385951184277844</c:v>
                </c:pt>
                <c:pt idx="3435">
                  <c:v>0.87389773377072866</c:v>
                </c:pt>
                <c:pt idx="3436">
                  <c:v>0.88963794504469262</c:v>
                </c:pt>
                <c:pt idx="3437">
                  <c:v>0.88033827911036211</c:v>
                </c:pt>
                <c:pt idx="3438">
                  <c:v>0.87624522225900625</c:v>
                </c:pt>
                <c:pt idx="3439">
                  <c:v>0.86640382821199624</c:v>
                </c:pt>
                <c:pt idx="3440">
                  <c:v>0.87296475757666958</c:v>
                </c:pt>
                <c:pt idx="3441">
                  <c:v>0.86023414692870259</c:v>
                </c:pt>
                <c:pt idx="3442">
                  <c:v>0.87004544496945257</c:v>
                </c:pt>
                <c:pt idx="3443">
                  <c:v>0.88307701568001928</c:v>
                </c:pt>
                <c:pt idx="3444">
                  <c:v>0.86971438890059294</c:v>
                </c:pt>
                <c:pt idx="3445">
                  <c:v>0.87591416619014661</c:v>
                </c:pt>
                <c:pt idx="3446">
                  <c:v>0.887260360550155</c:v>
                </c:pt>
                <c:pt idx="3447">
                  <c:v>0.87750925452192496</c:v>
                </c:pt>
                <c:pt idx="3448">
                  <c:v>0.88918650495079299</c:v>
                </c:pt>
                <c:pt idx="3449">
                  <c:v>0.88054895115418186</c:v>
                </c:pt>
                <c:pt idx="3450">
                  <c:v>0.88542450416829688</c:v>
                </c:pt>
                <c:pt idx="3451">
                  <c:v>0.87892376681614348</c:v>
                </c:pt>
                <c:pt idx="3452">
                  <c:v>0.88644776838113581</c:v>
                </c:pt>
                <c:pt idx="3453">
                  <c:v>0.8904505372137117</c:v>
                </c:pt>
                <c:pt idx="3454">
                  <c:v>0.86757757245613509</c:v>
                </c:pt>
                <c:pt idx="3455">
                  <c:v>0.87531224606494717</c:v>
                </c:pt>
                <c:pt idx="3456">
                  <c:v>0.87052698106961202</c:v>
                </c:pt>
                <c:pt idx="3457">
                  <c:v>0.87455984590844793</c:v>
                </c:pt>
                <c:pt idx="3458">
                  <c:v>0.85683329822132603</c:v>
                </c:pt>
                <c:pt idx="3459">
                  <c:v>0.86143798717910136</c:v>
                </c:pt>
                <c:pt idx="3460">
                  <c:v>0.87452974990218801</c:v>
                </c:pt>
                <c:pt idx="3461">
                  <c:v>0.86799891654377459</c:v>
                </c:pt>
                <c:pt idx="3462">
                  <c:v>0.87215216540765039</c:v>
                </c:pt>
                <c:pt idx="3463">
                  <c:v>0.87910434285370331</c:v>
                </c:pt>
                <c:pt idx="3464">
                  <c:v>0.8704968850633521</c:v>
                </c:pt>
                <c:pt idx="3465">
                  <c:v>0.87067746110091193</c:v>
                </c:pt>
                <c:pt idx="3466">
                  <c:v>0.85698377825262584</c:v>
                </c:pt>
                <c:pt idx="3467">
                  <c:v>0.86237096337316033</c:v>
                </c:pt>
                <c:pt idx="3468">
                  <c:v>0.87531224606494717</c:v>
                </c:pt>
                <c:pt idx="3469">
                  <c:v>0.86836006861889425</c:v>
                </c:pt>
                <c:pt idx="3470">
                  <c:v>0.86387576368615882</c:v>
                </c:pt>
                <c:pt idx="3471">
                  <c:v>0.87410840581454841</c:v>
                </c:pt>
                <c:pt idx="3472">
                  <c:v>0.87052698106961202</c:v>
                </c:pt>
                <c:pt idx="3473">
                  <c:v>0.86977458091311288</c:v>
                </c:pt>
                <c:pt idx="3474">
                  <c:v>0.87046678905709207</c:v>
                </c:pt>
                <c:pt idx="3475">
                  <c:v>0.87720829445932524</c:v>
                </c:pt>
                <c:pt idx="3476">
                  <c:v>0.88355855178017872</c:v>
                </c:pt>
                <c:pt idx="3477">
                  <c:v>0.87961597496012278</c:v>
                </c:pt>
                <c:pt idx="3478">
                  <c:v>0.88057904716044177</c:v>
                </c:pt>
                <c:pt idx="3479">
                  <c:v>0.88154211936076088</c:v>
                </c:pt>
                <c:pt idx="3480">
                  <c:v>0.88036837511662203</c:v>
                </c:pt>
                <c:pt idx="3481">
                  <c:v>0.87726848647184519</c:v>
                </c:pt>
                <c:pt idx="3482">
                  <c:v>0.87242302946399009</c:v>
                </c:pt>
                <c:pt idx="3483">
                  <c:v>0.88277605561741956</c:v>
                </c:pt>
                <c:pt idx="3484">
                  <c:v>0.8603846269600024</c:v>
                </c:pt>
                <c:pt idx="3485">
                  <c:v>0.85677310620880609</c:v>
                </c:pt>
                <c:pt idx="3486">
                  <c:v>0.86351461161103926</c:v>
                </c:pt>
                <c:pt idx="3487">
                  <c:v>0.86944352484425313</c:v>
                </c:pt>
                <c:pt idx="3488">
                  <c:v>0.87245312547025011</c:v>
                </c:pt>
                <c:pt idx="3489">
                  <c:v>0.86971438890059294</c:v>
                </c:pt>
                <c:pt idx="3490">
                  <c:v>0.8746501339272279</c:v>
                </c:pt>
                <c:pt idx="3491">
                  <c:v>0.86854064465645409</c:v>
                </c:pt>
                <c:pt idx="3492">
                  <c:v>0.86125741114154153</c:v>
                </c:pt>
                <c:pt idx="3493">
                  <c:v>0.87419869383332827</c:v>
                </c:pt>
                <c:pt idx="3494">
                  <c:v>0.87916453486622326</c:v>
                </c:pt>
                <c:pt idx="3495">
                  <c:v>0.86808920456255456</c:v>
                </c:pt>
                <c:pt idx="3496">
                  <c:v>0.86477864387395798</c:v>
                </c:pt>
                <c:pt idx="3497">
                  <c:v>0.8771481024468053</c:v>
                </c:pt>
                <c:pt idx="3498">
                  <c:v>0.86372528365485901</c:v>
                </c:pt>
                <c:pt idx="3499">
                  <c:v>0.8638456676798989</c:v>
                </c:pt>
                <c:pt idx="3500">
                  <c:v>0.87431907785836815</c:v>
                </c:pt>
                <c:pt idx="3501">
                  <c:v>0.87958587895386287</c:v>
                </c:pt>
                <c:pt idx="3502">
                  <c:v>0.87844223071598404</c:v>
                </c:pt>
                <c:pt idx="3503">
                  <c:v>0.85027236885665269</c:v>
                </c:pt>
                <c:pt idx="3504">
                  <c:v>0.86577181208053688</c:v>
                </c:pt>
                <c:pt idx="3505">
                  <c:v>0.87753935052818488</c:v>
                </c:pt>
                <c:pt idx="3506">
                  <c:v>0.876455894302826</c:v>
                </c:pt>
                <c:pt idx="3507">
                  <c:v>0.87462003792096787</c:v>
                </c:pt>
                <c:pt idx="3508">
                  <c:v>0.87200168537635059</c:v>
                </c:pt>
                <c:pt idx="3509">
                  <c:v>0.88036837511662203</c:v>
                </c:pt>
                <c:pt idx="3510">
                  <c:v>0.88006741505402231</c:v>
                </c:pt>
                <c:pt idx="3511">
                  <c:v>0.86760766846239501</c:v>
                </c:pt>
                <c:pt idx="3512">
                  <c:v>0.87158034128871098</c:v>
                </c:pt>
                <c:pt idx="3513">
                  <c:v>0.85698377825262584</c:v>
                </c:pt>
                <c:pt idx="3514">
                  <c:v>0.86516989195533756</c:v>
                </c:pt>
                <c:pt idx="3515">
                  <c:v>0.8792247268787432</c:v>
                </c:pt>
                <c:pt idx="3516">
                  <c:v>0.88100039124808138</c:v>
                </c:pt>
                <c:pt idx="3517">
                  <c:v>0.87498118999608754</c:v>
                </c:pt>
                <c:pt idx="3518">
                  <c:v>0.88614680831853609</c:v>
                </c:pt>
                <c:pt idx="3519">
                  <c:v>0.87272398952658981</c:v>
                </c:pt>
                <c:pt idx="3520">
                  <c:v>0.88148192734824093</c:v>
                </c:pt>
                <c:pt idx="3521">
                  <c:v>0.8594215547596834</c:v>
                </c:pt>
                <c:pt idx="3522">
                  <c:v>0.87573359015258678</c:v>
                </c:pt>
                <c:pt idx="3523">
                  <c:v>0.88151202335450085</c:v>
                </c:pt>
                <c:pt idx="3524">
                  <c:v>0.87167062930749084</c:v>
                </c:pt>
                <c:pt idx="3525">
                  <c:v>0.87257350949529</c:v>
                </c:pt>
                <c:pt idx="3526">
                  <c:v>0.86748728443735512</c:v>
                </c:pt>
                <c:pt idx="3527">
                  <c:v>0.8601137629036627</c:v>
                </c:pt>
                <c:pt idx="3528">
                  <c:v>0.8706473650946519</c:v>
                </c:pt>
                <c:pt idx="3529">
                  <c:v>0.86065549101634209</c:v>
                </c:pt>
                <c:pt idx="3530">
                  <c:v>0.8580371384717248</c:v>
                </c:pt>
                <c:pt idx="3531">
                  <c:v>0.8723026454389502</c:v>
                </c:pt>
                <c:pt idx="3532">
                  <c:v>0.883377975742619</c:v>
                </c:pt>
                <c:pt idx="3533">
                  <c:v>0.87142986125741118</c:v>
                </c:pt>
                <c:pt idx="3534">
                  <c:v>0.85945165076594332</c:v>
                </c:pt>
                <c:pt idx="3535">
                  <c:v>0.87263370150780994</c:v>
                </c:pt>
                <c:pt idx="3536">
                  <c:v>0.88512354410569716</c:v>
                </c:pt>
                <c:pt idx="3537">
                  <c:v>0.86056520299756223</c:v>
                </c:pt>
                <c:pt idx="3538">
                  <c:v>0.87431907785836815</c:v>
                </c:pt>
                <c:pt idx="3539">
                  <c:v>0.86965419688807299</c:v>
                </c:pt>
                <c:pt idx="3540">
                  <c:v>0.88647786438739584</c:v>
                </c:pt>
                <c:pt idx="3541">
                  <c:v>0.87702771842176541</c:v>
                </c:pt>
                <c:pt idx="3542">
                  <c:v>0.87058717308213196</c:v>
                </c:pt>
                <c:pt idx="3543">
                  <c:v>0.86444758780509823</c:v>
                </c:pt>
                <c:pt idx="3544">
                  <c:v>0.87239293345773017</c:v>
                </c:pt>
                <c:pt idx="3545">
                  <c:v>0.87007554097571249</c:v>
                </c:pt>
                <c:pt idx="3546">
                  <c:v>0.8763054142715262</c:v>
                </c:pt>
                <c:pt idx="3547">
                  <c:v>0.86595238811809672</c:v>
                </c:pt>
                <c:pt idx="3548">
                  <c:v>0.88148192734824093</c:v>
                </c:pt>
                <c:pt idx="3549">
                  <c:v>0.8692629488066933</c:v>
                </c:pt>
                <c:pt idx="3550">
                  <c:v>0.88382941583651853</c:v>
                </c:pt>
                <c:pt idx="3551">
                  <c:v>0.8711890932073314</c:v>
                </c:pt>
                <c:pt idx="3552">
                  <c:v>0.87425888584584821</c:v>
                </c:pt>
                <c:pt idx="3553">
                  <c:v>0.88081981521052155</c:v>
                </c:pt>
                <c:pt idx="3554">
                  <c:v>0.87859271074728384</c:v>
                </c:pt>
                <c:pt idx="3555">
                  <c:v>0.88247509555481984</c:v>
                </c:pt>
                <c:pt idx="3556">
                  <c:v>0.8810304872543413</c:v>
                </c:pt>
                <c:pt idx="3557">
                  <c:v>0.87636560628404614</c:v>
                </c:pt>
                <c:pt idx="3558">
                  <c:v>0.86252144340446024</c:v>
                </c:pt>
                <c:pt idx="3559">
                  <c:v>0.87552291810876692</c:v>
                </c:pt>
                <c:pt idx="3560">
                  <c:v>0.86188942727300089</c:v>
                </c:pt>
                <c:pt idx="3561">
                  <c:v>0.87717819845306533</c:v>
                </c:pt>
                <c:pt idx="3562">
                  <c:v>0.85909049869082377</c:v>
                </c:pt>
                <c:pt idx="3563">
                  <c:v>0.87100851716977157</c:v>
                </c:pt>
                <c:pt idx="3564">
                  <c:v>0.87672675835916569</c:v>
                </c:pt>
                <c:pt idx="3565">
                  <c:v>0.8663436361994763</c:v>
                </c:pt>
                <c:pt idx="3566">
                  <c:v>0.8806091431667018</c:v>
                </c:pt>
                <c:pt idx="3567">
                  <c:v>0.8558100340084871</c:v>
                </c:pt>
                <c:pt idx="3568">
                  <c:v>0.86760766846239501</c:v>
                </c:pt>
                <c:pt idx="3569">
                  <c:v>0.86369518764859898</c:v>
                </c:pt>
                <c:pt idx="3570">
                  <c:v>0.87663647034038583</c:v>
                </c:pt>
                <c:pt idx="3571">
                  <c:v>0.8677280524874349</c:v>
                </c:pt>
                <c:pt idx="3572">
                  <c:v>0.87155024528245106</c:v>
                </c:pt>
                <c:pt idx="3573">
                  <c:v>0.8699551569506726</c:v>
                </c:pt>
                <c:pt idx="3574">
                  <c:v>0.87549282210250701</c:v>
                </c:pt>
                <c:pt idx="3575">
                  <c:v>0.88051885514792183</c:v>
                </c:pt>
                <c:pt idx="3576">
                  <c:v>0.8691124687753935</c:v>
                </c:pt>
                <c:pt idx="3577">
                  <c:v>0.87811117464712429</c:v>
                </c:pt>
                <c:pt idx="3578">
                  <c:v>0.87046678905709207</c:v>
                </c:pt>
                <c:pt idx="3579">
                  <c:v>0.87158034128871098</c:v>
                </c:pt>
                <c:pt idx="3580">
                  <c:v>0.86207000331056072</c:v>
                </c:pt>
                <c:pt idx="3581">
                  <c:v>0.88298672766123931</c:v>
                </c:pt>
                <c:pt idx="3582">
                  <c:v>0.87955578294760284</c:v>
                </c:pt>
                <c:pt idx="3583">
                  <c:v>0.8583080025280645</c:v>
                </c:pt>
                <c:pt idx="3584">
                  <c:v>0.86757757245613509</c:v>
                </c:pt>
                <c:pt idx="3585">
                  <c:v>0.8638456676798989</c:v>
                </c:pt>
                <c:pt idx="3586">
                  <c:v>0.87449965389592799</c:v>
                </c:pt>
                <c:pt idx="3587">
                  <c:v>0.86441749179883831</c:v>
                </c:pt>
                <c:pt idx="3588">
                  <c:v>0.87329581364552922</c:v>
                </c:pt>
                <c:pt idx="3589">
                  <c:v>0.8580371384717248</c:v>
                </c:pt>
                <c:pt idx="3590">
                  <c:v>0.8723026454389502</c:v>
                </c:pt>
                <c:pt idx="3591">
                  <c:v>0.85815752249676469</c:v>
                </c:pt>
                <c:pt idx="3592">
                  <c:v>0.87446955788966807</c:v>
                </c:pt>
                <c:pt idx="3593">
                  <c:v>0.87561320612754689</c:v>
                </c:pt>
                <c:pt idx="3594">
                  <c:v>0.86450777981761817</c:v>
                </c:pt>
                <c:pt idx="3595">
                  <c:v>0.85954193878472329</c:v>
                </c:pt>
                <c:pt idx="3596">
                  <c:v>0.87004544496945257</c:v>
                </c:pt>
                <c:pt idx="3597">
                  <c:v>0.86929304481295333</c:v>
                </c:pt>
                <c:pt idx="3598">
                  <c:v>0.89300869774580915</c:v>
                </c:pt>
                <c:pt idx="3599">
                  <c:v>0.87091822915099171</c:v>
                </c:pt>
                <c:pt idx="3600">
                  <c:v>0.87832184669094415</c:v>
                </c:pt>
                <c:pt idx="3601">
                  <c:v>0.87588407018388659</c:v>
                </c:pt>
                <c:pt idx="3602">
                  <c:v>0.87627531826526617</c:v>
                </c:pt>
                <c:pt idx="3603">
                  <c:v>0.8810304872543413</c:v>
                </c:pt>
                <c:pt idx="3604">
                  <c:v>0.89105245733891114</c:v>
                </c:pt>
                <c:pt idx="3605">
                  <c:v>0.88473229602431758</c:v>
                </c:pt>
                <c:pt idx="3606">
                  <c:v>0.87019592500075238</c:v>
                </c:pt>
                <c:pt idx="3607">
                  <c:v>0.87269389352032989</c:v>
                </c:pt>
                <c:pt idx="3608">
                  <c:v>0.87076774911969179</c:v>
                </c:pt>
                <c:pt idx="3609">
                  <c:v>0.89324946579588893</c:v>
                </c:pt>
                <c:pt idx="3610">
                  <c:v>0.89153399343907058</c:v>
                </c:pt>
                <c:pt idx="3611">
                  <c:v>0.88638757636861587</c:v>
                </c:pt>
                <c:pt idx="3612">
                  <c:v>0.88063923917296172</c:v>
                </c:pt>
                <c:pt idx="3613">
                  <c:v>0.87458994191470796</c:v>
                </c:pt>
                <c:pt idx="3614">
                  <c:v>0.88027808709784217</c:v>
                </c:pt>
                <c:pt idx="3615">
                  <c:v>0.87001534896319255</c:v>
                </c:pt>
                <c:pt idx="3616">
                  <c:v>0.86077587504138198</c:v>
                </c:pt>
                <c:pt idx="3617">
                  <c:v>0.87642579829656608</c:v>
                </c:pt>
                <c:pt idx="3618">
                  <c:v>0.87711800644054538</c:v>
                </c:pt>
                <c:pt idx="3619">
                  <c:v>0.88978842507599243</c:v>
                </c:pt>
                <c:pt idx="3620">
                  <c:v>0.88211394347970029</c:v>
                </c:pt>
                <c:pt idx="3621">
                  <c:v>0.88229451951726001</c:v>
                </c:pt>
                <c:pt idx="3622">
                  <c:v>0.87329581364552922</c:v>
                </c:pt>
                <c:pt idx="3623">
                  <c:v>0.87085803713847176</c:v>
                </c:pt>
                <c:pt idx="3624">
                  <c:v>0.88680892045625548</c:v>
                </c:pt>
                <c:pt idx="3625">
                  <c:v>0.86474854786769795</c:v>
                </c:pt>
                <c:pt idx="3626">
                  <c:v>0.87684714238420558</c:v>
                </c:pt>
                <c:pt idx="3627">
                  <c:v>0.8865681524061757</c:v>
                </c:pt>
                <c:pt idx="3628">
                  <c:v>0.86902218075661364</c:v>
                </c:pt>
                <c:pt idx="3629">
                  <c:v>0.87519186203990729</c:v>
                </c:pt>
                <c:pt idx="3630">
                  <c:v>0.87805098263460435</c:v>
                </c:pt>
                <c:pt idx="3631">
                  <c:v>0.87350648568934908</c:v>
                </c:pt>
                <c:pt idx="3632">
                  <c:v>0.86986486893189274</c:v>
                </c:pt>
                <c:pt idx="3633">
                  <c:v>0.88385951184277844</c:v>
                </c:pt>
                <c:pt idx="3634">
                  <c:v>0.88009751106028233</c:v>
                </c:pt>
                <c:pt idx="3635">
                  <c:v>0.87982664700394253</c:v>
                </c:pt>
                <c:pt idx="3636">
                  <c:v>0.89854636289764345</c:v>
                </c:pt>
                <c:pt idx="3637">
                  <c:v>0.89965991512926236</c:v>
                </c:pt>
                <c:pt idx="3638">
                  <c:v>0.91314292593372859</c:v>
                </c:pt>
                <c:pt idx="3639">
                  <c:v>0.91654377464110515</c:v>
                </c:pt>
                <c:pt idx="3640">
                  <c:v>0.91609233454720562</c:v>
                </c:pt>
                <c:pt idx="3641">
                  <c:v>0.93336744214042799</c:v>
                </c:pt>
                <c:pt idx="3642">
                  <c:v>0.92927438528907214</c:v>
                </c:pt>
                <c:pt idx="3643">
                  <c:v>0.92608420862551544</c:v>
                </c:pt>
                <c:pt idx="3644">
                  <c:v>0.94381075631263733</c:v>
                </c:pt>
                <c:pt idx="3645">
                  <c:v>0.94814458121407286</c:v>
                </c:pt>
                <c:pt idx="3646">
                  <c:v>0.94092153971168024</c:v>
                </c:pt>
                <c:pt idx="3647">
                  <c:v>0.96439642459445629</c:v>
                </c:pt>
                <c:pt idx="3648">
                  <c:v>0.97444849068528605</c:v>
                </c:pt>
                <c:pt idx="3649">
                  <c:v>0.97207090619074854</c:v>
                </c:pt>
                <c:pt idx="3650">
                  <c:v>0.96978360971499078</c:v>
                </c:pt>
                <c:pt idx="3651">
                  <c:v>0.98085894001865948</c:v>
                </c:pt>
                <c:pt idx="3652">
                  <c:v>0.97649501911096392</c:v>
                </c:pt>
                <c:pt idx="3653">
                  <c:v>0.97288349835976762</c:v>
                </c:pt>
                <c:pt idx="3654">
                  <c:v>0.97059620188400997</c:v>
                </c:pt>
                <c:pt idx="3655">
                  <c:v>0.96755650525175307</c:v>
                </c:pt>
                <c:pt idx="3656">
                  <c:v>0.96647304902639419</c:v>
                </c:pt>
                <c:pt idx="3657">
                  <c:v>0.96081499984952001</c:v>
                </c:pt>
                <c:pt idx="3658">
                  <c:v>0.96629247298883436</c:v>
                </c:pt>
                <c:pt idx="3659">
                  <c:v>0.97980557979956062</c:v>
                </c:pt>
                <c:pt idx="3660">
                  <c:v>0.97842116351160202</c:v>
                </c:pt>
                <c:pt idx="3661">
                  <c:v>0.9807385559936197</c:v>
                </c:pt>
                <c:pt idx="3662">
                  <c:v>0.98763054142715256</c:v>
                </c:pt>
                <c:pt idx="3663">
                  <c:v>0.97977548379330059</c:v>
                </c:pt>
                <c:pt idx="3664">
                  <c:v>0.98835284557739189</c:v>
                </c:pt>
                <c:pt idx="3665">
                  <c:v>0.99085081409696929</c:v>
                </c:pt>
                <c:pt idx="3666">
                  <c:v>0.97787943539892253</c:v>
                </c:pt>
                <c:pt idx="3667">
                  <c:v>0.98389863665091637</c:v>
                </c:pt>
                <c:pt idx="3668">
                  <c:v>1.0035212327324163</c:v>
                </c:pt>
                <c:pt idx="3669">
                  <c:v>0.99554579107352459</c:v>
                </c:pt>
                <c:pt idx="3670">
                  <c:v>1.0078851536401119</c:v>
                </c:pt>
                <c:pt idx="3671">
                  <c:v>0.98043759593101998</c:v>
                </c:pt>
                <c:pt idx="3672">
                  <c:v>0.98561410900773472</c:v>
                </c:pt>
                <c:pt idx="3673">
                  <c:v>0.99392060673548621</c:v>
                </c:pt>
                <c:pt idx="3674">
                  <c:v>0.99217503837240795</c:v>
                </c:pt>
                <c:pt idx="3675">
                  <c:v>0.9907304300719294</c:v>
                </c:pt>
                <c:pt idx="3676">
                  <c:v>0.9933487826165468</c:v>
                </c:pt>
                <c:pt idx="3677">
                  <c:v>1.0002407680500798</c:v>
                </c:pt>
                <c:pt idx="3678">
                  <c:v>0.98332681253197696</c:v>
                </c:pt>
                <c:pt idx="3679">
                  <c:v>0.99298763054142714</c:v>
                </c:pt>
                <c:pt idx="3680">
                  <c:v>0.99067023805940957</c:v>
                </c:pt>
                <c:pt idx="3681">
                  <c:v>0.97799981942396241</c:v>
                </c:pt>
                <c:pt idx="3682">
                  <c:v>0.97772895536762272</c:v>
                </c:pt>
                <c:pt idx="3683">
                  <c:v>0.97697655521112348</c:v>
                </c:pt>
                <c:pt idx="3684">
                  <c:v>0.97676588316730373</c:v>
                </c:pt>
                <c:pt idx="3685">
                  <c:v>0.97956481174948085</c:v>
                </c:pt>
                <c:pt idx="3686">
                  <c:v>0.989195533752671</c:v>
                </c:pt>
                <c:pt idx="3687">
                  <c:v>0.98052788394979984</c:v>
                </c:pt>
                <c:pt idx="3688">
                  <c:v>0.98453065278237573</c:v>
                </c:pt>
                <c:pt idx="3689">
                  <c:v>1.0024678725133176</c:v>
                </c:pt>
                <c:pt idx="3690">
                  <c:v>0.99045956601558971</c:v>
                </c:pt>
                <c:pt idx="3691">
                  <c:v>0.98504228488879531</c:v>
                </c:pt>
                <c:pt idx="3692">
                  <c:v>0.99512444698588498</c:v>
                </c:pt>
                <c:pt idx="3693">
                  <c:v>1.0054172811267945</c:v>
                </c:pt>
                <c:pt idx="3694">
                  <c:v>0.98591506907033433</c:v>
                </c:pt>
                <c:pt idx="3695">
                  <c:v>0.98489180485749539</c:v>
                </c:pt>
                <c:pt idx="3696">
                  <c:v>1.0039425768200561</c:v>
                </c:pt>
                <c:pt idx="3697">
                  <c:v>0.99735155144912269</c:v>
                </c:pt>
                <c:pt idx="3698">
                  <c:v>0.98805188551479217</c:v>
                </c:pt>
                <c:pt idx="3699">
                  <c:v>0.99250609444126769</c:v>
                </c:pt>
                <c:pt idx="3700">
                  <c:v>0.99795347157432213</c:v>
                </c:pt>
                <c:pt idx="3701">
                  <c:v>1.0111054263099286</c:v>
                </c:pt>
                <c:pt idx="3702">
                  <c:v>0.98982754988413035</c:v>
                </c:pt>
                <c:pt idx="3703">
                  <c:v>0.98055797995605987</c:v>
                </c:pt>
                <c:pt idx="3704">
                  <c:v>0.99437204682938574</c:v>
                </c:pt>
                <c:pt idx="3705">
                  <c:v>0.98859361362747167</c:v>
                </c:pt>
                <c:pt idx="3706">
                  <c:v>0.99581665512986428</c:v>
                </c:pt>
                <c:pt idx="3707">
                  <c:v>0.98817226953983206</c:v>
                </c:pt>
                <c:pt idx="3708">
                  <c:v>0.97694645920486356</c:v>
                </c:pt>
                <c:pt idx="3709">
                  <c:v>0.98543353297017489</c:v>
                </c:pt>
                <c:pt idx="3710">
                  <c:v>0.96824871339573237</c:v>
                </c:pt>
                <c:pt idx="3711">
                  <c:v>0.99175369428476845</c:v>
                </c:pt>
                <c:pt idx="3712">
                  <c:v>0.98582478105155447</c:v>
                </c:pt>
                <c:pt idx="3713">
                  <c:v>0.98714900532699312</c:v>
                </c:pt>
                <c:pt idx="3714">
                  <c:v>0.97941433171818104</c:v>
                </c:pt>
                <c:pt idx="3715">
                  <c:v>0.98106961206247933</c:v>
                </c:pt>
                <c:pt idx="3716">
                  <c:v>0.98287537243807743</c:v>
                </c:pt>
                <c:pt idx="3717">
                  <c:v>0.97297378637854759</c:v>
                </c:pt>
                <c:pt idx="3718">
                  <c:v>0.97489993077918558</c:v>
                </c:pt>
                <c:pt idx="3719">
                  <c:v>0.97622415505462423</c:v>
                </c:pt>
                <c:pt idx="3720">
                  <c:v>0.98444036476359587</c:v>
                </c:pt>
                <c:pt idx="3721">
                  <c:v>0.98194239624401847</c:v>
                </c:pt>
                <c:pt idx="3722">
                  <c:v>0.97432810666024616</c:v>
                </c:pt>
                <c:pt idx="3723">
                  <c:v>0.97965509976826071</c:v>
                </c:pt>
                <c:pt idx="3724">
                  <c:v>0.98173172420019861</c:v>
                </c:pt>
                <c:pt idx="3725">
                  <c:v>0.96728564119541338</c:v>
                </c:pt>
                <c:pt idx="3726">
                  <c:v>0.9770066512173835</c:v>
                </c:pt>
                <c:pt idx="3727">
                  <c:v>0.9760435790170644</c:v>
                </c:pt>
                <c:pt idx="3728">
                  <c:v>0.95891895145514194</c:v>
                </c:pt>
                <c:pt idx="3729">
                  <c:v>0.96698468113281366</c:v>
                </c:pt>
                <c:pt idx="3730">
                  <c:v>0.95825683931742256</c:v>
                </c:pt>
                <c:pt idx="3731">
                  <c:v>0.97496012279170552</c:v>
                </c:pt>
                <c:pt idx="3732">
                  <c:v>0.96770698528305299</c:v>
                </c:pt>
                <c:pt idx="3733">
                  <c:v>0.9699340897462907</c:v>
                </c:pt>
                <c:pt idx="3734">
                  <c:v>0.97962500376200079</c:v>
                </c:pt>
                <c:pt idx="3735">
                  <c:v>0.97643482709844409</c:v>
                </c:pt>
                <c:pt idx="3736">
                  <c:v>0.98585487705781438</c:v>
                </c:pt>
                <c:pt idx="3737">
                  <c:v>0.96900111355223162</c:v>
                </c:pt>
                <c:pt idx="3738">
                  <c:v>0.94555632467571549</c:v>
                </c:pt>
                <c:pt idx="3739">
                  <c:v>0.97071658590904986</c:v>
                </c:pt>
                <c:pt idx="3740">
                  <c:v>0.96698468113281366</c:v>
                </c:pt>
                <c:pt idx="3741">
                  <c:v>0.95112408583380981</c:v>
                </c:pt>
                <c:pt idx="3742">
                  <c:v>0.97526108285430524</c:v>
                </c:pt>
                <c:pt idx="3743">
                  <c:v>0.97580281096698473</c:v>
                </c:pt>
                <c:pt idx="3744">
                  <c:v>0.96120624793089959</c:v>
                </c:pt>
                <c:pt idx="3745">
                  <c:v>0.96156740000601915</c:v>
                </c:pt>
                <c:pt idx="3746">
                  <c:v>0.97586300297950457</c:v>
                </c:pt>
                <c:pt idx="3747">
                  <c:v>0.9699340897462907</c:v>
                </c:pt>
                <c:pt idx="3748">
                  <c:v>0.96882053751467179</c:v>
                </c:pt>
                <c:pt idx="3749">
                  <c:v>0.97682607517982367</c:v>
                </c:pt>
                <c:pt idx="3750">
                  <c:v>0.96581093688867492</c:v>
                </c:pt>
                <c:pt idx="3751">
                  <c:v>0.93995846751136125</c:v>
                </c:pt>
                <c:pt idx="3752">
                  <c:v>0.95461522255996634</c:v>
                </c:pt>
                <c:pt idx="3753">
                  <c:v>0.97222138622204834</c:v>
                </c:pt>
                <c:pt idx="3754">
                  <c:v>0.96168778403105903</c:v>
                </c:pt>
                <c:pt idx="3755">
                  <c:v>0.96903120955849154</c:v>
                </c:pt>
                <c:pt idx="3756">
                  <c:v>0.96192855208113881</c:v>
                </c:pt>
                <c:pt idx="3757">
                  <c:v>0.95253859812802844</c:v>
                </c:pt>
                <c:pt idx="3758">
                  <c:v>0.96854967345833209</c:v>
                </c:pt>
                <c:pt idx="3759">
                  <c:v>0.95578896680410508</c:v>
                </c:pt>
                <c:pt idx="3760">
                  <c:v>0.96075480783700007</c:v>
                </c:pt>
                <c:pt idx="3761">
                  <c:v>0.96785746531435279</c:v>
                </c:pt>
                <c:pt idx="3762">
                  <c:v>0.95317061425948779</c:v>
                </c:pt>
                <c:pt idx="3763">
                  <c:v>0.9603936557618804</c:v>
                </c:pt>
                <c:pt idx="3764">
                  <c:v>0.94366027628133742</c:v>
                </c:pt>
                <c:pt idx="3765">
                  <c:v>0.95542781472898541</c:v>
                </c:pt>
                <c:pt idx="3766">
                  <c:v>0.96090528786829987</c:v>
                </c:pt>
                <c:pt idx="3767">
                  <c:v>0.96469738465705601</c:v>
                </c:pt>
                <c:pt idx="3768">
                  <c:v>0.95602973485418485</c:v>
                </c:pt>
                <c:pt idx="3769">
                  <c:v>0.94865621332049233</c:v>
                </c:pt>
                <c:pt idx="3770">
                  <c:v>0.96120624793089959</c:v>
                </c:pt>
                <c:pt idx="3771">
                  <c:v>0.94886688536431218</c:v>
                </c:pt>
                <c:pt idx="3772">
                  <c:v>0.96310229632527766</c:v>
                </c:pt>
                <c:pt idx="3773">
                  <c:v>0.94745237307009356</c:v>
                </c:pt>
                <c:pt idx="3774">
                  <c:v>0.94107201974298016</c:v>
                </c:pt>
                <c:pt idx="3775">
                  <c:v>0.96192855208113881</c:v>
                </c:pt>
                <c:pt idx="3776">
                  <c:v>0.96018298371806066</c:v>
                </c:pt>
                <c:pt idx="3777">
                  <c:v>0.97279321034098776</c:v>
                </c:pt>
                <c:pt idx="3778">
                  <c:v>0.9475125650826135</c:v>
                </c:pt>
                <c:pt idx="3779">
                  <c:v>0.95100370180877003</c:v>
                </c:pt>
                <c:pt idx="3780">
                  <c:v>0.9642760405694164</c:v>
                </c:pt>
                <c:pt idx="3781">
                  <c:v>0.9649682487133957</c:v>
                </c:pt>
                <c:pt idx="3782">
                  <c:v>0.9477834291389533</c:v>
                </c:pt>
                <c:pt idx="3783">
                  <c:v>0.96162759201853909</c:v>
                </c:pt>
                <c:pt idx="3784">
                  <c:v>0.95359195834712729</c:v>
                </c:pt>
                <c:pt idx="3785">
                  <c:v>0.95732386312336348</c:v>
                </c:pt>
                <c:pt idx="3786">
                  <c:v>0.95181629397778911</c:v>
                </c:pt>
                <c:pt idx="3787">
                  <c:v>0.95178619797152919</c:v>
                </c:pt>
                <c:pt idx="3788">
                  <c:v>0.95259879014054838</c:v>
                </c:pt>
                <c:pt idx="3789">
                  <c:v>0.95696271104824393</c:v>
                </c:pt>
                <c:pt idx="3790">
                  <c:v>0.9477834291389533</c:v>
                </c:pt>
                <c:pt idx="3791">
                  <c:v>0.96096547988081982</c:v>
                </c:pt>
                <c:pt idx="3792">
                  <c:v>0.95148523790892947</c:v>
                </c:pt>
                <c:pt idx="3793">
                  <c:v>0.93983808348632136</c:v>
                </c:pt>
                <c:pt idx="3794">
                  <c:v>0.94525536461311588</c:v>
                </c:pt>
                <c:pt idx="3795">
                  <c:v>0.93800222710446324</c:v>
                </c:pt>
                <c:pt idx="3796">
                  <c:v>0.94982995756463118</c:v>
                </c:pt>
                <c:pt idx="3797">
                  <c:v>0.93667800282902458</c:v>
                </c:pt>
                <c:pt idx="3798">
                  <c:v>0.93986817949258128</c:v>
                </c:pt>
                <c:pt idx="3799">
                  <c:v>0.95145514190266955</c:v>
                </c:pt>
                <c:pt idx="3800">
                  <c:v>0.94411171637523705</c:v>
                </c:pt>
                <c:pt idx="3801">
                  <c:v>0.96493815270713579</c:v>
                </c:pt>
                <c:pt idx="3802">
                  <c:v>0.95217744605290877</c:v>
                </c:pt>
                <c:pt idx="3803">
                  <c:v>0.94185451590573932</c:v>
                </c:pt>
                <c:pt idx="3804">
                  <c:v>0.94375056430011739</c:v>
                </c:pt>
                <c:pt idx="3805">
                  <c:v>0.9380925151232431</c:v>
                </c:pt>
                <c:pt idx="3806">
                  <c:v>0.94290787612483828</c:v>
                </c:pt>
                <c:pt idx="3807">
                  <c:v>0.93691877087910436</c:v>
                </c:pt>
                <c:pt idx="3808">
                  <c:v>0.94615824480091493</c:v>
                </c:pt>
                <c:pt idx="3809">
                  <c:v>0.93484214644716646</c:v>
                </c:pt>
                <c:pt idx="3810">
                  <c:v>0.94028952358022089</c:v>
                </c:pt>
                <c:pt idx="3811">
                  <c:v>0.94703102898245406</c:v>
                </c:pt>
                <c:pt idx="3812">
                  <c:v>0.94513498058807599</c:v>
                </c:pt>
                <c:pt idx="3813">
                  <c:v>0.94456315646913658</c:v>
                </c:pt>
                <c:pt idx="3814">
                  <c:v>0.93237427393384897</c:v>
                </c:pt>
                <c:pt idx="3815">
                  <c:v>0.94838534926415263</c:v>
                </c:pt>
                <c:pt idx="3816">
                  <c:v>0.93526349053480606</c:v>
                </c:pt>
                <c:pt idx="3817">
                  <c:v>0.92930448129533216</c:v>
                </c:pt>
                <c:pt idx="3818">
                  <c:v>0.95494627862882597</c:v>
                </c:pt>
                <c:pt idx="3819">
                  <c:v>0.93712944292292411</c:v>
                </c:pt>
                <c:pt idx="3820">
                  <c:v>0.94131278779305982</c:v>
                </c:pt>
                <c:pt idx="3821">
                  <c:v>0.94495440455051616</c:v>
                </c:pt>
                <c:pt idx="3822">
                  <c:v>0.95491618262256595</c:v>
                </c:pt>
                <c:pt idx="3823">
                  <c:v>0.94817467722033288</c:v>
                </c:pt>
                <c:pt idx="3824">
                  <c:v>0.93721973094170408</c:v>
                </c:pt>
                <c:pt idx="3825">
                  <c:v>0.9461281487946549</c:v>
                </c:pt>
                <c:pt idx="3826">
                  <c:v>0.95043187768983051</c:v>
                </c:pt>
                <c:pt idx="3827">
                  <c:v>0.94230595599963884</c:v>
                </c:pt>
                <c:pt idx="3828">
                  <c:v>0.9477834291389533</c:v>
                </c:pt>
                <c:pt idx="3829">
                  <c:v>0.93234417792758906</c:v>
                </c:pt>
                <c:pt idx="3830">
                  <c:v>0.93845366719836276</c:v>
                </c:pt>
                <c:pt idx="3831">
                  <c:v>0.93899539531104226</c:v>
                </c:pt>
                <c:pt idx="3832">
                  <c:v>0.94630872483221473</c:v>
                </c:pt>
                <c:pt idx="3833">
                  <c:v>0.93815270713576304</c:v>
                </c:pt>
                <c:pt idx="3834">
                  <c:v>0.95657146296686435</c:v>
                </c:pt>
                <c:pt idx="3835">
                  <c:v>0.93875462726096248</c:v>
                </c:pt>
                <c:pt idx="3836">
                  <c:v>0.94549613266319554</c:v>
                </c:pt>
                <c:pt idx="3837">
                  <c:v>0.94173413188069943</c:v>
                </c:pt>
                <c:pt idx="3838">
                  <c:v>0.93812261112950313</c:v>
                </c:pt>
                <c:pt idx="3839">
                  <c:v>0.94477382851295633</c:v>
                </c:pt>
                <c:pt idx="3840">
                  <c:v>0.94065067565534055</c:v>
                </c:pt>
                <c:pt idx="3841">
                  <c:v>0.94188461191199924</c:v>
                </c:pt>
                <c:pt idx="3842">
                  <c:v>0.93950702741746173</c:v>
                </c:pt>
                <c:pt idx="3843">
                  <c:v>0.93472176242212657</c:v>
                </c:pt>
                <c:pt idx="3844">
                  <c:v>0.93908568332982212</c:v>
                </c:pt>
                <c:pt idx="3845">
                  <c:v>0.9297860173954916</c:v>
                </c:pt>
                <c:pt idx="3846">
                  <c:v>0.95645107894182446</c:v>
                </c:pt>
                <c:pt idx="3847">
                  <c:v>0.94107201974298016</c:v>
                </c:pt>
                <c:pt idx="3848">
                  <c:v>0.93111024167093026</c:v>
                </c:pt>
                <c:pt idx="3849">
                  <c:v>0.93893520329852231</c:v>
                </c:pt>
                <c:pt idx="3850">
                  <c:v>0.92150961567400003</c:v>
                </c:pt>
                <c:pt idx="3851">
                  <c:v>0.92611430463177535</c:v>
                </c:pt>
                <c:pt idx="3852">
                  <c:v>0.94546603665693563</c:v>
                </c:pt>
                <c:pt idx="3853">
                  <c:v>0.93833328317332287</c:v>
                </c:pt>
                <c:pt idx="3854">
                  <c:v>0.92578324856291572</c:v>
                </c:pt>
                <c:pt idx="3855">
                  <c:v>0.92966563337045172</c:v>
                </c:pt>
                <c:pt idx="3856">
                  <c:v>0.92286393595569871</c:v>
                </c:pt>
                <c:pt idx="3857">
                  <c:v>0.94296806813735812</c:v>
                </c:pt>
                <c:pt idx="3858">
                  <c:v>0.93092966563337043</c:v>
                </c:pt>
                <c:pt idx="3859">
                  <c:v>0.92713756884461429</c:v>
                </c:pt>
                <c:pt idx="3860">
                  <c:v>0.93830318716706296</c:v>
                </c:pt>
                <c:pt idx="3861">
                  <c:v>0.93556445059740567</c:v>
                </c:pt>
                <c:pt idx="3862">
                  <c:v>0.92728804887591421</c:v>
                </c:pt>
                <c:pt idx="3863">
                  <c:v>0.92882294519517261</c:v>
                </c:pt>
                <c:pt idx="3864">
                  <c:v>0.92331537604959824</c:v>
                </c:pt>
                <c:pt idx="3865">
                  <c:v>0.93788184307942335</c:v>
                </c:pt>
                <c:pt idx="3866">
                  <c:v>0.9349023384596864</c:v>
                </c:pt>
                <c:pt idx="3867">
                  <c:v>0.94654949288229451</c:v>
                </c:pt>
                <c:pt idx="3868">
                  <c:v>0.92608420862551544</c:v>
                </c:pt>
                <c:pt idx="3869">
                  <c:v>0.93598579468504528</c:v>
                </c:pt>
                <c:pt idx="3870">
                  <c:v>0.93405965028440729</c:v>
                </c:pt>
                <c:pt idx="3871">
                  <c:v>0.93186264182742951</c:v>
                </c:pt>
                <c:pt idx="3872">
                  <c:v>0.92352604809341798</c:v>
                </c:pt>
                <c:pt idx="3873">
                  <c:v>0.9275589129322539</c:v>
                </c:pt>
                <c:pt idx="3874">
                  <c:v>0.92659584073193491</c:v>
                </c:pt>
                <c:pt idx="3875">
                  <c:v>0.92906371324525239</c:v>
                </c:pt>
                <c:pt idx="3876">
                  <c:v>0.93017726547687118</c:v>
                </c:pt>
                <c:pt idx="3877">
                  <c:v>0.93851385921088271</c:v>
                </c:pt>
                <c:pt idx="3878">
                  <c:v>0.92551238450657602</c:v>
                </c:pt>
                <c:pt idx="3879">
                  <c:v>0.9311704336834502</c:v>
                </c:pt>
                <c:pt idx="3880">
                  <c:v>0.93989827549884131</c:v>
                </c:pt>
                <c:pt idx="3881">
                  <c:v>0.928401601107533</c:v>
                </c:pt>
                <c:pt idx="3882">
                  <c:v>0.94624853281969479</c:v>
                </c:pt>
                <c:pt idx="3883">
                  <c:v>0.93089956962711051</c:v>
                </c:pt>
                <c:pt idx="3884">
                  <c:v>0.94200499593703912</c:v>
                </c:pt>
                <c:pt idx="3885">
                  <c:v>0.92807054503867337</c:v>
                </c:pt>
                <c:pt idx="3886">
                  <c:v>0.93622656273512506</c:v>
                </c:pt>
                <c:pt idx="3887">
                  <c:v>0.93706925091040416</c:v>
                </c:pt>
                <c:pt idx="3888">
                  <c:v>0.93068889758329065</c:v>
                </c:pt>
                <c:pt idx="3889">
                  <c:v>0.92030577542360126</c:v>
                </c:pt>
                <c:pt idx="3890">
                  <c:v>0.92719776085713423</c:v>
                </c:pt>
                <c:pt idx="3891">
                  <c:v>0.91467782225298699</c:v>
                </c:pt>
                <c:pt idx="3892">
                  <c:v>0.93761097902308366</c:v>
                </c:pt>
                <c:pt idx="3893">
                  <c:v>0.93550425858488584</c:v>
                </c:pt>
                <c:pt idx="3894">
                  <c:v>0.91663406265988501</c:v>
                </c:pt>
                <c:pt idx="3895">
                  <c:v>0.93791193908568338</c:v>
                </c:pt>
                <c:pt idx="3896">
                  <c:v>0.92433864026243717</c:v>
                </c:pt>
                <c:pt idx="3897">
                  <c:v>0.92448912029373698</c:v>
                </c:pt>
                <c:pt idx="3898">
                  <c:v>0.93098985764589037</c:v>
                </c:pt>
                <c:pt idx="3899">
                  <c:v>0.9121798537334096</c:v>
                </c:pt>
                <c:pt idx="3900">
                  <c:v>0.9252114244439763</c:v>
                </c:pt>
                <c:pt idx="3901">
                  <c:v>0.93682848286032439</c:v>
                </c:pt>
                <c:pt idx="3902">
                  <c:v>0.92837150510127309</c:v>
                </c:pt>
                <c:pt idx="3903">
                  <c:v>0.92584344057543566</c:v>
                </c:pt>
                <c:pt idx="3904">
                  <c:v>0.92524152045023622</c:v>
                </c:pt>
                <c:pt idx="3905">
                  <c:v>0.92683660878201468</c:v>
                </c:pt>
                <c:pt idx="3906">
                  <c:v>0.92897342522647242</c:v>
                </c:pt>
                <c:pt idx="3907">
                  <c:v>0.92981611340175163</c:v>
                </c:pt>
                <c:pt idx="3908">
                  <c:v>0.93929635537364187</c:v>
                </c:pt>
                <c:pt idx="3909">
                  <c:v>0.91946308724832215</c:v>
                </c:pt>
                <c:pt idx="3910">
                  <c:v>0.93785174707316343</c:v>
                </c:pt>
                <c:pt idx="3911">
                  <c:v>0.92295422397447857</c:v>
                </c:pt>
                <c:pt idx="3912">
                  <c:v>0.91877087910434285</c:v>
                </c:pt>
                <c:pt idx="3913">
                  <c:v>0.9307490895958106</c:v>
                </c:pt>
                <c:pt idx="3914">
                  <c:v>0.92304451199325854</c:v>
                </c:pt>
                <c:pt idx="3915">
                  <c:v>0.93327715412164802</c:v>
                </c:pt>
                <c:pt idx="3916">
                  <c:v>0.91263129382730912</c:v>
                </c:pt>
                <c:pt idx="3917">
                  <c:v>0.92518132843771628</c:v>
                </c:pt>
                <c:pt idx="3918">
                  <c:v>0.92081740753002073</c:v>
                </c:pt>
                <c:pt idx="3919">
                  <c:v>0.92150961567400003</c:v>
                </c:pt>
                <c:pt idx="3920">
                  <c:v>0.92945496132663197</c:v>
                </c:pt>
                <c:pt idx="3921">
                  <c:v>0.93399945827188735</c:v>
                </c:pt>
                <c:pt idx="3922">
                  <c:v>0.92045625545490117</c:v>
                </c:pt>
                <c:pt idx="3923">
                  <c:v>0.91296234989616876</c:v>
                </c:pt>
                <c:pt idx="3924">
                  <c:v>0.9275589129322539</c:v>
                </c:pt>
                <c:pt idx="3925">
                  <c:v>0.92060673548620098</c:v>
                </c:pt>
                <c:pt idx="3926">
                  <c:v>0.92641526469437507</c:v>
                </c:pt>
                <c:pt idx="3927">
                  <c:v>0.94047009961778072</c:v>
                </c:pt>
                <c:pt idx="3928">
                  <c:v>0.91395551810274778</c:v>
                </c:pt>
                <c:pt idx="3929">
                  <c:v>0.9130225419086887</c:v>
                </c:pt>
                <c:pt idx="3930">
                  <c:v>0.92250278388057905</c:v>
                </c:pt>
                <c:pt idx="3931">
                  <c:v>0.93393926625936741</c:v>
                </c:pt>
                <c:pt idx="3932">
                  <c:v>0.93327715412164802</c:v>
                </c:pt>
                <c:pt idx="3933">
                  <c:v>0.92129894363018028</c:v>
                </c:pt>
                <c:pt idx="3934">
                  <c:v>0.92746862491347393</c:v>
                </c:pt>
                <c:pt idx="3935">
                  <c:v>0.92214163180545938</c:v>
                </c:pt>
                <c:pt idx="3936">
                  <c:v>0.92214163180545938</c:v>
                </c:pt>
                <c:pt idx="3937">
                  <c:v>0.91705540674752462</c:v>
                </c:pt>
                <c:pt idx="3938">
                  <c:v>0.92873265717639264</c:v>
                </c:pt>
                <c:pt idx="3939">
                  <c:v>0.92704728082583443</c:v>
                </c:pt>
                <c:pt idx="3940">
                  <c:v>0.93186264182742951</c:v>
                </c:pt>
                <c:pt idx="3941">
                  <c:v>0.92623468865681524</c:v>
                </c:pt>
                <c:pt idx="3942">
                  <c:v>0.92460950431877686</c:v>
                </c:pt>
                <c:pt idx="3943">
                  <c:v>0.90932073313871253</c:v>
                </c:pt>
                <c:pt idx="3944">
                  <c:v>0.91455743822794711</c:v>
                </c:pt>
                <c:pt idx="3945">
                  <c:v>0.92463960032503689</c:v>
                </c:pt>
                <c:pt idx="3946">
                  <c:v>0.9130225419086887</c:v>
                </c:pt>
                <c:pt idx="3947">
                  <c:v>0.92226201583049927</c:v>
                </c:pt>
                <c:pt idx="3948">
                  <c:v>0.92349595208715807</c:v>
                </c:pt>
                <c:pt idx="3949">
                  <c:v>0.9171757907725645</c:v>
                </c:pt>
                <c:pt idx="3950">
                  <c:v>0.93715953892918413</c:v>
                </c:pt>
                <c:pt idx="3951">
                  <c:v>0.92650555271315493</c:v>
                </c:pt>
                <c:pt idx="3952">
                  <c:v>0.92764920095103376</c:v>
                </c:pt>
                <c:pt idx="3953">
                  <c:v>0.92048635146116109</c:v>
                </c:pt>
                <c:pt idx="3954">
                  <c:v>0.91657387064736506</c:v>
                </c:pt>
                <c:pt idx="3955">
                  <c:v>0.93252475396514878</c:v>
                </c:pt>
                <c:pt idx="3956">
                  <c:v>0.92641526469437507</c:v>
                </c:pt>
                <c:pt idx="3957">
                  <c:v>0.91106630150179069</c:v>
                </c:pt>
                <c:pt idx="3958">
                  <c:v>0.91985433532970173</c:v>
                </c:pt>
                <c:pt idx="3959">
                  <c:v>0.9224425918680591</c:v>
                </c:pt>
                <c:pt idx="3960">
                  <c:v>0.92752881692599387</c:v>
                </c:pt>
                <c:pt idx="3961">
                  <c:v>0.92801035302615342</c:v>
                </c:pt>
                <c:pt idx="3962">
                  <c:v>0.9150991663406266</c:v>
                </c:pt>
                <c:pt idx="3963">
                  <c:v>0.92948505733289188</c:v>
                </c:pt>
                <c:pt idx="3964">
                  <c:v>0.92418816023113737</c:v>
                </c:pt>
                <c:pt idx="3965">
                  <c:v>0.92120865561140042</c:v>
                </c:pt>
                <c:pt idx="3966">
                  <c:v>0.91175850964576999</c:v>
                </c:pt>
                <c:pt idx="3967">
                  <c:v>0.9240978722123574</c:v>
                </c:pt>
                <c:pt idx="3968">
                  <c:v>0.92614440063803538</c:v>
                </c:pt>
                <c:pt idx="3969">
                  <c:v>0.90372287597435819</c:v>
                </c:pt>
                <c:pt idx="3970">
                  <c:v>0.9234056640683781</c:v>
                </c:pt>
                <c:pt idx="3971">
                  <c:v>0.91726607879134436</c:v>
                </c:pt>
                <c:pt idx="3972">
                  <c:v>0.92683660878201468</c:v>
                </c:pt>
                <c:pt idx="3973">
                  <c:v>0.9300568814518313</c:v>
                </c:pt>
                <c:pt idx="3974">
                  <c:v>0.93264513799018867</c:v>
                </c:pt>
                <c:pt idx="3975">
                  <c:v>0.91347398200258823</c:v>
                </c:pt>
                <c:pt idx="3976">
                  <c:v>0.91160802961447018</c:v>
                </c:pt>
                <c:pt idx="3977">
                  <c:v>0.9282511210762332</c:v>
                </c:pt>
                <c:pt idx="3978">
                  <c:v>0.92093779155506061</c:v>
                </c:pt>
                <c:pt idx="3979">
                  <c:v>0.91943299124206213</c:v>
                </c:pt>
                <c:pt idx="3980">
                  <c:v>0.91850001504800316</c:v>
                </c:pt>
                <c:pt idx="3981">
                  <c:v>0.90998284527643181</c:v>
                </c:pt>
                <c:pt idx="3982">
                  <c:v>0.92099798356758056</c:v>
                </c:pt>
                <c:pt idx="3983">
                  <c:v>0.92996659343305144</c:v>
                </c:pt>
                <c:pt idx="3984">
                  <c:v>0.91606223854094559</c:v>
                </c:pt>
                <c:pt idx="3985">
                  <c:v>0.93535377855358592</c:v>
                </c:pt>
                <c:pt idx="3986">
                  <c:v>0.92530171246275617</c:v>
                </c:pt>
                <c:pt idx="3987">
                  <c:v>0.91657387064736506</c:v>
                </c:pt>
                <c:pt idx="3988">
                  <c:v>0.91825924699792338</c:v>
                </c:pt>
                <c:pt idx="3989">
                  <c:v>0.91275167785234901</c:v>
                </c:pt>
                <c:pt idx="3990">
                  <c:v>0.90898967706985279</c:v>
                </c:pt>
                <c:pt idx="3991">
                  <c:v>0.92078731152376081</c:v>
                </c:pt>
                <c:pt idx="3992">
                  <c:v>0.92166009570529994</c:v>
                </c:pt>
                <c:pt idx="3993">
                  <c:v>0.90802660486953379</c:v>
                </c:pt>
                <c:pt idx="3994">
                  <c:v>0.91365455804014806</c:v>
                </c:pt>
                <c:pt idx="3995">
                  <c:v>0.913714750052668</c:v>
                </c:pt>
                <c:pt idx="3996">
                  <c:v>0.93065880157703074</c:v>
                </c:pt>
                <c:pt idx="3997">
                  <c:v>0.91624281457850543</c:v>
                </c:pt>
                <c:pt idx="3998">
                  <c:v>0.91741655882264428</c:v>
                </c:pt>
                <c:pt idx="3999">
                  <c:v>0.92045625545490117</c:v>
                </c:pt>
                <c:pt idx="4000">
                  <c:v>0.89863665091642342</c:v>
                </c:pt>
                <c:pt idx="4001">
                  <c:v>0.91251090980226923</c:v>
                </c:pt>
                <c:pt idx="4002">
                  <c:v>0.92250278388057905</c:v>
                </c:pt>
                <c:pt idx="4003">
                  <c:v>0.92223191982423935</c:v>
                </c:pt>
                <c:pt idx="4004">
                  <c:v>0.91576127847834587</c:v>
                </c:pt>
                <c:pt idx="4005">
                  <c:v>0.92349595208715807</c:v>
                </c:pt>
                <c:pt idx="4006">
                  <c:v>0.91886116712312271</c:v>
                </c:pt>
                <c:pt idx="4007">
                  <c:v>0.91290215788364881</c:v>
                </c:pt>
                <c:pt idx="4008">
                  <c:v>0.91064495741415119</c:v>
                </c:pt>
                <c:pt idx="4009">
                  <c:v>0.92024558341108131</c:v>
                </c:pt>
                <c:pt idx="4010">
                  <c:v>0.91765732687272394</c:v>
                </c:pt>
                <c:pt idx="4011">
                  <c:v>0.91377494206518795</c:v>
                </c:pt>
                <c:pt idx="4012">
                  <c:v>0.92858217714509284</c:v>
                </c:pt>
                <c:pt idx="4013">
                  <c:v>0.91612243055346554</c:v>
                </c:pt>
                <c:pt idx="4014">
                  <c:v>0.92816083305745323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0-406D-4685-9C31-077D5640B09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68068495"/>
        <c:axId val="168080975"/>
      </c:scatterChart>
      <c:valAx>
        <c:axId val="168068495"/>
        <c:scaling>
          <c:orientation val="minMax"/>
          <c:max val="1750"/>
          <c:min val="250"/>
        </c:scaling>
        <c:delete val="1"/>
        <c:axPos val="b"/>
        <c:numFmt formatCode="General" sourceLinked="1"/>
        <c:majorTickMark val="out"/>
        <c:minorTickMark val="none"/>
        <c:tickLblPos val="nextTo"/>
        <c:crossAx val="168080975"/>
        <c:crosses val="autoZero"/>
        <c:crossBetween val="midCat"/>
      </c:valAx>
      <c:valAx>
        <c:axId val="168080975"/>
        <c:scaling>
          <c:orientation val="minMax"/>
          <c:max val="2"/>
          <c:min val="0.5"/>
        </c:scaling>
        <c:delete val="1"/>
        <c:axPos val="l"/>
        <c:numFmt formatCode="General" sourceLinked="1"/>
        <c:majorTickMark val="out"/>
        <c:minorTickMark val="none"/>
        <c:tickLblPos val="nextTo"/>
        <c:crossAx val="168068495"/>
        <c:crosses val="autoZero"/>
        <c:crossBetween val="midCat"/>
        <c:majorUnit val="0.2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400">
          <a:solidFill>
            <a:schemeClr val="tx1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withinLinear" id="15">
  <a:schemeClr val="accent2"/>
</cs:colorStyle>
</file>

<file path=ppt/charts/colors2.xml><?xml version="1.0" encoding="utf-8"?>
<cs:colorStyle xmlns:cs="http://schemas.microsoft.com/office/drawing/2012/chartStyle" xmlns:a="http://schemas.openxmlformats.org/drawingml/2006/main" meth="withinLinear" id="19">
  <a:schemeClr val="accent6"/>
</cs:colorStyle>
</file>

<file path=ppt/charts/style1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31ED5DB-1D6F-4A34-9400-23C1B8C75DD9}" type="datetimeFigureOut">
              <a:rPr lang="en-US" smtClean="0"/>
              <a:t>11/18/202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BACDC44-CFA8-48CC-B7B6-53D7ECABA47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932469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2F2EE36-B404-4EB3-8EC1-DFB2D43C9673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9471627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8C30FD-0C5D-4A5B-B301-D52CDC6E442A}" type="datetimeFigureOut">
              <a:rPr lang="en-US" smtClean="0"/>
              <a:t>11/18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6CDDB9-A203-4442-B2A9-03188924956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0367156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8C30FD-0C5D-4A5B-B301-D52CDC6E442A}" type="datetimeFigureOut">
              <a:rPr lang="en-US" smtClean="0"/>
              <a:t>11/18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6CDDB9-A203-4442-B2A9-03188924956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9781352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8C30FD-0C5D-4A5B-B301-D52CDC6E442A}" type="datetimeFigureOut">
              <a:rPr lang="en-US" smtClean="0"/>
              <a:t>11/18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6CDDB9-A203-4442-B2A9-03188924956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9563615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8C30FD-0C5D-4A5B-B301-D52CDC6E442A}" type="datetimeFigureOut">
              <a:rPr lang="en-US" smtClean="0"/>
              <a:t>11/18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6CDDB9-A203-4442-B2A9-03188924956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6275390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8C30FD-0C5D-4A5B-B301-D52CDC6E442A}" type="datetimeFigureOut">
              <a:rPr lang="en-US" smtClean="0"/>
              <a:t>11/18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6CDDB9-A203-4442-B2A9-03188924956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854126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8C30FD-0C5D-4A5B-B301-D52CDC6E442A}" type="datetimeFigureOut">
              <a:rPr lang="en-US" smtClean="0"/>
              <a:t>11/18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6CDDB9-A203-4442-B2A9-03188924956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8547620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8C30FD-0C5D-4A5B-B301-D52CDC6E442A}" type="datetimeFigureOut">
              <a:rPr lang="en-US" smtClean="0"/>
              <a:t>11/18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6CDDB9-A203-4442-B2A9-03188924956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5533272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8C30FD-0C5D-4A5B-B301-D52CDC6E442A}" type="datetimeFigureOut">
              <a:rPr lang="en-US" smtClean="0"/>
              <a:t>11/18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6CDDB9-A203-4442-B2A9-03188924956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5780754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8C30FD-0C5D-4A5B-B301-D52CDC6E442A}" type="datetimeFigureOut">
              <a:rPr lang="en-US" smtClean="0"/>
              <a:t>11/18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6CDDB9-A203-4442-B2A9-03188924956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1735599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8C30FD-0C5D-4A5B-B301-D52CDC6E442A}" type="datetimeFigureOut">
              <a:rPr lang="en-US" smtClean="0"/>
              <a:t>11/18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6CDDB9-A203-4442-B2A9-03188924956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0097086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8C30FD-0C5D-4A5B-B301-D52CDC6E442A}" type="datetimeFigureOut">
              <a:rPr lang="en-US" smtClean="0"/>
              <a:t>11/18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6CDDB9-A203-4442-B2A9-03188924956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4979453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E8C30FD-0C5D-4A5B-B301-D52CDC6E442A}" type="datetimeFigureOut">
              <a:rPr lang="en-US" smtClean="0"/>
              <a:t>11/18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76CDDB9-A203-4442-B2A9-03188924956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4480422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7" Type="http://schemas.openxmlformats.org/officeDocument/2006/relationships/chart" Target="../charts/chart3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chart" Target="../charts/chart2.xml"/><Relationship Id="rId5" Type="http://schemas.openxmlformats.org/officeDocument/2006/relationships/chart" Target="../charts/chart1.xml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8" name="Group 77"/>
          <p:cNvGrpSpPr/>
          <p:nvPr/>
        </p:nvGrpSpPr>
        <p:grpSpPr>
          <a:xfrm>
            <a:off x="-108860" y="0"/>
            <a:ext cx="12453257" cy="6858000"/>
            <a:chOff x="-108860" y="0"/>
            <a:chExt cx="12453257" cy="6858000"/>
          </a:xfrm>
        </p:grpSpPr>
        <p:sp>
          <p:nvSpPr>
            <p:cNvPr id="77" name="Rectangle 76"/>
            <p:cNvSpPr/>
            <p:nvPr/>
          </p:nvSpPr>
          <p:spPr>
            <a:xfrm>
              <a:off x="-108860" y="0"/>
              <a:ext cx="12453257" cy="685800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pic>
          <p:nvPicPr>
            <p:cNvPr id="72" name="Picture 71"/>
            <p:cNvPicPr>
              <a:picLocks noChangeAspect="1"/>
            </p:cNvPicPr>
            <p:nvPr/>
          </p:nvPicPr>
          <p:blipFill rotWithShape="1">
            <a:blip r:embed="rId3"/>
            <a:srcRect l="31039" t="33322" r="12545" b="46414"/>
            <a:stretch/>
          </p:blipFill>
          <p:spPr>
            <a:xfrm>
              <a:off x="958040" y="935260"/>
              <a:ext cx="11125099" cy="2084558"/>
            </a:xfrm>
            <a:prstGeom prst="rect">
              <a:avLst/>
            </a:prstGeom>
          </p:spPr>
        </p:pic>
        <p:grpSp>
          <p:nvGrpSpPr>
            <p:cNvPr id="66" name="Group 65"/>
            <p:cNvGrpSpPr/>
            <p:nvPr/>
          </p:nvGrpSpPr>
          <p:grpSpPr>
            <a:xfrm>
              <a:off x="-108860" y="623111"/>
              <a:ext cx="12338236" cy="5736344"/>
              <a:chOff x="0" y="-165835"/>
              <a:chExt cx="9253677" cy="4302258"/>
            </a:xfrm>
          </p:grpSpPr>
          <p:grpSp>
            <p:nvGrpSpPr>
              <p:cNvPr id="64" name="Group 63"/>
              <p:cNvGrpSpPr/>
              <p:nvPr/>
            </p:nvGrpSpPr>
            <p:grpSpPr>
              <a:xfrm>
                <a:off x="0" y="-165835"/>
                <a:ext cx="9253677" cy="3843823"/>
                <a:chOff x="0" y="-165835"/>
                <a:chExt cx="9253677" cy="3843823"/>
              </a:xfrm>
            </p:grpSpPr>
            <p:grpSp>
              <p:nvGrpSpPr>
                <p:cNvPr id="2" name="Group 1"/>
                <p:cNvGrpSpPr/>
                <p:nvPr/>
              </p:nvGrpSpPr>
              <p:grpSpPr>
                <a:xfrm>
                  <a:off x="0" y="-165835"/>
                  <a:ext cx="9253677" cy="3843823"/>
                  <a:chOff x="0" y="-165835"/>
                  <a:chExt cx="9253677" cy="3843823"/>
                </a:xfrm>
              </p:grpSpPr>
              <p:pic>
                <p:nvPicPr>
                  <p:cNvPr id="3" name="Picture 2"/>
                  <p:cNvPicPr>
                    <a:picLocks noChangeAspect="1"/>
                  </p:cNvPicPr>
                  <p:nvPr/>
                </p:nvPicPr>
                <p:blipFill rotWithShape="1">
                  <a:blip r:embed="rId4"/>
                  <a:srcRect l="23542" t="59299" r="4791" b="34238"/>
                  <a:stretch/>
                </p:blipFill>
                <p:spPr>
                  <a:xfrm>
                    <a:off x="0" y="2219643"/>
                    <a:ext cx="9144000" cy="394004"/>
                  </a:xfrm>
                  <a:prstGeom prst="rect">
                    <a:avLst/>
                  </a:prstGeom>
                </p:spPr>
              </p:pic>
              <p:pic>
                <p:nvPicPr>
                  <p:cNvPr id="5" name="Picture 4"/>
                  <p:cNvPicPr>
                    <a:picLocks noChangeAspect="1"/>
                  </p:cNvPicPr>
                  <p:nvPr/>
                </p:nvPicPr>
                <p:blipFill rotWithShape="1">
                  <a:blip r:embed="rId4"/>
                  <a:srcRect l="23542" t="78988" r="72965" b="12222"/>
                  <a:stretch/>
                </p:blipFill>
                <p:spPr>
                  <a:xfrm>
                    <a:off x="1125571" y="3105557"/>
                    <a:ext cx="445668" cy="535853"/>
                  </a:xfrm>
                  <a:prstGeom prst="rect">
                    <a:avLst/>
                  </a:prstGeom>
                </p:spPr>
              </p:pic>
              <p:graphicFrame>
                <p:nvGraphicFramePr>
                  <p:cNvPr id="6" name="Chart 5"/>
                  <p:cNvGraphicFramePr>
                    <a:graphicFrameLocks/>
                  </p:cNvGraphicFramePr>
                  <p:nvPr>
                    <p:extLst/>
                  </p:nvPr>
                </p:nvGraphicFramePr>
                <p:xfrm>
                  <a:off x="716715" y="-165835"/>
                  <a:ext cx="2679641" cy="2725338"/>
                </p:xfrm>
                <a:graphic>
                  <a:graphicData uri="http://schemas.openxmlformats.org/drawingml/2006/chart">
                    <c:chart xmlns:c="http://schemas.openxmlformats.org/drawingml/2006/chart" xmlns:r="http://schemas.openxmlformats.org/officeDocument/2006/relationships" r:id="rId5"/>
                  </a:graphicData>
                </a:graphic>
              </p:graphicFrame>
              <p:graphicFrame>
                <p:nvGraphicFramePr>
                  <p:cNvPr id="7" name="Chart 6"/>
                  <p:cNvGraphicFramePr>
                    <a:graphicFrameLocks/>
                  </p:cNvGraphicFramePr>
                  <p:nvPr>
                    <p:extLst/>
                  </p:nvPr>
                </p:nvGraphicFramePr>
                <p:xfrm>
                  <a:off x="6412141" y="332161"/>
                  <a:ext cx="2841536" cy="2724912"/>
                </p:xfrm>
                <a:graphic>
                  <a:graphicData uri="http://schemas.openxmlformats.org/drawingml/2006/chart">
                    <c:chart xmlns:c="http://schemas.openxmlformats.org/drawingml/2006/chart" xmlns:r="http://schemas.openxmlformats.org/officeDocument/2006/relationships" r:id="rId6"/>
                  </a:graphicData>
                </a:graphic>
              </p:graphicFrame>
              <p:graphicFrame>
                <p:nvGraphicFramePr>
                  <p:cNvPr id="8" name="Chart 7"/>
                  <p:cNvGraphicFramePr>
                    <a:graphicFrameLocks/>
                  </p:cNvGraphicFramePr>
                  <p:nvPr>
                    <p:extLst/>
                  </p:nvPr>
                </p:nvGraphicFramePr>
                <p:xfrm>
                  <a:off x="3485798" y="1160560"/>
                  <a:ext cx="2761058" cy="1739890"/>
                </p:xfrm>
                <a:graphic>
                  <a:graphicData uri="http://schemas.openxmlformats.org/drawingml/2006/chart">
                    <c:chart xmlns:c="http://schemas.openxmlformats.org/drawingml/2006/chart" xmlns:r="http://schemas.openxmlformats.org/officeDocument/2006/relationships" r:id="rId7"/>
                  </a:graphicData>
                </a:graphic>
              </p:graphicFrame>
              <p:sp>
                <p:nvSpPr>
                  <p:cNvPr id="9" name="Rectangle 8"/>
                  <p:cNvSpPr/>
                  <p:nvPr/>
                </p:nvSpPr>
                <p:spPr>
                  <a:xfrm rot="16200000">
                    <a:off x="74448" y="1803744"/>
                    <a:ext cx="1119032" cy="83379"/>
                  </a:xfrm>
                  <a:prstGeom prst="rect">
                    <a:avLst/>
                  </a:prstGeom>
                  <a:gradFill flip="none" rotWithShape="1">
                    <a:gsLst>
                      <a:gs pos="0">
                        <a:schemeClr val="accent1">
                          <a:lumMod val="5000"/>
                          <a:lumOff val="95000"/>
                        </a:schemeClr>
                      </a:gs>
                      <a:gs pos="35000">
                        <a:srgbClr val="00588A"/>
                      </a:gs>
                      <a:gs pos="18000">
                        <a:srgbClr val="00B0F0"/>
                      </a:gs>
                      <a:gs pos="50015">
                        <a:srgbClr val="EEECE1"/>
                      </a:gs>
                      <a:gs pos="83000">
                        <a:srgbClr val="F58220"/>
                      </a:gs>
                      <a:gs pos="66000">
                        <a:srgbClr val="FBCDA6"/>
                      </a:gs>
                      <a:gs pos="100000">
                        <a:srgbClr val="C76009"/>
                      </a:gs>
                    </a:gsLst>
                    <a:lin ang="0" scaled="1"/>
                    <a:tileRect/>
                  </a:gra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 sz="2400"/>
                  </a:p>
                </p:txBody>
              </p:sp>
              <p:sp>
                <p:nvSpPr>
                  <p:cNvPr id="10" name="Rectangle 9"/>
                  <p:cNvSpPr/>
                  <p:nvPr/>
                </p:nvSpPr>
                <p:spPr>
                  <a:xfrm rot="16200000">
                    <a:off x="-139495" y="1644374"/>
                    <a:ext cx="1117133" cy="253916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sz="1600" dirty="0">
                        <a:latin typeface="Arial"/>
                        <a:cs typeface="Arial"/>
                      </a:rPr>
                      <a:t>Cytosolic Ca</a:t>
                    </a:r>
                    <a:r>
                      <a:rPr lang="en-US" sz="1600" baseline="30000" dirty="0">
                        <a:latin typeface="Arial"/>
                        <a:cs typeface="Arial"/>
                      </a:rPr>
                      <a:t>2+</a:t>
                    </a:r>
                  </a:p>
                </p:txBody>
              </p:sp>
              <p:sp>
                <p:nvSpPr>
                  <p:cNvPr id="11" name="Rectangle 10"/>
                  <p:cNvSpPr/>
                  <p:nvPr/>
                </p:nvSpPr>
                <p:spPr>
                  <a:xfrm>
                    <a:off x="521294" y="433503"/>
                    <a:ext cx="475130" cy="238575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pPr algn="ctr"/>
                    <a:r>
                      <a:rPr lang="en-US" sz="1467" dirty="0">
                        <a:solidFill>
                          <a:srgbClr val="F58220"/>
                        </a:solidFill>
                        <a:latin typeface="Arial"/>
                        <a:cs typeface="Arial"/>
                      </a:rPr>
                      <a:t>Glut2</a:t>
                    </a:r>
                    <a:endParaRPr lang="en-US" sz="1467" baseline="30000" dirty="0">
                      <a:solidFill>
                        <a:srgbClr val="F58220"/>
                      </a:solidFill>
                      <a:latin typeface="Arial"/>
                      <a:cs typeface="Arial"/>
                    </a:endParaRPr>
                  </a:p>
                </p:txBody>
              </p:sp>
              <p:sp>
                <p:nvSpPr>
                  <p:cNvPr id="12" name="Rectangle 11"/>
                  <p:cNvSpPr/>
                  <p:nvPr/>
                </p:nvSpPr>
                <p:spPr>
                  <a:xfrm>
                    <a:off x="1022005" y="430111"/>
                    <a:ext cx="408045" cy="238575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pPr algn="ctr"/>
                    <a:r>
                      <a:rPr lang="en-US" sz="1467" dirty="0">
                        <a:solidFill>
                          <a:srgbClr val="20AEFF"/>
                        </a:solidFill>
                        <a:latin typeface="Arial"/>
                        <a:cs typeface="Arial"/>
                      </a:rPr>
                      <a:t>K</a:t>
                    </a:r>
                    <a:r>
                      <a:rPr lang="en-US" sz="1467" baseline="-25000" dirty="0">
                        <a:solidFill>
                          <a:srgbClr val="20AEFF"/>
                        </a:solidFill>
                        <a:latin typeface="Arial"/>
                        <a:cs typeface="Arial"/>
                      </a:rPr>
                      <a:t>ATP</a:t>
                    </a:r>
                  </a:p>
                </p:txBody>
              </p:sp>
              <p:sp>
                <p:nvSpPr>
                  <p:cNvPr id="13" name="Rectangle 12"/>
                  <p:cNvSpPr/>
                  <p:nvPr/>
                </p:nvSpPr>
                <p:spPr>
                  <a:xfrm>
                    <a:off x="1321614" y="437371"/>
                    <a:ext cx="497108" cy="238575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pPr algn="ctr"/>
                    <a:r>
                      <a:rPr lang="en-US" sz="1467" dirty="0">
                        <a:solidFill>
                          <a:srgbClr val="B5E4FF"/>
                        </a:solidFill>
                        <a:latin typeface="Arial"/>
                        <a:cs typeface="Arial"/>
                      </a:rPr>
                      <a:t>LTCC</a:t>
                    </a:r>
                    <a:endParaRPr lang="en-US" sz="1467" baseline="30000" dirty="0">
                      <a:solidFill>
                        <a:srgbClr val="B5E4FF"/>
                      </a:solidFill>
                      <a:latin typeface="Arial"/>
                      <a:cs typeface="Arial"/>
                    </a:endParaRPr>
                  </a:p>
                </p:txBody>
              </p:sp>
              <p:sp>
                <p:nvSpPr>
                  <p:cNvPr id="14" name="Rectangle 13"/>
                  <p:cNvSpPr/>
                  <p:nvPr/>
                </p:nvSpPr>
                <p:spPr>
                  <a:xfrm>
                    <a:off x="2382134" y="408070"/>
                    <a:ext cx="601367" cy="238575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pPr algn="ctr"/>
                    <a:r>
                      <a:rPr lang="en-US" sz="1467" dirty="0">
                        <a:solidFill>
                          <a:srgbClr val="C76009"/>
                        </a:solidFill>
                        <a:latin typeface="Arial"/>
                        <a:cs typeface="Arial"/>
                      </a:rPr>
                      <a:t>TRPC3</a:t>
                    </a:r>
                    <a:endParaRPr lang="en-US" sz="1467" baseline="30000" dirty="0">
                      <a:solidFill>
                        <a:srgbClr val="C76009"/>
                      </a:solidFill>
                      <a:latin typeface="Arial"/>
                      <a:cs typeface="Arial"/>
                    </a:endParaRPr>
                  </a:p>
                </p:txBody>
              </p:sp>
              <p:sp>
                <p:nvSpPr>
                  <p:cNvPr id="15" name="Rectangle 14"/>
                  <p:cNvSpPr/>
                  <p:nvPr/>
                </p:nvSpPr>
                <p:spPr>
                  <a:xfrm>
                    <a:off x="2952663" y="412969"/>
                    <a:ext cx="475130" cy="238575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pPr algn="ctr"/>
                    <a:r>
                      <a:rPr lang="en-US" sz="1467" dirty="0">
                        <a:solidFill>
                          <a:srgbClr val="F58220"/>
                        </a:solidFill>
                        <a:latin typeface="Arial"/>
                        <a:cs typeface="Arial"/>
                      </a:rPr>
                      <a:t>Glut2</a:t>
                    </a:r>
                    <a:endParaRPr lang="en-US" sz="1467" baseline="30000" dirty="0">
                      <a:solidFill>
                        <a:srgbClr val="F58220"/>
                      </a:solidFill>
                      <a:latin typeface="Arial"/>
                      <a:cs typeface="Arial"/>
                    </a:endParaRPr>
                  </a:p>
                </p:txBody>
              </p:sp>
              <p:sp>
                <p:nvSpPr>
                  <p:cNvPr id="16" name="Rectangle 15"/>
                  <p:cNvSpPr/>
                  <p:nvPr/>
                </p:nvSpPr>
                <p:spPr>
                  <a:xfrm>
                    <a:off x="1332741" y="-86579"/>
                    <a:ext cx="1404472" cy="253916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pPr algn="ctr"/>
                    <a:r>
                      <a:rPr lang="en-US" sz="1600" b="1" dirty="0">
                        <a:latin typeface="Arial"/>
                        <a:cs typeface="Arial"/>
                      </a:rPr>
                      <a:t>Normal condition</a:t>
                    </a:r>
                    <a:endParaRPr lang="en-US" sz="1600" b="1" baseline="30000" dirty="0">
                      <a:latin typeface="Arial"/>
                      <a:cs typeface="Arial"/>
                    </a:endParaRPr>
                  </a:p>
                </p:txBody>
              </p:sp>
              <p:sp>
                <p:nvSpPr>
                  <p:cNvPr id="17" name="Rectangle 16"/>
                  <p:cNvSpPr/>
                  <p:nvPr/>
                </p:nvSpPr>
                <p:spPr>
                  <a:xfrm>
                    <a:off x="4003154" y="-86579"/>
                    <a:ext cx="1806024" cy="253916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pPr algn="ctr"/>
                    <a:r>
                      <a:rPr lang="en-US" sz="1600" b="1" dirty="0">
                        <a:latin typeface="Arial"/>
                        <a:cs typeface="Arial"/>
                      </a:rPr>
                      <a:t>TRPC3 inhibition &amp; KO</a:t>
                    </a:r>
                    <a:endParaRPr lang="en-US" sz="1600" b="1" baseline="30000" dirty="0">
                      <a:latin typeface="Arial"/>
                      <a:cs typeface="Arial"/>
                    </a:endParaRPr>
                  </a:p>
                </p:txBody>
              </p:sp>
              <p:sp>
                <p:nvSpPr>
                  <p:cNvPr id="18" name="Rectangle 17"/>
                  <p:cNvSpPr/>
                  <p:nvPr/>
                </p:nvSpPr>
                <p:spPr>
                  <a:xfrm>
                    <a:off x="7141953" y="-86579"/>
                    <a:ext cx="1403269" cy="253916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pPr algn="ctr"/>
                    <a:r>
                      <a:rPr lang="en-US" sz="1600" b="1" dirty="0">
                        <a:latin typeface="Arial"/>
                        <a:cs typeface="Arial"/>
                      </a:rPr>
                      <a:t>TRPC3 activation</a:t>
                    </a:r>
                    <a:endParaRPr lang="en-US" sz="1600" b="1" baseline="30000" dirty="0">
                      <a:latin typeface="Arial"/>
                      <a:cs typeface="Arial"/>
                    </a:endParaRPr>
                  </a:p>
                </p:txBody>
              </p:sp>
              <p:grpSp>
                <p:nvGrpSpPr>
                  <p:cNvPr id="19" name="Group 18"/>
                  <p:cNvGrpSpPr/>
                  <p:nvPr/>
                </p:nvGrpSpPr>
                <p:grpSpPr>
                  <a:xfrm>
                    <a:off x="1019705" y="1556888"/>
                    <a:ext cx="2224979" cy="259967"/>
                    <a:chOff x="1019705" y="1615880"/>
                    <a:chExt cx="2224979" cy="259967"/>
                  </a:xfrm>
                </p:grpSpPr>
                <p:grpSp>
                  <p:nvGrpSpPr>
                    <p:cNvPr id="55" name="Group 54"/>
                    <p:cNvGrpSpPr/>
                    <p:nvPr/>
                  </p:nvGrpSpPr>
                  <p:grpSpPr>
                    <a:xfrm flipV="1">
                      <a:off x="1170002" y="1830128"/>
                      <a:ext cx="457200" cy="45719"/>
                      <a:chOff x="1222421" y="1542202"/>
                      <a:chExt cx="439534" cy="2146004860"/>
                    </a:xfrm>
                  </p:grpSpPr>
                  <p:cxnSp>
                    <p:nvCxnSpPr>
                      <p:cNvPr id="61" name="Straight Arrow Connector 60"/>
                      <p:cNvCxnSpPr/>
                      <p:nvPr/>
                    </p:nvCxnSpPr>
                    <p:spPr>
                      <a:xfrm flipV="1">
                        <a:off x="1287096" y="1542202"/>
                        <a:ext cx="374859" cy="1"/>
                      </a:xfrm>
                      <a:prstGeom prst="straightConnector1">
                        <a:avLst/>
                      </a:prstGeom>
                      <a:ln w="9525" cmpd="sng">
                        <a:headEnd w="sm" len="sm"/>
                        <a:tailEnd type="stealth" w="med" len="med"/>
                      </a:ln>
                      <a:effectLst/>
                    </p:spPr>
                    <p:style>
                      <a:lnRef idx="3">
                        <a:schemeClr val="dk1"/>
                      </a:lnRef>
                      <a:fillRef idx="0">
                        <a:schemeClr val="dk1"/>
                      </a:fillRef>
                      <a:effectRef idx="2">
                        <a:schemeClr val="dk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62" name="Straight Arrow Connector 61"/>
                      <p:cNvCxnSpPr/>
                      <p:nvPr/>
                    </p:nvCxnSpPr>
                    <p:spPr>
                      <a:xfrm flipH="1">
                        <a:off x="1222421" y="1542202"/>
                        <a:ext cx="383460" cy="0"/>
                      </a:xfrm>
                      <a:prstGeom prst="straightConnector1">
                        <a:avLst/>
                      </a:prstGeom>
                      <a:ln w="9525" cmpd="sng">
                        <a:tailEnd type="stealth" w="med" len="med"/>
                      </a:ln>
                      <a:effectLst/>
                    </p:spPr>
                    <p:style>
                      <a:lnRef idx="3">
                        <a:schemeClr val="dk1"/>
                      </a:lnRef>
                      <a:fillRef idx="0">
                        <a:schemeClr val="dk1"/>
                      </a:fillRef>
                      <a:effectRef idx="2">
                        <a:schemeClr val="dk1"/>
                      </a:effectRef>
                      <a:fontRef idx="minor">
                        <a:schemeClr val="tx1"/>
                      </a:fontRef>
                    </p:style>
                  </p:cxnSp>
                </p:grpSp>
                <p:grpSp>
                  <p:nvGrpSpPr>
                    <p:cNvPr id="56" name="Group 55"/>
                    <p:cNvGrpSpPr/>
                    <p:nvPr/>
                  </p:nvGrpSpPr>
                  <p:grpSpPr>
                    <a:xfrm flipV="1">
                      <a:off x="1690204" y="1830128"/>
                      <a:ext cx="1554480" cy="45719"/>
                      <a:chOff x="1222421" y="1542202"/>
                      <a:chExt cx="439534" cy="2146004860"/>
                    </a:xfrm>
                  </p:grpSpPr>
                  <p:cxnSp>
                    <p:nvCxnSpPr>
                      <p:cNvPr id="59" name="Straight Arrow Connector 58"/>
                      <p:cNvCxnSpPr/>
                      <p:nvPr/>
                    </p:nvCxnSpPr>
                    <p:spPr>
                      <a:xfrm flipV="1">
                        <a:off x="1287096" y="1542202"/>
                        <a:ext cx="374859" cy="1"/>
                      </a:xfrm>
                      <a:prstGeom prst="straightConnector1">
                        <a:avLst/>
                      </a:prstGeom>
                      <a:ln w="9525" cmpd="sng">
                        <a:headEnd w="sm" len="sm"/>
                        <a:tailEnd type="stealth" w="med" len="med"/>
                      </a:ln>
                      <a:effectLst/>
                    </p:spPr>
                    <p:style>
                      <a:lnRef idx="3">
                        <a:schemeClr val="dk1"/>
                      </a:lnRef>
                      <a:fillRef idx="0">
                        <a:schemeClr val="dk1"/>
                      </a:fillRef>
                      <a:effectRef idx="2">
                        <a:schemeClr val="dk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60" name="Straight Arrow Connector 59"/>
                      <p:cNvCxnSpPr/>
                      <p:nvPr/>
                    </p:nvCxnSpPr>
                    <p:spPr>
                      <a:xfrm flipH="1">
                        <a:off x="1222421" y="1542202"/>
                        <a:ext cx="383460" cy="0"/>
                      </a:xfrm>
                      <a:prstGeom prst="straightConnector1">
                        <a:avLst/>
                      </a:prstGeom>
                      <a:ln w="9525" cmpd="sng">
                        <a:tailEnd type="stealth" w="med" len="med"/>
                      </a:ln>
                      <a:effectLst/>
                    </p:spPr>
                    <p:style>
                      <a:lnRef idx="3">
                        <a:schemeClr val="dk1"/>
                      </a:lnRef>
                      <a:fillRef idx="0">
                        <a:schemeClr val="dk1"/>
                      </a:fillRef>
                      <a:effectRef idx="2">
                        <a:schemeClr val="dk1"/>
                      </a:effectRef>
                      <a:fontRef idx="minor">
                        <a:schemeClr val="tx1"/>
                      </a:fontRef>
                    </p:style>
                  </p:cxnSp>
                </p:grpSp>
                <p:sp>
                  <p:nvSpPr>
                    <p:cNvPr id="57" name="Rectangle 56"/>
                    <p:cNvSpPr/>
                    <p:nvPr/>
                  </p:nvSpPr>
                  <p:spPr>
                    <a:xfrm>
                      <a:off x="1019705" y="1615880"/>
                      <a:ext cx="766075" cy="253916"/>
                    </a:xfrm>
                    <a:prstGeom prst="rect">
                      <a:avLst/>
                    </a:prstGeom>
                  </p:spPr>
                  <p:txBody>
                    <a:bodyPr wrap="none">
                      <a:spAutoFit/>
                    </a:bodyPr>
                    <a:lstStyle/>
                    <a:p>
                      <a:pPr algn="ctr"/>
                      <a:r>
                        <a:rPr lang="en-US" sz="1600" dirty="0">
                          <a:latin typeface="Arial"/>
                          <a:cs typeface="Arial"/>
                        </a:rPr>
                        <a:t>1</a:t>
                      </a:r>
                      <a:r>
                        <a:rPr lang="en-US" sz="1600" baseline="30000" dirty="0">
                          <a:latin typeface="Arial"/>
                          <a:cs typeface="Arial"/>
                        </a:rPr>
                        <a:t>st</a:t>
                      </a:r>
                      <a:r>
                        <a:rPr lang="en-US" sz="1600" dirty="0">
                          <a:latin typeface="Arial"/>
                          <a:cs typeface="Arial"/>
                        </a:rPr>
                        <a:t> phase</a:t>
                      </a:r>
                      <a:endParaRPr lang="en-US" sz="1600" baseline="30000" dirty="0">
                        <a:latin typeface="Arial"/>
                        <a:cs typeface="Arial"/>
                      </a:endParaRPr>
                    </a:p>
                  </p:txBody>
                </p:sp>
                <p:sp>
                  <p:nvSpPr>
                    <p:cNvPr id="58" name="Rectangle 57"/>
                    <p:cNvSpPr/>
                    <p:nvPr/>
                  </p:nvSpPr>
                  <p:spPr>
                    <a:xfrm>
                      <a:off x="2090534" y="1615973"/>
                      <a:ext cx="798535" cy="253916"/>
                    </a:xfrm>
                    <a:prstGeom prst="rect">
                      <a:avLst/>
                    </a:prstGeom>
                  </p:spPr>
                  <p:txBody>
                    <a:bodyPr wrap="none">
                      <a:spAutoFit/>
                    </a:bodyPr>
                    <a:lstStyle/>
                    <a:p>
                      <a:pPr algn="ctr"/>
                      <a:r>
                        <a:rPr lang="en-US" sz="1600" dirty="0">
                          <a:latin typeface="Arial"/>
                          <a:cs typeface="Arial"/>
                        </a:rPr>
                        <a:t>2</a:t>
                      </a:r>
                      <a:r>
                        <a:rPr lang="en-US" sz="1600" baseline="30000" dirty="0">
                          <a:latin typeface="Arial"/>
                          <a:cs typeface="Arial"/>
                        </a:rPr>
                        <a:t>nd</a:t>
                      </a:r>
                      <a:r>
                        <a:rPr lang="en-US" sz="1600" dirty="0">
                          <a:latin typeface="Arial"/>
                          <a:cs typeface="Arial"/>
                        </a:rPr>
                        <a:t> phase</a:t>
                      </a:r>
                      <a:endParaRPr lang="en-US" sz="1600" baseline="30000" dirty="0">
                        <a:latin typeface="Arial"/>
                        <a:cs typeface="Arial"/>
                      </a:endParaRPr>
                    </a:p>
                  </p:txBody>
                </p:sp>
              </p:grpSp>
              <p:grpSp>
                <p:nvGrpSpPr>
                  <p:cNvPr id="20" name="Group 19"/>
                  <p:cNvGrpSpPr/>
                  <p:nvPr/>
                </p:nvGrpSpPr>
                <p:grpSpPr>
                  <a:xfrm>
                    <a:off x="3859829" y="1552086"/>
                    <a:ext cx="2225673" cy="272143"/>
                    <a:chOff x="1019011" y="1603704"/>
                    <a:chExt cx="2225673" cy="272143"/>
                  </a:xfrm>
                </p:grpSpPr>
                <p:grpSp>
                  <p:nvGrpSpPr>
                    <p:cNvPr id="47" name="Group 46"/>
                    <p:cNvGrpSpPr/>
                    <p:nvPr/>
                  </p:nvGrpSpPr>
                  <p:grpSpPr>
                    <a:xfrm flipV="1">
                      <a:off x="1170002" y="1830128"/>
                      <a:ext cx="457200" cy="45719"/>
                      <a:chOff x="1222421" y="1542202"/>
                      <a:chExt cx="439534" cy="2146004860"/>
                    </a:xfrm>
                  </p:grpSpPr>
                  <p:cxnSp>
                    <p:nvCxnSpPr>
                      <p:cNvPr id="53" name="Straight Arrow Connector 52"/>
                      <p:cNvCxnSpPr/>
                      <p:nvPr/>
                    </p:nvCxnSpPr>
                    <p:spPr>
                      <a:xfrm flipV="1">
                        <a:off x="1287096" y="1542202"/>
                        <a:ext cx="374859" cy="1"/>
                      </a:xfrm>
                      <a:prstGeom prst="straightConnector1">
                        <a:avLst/>
                      </a:prstGeom>
                      <a:ln w="9525" cmpd="sng">
                        <a:headEnd w="sm" len="sm"/>
                        <a:tailEnd type="stealth" w="med" len="med"/>
                      </a:ln>
                      <a:effectLst/>
                    </p:spPr>
                    <p:style>
                      <a:lnRef idx="3">
                        <a:schemeClr val="dk1"/>
                      </a:lnRef>
                      <a:fillRef idx="0">
                        <a:schemeClr val="dk1"/>
                      </a:fillRef>
                      <a:effectRef idx="2">
                        <a:schemeClr val="dk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54" name="Straight Arrow Connector 53"/>
                      <p:cNvCxnSpPr/>
                      <p:nvPr/>
                    </p:nvCxnSpPr>
                    <p:spPr>
                      <a:xfrm flipH="1">
                        <a:off x="1222421" y="1542202"/>
                        <a:ext cx="383460" cy="0"/>
                      </a:xfrm>
                      <a:prstGeom prst="straightConnector1">
                        <a:avLst/>
                      </a:prstGeom>
                      <a:ln w="9525" cmpd="sng">
                        <a:tailEnd type="stealth" w="med" len="med"/>
                      </a:ln>
                      <a:effectLst/>
                    </p:spPr>
                    <p:style>
                      <a:lnRef idx="3">
                        <a:schemeClr val="dk1"/>
                      </a:lnRef>
                      <a:fillRef idx="0">
                        <a:schemeClr val="dk1"/>
                      </a:fillRef>
                      <a:effectRef idx="2">
                        <a:schemeClr val="dk1"/>
                      </a:effectRef>
                      <a:fontRef idx="minor">
                        <a:schemeClr val="tx1"/>
                      </a:fontRef>
                    </p:style>
                  </p:cxnSp>
                </p:grpSp>
                <p:grpSp>
                  <p:nvGrpSpPr>
                    <p:cNvPr id="48" name="Group 47"/>
                    <p:cNvGrpSpPr/>
                    <p:nvPr/>
                  </p:nvGrpSpPr>
                  <p:grpSpPr>
                    <a:xfrm flipV="1">
                      <a:off x="1690204" y="1830128"/>
                      <a:ext cx="1554480" cy="45719"/>
                      <a:chOff x="1222421" y="1542202"/>
                      <a:chExt cx="439534" cy="2146004860"/>
                    </a:xfrm>
                  </p:grpSpPr>
                  <p:cxnSp>
                    <p:nvCxnSpPr>
                      <p:cNvPr id="51" name="Straight Arrow Connector 50"/>
                      <p:cNvCxnSpPr/>
                      <p:nvPr/>
                    </p:nvCxnSpPr>
                    <p:spPr>
                      <a:xfrm flipV="1">
                        <a:off x="1287096" y="1542202"/>
                        <a:ext cx="374859" cy="1"/>
                      </a:xfrm>
                      <a:prstGeom prst="straightConnector1">
                        <a:avLst/>
                      </a:prstGeom>
                      <a:ln w="9525" cmpd="sng">
                        <a:headEnd w="sm" len="sm"/>
                        <a:tailEnd type="stealth" w="med" len="med"/>
                      </a:ln>
                      <a:effectLst/>
                    </p:spPr>
                    <p:style>
                      <a:lnRef idx="3">
                        <a:schemeClr val="dk1"/>
                      </a:lnRef>
                      <a:fillRef idx="0">
                        <a:schemeClr val="dk1"/>
                      </a:fillRef>
                      <a:effectRef idx="2">
                        <a:schemeClr val="dk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52" name="Straight Arrow Connector 51"/>
                      <p:cNvCxnSpPr/>
                      <p:nvPr/>
                    </p:nvCxnSpPr>
                    <p:spPr>
                      <a:xfrm flipH="1">
                        <a:off x="1222421" y="1542202"/>
                        <a:ext cx="383460" cy="0"/>
                      </a:xfrm>
                      <a:prstGeom prst="straightConnector1">
                        <a:avLst/>
                      </a:prstGeom>
                      <a:ln w="9525" cmpd="sng">
                        <a:tailEnd type="stealth" w="med" len="med"/>
                      </a:ln>
                      <a:effectLst/>
                    </p:spPr>
                    <p:style>
                      <a:lnRef idx="3">
                        <a:schemeClr val="dk1"/>
                      </a:lnRef>
                      <a:fillRef idx="0">
                        <a:schemeClr val="dk1"/>
                      </a:fillRef>
                      <a:effectRef idx="2">
                        <a:schemeClr val="dk1"/>
                      </a:effectRef>
                      <a:fontRef idx="minor">
                        <a:schemeClr val="tx1"/>
                      </a:fontRef>
                    </p:style>
                  </p:cxnSp>
                </p:grpSp>
                <p:sp>
                  <p:nvSpPr>
                    <p:cNvPr id="49" name="Rectangle 48"/>
                    <p:cNvSpPr/>
                    <p:nvPr/>
                  </p:nvSpPr>
                  <p:spPr>
                    <a:xfrm>
                      <a:off x="1019011" y="1603704"/>
                      <a:ext cx="766075" cy="253916"/>
                    </a:xfrm>
                    <a:prstGeom prst="rect">
                      <a:avLst/>
                    </a:prstGeom>
                  </p:spPr>
                  <p:txBody>
                    <a:bodyPr wrap="none">
                      <a:spAutoFit/>
                    </a:bodyPr>
                    <a:lstStyle/>
                    <a:p>
                      <a:pPr algn="ctr"/>
                      <a:r>
                        <a:rPr lang="en-US" sz="1600" dirty="0">
                          <a:latin typeface="Arial"/>
                          <a:cs typeface="Arial"/>
                        </a:rPr>
                        <a:t>1</a:t>
                      </a:r>
                      <a:r>
                        <a:rPr lang="en-US" sz="1600" baseline="30000" dirty="0">
                          <a:latin typeface="Arial"/>
                          <a:cs typeface="Arial"/>
                        </a:rPr>
                        <a:t>st</a:t>
                      </a:r>
                      <a:r>
                        <a:rPr lang="en-US" sz="1600" dirty="0">
                          <a:latin typeface="Arial"/>
                          <a:cs typeface="Arial"/>
                        </a:rPr>
                        <a:t> phase</a:t>
                      </a:r>
                      <a:endParaRPr lang="en-US" sz="1600" baseline="30000" dirty="0">
                        <a:latin typeface="Arial"/>
                        <a:cs typeface="Arial"/>
                      </a:endParaRPr>
                    </a:p>
                  </p:txBody>
                </p:sp>
                <p:sp>
                  <p:nvSpPr>
                    <p:cNvPr id="50" name="Rectangle 49"/>
                    <p:cNvSpPr/>
                    <p:nvPr/>
                  </p:nvSpPr>
                  <p:spPr>
                    <a:xfrm>
                      <a:off x="2035940" y="1613168"/>
                      <a:ext cx="798536" cy="253916"/>
                    </a:xfrm>
                    <a:prstGeom prst="rect">
                      <a:avLst/>
                    </a:prstGeom>
                  </p:spPr>
                  <p:txBody>
                    <a:bodyPr wrap="none">
                      <a:spAutoFit/>
                    </a:bodyPr>
                    <a:lstStyle/>
                    <a:p>
                      <a:pPr algn="ctr"/>
                      <a:r>
                        <a:rPr lang="en-US" sz="1600" dirty="0">
                          <a:latin typeface="Arial"/>
                          <a:cs typeface="Arial"/>
                        </a:rPr>
                        <a:t>2</a:t>
                      </a:r>
                      <a:r>
                        <a:rPr lang="en-US" sz="1600" baseline="30000" dirty="0">
                          <a:latin typeface="Arial"/>
                          <a:cs typeface="Arial"/>
                        </a:rPr>
                        <a:t>nd</a:t>
                      </a:r>
                      <a:r>
                        <a:rPr lang="en-US" sz="1600" dirty="0">
                          <a:latin typeface="Arial"/>
                          <a:cs typeface="Arial"/>
                        </a:rPr>
                        <a:t> phase</a:t>
                      </a:r>
                      <a:endParaRPr lang="en-US" sz="1600" baseline="30000" dirty="0">
                        <a:latin typeface="Arial"/>
                        <a:cs typeface="Arial"/>
                      </a:endParaRPr>
                    </a:p>
                  </p:txBody>
                </p:sp>
              </p:grpSp>
              <p:grpSp>
                <p:nvGrpSpPr>
                  <p:cNvPr id="21" name="Group 20"/>
                  <p:cNvGrpSpPr/>
                  <p:nvPr/>
                </p:nvGrpSpPr>
                <p:grpSpPr>
                  <a:xfrm>
                    <a:off x="6811733" y="1554604"/>
                    <a:ext cx="2225683" cy="276999"/>
                    <a:chOff x="1019001" y="1598848"/>
                    <a:chExt cx="2225683" cy="276999"/>
                  </a:xfrm>
                </p:grpSpPr>
                <p:grpSp>
                  <p:nvGrpSpPr>
                    <p:cNvPr id="39" name="Group 38"/>
                    <p:cNvGrpSpPr/>
                    <p:nvPr/>
                  </p:nvGrpSpPr>
                  <p:grpSpPr>
                    <a:xfrm flipV="1">
                      <a:off x="1170002" y="1830128"/>
                      <a:ext cx="457200" cy="45719"/>
                      <a:chOff x="1222421" y="1542202"/>
                      <a:chExt cx="439534" cy="2146004860"/>
                    </a:xfrm>
                  </p:grpSpPr>
                  <p:cxnSp>
                    <p:nvCxnSpPr>
                      <p:cNvPr id="45" name="Straight Arrow Connector 44"/>
                      <p:cNvCxnSpPr/>
                      <p:nvPr/>
                    </p:nvCxnSpPr>
                    <p:spPr>
                      <a:xfrm flipV="1">
                        <a:off x="1287096" y="1542202"/>
                        <a:ext cx="374859" cy="1"/>
                      </a:xfrm>
                      <a:prstGeom prst="straightConnector1">
                        <a:avLst/>
                      </a:prstGeom>
                      <a:ln w="9525" cmpd="sng">
                        <a:headEnd w="sm" len="sm"/>
                        <a:tailEnd type="stealth" w="med" len="med"/>
                      </a:ln>
                      <a:effectLst/>
                    </p:spPr>
                    <p:style>
                      <a:lnRef idx="3">
                        <a:schemeClr val="dk1"/>
                      </a:lnRef>
                      <a:fillRef idx="0">
                        <a:schemeClr val="dk1"/>
                      </a:fillRef>
                      <a:effectRef idx="2">
                        <a:schemeClr val="dk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46" name="Straight Arrow Connector 45"/>
                      <p:cNvCxnSpPr/>
                      <p:nvPr/>
                    </p:nvCxnSpPr>
                    <p:spPr>
                      <a:xfrm flipH="1">
                        <a:off x="1222421" y="1542202"/>
                        <a:ext cx="383460" cy="0"/>
                      </a:xfrm>
                      <a:prstGeom prst="straightConnector1">
                        <a:avLst/>
                      </a:prstGeom>
                      <a:ln w="9525" cmpd="sng">
                        <a:tailEnd type="stealth" w="med" len="med"/>
                      </a:ln>
                      <a:effectLst/>
                    </p:spPr>
                    <p:style>
                      <a:lnRef idx="3">
                        <a:schemeClr val="dk1"/>
                      </a:lnRef>
                      <a:fillRef idx="0">
                        <a:schemeClr val="dk1"/>
                      </a:fillRef>
                      <a:effectRef idx="2">
                        <a:schemeClr val="dk1"/>
                      </a:effectRef>
                      <a:fontRef idx="minor">
                        <a:schemeClr val="tx1"/>
                      </a:fontRef>
                    </p:style>
                  </p:cxnSp>
                </p:grpSp>
                <p:grpSp>
                  <p:nvGrpSpPr>
                    <p:cNvPr id="40" name="Group 39"/>
                    <p:cNvGrpSpPr/>
                    <p:nvPr/>
                  </p:nvGrpSpPr>
                  <p:grpSpPr>
                    <a:xfrm flipV="1">
                      <a:off x="1690204" y="1830128"/>
                      <a:ext cx="1554480" cy="45719"/>
                      <a:chOff x="1222421" y="1542202"/>
                      <a:chExt cx="439534" cy="2146004860"/>
                    </a:xfrm>
                  </p:grpSpPr>
                  <p:cxnSp>
                    <p:nvCxnSpPr>
                      <p:cNvPr id="43" name="Straight Arrow Connector 42"/>
                      <p:cNvCxnSpPr/>
                      <p:nvPr/>
                    </p:nvCxnSpPr>
                    <p:spPr>
                      <a:xfrm flipV="1">
                        <a:off x="1287096" y="1542202"/>
                        <a:ext cx="374859" cy="1"/>
                      </a:xfrm>
                      <a:prstGeom prst="straightConnector1">
                        <a:avLst/>
                      </a:prstGeom>
                      <a:ln w="9525" cmpd="sng">
                        <a:headEnd w="sm" len="sm"/>
                        <a:tailEnd type="stealth" w="med" len="med"/>
                      </a:ln>
                      <a:effectLst/>
                    </p:spPr>
                    <p:style>
                      <a:lnRef idx="3">
                        <a:schemeClr val="dk1"/>
                      </a:lnRef>
                      <a:fillRef idx="0">
                        <a:schemeClr val="dk1"/>
                      </a:fillRef>
                      <a:effectRef idx="2">
                        <a:schemeClr val="dk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44" name="Straight Arrow Connector 43"/>
                      <p:cNvCxnSpPr/>
                      <p:nvPr/>
                    </p:nvCxnSpPr>
                    <p:spPr>
                      <a:xfrm flipH="1">
                        <a:off x="1222421" y="1542202"/>
                        <a:ext cx="383460" cy="0"/>
                      </a:xfrm>
                      <a:prstGeom prst="straightConnector1">
                        <a:avLst/>
                      </a:prstGeom>
                      <a:ln w="9525" cmpd="sng">
                        <a:tailEnd type="stealth" w="med" len="med"/>
                      </a:ln>
                      <a:effectLst/>
                    </p:spPr>
                    <p:style>
                      <a:lnRef idx="3">
                        <a:schemeClr val="dk1"/>
                      </a:lnRef>
                      <a:fillRef idx="0">
                        <a:schemeClr val="dk1"/>
                      </a:fillRef>
                      <a:effectRef idx="2">
                        <a:schemeClr val="dk1"/>
                      </a:effectRef>
                      <a:fontRef idx="minor">
                        <a:schemeClr val="tx1"/>
                      </a:fontRef>
                    </p:style>
                  </p:cxnSp>
                </p:grpSp>
                <p:sp>
                  <p:nvSpPr>
                    <p:cNvPr id="41" name="Rectangle 40"/>
                    <p:cNvSpPr/>
                    <p:nvPr/>
                  </p:nvSpPr>
                  <p:spPr>
                    <a:xfrm>
                      <a:off x="1019001" y="1598848"/>
                      <a:ext cx="766075" cy="253915"/>
                    </a:xfrm>
                    <a:prstGeom prst="rect">
                      <a:avLst/>
                    </a:prstGeom>
                  </p:spPr>
                  <p:txBody>
                    <a:bodyPr wrap="none">
                      <a:spAutoFit/>
                    </a:bodyPr>
                    <a:lstStyle/>
                    <a:p>
                      <a:pPr algn="ctr"/>
                      <a:r>
                        <a:rPr lang="en-US" sz="1600" dirty="0">
                          <a:latin typeface="Arial"/>
                          <a:cs typeface="Arial"/>
                        </a:rPr>
                        <a:t>1</a:t>
                      </a:r>
                      <a:r>
                        <a:rPr lang="en-US" sz="1600" baseline="30000" dirty="0">
                          <a:latin typeface="Arial"/>
                          <a:cs typeface="Arial"/>
                        </a:rPr>
                        <a:t>st</a:t>
                      </a:r>
                      <a:r>
                        <a:rPr lang="en-US" sz="1600" dirty="0">
                          <a:latin typeface="Arial"/>
                          <a:cs typeface="Arial"/>
                        </a:rPr>
                        <a:t> phase</a:t>
                      </a:r>
                      <a:endParaRPr lang="en-US" sz="1600" baseline="30000" dirty="0">
                        <a:latin typeface="Arial"/>
                        <a:cs typeface="Arial"/>
                      </a:endParaRPr>
                    </a:p>
                  </p:txBody>
                </p:sp>
                <p:sp>
                  <p:nvSpPr>
                    <p:cNvPr id="42" name="Rectangle 41"/>
                    <p:cNvSpPr/>
                    <p:nvPr/>
                  </p:nvSpPr>
                  <p:spPr>
                    <a:xfrm>
                      <a:off x="2058857" y="1605794"/>
                      <a:ext cx="798536" cy="253915"/>
                    </a:xfrm>
                    <a:prstGeom prst="rect">
                      <a:avLst/>
                    </a:prstGeom>
                  </p:spPr>
                  <p:txBody>
                    <a:bodyPr wrap="none">
                      <a:spAutoFit/>
                    </a:bodyPr>
                    <a:lstStyle/>
                    <a:p>
                      <a:pPr algn="ctr"/>
                      <a:r>
                        <a:rPr lang="en-US" sz="1600" dirty="0">
                          <a:latin typeface="Arial"/>
                          <a:cs typeface="Arial"/>
                        </a:rPr>
                        <a:t>2</a:t>
                      </a:r>
                      <a:r>
                        <a:rPr lang="en-US" sz="1600" baseline="30000" dirty="0">
                          <a:latin typeface="Arial"/>
                          <a:cs typeface="Arial"/>
                        </a:rPr>
                        <a:t>nd</a:t>
                      </a:r>
                      <a:r>
                        <a:rPr lang="en-US" sz="1600" dirty="0">
                          <a:latin typeface="Arial"/>
                          <a:cs typeface="Arial"/>
                        </a:rPr>
                        <a:t> phase</a:t>
                      </a:r>
                      <a:endParaRPr lang="en-US" sz="1600" baseline="30000" dirty="0">
                        <a:latin typeface="Arial"/>
                        <a:cs typeface="Arial"/>
                      </a:endParaRPr>
                    </a:p>
                  </p:txBody>
                </p:sp>
              </p:grpSp>
              <p:sp>
                <p:nvSpPr>
                  <p:cNvPr id="22" name="Rectangle 21"/>
                  <p:cNvSpPr/>
                  <p:nvPr/>
                </p:nvSpPr>
                <p:spPr>
                  <a:xfrm>
                    <a:off x="1437336" y="2514091"/>
                    <a:ext cx="1195280" cy="284742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pPr algn="ctr"/>
                    <a:r>
                      <a:rPr lang="en-US" sz="1867" dirty="0">
                        <a:latin typeface="Arial"/>
                        <a:cs typeface="Arial"/>
                      </a:rPr>
                      <a:t>Normal GSIS</a:t>
                    </a:r>
                    <a:endParaRPr lang="en-US" sz="1867" baseline="30000" dirty="0">
                      <a:latin typeface="Arial"/>
                      <a:cs typeface="Arial"/>
                    </a:endParaRPr>
                  </a:p>
                </p:txBody>
              </p:sp>
              <p:sp>
                <p:nvSpPr>
                  <p:cNvPr id="23" name="Rectangle 22"/>
                  <p:cNvSpPr/>
                  <p:nvPr/>
                </p:nvSpPr>
                <p:spPr>
                  <a:xfrm>
                    <a:off x="4243637" y="2502666"/>
                    <a:ext cx="1314302" cy="284742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pPr algn="ctr"/>
                    <a:r>
                      <a:rPr lang="en-US" sz="1867" dirty="0">
                        <a:latin typeface="Arial"/>
                        <a:cs typeface="Arial"/>
                      </a:rPr>
                      <a:t>Impaired GSIS</a:t>
                    </a:r>
                  </a:p>
                </p:txBody>
              </p:sp>
              <p:sp>
                <p:nvSpPr>
                  <p:cNvPr id="24" name="Rectangle 23"/>
                  <p:cNvSpPr/>
                  <p:nvPr/>
                </p:nvSpPr>
                <p:spPr>
                  <a:xfrm>
                    <a:off x="4041654" y="2712178"/>
                    <a:ext cx="1724270" cy="284742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pPr algn="ctr"/>
                    <a:r>
                      <a:rPr lang="en-US" sz="1867" dirty="0">
                        <a:latin typeface="Arial"/>
                        <a:cs typeface="Arial"/>
                      </a:rPr>
                      <a:t>Glucose intolerance</a:t>
                    </a:r>
                  </a:p>
                </p:txBody>
              </p:sp>
              <p:sp>
                <p:nvSpPr>
                  <p:cNvPr id="25" name="Rectangle 24"/>
                  <p:cNvSpPr/>
                  <p:nvPr/>
                </p:nvSpPr>
                <p:spPr>
                  <a:xfrm>
                    <a:off x="7125469" y="2490132"/>
                    <a:ext cx="1405673" cy="284742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pPr algn="ctr"/>
                    <a:r>
                      <a:rPr lang="en-US" sz="1867" dirty="0">
                        <a:latin typeface="Arial"/>
                        <a:cs typeface="Arial"/>
                      </a:rPr>
                      <a:t>Increased GSIS</a:t>
                    </a:r>
                  </a:p>
                </p:txBody>
              </p:sp>
              <p:sp>
                <p:nvSpPr>
                  <p:cNvPr id="26" name="Rectangle 25"/>
                  <p:cNvSpPr/>
                  <p:nvPr/>
                </p:nvSpPr>
                <p:spPr>
                  <a:xfrm>
                    <a:off x="6626534" y="2706391"/>
                    <a:ext cx="2403542" cy="284742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pPr algn="ctr"/>
                    <a:r>
                      <a:rPr lang="en-US" sz="1867" dirty="0">
                        <a:latin typeface="Arial"/>
                        <a:cs typeface="Arial"/>
                      </a:rPr>
                      <a:t>Enhanced glucose tolerance</a:t>
                    </a:r>
                  </a:p>
                </p:txBody>
              </p:sp>
              <p:sp>
                <p:nvSpPr>
                  <p:cNvPr id="27" name="Rectangle 26"/>
                  <p:cNvSpPr/>
                  <p:nvPr/>
                </p:nvSpPr>
                <p:spPr>
                  <a:xfrm>
                    <a:off x="6615542" y="2928345"/>
                    <a:ext cx="2431195" cy="284742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pPr algn="ctr"/>
                    <a:r>
                      <a:rPr lang="en-US" sz="1867" dirty="0">
                        <a:latin typeface="Arial"/>
                        <a:cs typeface="Arial"/>
                      </a:rPr>
                      <a:t>Improved diabetes hallmarks</a:t>
                    </a:r>
                  </a:p>
                </p:txBody>
              </p:sp>
              <p:grpSp>
                <p:nvGrpSpPr>
                  <p:cNvPr id="28" name="Group 27"/>
                  <p:cNvGrpSpPr/>
                  <p:nvPr/>
                </p:nvGrpSpPr>
                <p:grpSpPr>
                  <a:xfrm>
                    <a:off x="6049" y="2826322"/>
                    <a:ext cx="1289066" cy="851666"/>
                    <a:chOff x="132734" y="2796826"/>
                    <a:chExt cx="1289066" cy="851666"/>
                  </a:xfrm>
                </p:grpSpPr>
                <p:pic>
                  <p:nvPicPr>
                    <p:cNvPr id="34" name="Picture 33"/>
                    <p:cNvPicPr>
                      <a:picLocks noChangeAspect="1"/>
                    </p:cNvPicPr>
                    <p:nvPr/>
                  </p:nvPicPr>
                  <p:blipFill rotWithShape="1">
                    <a:blip r:embed="rId4"/>
                    <a:srcRect l="23647" t="65681" r="72965" b="21696"/>
                    <a:stretch/>
                  </p:blipFill>
                  <p:spPr>
                    <a:xfrm>
                      <a:off x="132734" y="2821752"/>
                      <a:ext cx="432310" cy="769482"/>
                    </a:xfrm>
                    <a:prstGeom prst="rect">
                      <a:avLst/>
                    </a:prstGeom>
                  </p:spPr>
                </p:pic>
                <p:sp>
                  <p:nvSpPr>
                    <p:cNvPr id="35" name="Rectangle 34"/>
                    <p:cNvSpPr/>
                    <p:nvPr/>
                  </p:nvSpPr>
                  <p:spPr>
                    <a:xfrm>
                      <a:off x="486207" y="2796826"/>
                      <a:ext cx="935593" cy="223091"/>
                    </a:xfrm>
                    <a:prstGeom prst="rect">
                      <a:avLst/>
                    </a:prstGeom>
                  </p:spPr>
                  <p:txBody>
                    <a:bodyPr wrap="none">
                      <a:spAutoFit/>
                    </a:bodyPr>
                    <a:lstStyle/>
                    <a:p>
                      <a:pPr algn="ctr"/>
                      <a:r>
                        <a:rPr lang="en-US" sz="1333" dirty="0">
                          <a:latin typeface="Arial"/>
                          <a:cs typeface="Arial"/>
                        </a:rPr>
                        <a:t>Insulin vesicle</a:t>
                      </a:r>
                      <a:endParaRPr lang="en-US" sz="1333" baseline="30000" dirty="0">
                        <a:latin typeface="Arial"/>
                        <a:cs typeface="Arial"/>
                      </a:endParaRPr>
                    </a:p>
                  </p:txBody>
                </p:sp>
                <p:sp>
                  <p:nvSpPr>
                    <p:cNvPr id="36" name="Rectangle 35"/>
                    <p:cNvSpPr/>
                    <p:nvPr/>
                  </p:nvSpPr>
                  <p:spPr>
                    <a:xfrm>
                      <a:off x="484798" y="3006351"/>
                      <a:ext cx="377843" cy="223091"/>
                    </a:xfrm>
                    <a:prstGeom prst="rect">
                      <a:avLst/>
                    </a:prstGeom>
                  </p:spPr>
                  <p:txBody>
                    <a:bodyPr wrap="none">
                      <a:spAutoFit/>
                    </a:bodyPr>
                    <a:lstStyle/>
                    <a:p>
                      <a:pPr algn="ctr"/>
                      <a:r>
                        <a:rPr lang="en-US" sz="1333" dirty="0">
                          <a:latin typeface="Arial"/>
                          <a:cs typeface="Arial"/>
                        </a:rPr>
                        <a:t>ATP</a:t>
                      </a:r>
                      <a:endParaRPr lang="en-US" sz="1333" baseline="30000" dirty="0">
                        <a:latin typeface="Arial"/>
                        <a:cs typeface="Arial"/>
                      </a:endParaRPr>
                    </a:p>
                  </p:txBody>
                </p:sp>
                <p:sp>
                  <p:nvSpPr>
                    <p:cNvPr id="37" name="Rectangle 36"/>
                    <p:cNvSpPr/>
                    <p:nvPr/>
                  </p:nvSpPr>
                  <p:spPr>
                    <a:xfrm>
                      <a:off x="477417" y="3215876"/>
                      <a:ext cx="400591" cy="223091"/>
                    </a:xfrm>
                    <a:prstGeom prst="rect">
                      <a:avLst/>
                    </a:prstGeom>
                  </p:spPr>
                  <p:txBody>
                    <a:bodyPr wrap="none">
                      <a:spAutoFit/>
                    </a:bodyPr>
                    <a:lstStyle/>
                    <a:p>
                      <a:pPr algn="ctr"/>
                      <a:r>
                        <a:rPr lang="en-US" sz="1333" dirty="0">
                          <a:latin typeface="Arial"/>
                          <a:cs typeface="Arial"/>
                        </a:rPr>
                        <a:t>Ca</a:t>
                      </a:r>
                      <a:r>
                        <a:rPr lang="en-US" sz="1333" baseline="30000" dirty="0">
                          <a:latin typeface="Arial"/>
                          <a:cs typeface="Arial"/>
                        </a:rPr>
                        <a:t>2+</a:t>
                      </a:r>
                    </a:p>
                  </p:txBody>
                </p:sp>
                <p:sp>
                  <p:nvSpPr>
                    <p:cNvPr id="38" name="Rectangle 37"/>
                    <p:cNvSpPr/>
                    <p:nvPr/>
                  </p:nvSpPr>
                  <p:spPr>
                    <a:xfrm>
                      <a:off x="473388" y="3425401"/>
                      <a:ext cx="508793" cy="223091"/>
                    </a:xfrm>
                    <a:prstGeom prst="rect">
                      <a:avLst/>
                    </a:prstGeom>
                  </p:spPr>
                  <p:txBody>
                    <a:bodyPr wrap="none">
                      <a:spAutoFit/>
                    </a:bodyPr>
                    <a:lstStyle/>
                    <a:p>
                      <a:pPr algn="ctr"/>
                      <a:r>
                        <a:rPr lang="en-US" sz="1333" dirty="0">
                          <a:latin typeface="Arial"/>
                          <a:cs typeface="Arial"/>
                        </a:rPr>
                        <a:t>Insulin</a:t>
                      </a:r>
                      <a:endParaRPr lang="en-US" sz="1333" baseline="30000" dirty="0">
                        <a:latin typeface="Arial"/>
                        <a:cs typeface="Arial"/>
                      </a:endParaRPr>
                    </a:p>
                  </p:txBody>
                </p:sp>
              </p:grpSp>
              <p:sp>
                <p:nvSpPr>
                  <p:cNvPr id="29" name="Rectangle 28"/>
                  <p:cNvSpPr/>
                  <p:nvPr/>
                </p:nvSpPr>
                <p:spPr>
                  <a:xfrm>
                    <a:off x="1472779" y="3071437"/>
                    <a:ext cx="607378" cy="223090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pPr algn="ctr"/>
                    <a:r>
                      <a:rPr lang="en-US" sz="1333" dirty="0">
                        <a:latin typeface="Arial"/>
                        <a:cs typeface="Arial"/>
                      </a:rPr>
                      <a:t>Glucose</a:t>
                    </a:r>
                    <a:endParaRPr lang="en-US" sz="1333" baseline="30000" dirty="0">
                      <a:latin typeface="Arial"/>
                      <a:cs typeface="Arial"/>
                    </a:endParaRPr>
                  </a:p>
                </p:txBody>
              </p:sp>
              <p:sp>
                <p:nvSpPr>
                  <p:cNvPr id="30" name="Rectangle 29"/>
                  <p:cNvSpPr/>
                  <p:nvPr/>
                </p:nvSpPr>
                <p:spPr>
                  <a:xfrm>
                    <a:off x="1474271" y="3264628"/>
                    <a:ext cx="1869743" cy="223090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pPr algn="ctr"/>
                    <a:r>
                      <a:rPr lang="en-US" sz="1333" dirty="0">
                        <a:latin typeface="Arial"/>
                        <a:cs typeface="Arial"/>
                      </a:rPr>
                      <a:t>Pharmacologic inhibition &amp; KO</a:t>
                    </a:r>
                    <a:endParaRPr lang="en-US" sz="1333" baseline="30000" dirty="0">
                      <a:latin typeface="Arial"/>
                      <a:cs typeface="Arial"/>
                    </a:endParaRPr>
                  </a:p>
                </p:txBody>
              </p:sp>
              <p:sp>
                <p:nvSpPr>
                  <p:cNvPr id="31" name="Rectangle 30"/>
                  <p:cNvSpPr/>
                  <p:nvPr/>
                </p:nvSpPr>
                <p:spPr>
                  <a:xfrm>
                    <a:off x="1484285" y="3454896"/>
                    <a:ext cx="693940" cy="223090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pPr algn="ctr"/>
                    <a:r>
                      <a:rPr lang="en-US" sz="1333" dirty="0">
                        <a:latin typeface="Arial"/>
                        <a:cs typeface="Arial"/>
                      </a:rPr>
                      <a:t>Activation</a:t>
                    </a:r>
                    <a:endParaRPr lang="en-US" sz="1333" baseline="30000" dirty="0">
                      <a:latin typeface="Arial"/>
                      <a:cs typeface="Arial"/>
                    </a:endParaRPr>
                  </a:p>
                </p:txBody>
              </p:sp>
              <p:sp>
                <p:nvSpPr>
                  <p:cNvPr id="32" name="Rectangle 31"/>
                  <p:cNvSpPr/>
                  <p:nvPr/>
                </p:nvSpPr>
                <p:spPr>
                  <a:xfrm>
                    <a:off x="530450" y="2278243"/>
                    <a:ext cx="207028" cy="315423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pPr algn="ctr"/>
                    <a:r>
                      <a:rPr lang="en-US" sz="2133" dirty="0">
                        <a:latin typeface="Arial"/>
                        <a:cs typeface="Arial"/>
                      </a:rPr>
                      <a:t>-</a:t>
                    </a:r>
                    <a:endParaRPr lang="en-US" sz="2133" baseline="30000" dirty="0">
                      <a:latin typeface="Arial"/>
                      <a:cs typeface="Arial"/>
                    </a:endParaRPr>
                  </a:p>
                </p:txBody>
              </p:sp>
              <p:sp>
                <p:nvSpPr>
                  <p:cNvPr id="33" name="Rectangle 32"/>
                  <p:cNvSpPr/>
                  <p:nvPr/>
                </p:nvSpPr>
                <p:spPr>
                  <a:xfrm>
                    <a:off x="508760" y="1046174"/>
                    <a:ext cx="258725" cy="315423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pPr algn="ctr"/>
                    <a:r>
                      <a:rPr lang="en-US" sz="2133" dirty="0">
                        <a:latin typeface="Arial"/>
                        <a:cs typeface="Arial"/>
                      </a:rPr>
                      <a:t>+</a:t>
                    </a:r>
                    <a:endParaRPr lang="en-US" sz="2133" baseline="30000" dirty="0">
                      <a:latin typeface="Arial"/>
                      <a:cs typeface="Arial"/>
                    </a:endParaRPr>
                  </a:p>
                </p:txBody>
              </p:sp>
            </p:grpSp>
            <p:sp>
              <p:nvSpPr>
                <p:cNvPr id="63" name="Rectangle 62"/>
                <p:cNvSpPr/>
                <p:nvPr/>
              </p:nvSpPr>
              <p:spPr>
                <a:xfrm>
                  <a:off x="7030008" y="3264628"/>
                  <a:ext cx="2037207" cy="356102"/>
                </a:xfrm>
                <a:prstGeom prst="rect">
                  <a:avLst/>
                </a:prstGeom>
                <a:solidFill>
                  <a:schemeClr val="bg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2400"/>
                </a:p>
              </p:txBody>
            </p:sp>
          </p:grpSp>
          <p:sp>
            <p:nvSpPr>
              <p:cNvPr id="65" name="TextBox 64"/>
              <p:cNvSpPr txBox="1"/>
              <p:nvPr/>
            </p:nvSpPr>
            <p:spPr>
              <a:xfrm>
                <a:off x="3867601" y="3882508"/>
                <a:ext cx="1529171" cy="25391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6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upplemental Fig. </a:t>
                </a:r>
                <a:r>
                  <a:rPr lang="en-US" sz="16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3</a:t>
                </a:r>
                <a:endParaRPr lang="en-US" sz="16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74" name="Rounded Rectangle 73"/>
            <p:cNvSpPr/>
            <p:nvPr/>
          </p:nvSpPr>
          <p:spPr>
            <a:xfrm>
              <a:off x="2814491" y="1417705"/>
              <a:ext cx="1639232" cy="1420745"/>
            </a:xfrm>
            <a:prstGeom prst="roundRect">
              <a:avLst/>
            </a:prstGeom>
            <a:solidFill>
              <a:schemeClr val="accent1">
                <a:alpha val="10000"/>
              </a:schemeClr>
            </a:solidFill>
            <a:ln>
              <a:noFill/>
            </a:ln>
            <a:effectLst>
              <a:softEdge rad="12700"/>
            </a:effectLst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75" name="Rounded Rectangle 74"/>
            <p:cNvSpPr/>
            <p:nvPr/>
          </p:nvSpPr>
          <p:spPr>
            <a:xfrm>
              <a:off x="6944101" y="1584725"/>
              <a:ext cx="1176639" cy="823829"/>
            </a:xfrm>
            <a:prstGeom prst="roundRect">
              <a:avLst/>
            </a:prstGeom>
            <a:solidFill>
              <a:schemeClr val="accent1">
                <a:alpha val="1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76" name="Rounded Rectangle 75"/>
            <p:cNvSpPr/>
            <p:nvPr/>
          </p:nvSpPr>
          <p:spPr>
            <a:xfrm>
              <a:off x="10449262" y="1305979"/>
              <a:ext cx="1745157" cy="1713839"/>
            </a:xfrm>
            <a:prstGeom prst="roundRect">
              <a:avLst/>
            </a:prstGeom>
            <a:solidFill>
              <a:schemeClr val="accent1">
                <a:alpha val="1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</p:spTree>
    <p:extLst>
      <p:ext uri="{BB962C8B-B14F-4D97-AF65-F5344CB8AC3E}">
        <p14:creationId xmlns:p14="http://schemas.microsoft.com/office/powerpoint/2010/main" val="410914820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75558</TotalTime>
  <Words>61</Words>
  <Application>Microsoft Office PowerPoint</Application>
  <PresentationFormat>Widescreen</PresentationFormat>
  <Paragraphs>32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Youakim</dc:creator>
  <cp:lastModifiedBy>Nassim Fares</cp:lastModifiedBy>
  <cp:revision>664</cp:revision>
  <dcterms:created xsi:type="dcterms:W3CDTF">2021-03-23T17:40:46Z</dcterms:created>
  <dcterms:modified xsi:type="dcterms:W3CDTF">2022-11-18T13:38:42Z</dcterms:modified>
</cp:coreProperties>
</file>